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5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2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1.apss.tn.it\USR1$\5320414\Ipofrazionamento\Articolo\Submission%20JACMP\Secondo%20Invio\DHV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1.apss.tn.it\USR1$\5320414\Ipofrazionamento\Articolo\Submission%20JACMP\Secondo%20Invio\DHV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1.apss.tn.it\USR1$\5320414\Ipofrazionamento\Articolo\Submission%20JACMP\Secondo%20Invio\DHV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1.apss.tn.it\USR1$\5320414\Ipofrazionamento\Articolo\Submission%20JACMP\Secondo%20Invio\DHV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172.21.101.229\Pubblica\UTENTI\RIGHETTO\JACMP%20Secondo%20Invio\File%20lavoro\DHV%20Neuroma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359166201874956"/>
          <c:y val="5.4880162372780844E-2"/>
          <c:w val="0.70471193737918603"/>
          <c:h val="0.73060771067862351"/>
        </c:manualLayout>
      </c:layout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rgbClr val="9DC3E6"/>
              </a:solidFill>
              <a:round/>
            </a:ln>
            <a:effectLst/>
          </c:spPr>
          <c:marker>
            <c:symbol val="none"/>
          </c:marker>
          <c:xVal>
            <c:numRef>
              <c:f>Foglio6!$A$5:$A$406</c:f>
              <c:numCache>
                <c:formatCode>General</c:formatCode>
                <c:ptCount val="402"/>
                <c:pt idx="0">
                  <c:v>0</c:v>
                </c:pt>
                <c:pt idx="1">
                  <c:v>6.7670000000000003</c:v>
                </c:pt>
                <c:pt idx="2">
                  <c:v>13.534000000000001</c:v>
                </c:pt>
                <c:pt idx="3">
                  <c:v>20.300999999999998</c:v>
                </c:pt>
                <c:pt idx="4">
                  <c:v>27.068000000000001</c:v>
                </c:pt>
                <c:pt idx="5">
                  <c:v>33.835000000000001</c:v>
                </c:pt>
                <c:pt idx="6">
                  <c:v>40.601999999999997</c:v>
                </c:pt>
                <c:pt idx="7">
                  <c:v>47.369</c:v>
                </c:pt>
                <c:pt idx="8">
                  <c:v>54.136000000000003</c:v>
                </c:pt>
                <c:pt idx="9">
                  <c:v>60.902999999999999</c:v>
                </c:pt>
                <c:pt idx="10">
                  <c:v>67.67</c:v>
                </c:pt>
                <c:pt idx="11">
                  <c:v>74.436999999999998</c:v>
                </c:pt>
                <c:pt idx="12">
                  <c:v>81.203999999999994</c:v>
                </c:pt>
                <c:pt idx="13">
                  <c:v>87.971000000000004</c:v>
                </c:pt>
                <c:pt idx="14">
                  <c:v>94.738</c:v>
                </c:pt>
                <c:pt idx="15">
                  <c:v>101.505</c:v>
                </c:pt>
                <c:pt idx="16">
                  <c:v>108.27200000000001</c:v>
                </c:pt>
                <c:pt idx="17">
                  <c:v>115.039</c:v>
                </c:pt>
                <c:pt idx="18">
                  <c:v>121.806</c:v>
                </c:pt>
                <c:pt idx="19">
                  <c:v>128.57400000000001</c:v>
                </c:pt>
                <c:pt idx="20">
                  <c:v>135.34100000000001</c:v>
                </c:pt>
                <c:pt idx="21">
                  <c:v>142.108</c:v>
                </c:pt>
                <c:pt idx="22">
                  <c:v>148.875</c:v>
                </c:pt>
                <c:pt idx="23">
                  <c:v>155.642</c:v>
                </c:pt>
                <c:pt idx="24">
                  <c:v>162.40899999999999</c:v>
                </c:pt>
                <c:pt idx="25">
                  <c:v>169.17599999999999</c:v>
                </c:pt>
                <c:pt idx="26">
                  <c:v>175.94300000000001</c:v>
                </c:pt>
                <c:pt idx="27">
                  <c:v>182.71</c:v>
                </c:pt>
                <c:pt idx="28">
                  <c:v>189.477</c:v>
                </c:pt>
                <c:pt idx="29">
                  <c:v>196.244</c:v>
                </c:pt>
                <c:pt idx="30">
                  <c:v>203.011</c:v>
                </c:pt>
                <c:pt idx="31">
                  <c:v>209.77799999999999</c:v>
                </c:pt>
                <c:pt idx="32">
                  <c:v>216.54499999999999</c:v>
                </c:pt>
                <c:pt idx="33">
                  <c:v>223.31200000000001</c:v>
                </c:pt>
                <c:pt idx="34">
                  <c:v>230.07900000000001</c:v>
                </c:pt>
                <c:pt idx="35">
                  <c:v>236.846</c:v>
                </c:pt>
                <c:pt idx="36">
                  <c:v>243.613</c:v>
                </c:pt>
                <c:pt idx="37">
                  <c:v>250.38</c:v>
                </c:pt>
                <c:pt idx="38">
                  <c:v>257.14699999999999</c:v>
                </c:pt>
                <c:pt idx="39">
                  <c:v>263.91399999999999</c:v>
                </c:pt>
                <c:pt idx="40">
                  <c:v>270.68099999999998</c:v>
                </c:pt>
                <c:pt idx="41">
                  <c:v>277.44799999999998</c:v>
                </c:pt>
                <c:pt idx="42">
                  <c:v>284.21499999999997</c:v>
                </c:pt>
                <c:pt idx="43">
                  <c:v>290.98200000000003</c:v>
                </c:pt>
                <c:pt idx="44">
                  <c:v>297.74900000000002</c:v>
                </c:pt>
                <c:pt idx="45">
                  <c:v>304.51600000000002</c:v>
                </c:pt>
                <c:pt idx="46">
                  <c:v>311.28300000000002</c:v>
                </c:pt>
                <c:pt idx="47">
                  <c:v>318.05</c:v>
                </c:pt>
                <c:pt idx="48">
                  <c:v>324.81700000000001</c:v>
                </c:pt>
                <c:pt idx="49">
                  <c:v>331.584</c:v>
                </c:pt>
                <c:pt idx="50">
                  <c:v>338.351</c:v>
                </c:pt>
                <c:pt idx="51">
                  <c:v>345.11799999999999</c:v>
                </c:pt>
                <c:pt idx="52">
                  <c:v>351.88499999999999</c:v>
                </c:pt>
                <c:pt idx="53">
                  <c:v>358.65199999999999</c:v>
                </c:pt>
                <c:pt idx="54">
                  <c:v>365.41899999999998</c:v>
                </c:pt>
                <c:pt idx="55">
                  <c:v>372.18599999999998</c:v>
                </c:pt>
                <c:pt idx="56">
                  <c:v>378.95299999999997</c:v>
                </c:pt>
                <c:pt idx="57">
                  <c:v>385.721</c:v>
                </c:pt>
                <c:pt idx="58">
                  <c:v>392.488</c:v>
                </c:pt>
                <c:pt idx="59">
                  <c:v>399.255</c:v>
                </c:pt>
                <c:pt idx="60">
                  <c:v>406.02199999999999</c:v>
                </c:pt>
                <c:pt idx="61">
                  <c:v>412.78899999999999</c:v>
                </c:pt>
                <c:pt idx="62">
                  <c:v>419.55599999999998</c:v>
                </c:pt>
                <c:pt idx="63">
                  <c:v>426.32299999999998</c:v>
                </c:pt>
                <c:pt idx="64">
                  <c:v>433.09</c:v>
                </c:pt>
                <c:pt idx="65">
                  <c:v>439.85700000000003</c:v>
                </c:pt>
                <c:pt idx="66">
                  <c:v>446.62400000000002</c:v>
                </c:pt>
                <c:pt idx="67">
                  <c:v>453.39100000000002</c:v>
                </c:pt>
                <c:pt idx="68">
                  <c:v>460.15800000000002</c:v>
                </c:pt>
                <c:pt idx="69">
                  <c:v>466.92500000000001</c:v>
                </c:pt>
                <c:pt idx="70">
                  <c:v>473.69200000000001</c:v>
                </c:pt>
                <c:pt idx="71">
                  <c:v>480.459</c:v>
                </c:pt>
                <c:pt idx="72">
                  <c:v>487.226</c:v>
                </c:pt>
                <c:pt idx="73">
                  <c:v>493.99299999999999</c:v>
                </c:pt>
                <c:pt idx="74">
                  <c:v>500.76</c:v>
                </c:pt>
                <c:pt idx="75">
                  <c:v>507.52699999999999</c:v>
                </c:pt>
                <c:pt idx="76">
                  <c:v>514.29399999999998</c:v>
                </c:pt>
                <c:pt idx="77">
                  <c:v>521.06100000000004</c:v>
                </c:pt>
                <c:pt idx="78">
                  <c:v>527.82799999999997</c:v>
                </c:pt>
                <c:pt idx="79">
                  <c:v>534.59500000000003</c:v>
                </c:pt>
                <c:pt idx="80">
                  <c:v>541.36199999999997</c:v>
                </c:pt>
                <c:pt idx="81">
                  <c:v>548.12900000000002</c:v>
                </c:pt>
                <c:pt idx="82">
                  <c:v>554.89599999999996</c:v>
                </c:pt>
                <c:pt idx="83">
                  <c:v>561.66300000000001</c:v>
                </c:pt>
                <c:pt idx="84">
                  <c:v>568.42999999999995</c:v>
                </c:pt>
                <c:pt idx="85">
                  <c:v>575.197</c:v>
                </c:pt>
                <c:pt idx="86">
                  <c:v>581.96400000000006</c:v>
                </c:pt>
                <c:pt idx="87">
                  <c:v>588.73099999999999</c:v>
                </c:pt>
                <c:pt idx="88">
                  <c:v>595.49800000000005</c:v>
                </c:pt>
                <c:pt idx="89">
                  <c:v>602.26499999999999</c:v>
                </c:pt>
                <c:pt idx="90">
                  <c:v>609.03200000000004</c:v>
                </c:pt>
                <c:pt idx="91">
                  <c:v>615.79899999999998</c:v>
                </c:pt>
                <c:pt idx="92">
                  <c:v>622.56600000000003</c:v>
                </c:pt>
                <c:pt idx="93">
                  <c:v>629.33299999999997</c:v>
                </c:pt>
                <c:pt idx="94">
                  <c:v>636.1</c:v>
                </c:pt>
                <c:pt idx="95">
                  <c:v>642.86800000000005</c:v>
                </c:pt>
                <c:pt idx="96">
                  <c:v>649.63499999999999</c:v>
                </c:pt>
                <c:pt idx="97">
                  <c:v>656.40200000000004</c:v>
                </c:pt>
                <c:pt idx="98">
                  <c:v>663.16899999999998</c:v>
                </c:pt>
                <c:pt idx="99">
                  <c:v>669.93600000000004</c:v>
                </c:pt>
                <c:pt idx="100">
                  <c:v>676.70299999999997</c:v>
                </c:pt>
                <c:pt idx="101">
                  <c:v>683.47</c:v>
                </c:pt>
                <c:pt idx="102">
                  <c:v>690.23699999999997</c:v>
                </c:pt>
                <c:pt idx="103">
                  <c:v>697.00400000000002</c:v>
                </c:pt>
                <c:pt idx="104">
                  <c:v>703.77099999999996</c:v>
                </c:pt>
                <c:pt idx="105">
                  <c:v>710.53800000000001</c:v>
                </c:pt>
                <c:pt idx="106">
                  <c:v>717.30499999999995</c:v>
                </c:pt>
                <c:pt idx="107">
                  <c:v>724.072</c:v>
                </c:pt>
                <c:pt idx="108">
                  <c:v>730.83900000000006</c:v>
                </c:pt>
                <c:pt idx="109">
                  <c:v>737.60599999999999</c:v>
                </c:pt>
                <c:pt idx="110">
                  <c:v>744.37300000000005</c:v>
                </c:pt>
                <c:pt idx="111">
                  <c:v>751.14</c:v>
                </c:pt>
                <c:pt idx="112">
                  <c:v>757.90700000000004</c:v>
                </c:pt>
                <c:pt idx="113">
                  <c:v>764.67399999999998</c:v>
                </c:pt>
                <c:pt idx="114">
                  <c:v>771.44100000000003</c:v>
                </c:pt>
                <c:pt idx="115">
                  <c:v>778.20799999999997</c:v>
                </c:pt>
                <c:pt idx="116">
                  <c:v>784.97500000000002</c:v>
                </c:pt>
                <c:pt idx="117">
                  <c:v>791.74199999999996</c:v>
                </c:pt>
                <c:pt idx="118">
                  <c:v>798.50900000000001</c:v>
                </c:pt>
                <c:pt idx="119">
                  <c:v>805.27599999999995</c:v>
                </c:pt>
                <c:pt idx="120">
                  <c:v>812.04300000000001</c:v>
                </c:pt>
                <c:pt idx="121">
                  <c:v>818.81</c:v>
                </c:pt>
                <c:pt idx="122">
                  <c:v>825.577</c:v>
                </c:pt>
                <c:pt idx="123">
                  <c:v>832.34400000000005</c:v>
                </c:pt>
                <c:pt idx="124">
                  <c:v>839.11099999999999</c:v>
                </c:pt>
                <c:pt idx="125">
                  <c:v>845.87800000000004</c:v>
                </c:pt>
                <c:pt idx="126">
                  <c:v>852.64499999999998</c:v>
                </c:pt>
                <c:pt idx="127">
                  <c:v>859.41200000000003</c:v>
                </c:pt>
                <c:pt idx="128">
                  <c:v>866.17899999999997</c:v>
                </c:pt>
                <c:pt idx="129">
                  <c:v>872.94600000000003</c:v>
                </c:pt>
                <c:pt idx="130">
                  <c:v>879.71299999999997</c:v>
                </c:pt>
                <c:pt idx="131">
                  <c:v>886.48</c:v>
                </c:pt>
                <c:pt idx="132">
                  <c:v>893.24699999999996</c:v>
                </c:pt>
                <c:pt idx="133">
                  <c:v>900.01499999999999</c:v>
                </c:pt>
                <c:pt idx="134">
                  <c:v>906.78200000000004</c:v>
                </c:pt>
                <c:pt idx="135">
                  <c:v>913.54899999999998</c:v>
                </c:pt>
                <c:pt idx="136">
                  <c:v>920.31600000000003</c:v>
                </c:pt>
                <c:pt idx="137">
                  <c:v>927.08299999999997</c:v>
                </c:pt>
                <c:pt idx="138">
                  <c:v>933.85</c:v>
                </c:pt>
                <c:pt idx="139">
                  <c:v>940.61699999999996</c:v>
                </c:pt>
                <c:pt idx="140">
                  <c:v>947.38400000000001</c:v>
                </c:pt>
                <c:pt idx="141">
                  <c:v>954.15099999999995</c:v>
                </c:pt>
                <c:pt idx="142">
                  <c:v>960.91800000000001</c:v>
                </c:pt>
                <c:pt idx="143">
                  <c:v>967.68499999999995</c:v>
                </c:pt>
                <c:pt idx="144">
                  <c:v>974.452</c:v>
                </c:pt>
                <c:pt idx="145">
                  <c:v>981.21900000000005</c:v>
                </c:pt>
                <c:pt idx="146">
                  <c:v>987.98599999999999</c:v>
                </c:pt>
                <c:pt idx="147">
                  <c:v>994.75300000000004</c:v>
                </c:pt>
                <c:pt idx="148">
                  <c:v>1001.52</c:v>
                </c:pt>
                <c:pt idx="149">
                  <c:v>1008.287</c:v>
                </c:pt>
                <c:pt idx="150">
                  <c:v>1015.054</c:v>
                </c:pt>
                <c:pt idx="151">
                  <c:v>1021.821</c:v>
                </c:pt>
                <c:pt idx="152">
                  <c:v>1028.588</c:v>
                </c:pt>
                <c:pt idx="153">
                  <c:v>1035.355</c:v>
                </c:pt>
                <c:pt idx="154">
                  <c:v>1042.1220000000001</c:v>
                </c:pt>
                <c:pt idx="155">
                  <c:v>1048.8889999999999</c:v>
                </c:pt>
                <c:pt idx="156">
                  <c:v>1055.6559999999999</c:v>
                </c:pt>
                <c:pt idx="157">
                  <c:v>1062.423</c:v>
                </c:pt>
                <c:pt idx="158">
                  <c:v>1069.19</c:v>
                </c:pt>
                <c:pt idx="159">
                  <c:v>1075.9570000000001</c:v>
                </c:pt>
                <c:pt idx="160">
                  <c:v>1082.7239999999999</c:v>
                </c:pt>
                <c:pt idx="161">
                  <c:v>1089.491</c:v>
                </c:pt>
                <c:pt idx="162">
                  <c:v>1096.258</c:v>
                </c:pt>
                <c:pt idx="163">
                  <c:v>1103.0250000000001</c:v>
                </c:pt>
                <c:pt idx="164">
                  <c:v>1109.7919999999999</c:v>
                </c:pt>
                <c:pt idx="165">
                  <c:v>1116.559</c:v>
                </c:pt>
                <c:pt idx="166">
                  <c:v>1123.326</c:v>
                </c:pt>
                <c:pt idx="167">
                  <c:v>1130.0930000000001</c:v>
                </c:pt>
                <c:pt idx="168">
                  <c:v>1136.8599999999999</c:v>
                </c:pt>
                <c:pt idx="169">
                  <c:v>1143.627</c:v>
                </c:pt>
                <c:pt idx="170">
                  <c:v>1147.002</c:v>
                </c:pt>
                <c:pt idx="171">
                  <c:v>1150.394</c:v>
                </c:pt>
                <c:pt idx="172">
                  <c:v>1157.162</c:v>
                </c:pt>
                <c:pt idx="173">
                  <c:v>1163.9290000000001</c:v>
                </c:pt>
                <c:pt idx="174">
                  <c:v>1170.6959999999999</c:v>
                </c:pt>
                <c:pt idx="175">
                  <c:v>1177.463</c:v>
                </c:pt>
                <c:pt idx="176">
                  <c:v>1184.23</c:v>
                </c:pt>
                <c:pt idx="177">
                  <c:v>1190.9970000000001</c:v>
                </c:pt>
                <c:pt idx="178">
                  <c:v>1194.221</c:v>
                </c:pt>
                <c:pt idx="179">
                  <c:v>1197.7639999999999</c:v>
                </c:pt>
                <c:pt idx="180">
                  <c:v>1200</c:v>
                </c:pt>
                <c:pt idx="181">
                  <c:v>1204.5309999999999</c:v>
                </c:pt>
                <c:pt idx="182">
                  <c:v>1207.9839999999999</c:v>
                </c:pt>
                <c:pt idx="183">
                  <c:v>1211.298</c:v>
                </c:pt>
                <c:pt idx="184">
                  <c:v>1212.846</c:v>
                </c:pt>
                <c:pt idx="185">
                  <c:v>1214.9090000000001</c:v>
                </c:pt>
                <c:pt idx="186">
                  <c:v>1218.0650000000001</c:v>
                </c:pt>
                <c:pt idx="187">
                  <c:v>1219.7190000000001</c:v>
                </c:pt>
                <c:pt idx="188">
                  <c:v>1222.9480000000001</c:v>
                </c:pt>
                <c:pt idx="189">
                  <c:v>1224.0229999999999</c:v>
                </c:pt>
                <c:pt idx="190">
                  <c:v>1224.8320000000001</c:v>
                </c:pt>
                <c:pt idx="191">
                  <c:v>1227.3150000000001</c:v>
                </c:pt>
                <c:pt idx="192">
                  <c:v>1228.6199999999999</c:v>
                </c:pt>
                <c:pt idx="193">
                  <c:v>1231.2449999999999</c:v>
                </c:pt>
                <c:pt idx="194">
                  <c:v>1231.5989999999999</c:v>
                </c:pt>
                <c:pt idx="195">
                  <c:v>1232.809</c:v>
                </c:pt>
                <c:pt idx="196">
                  <c:v>1235.1279999999999</c:v>
                </c:pt>
                <c:pt idx="197">
                  <c:v>1237.7560000000001</c:v>
                </c:pt>
                <c:pt idx="198">
                  <c:v>1238.366</c:v>
                </c:pt>
                <c:pt idx="199">
                  <c:v>1239.3230000000001</c:v>
                </c:pt>
                <c:pt idx="200">
                  <c:v>1241.0260000000001</c:v>
                </c:pt>
                <c:pt idx="201">
                  <c:v>1241.847</c:v>
                </c:pt>
                <c:pt idx="202">
                  <c:v>1243.548</c:v>
                </c:pt>
                <c:pt idx="203">
                  <c:v>1245.133</c:v>
                </c:pt>
                <c:pt idx="204">
                  <c:v>1245.5129999999999</c:v>
                </c:pt>
                <c:pt idx="205">
                  <c:v>1247.748</c:v>
                </c:pt>
                <c:pt idx="206">
                  <c:v>1248.605</c:v>
                </c:pt>
                <c:pt idx="207">
                  <c:v>1249.982</c:v>
                </c:pt>
                <c:pt idx="208">
                  <c:v>1251.1590000000001</c:v>
                </c:pt>
                <c:pt idx="209">
                  <c:v>1251.9000000000001</c:v>
                </c:pt>
                <c:pt idx="210">
                  <c:v>1252.133</c:v>
                </c:pt>
                <c:pt idx="211">
                  <c:v>1252.69</c:v>
                </c:pt>
                <c:pt idx="212">
                  <c:v>1252.9659999999999</c:v>
                </c:pt>
                <c:pt idx="213">
                  <c:v>1253.8689999999999</c:v>
                </c:pt>
                <c:pt idx="214">
                  <c:v>1255.3389999999999</c:v>
                </c:pt>
                <c:pt idx="215">
                  <c:v>1256.991</c:v>
                </c:pt>
                <c:pt idx="216">
                  <c:v>1258.2629999999999</c:v>
                </c:pt>
                <c:pt idx="217">
                  <c:v>1258.6669999999999</c:v>
                </c:pt>
                <c:pt idx="218">
                  <c:v>1259.643</c:v>
                </c:pt>
                <c:pt idx="219">
                  <c:v>1261.086</c:v>
                </c:pt>
                <c:pt idx="220">
                  <c:v>1261.8</c:v>
                </c:pt>
                <c:pt idx="221">
                  <c:v>1262.9939999999999</c:v>
                </c:pt>
                <c:pt idx="222">
                  <c:v>1263.7070000000001</c:v>
                </c:pt>
                <c:pt idx="223">
                  <c:v>1264.9290000000001</c:v>
                </c:pt>
                <c:pt idx="224">
                  <c:v>1265.434</c:v>
                </c:pt>
                <c:pt idx="225">
                  <c:v>1265.4359999999999</c:v>
                </c:pt>
                <c:pt idx="226">
                  <c:v>1265.857</c:v>
                </c:pt>
                <c:pt idx="227">
                  <c:v>1266.328</c:v>
                </c:pt>
                <c:pt idx="228">
                  <c:v>1267.5530000000001</c:v>
                </c:pt>
                <c:pt idx="229">
                  <c:v>1268.1079999999999</c:v>
                </c:pt>
                <c:pt idx="230">
                  <c:v>1268.5509999999999</c:v>
                </c:pt>
                <c:pt idx="231">
                  <c:v>1269.298</c:v>
                </c:pt>
                <c:pt idx="232">
                  <c:v>1270.2929999999999</c:v>
                </c:pt>
                <c:pt idx="233">
                  <c:v>1270.7070000000001</c:v>
                </c:pt>
                <c:pt idx="234">
                  <c:v>1271.3109999999999</c:v>
                </c:pt>
                <c:pt idx="235">
                  <c:v>1271.961</c:v>
                </c:pt>
                <c:pt idx="236">
                  <c:v>1272.201</c:v>
                </c:pt>
                <c:pt idx="237">
                  <c:v>1272.336</c:v>
                </c:pt>
                <c:pt idx="238">
                  <c:v>1272.68</c:v>
                </c:pt>
                <c:pt idx="239">
                  <c:v>1272.9580000000001</c:v>
                </c:pt>
                <c:pt idx="240">
                  <c:v>1273.626</c:v>
                </c:pt>
                <c:pt idx="241">
                  <c:v>1274.0899999999999</c:v>
                </c:pt>
                <c:pt idx="242">
                  <c:v>1274.2090000000001</c:v>
                </c:pt>
                <c:pt idx="243">
                  <c:v>1275.067</c:v>
                </c:pt>
                <c:pt idx="244">
                  <c:v>1275.625</c:v>
                </c:pt>
                <c:pt idx="245">
                  <c:v>1276.1279999999999</c:v>
                </c:pt>
                <c:pt idx="246">
                  <c:v>1276.636</c:v>
                </c:pt>
                <c:pt idx="247">
                  <c:v>1276.961</c:v>
                </c:pt>
                <c:pt idx="248">
                  <c:v>1277.748</c:v>
                </c:pt>
                <c:pt idx="249">
                  <c:v>1278.1880000000001</c:v>
                </c:pt>
                <c:pt idx="250">
                  <c:v>1278.646</c:v>
                </c:pt>
                <c:pt idx="251">
                  <c:v>1278.9680000000001</c:v>
                </c:pt>
                <c:pt idx="252">
                  <c:v>1278.9690000000001</c:v>
                </c:pt>
                <c:pt idx="253">
                  <c:v>1279.2429999999999</c:v>
                </c:pt>
                <c:pt idx="254">
                  <c:v>1279.7719999999999</c:v>
                </c:pt>
                <c:pt idx="255">
                  <c:v>1280.239</c:v>
                </c:pt>
                <c:pt idx="256">
                  <c:v>1280.731</c:v>
                </c:pt>
                <c:pt idx="257">
                  <c:v>1281.1369999999999</c:v>
                </c:pt>
                <c:pt idx="258">
                  <c:v>1281.605</c:v>
                </c:pt>
                <c:pt idx="259">
                  <c:v>1282.192</c:v>
                </c:pt>
                <c:pt idx="260">
                  <c:v>1282.7190000000001</c:v>
                </c:pt>
                <c:pt idx="261">
                  <c:v>1283.095</c:v>
                </c:pt>
                <c:pt idx="262">
                  <c:v>1283.8050000000001</c:v>
                </c:pt>
                <c:pt idx="263">
                  <c:v>1284.1859999999999</c:v>
                </c:pt>
                <c:pt idx="264">
                  <c:v>1284.46</c:v>
                </c:pt>
                <c:pt idx="265">
                  <c:v>1285.008</c:v>
                </c:pt>
                <c:pt idx="266">
                  <c:v>1285.578</c:v>
                </c:pt>
                <c:pt idx="267">
                  <c:v>1285.7349999999999</c:v>
                </c:pt>
                <c:pt idx="268">
                  <c:v>1285.77</c:v>
                </c:pt>
                <c:pt idx="269">
                  <c:v>1285.982</c:v>
                </c:pt>
                <c:pt idx="270">
                  <c:v>1286.5429999999999</c:v>
                </c:pt>
                <c:pt idx="271">
                  <c:v>1287.5719999999999</c:v>
                </c:pt>
                <c:pt idx="272">
                  <c:v>1288.018</c:v>
                </c:pt>
                <c:pt idx="273">
                  <c:v>1288.499</c:v>
                </c:pt>
                <c:pt idx="274">
                  <c:v>1288.896</c:v>
                </c:pt>
                <c:pt idx="275">
                  <c:v>1289.32</c:v>
                </c:pt>
                <c:pt idx="276">
                  <c:v>1289.4960000000001</c:v>
                </c:pt>
                <c:pt idx="277">
                  <c:v>1289.9970000000001</c:v>
                </c:pt>
                <c:pt idx="278">
                  <c:v>1290.7529999999999</c:v>
                </c:pt>
                <c:pt idx="279">
                  <c:v>1291.4680000000001</c:v>
                </c:pt>
                <c:pt idx="280">
                  <c:v>1291.933</c:v>
                </c:pt>
                <c:pt idx="281">
                  <c:v>1292.171</c:v>
                </c:pt>
                <c:pt idx="282">
                  <c:v>1292.502</c:v>
                </c:pt>
                <c:pt idx="283">
                  <c:v>1292.598</c:v>
                </c:pt>
                <c:pt idx="284">
                  <c:v>1292.8440000000001</c:v>
                </c:pt>
                <c:pt idx="285">
                  <c:v>1293.422</c:v>
                </c:pt>
                <c:pt idx="286">
                  <c:v>1293.607</c:v>
                </c:pt>
                <c:pt idx="287">
                  <c:v>1293.883</c:v>
                </c:pt>
                <c:pt idx="288">
                  <c:v>1294.22</c:v>
                </c:pt>
                <c:pt idx="289">
                  <c:v>1294.6120000000001</c:v>
                </c:pt>
                <c:pt idx="290">
                  <c:v>1295.027</c:v>
                </c:pt>
                <c:pt idx="291">
                  <c:v>1295.2070000000001</c:v>
                </c:pt>
                <c:pt idx="292">
                  <c:v>1295.4359999999999</c:v>
                </c:pt>
                <c:pt idx="293">
                  <c:v>1295.961</c:v>
                </c:pt>
                <c:pt idx="294">
                  <c:v>1296.0889999999999</c:v>
                </c:pt>
                <c:pt idx="295">
                  <c:v>1296.423</c:v>
                </c:pt>
                <c:pt idx="296">
                  <c:v>1296.8320000000001</c:v>
                </c:pt>
                <c:pt idx="297">
                  <c:v>1297.2629999999999</c:v>
                </c:pt>
                <c:pt idx="298">
                  <c:v>1297.683</c:v>
                </c:pt>
                <c:pt idx="299">
                  <c:v>1297.925</c:v>
                </c:pt>
                <c:pt idx="300">
                  <c:v>1298.1400000000001</c:v>
                </c:pt>
                <c:pt idx="301">
                  <c:v>1298.366</c:v>
                </c:pt>
                <c:pt idx="302">
                  <c:v>1298.5730000000001</c:v>
                </c:pt>
                <c:pt idx="303">
                  <c:v>1298.76</c:v>
                </c:pt>
                <c:pt idx="304">
                  <c:v>1298.8530000000001</c:v>
                </c:pt>
                <c:pt idx="305">
                  <c:v>1299.059</c:v>
                </c:pt>
                <c:pt idx="306">
                  <c:v>1299.269</c:v>
                </c:pt>
                <c:pt idx="307">
                  <c:v>1299.328</c:v>
                </c:pt>
                <c:pt idx="308">
                  <c:v>1299.627</c:v>
                </c:pt>
                <c:pt idx="309">
                  <c:v>1299.9939999999999</c:v>
                </c:pt>
                <c:pt idx="310">
                  <c:v>1300.3910000000001</c:v>
                </c:pt>
                <c:pt idx="311">
                  <c:v>1300.8320000000001</c:v>
                </c:pt>
                <c:pt idx="312">
                  <c:v>1301.0250000000001</c:v>
                </c:pt>
                <c:pt idx="313">
                  <c:v>1301.2950000000001</c:v>
                </c:pt>
                <c:pt idx="314">
                  <c:v>1302.221</c:v>
                </c:pt>
                <c:pt idx="315">
                  <c:v>1302.296</c:v>
                </c:pt>
                <c:pt idx="316">
                  <c:v>1302.4939999999999</c:v>
                </c:pt>
                <c:pt idx="317">
                  <c:v>1302.6410000000001</c:v>
                </c:pt>
                <c:pt idx="318">
                  <c:v>1302.9190000000001</c:v>
                </c:pt>
                <c:pt idx="319">
                  <c:v>1303.153</c:v>
                </c:pt>
                <c:pt idx="320">
                  <c:v>1303.5530000000001</c:v>
                </c:pt>
                <c:pt idx="321">
                  <c:v>1303.7550000000001</c:v>
                </c:pt>
                <c:pt idx="322">
                  <c:v>1304.104</c:v>
                </c:pt>
                <c:pt idx="323">
                  <c:v>1304.6079999999999</c:v>
                </c:pt>
                <c:pt idx="324">
                  <c:v>1305.193</c:v>
                </c:pt>
                <c:pt idx="325">
                  <c:v>1305.3800000000001</c:v>
                </c:pt>
                <c:pt idx="326">
                  <c:v>1305.9000000000001</c:v>
                </c:pt>
                <c:pt idx="327">
                  <c:v>1306.0360000000001</c:v>
                </c:pt>
                <c:pt idx="328">
                  <c:v>1306.145</c:v>
                </c:pt>
                <c:pt idx="329">
                  <c:v>1306.5930000000001</c:v>
                </c:pt>
                <c:pt idx="330">
                  <c:v>1306.73</c:v>
                </c:pt>
                <c:pt idx="331">
                  <c:v>1306.789</c:v>
                </c:pt>
                <c:pt idx="332">
                  <c:v>1307.002</c:v>
                </c:pt>
                <c:pt idx="333">
                  <c:v>1307.2929999999999</c:v>
                </c:pt>
                <c:pt idx="334">
                  <c:v>1308.5940000000001</c:v>
                </c:pt>
                <c:pt idx="335">
                  <c:v>1308.9369999999999</c:v>
                </c:pt>
                <c:pt idx="336">
                  <c:v>1309.0150000000001</c:v>
                </c:pt>
                <c:pt idx="337">
                  <c:v>1309.241</c:v>
                </c:pt>
                <c:pt idx="338">
                  <c:v>1309.356</c:v>
                </c:pt>
                <c:pt idx="339">
                  <c:v>1309.826</c:v>
                </c:pt>
                <c:pt idx="340">
                  <c:v>1310.0709999999999</c:v>
                </c:pt>
                <c:pt idx="341">
                  <c:v>1310.5250000000001</c:v>
                </c:pt>
                <c:pt idx="342">
                  <c:v>1310.9169999999999</c:v>
                </c:pt>
                <c:pt idx="343">
                  <c:v>1311.7860000000001</c:v>
                </c:pt>
                <c:pt idx="344">
                  <c:v>1312.105</c:v>
                </c:pt>
                <c:pt idx="345">
                  <c:v>1312.527</c:v>
                </c:pt>
                <c:pt idx="346">
                  <c:v>1312.8030000000001</c:v>
                </c:pt>
                <c:pt idx="347">
                  <c:v>1312.8320000000001</c:v>
                </c:pt>
                <c:pt idx="348">
                  <c:v>1313.4780000000001</c:v>
                </c:pt>
                <c:pt idx="349">
                  <c:v>1313.713</c:v>
                </c:pt>
                <c:pt idx="350">
                  <c:v>1314.182</c:v>
                </c:pt>
                <c:pt idx="351">
                  <c:v>1314.59</c:v>
                </c:pt>
                <c:pt idx="352">
                  <c:v>1314.8150000000001</c:v>
                </c:pt>
                <c:pt idx="353">
                  <c:v>1315.162</c:v>
                </c:pt>
                <c:pt idx="354">
                  <c:v>1315.761</c:v>
                </c:pt>
                <c:pt idx="355">
                  <c:v>1315.903</c:v>
                </c:pt>
                <c:pt idx="356">
                  <c:v>1316.125</c:v>
                </c:pt>
                <c:pt idx="357">
                  <c:v>1316.501</c:v>
                </c:pt>
                <c:pt idx="358">
                  <c:v>1316.8389999999999</c:v>
                </c:pt>
                <c:pt idx="359">
                  <c:v>1317.232</c:v>
                </c:pt>
                <c:pt idx="360">
                  <c:v>1317.809</c:v>
                </c:pt>
                <c:pt idx="361">
                  <c:v>1318.7149999999999</c:v>
                </c:pt>
                <c:pt idx="362">
                  <c:v>1319.5</c:v>
                </c:pt>
                <c:pt idx="363">
                  <c:v>1319.57</c:v>
                </c:pt>
                <c:pt idx="364">
                  <c:v>1319.9369999999999</c:v>
                </c:pt>
                <c:pt idx="365">
                  <c:v>1320.702</c:v>
                </c:pt>
                <c:pt idx="366">
                  <c:v>1321.146</c:v>
                </c:pt>
                <c:pt idx="367">
                  <c:v>1321.329</c:v>
                </c:pt>
                <c:pt idx="368">
                  <c:v>1321.7539999999999</c:v>
                </c:pt>
                <c:pt idx="369">
                  <c:v>1322.085</c:v>
                </c:pt>
                <c:pt idx="370">
                  <c:v>1322.549</c:v>
                </c:pt>
                <c:pt idx="371">
                  <c:v>1323.5129999999999</c:v>
                </c:pt>
                <c:pt idx="372">
                  <c:v>1323.6759999999999</c:v>
                </c:pt>
                <c:pt idx="373">
                  <c:v>1323.8219999999999</c:v>
                </c:pt>
                <c:pt idx="374">
                  <c:v>1324.125</c:v>
                </c:pt>
                <c:pt idx="375">
                  <c:v>1324.8030000000001</c:v>
                </c:pt>
                <c:pt idx="376">
                  <c:v>1325.643</c:v>
                </c:pt>
                <c:pt idx="377">
                  <c:v>1325.9849999999999</c:v>
                </c:pt>
                <c:pt idx="378">
                  <c:v>1326.2850000000001</c:v>
                </c:pt>
                <c:pt idx="379">
                  <c:v>1326.337</c:v>
                </c:pt>
                <c:pt idx="380">
                  <c:v>1326.4190000000001</c:v>
                </c:pt>
                <c:pt idx="381">
                  <c:v>1326.9929999999999</c:v>
                </c:pt>
                <c:pt idx="382">
                  <c:v>1327.5050000000001</c:v>
                </c:pt>
                <c:pt idx="383">
                  <c:v>1328.066</c:v>
                </c:pt>
                <c:pt idx="384">
                  <c:v>1328.578</c:v>
                </c:pt>
                <c:pt idx="385">
                  <c:v>1330.5740000000001</c:v>
                </c:pt>
                <c:pt idx="386">
                  <c:v>1331.69</c:v>
                </c:pt>
                <c:pt idx="387">
                  <c:v>1332.874</c:v>
                </c:pt>
                <c:pt idx="388">
                  <c:v>1333.104</c:v>
                </c:pt>
                <c:pt idx="389">
                  <c:v>1333.83</c:v>
                </c:pt>
                <c:pt idx="390">
                  <c:v>1334.873</c:v>
                </c:pt>
                <c:pt idx="391">
                  <c:v>1335.9269999999999</c:v>
                </c:pt>
                <c:pt idx="392">
                  <c:v>1336.8679999999999</c:v>
                </c:pt>
                <c:pt idx="393">
                  <c:v>1339.787</c:v>
                </c:pt>
                <c:pt idx="394">
                  <c:v>1339.8710000000001</c:v>
                </c:pt>
                <c:pt idx="395">
                  <c:v>1341.136</c:v>
                </c:pt>
                <c:pt idx="396">
                  <c:v>1342.1690000000001</c:v>
                </c:pt>
                <c:pt idx="397">
                  <c:v>1345.0309999999999</c:v>
                </c:pt>
                <c:pt idx="398">
                  <c:v>1346.6379999999999</c:v>
                </c:pt>
                <c:pt idx="399">
                  <c:v>1349.7629999999999</c:v>
                </c:pt>
                <c:pt idx="400">
                  <c:v>1353.405</c:v>
                </c:pt>
                <c:pt idx="401">
                  <c:v>1353.405</c:v>
                </c:pt>
              </c:numCache>
            </c:numRef>
          </c:xVal>
          <c:yVal>
            <c:numRef>
              <c:f>Foglio6!$B$5:$B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100</c:v>
                </c:pt>
                <c:pt idx="168">
                  <c:v>100</c:v>
                </c:pt>
                <c:pt idx="169">
                  <c:v>100</c:v>
                </c:pt>
                <c:pt idx="170">
                  <c:v>100</c:v>
                </c:pt>
                <c:pt idx="171">
                  <c:v>99.992000000000004</c:v>
                </c:pt>
                <c:pt idx="172">
                  <c:v>99.986000000000004</c:v>
                </c:pt>
                <c:pt idx="173">
                  <c:v>99.977000000000004</c:v>
                </c:pt>
                <c:pt idx="174">
                  <c:v>99.947999999999993</c:v>
                </c:pt>
                <c:pt idx="175">
                  <c:v>99.835999999999999</c:v>
                </c:pt>
                <c:pt idx="176">
                  <c:v>99.64</c:v>
                </c:pt>
                <c:pt idx="177">
                  <c:v>99.534000000000006</c:v>
                </c:pt>
                <c:pt idx="178">
                  <c:v>99.5</c:v>
                </c:pt>
                <c:pt idx="179">
                  <c:v>99.126000000000005</c:v>
                </c:pt>
                <c:pt idx="180">
                  <c:v>99</c:v>
                </c:pt>
                <c:pt idx="181">
                  <c:v>98.76</c:v>
                </c:pt>
                <c:pt idx="182">
                  <c:v>98.5</c:v>
                </c:pt>
                <c:pt idx="183">
                  <c:v>98.054000000000002</c:v>
                </c:pt>
                <c:pt idx="184">
                  <c:v>98</c:v>
                </c:pt>
                <c:pt idx="185">
                  <c:v>97.5</c:v>
                </c:pt>
                <c:pt idx="186">
                  <c:v>97.203999999999994</c:v>
                </c:pt>
                <c:pt idx="187">
                  <c:v>97</c:v>
                </c:pt>
                <c:pt idx="188">
                  <c:v>96.5</c:v>
                </c:pt>
                <c:pt idx="189">
                  <c:v>96</c:v>
                </c:pt>
                <c:pt idx="190">
                  <c:v>95.938000000000002</c:v>
                </c:pt>
                <c:pt idx="191">
                  <c:v>95.5</c:v>
                </c:pt>
                <c:pt idx="192">
                  <c:v>95</c:v>
                </c:pt>
                <c:pt idx="193">
                  <c:v>94.5</c:v>
                </c:pt>
                <c:pt idx="194">
                  <c:v>94.370999999999995</c:v>
                </c:pt>
                <c:pt idx="195">
                  <c:v>94</c:v>
                </c:pt>
                <c:pt idx="196">
                  <c:v>93.5</c:v>
                </c:pt>
                <c:pt idx="197">
                  <c:v>93</c:v>
                </c:pt>
                <c:pt idx="198">
                  <c:v>92.864000000000004</c:v>
                </c:pt>
                <c:pt idx="199">
                  <c:v>92.5</c:v>
                </c:pt>
                <c:pt idx="200">
                  <c:v>92</c:v>
                </c:pt>
                <c:pt idx="201">
                  <c:v>91.5</c:v>
                </c:pt>
                <c:pt idx="202">
                  <c:v>91</c:v>
                </c:pt>
                <c:pt idx="203">
                  <c:v>90.576999999999998</c:v>
                </c:pt>
                <c:pt idx="204">
                  <c:v>90.5</c:v>
                </c:pt>
                <c:pt idx="205">
                  <c:v>90</c:v>
                </c:pt>
                <c:pt idx="206">
                  <c:v>89.5</c:v>
                </c:pt>
                <c:pt idx="207">
                  <c:v>89</c:v>
                </c:pt>
                <c:pt idx="208">
                  <c:v>88.5</c:v>
                </c:pt>
                <c:pt idx="209">
                  <c:v>88.256</c:v>
                </c:pt>
                <c:pt idx="210">
                  <c:v>88</c:v>
                </c:pt>
                <c:pt idx="211">
                  <c:v>87.5</c:v>
                </c:pt>
                <c:pt idx="212">
                  <c:v>87</c:v>
                </c:pt>
                <c:pt idx="213">
                  <c:v>86.5</c:v>
                </c:pt>
                <c:pt idx="214">
                  <c:v>86</c:v>
                </c:pt>
                <c:pt idx="215">
                  <c:v>85.5</c:v>
                </c:pt>
                <c:pt idx="216">
                  <c:v>85</c:v>
                </c:pt>
                <c:pt idx="217">
                  <c:v>84.93</c:v>
                </c:pt>
                <c:pt idx="218">
                  <c:v>84.5</c:v>
                </c:pt>
                <c:pt idx="219">
                  <c:v>84</c:v>
                </c:pt>
                <c:pt idx="220">
                  <c:v>83.5</c:v>
                </c:pt>
                <c:pt idx="221">
                  <c:v>83</c:v>
                </c:pt>
                <c:pt idx="222">
                  <c:v>82.5</c:v>
                </c:pt>
                <c:pt idx="223">
                  <c:v>82</c:v>
                </c:pt>
                <c:pt idx="224">
                  <c:v>81.540000000000006</c:v>
                </c:pt>
                <c:pt idx="225">
                  <c:v>81.5</c:v>
                </c:pt>
                <c:pt idx="226">
                  <c:v>81</c:v>
                </c:pt>
                <c:pt idx="227">
                  <c:v>80.5</c:v>
                </c:pt>
                <c:pt idx="228">
                  <c:v>80</c:v>
                </c:pt>
                <c:pt idx="229">
                  <c:v>79.5</c:v>
                </c:pt>
                <c:pt idx="230">
                  <c:v>79</c:v>
                </c:pt>
                <c:pt idx="231">
                  <c:v>78.5</c:v>
                </c:pt>
                <c:pt idx="232">
                  <c:v>78</c:v>
                </c:pt>
                <c:pt idx="233">
                  <c:v>77.5</c:v>
                </c:pt>
                <c:pt idx="234">
                  <c:v>77</c:v>
                </c:pt>
                <c:pt idx="235">
                  <c:v>76.5</c:v>
                </c:pt>
                <c:pt idx="236">
                  <c:v>76.146000000000001</c:v>
                </c:pt>
                <c:pt idx="237">
                  <c:v>76</c:v>
                </c:pt>
                <c:pt idx="238">
                  <c:v>75.5</c:v>
                </c:pt>
                <c:pt idx="239">
                  <c:v>75</c:v>
                </c:pt>
                <c:pt idx="240">
                  <c:v>74.5</c:v>
                </c:pt>
                <c:pt idx="241">
                  <c:v>74</c:v>
                </c:pt>
                <c:pt idx="242">
                  <c:v>73.5</c:v>
                </c:pt>
                <c:pt idx="243">
                  <c:v>73</c:v>
                </c:pt>
                <c:pt idx="244">
                  <c:v>72.5</c:v>
                </c:pt>
                <c:pt idx="245">
                  <c:v>72</c:v>
                </c:pt>
                <c:pt idx="246">
                  <c:v>71.5</c:v>
                </c:pt>
                <c:pt idx="247">
                  <c:v>71</c:v>
                </c:pt>
                <c:pt idx="248">
                  <c:v>70.5</c:v>
                </c:pt>
                <c:pt idx="249">
                  <c:v>70</c:v>
                </c:pt>
                <c:pt idx="250">
                  <c:v>69.5</c:v>
                </c:pt>
                <c:pt idx="251">
                  <c:v>69.001000000000005</c:v>
                </c:pt>
                <c:pt idx="252">
                  <c:v>69</c:v>
                </c:pt>
                <c:pt idx="253">
                  <c:v>68.5</c:v>
                </c:pt>
                <c:pt idx="254">
                  <c:v>68</c:v>
                </c:pt>
                <c:pt idx="255">
                  <c:v>67.5</c:v>
                </c:pt>
                <c:pt idx="256">
                  <c:v>67</c:v>
                </c:pt>
                <c:pt idx="257">
                  <c:v>66.5</c:v>
                </c:pt>
                <c:pt idx="258">
                  <c:v>66</c:v>
                </c:pt>
                <c:pt idx="259">
                  <c:v>65.5</c:v>
                </c:pt>
                <c:pt idx="260">
                  <c:v>65</c:v>
                </c:pt>
                <c:pt idx="261">
                  <c:v>64.5</c:v>
                </c:pt>
                <c:pt idx="262">
                  <c:v>64</c:v>
                </c:pt>
                <c:pt idx="263">
                  <c:v>63.5</c:v>
                </c:pt>
                <c:pt idx="264">
                  <c:v>63</c:v>
                </c:pt>
                <c:pt idx="265">
                  <c:v>62.5</c:v>
                </c:pt>
                <c:pt idx="266">
                  <c:v>62</c:v>
                </c:pt>
                <c:pt idx="267">
                  <c:v>61.703000000000003</c:v>
                </c:pt>
                <c:pt idx="268">
                  <c:v>61.5</c:v>
                </c:pt>
                <c:pt idx="269">
                  <c:v>61</c:v>
                </c:pt>
                <c:pt idx="270">
                  <c:v>60.5</c:v>
                </c:pt>
                <c:pt idx="271">
                  <c:v>60</c:v>
                </c:pt>
                <c:pt idx="272">
                  <c:v>59.5</c:v>
                </c:pt>
                <c:pt idx="273">
                  <c:v>59</c:v>
                </c:pt>
                <c:pt idx="274">
                  <c:v>58.5</c:v>
                </c:pt>
                <c:pt idx="275">
                  <c:v>58</c:v>
                </c:pt>
                <c:pt idx="276">
                  <c:v>57.5</c:v>
                </c:pt>
                <c:pt idx="277">
                  <c:v>57</c:v>
                </c:pt>
                <c:pt idx="278">
                  <c:v>56.5</c:v>
                </c:pt>
                <c:pt idx="279">
                  <c:v>56</c:v>
                </c:pt>
                <c:pt idx="280">
                  <c:v>55.5</c:v>
                </c:pt>
                <c:pt idx="281">
                  <c:v>55</c:v>
                </c:pt>
                <c:pt idx="282">
                  <c:v>54.622</c:v>
                </c:pt>
                <c:pt idx="283">
                  <c:v>54.5</c:v>
                </c:pt>
                <c:pt idx="284">
                  <c:v>54</c:v>
                </c:pt>
                <c:pt idx="285">
                  <c:v>53.5</c:v>
                </c:pt>
                <c:pt idx="286">
                  <c:v>53</c:v>
                </c:pt>
                <c:pt idx="287">
                  <c:v>52.5</c:v>
                </c:pt>
                <c:pt idx="288">
                  <c:v>52</c:v>
                </c:pt>
                <c:pt idx="289">
                  <c:v>51.5</c:v>
                </c:pt>
                <c:pt idx="290">
                  <c:v>51</c:v>
                </c:pt>
                <c:pt idx="291">
                  <c:v>50.5</c:v>
                </c:pt>
                <c:pt idx="292">
                  <c:v>50</c:v>
                </c:pt>
                <c:pt idx="293">
                  <c:v>49.5</c:v>
                </c:pt>
                <c:pt idx="294">
                  <c:v>49</c:v>
                </c:pt>
                <c:pt idx="295">
                  <c:v>48.5</c:v>
                </c:pt>
                <c:pt idx="296">
                  <c:v>48</c:v>
                </c:pt>
                <c:pt idx="297">
                  <c:v>47.5</c:v>
                </c:pt>
                <c:pt idx="298">
                  <c:v>47</c:v>
                </c:pt>
                <c:pt idx="299">
                  <c:v>46.5</c:v>
                </c:pt>
                <c:pt idx="300">
                  <c:v>46</c:v>
                </c:pt>
                <c:pt idx="301">
                  <c:v>45.5</c:v>
                </c:pt>
                <c:pt idx="302">
                  <c:v>45</c:v>
                </c:pt>
                <c:pt idx="303">
                  <c:v>44.5</c:v>
                </c:pt>
                <c:pt idx="304">
                  <c:v>44</c:v>
                </c:pt>
                <c:pt idx="305">
                  <c:v>43.5</c:v>
                </c:pt>
                <c:pt idx="306">
                  <c:v>43.106000000000002</c:v>
                </c:pt>
                <c:pt idx="307">
                  <c:v>43</c:v>
                </c:pt>
                <c:pt idx="308">
                  <c:v>42.5</c:v>
                </c:pt>
                <c:pt idx="309">
                  <c:v>42</c:v>
                </c:pt>
                <c:pt idx="310">
                  <c:v>41.5</c:v>
                </c:pt>
                <c:pt idx="311">
                  <c:v>41</c:v>
                </c:pt>
                <c:pt idx="312">
                  <c:v>40.5</c:v>
                </c:pt>
                <c:pt idx="313">
                  <c:v>40</c:v>
                </c:pt>
                <c:pt idx="314">
                  <c:v>39.5</c:v>
                </c:pt>
                <c:pt idx="315">
                  <c:v>39</c:v>
                </c:pt>
                <c:pt idx="316">
                  <c:v>38.5</c:v>
                </c:pt>
                <c:pt idx="317">
                  <c:v>38</c:v>
                </c:pt>
                <c:pt idx="318">
                  <c:v>37.5</c:v>
                </c:pt>
                <c:pt idx="319">
                  <c:v>37</c:v>
                </c:pt>
                <c:pt idx="320">
                  <c:v>36.5</c:v>
                </c:pt>
                <c:pt idx="321">
                  <c:v>36</c:v>
                </c:pt>
                <c:pt idx="322">
                  <c:v>35.5</c:v>
                </c:pt>
                <c:pt idx="323">
                  <c:v>35</c:v>
                </c:pt>
                <c:pt idx="324">
                  <c:v>34.5</c:v>
                </c:pt>
                <c:pt idx="325">
                  <c:v>34</c:v>
                </c:pt>
                <c:pt idx="326">
                  <c:v>33.5</c:v>
                </c:pt>
                <c:pt idx="327">
                  <c:v>33.316000000000003</c:v>
                </c:pt>
                <c:pt idx="328">
                  <c:v>33</c:v>
                </c:pt>
                <c:pt idx="329">
                  <c:v>32.5</c:v>
                </c:pt>
                <c:pt idx="330">
                  <c:v>32</c:v>
                </c:pt>
                <c:pt idx="331">
                  <c:v>31.5</c:v>
                </c:pt>
                <c:pt idx="332">
                  <c:v>31</c:v>
                </c:pt>
                <c:pt idx="333">
                  <c:v>30.5</c:v>
                </c:pt>
                <c:pt idx="334">
                  <c:v>30</c:v>
                </c:pt>
                <c:pt idx="335">
                  <c:v>29.5</c:v>
                </c:pt>
                <c:pt idx="336">
                  <c:v>29</c:v>
                </c:pt>
                <c:pt idx="337">
                  <c:v>28.5</c:v>
                </c:pt>
                <c:pt idx="338">
                  <c:v>28</c:v>
                </c:pt>
                <c:pt idx="339">
                  <c:v>27.5</c:v>
                </c:pt>
                <c:pt idx="340">
                  <c:v>27</c:v>
                </c:pt>
                <c:pt idx="341">
                  <c:v>26.5</c:v>
                </c:pt>
                <c:pt idx="342">
                  <c:v>26</c:v>
                </c:pt>
                <c:pt idx="343">
                  <c:v>25.5</c:v>
                </c:pt>
                <c:pt idx="344">
                  <c:v>25</c:v>
                </c:pt>
                <c:pt idx="345">
                  <c:v>24.5</c:v>
                </c:pt>
                <c:pt idx="346">
                  <c:v>24.116</c:v>
                </c:pt>
                <c:pt idx="347">
                  <c:v>24</c:v>
                </c:pt>
                <c:pt idx="348">
                  <c:v>23.5</c:v>
                </c:pt>
                <c:pt idx="349">
                  <c:v>23</c:v>
                </c:pt>
                <c:pt idx="350">
                  <c:v>22.5</c:v>
                </c:pt>
                <c:pt idx="351">
                  <c:v>22</c:v>
                </c:pt>
                <c:pt idx="352">
                  <c:v>21.5</c:v>
                </c:pt>
                <c:pt idx="353">
                  <c:v>21</c:v>
                </c:pt>
                <c:pt idx="354">
                  <c:v>20.5</c:v>
                </c:pt>
                <c:pt idx="355">
                  <c:v>20</c:v>
                </c:pt>
                <c:pt idx="356">
                  <c:v>19.5</c:v>
                </c:pt>
                <c:pt idx="357">
                  <c:v>19</c:v>
                </c:pt>
                <c:pt idx="358">
                  <c:v>18.5</c:v>
                </c:pt>
                <c:pt idx="359">
                  <c:v>18</c:v>
                </c:pt>
                <c:pt idx="360">
                  <c:v>17.5</c:v>
                </c:pt>
                <c:pt idx="361">
                  <c:v>17</c:v>
                </c:pt>
                <c:pt idx="362">
                  <c:v>16.5</c:v>
                </c:pt>
                <c:pt idx="363">
                  <c:v>16.475000000000001</c:v>
                </c:pt>
                <c:pt idx="364">
                  <c:v>16</c:v>
                </c:pt>
                <c:pt idx="365">
                  <c:v>15.5</c:v>
                </c:pt>
                <c:pt idx="366">
                  <c:v>15</c:v>
                </c:pt>
                <c:pt idx="367">
                  <c:v>14.5</c:v>
                </c:pt>
                <c:pt idx="368">
                  <c:v>14</c:v>
                </c:pt>
                <c:pt idx="369">
                  <c:v>13.5</c:v>
                </c:pt>
                <c:pt idx="370">
                  <c:v>13</c:v>
                </c:pt>
                <c:pt idx="371">
                  <c:v>12.5</c:v>
                </c:pt>
                <c:pt idx="372">
                  <c:v>12</c:v>
                </c:pt>
                <c:pt idx="373">
                  <c:v>11.5</c:v>
                </c:pt>
                <c:pt idx="374">
                  <c:v>11</c:v>
                </c:pt>
                <c:pt idx="375">
                  <c:v>10.5</c:v>
                </c:pt>
                <c:pt idx="376">
                  <c:v>10</c:v>
                </c:pt>
                <c:pt idx="377">
                  <c:v>9.5</c:v>
                </c:pt>
                <c:pt idx="378">
                  <c:v>9</c:v>
                </c:pt>
                <c:pt idx="379">
                  <c:v>8.718</c:v>
                </c:pt>
                <c:pt idx="380">
                  <c:v>8.5</c:v>
                </c:pt>
                <c:pt idx="381">
                  <c:v>8</c:v>
                </c:pt>
                <c:pt idx="382">
                  <c:v>7.5</c:v>
                </c:pt>
                <c:pt idx="383">
                  <c:v>7</c:v>
                </c:pt>
                <c:pt idx="384">
                  <c:v>6.5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806</c:v>
                </c:pt>
                <c:pt idx="389">
                  <c:v>4.5</c:v>
                </c:pt>
                <c:pt idx="390">
                  <c:v>4</c:v>
                </c:pt>
                <c:pt idx="391">
                  <c:v>3.5</c:v>
                </c:pt>
                <c:pt idx="392">
                  <c:v>3</c:v>
                </c:pt>
                <c:pt idx="393">
                  <c:v>2.5</c:v>
                </c:pt>
                <c:pt idx="394">
                  <c:v>2.484</c:v>
                </c:pt>
                <c:pt idx="395">
                  <c:v>2</c:v>
                </c:pt>
                <c:pt idx="396">
                  <c:v>1.5</c:v>
                </c:pt>
                <c:pt idx="397">
                  <c:v>1</c:v>
                </c:pt>
                <c:pt idx="398">
                  <c:v>0.76400000000000001</c:v>
                </c:pt>
                <c:pt idx="399">
                  <c:v>0.5</c:v>
                </c:pt>
                <c:pt idx="400">
                  <c:v>7.1999999999999995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A88-4DA4-99B1-07BA75EC6953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xVal>
            <c:numRef>
              <c:f>Foglio6!$C$5:$C$406</c:f>
              <c:numCache>
                <c:formatCode>General</c:formatCode>
                <c:ptCount val="402"/>
                <c:pt idx="0">
                  <c:v>0</c:v>
                </c:pt>
                <c:pt idx="1">
                  <c:v>7.1509999999999998</c:v>
                </c:pt>
                <c:pt idx="2">
                  <c:v>14.303000000000001</c:v>
                </c:pt>
                <c:pt idx="3">
                  <c:v>21.454000000000001</c:v>
                </c:pt>
                <c:pt idx="4">
                  <c:v>28.605</c:v>
                </c:pt>
                <c:pt idx="5">
                  <c:v>35.756</c:v>
                </c:pt>
                <c:pt idx="6">
                  <c:v>42.908000000000001</c:v>
                </c:pt>
                <c:pt idx="7">
                  <c:v>50.058999999999997</c:v>
                </c:pt>
                <c:pt idx="8">
                  <c:v>57.21</c:v>
                </c:pt>
                <c:pt idx="9">
                  <c:v>64.361000000000004</c:v>
                </c:pt>
                <c:pt idx="10">
                  <c:v>71.513000000000005</c:v>
                </c:pt>
                <c:pt idx="11">
                  <c:v>78.664000000000001</c:v>
                </c:pt>
                <c:pt idx="12">
                  <c:v>85.814999999999998</c:v>
                </c:pt>
                <c:pt idx="13">
                  <c:v>92.965999999999994</c:v>
                </c:pt>
                <c:pt idx="14">
                  <c:v>100.11799999999999</c:v>
                </c:pt>
                <c:pt idx="15">
                  <c:v>107.26900000000001</c:v>
                </c:pt>
                <c:pt idx="16">
                  <c:v>114.42</c:v>
                </c:pt>
                <c:pt idx="17">
                  <c:v>121.571</c:v>
                </c:pt>
                <c:pt idx="18">
                  <c:v>128.72300000000001</c:v>
                </c:pt>
                <c:pt idx="19">
                  <c:v>135.874</c:v>
                </c:pt>
                <c:pt idx="20">
                  <c:v>143.02500000000001</c:v>
                </c:pt>
                <c:pt idx="21">
                  <c:v>150.17599999999999</c:v>
                </c:pt>
                <c:pt idx="22">
                  <c:v>157.328</c:v>
                </c:pt>
                <c:pt idx="23">
                  <c:v>164.47900000000001</c:v>
                </c:pt>
                <c:pt idx="24">
                  <c:v>171.63</c:v>
                </c:pt>
                <c:pt idx="25">
                  <c:v>178.78100000000001</c:v>
                </c:pt>
                <c:pt idx="26">
                  <c:v>185.93299999999999</c:v>
                </c:pt>
                <c:pt idx="27">
                  <c:v>193.084</c:v>
                </c:pt>
                <c:pt idx="28">
                  <c:v>200.23500000000001</c:v>
                </c:pt>
                <c:pt idx="29">
                  <c:v>207.386</c:v>
                </c:pt>
                <c:pt idx="30">
                  <c:v>214.53800000000001</c:v>
                </c:pt>
                <c:pt idx="31">
                  <c:v>221.68899999999999</c:v>
                </c:pt>
                <c:pt idx="32">
                  <c:v>228.84</c:v>
                </c:pt>
                <c:pt idx="33">
                  <c:v>235.99100000000001</c:v>
                </c:pt>
                <c:pt idx="34">
                  <c:v>243.143</c:v>
                </c:pt>
                <c:pt idx="35">
                  <c:v>250.29400000000001</c:v>
                </c:pt>
                <c:pt idx="36">
                  <c:v>257.44499999999999</c:v>
                </c:pt>
                <c:pt idx="37">
                  <c:v>264.59699999999998</c:v>
                </c:pt>
                <c:pt idx="38">
                  <c:v>271.74799999999999</c:v>
                </c:pt>
                <c:pt idx="39">
                  <c:v>278.899</c:v>
                </c:pt>
                <c:pt idx="40">
                  <c:v>286.05</c:v>
                </c:pt>
                <c:pt idx="41">
                  <c:v>293.202</c:v>
                </c:pt>
                <c:pt idx="42">
                  <c:v>300.35300000000001</c:v>
                </c:pt>
                <c:pt idx="43">
                  <c:v>307.50400000000002</c:v>
                </c:pt>
                <c:pt idx="44">
                  <c:v>314.65499999999997</c:v>
                </c:pt>
                <c:pt idx="45">
                  <c:v>321.80700000000002</c:v>
                </c:pt>
                <c:pt idx="46">
                  <c:v>328.95800000000003</c:v>
                </c:pt>
                <c:pt idx="47">
                  <c:v>336.10899999999998</c:v>
                </c:pt>
                <c:pt idx="48">
                  <c:v>343.26</c:v>
                </c:pt>
                <c:pt idx="49">
                  <c:v>350.41199999999998</c:v>
                </c:pt>
                <c:pt idx="50">
                  <c:v>357.56299999999999</c:v>
                </c:pt>
                <c:pt idx="51">
                  <c:v>364.714</c:v>
                </c:pt>
                <c:pt idx="52">
                  <c:v>371.86500000000001</c:v>
                </c:pt>
                <c:pt idx="53">
                  <c:v>379.017</c:v>
                </c:pt>
                <c:pt idx="54">
                  <c:v>386.16800000000001</c:v>
                </c:pt>
                <c:pt idx="55">
                  <c:v>393.31900000000002</c:v>
                </c:pt>
                <c:pt idx="56">
                  <c:v>400.47</c:v>
                </c:pt>
                <c:pt idx="57">
                  <c:v>407.62200000000001</c:v>
                </c:pt>
                <c:pt idx="58">
                  <c:v>414.77300000000002</c:v>
                </c:pt>
                <c:pt idx="59">
                  <c:v>421.92399999999998</c:v>
                </c:pt>
                <c:pt idx="60">
                  <c:v>429.07499999999999</c:v>
                </c:pt>
                <c:pt idx="61">
                  <c:v>436.22699999999998</c:v>
                </c:pt>
                <c:pt idx="62">
                  <c:v>443.37799999999999</c:v>
                </c:pt>
                <c:pt idx="63">
                  <c:v>450.529</c:v>
                </c:pt>
                <c:pt idx="64">
                  <c:v>457.68</c:v>
                </c:pt>
                <c:pt idx="65">
                  <c:v>464.83199999999999</c:v>
                </c:pt>
                <c:pt idx="66">
                  <c:v>471.983</c:v>
                </c:pt>
                <c:pt idx="67">
                  <c:v>479.13400000000001</c:v>
                </c:pt>
                <c:pt idx="68">
                  <c:v>486.28500000000003</c:v>
                </c:pt>
                <c:pt idx="69">
                  <c:v>493.43700000000001</c:v>
                </c:pt>
                <c:pt idx="70">
                  <c:v>500.58800000000002</c:v>
                </c:pt>
                <c:pt idx="71">
                  <c:v>507.73899999999998</c:v>
                </c:pt>
                <c:pt idx="72">
                  <c:v>514.89099999999996</c:v>
                </c:pt>
                <c:pt idx="73">
                  <c:v>522.04200000000003</c:v>
                </c:pt>
                <c:pt idx="74">
                  <c:v>529.19299999999998</c:v>
                </c:pt>
                <c:pt idx="75">
                  <c:v>536.34400000000005</c:v>
                </c:pt>
                <c:pt idx="76">
                  <c:v>543.49599999999998</c:v>
                </c:pt>
                <c:pt idx="77">
                  <c:v>550.64700000000005</c:v>
                </c:pt>
                <c:pt idx="78">
                  <c:v>557.798</c:v>
                </c:pt>
                <c:pt idx="79">
                  <c:v>564.94899999999996</c:v>
                </c:pt>
                <c:pt idx="80">
                  <c:v>572.101</c:v>
                </c:pt>
                <c:pt idx="81">
                  <c:v>579.25199999999995</c:v>
                </c:pt>
                <c:pt idx="82">
                  <c:v>586.40300000000002</c:v>
                </c:pt>
                <c:pt idx="83">
                  <c:v>593.55399999999997</c:v>
                </c:pt>
                <c:pt idx="84">
                  <c:v>600.70600000000002</c:v>
                </c:pt>
                <c:pt idx="85">
                  <c:v>607.85699999999997</c:v>
                </c:pt>
                <c:pt idx="86">
                  <c:v>615.00800000000004</c:v>
                </c:pt>
                <c:pt idx="87">
                  <c:v>622.15899999999999</c:v>
                </c:pt>
                <c:pt idx="88">
                  <c:v>629.31100000000004</c:v>
                </c:pt>
                <c:pt idx="89">
                  <c:v>636.46199999999999</c:v>
                </c:pt>
                <c:pt idx="90">
                  <c:v>643.61300000000006</c:v>
                </c:pt>
                <c:pt idx="91">
                  <c:v>650.76400000000001</c:v>
                </c:pt>
                <c:pt idx="92">
                  <c:v>657.91600000000005</c:v>
                </c:pt>
                <c:pt idx="93">
                  <c:v>665.06700000000001</c:v>
                </c:pt>
                <c:pt idx="94">
                  <c:v>672.21799999999996</c:v>
                </c:pt>
                <c:pt idx="95">
                  <c:v>679.36900000000003</c:v>
                </c:pt>
                <c:pt idx="96">
                  <c:v>686.52099999999996</c:v>
                </c:pt>
                <c:pt idx="97">
                  <c:v>693.67200000000003</c:v>
                </c:pt>
                <c:pt idx="98">
                  <c:v>700.82299999999998</c:v>
                </c:pt>
                <c:pt idx="99">
                  <c:v>707.97400000000005</c:v>
                </c:pt>
                <c:pt idx="100">
                  <c:v>715.12599999999998</c:v>
                </c:pt>
                <c:pt idx="101">
                  <c:v>722.27700000000004</c:v>
                </c:pt>
                <c:pt idx="102">
                  <c:v>729.428</c:v>
                </c:pt>
                <c:pt idx="103">
                  <c:v>736.58</c:v>
                </c:pt>
                <c:pt idx="104">
                  <c:v>743.73099999999999</c:v>
                </c:pt>
                <c:pt idx="105">
                  <c:v>750.88199999999995</c:v>
                </c:pt>
                <c:pt idx="106">
                  <c:v>758.03300000000002</c:v>
                </c:pt>
                <c:pt idx="107">
                  <c:v>765.18499999999995</c:v>
                </c:pt>
                <c:pt idx="108">
                  <c:v>772.33600000000001</c:v>
                </c:pt>
                <c:pt idx="109">
                  <c:v>779.48699999999997</c:v>
                </c:pt>
                <c:pt idx="110">
                  <c:v>786.63800000000003</c:v>
                </c:pt>
                <c:pt idx="111">
                  <c:v>793.79</c:v>
                </c:pt>
                <c:pt idx="112">
                  <c:v>800.94100000000003</c:v>
                </c:pt>
                <c:pt idx="113">
                  <c:v>808.09199999999998</c:v>
                </c:pt>
                <c:pt idx="114">
                  <c:v>815.24300000000005</c:v>
                </c:pt>
                <c:pt idx="115">
                  <c:v>822.39499999999998</c:v>
                </c:pt>
                <c:pt idx="116">
                  <c:v>829.54600000000005</c:v>
                </c:pt>
                <c:pt idx="117">
                  <c:v>836.697</c:v>
                </c:pt>
                <c:pt idx="118">
                  <c:v>843.84799999999996</c:v>
                </c:pt>
                <c:pt idx="119">
                  <c:v>851</c:v>
                </c:pt>
                <c:pt idx="120">
                  <c:v>858.15099999999995</c:v>
                </c:pt>
                <c:pt idx="121">
                  <c:v>865.30200000000002</c:v>
                </c:pt>
                <c:pt idx="122">
                  <c:v>872.45299999999997</c:v>
                </c:pt>
                <c:pt idx="123">
                  <c:v>879.60500000000002</c:v>
                </c:pt>
                <c:pt idx="124">
                  <c:v>886.75599999999997</c:v>
                </c:pt>
                <c:pt idx="125">
                  <c:v>893.90700000000004</c:v>
                </c:pt>
                <c:pt idx="126">
                  <c:v>901.05799999999999</c:v>
                </c:pt>
                <c:pt idx="127">
                  <c:v>908.21</c:v>
                </c:pt>
                <c:pt idx="128">
                  <c:v>915.36099999999999</c:v>
                </c:pt>
                <c:pt idx="129">
                  <c:v>922.51199999999994</c:v>
                </c:pt>
                <c:pt idx="130">
                  <c:v>929.66300000000001</c:v>
                </c:pt>
                <c:pt idx="131">
                  <c:v>936.81500000000005</c:v>
                </c:pt>
                <c:pt idx="132">
                  <c:v>943.96600000000001</c:v>
                </c:pt>
                <c:pt idx="133">
                  <c:v>951.11699999999996</c:v>
                </c:pt>
                <c:pt idx="134">
                  <c:v>958.26800000000003</c:v>
                </c:pt>
                <c:pt idx="135">
                  <c:v>965.42</c:v>
                </c:pt>
                <c:pt idx="136">
                  <c:v>972.57100000000003</c:v>
                </c:pt>
                <c:pt idx="137">
                  <c:v>979.72199999999998</c:v>
                </c:pt>
                <c:pt idx="138">
                  <c:v>986.87400000000002</c:v>
                </c:pt>
                <c:pt idx="139">
                  <c:v>994.02499999999998</c:v>
                </c:pt>
                <c:pt idx="140">
                  <c:v>1001.176</c:v>
                </c:pt>
                <c:pt idx="141">
                  <c:v>1008.327</c:v>
                </c:pt>
                <c:pt idx="142">
                  <c:v>1015.479</c:v>
                </c:pt>
                <c:pt idx="143">
                  <c:v>1022.63</c:v>
                </c:pt>
                <c:pt idx="144">
                  <c:v>1029.7809999999999</c:v>
                </c:pt>
                <c:pt idx="145">
                  <c:v>1036.932</c:v>
                </c:pt>
                <c:pt idx="146">
                  <c:v>1044.0840000000001</c:v>
                </c:pt>
                <c:pt idx="147">
                  <c:v>1051.2349999999999</c:v>
                </c:pt>
                <c:pt idx="148">
                  <c:v>1058.386</c:v>
                </c:pt>
                <c:pt idx="149">
                  <c:v>1065.537</c:v>
                </c:pt>
                <c:pt idx="150">
                  <c:v>1072.6890000000001</c:v>
                </c:pt>
                <c:pt idx="151">
                  <c:v>1079.8399999999999</c:v>
                </c:pt>
                <c:pt idx="152">
                  <c:v>1086.991</c:v>
                </c:pt>
                <c:pt idx="153">
                  <c:v>1094.1420000000001</c:v>
                </c:pt>
                <c:pt idx="154">
                  <c:v>1101.2940000000001</c:v>
                </c:pt>
                <c:pt idx="155">
                  <c:v>1108.4449999999999</c:v>
                </c:pt>
                <c:pt idx="156">
                  <c:v>1115.596</c:v>
                </c:pt>
                <c:pt idx="157">
                  <c:v>1122.7470000000001</c:v>
                </c:pt>
                <c:pt idx="158">
                  <c:v>1129.8989999999999</c:v>
                </c:pt>
                <c:pt idx="159">
                  <c:v>1137.05</c:v>
                </c:pt>
                <c:pt idx="160">
                  <c:v>1143.498</c:v>
                </c:pt>
                <c:pt idx="161">
                  <c:v>1144.201</c:v>
                </c:pt>
                <c:pt idx="162">
                  <c:v>1151.3520000000001</c:v>
                </c:pt>
                <c:pt idx="163">
                  <c:v>1158.5039999999999</c:v>
                </c:pt>
                <c:pt idx="164">
                  <c:v>1165.655</c:v>
                </c:pt>
                <c:pt idx="165">
                  <c:v>1172.806</c:v>
                </c:pt>
                <c:pt idx="166">
                  <c:v>1179.9570000000001</c:v>
                </c:pt>
                <c:pt idx="167">
                  <c:v>1187.1089999999999</c:v>
                </c:pt>
                <c:pt idx="168">
                  <c:v>1187.3420000000001</c:v>
                </c:pt>
                <c:pt idx="169">
                  <c:v>1194.26</c:v>
                </c:pt>
                <c:pt idx="170">
                  <c:v>1200</c:v>
                </c:pt>
                <c:pt idx="171">
                  <c:v>1201.4110000000001</c:v>
                </c:pt>
                <c:pt idx="172">
                  <c:v>1207.94</c:v>
                </c:pt>
                <c:pt idx="173">
                  <c:v>1208.5619999999999</c:v>
                </c:pt>
                <c:pt idx="174">
                  <c:v>1215.7139999999999</c:v>
                </c:pt>
                <c:pt idx="175">
                  <c:v>1219.77</c:v>
                </c:pt>
                <c:pt idx="176">
                  <c:v>1222.865</c:v>
                </c:pt>
                <c:pt idx="177">
                  <c:v>1224.675</c:v>
                </c:pt>
                <c:pt idx="178">
                  <c:v>1226.1859999999999</c:v>
                </c:pt>
                <c:pt idx="179">
                  <c:v>1230.0160000000001</c:v>
                </c:pt>
                <c:pt idx="180">
                  <c:v>1233.029</c:v>
                </c:pt>
                <c:pt idx="181">
                  <c:v>1235.154</c:v>
                </c:pt>
                <c:pt idx="182">
                  <c:v>1237.1679999999999</c:v>
                </c:pt>
                <c:pt idx="183">
                  <c:v>1244.319</c:v>
                </c:pt>
                <c:pt idx="184">
                  <c:v>1244.3779999999999</c:v>
                </c:pt>
                <c:pt idx="185">
                  <c:v>1249.3889999999999</c:v>
                </c:pt>
                <c:pt idx="186">
                  <c:v>1251.33</c:v>
                </c:pt>
                <c:pt idx="187">
                  <c:v>1251.47</c:v>
                </c:pt>
                <c:pt idx="188">
                  <c:v>1254.2829999999999</c:v>
                </c:pt>
                <c:pt idx="189">
                  <c:v>1256.183</c:v>
                </c:pt>
                <c:pt idx="190">
                  <c:v>1257.865</c:v>
                </c:pt>
                <c:pt idx="191">
                  <c:v>1258.6210000000001</c:v>
                </c:pt>
                <c:pt idx="192">
                  <c:v>1261.04</c:v>
                </c:pt>
                <c:pt idx="193">
                  <c:v>1263.8699999999999</c:v>
                </c:pt>
                <c:pt idx="194">
                  <c:v>1265.7729999999999</c:v>
                </c:pt>
                <c:pt idx="195">
                  <c:v>1265.932</c:v>
                </c:pt>
                <c:pt idx="196">
                  <c:v>1268.623</c:v>
                </c:pt>
                <c:pt idx="197">
                  <c:v>1270.6310000000001</c:v>
                </c:pt>
                <c:pt idx="198">
                  <c:v>1272.2650000000001</c:v>
                </c:pt>
                <c:pt idx="199">
                  <c:v>1272.924</c:v>
                </c:pt>
                <c:pt idx="200">
                  <c:v>1274.191</c:v>
                </c:pt>
                <c:pt idx="201">
                  <c:v>1277.711</c:v>
                </c:pt>
                <c:pt idx="202">
                  <c:v>1280.075</c:v>
                </c:pt>
                <c:pt idx="203">
                  <c:v>1280.3779999999999</c:v>
                </c:pt>
                <c:pt idx="204">
                  <c:v>1282.146</c:v>
                </c:pt>
                <c:pt idx="205">
                  <c:v>1283.1569999999999</c:v>
                </c:pt>
                <c:pt idx="206">
                  <c:v>1285.539</c:v>
                </c:pt>
                <c:pt idx="207">
                  <c:v>1286.98</c:v>
                </c:pt>
                <c:pt idx="208">
                  <c:v>1287.2260000000001</c:v>
                </c:pt>
                <c:pt idx="209">
                  <c:v>1288.8779999999999</c:v>
                </c:pt>
                <c:pt idx="210">
                  <c:v>1289.8409999999999</c:v>
                </c:pt>
                <c:pt idx="211">
                  <c:v>1292.7270000000001</c:v>
                </c:pt>
                <c:pt idx="212">
                  <c:v>1294.3779999999999</c:v>
                </c:pt>
                <c:pt idx="213">
                  <c:v>1294.8520000000001</c:v>
                </c:pt>
                <c:pt idx="214">
                  <c:v>1296.1199999999999</c:v>
                </c:pt>
                <c:pt idx="215">
                  <c:v>1297.277</c:v>
                </c:pt>
                <c:pt idx="216">
                  <c:v>1297.585</c:v>
                </c:pt>
                <c:pt idx="217">
                  <c:v>1298.4079999999999</c:v>
                </c:pt>
                <c:pt idx="218">
                  <c:v>1299.479</c:v>
                </c:pt>
                <c:pt idx="219">
                  <c:v>1300.6220000000001</c:v>
                </c:pt>
                <c:pt idx="220">
                  <c:v>1301.529</c:v>
                </c:pt>
                <c:pt idx="221">
                  <c:v>1301.5440000000001</c:v>
                </c:pt>
                <c:pt idx="222">
                  <c:v>1302.366</c:v>
                </c:pt>
                <c:pt idx="223">
                  <c:v>1303.701</c:v>
                </c:pt>
                <c:pt idx="224">
                  <c:v>1305.9459999999999</c:v>
                </c:pt>
                <c:pt idx="225">
                  <c:v>1307.8620000000001</c:v>
                </c:pt>
                <c:pt idx="226">
                  <c:v>1308.68</c:v>
                </c:pt>
                <c:pt idx="227">
                  <c:v>1309.424</c:v>
                </c:pt>
                <c:pt idx="228">
                  <c:v>1310.885</c:v>
                </c:pt>
                <c:pt idx="229">
                  <c:v>1311.7560000000001</c:v>
                </c:pt>
                <c:pt idx="230">
                  <c:v>1312.8009999999999</c:v>
                </c:pt>
                <c:pt idx="231">
                  <c:v>1314.318</c:v>
                </c:pt>
                <c:pt idx="232">
                  <c:v>1315.5170000000001</c:v>
                </c:pt>
                <c:pt idx="233">
                  <c:v>1315.8309999999999</c:v>
                </c:pt>
                <c:pt idx="234">
                  <c:v>1316.0820000000001</c:v>
                </c:pt>
                <c:pt idx="235">
                  <c:v>1316.519</c:v>
                </c:pt>
                <c:pt idx="236">
                  <c:v>1317.4290000000001</c:v>
                </c:pt>
                <c:pt idx="237">
                  <c:v>1318.087</c:v>
                </c:pt>
                <c:pt idx="238">
                  <c:v>1318.9570000000001</c:v>
                </c:pt>
                <c:pt idx="239">
                  <c:v>1319.5940000000001</c:v>
                </c:pt>
                <c:pt idx="240">
                  <c:v>1321.645</c:v>
                </c:pt>
                <c:pt idx="241">
                  <c:v>1322.1010000000001</c:v>
                </c:pt>
                <c:pt idx="242">
                  <c:v>1322.75</c:v>
                </c:pt>
                <c:pt idx="243">
                  <c:v>1322.9829999999999</c:v>
                </c:pt>
                <c:pt idx="244">
                  <c:v>1323.2850000000001</c:v>
                </c:pt>
                <c:pt idx="245">
                  <c:v>1323.675</c:v>
                </c:pt>
                <c:pt idx="246">
                  <c:v>1325.1790000000001</c:v>
                </c:pt>
                <c:pt idx="247">
                  <c:v>1326.3240000000001</c:v>
                </c:pt>
                <c:pt idx="248">
                  <c:v>1326.806</c:v>
                </c:pt>
                <c:pt idx="249">
                  <c:v>1327.2919999999999</c:v>
                </c:pt>
                <c:pt idx="250">
                  <c:v>1327.7270000000001</c:v>
                </c:pt>
                <c:pt idx="251">
                  <c:v>1328.123</c:v>
                </c:pt>
                <c:pt idx="252">
                  <c:v>1328.9090000000001</c:v>
                </c:pt>
                <c:pt idx="253">
                  <c:v>1329.671</c:v>
                </c:pt>
                <c:pt idx="254">
                  <c:v>1330.134</c:v>
                </c:pt>
                <c:pt idx="255">
                  <c:v>1330.4459999999999</c:v>
                </c:pt>
                <c:pt idx="256">
                  <c:v>1331.037</c:v>
                </c:pt>
                <c:pt idx="257">
                  <c:v>1331.5039999999999</c:v>
                </c:pt>
                <c:pt idx="258">
                  <c:v>1331.998</c:v>
                </c:pt>
                <c:pt idx="259">
                  <c:v>1333.271</c:v>
                </c:pt>
                <c:pt idx="260">
                  <c:v>1334.0540000000001</c:v>
                </c:pt>
                <c:pt idx="261">
                  <c:v>1334.75</c:v>
                </c:pt>
                <c:pt idx="262">
                  <c:v>1334.963</c:v>
                </c:pt>
                <c:pt idx="263">
                  <c:v>1335.768</c:v>
                </c:pt>
                <c:pt idx="264">
                  <c:v>1336.386</c:v>
                </c:pt>
                <c:pt idx="265">
                  <c:v>1336.981</c:v>
                </c:pt>
                <c:pt idx="266">
                  <c:v>1337.2850000000001</c:v>
                </c:pt>
                <c:pt idx="267">
                  <c:v>1337.51</c:v>
                </c:pt>
                <c:pt idx="268">
                  <c:v>1338.201</c:v>
                </c:pt>
                <c:pt idx="269">
                  <c:v>1339.2349999999999</c:v>
                </c:pt>
                <c:pt idx="270">
                  <c:v>1339.8630000000001</c:v>
                </c:pt>
                <c:pt idx="271">
                  <c:v>1340.048</c:v>
                </c:pt>
                <c:pt idx="272">
                  <c:v>1340.731</c:v>
                </c:pt>
                <c:pt idx="273">
                  <c:v>1341.0889999999999</c:v>
                </c:pt>
                <c:pt idx="274">
                  <c:v>1341.48</c:v>
                </c:pt>
                <c:pt idx="275">
                  <c:v>1341.9190000000001</c:v>
                </c:pt>
                <c:pt idx="276">
                  <c:v>1342.548</c:v>
                </c:pt>
                <c:pt idx="277">
                  <c:v>1343.0319999999999</c:v>
                </c:pt>
                <c:pt idx="278">
                  <c:v>1343.5039999999999</c:v>
                </c:pt>
                <c:pt idx="279">
                  <c:v>1343.9649999999999</c:v>
                </c:pt>
                <c:pt idx="280">
                  <c:v>1344.402</c:v>
                </c:pt>
                <c:pt idx="281">
                  <c:v>1344.4359999999999</c:v>
                </c:pt>
                <c:pt idx="282">
                  <c:v>1344.874</c:v>
                </c:pt>
                <c:pt idx="283">
                  <c:v>1345.654</c:v>
                </c:pt>
                <c:pt idx="284">
                  <c:v>1346.404</c:v>
                </c:pt>
                <c:pt idx="285">
                  <c:v>1347.326</c:v>
                </c:pt>
                <c:pt idx="286">
                  <c:v>1347.9549999999999</c:v>
                </c:pt>
                <c:pt idx="287">
                  <c:v>1348.1510000000001</c:v>
                </c:pt>
                <c:pt idx="288">
                  <c:v>1348.6220000000001</c:v>
                </c:pt>
                <c:pt idx="289">
                  <c:v>1349.124</c:v>
                </c:pt>
                <c:pt idx="290">
                  <c:v>1349.8720000000001</c:v>
                </c:pt>
                <c:pt idx="291">
                  <c:v>1350.645</c:v>
                </c:pt>
                <c:pt idx="292">
                  <c:v>1351.3230000000001</c:v>
                </c:pt>
                <c:pt idx="293">
                  <c:v>1351.588</c:v>
                </c:pt>
                <c:pt idx="294">
                  <c:v>1351.692</c:v>
                </c:pt>
                <c:pt idx="295">
                  <c:v>1351.9079999999999</c:v>
                </c:pt>
                <c:pt idx="296">
                  <c:v>1352.175</c:v>
                </c:pt>
                <c:pt idx="297">
                  <c:v>1352.567</c:v>
                </c:pt>
                <c:pt idx="298">
                  <c:v>1352.894</c:v>
                </c:pt>
                <c:pt idx="299">
                  <c:v>1353.175</c:v>
                </c:pt>
                <c:pt idx="300">
                  <c:v>1354.424</c:v>
                </c:pt>
                <c:pt idx="301">
                  <c:v>1354.761</c:v>
                </c:pt>
                <c:pt idx="302">
                  <c:v>1355.385</c:v>
                </c:pt>
                <c:pt idx="303">
                  <c:v>1355.981</c:v>
                </c:pt>
                <c:pt idx="304">
                  <c:v>1356.4359999999999</c:v>
                </c:pt>
                <c:pt idx="305">
                  <c:v>1356.789</c:v>
                </c:pt>
                <c:pt idx="306">
                  <c:v>1356.9459999999999</c:v>
                </c:pt>
                <c:pt idx="307">
                  <c:v>1357.2460000000001</c:v>
                </c:pt>
                <c:pt idx="308">
                  <c:v>1357.7170000000001</c:v>
                </c:pt>
                <c:pt idx="309">
                  <c:v>1357.873</c:v>
                </c:pt>
                <c:pt idx="310">
                  <c:v>1358.172</c:v>
                </c:pt>
                <c:pt idx="311">
                  <c:v>1358.713</c:v>
                </c:pt>
                <c:pt idx="312">
                  <c:v>1358.739</c:v>
                </c:pt>
                <c:pt idx="313">
                  <c:v>1359.4670000000001</c:v>
                </c:pt>
                <c:pt idx="314">
                  <c:v>1360.01</c:v>
                </c:pt>
                <c:pt idx="315">
                  <c:v>1360.2239999999999</c:v>
                </c:pt>
                <c:pt idx="316">
                  <c:v>1360.557</c:v>
                </c:pt>
                <c:pt idx="317">
                  <c:v>1361.7739999999999</c:v>
                </c:pt>
                <c:pt idx="318">
                  <c:v>1362.0930000000001</c:v>
                </c:pt>
                <c:pt idx="319">
                  <c:v>1362.6</c:v>
                </c:pt>
                <c:pt idx="320">
                  <c:v>1363.153</c:v>
                </c:pt>
                <c:pt idx="321">
                  <c:v>1363.6969999999999</c:v>
                </c:pt>
                <c:pt idx="322">
                  <c:v>1364.0150000000001</c:v>
                </c:pt>
                <c:pt idx="323">
                  <c:v>1364.47</c:v>
                </c:pt>
                <c:pt idx="324">
                  <c:v>1364.8879999999999</c:v>
                </c:pt>
                <c:pt idx="325">
                  <c:v>1365.241</c:v>
                </c:pt>
                <c:pt idx="326">
                  <c:v>1365.6759999999999</c:v>
                </c:pt>
                <c:pt idx="327">
                  <c:v>1365.89</c:v>
                </c:pt>
                <c:pt idx="328">
                  <c:v>1366.184</c:v>
                </c:pt>
                <c:pt idx="329">
                  <c:v>1366.8240000000001</c:v>
                </c:pt>
                <c:pt idx="330">
                  <c:v>1367.2750000000001</c:v>
                </c:pt>
                <c:pt idx="331">
                  <c:v>1367.702</c:v>
                </c:pt>
                <c:pt idx="332">
                  <c:v>1368.0360000000001</c:v>
                </c:pt>
                <c:pt idx="333">
                  <c:v>1368.3420000000001</c:v>
                </c:pt>
                <c:pt idx="334">
                  <c:v>1369.2349999999999</c:v>
                </c:pt>
                <c:pt idx="335">
                  <c:v>1369.7940000000001</c:v>
                </c:pt>
                <c:pt idx="336">
                  <c:v>1370.5519999999999</c:v>
                </c:pt>
                <c:pt idx="337">
                  <c:v>1370.9839999999999</c:v>
                </c:pt>
                <c:pt idx="338">
                  <c:v>1371.7670000000001</c:v>
                </c:pt>
                <c:pt idx="339">
                  <c:v>1372.0070000000001</c:v>
                </c:pt>
                <c:pt idx="340">
                  <c:v>1372.4110000000001</c:v>
                </c:pt>
                <c:pt idx="341">
                  <c:v>1372.646</c:v>
                </c:pt>
                <c:pt idx="342">
                  <c:v>1373.0409999999999</c:v>
                </c:pt>
                <c:pt idx="343">
                  <c:v>1374.1120000000001</c:v>
                </c:pt>
                <c:pt idx="344">
                  <c:v>1375.07</c:v>
                </c:pt>
                <c:pt idx="345">
                  <c:v>1375.693</c:v>
                </c:pt>
                <c:pt idx="346">
                  <c:v>1376.3579999999999</c:v>
                </c:pt>
                <c:pt idx="347">
                  <c:v>1377.9280000000001</c:v>
                </c:pt>
                <c:pt idx="348">
                  <c:v>1378.46</c:v>
                </c:pt>
                <c:pt idx="349">
                  <c:v>1379.211</c:v>
                </c:pt>
                <c:pt idx="350">
                  <c:v>1379.6869999999999</c:v>
                </c:pt>
                <c:pt idx="351">
                  <c:v>1380.0940000000001</c:v>
                </c:pt>
                <c:pt idx="352">
                  <c:v>1380.193</c:v>
                </c:pt>
                <c:pt idx="353">
                  <c:v>1380.89</c:v>
                </c:pt>
                <c:pt idx="354">
                  <c:v>1381.1590000000001</c:v>
                </c:pt>
                <c:pt idx="355">
                  <c:v>1381.5640000000001</c:v>
                </c:pt>
                <c:pt idx="356">
                  <c:v>1382.329</c:v>
                </c:pt>
                <c:pt idx="357">
                  <c:v>1382.8520000000001</c:v>
                </c:pt>
                <c:pt idx="358">
                  <c:v>1383.309</c:v>
                </c:pt>
                <c:pt idx="359">
                  <c:v>1383.9480000000001</c:v>
                </c:pt>
                <c:pt idx="360">
                  <c:v>1385.202</c:v>
                </c:pt>
                <c:pt idx="361">
                  <c:v>1385.8879999999999</c:v>
                </c:pt>
                <c:pt idx="362">
                  <c:v>1386.7329999999999</c:v>
                </c:pt>
                <c:pt idx="363">
                  <c:v>1387.1289999999999</c:v>
                </c:pt>
                <c:pt idx="364">
                  <c:v>1387.2729999999999</c:v>
                </c:pt>
                <c:pt idx="365">
                  <c:v>1387.3440000000001</c:v>
                </c:pt>
                <c:pt idx="366">
                  <c:v>1388.173</c:v>
                </c:pt>
                <c:pt idx="367">
                  <c:v>1388.704</c:v>
                </c:pt>
                <c:pt idx="368">
                  <c:v>1389.21</c:v>
                </c:pt>
                <c:pt idx="369">
                  <c:v>1390.2739999999999</c:v>
                </c:pt>
                <c:pt idx="370">
                  <c:v>1390.7570000000001</c:v>
                </c:pt>
                <c:pt idx="371">
                  <c:v>1391.2919999999999</c:v>
                </c:pt>
                <c:pt idx="372">
                  <c:v>1392.3530000000001</c:v>
                </c:pt>
                <c:pt idx="373">
                  <c:v>1392.9559999999999</c:v>
                </c:pt>
                <c:pt idx="374">
                  <c:v>1394.18</c:v>
                </c:pt>
                <c:pt idx="375">
                  <c:v>1394.4949999999999</c:v>
                </c:pt>
                <c:pt idx="376">
                  <c:v>1395.6759999999999</c:v>
                </c:pt>
                <c:pt idx="377">
                  <c:v>1396.537</c:v>
                </c:pt>
                <c:pt idx="378">
                  <c:v>1397.2529999999999</c:v>
                </c:pt>
                <c:pt idx="379">
                  <c:v>1397.8140000000001</c:v>
                </c:pt>
                <c:pt idx="380">
                  <c:v>1398.463</c:v>
                </c:pt>
                <c:pt idx="381">
                  <c:v>1399.425</c:v>
                </c:pt>
                <c:pt idx="382">
                  <c:v>1400.1869999999999</c:v>
                </c:pt>
                <c:pt idx="383">
                  <c:v>1400.8989999999999</c:v>
                </c:pt>
                <c:pt idx="384">
                  <c:v>1401.646</c:v>
                </c:pt>
                <c:pt idx="385">
                  <c:v>1402.4359999999999</c:v>
                </c:pt>
                <c:pt idx="386">
                  <c:v>1402.7819999999999</c:v>
                </c:pt>
                <c:pt idx="387">
                  <c:v>1403.547</c:v>
                </c:pt>
                <c:pt idx="388">
                  <c:v>1404.489</c:v>
                </c:pt>
                <c:pt idx="389">
                  <c:v>1406.375</c:v>
                </c:pt>
                <c:pt idx="390">
                  <c:v>1407.316</c:v>
                </c:pt>
                <c:pt idx="391">
                  <c:v>1408.798</c:v>
                </c:pt>
                <c:pt idx="392">
                  <c:v>1408.8050000000001</c:v>
                </c:pt>
                <c:pt idx="393">
                  <c:v>1409.6489999999999</c:v>
                </c:pt>
                <c:pt idx="394">
                  <c:v>1412.6990000000001</c:v>
                </c:pt>
                <c:pt idx="395">
                  <c:v>1415.9490000000001</c:v>
                </c:pt>
                <c:pt idx="396">
                  <c:v>1417.0360000000001</c:v>
                </c:pt>
                <c:pt idx="397">
                  <c:v>1420.63</c:v>
                </c:pt>
                <c:pt idx="398">
                  <c:v>1422.095</c:v>
                </c:pt>
                <c:pt idx="399">
                  <c:v>1423.1</c:v>
                </c:pt>
                <c:pt idx="400">
                  <c:v>1430.251</c:v>
                </c:pt>
                <c:pt idx="401">
                  <c:v>1430.251</c:v>
                </c:pt>
              </c:numCache>
            </c:numRef>
          </c:xVal>
          <c:yVal>
            <c:numRef>
              <c:f>Foglio6!$D$5:$D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99.998000000000005</c:v>
                </c:pt>
                <c:pt idx="162">
                  <c:v>99.994</c:v>
                </c:pt>
                <c:pt idx="163">
                  <c:v>99.989000000000004</c:v>
                </c:pt>
                <c:pt idx="164">
                  <c:v>99.947999999999993</c:v>
                </c:pt>
                <c:pt idx="165">
                  <c:v>99.867000000000004</c:v>
                </c:pt>
                <c:pt idx="166">
                  <c:v>99.819000000000003</c:v>
                </c:pt>
                <c:pt idx="167">
                  <c:v>99.52</c:v>
                </c:pt>
                <c:pt idx="168">
                  <c:v>99.5</c:v>
                </c:pt>
                <c:pt idx="169">
                  <c:v>99.236999999999995</c:v>
                </c:pt>
                <c:pt idx="170">
                  <c:v>99</c:v>
                </c:pt>
                <c:pt idx="171">
                  <c:v>98.957999999999998</c:v>
                </c:pt>
                <c:pt idx="172">
                  <c:v>98.5</c:v>
                </c:pt>
                <c:pt idx="173">
                  <c:v>98.47</c:v>
                </c:pt>
                <c:pt idx="174">
                  <c:v>98.197999999999993</c:v>
                </c:pt>
                <c:pt idx="175">
                  <c:v>98</c:v>
                </c:pt>
                <c:pt idx="176">
                  <c:v>97.632999999999996</c:v>
                </c:pt>
                <c:pt idx="177">
                  <c:v>97.5</c:v>
                </c:pt>
                <c:pt idx="178">
                  <c:v>97</c:v>
                </c:pt>
                <c:pt idx="179">
                  <c:v>96.84</c:v>
                </c:pt>
                <c:pt idx="180">
                  <c:v>96.5</c:v>
                </c:pt>
                <c:pt idx="181">
                  <c:v>96</c:v>
                </c:pt>
                <c:pt idx="182">
                  <c:v>95.876000000000005</c:v>
                </c:pt>
                <c:pt idx="183">
                  <c:v>95.524000000000001</c:v>
                </c:pt>
                <c:pt idx="184">
                  <c:v>95.5</c:v>
                </c:pt>
                <c:pt idx="185">
                  <c:v>95</c:v>
                </c:pt>
                <c:pt idx="186">
                  <c:v>94.5</c:v>
                </c:pt>
                <c:pt idx="187">
                  <c:v>94.480999999999995</c:v>
                </c:pt>
                <c:pt idx="188">
                  <c:v>94</c:v>
                </c:pt>
                <c:pt idx="189">
                  <c:v>93.5</c:v>
                </c:pt>
                <c:pt idx="190">
                  <c:v>93</c:v>
                </c:pt>
                <c:pt idx="191">
                  <c:v>92.881</c:v>
                </c:pt>
                <c:pt idx="192">
                  <c:v>92.5</c:v>
                </c:pt>
                <c:pt idx="193">
                  <c:v>92</c:v>
                </c:pt>
                <c:pt idx="194">
                  <c:v>91.543000000000006</c:v>
                </c:pt>
                <c:pt idx="195">
                  <c:v>91.5</c:v>
                </c:pt>
                <c:pt idx="196">
                  <c:v>91</c:v>
                </c:pt>
                <c:pt idx="197">
                  <c:v>90.5</c:v>
                </c:pt>
                <c:pt idx="198">
                  <c:v>90</c:v>
                </c:pt>
                <c:pt idx="199">
                  <c:v>89.917000000000002</c:v>
                </c:pt>
                <c:pt idx="200">
                  <c:v>89.5</c:v>
                </c:pt>
                <c:pt idx="201">
                  <c:v>89</c:v>
                </c:pt>
                <c:pt idx="202">
                  <c:v>88.65</c:v>
                </c:pt>
                <c:pt idx="203">
                  <c:v>88.5</c:v>
                </c:pt>
                <c:pt idx="204">
                  <c:v>88</c:v>
                </c:pt>
                <c:pt idx="205">
                  <c:v>87.5</c:v>
                </c:pt>
                <c:pt idx="206">
                  <c:v>87</c:v>
                </c:pt>
                <c:pt idx="207">
                  <c:v>86.5</c:v>
                </c:pt>
                <c:pt idx="208">
                  <c:v>86.361999999999995</c:v>
                </c:pt>
                <c:pt idx="209">
                  <c:v>86</c:v>
                </c:pt>
                <c:pt idx="210">
                  <c:v>85.5</c:v>
                </c:pt>
                <c:pt idx="211">
                  <c:v>85</c:v>
                </c:pt>
                <c:pt idx="212">
                  <c:v>84.551000000000002</c:v>
                </c:pt>
                <c:pt idx="213">
                  <c:v>84.5</c:v>
                </c:pt>
                <c:pt idx="214">
                  <c:v>84</c:v>
                </c:pt>
                <c:pt idx="215">
                  <c:v>83.5</c:v>
                </c:pt>
                <c:pt idx="216">
                  <c:v>83</c:v>
                </c:pt>
                <c:pt idx="217">
                  <c:v>82.5</c:v>
                </c:pt>
                <c:pt idx="218">
                  <c:v>82</c:v>
                </c:pt>
                <c:pt idx="219">
                  <c:v>81.5</c:v>
                </c:pt>
                <c:pt idx="220">
                  <c:v>81.006</c:v>
                </c:pt>
                <c:pt idx="221">
                  <c:v>81</c:v>
                </c:pt>
                <c:pt idx="222">
                  <c:v>80.5</c:v>
                </c:pt>
                <c:pt idx="223">
                  <c:v>80</c:v>
                </c:pt>
                <c:pt idx="224">
                  <c:v>79.5</c:v>
                </c:pt>
                <c:pt idx="225">
                  <c:v>79</c:v>
                </c:pt>
                <c:pt idx="226">
                  <c:v>78.715999999999994</c:v>
                </c:pt>
                <c:pt idx="227">
                  <c:v>78.5</c:v>
                </c:pt>
                <c:pt idx="228">
                  <c:v>78</c:v>
                </c:pt>
                <c:pt idx="229">
                  <c:v>77.5</c:v>
                </c:pt>
                <c:pt idx="230">
                  <c:v>77</c:v>
                </c:pt>
                <c:pt idx="231">
                  <c:v>76.5</c:v>
                </c:pt>
                <c:pt idx="232">
                  <c:v>76</c:v>
                </c:pt>
                <c:pt idx="233">
                  <c:v>75.72</c:v>
                </c:pt>
                <c:pt idx="234">
                  <c:v>75.5</c:v>
                </c:pt>
                <c:pt idx="235">
                  <c:v>75</c:v>
                </c:pt>
                <c:pt idx="236">
                  <c:v>74.5</c:v>
                </c:pt>
                <c:pt idx="237">
                  <c:v>74</c:v>
                </c:pt>
                <c:pt idx="238">
                  <c:v>73.5</c:v>
                </c:pt>
                <c:pt idx="239">
                  <c:v>73</c:v>
                </c:pt>
                <c:pt idx="240">
                  <c:v>72.5</c:v>
                </c:pt>
                <c:pt idx="241">
                  <c:v>72</c:v>
                </c:pt>
                <c:pt idx="242">
                  <c:v>71.5</c:v>
                </c:pt>
                <c:pt idx="243">
                  <c:v>71.341999999999999</c:v>
                </c:pt>
                <c:pt idx="244">
                  <c:v>71</c:v>
                </c:pt>
                <c:pt idx="245">
                  <c:v>70.5</c:v>
                </c:pt>
                <c:pt idx="246">
                  <c:v>70</c:v>
                </c:pt>
                <c:pt idx="247">
                  <c:v>69.5</c:v>
                </c:pt>
                <c:pt idx="248">
                  <c:v>69</c:v>
                </c:pt>
                <c:pt idx="249">
                  <c:v>68.5</c:v>
                </c:pt>
                <c:pt idx="250">
                  <c:v>68</c:v>
                </c:pt>
                <c:pt idx="251">
                  <c:v>67.5</c:v>
                </c:pt>
                <c:pt idx="252">
                  <c:v>67</c:v>
                </c:pt>
                <c:pt idx="253">
                  <c:v>66.5</c:v>
                </c:pt>
                <c:pt idx="254">
                  <c:v>66.204999999999998</c:v>
                </c:pt>
                <c:pt idx="255">
                  <c:v>66</c:v>
                </c:pt>
                <c:pt idx="256">
                  <c:v>65.5</c:v>
                </c:pt>
                <c:pt idx="257">
                  <c:v>65</c:v>
                </c:pt>
                <c:pt idx="258">
                  <c:v>64.5</c:v>
                </c:pt>
                <c:pt idx="259">
                  <c:v>64</c:v>
                </c:pt>
                <c:pt idx="260">
                  <c:v>63.5</c:v>
                </c:pt>
                <c:pt idx="261">
                  <c:v>63</c:v>
                </c:pt>
                <c:pt idx="262">
                  <c:v>62.5</c:v>
                </c:pt>
                <c:pt idx="263">
                  <c:v>62</c:v>
                </c:pt>
                <c:pt idx="264">
                  <c:v>61.5</c:v>
                </c:pt>
                <c:pt idx="265">
                  <c:v>61</c:v>
                </c:pt>
                <c:pt idx="266">
                  <c:v>60.914999999999999</c:v>
                </c:pt>
                <c:pt idx="267">
                  <c:v>60.5</c:v>
                </c:pt>
                <c:pt idx="268">
                  <c:v>60</c:v>
                </c:pt>
                <c:pt idx="269">
                  <c:v>59.5</c:v>
                </c:pt>
                <c:pt idx="270">
                  <c:v>59</c:v>
                </c:pt>
                <c:pt idx="271">
                  <c:v>58.5</c:v>
                </c:pt>
                <c:pt idx="272">
                  <c:v>58</c:v>
                </c:pt>
                <c:pt idx="273">
                  <c:v>57.5</c:v>
                </c:pt>
                <c:pt idx="274">
                  <c:v>57</c:v>
                </c:pt>
                <c:pt idx="275">
                  <c:v>56.5</c:v>
                </c:pt>
                <c:pt idx="276">
                  <c:v>56</c:v>
                </c:pt>
                <c:pt idx="277">
                  <c:v>55.5</c:v>
                </c:pt>
                <c:pt idx="278">
                  <c:v>55</c:v>
                </c:pt>
                <c:pt idx="279">
                  <c:v>54.5</c:v>
                </c:pt>
                <c:pt idx="280">
                  <c:v>54</c:v>
                </c:pt>
                <c:pt idx="281">
                  <c:v>53.866</c:v>
                </c:pt>
                <c:pt idx="282">
                  <c:v>53.5</c:v>
                </c:pt>
                <c:pt idx="283">
                  <c:v>53</c:v>
                </c:pt>
                <c:pt idx="284">
                  <c:v>52.5</c:v>
                </c:pt>
                <c:pt idx="285">
                  <c:v>52</c:v>
                </c:pt>
                <c:pt idx="286">
                  <c:v>51.5</c:v>
                </c:pt>
                <c:pt idx="287">
                  <c:v>51</c:v>
                </c:pt>
                <c:pt idx="288">
                  <c:v>50.5</c:v>
                </c:pt>
                <c:pt idx="289">
                  <c:v>50</c:v>
                </c:pt>
                <c:pt idx="290">
                  <c:v>49.5</c:v>
                </c:pt>
                <c:pt idx="291">
                  <c:v>49</c:v>
                </c:pt>
                <c:pt idx="292">
                  <c:v>48.5</c:v>
                </c:pt>
                <c:pt idx="293">
                  <c:v>48.218000000000004</c:v>
                </c:pt>
                <c:pt idx="294">
                  <c:v>48</c:v>
                </c:pt>
                <c:pt idx="295">
                  <c:v>47.5</c:v>
                </c:pt>
                <c:pt idx="296">
                  <c:v>47</c:v>
                </c:pt>
                <c:pt idx="297">
                  <c:v>46.5</c:v>
                </c:pt>
                <c:pt idx="298">
                  <c:v>46</c:v>
                </c:pt>
                <c:pt idx="299">
                  <c:v>45.5</c:v>
                </c:pt>
                <c:pt idx="300">
                  <c:v>45</c:v>
                </c:pt>
                <c:pt idx="301">
                  <c:v>44.5</c:v>
                </c:pt>
                <c:pt idx="302">
                  <c:v>44</c:v>
                </c:pt>
                <c:pt idx="303">
                  <c:v>43.5</c:v>
                </c:pt>
                <c:pt idx="304">
                  <c:v>43</c:v>
                </c:pt>
                <c:pt idx="305">
                  <c:v>42.5</c:v>
                </c:pt>
                <c:pt idx="306">
                  <c:v>42</c:v>
                </c:pt>
                <c:pt idx="307">
                  <c:v>41.5</c:v>
                </c:pt>
                <c:pt idx="308">
                  <c:v>41</c:v>
                </c:pt>
                <c:pt idx="309">
                  <c:v>40.5</c:v>
                </c:pt>
                <c:pt idx="310">
                  <c:v>40</c:v>
                </c:pt>
                <c:pt idx="311">
                  <c:v>39.5</c:v>
                </c:pt>
                <c:pt idx="312">
                  <c:v>39.466999999999999</c:v>
                </c:pt>
                <c:pt idx="313">
                  <c:v>39</c:v>
                </c:pt>
                <c:pt idx="314">
                  <c:v>38.5</c:v>
                </c:pt>
                <c:pt idx="315">
                  <c:v>38</c:v>
                </c:pt>
                <c:pt idx="316">
                  <c:v>37.5</c:v>
                </c:pt>
                <c:pt idx="317">
                  <c:v>37</c:v>
                </c:pt>
                <c:pt idx="318">
                  <c:v>36.5</c:v>
                </c:pt>
                <c:pt idx="319">
                  <c:v>36</c:v>
                </c:pt>
                <c:pt idx="320">
                  <c:v>35.5</c:v>
                </c:pt>
                <c:pt idx="321">
                  <c:v>35</c:v>
                </c:pt>
                <c:pt idx="322">
                  <c:v>34.5</c:v>
                </c:pt>
                <c:pt idx="323">
                  <c:v>34</c:v>
                </c:pt>
                <c:pt idx="324">
                  <c:v>33.5</c:v>
                </c:pt>
                <c:pt idx="325">
                  <c:v>33</c:v>
                </c:pt>
                <c:pt idx="326">
                  <c:v>32.5</c:v>
                </c:pt>
                <c:pt idx="327">
                  <c:v>32.377000000000002</c:v>
                </c:pt>
                <c:pt idx="328">
                  <c:v>32</c:v>
                </c:pt>
                <c:pt idx="329">
                  <c:v>31.5</c:v>
                </c:pt>
                <c:pt idx="330">
                  <c:v>31</c:v>
                </c:pt>
                <c:pt idx="331">
                  <c:v>30.5</c:v>
                </c:pt>
                <c:pt idx="332">
                  <c:v>30</c:v>
                </c:pt>
                <c:pt idx="333">
                  <c:v>29.5</c:v>
                </c:pt>
                <c:pt idx="334">
                  <c:v>29</c:v>
                </c:pt>
                <c:pt idx="335">
                  <c:v>28.5</c:v>
                </c:pt>
                <c:pt idx="336">
                  <c:v>28</c:v>
                </c:pt>
                <c:pt idx="337">
                  <c:v>27.5</c:v>
                </c:pt>
                <c:pt idx="338">
                  <c:v>27</c:v>
                </c:pt>
                <c:pt idx="339">
                  <c:v>26.5</c:v>
                </c:pt>
                <c:pt idx="340">
                  <c:v>26</c:v>
                </c:pt>
                <c:pt idx="341">
                  <c:v>25.5</c:v>
                </c:pt>
                <c:pt idx="342">
                  <c:v>25.251000000000001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</c:v>
                </c:pt>
                <c:pt idx="350">
                  <c:v>21.5</c:v>
                </c:pt>
                <c:pt idx="351">
                  <c:v>21</c:v>
                </c:pt>
                <c:pt idx="352">
                  <c:v>20.882000000000001</c:v>
                </c:pt>
                <c:pt idx="353">
                  <c:v>20.5</c:v>
                </c:pt>
                <c:pt idx="354">
                  <c:v>20</c:v>
                </c:pt>
                <c:pt idx="355">
                  <c:v>19.5</c:v>
                </c:pt>
                <c:pt idx="356">
                  <c:v>19</c:v>
                </c:pt>
                <c:pt idx="357">
                  <c:v>18.5</c:v>
                </c:pt>
                <c:pt idx="358">
                  <c:v>18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965</c:v>
                </c:pt>
                <c:pt idx="366">
                  <c:v>14.5</c:v>
                </c:pt>
                <c:pt idx="367">
                  <c:v>14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5</c:v>
                </c:pt>
                <c:pt idx="375">
                  <c:v>10.423</c:v>
                </c:pt>
                <c:pt idx="376">
                  <c:v>10</c:v>
                </c:pt>
                <c:pt idx="377">
                  <c:v>9.5</c:v>
                </c:pt>
                <c:pt idx="378">
                  <c:v>9</c:v>
                </c:pt>
                <c:pt idx="379">
                  <c:v>8.5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5</c:v>
                </c:pt>
                <c:pt idx="384">
                  <c:v>6.3010000000000002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5</c:v>
                </c:pt>
                <c:pt idx="389">
                  <c:v>4</c:v>
                </c:pt>
                <c:pt idx="390">
                  <c:v>3.5</c:v>
                </c:pt>
                <c:pt idx="391">
                  <c:v>3.0030000000000001</c:v>
                </c:pt>
                <c:pt idx="392">
                  <c:v>3</c:v>
                </c:pt>
                <c:pt idx="393">
                  <c:v>2.5</c:v>
                </c:pt>
                <c:pt idx="394">
                  <c:v>2</c:v>
                </c:pt>
                <c:pt idx="395">
                  <c:v>1.579</c:v>
                </c:pt>
                <c:pt idx="396">
                  <c:v>1.5</c:v>
                </c:pt>
                <c:pt idx="397">
                  <c:v>1</c:v>
                </c:pt>
                <c:pt idx="398">
                  <c:v>0.5</c:v>
                </c:pt>
                <c:pt idx="399">
                  <c:v>0.41099999999999998</c:v>
                </c:pt>
                <c:pt idx="400">
                  <c:v>7.1999999999999995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A88-4DA4-99B1-07BA75EC6953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xVal>
            <c:numRef>
              <c:f>Foglio6!$E$5:$E$406</c:f>
              <c:numCache>
                <c:formatCode>General</c:formatCode>
                <c:ptCount val="402"/>
                <c:pt idx="0">
                  <c:v>0</c:v>
                </c:pt>
                <c:pt idx="1">
                  <c:v>6.8860000000000001</c:v>
                </c:pt>
                <c:pt idx="2">
                  <c:v>13.772</c:v>
                </c:pt>
                <c:pt idx="3">
                  <c:v>20.658000000000001</c:v>
                </c:pt>
                <c:pt idx="4">
                  <c:v>27.545000000000002</c:v>
                </c:pt>
                <c:pt idx="5">
                  <c:v>34.430999999999997</c:v>
                </c:pt>
                <c:pt idx="6">
                  <c:v>41.317</c:v>
                </c:pt>
                <c:pt idx="7">
                  <c:v>48.203000000000003</c:v>
                </c:pt>
                <c:pt idx="8">
                  <c:v>55.088999999999999</c:v>
                </c:pt>
                <c:pt idx="9">
                  <c:v>61.975000000000001</c:v>
                </c:pt>
                <c:pt idx="10">
                  <c:v>68.861999999999995</c:v>
                </c:pt>
                <c:pt idx="11">
                  <c:v>75.748000000000005</c:v>
                </c:pt>
                <c:pt idx="12">
                  <c:v>82.634</c:v>
                </c:pt>
                <c:pt idx="13">
                  <c:v>89.52</c:v>
                </c:pt>
                <c:pt idx="14">
                  <c:v>96.406000000000006</c:v>
                </c:pt>
                <c:pt idx="15">
                  <c:v>103.292</c:v>
                </c:pt>
                <c:pt idx="16">
                  <c:v>110.179</c:v>
                </c:pt>
                <c:pt idx="17">
                  <c:v>117.065</c:v>
                </c:pt>
                <c:pt idx="18">
                  <c:v>123.95099999999999</c:v>
                </c:pt>
                <c:pt idx="19">
                  <c:v>130.83699999999999</c:v>
                </c:pt>
                <c:pt idx="20">
                  <c:v>137.72300000000001</c:v>
                </c:pt>
                <c:pt idx="21">
                  <c:v>144.60900000000001</c:v>
                </c:pt>
                <c:pt idx="22">
                  <c:v>151.49600000000001</c:v>
                </c:pt>
                <c:pt idx="23">
                  <c:v>158.38200000000001</c:v>
                </c:pt>
                <c:pt idx="24">
                  <c:v>165.268</c:v>
                </c:pt>
                <c:pt idx="25">
                  <c:v>172.154</c:v>
                </c:pt>
                <c:pt idx="26">
                  <c:v>179.04</c:v>
                </c:pt>
                <c:pt idx="27">
                  <c:v>185.92599999999999</c:v>
                </c:pt>
                <c:pt idx="28">
                  <c:v>192.81200000000001</c:v>
                </c:pt>
                <c:pt idx="29">
                  <c:v>199.69900000000001</c:v>
                </c:pt>
                <c:pt idx="30">
                  <c:v>206.58500000000001</c:v>
                </c:pt>
                <c:pt idx="31">
                  <c:v>213.471</c:v>
                </c:pt>
                <c:pt idx="32">
                  <c:v>220.357</c:v>
                </c:pt>
                <c:pt idx="33">
                  <c:v>227.24299999999999</c:v>
                </c:pt>
                <c:pt idx="34">
                  <c:v>234.12899999999999</c:v>
                </c:pt>
                <c:pt idx="35">
                  <c:v>241.01599999999999</c:v>
                </c:pt>
                <c:pt idx="36">
                  <c:v>247.90199999999999</c:v>
                </c:pt>
                <c:pt idx="37">
                  <c:v>254.78800000000001</c:v>
                </c:pt>
                <c:pt idx="38">
                  <c:v>261.67399999999998</c:v>
                </c:pt>
                <c:pt idx="39">
                  <c:v>268.56</c:v>
                </c:pt>
                <c:pt idx="40">
                  <c:v>275.44600000000003</c:v>
                </c:pt>
                <c:pt idx="41">
                  <c:v>282.33300000000003</c:v>
                </c:pt>
                <c:pt idx="42">
                  <c:v>289.21899999999999</c:v>
                </c:pt>
                <c:pt idx="43">
                  <c:v>296.10500000000002</c:v>
                </c:pt>
                <c:pt idx="44">
                  <c:v>302.99099999999999</c:v>
                </c:pt>
                <c:pt idx="45">
                  <c:v>309.87700000000001</c:v>
                </c:pt>
                <c:pt idx="46">
                  <c:v>316.76299999999998</c:v>
                </c:pt>
                <c:pt idx="47">
                  <c:v>323.64999999999998</c:v>
                </c:pt>
                <c:pt idx="48">
                  <c:v>330.536</c:v>
                </c:pt>
                <c:pt idx="49">
                  <c:v>337.42200000000003</c:v>
                </c:pt>
                <c:pt idx="50">
                  <c:v>344.30799999999999</c:v>
                </c:pt>
                <c:pt idx="51">
                  <c:v>351.19400000000002</c:v>
                </c:pt>
                <c:pt idx="52">
                  <c:v>358.08</c:v>
                </c:pt>
                <c:pt idx="53">
                  <c:v>364.96600000000001</c:v>
                </c:pt>
                <c:pt idx="54">
                  <c:v>371.85300000000001</c:v>
                </c:pt>
                <c:pt idx="55">
                  <c:v>378.73899999999998</c:v>
                </c:pt>
                <c:pt idx="56">
                  <c:v>385.625</c:v>
                </c:pt>
                <c:pt idx="57">
                  <c:v>392.51100000000002</c:v>
                </c:pt>
                <c:pt idx="58">
                  <c:v>399.39699999999999</c:v>
                </c:pt>
                <c:pt idx="59">
                  <c:v>406.28300000000002</c:v>
                </c:pt>
                <c:pt idx="60">
                  <c:v>413.17</c:v>
                </c:pt>
                <c:pt idx="61">
                  <c:v>420.05599999999998</c:v>
                </c:pt>
                <c:pt idx="62">
                  <c:v>426.94200000000001</c:v>
                </c:pt>
                <c:pt idx="63">
                  <c:v>433.82799999999997</c:v>
                </c:pt>
                <c:pt idx="64">
                  <c:v>440.714</c:v>
                </c:pt>
                <c:pt idx="65">
                  <c:v>447.6</c:v>
                </c:pt>
                <c:pt idx="66">
                  <c:v>454.48700000000002</c:v>
                </c:pt>
                <c:pt idx="67">
                  <c:v>461.37299999999999</c:v>
                </c:pt>
                <c:pt idx="68">
                  <c:v>468.25900000000001</c:v>
                </c:pt>
                <c:pt idx="69">
                  <c:v>475.14499999999998</c:v>
                </c:pt>
                <c:pt idx="70">
                  <c:v>482.03100000000001</c:v>
                </c:pt>
                <c:pt idx="71">
                  <c:v>488.91699999999997</c:v>
                </c:pt>
                <c:pt idx="72">
                  <c:v>495.803</c:v>
                </c:pt>
                <c:pt idx="73">
                  <c:v>502.69</c:v>
                </c:pt>
                <c:pt idx="74">
                  <c:v>509.57600000000002</c:v>
                </c:pt>
                <c:pt idx="75">
                  <c:v>516.46199999999999</c:v>
                </c:pt>
                <c:pt idx="76">
                  <c:v>523.34799999999996</c:v>
                </c:pt>
                <c:pt idx="77">
                  <c:v>530.23400000000004</c:v>
                </c:pt>
                <c:pt idx="78">
                  <c:v>537.12</c:v>
                </c:pt>
                <c:pt idx="79">
                  <c:v>544.00699999999995</c:v>
                </c:pt>
                <c:pt idx="80">
                  <c:v>550.89300000000003</c:v>
                </c:pt>
                <c:pt idx="81">
                  <c:v>557.779</c:v>
                </c:pt>
                <c:pt idx="82">
                  <c:v>564.66499999999996</c:v>
                </c:pt>
                <c:pt idx="83">
                  <c:v>571.55100000000004</c:v>
                </c:pt>
                <c:pt idx="84">
                  <c:v>578.43700000000001</c:v>
                </c:pt>
                <c:pt idx="85">
                  <c:v>585.32399999999996</c:v>
                </c:pt>
                <c:pt idx="86">
                  <c:v>592.21</c:v>
                </c:pt>
                <c:pt idx="87">
                  <c:v>599.096</c:v>
                </c:pt>
                <c:pt idx="88">
                  <c:v>605.98199999999997</c:v>
                </c:pt>
                <c:pt idx="89">
                  <c:v>612.86800000000005</c:v>
                </c:pt>
                <c:pt idx="90">
                  <c:v>619.75400000000002</c:v>
                </c:pt>
                <c:pt idx="91">
                  <c:v>626.64099999999996</c:v>
                </c:pt>
                <c:pt idx="92">
                  <c:v>633.52700000000004</c:v>
                </c:pt>
                <c:pt idx="93">
                  <c:v>640.41300000000001</c:v>
                </c:pt>
                <c:pt idx="94">
                  <c:v>647.29899999999998</c:v>
                </c:pt>
                <c:pt idx="95">
                  <c:v>654.18499999999995</c:v>
                </c:pt>
                <c:pt idx="96">
                  <c:v>661.07100000000003</c:v>
                </c:pt>
                <c:pt idx="97">
                  <c:v>667.95699999999999</c:v>
                </c:pt>
                <c:pt idx="98">
                  <c:v>674.84400000000005</c:v>
                </c:pt>
                <c:pt idx="99">
                  <c:v>681.73</c:v>
                </c:pt>
                <c:pt idx="100">
                  <c:v>688.61599999999999</c:v>
                </c:pt>
                <c:pt idx="101">
                  <c:v>695.50199999999995</c:v>
                </c:pt>
                <c:pt idx="102">
                  <c:v>702.38800000000003</c:v>
                </c:pt>
                <c:pt idx="103">
                  <c:v>709.274</c:v>
                </c:pt>
                <c:pt idx="104">
                  <c:v>716.16099999999994</c:v>
                </c:pt>
                <c:pt idx="105">
                  <c:v>723.04700000000003</c:v>
                </c:pt>
                <c:pt idx="106">
                  <c:v>729.93299999999999</c:v>
                </c:pt>
                <c:pt idx="107">
                  <c:v>736.81899999999996</c:v>
                </c:pt>
                <c:pt idx="108">
                  <c:v>743.70500000000004</c:v>
                </c:pt>
                <c:pt idx="109">
                  <c:v>750.59100000000001</c:v>
                </c:pt>
                <c:pt idx="110">
                  <c:v>757.47799999999995</c:v>
                </c:pt>
                <c:pt idx="111">
                  <c:v>764.36400000000003</c:v>
                </c:pt>
                <c:pt idx="112">
                  <c:v>771.25</c:v>
                </c:pt>
                <c:pt idx="113">
                  <c:v>778.13599999999997</c:v>
                </c:pt>
                <c:pt idx="114">
                  <c:v>785.02200000000005</c:v>
                </c:pt>
                <c:pt idx="115">
                  <c:v>791.90800000000002</c:v>
                </c:pt>
                <c:pt idx="116">
                  <c:v>798.79499999999996</c:v>
                </c:pt>
                <c:pt idx="117">
                  <c:v>805.68100000000004</c:v>
                </c:pt>
                <c:pt idx="118">
                  <c:v>812.56700000000001</c:v>
                </c:pt>
                <c:pt idx="119">
                  <c:v>819.45299999999997</c:v>
                </c:pt>
                <c:pt idx="120">
                  <c:v>826.33900000000006</c:v>
                </c:pt>
                <c:pt idx="121">
                  <c:v>833.22500000000002</c:v>
                </c:pt>
                <c:pt idx="122">
                  <c:v>840.11099999999999</c:v>
                </c:pt>
                <c:pt idx="123">
                  <c:v>846.99800000000005</c:v>
                </c:pt>
                <c:pt idx="124">
                  <c:v>853.88400000000001</c:v>
                </c:pt>
                <c:pt idx="125">
                  <c:v>860.77</c:v>
                </c:pt>
                <c:pt idx="126">
                  <c:v>867.65599999999995</c:v>
                </c:pt>
                <c:pt idx="127">
                  <c:v>874.54200000000003</c:v>
                </c:pt>
                <c:pt idx="128">
                  <c:v>881.428</c:v>
                </c:pt>
                <c:pt idx="129">
                  <c:v>888.31500000000005</c:v>
                </c:pt>
                <c:pt idx="130">
                  <c:v>895.20100000000002</c:v>
                </c:pt>
                <c:pt idx="131">
                  <c:v>902.08699999999999</c:v>
                </c:pt>
                <c:pt idx="132">
                  <c:v>908.97299999999996</c:v>
                </c:pt>
                <c:pt idx="133">
                  <c:v>915.85900000000004</c:v>
                </c:pt>
                <c:pt idx="134">
                  <c:v>922.745</c:v>
                </c:pt>
                <c:pt idx="135">
                  <c:v>929.63199999999995</c:v>
                </c:pt>
                <c:pt idx="136">
                  <c:v>936.51800000000003</c:v>
                </c:pt>
                <c:pt idx="137">
                  <c:v>943.404</c:v>
                </c:pt>
                <c:pt idx="138">
                  <c:v>950.29</c:v>
                </c:pt>
                <c:pt idx="139">
                  <c:v>957.17600000000004</c:v>
                </c:pt>
                <c:pt idx="140">
                  <c:v>964.06200000000001</c:v>
                </c:pt>
                <c:pt idx="141">
                  <c:v>970.94899999999996</c:v>
                </c:pt>
                <c:pt idx="142">
                  <c:v>977.83500000000004</c:v>
                </c:pt>
                <c:pt idx="143">
                  <c:v>984.721</c:v>
                </c:pt>
                <c:pt idx="144">
                  <c:v>991.60699999999997</c:v>
                </c:pt>
                <c:pt idx="145">
                  <c:v>998.49300000000005</c:v>
                </c:pt>
                <c:pt idx="146">
                  <c:v>1005.379</c:v>
                </c:pt>
                <c:pt idx="147">
                  <c:v>1012.265</c:v>
                </c:pt>
                <c:pt idx="148">
                  <c:v>1019.152</c:v>
                </c:pt>
                <c:pt idx="149">
                  <c:v>1026.038</c:v>
                </c:pt>
                <c:pt idx="150">
                  <c:v>1032.924</c:v>
                </c:pt>
                <c:pt idx="151">
                  <c:v>1039.81</c:v>
                </c:pt>
                <c:pt idx="152">
                  <c:v>1046.6959999999999</c:v>
                </c:pt>
                <c:pt idx="153">
                  <c:v>1053.5820000000001</c:v>
                </c:pt>
                <c:pt idx="154">
                  <c:v>1060.4690000000001</c:v>
                </c:pt>
                <c:pt idx="155">
                  <c:v>1067.355</c:v>
                </c:pt>
                <c:pt idx="156">
                  <c:v>1074.241</c:v>
                </c:pt>
                <c:pt idx="157">
                  <c:v>1081.127</c:v>
                </c:pt>
                <c:pt idx="158">
                  <c:v>1088.0129999999999</c:v>
                </c:pt>
                <c:pt idx="159">
                  <c:v>1094.8989999999999</c:v>
                </c:pt>
                <c:pt idx="160">
                  <c:v>1101.7860000000001</c:v>
                </c:pt>
                <c:pt idx="161">
                  <c:v>1108.672</c:v>
                </c:pt>
                <c:pt idx="162">
                  <c:v>1115.558</c:v>
                </c:pt>
                <c:pt idx="163">
                  <c:v>1122.444</c:v>
                </c:pt>
                <c:pt idx="164">
                  <c:v>1129.33</c:v>
                </c:pt>
                <c:pt idx="165">
                  <c:v>1136.2159999999999</c:v>
                </c:pt>
                <c:pt idx="166">
                  <c:v>1143.1030000000001</c:v>
                </c:pt>
                <c:pt idx="167">
                  <c:v>1149.989</c:v>
                </c:pt>
                <c:pt idx="168">
                  <c:v>1151.9179999999999</c:v>
                </c:pt>
                <c:pt idx="169">
                  <c:v>1156.875</c:v>
                </c:pt>
                <c:pt idx="170">
                  <c:v>1163.761</c:v>
                </c:pt>
                <c:pt idx="171">
                  <c:v>1170.6469999999999</c:v>
                </c:pt>
                <c:pt idx="172">
                  <c:v>1177.5329999999999</c:v>
                </c:pt>
                <c:pt idx="173">
                  <c:v>1184.4190000000001</c:v>
                </c:pt>
                <c:pt idx="174">
                  <c:v>1191.1949999999999</c:v>
                </c:pt>
                <c:pt idx="175">
                  <c:v>1191.306</c:v>
                </c:pt>
                <c:pt idx="176">
                  <c:v>1198.192</c:v>
                </c:pt>
                <c:pt idx="177">
                  <c:v>1200</c:v>
                </c:pt>
                <c:pt idx="178">
                  <c:v>1205.078</c:v>
                </c:pt>
                <c:pt idx="179">
                  <c:v>1211.9639999999999</c:v>
                </c:pt>
                <c:pt idx="180">
                  <c:v>1214.5350000000001</c:v>
                </c:pt>
                <c:pt idx="181">
                  <c:v>1217.328</c:v>
                </c:pt>
                <c:pt idx="182">
                  <c:v>1218.8499999999999</c:v>
                </c:pt>
                <c:pt idx="183">
                  <c:v>1223.875</c:v>
                </c:pt>
                <c:pt idx="184">
                  <c:v>1225.2570000000001</c:v>
                </c:pt>
                <c:pt idx="185">
                  <c:v>1225.7360000000001</c:v>
                </c:pt>
                <c:pt idx="186">
                  <c:v>1227.605</c:v>
                </c:pt>
                <c:pt idx="187">
                  <c:v>1232.623</c:v>
                </c:pt>
                <c:pt idx="188">
                  <c:v>1232.79</c:v>
                </c:pt>
                <c:pt idx="189">
                  <c:v>1237.0229999999999</c:v>
                </c:pt>
                <c:pt idx="190">
                  <c:v>1239.509</c:v>
                </c:pt>
                <c:pt idx="191">
                  <c:v>1240.6300000000001</c:v>
                </c:pt>
                <c:pt idx="192">
                  <c:v>1244.1500000000001</c:v>
                </c:pt>
                <c:pt idx="193">
                  <c:v>1246.395</c:v>
                </c:pt>
                <c:pt idx="194">
                  <c:v>1247.4649999999999</c:v>
                </c:pt>
                <c:pt idx="195">
                  <c:v>1248.7539999999999</c:v>
                </c:pt>
                <c:pt idx="196">
                  <c:v>1251.933</c:v>
                </c:pt>
                <c:pt idx="197">
                  <c:v>1253.2809999999999</c:v>
                </c:pt>
                <c:pt idx="198">
                  <c:v>1253.3399999999999</c:v>
                </c:pt>
                <c:pt idx="199">
                  <c:v>1255.8620000000001</c:v>
                </c:pt>
                <c:pt idx="200">
                  <c:v>1257.7819999999999</c:v>
                </c:pt>
                <c:pt idx="201">
                  <c:v>1258.443</c:v>
                </c:pt>
                <c:pt idx="202">
                  <c:v>1260.1669999999999</c:v>
                </c:pt>
                <c:pt idx="203">
                  <c:v>1261.7619999999999</c:v>
                </c:pt>
                <c:pt idx="204">
                  <c:v>1263.221</c:v>
                </c:pt>
                <c:pt idx="205">
                  <c:v>1265.768</c:v>
                </c:pt>
                <c:pt idx="206">
                  <c:v>1267.0530000000001</c:v>
                </c:pt>
                <c:pt idx="207">
                  <c:v>1267.5119999999999</c:v>
                </c:pt>
                <c:pt idx="208">
                  <c:v>1269.7380000000001</c:v>
                </c:pt>
                <c:pt idx="209">
                  <c:v>1271.5889999999999</c:v>
                </c:pt>
                <c:pt idx="210">
                  <c:v>1272.1510000000001</c:v>
                </c:pt>
                <c:pt idx="211">
                  <c:v>1272.915</c:v>
                </c:pt>
                <c:pt idx="212">
                  <c:v>1273.691</c:v>
                </c:pt>
                <c:pt idx="213">
                  <c:v>1273.94</c:v>
                </c:pt>
                <c:pt idx="214">
                  <c:v>1274.973</c:v>
                </c:pt>
                <c:pt idx="215">
                  <c:v>1275.4490000000001</c:v>
                </c:pt>
                <c:pt idx="216">
                  <c:v>1276.1189999999999</c:v>
                </c:pt>
                <c:pt idx="217">
                  <c:v>1277.877</c:v>
                </c:pt>
                <c:pt idx="218">
                  <c:v>1278.499</c:v>
                </c:pt>
                <c:pt idx="219">
                  <c:v>1278.7760000000001</c:v>
                </c:pt>
                <c:pt idx="220">
                  <c:v>1279.5340000000001</c:v>
                </c:pt>
                <c:pt idx="221">
                  <c:v>1280.568</c:v>
                </c:pt>
                <c:pt idx="222">
                  <c:v>1280.826</c:v>
                </c:pt>
                <c:pt idx="223">
                  <c:v>1281.2090000000001</c:v>
                </c:pt>
                <c:pt idx="224">
                  <c:v>1282.9829999999999</c:v>
                </c:pt>
                <c:pt idx="225">
                  <c:v>1283.627</c:v>
                </c:pt>
                <c:pt idx="226">
                  <c:v>1283.9670000000001</c:v>
                </c:pt>
                <c:pt idx="227">
                  <c:v>1284.883</c:v>
                </c:pt>
                <c:pt idx="228">
                  <c:v>1285.222</c:v>
                </c:pt>
                <c:pt idx="229">
                  <c:v>1285.673</c:v>
                </c:pt>
                <c:pt idx="230">
                  <c:v>1286.461</c:v>
                </c:pt>
                <c:pt idx="231">
                  <c:v>1287.4849999999999</c:v>
                </c:pt>
                <c:pt idx="232">
                  <c:v>1287.712</c:v>
                </c:pt>
                <c:pt idx="233">
                  <c:v>1288.415</c:v>
                </c:pt>
                <c:pt idx="234">
                  <c:v>1288.9570000000001</c:v>
                </c:pt>
                <c:pt idx="235">
                  <c:v>1289.732</c:v>
                </c:pt>
                <c:pt idx="236">
                  <c:v>1290.277</c:v>
                </c:pt>
                <c:pt idx="237">
                  <c:v>1290.616</c:v>
                </c:pt>
                <c:pt idx="238">
                  <c:v>1291.0409999999999</c:v>
                </c:pt>
                <c:pt idx="239">
                  <c:v>1291.5540000000001</c:v>
                </c:pt>
                <c:pt idx="240">
                  <c:v>1292.134</c:v>
                </c:pt>
                <c:pt idx="241">
                  <c:v>1292.431</c:v>
                </c:pt>
                <c:pt idx="242">
                  <c:v>1292.6959999999999</c:v>
                </c:pt>
                <c:pt idx="243">
                  <c:v>1293.107</c:v>
                </c:pt>
                <c:pt idx="244">
                  <c:v>1293.847</c:v>
                </c:pt>
                <c:pt idx="245">
                  <c:v>1294.5139999999999</c:v>
                </c:pt>
                <c:pt idx="246">
                  <c:v>1294.598</c:v>
                </c:pt>
                <c:pt idx="247">
                  <c:v>1294.8579999999999</c:v>
                </c:pt>
                <c:pt idx="248">
                  <c:v>1295.538</c:v>
                </c:pt>
                <c:pt idx="249">
                  <c:v>1295.9649999999999</c:v>
                </c:pt>
                <c:pt idx="250">
                  <c:v>1296.5050000000001</c:v>
                </c:pt>
                <c:pt idx="251">
                  <c:v>1296.98</c:v>
                </c:pt>
                <c:pt idx="252">
                  <c:v>1297.6110000000001</c:v>
                </c:pt>
                <c:pt idx="253">
                  <c:v>1297.922</c:v>
                </c:pt>
                <c:pt idx="254">
                  <c:v>1298.4559999999999</c:v>
                </c:pt>
                <c:pt idx="255">
                  <c:v>1298.8620000000001</c:v>
                </c:pt>
                <c:pt idx="256">
                  <c:v>1298.9839999999999</c:v>
                </c:pt>
                <c:pt idx="257">
                  <c:v>1299.357</c:v>
                </c:pt>
                <c:pt idx="258">
                  <c:v>1299.55</c:v>
                </c:pt>
                <c:pt idx="259">
                  <c:v>1299.7929999999999</c:v>
                </c:pt>
                <c:pt idx="260">
                  <c:v>1300.3920000000001</c:v>
                </c:pt>
                <c:pt idx="261">
                  <c:v>1300.5730000000001</c:v>
                </c:pt>
                <c:pt idx="262">
                  <c:v>1301.0160000000001</c:v>
                </c:pt>
                <c:pt idx="263">
                  <c:v>1301.4179999999999</c:v>
                </c:pt>
                <c:pt idx="264">
                  <c:v>1301.4839999999999</c:v>
                </c:pt>
                <c:pt idx="265">
                  <c:v>1301.5840000000001</c:v>
                </c:pt>
                <c:pt idx="266">
                  <c:v>1301.998</c:v>
                </c:pt>
                <c:pt idx="267">
                  <c:v>1302.298</c:v>
                </c:pt>
                <c:pt idx="268">
                  <c:v>1302.68</c:v>
                </c:pt>
                <c:pt idx="269">
                  <c:v>1303.1790000000001</c:v>
                </c:pt>
                <c:pt idx="270">
                  <c:v>1303.4680000000001</c:v>
                </c:pt>
                <c:pt idx="271">
                  <c:v>1303.634</c:v>
                </c:pt>
                <c:pt idx="272">
                  <c:v>1303.8</c:v>
                </c:pt>
                <c:pt idx="273">
                  <c:v>1304.1510000000001</c:v>
                </c:pt>
                <c:pt idx="274">
                  <c:v>1304.4970000000001</c:v>
                </c:pt>
                <c:pt idx="275">
                  <c:v>1304.6420000000001</c:v>
                </c:pt>
                <c:pt idx="276">
                  <c:v>1304.836</c:v>
                </c:pt>
                <c:pt idx="277">
                  <c:v>1305.5429999999999</c:v>
                </c:pt>
                <c:pt idx="278">
                  <c:v>1305.8420000000001</c:v>
                </c:pt>
                <c:pt idx="279">
                  <c:v>1306.4570000000001</c:v>
                </c:pt>
                <c:pt idx="280">
                  <c:v>1306.951</c:v>
                </c:pt>
                <c:pt idx="281">
                  <c:v>1307.1220000000001</c:v>
                </c:pt>
                <c:pt idx="282">
                  <c:v>1307.412</c:v>
                </c:pt>
                <c:pt idx="283">
                  <c:v>1307.7270000000001</c:v>
                </c:pt>
                <c:pt idx="284">
                  <c:v>1307.9059999999999</c:v>
                </c:pt>
                <c:pt idx="285">
                  <c:v>1308.098</c:v>
                </c:pt>
                <c:pt idx="286">
                  <c:v>1308.2380000000001</c:v>
                </c:pt>
                <c:pt idx="287">
                  <c:v>1308.3699999999999</c:v>
                </c:pt>
                <c:pt idx="288">
                  <c:v>1308.414</c:v>
                </c:pt>
                <c:pt idx="289">
                  <c:v>1308.915</c:v>
                </c:pt>
                <c:pt idx="290">
                  <c:v>1309.1600000000001</c:v>
                </c:pt>
                <c:pt idx="291">
                  <c:v>1309.52</c:v>
                </c:pt>
                <c:pt idx="292">
                  <c:v>1310.0740000000001</c:v>
                </c:pt>
                <c:pt idx="293">
                  <c:v>1310.192</c:v>
                </c:pt>
                <c:pt idx="294">
                  <c:v>1310.8820000000001</c:v>
                </c:pt>
                <c:pt idx="295">
                  <c:v>1311.0609999999999</c:v>
                </c:pt>
                <c:pt idx="296">
                  <c:v>1311.5160000000001</c:v>
                </c:pt>
                <c:pt idx="297">
                  <c:v>1311.9829999999999</c:v>
                </c:pt>
                <c:pt idx="298">
                  <c:v>1312.175</c:v>
                </c:pt>
                <c:pt idx="299">
                  <c:v>1312.317</c:v>
                </c:pt>
                <c:pt idx="300">
                  <c:v>1312.585</c:v>
                </c:pt>
                <c:pt idx="301">
                  <c:v>1313.259</c:v>
                </c:pt>
                <c:pt idx="302">
                  <c:v>1313.7159999999999</c:v>
                </c:pt>
                <c:pt idx="303">
                  <c:v>1314.318</c:v>
                </c:pt>
                <c:pt idx="304">
                  <c:v>1314.6559999999999</c:v>
                </c:pt>
                <c:pt idx="305">
                  <c:v>1314.79</c:v>
                </c:pt>
                <c:pt idx="306">
                  <c:v>1315.2439999999999</c:v>
                </c:pt>
                <c:pt idx="307">
                  <c:v>1315.2560000000001</c:v>
                </c:pt>
                <c:pt idx="308">
                  <c:v>1315.5219999999999</c:v>
                </c:pt>
                <c:pt idx="309">
                  <c:v>1315.894</c:v>
                </c:pt>
                <c:pt idx="310">
                  <c:v>1316.1849999999999</c:v>
                </c:pt>
                <c:pt idx="311">
                  <c:v>1316.5239999999999</c:v>
                </c:pt>
                <c:pt idx="312">
                  <c:v>1316.6110000000001</c:v>
                </c:pt>
                <c:pt idx="313">
                  <c:v>1316.799</c:v>
                </c:pt>
                <c:pt idx="314">
                  <c:v>1317.1179999999999</c:v>
                </c:pt>
                <c:pt idx="315">
                  <c:v>1317.2760000000001</c:v>
                </c:pt>
                <c:pt idx="316">
                  <c:v>1317.489</c:v>
                </c:pt>
                <c:pt idx="317">
                  <c:v>1317.7080000000001</c:v>
                </c:pt>
                <c:pt idx="318">
                  <c:v>1318.2260000000001</c:v>
                </c:pt>
                <c:pt idx="319">
                  <c:v>1318.52</c:v>
                </c:pt>
                <c:pt idx="320">
                  <c:v>1318.864</c:v>
                </c:pt>
                <c:pt idx="321">
                  <c:v>1319.1210000000001</c:v>
                </c:pt>
                <c:pt idx="322">
                  <c:v>1319.29</c:v>
                </c:pt>
                <c:pt idx="323">
                  <c:v>1319.6079999999999</c:v>
                </c:pt>
                <c:pt idx="324">
                  <c:v>1319.874</c:v>
                </c:pt>
                <c:pt idx="325">
                  <c:v>1320.2909999999999</c:v>
                </c:pt>
                <c:pt idx="326">
                  <c:v>1320.873</c:v>
                </c:pt>
                <c:pt idx="327">
                  <c:v>1321.6849999999999</c:v>
                </c:pt>
                <c:pt idx="328">
                  <c:v>1321.808</c:v>
                </c:pt>
                <c:pt idx="329">
                  <c:v>1322.143</c:v>
                </c:pt>
                <c:pt idx="330">
                  <c:v>1322.184</c:v>
                </c:pt>
                <c:pt idx="331">
                  <c:v>1322.307</c:v>
                </c:pt>
                <c:pt idx="332">
                  <c:v>1322.569</c:v>
                </c:pt>
                <c:pt idx="333">
                  <c:v>1322.7239999999999</c:v>
                </c:pt>
                <c:pt idx="334">
                  <c:v>1323.434</c:v>
                </c:pt>
                <c:pt idx="335">
                  <c:v>1323.9749999999999</c:v>
                </c:pt>
                <c:pt idx="336">
                  <c:v>1324.3119999999999</c:v>
                </c:pt>
                <c:pt idx="337">
                  <c:v>1324.682</c:v>
                </c:pt>
                <c:pt idx="338">
                  <c:v>1324.7919999999999</c:v>
                </c:pt>
                <c:pt idx="339">
                  <c:v>1325.0340000000001</c:v>
                </c:pt>
                <c:pt idx="340">
                  <c:v>1325.329</c:v>
                </c:pt>
                <c:pt idx="341">
                  <c:v>1325.873</c:v>
                </c:pt>
                <c:pt idx="342">
                  <c:v>1326.49</c:v>
                </c:pt>
                <c:pt idx="343">
                  <c:v>1326.885</c:v>
                </c:pt>
                <c:pt idx="344">
                  <c:v>1327.146</c:v>
                </c:pt>
                <c:pt idx="345">
                  <c:v>1327.731</c:v>
                </c:pt>
                <c:pt idx="346">
                  <c:v>1327.8810000000001</c:v>
                </c:pt>
                <c:pt idx="347">
                  <c:v>1328.09</c:v>
                </c:pt>
                <c:pt idx="348">
                  <c:v>1328.422</c:v>
                </c:pt>
                <c:pt idx="349">
                  <c:v>1328.6489999999999</c:v>
                </c:pt>
                <c:pt idx="350">
                  <c:v>1329.029</c:v>
                </c:pt>
                <c:pt idx="351">
                  <c:v>1329.277</c:v>
                </c:pt>
                <c:pt idx="352">
                  <c:v>1329.9079999999999</c:v>
                </c:pt>
                <c:pt idx="353">
                  <c:v>1330.2149999999999</c:v>
                </c:pt>
                <c:pt idx="354">
                  <c:v>1330.529</c:v>
                </c:pt>
                <c:pt idx="355">
                  <c:v>1331.2449999999999</c:v>
                </c:pt>
                <c:pt idx="356">
                  <c:v>1331.941</c:v>
                </c:pt>
                <c:pt idx="357">
                  <c:v>1332.222</c:v>
                </c:pt>
                <c:pt idx="358">
                  <c:v>1332.4269999999999</c:v>
                </c:pt>
                <c:pt idx="359">
                  <c:v>1332.7429999999999</c:v>
                </c:pt>
                <c:pt idx="360">
                  <c:v>1333.373</c:v>
                </c:pt>
                <c:pt idx="361">
                  <c:v>1333.6769999999999</c:v>
                </c:pt>
                <c:pt idx="362">
                  <c:v>1334.694</c:v>
                </c:pt>
                <c:pt idx="363">
                  <c:v>1335.152</c:v>
                </c:pt>
                <c:pt idx="364">
                  <c:v>1335.703</c:v>
                </c:pt>
                <c:pt idx="365">
                  <c:v>1335.915</c:v>
                </c:pt>
                <c:pt idx="366">
                  <c:v>1336.6849999999999</c:v>
                </c:pt>
                <c:pt idx="367">
                  <c:v>1337.5129999999999</c:v>
                </c:pt>
                <c:pt idx="368">
                  <c:v>1337.8309999999999</c:v>
                </c:pt>
                <c:pt idx="369">
                  <c:v>1338.2940000000001</c:v>
                </c:pt>
                <c:pt idx="370">
                  <c:v>1338.605</c:v>
                </c:pt>
                <c:pt idx="371">
                  <c:v>1339.0419999999999</c:v>
                </c:pt>
                <c:pt idx="372">
                  <c:v>1339.306</c:v>
                </c:pt>
                <c:pt idx="373">
                  <c:v>1339.7260000000001</c:v>
                </c:pt>
                <c:pt idx="374">
                  <c:v>1340.2049999999999</c:v>
                </c:pt>
                <c:pt idx="375">
                  <c:v>1340.963</c:v>
                </c:pt>
                <c:pt idx="376">
                  <c:v>1341.4280000000001</c:v>
                </c:pt>
                <c:pt idx="377">
                  <c:v>1341.8</c:v>
                </c:pt>
                <c:pt idx="378">
                  <c:v>1342.3430000000001</c:v>
                </c:pt>
                <c:pt idx="379">
                  <c:v>1342.8009999999999</c:v>
                </c:pt>
                <c:pt idx="380">
                  <c:v>1342.8520000000001</c:v>
                </c:pt>
                <c:pt idx="381">
                  <c:v>1343.575</c:v>
                </c:pt>
                <c:pt idx="382">
                  <c:v>1344.239</c:v>
                </c:pt>
                <c:pt idx="383">
                  <c:v>1345.5519999999999</c:v>
                </c:pt>
                <c:pt idx="384">
                  <c:v>1346.3879999999999</c:v>
                </c:pt>
                <c:pt idx="385">
                  <c:v>1346.8920000000001</c:v>
                </c:pt>
                <c:pt idx="386">
                  <c:v>1348.194</c:v>
                </c:pt>
                <c:pt idx="387">
                  <c:v>1349.6869999999999</c:v>
                </c:pt>
                <c:pt idx="388">
                  <c:v>1350.32</c:v>
                </c:pt>
                <c:pt idx="389">
                  <c:v>1350.8409999999999</c:v>
                </c:pt>
                <c:pt idx="390">
                  <c:v>1351.797</c:v>
                </c:pt>
                <c:pt idx="391">
                  <c:v>1352.2339999999999</c:v>
                </c:pt>
                <c:pt idx="392">
                  <c:v>1352.94</c:v>
                </c:pt>
                <c:pt idx="393">
                  <c:v>1354.7919999999999</c:v>
                </c:pt>
                <c:pt idx="394">
                  <c:v>1356.5730000000001</c:v>
                </c:pt>
                <c:pt idx="395">
                  <c:v>1358.2159999999999</c:v>
                </c:pt>
                <c:pt idx="396">
                  <c:v>1359.1210000000001</c:v>
                </c:pt>
                <c:pt idx="397">
                  <c:v>1363.46</c:v>
                </c:pt>
                <c:pt idx="398">
                  <c:v>1364.0039999999999</c:v>
                </c:pt>
                <c:pt idx="399">
                  <c:v>1370.346</c:v>
                </c:pt>
                <c:pt idx="400">
                  <c:v>1377.232</c:v>
                </c:pt>
                <c:pt idx="401">
                  <c:v>1377.232</c:v>
                </c:pt>
              </c:numCache>
            </c:numRef>
          </c:xVal>
          <c:yVal>
            <c:numRef>
              <c:f>Foglio6!$F$5:$F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100</c:v>
                </c:pt>
                <c:pt idx="168">
                  <c:v>100</c:v>
                </c:pt>
                <c:pt idx="169">
                  <c:v>99.977000000000004</c:v>
                </c:pt>
                <c:pt idx="170">
                  <c:v>99.956999999999994</c:v>
                </c:pt>
                <c:pt idx="171">
                  <c:v>99.938000000000002</c:v>
                </c:pt>
                <c:pt idx="172">
                  <c:v>99.914000000000001</c:v>
                </c:pt>
                <c:pt idx="173">
                  <c:v>99.828999999999994</c:v>
                </c:pt>
                <c:pt idx="174">
                  <c:v>99.5</c:v>
                </c:pt>
                <c:pt idx="175">
                  <c:v>99.484999999999999</c:v>
                </c:pt>
                <c:pt idx="176">
                  <c:v>99.227000000000004</c:v>
                </c:pt>
                <c:pt idx="177">
                  <c:v>99</c:v>
                </c:pt>
                <c:pt idx="178">
                  <c:v>98.817999999999998</c:v>
                </c:pt>
                <c:pt idx="179">
                  <c:v>98.575000000000003</c:v>
                </c:pt>
                <c:pt idx="180">
                  <c:v>98.5</c:v>
                </c:pt>
                <c:pt idx="181">
                  <c:v>98</c:v>
                </c:pt>
                <c:pt idx="182">
                  <c:v>97.751000000000005</c:v>
                </c:pt>
                <c:pt idx="183">
                  <c:v>97.5</c:v>
                </c:pt>
                <c:pt idx="184">
                  <c:v>97</c:v>
                </c:pt>
                <c:pt idx="185">
                  <c:v>96.703000000000003</c:v>
                </c:pt>
                <c:pt idx="186">
                  <c:v>96.5</c:v>
                </c:pt>
                <c:pt idx="187">
                  <c:v>96.028000000000006</c:v>
                </c:pt>
                <c:pt idx="188">
                  <c:v>96</c:v>
                </c:pt>
                <c:pt idx="189">
                  <c:v>95.5</c:v>
                </c:pt>
                <c:pt idx="190">
                  <c:v>95.010999999999996</c:v>
                </c:pt>
                <c:pt idx="191">
                  <c:v>95</c:v>
                </c:pt>
                <c:pt idx="192">
                  <c:v>94.5</c:v>
                </c:pt>
                <c:pt idx="193">
                  <c:v>94.257999999999996</c:v>
                </c:pt>
                <c:pt idx="194">
                  <c:v>94</c:v>
                </c:pt>
                <c:pt idx="195">
                  <c:v>93.5</c:v>
                </c:pt>
                <c:pt idx="196">
                  <c:v>93</c:v>
                </c:pt>
                <c:pt idx="197">
                  <c:v>92.506</c:v>
                </c:pt>
                <c:pt idx="198">
                  <c:v>92.5</c:v>
                </c:pt>
                <c:pt idx="199">
                  <c:v>92</c:v>
                </c:pt>
                <c:pt idx="200">
                  <c:v>91.5</c:v>
                </c:pt>
                <c:pt idx="201">
                  <c:v>91</c:v>
                </c:pt>
                <c:pt idx="202">
                  <c:v>90.804000000000002</c:v>
                </c:pt>
                <c:pt idx="203">
                  <c:v>90.5</c:v>
                </c:pt>
                <c:pt idx="204">
                  <c:v>90</c:v>
                </c:pt>
                <c:pt idx="205">
                  <c:v>89.5</c:v>
                </c:pt>
                <c:pt idx="206">
                  <c:v>89.070999999999998</c:v>
                </c:pt>
                <c:pt idx="207">
                  <c:v>89</c:v>
                </c:pt>
                <c:pt idx="208">
                  <c:v>88.5</c:v>
                </c:pt>
                <c:pt idx="209">
                  <c:v>88</c:v>
                </c:pt>
                <c:pt idx="210">
                  <c:v>87.5</c:v>
                </c:pt>
                <c:pt idx="211">
                  <c:v>87</c:v>
                </c:pt>
                <c:pt idx="212">
                  <c:v>86.5</c:v>
                </c:pt>
                <c:pt idx="213">
                  <c:v>86.424999999999997</c:v>
                </c:pt>
                <c:pt idx="214">
                  <c:v>86</c:v>
                </c:pt>
                <c:pt idx="215">
                  <c:v>85.5</c:v>
                </c:pt>
                <c:pt idx="216">
                  <c:v>85</c:v>
                </c:pt>
                <c:pt idx="217">
                  <c:v>84.5</c:v>
                </c:pt>
                <c:pt idx="218">
                  <c:v>84</c:v>
                </c:pt>
                <c:pt idx="219">
                  <c:v>83.5</c:v>
                </c:pt>
                <c:pt idx="220">
                  <c:v>83</c:v>
                </c:pt>
                <c:pt idx="221">
                  <c:v>82.5</c:v>
                </c:pt>
                <c:pt idx="222">
                  <c:v>82.412000000000006</c:v>
                </c:pt>
                <c:pt idx="223">
                  <c:v>82</c:v>
                </c:pt>
                <c:pt idx="224">
                  <c:v>81.5</c:v>
                </c:pt>
                <c:pt idx="225">
                  <c:v>81</c:v>
                </c:pt>
                <c:pt idx="226">
                  <c:v>80.5</c:v>
                </c:pt>
                <c:pt idx="227">
                  <c:v>80</c:v>
                </c:pt>
                <c:pt idx="228">
                  <c:v>79.5</c:v>
                </c:pt>
                <c:pt idx="229">
                  <c:v>79</c:v>
                </c:pt>
                <c:pt idx="230">
                  <c:v>78.5</c:v>
                </c:pt>
                <c:pt idx="231">
                  <c:v>78</c:v>
                </c:pt>
                <c:pt idx="232">
                  <c:v>77.841999999999999</c:v>
                </c:pt>
                <c:pt idx="233">
                  <c:v>77.5</c:v>
                </c:pt>
                <c:pt idx="234">
                  <c:v>77</c:v>
                </c:pt>
                <c:pt idx="235">
                  <c:v>76.5</c:v>
                </c:pt>
                <c:pt idx="236">
                  <c:v>76</c:v>
                </c:pt>
                <c:pt idx="237">
                  <c:v>75.5</c:v>
                </c:pt>
                <c:pt idx="238">
                  <c:v>75</c:v>
                </c:pt>
                <c:pt idx="239">
                  <c:v>74.5</c:v>
                </c:pt>
                <c:pt idx="240">
                  <c:v>74</c:v>
                </c:pt>
                <c:pt idx="241">
                  <c:v>73.5</c:v>
                </c:pt>
                <c:pt idx="242">
                  <c:v>73</c:v>
                </c:pt>
                <c:pt idx="243">
                  <c:v>72.5</c:v>
                </c:pt>
                <c:pt idx="244">
                  <c:v>72</c:v>
                </c:pt>
                <c:pt idx="245">
                  <c:v>71.5</c:v>
                </c:pt>
                <c:pt idx="246">
                  <c:v>71.376000000000005</c:v>
                </c:pt>
                <c:pt idx="247">
                  <c:v>71</c:v>
                </c:pt>
                <c:pt idx="248">
                  <c:v>70.5</c:v>
                </c:pt>
                <c:pt idx="249">
                  <c:v>70</c:v>
                </c:pt>
                <c:pt idx="250">
                  <c:v>69.5</c:v>
                </c:pt>
                <c:pt idx="251">
                  <c:v>69</c:v>
                </c:pt>
                <c:pt idx="252">
                  <c:v>68.5</c:v>
                </c:pt>
                <c:pt idx="253">
                  <c:v>68</c:v>
                </c:pt>
                <c:pt idx="254">
                  <c:v>67.5</c:v>
                </c:pt>
                <c:pt idx="255">
                  <c:v>67</c:v>
                </c:pt>
                <c:pt idx="256">
                  <c:v>66.5</c:v>
                </c:pt>
                <c:pt idx="257">
                  <c:v>66</c:v>
                </c:pt>
                <c:pt idx="258">
                  <c:v>65.5</c:v>
                </c:pt>
                <c:pt idx="259">
                  <c:v>65</c:v>
                </c:pt>
                <c:pt idx="260">
                  <c:v>64.5</c:v>
                </c:pt>
                <c:pt idx="261">
                  <c:v>64</c:v>
                </c:pt>
                <c:pt idx="262">
                  <c:v>63.5</c:v>
                </c:pt>
                <c:pt idx="263">
                  <c:v>63</c:v>
                </c:pt>
                <c:pt idx="264">
                  <c:v>62.814</c:v>
                </c:pt>
                <c:pt idx="265">
                  <c:v>62.5</c:v>
                </c:pt>
                <c:pt idx="266">
                  <c:v>62</c:v>
                </c:pt>
                <c:pt idx="267">
                  <c:v>61.5</c:v>
                </c:pt>
                <c:pt idx="268">
                  <c:v>61</c:v>
                </c:pt>
                <c:pt idx="269">
                  <c:v>60.5</c:v>
                </c:pt>
                <c:pt idx="270">
                  <c:v>60</c:v>
                </c:pt>
                <c:pt idx="271">
                  <c:v>59.5</c:v>
                </c:pt>
                <c:pt idx="272">
                  <c:v>59</c:v>
                </c:pt>
                <c:pt idx="273">
                  <c:v>58.5</c:v>
                </c:pt>
                <c:pt idx="274">
                  <c:v>58</c:v>
                </c:pt>
                <c:pt idx="275">
                  <c:v>57.5</c:v>
                </c:pt>
                <c:pt idx="276">
                  <c:v>57</c:v>
                </c:pt>
                <c:pt idx="277">
                  <c:v>56.5</c:v>
                </c:pt>
                <c:pt idx="278">
                  <c:v>56</c:v>
                </c:pt>
                <c:pt idx="279">
                  <c:v>55.5</c:v>
                </c:pt>
                <c:pt idx="280">
                  <c:v>55</c:v>
                </c:pt>
                <c:pt idx="281">
                  <c:v>54.5</c:v>
                </c:pt>
                <c:pt idx="282">
                  <c:v>54</c:v>
                </c:pt>
                <c:pt idx="283">
                  <c:v>53.5</c:v>
                </c:pt>
                <c:pt idx="284">
                  <c:v>53</c:v>
                </c:pt>
                <c:pt idx="285">
                  <c:v>52.5</c:v>
                </c:pt>
                <c:pt idx="286">
                  <c:v>52</c:v>
                </c:pt>
                <c:pt idx="287">
                  <c:v>51.598999999999997</c:v>
                </c:pt>
                <c:pt idx="288">
                  <c:v>51.5</c:v>
                </c:pt>
                <c:pt idx="289">
                  <c:v>51</c:v>
                </c:pt>
                <c:pt idx="290">
                  <c:v>50.5</c:v>
                </c:pt>
                <c:pt idx="291">
                  <c:v>50</c:v>
                </c:pt>
                <c:pt idx="292">
                  <c:v>49.5</c:v>
                </c:pt>
                <c:pt idx="293">
                  <c:v>49</c:v>
                </c:pt>
                <c:pt idx="294">
                  <c:v>48.5</c:v>
                </c:pt>
                <c:pt idx="295">
                  <c:v>48</c:v>
                </c:pt>
                <c:pt idx="296">
                  <c:v>47.5</c:v>
                </c:pt>
                <c:pt idx="297">
                  <c:v>47</c:v>
                </c:pt>
                <c:pt idx="298">
                  <c:v>46.5</c:v>
                </c:pt>
                <c:pt idx="299">
                  <c:v>46</c:v>
                </c:pt>
                <c:pt idx="300">
                  <c:v>45.5</c:v>
                </c:pt>
                <c:pt idx="301">
                  <c:v>45</c:v>
                </c:pt>
                <c:pt idx="302">
                  <c:v>44.5</c:v>
                </c:pt>
                <c:pt idx="303">
                  <c:v>44</c:v>
                </c:pt>
                <c:pt idx="304">
                  <c:v>43.5</c:v>
                </c:pt>
                <c:pt idx="305">
                  <c:v>43</c:v>
                </c:pt>
                <c:pt idx="306">
                  <c:v>42.5</c:v>
                </c:pt>
                <c:pt idx="307">
                  <c:v>42.457999999999998</c:v>
                </c:pt>
                <c:pt idx="308">
                  <c:v>42</c:v>
                </c:pt>
                <c:pt idx="309">
                  <c:v>41.5</c:v>
                </c:pt>
                <c:pt idx="310">
                  <c:v>41</c:v>
                </c:pt>
                <c:pt idx="311">
                  <c:v>40.5</c:v>
                </c:pt>
                <c:pt idx="312">
                  <c:v>40</c:v>
                </c:pt>
                <c:pt idx="313">
                  <c:v>39.5</c:v>
                </c:pt>
                <c:pt idx="314">
                  <c:v>39</c:v>
                </c:pt>
                <c:pt idx="315">
                  <c:v>38.5</c:v>
                </c:pt>
                <c:pt idx="316">
                  <c:v>38</c:v>
                </c:pt>
                <c:pt idx="317">
                  <c:v>37.5</c:v>
                </c:pt>
                <c:pt idx="318">
                  <c:v>37</c:v>
                </c:pt>
                <c:pt idx="319">
                  <c:v>36.5</c:v>
                </c:pt>
                <c:pt idx="320">
                  <c:v>36</c:v>
                </c:pt>
                <c:pt idx="321">
                  <c:v>35.5</c:v>
                </c:pt>
                <c:pt idx="322">
                  <c:v>35</c:v>
                </c:pt>
                <c:pt idx="323">
                  <c:v>34.5</c:v>
                </c:pt>
                <c:pt idx="324">
                  <c:v>34</c:v>
                </c:pt>
                <c:pt idx="325">
                  <c:v>33.5</c:v>
                </c:pt>
                <c:pt idx="326">
                  <c:v>33</c:v>
                </c:pt>
                <c:pt idx="327">
                  <c:v>32.5</c:v>
                </c:pt>
                <c:pt idx="328">
                  <c:v>32</c:v>
                </c:pt>
                <c:pt idx="329">
                  <c:v>31.568000000000001</c:v>
                </c:pt>
                <c:pt idx="330">
                  <c:v>31.5</c:v>
                </c:pt>
                <c:pt idx="331">
                  <c:v>31</c:v>
                </c:pt>
                <c:pt idx="332">
                  <c:v>30.5</c:v>
                </c:pt>
                <c:pt idx="333">
                  <c:v>30</c:v>
                </c:pt>
                <c:pt idx="334">
                  <c:v>29.5</c:v>
                </c:pt>
                <c:pt idx="335">
                  <c:v>29</c:v>
                </c:pt>
                <c:pt idx="336">
                  <c:v>28.5</c:v>
                </c:pt>
                <c:pt idx="337">
                  <c:v>28</c:v>
                </c:pt>
                <c:pt idx="338">
                  <c:v>27.5</c:v>
                </c:pt>
                <c:pt idx="339">
                  <c:v>27</c:v>
                </c:pt>
                <c:pt idx="340">
                  <c:v>26.5</c:v>
                </c:pt>
                <c:pt idx="341">
                  <c:v>26</c:v>
                </c:pt>
                <c:pt idx="342">
                  <c:v>25.5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</c:v>
                </c:pt>
                <c:pt idx="350">
                  <c:v>21.693999999999999</c:v>
                </c:pt>
                <c:pt idx="351">
                  <c:v>21.5</c:v>
                </c:pt>
                <c:pt idx="352">
                  <c:v>21</c:v>
                </c:pt>
                <c:pt idx="353">
                  <c:v>20.5</c:v>
                </c:pt>
                <c:pt idx="354">
                  <c:v>20</c:v>
                </c:pt>
                <c:pt idx="355">
                  <c:v>19.5</c:v>
                </c:pt>
                <c:pt idx="356">
                  <c:v>19</c:v>
                </c:pt>
                <c:pt idx="357">
                  <c:v>18.5</c:v>
                </c:pt>
                <c:pt idx="358">
                  <c:v>18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879</c:v>
                </c:pt>
                <c:pt idx="366">
                  <c:v>14.5</c:v>
                </c:pt>
                <c:pt idx="367">
                  <c:v>14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5</c:v>
                </c:pt>
                <c:pt idx="375">
                  <c:v>10</c:v>
                </c:pt>
                <c:pt idx="376">
                  <c:v>9.5</c:v>
                </c:pt>
                <c:pt idx="377">
                  <c:v>9</c:v>
                </c:pt>
                <c:pt idx="378">
                  <c:v>8.5</c:v>
                </c:pt>
                <c:pt idx="379">
                  <c:v>8.0269999999999992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5</c:v>
                </c:pt>
                <c:pt idx="384">
                  <c:v>6</c:v>
                </c:pt>
                <c:pt idx="385">
                  <c:v>5.5</c:v>
                </c:pt>
                <c:pt idx="386">
                  <c:v>5</c:v>
                </c:pt>
                <c:pt idx="387">
                  <c:v>4.6829999999999998</c:v>
                </c:pt>
                <c:pt idx="388">
                  <c:v>4.5</c:v>
                </c:pt>
                <c:pt idx="389">
                  <c:v>4</c:v>
                </c:pt>
                <c:pt idx="390">
                  <c:v>3.5</c:v>
                </c:pt>
                <c:pt idx="391">
                  <c:v>3</c:v>
                </c:pt>
                <c:pt idx="392">
                  <c:v>2.5</c:v>
                </c:pt>
                <c:pt idx="393">
                  <c:v>2</c:v>
                </c:pt>
                <c:pt idx="394">
                  <c:v>1.8240000000000001</c:v>
                </c:pt>
                <c:pt idx="395">
                  <c:v>1.5</c:v>
                </c:pt>
                <c:pt idx="396">
                  <c:v>1</c:v>
                </c:pt>
                <c:pt idx="397">
                  <c:v>0.53400000000000003</c:v>
                </c:pt>
                <c:pt idx="398">
                  <c:v>0.5</c:v>
                </c:pt>
                <c:pt idx="399">
                  <c:v>0.19800000000000001</c:v>
                </c:pt>
                <c:pt idx="400">
                  <c:v>7.1999999999999995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A88-4DA4-99B1-07BA75EC6953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xVal>
            <c:numRef>
              <c:f>Foglio6!$G$5:$G$406</c:f>
              <c:numCache>
                <c:formatCode>General</c:formatCode>
                <c:ptCount val="402"/>
                <c:pt idx="0">
                  <c:v>0</c:v>
                </c:pt>
                <c:pt idx="1">
                  <c:v>7.1289999999999996</c:v>
                </c:pt>
                <c:pt idx="2">
                  <c:v>14.257</c:v>
                </c:pt>
                <c:pt idx="3">
                  <c:v>21.385999999999999</c:v>
                </c:pt>
                <c:pt idx="4">
                  <c:v>28.513999999999999</c:v>
                </c:pt>
                <c:pt idx="5">
                  <c:v>35.643000000000001</c:v>
                </c:pt>
                <c:pt idx="6">
                  <c:v>42.771000000000001</c:v>
                </c:pt>
                <c:pt idx="7">
                  <c:v>49.9</c:v>
                </c:pt>
                <c:pt idx="8">
                  <c:v>57.027999999999999</c:v>
                </c:pt>
                <c:pt idx="9">
                  <c:v>64.156999999999996</c:v>
                </c:pt>
                <c:pt idx="10">
                  <c:v>71.284999999999997</c:v>
                </c:pt>
                <c:pt idx="11">
                  <c:v>78.414000000000001</c:v>
                </c:pt>
                <c:pt idx="12">
                  <c:v>85.542000000000002</c:v>
                </c:pt>
                <c:pt idx="13">
                  <c:v>92.671000000000006</c:v>
                </c:pt>
                <c:pt idx="14">
                  <c:v>99.799000000000007</c:v>
                </c:pt>
                <c:pt idx="15">
                  <c:v>106.928</c:v>
                </c:pt>
                <c:pt idx="16">
                  <c:v>114.056</c:v>
                </c:pt>
                <c:pt idx="17">
                  <c:v>121.185</c:v>
                </c:pt>
                <c:pt idx="18">
                  <c:v>128.31299999999999</c:v>
                </c:pt>
                <c:pt idx="19">
                  <c:v>135.44200000000001</c:v>
                </c:pt>
                <c:pt idx="20">
                  <c:v>142.57</c:v>
                </c:pt>
                <c:pt idx="21">
                  <c:v>149.69900000000001</c:v>
                </c:pt>
                <c:pt idx="22">
                  <c:v>156.827</c:v>
                </c:pt>
                <c:pt idx="23">
                  <c:v>163.95599999999999</c:v>
                </c:pt>
                <c:pt idx="24">
                  <c:v>171.084</c:v>
                </c:pt>
                <c:pt idx="25">
                  <c:v>178.21299999999999</c:v>
                </c:pt>
                <c:pt idx="26">
                  <c:v>185.34200000000001</c:v>
                </c:pt>
                <c:pt idx="27">
                  <c:v>192.47</c:v>
                </c:pt>
                <c:pt idx="28">
                  <c:v>199.59899999999999</c:v>
                </c:pt>
                <c:pt idx="29">
                  <c:v>206.727</c:v>
                </c:pt>
                <c:pt idx="30">
                  <c:v>213.85599999999999</c:v>
                </c:pt>
                <c:pt idx="31">
                  <c:v>220.98400000000001</c:v>
                </c:pt>
                <c:pt idx="32">
                  <c:v>228.113</c:v>
                </c:pt>
                <c:pt idx="33">
                  <c:v>235.24100000000001</c:v>
                </c:pt>
                <c:pt idx="34">
                  <c:v>242.37</c:v>
                </c:pt>
                <c:pt idx="35">
                  <c:v>249.49799999999999</c:v>
                </c:pt>
                <c:pt idx="36">
                  <c:v>256.62700000000001</c:v>
                </c:pt>
                <c:pt idx="37">
                  <c:v>263.755</c:v>
                </c:pt>
                <c:pt idx="38">
                  <c:v>270.88400000000001</c:v>
                </c:pt>
                <c:pt idx="39">
                  <c:v>278.012</c:v>
                </c:pt>
                <c:pt idx="40">
                  <c:v>285.14100000000002</c:v>
                </c:pt>
                <c:pt idx="41">
                  <c:v>292.26900000000001</c:v>
                </c:pt>
                <c:pt idx="42">
                  <c:v>299.39800000000002</c:v>
                </c:pt>
                <c:pt idx="43">
                  <c:v>306.52600000000001</c:v>
                </c:pt>
                <c:pt idx="44">
                  <c:v>313.65499999999997</c:v>
                </c:pt>
                <c:pt idx="45">
                  <c:v>320.78300000000002</c:v>
                </c:pt>
                <c:pt idx="46">
                  <c:v>327.91199999999998</c:v>
                </c:pt>
                <c:pt idx="47">
                  <c:v>335.04</c:v>
                </c:pt>
                <c:pt idx="48">
                  <c:v>342.16899999999998</c:v>
                </c:pt>
                <c:pt idx="49">
                  <c:v>349.29700000000003</c:v>
                </c:pt>
                <c:pt idx="50">
                  <c:v>356.42599999999999</c:v>
                </c:pt>
                <c:pt idx="51">
                  <c:v>363.55399999999997</c:v>
                </c:pt>
                <c:pt idx="52">
                  <c:v>370.68299999999999</c:v>
                </c:pt>
                <c:pt idx="53">
                  <c:v>377.81200000000001</c:v>
                </c:pt>
                <c:pt idx="54">
                  <c:v>384.94</c:v>
                </c:pt>
                <c:pt idx="55">
                  <c:v>392.06900000000002</c:v>
                </c:pt>
                <c:pt idx="56">
                  <c:v>399.197</c:v>
                </c:pt>
                <c:pt idx="57">
                  <c:v>406.32600000000002</c:v>
                </c:pt>
                <c:pt idx="58">
                  <c:v>413.45400000000001</c:v>
                </c:pt>
                <c:pt idx="59">
                  <c:v>420.58300000000003</c:v>
                </c:pt>
                <c:pt idx="60">
                  <c:v>427.71100000000001</c:v>
                </c:pt>
                <c:pt idx="61">
                  <c:v>434.84</c:v>
                </c:pt>
                <c:pt idx="62">
                  <c:v>441.96800000000002</c:v>
                </c:pt>
                <c:pt idx="63">
                  <c:v>449.09699999999998</c:v>
                </c:pt>
                <c:pt idx="64">
                  <c:v>456.22500000000002</c:v>
                </c:pt>
                <c:pt idx="65">
                  <c:v>463.35399999999998</c:v>
                </c:pt>
                <c:pt idx="66">
                  <c:v>470.48200000000003</c:v>
                </c:pt>
                <c:pt idx="67">
                  <c:v>477.61099999999999</c:v>
                </c:pt>
                <c:pt idx="68">
                  <c:v>484.73899999999998</c:v>
                </c:pt>
                <c:pt idx="69">
                  <c:v>491.86799999999999</c:v>
                </c:pt>
                <c:pt idx="70">
                  <c:v>498.99599999999998</c:v>
                </c:pt>
                <c:pt idx="71">
                  <c:v>506.125</c:v>
                </c:pt>
                <c:pt idx="72">
                  <c:v>513.25300000000004</c:v>
                </c:pt>
                <c:pt idx="73">
                  <c:v>520.38199999999995</c:v>
                </c:pt>
                <c:pt idx="74">
                  <c:v>527.51</c:v>
                </c:pt>
                <c:pt idx="75">
                  <c:v>534.63900000000001</c:v>
                </c:pt>
                <c:pt idx="76">
                  <c:v>541.76700000000005</c:v>
                </c:pt>
                <c:pt idx="77">
                  <c:v>548.89599999999996</c:v>
                </c:pt>
                <c:pt idx="78">
                  <c:v>556.02499999999998</c:v>
                </c:pt>
                <c:pt idx="79">
                  <c:v>563.15300000000002</c:v>
                </c:pt>
                <c:pt idx="80">
                  <c:v>570.28200000000004</c:v>
                </c:pt>
                <c:pt idx="81">
                  <c:v>577.41</c:v>
                </c:pt>
                <c:pt idx="82">
                  <c:v>584.53899999999999</c:v>
                </c:pt>
                <c:pt idx="83">
                  <c:v>591.66700000000003</c:v>
                </c:pt>
                <c:pt idx="84">
                  <c:v>598.79600000000005</c:v>
                </c:pt>
                <c:pt idx="85">
                  <c:v>605.92399999999998</c:v>
                </c:pt>
                <c:pt idx="86">
                  <c:v>613.053</c:v>
                </c:pt>
                <c:pt idx="87">
                  <c:v>620.18100000000004</c:v>
                </c:pt>
                <c:pt idx="88">
                  <c:v>627.30999999999995</c:v>
                </c:pt>
                <c:pt idx="89">
                  <c:v>634.43799999999999</c:v>
                </c:pt>
                <c:pt idx="90">
                  <c:v>641.56700000000001</c:v>
                </c:pt>
                <c:pt idx="91">
                  <c:v>648.69500000000005</c:v>
                </c:pt>
                <c:pt idx="92">
                  <c:v>655.82399999999996</c:v>
                </c:pt>
                <c:pt idx="93">
                  <c:v>662.952</c:v>
                </c:pt>
                <c:pt idx="94">
                  <c:v>670.08100000000002</c:v>
                </c:pt>
                <c:pt idx="95">
                  <c:v>677.20899999999995</c:v>
                </c:pt>
                <c:pt idx="96">
                  <c:v>684.33799999999997</c:v>
                </c:pt>
                <c:pt idx="97">
                  <c:v>691.46600000000001</c:v>
                </c:pt>
                <c:pt idx="98">
                  <c:v>698.59500000000003</c:v>
                </c:pt>
                <c:pt idx="99">
                  <c:v>705.72299999999996</c:v>
                </c:pt>
                <c:pt idx="100">
                  <c:v>712.85199999999998</c:v>
                </c:pt>
                <c:pt idx="101">
                  <c:v>719.98</c:v>
                </c:pt>
                <c:pt idx="102">
                  <c:v>727.10900000000004</c:v>
                </c:pt>
                <c:pt idx="103">
                  <c:v>734.23699999999997</c:v>
                </c:pt>
                <c:pt idx="104">
                  <c:v>741.36599999999999</c:v>
                </c:pt>
                <c:pt idx="105">
                  <c:v>748.495</c:v>
                </c:pt>
                <c:pt idx="106">
                  <c:v>755.62300000000005</c:v>
                </c:pt>
                <c:pt idx="107">
                  <c:v>762.75199999999995</c:v>
                </c:pt>
                <c:pt idx="108">
                  <c:v>769.88</c:v>
                </c:pt>
                <c:pt idx="109">
                  <c:v>777.00900000000001</c:v>
                </c:pt>
                <c:pt idx="110">
                  <c:v>784.13699999999994</c:v>
                </c:pt>
                <c:pt idx="111">
                  <c:v>791.26599999999996</c:v>
                </c:pt>
                <c:pt idx="112">
                  <c:v>798.39400000000001</c:v>
                </c:pt>
                <c:pt idx="113">
                  <c:v>805.52300000000002</c:v>
                </c:pt>
                <c:pt idx="114">
                  <c:v>812.65099999999995</c:v>
                </c:pt>
                <c:pt idx="115">
                  <c:v>819.78</c:v>
                </c:pt>
                <c:pt idx="116">
                  <c:v>826.90800000000002</c:v>
                </c:pt>
                <c:pt idx="117">
                  <c:v>834.03700000000003</c:v>
                </c:pt>
                <c:pt idx="118">
                  <c:v>841.16499999999996</c:v>
                </c:pt>
                <c:pt idx="119">
                  <c:v>848.29399999999998</c:v>
                </c:pt>
                <c:pt idx="120">
                  <c:v>855.42200000000003</c:v>
                </c:pt>
                <c:pt idx="121">
                  <c:v>862.55100000000004</c:v>
                </c:pt>
                <c:pt idx="122">
                  <c:v>869.67899999999997</c:v>
                </c:pt>
                <c:pt idx="123">
                  <c:v>876.80799999999999</c:v>
                </c:pt>
                <c:pt idx="124">
                  <c:v>883.93600000000004</c:v>
                </c:pt>
                <c:pt idx="125">
                  <c:v>891.06500000000005</c:v>
                </c:pt>
                <c:pt idx="126">
                  <c:v>898.19299999999998</c:v>
                </c:pt>
                <c:pt idx="127">
                  <c:v>905.322</c:v>
                </c:pt>
                <c:pt idx="128">
                  <c:v>912.45</c:v>
                </c:pt>
                <c:pt idx="129">
                  <c:v>919.57899999999995</c:v>
                </c:pt>
                <c:pt idx="130">
                  <c:v>926.70799999999997</c:v>
                </c:pt>
                <c:pt idx="131">
                  <c:v>933.83600000000001</c:v>
                </c:pt>
                <c:pt idx="132">
                  <c:v>940.96500000000003</c:v>
                </c:pt>
                <c:pt idx="133">
                  <c:v>948.09299999999996</c:v>
                </c:pt>
                <c:pt idx="134">
                  <c:v>955.22199999999998</c:v>
                </c:pt>
                <c:pt idx="135">
                  <c:v>962.35</c:v>
                </c:pt>
                <c:pt idx="136">
                  <c:v>969.47900000000004</c:v>
                </c:pt>
                <c:pt idx="137">
                  <c:v>976.60699999999997</c:v>
                </c:pt>
                <c:pt idx="138">
                  <c:v>983.73599999999999</c:v>
                </c:pt>
                <c:pt idx="139">
                  <c:v>990.86400000000003</c:v>
                </c:pt>
                <c:pt idx="140">
                  <c:v>997.99300000000005</c:v>
                </c:pt>
                <c:pt idx="141">
                  <c:v>1005.121</c:v>
                </c:pt>
                <c:pt idx="142">
                  <c:v>1012.25</c:v>
                </c:pt>
                <c:pt idx="143">
                  <c:v>1019.378</c:v>
                </c:pt>
                <c:pt idx="144">
                  <c:v>1026.5070000000001</c:v>
                </c:pt>
                <c:pt idx="145">
                  <c:v>1033.635</c:v>
                </c:pt>
                <c:pt idx="146">
                  <c:v>1040.7639999999999</c:v>
                </c:pt>
                <c:pt idx="147">
                  <c:v>1047.8920000000001</c:v>
                </c:pt>
                <c:pt idx="148">
                  <c:v>1055.021</c:v>
                </c:pt>
                <c:pt idx="149">
                  <c:v>1062.1489999999999</c:v>
                </c:pt>
                <c:pt idx="150">
                  <c:v>1069.278</c:v>
                </c:pt>
                <c:pt idx="151">
                  <c:v>1076.4059999999999</c:v>
                </c:pt>
                <c:pt idx="152">
                  <c:v>1083.5350000000001</c:v>
                </c:pt>
                <c:pt idx="153">
                  <c:v>1090.663</c:v>
                </c:pt>
                <c:pt idx="154">
                  <c:v>1097.7919999999999</c:v>
                </c:pt>
                <c:pt idx="155">
                  <c:v>1104.92</c:v>
                </c:pt>
                <c:pt idx="156">
                  <c:v>1112.049</c:v>
                </c:pt>
                <c:pt idx="157">
                  <c:v>1119.1780000000001</c:v>
                </c:pt>
                <c:pt idx="158">
                  <c:v>1126.306</c:v>
                </c:pt>
                <c:pt idx="159">
                  <c:v>1133.4349999999999</c:v>
                </c:pt>
                <c:pt idx="160">
                  <c:v>1134.9380000000001</c:v>
                </c:pt>
                <c:pt idx="161">
                  <c:v>1140.5630000000001</c:v>
                </c:pt>
                <c:pt idx="162">
                  <c:v>1147.692</c:v>
                </c:pt>
                <c:pt idx="163">
                  <c:v>1154.82</c:v>
                </c:pt>
                <c:pt idx="164">
                  <c:v>1161.9490000000001</c:v>
                </c:pt>
                <c:pt idx="165">
                  <c:v>1169.077</c:v>
                </c:pt>
                <c:pt idx="166">
                  <c:v>1176.2059999999999</c:v>
                </c:pt>
                <c:pt idx="167">
                  <c:v>1183.3340000000001</c:v>
                </c:pt>
                <c:pt idx="168">
                  <c:v>1190.463</c:v>
                </c:pt>
                <c:pt idx="169">
                  <c:v>1191.3320000000001</c:v>
                </c:pt>
                <c:pt idx="170">
                  <c:v>1197.5909999999999</c:v>
                </c:pt>
                <c:pt idx="171">
                  <c:v>1200</c:v>
                </c:pt>
                <c:pt idx="172">
                  <c:v>1204.72</c:v>
                </c:pt>
                <c:pt idx="173">
                  <c:v>1211.848</c:v>
                </c:pt>
                <c:pt idx="174">
                  <c:v>1212.4190000000001</c:v>
                </c:pt>
                <c:pt idx="175">
                  <c:v>1218.9770000000001</c:v>
                </c:pt>
                <c:pt idx="176">
                  <c:v>1224.271</c:v>
                </c:pt>
                <c:pt idx="177">
                  <c:v>1226.105</c:v>
                </c:pt>
                <c:pt idx="178">
                  <c:v>1228.6579999999999</c:v>
                </c:pt>
                <c:pt idx="179">
                  <c:v>1231.373</c:v>
                </c:pt>
                <c:pt idx="180">
                  <c:v>1233.2339999999999</c:v>
                </c:pt>
                <c:pt idx="181">
                  <c:v>1236.9010000000001</c:v>
                </c:pt>
                <c:pt idx="182">
                  <c:v>1240.3620000000001</c:v>
                </c:pt>
                <c:pt idx="183">
                  <c:v>1242.3979999999999</c:v>
                </c:pt>
                <c:pt idx="184">
                  <c:v>1246.154</c:v>
                </c:pt>
                <c:pt idx="185">
                  <c:v>1247.491</c:v>
                </c:pt>
                <c:pt idx="186">
                  <c:v>1252.4670000000001</c:v>
                </c:pt>
                <c:pt idx="187">
                  <c:v>1254.6189999999999</c:v>
                </c:pt>
                <c:pt idx="188">
                  <c:v>1257.0530000000001</c:v>
                </c:pt>
                <c:pt idx="189">
                  <c:v>1260.7139999999999</c:v>
                </c:pt>
                <c:pt idx="190">
                  <c:v>1261.748</c:v>
                </c:pt>
                <c:pt idx="191">
                  <c:v>1267.0250000000001</c:v>
                </c:pt>
                <c:pt idx="192">
                  <c:v>1268.876</c:v>
                </c:pt>
                <c:pt idx="193">
                  <c:v>1269.336</c:v>
                </c:pt>
                <c:pt idx="194">
                  <c:v>1272.502</c:v>
                </c:pt>
                <c:pt idx="195">
                  <c:v>1273.646</c:v>
                </c:pt>
                <c:pt idx="196">
                  <c:v>1276.0050000000001</c:v>
                </c:pt>
                <c:pt idx="197">
                  <c:v>1276.4580000000001</c:v>
                </c:pt>
                <c:pt idx="198">
                  <c:v>1278.442</c:v>
                </c:pt>
                <c:pt idx="199">
                  <c:v>1280.499</c:v>
                </c:pt>
                <c:pt idx="200">
                  <c:v>1282.5899999999999</c:v>
                </c:pt>
                <c:pt idx="201">
                  <c:v>1283.133</c:v>
                </c:pt>
                <c:pt idx="202">
                  <c:v>1284.6510000000001</c:v>
                </c:pt>
                <c:pt idx="203">
                  <c:v>1286.876</c:v>
                </c:pt>
                <c:pt idx="204">
                  <c:v>1288.7539999999999</c:v>
                </c:pt>
                <c:pt idx="205">
                  <c:v>1290.2619999999999</c:v>
                </c:pt>
                <c:pt idx="206">
                  <c:v>1291.1310000000001</c:v>
                </c:pt>
                <c:pt idx="207">
                  <c:v>1291.4480000000001</c:v>
                </c:pt>
                <c:pt idx="208">
                  <c:v>1293.635</c:v>
                </c:pt>
                <c:pt idx="209">
                  <c:v>1294.71</c:v>
                </c:pt>
                <c:pt idx="210">
                  <c:v>1296.1279999999999</c:v>
                </c:pt>
                <c:pt idx="211">
                  <c:v>1297.3910000000001</c:v>
                </c:pt>
                <c:pt idx="212">
                  <c:v>1299.127</c:v>
                </c:pt>
                <c:pt idx="213">
                  <c:v>1300.261</c:v>
                </c:pt>
                <c:pt idx="214">
                  <c:v>1302.1189999999999</c:v>
                </c:pt>
                <c:pt idx="215">
                  <c:v>1304.2370000000001</c:v>
                </c:pt>
                <c:pt idx="216">
                  <c:v>1304.519</c:v>
                </c:pt>
                <c:pt idx="217">
                  <c:v>1305.5440000000001</c:v>
                </c:pt>
                <c:pt idx="218">
                  <c:v>1307.3869999999999</c:v>
                </c:pt>
                <c:pt idx="219">
                  <c:v>1310.048</c:v>
                </c:pt>
                <c:pt idx="220">
                  <c:v>1310.4849999999999</c:v>
                </c:pt>
                <c:pt idx="221">
                  <c:v>1311.4549999999999</c:v>
                </c:pt>
                <c:pt idx="222">
                  <c:v>1311.6479999999999</c:v>
                </c:pt>
                <c:pt idx="223">
                  <c:v>1312.0609999999999</c:v>
                </c:pt>
                <c:pt idx="224">
                  <c:v>1312.549</c:v>
                </c:pt>
                <c:pt idx="225">
                  <c:v>1312.944</c:v>
                </c:pt>
                <c:pt idx="226">
                  <c:v>1314.3530000000001</c:v>
                </c:pt>
                <c:pt idx="227">
                  <c:v>1315.08</c:v>
                </c:pt>
                <c:pt idx="228">
                  <c:v>1315.588</c:v>
                </c:pt>
                <c:pt idx="229">
                  <c:v>1316.2739999999999</c:v>
                </c:pt>
                <c:pt idx="230">
                  <c:v>1317.144</c:v>
                </c:pt>
                <c:pt idx="231">
                  <c:v>1317.58</c:v>
                </c:pt>
                <c:pt idx="232">
                  <c:v>1317.9780000000001</c:v>
                </c:pt>
                <c:pt idx="233">
                  <c:v>1318.61</c:v>
                </c:pt>
                <c:pt idx="234">
                  <c:v>1318.7760000000001</c:v>
                </c:pt>
                <c:pt idx="235">
                  <c:v>1319.9559999999999</c:v>
                </c:pt>
                <c:pt idx="236">
                  <c:v>1321.4369999999999</c:v>
                </c:pt>
                <c:pt idx="237">
                  <c:v>1322.058</c:v>
                </c:pt>
                <c:pt idx="238">
                  <c:v>1323.047</c:v>
                </c:pt>
                <c:pt idx="239">
                  <c:v>1324.173</c:v>
                </c:pt>
                <c:pt idx="240">
                  <c:v>1324.749</c:v>
                </c:pt>
                <c:pt idx="241">
                  <c:v>1325.6579999999999</c:v>
                </c:pt>
                <c:pt idx="242">
                  <c:v>1325.905</c:v>
                </c:pt>
                <c:pt idx="243">
                  <c:v>1326.489</c:v>
                </c:pt>
                <c:pt idx="244">
                  <c:v>1327.675</c:v>
                </c:pt>
                <c:pt idx="245">
                  <c:v>1328.144</c:v>
                </c:pt>
                <c:pt idx="246">
                  <c:v>1329.23</c:v>
                </c:pt>
                <c:pt idx="247">
                  <c:v>1329.875</c:v>
                </c:pt>
                <c:pt idx="248">
                  <c:v>1330.1220000000001</c:v>
                </c:pt>
                <c:pt idx="249">
                  <c:v>1330.6510000000001</c:v>
                </c:pt>
                <c:pt idx="250">
                  <c:v>1331.625</c:v>
                </c:pt>
                <c:pt idx="251">
                  <c:v>1331.9860000000001</c:v>
                </c:pt>
                <c:pt idx="252">
                  <c:v>1332.3889999999999</c:v>
                </c:pt>
                <c:pt idx="253">
                  <c:v>1333.0329999999999</c:v>
                </c:pt>
                <c:pt idx="254">
                  <c:v>1333.2550000000001</c:v>
                </c:pt>
                <c:pt idx="255">
                  <c:v>1333.9</c:v>
                </c:pt>
                <c:pt idx="256">
                  <c:v>1334.375</c:v>
                </c:pt>
                <c:pt idx="257">
                  <c:v>1334.68</c:v>
                </c:pt>
                <c:pt idx="258">
                  <c:v>1335.09</c:v>
                </c:pt>
                <c:pt idx="259">
                  <c:v>1335.4110000000001</c:v>
                </c:pt>
                <c:pt idx="260">
                  <c:v>1336.4480000000001</c:v>
                </c:pt>
                <c:pt idx="261">
                  <c:v>1337.15</c:v>
                </c:pt>
                <c:pt idx="262">
                  <c:v>1338.1110000000001</c:v>
                </c:pt>
                <c:pt idx="263">
                  <c:v>1338.963</c:v>
                </c:pt>
                <c:pt idx="264">
                  <c:v>1339.2059999999999</c:v>
                </c:pt>
                <c:pt idx="265">
                  <c:v>1339.6869999999999</c:v>
                </c:pt>
                <c:pt idx="266">
                  <c:v>1340.162</c:v>
                </c:pt>
                <c:pt idx="267">
                  <c:v>1340.7639999999999</c:v>
                </c:pt>
                <c:pt idx="268">
                  <c:v>1341.5650000000001</c:v>
                </c:pt>
                <c:pt idx="269">
                  <c:v>1342.778</c:v>
                </c:pt>
                <c:pt idx="270">
                  <c:v>1343.337</c:v>
                </c:pt>
                <c:pt idx="271">
                  <c:v>1343.568</c:v>
                </c:pt>
                <c:pt idx="272">
                  <c:v>1344.2860000000001</c:v>
                </c:pt>
                <c:pt idx="273">
                  <c:v>1344.6420000000001</c:v>
                </c:pt>
                <c:pt idx="274">
                  <c:v>1345.066</c:v>
                </c:pt>
                <c:pt idx="275">
                  <c:v>1345.345</c:v>
                </c:pt>
                <c:pt idx="276">
                  <c:v>1345.59</c:v>
                </c:pt>
                <c:pt idx="277">
                  <c:v>1345.693</c:v>
                </c:pt>
                <c:pt idx="278">
                  <c:v>1346.3710000000001</c:v>
                </c:pt>
                <c:pt idx="279">
                  <c:v>1346.797</c:v>
                </c:pt>
                <c:pt idx="280">
                  <c:v>1347.29</c:v>
                </c:pt>
                <c:pt idx="281">
                  <c:v>1347.4659999999999</c:v>
                </c:pt>
                <c:pt idx="282">
                  <c:v>1347.5820000000001</c:v>
                </c:pt>
                <c:pt idx="283">
                  <c:v>1347.921</c:v>
                </c:pt>
                <c:pt idx="284">
                  <c:v>1348.383</c:v>
                </c:pt>
                <c:pt idx="285">
                  <c:v>1348.8910000000001</c:v>
                </c:pt>
                <c:pt idx="286">
                  <c:v>1349.7170000000001</c:v>
                </c:pt>
                <c:pt idx="287">
                  <c:v>1350.337</c:v>
                </c:pt>
                <c:pt idx="288">
                  <c:v>1350.835</c:v>
                </c:pt>
                <c:pt idx="289">
                  <c:v>1351.3869999999999</c:v>
                </c:pt>
                <c:pt idx="290">
                  <c:v>1351.8779999999999</c:v>
                </c:pt>
                <c:pt idx="291">
                  <c:v>1352.038</c:v>
                </c:pt>
                <c:pt idx="292">
                  <c:v>1352.4829999999999</c:v>
                </c:pt>
                <c:pt idx="293">
                  <c:v>1352.732</c:v>
                </c:pt>
                <c:pt idx="294">
                  <c:v>1353.3779999999999</c:v>
                </c:pt>
                <c:pt idx="295">
                  <c:v>1353.8019999999999</c:v>
                </c:pt>
                <c:pt idx="296">
                  <c:v>1353.913</c:v>
                </c:pt>
                <c:pt idx="297">
                  <c:v>1354.163</c:v>
                </c:pt>
                <c:pt idx="298">
                  <c:v>1354.356</c:v>
                </c:pt>
                <c:pt idx="299">
                  <c:v>1354.4190000000001</c:v>
                </c:pt>
                <c:pt idx="300">
                  <c:v>1354.826</c:v>
                </c:pt>
                <c:pt idx="301">
                  <c:v>1355.069</c:v>
                </c:pt>
                <c:pt idx="302">
                  <c:v>1355.6410000000001</c:v>
                </c:pt>
                <c:pt idx="303">
                  <c:v>1356.096</c:v>
                </c:pt>
                <c:pt idx="304">
                  <c:v>1356.473</c:v>
                </c:pt>
                <c:pt idx="305">
                  <c:v>1356.7909999999999</c:v>
                </c:pt>
                <c:pt idx="306">
                  <c:v>1357.415</c:v>
                </c:pt>
                <c:pt idx="307">
                  <c:v>1357.627</c:v>
                </c:pt>
                <c:pt idx="308">
                  <c:v>1358.088</c:v>
                </c:pt>
                <c:pt idx="309">
                  <c:v>1358.5719999999999</c:v>
                </c:pt>
                <c:pt idx="310">
                  <c:v>1359.029</c:v>
                </c:pt>
                <c:pt idx="311">
                  <c:v>1359.356</c:v>
                </c:pt>
                <c:pt idx="312">
                  <c:v>1359.9670000000001</c:v>
                </c:pt>
                <c:pt idx="313">
                  <c:v>1360.3040000000001</c:v>
                </c:pt>
                <c:pt idx="314">
                  <c:v>1360.664</c:v>
                </c:pt>
                <c:pt idx="315">
                  <c:v>1360.8309999999999</c:v>
                </c:pt>
                <c:pt idx="316">
                  <c:v>1361.11</c:v>
                </c:pt>
                <c:pt idx="317">
                  <c:v>1361.364</c:v>
                </c:pt>
                <c:pt idx="318">
                  <c:v>1361.547</c:v>
                </c:pt>
                <c:pt idx="319">
                  <c:v>1361.789</c:v>
                </c:pt>
                <c:pt idx="320">
                  <c:v>1361.933</c:v>
                </c:pt>
                <c:pt idx="321">
                  <c:v>1362.078</c:v>
                </c:pt>
                <c:pt idx="322">
                  <c:v>1362.1980000000001</c:v>
                </c:pt>
                <c:pt idx="323">
                  <c:v>1362.481</c:v>
                </c:pt>
                <c:pt idx="324">
                  <c:v>1362.9549999999999</c:v>
                </c:pt>
                <c:pt idx="325">
                  <c:v>1363.2639999999999</c:v>
                </c:pt>
                <c:pt idx="326">
                  <c:v>1363.6030000000001</c:v>
                </c:pt>
                <c:pt idx="327">
                  <c:v>1363.7750000000001</c:v>
                </c:pt>
                <c:pt idx="328">
                  <c:v>1364.222</c:v>
                </c:pt>
                <c:pt idx="329">
                  <c:v>1364.79</c:v>
                </c:pt>
                <c:pt idx="330">
                  <c:v>1364.9970000000001</c:v>
                </c:pt>
                <c:pt idx="331">
                  <c:v>1365.59</c:v>
                </c:pt>
                <c:pt idx="332">
                  <c:v>1365.895</c:v>
                </c:pt>
                <c:pt idx="333">
                  <c:v>1366.105</c:v>
                </c:pt>
                <c:pt idx="334">
                  <c:v>1366.395</c:v>
                </c:pt>
                <c:pt idx="335">
                  <c:v>1366.7270000000001</c:v>
                </c:pt>
                <c:pt idx="336">
                  <c:v>1367.38</c:v>
                </c:pt>
                <c:pt idx="337">
                  <c:v>1367.5530000000001</c:v>
                </c:pt>
                <c:pt idx="338">
                  <c:v>1367.7660000000001</c:v>
                </c:pt>
                <c:pt idx="339">
                  <c:v>1367.9570000000001</c:v>
                </c:pt>
                <c:pt idx="340">
                  <c:v>1368.597</c:v>
                </c:pt>
                <c:pt idx="341">
                  <c:v>1368.6759999999999</c:v>
                </c:pt>
                <c:pt idx="342">
                  <c:v>1368.999</c:v>
                </c:pt>
                <c:pt idx="343">
                  <c:v>1369.155</c:v>
                </c:pt>
                <c:pt idx="344">
                  <c:v>1369.3679999999999</c:v>
                </c:pt>
                <c:pt idx="345">
                  <c:v>1369.665</c:v>
                </c:pt>
                <c:pt idx="346">
                  <c:v>1370.421</c:v>
                </c:pt>
                <c:pt idx="347">
                  <c:v>1370.788</c:v>
                </c:pt>
                <c:pt idx="348">
                  <c:v>1371.1759999999999</c:v>
                </c:pt>
                <c:pt idx="349">
                  <c:v>1371.471</c:v>
                </c:pt>
                <c:pt idx="350">
                  <c:v>1371.636</c:v>
                </c:pt>
                <c:pt idx="351">
                  <c:v>1371.9390000000001</c:v>
                </c:pt>
                <c:pt idx="352">
                  <c:v>1372.4459999999999</c:v>
                </c:pt>
                <c:pt idx="353">
                  <c:v>1373.0360000000001</c:v>
                </c:pt>
                <c:pt idx="354">
                  <c:v>1373.2829999999999</c:v>
                </c:pt>
                <c:pt idx="355">
                  <c:v>1373.4670000000001</c:v>
                </c:pt>
                <c:pt idx="356">
                  <c:v>1373.61</c:v>
                </c:pt>
                <c:pt idx="357">
                  <c:v>1373.8230000000001</c:v>
                </c:pt>
                <c:pt idx="358">
                  <c:v>1374.481</c:v>
                </c:pt>
                <c:pt idx="359">
                  <c:v>1374.6679999999999</c:v>
                </c:pt>
                <c:pt idx="360">
                  <c:v>1374.9079999999999</c:v>
                </c:pt>
                <c:pt idx="361">
                  <c:v>1375.394</c:v>
                </c:pt>
                <c:pt idx="362">
                  <c:v>1375.6010000000001</c:v>
                </c:pt>
                <c:pt idx="363">
                  <c:v>1375.7829999999999</c:v>
                </c:pt>
                <c:pt idx="364">
                  <c:v>1375.8040000000001</c:v>
                </c:pt>
                <c:pt idx="365">
                  <c:v>1376.3510000000001</c:v>
                </c:pt>
                <c:pt idx="366">
                  <c:v>1377.3879999999999</c:v>
                </c:pt>
                <c:pt idx="367">
                  <c:v>1377.6420000000001</c:v>
                </c:pt>
                <c:pt idx="368">
                  <c:v>1378.19</c:v>
                </c:pt>
                <c:pt idx="369">
                  <c:v>1379.385</c:v>
                </c:pt>
                <c:pt idx="370">
                  <c:v>1380.069</c:v>
                </c:pt>
                <c:pt idx="371">
                  <c:v>1380.979</c:v>
                </c:pt>
                <c:pt idx="372">
                  <c:v>1381.3969999999999</c:v>
                </c:pt>
                <c:pt idx="373">
                  <c:v>1381.799</c:v>
                </c:pt>
                <c:pt idx="374">
                  <c:v>1382.12</c:v>
                </c:pt>
                <c:pt idx="375">
                  <c:v>1382.7729999999999</c:v>
                </c:pt>
                <c:pt idx="376">
                  <c:v>1382.933</c:v>
                </c:pt>
                <c:pt idx="377">
                  <c:v>1384.0029999999999</c:v>
                </c:pt>
                <c:pt idx="378">
                  <c:v>1385.4480000000001</c:v>
                </c:pt>
                <c:pt idx="379">
                  <c:v>1386.739</c:v>
                </c:pt>
                <c:pt idx="380">
                  <c:v>1387.3389999999999</c:v>
                </c:pt>
                <c:pt idx="381">
                  <c:v>1387.9549999999999</c:v>
                </c:pt>
                <c:pt idx="382">
                  <c:v>1388.3820000000001</c:v>
                </c:pt>
                <c:pt idx="383">
                  <c:v>1389.674</c:v>
                </c:pt>
                <c:pt idx="384">
                  <c:v>1390.0609999999999</c:v>
                </c:pt>
                <c:pt idx="385">
                  <c:v>1390.3589999999999</c:v>
                </c:pt>
                <c:pt idx="386">
                  <c:v>1391.096</c:v>
                </c:pt>
                <c:pt idx="387">
                  <c:v>1391.4159999999999</c:v>
                </c:pt>
                <c:pt idx="388">
                  <c:v>1392.606</c:v>
                </c:pt>
                <c:pt idx="389">
                  <c:v>1394.2619999999999</c:v>
                </c:pt>
                <c:pt idx="390">
                  <c:v>1395.6479999999999</c:v>
                </c:pt>
                <c:pt idx="391">
                  <c:v>1397.19</c:v>
                </c:pt>
                <c:pt idx="392">
                  <c:v>1397.998</c:v>
                </c:pt>
                <c:pt idx="393">
                  <c:v>1399.7619999999999</c:v>
                </c:pt>
                <c:pt idx="394">
                  <c:v>1403.7</c:v>
                </c:pt>
                <c:pt idx="395">
                  <c:v>1404.318</c:v>
                </c:pt>
                <c:pt idx="396">
                  <c:v>1410.6569999999999</c:v>
                </c:pt>
                <c:pt idx="397">
                  <c:v>1411.4469999999999</c:v>
                </c:pt>
                <c:pt idx="398">
                  <c:v>1413.828</c:v>
                </c:pt>
                <c:pt idx="399">
                  <c:v>1418.575</c:v>
                </c:pt>
                <c:pt idx="400">
                  <c:v>1425.704</c:v>
                </c:pt>
                <c:pt idx="401">
                  <c:v>1425.704</c:v>
                </c:pt>
              </c:numCache>
            </c:numRef>
          </c:xVal>
          <c:yVal>
            <c:numRef>
              <c:f>Foglio6!$H$5:$H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99.988</c:v>
                </c:pt>
                <c:pt idx="162">
                  <c:v>99.983000000000004</c:v>
                </c:pt>
                <c:pt idx="163">
                  <c:v>99.977999999999994</c:v>
                </c:pt>
                <c:pt idx="164">
                  <c:v>99.975999999999999</c:v>
                </c:pt>
                <c:pt idx="165">
                  <c:v>99.888999999999996</c:v>
                </c:pt>
                <c:pt idx="166">
                  <c:v>99.748999999999995</c:v>
                </c:pt>
                <c:pt idx="167">
                  <c:v>99.716999999999999</c:v>
                </c:pt>
                <c:pt idx="168">
                  <c:v>99.521000000000001</c:v>
                </c:pt>
                <c:pt idx="169">
                  <c:v>99.5</c:v>
                </c:pt>
                <c:pt idx="170">
                  <c:v>99.091999999999999</c:v>
                </c:pt>
                <c:pt idx="171">
                  <c:v>99</c:v>
                </c:pt>
                <c:pt idx="172">
                  <c:v>98.718000000000004</c:v>
                </c:pt>
                <c:pt idx="173">
                  <c:v>98.516999999999996</c:v>
                </c:pt>
                <c:pt idx="174">
                  <c:v>98.5</c:v>
                </c:pt>
                <c:pt idx="175">
                  <c:v>98.254000000000005</c:v>
                </c:pt>
                <c:pt idx="176">
                  <c:v>98</c:v>
                </c:pt>
                <c:pt idx="177">
                  <c:v>97.921000000000006</c:v>
                </c:pt>
                <c:pt idx="178">
                  <c:v>97.5</c:v>
                </c:pt>
                <c:pt idx="179">
                  <c:v>97</c:v>
                </c:pt>
                <c:pt idx="180">
                  <c:v>96.864000000000004</c:v>
                </c:pt>
                <c:pt idx="181">
                  <c:v>96.5</c:v>
                </c:pt>
                <c:pt idx="182">
                  <c:v>96.182000000000002</c:v>
                </c:pt>
                <c:pt idx="183">
                  <c:v>96</c:v>
                </c:pt>
                <c:pt idx="184">
                  <c:v>95.5</c:v>
                </c:pt>
                <c:pt idx="185">
                  <c:v>95.304000000000002</c:v>
                </c:pt>
                <c:pt idx="186">
                  <c:v>95</c:v>
                </c:pt>
                <c:pt idx="187">
                  <c:v>94.873000000000005</c:v>
                </c:pt>
                <c:pt idx="188">
                  <c:v>94.5</c:v>
                </c:pt>
                <c:pt idx="189">
                  <c:v>94</c:v>
                </c:pt>
                <c:pt idx="190">
                  <c:v>93.849000000000004</c:v>
                </c:pt>
                <c:pt idx="191">
                  <c:v>93.5</c:v>
                </c:pt>
                <c:pt idx="192">
                  <c:v>93.168000000000006</c:v>
                </c:pt>
                <c:pt idx="193">
                  <c:v>93</c:v>
                </c:pt>
                <c:pt idx="194">
                  <c:v>92.5</c:v>
                </c:pt>
                <c:pt idx="195">
                  <c:v>92</c:v>
                </c:pt>
                <c:pt idx="196">
                  <c:v>91.616</c:v>
                </c:pt>
                <c:pt idx="197">
                  <c:v>91.5</c:v>
                </c:pt>
                <c:pt idx="198">
                  <c:v>91</c:v>
                </c:pt>
                <c:pt idx="199">
                  <c:v>90.5</c:v>
                </c:pt>
                <c:pt idx="200">
                  <c:v>90</c:v>
                </c:pt>
                <c:pt idx="201">
                  <c:v>89.914000000000001</c:v>
                </c:pt>
                <c:pt idx="202">
                  <c:v>89.5</c:v>
                </c:pt>
                <c:pt idx="203">
                  <c:v>89</c:v>
                </c:pt>
                <c:pt idx="204">
                  <c:v>88.5</c:v>
                </c:pt>
                <c:pt idx="205">
                  <c:v>88.177000000000007</c:v>
                </c:pt>
                <c:pt idx="206">
                  <c:v>88</c:v>
                </c:pt>
                <c:pt idx="207">
                  <c:v>87.5</c:v>
                </c:pt>
                <c:pt idx="208">
                  <c:v>87</c:v>
                </c:pt>
                <c:pt idx="209">
                  <c:v>86.5</c:v>
                </c:pt>
                <c:pt idx="210">
                  <c:v>86</c:v>
                </c:pt>
                <c:pt idx="211">
                  <c:v>85.819000000000003</c:v>
                </c:pt>
                <c:pt idx="212">
                  <c:v>85.5</c:v>
                </c:pt>
                <c:pt idx="213">
                  <c:v>85</c:v>
                </c:pt>
                <c:pt idx="214">
                  <c:v>84.5</c:v>
                </c:pt>
                <c:pt idx="215">
                  <c:v>84</c:v>
                </c:pt>
                <c:pt idx="216">
                  <c:v>83.917000000000002</c:v>
                </c:pt>
                <c:pt idx="217">
                  <c:v>83.5</c:v>
                </c:pt>
                <c:pt idx="218">
                  <c:v>83</c:v>
                </c:pt>
                <c:pt idx="219">
                  <c:v>82.5</c:v>
                </c:pt>
                <c:pt idx="220">
                  <c:v>82</c:v>
                </c:pt>
                <c:pt idx="221">
                  <c:v>81.5</c:v>
                </c:pt>
                <c:pt idx="222">
                  <c:v>81.17</c:v>
                </c:pt>
                <c:pt idx="223">
                  <c:v>81</c:v>
                </c:pt>
                <c:pt idx="224">
                  <c:v>80.5</c:v>
                </c:pt>
                <c:pt idx="225">
                  <c:v>80</c:v>
                </c:pt>
                <c:pt idx="226">
                  <c:v>79.5</c:v>
                </c:pt>
                <c:pt idx="227">
                  <c:v>79</c:v>
                </c:pt>
                <c:pt idx="228">
                  <c:v>78.5</c:v>
                </c:pt>
                <c:pt idx="229">
                  <c:v>78</c:v>
                </c:pt>
                <c:pt idx="230">
                  <c:v>77.5</c:v>
                </c:pt>
                <c:pt idx="231">
                  <c:v>77</c:v>
                </c:pt>
                <c:pt idx="232">
                  <c:v>76.5</c:v>
                </c:pt>
                <c:pt idx="233">
                  <c:v>76</c:v>
                </c:pt>
                <c:pt idx="234">
                  <c:v>75.962000000000003</c:v>
                </c:pt>
                <c:pt idx="235">
                  <c:v>75.5</c:v>
                </c:pt>
                <c:pt idx="236">
                  <c:v>75</c:v>
                </c:pt>
                <c:pt idx="237">
                  <c:v>74.5</c:v>
                </c:pt>
                <c:pt idx="238">
                  <c:v>74</c:v>
                </c:pt>
                <c:pt idx="239">
                  <c:v>73.5</c:v>
                </c:pt>
                <c:pt idx="240">
                  <c:v>73</c:v>
                </c:pt>
                <c:pt idx="241">
                  <c:v>72.5</c:v>
                </c:pt>
                <c:pt idx="242">
                  <c:v>72.278999999999996</c:v>
                </c:pt>
                <c:pt idx="243">
                  <c:v>72</c:v>
                </c:pt>
                <c:pt idx="244">
                  <c:v>71.5</c:v>
                </c:pt>
                <c:pt idx="245">
                  <c:v>71</c:v>
                </c:pt>
                <c:pt idx="246">
                  <c:v>70.5</c:v>
                </c:pt>
                <c:pt idx="247">
                  <c:v>70</c:v>
                </c:pt>
                <c:pt idx="248">
                  <c:v>69.5</c:v>
                </c:pt>
                <c:pt idx="249">
                  <c:v>69</c:v>
                </c:pt>
                <c:pt idx="250">
                  <c:v>68.5</c:v>
                </c:pt>
                <c:pt idx="251">
                  <c:v>68</c:v>
                </c:pt>
                <c:pt idx="252">
                  <c:v>67.5</c:v>
                </c:pt>
                <c:pt idx="253">
                  <c:v>67.123999999999995</c:v>
                </c:pt>
                <c:pt idx="254">
                  <c:v>67</c:v>
                </c:pt>
                <c:pt idx="255">
                  <c:v>66.5</c:v>
                </c:pt>
                <c:pt idx="256">
                  <c:v>66</c:v>
                </c:pt>
                <c:pt idx="257">
                  <c:v>65.5</c:v>
                </c:pt>
                <c:pt idx="258">
                  <c:v>65</c:v>
                </c:pt>
                <c:pt idx="259">
                  <c:v>64.5</c:v>
                </c:pt>
                <c:pt idx="260">
                  <c:v>64</c:v>
                </c:pt>
                <c:pt idx="261">
                  <c:v>63.5</c:v>
                </c:pt>
                <c:pt idx="262">
                  <c:v>63</c:v>
                </c:pt>
                <c:pt idx="263">
                  <c:v>62.5</c:v>
                </c:pt>
                <c:pt idx="264">
                  <c:v>62</c:v>
                </c:pt>
                <c:pt idx="265">
                  <c:v>61.5</c:v>
                </c:pt>
                <c:pt idx="266">
                  <c:v>61.335000000000001</c:v>
                </c:pt>
                <c:pt idx="267">
                  <c:v>61</c:v>
                </c:pt>
                <c:pt idx="268">
                  <c:v>60.5</c:v>
                </c:pt>
                <c:pt idx="269">
                  <c:v>60</c:v>
                </c:pt>
                <c:pt idx="270">
                  <c:v>59.5</c:v>
                </c:pt>
                <c:pt idx="271">
                  <c:v>59</c:v>
                </c:pt>
                <c:pt idx="272">
                  <c:v>58.5</c:v>
                </c:pt>
                <c:pt idx="273">
                  <c:v>58</c:v>
                </c:pt>
                <c:pt idx="274">
                  <c:v>57.5</c:v>
                </c:pt>
                <c:pt idx="275">
                  <c:v>57</c:v>
                </c:pt>
                <c:pt idx="276">
                  <c:v>56.5</c:v>
                </c:pt>
                <c:pt idx="277">
                  <c:v>56</c:v>
                </c:pt>
                <c:pt idx="278">
                  <c:v>55.5</c:v>
                </c:pt>
                <c:pt idx="279">
                  <c:v>55</c:v>
                </c:pt>
                <c:pt idx="280">
                  <c:v>54.661999999999999</c:v>
                </c:pt>
                <c:pt idx="281">
                  <c:v>54.5</c:v>
                </c:pt>
                <c:pt idx="282">
                  <c:v>54</c:v>
                </c:pt>
                <c:pt idx="283">
                  <c:v>53.5</c:v>
                </c:pt>
                <c:pt idx="284">
                  <c:v>53</c:v>
                </c:pt>
                <c:pt idx="285">
                  <c:v>52.5</c:v>
                </c:pt>
                <c:pt idx="286">
                  <c:v>52</c:v>
                </c:pt>
                <c:pt idx="287">
                  <c:v>51.5</c:v>
                </c:pt>
                <c:pt idx="288">
                  <c:v>51</c:v>
                </c:pt>
                <c:pt idx="289">
                  <c:v>50.5</c:v>
                </c:pt>
                <c:pt idx="290">
                  <c:v>50</c:v>
                </c:pt>
                <c:pt idx="291">
                  <c:v>49.5</c:v>
                </c:pt>
                <c:pt idx="292">
                  <c:v>49</c:v>
                </c:pt>
                <c:pt idx="293">
                  <c:v>48.5</c:v>
                </c:pt>
                <c:pt idx="294">
                  <c:v>48</c:v>
                </c:pt>
                <c:pt idx="295">
                  <c:v>47.5</c:v>
                </c:pt>
                <c:pt idx="296">
                  <c:v>47</c:v>
                </c:pt>
                <c:pt idx="297">
                  <c:v>46.5</c:v>
                </c:pt>
                <c:pt idx="298">
                  <c:v>46</c:v>
                </c:pt>
                <c:pt idx="299">
                  <c:v>45.966999999999999</c:v>
                </c:pt>
                <c:pt idx="300">
                  <c:v>45.5</c:v>
                </c:pt>
                <c:pt idx="301">
                  <c:v>45</c:v>
                </c:pt>
                <c:pt idx="302">
                  <c:v>44.5</c:v>
                </c:pt>
                <c:pt idx="303">
                  <c:v>44</c:v>
                </c:pt>
                <c:pt idx="304">
                  <c:v>43.5</c:v>
                </c:pt>
                <c:pt idx="305">
                  <c:v>43</c:v>
                </c:pt>
                <c:pt idx="306">
                  <c:v>42.5</c:v>
                </c:pt>
                <c:pt idx="307">
                  <c:v>42</c:v>
                </c:pt>
                <c:pt idx="308">
                  <c:v>41.5</c:v>
                </c:pt>
                <c:pt idx="309">
                  <c:v>41</c:v>
                </c:pt>
                <c:pt idx="310">
                  <c:v>40.5</c:v>
                </c:pt>
                <c:pt idx="311">
                  <c:v>40</c:v>
                </c:pt>
                <c:pt idx="312">
                  <c:v>39.5</c:v>
                </c:pt>
                <c:pt idx="313">
                  <c:v>39</c:v>
                </c:pt>
                <c:pt idx="314">
                  <c:v>38.5</c:v>
                </c:pt>
                <c:pt idx="315">
                  <c:v>38</c:v>
                </c:pt>
                <c:pt idx="316">
                  <c:v>37.5</c:v>
                </c:pt>
                <c:pt idx="317">
                  <c:v>37</c:v>
                </c:pt>
                <c:pt idx="318">
                  <c:v>36.933</c:v>
                </c:pt>
                <c:pt idx="319">
                  <c:v>36.5</c:v>
                </c:pt>
                <c:pt idx="320">
                  <c:v>36</c:v>
                </c:pt>
                <c:pt idx="321">
                  <c:v>35.5</c:v>
                </c:pt>
                <c:pt idx="322">
                  <c:v>35</c:v>
                </c:pt>
                <c:pt idx="323">
                  <c:v>34.5</c:v>
                </c:pt>
                <c:pt idx="324">
                  <c:v>34</c:v>
                </c:pt>
                <c:pt idx="325">
                  <c:v>33.5</c:v>
                </c:pt>
                <c:pt idx="326">
                  <c:v>33</c:v>
                </c:pt>
                <c:pt idx="327">
                  <c:v>32.5</c:v>
                </c:pt>
                <c:pt idx="328">
                  <c:v>32</c:v>
                </c:pt>
                <c:pt idx="329">
                  <c:v>31.5</c:v>
                </c:pt>
                <c:pt idx="330">
                  <c:v>31</c:v>
                </c:pt>
                <c:pt idx="331">
                  <c:v>30.5</c:v>
                </c:pt>
                <c:pt idx="332">
                  <c:v>30</c:v>
                </c:pt>
                <c:pt idx="333">
                  <c:v>29.5</c:v>
                </c:pt>
                <c:pt idx="334">
                  <c:v>29</c:v>
                </c:pt>
                <c:pt idx="335">
                  <c:v>28.5</c:v>
                </c:pt>
                <c:pt idx="336">
                  <c:v>28</c:v>
                </c:pt>
                <c:pt idx="337">
                  <c:v>27.5</c:v>
                </c:pt>
                <c:pt idx="338">
                  <c:v>27</c:v>
                </c:pt>
                <c:pt idx="339">
                  <c:v>26.5</c:v>
                </c:pt>
                <c:pt idx="340">
                  <c:v>26</c:v>
                </c:pt>
                <c:pt idx="341">
                  <c:v>25.925999999999998</c:v>
                </c:pt>
                <c:pt idx="342">
                  <c:v>25.5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</c:v>
                </c:pt>
                <c:pt idx="350">
                  <c:v>21.5</c:v>
                </c:pt>
                <c:pt idx="351">
                  <c:v>21</c:v>
                </c:pt>
                <c:pt idx="352">
                  <c:v>20.5</c:v>
                </c:pt>
                <c:pt idx="353">
                  <c:v>20</c:v>
                </c:pt>
                <c:pt idx="354">
                  <c:v>19.5</c:v>
                </c:pt>
                <c:pt idx="355">
                  <c:v>19</c:v>
                </c:pt>
                <c:pt idx="356">
                  <c:v>18.5</c:v>
                </c:pt>
                <c:pt idx="357">
                  <c:v>18</c:v>
                </c:pt>
                <c:pt idx="358">
                  <c:v>17.5</c:v>
                </c:pt>
                <c:pt idx="359">
                  <c:v>17</c:v>
                </c:pt>
                <c:pt idx="360">
                  <c:v>16.5</c:v>
                </c:pt>
                <c:pt idx="361">
                  <c:v>16</c:v>
                </c:pt>
                <c:pt idx="362">
                  <c:v>15.5</c:v>
                </c:pt>
                <c:pt idx="363">
                  <c:v>15</c:v>
                </c:pt>
                <c:pt idx="364">
                  <c:v>14.984999999999999</c:v>
                </c:pt>
                <c:pt idx="365">
                  <c:v>14.5</c:v>
                </c:pt>
                <c:pt idx="366">
                  <c:v>14</c:v>
                </c:pt>
                <c:pt idx="367">
                  <c:v>13.5</c:v>
                </c:pt>
                <c:pt idx="368">
                  <c:v>13</c:v>
                </c:pt>
                <c:pt idx="369">
                  <c:v>12.5</c:v>
                </c:pt>
                <c:pt idx="370">
                  <c:v>12</c:v>
                </c:pt>
                <c:pt idx="371">
                  <c:v>11.5</c:v>
                </c:pt>
                <c:pt idx="372">
                  <c:v>11</c:v>
                </c:pt>
                <c:pt idx="373">
                  <c:v>10.5</c:v>
                </c:pt>
                <c:pt idx="374">
                  <c:v>10</c:v>
                </c:pt>
                <c:pt idx="375">
                  <c:v>9.5</c:v>
                </c:pt>
                <c:pt idx="376">
                  <c:v>9.3889999999999993</c:v>
                </c:pt>
                <c:pt idx="377">
                  <c:v>9</c:v>
                </c:pt>
                <c:pt idx="378">
                  <c:v>8.5</c:v>
                </c:pt>
                <c:pt idx="379">
                  <c:v>8</c:v>
                </c:pt>
                <c:pt idx="380">
                  <c:v>7.5</c:v>
                </c:pt>
                <c:pt idx="381">
                  <c:v>7</c:v>
                </c:pt>
                <c:pt idx="382">
                  <c:v>6.5</c:v>
                </c:pt>
                <c:pt idx="383">
                  <c:v>6</c:v>
                </c:pt>
                <c:pt idx="384">
                  <c:v>5.6520000000000001</c:v>
                </c:pt>
                <c:pt idx="385">
                  <c:v>5.5</c:v>
                </c:pt>
                <c:pt idx="386">
                  <c:v>5</c:v>
                </c:pt>
                <c:pt idx="387">
                  <c:v>4.5</c:v>
                </c:pt>
                <c:pt idx="388">
                  <c:v>4</c:v>
                </c:pt>
                <c:pt idx="389">
                  <c:v>3.5</c:v>
                </c:pt>
                <c:pt idx="390">
                  <c:v>3</c:v>
                </c:pt>
                <c:pt idx="391">
                  <c:v>2.6360000000000001</c:v>
                </c:pt>
                <c:pt idx="392">
                  <c:v>2.5</c:v>
                </c:pt>
                <c:pt idx="393">
                  <c:v>2</c:v>
                </c:pt>
                <c:pt idx="394">
                  <c:v>1.5</c:v>
                </c:pt>
                <c:pt idx="395">
                  <c:v>1.4830000000000001</c:v>
                </c:pt>
                <c:pt idx="396">
                  <c:v>1</c:v>
                </c:pt>
                <c:pt idx="397">
                  <c:v>0.76800000000000002</c:v>
                </c:pt>
                <c:pt idx="398">
                  <c:v>0.5</c:v>
                </c:pt>
                <c:pt idx="399">
                  <c:v>0.16300000000000001</c:v>
                </c:pt>
                <c:pt idx="400">
                  <c:v>7.1999999999999995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A88-4DA4-99B1-07BA75EC6953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I$5:$I$406</c:f>
              <c:numCache>
                <c:formatCode>General</c:formatCode>
                <c:ptCount val="402"/>
                <c:pt idx="0">
                  <c:v>0</c:v>
                </c:pt>
                <c:pt idx="1">
                  <c:v>6.9340000000000002</c:v>
                </c:pt>
                <c:pt idx="2">
                  <c:v>13.868</c:v>
                </c:pt>
                <c:pt idx="3">
                  <c:v>20.802</c:v>
                </c:pt>
                <c:pt idx="4">
                  <c:v>27.736000000000001</c:v>
                </c:pt>
                <c:pt idx="5">
                  <c:v>34.67</c:v>
                </c:pt>
                <c:pt idx="6">
                  <c:v>41.603999999999999</c:v>
                </c:pt>
                <c:pt idx="7">
                  <c:v>48.537999999999997</c:v>
                </c:pt>
                <c:pt idx="8">
                  <c:v>55.472000000000001</c:v>
                </c:pt>
                <c:pt idx="9">
                  <c:v>62.405000000000001</c:v>
                </c:pt>
                <c:pt idx="10">
                  <c:v>69.338999999999999</c:v>
                </c:pt>
                <c:pt idx="11">
                  <c:v>76.272999999999996</c:v>
                </c:pt>
                <c:pt idx="12">
                  <c:v>83.206999999999994</c:v>
                </c:pt>
                <c:pt idx="13">
                  <c:v>90.141000000000005</c:v>
                </c:pt>
                <c:pt idx="14">
                  <c:v>97.075000000000003</c:v>
                </c:pt>
                <c:pt idx="15">
                  <c:v>104.009</c:v>
                </c:pt>
                <c:pt idx="16">
                  <c:v>110.943</c:v>
                </c:pt>
                <c:pt idx="17">
                  <c:v>117.877</c:v>
                </c:pt>
                <c:pt idx="18">
                  <c:v>124.81100000000001</c:v>
                </c:pt>
                <c:pt idx="19">
                  <c:v>131.745</c:v>
                </c:pt>
                <c:pt idx="20">
                  <c:v>138.679</c:v>
                </c:pt>
                <c:pt idx="21">
                  <c:v>145.613</c:v>
                </c:pt>
                <c:pt idx="22">
                  <c:v>152.547</c:v>
                </c:pt>
                <c:pt idx="23">
                  <c:v>159.48099999999999</c:v>
                </c:pt>
                <c:pt idx="24">
                  <c:v>166.41499999999999</c:v>
                </c:pt>
                <c:pt idx="25">
                  <c:v>173.34899999999999</c:v>
                </c:pt>
                <c:pt idx="26">
                  <c:v>180.28200000000001</c:v>
                </c:pt>
                <c:pt idx="27">
                  <c:v>187.21600000000001</c:v>
                </c:pt>
                <c:pt idx="28">
                  <c:v>194.15</c:v>
                </c:pt>
                <c:pt idx="29">
                  <c:v>201.084</c:v>
                </c:pt>
                <c:pt idx="30">
                  <c:v>208.018</c:v>
                </c:pt>
                <c:pt idx="31">
                  <c:v>214.952</c:v>
                </c:pt>
                <c:pt idx="32">
                  <c:v>221.886</c:v>
                </c:pt>
                <c:pt idx="33">
                  <c:v>228.82</c:v>
                </c:pt>
                <c:pt idx="34">
                  <c:v>235.75399999999999</c:v>
                </c:pt>
                <c:pt idx="35">
                  <c:v>242.68799999999999</c:v>
                </c:pt>
                <c:pt idx="36">
                  <c:v>249.62200000000001</c:v>
                </c:pt>
                <c:pt idx="37">
                  <c:v>256.55599999999998</c:v>
                </c:pt>
                <c:pt idx="38">
                  <c:v>263.49</c:v>
                </c:pt>
                <c:pt idx="39">
                  <c:v>270.42399999999998</c:v>
                </c:pt>
                <c:pt idx="40">
                  <c:v>277.358</c:v>
                </c:pt>
                <c:pt idx="41">
                  <c:v>284.29199999999997</c:v>
                </c:pt>
                <c:pt idx="42">
                  <c:v>291.226</c:v>
                </c:pt>
                <c:pt idx="43">
                  <c:v>298.15899999999999</c:v>
                </c:pt>
                <c:pt idx="44">
                  <c:v>305.09300000000002</c:v>
                </c:pt>
                <c:pt idx="45">
                  <c:v>312.02699999999999</c:v>
                </c:pt>
                <c:pt idx="46">
                  <c:v>318.96100000000001</c:v>
                </c:pt>
                <c:pt idx="47">
                  <c:v>325.89499999999998</c:v>
                </c:pt>
                <c:pt idx="48">
                  <c:v>332.82900000000001</c:v>
                </c:pt>
                <c:pt idx="49">
                  <c:v>339.76299999999998</c:v>
                </c:pt>
                <c:pt idx="50">
                  <c:v>346.697</c:v>
                </c:pt>
                <c:pt idx="51">
                  <c:v>353.63099999999997</c:v>
                </c:pt>
                <c:pt idx="52">
                  <c:v>360.565</c:v>
                </c:pt>
                <c:pt idx="53">
                  <c:v>367.49900000000002</c:v>
                </c:pt>
                <c:pt idx="54">
                  <c:v>374.43299999999999</c:v>
                </c:pt>
                <c:pt idx="55">
                  <c:v>381.36700000000002</c:v>
                </c:pt>
                <c:pt idx="56">
                  <c:v>388.30099999999999</c:v>
                </c:pt>
                <c:pt idx="57">
                  <c:v>395.23500000000001</c:v>
                </c:pt>
                <c:pt idx="58">
                  <c:v>402.16899999999998</c:v>
                </c:pt>
                <c:pt idx="59">
                  <c:v>409.10300000000001</c:v>
                </c:pt>
                <c:pt idx="60">
                  <c:v>416.036</c:v>
                </c:pt>
                <c:pt idx="61">
                  <c:v>422.97</c:v>
                </c:pt>
                <c:pt idx="62">
                  <c:v>429.904</c:v>
                </c:pt>
                <c:pt idx="63">
                  <c:v>436.83800000000002</c:v>
                </c:pt>
                <c:pt idx="64">
                  <c:v>443.77199999999999</c:v>
                </c:pt>
                <c:pt idx="65">
                  <c:v>450.70600000000002</c:v>
                </c:pt>
                <c:pt idx="66">
                  <c:v>457.64</c:v>
                </c:pt>
                <c:pt idx="67">
                  <c:v>464.57400000000001</c:v>
                </c:pt>
                <c:pt idx="68">
                  <c:v>471.50799999999998</c:v>
                </c:pt>
                <c:pt idx="69">
                  <c:v>478.44200000000001</c:v>
                </c:pt>
                <c:pt idx="70">
                  <c:v>485.37599999999998</c:v>
                </c:pt>
                <c:pt idx="71">
                  <c:v>492.31</c:v>
                </c:pt>
                <c:pt idx="72">
                  <c:v>499.24400000000003</c:v>
                </c:pt>
                <c:pt idx="73">
                  <c:v>506.178</c:v>
                </c:pt>
                <c:pt idx="74">
                  <c:v>513.11199999999997</c:v>
                </c:pt>
                <c:pt idx="75">
                  <c:v>520.04600000000005</c:v>
                </c:pt>
                <c:pt idx="76">
                  <c:v>526.98</c:v>
                </c:pt>
                <c:pt idx="77">
                  <c:v>533.91300000000001</c:v>
                </c:pt>
                <c:pt idx="78">
                  <c:v>540.84699999999998</c:v>
                </c:pt>
                <c:pt idx="79">
                  <c:v>547.78099999999995</c:v>
                </c:pt>
                <c:pt idx="80">
                  <c:v>554.71500000000003</c:v>
                </c:pt>
                <c:pt idx="81">
                  <c:v>561.649</c:v>
                </c:pt>
                <c:pt idx="82">
                  <c:v>568.58299999999997</c:v>
                </c:pt>
                <c:pt idx="83">
                  <c:v>575.51700000000005</c:v>
                </c:pt>
                <c:pt idx="84">
                  <c:v>582.45100000000002</c:v>
                </c:pt>
                <c:pt idx="85">
                  <c:v>589.38499999999999</c:v>
                </c:pt>
                <c:pt idx="86">
                  <c:v>596.31899999999996</c:v>
                </c:pt>
                <c:pt idx="87">
                  <c:v>603.25300000000004</c:v>
                </c:pt>
                <c:pt idx="88">
                  <c:v>610.18700000000001</c:v>
                </c:pt>
                <c:pt idx="89">
                  <c:v>617.12099999999998</c:v>
                </c:pt>
                <c:pt idx="90">
                  <c:v>624.05499999999995</c:v>
                </c:pt>
                <c:pt idx="91">
                  <c:v>630.98900000000003</c:v>
                </c:pt>
                <c:pt idx="92">
                  <c:v>637.923</c:v>
                </c:pt>
                <c:pt idx="93">
                  <c:v>644.85699999999997</c:v>
                </c:pt>
                <c:pt idx="94">
                  <c:v>651.79</c:v>
                </c:pt>
                <c:pt idx="95">
                  <c:v>658.72400000000005</c:v>
                </c:pt>
                <c:pt idx="96">
                  <c:v>665.65800000000002</c:v>
                </c:pt>
                <c:pt idx="97">
                  <c:v>672.59199999999998</c:v>
                </c:pt>
                <c:pt idx="98">
                  <c:v>679.52599999999995</c:v>
                </c:pt>
                <c:pt idx="99">
                  <c:v>686.46</c:v>
                </c:pt>
                <c:pt idx="100">
                  <c:v>693.39400000000001</c:v>
                </c:pt>
                <c:pt idx="101">
                  <c:v>700.32799999999997</c:v>
                </c:pt>
                <c:pt idx="102">
                  <c:v>707.26199999999994</c:v>
                </c:pt>
                <c:pt idx="103">
                  <c:v>714.19600000000003</c:v>
                </c:pt>
                <c:pt idx="104">
                  <c:v>721.13</c:v>
                </c:pt>
                <c:pt idx="105">
                  <c:v>728.06399999999996</c:v>
                </c:pt>
                <c:pt idx="106">
                  <c:v>734.99800000000005</c:v>
                </c:pt>
                <c:pt idx="107">
                  <c:v>741.93200000000002</c:v>
                </c:pt>
                <c:pt idx="108">
                  <c:v>748.86599999999999</c:v>
                </c:pt>
                <c:pt idx="109">
                  <c:v>755.8</c:v>
                </c:pt>
                <c:pt idx="110">
                  <c:v>762.73400000000004</c:v>
                </c:pt>
                <c:pt idx="111">
                  <c:v>769.66700000000003</c:v>
                </c:pt>
                <c:pt idx="112">
                  <c:v>776.601</c:v>
                </c:pt>
                <c:pt idx="113">
                  <c:v>783.53499999999997</c:v>
                </c:pt>
                <c:pt idx="114">
                  <c:v>790.46900000000005</c:v>
                </c:pt>
                <c:pt idx="115">
                  <c:v>797.40300000000002</c:v>
                </c:pt>
                <c:pt idx="116">
                  <c:v>804.33699999999999</c:v>
                </c:pt>
                <c:pt idx="117">
                  <c:v>811.27099999999996</c:v>
                </c:pt>
                <c:pt idx="118">
                  <c:v>818.20500000000004</c:v>
                </c:pt>
                <c:pt idx="119">
                  <c:v>825.13900000000001</c:v>
                </c:pt>
                <c:pt idx="120">
                  <c:v>832.07299999999998</c:v>
                </c:pt>
                <c:pt idx="121">
                  <c:v>839.00699999999995</c:v>
                </c:pt>
                <c:pt idx="122">
                  <c:v>845.94100000000003</c:v>
                </c:pt>
                <c:pt idx="123">
                  <c:v>852.875</c:v>
                </c:pt>
                <c:pt idx="124">
                  <c:v>859.80899999999997</c:v>
                </c:pt>
                <c:pt idx="125">
                  <c:v>866.74300000000005</c:v>
                </c:pt>
                <c:pt idx="126">
                  <c:v>873.67700000000002</c:v>
                </c:pt>
                <c:pt idx="127">
                  <c:v>880.61099999999999</c:v>
                </c:pt>
                <c:pt idx="128">
                  <c:v>887.54399999999998</c:v>
                </c:pt>
                <c:pt idx="129">
                  <c:v>894.47799999999995</c:v>
                </c:pt>
                <c:pt idx="130">
                  <c:v>901.41200000000003</c:v>
                </c:pt>
                <c:pt idx="131">
                  <c:v>908.346</c:v>
                </c:pt>
                <c:pt idx="132">
                  <c:v>915.28</c:v>
                </c:pt>
                <c:pt idx="133">
                  <c:v>922.21400000000006</c:v>
                </c:pt>
                <c:pt idx="134">
                  <c:v>929.14800000000002</c:v>
                </c:pt>
                <c:pt idx="135">
                  <c:v>936.08199999999999</c:v>
                </c:pt>
                <c:pt idx="136">
                  <c:v>943.01599999999996</c:v>
                </c:pt>
                <c:pt idx="137">
                  <c:v>949.95</c:v>
                </c:pt>
                <c:pt idx="138">
                  <c:v>956.88400000000001</c:v>
                </c:pt>
                <c:pt idx="139">
                  <c:v>963.81799999999998</c:v>
                </c:pt>
                <c:pt idx="140">
                  <c:v>970.75199999999995</c:v>
                </c:pt>
                <c:pt idx="141">
                  <c:v>977.68600000000004</c:v>
                </c:pt>
                <c:pt idx="142">
                  <c:v>984.62</c:v>
                </c:pt>
                <c:pt idx="143">
                  <c:v>991.55399999999997</c:v>
                </c:pt>
                <c:pt idx="144">
                  <c:v>998.48800000000006</c:v>
                </c:pt>
                <c:pt idx="145">
                  <c:v>1005.421</c:v>
                </c:pt>
                <c:pt idx="146">
                  <c:v>1012.355</c:v>
                </c:pt>
                <c:pt idx="147">
                  <c:v>1019.289</c:v>
                </c:pt>
                <c:pt idx="148">
                  <c:v>1026.223</c:v>
                </c:pt>
                <c:pt idx="149">
                  <c:v>1033.1569999999999</c:v>
                </c:pt>
                <c:pt idx="150">
                  <c:v>1040.0909999999999</c:v>
                </c:pt>
                <c:pt idx="151">
                  <c:v>1047.0250000000001</c:v>
                </c:pt>
                <c:pt idx="152">
                  <c:v>1053.9590000000001</c:v>
                </c:pt>
                <c:pt idx="153">
                  <c:v>1060.893</c:v>
                </c:pt>
                <c:pt idx="154">
                  <c:v>1067.827</c:v>
                </c:pt>
                <c:pt idx="155">
                  <c:v>1074.761</c:v>
                </c:pt>
                <c:pt idx="156">
                  <c:v>1081.6949999999999</c:v>
                </c:pt>
                <c:pt idx="157">
                  <c:v>1088.6289999999999</c:v>
                </c:pt>
                <c:pt idx="158">
                  <c:v>1095.5630000000001</c:v>
                </c:pt>
                <c:pt idx="159">
                  <c:v>1102.4970000000001</c:v>
                </c:pt>
                <c:pt idx="160">
                  <c:v>1109.431</c:v>
                </c:pt>
                <c:pt idx="161">
                  <c:v>1116.365</c:v>
                </c:pt>
                <c:pt idx="162">
                  <c:v>1123.298</c:v>
                </c:pt>
                <c:pt idx="163">
                  <c:v>1130.232</c:v>
                </c:pt>
                <c:pt idx="164">
                  <c:v>1137.1659999999999</c:v>
                </c:pt>
                <c:pt idx="165">
                  <c:v>1144.0999999999999</c:v>
                </c:pt>
                <c:pt idx="166">
                  <c:v>1147.9280000000001</c:v>
                </c:pt>
                <c:pt idx="167">
                  <c:v>1151.0340000000001</c:v>
                </c:pt>
                <c:pt idx="168">
                  <c:v>1157.9680000000001</c:v>
                </c:pt>
                <c:pt idx="169">
                  <c:v>1164.902</c:v>
                </c:pt>
                <c:pt idx="170">
                  <c:v>1171.836</c:v>
                </c:pt>
                <c:pt idx="171">
                  <c:v>1178.77</c:v>
                </c:pt>
                <c:pt idx="172">
                  <c:v>1185.704</c:v>
                </c:pt>
                <c:pt idx="173">
                  <c:v>1190.499</c:v>
                </c:pt>
                <c:pt idx="174">
                  <c:v>1192.6379999999999</c:v>
                </c:pt>
                <c:pt idx="175">
                  <c:v>1199.5719999999999</c:v>
                </c:pt>
                <c:pt idx="176">
                  <c:v>1200</c:v>
                </c:pt>
                <c:pt idx="177">
                  <c:v>1206.5060000000001</c:v>
                </c:pt>
                <c:pt idx="178">
                  <c:v>1207.2270000000001</c:v>
                </c:pt>
                <c:pt idx="179">
                  <c:v>1212.088</c:v>
                </c:pt>
                <c:pt idx="180">
                  <c:v>1213.44</c:v>
                </c:pt>
                <c:pt idx="181">
                  <c:v>1220.374</c:v>
                </c:pt>
                <c:pt idx="182">
                  <c:v>1222.4290000000001</c:v>
                </c:pt>
                <c:pt idx="183">
                  <c:v>1224.521</c:v>
                </c:pt>
                <c:pt idx="184">
                  <c:v>1227.308</c:v>
                </c:pt>
                <c:pt idx="185">
                  <c:v>1227.4290000000001</c:v>
                </c:pt>
                <c:pt idx="186">
                  <c:v>1229.675</c:v>
                </c:pt>
                <c:pt idx="187">
                  <c:v>1233.43</c:v>
                </c:pt>
                <c:pt idx="188">
                  <c:v>1234.242</c:v>
                </c:pt>
                <c:pt idx="189">
                  <c:v>1235.769</c:v>
                </c:pt>
                <c:pt idx="190">
                  <c:v>1239.3</c:v>
                </c:pt>
                <c:pt idx="191">
                  <c:v>1241.175</c:v>
                </c:pt>
                <c:pt idx="192">
                  <c:v>1242.1310000000001</c:v>
                </c:pt>
                <c:pt idx="193">
                  <c:v>1243.482</c:v>
                </c:pt>
                <c:pt idx="194">
                  <c:v>1246.2850000000001</c:v>
                </c:pt>
                <c:pt idx="195">
                  <c:v>1248.1089999999999</c:v>
                </c:pt>
                <c:pt idx="196">
                  <c:v>1249.454</c:v>
                </c:pt>
                <c:pt idx="197">
                  <c:v>1250.1210000000001</c:v>
                </c:pt>
                <c:pt idx="198">
                  <c:v>1251.855</c:v>
                </c:pt>
                <c:pt idx="199">
                  <c:v>1254.604</c:v>
                </c:pt>
                <c:pt idx="200">
                  <c:v>1255.0429999999999</c:v>
                </c:pt>
                <c:pt idx="201">
                  <c:v>1257.4839999999999</c:v>
                </c:pt>
                <c:pt idx="202">
                  <c:v>1259.692</c:v>
                </c:pt>
                <c:pt idx="203">
                  <c:v>1260.4760000000001</c:v>
                </c:pt>
                <c:pt idx="204">
                  <c:v>1261.9770000000001</c:v>
                </c:pt>
                <c:pt idx="205">
                  <c:v>1262.817</c:v>
                </c:pt>
                <c:pt idx="206">
                  <c:v>1263.653</c:v>
                </c:pt>
                <c:pt idx="207">
                  <c:v>1266.2760000000001</c:v>
                </c:pt>
                <c:pt idx="208">
                  <c:v>1268.2529999999999</c:v>
                </c:pt>
                <c:pt idx="209">
                  <c:v>1268.9110000000001</c:v>
                </c:pt>
                <c:pt idx="210">
                  <c:v>1269.53</c:v>
                </c:pt>
                <c:pt idx="211">
                  <c:v>1270.7439999999999</c:v>
                </c:pt>
                <c:pt idx="212">
                  <c:v>1271.4459999999999</c:v>
                </c:pt>
                <c:pt idx="213">
                  <c:v>1273.527</c:v>
                </c:pt>
                <c:pt idx="214">
                  <c:v>1275.173</c:v>
                </c:pt>
                <c:pt idx="215">
                  <c:v>1275.845</c:v>
                </c:pt>
                <c:pt idx="216">
                  <c:v>1276.0119999999999</c:v>
                </c:pt>
                <c:pt idx="217">
                  <c:v>1276.74</c:v>
                </c:pt>
                <c:pt idx="218">
                  <c:v>1277.664</c:v>
                </c:pt>
                <c:pt idx="219">
                  <c:v>1278.519</c:v>
                </c:pt>
                <c:pt idx="220">
                  <c:v>1279.4100000000001</c:v>
                </c:pt>
                <c:pt idx="221">
                  <c:v>1280.1880000000001</c:v>
                </c:pt>
                <c:pt idx="222">
                  <c:v>1281.1679999999999</c:v>
                </c:pt>
                <c:pt idx="223">
                  <c:v>1282.008</c:v>
                </c:pt>
                <c:pt idx="224">
                  <c:v>1282.779</c:v>
                </c:pt>
                <c:pt idx="225">
                  <c:v>1282.867</c:v>
                </c:pt>
                <c:pt idx="226">
                  <c:v>1283.944</c:v>
                </c:pt>
                <c:pt idx="227">
                  <c:v>1284.6690000000001</c:v>
                </c:pt>
                <c:pt idx="228">
                  <c:v>1285.211</c:v>
                </c:pt>
                <c:pt idx="229">
                  <c:v>1285.8109999999999</c:v>
                </c:pt>
                <c:pt idx="230">
                  <c:v>1286.8320000000001</c:v>
                </c:pt>
                <c:pt idx="231">
                  <c:v>1287.692</c:v>
                </c:pt>
                <c:pt idx="232">
                  <c:v>1288.2529999999999</c:v>
                </c:pt>
                <c:pt idx="233">
                  <c:v>1288.9939999999999</c:v>
                </c:pt>
                <c:pt idx="234">
                  <c:v>1289.713</c:v>
                </c:pt>
                <c:pt idx="235">
                  <c:v>1289.7149999999999</c:v>
                </c:pt>
                <c:pt idx="236">
                  <c:v>1290.0340000000001</c:v>
                </c:pt>
                <c:pt idx="237">
                  <c:v>1290.595</c:v>
                </c:pt>
                <c:pt idx="238">
                  <c:v>1291.5509999999999</c:v>
                </c:pt>
                <c:pt idx="239">
                  <c:v>1292.42</c:v>
                </c:pt>
                <c:pt idx="240">
                  <c:v>1293.204</c:v>
                </c:pt>
                <c:pt idx="241">
                  <c:v>1293.646</c:v>
                </c:pt>
                <c:pt idx="242">
                  <c:v>1294.3610000000001</c:v>
                </c:pt>
                <c:pt idx="243">
                  <c:v>1295.471</c:v>
                </c:pt>
                <c:pt idx="244">
                  <c:v>1295.6320000000001</c:v>
                </c:pt>
                <c:pt idx="245">
                  <c:v>1295.97</c:v>
                </c:pt>
                <c:pt idx="246">
                  <c:v>1296.23</c:v>
                </c:pt>
                <c:pt idx="247">
                  <c:v>1296.6379999999999</c:v>
                </c:pt>
                <c:pt idx="248">
                  <c:v>1296.6469999999999</c:v>
                </c:pt>
                <c:pt idx="249">
                  <c:v>1296.971</c:v>
                </c:pt>
                <c:pt idx="250">
                  <c:v>1297.4880000000001</c:v>
                </c:pt>
                <c:pt idx="251">
                  <c:v>1298.8499999999999</c:v>
                </c:pt>
                <c:pt idx="252">
                  <c:v>1299.0070000000001</c:v>
                </c:pt>
                <c:pt idx="253">
                  <c:v>1299.614</c:v>
                </c:pt>
                <c:pt idx="254">
                  <c:v>1300.1279999999999</c:v>
                </c:pt>
                <c:pt idx="255">
                  <c:v>1300.579</c:v>
                </c:pt>
                <c:pt idx="256">
                  <c:v>1301.22</c:v>
                </c:pt>
                <c:pt idx="257">
                  <c:v>1301.9190000000001</c:v>
                </c:pt>
                <c:pt idx="258">
                  <c:v>1302.5170000000001</c:v>
                </c:pt>
                <c:pt idx="259">
                  <c:v>1303.058</c:v>
                </c:pt>
                <c:pt idx="260">
                  <c:v>1303.2380000000001</c:v>
                </c:pt>
                <c:pt idx="261">
                  <c:v>1303.402</c:v>
                </c:pt>
                <c:pt idx="262">
                  <c:v>1303.5809999999999</c:v>
                </c:pt>
                <c:pt idx="263">
                  <c:v>1303.829</c:v>
                </c:pt>
                <c:pt idx="264">
                  <c:v>1304.3779999999999</c:v>
                </c:pt>
                <c:pt idx="265">
                  <c:v>1304.7339999999999</c:v>
                </c:pt>
                <c:pt idx="266">
                  <c:v>1305.0889999999999</c:v>
                </c:pt>
                <c:pt idx="267">
                  <c:v>1305.366</c:v>
                </c:pt>
                <c:pt idx="268">
                  <c:v>1305.605</c:v>
                </c:pt>
                <c:pt idx="269">
                  <c:v>1305.7180000000001</c:v>
                </c:pt>
                <c:pt idx="270">
                  <c:v>1306.5170000000001</c:v>
                </c:pt>
                <c:pt idx="271">
                  <c:v>1306.893</c:v>
                </c:pt>
                <c:pt idx="272">
                  <c:v>1307.963</c:v>
                </c:pt>
                <c:pt idx="273">
                  <c:v>1308.2729999999999</c:v>
                </c:pt>
                <c:pt idx="274">
                  <c:v>1308.6790000000001</c:v>
                </c:pt>
                <c:pt idx="275">
                  <c:v>1309.0889999999999</c:v>
                </c:pt>
                <c:pt idx="276">
                  <c:v>1309.412</c:v>
                </c:pt>
                <c:pt idx="277">
                  <c:v>1309.954</c:v>
                </c:pt>
                <c:pt idx="278">
                  <c:v>1310.164</c:v>
                </c:pt>
                <c:pt idx="279">
                  <c:v>1310.4649999999999</c:v>
                </c:pt>
                <c:pt idx="280">
                  <c:v>1310.5150000000001</c:v>
                </c:pt>
                <c:pt idx="281">
                  <c:v>1310.77</c:v>
                </c:pt>
                <c:pt idx="282">
                  <c:v>1311.269</c:v>
                </c:pt>
                <c:pt idx="283">
                  <c:v>1311.6780000000001</c:v>
                </c:pt>
                <c:pt idx="284">
                  <c:v>1312.3910000000001</c:v>
                </c:pt>
                <c:pt idx="285">
                  <c:v>1313.0550000000001</c:v>
                </c:pt>
                <c:pt idx="286">
                  <c:v>1313.5340000000001</c:v>
                </c:pt>
                <c:pt idx="287">
                  <c:v>1314.018</c:v>
                </c:pt>
                <c:pt idx="288">
                  <c:v>1314.4960000000001</c:v>
                </c:pt>
                <c:pt idx="289">
                  <c:v>1314.9939999999999</c:v>
                </c:pt>
                <c:pt idx="290">
                  <c:v>1315.2940000000001</c:v>
                </c:pt>
                <c:pt idx="291">
                  <c:v>1315.614</c:v>
                </c:pt>
                <c:pt idx="292">
                  <c:v>1315.826</c:v>
                </c:pt>
                <c:pt idx="293">
                  <c:v>1316.731</c:v>
                </c:pt>
                <c:pt idx="294">
                  <c:v>1316.9780000000001</c:v>
                </c:pt>
                <c:pt idx="295">
                  <c:v>1317.364</c:v>
                </c:pt>
                <c:pt idx="296">
                  <c:v>1317.4490000000001</c:v>
                </c:pt>
                <c:pt idx="297">
                  <c:v>1317.9480000000001</c:v>
                </c:pt>
                <c:pt idx="298">
                  <c:v>1318.6010000000001</c:v>
                </c:pt>
                <c:pt idx="299">
                  <c:v>1319.443</c:v>
                </c:pt>
                <c:pt idx="300">
                  <c:v>1319.568</c:v>
                </c:pt>
                <c:pt idx="301">
                  <c:v>1319.7550000000001</c:v>
                </c:pt>
                <c:pt idx="302">
                  <c:v>1320.296</c:v>
                </c:pt>
                <c:pt idx="303">
                  <c:v>1320.6769999999999</c:v>
                </c:pt>
                <c:pt idx="304">
                  <c:v>1320.923</c:v>
                </c:pt>
                <c:pt idx="305">
                  <c:v>1321.422</c:v>
                </c:pt>
                <c:pt idx="306">
                  <c:v>1322.0229999999999</c:v>
                </c:pt>
                <c:pt idx="307">
                  <c:v>1322.3340000000001</c:v>
                </c:pt>
                <c:pt idx="308">
                  <c:v>1322.518</c:v>
                </c:pt>
                <c:pt idx="309">
                  <c:v>1322.819</c:v>
                </c:pt>
                <c:pt idx="310">
                  <c:v>1322.9469999999999</c:v>
                </c:pt>
                <c:pt idx="311">
                  <c:v>1323.1</c:v>
                </c:pt>
                <c:pt idx="312">
                  <c:v>1323.925</c:v>
                </c:pt>
                <c:pt idx="313">
                  <c:v>1324.338</c:v>
                </c:pt>
                <c:pt idx="314">
                  <c:v>1324.383</c:v>
                </c:pt>
                <c:pt idx="315">
                  <c:v>1324.681</c:v>
                </c:pt>
                <c:pt idx="316">
                  <c:v>1325.298</c:v>
                </c:pt>
                <c:pt idx="317">
                  <c:v>1326.213</c:v>
                </c:pt>
                <c:pt idx="318">
                  <c:v>1326.7070000000001</c:v>
                </c:pt>
                <c:pt idx="319">
                  <c:v>1326.93</c:v>
                </c:pt>
                <c:pt idx="320">
                  <c:v>1327.66</c:v>
                </c:pt>
                <c:pt idx="321">
                  <c:v>1327.85</c:v>
                </c:pt>
                <c:pt idx="322">
                  <c:v>1328.2429999999999</c:v>
                </c:pt>
                <c:pt idx="323">
                  <c:v>1328.463</c:v>
                </c:pt>
                <c:pt idx="324">
                  <c:v>1328.749</c:v>
                </c:pt>
                <c:pt idx="325">
                  <c:v>1329.248</c:v>
                </c:pt>
                <c:pt idx="326">
                  <c:v>1329.4570000000001</c:v>
                </c:pt>
                <c:pt idx="327">
                  <c:v>1329.82</c:v>
                </c:pt>
                <c:pt idx="328">
                  <c:v>1330.211</c:v>
                </c:pt>
                <c:pt idx="329">
                  <c:v>1330.7260000000001</c:v>
                </c:pt>
                <c:pt idx="330">
                  <c:v>1331.2829999999999</c:v>
                </c:pt>
                <c:pt idx="331">
                  <c:v>1331.317</c:v>
                </c:pt>
                <c:pt idx="332">
                  <c:v>1331.415</c:v>
                </c:pt>
                <c:pt idx="333">
                  <c:v>1331.7349999999999</c:v>
                </c:pt>
                <c:pt idx="334">
                  <c:v>1332.1420000000001</c:v>
                </c:pt>
                <c:pt idx="335">
                  <c:v>1332.4580000000001</c:v>
                </c:pt>
                <c:pt idx="336">
                  <c:v>1333.134</c:v>
                </c:pt>
                <c:pt idx="337">
                  <c:v>1333.751</c:v>
                </c:pt>
                <c:pt idx="338">
                  <c:v>1334.002</c:v>
                </c:pt>
                <c:pt idx="339">
                  <c:v>1334.316</c:v>
                </c:pt>
                <c:pt idx="340">
                  <c:v>1334.653</c:v>
                </c:pt>
                <c:pt idx="341">
                  <c:v>1335.259</c:v>
                </c:pt>
                <c:pt idx="342">
                  <c:v>1335.453</c:v>
                </c:pt>
                <c:pt idx="343">
                  <c:v>1335.798</c:v>
                </c:pt>
                <c:pt idx="344">
                  <c:v>1335.952</c:v>
                </c:pt>
                <c:pt idx="345">
                  <c:v>1336.2760000000001</c:v>
                </c:pt>
                <c:pt idx="346">
                  <c:v>1336.518</c:v>
                </c:pt>
                <c:pt idx="347">
                  <c:v>1336.8320000000001</c:v>
                </c:pt>
                <c:pt idx="348">
                  <c:v>1337.547</c:v>
                </c:pt>
                <c:pt idx="349">
                  <c:v>1337.8040000000001</c:v>
                </c:pt>
                <c:pt idx="350">
                  <c:v>1338.251</c:v>
                </c:pt>
                <c:pt idx="351">
                  <c:v>1338.421</c:v>
                </c:pt>
                <c:pt idx="352">
                  <c:v>1338.7280000000001</c:v>
                </c:pt>
                <c:pt idx="353">
                  <c:v>1338.9269999999999</c:v>
                </c:pt>
                <c:pt idx="354">
                  <c:v>1339.134</c:v>
                </c:pt>
                <c:pt idx="355">
                  <c:v>1340.221</c:v>
                </c:pt>
                <c:pt idx="356">
                  <c:v>1340.36</c:v>
                </c:pt>
                <c:pt idx="357">
                  <c:v>1340.5229999999999</c:v>
                </c:pt>
                <c:pt idx="358">
                  <c:v>1341.095</c:v>
                </c:pt>
                <c:pt idx="359">
                  <c:v>1341.4749999999999</c:v>
                </c:pt>
                <c:pt idx="360">
                  <c:v>1342.231</c:v>
                </c:pt>
                <c:pt idx="361">
                  <c:v>1342.6189999999999</c:v>
                </c:pt>
                <c:pt idx="362">
                  <c:v>1342.941</c:v>
                </c:pt>
                <c:pt idx="363">
                  <c:v>1343.7070000000001</c:v>
                </c:pt>
                <c:pt idx="364">
                  <c:v>1344.4290000000001</c:v>
                </c:pt>
                <c:pt idx="365">
                  <c:v>1344.63</c:v>
                </c:pt>
                <c:pt idx="366">
                  <c:v>1344.768</c:v>
                </c:pt>
                <c:pt idx="367">
                  <c:v>1345.1849999999999</c:v>
                </c:pt>
                <c:pt idx="368">
                  <c:v>1345.49</c:v>
                </c:pt>
                <c:pt idx="369">
                  <c:v>1346.0129999999999</c:v>
                </c:pt>
                <c:pt idx="370">
                  <c:v>1347.0409999999999</c:v>
                </c:pt>
                <c:pt idx="371">
                  <c:v>1347.5309999999999</c:v>
                </c:pt>
                <c:pt idx="372">
                  <c:v>1348.0250000000001</c:v>
                </c:pt>
                <c:pt idx="373">
                  <c:v>1348.539</c:v>
                </c:pt>
                <c:pt idx="374">
                  <c:v>1349.181</c:v>
                </c:pt>
                <c:pt idx="375">
                  <c:v>1349.5820000000001</c:v>
                </c:pt>
                <c:pt idx="376">
                  <c:v>1350.307</c:v>
                </c:pt>
                <c:pt idx="377">
                  <c:v>1351.086</c:v>
                </c:pt>
                <c:pt idx="378">
                  <c:v>1351.7750000000001</c:v>
                </c:pt>
                <c:pt idx="379">
                  <c:v>1352.1189999999999</c:v>
                </c:pt>
                <c:pt idx="380">
                  <c:v>1352.299</c:v>
                </c:pt>
                <c:pt idx="381">
                  <c:v>1352.7239999999999</c:v>
                </c:pt>
                <c:pt idx="382">
                  <c:v>1354.049</c:v>
                </c:pt>
                <c:pt idx="383">
                  <c:v>1354.723</c:v>
                </c:pt>
                <c:pt idx="384">
                  <c:v>1355.194</c:v>
                </c:pt>
                <c:pt idx="385">
                  <c:v>1355.9280000000001</c:v>
                </c:pt>
                <c:pt idx="386">
                  <c:v>1356.7860000000001</c:v>
                </c:pt>
                <c:pt idx="387">
                  <c:v>1357.7370000000001</c:v>
                </c:pt>
                <c:pt idx="388">
                  <c:v>1358.298</c:v>
                </c:pt>
                <c:pt idx="389">
                  <c:v>1359.0519999999999</c:v>
                </c:pt>
                <c:pt idx="390">
                  <c:v>1360.338</c:v>
                </c:pt>
                <c:pt idx="391">
                  <c:v>1361.463</c:v>
                </c:pt>
                <c:pt idx="392">
                  <c:v>1364.826</c:v>
                </c:pt>
                <c:pt idx="393">
                  <c:v>1365.9860000000001</c:v>
                </c:pt>
                <c:pt idx="394">
                  <c:v>1369.002</c:v>
                </c:pt>
                <c:pt idx="395">
                  <c:v>1371.3989999999999</c:v>
                </c:pt>
                <c:pt idx="396">
                  <c:v>1372.92</c:v>
                </c:pt>
                <c:pt idx="397">
                  <c:v>1379.854</c:v>
                </c:pt>
                <c:pt idx="398">
                  <c:v>1380.056</c:v>
                </c:pt>
                <c:pt idx="399">
                  <c:v>1381.864</c:v>
                </c:pt>
                <c:pt idx="400">
                  <c:v>1386.788</c:v>
                </c:pt>
                <c:pt idx="401">
                  <c:v>1386.788</c:v>
                </c:pt>
              </c:numCache>
            </c:numRef>
          </c:xVal>
          <c:yVal>
            <c:numRef>
              <c:f>Foglio6!$J$5:$J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100</c:v>
                </c:pt>
                <c:pt idx="163">
                  <c:v>100</c:v>
                </c:pt>
                <c:pt idx="164">
                  <c:v>100</c:v>
                </c:pt>
                <c:pt idx="165">
                  <c:v>100</c:v>
                </c:pt>
                <c:pt idx="166">
                  <c:v>100</c:v>
                </c:pt>
                <c:pt idx="167">
                  <c:v>99.991</c:v>
                </c:pt>
                <c:pt idx="168">
                  <c:v>99.983999999999995</c:v>
                </c:pt>
                <c:pt idx="169">
                  <c:v>99.957999999999998</c:v>
                </c:pt>
                <c:pt idx="170">
                  <c:v>99.831000000000003</c:v>
                </c:pt>
                <c:pt idx="171">
                  <c:v>99.772000000000006</c:v>
                </c:pt>
                <c:pt idx="172">
                  <c:v>99.596999999999994</c:v>
                </c:pt>
                <c:pt idx="173">
                  <c:v>99.5</c:v>
                </c:pt>
                <c:pt idx="174">
                  <c:v>99.388000000000005</c:v>
                </c:pt>
                <c:pt idx="175">
                  <c:v>99.146000000000001</c:v>
                </c:pt>
                <c:pt idx="176">
                  <c:v>99</c:v>
                </c:pt>
                <c:pt idx="177">
                  <c:v>98.584000000000003</c:v>
                </c:pt>
                <c:pt idx="178">
                  <c:v>98.5</c:v>
                </c:pt>
                <c:pt idx="179">
                  <c:v>98</c:v>
                </c:pt>
                <c:pt idx="180">
                  <c:v>97.974999999999994</c:v>
                </c:pt>
                <c:pt idx="181">
                  <c:v>97.602000000000004</c:v>
                </c:pt>
                <c:pt idx="182">
                  <c:v>97.5</c:v>
                </c:pt>
                <c:pt idx="183">
                  <c:v>97</c:v>
                </c:pt>
                <c:pt idx="184">
                  <c:v>96.557000000000002</c:v>
                </c:pt>
                <c:pt idx="185">
                  <c:v>96.5</c:v>
                </c:pt>
                <c:pt idx="186">
                  <c:v>96</c:v>
                </c:pt>
                <c:pt idx="187">
                  <c:v>95.5</c:v>
                </c:pt>
                <c:pt idx="188">
                  <c:v>95.415999999999997</c:v>
                </c:pt>
                <c:pt idx="189">
                  <c:v>95</c:v>
                </c:pt>
                <c:pt idx="190">
                  <c:v>94.5</c:v>
                </c:pt>
                <c:pt idx="191">
                  <c:v>94.391999999999996</c:v>
                </c:pt>
                <c:pt idx="192">
                  <c:v>94</c:v>
                </c:pt>
                <c:pt idx="193">
                  <c:v>93.5</c:v>
                </c:pt>
                <c:pt idx="194">
                  <c:v>93</c:v>
                </c:pt>
                <c:pt idx="195">
                  <c:v>92.88</c:v>
                </c:pt>
                <c:pt idx="196">
                  <c:v>92.5</c:v>
                </c:pt>
                <c:pt idx="197">
                  <c:v>92</c:v>
                </c:pt>
                <c:pt idx="198">
                  <c:v>91.5</c:v>
                </c:pt>
                <c:pt idx="199">
                  <c:v>91</c:v>
                </c:pt>
                <c:pt idx="200">
                  <c:v>90.930999999999997</c:v>
                </c:pt>
                <c:pt idx="201">
                  <c:v>90.5</c:v>
                </c:pt>
                <c:pt idx="202">
                  <c:v>90</c:v>
                </c:pt>
                <c:pt idx="203">
                  <c:v>89.5</c:v>
                </c:pt>
                <c:pt idx="204">
                  <c:v>89.177000000000007</c:v>
                </c:pt>
                <c:pt idx="205">
                  <c:v>89</c:v>
                </c:pt>
                <c:pt idx="206">
                  <c:v>88.5</c:v>
                </c:pt>
                <c:pt idx="207">
                  <c:v>88</c:v>
                </c:pt>
                <c:pt idx="208">
                  <c:v>87.5</c:v>
                </c:pt>
                <c:pt idx="209">
                  <c:v>87.224999999999994</c:v>
                </c:pt>
                <c:pt idx="210">
                  <c:v>87</c:v>
                </c:pt>
                <c:pt idx="211">
                  <c:v>86.5</c:v>
                </c:pt>
                <c:pt idx="212">
                  <c:v>86</c:v>
                </c:pt>
                <c:pt idx="213">
                  <c:v>85.5</c:v>
                </c:pt>
                <c:pt idx="214">
                  <c:v>85</c:v>
                </c:pt>
                <c:pt idx="215">
                  <c:v>84.650999999999996</c:v>
                </c:pt>
                <c:pt idx="216">
                  <c:v>84.5</c:v>
                </c:pt>
                <c:pt idx="217">
                  <c:v>84</c:v>
                </c:pt>
                <c:pt idx="218">
                  <c:v>83.5</c:v>
                </c:pt>
                <c:pt idx="219">
                  <c:v>83</c:v>
                </c:pt>
                <c:pt idx="220">
                  <c:v>82.5</c:v>
                </c:pt>
                <c:pt idx="221">
                  <c:v>82</c:v>
                </c:pt>
                <c:pt idx="222">
                  <c:v>81.5</c:v>
                </c:pt>
                <c:pt idx="223">
                  <c:v>81</c:v>
                </c:pt>
                <c:pt idx="224">
                  <c:v>80.625</c:v>
                </c:pt>
                <c:pt idx="225">
                  <c:v>80.5</c:v>
                </c:pt>
                <c:pt idx="226">
                  <c:v>80</c:v>
                </c:pt>
                <c:pt idx="227">
                  <c:v>79.5</c:v>
                </c:pt>
                <c:pt idx="228">
                  <c:v>79</c:v>
                </c:pt>
                <c:pt idx="229">
                  <c:v>78.5</c:v>
                </c:pt>
                <c:pt idx="230">
                  <c:v>78</c:v>
                </c:pt>
                <c:pt idx="231">
                  <c:v>77.5</c:v>
                </c:pt>
                <c:pt idx="232">
                  <c:v>77</c:v>
                </c:pt>
                <c:pt idx="233">
                  <c:v>76.5</c:v>
                </c:pt>
                <c:pt idx="234">
                  <c:v>76.009</c:v>
                </c:pt>
                <c:pt idx="235">
                  <c:v>76</c:v>
                </c:pt>
                <c:pt idx="236">
                  <c:v>75.5</c:v>
                </c:pt>
                <c:pt idx="237">
                  <c:v>75</c:v>
                </c:pt>
                <c:pt idx="238">
                  <c:v>74.5</c:v>
                </c:pt>
                <c:pt idx="239">
                  <c:v>74</c:v>
                </c:pt>
                <c:pt idx="240">
                  <c:v>73.5</c:v>
                </c:pt>
                <c:pt idx="241">
                  <c:v>73</c:v>
                </c:pt>
                <c:pt idx="242">
                  <c:v>72.5</c:v>
                </c:pt>
                <c:pt idx="243">
                  <c:v>72</c:v>
                </c:pt>
                <c:pt idx="244">
                  <c:v>71.5</c:v>
                </c:pt>
                <c:pt idx="245">
                  <c:v>71</c:v>
                </c:pt>
                <c:pt idx="246">
                  <c:v>70.5</c:v>
                </c:pt>
                <c:pt idx="247">
                  <c:v>70</c:v>
                </c:pt>
                <c:pt idx="248">
                  <c:v>69.91</c:v>
                </c:pt>
                <c:pt idx="249">
                  <c:v>69.5</c:v>
                </c:pt>
                <c:pt idx="250">
                  <c:v>69</c:v>
                </c:pt>
                <c:pt idx="251">
                  <c:v>68.5</c:v>
                </c:pt>
                <c:pt idx="252">
                  <c:v>68</c:v>
                </c:pt>
                <c:pt idx="253">
                  <c:v>67.5</c:v>
                </c:pt>
                <c:pt idx="254">
                  <c:v>67</c:v>
                </c:pt>
                <c:pt idx="255">
                  <c:v>66.5</c:v>
                </c:pt>
                <c:pt idx="256">
                  <c:v>66</c:v>
                </c:pt>
                <c:pt idx="257">
                  <c:v>65.5</c:v>
                </c:pt>
                <c:pt idx="258">
                  <c:v>65</c:v>
                </c:pt>
                <c:pt idx="259">
                  <c:v>64.5</c:v>
                </c:pt>
                <c:pt idx="260">
                  <c:v>64</c:v>
                </c:pt>
                <c:pt idx="261">
                  <c:v>63.5</c:v>
                </c:pt>
                <c:pt idx="262">
                  <c:v>63.180999999999997</c:v>
                </c:pt>
                <c:pt idx="263">
                  <c:v>63</c:v>
                </c:pt>
                <c:pt idx="264">
                  <c:v>62.5</c:v>
                </c:pt>
                <c:pt idx="265">
                  <c:v>62</c:v>
                </c:pt>
                <c:pt idx="266">
                  <c:v>61.5</c:v>
                </c:pt>
                <c:pt idx="267">
                  <c:v>61</c:v>
                </c:pt>
                <c:pt idx="268">
                  <c:v>60.5</c:v>
                </c:pt>
                <c:pt idx="269">
                  <c:v>60</c:v>
                </c:pt>
                <c:pt idx="270">
                  <c:v>59.5</c:v>
                </c:pt>
                <c:pt idx="271">
                  <c:v>59</c:v>
                </c:pt>
                <c:pt idx="272">
                  <c:v>58.5</c:v>
                </c:pt>
                <c:pt idx="273">
                  <c:v>58</c:v>
                </c:pt>
                <c:pt idx="274">
                  <c:v>57.5</c:v>
                </c:pt>
                <c:pt idx="275">
                  <c:v>57</c:v>
                </c:pt>
                <c:pt idx="276">
                  <c:v>56.5</c:v>
                </c:pt>
                <c:pt idx="277">
                  <c:v>56</c:v>
                </c:pt>
                <c:pt idx="278">
                  <c:v>55.5</c:v>
                </c:pt>
                <c:pt idx="279">
                  <c:v>55</c:v>
                </c:pt>
                <c:pt idx="280">
                  <c:v>54.959000000000003</c:v>
                </c:pt>
                <c:pt idx="281">
                  <c:v>54.5</c:v>
                </c:pt>
                <c:pt idx="282">
                  <c:v>54</c:v>
                </c:pt>
                <c:pt idx="283">
                  <c:v>53.5</c:v>
                </c:pt>
                <c:pt idx="284">
                  <c:v>53</c:v>
                </c:pt>
                <c:pt idx="285">
                  <c:v>52.5</c:v>
                </c:pt>
                <c:pt idx="286">
                  <c:v>52</c:v>
                </c:pt>
                <c:pt idx="287">
                  <c:v>51.5</c:v>
                </c:pt>
                <c:pt idx="288">
                  <c:v>51</c:v>
                </c:pt>
                <c:pt idx="289">
                  <c:v>50.5</c:v>
                </c:pt>
                <c:pt idx="290">
                  <c:v>50</c:v>
                </c:pt>
                <c:pt idx="291">
                  <c:v>49.5</c:v>
                </c:pt>
                <c:pt idx="292">
                  <c:v>49</c:v>
                </c:pt>
                <c:pt idx="293">
                  <c:v>48.5</c:v>
                </c:pt>
                <c:pt idx="294">
                  <c:v>48</c:v>
                </c:pt>
                <c:pt idx="295">
                  <c:v>47.5</c:v>
                </c:pt>
                <c:pt idx="296">
                  <c:v>47.393999999999998</c:v>
                </c:pt>
                <c:pt idx="297">
                  <c:v>47</c:v>
                </c:pt>
                <c:pt idx="298">
                  <c:v>46.5</c:v>
                </c:pt>
                <c:pt idx="299">
                  <c:v>46</c:v>
                </c:pt>
                <c:pt idx="300">
                  <c:v>45.5</c:v>
                </c:pt>
                <c:pt idx="301">
                  <c:v>45</c:v>
                </c:pt>
                <c:pt idx="302">
                  <c:v>44.5</c:v>
                </c:pt>
                <c:pt idx="303">
                  <c:v>44</c:v>
                </c:pt>
                <c:pt idx="304">
                  <c:v>43.5</c:v>
                </c:pt>
                <c:pt idx="305">
                  <c:v>43</c:v>
                </c:pt>
                <c:pt idx="306">
                  <c:v>42.5</c:v>
                </c:pt>
                <c:pt idx="307">
                  <c:v>42</c:v>
                </c:pt>
                <c:pt idx="308">
                  <c:v>41.5</c:v>
                </c:pt>
                <c:pt idx="309">
                  <c:v>41</c:v>
                </c:pt>
                <c:pt idx="310">
                  <c:v>40.5</c:v>
                </c:pt>
                <c:pt idx="311">
                  <c:v>40</c:v>
                </c:pt>
                <c:pt idx="312">
                  <c:v>39.5</c:v>
                </c:pt>
                <c:pt idx="313">
                  <c:v>39</c:v>
                </c:pt>
                <c:pt idx="314">
                  <c:v>38.808999999999997</c:v>
                </c:pt>
                <c:pt idx="315">
                  <c:v>38.5</c:v>
                </c:pt>
                <c:pt idx="316">
                  <c:v>38</c:v>
                </c:pt>
                <c:pt idx="317">
                  <c:v>37.5</c:v>
                </c:pt>
                <c:pt idx="318">
                  <c:v>37</c:v>
                </c:pt>
                <c:pt idx="319">
                  <c:v>36.5</c:v>
                </c:pt>
                <c:pt idx="320">
                  <c:v>36</c:v>
                </c:pt>
                <c:pt idx="321">
                  <c:v>35.5</c:v>
                </c:pt>
                <c:pt idx="322">
                  <c:v>35</c:v>
                </c:pt>
                <c:pt idx="323">
                  <c:v>34.5</c:v>
                </c:pt>
                <c:pt idx="324">
                  <c:v>34</c:v>
                </c:pt>
                <c:pt idx="325">
                  <c:v>33.5</c:v>
                </c:pt>
                <c:pt idx="326">
                  <c:v>33</c:v>
                </c:pt>
                <c:pt idx="327">
                  <c:v>32.5</c:v>
                </c:pt>
                <c:pt idx="328">
                  <c:v>32</c:v>
                </c:pt>
                <c:pt idx="329">
                  <c:v>31.5</c:v>
                </c:pt>
                <c:pt idx="330">
                  <c:v>31</c:v>
                </c:pt>
                <c:pt idx="331">
                  <c:v>30.952000000000002</c:v>
                </c:pt>
                <c:pt idx="332">
                  <c:v>30.5</c:v>
                </c:pt>
                <c:pt idx="333">
                  <c:v>30</c:v>
                </c:pt>
                <c:pt idx="334">
                  <c:v>29.5</c:v>
                </c:pt>
                <c:pt idx="335">
                  <c:v>29</c:v>
                </c:pt>
                <c:pt idx="336">
                  <c:v>28.5</c:v>
                </c:pt>
                <c:pt idx="337">
                  <c:v>28</c:v>
                </c:pt>
                <c:pt idx="338">
                  <c:v>27.5</c:v>
                </c:pt>
                <c:pt idx="339">
                  <c:v>27</c:v>
                </c:pt>
                <c:pt idx="340">
                  <c:v>26.5</c:v>
                </c:pt>
                <c:pt idx="341">
                  <c:v>26</c:v>
                </c:pt>
                <c:pt idx="342">
                  <c:v>25.5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</c:v>
                </c:pt>
                <c:pt idx="350">
                  <c:v>21.738</c:v>
                </c:pt>
                <c:pt idx="351">
                  <c:v>21.5</c:v>
                </c:pt>
                <c:pt idx="352">
                  <c:v>21</c:v>
                </c:pt>
                <c:pt idx="353">
                  <c:v>20.5</c:v>
                </c:pt>
                <c:pt idx="354">
                  <c:v>20</c:v>
                </c:pt>
                <c:pt idx="355">
                  <c:v>19.5</c:v>
                </c:pt>
                <c:pt idx="356">
                  <c:v>19</c:v>
                </c:pt>
                <c:pt idx="357">
                  <c:v>18.5</c:v>
                </c:pt>
                <c:pt idx="358">
                  <c:v>18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5</c:v>
                </c:pt>
                <c:pt idx="366">
                  <c:v>14</c:v>
                </c:pt>
                <c:pt idx="367">
                  <c:v>13.7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5</c:v>
                </c:pt>
                <c:pt idx="375">
                  <c:v>10</c:v>
                </c:pt>
                <c:pt idx="376">
                  <c:v>9.5</c:v>
                </c:pt>
                <c:pt idx="377">
                  <c:v>9</c:v>
                </c:pt>
                <c:pt idx="378">
                  <c:v>8.5</c:v>
                </c:pt>
                <c:pt idx="379">
                  <c:v>8.0579999999999998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5</c:v>
                </c:pt>
                <c:pt idx="384">
                  <c:v>6</c:v>
                </c:pt>
                <c:pt idx="385">
                  <c:v>5.5</c:v>
                </c:pt>
                <c:pt idx="386">
                  <c:v>5</c:v>
                </c:pt>
                <c:pt idx="387">
                  <c:v>4.5</c:v>
                </c:pt>
                <c:pt idx="388">
                  <c:v>4</c:v>
                </c:pt>
                <c:pt idx="389">
                  <c:v>3.7650000000000001</c:v>
                </c:pt>
                <c:pt idx="390">
                  <c:v>3.5</c:v>
                </c:pt>
                <c:pt idx="391">
                  <c:v>3</c:v>
                </c:pt>
                <c:pt idx="392">
                  <c:v>2.5</c:v>
                </c:pt>
                <c:pt idx="393">
                  <c:v>2.3319999999999999</c:v>
                </c:pt>
                <c:pt idx="394">
                  <c:v>2</c:v>
                </c:pt>
                <c:pt idx="395">
                  <c:v>1.5</c:v>
                </c:pt>
                <c:pt idx="396">
                  <c:v>1.2130000000000001</c:v>
                </c:pt>
                <c:pt idx="397">
                  <c:v>1.042</c:v>
                </c:pt>
                <c:pt idx="398">
                  <c:v>1</c:v>
                </c:pt>
                <c:pt idx="399">
                  <c:v>0.5</c:v>
                </c:pt>
                <c:pt idx="400">
                  <c:v>7.1999999999999995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A88-4DA4-99B1-07BA75EC6953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K$5:$K$406</c:f>
              <c:numCache>
                <c:formatCode>General</c:formatCode>
                <c:ptCount val="402"/>
                <c:pt idx="0">
                  <c:v>0</c:v>
                </c:pt>
                <c:pt idx="1">
                  <c:v>7.0819999999999999</c:v>
                </c:pt>
                <c:pt idx="2">
                  <c:v>14.164999999999999</c:v>
                </c:pt>
                <c:pt idx="3">
                  <c:v>21.247</c:v>
                </c:pt>
                <c:pt idx="4">
                  <c:v>28.33</c:v>
                </c:pt>
                <c:pt idx="5">
                  <c:v>35.411999999999999</c:v>
                </c:pt>
                <c:pt idx="6">
                  <c:v>42.494999999999997</c:v>
                </c:pt>
                <c:pt idx="7">
                  <c:v>49.576999999999998</c:v>
                </c:pt>
                <c:pt idx="8">
                  <c:v>56.66</c:v>
                </c:pt>
                <c:pt idx="9">
                  <c:v>63.741999999999997</c:v>
                </c:pt>
                <c:pt idx="10">
                  <c:v>70.823999999999998</c:v>
                </c:pt>
                <c:pt idx="11">
                  <c:v>77.906999999999996</c:v>
                </c:pt>
                <c:pt idx="12">
                  <c:v>84.989000000000004</c:v>
                </c:pt>
                <c:pt idx="13">
                  <c:v>92.072000000000003</c:v>
                </c:pt>
                <c:pt idx="14">
                  <c:v>99.153999999999996</c:v>
                </c:pt>
                <c:pt idx="15">
                  <c:v>106.23699999999999</c:v>
                </c:pt>
                <c:pt idx="16">
                  <c:v>113.319</c:v>
                </c:pt>
                <c:pt idx="17">
                  <c:v>120.402</c:v>
                </c:pt>
                <c:pt idx="18">
                  <c:v>127.48399999999999</c:v>
                </c:pt>
                <c:pt idx="19">
                  <c:v>134.566</c:v>
                </c:pt>
                <c:pt idx="20">
                  <c:v>141.649</c:v>
                </c:pt>
                <c:pt idx="21">
                  <c:v>148.73099999999999</c:v>
                </c:pt>
                <c:pt idx="22">
                  <c:v>155.81399999999999</c:v>
                </c:pt>
                <c:pt idx="23">
                  <c:v>162.89599999999999</c:v>
                </c:pt>
                <c:pt idx="24">
                  <c:v>169.97900000000001</c:v>
                </c:pt>
                <c:pt idx="25">
                  <c:v>177.06100000000001</c:v>
                </c:pt>
                <c:pt idx="26">
                  <c:v>184.14400000000001</c:v>
                </c:pt>
                <c:pt idx="27">
                  <c:v>191.226</c:v>
                </c:pt>
                <c:pt idx="28">
                  <c:v>198.30799999999999</c:v>
                </c:pt>
                <c:pt idx="29">
                  <c:v>205.39099999999999</c:v>
                </c:pt>
                <c:pt idx="30">
                  <c:v>212.47300000000001</c:v>
                </c:pt>
                <c:pt idx="31">
                  <c:v>219.55600000000001</c:v>
                </c:pt>
                <c:pt idx="32">
                  <c:v>226.63800000000001</c:v>
                </c:pt>
                <c:pt idx="33">
                  <c:v>233.721</c:v>
                </c:pt>
                <c:pt idx="34">
                  <c:v>240.803</c:v>
                </c:pt>
                <c:pt idx="35">
                  <c:v>247.886</c:v>
                </c:pt>
                <c:pt idx="36">
                  <c:v>254.96799999999999</c:v>
                </c:pt>
                <c:pt idx="37">
                  <c:v>262.05</c:v>
                </c:pt>
                <c:pt idx="38">
                  <c:v>269.13299999999998</c:v>
                </c:pt>
                <c:pt idx="39">
                  <c:v>276.21499999999997</c:v>
                </c:pt>
                <c:pt idx="40">
                  <c:v>283.298</c:v>
                </c:pt>
                <c:pt idx="41">
                  <c:v>290.38</c:v>
                </c:pt>
                <c:pt idx="42">
                  <c:v>297.46300000000002</c:v>
                </c:pt>
                <c:pt idx="43">
                  <c:v>304.54500000000002</c:v>
                </c:pt>
                <c:pt idx="44">
                  <c:v>311.62799999999999</c:v>
                </c:pt>
                <c:pt idx="45">
                  <c:v>318.70999999999998</c:v>
                </c:pt>
                <c:pt idx="46">
                  <c:v>325.79199999999997</c:v>
                </c:pt>
                <c:pt idx="47">
                  <c:v>332.875</c:v>
                </c:pt>
                <c:pt idx="48">
                  <c:v>339.95699999999999</c:v>
                </c:pt>
                <c:pt idx="49">
                  <c:v>347.04</c:v>
                </c:pt>
                <c:pt idx="50">
                  <c:v>354.12200000000001</c:v>
                </c:pt>
                <c:pt idx="51">
                  <c:v>361.20499999999998</c:v>
                </c:pt>
                <c:pt idx="52">
                  <c:v>368.28699999999998</c:v>
                </c:pt>
                <c:pt idx="53">
                  <c:v>375.36900000000003</c:v>
                </c:pt>
                <c:pt idx="54">
                  <c:v>382.452</c:v>
                </c:pt>
                <c:pt idx="55">
                  <c:v>389.53399999999999</c:v>
                </c:pt>
                <c:pt idx="56">
                  <c:v>396.61700000000002</c:v>
                </c:pt>
                <c:pt idx="57">
                  <c:v>403.69900000000001</c:v>
                </c:pt>
                <c:pt idx="58">
                  <c:v>410.78199999999998</c:v>
                </c:pt>
                <c:pt idx="59">
                  <c:v>417.86399999999998</c:v>
                </c:pt>
                <c:pt idx="60">
                  <c:v>424.947</c:v>
                </c:pt>
                <c:pt idx="61">
                  <c:v>432.029</c:v>
                </c:pt>
                <c:pt idx="62">
                  <c:v>439.11099999999999</c:v>
                </c:pt>
                <c:pt idx="63">
                  <c:v>446.19400000000002</c:v>
                </c:pt>
                <c:pt idx="64">
                  <c:v>453.27600000000001</c:v>
                </c:pt>
                <c:pt idx="65">
                  <c:v>460.35899999999998</c:v>
                </c:pt>
                <c:pt idx="66">
                  <c:v>467.44099999999997</c:v>
                </c:pt>
                <c:pt idx="67">
                  <c:v>474.524</c:v>
                </c:pt>
                <c:pt idx="68">
                  <c:v>481.60599999999999</c:v>
                </c:pt>
                <c:pt idx="69">
                  <c:v>488.68900000000002</c:v>
                </c:pt>
                <c:pt idx="70">
                  <c:v>495.77100000000002</c:v>
                </c:pt>
                <c:pt idx="71">
                  <c:v>502.85300000000001</c:v>
                </c:pt>
                <c:pt idx="72">
                  <c:v>509.93599999999998</c:v>
                </c:pt>
                <c:pt idx="73">
                  <c:v>517.01800000000003</c:v>
                </c:pt>
                <c:pt idx="74">
                  <c:v>524.101</c:v>
                </c:pt>
                <c:pt idx="75">
                  <c:v>531.18299999999999</c:v>
                </c:pt>
                <c:pt idx="76">
                  <c:v>538.26599999999996</c:v>
                </c:pt>
                <c:pt idx="77">
                  <c:v>545.34799999999996</c:v>
                </c:pt>
                <c:pt idx="78">
                  <c:v>552.43100000000004</c:v>
                </c:pt>
                <c:pt idx="79">
                  <c:v>559.51300000000003</c:v>
                </c:pt>
                <c:pt idx="80">
                  <c:v>566.59500000000003</c:v>
                </c:pt>
                <c:pt idx="81">
                  <c:v>573.678</c:v>
                </c:pt>
                <c:pt idx="82">
                  <c:v>580.76</c:v>
                </c:pt>
                <c:pt idx="83">
                  <c:v>587.84299999999996</c:v>
                </c:pt>
                <c:pt idx="84">
                  <c:v>594.92499999999995</c:v>
                </c:pt>
                <c:pt idx="85">
                  <c:v>602.00800000000004</c:v>
                </c:pt>
                <c:pt idx="86">
                  <c:v>609.09</c:v>
                </c:pt>
                <c:pt idx="87">
                  <c:v>616.173</c:v>
                </c:pt>
                <c:pt idx="88">
                  <c:v>623.255</c:v>
                </c:pt>
                <c:pt idx="89">
                  <c:v>630.33699999999999</c:v>
                </c:pt>
                <c:pt idx="90">
                  <c:v>637.41999999999996</c:v>
                </c:pt>
                <c:pt idx="91">
                  <c:v>644.50199999999995</c:v>
                </c:pt>
                <c:pt idx="92">
                  <c:v>651.58500000000004</c:v>
                </c:pt>
                <c:pt idx="93">
                  <c:v>658.66700000000003</c:v>
                </c:pt>
                <c:pt idx="94">
                  <c:v>665.75</c:v>
                </c:pt>
                <c:pt idx="95">
                  <c:v>672.83199999999999</c:v>
                </c:pt>
                <c:pt idx="96">
                  <c:v>679.91499999999996</c:v>
                </c:pt>
                <c:pt idx="97">
                  <c:v>686.99699999999996</c:v>
                </c:pt>
                <c:pt idx="98">
                  <c:v>694.07899999999995</c:v>
                </c:pt>
                <c:pt idx="99">
                  <c:v>701.16200000000003</c:v>
                </c:pt>
                <c:pt idx="100">
                  <c:v>708.24400000000003</c:v>
                </c:pt>
                <c:pt idx="101">
                  <c:v>715.327</c:v>
                </c:pt>
                <c:pt idx="102">
                  <c:v>722.40899999999999</c:v>
                </c:pt>
                <c:pt idx="103">
                  <c:v>729.49199999999996</c:v>
                </c:pt>
                <c:pt idx="104">
                  <c:v>736.57399999999996</c:v>
                </c:pt>
                <c:pt idx="105">
                  <c:v>743.65700000000004</c:v>
                </c:pt>
                <c:pt idx="106">
                  <c:v>750.73900000000003</c:v>
                </c:pt>
                <c:pt idx="107">
                  <c:v>757.82100000000003</c:v>
                </c:pt>
                <c:pt idx="108">
                  <c:v>764.904</c:v>
                </c:pt>
                <c:pt idx="109">
                  <c:v>771.98599999999999</c:v>
                </c:pt>
                <c:pt idx="110">
                  <c:v>779.06899999999996</c:v>
                </c:pt>
                <c:pt idx="111">
                  <c:v>786.15099999999995</c:v>
                </c:pt>
                <c:pt idx="112">
                  <c:v>793.23400000000004</c:v>
                </c:pt>
                <c:pt idx="113">
                  <c:v>800.31600000000003</c:v>
                </c:pt>
                <c:pt idx="114">
                  <c:v>807.399</c:v>
                </c:pt>
                <c:pt idx="115">
                  <c:v>814.48099999999999</c:v>
                </c:pt>
                <c:pt idx="116">
                  <c:v>821.56299999999999</c:v>
                </c:pt>
                <c:pt idx="117">
                  <c:v>828.64599999999996</c:v>
                </c:pt>
                <c:pt idx="118">
                  <c:v>835.72799999999995</c:v>
                </c:pt>
                <c:pt idx="119">
                  <c:v>842.81100000000004</c:v>
                </c:pt>
                <c:pt idx="120">
                  <c:v>849.89300000000003</c:v>
                </c:pt>
                <c:pt idx="121">
                  <c:v>856.976</c:v>
                </c:pt>
                <c:pt idx="122">
                  <c:v>864.05799999999999</c:v>
                </c:pt>
                <c:pt idx="123">
                  <c:v>871.14099999999996</c:v>
                </c:pt>
                <c:pt idx="124">
                  <c:v>878.22299999999996</c:v>
                </c:pt>
                <c:pt idx="125">
                  <c:v>885.30499999999995</c:v>
                </c:pt>
                <c:pt idx="126">
                  <c:v>892.38800000000003</c:v>
                </c:pt>
                <c:pt idx="127">
                  <c:v>899.47</c:v>
                </c:pt>
                <c:pt idx="128">
                  <c:v>906.553</c:v>
                </c:pt>
                <c:pt idx="129">
                  <c:v>913.63499999999999</c:v>
                </c:pt>
                <c:pt idx="130">
                  <c:v>920.71799999999996</c:v>
                </c:pt>
                <c:pt idx="131">
                  <c:v>927.8</c:v>
                </c:pt>
                <c:pt idx="132">
                  <c:v>934.88300000000004</c:v>
                </c:pt>
                <c:pt idx="133">
                  <c:v>941.96500000000003</c:v>
                </c:pt>
                <c:pt idx="134">
                  <c:v>949.04700000000003</c:v>
                </c:pt>
                <c:pt idx="135">
                  <c:v>956.13</c:v>
                </c:pt>
                <c:pt idx="136">
                  <c:v>963.21199999999999</c:v>
                </c:pt>
                <c:pt idx="137">
                  <c:v>970.29499999999996</c:v>
                </c:pt>
                <c:pt idx="138">
                  <c:v>977.37699999999995</c:v>
                </c:pt>
                <c:pt idx="139">
                  <c:v>984.46</c:v>
                </c:pt>
                <c:pt idx="140">
                  <c:v>991.54200000000003</c:v>
                </c:pt>
                <c:pt idx="141">
                  <c:v>998.62400000000002</c:v>
                </c:pt>
                <c:pt idx="142">
                  <c:v>1005.707</c:v>
                </c:pt>
                <c:pt idx="143">
                  <c:v>1012.789</c:v>
                </c:pt>
                <c:pt idx="144">
                  <c:v>1019.872</c:v>
                </c:pt>
                <c:pt idx="145">
                  <c:v>1026.954</c:v>
                </c:pt>
                <c:pt idx="146">
                  <c:v>1034.037</c:v>
                </c:pt>
                <c:pt idx="147">
                  <c:v>1041.1189999999999</c:v>
                </c:pt>
                <c:pt idx="148">
                  <c:v>1048.202</c:v>
                </c:pt>
                <c:pt idx="149">
                  <c:v>1055.2840000000001</c:v>
                </c:pt>
                <c:pt idx="150">
                  <c:v>1062.366</c:v>
                </c:pt>
                <c:pt idx="151">
                  <c:v>1069.4490000000001</c:v>
                </c:pt>
                <c:pt idx="152">
                  <c:v>1076.5309999999999</c:v>
                </c:pt>
                <c:pt idx="153">
                  <c:v>1083.614</c:v>
                </c:pt>
                <c:pt idx="154">
                  <c:v>1090.6959999999999</c:v>
                </c:pt>
                <c:pt idx="155">
                  <c:v>1097.779</c:v>
                </c:pt>
                <c:pt idx="156">
                  <c:v>1104.8610000000001</c:v>
                </c:pt>
                <c:pt idx="157">
                  <c:v>1111.944</c:v>
                </c:pt>
                <c:pt idx="158">
                  <c:v>1119.0260000000001</c:v>
                </c:pt>
                <c:pt idx="159">
                  <c:v>1126.1079999999999</c:v>
                </c:pt>
                <c:pt idx="160">
                  <c:v>1133.191</c:v>
                </c:pt>
                <c:pt idx="161">
                  <c:v>1135.788</c:v>
                </c:pt>
                <c:pt idx="162">
                  <c:v>1140.2729999999999</c:v>
                </c:pt>
                <c:pt idx="163">
                  <c:v>1147.356</c:v>
                </c:pt>
                <c:pt idx="164">
                  <c:v>1154.4380000000001</c:v>
                </c:pt>
                <c:pt idx="165">
                  <c:v>1161.521</c:v>
                </c:pt>
                <c:pt idx="166">
                  <c:v>1168.6030000000001</c:v>
                </c:pt>
                <c:pt idx="167">
                  <c:v>1175.6859999999999</c:v>
                </c:pt>
                <c:pt idx="168">
                  <c:v>1182.768</c:v>
                </c:pt>
                <c:pt idx="169">
                  <c:v>1189.8499999999999</c:v>
                </c:pt>
                <c:pt idx="170">
                  <c:v>1192.836</c:v>
                </c:pt>
                <c:pt idx="171">
                  <c:v>1196.933</c:v>
                </c:pt>
                <c:pt idx="172">
                  <c:v>1200</c:v>
                </c:pt>
                <c:pt idx="173">
                  <c:v>1204.0150000000001</c:v>
                </c:pt>
                <c:pt idx="174">
                  <c:v>1210.7329999999999</c:v>
                </c:pt>
                <c:pt idx="175">
                  <c:v>1211.098</c:v>
                </c:pt>
                <c:pt idx="176">
                  <c:v>1216.5139999999999</c:v>
                </c:pt>
                <c:pt idx="177">
                  <c:v>1218.18</c:v>
                </c:pt>
                <c:pt idx="178">
                  <c:v>1221.595</c:v>
                </c:pt>
                <c:pt idx="179">
                  <c:v>1224.8779999999999</c:v>
                </c:pt>
                <c:pt idx="180">
                  <c:v>1225.2629999999999</c:v>
                </c:pt>
                <c:pt idx="181">
                  <c:v>1229.43</c:v>
                </c:pt>
                <c:pt idx="182">
                  <c:v>1231.752</c:v>
                </c:pt>
                <c:pt idx="183">
                  <c:v>1232.345</c:v>
                </c:pt>
                <c:pt idx="184">
                  <c:v>1235.674</c:v>
                </c:pt>
                <c:pt idx="185">
                  <c:v>1239.0609999999999</c:v>
                </c:pt>
                <c:pt idx="186">
                  <c:v>1239.4280000000001</c:v>
                </c:pt>
                <c:pt idx="187">
                  <c:v>1242.9269999999999</c:v>
                </c:pt>
                <c:pt idx="188">
                  <c:v>1245.548</c:v>
                </c:pt>
                <c:pt idx="189">
                  <c:v>1246.51</c:v>
                </c:pt>
                <c:pt idx="190">
                  <c:v>1249.6559999999999</c:v>
                </c:pt>
                <c:pt idx="191">
                  <c:v>1253.1659999999999</c:v>
                </c:pt>
                <c:pt idx="192">
                  <c:v>1253.5920000000001</c:v>
                </c:pt>
                <c:pt idx="193">
                  <c:v>1255.548</c:v>
                </c:pt>
                <c:pt idx="194">
                  <c:v>1258.046</c:v>
                </c:pt>
                <c:pt idx="195">
                  <c:v>1260.675</c:v>
                </c:pt>
                <c:pt idx="196">
                  <c:v>1260.9549999999999</c:v>
                </c:pt>
                <c:pt idx="197">
                  <c:v>1263.903</c:v>
                </c:pt>
                <c:pt idx="198">
                  <c:v>1265.6559999999999</c:v>
                </c:pt>
                <c:pt idx="199">
                  <c:v>1267.4290000000001</c:v>
                </c:pt>
                <c:pt idx="200">
                  <c:v>1267.7570000000001</c:v>
                </c:pt>
                <c:pt idx="201">
                  <c:v>1268.318</c:v>
                </c:pt>
                <c:pt idx="202">
                  <c:v>1272.0170000000001</c:v>
                </c:pt>
                <c:pt idx="203">
                  <c:v>1274.1020000000001</c:v>
                </c:pt>
                <c:pt idx="204">
                  <c:v>1274.8399999999999</c:v>
                </c:pt>
                <c:pt idx="205">
                  <c:v>1276.752</c:v>
                </c:pt>
                <c:pt idx="206">
                  <c:v>1279.5440000000001</c:v>
                </c:pt>
                <c:pt idx="207">
                  <c:v>1281.4259999999999</c:v>
                </c:pt>
                <c:pt idx="208">
                  <c:v>1281.922</c:v>
                </c:pt>
                <c:pt idx="209">
                  <c:v>1285.0150000000001</c:v>
                </c:pt>
                <c:pt idx="210">
                  <c:v>1286.5329999999999</c:v>
                </c:pt>
                <c:pt idx="211">
                  <c:v>1288.1890000000001</c:v>
                </c:pt>
                <c:pt idx="212">
                  <c:v>1289.0050000000001</c:v>
                </c:pt>
                <c:pt idx="213">
                  <c:v>1289.355</c:v>
                </c:pt>
                <c:pt idx="214">
                  <c:v>1290.3389999999999</c:v>
                </c:pt>
                <c:pt idx="215">
                  <c:v>1291.954</c:v>
                </c:pt>
                <c:pt idx="216">
                  <c:v>1292.8689999999999</c:v>
                </c:pt>
                <c:pt idx="217">
                  <c:v>1295.0060000000001</c:v>
                </c:pt>
                <c:pt idx="218">
                  <c:v>1296.087</c:v>
                </c:pt>
                <c:pt idx="219">
                  <c:v>1298.0060000000001</c:v>
                </c:pt>
                <c:pt idx="220">
                  <c:v>1299.789</c:v>
                </c:pt>
                <c:pt idx="221">
                  <c:v>1301.385</c:v>
                </c:pt>
                <c:pt idx="222">
                  <c:v>1302.7260000000001</c:v>
                </c:pt>
                <c:pt idx="223">
                  <c:v>1303.17</c:v>
                </c:pt>
                <c:pt idx="224">
                  <c:v>1303.58</c:v>
                </c:pt>
                <c:pt idx="225">
                  <c:v>1304.5329999999999</c:v>
                </c:pt>
                <c:pt idx="226">
                  <c:v>1305.624</c:v>
                </c:pt>
                <c:pt idx="227">
                  <c:v>1306.4349999999999</c:v>
                </c:pt>
                <c:pt idx="228">
                  <c:v>1308.173</c:v>
                </c:pt>
                <c:pt idx="229">
                  <c:v>1309.1120000000001</c:v>
                </c:pt>
                <c:pt idx="230">
                  <c:v>1309.7719999999999</c:v>
                </c:pt>
                <c:pt idx="231">
                  <c:v>1310.252</c:v>
                </c:pt>
                <c:pt idx="232">
                  <c:v>1310.991</c:v>
                </c:pt>
                <c:pt idx="233">
                  <c:v>1311.675</c:v>
                </c:pt>
                <c:pt idx="234">
                  <c:v>1312.421</c:v>
                </c:pt>
                <c:pt idx="235">
                  <c:v>1313.1590000000001</c:v>
                </c:pt>
                <c:pt idx="236">
                  <c:v>1314.7950000000001</c:v>
                </c:pt>
                <c:pt idx="237">
                  <c:v>1315.606</c:v>
                </c:pt>
                <c:pt idx="238">
                  <c:v>1316.2550000000001</c:v>
                </c:pt>
                <c:pt idx="239">
                  <c:v>1317.3340000000001</c:v>
                </c:pt>
                <c:pt idx="240">
                  <c:v>1317.38</c:v>
                </c:pt>
                <c:pt idx="241">
                  <c:v>1318.2940000000001</c:v>
                </c:pt>
                <c:pt idx="242">
                  <c:v>1319.0630000000001</c:v>
                </c:pt>
                <c:pt idx="243">
                  <c:v>1319.8030000000001</c:v>
                </c:pt>
                <c:pt idx="244">
                  <c:v>1320.4739999999999</c:v>
                </c:pt>
                <c:pt idx="245">
                  <c:v>1321.143</c:v>
                </c:pt>
                <c:pt idx="246">
                  <c:v>1322.338</c:v>
                </c:pt>
                <c:pt idx="247">
                  <c:v>1323.2629999999999</c:v>
                </c:pt>
                <c:pt idx="248">
                  <c:v>1323.83</c:v>
                </c:pt>
                <c:pt idx="249">
                  <c:v>1324.357</c:v>
                </c:pt>
                <c:pt idx="250">
                  <c:v>1324.4169999999999</c:v>
                </c:pt>
                <c:pt idx="251">
                  <c:v>1325.7159999999999</c:v>
                </c:pt>
                <c:pt idx="252">
                  <c:v>1326.2760000000001</c:v>
                </c:pt>
                <c:pt idx="253">
                  <c:v>1326.7739999999999</c:v>
                </c:pt>
                <c:pt idx="254">
                  <c:v>1327.204</c:v>
                </c:pt>
                <c:pt idx="255">
                  <c:v>1327.8140000000001</c:v>
                </c:pt>
                <c:pt idx="256">
                  <c:v>1328.1179999999999</c:v>
                </c:pt>
                <c:pt idx="257">
                  <c:v>1329.2249999999999</c:v>
                </c:pt>
                <c:pt idx="258">
                  <c:v>1330.1569999999999</c:v>
                </c:pt>
                <c:pt idx="259">
                  <c:v>1330.9970000000001</c:v>
                </c:pt>
                <c:pt idx="260">
                  <c:v>1331.2260000000001</c:v>
                </c:pt>
                <c:pt idx="261">
                  <c:v>1331.499</c:v>
                </c:pt>
                <c:pt idx="262">
                  <c:v>1332.029</c:v>
                </c:pt>
                <c:pt idx="263">
                  <c:v>1332.556</c:v>
                </c:pt>
                <c:pt idx="264">
                  <c:v>1333.01</c:v>
                </c:pt>
                <c:pt idx="265">
                  <c:v>1333.4949999999999</c:v>
                </c:pt>
                <c:pt idx="266">
                  <c:v>1333.999</c:v>
                </c:pt>
                <c:pt idx="267">
                  <c:v>1334.732</c:v>
                </c:pt>
                <c:pt idx="268">
                  <c:v>1334.9960000000001</c:v>
                </c:pt>
                <c:pt idx="269">
                  <c:v>1335.49</c:v>
                </c:pt>
                <c:pt idx="270">
                  <c:v>1336.038</c:v>
                </c:pt>
                <c:pt idx="271">
                  <c:v>1336.521</c:v>
                </c:pt>
                <c:pt idx="272">
                  <c:v>1336.8409999999999</c:v>
                </c:pt>
                <c:pt idx="273">
                  <c:v>1337.4280000000001</c:v>
                </c:pt>
                <c:pt idx="274">
                  <c:v>1337.873</c:v>
                </c:pt>
                <c:pt idx="275">
                  <c:v>1338.3679999999999</c:v>
                </c:pt>
                <c:pt idx="276">
                  <c:v>1338.5820000000001</c:v>
                </c:pt>
                <c:pt idx="277">
                  <c:v>1338.7439999999999</c:v>
                </c:pt>
                <c:pt idx="278">
                  <c:v>1339.15</c:v>
                </c:pt>
                <c:pt idx="279">
                  <c:v>1339.999</c:v>
                </c:pt>
                <c:pt idx="280">
                  <c:v>1340.4459999999999</c:v>
                </c:pt>
                <c:pt idx="281">
                  <c:v>1340.6759999999999</c:v>
                </c:pt>
                <c:pt idx="282">
                  <c:v>1340.89</c:v>
                </c:pt>
                <c:pt idx="283">
                  <c:v>1341.4949999999999</c:v>
                </c:pt>
                <c:pt idx="284">
                  <c:v>1342.0530000000001</c:v>
                </c:pt>
                <c:pt idx="285">
                  <c:v>1342.3679999999999</c:v>
                </c:pt>
                <c:pt idx="286">
                  <c:v>1342.7329999999999</c:v>
                </c:pt>
                <c:pt idx="287">
                  <c:v>1343.2180000000001</c:v>
                </c:pt>
                <c:pt idx="288">
                  <c:v>1343.471</c:v>
                </c:pt>
                <c:pt idx="289">
                  <c:v>1343.645</c:v>
                </c:pt>
                <c:pt idx="290">
                  <c:v>1344.24</c:v>
                </c:pt>
                <c:pt idx="291">
                  <c:v>1345.1880000000001</c:v>
                </c:pt>
                <c:pt idx="292">
                  <c:v>1345.356</c:v>
                </c:pt>
                <c:pt idx="293">
                  <c:v>1345.664</c:v>
                </c:pt>
                <c:pt idx="294">
                  <c:v>1345.98</c:v>
                </c:pt>
                <c:pt idx="295">
                  <c:v>1346.662</c:v>
                </c:pt>
                <c:pt idx="296">
                  <c:v>1347.174</c:v>
                </c:pt>
                <c:pt idx="297">
                  <c:v>1347.65</c:v>
                </c:pt>
                <c:pt idx="298">
                  <c:v>1347.8130000000001</c:v>
                </c:pt>
                <c:pt idx="299">
                  <c:v>1348.2360000000001</c:v>
                </c:pt>
                <c:pt idx="300">
                  <c:v>1348.768</c:v>
                </c:pt>
                <c:pt idx="301">
                  <c:v>1349.1110000000001</c:v>
                </c:pt>
                <c:pt idx="302">
                  <c:v>1349.33</c:v>
                </c:pt>
                <c:pt idx="303">
                  <c:v>1349.6120000000001</c:v>
                </c:pt>
                <c:pt idx="304">
                  <c:v>1349.788</c:v>
                </c:pt>
                <c:pt idx="305">
                  <c:v>1350.2429999999999</c:v>
                </c:pt>
                <c:pt idx="306">
                  <c:v>1351.242</c:v>
                </c:pt>
                <c:pt idx="307">
                  <c:v>1351.5250000000001</c:v>
                </c:pt>
                <c:pt idx="308">
                  <c:v>1351.933</c:v>
                </c:pt>
                <c:pt idx="309">
                  <c:v>1352.5440000000001</c:v>
                </c:pt>
                <c:pt idx="310">
                  <c:v>1352.7470000000001</c:v>
                </c:pt>
                <c:pt idx="311">
                  <c:v>1352.8710000000001</c:v>
                </c:pt>
                <c:pt idx="312">
                  <c:v>1353.423</c:v>
                </c:pt>
                <c:pt idx="313">
                  <c:v>1353.6669999999999</c:v>
                </c:pt>
                <c:pt idx="314">
                  <c:v>1354.175</c:v>
                </c:pt>
                <c:pt idx="315">
                  <c:v>1354.595</c:v>
                </c:pt>
                <c:pt idx="316">
                  <c:v>1355.0039999999999</c:v>
                </c:pt>
                <c:pt idx="317">
                  <c:v>1355.442</c:v>
                </c:pt>
                <c:pt idx="318">
                  <c:v>1355.7380000000001</c:v>
                </c:pt>
                <c:pt idx="319">
                  <c:v>1356.3119999999999</c:v>
                </c:pt>
                <c:pt idx="320">
                  <c:v>1356.579</c:v>
                </c:pt>
                <c:pt idx="321">
                  <c:v>1356.8889999999999</c:v>
                </c:pt>
                <c:pt idx="322">
                  <c:v>1357.0930000000001</c:v>
                </c:pt>
                <c:pt idx="323">
                  <c:v>1357.154</c:v>
                </c:pt>
                <c:pt idx="324">
                  <c:v>1357.413</c:v>
                </c:pt>
                <c:pt idx="325">
                  <c:v>1357.5160000000001</c:v>
                </c:pt>
                <c:pt idx="326">
                  <c:v>1357.89</c:v>
                </c:pt>
                <c:pt idx="327">
                  <c:v>1358.115</c:v>
                </c:pt>
                <c:pt idx="328">
                  <c:v>1358.46</c:v>
                </c:pt>
                <c:pt idx="329">
                  <c:v>1358.7750000000001</c:v>
                </c:pt>
                <c:pt idx="330">
                  <c:v>1358.864</c:v>
                </c:pt>
                <c:pt idx="331">
                  <c:v>1359.2809999999999</c:v>
                </c:pt>
                <c:pt idx="332">
                  <c:v>1359.595</c:v>
                </c:pt>
                <c:pt idx="333">
                  <c:v>1359.829</c:v>
                </c:pt>
                <c:pt idx="334">
                  <c:v>1359.982</c:v>
                </c:pt>
                <c:pt idx="335">
                  <c:v>1360.1369999999999</c:v>
                </c:pt>
                <c:pt idx="336">
                  <c:v>1360.4090000000001</c:v>
                </c:pt>
                <c:pt idx="337">
                  <c:v>1360.7570000000001</c:v>
                </c:pt>
                <c:pt idx="338">
                  <c:v>1360.94</c:v>
                </c:pt>
                <c:pt idx="339">
                  <c:v>1361.509</c:v>
                </c:pt>
                <c:pt idx="340">
                  <c:v>1361.6780000000001</c:v>
                </c:pt>
                <c:pt idx="341">
                  <c:v>1362.008</c:v>
                </c:pt>
                <c:pt idx="342">
                  <c:v>1362.097</c:v>
                </c:pt>
                <c:pt idx="343">
                  <c:v>1362.557</c:v>
                </c:pt>
                <c:pt idx="344">
                  <c:v>1362.9390000000001</c:v>
                </c:pt>
                <c:pt idx="345">
                  <c:v>1363.5989999999999</c:v>
                </c:pt>
                <c:pt idx="346">
                  <c:v>1364.0239999999999</c:v>
                </c:pt>
                <c:pt idx="347">
                  <c:v>1364.1489999999999</c:v>
                </c:pt>
                <c:pt idx="348">
                  <c:v>1364.6859999999999</c:v>
                </c:pt>
                <c:pt idx="349">
                  <c:v>1365.2719999999999</c:v>
                </c:pt>
                <c:pt idx="350">
                  <c:v>1365.5409999999999</c:v>
                </c:pt>
                <c:pt idx="351">
                  <c:v>1365.7719999999999</c:v>
                </c:pt>
                <c:pt idx="352">
                  <c:v>1366.239</c:v>
                </c:pt>
                <c:pt idx="353">
                  <c:v>1366.4380000000001</c:v>
                </c:pt>
                <c:pt idx="354">
                  <c:v>1366.912</c:v>
                </c:pt>
                <c:pt idx="355">
                  <c:v>1367.1179999999999</c:v>
                </c:pt>
                <c:pt idx="356">
                  <c:v>1367.672</c:v>
                </c:pt>
                <c:pt idx="357">
                  <c:v>1368.116</c:v>
                </c:pt>
                <c:pt idx="358">
                  <c:v>1368.7249999999999</c:v>
                </c:pt>
                <c:pt idx="359">
                  <c:v>1370.0930000000001</c:v>
                </c:pt>
                <c:pt idx="360">
                  <c:v>1370.424</c:v>
                </c:pt>
                <c:pt idx="361">
                  <c:v>1370.607</c:v>
                </c:pt>
                <c:pt idx="362">
                  <c:v>1370.7719999999999</c:v>
                </c:pt>
                <c:pt idx="363">
                  <c:v>1371.039</c:v>
                </c:pt>
                <c:pt idx="364">
                  <c:v>1372.0319999999999</c:v>
                </c:pt>
                <c:pt idx="365">
                  <c:v>1372.8920000000001</c:v>
                </c:pt>
                <c:pt idx="366">
                  <c:v>1373.88</c:v>
                </c:pt>
                <c:pt idx="367">
                  <c:v>1373.9939999999999</c:v>
                </c:pt>
                <c:pt idx="368">
                  <c:v>1374.4259999999999</c:v>
                </c:pt>
                <c:pt idx="369">
                  <c:v>1375.578</c:v>
                </c:pt>
                <c:pt idx="370">
                  <c:v>1376.3620000000001</c:v>
                </c:pt>
                <c:pt idx="371">
                  <c:v>1376.838</c:v>
                </c:pt>
                <c:pt idx="372">
                  <c:v>1377.806</c:v>
                </c:pt>
                <c:pt idx="373">
                  <c:v>1378.31</c:v>
                </c:pt>
                <c:pt idx="374">
                  <c:v>1379.231</c:v>
                </c:pt>
                <c:pt idx="375">
                  <c:v>1379.873</c:v>
                </c:pt>
                <c:pt idx="376">
                  <c:v>1381.076</c:v>
                </c:pt>
                <c:pt idx="377">
                  <c:v>1381.1489999999999</c:v>
                </c:pt>
                <c:pt idx="378">
                  <c:v>1381.809</c:v>
                </c:pt>
                <c:pt idx="379">
                  <c:v>1383.7080000000001</c:v>
                </c:pt>
                <c:pt idx="380">
                  <c:v>1384.614</c:v>
                </c:pt>
                <c:pt idx="381">
                  <c:v>1385.5630000000001</c:v>
                </c:pt>
                <c:pt idx="382">
                  <c:v>1387.0709999999999</c:v>
                </c:pt>
                <c:pt idx="383">
                  <c:v>1387.6590000000001</c:v>
                </c:pt>
                <c:pt idx="384">
                  <c:v>1388.1590000000001</c:v>
                </c:pt>
                <c:pt idx="385">
                  <c:v>1389.912</c:v>
                </c:pt>
                <c:pt idx="386">
                  <c:v>1391.193</c:v>
                </c:pt>
                <c:pt idx="387">
                  <c:v>1391.4570000000001</c:v>
                </c:pt>
                <c:pt idx="388">
                  <c:v>1392.058</c:v>
                </c:pt>
                <c:pt idx="389">
                  <c:v>1393.4349999999999</c:v>
                </c:pt>
                <c:pt idx="390">
                  <c:v>1395.241</c:v>
                </c:pt>
                <c:pt idx="391">
                  <c:v>1396.1849999999999</c:v>
                </c:pt>
                <c:pt idx="392">
                  <c:v>1399.499</c:v>
                </c:pt>
                <c:pt idx="393">
                  <c:v>1401.231</c:v>
                </c:pt>
                <c:pt idx="394">
                  <c:v>1402.3240000000001</c:v>
                </c:pt>
                <c:pt idx="395">
                  <c:v>1402.492</c:v>
                </c:pt>
                <c:pt idx="396">
                  <c:v>1404.09</c:v>
                </c:pt>
                <c:pt idx="397">
                  <c:v>1405.4870000000001</c:v>
                </c:pt>
                <c:pt idx="398">
                  <c:v>1406.6410000000001</c:v>
                </c:pt>
                <c:pt idx="399">
                  <c:v>1409.4059999999999</c:v>
                </c:pt>
                <c:pt idx="400">
                  <c:v>1416.489</c:v>
                </c:pt>
                <c:pt idx="401">
                  <c:v>1416.489</c:v>
                </c:pt>
              </c:numCache>
            </c:numRef>
          </c:xVal>
          <c:yVal>
            <c:numRef>
              <c:f>Foglio6!$L$5:$L$406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100</c:v>
                </c:pt>
                <c:pt idx="76">
                  <c:v>100</c:v>
                </c:pt>
                <c:pt idx="77">
                  <c:v>100</c:v>
                </c:pt>
                <c:pt idx="78">
                  <c:v>100</c:v>
                </c:pt>
                <c:pt idx="79">
                  <c:v>100</c:v>
                </c:pt>
                <c:pt idx="80">
                  <c:v>100</c:v>
                </c:pt>
                <c:pt idx="81">
                  <c:v>100</c:v>
                </c:pt>
                <c:pt idx="82">
                  <c:v>100</c:v>
                </c:pt>
                <c:pt idx="83">
                  <c:v>100</c:v>
                </c:pt>
                <c:pt idx="84">
                  <c:v>100</c:v>
                </c:pt>
                <c:pt idx="85">
                  <c:v>100</c:v>
                </c:pt>
                <c:pt idx="86">
                  <c:v>100</c:v>
                </c:pt>
                <c:pt idx="87">
                  <c:v>100</c:v>
                </c:pt>
                <c:pt idx="88">
                  <c:v>100</c:v>
                </c:pt>
                <c:pt idx="89">
                  <c:v>100</c:v>
                </c:pt>
                <c:pt idx="90">
                  <c:v>100</c:v>
                </c:pt>
                <c:pt idx="91">
                  <c:v>100</c:v>
                </c:pt>
                <c:pt idx="92">
                  <c:v>100</c:v>
                </c:pt>
                <c:pt idx="93">
                  <c:v>100</c:v>
                </c:pt>
                <c:pt idx="94">
                  <c:v>100</c:v>
                </c:pt>
                <c:pt idx="95">
                  <c:v>100</c:v>
                </c:pt>
                <c:pt idx="96">
                  <c:v>100</c:v>
                </c:pt>
                <c:pt idx="97">
                  <c:v>100</c:v>
                </c:pt>
                <c:pt idx="98">
                  <c:v>100</c:v>
                </c:pt>
                <c:pt idx="99">
                  <c:v>100</c:v>
                </c:pt>
                <c:pt idx="100">
                  <c:v>100</c:v>
                </c:pt>
                <c:pt idx="101">
                  <c:v>100</c:v>
                </c:pt>
                <c:pt idx="102">
                  <c:v>100</c:v>
                </c:pt>
                <c:pt idx="103">
                  <c:v>100</c:v>
                </c:pt>
                <c:pt idx="104">
                  <c:v>100</c:v>
                </c:pt>
                <c:pt idx="105">
                  <c:v>100</c:v>
                </c:pt>
                <c:pt idx="106">
                  <c:v>100</c:v>
                </c:pt>
                <c:pt idx="107">
                  <c:v>100</c:v>
                </c:pt>
                <c:pt idx="108">
                  <c:v>100</c:v>
                </c:pt>
                <c:pt idx="109">
                  <c:v>100</c:v>
                </c:pt>
                <c:pt idx="110">
                  <c:v>100</c:v>
                </c:pt>
                <c:pt idx="111">
                  <c:v>100</c:v>
                </c:pt>
                <c:pt idx="112">
                  <c:v>100</c:v>
                </c:pt>
                <c:pt idx="113">
                  <c:v>100</c:v>
                </c:pt>
                <c:pt idx="114">
                  <c:v>100</c:v>
                </c:pt>
                <c:pt idx="115">
                  <c:v>100</c:v>
                </c:pt>
                <c:pt idx="116">
                  <c:v>100</c:v>
                </c:pt>
                <c:pt idx="117">
                  <c:v>100</c:v>
                </c:pt>
                <c:pt idx="118">
                  <c:v>100</c:v>
                </c:pt>
                <c:pt idx="119">
                  <c:v>100</c:v>
                </c:pt>
                <c:pt idx="120">
                  <c:v>100</c:v>
                </c:pt>
                <c:pt idx="121">
                  <c:v>100</c:v>
                </c:pt>
                <c:pt idx="122">
                  <c:v>100</c:v>
                </c:pt>
                <c:pt idx="123">
                  <c:v>100</c:v>
                </c:pt>
                <c:pt idx="124">
                  <c:v>100</c:v>
                </c:pt>
                <c:pt idx="125">
                  <c:v>100</c:v>
                </c:pt>
                <c:pt idx="126">
                  <c:v>100</c:v>
                </c:pt>
                <c:pt idx="127">
                  <c:v>100</c:v>
                </c:pt>
                <c:pt idx="128">
                  <c:v>100</c:v>
                </c:pt>
                <c:pt idx="129">
                  <c:v>100</c:v>
                </c:pt>
                <c:pt idx="130">
                  <c:v>100</c:v>
                </c:pt>
                <c:pt idx="131">
                  <c:v>100</c:v>
                </c:pt>
                <c:pt idx="132">
                  <c:v>100</c:v>
                </c:pt>
                <c:pt idx="133">
                  <c:v>100</c:v>
                </c:pt>
                <c:pt idx="134">
                  <c:v>100</c:v>
                </c:pt>
                <c:pt idx="135">
                  <c:v>100</c:v>
                </c:pt>
                <c:pt idx="136">
                  <c:v>100</c:v>
                </c:pt>
                <c:pt idx="137">
                  <c:v>100</c:v>
                </c:pt>
                <c:pt idx="138">
                  <c:v>100</c:v>
                </c:pt>
                <c:pt idx="139">
                  <c:v>100</c:v>
                </c:pt>
                <c:pt idx="140">
                  <c:v>100</c:v>
                </c:pt>
                <c:pt idx="141">
                  <c:v>100</c:v>
                </c:pt>
                <c:pt idx="142">
                  <c:v>100</c:v>
                </c:pt>
                <c:pt idx="143">
                  <c:v>100</c:v>
                </c:pt>
                <c:pt idx="144">
                  <c:v>100</c:v>
                </c:pt>
                <c:pt idx="145">
                  <c:v>100</c:v>
                </c:pt>
                <c:pt idx="146">
                  <c:v>100</c:v>
                </c:pt>
                <c:pt idx="147">
                  <c:v>100</c:v>
                </c:pt>
                <c:pt idx="148">
                  <c:v>100</c:v>
                </c:pt>
                <c:pt idx="149">
                  <c:v>100</c:v>
                </c:pt>
                <c:pt idx="150">
                  <c:v>100</c:v>
                </c:pt>
                <c:pt idx="151">
                  <c:v>100</c:v>
                </c:pt>
                <c:pt idx="152">
                  <c:v>100</c:v>
                </c:pt>
                <c:pt idx="153">
                  <c:v>100</c:v>
                </c:pt>
                <c:pt idx="154">
                  <c:v>100</c:v>
                </c:pt>
                <c:pt idx="155">
                  <c:v>100</c:v>
                </c:pt>
                <c:pt idx="156">
                  <c:v>100</c:v>
                </c:pt>
                <c:pt idx="157">
                  <c:v>100</c:v>
                </c:pt>
                <c:pt idx="158">
                  <c:v>100</c:v>
                </c:pt>
                <c:pt idx="159">
                  <c:v>100</c:v>
                </c:pt>
                <c:pt idx="160">
                  <c:v>100</c:v>
                </c:pt>
                <c:pt idx="161">
                  <c:v>100</c:v>
                </c:pt>
                <c:pt idx="162">
                  <c:v>99.986000000000004</c:v>
                </c:pt>
                <c:pt idx="163">
                  <c:v>99.981999999999999</c:v>
                </c:pt>
                <c:pt idx="164">
                  <c:v>99.98</c:v>
                </c:pt>
                <c:pt idx="165">
                  <c:v>99.977999999999994</c:v>
                </c:pt>
                <c:pt idx="166">
                  <c:v>99.953999999999994</c:v>
                </c:pt>
                <c:pt idx="167">
                  <c:v>99.813000000000002</c:v>
                </c:pt>
                <c:pt idx="168">
                  <c:v>99.751999999999995</c:v>
                </c:pt>
                <c:pt idx="169">
                  <c:v>99.66</c:v>
                </c:pt>
                <c:pt idx="170">
                  <c:v>99.5</c:v>
                </c:pt>
                <c:pt idx="171">
                  <c:v>99.284999999999997</c:v>
                </c:pt>
                <c:pt idx="172">
                  <c:v>99</c:v>
                </c:pt>
                <c:pt idx="173">
                  <c:v>98.841999999999999</c:v>
                </c:pt>
                <c:pt idx="174">
                  <c:v>98.5</c:v>
                </c:pt>
                <c:pt idx="175">
                  <c:v>98.488</c:v>
                </c:pt>
                <c:pt idx="176">
                  <c:v>98</c:v>
                </c:pt>
                <c:pt idx="177">
                  <c:v>97.715999999999994</c:v>
                </c:pt>
                <c:pt idx="178">
                  <c:v>97.5</c:v>
                </c:pt>
                <c:pt idx="179">
                  <c:v>97</c:v>
                </c:pt>
                <c:pt idx="180">
                  <c:v>96.977000000000004</c:v>
                </c:pt>
                <c:pt idx="181">
                  <c:v>96.5</c:v>
                </c:pt>
                <c:pt idx="182">
                  <c:v>96</c:v>
                </c:pt>
                <c:pt idx="183">
                  <c:v>95.878</c:v>
                </c:pt>
                <c:pt idx="184">
                  <c:v>95.5</c:v>
                </c:pt>
                <c:pt idx="185">
                  <c:v>95</c:v>
                </c:pt>
                <c:pt idx="186">
                  <c:v>94.87</c:v>
                </c:pt>
                <c:pt idx="187">
                  <c:v>94.5</c:v>
                </c:pt>
                <c:pt idx="188">
                  <c:v>94</c:v>
                </c:pt>
                <c:pt idx="189">
                  <c:v>93.808000000000007</c:v>
                </c:pt>
                <c:pt idx="190">
                  <c:v>93.5</c:v>
                </c:pt>
                <c:pt idx="191">
                  <c:v>93</c:v>
                </c:pt>
                <c:pt idx="192">
                  <c:v>92.956000000000003</c:v>
                </c:pt>
                <c:pt idx="193">
                  <c:v>92.5</c:v>
                </c:pt>
                <c:pt idx="194">
                  <c:v>92</c:v>
                </c:pt>
                <c:pt idx="195">
                  <c:v>91.611999999999995</c:v>
                </c:pt>
                <c:pt idx="196">
                  <c:v>91.5</c:v>
                </c:pt>
                <c:pt idx="197">
                  <c:v>91</c:v>
                </c:pt>
                <c:pt idx="198">
                  <c:v>90.5</c:v>
                </c:pt>
                <c:pt idx="199">
                  <c:v>90</c:v>
                </c:pt>
                <c:pt idx="200">
                  <c:v>89.846000000000004</c:v>
                </c:pt>
                <c:pt idx="201">
                  <c:v>89.5</c:v>
                </c:pt>
                <c:pt idx="202">
                  <c:v>89</c:v>
                </c:pt>
                <c:pt idx="203">
                  <c:v>88.5</c:v>
                </c:pt>
                <c:pt idx="204">
                  <c:v>88.266999999999996</c:v>
                </c:pt>
                <c:pt idx="205">
                  <c:v>88</c:v>
                </c:pt>
                <c:pt idx="206">
                  <c:v>87.5</c:v>
                </c:pt>
                <c:pt idx="207">
                  <c:v>87</c:v>
                </c:pt>
                <c:pt idx="208">
                  <c:v>86.923000000000002</c:v>
                </c:pt>
                <c:pt idx="209">
                  <c:v>86.5</c:v>
                </c:pt>
                <c:pt idx="210">
                  <c:v>86</c:v>
                </c:pt>
                <c:pt idx="211">
                  <c:v>85.5</c:v>
                </c:pt>
                <c:pt idx="212">
                  <c:v>85.225999999999999</c:v>
                </c:pt>
                <c:pt idx="213">
                  <c:v>85</c:v>
                </c:pt>
                <c:pt idx="214">
                  <c:v>84.5</c:v>
                </c:pt>
                <c:pt idx="215">
                  <c:v>84</c:v>
                </c:pt>
                <c:pt idx="216">
                  <c:v>83.5</c:v>
                </c:pt>
                <c:pt idx="217">
                  <c:v>83</c:v>
                </c:pt>
                <c:pt idx="218">
                  <c:v>82.802000000000007</c:v>
                </c:pt>
                <c:pt idx="219">
                  <c:v>82.5</c:v>
                </c:pt>
                <c:pt idx="220">
                  <c:v>82</c:v>
                </c:pt>
                <c:pt idx="221">
                  <c:v>81.5</c:v>
                </c:pt>
                <c:pt idx="222">
                  <c:v>81</c:v>
                </c:pt>
                <c:pt idx="223">
                  <c:v>80.897999999999996</c:v>
                </c:pt>
                <c:pt idx="224">
                  <c:v>80.5</c:v>
                </c:pt>
                <c:pt idx="225">
                  <c:v>80</c:v>
                </c:pt>
                <c:pt idx="226">
                  <c:v>79.5</c:v>
                </c:pt>
                <c:pt idx="227">
                  <c:v>79</c:v>
                </c:pt>
                <c:pt idx="228">
                  <c:v>78.5</c:v>
                </c:pt>
                <c:pt idx="229">
                  <c:v>78</c:v>
                </c:pt>
                <c:pt idx="230">
                  <c:v>77.5</c:v>
                </c:pt>
                <c:pt idx="231">
                  <c:v>77.382999999999996</c:v>
                </c:pt>
                <c:pt idx="232">
                  <c:v>77</c:v>
                </c:pt>
                <c:pt idx="233">
                  <c:v>76.5</c:v>
                </c:pt>
                <c:pt idx="234">
                  <c:v>76</c:v>
                </c:pt>
                <c:pt idx="235">
                  <c:v>75.5</c:v>
                </c:pt>
                <c:pt idx="236">
                  <c:v>75</c:v>
                </c:pt>
                <c:pt idx="237">
                  <c:v>74.5</c:v>
                </c:pt>
                <c:pt idx="238">
                  <c:v>74</c:v>
                </c:pt>
                <c:pt idx="239">
                  <c:v>73.545000000000002</c:v>
                </c:pt>
                <c:pt idx="240">
                  <c:v>73.5</c:v>
                </c:pt>
                <c:pt idx="241">
                  <c:v>73</c:v>
                </c:pt>
                <c:pt idx="242">
                  <c:v>72.5</c:v>
                </c:pt>
                <c:pt idx="243">
                  <c:v>72</c:v>
                </c:pt>
                <c:pt idx="244">
                  <c:v>71.5</c:v>
                </c:pt>
                <c:pt idx="245">
                  <c:v>71</c:v>
                </c:pt>
                <c:pt idx="246">
                  <c:v>70.5</c:v>
                </c:pt>
                <c:pt idx="247">
                  <c:v>70</c:v>
                </c:pt>
                <c:pt idx="248">
                  <c:v>69.5</c:v>
                </c:pt>
                <c:pt idx="249">
                  <c:v>69</c:v>
                </c:pt>
                <c:pt idx="250">
                  <c:v>68.988</c:v>
                </c:pt>
                <c:pt idx="251">
                  <c:v>68.5</c:v>
                </c:pt>
                <c:pt idx="252">
                  <c:v>68</c:v>
                </c:pt>
                <c:pt idx="253">
                  <c:v>67.5</c:v>
                </c:pt>
                <c:pt idx="254">
                  <c:v>67</c:v>
                </c:pt>
                <c:pt idx="255">
                  <c:v>66.5</c:v>
                </c:pt>
                <c:pt idx="256">
                  <c:v>66</c:v>
                </c:pt>
                <c:pt idx="257">
                  <c:v>65.5</c:v>
                </c:pt>
                <c:pt idx="258">
                  <c:v>65</c:v>
                </c:pt>
                <c:pt idx="259">
                  <c:v>64.5</c:v>
                </c:pt>
                <c:pt idx="260">
                  <c:v>64</c:v>
                </c:pt>
                <c:pt idx="261">
                  <c:v>63.951000000000001</c:v>
                </c:pt>
                <c:pt idx="262">
                  <c:v>63.5</c:v>
                </c:pt>
                <c:pt idx="263">
                  <c:v>63</c:v>
                </c:pt>
                <c:pt idx="264">
                  <c:v>62.5</c:v>
                </c:pt>
                <c:pt idx="265">
                  <c:v>62</c:v>
                </c:pt>
                <c:pt idx="266">
                  <c:v>61.5</c:v>
                </c:pt>
                <c:pt idx="267">
                  <c:v>61</c:v>
                </c:pt>
                <c:pt idx="268">
                  <c:v>60.5</c:v>
                </c:pt>
                <c:pt idx="269">
                  <c:v>60</c:v>
                </c:pt>
                <c:pt idx="270">
                  <c:v>59.5</c:v>
                </c:pt>
                <c:pt idx="271">
                  <c:v>59</c:v>
                </c:pt>
                <c:pt idx="272">
                  <c:v>58.5</c:v>
                </c:pt>
                <c:pt idx="273">
                  <c:v>58</c:v>
                </c:pt>
                <c:pt idx="274">
                  <c:v>57.5</c:v>
                </c:pt>
                <c:pt idx="275">
                  <c:v>57</c:v>
                </c:pt>
                <c:pt idx="276">
                  <c:v>56.625999999999998</c:v>
                </c:pt>
                <c:pt idx="277">
                  <c:v>56.5</c:v>
                </c:pt>
                <c:pt idx="278">
                  <c:v>56</c:v>
                </c:pt>
                <c:pt idx="279">
                  <c:v>55.5</c:v>
                </c:pt>
                <c:pt idx="280">
                  <c:v>55</c:v>
                </c:pt>
                <c:pt idx="281">
                  <c:v>54.5</c:v>
                </c:pt>
                <c:pt idx="282">
                  <c:v>54</c:v>
                </c:pt>
                <c:pt idx="283">
                  <c:v>53.5</c:v>
                </c:pt>
                <c:pt idx="284">
                  <c:v>53</c:v>
                </c:pt>
                <c:pt idx="285">
                  <c:v>52.5</c:v>
                </c:pt>
                <c:pt idx="286">
                  <c:v>52</c:v>
                </c:pt>
                <c:pt idx="287">
                  <c:v>51.5</c:v>
                </c:pt>
                <c:pt idx="288">
                  <c:v>51</c:v>
                </c:pt>
                <c:pt idx="289">
                  <c:v>50.5</c:v>
                </c:pt>
                <c:pt idx="290">
                  <c:v>50</c:v>
                </c:pt>
                <c:pt idx="291">
                  <c:v>49.5</c:v>
                </c:pt>
                <c:pt idx="292">
                  <c:v>49</c:v>
                </c:pt>
                <c:pt idx="293">
                  <c:v>48.734000000000002</c:v>
                </c:pt>
                <c:pt idx="294">
                  <c:v>48.5</c:v>
                </c:pt>
                <c:pt idx="295">
                  <c:v>48</c:v>
                </c:pt>
                <c:pt idx="296">
                  <c:v>47.5</c:v>
                </c:pt>
                <c:pt idx="297">
                  <c:v>47</c:v>
                </c:pt>
                <c:pt idx="298">
                  <c:v>46.5</c:v>
                </c:pt>
                <c:pt idx="299">
                  <c:v>46</c:v>
                </c:pt>
                <c:pt idx="300">
                  <c:v>45.5</c:v>
                </c:pt>
                <c:pt idx="301">
                  <c:v>45</c:v>
                </c:pt>
                <c:pt idx="302">
                  <c:v>44.5</c:v>
                </c:pt>
                <c:pt idx="303">
                  <c:v>44</c:v>
                </c:pt>
                <c:pt idx="304">
                  <c:v>43.5</c:v>
                </c:pt>
                <c:pt idx="305">
                  <c:v>43</c:v>
                </c:pt>
                <c:pt idx="306">
                  <c:v>42.5</c:v>
                </c:pt>
                <c:pt idx="307">
                  <c:v>42</c:v>
                </c:pt>
                <c:pt idx="308">
                  <c:v>41.5</c:v>
                </c:pt>
                <c:pt idx="309">
                  <c:v>41</c:v>
                </c:pt>
                <c:pt idx="310">
                  <c:v>40.83</c:v>
                </c:pt>
                <c:pt idx="311">
                  <c:v>40.5</c:v>
                </c:pt>
                <c:pt idx="312">
                  <c:v>40</c:v>
                </c:pt>
                <c:pt idx="313">
                  <c:v>39.5</c:v>
                </c:pt>
                <c:pt idx="314">
                  <c:v>39</c:v>
                </c:pt>
                <c:pt idx="315">
                  <c:v>38.5</c:v>
                </c:pt>
                <c:pt idx="316">
                  <c:v>38</c:v>
                </c:pt>
                <c:pt idx="317">
                  <c:v>37.5</c:v>
                </c:pt>
                <c:pt idx="318">
                  <c:v>37</c:v>
                </c:pt>
                <c:pt idx="319">
                  <c:v>36.5</c:v>
                </c:pt>
                <c:pt idx="320">
                  <c:v>36</c:v>
                </c:pt>
                <c:pt idx="321">
                  <c:v>35.5</c:v>
                </c:pt>
                <c:pt idx="322">
                  <c:v>35</c:v>
                </c:pt>
                <c:pt idx="323">
                  <c:v>34.5</c:v>
                </c:pt>
                <c:pt idx="324">
                  <c:v>34</c:v>
                </c:pt>
                <c:pt idx="325">
                  <c:v>33.5</c:v>
                </c:pt>
                <c:pt idx="326">
                  <c:v>33</c:v>
                </c:pt>
                <c:pt idx="327">
                  <c:v>32.5</c:v>
                </c:pt>
                <c:pt idx="328">
                  <c:v>32</c:v>
                </c:pt>
                <c:pt idx="329">
                  <c:v>31.5</c:v>
                </c:pt>
                <c:pt idx="330">
                  <c:v>31</c:v>
                </c:pt>
                <c:pt idx="331">
                  <c:v>30.5</c:v>
                </c:pt>
                <c:pt idx="332">
                  <c:v>30</c:v>
                </c:pt>
                <c:pt idx="333">
                  <c:v>29.849</c:v>
                </c:pt>
                <c:pt idx="334">
                  <c:v>29.5</c:v>
                </c:pt>
                <c:pt idx="335">
                  <c:v>29</c:v>
                </c:pt>
                <c:pt idx="336">
                  <c:v>28.5</c:v>
                </c:pt>
                <c:pt idx="337">
                  <c:v>28</c:v>
                </c:pt>
                <c:pt idx="338">
                  <c:v>27.5</c:v>
                </c:pt>
                <c:pt idx="339">
                  <c:v>27</c:v>
                </c:pt>
                <c:pt idx="340">
                  <c:v>26.5</c:v>
                </c:pt>
                <c:pt idx="341">
                  <c:v>26</c:v>
                </c:pt>
                <c:pt idx="342">
                  <c:v>25.5</c:v>
                </c:pt>
                <c:pt idx="343">
                  <c:v>25</c:v>
                </c:pt>
                <c:pt idx="344">
                  <c:v>24.5</c:v>
                </c:pt>
                <c:pt idx="345">
                  <c:v>24</c:v>
                </c:pt>
                <c:pt idx="346">
                  <c:v>23.5</c:v>
                </c:pt>
                <c:pt idx="347">
                  <c:v>23</c:v>
                </c:pt>
                <c:pt idx="348">
                  <c:v>22.5</c:v>
                </c:pt>
                <c:pt idx="349">
                  <c:v>22</c:v>
                </c:pt>
                <c:pt idx="350">
                  <c:v>21.5</c:v>
                </c:pt>
                <c:pt idx="351">
                  <c:v>21</c:v>
                </c:pt>
                <c:pt idx="352">
                  <c:v>20.5</c:v>
                </c:pt>
                <c:pt idx="353">
                  <c:v>20</c:v>
                </c:pt>
                <c:pt idx="354">
                  <c:v>19.620999999999999</c:v>
                </c:pt>
                <c:pt idx="355">
                  <c:v>19.5</c:v>
                </c:pt>
                <c:pt idx="356">
                  <c:v>19</c:v>
                </c:pt>
                <c:pt idx="357">
                  <c:v>18.5</c:v>
                </c:pt>
                <c:pt idx="358">
                  <c:v>18</c:v>
                </c:pt>
                <c:pt idx="359">
                  <c:v>17.5</c:v>
                </c:pt>
                <c:pt idx="360">
                  <c:v>17</c:v>
                </c:pt>
                <c:pt idx="361">
                  <c:v>16.5</c:v>
                </c:pt>
                <c:pt idx="362">
                  <c:v>16</c:v>
                </c:pt>
                <c:pt idx="363">
                  <c:v>15.5</c:v>
                </c:pt>
                <c:pt idx="364">
                  <c:v>15</c:v>
                </c:pt>
                <c:pt idx="365">
                  <c:v>14.5</c:v>
                </c:pt>
                <c:pt idx="366">
                  <c:v>14</c:v>
                </c:pt>
                <c:pt idx="367">
                  <c:v>13.788</c:v>
                </c:pt>
                <c:pt idx="368">
                  <c:v>13.5</c:v>
                </c:pt>
                <c:pt idx="369">
                  <c:v>13</c:v>
                </c:pt>
                <c:pt idx="370">
                  <c:v>12.5</c:v>
                </c:pt>
                <c:pt idx="371">
                  <c:v>12</c:v>
                </c:pt>
                <c:pt idx="372">
                  <c:v>11.5</c:v>
                </c:pt>
                <c:pt idx="373">
                  <c:v>11</c:v>
                </c:pt>
                <c:pt idx="374">
                  <c:v>10.5</c:v>
                </c:pt>
                <c:pt idx="375">
                  <c:v>10</c:v>
                </c:pt>
                <c:pt idx="376">
                  <c:v>9.5749999999999993</c:v>
                </c:pt>
                <c:pt idx="377">
                  <c:v>9.5</c:v>
                </c:pt>
                <c:pt idx="378">
                  <c:v>9</c:v>
                </c:pt>
                <c:pt idx="379">
                  <c:v>8.5</c:v>
                </c:pt>
                <c:pt idx="380">
                  <c:v>8</c:v>
                </c:pt>
                <c:pt idx="381">
                  <c:v>7.5</c:v>
                </c:pt>
                <c:pt idx="382">
                  <c:v>7</c:v>
                </c:pt>
                <c:pt idx="383">
                  <c:v>6.5</c:v>
                </c:pt>
                <c:pt idx="384">
                  <c:v>6.3730000000000002</c:v>
                </c:pt>
                <c:pt idx="385">
                  <c:v>6</c:v>
                </c:pt>
                <c:pt idx="386">
                  <c:v>5.5</c:v>
                </c:pt>
                <c:pt idx="387">
                  <c:v>5</c:v>
                </c:pt>
                <c:pt idx="388">
                  <c:v>4.5</c:v>
                </c:pt>
                <c:pt idx="389">
                  <c:v>4</c:v>
                </c:pt>
                <c:pt idx="390">
                  <c:v>3.726</c:v>
                </c:pt>
                <c:pt idx="391">
                  <c:v>3.5</c:v>
                </c:pt>
                <c:pt idx="392">
                  <c:v>3</c:v>
                </c:pt>
                <c:pt idx="393">
                  <c:v>2.5</c:v>
                </c:pt>
                <c:pt idx="394">
                  <c:v>2.125</c:v>
                </c:pt>
                <c:pt idx="395">
                  <c:v>2</c:v>
                </c:pt>
                <c:pt idx="396">
                  <c:v>1.5</c:v>
                </c:pt>
                <c:pt idx="397">
                  <c:v>1</c:v>
                </c:pt>
                <c:pt idx="398">
                  <c:v>0.5</c:v>
                </c:pt>
                <c:pt idx="399">
                  <c:v>0.27900000000000003</c:v>
                </c:pt>
                <c:pt idx="400">
                  <c:v>7.1999999999999995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A88-4DA4-99B1-07BA75EC69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1500"/>
          <c:min val="10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it-IT" sz="8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rPr>
                  <a:t>Dose [cGy(RBE)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ctr" rtl="0">
                <a:defRPr lang="it-IT" sz="800" b="0" i="0" u="none" strike="noStrike" kern="1200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/>
                  <a:t>Volume [%]</a:t>
                </a:r>
              </a:p>
            </c:rich>
          </c:tx>
          <c:layout>
            <c:manualLayout>
              <c:xMode val="edge"/>
              <c:yMode val="edge"/>
              <c:x val="1.3229166666666667E-2"/>
              <c:y val="0.195170555555555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779206349206349"/>
          <c:y val="7.7611111111111117E-2"/>
          <c:w val="0.7308095238095238"/>
          <c:h val="0.73214777777777773"/>
        </c:manualLayout>
      </c:layout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Foglio6!$A$411:$A$812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7999999999999999E-2</c:v>
                </c:pt>
                <c:pt idx="6">
                  <c:v>0.105</c:v>
                </c:pt>
                <c:pt idx="7">
                  <c:v>0.192</c:v>
                </c:pt>
                <c:pt idx="8">
                  <c:v>0.27900000000000003</c:v>
                </c:pt>
                <c:pt idx="9">
                  <c:v>0.36599999999999999</c:v>
                </c:pt>
                <c:pt idx="10">
                  <c:v>0.45300000000000001</c:v>
                </c:pt>
                <c:pt idx="11">
                  <c:v>0.54</c:v>
                </c:pt>
                <c:pt idx="12">
                  <c:v>0.627</c:v>
                </c:pt>
                <c:pt idx="13">
                  <c:v>0.71399999999999997</c:v>
                </c:pt>
                <c:pt idx="14">
                  <c:v>0.80100000000000005</c:v>
                </c:pt>
                <c:pt idx="15">
                  <c:v>0.88800000000000001</c:v>
                </c:pt>
                <c:pt idx="16">
                  <c:v>0.97499999999999998</c:v>
                </c:pt>
                <c:pt idx="17">
                  <c:v>1.0620000000000001</c:v>
                </c:pt>
                <c:pt idx="18">
                  <c:v>1.149</c:v>
                </c:pt>
                <c:pt idx="19">
                  <c:v>1.2330000000000001</c:v>
                </c:pt>
                <c:pt idx="20">
                  <c:v>1.2949999999999999</c:v>
                </c:pt>
                <c:pt idx="21">
                  <c:v>1.357</c:v>
                </c:pt>
                <c:pt idx="22">
                  <c:v>1.4179999999999999</c:v>
                </c:pt>
                <c:pt idx="23">
                  <c:v>1.48</c:v>
                </c:pt>
                <c:pt idx="24">
                  <c:v>1.542</c:v>
                </c:pt>
                <c:pt idx="25">
                  <c:v>1.6040000000000001</c:v>
                </c:pt>
                <c:pt idx="26">
                  <c:v>1.6659999999999999</c:v>
                </c:pt>
                <c:pt idx="27">
                  <c:v>1.728</c:v>
                </c:pt>
                <c:pt idx="28">
                  <c:v>1.79</c:v>
                </c:pt>
                <c:pt idx="29">
                  <c:v>1.8520000000000001</c:v>
                </c:pt>
                <c:pt idx="30">
                  <c:v>1.9139999999999999</c:v>
                </c:pt>
                <c:pt idx="31">
                  <c:v>1.9750000000000001</c:v>
                </c:pt>
                <c:pt idx="32">
                  <c:v>2.0369999999999999</c:v>
                </c:pt>
                <c:pt idx="33">
                  <c:v>2.0990000000000002</c:v>
                </c:pt>
                <c:pt idx="34">
                  <c:v>2.161</c:v>
                </c:pt>
                <c:pt idx="35">
                  <c:v>2.2229999999999999</c:v>
                </c:pt>
                <c:pt idx="36">
                  <c:v>2.2850000000000001</c:v>
                </c:pt>
                <c:pt idx="37">
                  <c:v>2.347</c:v>
                </c:pt>
                <c:pt idx="38">
                  <c:v>2.4089999999999998</c:v>
                </c:pt>
                <c:pt idx="39">
                  <c:v>2.4750000000000001</c:v>
                </c:pt>
                <c:pt idx="40">
                  <c:v>2.552</c:v>
                </c:pt>
                <c:pt idx="41">
                  <c:v>2.6280000000000001</c:v>
                </c:pt>
                <c:pt idx="42">
                  <c:v>2.7050000000000001</c:v>
                </c:pt>
                <c:pt idx="43">
                  <c:v>2.7810000000000001</c:v>
                </c:pt>
                <c:pt idx="44">
                  <c:v>2.8580000000000001</c:v>
                </c:pt>
                <c:pt idx="45">
                  <c:v>2.9350000000000001</c:v>
                </c:pt>
                <c:pt idx="46">
                  <c:v>3.0110000000000001</c:v>
                </c:pt>
                <c:pt idx="47">
                  <c:v>3.0880000000000001</c:v>
                </c:pt>
                <c:pt idx="48">
                  <c:v>3.1640000000000001</c:v>
                </c:pt>
                <c:pt idx="49">
                  <c:v>3.2410000000000001</c:v>
                </c:pt>
                <c:pt idx="50">
                  <c:v>3.3170000000000002</c:v>
                </c:pt>
                <c:pt idx="51">
                  <c:v>3.3940000000000001</c:v>
                </c:pt>
                <c:pt idx="52">
                  <c:v>3.4710000000000001</c:v>
                </c:pt>
                <c:pt idx="53">
                  <c:v>3.5470000000000002</c:v>
                </c:pt>
                <c:pt idx="54">
                  <c:v>3.6240000000000001</c:v>
                </c:pt>
                <c:pt idx="55">
                  <c:v>3.7109999999999999</c:v>
                </c:pt>
                <c:pt idx="56">
                  <c:v>3.8210000000000002</c:v>
                </c:pt>
                <c:pt idx="57">
                  <c:v>3.931</c:v>
                </c:pt>
                <c:pt idx="58">
                  <c:v>4.0419999999999998</c:v>
                </c:pt>
                <c:pt idx="59">
                  <c:v>4.1520000000000001</c:v>
                </c:pt>
                <c:pt idx="60">
                  <c:v>4.2619999999999996</c:v>
                </c:pt>
                <c:pt idx="61">
                  <c:v>4.3730000000000002</c:v>
                </c:pt>
                <c:pt idx="62">
                  <c:v>4.4829999999999997</c:v>
                </c:pt>
                <c:pt idx="63">
                  <c:v>4.593</c:v>
                </c:pt>
                <c:pt idx="64">
                  <c:v>4.7039999999999997</c:v>
                </c:pt>
                <c:pt idx="65">
                  <c:v>4.8140000000000001</c:v>
                </c:pt>
                <c:pt idx="66">
                  <c:v>4.9329999999999998</c:v>
                </c:pt>
                <c:pt idx="67">
                  <c:v>5.0880000000000001</c:v>
                </c:pt>
                <c:pt idx="68">
                  <c:v>5.2430000000000003</c:v>
                </c:pt>
                <c:pt idx="69">
                  <c:v>5.399</c:v>
                </c:pt>
                <c:pt idx="70">
                  <c:v>5.5540000000000003</c:v>
                </c:pt>
                <c:pt idx="71">
                  <c:v>5.7089999999999996</c:v>
                </c:pt>
                <c:pt idx="72">
                  <c:v>5.8650000000000002</c:v>
                </c:pt>
                <c:pt idx="73">
                  <c:v>6.02</c:v>
                </c:pt>
                <c:pt idx="74">
                  <c:v>6.1280000000000001</c:v>
                </c:pt>
                <c:pt idx="75">
                  <c:v>6.1909999999999998</c:v>
                </c:pt>
                <c:pt idx="76">
                  <c:v>6.3979999999999997</c:v>
                </c:pt>
                <c:pt idx="77">
                  <c:v>6.6059999999999999</c:v>
                </c:pt>
                <c:pt idx="78">
                  <c:v>6.8140000000000001</c:v>
                </c:pt>
                <c:pt idx="79">
                  <c:v>7.0209999999999999</c:v>
                </c:pt>
                <c:pt idx="80">
                  <c:v>7.2290000000000001</c:v>
                </c:pt>
                <c:pt idx="81">
                  <c:v>7.4569999999999999</c:v>
                </c:pt>
                <c:pt idx="82">
                  <c:v>7.7149999999999999</c:v>
                </c:pt>
                <c:pt idx="83">
                  <c:v>7.9729999999999999</c:v>
                </c:pt>
                <c:pt idx="84">
                  <c:v>8.2309999999999999</c:v>
                </c:pt>
                <c:pt idx="85">
                  <c:v>8.4890000000000008</c:v>
                </c:pt>
                <c:pt idx="86">
                  <c:v>8.782</c:v>
                </c:pt>
                <c:pt idx="87">
                  <c:v>9.0939999999999994</c:v>
                </c:pt>
                <c:pt idx="88">
                  <c:v>9.4060000000000006</c:v>
                </c:pt>
                <c:pt idx="89">
                  <c:v>9.718</c:v>
                </c:pt>
                <c:pt idx="90">
                  <c:v>10.074</c:v>
                </c:pt>
                <c:pt idx="91">
                  <c:v>10.448</c:v>
                </c:pt>
                <c:pt idx="92">
                  <c:v>10.821</c:v>
                </c:pt>
                <c:pt idx="93">
                  <c:v>11.22</c:v>
                </c:pt>
                <c:pt idx="94">
                  <c:v>11.651</c:v>
                </c:pt>
                <c:pt idx="95">
                  <c:v>12.082000000000001</c:v>
                </c:pt>
                <c:pt idx="96">
                  <c:v>12.257</c:v>
                </c:pt>
                <c:pt idx="97">
                  <c:v>12.536</c:v>
                </c:pt>
                <c:pt idx="98">
                  <c:v>13.007</c:v>
                </c:pt>
                <c:pt idx="99">
                  <c:v>13.478</c:v>
                </c:pt>
                <c:pt idx="100">
                  <c:v>13.997999999999999</c:v>
                </c:pt>
                <c:pt idx="101">
                  <c:v>14.518000000000001</c:v>
                </c:pt>
                <c:pt idx="102">
                  <c:v>15.066000000000001</c:v>
                </c:pt>
                <c:pt idx="103">
                  <c:v>15.631</c:v>
                </c:pt>
                <c:pt idx="104">
                  <c:v>16.228000000000002</c:v>
                </c:pt>
                <c:pt idx="105">
                  <c:v>16.861000000000001</c:v>
                </c:pt>
                <c:pt idx="106">
                  <c:v>17.527000000000001</c:v>
                </c:pt>
                <c:pt idx="107">
                  <c:v>18.222000000000001</c:v>
                </c:pt>
                <c:pt idx="108">
                  <c:v>18.385000000000002</c:v>
                </c:pt>
                <c:pt idx="109">
                  <c:v>18.931999999999999</c:v>
                </c:pt>
                <c:pt idx="110">
                  <c:v>19.651</c:v>
                </c:pt>
                <c:pt idx="111">
                  <c:v>20.437000000000001</c:v>
                </c:pt>
                <c:pt idx="112">
                  <c:v>21.248000000000001</c:v>
                </c:pt>
                <c:pt idx="113">
                  <c:v>22.088000000000001</c:v>
                </c:pt>
                <c:pt idx="114">
                  <c:v>23.004999999999999</c:v>
                </c:pt>
                <c:pt idx="115">
                  <c:v>24.004000000000001</c:v>
                </c:pt>
                <c:pt idx="116">
                  <c:v>24.513999999999999</c:v>
                </c:pt>
                <c:pt idx="117">
                  <c:v>25.035</c:v>
                </c:pt>
                <c:pt idx="118">
                  <c:v>26.07</c:v>
                </c:pt>
                <c:pt idx="119">
                  <c:v>27.145</c:v>
                </c:pt>
                <c:pt idx="120">
                  <c:v>28.326000000000001</c:v>
                </c:pt>
                <c:pt idx="121">
                  <c:v>29.611000000000001</c:v>
                </c:pt>
                <c:pt idx="122">
                  <c:v>30.641999999999999</c:v>
                </c:pt>
                <c:pt idx="123">
                  <c:v>31.016999999999999</c:v>
                </c:pt>
                <c:pt idx="124">
                  <c:v>32.326000000000001</c:v>
                </c:pt>
                <c:pt idx="125">
                  <c:v>33.750999999999998</c:v>
                </c:pt>
                <c:pt idx="126">
                  <c:v>35.415999999999997</c:v>
                </c:pt>
                <c:pt idx="127">
                  <c:v>36.770000000000003</c:v>
                </c:pt>
                <c:pt idx="128">
                  <c:v>36.975999999999999</c:v>
                </c:pt>
                <c:pt idx="129">
                  <c:v>38.603000000000002</c:v>
                </c:pt>
                <c:pt idx="130">
                  <c:v>40.387999999999998</c:v>
                </c:pt>
                <c:pt idx="131">
                  <c:v>42.122</c:v>
                </c:pt>
                <c:pt idx="132">
                  <c:v>42.899000000000001</c:v>
                </c:pt>
                <c:pt idx="133">
                  <c:v>44.043999999999997</c:v>
                </c:pt>
                <c:pt idx="134">
                  <c:v>46.213999999999999</c:v>
                </c:pt>
                <c:pt idx="135">
                  <c:v>48.427999999999997</c:v>
                </c:pt>
                <c:pt idx="136">
                  <c:v>49.027000000000001</c:v>
                </c:pt>
                <c:pt idx="137">
                  <c:v>50.588999999999999</c:v>
                </c:pt>
                <c:pt idx="138">
                  <c:v>52.976999999999997</c:v>
                </c:pt>
                <c:pt idx="139">
                  <c:v>55.155999999999999</c:v>
                </c:pt>
                <c:pt idx="140">
                  <c:v>55.566000000000003</c:v>
                </c:pt>
                <c:pt idx="141">
                  <c:v>58.087000000000003</c:v>
                </c:pt>
                <c:pt idx="142">
                  <c:v>60.869</c:v>
                </c:pt>
                <c:pt idx="143">
                  <c:v>61.283999999999999</c:v>
                </c:pt>
                <c:pt idx="144">
                  <c:v>64.007999999999996</c:v>
                </c:pt>
                <c:pt idx="145">
                  <c:v>66.938999999999993</c:v>
                </c:pt>
                <c:pt idx="146">
                  <c:v>67.412000000000006</c:v>
                </c:pt>
                <c:pt idx="147">
                  <c:v>69.781999999999996</c:v>
                </c:pt>
                <c:pt idx="148">
                  <c:v>73.088999999999999</c:v>
                </c:pt>
                <c:pt idx="149">
                  <c:v>73.540999999999997</c:v>
                </c:pt>
                <c:pt idx="150">
                  <c:v>76.998999999999995</c:v>
                </c:pt>
                <c:pt idx="151">
                  <c:v>79.668999999999997</c:v>
                </c:pt>
                <c:pt idx="152">
                  <c:v>80.62</c:v>
                </c:pt>
                <c:pt idx="153">
                  <c:v>84.531000000000006</c:v>
                </c:pt>
                <c:pt idx="154">
                  <c:v>85.798000000000002</c:v>
                </c:pt>
                <c:pt idx="155">
                  <c:v>88.828999999999994</c:v>
                </c:pt>
                <c:pt idx="156">
                  <c:v>91.926000000000002</c:v>
                </c:pt>
                <c:pt idx="157">
                  <c:v>93.311000000000007</c:v>
                </c:pt>
                <c:pt idx="158">
                  <c:v>98.054000000000002</c:v>
                </c:pt>
                <c:pt idx="159">
                  <c:v>98.085999999999999</c:v>
                </c:pt>
                <c:pt idx="160">
                  <c:v>103.646</c:v>
                </c:pt>
                <c:pt idx="161">
                  <c:v>104.18300000000001</c:v>
                </c:pt>
                <c:pt idx="162">
                  <c:v>108.746</c:v>
                </c:pt>
                <c:pt idx="163">
                  <c:v>110.31100000000001</c:v>
                </c:pt>
                <c:pt idx="164">
                  <c:v>114.315</c:v>
                </c:pt>
                <c:pt idx="165">
                  <c:v>116.44</c:v>
                </c:pt>
                <c:pt idx="166">
                  <c:v>121.113</c:v>
                </c:pt>
                <c:pt idx="167">
                  <c:v>122.568</c:v>
                </c:pt>
                <c:pt idx="168">
                  <c:v>126.712</c:v>
                </c:pt>
                <c:pt idx="169">
                  <c:v>128.696</c:v>
                </c:pt>
                <c:pt idx="170">
                  <c:v>133.29300000000001</c:v>
                </c:pt>
                <c:pt idx="171">
                  <c:v>134.82499999999999</c:v>
                </c:pt>
                <c:pt idx="172">
                  <c:v>140.434</c:v>
                </c:pt>
                <c:pt idx="173">
                  <c:v>140.953</c:v>
                </c:pt>
                <c:pt idx="174">
                  <c:v>147.08199999999999</c:v>
                </c:pt>
                <c:pt idx="175">
                  <c:v>148.74299999999999</c:v>
                </c:pt>
                <c:pt idx="176">
                  <c:v>153.21</c:v>
                </c:pt>
                <c:pt idx="177">
                  <c:v>156.59700000000001</c:v>
                </c:pt>
                <c:pt idx="178">
                  <c:v>159.339</c:v>
                </c:pt>
                <c:pt idx="179">
                  <c:v>164.66200000000001</c:v>
                </c:pt>
                <c:pt idx="180">
                  <c:v>165.46700000000001</c:v>
                </c:pt>
                <c:pt idx="181">
                  <c:v>171.595</c:v>
                </c:pt>
                <c:pt idx="182">
                  <c:v>174.101</c:v>
                </c:pt>
                <c:pt idx="183">
                  <c:v>177.72399999999999</c:v>
                </c:pt>
                <c:pt idx="184">
                  <c:v>183.624</c:v>
                </c:pt>
                <c:pt idx="185">
                  <c:v>183.852</c:v>
                </c:pt>
                <c:pt idx="186">
                  <c:v>189.98099999999999</c:v>
                </c:pt>
                <c:pt idx="187">
                  <c:v>193.30500000000001</c:v>
                </c:pt>
                <c:pt idx="188">
                  <c:v>196.10900000000001</c:v>
                </c:pt>
                <c:pt idx="189">
                  <c:v>202.23699999999999</c:v>
                </c:pt>
                <c:pt idx="190">
                  <c:v>203.42500000000001</c:v>
                </c:pt>
                <c:pt idx="191">
                  <c:v>208.36600000000001</c:v>
                </c:pt>
                <c:pt idx="192">
                  <c:v>213.54599999999999</c:v>
                </c:pt>
                <c:pt idx="193">
                  <c:v>214.494</c:v>
                </c:pt>
                <c:pt idx="194">
                  <c:v>220.62299999999999</c:v>
                </c:pt>
                <c:pt idx="195">
                  <c:v>226.751</c:v>
                </c:pt>
                <c:pt idx="196">
                  <c:v>227.048</c:v>
                </c:pt>
                <c:pt idx="197">
                  <c:v>232.87899999999999</c:v>
                </c:pt>
                <c:pt idx="198">
                  <c:v>237.232</c:v>
                </c:pt>
                <c:pt idx="199">
                  <c:v>239.00800000000001</c:v>
                </c:pt>
                <c:pt idx="200">
                  <c:v>245.136</c:v>
                </c:pt>
                <c:pt idx="201">
                  <c:v>247.82400000000001</c:v>
                </c:pt>
                <c:pt idx="202">
                  <c:v>251.26499999999999</c:v>
                </c:pt>
                <c:pt idx="203">
                  <c:v>257.39299999999997</c:v>
                </c:pt>
                <c:pt idx="204">
                  <c:v>260.52600000000001</c:v>
                </c:pt>
                <c:pt idx="205">
                  <c:v>263.52100000000002</c:v>
                </c:pt>
                <c:pt idx="206">
                  <c:v>269.64999999999998</c:v>
                </c:pt>
                <c:pt idx="207">
                  <c:v>275.77800000000002</c:v>
                </c:pt>
                <c:pt idx="208">
                  <c:v>275.8</c:v>
                </c:pt>
                <c:pt idx="209">
                  <c:v>281.90699999999998</c:v>
                </c:pt>
                <c:pt idx="210">
                  <c:v>288.03500000000003</c:v>
                </c:pt>
                <c:pt idx="211">
                  <c:v>289.63900000000001</c:v>
                </c:pt>
                <c:pt idx="212">
                  <c:v>294.16300000000001</c:v>
                </c:pt>
                <c:pt idx="213">
                  <c:v>300.29199999999997</c:v>
                </c:pt>
                <c:pt idx="214">
                  <c:v>301.38200000000001</c:v>
                </c:pt>
                <c:pt idx="215">
                  <c:v>306.42</c:v>
                </c:pt>
                <c:pt idx="216">
                  <c:v>312.54899999999998</c:v>
                </c:pt>
                <c:pt idx="217">
                  <c:v>317.27100000000002</c:v>
                </c:pt>
                <c:pt idx="218">
                  <c:v>318.67700000000002</c:v>
                </c:pt>
                <c:pt idx="219">
                  <c:v>324.80500000000001</c:v>
                </c:pt>
                <c:pt idx="220">
                  <c:v>330.93400000000003</c:v>
                </c:pt>
                <c:pt idx="221">
                  <c:v>332.46300000000002</c:v>
                </c:pt>
                <c:pt idx="222">
                  <c:v>337.06200000000001</c:v>
                </c:pt>
                <c:pt idx="223">
                  <c:v>343.19099999999997</c:v>
                </c:pt>
                <c:pt idx="224">
                  <c:v>346.7</c:v>
                </c:pt>
                <c:pt idx="225">
                  <c:v>349.31900000000002</c:v>
                </c:pt>
                <c:pt idx="226">
                  <c:v>355.447</c:v>
                </c:pt>
                <c:pt idx="227">
                  <c:v>361.57600000000002</c:v>
                </c:pt>
                <c:pt idx="228">
                  <c:v>364.363</c:v>
                </c:pt>
                <c:pt idx="229">
                  <c:v>367.70400000000001</c:v>
                </c:pt>
                <c:pt idx="230">
                  <c:v>373.83300000000003</c:v>
                </c:pt>
                <c:pt idx="231">
                  <c:v>379.96100000000001</c:v>
                </c:pt>
                <c:pt idx="232">
                  <c:v>380.005</c:v>
                </c:pt>
                <c:pt idx="233">
                  <c:v>386.089</c:v>
                </c:pt>
                <c:pt idx="234">
                  <c:v>392.21800000000002</c:v>
                </c:pt>
                <c:pt idx="235">
                  <c:v>396.12099999999998</c:v>
                </c:pt>
                <c:pt idx="236">
                  <c:v>398.346</c:v>
                </c:pt>
                <c:pt idx="237">
                  <c:v>404.47500000000002</c:v>
                </c:pt>
                <c:pt idx="238">
                  <c:v>410.60300000000001</c:v>
                </c:pt>
                <c:pt idx="239">
                  <c:v>411.42700000000002</c:v>
                </c:pt>
                <c:pt idx="240">
                  <c:v>416.73200000000003</c:v>
                </c:pt>
                <c:pt idx="241">
                  <c:v>422.86</c:v>
                </c:pt>
                <c:pt idx="242">
                  <c:v>428.988</c:v>
                </c:pt>
                <c:pt idx="243">
                  <c:v>429.01900000000001</c:v>
                </c:pt>
                <c:pt idx="244">
                  <c:v>435.11700000000002</c:v>
                </c:pt>
                <c:pt idx="245">
                  <c:v>441.245</c:v>
                </c:pt>
                <c:pt idx="246">
                  <c:v>447.37400000000002</c:v>
                </c:pt>
                <c:pt idx="247">
                  <c:v>448.04700000000003</c:v>
                </c:pt>
                <c:pt idx="248">
                  <c:v>453.50200000000001</c:v>
                </c:pt>
                <c:pt idx="249">
                  <c:v>459.63</c:v>
                </c:pt>
                <c:pt idx="250">
                  <c:v>465.75900000000001</c:v>
                </c:pt>
                <c:pt idx="251">
                  <c:v>467.24200000000002</c:v>
                </c:pt>
                <c:pt idx="252">
                  <c:v>471.887</c:v>
                </c:pt>
                <c:pt idx="253">
                  <c:v>478.01600000000002</c:v>
                </c:pt>
                <c:pt idx="254">
                  <c:v>484.14400000000001</c:v>
                </c:pt>
                <c:pt idx="255">
                  <c:v>488.71300000000002</c:v>
                </c:pt>
                <c:pt idx="256">
                  <c:v>490.27199999999999</c:v>
                </c:pt>
                <c:pt idx="257">
                  <c:v>496.40100000000001</c:v>
                </c:pt>
                <c:pt idx="258">
                  <c:v>502.529</c:v>
                </c:pt>
                <c:pt idx="259">
                  <c:v>508.65800000000002</c:v>
                </c:pt>
                <c:pt idx="260">
                  <c:v>510.24299999999999</c:v>
                </c:pt>
                <c:pt idx="261">
                  <c:v>514.78599999999994</c:v>
                </c:pt>
                <c:pt idx="262">
                  <c:v>520.91399999999999</c:v>
                </c:pt>
                <c:pt idx="263">
                  <c:v>527.04300000000001</c:v>
                </c:pt>
                <c:pt idx="264">
                  <c:v>530.47900000000004</c:v>
                </c:pt>
                <c:pt idx="265">
                  <c:v>533.17100000000005</c:v>
                </c:pt>
                <c:pt idx="266">
                  <c:v>539.29999999999995</c:v>
                </c:pt>
                <c:pt idx="267">
                  <c:v>545.428</c:v>
                </c:pt>
                <c:pt idx="268">
                  <c:v>551.55600000000004</c:v>
                </c:pt>
                <c:pt idx="269">
                  <c:v>552.42100000000005</c:v>
                </c:pt>
                <c:pt idx="270">
                  <c:v>557.68499999999995</c:v>
                </c:pt>
                <c:pt idx="271">
                  <c:v>563.81299999999999</c:v>
                </c:pt>
                <c:pt idx="272">
                  <c:v>569.94200000000001</c:v>
                </c:pt>
                <c:pt idx="273">
                  <c:v>576.03800000000001</c:v>
                </c:pt>
                <c:pt idx="274">
                  <c:v>576.07000000000005</c:v>
                </c:pt>
                <c:pt idx="275">
                  <c:v>582.19799999999998</c:v>
                </c:pt>
                <c:pt idx="276">
                  <c:v>588.327</c:v>
                </c:pt>
                <c:pt idx="277">
                  <c:v>594.45500000000004</c:v>
                </c:pt>
                <c:pt idx="278">
                  <c:v>595.35699999999997</c:v>
                </c:pt>
                <c:pt idx="279">
                  <c:v>600.58399999999995</c:v>
                </c:pt>
                <c:pt idx="280">
                  <c:v>606.71199999999999</c:v>
                </c:pt>
                <c:pt idx="281">
                  <c:v>612.84</c:v>
                </c:pt>
                <c:pt idx="282">
                  <c:v>618.96900000000005</c:v>
                </c:pt>
                <c:pt idx="283">
                  <c:v>620.02099999999996</c:v>
                </c:pt>
                <c:pt idx="284">
                  <c:v>625.09699999999998</c:v>
                </c:pt>
                <c:pt idx="285">
                  <c:v>631.226</c:v>
                </c:pt>
                <c:pt idx="286">
                  <c:v>637.35400000000004</c:v>
                </c:pt>
                <c:pt idx="287">
                  <c:v>641.02200000000005</c:v>
                </c:pt>
                <c:pt idx="288">
                  <c:v>643.48199999999997</c:v>
                </c:pt>
                <c:pt idx="289">
                  <c:v>649.61099999999999</c:v>
                </c:pt>
                <c:pt idx="290">
                  <c:v>655.73900000000003</c:v>
                </c:pt>
                <c:pt idx="291">
                  <c:v>660.12699999999995</c:v>
                </c:pt>
                <c:pt idx="292">
                  <c:v>661.86800000000005</c:v>
                </c:pt>
                <c:pt idx="293">
                  <c:v>667.99599999999998</c:v>
                </c:pt>
                <c:pt idx="294">
                  <c:v>674.12400000000002</c:v>
                </c:pt>
                <c:pt idx="295">
                  <c:v>680.25300000000004</c:v>
                </c:pt>
                <c:pt idx="296">
                  <c:v>684.49099999999999</c:v>
                </c:pt>
                <c:pt idx="297">
                  <c:v>686.38099999999997</c:v>
                </c:pt>
                <c:pt idx="298">
                  <c:v>692.51</c:v>
                </c:pt>
                <c:pt idx="299">
                  <c:v>698.63800000000003</c:v>
                </c:pt>
                <c:pt idx="300">
                  <c:v>704.58100000000002</c:v>
                </c:pt>
                <c:pt idx="301">
                  <c:v>704.76700000000005</c:v>
                </c:pt>
                <c:pt idx="302">
                  <c:v>710.89499999999998</c:v>
                </c:pt>
                <c:pt idx="303">
                  <c:v>717.02300000000002</c:v>
                </c:pt>
                <c:pt idx="304">
                  <c:v>723.15200000000004</c:v>
                </c:pt>
                <c:pt idx="305">
                  <c:v>725.22699999999998</c:v>
                </c:pt>
                <c:pt idx="306">
                  <c:v>729.28</c:v>
                </c:pt>
                <c:pt idx="307">
                  <c:v>735.40899999999999</c:v>
                </c:pt>
                <c:pt idx="308">
                  <c:v>741.53700000000003</c:v>
                </c:pt>
                <c:pt idx="309">
                  <c:v>747.66499999999996</c:v>
                </c:pt>
                <c:pt idx="310">
                  <c:v>751.35699999999997</c:v>
                </c:pt>
                <c:pt idx="311">
                  <c:v>753.79399999999998</c:v>
                </c:pt>
                <c:pt idx="312">
                  <c:v>759.92200000000003</c:v>
                </c:pt>
                <c:pt idx="313">
                  <c:v>766.05100000000004</c:v>
                </c:pt>
                <c:pt idx="314">
                  <c:v>772.17899999999997</c:v>
                </c:pt>
                <c:pt idx="315">
                  <c:v>774.21500000000003</c:v>
                </c:pt>
                <c:pt idx="316">
                  <c:v>778.30700000000002</c:v>
                </c:pt>
                <c:pt idx="317">
                  <c:v>784.43600000000004</c:v>
                </c:pt>
                <c:pt idx="318">
                  <c:v>790.56399999999996</c:v>
                </c:pt>
                <c:pt idx="319">
                  <c:v>796.69299999999998</c:v>
                </c:pt>
                <c:pt idx="320">
                  <c:v>799.66099999999994</c:v>
                </c:pt>
                <c:pt idx="321">
                  <c:v>802.82100000000003</c:v>
                </c:pt>
                <c:pt idx="322">
                  <c:v>808.94899999999996</c:v>
                </c:pt>
                <c:pt idx="323">
                  <c:v>815.07799999999997</c:v>
                </c:pt>
                <c:pt idx="324">
                  <c:v>821.20600000000002</c:v>
                </c:pt>
                <c:pt idx="325">
                  <c:v>825.66899999999998</c:v>
                </c:pt>
                <c:pt idx="326">
                  <c:v>827.33500000000004</c:v>
                </c:pt>
                <c:pt idx="327">
                  <c:v>833.46299999999997</c:v>
                </c:pt>
                <c:pt idx="328">
                  <c:v>839.59100000000001</c:v>
                </c:pt>
                <c:pt idx="329">
                  <c:v>845.72</c:v>
                </c:pt>
                <c:pt idx="330">
                  <c:v>851.84799999999996</c:v>
                </c:pt>
                <c:pt idx="331">
                  <c:v>851.86099999999999</c:v>
                </c:pt>
                <c:pt idx="332">
                  <c:v>857.97699999999998</c:v>
                </c:pt>
                <c:pt idx="333">
                  <c:v>864.10500000000002</c:v>
                </c:pt>
                <c:pt idx="334">
                  <c:v>870.23299999999995</c:v>
                </c:pt>
                <c:pt idx="335">
                  <c:v>876.36199999999997</c:v>
                </c:pt>
                <c:pt idx="336">
                  <c:v>878.39300000000003</c:v>
                </c:pt>
                <c:pt idx="337">
                  <c:v>882.49</c:v>
                </c:pt>
                <c:pt idx="338">
                  <c:v>888.61900000000003</c:v>
                </c:pt>
                <c:pt idx="339">
                  <c:v>894.74699999999996</c:v>
                </c:pt>
                <c:pt idx="340">
                  <c:v>900.875</c:v>
                </c:pt>
                <c:pt idx="341">
                  <c:v>907.00400000000002</c:v>
                </c:pt>
                <c:pt idx="342">
                  <c:v>912.00699999999995</c:v>
                </c:pt>
                <c:pt idx="343">
                  <c:v>913.13199999999995</c:v>
                </c:pt>
                <c:pt idx="344">
                  <c:v>919.26099999999997</c:v>
                </c:pt>
                <c:pt idx="345">
                  <c:v>925.38900000000001</c:v>
                </c:pt>
                <c:pt idx="346">
                  <c:v>931.51700000000005</c:v>
                </c:pt>
                <c:pt idx="347">
                  <c:v>937.64599999999996</c:v>
                </c:pt>
                <c:pt idx="348">
                  <c:v>941.10400000000004</c:v>
                </c:pt>
                <c:pt idx="349">
                  <c:v>943.774</c:v>
                </c:pt>
                <c:pt idx="350">
                  <c:v>949.90300000000002</c:v>
                </c:pt>
                <c:pt idx="351">
                  <c:v>956.03099999999995</c:v>
                </c:pt>
                <c:pt idx="352">
                  <c:v>962.16</c:v>
                </c:pt>
                <c:pt idx="353">
                  <c:v>968.28800000000001</c:v>
                </c:pt>
                <c:pt idx="354">
                  <c:v>972.101</c:v>
                </c:pt>
                <c:pt idx="355">
                  <c:v>974.41600000000005</c:v>
                </c:pt>
                <c:pt idx="356">
                  <c:v>980.54499999999996</c:v>
                </c:pt>
                <c:pt idx="357">
                  <c:v>986.673</c:v>
                </c:pt>
                <c:pt idx="358">
                  <c:v>992.80200000000002</c:v>
                </c:pt>
                <c:pt idx="359">
                  <c:v>998.93</c:v>
                </c:pt>
                <c:pt idx="360">
                  <c:v>1005.058</c:v>
                </c:pt>
                <c:pt idx="361">
                  <c:v>1009.524</c:v>
                </c:pt>
                <c:pt idx="362">
                  <c:v>1011.187</c:v>
                </c:pt>
                <c:pt idx="363">
                  <c:v>1017.3150000000001</c:v>
                </c:pt>
                <c:pt idx="364">
                  <c:v>1023.444</c:v>
                </c:pt>
                <c:pt idx="365">
                  <c:v>1029.5719999999999</c:v>
                </c:pt>
                <c:pt idx="366">
                  <c:v>1035.7</c:v>
                </c:pt>
                <c:pt idx="367">
                  <c:v>1041.829</c:v>
                </c:pt>
                <c:pt idx="368">
                  <c:v>1044.0440000000001</c:v>
                </c:pt>
                <c:pt idx="369">
                  <c:v>1047.9570000000001</c:v>
                </c:pt>
                <c:pt idx="370">
                  <c:v>1054.086</c:v>
                </c:pt>
                <c:pt idx="371">
                  <c:v>1060.2139999999999</c:v>
                </c:pt>
                <c:pt idx="372">
                  <c:v>1066.3420000000001</c:v>
                </c:pt>
                <c:pt idx="373">
                  <c:v>1072.471</c:v>
                </c:pt>
                <c:pt idx="374">
                  <c:v>1078.5989999999999</c:v>
                </c:pt>
                <c:pt idx="375">
                  <c:v>1084.7280000000001</c:v>
                </c:pt>
                <c:pt idx="376">
                  <c:v>1085.3009999999999</c:v>
                </c:pt>
                <c:pt idx="377">
                  <c:v>1090.856</c:v>
                </c:pt>
                <c:pt idx="378">
                  <c:v>1096.9839999999999</c:v>
                </c:pt>
                <c:pt idx="379">
                  <c:v>1103.1130000000001</c:v>
                </c:pt>
                <c:pt idx="380">
                  <c:v>1109.241</c:v>
                </c:pt>
                <c:pt idx="381">
                  <c:v>1115.3699999999999</c:v>
                </c:pt>
                <c:pt idx="382">
                  <c:v>1121.498</c:v>
                </c:pt>
                <c:pt idx="383">
                  <c:v>1127.434</c:v>
                </c:pt>
                <c:pt idx="384">
                  <c:v>1127.626</c:v>
                </c:pt>
                <c:pt idx="385">
                  <c:v>1133.7550000000001</c:v>
                </c:pt>
                <c:pt idx="386">
                  <c:v>1139.883</c:v>
                </c:pt>
                <c:pt idx="387">
                  <c:v>1146.0119999999999</c:v>
                </c:pt>
                <c:pt idx="388">
                  <c:v>1152.1400000000001</c:v>
                </c:pt>
                <c:pt idx="389">
                  <c:v>1158.268</c:v>
                </c:pt>
                <c:pt idx="390">
                  <c:v>1164.3969999999999</c:v>
                </c:pt>
                <c:pt idx="391">
                  <c:v>1170.5250000000001</c:v>
                </c:pt>
                <c:pt idx="392">
                  <c:v>1176.654</c:v>
                </c:pt>
                <c:pt idx="393">
                  <c:v>1182.7819999999999</c:v>
                </c:pt>
                <c:pt idx="394">
                  <c:v>1188.9100000000001</c:v>
                </c:pt>
                <c:pt idx="395">
                  <c:v>1195.039</c:v>
                </c:pt>
                <c:pt idx="396">
                  <c:v>1201.1669999999999</c:v>
                </c:pt>
                <c:pt idx="397">
                  <c:v>1207.296</c:v>
                </c:pt>
                <c:pt idx="398">
                  <c:v>1213.424</c:v>
                </c:pt>
                <c:pt idx="399">
                  <c:v>1219.5530000000001</c:v>
                </c:pt>
                <c:pt idx="400">
                  <c:v>1225.681</c:v>
                </c:pt>
                <c:pt idx="401">
                  <c:v>1225.681</c:v>
                </c:pt>
              </c:numCache>
            </c:numRef>
          </c:xVal>
          <c:yVal>
            <c:numRef>
              <c:f>Foglio6!$B$411:$B$812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65</c:v>
                </c:pt>
                <c:pt idx="75">
                  <c:v>63.5</c:v>
                </c:pt>
                <c:pt idx="76">
                  <c:v>63</c:v>
                </c:pt>
                <c:pt idx="77">
                  <c:v>62.5</c:v>
                </c:pt>
                <c:pt idx="78">
                  <c:v>62</c:v>
                </c:pt>
                <c:pt idx="79">
                  <c:v>61.5</c:v>
                </c:pt>
                <c:pt idx="80">
                  <c:v>61</c:v>
                </c:pt>
                <c:pt idx="81">
                  <c:v>60.5</c:v>
                </c:pt>
                <c:pt idx="82">
                  <c:v>60</c:v>
                </c:pt>
                <c:pt idx="83">
                  <c:v>59.5</c:v>
                </c:pt>
                <c:pt idx="84">
                  <c:v>59</c:v>
                </c:pt>
                <c:pt idx="85">
                  <c:v>58.5</c:v>
                </c:pt>
                <c:pt idx="86">
                  <c:v>58</c:v>
                </c:pt>
                <c:pt idx="87">
                  <c:v>57.5</c:v>
                </c:pt>
                <c:pt idx="88">
                  <c:v>57</c:v>
                </c:pt>
                <c:pt idx="89">
                  <c:v>56.5</c:v>
                </c:pt>
                <c:pt idx="90">
                  <c:v>56</c:v>
                </c:pt>
                <c:pt idx="91">
                  <c:v>55.5</c:v>
                </c:pt>
                <c:pt idx="92">
                  <c:v>55</c:v>
                </c:pt>
                <c:pt idx="93">
                  <c:v>54.5</c:v>
                </c:pt>
                <c:pt idx="94">
                  <c:v>54</c:v>
                </c:pt>
                <c:pt idx="95">
                  <c:v>53.5</c:v>
                </c:pt>
                <c:pt idx="96">
                  <c:v>53.296999999999997</c:v>
                </c:pt>
                <c:pt idx="97">
                  <c:v>53</c:v>
                </c:pt>
                <c:pt idx="98">
                  <c:v>52.5</c:v>
                </c:pt>
                <c:pt idx="99">
                  <c:v>52</c:v>
                </c:pt>
                <c:pt idx="100">
                  <c:v>51.5</c:v>
                </c:pt>
                <c:pt idx="101">
                  <c:v>51</c:v>
                </c:pt>
                <c:pt idx="102">
                  <c:v>50.5</c:v>
                </c:pt>
                <c:pt idx="103">
                  <c:v>50</c:v>
                </c:pt>
                <c:pt idx="104">
                  <c:v>49.5</c:v>
                </c:pt>
                <c:pt idx="105">
                  <c:v>49</c:v>
                </c:pt>
                <c:pt idx="106">
                  <c:v>48.5</c:v>
                </c:pt>
                <c:pt idx="107">
                  <c:v>48</c:v>
                </c:pt>
                <c:pt idx="108">
                  <c:v>47.881999999999998</c:v>
                </c:pt>
                <c:pt idx="109">
                  <c:v>47.5</c:v>
                </c:pt>
                <c:pt idx="110">
                  <c:v>47</c:v>
                </c:pt>
                <c:pt idx="111">
                  <c:v>46.5</c:v>
                </c:pt>
                <c:pt idx="112">
                  <c:v>46</c:v>
                </c:pt>
                <c:pt idx="113">
                  <c:v>45.5</c:v>
                </c:pt>
                <c:pt idx="114">
                  <c:v>45</c:v>
                </c:pt>
                <c:pt idx="115">
                  <c:v>44.5</c:v>
                </c:pt>
                <c:pt idx="116">
                  <c:v>44.253999999999998</c:v>
                </c:pt>
                <c:pt idx="117">
                  <c:v>44</c:v>
                </c:pt>
                <c:pt idx="118">
                  <c:v>43.5</c:v>
                </c:pt>
                <c:pt idx="119">
                  <c:v>43</c:v>
                </c:pt>
                <c:pt idx="120">
                  <c:v>42.5</c:v>
                </c:pt>
                <c:pt idx="121">
                  <c:v>42</c:v>
                </c:pt>
                <c:pt idx="122">
                  <c:v>41.642000000000003</c:v>
                </c:pt>
                <c:pt idx="123">
                  <c:v>41.5</c:v>
                </c:pt>
                <c:pt idx="124">
                  <c:v>41</c:v>
                </c:pt>
                <c:pt idx="125">
                  <c:v>40.5</c:v>
                </c:pt>
                <c:pt idx="126">
                  <c:v>40</c:v>
                </c:pt>
                <c:pt idx="127">
                  <c:v>39.567</c:v>
                </c:pt>
                <c:pt idx="128">
                  <c:v>39.5</c:v>
                </c:pt>
                <c:pt idx="129">
                  <c:v>39</c:v>
                </c:pt>
                <c:pt idx="130">
                  <c:v>38.5</c:v>
                </c:pt>
                <c:pt idx="131">
                  <c:v>38</c:v>
                </c:pt>
                <c:pt idx="132">
                  <c:v>37.78</c:v>
                </c:pt>
                <c:pt idx="133">
                  <c:v>37.5</c:v>
                </c:pt>
                <c:pt idx="134">
                  <c:v>37</c:v>
                </c:pt>
                <c:pt idx="135">
                  <c:v>36.5</c:v>
                </c:pt>
                <c:pt idx="136">
                  <c:v>36.369999999999997</c:v>
                </c:pt>
                <c:pt idx="137">
                  <c:v>36</c:v>
                </c:pt>
                <c:pt idx="138">
                  <c:v>35.5</c:v>
                </c:pt>
                <c:pt idx="139">
                  <c:v>35.078000000000003</c:v>
                </c:pt>
                <c:pt idx="140">
                  <c:v>35</c:v>
                </c:pt>
                <c:pt idx="141">
                  <c:v>34.5</c:v>
                </c:pt>
                <c:pt idx="142">
                  <c:v>34</c:v>
                </c:pt>
                <c:pt idx="143">
                  <c:v>33.935000000000002</c:v>
                </c:pt>
                <c:pt idx="144">
                  <c:v>33.5</c:v>
                </c:pt>
                <c:pt idx="145">
                  <c:v>33</c:v>
                </c:pt>
                <c:pt idx="146">
                  <c:v>32.912999999999997</c:v>
                </c:pt>
                <c:pt idx="147">
                  <c:v>32.5</c:v>
                </c:pt>
                <c:pt idx="148">
                  <c:v>32</c:v>
                </c:pt>
                <c:pt idx="149">
                  <c:v>31.940999999999999</c:v>
                </c:pt>
                <c:pt idx="150">
                  <c:v>31.5</c:v>
                </c:pt>
                <c:pt idx="151">
                  <c:v>31.117000000000001</c:v>
                </c:pt>
                <c:pt idx="152">
                  <c:v>31</c:v>
                </c:pt>
                <c:pt idx="153">
                  <c:v>30.5</c:v>
                </c:pt>
                <c:pt idx="154">
                  <c:v>30.358000000000001</c:v>
                </c:pt>
                <c:pt idx="155">
                  <c:v>30</c:v>
                </c:pt>
                <c:pt idx="156">
                  <c:v>29.632999999999999</c:v>
                </c:pt>
                <c:pt idx="157">
                  <c:v>29.5</c:v>
                </c:pt>
                <c:pt idx="158">
                  <c:v>29.003</c:v>
                </c:pt>
                <c:pt idx="159">
                  <c:v>29</c:v>
                </c:pt>
                <c:pt idx="160">
                  <c:v>28.5</c:v>
                </c:pt>
                <c:pt idx="161">
                  <c:v>28.451000000000001</c:v>
                </c:pt>
                <c:pt idx="162">
                  <c:v>28</c:v>
                </c:pt>
                <c:pt idx="163">
                  <c:v>27.844000000000001</c:v>
                </c:pt>
                <c:pt idx="164">
                  <c:v>27.5</c:v>
                </c:pt>
                <c:pt idx="165">
                  <c:v>27.346</c:v>
                </c:pt>
                <c:pt idx="166">
                  <c:v>27</c:v>
                </c:pt>
                <c:pt idx="167">
                  <c:v>26.917999999999999</c:v>
                </c:pt>
                <c:pt idx="168">
                  <c:v>26.5</c:v>
                </c:pt>
                <c:pt idx="169">
                  <c:v>26.338999999999999</c:v>
                </c:pt>
                <c:pt idx="170">
                  <c:v>26</c:v>
                </c:pt>
                <c:pt idx="171">
                  <c:v>25.875</c:v>
                </c:pt>
                <c:pt idx="172">
                  <c:v>25.5</c:v>
                </c:pt>
                <c:pt idx="173">
                  <c:v>25.472000000000001</c:v>
                </c:pt>
                <c:pt idx="174">
                  <c:v>25.105</c:v>
                </c:pt>
                <c:pt idx="175">
                  <c:v>25</c:v>
                </c:pt>
                <c:pt idx="176">
                  <c:v>24.712</c:v>
                </c:pt>
                <c:pt idx="177">
                  <c:v>24.5</c:v>
                </c:pt>
                <c:pt idx="178">
                  <c:v>24.366</c:v>
                </c:pt>
                <c:pt idx="179">
                  <c:v>24</c:v>
                </c:pt>
                <c:pt idx="180">
                  <c:v>23.939</c:v>
                </c:pt>
                <c:pt idx="181">
                  <c:v>23.596</c:v>
                </c:pt>
                <c:pt idx="182">
                  <c:v>23.5</c:v>
                </c:pt>
                <c:pt idx="183">
                  <c:v>23.352</c:v>
                </c:pt>
                <c:pt idx="184">
                  <c:v>23</c:v>
                </c:pt>
                <c:pt idx="185">
                  <c:v>22.984999999999999</c:v>
                </c:pt>
                <c:pt idx="186">
                  <c:v>22.681000000000001</c:v>
                </c:pt>
                <c:pt idx="187">
                  <c:v>22.5</c:v>
                </c:pt>
                <c:pt idx="188">
                  <c:v>22.363</c:v>
                </c:pt>
                <c:pt idx="189">
                  <c:v>22.056000000000001</c:v>
                </c:pt>
                <c:pt idx="190">
                  <c:v>22</c:v>
                </c:pt>
                <c:pt idx="191">
                  <c:v>21.73</c:v>
                </c:pt>
                <c:pt idx="192">
                  <c:v>21.5</c:v>
                </c:pt>
                <c:pt idx="193">
                  <c:v>21.46</c:v>
                </c:pt>
                <c:pt idx="194">
                  <c:v>21.234000000000002</c:v>
                </c:pt>
                <c:pt idx="195">
                  <c:v>21.013000000000002</c:v>
                </c:pt>
                <c:pt idx="196">
                  <c:v>21</c:v>
                </c:pt>
                <c:pt idx="197">
                  <c:v>20.704000000000001</c:v>
                </c:pt>
                <c:pt idx="198">
                  <c:v>20.5</c:v>
                </c:pt>
                <c:pt idx="199">
                  <c:v>20.414999999999999</c:v>
                </c:pt>
                <c:pt idx="200">
                  <c:v>20.134</c:v>
                </c:pt>
                <c:pt idx="201">
                  <c:v>20</c:v>
                </c:pt>
                <c:pt idx="202">
                  <c:v>19.844999999999999</c:v>
                </c:pt>
                <c:pt idx="203">
                  <c:v>19.609000000000002</c:v>
                </c:pt>
                <c:pt idx="204">
                  <c:v>19.5</c:v>
                </c:pt>
                <c:pt idx="205">
                  <c:v>19.398</c:v>
                </c:pt>
                <c:pt idx="206">
                  <c:v>19.218</c:v>
                </c:pt>
                <c:pt idx="207">
                  <c:v>19.001000000000001</c:v>
                </c:pt>
                <c:pt idx="208">
                  <c:v>19</c:v>
                </c:pt>
                <c:pt idx="209">
                  <c:v>18.785</c:v>
                </c:pt>
                <c:pt idx="210">
                  <c:v>18.552</c:v>
                </c:pt>
                <c:pt idx="211">
                  <c:v>18.5</c:v>
                </c:pt>
                <c:pt idx="212">
                  <c:v>18.306999999999999</c:v>
                </c:pt>
                <c:pt idx="213">
                  <c:v>18.047999999999998</c:v>
                </c:pt>
                <c:pt idx="214">
                  <c:v>18</c:v>
                </c:pt>
                <c:pt idx="215">
                  <c:v>17.815999999999999</c:v>
                </c:pt>
                <c:pt idx="216">
                  <c:v>17.632000000000001</c:v>
                </c:pt>
                <c:pt idx="217">
                  <c:v>17.5</c:v>
                </c:pt>
                <c:pt idx="218">
                  <c:v>17.45</c:v>
                </c:pt>
                <c:pt idx="219">
                  <c:v>17.231000000000002</c:v>
                </c:pt>
                <c:pt idx="220">
                  <c:v>17.058</c:v>
                </c:pt>
                <c:pt idx="221">
                  <c:v>17</c:v>
                </c:pt>
                <c:pt idx="222">
                  <c:v>16.818999999999999</c:v>
                </c:pt>
                <c:pt idx="223">
                  <c:v>16.617000000000001</c:v>
                </c:pt>
                <c:pt idx="224">
                  <c:v>16.5</c:v>
                </c:pt>
                <c:pt idx="225">
                  <c:v>16.414999999999999</c:v>
                </c:pt>
                <c:pt idx="226">
                  <c:v>16.227</c:v>
                </c:pt>
                <c:pt idx="227">
                  <c:v>16.068999999999999</c:v>
                </c:pt>
                <c:pt idx="228">
                  <c:v>16</c:v>
                </c:pt>
                <c:pt idx="229">
                  <c:v>15.879</c:v>
                </c:pt>
                <c:pt idx="230">
                  <c:v>15.666</c:v>
                </c:pt>
                <c:pt idx="231">
                  <c:v>15.502000000000001</c:v>
                </c:pt>
                <c:pt idx="232">
                  <c:v>15.5</c:v>
                </c:pt>
                <c:pt idx="233">
                  <c:v>15.298</c:v>
                </c:pt>
                <c:pt idx="234">
                  <c:v>15.102</c:v>
                </c:pt>
                <c:pt idx="235">
                  <c:v>15</c:v>
                </c:pt>
                <c:pt idx="236">
                  <c:v>14.935</c:v>
                </c:pt>
                <c:pt idx="237">
                  <c:v>14.737</c:v>
                </c:pt>
                <c:pt idx="238">
                  <c:v>14.532999999999999</c:v>
                </c:pt>
                <c:pt idx="239">
                  <c:v>14.5</c:v>
                </c:pt>
                <c:pt idx="240">
                  <c:v>14.340999999999999</c:v>
                </c:pt>
                <c:pt idx="241">
                  <c:v>14.148</c:v>
                </c:pt>
                <c:pt idx="242">
                  <c:v>14.000999999999999</c:v>
                </c:pt>
                <c:pt idx="243">
                  <c:v>14</c:v>
                </c:pt>
                <c:pt idx="244">
                  <c:v>13.824</c:v>
                </c:pt>
                <c:pt idx="245">
                  <c:v>13.661</c:v>
                </c:pt>
                <c:pt idx="246">
                  <c:v>13.512</c:v>
                </c:pt>
                <c:pt idx="247">
                  <c:v>13.5</c:v>
                </c:pt>
                <c:pt idx="248">
                  <c:v>13.369</c:v>
                </c:pt>
                <c:pt idx="249">
                  <c:v>13.221</c:v>
                </c:pt>
                <c:pt idx="250">
                  <c:v>13.035</c:v>
                </c:pt>
                <c:pt idx="251">
                  <c:v>13</c:v>
                </c:pt>
                <c:pt idx="252">
                  <c:v>12.907999999999999</c:v>
                </c:pt>
                <c:pt idx="253">
                  <c:v>12.766999999999999</c:v>
                </c:pt>
                <c:pt idx="254">
                  <c:v>12.587</c:v>
                </c:pt>
                <c:pt idx="255">
                  <c:v>12.5</c:v>
                </c:pt>
                <c:pt idx="256">
                  <c:v>12.474</c:v>
                </c:pt>
                <c:pt idx="257">
                  <c:v>12.324</c:v>
                </c:pt>
                <c:pt idx="258">
                  <c:v>12.202</c:v>
                </c:pt>
                <c:pt idx="259">
                  <c:v>12.047000000000001</c:v>
                </c:pt>
                <c:pt idx="260">
                  <c:v>12</c:v>
                </c:pt>
                <c:pt idx="261">
                  <c:v>11.885</c:v>
                </c:pt>
                <c:pt idx="262">
                  <c:v>11.728</c:v>
                </c:pt>
                <c:pt idx="263">
                  <c:v>11.585000000000001</c:v>
                </c:pt>
                <c:pt idx="264">
                  <c:v>11.5</c:v>
                </c:pt>
                <c:pt idx="265">
                  <c:v>11.45</c:v>
                </c:pt>
                <c:pt idx="266">
                  <c:v>11.318</c:v>
                </c:pt>
                <c:pt idx="267">
                  <c:v>11.173999999999999</c:v>
                </c:pt>
                <c:pt idx="268">
                  <c:v>11.016999999999999</c:v>
                </c:pt>
                <c:pt idx="269">
                  <c:v>11</c:v>
                </c:pt>
                <c:pt idx="270">
                  <c:v>10.891999999999999</c:v>
                </c:pt>
                <c:pt idx="271">
                  <c:v>10.772</c:v>
                </c:pt>
                <c:pt idx="272">
                  <c:v>10.627000000000001</c:v>
                </c:pt>
                <c:pt idx="273">
                  <c:v>10.5</c:v>
                </c:pt>
                <c:pt idx="274">
                  <c:v>10.499000000000001</c:v>
                </c:pt>
                <c:pt idx="275">
                  <c:v>10.324</c:v>
                </c:pt>
                <c:pt idx="276">
                  <c:v>10.161</c:v>
                </c:pt>
                <c:pt idx="277">
                  <c:v>10.018000000000001</c:v>
                </c:pt>
                <c:pt idx="278">
                  <c:v>10</c:v>
                </c:pt>
                <c:pt idx="279">
                  <c:v>9.9079999999999995</c:v>
                </c:pt>
                <c:pt idx="280">
                  <c:v>9.7810000000000006</c:v>
                </c:pt>
                <c:pt idx="281">
                  <c:v>9.6530000000000005</c:v>
                </c:pt>
                <c:pt idx="282">
                  <c:v>9.5259999999999998</c:v>
                </c:pt>
                <c:pt idx="283">
                  <c:v>9.5</c:v>
                </c:pt>
                <c:pt idx="284">
                  <c:v>9.3650000000000002</c:v>
                </c:pt>
                <c:pt idx="285">
                  <c:v>9.2249999999999996</c:v>
                </c:pt>
                <c:pt idx="286">
                  <c:v>9.1069999999999993</c:v>
                </c:pt>
                <c:pt idx="287">
                  <c:v>9</c:v>
                </c:pt>
                <c:pt idx="288">
                  <c:v>8.9489999999999998</c:v>
                </c:pt>
                <c:pt idx="289">
                  <c:v>8.77</c:v>
                </c:pt>
                <c:pt idx="290">
                  <c:v>8.5969999999999995</c:v>
                </c:pt>
                <c:pt idx="291">
                  <c:v>8.5</c:v>
                </c:pt>
                <c:pt idx="292">
                  <c:v>8.4559999999999995</c:v>
                </c:pt>
                <c:pt idx="293">
                  <c:v>8.3379999999999992</c:v>
                </c:pt>
                <c:pt idx="294">
                  <c:v>8.1999999999999993</c:v>
                </c:pt>
                <c:pt idx="295">
                  <c:v>8.09</c:v>
                </c:pt>
                <c:pt idx="296">
                  <c:v>8</c:v>
                </c:pt>
                <c:pt idx="297">
                  <c:v>7.9589999999999996</c:v>
                </c:pt>
                <c:pt idx="298">
                  <c:v>7.8079999999999998</c:v>
                </c:pt>
                <c:pt idx="299">
                  <c:v>7.6420000000000003</c:v>
                </c:pt>
                <c:pt idx="300">
                  <c:v>7.5</c:v>
                </c:pt>
                <c:pt idx="301">
                  <c:v>7.4969999999999999</c:v>
                </c:pt>
                <c:pt idx="302">
                  <c:v>7.3490000000000002</c:v>
                </c:pt>
                <c:pt idx="303">
                  <c:v>7.218</c:v>
                </c:pt>
                <c:pt idx="304">
                  <c:v>7.0339999999999998</c:v>
                </c:pt>
                <c:pt idx="305">
                  <c:v>7</c:v>
                </c:pt>
                <c:pt idx="306">
                  <c:v>6.9290000000000003</c:v>
                </c:pt>
                <c:pt idx="307">
                  <c:v>6.8120000000000003</c:v>
                </c:pt>
                <c:pt idx="308">
                  <c:v>6.6970000000000001</c:v>
                </c:pt>
                <c:pt idx="309">
                  <c:v>6.5679999999999996</c:v>
                </c:pt>
                <c:pt idx="310">
                  <c:v>6.5</c:v>
                </c:pt>
                <c:pt idx="311">
                  <c:v>6.4349999999999996</c:v>
                </c:pt>
                <c:pt idx="312">
                  <c:v>6.319</c:v>
                </c:pt>
                <c:pt idx="313">
                  <c:v>6.1870000000000003</c:v>
                </c:pt>
                <c:pt idx="314">
                  <c:v>6.0490000000000004</c:v>
                </c:pt>
                <c:pt idx="315">
                  <c:v>6</c:v>
                </c:pt>
                <c:pt idx="316">
                  <c:v>5.93</c:v>
                </c:pt>
                <c:pt idx="317">
                  <c:v>5.8049999999999997</c:v>
                </c:pt>
                <c:pt idx="318">
                  <c:v>5.657</c:v>
                </c:pt>
                <c:pt idx="319">
                  <c:v>5.55</c:v>
                </c:pt>
                <c:pt idx="320">
                  <c:v>5.5</c:v>
                </c:pt>
                <c:pt idx="321">
                  <c:v>5.431</c:v>
                </c:pt>
                <c:pt idx="322">
                  <c:v>5.3090000000000002</c:v>
                </c:pt>
                <c:pt idx="323">
                  <c:v>5.1909999999999998</c:v>
                </c:pt>
                <c:pt idx="324">
                  <c:v>5.0860000000000003</c:v>
                </c:pt>
                <c:pt idx="325">
                  <c:v>5</c:v>
                </c:pt>
                <c:pt idx="326">
                  <c:v>4.9710000000000001</c:v>
                </c:pt>
                <c:pt idx="327">
                  <c:v>4.8380000000000001</c:v>
                </c:pt>
                <c:pt idx="328">
                  <c:v>4.7119999999999997</c:v>
                </c:pt>
                <c:pt idx="329">
                  <c:v>4.5949999999999998</c:v>
                </c:pt>
                <c:pt idx="330">
                  <c:v>4.5</c:v>
                </c:pt>
                <c:pt idx="331">
                  <c:v>4.5</c:v>
                </c:pt>
                <c:pt idx="332">
                  <c:v>4.3719999999999999</c:v>
                </c:pt>
                <c:pt idx="333">
                  <c:v>4.2690000000000001</c:v>
                </c:pt>
                <c:pt idx="334">
                  <c:v>4.1669999999999998</c:v>
                </c:pt>
                <c:pt idx="335">
                  <c:v>4.0369999999999999</c:v>
                </c:pt>
                <c:pt idx="336">
                  <c:v>4</c:v>
                </c:pt>
                <c:pt idx="337">
                  <c:v>3.9409999999999998</c:v>
                </c:pt>
                <c:pt idx="338">
                  <c:v>3.835</c:v>
                </c:pt>
                <c:pt idx="339">
                  <c:v>3.73</c:v>
                </c:pt>
                <c:pt idx="340">
                  <c:v>3.657</c:v>
                </c:pt>
                <c:pt idx="341">
                  <c:v>3.573</c:v>
                </c:pt>
                <c:pt idx="342">
                  <c:v>3.5</c:v>
                </c:pt>
                <c:pt idx="343">
                  <c:v>3.476</c:v>
                </c:pt>
                <c:pt idx="344">
                  <c:v>3.343</c:v>
                </c:pt>
                <c:pt idx="345">
                  <c:v>3.2360000000000002</c:v>
                </c:pt>
                <c:pt idx="346">
                  <c:v>3.1320000000000001</c:v>
                </c:pt>
                <c:pt idx="347">
                  <c:v>3.0590000000000002</c:v>
                </c:pt>
                <c:pt idx="348">
                  <c:v>3</c:v>
                </c:pt>
                <c:pt idx="349">
                  <c:v>2.9710000000000001</c:v>
                </c:pt>
                <c:pt idx="350">
                  <c:v>2.8610000000000002</c:v>
                </c:pt>
                <c:pt idx="351">
                  <c:v>2.738</c:v>
                </c:pt>
                <c:pt idx="352">
                  <c:v>2.6280000000000001</c:v>
                </c:pt>
                <c:pt idx="353">
                  <c:v>2.544</c:v>
                </c:pt>
                <c:pt idx="354">
                  <c:v>2.5</c:v>
                </c:pt>
                <c:pt idx="355">
                  <c:v>2.468</c:v>
                </c:pt>
                <c:pt idx="356">
                  <c:v>2.3860000000000001</c:v>
                </c:pt>
                <c:pt idx="357">
                  <c:v>2.2930000000000001</c:v>
                </c:pt>
                <c:pt idx="358">
                  <c:v>2.222</c:v>
                </c:pt>
                <c:pt idx="359">
                  <c:v>2.1389999999999998</c:v>
                </c:pt>
                <c:pt idx="360">
                  <c:v>2.056</c:v>
                </c:pt>
                <c:pt idx="361">
                  <c:v>2</c:v>
                </c:pt>
                <c:pt idx="362">
                  <c:v>1.964</c:v>
                </c:pt>
                <c:pt idx="363">
                  <c:v>1.873</c:v>
                </c:pt>
                <c:pt idx="364">
                  <c:v>1.794</c:v>
                </c:pt>
                <c:pt idx="365">
                  <c:v>1.7230000000000001</c:v>
                </c:pt>
                <c:pt idx="366">
                  <c:v>1.6259999999999999</c:v>
                </c:pt>
                <c:pt idx="367">
                  <c:v>1.522</c:v>
                </c:pt>
                <c:pt idx="368">
                  <c:v>1.5</c:v>
                </c:pt>
                <c:pt idx="369">
                  <c:v>1.4470000000000001</c:v>
                </c:pt>
                <c:pt idx="370">
                  <c:v>1.38</c:v>
                </c:pt>
                <c:pt idx="371">
                  <c:v>1.296</c:v>
                </c:pt>
                <c:pt idx="372">
                  <c:v>1.2290000000000001</c:v>
                </c:pt>
                <c:pt idx="373">
                  <c:v>1.1639999999999999</c:v>
                </c:pt>
                <c:pt idx="374">
                  <c:v>1.0960000000000001</c:v>
                </c:pt>
                <c:pt idx="375">
                  <c:v>1.008</c:v>
                </c:pt>
                <c:pt idx="376">
                  <c:v>1</c:v>
                </c:pt>
                <c:pt idx="377">
                  <c:v>0.93500000000000005</c:v>
                </c:pt>
                <c:pt idx="378">
                  <c:v>0.86</c:v>
                </c:pt>
                <c:pt idx="379">
                  <c:v>0.77100000000000002</c:v>
                </c:pt>
                <c:pt idx="380">
                  <c:v>0.70399999999999996</c:v>
                </c:pt>
                <c:pt idx="381">
                  <c:v>0.64600000000000002</c:v>
                </c:pt>
                <c:pt idx="382">
                  <c:v>0.57899999999999996</c:v>
                </c:pt>
                <c:pt idx="383">
                  <c:v>0.5</c:v>
                </c:pt>
                <c:pt idx="384">
                  <c:v>0.497</c:v>
                </c:pt>
                <c:pt idx="385">
                  <c:v>0.439</c:v>
                </c:pt>
                <c:pt idx="386">
                  <c:v>0.37</c:v>
                </c:pt>
                <c:pt idx="387">
                  <c:v>0.30499999999999999</c:v>
                </c:pt>
                <c:pt idx="388">
                  <c:v>0.24099999999999999</c:v>
                </c:pt>
                <c:pt idx="389">
                  <c:v>0.192</c:v>
                </c:pt>
                <c:pt idx="390">
                  <c:v>0.151</c:v>
                </c:pt>
                <c:pt idx="391">
                  <c:v>0.105</c:v>
                </c:pt>
                <c:pt idx="392">
                  <c:v>7.5999999999999998E-2</c:v>
                </c:pt>
                <c:pt idx="393">
                  <c:v>5.7000000000000002E-2</c:v>
                </c:pt>
                <c:pt idx="394">
                  <c:v>3.5000000000000003E-2</c:v>
                </c:pt>
                <c:pt idx="395">
                  <c:v>2.1999999999999999E-2</c:v>
                </c:pt>
                <c:pt idx="396">
                  <c:v>8.9999999999999993E-3</c:v>
                </c:pt>
                <c:pt idx="397">
                  <c:v>5.0000000000000001E-3</c:v>
                </c:pt>
                <c:pt idx="398">
                  <c:v>2E-3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EB-4971-BBB7-EC35B5F78EDB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xVal>
            <c:numRef>
              <c:f>Foglio6!$C$411:$C$812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7000000000000002E-2</c:v>
                </c:pt>
                <c:pt idx="6">
                  <c:v>0.14899999999999999</c:v>
                </c:pt>
                <c:pt idx="7">
                  <c:v>0.24099999999999999</c:v>
                </c:pt>
                <c:pt idx="8">
                  <c:v>0.33400000000000002</c:v>
                </c:pt>
                <c:pt idx="9">
                  <c:v>0.42599999999999999</c:v>
                </c:pt>
                <c:pt idx="10">
                  <c:v>0.51800000000000002</c:v>
                </c:pt>
                <c:pt idx="11">
                  <c:v>0.61099999999999999</c:v>
                </c:pt>
                <c:pt idx="12">
                  <c:v>0.70299999999999996</c:v>
                </c:pt>
                <c:pt idx="13">
                  <c:v>0.79500000000000004</c:v>
                </c:pt>
                <c:pt idx="14">
                  <c:v>0.88800000000000001</c:v>
                </c:pt>
                <c:pt idx="15">
                  <c:v>0.98</c:v>
                </c:pt>
                <c:pt idx="16">
                  <c:v>1.0720000000000001</c:v>
                </c:pt>
                <c:pt idx="17">
                  <c:v>1.165</c:v>
                </c:pt>
                <c:pt idx="18">
                  <c:v>1.2490000000000001</c:v>
                </c:pt>
                <c:pt idx="19">
                  <c:v>1.3140000000000001</c:v>
                </c:pt>
                <c:pt idx="20">
                  <c:v>1.379</c:v>
                </c:pt>
                <c:pt idx="21">
                  <c:v>1.444</c:v>
                </c:pt>
                <c:pt idx="22">
                  <c:v>1.5089999999999999</c:v>
                </c:pt>
                <c:pt idx="23">
                  <c:v>1.573</c:v>
                </c:pt>
                <c:pt idx="24">
                  <c:v>1.6379999999999999</c:v>
                </c:pt>
                <c:pt idx="25">
                  <c:v>1.7030000000000001</c:v>
                </c:pt>
                <c:pt idx="26">
                  <c:v>1.768</c:v>
                </c:pt>
                <c:pt idx="27">
                  <c:v>1.833</c:v>
                </c:pt>
                <c:pt idx="28">
                  <c:v>1.8979999999999999</c:v>
                </c:pt>
                <c:pt idx="29">
                  <c:v>1.9630000000000001</c:v>
                </c:pt>
                <c:pt idx="30">
                  <c:v>2.028</c:v>
                </c:pt>
                <c:pt idx="31">
                  <c:v>2.093</c:v>
                </c:pt>
                <c:pt idx="32">
                  <c:v>2.1579999999999999</c:v>
                </c:pt>
                <c:pt idx="33">
                  <c:v>2.2229999999999999</c:v>
                </c:pt>
                <c:pt idx="34">
                  <c:v>2.2879999999999998</c:v>
                </c:pt>
                <c:pt idx="35">
                  <c:v>2.3530000000000002</c:v>
                </c:pt>
                <c:pt idx="36">
                  <c:v>2.4180000000000001</c:v>
                </c:pt>
                <c:pt idx="37">
                  <c:v>2.488</c:v>
                </c:pt>
                <c:pt idx="38">
                  <c:v>2.5659999999999998</c:v>
                </c:pt>
                <c:pt idx="39">
                  <c:v>2.645</c:v>
                </c:pt>
                <c:pt idx="40">
                  <c:v>2.7229999999999999</c:v>
                </c:pt>
                <c:pt idx="41">
                  <c:v>2.802</c:v>
                </c:pt>
                <c:pt idx="42">
                  <c:v>2.88</c:v>
                </c:pt>
                <c:pt idx="43">
                  <c:v>2.9580000000000002</c:v>
                </c:pt>
                <c:pt idx="44">
                  <c:v>3.0369999999999999</c:v>
                </c:pt>
                <c:pt idx="45">
                  <c:v>3.1150000000000002</c:v>
                </c:pt>
                <c:pt idx="46">
                  <c:v>3.194</c:v>
                </c:pt>
                <c:pt idx="47">
                  <c:v>3.2719999999999998</c:v>
                </c:pt>
                <c:pt idx="48">
                  <c:v>3.35</c:v>
                </c:pt>
                <c:pt idx="49">
                  <c:v>3.4289999999999998</c:v>
                </c:pt>
                <c:pt idx="50">
                  <c:v>3.5070000000000001</c:v>
                </c:pt>
                <c:pt idx="51">
                  <c:v>3.5859999999999999</c:v>
                </c:pt>
                <c:pt idx="52">
                  <c:v>3.6640000000000001</c:v>
                </c:pt>
                <c:pt idx="53">
                  <c:v>3.7639999999999998</c:v>
                </c:pt>
                <c:pt idx="54">
                  <c:v>3.8730000000000002</c:v>
                </c:pt>
                <c:pt idx="55">
                  <c:v>3.9820000000000002</c:v>
                </c:pt>
                <c:pt idx="56">
                  <c:v>4.0919999999999996</c:v>
                </c:pt>
                <c:pt idx="57">
                  <c:v>4.2009999999999996</c:v>
                </c:pt>
                <c:pt idx="58">
                  <c:v>4.3099999999999996</c:v>
                </c:pt>
                <c:pt idx="59">
                  <c:v>4.4189999999999996</c:v>
                </c:pt>
                <c:pt idx="60">
                  <c:v>4.5279999999999996</c:v>
                </c:pt>
                <c:pt idx="61">
                  <c:v>4.6369999999999996</c:v>
                </c:pt>
                <c:pt idx="62">
                  <c:v>4.7460000000000004</c:v>
                </c:pt>
                <c:pt idx="63">
                  <c:v>4.8559999999999999</c:v>
                </c:pt>
                <c:pt idx="64">
                  <c:v>4.9850000000000003</c:v>
                </c:pt>
                <c:pt idx="65">
                  <c:v>5.141</c:v>
                </c:pt>
                <c:pt idx="66">
                  <c:v>5.2960000000000003</c:v>
                </c:pt>
                <c:pt idx="67">
                  <c:v>5.4509999999999996</c:v>
                </c:pt>
                <c:pt idx="68">
                  <c:v>5.6070000000000002</c:v>
                </c:pt>
                <c:pt idx="69">
                  <c:v>5.7619999999999996</c:v>
                </c:pt>
                <c:pt idx="70">
                  <c:v>5.9169999999999998</c:v>
                </c:pt>
                <c:pt idx="71">
                  <c:v>6.0730000000000004</c:v>
                </c:pt>
                <c:pt idx="72">
                  <c:v>6.1449999999999996</c:v>
                </c:pt>
                <c:pt idx="73">
                  <c:v>6.25</c:v>
                </c:pt>
                <c:pt idx="74">
                  <c:v>6.4470000000000001</c:v>
                </c:pt>
                <c:pt idx="75">
                  <c:v>6.6440000000000001</c:v>
                </c:pt>
                <c:pt idx="76">
                  <c:v>6.8410000000000002</c:v>
                </c:pt>
                <c:pt idx="77">
                  <c:v>7.0380000000000003</c:v>
                </c:pt>
                <c:pt idx="78">
                  <c:v>7.2350000000000003</c:v>
                </c:pt>
                <c:pt idx="79">
                  <c:v>7.444</c:v>
                </c:pt>
                <c:pt idx="80">
                  <c:v>7.681</c:v>
                </c:pt>
                <c:pt idx="81">
                  <c:v>7.9180000000000001</c:v>
                </c:pt>
                <c:pt idx="82">
                  <c:v>8.1549999999999994</c:v>
                </c:pt>
                <c:pt idx="83">
                  <c:v>8.3919999999999995</c:v>
                </c:pt>
                <c:pt idx="84">
                  <c:v>8.6349999999999998</c:v>
                </c:pt>
                <c:pt idx="85">
                  <c:v>8.9269999999999996</c:v>
                </c:pt>
                <c:pt idx="86">
                  <c:v>9.2189999999999994</c:v>
                </c:pt>
                <c:pt idx="87">
                  <c:v>9.5109999999999992</c:v>
                </c:pt>
                <c:pt idx="88">
                  <c:v>9.8040000000000003</c:v>
                </c:pt>
                <c:pt idx="89">
                  <c:v>10.146000000000001</c:v>
                </c:pt>
                <c:pt idx="90">
                  <c:v>10.494999999999999</c:v>
                </c:pt>
                <c:pt idx="91">
                  <c:v>10.843</c:v>
                </c:pt>
                <c:pt idx="92">
                  <c:v>11.217000000000001</c:v>
                </c:pt>
                <c:pt idx="93">
                  <c:v>11.632999999999999</c:v>
                </c:pt>
                <c:pt idx="94">
                  <c:v>12.048999999999999</c:v>
                </c:pt>
                <c:pt idx="95">
                  <c:v>12.29</c:v>
                </c:pt>
                <c:pt idx="96">
                  <c:v>12.486000000000001</c:v>
                </c:pt>
                <c:pt idx="97">
                  <c:v>12.951000000000001</c:v>
                </c:pt>
                <c:pt idx="98">
                  <c:v>13.417</c:v>
                </c:pt>
                <c:pt idx="99">
                  <c:v>13.927</c:v>
                </c:pt>
                <c:pt idx="100">
                  <c:v>14.45</c:v>
                </c:pt>
                <c:pt idx="101">
                  <c:v>14.993</c:v>
                </c:pt>
                <c:pt idx="102">
                  <c:v>15.561999999999999</c:v>
                </c:pt>
                <c:pt idx="103">
                  <c:v>16.138999999999999</c:v>
                </c:pt>
                <c:pt idx="104">
                  <c:v>16.734000000000002</c:v>
                </c:pt>
                <c:pt idx="105">
                  <c:v>17.347000000000001</c:v>
                </c:pt>
                <c:pt idx="106">
                  <c:v>18.029</c:v>
                </c:pt>
                <c:pt idx="107">
                  <c:v>18.434999999999999</c:v>
                </c:pt>
                <c:pt idx="108">
                  <c:v>18.725000000000001</c:v>
                </c:pt>
                <c:pt idx="109">
                  <c:v>19.442</c:v>
                </c:pt>
                <c:pt idx="110">
                  <c:v>20.184000000000001</c:v>
                </c:pt>
                <c:pt idx="111">
                  <c:v>20.946999999999999</c:v>
                </c:pt>
                <c:pt idx="112">
                  <c:v>21.838999999999999</c:v>
                </c:pt>
                <c:pt idx="113">
                  <c:v>22.824000000000002</c:v>
                </c:pt>
                <c:pt idx="114">
                  <c:v>23.84</c:v>
                </c:pt>
                <c:pt idx="115">
                  <c:v>24.58</c:v>
                </c:pt>
                <c:pt idx="116">
                  <c:v>24.827999999999999</c:v>
                </c:pt>
                <c:pt idx="117">
                  <c:v>25.774000000000001</c:v>
                </c:pt>
                <c:pt idx="118">
                  <c:v>26.891999999999999</c:v>
                </c:pt>
                <c:pt idx="119">
                  <c:v>28.088000000000001</c:v>
                </c:pt>
                <c:pt idx="120">
                  <c:v>29.308</c:v>
                </c:pt>
                <c:pt idx="121">
                  <c:v>30.577999999999999</c:v>
                </c:pt>
                <c:pt idx="122">
                  <c:v>30.725000000000001</c:v>
                </c:pt>
                <c:pt idx="123">
                  <c:v>31.885999999999999</c:v>
                </c:pt>
                <c:pt idx="124">
                  <c:v>33.304000000000002</c:v>
                </c:pt>
                <c:pt idx="125">
                  <c:v>34.744999999999997</c:v>
                </c:pt>
                <c:pt idx="126">
                  <c:v>36.412999999999997</c:v>
                </c:pt>
                <c:pt idx="127">
                  <c:v>36.869999999999997</c:v>
                </c:pt>
                <c:pt idx="128">
                  <c:v>38.140999999999998</c:v>
                </c:pt>
                <c:pt idx="129">
                  <c:v>39.874000000000002</c:v>
                </c:pt>
                <c:pt idx="130">
                  <c:v>41.646000000000001</c:v>
                </c:pt>
                <c:pt idx="131">
                  <c:v>43.015000000000001</c:v>
                </c:pt>
                <c:pt idx="132">
                  <c:v>43.612000000000002</c:v>
                </c:pt>
                <c:pt idx="133">
                  <c:v>45.613</c:v>
                </c:pt>
                <c:pt idx="134">
                  <c:v>47.947000000000003</c:v>
                </c:pt>
                <c:pt idx="135">
                  <c:v>49.16</c:v>
                </c:pt>
                <c:pt idx="136">
                  <c:v>50.091000000000001</c:v>
                </c:pt>
                <c:pt idx="137">
                  <c:v>52.256999999999998</c:v>
                </c:pt>
                <c:pt idx="138">
                  <c:v>54.719000000000001</c:v>
                </c:pt>
                <c:pt idx="139">
                  <c:v>55.305</c:v>
                </c:pt>
                <c:pt idx="140">
                  <c:v>57.439</c:v>
                </c:pt>
                <c:pt idx="141">
                  <c:v>60.197000000000003</c:v>
                </c:pt>
                <c:pt idx="142">
                  <c:v>61.448999999999998</c:v>
                </c:pt>
                <c:pt idx="143">
                  <c:v>63.183</c:v>
                </c:pt>
                <c:pt idx="144">
                  <c:v>66.203999999999994</c:v>
                </c:pt>
                <c:pt idx="145">
                  <c:v>67.593999999999994</c:v>
                </c:pt>
                <c:pt idx="146">
                  <c:v>69.400000000000006</c:v>
                </c:pt>
                <c:pt idx="147">
                  <c:v>73.135999999999996</c:v>
                </c:pt>
                <c:pt idx="148">
                  <c:v>73.739000000000004</c:v>
                </c:pt>
                <c:pt idx="149">
                  <c:v>77.334000000000003</c:v>
                </c:pt>
                <c:pt idx="150">
                  <c:v>79.884</c:v>
                </c:pt>
                <c:pt idx="151">
                  <c:v>80.94</c:v>
                </c:pt>
                <c:pt idx="152">
                  <c:v>85.153000000000006</c:v>
                </c:pt>
                <c:pt idx="153">
                  <c:v>86.028999999999996</c:v>
                </c:pt>
                <c:pt idx="154">
                  <c:v>89.283000000000001</c:v>
                </c:pt>
                <c:pt idx="155">
                  <c:v>92.174000000000007</c:v>
                </c:pt>
                <c:pt idx="156">
                  <c:v>94.287000000000006</c:v>
                </c:pt>
                <c:pt idx="157">
                  <c:v>98.319000000000003</c:v>
                </c:pt>
                <c:pt idx="158">
                  <c:v>99.537999999999997</c:v>
                </c:pt>
                <c:pt idx="159">
                  <c:v>104.464</c:v>
                </c:pt>
                <c:pt idx="160">
                  <c:v>104.789</c:v>
                </c:pt>
                <c:pt idx="161">
                  <c:v>109.792</c:v>
                </c:pt>
                <c:pt idx="162">
                  <c:v>110.60899999999999</c:v>
                </c:pt>
                <c:pt idx="163">
                  <c:v>115.613</c:v>
                </c:pt>
                <c:pt idx="164">
                  <c:v>116.754</c:v>
                </c:pt>
                <c:pt idx="165">
                  <c:v>122.015</c:v>
                </c:pt>
                <c:pt idx="166">
                  <c:v>122.899</c:v>
                </c:pt>
                <c:pt idx="167">
                  <c:v>128.82599999999999</c:v>
                </c:pt>
                <c:pt idx="168">
                  <c:v>129.04400000000001</c:v>
                </c:pt>
                <c:pt idx="169">
                  <c:v>135.18899999999999</c:v>
                </c:pt>
                <c:pt idx="170">
                  <c:v>136.34800000000001</c:v>
                </c:pt>
                <c:pt idx="171">
                  <c:v>141.334</c:v>
                </c:pt>
                <c:pt idx="172">
                  <c:v>144.09299999999999</c:v>
                </c:pt>
                <c:pt idx="173">
                  <c:v>147.47900000000001</c:v>
                </c:pt>
                <c:pt idx="174">
                  <c:v>152.03800000000001</c:v>
                </c:pt>
                <c:pt idx="175">
                  <c:v>153.624</c:v>
                </c:pt>
                <c:pt idx="176">
                  <c:v>159.18199999999999</c:v>
                </c:pt>
                <c:pt idx="177">
                  <c:v>159.76900000000001</c:v>
                </c:pt>
                <c:pt idx="178">
                  <c:v>165.91399999999999</c:v>
                </c:pt>
                <c:pt idx="179">
                  <c:v>167.53700000000001</c:v>
                </c:pt>
                <c:pt idx="180">
                  <c:v>172.059</c:v>
                </c:pt>
                <c:pt idx="181">
                  <c:v>177.84100000000001</c:v>
                </c:pt>
                <c:pt idx="182">
                  <c:v>178.20400000000001</c:v>
                </c:pt>
                <c:pt idx="183">
                  <c:v>184.34800000000001</c:v>
                </c:pt>
                <c:pt idx="184">
                  <c:v>187.947</c:v>
                </c:pt>
                <c:pt idx="185">
                  <c:v>190.49299999999999</c:v>
                </c:pt>
                <c:pt idx="186">
                  <c:v>196.63800000000001</c:v>
                </c:pt>
                <c:pt idx="187">
                  <c:v>198.78299999999999</c:v>
                </c:pt>
                <c:pt idx="188">
                  <c:v>202.78299999999999</c:v>
                </c:pt>
                <c:pt idx="189">
                  <c:v>208.04599999999999</c:v>
                </c:pt>
                <c:pt idx="190">
                  <c:v>208.928</c:v>
                </c:pt>
                <c:pt idx="191">
                  <c:v>215.07300000000001</c:v>
                </c:pt>
                <c:pt idx="192">
                  <c:v>217.61600000000001</c:v>
                </c:pt>
                <c:pt idx="193">
                  <c:v>221.21799999999999</c:v>
                </c:pt>
                <c:pt idx="194">
                  <c:v>227.363</c:v>
                </c:pt>
                <c:pt idx="195">
                  <c:v>230.29300000000001</c:v>
                </c:pt>
                <c:pt idx="196">
                  <c:v>233.50800000000001</c:v>
                </c:pt>
                <c:pt idx="197">
                  <c:v>239.65299999999999</c:v>
                </c:pt>
                <c:pt idx="198">
                  <c:v>244.435</c:v>
                </c:pt>
                <c:pt idx="199">
                  <c:v>245.798</c:v>
                </c:pt>
                <c:pt idx="200">
                  <c:v>251.94300000000001</c:v>
                </c:pt>
                <c:pt idx="201">
                  <c:v>256.16300000000001</c:v>
                </c:pt>
                <c:pt idx="202">
                  <c:v>258.08800000000002</c:v>
                </c:pt>
                <c:pt idx="203">
                  <c:v>264.233</c:v>
                </c:pt>
                <c:pt idx="204">
                  <c:v>269.05599999999998</c:v>
                </c:pt>
                <c:pt idx="205">
                  <c:v>270.37799999999999</c:v>
                </c:pt>
                <c:pt idx="206">
                  <c:v>276.52300000000002</c:v>
                </c:pt>
                <c:pt idx="207">
                  <c:v>282.47500000000002</c:v>
                </c:pt>
                <c:pt idx="208">
                  <c:v>282.66800000000001</c:v>
                </c:pt>
                <c:pt idx="209">
                  <c:v>288.81299999999999</c:v>
                </c:pt>
                <c:pt idx="210">
                  <c:v>294.95800000000003</c:v>
                </c:pt>
                <c:pt idx="211">
                  <c:v>296.89699999999999</c:v>
                </c:pt>
                <c:pt idx="212">
                  <c:v>301.10199999999998</c:v>
                </c:pt>
                <c:pt idx="213">
                  <c:v>307.24700000000001</c:v>
                </c:pt>
                <c:pt idx="214">
                  <c:v>312.86099999999999</c:v>
                </c:pt>
                <c:pt idx="215">
                  <c:v>313.392</c:v>
                </c:pt>
                <c:pt idx="216">
                  <c:v>319.53699999999998</c:v>
                </c:pt>
                <c:pt idx="217">
                  <c:v>325.68200000000002</c:v>
                </c:pt>
                <c:pt idx="218">
                  <c:v>327.85</c:v>
                </c:pt>
                <c:pt idx="219">
                  <c:v>331.827</c:v>
                </c:pt>
                <c:pt idx="220">
                  <c:v>337.97199999999998</c:v>
                </c:pt>
                <c:pt idx="221">
                  <c:v>344.11700000000002</c:v>
                </c:pt>
                <c:pt idx="222">
                  <c:v>344.82100000000003</c:v>
                </c:pt>
                <c:pt idx="223">
                  <c:v>350.262</c:v>
                </c:pt>
                <c:pt idx="224">
                  <c:v>356.40699999999998</c:v>
                </c:pt>
                <c:pt idx="225">
                  <c:v>362.149</c:v>
                </c:pt>
                <c:pt idx="226">
                  <c:v>362.55200000000002</c:v>
                </c:pt>
                <c:pt idx="227">
                  <c:v>368.697</c:v>
                </c:pt>
                <c:pt idx="228">
                  <c:v>374.84199999999998</c:v>
                </c:pt>
                <c:pt idx="229">
                  <c:v>379.49799999999999</c:v>
                </c:pt>
                <c:pt idx="230">
                  <c:v>380.98700000000002</c:v>
                </c:pt>
                <c:pt idx="231">
                  <c:v>387.13200000000001</c:v>
                </c:pt>
                <c:pt idx="232">
                  <c:v>393.27699999999999</c:v>
                </c:pt>
                <c:pt idx="233">
                  <c:v>397.14600000000002</c:v>
                </c:pt>
                <c:pt idx="234">
                  <c:v>399.42200000000003</c:v>
                </c:pt>
                <c:pt idx="235">
                  <c:v>405.56700000000001</c:v>
                </c:pt>
                <c:pt idx="236">
                  <c:v>411.71199999999999</c:v>
                </c:pt>
                <c:pt idx="237">
                  <c:v>417.85700000000003</c:v>
                </c:pt>
                <c:pt idx="238">
                  <c:v>418.358</c:v>
                </c:pt>
                <c:pt idx="239">
                  <c:v>424.00099999999998</c:v>
                </c:pt>
                <c:pt idx="240">
                  <c:v>430.14600000000002</c:v>
                </c:pt>
                <c:pt idx="241">
                  <c:v>436.291</c:v>
                </c:pt>
                <c:pt idx="242">
                  <c:v>437.49900000000002</c:v>
                </c:pt>
                <c:pt idx="243">
                  <c:v>442.43599999999998</c:v>
                </c:pt>
                <c:pt idx="244">
                  <c:v>448.58100000000002</c:v>
                </c:pt>
                <c:pt idx="245">
                  <c:v>454.726</c:v>
                </c:pt>
                <c:pt idx="246">
                  <c:v>457.57299999999998</c:v>
                </c:pt>
                <c:pt idx="247">
                  <c:v>460.87099999999998</c:v>
                </c:pt>
                <c:pt idx="248">
                  <c:v>467.01600000000002</c:v>
                </c:pt>
                <c:pt idx="249">
                  <c:v>473.161</c:v>
                </c:pt>
                <c:pt idx="250">
                  <c:v>476.96699999999998</c:v>
                </c:pt>
                <c:pt idx="251">
                  <c:v>479.30599999999998</c:v>
                </c:pt>
                <c:pt idx="252">
                  <c:v>485.45100000000002</c:v>
                </c:pt>
                <c:pt idx="253">
                  <c:v>491.596</c:v>
                </c:pt>
                <c:pt idx="254">
                  <c:v>497.74099999999999</c:v>
                </c:pt>
                <c:pt idx="255">
                  <c:v>498.14400000000001</c:v>
                </c:pt>
                <c:pt idx="256">
                  <c:v>503.88600000000002</c:v>
                </c:pt>
                <c:pt idx="257">
                  <c:v>510.03100000000001</c:v>
                </c:pt>
                <c:pt idx="258">
                  <c:v>516.17600000000004</c:v>
                </c:pt>
                <c:pt idx="259">
                  <c:v>520.90800000000002</c:v>
                </c:pt>
                <c:pt idx="260">
                  <c:v>522.32100000000003</c:v>
                </c:pt>
                <c:pt idx="261">
                  <c:v>528.46600000000001</c:v>
                </c:pt>
                <c:pt idx="262">
                  <c:v>534.61099999999999</c:v>
                </c:pt>
                <c:pt idx="263">
                  <c:v>540.755</c:v>
                </c:pt>
                <c:pt idx="264">
                  <c:v>543.44299999999998</c:v>
                </c:pt>
                <c:pt idx="265">
                  <c:v>546.9</c:v>
                </c:pt>
                <c:pt idx="266">
                  <c:v>553.04499999999996</c:v>
                </c:pt>
                <c:pt idx="267">
                  <c:v>559.19000000000005</c:v>
                </c:pt>
                <c:pt idx="268">
                  <c:v>565.33500000000004</c:v>
                </c:pt>
                <c:pt idx="269">
                  <c:v>565.60299999999995</c:v>
                </c:pt>
                <c:pt idx="270">
                  <c:v>571.48</c:v>
                </c:pt>
                <c:pt idx="271">
                  <c:v>577.625</c:v>
                </c:pt>
                <c:pt idx="272">
                  <c:v>583.77</c:v>
                </c:pt>
                <c:pt idx="273">
                  <c:v>589.42100000000005</c:v>
                </c:pt>
                <c:pt idx="274">
                  <c:v>589.91499999999996</c:v>
                </c:pt>
                <c:pt idx="275">
                  <c:v>596.05999999999995</c:v>
                </c:pt>
                <c:pt idx="276">
                  <c:v>602.20500000000004</c:v>
                </c:pt>
                <c:pt idx="277">
                  <c:v>608.35</c:v>
                </c:pt>
                <c:pt idx="278">
                  <c:v>613.98900000000003</c:v>
                </c:pt>
                <c:pt idx="279">
                  <c:v>614.495</c:v>
                </c:pt>
                <c:pt idx="280">
                  <c:v>620.64</c:v>
                </c:pt>
                <c:pt idx="281">
                  <c:v>626.78499999999997</c:v>
                </c:pt>
                <c:pt idx="282">
                  <c:v>632.92999999999995</c:v>
                </c:pt>
                <c:pt idx="283">
                  <c:v>638.64</c:v>
                </c:pt>
                <c:pt idx="284">
                  <c:v>639.07500000000005</c:v>
                </c:pt>
                <c:pt idx="285">
                  <c:v>645.22</c:v>
                </c:pt>
                <c:pt idx="286">
                  <c:v>651.36500000000001</c:v>
                </c:pt>
                <c:pt idx="287">
                  <c:v>657.51</c:v>
                </c:pt>
                <c:pt idx="288">
                  <c:v>659.91099999999994</c:v>
                </c:pt>
                <c:pt idx="289">
                  <c:v>663.654</c:v>
                </c:pt>
                <c:pt idx="290">
                  <c:v>669.79899999999998</c:v>
                </c:pt>
                <c:pt idx="291">
                  <c:v>675.94399999999996</c:v>
                </c:pt>
                <c:pt idx="292">
                  <c:v>682.08900000000006</c:v>
                </c:pt>
                <c:pt idx="293">
                  <c:v>683.03800000000001</c:v>
                </c:pt>
                <c:pt idx="294">
                  <c:v>688.23400000000004</c:v>
                </c:pt>
                <c:pt idx="295">
                  <c:v>694.37900000000002</c:v>
                </c:pt>
                <c:pt idx="296">
                  <c:v>700.524</c:v>
                </c:pt>
                <c:pt idx="297">
                  <c:v>705.51700000000005</c:v>
                </c:pt>
                <c:pt idx="298">
                  <c:v>706.66899999999998</c:v>
                </c:pt>
                <c:pt idx="299">
                  <c:v>712.81399999999996</c:v>
                </c:pt>
                <c:pt idx="300">
                  <c:v>718.95899999999995</c:v>
                </c:pt>
                <c:pt idx="301">
                  <c:v>725.10400000000004</c:v>
                </c:pt>
                <c:pt idx="302">
                  <c:v>726.04200000000003</c:v>
                </c:pt>
                <c:pt idx="303">
                  <c:v>731.24900000000002</c:v>
                </c:pt>
                <c:pt idx="304">
                  <c:v>737.39400000000001</c:v>
                </c:pt>
                <c:pt idx="305">
                  <c:v>743.53899999999999</c:v>
                </c:pt>
                <c:pt idx="306">
                  <c:v>748.81600000000003</c:v>
                </c:pt>
                <c:pt idx="307">
                  <c:v>749.68399999999997</c:v>
                </c:pt>
                <c:pt idx="308">
                  <c:v>755.82899999999995</c:v>
                </c:pt>
                <c:pt idx="309">
                  <c:v>761.97400000000005</c:v>
                </c:pt>
                <c:pt idx="310">
                  <c:v>768.11900000000003</c:v>
                </c:pt>
                <c:pt idx="311">
                  <c:v>770.05</c:v>
                </c:pt>
                <c:pt idx="312">
                  <c:v>774.26400000000001</c:v>
                </c:pt>
                <c:pt idx="313">
                  <c:v>780.40800000000002</c:v>
                </c:pt>
                <c:pt idx="314">
                  <c:v>786.553</c:v>
                </c:pt>
                <c:pt idx="315">
                  <c:v>792.50699999999995</c:v>
                </c:pt>
                <c:pt idx="316">
                  <c:v>792.69799999999998</c:v>
                </c:pt>
                <c:pt idx="317">
                  <c:v>798.84299999999996</c:v>
                </c:pt>
                <c:pt idx="318">
                  <c:v>804.98800000000006</c:v>
                </c:pt>
                <c:pt idx="319">
                  <c:v>811.13300000000004</c:v>
                </c:pt>
                <c:pt idx="320">
                  <c:v>815.20100000000002</c:v>
                </c:pt>
                <c:pt idx="321">
                  <c:v>817.27800000000002</c:v>
                </c:pt>
                <c:pt idx="322">
                  <c:v>823.423</c:v>
                </c:pt>
                <c:pt idx="323">
                  <c:v>829.56799999999998</c:v>
                </c:pt>
                <c:pt idx="324">
                  <c:v>835.71299999999997</c:v>
                </c:pt>
                <c:pt idx="325">
                  <c:v>838.26900000000001</c:v>
                </c:pt>
                <c:pt idx="326">
                  <c:v>841.85799999999995</c:v>
                </c:pt>
                <c:pt idx="327">
                  <c:v>848.00300000000004</c:v>
                </c:pt>
                <c:pt idx="328">
                  <c:v>854.14800000000002</c:v>
                </c:pt>
                <c:pt idx="329">
                  <c:v>860.29300000000001</c:v>
                </c:pt>
                <c:pt idx="330">
                  <c:v>862.00099999999998</c:v>
                </c:pt>
                <c:pt idx="331">
                  <c:v>866.43799999999999</c:v>
                </c:pt>
                <c:pt idx="332">
                  <c:v>872.58299999999997</c:v>
                </c:pt>
                <c:pt idx="333">
                  <c:v>878.72799999999995</c:v>
                </c:pt>
                <c:pt idx="334">
                  <c:v>884.87300000000005</c:v>
                </c:pt>
                <c:pt idx="335">
                  <c:v>885.62699999999995</c:v>
                </c:pt>
                <c:pt idx="336">
                  <c:v>891.01800000000003</c:v>
                </c:pt>
                <c:pt idx="337">
                  <c:v>897.16300000000001</c:v>
                </c:pt>
                <c:pt idx="338">
                  <c:v>903.30700000000002</c:v>
                </c:pt>
                <c:pt idx="339">
                  <c:v>909.452</c:v>
                </c:pt>
                <c:pt idx="340">
                  <c:v>911.75</c:v>
                </c:pt>
                <c:pt idx="341">
                  <c:v>915.59699999999998</c:v>
                </c:pt>
                <c:pt idx="342">
                  <c:v>921.74199999999996</c:v>
                </c:pt>
                <c:pt idx="343">
                  <c:v>927.88699999999994</c:v>
                </c:pt>
                <c:pt idx="344">
                  <c:v>934.03200000000004</c:v>
                </c:pt>
                <c:pt idx="345">
                  <c:v>936.28499999999997</c:v>
                </c:pt>
                <c:pt idx="346">
                  <c:v>940.17700000000002</c:v>
                </c:pt>
                <c:pt idx="347">
                  <c:v>946.322</c:v>
                </c:pt>
                <c:pt idx="348">
                  <c:v>952.46699999999998</c:v>
                </c:pt>
                <c:pt idx="349">
                  <c:v>958.61199999999997</c:v>
                </c:pt>
                <c:pt idx="350">
                  <c:v>962.53300000000002</c:v>
                </c:pt>
                <c:pt idx="351">
                  <c:v>964.75699999999995</c:v>
                </c:pt>
                <c:pt idx="352">
                  <c:v>970.90200000000004</c:v>
                </c:pt>
                <c:pt idx="353">
                  <c:v>977.04700000000003</c:v>
                </c:pt>
                <c:pt idx="354">
                  <c:v>983.19200000000001</c:v>
                </c:pt>
                <c:pt idx="355">
                  <c:v>989.33699999999999</c:v>
                </c:pt>
                <c:pt idx="356">
                  <c:v>990.63300000000004</c:v>
                </c:pt>
                <c:pt idx="357">
                  <c:v>995.48199999999997</c:v>
                </c:pt>
                <c:pt idx="358">
                  <c:v>1001.627</c:v>
                </c:pt>
                <c:pt idx="359">
                  <c:v>1007.772</c:v>
                </c:pt>
                <c:pt idx="360">
                  <c:v>1013.917</c:v>
                </c:pt>
                <c:pt idx="361">
                  <c:v>1016.457</c:v>
                </c:pt>
                <c:pt idx="362">
                  <c:v>1020.061</c:v>
                </c:pt>
                <c:pt idx="363">
                  <c:v>1026.2059999999999</c:v>
                </c:pt>
                <c:pt idx="364">
                  <c:v>1032.3510000000001</c:v>
                </c:pt>
                <c:pt idx="365">
                  <c:v>1038.4960000000001</c:v>
                </c:pt>
                <c:pt idx="366">
                  <c:v>1043.19</c:v>
                </c:pt>
                <c:pt idx="367">
                  <c:v>1044.6410000000001</c:v>
                </c:pt>
                <c:pt idx="368">
                  <c:v>1050.7860000000001</c:v>
                </c:pt>
                <c:pt idx="369">
                  <c:v>1056.931</c:v>
                </c:pt>
                <c:pt idx="370">
                  <c:v>1063.076</c:v>
                </c:pt>
                <c:pt idx="371">
                  <c:v>1069.221</c:v>
                </c:pt>
                <c:pt idx="372">
                  <c:v>1071.538</c:v>
                </c:pt>
                <c:pt idx="373">
                  <c:v>1075.366</c:v>
                </c:pt>
                <c:pt idx="374">
                  <c:v>1081.511</c:v>
                </c:pt>
                <c:pt idx="375">
                  <c:v>1087.6559999999999</c:v>
                </c:pt>
                <c:pt idx="376">
                  <c:v>1093.8009999999999</c:v>
                </c:pt>
                <c:pt idx="377">
                  <c:v>1097.4280000000001</c:v>
                </c:pt>
                <c:pt idx="378">
                  <c:v>1099.9459999999999</c:v>
                </c:pt>
                <c:pt idx="379">
                  <c:v>1106.0909999999999</c:v>
                </c:pt>
                <c:pt idx="380">
                  <c:v>1112.2360000000001</c:v>
                </c:pt>
                <c:pt idx="381">
                  <c:v>1118.3810000000001</c:v>
                </c:pt>
                <c:pt idx="382">
                  <c:v>1124.5260000000001</c:v>
                </c:pt>
                <c:pt idx="383">
                  <c:v>1130.4839999999999</c:v>
                </c:pt>
                <c:pt idx="384">
                  <c:v>1130.671</c:v>
                </c:pt>
                <c:pt idx="385">
                  <c:v>1136.816</c:v>
                </c:pt>
                <c:pt idx="386">
                  <c:v>1142.96</c:v>
                </c:pt>
                <c:pt idx="387">
                  <c:v>1149.105</c:v>
                </c:pt>
                <c:pt idx="388">
                  <c:v>1155.25</c:v>
                </c:pt>
                <c:pt idx="389">
                  <c:v>1161.395</c:v>
                </c:pt>
                <c:pt idx="390">
                  <c:v>1167.54</c:v>
                </c:pt>
                <c:pt idx="391">
                  <c:v>1173.6849999999999</c:v>
                </c:pt>
                <c:pt idx="392">
                  <c:v>1179.83</c:v>
                </c:pt>
                <c:pt idx="393">
                  <c:v>1185.9749999999999</c:v>
                </c:pt>
                <c:pt idx="394">
                  <c:v>1192.1199999999999</c:v>
                </c:pt>
                <c:pt idx="395">
                  <c:v>1198.2650000000001</c:v>
                </c:pt>
                <c:pt idx="396">
                  <c:v>1204.4100000000001</c:v>
                </c:pt>
                <c:pt idx="397">
                  <c:v>1210.5550000000001</c:v>
                </c:pt>
                <c:pt idx="398">
                  <c:v>1216.7</c:v>
                </c:pt>
                <c:pt idx="399">
                  <c:v>1222.845</c:v>
                </c:pt>
                <c:pt idx="400">
                  <c:v>1228.99</c:v>
                </c:pt>
                <c:pt idx="401">
                  <c:v>1228.99</c:v>
                </c:pt>
              </c:numCache>
            </c:numRef>
          </c:xVal>
          <c:yVal>
            <c:numRef>
              <c:f>Foglio6!$D$411:$D$812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768000000000001</c:v>
                </c:pt>
                <c:pt idx="73">
                  <c:v>64.5</c:v>
                </c:pt>
                <c:pt idx="74">
                  <c:v>64</c:v>
                </c:pt>
                <c:pt idx="75">
                  <c:v>63.5</c:v>
                </c:pt>
                <c:pt idx="76">
                  <c:v>63</c:v>
                </c:pt>
                <c:pt idx="77">
                  <c:v>62.5</c:v>
                </c:pt>
                <c:pt idx="78">
                  <c:v>62</c:v>
                </c:pt>
                <c:pt idx="79">
                  <c:v>61.5</c:v>
                </c:pt>
                <c:pt idx="80">
                  <c:v>61</c:v>
                </c:pt>
                <c:pt idx="81">
                  <c:v>60.5</c:v>
                </c:pt>
                <c:pt idx="82">
                  <c:v>60</c:v>
                </c:pt>
                <c:pt idx="83">
                  <c:v>59.5</c:v>
                </c:pt>
                <c:pt idx="84">
                  <c:v>59</c:v>
                </c:pt>
                <c:pt idx="85">
                  <c:v>58.5</c:v>
                </c:pt>
                <c:pt idx="86">
                  <c:v>58</c:v>
                </c:pt>
                <c:pt idx="87">
                  <c:v>57.5</c:v>
                </c:pt>
                <c:pt idx="88">
                  <c:v>57</c:v>
                </c:pt>
                <c:pt idx="89">
                  <c:v>56.5</c:v>
                </c:pt>
                <c:pt idx="90">
                  <c:v>56</c:v>
                </c:pt>
                <c:pt idx="91">
                  <c:v>55.5</c:v>
                </c:pt>
                <c:pt idx="92">
                  <c:v>55</c:v>
                </c:pt>
                <c:pt idx="93">
                  <c:v>54.5</c:v>
                </c:pt>
                <c:pt idx="94">
                  <c:v>54</c:v>
                </c:pt>
                <c:pt idx="95">
                  <c:v>53.71</c:v>
                </c:pt>
                <c:pt idx="96">
                  <c:v>53.5</c:v>
                </c:pt>
                <c:pt idx="97">
                  <c:v>53</c:v>
                </c:pt>
                <c:pt idx="98">
                  <c:v>52.5</c:v>
                </c:pt>
                <c:pt idx="99">
                  <c:v>52</c:v>
                </c:pt>
                <c:pt idx="100">
                  <c:v>51.5</c:v>
                </c:pt>
                <c:pt idx="101">
                  <c:v>51</c:v>
                </c:pt>
                <c:pt idx="102">
                  <c:v>50.5</c:v>
                </c:pt>
                <c:pt idx="103">
                  <c:v>50</c:v>
                </c:pt>
                <c:pt idx="104">
                  <c:v>49.5</c:v>
                </c:pt>
                <c:pt idx="105">
                  <c:v>49</c:v>
                </c:pt>
                <c:pt idx="106">
                  <c:v>48.5</c:v>
                </c:pt>
                <c:pt idx="107">
                  <c:v>48.203000000000003</c:v>
                </c:pt>
                <c:pt idx="108">
                  <c:v>48</c:v>
                </c:pt>
                <c:pt idx="109">
                  <c:v>47.5</c:v>
                </c:pt>
                <c:pt idx="110">
                  <c:v>47</c:v>
                </c:pt>
                <c:pt idx="111">
                  <c:v>46.5</c:v>
                </c:pt>
                <c:pt idx="112">
                  <c:v>46</c:v>
                </c:pt>
                <c:pt idx="113">
                  <c:v>45.5</c:v>
                </c:pt>
                <c:pt idx="114">
                  <c:v>45</c:v>
                </c:pt>
                <c:pt idx="115">
                  <c:v>44.631</c:v>
                </c:pt>
                <c:pt idx="116">
                  <c:v>44.5</c:v>
                </c:pt>
                <c:pt idx="117">
                  <c:v>44</c:v>
                </c:pt>
                <c:pt idx="118">
                  <c:v>43.5</c:v>
                </c:pt>
                <c:pt idx="119">
                  <c:v>43</c:v>
                </c:pt>
                <c:pt idx="120">
                  <c:v>42.5</c:v>
                </c:pt>
                <c:pt idx="121">
                  <c:v>42</c:v>
                </c:pt>
                <c:pt idx="122">
                  <c:v>41.942999999999998</c:v>
                </c:pt>
                <c:pt idx="123">
                  <c:v>41.5</c:v>
                </c:pt>
                <c:pt idx="124">
                  <c:v>41</c:v>
                </c:pt>
                <c:pt idx="125">
                  <c:v>40.5</c:v>
                </c:pt>
                <c:pt idx="126">
                  <c:v>40</c:v>
                </c:pt>
                <c:pt idx="127">
                  <c:v>39.869999999999997</c:v>
                </c:pt>
                <c:pt idx="128">
                  <c:v>39.5</c:v>
                </c:pt>
                <c:pt idx="129">
                  <c:v>39</c:v>
                </c:pt>
                <c:pt idx="130">
                  <c:v>38.5</c:v>
                </c:pt>
                <c:pt idx="131">
                  <c:v>38.143999999999998</c:v>
                </c:pt>
                <c:pt idx="132">
                  <c:v>38</c:v>
                </c:pt>
                <c:pt idx="133">
                  <c:v>37.5</c:v>
                </c:pt>
                <c:pt idx="134">
                  <c:v>37</c:v>
                </c:pt>
                <c:pt idx="135">
                  <c:v>36.716000000000001</c:v>
                </c:pt>
                <c:pt idx="136">
                  <c:v>36.5</c:v>
                </c:pt>
                <c:pt idx="137">
                  <c:v>36</c:v>
                </c:pt>
                <c:pt idx="138">
                  <c:v>35.5</c:v>
                </c:pt>
                <c:pt idx="139">
                  <c:v>35.404000000000003</c:v>
                </c:pt>
                <c:pt idx="140">
                  <c:v>35</c:v>
                </c:pt>
                <c:pt idx="141">
                  <c:v>34.5</c:v>
                </c:pt>
                <c:pt idx="142">
                  <c:v>34.277999999999999</c:v>
                </c:pt>
                <c:pt idx="143">
                  <c:v>34</c:v>
                </c:pt>
                <c:pt idx="144">
                  <c:v>33.5</c:v>
                </c:pt>
                <c:pt idx="145">
                  <c:v>33.292000000000002</c:v>
                </c:pt>
                <c:pt idx="146">
                  <c:v>33</c:v>
                </c:pt>
                <c:pt idx="147">
                  <c:v>32.5</c:v>
                </c:pt>
                <c:pt idx="148">
                  <c:v>32.424999999999997</c:v>
                </c:pt>
                <c:pt idx="149">
                  <c:v>32</c:v>
                </c:pt>
                <c:pt idx="150">
                  <c:v>31.645</c:v>
                </c:pt>
                <c:pt idx="151">
                  <c:v>31.5</c:v>
                </c:pt>
                <c:pt idx="152">
                  <c:v>31</c:v>
                </c:pt>
                <c:pt idx="153">
                  <c:v>30.881</c:v>
                </c:pt>
                <c:pt idx="154">
                  <c:v>30.5</c:v>
                </c:pt>
                <c:pt idx="155">
                  <c:v>30.193999999999999</c:v>
                </c:pt>
                <c:pt idx="156">
                  <c:v>30</c:v>
                </c:pt>
                <c:pt idx="157">
                  <c:v>29.622</c:v>
                </c:pt>
                <c:pt idx="158">
                  <c:v>29.5</c:v>
                </c:pt>
                <c:pt idx="159">
                  <c:v>29.032</c:v>
                </c:pt>
                <c:pt idx="160">
                  <c:v>29</c:v>
                </c:pt>
                <c:pt idx="161">
                  <c:v>28.5</c:v>
                </c:pt>
                <c:pt idx="162">
                  <c:v>28.416</c:v>
                </c:pt>
                <c:pt idx="163">
                  <c:v>28</c:v>
                </c:pt>
                <c:pt idx="164">
                  <c:v>27.914999999999999</c:v>
                </c:pt>
                <c:pt idx="165">
                  <c:v>27.5</c:v>
                </c:pt>
                <c:pt idx="166">
                  <c:v>27.411999999999999</c:v>
                </c:pt>
                <c:pt idx="167">
                  <c:v>27</c:v>
                </c:pt>
                <c:pt idx="168">
                  <c:v>26.984000000000002</c:v>
                </c:pt>
                <c:pt idx="169">
                  <c:v>26.576000000000001</c:v>
                </c:pt>
                <c:pt idx="170">
                  <c:v>26.5</c:v>
                </c:pt>
                <c:pt idx="171">
                  <c:v>26.190999999999999</c:v>
                </c:pt>
                <c:pt idx="172">
                  <c:v>26</c:v>
                </c:pt>
                <c:pt idx="173">
                  <c:v>25.766999999999999</c:v>
                </c:pt>
                <c:pt idx="174">
                  <c:v>25.5</c:v>
                </c:pt>
                <c:pt idx="175">
                  <c:v>25.39</c:v>
                </c:pt>
                <c:pt idx="176">
                  <c:v>25</c:v>
                </c:pt>
                <c:pt idx="177">
                  <c:v>24.96</c:v>
                </c:pt>
                <c:pt idx="178">
                  <c:v>24.588000000000001</c:v>
                </c:pt>
                <c:pt idx="179">
                  <c:v>24.5</c:v>
                </c:pt>
                <c:pt idx="180">
                  <c:v>24.276</c:v>
                </c:pt>
                <c:pt idx="181">
                  <c:v>24</c:v>
                </c:pt>
                <c:pt idx="182">
                  <c:v>23.978999999999999</c:v>
                </c:pt>
                <c:pt idx="183">
                  <c:v>23.673999999999999</c:v>
                </c:pt>
                <c:pt idx="184">
                  <c:v>23.5</c:v>
                </c:pt>
                <c:pt idx="185">
                  <c:v>23.378</c:v>
                </c:pt>
                <c:pt idx="186">
                  <c:v>23.097000000000001</c:v>
                </c:pt>
                <c:pt idx="187">
                  <c:v>23</c:v>
                </c:pt>
                <c:pt idx="188">
                  <c:v>22.792999999999999</c:v>
                </c:pt>
                <c:pt idx="189">
                  <c:v>22.5</c:v>
                </c:pt>
                <c:pt idx="190">
                  <c:v>22.446000000000002</c:v>
                </c:pt>
                <c:pt idx="191">
                  <c:v>22.13</c:v>
                </c:pt>
                <c:pt idx="192">
                  <c:v>22</c:v>
                </c:pt>
                <c:pt idx="193">
                  <c:v>21.832000000000001</c:v>
                </c:pt>
                <c:pt idx="194">
                  <c:v>21.63</c:v>
                </c:pt>
                <c:pt idx="195">
                  <c:v>21.5</c:v>
                </c:pt>
                <c:pt idx="196">
                  <c:v>21.381</c:v>
                </c:pt>
                <c:pt idx="197">
                  <c:v>21.157</c:v>
                </c:pt>
                <c:pt idx="198">
                  <c:v>21</c:v>
                </c:pt>
                <c:pt idx="199">
                  <c:v>20.939</c:v>
                </c:pt>
                <c:pt idx="200">
                  <c:v>20.686</c:v>
                </c:pt>
                <c:pt idx="201">
                  <c:v>20.5</c:v>
                </c:pt>
                <c:pt idx="202">
                  <c:v>20.437999999999999</c:v>
                </c:pt>
                <c:pt idx="203">
                  <c:v>20.184000000000001</c:v>
                </c:pt>
                <c:pt idx="204">
                  <c:v>20</c:v>
                </c:pt>
                <c:pt idx="205">
                  <c:v>19.937000000000001</c:v>
                </c:pt>
                <c:pt idx="206">
                  <c:v>19.73</c:v>
                </c:pt>
                <c:pt idx="207">
                  <c:v>19.5</c:v>
                </c:pt>
                <c:pt idx="208">
                  <c:v>19.491</c:v>
                </c:pt>
                <c:pt idx="209">
                  <c:v>19.295999999999999</c:v>
                </c:pt>
                <c:pt idx="210">
                  <c:v>19.042999999999999</c:v>
                </c:pt>
                <c:pt idx="211">
                  <c:v>19</c:v>
                </c:pt>
                <c:pt idx="212">
                  <c:v>18.87</c:v>
                </c:pt>
                <c:pt idx="213">
                  <c:v>18.678000000000001</c:v>
                </c:pt>
                <c:pt idx="214">
                  <c:v>18.5</c:v>
                </c:pt>
                <c:pt idx="215">
                  <c:v>18.481000000000002</c:v>
                </c:pt>
                <c:pt idx="216">
                  <c:v>18.260999999999999</c:v>
                </c:pt>
                <c:pt idx="217">
                  <c:v>18.077000000000002</c:v>
                </c:pt>
                <c:pt idx="218">
                  <c:v>18</c:v>
                </c:pt>
                <c:pt idx="219">
                  <c:v>17.866</c:v>
                </c:pt>
                <c:pt idx="220">
                  <c:v>17.702000000000002</c:v>
                </c:pt>
                <c:pt idx="221">
                  <c:v>17.527000000000001</c:v>
                </c:pt>
                <c:pt idx="222">
                  <c:v>17.5</c:v>
                </c:pt>
                <c:pt idx="223">
                  <c:v>17.324000000000002</c:v>
                </c:pt>
                <c:pt idx="224">
                  <c:v>17.151</c:v>
                </c:pt>
                <c:pt idx="225">
                  <c:v>17</c:v>
                </c:pt>
                <c:pt idx="226">
                  <c:v>16.988</c:v>
                </c:pt>
                <c:pt idx="227">
                  <c:v>16.824999999999999</c:v>
                </c:pt>
                <c:pt idx="228">
                  <c:v>16.643999999999998</c:v>
                </c:pt>
                <c:pt idx="229">
                  <c:v>16.5</c:v>
                </c:pt>
                <c:pt idx="230">
                  <c:v>16.459</c:v>
                </c:pt>
                <c:pt idx="231">
                  <c:v>16.315999999999999</c:v>
                </c:pt>
                <c:pt idx="232">
                  <c:v>16.108000000000001</c:v>
                </c:pt>
                <c:pt idx="233">
                  <c:v>16</c:v>
                </c:pt>
                <c:pt idx="234">
                  <c:v>15.945</c:v>
                </c:pt>
                <c:pt idx="235">
                  <c:v>15.817</c:v>
                </c:pt>
                <c:pt idx="236">
                  <c:v>15.661</c:v>
                </c:pt>
                <c:pt idx="237">
                  <c:v>15.515000000000001</c:v>
                </c:pt>
                <c:pt idx="238">
                  <c:v>15.5</c:v>
                </c:pt>
                <c:pt idx="239">
                  <c:v>15.351000000000001</c:v>
                </c:pt>
                <c:pt idx="240">
                  <c:v>15.209</c:v>
                </c:pt>
                <c:pt idx="241">
                  <c:v>15.054</c:v>
                </c:pt>
                <c:pt idx="242">
                  <c:v>15</c:v>
                </c:pt>
                <c:pt idx="243">
                  <c:v>14.896000000000001</c:v>
                </c:pt>
                <c:pt idx="244">
                  <c:v>14.744</c:v>
                </c:pt>
                <c:pt idx="245">
                  <c:v>14.567</c:v>
                </c:pt>
                <c:pt idx="246">
                  <c:v>14.5</c:v>
                </c:pt>
                <c:pt idx="247">
                  <c:v>14.401</c:v>
                </c:pt>
                <c:pt idx="248">
                  <c:v>14.228999999999999</c:v>
                </c:pt>
                <c:pt idx="249">
                  <c:v>14.101000000000001</c:v>
                </c:pt>
                <c:pt idx="250">
                  <c:v>14</c:v>
                </c:pt>
                <c:pt idx="251">
                  <c:v>13.954000000000001</c:v>
                </c:pt>
                <c:pt idx="252">
                  <c:v>13.832000000000001</c:v>
                </c:pt>
                <c:pt idx="253">
                  <c:v>13.714</c:v>
                </c:pt>
                <c:pt idx="254">
                  <c:v>13.512</c:v>
                </c:pt>
                <c:pt idx="255">
                  <c:v>13.5</c:v>
                </c:pt>
                <c:pt idx="256">
                  <c:v>13.393000000000001</c:v>
                </c:pt>
                <c:pt idx="257">
                  <c:v>13.234</c:v>
                </c:pt>
                <c:pt idx="258">
                  <c:v>13.097</c:v>
                </c:pt>
                <c:pt idx="259">
                  <c:v>13</c:v>
                </c:pt>
                <c:pt idx="260">
                  <c:v>12.965999999999999</c:v>
                </c:pt>
                <c:pt idx="261">
                  <c:v>12.821999999999999</c:v>
                </c:pt>
                <c:pt idx="262">
                  <c:v>12.689</c:v>
                </c:pt>
                <c:pt idx="263">
                  <c:v>12.561</c:v>
                </c:pt>
                <c:pt idx="264">
                  <c:v>12.5</c:v>
                </c:pt>
                <c:pt idx="265">
                  <c:v>12.403</c:v>
                </c:pt>
                <c:pt idx="266">
                  <c:v>12.263</c:v>
                </c:pt>
                <c:pt idx="267">
                  <c:v>12.129</c:v>
                </c:pt>
                <c:pt idx="268">
                  <c:v>12.005000000000001</c:v>
                </c:pt>
                <c:pt idx="269">
                  <c:v>12</c:v>
                </c:pt>
                <c:pt idx="270">
                  <c:v>11.858000000000001</c:v>
                </c:pt>
                <c:pt idx="271">
                  <c:v>11.769</c:v>
                </c:pt>
                <c:pt idx="272">
                  <c:v>11.599</c:v>
                </c:pt>
                <c:pt idx="273">
                  <c:v>11.5</c:v>
                </c:pt>
                <c:pt idx="274">
                  <c:v>11.49</c:v>
                </c:pt>
                <c:pt idx="275">
                  <c:v>11.382999999999999</c:v>
                </c:pt>
                <c:pt idx="276">
                  <c:v>11.268000000000001</c:v>
                </c:pt>
                <c:pt idx="277">
                  <c:v>11.135</c:v>
                </c:pt>
                <c:pt idx="278">
                  <c:v>11</c:v>
                </c:pt>
                <c:pt idx="279">
                  <c:v>10.984999999999999</c:v>
                </c:pt>
                <c:pt idx="280">
                  <c:v>10.84</c:v>
                </c:pt>
                <c:pt idx="281">
                  <c:v>10.727</c:v>
                </c:pt>
                <c:pt idx="282">
                  <c:v>10.61</c:v>
                </c:pt>
                <c:pt idx="283">
                  <c:v>10.5</c:v>
                </c:pt>
                <c:pt idx="284">
                  <c:v>10.492000000000001</c:v>
                </c:pt>
                <c:pt idx="285">
                  <c:v>10.332000000000001</c:v>
                </c:pt>
                <c:pt idx="286">
                  <c:v>10.173</c:v>
                </c:pt>
                <c:pt idx="287">
                  <c:v>10.055999999999999</c:v>
                </c:pt>
                <c:pt idx="288">
                  <c:v>10</c:v>
                </c:pt>
                <c:pt idx="289">
                  <c:v>9.9359999999999999</c:v>
                </c:pt>
                <c:pt idx="290">
                  <c:v>9.7970000000000006</c:v>
                </c:pt>
                <c:pt idx="291">
                  <c:v>9.6679999999999993</c:v>
                </c:pt>
                <c:pt idx="292">
                  <c:v>9.516</c:v>
                </c:pt>
                <c:pt idx="293">
                  <c:v>9.5</c:v>
                </c:pt>
                <c:pt idx="294">
                  <c:v>9.3780000000000001</c:v>
                </c:pt>
                <c:pt idx="295">
                  <c:v>9.2579999999999991</c:v>
                </c:pt>
                <c:pt idx="296">
                  <c:v>9.1059999999999999</c:v>
                </c:pt>
                <c:pt idx="297">
                  <c:v>9</c:v>
                </c:pt>
                <c:pt idx="298">
                  <c:v>8.9619999999999997</c:v>
                </c:pt>
                <c:pt idx="299">
                  <c:v>8.8079999999999998</c:v>
                </c:pt>
                <c:pt idx="300">
                  <c:v>8.6739999999999995</c:v>
                </c:pt>
                <c:pt idx="301">
                  <c:v>8.516</c:v>
                </c:pt>
                <c:pt idx="302">
                  <c:v>8.5</c:v>
                </c:pt>
                <c:pt idx="303">
                  <c:v>8.3930000000000007</c:v>
                </c:pt>
                <c:pt idx="304">
                  <c:v>8.24</c:v>
                </c:pt>
                <c:pt idx="305">
                  <c:v>8.1150000000000002</c:v>
                </c:pt>
                <c:pt idx="306">
                  <c:v>8</c:v>
                </c:pt>
                <c:pt idx="307">
                  <c:v>7.9809999999999999</c:v>
                </c:pt>
                <c:pt idx="308">
                  <c:v>7.8659999999999997</c:v>
                </c:pt>
                <c:pt idx="309">
                  <c:v>7.702</c:v>
                </c:pt>
                <c:pt idx="310">
                  <c:v>7.55</c:v>
                </c:pt>
                <c:pt idx="311">
                  <c:v>7.5</c:v>
                </c:pt>
                <c:pt idx="312">
                  <c:v>7.3979999999999997</c:v>
                </c:pt>
                <c:pt idx="313">
                  <c:v>7.2709999999999999</c:v>
                </c:pt>
                <c:pt idx="314">
                  <c:v>7.149</c:v>
                </c:pt>
                <c:pt idx="315">
                  <c:v>7</c:v>
                </c:pt>
                <c:pt idx="316">
                  <c:v>6.9960000000000004</c:v>
                </c:pt>
                <c:pt idx="317">
                  <c:v>6.867</c:v>
                </c:pt>
                <c:pt idx="318">
                  <c:v>6.7240000000000002</c:v>
                </c:pt>
                <c:pt idx="319">
                  <c:v>6.5839999999999996</c:v>
                </c:pt>
                <c:pt idx="320">
                  <c:v>6.5</c:v>
                </c:pt>
                <c:pt idx="321">
                  <c:v>6.4530000000000003</c:v>
                </c:pt>
                <c:pt idx="322">
                  <c:v>6.327</c:v>
                </c:pt>
                <c:pt idx="323">
                  <c:v>6.16</c:v>
                </c:pt>
                <c:pt idx="324">
                  <c:v>6.0449999999999999</c:v>
                </c:pt>
                <c:pt idx="325">
                  <c:v>6</c:v>
                </c:pt>
                <c:pt idx="326">
                  <c:v>5.94</c:v>
                </c:pt>
                <c:pt idx="327">
                  <c:v>5.806</c:v>
                </c:pt>
                <c:pt idx="328">
                  <c:v>5.6539999999999999</c:v>
                </c:pt>
                <c:pt idx="329">
                  <c:v>5.5259999999999998</c:v>
                </c:pt>
                <c:pt idx="330">
                  <c:v>5.5</c:v>
                </c:pt>
                <c:pt idx="331">
                  <c:v>5.3869999999999996</c:v>
                </c:pt>
                <c:pt idx="332">
                  <c:v>5.2729999999999997</c:v>
                </c:pt>
                <c:pt idx="333">
                  <c:v>5.1710000000000003</c:v>
                </c:pt>
                <c:pt idx="334">
                  <c:v>5.0190000000000001</c:v>
                </c:pt>
                <c:pt idx="335">
                  <c:v>5</c:v>
                </c:pt>
                <c:pt idx="336">
                  <c:v>4.891</c:v>
                </c:pt>
                <c:pt idx="337">
                  <c:v>4.7839999999999998</c:v>
                </c:pt>
                <c:pt idx="338">
                  <c:v>4.68</c:v>
                </c:pt>
                <c:pt idx="339">
                  <c:v>4.5519999999999996</c:v>
                </c:pt>
                <c:pt idx="340">
                  <c:v>4.5</c:v>
                </c:pt>
                <c:pt idx="341">
                  <c:v>4.431</c:v>
                </c:pt>
                <c:pt idx="342">
                  <c:v>4.2809999999999997</c:v>
                </c:pt>
                <c:pt idx="343">
                  <c:v>4.1680000000000001</c:v>
                </c:pt>
                <c:pt idx="344">
                  <c:v>4.0460000000000003</c:v>
                </c:pt>
                <c:pt idx="345">
                  <c:v>4</c:v>
                </c:pt>
                <c:pt idx="346">
                  <c:v>3.948</c:v>
                </c:pt>
                <c:pt idx="347">
                  <c:v>3.85</c:v>
                </c:pt>
                <c:pt idx="348">
                  <c:v>3.7050000000000001</c:v>
                </c:pt>
                <c:pt idx="349">
                  <c:v>3.5880000000000001</c:v>
                </c:pt>
                <c:pt idx="350">
                  <c:v>3.5</c:v>
                </c:pt>
                <c:pt idx="351">
                  <c:v>3.4489999999999998</c:v>
                </c:pt>
                <c:pt idx="352">
                  <c:v>3.3180000000000001</c:v>
                </c:pt>
                <c:pt idx="353">
                  <c:v>3.2269999999999999</c:v>
                </c:pt>
                <c:pt idx="354">
                  <c:v>3.1179999999999999</c:v>
                </c:pt>
                <c:pt idx="355">
                  <c:v>3.0209999999999999</c:v>
                </c:pt>
                <c:pt idx="356">
                  <c:v>3</c:v>
                </c:pt>
                <c:pt idx="357">
                  <c:v>2.8940000000000001</c:v>
                </c:pt>
                <c:pt idx="358">
                  <c:v>2.7639999999999998</c:v>
                </c:pt>
                <c:pt idx="359">
                  <c:v>2.6659999999999999</c:v>
                </c:pt>
                <c:pt idx="360">
                  <c:v>2.5449999999999999</c:v>
                </c:pt>
                <c:pt idx="361">
                  <c:v>2.5</c:v>
                </c:pt>
                <c:pt idx="362">
                  <c:v>2.4300000000000002</c:v>
                </c:pt>
                <c:pt idx="363">
                  <c:v>2.3199999999999998</c:v>
                </c:pt>
                <c:pt idx="364">
                  <c:v>2.2090000000000001</c:v>
                </c:pt>
                <c:pt idx="365">
                  <c:v>2.0880000000000001</c:v>
                </c:pt>
                <c:pt idx="366">
                  <c:v>2</c:v>
                </c:pt>
                <c:pt idx="367">
                  <c:v>1.958</c:v>
                </c:pt>
                <c:pt idx="368">
                  <c:v>1.8740000000000001</c:v>
                </c:pt>
                <c:pt idx="369">
                  <c:v>1.7470000000000001</c:v>
                </c:pt>
                <c:pt idx="370">
                  <c:v>1.66</c:v>
                </c:pt>
                <c:pt idx="371">
                  <c:v>1.5329999999999999</c:v>
                </c:pt>
                <c:pt idx="372">
                  <c:v>1.5</c:v>
                </c:pt>
                <c:pt idx="373">
                  <c:v>1.421</c:v>
                </c:pt>
                <c:pt idx="374">
                  <c:v>1.304</c:v>
                </c:pt>
                <c:pt idx="375">
                  <c:v>1.1579999999999999</c:v>
                </c:pt>
                <c:pt idx="376">
                  <c:v>1.0580000000000001</c:v>
                </c:pt>
                <c:pt idx="377">
                  <c:v>1</c:v>
                </c:pt>
                <c:pt idx="378">
                  <c:v>0.96399999999999997</c:v>
                </c:pt>
                <c:pt idx="379">
                  <c:v>0.86299999999999999</c:v>
                </c:pt>
                <c:pt idx="380">
                  <c:v>0.78</c:v>
                </c:pt>
                <c:pt idx="381">
                  <c:v>0.66300000000000003</c:v>
                </c:pt>
                <c:pt idx="382">
                  <c:v>0.56599999999999995</c:v>
                </c:pt>
                <c:pt idx="383">
                  <c:v>0.5</c:v>
                </c:pt>
                <c:pt idx="384">
                  <c:v>0.497</c:v>
                </c:pt>
                <c:pt idx="385">
                  <c:v>0.435</c:v>
                </c:pt>
                <c:pt idx="386">
                  <c:v>0.35499999999999998</c:v>
                </c:pt>
                <c:pt idx="387">
                  <c:v>0.29099999999999998</c:v>
                </c:pt>
                <c:pt idx="388">
                  <c:v>0.23699999999999999</c:v>
                </c:pt>
                <c:pt idx="389">
                  <c:v>0.183</c:v>
                </c:pt>
                <c:pt idx="390">
                  <c:v>0.14099999999999999</c:v>
                </c:pt>
                <c:pt idx="391">
                  <c:v>0.10100000000000001</c:v>
                </c:pt>
                <c:pt idx="392">
                  <c:v>6.4000000000000001E-2</c:v>
                </c:pt>
                <c:pt idx="393">
                  <c:v>4.2999999999999997E-2</c:v>
                </c:pt>
                <c:pt idx="394">
                  <c:v>2.9000000000000001E-2</c:v>
                </c:pt>
                <c:pt idx="395">
                  <c:v>1.7999999999999999E-2</c:v>
                </c:pt>
                <c:pt idx="396">
                  <c:v>1.2999999999999999E-2</c:v>
                </c:pt>
                <c:pt idx="397">
                  <c:v>6.0000000000000001E-3</c:v>
                </c:pt>
                <c:pt idx="398">
                  <c:v>1E-3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7EB-4971-BBB7-EC35B5F78EDB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xVal>
            <c:numRef>
              <c:f>Foglio6!$E$411:$E$812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2E-3</c:v>
                </c:pt>
                <c:pt idx="11">
                  <c:v>4.4999999999999998E-2</c:v>
                </c:pt>
                <c:pt idx="12">
                  <c:v>8.8999999999999996E-2</c:v>
                </c:pt>
                <c:pt idx="13">
                  <c:v>0.13200000000000001</c:v>
                </c:pt>
                <c:pt idx="14">
                  <c:v>0.17599999999999999</c:v>
                </c:pt>
                <c:pt idx="15">
                  <c:v>0.22</c:v>
                </c:pt>
                <c:pt idx="16">
                  <c:v>0.26300000000000001</c:v>
                </c:pt>
                <c:pt idx="17">
                  <c:v>0.307</c:v>
                </c:pt>
                <c:pt idx="18">
                  <c:v>0.35</c:v>
                </c:pt>
                <c:pt idx="19">
                  <c:v>0.39400000000000002</c:v>
                </c:pt>
                <c:pt idx="20">
                  <c:v>0.437</c:v>
                </c:pt>
                <c:pt idx="21">
                  <c:v>0.48099999999999998</c:v>
                </c:pt>
                <c:pt idx="22">
                  <c:v>0.52400000000000002</c:v>
                </c:pt>
                <c:pt idx="23">
                  <c:v>0.56799999999999995</c:v>
                </c:pt>
                <c:pt idx="24">
                  <c:v>0.61199999999999999</c:v>
                </c:pt>
                <c:pt idx="25">
                  <c:v>0.65500000000000003</c:v>
                </c:pt>
                <c:pt idx="26">
                  <c:v>0.69899999999999995</c:v>
                </c:pt>
                <c:pt idx="27">
                  <c:v>0.74199999999999999</c:v>
                </c:pt>
                <c:pt idx="28">
                  <c:v>0.78600000000000003</c:v>
                </c:pt>
                <c:pt idx="29">
                  <c:v>0.82899999999999996</c:v>
                </c:pt>
                <c:pt idx="30">
                  <c:v>0.873</c:v>
                </c:pt>
                <c:pt idx="31">
                  <c:v>0.91700000000000004</c:v>
                </c:pt>
                <c:pt idx="32">
                  <c:v>0.96</c:v>
                </c:pt>
                <c:pt idx="33">
                  <c:v>1.004</c:v>
                </c:pt>
                <c:pt idx="34">
                  <c:v>1.0469999999999999</c:v>
                </c:pt>
                <c:pt idx="35">
                  <c:v>1.091</c:v>
                </c:pt>
                <c:pt idx="36">
                  <c:v>1.1339999999999999</c:v>
                </c:pt>
                <c:pt idx="37">
                  <c:v>1.1779999999999999</c:v>
                </c:pt>
                <c:pt idx="38">
                  <c:v>1.2210000000000001</c:v>
                </c:pt>
                <c:pt idx="39">
                  <c:v>1.2609999999999999</c:v>
                </c:pt>
                <c:pt idx="40">
                  <c:v>1.2989999999999999</c:v>
                </c:pt>
                <c:pt idx="41">
                  <c:v>1.337</c:v>
                </c:pt>
                <c:pt idx="42">
                  <c:v>1.375</c:v>
                </c:pt>
                <c:pt idx="43">
                  <c:v>1.413</c:v>
                </c:pt>
                <c:pt idx="44">
                  <c:v>1.4510000000000001</c:v>
                </c:pt>
                <c:pt idx="45">
                  <c:v>1.49</c:v>
                </c:pt>
                <c:pt idx="46">
                  <c:v>1.528</c:v>
                </c:pt>
                <c:pt idx="47">
                  <c:v>1.5660000000000001</c:v>
                </c:pt>
                <c:pt idx="48">
                  <c:v>1.6040000000000001</c:v>
                </c:pt>
                <c:pt idx="49">
                  <c:v>1.6419999999999999</c:v>
                </c:pt>
                <c:pt idx="50">
                  <c:v>1.68</c:v>
                </c:pt>
                <c:pt idx="51">
                  <c:v>1.718</c:v>
                </c:pt>
                <c:pt idx="52">
                  <c:v>1.756</c:v>
                </c:pt>
                <c:pt idx="53">
                  <c:v>1.794</c:v>
                </c:pt>
                <c:pt idx="54">
                  <c:v>1.8320000000000001</c:v>
                </c:pt>
                <c:pt idx="55">
                  <c:v>1.87</c:v>
                </c:pt>
                <c:pt idx="56">
                  <c:v>1.9079999999999999</c:v>
                </c:pt>
                <c:pt idx="57">
                  <c:v>1.9470000000000001</c:v>
                </c:pt>
                <c:pt idx="58">
                  <c:v>1.9850000000000001</c:v>
                </c:pt>
                <c:pt idx="59">
                  <c:v>2.0230000000000001</c:v>
                </c:pt>
                <c:pt idx="60">
                  <c:v>2.0609999999999999</c:v>
                </c:pt>
                <c:pt idx="61">
                  <c:v>2.0990000000000002</c:v>
                </c:pt>
                <c:pt idx="62">
                  <c:v>2.137</c:v>
                </c:pt>
                <c:pt idx="63">
                  <c:v>2.1749999999999998</c:v>
                </c:pt>
                <c:pt idx="64">
                  <c:v>2.2130000000000001</c:v>
                </c:pt>
                <c:pt idx="65">
                  <c:v>2.2509999999999999</c:v>
                </c:pt>
                <c:pt idx="66">
                  <c:v>2.2890000000000001</c:v>
                </c:pt>
                <c:pt idx="67">
                  <c:v>2.327</c:v>
                </c:pt>
                <c:pt idx="68">
                  <c:v>2.3650000000000002</c:v>
                </c:pt>
                <c:pt idx="69">
                  <c:v>2.4039999999999999</c:v>
                </c:pt>
                <c:pt idx="70">
                  <c:v>2.4420000000000002</c:v>
                </c:pt>
                <c:pt idx="71">
                  <c:v>2.4860000000000002</c:v>
                </c:pt>
                <c:pt idx="72">
                  <c:v>2.5419999999999998</c:v>
                </c:pt>
                <c:pt idx="73">
                  <c:v>2.5979999999999999</c:v>
                </c:pt>
                <c:pt idx="74">
                  <c:v>2.6539999999999999</c:v>
                </c:pt>
                <c:pt idx="75">
                  <c:v>2.71</c:v>
                </c:pt>
                <c:pt idx="76">
                  <c:v>2.766</c:v>
                </c:pt>
                <c:pt idx="77">
                  <c:v>2.8220000000000001</c:v>
                </c:pt>
                <c:pt idx="78">
                  <c:v>2.8780000000000001</c:v>
                </c:pt>
                <c:pt idx="79">
                  <c:v>2.9340000000000002</c:v>
                </c:pt>
                <c:pt idx="80">
                  <c:v>2.99</c:v>
                </c:pt>
                <c:pt idx="81">
                  <c:v>3.0459999999999998</c:v>
                </c:pt>
                <c:pt idx="82">
                  <c:v>3.1019999999999999</c:v>
                </c:pt>
                <c:pt idx="83">
                  <c:v>3.1579999999999999</c:v>
                </c:pt>
                <c:pt idx="84">
                  <c:v>3.214</c:v>
                </c:pt>
                <c:pt idx="85">
                  <c:v>3.2690000000000001</c:v>
                </c:pt>
                <c:pt idx="86">
                  <c:v>3.3250000000000002</c:v>
                </c:pt>
                <c:pt idx="87">
                  <c:v>3.3809999999999998</c:v>
                </c:pt>
                <c:pt idx="88">
                  <c:v>3.4369999999999998</c:v>
                </c:pt>
                <c:pt idx="89">
                  <c:v>3.4929999999999999</c:v>
                </c:pt>
                <c:pt idx="90">
                  <c:v>3.5489999999999999</c:v>
                </c:pt>
                <c:pt idx="91">
                  <c:v>3.605</c:v>
                </c:pt>
                <c:pt idx="92">
                  <c:v>3.661</c:v>
                </c:pt>
                <c:pt idx="93">
                  <c:v>3.7250000000000001</c:v>
                </c:pt>
                <c:pt idx="94">
                  <c:v>3.8050000000000002</c:v>
                </c:pt>
                <c:pt idx="95">
                  <c:v>3.8849999999999998</c:v>
                </c:pt>
                <c:pt idx="96">
                  <c:v>3.9649999999999999</c:v>
                </c:pt>
                <c:pt idx="97">
                  <c:v>4.0449999999999999</c:v>
                </c:pt>
                <c:pt idx="98">
                  <c:v>4.125</c:v>
                </c:pt>
                <c:pt idx="99">
                  <c:v>4.2050000000000001</c:v>
                </c:pt>
                <c:pt idx="100">
                  <c:v>4.2850000000000001</c:v>
                </c:pt>
                <c:pt idx="101">
                  <c:v>4.3650000000000002</c:v>
                </c:pt>
                <c:pt idx="102">
                  <c:v>4.4450000000000003</c:v>
                </c:pt>
                <c:pt idx="103">
                  <c:v>4.5250000000000004</c:v>
                </c:pt>
                <c:pt idx="104">
                  <c:v>4.6050000000000004</c:v>
                </c:pt>
                <c:pt idx="105">
                  <c:v>4.6849999999999996</c:v>
                </c:pt>
                <c:pt idx="106">
                  <c:v>4.7649999999999997</c:v>
                </c:pt>
                <c:pt idx="107">
                  <c:v>4.8460000000000001</c:v>
                </c:pt>
                <c:pt idx="108">
                  <c:v>4.9260000000000002</c:v>
                </c:pt>
                <c:pt idx="109">
                  <c:v>5.0350000000000001</c:v>
                </c:pt>
                <c:pt idx="110">
                  <c:v>5.1470000000000002</c:v>
                </c:pt>
                <c:pt idx="111">
                  <c:v>5.2590000000000003</c:v>
                </c:pt>
                <c:pt idx="112">
                  <c:v>5.3710000000000004</c:v>
                </c:pt>
                <c:pt idx="113">
                  <c:v>5.4829999999999997</c:v>
                </c:pt>
                <c:pt idx="114">
                  <c:v>5.5940000000000003</c:v>
                </c:pt>
                <c:pt idx="115">
                  <c:v>5.7060000000000004</c:v>
                </c:pt>
                <c:pt idx="116">
                  <c:v>5.8179999999999996</c:v>
                </c:pt>
                <c:pt idx="117">
                  <c:v>5.93</c:v>
                </c:pt>
                <c:pt idx="118">
                  <c:v>6.0419999999999998</c:v>
                </c:pt>
                <c:pt idx="119">
                  <c:v>6.1539999999999999</c:v>
                </c:pt>
                <c:pt idx="120">
                  <c:v>6.1660000000000004</c:v>
                </c:pt>
                <c:pt idx="121">
                  <c:v>6.3070000000000004</c:v>
                </c:pt>
                <c:pt idx="122">
                  <c:v>6.4640000000000004</c:v>
                </c:pt>
                <c:pt idx="123">
                  <c:v>6.6219999999999999</c:v>
                </c:pt>
                <c:pt idx="124">
                  <c:v>6.7789999999999999</c:v>
                </c:pt>
                <c:pt idx="125">
                  <c:v>6.9370000000000003</c:v>
                </c:pt>
                <c:pt idx="126">
                  <c:v>7.0940000000000003</c:v>
                </c:pt>
                <c:pt idx="127">
                  <c:v>7.2510000000000003</c:v>
                </c:pt>
                <c:pt idx="128">
                  <c:v>7.4130000000000003</c:v>
                </c:pt>
                <c:pt idx="129">
                  <c:v>7.63</c:v>
                </c:pt>
                <c:pt idx="130">
                  <c:v>7.8470000000000004</c:v>
                </c:pt>
                <c:pt idx="131">
                  <c:v>8.0640000000000001</c:v>
                </c:pt>
                <c:pt idx="132">
                  <c:v>8.282</c:v>
                </c:pt>
                <c:pt idx="133">
                  <c:v>8.4990000000000006</c:v>
                </c:pt>
                <c:pt idx="134">
                  <c:v>8.7409999999999997</c:v>
                </c:pt>
                <c:pt idx="135">
                  <c:v>9.0220000000000002</c:v>
                </c:pt>
                <c:pt idx="136">
                  <c:v>9.3040000000000003</c:v>
                </c:pt>
                <c:pt idx="137">
                  <c:v>9.5850000000000009</c:v>
                </c:pt>
                <c:pt idx="138">
                  <c:v>9.8670000000000009</c:v>
                </c:pt>
                <c:pt idx="139">
                  <c:v>10.244</c:v>
                </c:pt>
                <c:pt idx="140">
                  <c:v>10.622</c:v>
                </c:pt>
                <c:pt idx="141">
                  <c:v>11</c:v>
                </c:pt>
                <c:pt idx="142">
                  <c:v>11.468</c:v>
                </c:pt>
                <c:pt idx="143">
                  <c:v>11.968</c:v>
                </c:pt>
                <c:pt idx="144">
                  <c:v>12.331</c:v>
                </c:pt>
                <c:pt idx="145">
                  <c:v>12.494999999999999</c:v>
                </c:pt>
                <c:pt idx="146">
                  <c:v>13.092000000000001</c:v>
                </c:pt>
                <c:pt idx="147">
                  <c:v>13.712</c:v>
                </c:pt>
                <c:pt idx="148">
                  <c:v>14.419</c:v>
                </c:pt>
                <c:pt idx="149">
                  <c:v>15.183</c:v>
                </c:pt>
                <c:pt idx="150">
                  <c:v>16.013000000000002</c:v>
                </c:pt>
                <c:pt idx="151">
                  <c:v>17.042999999999999</c:v>
                </c:pt>
                <c:pt idx="152">
                  <c:v>18.161000000000001</c:v>
                </c:pt>
                <c:pt idx="153">
                  <c:v>18.497</c:v>
                </c:pt>
                <c:pt idx="154">
                  <c:v>19.34</c:v>
                </c:pt>
                <c:pt idx="155">
                  <c:v>20.73</c:v>
                </c:pt>
                <c:pt idx="156">
                  <c:v>22.324999999999999</c:v>
                </c:pt>
                <c:pt idx="157">
                  <c:v>24.184999999999999</c:v>
                </c:pt>
                <c:pt idx="158">
                  <c:v>24.661999999999999</c:v>
                </c:pt>
                <c:pt idx="159">
                  <c:v>26.382000000000001</c:v>
                </c:pt>
                <c:pt idx="160">
                  <c:v>28.835999999999999</c:v>
                </c:pt>
                <c:pt idx="161">
                  <c:v>30.827999999999999</c:v>
                </c:pt>
                <c:pt idx="162">
                  <c:v>31.484000000000002</c:v>
                </c:pt>
                <c:pt idx="163">
                  <c:v>34.542000000000002</c:v>
                </c:pt>
                <c:pt idx="164">
                  <c:v>36.993000000000002</c:v>
                </c:pt>
                <c:pt idx="165">
                  <c:v>38.101999999999997</c:v>
                </c:pt>
                <c:pt idx="166">
                  <c:v>41.908000000000001</c:v>
                </c:pt>
                <c:pt idx="167">
                  <c:v>43.158999999999999</c:v>
                </c:pt>
                <c:pt idx="168">
                  <c:v>46.116999999999997</c:v>
                </c:pt>
                <c:pt idx="169">
                  <c:v>49.323999999999998</c:v>
                </c:pt>
                <c:pt idx="170">
                  <c:v>50.868000000000002</c:v>
                </c:pt>
                <c:pt idx="171">
                  <c:v>55.49</c:v>
                </c:pt>
                <c:pt idx="172">
                  <c:v>57.14</c:v>
                </c:pt>
                <c:pt idx="173">
                  <c:v>61.655000000000001</c:v>
                </c:pt>
                <c:pt idx="174">
                  <c:v>63.715000000000003</c:v>
                </c:pt>
                <c:pt idx="175">
                  <c:v>67.820999999999998</c:v>
                </c:pt>
                <c:pt idx="176">
                  <c:v>70.257999999999996</c:v>
                </c:pt>
                <c:pt idx="177">
                  <c:v>73.986000000000004</c:v>
                </c:pt>
                <c:pt idx="178">
                  <c:v>79.227999999999994</c:v>
                </c:pt>
                <c:pt idx="179">
                  <c:v>80.152000000000001</c:v>
                </c:pt>
                <c:pt idx="180">
                  <c:v>86.316999999999993</c:v>
                </c:pt>
                <c:pt idx="181">
                  <c:v>88.123000000000005</c:v>
                </c:pt>
                <c:pt idx="182">
                  <c:v>92.483000000000004</c:v>
                </c:pt>
                <c:pt idx="183">
                  <c:v>98.647999999999996</c:v>
                </c:pt>
                <c:pt idx="184">
                  <c:v>98.804000000000002</c:v>
                </c:pt>
                <c:pt idx="185">
                  <c:v>104.81399999999999</c:v>
                </c:pt>
                <c:pt idx="186">
                  <c:v>110.40900000000001</c:v>
                </c:pt>
                <c:pt idx="187">
                  <c:v>110.979</c:v>
                </c:pt>
                <c:pt idx="188">
                  <c:v>117.145</c:v>
                </c:pt>
                <c:pt idx="189">
                  <c:v>123.31</c:v>
                </c:pt>
                <c:pt idx="190">
                  <c:v>124.21599999999999</c:v>
                </c:pt>
                <c:pt idx="191">
                  <c:v>129.476</c:v>
                </c:pt>
                <c:pt idx="192">
                  <c:v>135.64099999999999</c:v>
                </c:pt>
                <c:pt idx="193">
                  <c:v>137.018</c:v>
                </c:pt>
                <c:pt idx="194">
                  <c:v>141.80699999999999</c:v>
                </c:pt>
                <c:pt idx="195">
                  <c:v>147.97200000000001</c:v>
                </c:pt>
                <c:pt idx="196">
                  <c:v>154.13800000000001</c:v>
                </c:pt>
                <c:pt idx="197">
                  <c:v>154.76599999999999</c:v>
                </c:pt>
                <c:pt idx="198">
                  <c:v>160.303</c:v>
                </c:pt>
                <c:pt idx="199">
                  <c:v>166.46899999999999</c:v>
                </c:pt>
                <c:pt idx="200">
                  <c:v>172.215</c:v>
                </c:pt>
                <c:pt idx="201">
                  <c:v>172.63399999999999</c:v>
                </c:pt>
                <c:pt idx="202">
                  <c:v>178.8</c:v>
                </c:pt>
                <c:pt idx="203">
                  <c:v>184.965</c:v>
                </c:pt>
                <c:pt idx="204">
                  <c:v>189.74199999999999</c:v>
                </c:pt>
                <c:pt idx="205">
                  <c:v>191.131</c:v>
                </c:pt>
                <c:pt idx="206">
                  <c:v>197.29599999999999</c:v>
                </c:pt>
                <c:pt idx="207">
                  <c:v>203.46199999999999</c:v>
                </c:pt>
                <c:pt idx="208">
                  <c:v>209.62700000000001</c:v>
                </c:pt>
                <c:pt idx="209">
                  <c:v>210.035</c:v>
                </c:pt>
                <c:pt idx="210">
                  <c:v>215.79300000000001</c:v>
                </c:pt>
                <c:pt idx="211">
                  <c:v>221.958</c:v>
                </c:pt>
                <c:pt idx="212">
                  <c:v>228.124</c:v>
                </c:pt>
                <c:pt idx="213">
                  <c:v>232.91</c:v>
                </c:pt>
                <c:pt idx="214">
                  <c:v>234.28899999999999</c:v>
                </c:pt>
                <c:pt idx="215">
                  <c:v>240.45500000000001</c:v>
                </c:pt>
                <c:pt idx="216">
                  <c:v>246.62</c:v>
                </c:pt>
                <c:pt idx="217">
                  <c:v>252.786</c:v>
                </c:pt>
                <c:pt idx="218">
                  <c:v>254.249</c:v>
                </c:pt>
                <c:pt idx="219">
                  <c:v>258.952</c:v>
                </c:pt>
                <c:pt idx="220">
                  <c:v>265.11700000000002</c:v>
                </c:pt>
                <c:pt idx="221">
                  <c:v>271.28300000000002</c:v>
                </c:pt>
                <c:pt idx="222">
                  <c:v>277.44799999999998</c:v>
                </c:pt>
                <c:pt idx="223">
                  <c:v>279.91399999999999</c:v>
                </c:pt>
                <c:pt idx="224">
                  <c:v>283.61399999999998</c:v>
                </c:pt>
                <c:pt idx="225">
                  <c:v>289.779</c:v>
                </c:pt>
                <c:pt idx="226">
                  <c:v>295.94499999999999</c:v>
                </c:pt>
                <c:pt idx="227">
                  <c:v>299.13200000000001</c:v>
                </c:pt>
                <c:pt idx="228">
                  <c:v>302.11</c:v>
                </c:pt>
                <c:pt idx="229">
                  <c:v>308.27600000000001</c:v>
                </c:pt>
                <c:pt idx="230">
                  <c:v>314.44099999999997</c:v>
                </c:pt>
                <c:pt idx="231">
                  <c:v>319.50799999999998</c:v>
                </c:pt>
                <c:pt idx="232">
                  <c:v>320.60700000000003</c:v>
                </c:pt>
                <c:pt idx="233">
                  <c:v>326.77199999999999</c:v>
                </c:pt>
                <c:pt idx="234">
                  <c:v>332.93799999999999</c:v>
                </c:pt>
                <c:pt idx="235">
                  <c:v>339.10300000000001</c:v>
                </c:pt>
                <c:pt idx="236">
                  <c:v>343.089</c:v>
                </c:pt>
                <c:pt idx="237">
                  <c:v>345.26900000000001</c:v>
                </c:pt>
                <c:pt idx="238">
                  <c:v>351.43400000000003</c:v>
                </c:pt>
                <c:pt idx="239">
                  <c:v>357.6</c:v>
                </c:pt>
                <c:pt idx="240">
                  <c:v>363.76499999999999</c:v>
                </c:pt>
                <c:pt idx="241">
                  <c:v>364.565</c:v>
                </c:pt>
                <c:pt idx="242">
                  <c:v>369.93099999999998</c:v>
                </c:pt>
                <c:pt idx="243">
                  <c:v>376.096</c:v>
                </c:pt>
                <c:pt idx="244">
                  <c:v>382.262</c:v>
                </c:pt>
                <c:pt idx="245">
                  <c:v>388.42700000000002</c:v>
                </c:pt>
                <c:pt idx="246">
                  <c:v>389.49900000000002</c:v>
                </c:pt>
                <c:pt idx="247">
                  <c:v>394.59300000000002</c:v>
                </c:pt>
                <c:pt idx="248">
                  <c:v>400.75799999999998</c:v>
                </c:pt>
                <c:pt idx="249">
                  <c:v>406.92399999999998</c:v>
                </c:pt>
                <c:pt idx="250">
                  <c:v>413.089</c:v>
                </c:pt>
                <c:pt idx="251">
                  <c:v>415.505</c:v>
                </c:pt>
                <c:pt idx="252">
                  <c:v>419.255</c:v>
                </c:pt>
                <c:pt idx="253">
                  <c:v>425.42</c:v>
                </c:pt>
                <c:pt idx="254">
                  <c:v>431.58600000000001</c:v>
                </c:pt>
                <c:pt idx="255">
                  <c:v>437.75099999999998</c:v>
                </c:pt>
                <c:pt idx="256">
                  <c:v>443.34199999999998</c:v>
                </c:pt>
                <c:pt idx="257">
                  <c:v>443.91699999999997</c:v>
                </c:pt>
                <c:pt idx="258">
                  <c:v>450.08199999999999</c:v>
                </c:pt>
                <c:pt idx="259">
                  <c:v>456.24799999999999</c:v>
                </c:pt>
                <c:pt idx="260">
                  <c:v>462.41300000000001</c:v>
                </c:pt>
                <c:pt idx="261">
                  <c:v>468.57900000000001</c:v>
                </c:pt>
                <c:pt idx="262">
                  <c:v>474.74400000000003</c:v>
                </c:pt>
                <c:pt idx="263">
                  <c:v>478.19</c:v>
                </c:pt>
                <c:pt idx="264">
                  <c:v>480.91</c:v>
                </c:pt>
                <c:pt idx="265">
                  <c:v>487.07499999999999</c:v>
                </c:pt>
                <c:pt idx="266">
                  <c:v>493.24099999999999</c:v>
                </c:pt>
                <c:pt idx="267">
                  <c:v>499.40600000000001</c:v>
                </c:pt>
                <c:pt idx="268">
                  <c:v>505.572</c:v>
                </c:pt>
                <c:pt idx="269">
                  <c:v>511.738</c:v>
                </c:pt>
                <c:pt idx="270">
                  <c:v>514.048</c:v>
                </c:pt>
                <c:pt idx="271">
                  <c:v>517.90300000000002</c:v>
                </c:pt>
                <c:pt idx="272">
                  <c:v>524.06899999999996</c:v>
                </c:pt>
                <c:pt idx="273">
                  <c:v>530.23400000000004</c:v>
                </c:pt>
                <c:pt idx="274">
                  <c:v>536.4</c:v>
                </c:pt>
                <c:pt idx="275">
                  <c:v>542.56500000000005</c:v>
                </c:pt>
                <c:pt idx="276">
                  <c:v>546.26700000000005</c:v>
                </c:pt>
                <c:pt idx="277">
                  <c:v>548.73099999999999</c:v>
                </c:pt>
                <c:pt idx="278">
                  <c:v>554.89599999999996</c:v>
                </c:pt>
                <c:pt idx="279">
                  <c:v>561.06200000000001</c:v>
                </c:pt>
                <c:pt idx="280">
                  <c:v>567.22699999999998</c:v>
                </c:pt>
                <c:pt idx="281">
                  <c:v>573.39300000000003</c:v>
                </c:pt>
                <c:pt idx="282">
                  <c:v>579.55799999999999</c:v>
                </c:pt>
                <c:pt idx="283">
                  <c:v>581.00800000000004</c:v>
                </c:pt>
                <c:pt idx="284">
                  <c:v>585.72400000000005</c:v>
                </c:pt>
                <c:pt idx="285">
                  <c:v>591.88900000000001</c:v>
                </c:pt>
                <c:pt idx="286">
                  <c:v>598.05499999999995</c:v>
                </c:pt>
                <c:pt idx="287">
                  <c:v>604.22</c:v>
                </c:pt>
                <c:pt idx="288">
                  <c:v>610.38599999999997</c:v>
                </c:pt>
                <c:pt idx="289">
                  <c:v>615.72900000000004</c:v>
                </c:pt>
                <c:pt idx="290">
                  <c:v>616.55100000000004</c:v>
                </c:pt>
                <c:pt idx="291">
                  <c:v>622.71699999999998</c:v>
                </c:pt>
                <c:pt idx="292">
                  <c:v>628.88199999999995</c:v>
                </c:pt>
                <c:pt idx="293">
                  <c:v>635.048</c:v>
                </c:pt>
                <c:pt idx="294">
                  <c:v>641.21299999999997</c:v>
                </c:pt>
                <c:pt idx="295">
                  <c:v>647.37900000000002</c:v>
                </c:pt>
                <c:pt idx="296">
                  <c:v>650.27499999999998</c:v>
                </c:pt>
                <c:pt idx="297">
                  <c:v>653.54399999999998</c:v>
                </c:pt>
                <c:pt idx="298">
                  <c:v>659.71</c:v>
                </c:pt>
                <c:pt idx="299">
                  <c:v>665.875</c:v>
                </c:pt>
                <c:pt idx="300">
                  <c:v>672.04100000000005</c:v>
                </c:pt>
                <c:pt idx="301">
                  <c:v>678.20600000000002</c:v>
                </c:pt>
                <c:pt idx="302">
                  <c:v>682.39200000000005</c:v>
                </c:pt>
                <c:pt idx="303">
                  <c:v>684.37199999999996</c:v>
                </c:pt>
                <c:pt idx="304">
                  <c:v>690.53700000000003</c:v>
                </c:pt>
                <c:pt idx="305">
                  <c:v>696.70299999999997</c:v>
                </c:pt>
                <c:pt idx="306">
                  <c:v>702.86800000000005</c:v>
                </c:pt>
                <c:pt idx="307">
                  <c:v>709.03399999999999</c:v>
                </c:pt>
                <c:pt idx="308">
                  <c:v>714.52499999999998</c:v>
                </c:pt>
                <c:pt idx="309">
                  <c:v>715.19899999999996</c:v>
                </c:pt>
                <c:pt idx="310">
                  <c:v>721.36500000000001</c:v>
                </c:pt>
                <c:pt idx="311">
                  <c:v>727.53</c:v>
                </c:pt>
                <c:pt idx="312">
                  <c:v>733.69600000000003</c:v>
                </c:pt>
                <c:pt idx="313">
                  <c:v>739.86099999999999</c:v>
                </c:pt>
                <c:pt idx="314">
                  <c:v>746.02700000000004</c:v>
                </c:pt>
                <c:pt idx="315">
                  <c:v>752.19200000000001</c:v>
                </c:pt>
                <c:pt idx="316">
                  <c:v>753.76</c:v>
                </c:pt>
                <c:pt idx="317">
                  <c:v>758.35799999999995</c:v>
                </c:pt>
                <c:pt idx="318">
                  <c:v>764.52300000000002</c:v>
                </c:pt>
                <c:pt idx="319">
                  <c:v>770.68899999999996</c:v>
                </c:pt>
                <c:pt idx="320">
                  <c:v>776.85500000000002</c:v>
                </c:pt>
                <c:pt idx="321">
                  <c:v>783.02</c:v>
                </c:pt>
                <c:pt idx="322">
                  <c:v>789.18600000000004</c:v>
                </c:pt>
                <c:pt idx="323">
                  <c:v>795.351</c:v>
                </c:pt>
                <c:pt idx="324">
                  <c:v>796.80200000000002</c:v>
                </c:pt>
                <c:pt idx="325">
                  <c:v>801.51700000000005</c:v>
                </c:pt>
                <c:pt idx="326">
                  <c:v>807.68200000000002</c:v>
                </c:pt>
                <c:pt idx="327">
                  <c:v>813.84799999999996</c:v>
                </c:pt>
                <c:pt idx="328">
                  <c:v>820.01300000000003</c:v>
                </c:pt>
                <c:pt idx="329">
                  <c:v>826.17899999999997</c:v>
                </c:pt>
                <c:pt idx="330">
                  <c:v>832.34400000000005</c:v>
                </c:pt>
                <c:pt idx="331">
                  <c:v>838.51</c:v>
                </c:pt>
                <c:pt idx="332">
                  <c:v>843.47</c:v>
                </c:pt>
                <c:pt idx="333">
                  <c:v>844.67499999999995</c:v>
                </c:pt>
                <c:pt idx="334">
                  <c:v>850.84100000000001</c:v>
                </c:pt>
                <c:pt idx="335">
                  <c:v>857.00599999999997</c:v>
                </c:pt>
                <c:pt idx="336">
                  <c:v>863.17200000000003</c:v>
                </c:pt>
                <c:pt idx="337">
                  <c:v>869.33699999999999</c:v>
                </c:pt>
                <c:pt idx="338">
                  <c:v>875.50300000000004</c:v>
                </c:pt>
                <c:pt idx="339">
                  <c:v>881.66800000000001</c:v>
                </c:pt>
                <c:pt idx="340">
                  <c:v>887.83399999999995</c:v>
                </c:pt>
                <c:pt idx="341">
                  <c:v>893.99900000000002</c:v>
                </c:pt>
                <c:pt idx="342">
                  <c:v>899.86599999999999</c:v>
                </c:pt>
                <c:pt idx="343">
                  <c:v>900.16499999999996</c:v>
                </c:pt>
                <c:pt idx="344">
                  <c:v>906.33</c:v>
                </c:pt>
                <c:pt idx="345">
                  <c:v>912.49599999999998</c:v>
                </c:pt>
                <c:pt idx="346">
                  <c:v>918.66099999999994</c:v>
                </c:pt>
                <c:pt idx="347">
                  <c:v>924.827</c:v>
                </c:pt>
                <c:pt idx="348">
                  <c:v>930.99199999999996</c:v>
                </c:pt>
                <c:pt idx="349">
                  <c:v>937.15800000000002</c:v>
                </c:pt>
                <c:pt idx="350">
                  <c:v>943.32299999999998</c:v>
                </c:pt>
                <c:pt idx="351">
                  <c:v>949.48900000000003</c:v>
                </c:pt>
                <c:pt idx="352">
                  <c:v>955.654</c:v>
                </c:pt>
                <c:pt idx="353">
                  <c:v>959.29200000000003</c:v>
                </c:pt>
                <c:pt idx="354">
                  <c:v>961.82</c:v>
                </c:pt>
                <c:pt idx="355">
                  <c:v>967.98500000000001</c:v>
                </c:pt>
                <c:pt idx="356">
                  <c:v>974.15099999999995</c:v>
                </c:pt>
                <c:pt idx="357">
                  <c:v>980.31600000000003</c:v>
                </c:pt>
                <c:pt idx="358">
                  <c:v>986.48199999999997</c:v>
                </c:pt>
                <c:pt idx="359">
                  <c:v>992.64700000000005</c:v>
                </c:pt>
                <c:pt idx="360">
                  <c:v>998.81299999999999</c:v>
                </c:pt>
                <c:pt idx="361">
                  <c:v>1004.978</c:v>
                </c:pt>
                <c:pt idx="362">
                  <c:v>1011.144</c:v>
                </c:pt>
                <c:pt idx="363">
                  <c:v>1017.309</c:v>
                </c:pt>
                <c:pt idx="364">
                  <c:v>1023.475</c:v>
                </c:pt>
                <c:pt idx="365">
                  <c:v>1023.9880000000001</c:v>
                </c:pt>
                <c:pt idx="366">
                  <c:v>1029.6410000000001</c:v>
                </c:pt>
                <c:pt idx="367">
                  <c:v>1035.806</c:v>
                </c:pt>
                <c:pt idx="368">
                  <c:v>1041.972</c:v>
                </c:pt>
                <c:pt idx="369">
                  <c:v>1048.1369999999999</c:v>
                </c:pt>
                <c:pt idx="370">
                  <c:v>1054.3030000000001</c:v>
                </c:pt>
                <c:pt idx="371">
                  <c:v>1060.4680000000001</c:v>
                </c:pt>
                <c:pt idx="372">
                  <c:v>1066.634</c:v>
                </c:pt>
                <c:pt idx="373">
                  <c:v>1072.799</c:v>
                </c:pt>
                <c:pt idx="374">
                  <c:v>1078.9649999999999</c:v>
                </c:pt>
                <c:pt idx="375">
                  <c:v>1085.1300000000001</c:v>
                </c:pt>
                <c:pt idx="376">
                  <c:v>1091.296</c:v>
                </c:pt>
                <c:pt idx="377">
                  <c:v>1096.5239999999999</c:v>
                </c:pt>
                <c:pt idx="378">
                  <c:v>1097.461</c:v>
                </c:pt>
                <c:pt idx="379">
                  <c:v>1103.627</c:v>
                </c:pt>
                <c:pt idx="380">
                  <c:v>1109.7919999999999</c:v>
                </c:pt>
                <c:pt idx="381">
                  <c:v>1115.9580000000001</c:v>
                </c:pt>
                <c:pt idx="382">
                  <c:v>1122.123</c:v>
                </c:pt>
                <c:pt idx="383">
                  <c:v>1128.289</c:v>
                </c:pt>
                <c:pt idx="384">
                  <c:v>1134.454</c:v>
                </c:pt>
                <c:pt idx="385">
                  <c:v>1140.6199999999999</c:v>
                </c:pt>
                <c:pt idx="386">
                  <c:v>1146.7850000000001</c:v>
                </c:pt>
                <c:pt idx="387">
                  <c:v>1152.951</c:v>
                </c:pt>
                <c:pt idx="388">
                  <c:v>1159.116</c:v>
                </c:pt>
                <c:pt idx="389">
                  <c:v>1165.2819999999999</c:v>
                </c:pt>
                <c:pt idx="390">
                  <c:v>1171.4469999999999</c:v>
                </c:pt>
                <c:pt idx="391">
                  <c:v>1177.6130000000001</c:v>
                </c:pt>
                <c:pt idx="392">
                  <c:v>1183.778</c:v>
                </c:pt>
                <c:pt idx="393">
                  <c:v>1189.944</c:v>
                </c:pt>
                <c:pt idx="394">
                  <c:v>1196.1089999999999</c:v>
                </c:pt>
                <c:pt idx="395">
                  <c:v>1202.2750000000001</c:v>
                </c:pt>
                <c:pt idx="396">
                  <c:v>1208.44</c:v>
                </c:pt>
                <c:pt idx="397">
                  <c:v>1214.606</c:v>
                </c:pt>
                <c:pt idx="398">
                  <c:v>1220.771</c:v>
                </c:pt>
                <c:pt idx="399">
                  <c:v>1226.9369999999999</c:v>
                </c:pt>
                <c:pt idx="400">
                  <c:v>1233.1020000000001</c:v>
                </c:pt>
                <c:pt idx="401">
                  <c:v>1233.1020000000001</c:v>
                </c:pt>
              </c:numCache>
            </c:numRef>
          </c:xVal>
          <c:yVal>
            <c:numRef>
              <c:f>Foglio6!$F$411:$F$812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950000000000003</c:v>
                </c:pt>
                <c:pt idx="121">
                  <c:v>40.5</c:v>
                </c:pt>
                <c:pt idx="122">
                  <c:v>40</c:v>
                </c:pt>
                <c:pt idx="123">
                  <c:v>39.5</c:v>
                </c:pt>
                <c:pt idx="124">
                  <c:v>39</c:v>
                </c:pt>
                <c:pt idx="125">
                  <c:v>38.5</c:v>
                </c:pt>
                <c:pt idx="126">
                  <c:v>38</c:v>
                </c:pt>
                <c:pt idx="127">
                  <c:v>37.5</c:v>
                </c:pt>
                <c:pt idx="128">
                  <c:v>37</c:v>
                </c:pt>
                <c:pt idx="129">
                  <c:v>36.5</c:v>
                </c:pt>
                <c:pt idx="130">
                  <c:v>36</c:v>
                </c:pt>
                <c:pt idx="131">
                  <c:v>35.5</c:v>
                </c:pt>
                <c:pt idx="132">
                  <c:v>35</c:v>
                </c:pt>
                <c:pt idx="133">
                  <c:v>34.5</c:v>
                </c:pt>
                <c:pt idx="134">
                  <c:v>34</c:v>
                </c:pt>
                <c:pt idx="135">
                  <c:v>33.5</c:v>
                </c:pt>
                <c:pt idx="136">
                  <c:v>33</c:v>
                </c:pt>
                <c:pt idx="137">
                  <c:v>32.5</c:v>
                </c:pt>
                <c:pt idx="138">
                  <c:v>32</c:v>
                </c:pt>
                <c:pt idx="139">
                  <c:v>31.5</c:v>
                </c:pt>
                <c:pt idx="140">
                  <c:v>31</c:v>
                </c:pt>
                <c:pt idx="141">
                  <c:v>30.5</c:v>
                </c:pt>
                <c:pt idx="142">
                  <c:v>30</c:v>
                </c:pt>
                <c:pt idx="143">
                  <c:v>29.5</c:v>
                </c:pt>
                <c:pt idx="144">
                  <c:v>29.137</c:v>
                </c:pt>
                <c:pt idx="145">
                  <c:v>29</c:v>
                </c:pt>
                <c:pt idx="146">
                  <c:v>28.5</c:v>
                </c:pt>
                <c:pt idx="147">
                  <c:v>28</c:v>
                </c:pt>
                <c:pt idx="148">
                  <c:v>27.5</c:v>
                </c:pt>
                <c:pt idx="149">
                  <c:v>27</c:v>
                </c:pt>
                <c:pt idx="150">
                  <c:v>26.5</c:v>
                </c:pt>
                <c:pt idx="151">
                  <c:v>26</c:v>
                </c:pt>
                <c:pt idx="152">
                  <c:v>25.5</c:v>
                </c:pt>
                <c:pt idx="153">
                  <c:v>25.353000000000002</c:v>
                </c:pt>
                <c:pt idx="154">
                  <c:v>25</c:v>
                </c:pt>
                <c:pt idx="155">
                  <c:v>24.5</c:v>
                </c:pt>
                <c:pt idx="156">
                  <c:v>24</c:v>
                </c:pt>
                <c:pt idx="157">
                  <c:v>23.5</c:v>
                </c:pt>
                <c:pt idx="158">
                  <c:v>23.379000000000001</c:v>
                </c:pt>
                <c:pt idx="159">
                  <c:v>23</c:v>
                </c:pt>
                <c:pt idx="160">
                  <c:v>22.5</c:v>
                </c:pt>
                <c:pt idx="161">
                  <c:v>22.113</c:v>
                </c:pt>
                <c:pt idx="162">
                  <c:v>22</c:v>
                </c:pt>
                <c:pt idx="163">
                  <c:v>21.5</c:v>
                </c:pt>
                <c:pt idx="164">
                  <c:v>21.158999999999999</c:v>
                </c:pt>
                <c:pt idx="165">
                  <c:v>21</c:v>
                </c:pt>
                <c:pt idx="166">
                  <c:v>20.5</c:v>
                </c:pt>
                <c:pt idx="167">
                  <c:v>20.36</c:v>
                </c:pt>
                <c:pt idx="168">
                  <c:v>20</c:v>
                </c:pt>
                <c:pt idx="169">
                  <c:v>19.641999999999999</c:v>
                </c:pt>
                <c:pt idx="170">
                  <c:v>19.5</c:v>
                </c:pt>
                <c:pt idx="171">
                  <c:v>19.12</c:v>
                </c:pt>
                <c:pt idx="172">
                  <c:v>19</c:v>
                </c:pt>
                <c:pt idx="173">
                  <c:v>18.664999999999999</c:v>
                </c:pt>
                <c:pt idx="174">
                  <c:v>18.5</c:v>
                </c:pt>
                <c:pt idx="175">
                  <c:v>18.175999999999998</c:v>
                </c:pt>
                <c:pt idx="176">
                  <c:v>18</c:v>
                </c:pt>
                <c:pt idx="177">
                  <c:v>17.747</c:v>
                </c:pt>
                <c:pt idx="178">
                  <c:v>17.5</c:v>
                </c:pt>
                <c:pt idx="179">
                  <c:v>17.443999999999999</c:v>
                </c:pt>
                <c:pt idx="180">
                  <c:v>17.082000000000001</c:v>
                </c:pt>
                <c:pt idx="181">
                  <c:v>17</c:v>
                </c:pt>
                <c:pt idx="182">
                  <c:v>16.757000000000001</c:v>
                </c:pt>
                <c:pt idx="183">
                  <c:v>16.509</c:v>
                </c:pt>
                <c:pt idx="184">
                  <c:v>16.5</c:v>
                </c:pt>
                <c:pt idx="185">
                  <c:v>16.221</c:v>
                </c:pt>
                <c:pt idx="186">
                  <c:v>16</c:v>
                </c:pt>
                <c:pt idx="187">
                  <c:v>15.978999999999999</c:v>
                </c:pt>
                <c:pt idx="188">
                  <c:v>15.786</c:v>
                </c:pt>
                <c:pt idx="189">
                  <c:v>15.537000000000001</c:v>
                </c:pt>
                <c:pt idx="190">
                  <c:v>15.5</c:v>
                </c:pt>
                <c:pt idx="191">
                  <c:v>15.281000000000001</c:v>
                </c:pt>
                <c:pt idx="192">
                  <c:v>15.053000000000001</c:v>
                </c:pt>
                <c:pt idx="193">
                  <c:v>15</c:v>
                </c:pt>
                <c:pt idx="194">
                  <c:v>14.826000000000001</c:v>
                </c:pt>
                <c:pt idx="195">
                  <c:v>14.667</c:v>
                </c:pt>
                <c:pt idx="196">
                  <c:v>14.516</c:v>
                </c:pt>
                <c:pt idx="197">
                  <c:v>14.5</c:v>
                </c:pt>
                <c:pt idx="198">
                  <c:v>14.363</c:v>
                </c:pt>
                <c:pt idx="199">
                  <c:v>14.186</c:v>
                </c:pt>
                <c:pt idx="200">
                  <c:v>14</c:v>
                </c:pt>
                <c:pt idx="201">
                  <c:v>13.986000000000001</c:v>
                </c:pt>
                <c:pt idx="202">
                  <c:v>13.821999999999999</c:v>
                </c:pt>
                <c:pt idx="203">
                  <c:v>13.638999999999999</c:v>
                </c:pt>
                <c:pt idx="204">
                  <c:v>13.5</c:v>
                </c:pt>
                <c:pt idx="205">
                  <c:v>13.456</c:v>
                </c:pt>
                <c:pt idx="206">
                  <c:v>13.295999999999999</c:v>
                </c:pt>
                <c:pt idx="207">
                  <c:v>13.141999999999999</c:v>
                </c:pt>
                <c:pt idx="208">
                  <c:v>13.012</c:v>
                </c:pt>
                <c:pt idx="209">
                  <c:v>13</c:v>
                </c:pt>
                <c:pt idx="210">
                  <c:v>12.865</c:v>
                </c:pt>
                <c:pt idx="211">
                  <c:v>12.724</c:v>
                </c:pt>
                <c:pt idx="212">
                  <c:v>12.595000000000001</c:v>
                </c:pt>
                <c:pt idx="213">
                  <c:v>12.5</c:v>
                </c:pt>
                <c:pt idx="214">
                  <c:v>12.475</c:v>
                </c:pt>
                <c:pt idx="215">
                  <c:v>12.346</c:v>
                </c:pt>
                <c:pt idx="216">
                  <c:v>12.202</c:v>
                </c:pt>
                <c:pt idx="217">
                  <c:v>12.037000000000001</c:v>
                </c:pt>
                <c:pt idx="218">
                  <c:v>12</c:v>
                </c:pt>
                <c:pt idx="219">
                  <c:v>11.911</c:v>
                </c:pt>
                <c:pt idx="220">
                  <c:v>11.77</c:v>
                </c:pt>
                <c:pt idx="221">
                  <c:v>11.637</c:v>
                </c:pt>
                <c:pt idx="222">
                  <c:v>11.542999999999999</c:v>
                </c:pt>
                <c:pt idx="223">
                  <c:v>11.5</c:v>
                </c:pt>
                <c:pt idx="224">
                  <c:v>11.412000000000001</c:v>
                </c:pt>
                <c:pt idx="225">
                  <c:v>11.271000000000001</c:v>
                </c:pt>
                <c:pt idx="226">
                  <c:v>11.090999999999999</c:v>
                </c:pt>
                <c:pt idx="227">
                  <c:v>11</c:v>
                </c:pt>
                <c:pt idx="228">
                  <c:v>10.93</c:v>
                </c:pt>
                <c:pt idx="229">
                  <c:v>10.76</c:v>
                </c:pt>
                <c:pt idx="230">
                  <c:v>10.612</c:v>
                </c:pt>
                <c:pt idx="231">
                  <c:v>10.5</c:v>
                </c:pt>
                <c:pt idx="232">
                  <c:v>10.478999999999999</c:v>
                </c:pt>
                <c:pt idx="233">
                  <c:v>10.374000000000001</c:v>
                </c:pt>
                <c:pt idx="234">
                  <c:v>10.234</c:v>
                </c:pt>
                <c:pt idx="235">
                  <c:v>10.085000000000001</c:v>
                </c:pt>
                <c:pt idx="236">
                  <c:v>10</c:v>
                </c:pt>
                <c:pt idx="237">
                  <c:v>9.9390000000000001</c:v>
                </c:pt>
                <c:pt idx="238">
                  <c:v>9.7910000000000004</c:v>
                </c:pt>
                <c:pt idx="239">
                  <c:v>9.6780000000000008</c:v>
                </c:pt>
                <c:pt idx="240">
                  <c:v>9.5229999999999997</c:v>
                </c:pt>
                <c:pt idx="241">
                  <c:v>9.5</c:v>
                </c:pt>
                <c:pt idx="242">
                  <c:v>9.3539999999999992</c:v>
                </c:pt>
                <c:pt idx="243">
                  <c:v>9.2439999999999998</c:v>
                </c:pt>
                <c:pt idx="244">
                  <c:v>9.1620000000000008</c:v>
                </c:pt>
                <c:pt idx="245">
                  <c:v>9.0280000000000005</c:v>
                </c:pt>
                <c:pt idx="246">
                  <c:v>9</c:v>
                </c:pt>
                <c:pt idx="247">
                  <c:v>8.8719999999999999</c:v>
                </c:pt>
                <c:pt idx="248">
                  <c:v>8.77</c:v>
                </c:pt>
                <c:pt idx="249">
                  <c:v>8.66</c:v>
                </c:pt>
                <c:pt idx="250">
                  <c:v>8.5410000000000004</c:v>
                </c:pt>
                <c:pt idx="251">
                  <c:v>8.5</c:v>
                </c:pt>
                <c:pt idx="252">
                  <c:v>8.4169999999999998</c:v>
                </c:pt>
                <c:pt idx="253">
                  <c:v>8.3170000000000002</c:v>
                </c:pt>
                <c:pt idx="254">
                  <c:v>8.2119999999999997</c:v>
                </c:pt>
                <c:pt idx="255">
                  <c:v>8.0820000000000007</c:v>
                </c:pt>
                <c:pt idx="256">
                  <c:v>8</c:v>
                </c:pt>
                <c:pt idx="257">
                  <c:v>7.9939999999999998</c:v>
                </c:pt>
                <c:pt idx="258">
                  <c:v>7.907</c:v>
                </c:pt>
                <c:pt idx="259">
                  <c:v>7.8179999999999996</c:v>
                </c:pt>
                <c:pt idx="260">
                  <c:v>7.7439999999999998</c:v>
                </c:pt>
                <c:pt idx="261">
                  <c:v>7.641</c:v>
                </c:pt>
                <c:pt idx="262">
                  <c:v>7.5570000000000004</c:v>
                </c:pt>
                <c:pt idx="263">
                  <c:v>7.5</c:v>
                </c:pt>
                <c:pt idx="264">
                  <c:v>7.4660000000000002</c:v>
                </c:pt>
                <c:pt idx="265">
                  <c:v>7.37</c:v>
                </c:pt>
                <c:pt idx="266">
                  <c:v>7.2720000000000002</c:v>
                </c:pt>
                <c:pt idx="267">
                  <c:v>7.1769999999999996</c:v>
                </c:pt>
                <c:pt idx="268">
                  <c:v>7.1050000000000004</c:v>
                </c:pt>
                <c:pt idx="269">
                  <c:v>7.0339999999999998</c:v>
                </c:pt>
                <c:pt idx="270">
                  <c:v>7</c:v>
                </c:pt>
                <c:pt idx="271">
                  <c:v>6.9580000000000002</c:v>
                </c:pt>
                <c:pt idx="272">
                  <c:v>6.8479999999999999</c:v>
                </c:pt>
                <c:pt idx="273">
                  <c:v>6.7539999999999996</c:v>
                </c:pt>
                <c:pt idx="274">
                  <c:v>6.6689999999999996</c:v>
                </c:pt>
                <c:pt idx="275">
                  <c:v>6.5670000000000002</c:v>
                </c:pt>
                <c:pt idx="276">
                  <c:v>6.5</c:v>
                </c:pt>
                <c:pt idx="277">
                  <c:v>6.4770000000000003</c:v>
                </c:pt>
                <c:pt idx="278">
                  <c:v>6.3979999999999997</c:v>
                </c:pt>
                <c:pt idx="279">
                  <c:v>6.2930000000000001</c:v>
                </c:pt>
                <c:pt idx="280">
                  <c:v>6.1829999999999998</c:v>
                </c:pt>
                <c:pt idx="281">
                  <c:v>6.1070000000000002</c:v>
                </c:pt>
                <c:pt idx="282">
                  <c:v>6.0170000000000003</c:v>
                </c:pt>
                <c:pt idx="283">
                  <c:v>6</c:v>
                </c:pt>
                <c:pt idx="284">
                  <c:v>5.8970000000000002</c:v>
                </c:pt>
                <c:pt idx="285">
                  <c:v>5.82</c:v>
                </c:pt>
                <c:pt idx="286">
                  <c:v>5.7359999999999998</c:v>
                </c:pt>
                <c:pt idx="287">
                  <c:v>5.6840000000000002</c:v>
                </c:pt>
                <c:pt idx="288">
                  <c:v>5.58</c:v>
                </c:pt>
                <c:pt idx="289">
                  <c:v>5.5</c:v>
                </c:pt>
                <c:pt idx="290">
                  <c:v>5.4859999999999998</c:v>
                </c:pt>
                <c:pt idx="291">
                  <c:v>5.3929999999999998</c:v>
                </c:pt>
                <c:pt idx="292">
                  <c:v>5.2859999999999996</c:v>
                </c:pt>
                <c:pt idx="293">
                  <c:v>5.202</c:v>
                </c:pt>
                <c:pt idx="294">
                  <c:v>5.141</c:v>
                </c:pt>
                <c:pt idx="295">
                  <c:v>5.0469999999999997</c:v>
                </c:pt>
                <c:pt idx="296">
                  <c:v>5</c:v>
                </c:pt>
                <c:pt idx="297">
                  <c:v>4.9480000000000004</c:v>
                </c:pt>
                <c:pt idx="298">
                  <c:v>4.867</c:v>
                </c:pt>
                <c:pt idx="299">
                  <c:v>4.7539999999999996</c:v>
                </c:pt>
                <c:pt idx="300">
                  <c:v>4.6520000000000001</c:v>
                </c:pt>
                <c:pt idx="301">
                  <c:v>4.5679999999999996</c:v>
                </c:pt>
                <c:pt idx="302">
                  <c:v>4.5</c:v>
                </c:pt>
                <c:pt idx="303">
                  <c:v>4.47</c:v>
                </c:pt>
                <c:pt idx="304">
                  <c:v>4.3949999999999996</c:v>
                </c:pt>
                <c:pt idx="305">
                  <c:v>4.2830000000000004</c:v>
                </c:pt>
                <c:pt idx="306">
                  <c:v>4.2009999999999996</c:v>
                </c:pt>
                <c:pt idx="307">
                  <c:v>4.1100000000000003</c:v>
                </c:pt>
                <c:pt idx="308">
                  <c:v>4</c:v>
                </c:pt>
                <c:pt idx="309">
                  <c:v>3.9870000000000001</c:v>
                </c:pt>
                <c:pt idx="310">
                  <c:v>3.9060000000000001</c:v>
                </c:pt>
                <c:pt idx="311">
                  <c:v>3.8340000000000001</c:v>
                </c:pt>
                <c:pt idx="312">
                  <c:v>3.7589999999999999</c:v>
                </c:pt>
                <c:pt idx="313">
                  <c:v>3.6589999999999998</c:v>
                </c:pt>
                <c:pt idx="314">
                  <c:v>3.5720000000000001</c:v>
                </c:pt>
                <c:pt idx="315">
                  <c:v>3.5190000000000001</c:v>
                </c:pt>
                <c:pt idx="316">
                  <c:v>3.5</c:v>
                </c:pt>
                <c:pt idx="317">
                  <c:v>3.4449999999999998</c:v>
                </c:pt>
                <c:pt idx="318">
                  <c:v>3.375</c:v>
                </c:pt>
                <c:pt idx="319">
                  <c:v>3.2829999999999999</c:v>
                </c:pt>
                <c:pt idx="320">
                  <c:v>3.1880000000000002</c:v>
                </c:pt>
                <c:pt idx="321">
                  <c:v>3.1379999999999999</c:v>
                </c:pt>
                <c:pt idx="322">
                  <c:v>3.0910000000000002</c:v>
                </c:pt>
                <c:pt idx="323">
                  <c:v>3.0139999999999998</c:v>
                </c:pt>
                <c:pt idx="324">
                  <c:v>3</c:v>
                </c:pt>
                <c:pt idx="325">
                  <c:v>2.9529999999999998</c:v>
                </c:pt>
                <c:pt idx="326">
                  <c:v>2.8769999999999998</c:v>
                </c:pt>
                <c:pt idx="327">
                  <c:v>2.8439999999999999</c:v>
                </c:pt>
                <c:pt idx="328">
                  <c:v>2.7610000000000001</c:v>
                </c:pt>
                <c:pt idx="329">
                  <c:v>2.6850000000000001</c:v>
                </c:pt>
                <c:pt idx="330">
                  <c:v>2.6379999999999999</c:v>
                </c:pt>
                <c:pt idx="331">
                  <c:v>2.5590000000000002</c:v>
                </c:pt>
                <c:pt idx="332">
                  <c:v>2.5</c:v>
                </c:pt>
                <c:pt idx="333">
                  <c:v>2.4809999999999999</c:v>
                </c:pt>
                <c:pt idx="334">
                  <c:v>2.4220000000000002</c:v>
                </c:pt>
                <c:pt idx="335">
                  <c:v>2.3650000000000002</c:v>
                </c:pt>
                <c:pt idx="336">
                  <c:v>2.3279999999999998</c:v>
                </c:pt>
                <c:pt idx="337">
                  <c:v>2.274</c:v>
                </c:pt>
                <c:pt idx="338">
                  <c:v>2.2160000000000002</c:v>
                </c:pt>
                <c:pt idx="339">
                  <c:v>2.1640000000000001</c:v>
                </c:pt>
                <c:pt idx="340">
                  <c:v>2.105</c:v>
                </c:pt>
                <c:pt idx="341">
                  <c:v>2.0379999999999998</c:v>
                </c:pt>
                <c:pt idx="342">
                  <c:v>2</c:v>
                </c:pt>
                <c:pt idx="343">
                  <c:v>1.9990000000000001</c:v>
                </c:pt>
                <c:pt idx="344">
                  <c:v>1.9450000000000001</c:v>
                </c:pt>
                <c:pt idx="345">
                  <c:v>1.867</c:v>
                </c:pt>
                <c:pt idx="346">
                  <c:v>1.8160000000000001</c:v>
                </c:pt>
                <c:pt idx="347">
                  <c:v>1.766</c:v>
                </c:pt>
                <c:pt idx="348">
                  <c:v>1.714</c:v>
                </c:pt>
                <c:pt idx="349">
                  <c:v>1.671</c:v>
                </c:pt>
                <c:pt idx="350">
                  <c:v>1.6220000000000001</c:v>
                </c:pt>
                <c:pt idx="351">
                  <c:v>1.583</c:v>
                </c:pt>
                <c:pt idx="352">
                  <c:v>1.5369999999999999</c:v>
                </c:pt>
                <c:pt idx="353">
                  <c:v>1.5</c:v>
                </c:pt>
                <c:pt idx="354">
                  <c:v>1.4830000000000001</c:v>
                </c:pt>
                <c:pt idx="355">
                  <c:v>1.4339999999999999</c:v>
                </c:pt>
                <c:pt idx="356">
                  <c:v>1.3959999999999999</c:v>
                </c:pt>
                <c:pt idx="357">
                  <c:v>1.3440000000000001</c:v>
                </c:pt>
                <c:pt idx="358">
                  <c:v>1.2609999999999999</c:v>
                </c:pt>
                <c:pt idx="359">
                  <c:v>1.218</c:v>
                </c:pt>
                <c:pt idx="360">
                  <c:v>1.1779999999999999</c:v>
                </c:pt>
                <c:pt idx="361">
                  <c:v>1.127</c:v>
                </c:pt>
                <c:pt idx="362">
                  <c:v>1.0920000000000001</c:v>
                </c:pt>
                <c:pt idx="363">
                  <c:v>1.05</c:v>
                </c:pt>
                <c:pt idx="364">
                  <c:v>1.004</c:v>
                </c:pt>
                <c:pt idx="365">
                  <c:v>1</c:v>
                </c:pt>
                <c:pt idx="366">
                  <c:v>0.96699999999999997</c:v>
                </c:pt>
                <c:pt idx="367">
                  <c:v>0.92500000000000004</c:v>
                </c:pt>
                <c:pt idx="368">
                  <c:v>0.876</c:v>
                </c:pt>
                <c:pt idx="369">
                  <c:v>0.82499999999999996</c:v>
                </c:pt>
                <c:pt idx="370">
                  <c:v>0.77200000000000002</c:v>
                </c:pt>
                <c:pt idx="371">
                  <c:v>0.73399999999999999</c:v>
                </c:pt>
                <c:pt idx="372">
                  <c:v>0.68200000000000005</c:v>
                </c:pt>
                <c:pt idx="373">
                  <c:v>0.64300000000000002</c:v>
                </c:pt>
                <c:pt idx="374">
                  <c:v>0.60399999999999998</c:v>
                </c:pt>
                <c:pt idx="375">
                  <c:v>0.55700000000000005</c:v>
                </c:pt>
                <c:pt idx="376">
                  <c:v>0.53600000000000003</c:v>
                </c:pt>
                <c:pt idx="377">
                  <c:v>0.5</c:v>
                </c:pt>
                <c:pt idx="378">
                  <c:v>0.49199999999999999</c:v>
                </c:pt>
                <c:pt idx="379">
                  <c:v>0.44900000000000001</c:v>
                </c:pt>
                <c:pt idx="380">
                  <c:v>0.42</c:v>
                </c:pt>
                <c:pt idx="381">
                  <c:v>0.38</c:v>
                </c:pt>
                <c:pt idx="382">
                  <c:v>0.34200000000000003</c:v>
                </c:pt>
                <c:pt idx="383">
                  <c:v>0.3</c:v>
                </c:pt>
                <c:pt idx="384">
                  <c:v>0.26700000000000002</c:v>
                </c:pt>
                <c:pt idx="385">
                  <c:v>0.23799999999999999</c:v>
                </c:pt>
                <c:pt idx="386">
                  <c:v>0.20300000000000001</c:v>
                </c:pt>
                <c:pt idx="387">
                  <c:v>0.16200000000000001</c:v>
                </c:pt>
                <c:pt idx="388">
                  <c:v>0.125</c:v>
                </c:pt>
                <c:pt idx="389">
                  <c:v>8.7999999999999995E-2</c:v>
                </c:pt>
                <c:pt idx="390">
                  <c:v>6.9000000000000006E-2</c:v>
                </c:pt>
                <c:pt idx="391">
                  <c:v>4.9000000000000002E-2</c:v>
                </c:pt>
                <c:pt idx="392">
                  <c:v>3.6999999999999998E-2</c:v>
                </c:pt>
                <c:pt idx="393">
                  <c:v>2.4E-2</c:v>
                </c:pt>
                <c:pt idx="394">
                  <c:v>1.4999999999999999E-2</c:v>
                </c:pt>
                <c:pt idx="395">
                  <c:v>1.0999999999999999E-2</c:v>
                </c:pt>
                <c:pt idx="396">
                  <c:v>8.0000000000000002E-3</c:v>
                </c:pt>
                <c:pt idx="397">
                  <c:v>5.0000000000000001E-3</c:v>
                </c:pt>
                <c:pt idx="398">
                  <c:v>1E-3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7EB-4971-BBB7-EC35B5F78EDB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xVal>
            <c:numRef>
              <c:f>Foglio6!$G$411:$G$812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02</c:v>
                </c:pt>
                <c:pt idx="11">
                  <c:v>6.4000000000000001E-2</c:v>
                </c:pt>
                <c:pt idx="12">
                  <c:v>0.108</c:v>
                </c:pt>
                <c:pt idx="13">
                  <c:v>0.152</c:v>
                </c:pt>
                <c:pt idx="14">
                  <c:v>0.19700000000000001</c:v>
                </c:pt>
                <c:pt idx="15">
                  <c:v>0.24099999999999999</c:v>
                </c:pt>
                <c:pt idx="16">
                  <c:v>0.28499999999999998</c:v>
                </c:pt>
                <c:pt idx="17">
                  <c:v>0.32900000000000001</c:v>
                </c:pt>
                <c:pt idx="18">
                  <c:v>0.374</c:v>
                </c:pt>
                <c:pt idx="19">
                  <c:v>0.41799999999999998</c:v>
                </c:pt>
                <c:pt idx="20">
                  <c:v>0.46200000000000002</c:v>
                </c:pt>
                <c:pt idx="21">
                  <c:v>0.50600000000000001</c:v>
                </c:pt>
                <c:pt idx="22">
                  <c:v>0.55100000000000005</c:v>
                </c:pt>
                <c:pt idx="23">
                  <c:v>0.59499999999999997</c:v>
                </c:pt>
                <c:pt idx="24">
                  <c:v>0.63900000000000001</c:v>
                </c:pt>
                <c:pt idx="25">
                  <c:v>0.68300000000000005</c:v>
                </c:pt>
                <c:pt idx="26">
                  <c:v>0.72699999999999998</c:v>
                </c:pt>
                <c:pt idx="27">
                  <c:v>0.77200000000000002</c:v>
                </c:pt>
                <c:pt idx="28">
                  <c:v>0.81599999999999995</c:v>
                </c:pt>
                <c:pt idx="29">
                  <c:v>0.86</c:v>
                </c:pt>
                <c:pt idx="30">
                  <c:v>0.90400000000000003</c:v>
                </c:pt>
                <c:pt idx="31">
                  <c:v>0.94899999999999995</c:v>
                </c:pt>
                <c:pt idx="32">
                  <c:v>0.99299999999999999</c:v>
                </c:pt>
                <c:pt idx="33">
                  <c:v>1.0369999999999999</c:v>
                </c:pt>
                <c:pt idx="34">
                  <c:v>1.081</c:v>
                </c:pt>
                <c:pt idx="35">
                  <c:v>1.1259999999999999</c:v>
                </c:pt>
                <c:pt idx="36">
                  <c:v>1.17</c:v>
                </c:pt>
                <c:pt idx="37">
                  <c:v>1.214</c:v>
                </c:pt>
                <c:pt idx="38">
                  <c:v>1.2549999999999999</c:v>
                </c:pt>
                <c:pt idx="39">
                  <c:v>1.2929999999999999</c:v>
                </c:pt>
                <c:pt idx="40">
                  <c:v>1.331</c:v>
                </c:pt>
                <c:pt idx="41">
                  <c:v>1.369</c:v>
                </c:pt>
                <c:pt idx="42">
                  <c:v>1.407</c:v>
                </c:pt>
                <c:pt idx="43">
                  <c:v>1.4450000000000001</c:v>
                </c:pt>
                <c:pt idx="44">
                  <c:v>1.484</c:v>
                </c:pt>
                <c:pt idx="45">
                  <c:v>1.522</c:v>
                </c:pt>
                <c:pt idx="46">
                  <c:v>1.56</c:v>
                </c:pt>
                <c:pt idx="47">
                  <c:v>1.5980000000000001</c:v>
                </c:pt>
                <c:pt idx="48">
                  <c:v>1.6359999999999999</c:v>
                </c:pt>
                <c:pt idx="49">
                  <c:v>1.6739999999999999</c:v>
                </c:pt>
                <c:pt idx="50">
                  <c:v>1.712</c:v>
                </c:pt>
                <c:pt idx="51">
                  <c:v>1.7509999999999999</c:v>
                </c:pt>
                <c:pt idx="52">
                  <c:v>1.7889999999999999</c:v>
                </c:pt>
                <c:pt idx="53">
                  <c:v>1.827</c:v>
                </c:pt>
                <c:pt idx="54">
                  <c:v>1.865</c:v>
                </c:pt>
                <c:pt idx="55">
                  <c:v>1.903</c:v>
                </c:pt>
                <c:pt idx="56">
                  <c:v>1.9410000000000001</c:v>
                </c:pt>
                <c:pt idx="57">
                  <c:v>1.9790000000000001</c:v>
                </c:pt>
                <c:pt idx="58">
                  <c:v>2.0169999999999999</c:v>
                </c:pt>
                <c:pt idx="59">
                  <c:v>2.056</c:v>
                </c:pt>
                <c:pt idx="60">
                  <c:v>2.0939999999999999</c:v>
                </c:pt>
                <c:pt idx="61">
                  <c:v>2.1320000000000001</c:v>
                </c:pt>
                <c:pt idx="62">
                  <c:v>2.17</c:v>
                </c:pt>
                <c:pt idx="63">
                  <c:v>2.2080000000000002</c:v>
                </c:pt>
                <c:pt idx="64">
                  <c:v>2.246</c:v>
                </c:pt>
                <c:pt idx="65">
                  <c:v>2.2839999999999998</c:v>
                </c:pt>
                <c:pt idx="66">
                  <c:v>2.323</c:v>
                </c:pt>
                <c:pt idx="67">
                  <c:v>2.3610000000000002</c:v>
                </c:pt>
                <c:pt idx="68">
                  <c:v>2.399</c:v>
                </c:pt>
                <c:pt idx="69">
                  <c:v>2.4369999999999998</c:v>
                </c:pt>
                <c:pt idx="70">
                  <c:v>2.48</c:v>
                </c:pt>
                <c:pt idx="71">
                  <c:v>2.536</c:v>
                </c:pt>
                <c:pt idx="72">
                  <c:v>2.5920000000000001</c:v>
                </c:pt>
                <c:pt idx="73">
                  <c:v>2.6480000000000001</c:v>
                </c:pt>
                <c:pt idx="74">
                  <c:v>2.7040000000000002</c:v>
                </c:pt>
                <c:pt idx="75">
                  <c:v>2.76</c:v>
                </c:pt>
                <c:pt idx="76">
                  <c:v>2.8159999999999998</c:v>
                </c:pt>
                <c:pt idx="77">
                  <c:v>2.8719999999999999</c:v>
                </c:pt>
                <c:pt idx="78">
                  <c:v>2.9279999999999999</c:v>
                </c:pt>
                <c:pt idx="79">
                  <c:v>2.984</c:v>
                </c:pt>
                <c:pt idx="80">
                  <c:v>3.04</c:v>
                </c:pt>
                <c:pt idx="81">
                  <c:v>3.0960000000000001</c:v>
                </c:pt>
                <c:pt idx="82">
                  <c:v>3.153</c:v>
                </c:pt>
                <c:pt idx="83">
                  <c:v>3.2090000000000001</c:v>
                </c:pt>
                <c:pt idx="84">
                  <c:v>3.2650000000000001</c:v>
                </c:pt>
                <c:pt idx="85">
                  <c:v>3.3210000000000002</c:v>
                </c:pt>
                <c:pt idx="86">
                  <c:v>3.3769999999999998</c:v>
                </c:pt>
                <c:pt idx="87">
                  <c:v>3.4329999999999998</c:v>
                </c:pt>
                <c:pt idx="88">
                  <c:v>3.4889999999999999</c:v>
                </c:pt>
                <c:pt idx="89">
                  <c:v>3.5449999999999999</c:v>
                </c:pt>
                <c:pt idx="90">
                  <c:v>3.601</c:v>
                </c:pt>
                <c:pt idx="91">
                  <c:v>3.657</c:v>
                </c:pt>
                <c:pt idx="92">
                  <c:v>3.72</c:v>
                </c:pt>
                <c:pt idx="93">
                  <c:v>3.8</c:v>
                </c:pt>
                <c:pt idx="94">
                  <c:v>3.8809999999999998</c:v>
                </c:pt>
                <c:pt idx="95">
                  <c:v>3.9609999999999999</c:v>
                </c:pt>
                <c:pt idx="96">
                  <c:v>4.0419999999999998</c:v>
                </c:pt>
                <c:pt idx="97">
                  <c:v>4.1219999999999999</c:v>
                </c:pt>
                <c:pt idx="98">
                  <c:v>4.2030000000000003</c:v>
                </c:pt>
                <c:pt idx="99">
                  <c:v>4.2830000000000004</c:v>
                </c:pt>
                <c:pt idx="100">
                  <c:v>4.3639999999999999</c:v>
                </c:pt>
                <c:pt idx="101">
                  <c:v>4.444</c:v>
                </c:pt>
                <c:pt idx="102">
                  <c:v>4.5250000000000004</c:v>
                </c:pt>
                <c:pt idx="103">
                  <c:v>4.6050000000000004</c:v>
                </c:pt>
                <c:pt idx="104">
                  <c:v>4.6859999999999999</c:v>
                </c:pt>
                <c:pt idx="105">
                  <c:v>4.766</c:v>
                </c:pt>
                <c:pt idx="106">
                  <c:v>4.8470000000000004</c:v>
                </c:pt>
                <c:pt idx="107">
                  <c:v>4.9269999999999996</c:v>
                </c:pt>
                <c:pt idx="108">
                  <c:v>5.0369999999999999</c:v>
                </c:pt>
                <c:pt idx="109">
                  <c:v>5.1470000000000002</c:v>
                </c:pt>
                <c:pt idx="110">
                  <c:v>5.258</c:v>
                </c:pt>
                <c:pt idx="111">
                  <c:v>5.3680000000000003</c:v>
                </c:pt>
                <c:pt idx="112">
                  <c:v>5.4790000000000001</c:v>
                </c:pt>
                <c:pt idx="113">
                  <c:v>5.59</c:v>
                </c:pt>
                <c:pt idx="114">
                  <c:v>5.7</c:v>
                </c:pt>
                <c:pt idx="115">
                  <c:v>5.8109999999999999</c:v>
                </c:pt>
                <c:pt idx="116">
                  <c:v>5.9210000000000003</c:v>
                </c:pt>
                <c:pt idx="117">
                  <c:v>6.032</c:v>
                </c:pt>
                <c:pt idx="118">
                  <c:v>6.1420000000000003</c:v>
                </c:pt>
                <c:pt idx="119">
                  <c:v>6.1619999999999999</c:v>
                </c:pt>
                <c:pt idx="120">
                  <c:v>6.2880000000000003</c:v>
                </c:pt>
                <c:pt idx="121">
                  <c:v>6.4420000000000002</c:v>
                </c:pt>
                <c:pt idx="122">
                  <c:v>6.5949999999999998</c:v>
                </c:pt>
                <c:pt idx="123">
                  <c:v>6.7480000000000002</c:v>
                </c:pt>
                <c:pt idx="124">
                  <c:v>6.9020000000000001</c:v>
                </c:pt>
                <c:pt idx="125">
                  <c:v>7.0549999999999997</c:v>
                </c:pt>
                <c:pt idx="126">
                  <c:v>7.2089999999999996</c:v>
                </c:pt>
                <c:pt idx="127">
                  <c:v>7.3620000000000001</c:v>
                </c:pt>
                <c:pt idx="128">
                  <c:v>7.5629999999999997</c:v>
                </c:pt>
                <c:pt idx="129">
                  <c:v>7.7759999999999998</c:v>
                </c:pt>
                <c:pt idx="130">
                  <c:v>7.9889999999999999</c:v>
                </c:pt>
                <c:pt idx="131">
                  <c:v>8.202</c:v>
                </c:pt>
                <c:pt idx="132">
                  <c:v>8.4160000000000004</c:v>
                </c:pt>
                <c:pt idx="133">
                  <c:v>8.6300000000000008</c:v>
                </c:pt>
                <c:pt idx="134">
                  <c:v>8.8949999999999996</c:v>
                </c:pt>
                <c:pt idx="135">
                  <c:v>9.16</c:v>
                </c:pt>
                <c:pt idx="136">
                  <c:v>9.4250000000000007</c:v>
                </c:pt>
                <c:pt idx="137">
                  <c:v>9.69</c:v>
                </c:pt>
                <c:pt idx="138">
                  <c:v>9.9870000000000001</c:v>
                </c:pt>
                <c:pt idx="139">
                  <c:v>10.339</c:v>
                </c:pt>
                <c:pt idx="140">
                  <c:v>10.691000000000001</c:v>
                </c:pt>
                <c:pt idx="141">
                  <c:v>11.044</c:v>
                </c:pt>
                <c:pt idx="142">
                  <c:v>11.506</c:v>
                </c:pt>
                <c:pt idx="143">
                  <c:v>11.986000000000001</c:v>
                </c:pt>
                <c:pt idx="144">
                  <c:v>12.324</c:v>
                </c:pt>
                <c:pt idx="145">
                  <c:v>12.493</c:v>
                </c:pt>
                <c:pt idx="146">
                  <c:v>13.061999999999999</c:v>
                </c:pt>
                <c:pt idx="147">
                  <c:v>13.648999999999999</c:v>
                </c:pt>
                <c:pt idx="148">
                  <c:v>14.351000000000001</c:v>
                </c:pt>
                <c:pt idx="149">
                  <c:v>15.111000000000001</c:v>
                </c:pt>
                <c:pt idx="150">
                  <c:v>15.971</c:v>
                </c:pt>
                <c:pt idx="151">
                  <c:v>16.902999999999999</c:v>
                </c:pt>
                <c:pt idx="152">
                  <c:v>17.923999999999999</c:v>
                </c:pt>
                <c:pt idx="153">
                  <c:v>18.486000000000001</c:v>
                </c:pt>
                <c:pt idx="154">
                  <c:v>19.091000000000001</c:v>
                </c:pt>
                <c:pt idx="155">
                  <c:v>20.390999999999998</c:v>
                </c:pt>
                <c:pt idx="156">
                  <c:v>21.812999999999999</c:v>
                </c:pt>
                <c:pt idx="157">
                  <c:v>23.579000000000001</c:v>
                </c:pt>
                <c:pt idx="158">
                  <c:v>24.649000000000001</c:v>
                </c:pt>
                <c:pt idx="159">
                  <c:v>25.620999999999999</c:v>
                </c:pt>
                <c:pt idx="160">
                  <c:v>27.978999999999999</c:v>
                </c:pt>
                <c:pt idx="161">
                  <c:v>30.591000000000001</c:v>
                </c:pt>
                <c:pt idx="162">
                  <c:v>30.811</c:v>
                </c:pt>
                <c:pt idx="163">
                  <c:v>33.579000000000001</c:v>
                </c:pt>
                <c:pt idx="164">
                  <c:v>36.79</c:v>
                </c:pt>
                <c:pt idx="165">
                  <c:v>36.972999999999999</c:v>
                </c:pt>
                <c:pt idx="166">
                  <c:v>40.478999999999999</c:v>
                </c:pt>
                <c:pt idx="167">
                  <c:v>43.134999999999998</c:v>
                </c:pt>
                <c:pt idx="168">
                  <c:v>44.951000000000001</c:v>
                </c:pt>
                <c:pt idx="169">
                  <c:v>49.296999999999997</c:v>
                </c:pt>
                <c:pt idx="170">
                  <c:v>49.878999999999998</c:v>
                </c:pt>
                <c:pt idx="171">
                  <c:v>55.063000000000002</c:v>
                </c:pt>
                <c:pt idx="172">
                  <c:v>55.459000000000003</c:v>
                </c:pt>
                <c:pt idx="173">
                  <c:v>61.621000000000002</c:v>
                </c:pt>
                <c:pt idx="174">
                  <c:v>61.735999999999997</c:v>
                </c:pt>
                <c:pt idx="175">
                  <c:v>67.783000000000001</c:v>
                </c:pt>
                <c:pt idx="176">
                  <c:v>68.819999999999993</c:v>
                </c:pt>
                <c:pt idx="177">
                  <c:v>73.945999999999998</c:v>
                </c:pt>
                <c:pt idx="178">
                  <c:v>76.765000000000001</c:v>
                </c:pt>
                <c:pt idx="179">
                  <c:v>80.108000000000004</c:v>
                </c:pt>
                <c:pt idx="180">
                  <c:v>86.224000000000004</c:v>
                </c:pt>
                <c:pt idx="181">
                  <c:v>86.27</c:v>
                </c:pt>
                <c:pt idx="182">
                  <c:v>92.432000000000002</c:v>
                </c:pt>
                <c:pt idx="183">
                  <c:v>97.210999999999999</c:v>
                </c:pt>
                <c:pt idx="184">
                  <c:v>98.593999999999994</c:v>
                </c:pt>
                <c:pt idx="185">
                  <c:v>104.756</c:v>
                </c:pt>
                <c:pt idx="186">
                  <c:v>108.26900000000001</c:v>
                </c:pt>
                <c:pt idx="187">
                  <c:v>110.91800000000001</c:v>
                </c:pt>
                <c:pt idx="188">
                  <c:v>117.08</c:v>
                </c:pt>
                <c:pt idx="189">
                  <c:v>121.958</c:v>
                </c:pt>
                <c:pt idx="190">
                  <c:v>123.24299999999999</c:v>
                </c:pt>
                <c:pt idx="191">
                  <c:v>129.405</c:v>
                </c:pt>
                <c:pt idx="192">
                  <c:v>135.56700000000001</c:v>
                </c:pt>
                <c:pt idx="193">
                  <c:v>135.87899999999999</c:v>
                </c:pt>
                <c:pt idx="194">
                  <c:v>141.72900000000001</c:v>
                </c:pt>
                <c:pt idx="195">
                  <c:v>147.89099999999999</c:v>
                </c:pt>
                <c:pt idx="196">
                  <c:v>152.727</c:v>
                </c:pt>
                <c:pt idx="197">
                  <c:v>154.053</c:v>
                </c:pt>
                <c:pt idx="198">
                  <c:v>160.215</c:v>
                </c:pt>
                <c:pt idx="199">
                  <c:v>166.37700000000001</c:v>
                </c:pt>
                <c:pt idx="200">
                  <c:v>170.30099999999999</c:v>
                </c:pt>
                <c:pt idx="201">
                  <c:v>172.54</c:v>
                </c:pt>
                <c:pt idx="202">
                  <c:v>178.702</c:v>
                </c:pt>
                <c:pt idx="203">
                  <c:v>184.864</c:v>
                </c:pt>
                <c:pt idx="204">
                  <c:v>189.55799999999999</c:v>
                </c:pt>
                <c:pt idx="205">
                  <c:v>191.02600000000001</c:v>
                </c:pt>
                <c:pt idx="206">
                  <c:v>197.18799999999999</c:v>
                </c:pt>
                <c:pt idx="207">
                  <c:v>203.35</c:v>
                </c:pt>
                <c:pt idx="208">
                  <c:v>209.512</c:v>
                </c:pt>
                <c:pt idx="209">
                  <c:v>212.71</c:v>
                </c:pt>
                <c:pt idx="210">
                  <c:v>215.67400000000001</c:v>
                </c:pt>
                <c:pt idx="211">
                  <c:v>221.83699999999999</c:v>
                </c:pt>
                <c:pt idx="212">
                  <c:v>227.999</c:v>
                </c:pt>
                <c:pt idx="213">
                  <c:v>234.161</c:v>
                </c:pt>
                <c:pt idx="214">
                  <c:v>234.67699999999999</c:v>
                </c:pt>
                <c:pt idx="215">
                  <c:v>240.32300000000001</c:v>
                </c:pt>
                <c:pt idx="216">
                  <c:v>246.48500000000001</c:v>
                </c:pt>
                <c:pt idx="217">
                  <c:v>252.64699999999999</c:v>
                </c:pt>
                <c:pt idx="218">
                  <c:v>258.80900000000003</c:v>
                </c:pt>
                <c:pt idx="219">
                  <c:v>260.08800000000002</c:v>
                </c:pt>
                <c:pt idx="220">
                  <c:v>264.97199999999998</c:v>
                </c:pt>
                <c:pt idx="221">
                  <c:v>271.13400000000001</c:v>
                </c:pt>
                <c:pt idx="222">
                  <c:v>277.29599999999999</c:v>
                </c:pt>
                <c:pt idx="223">
                  <c:v>283.45800000000003</c:v>
                </c:pt>
                <c:pt idx="224">
                  <c:v>284.178</c:v>
                </c:pt>
                <c:pt idx="225">
                  <c:v>289.62</c:v>
                </c:pt>
                <c:pt idx="226">
                  <c:v>295.78199999999998</c:v>
                </c:pt>
                <c:pt idx="227">
                  <c:v>301.94400000000002</c:v>
                </c:pt>
                <c:pt idx="228">
                  <c:v>308.10599999999999</c:v>
                </c:pt>
                <c:pt idx="229">
                  <c:v>314.26900000000001</c:v>
                </c:pt>
                <c:pt idx="230">
                  <c:v>315.34899999999999</c:v>
                </c:pt>
                <c:pt idx="231">
                  <c:v>320.43099999999998</c:v>
                </c:pt>
                <c:pt idx="232">
                  <c:v>326.59300000000002</c:v>
                </c:pt>
                <c:pt idx="233">
                  <c:v>332.755</c:v>
                </c:pt>
                <c:pt idx="234">
                  <c:v>338.91699999999997</c:v>
                </c:pt>
                <c:pt idx="235">
                  <c:v>341.62099999999998</c:v>
                </c:pt>
                <c:pt idx="236">
                  <c:v>345.07900000000001</c:v>
                </c:pt>
                <c:pt idx="237">
                  <c:v>351.24099999999999</c:v>
                </c:pt>
                <c:pt idx="238">
                  <c:v>357.40300000000002</c:v>
                </c:pt>
                <c:pt idx="239">
                  <c:v>363.56599999999997</c:v>
                </c:pt>
                <c:pt idx="240">
                  <c:v>367.87799999999999</c:v>
                </c:pt>
                <c:pt idx="241">
                  <c:v>369.72800000000001</c:v>
                </c:pt>
                <c:pt idx="242">
                  <c:v>375.89</c:v>
                </c:pt>
                <c:pt idx="243">
                  <c:v>382.05200000000002</c:v>
                </c:pt>
                <c:pt idx="244">
                  <c:v>388.214</c:v>
                </c:pt>
                <c:pt idx="245">
                  <c:v>394.37599999999998</c:v>
                </c:pt>
                <c:pt idx="246">
                  <c:v>396.05500000000001</c:v>
                </c:pt>
                <c:pt idx="247">
                  <c:v>400.53800000000001</c:v>
                </c:pt>
                <c:pt idx="248">
                  <c:v>406.7</c:v>
                </c:pt>
                <c:pt idx="249">
                  <c:v>412.863</c:v>
                </c:pt>
                <c:pt idx="250">
                  <c:v>419.02499999999998</c:v>
                </c:pt>
                <c:pt idx="251">
                  <c:v>423.423</c:v>
                </c:pt>
                <c:pt idx="252">
                  <c:v>425.18700000000001</c:v>
                </c:pt>
                <c:pt idx="253">
                  <c:v>431.34899999999999</c:v>
                </c:pt>
                <c:pt idx="254">
                  <c:v>437.51100000000002</c:v>
                </c:pt>
                <c:pt idx="255">
                  <c:v>443.673</c:v>
                </c:pt>
                <c:pt idx="256">
                  <c:v>449.23399999999998</c:v>
                </c:pt>
                <c:pt idx="257">
                  <c:v>449.83499999999998</c:v>
                </c:pt>
                <c:pt idx="258">
                  <c:v>455.99700000000001</c:v>
                </c:pt>
                <c:pt idx="259">
                  <c:v>462.16</c:v>
                </c:pt>
                <c:pt idx="260">
                  <c:v>468.322</c:v>
                </c:pt>
                <c:pt idx="261">
                  <c:v>474.48399999999998</c:v>
                </c:pt>
                <c:pt idx="262">
                  <c:v>480.64600000000002</c:v>
                </c:pt>
                <c:pt idx="263">
                  <c:v>482.63900000000001</c:v>
                </c:pt>
                <c:pt idx="264">
                  <c:v>486.80799999999999</c:v>
                </c:pt>
                <c:pt idx="265">
                  <c:v>492.97</c:v>
                </c:pt>
                <c:pt idx="266">
                  <c:v>499.13200000000001</c:v>
                </c:pt>
                <c:pt idx="267">
                  <c:v>505.29500000000002</c:v>
                </c:pt>
                <c:pt idx="268">
                  <c:v>511.45699999999999</c:v>
                </c:pt>
                <c:pt idx="269">
                  <c:v>513.17399999999998</c:v>
                </c:pt>
                <c:pt idx="270">
                  <c:v>517.61900000000003</c:v>
                </c:pt>
                <c:pt idx="271">
                  <c:v>523.78099999999995</c:v>
                </c:pt>
                <c:pt idx="272">
                  <c:v>529.94299999999998</c:v>
                </c:pt>
                <c:pt idx="273">
                  <c:v>536.10500000000002</c:v>
                </c:pt>
                <c:pt idx="274">
                  <c:v>542.26700000000005</c:v>
                </c:pt>
                <c:pt idx="275">
                  <c:v>545.07000000000005</c:v>
                </c:pt>
                <c:pt idx="276">
                  <c:v>548.42899999999997</c:v>
                </c:pt>
                <c:pt idx="277">
                  <c:v>554.59199999999998</c:v>
                </c:pt>
                <c:pt idx="278">
                  <c:v>560.75400000000002</c:v>
                </c:pt>
                <c:pt idx="279">
                  <c:v>566.91600000000005</c:v>
                </c:pt>
                <c:pt idx="280">
                  <c:v>573.07799999999997</c:v>
                </c:pt>
                <c:pt idx="281">
                  <c:v>579.24</c:v>
                </c:pt>
                <c:pt idx="282">
                  <c:v>581.68899999999996</c:v>
                </c:pt>
                <c:pt idx="283">
                  <c:v>585.40200000000004</c:v>
                </c:pt>
                <c:pt idx="284">
                  <c:v>591.56399999999996</c:v>
                </c:pt>
                <c:pt idx="285">
                  <c:v>597.726</c:v>
                </c:pt>
                <c:pt idx="286">
                  <c:v>603.88900000000001</c:v>
                </c:pt>
                <c:pt idx="287">
                  <c:v>610.05100000000004</c:v>
                </c:pt>
                <c:pt idx="288">
                  <c:v>616.21299999999997</c:v>
                </c:pt>
                <c:pt idx="289">
                  <c:v>621.85799999999995</c:v>
                </c:pt>
                <c:pt idx="290">
                  <c:v>622.375</c:v>
                </c:pt>
                <c:pt idx="291">
                  <c:v>628.53700000000003</c:v>
                </c:pt>
                <c:pt idx="292">
                  <c:v>634.69899999999996</c:v>
                </c:pt>
                <c:pt idx="293">
                  <c:v>640.86099999999999</c:v>
                </c:pt>
                <c:pt idx="294">
                  <c:v>647.02300000000002</c:v>
                </c:pt>
                <c:pt idx="295">
                  <c:v>653.18600000000004</c:v>
                </c:pt>
                <c:pt idx="296">
                  <c:v>659.15300000000002</c:v>
                </c:pt>
                <c:pt idx="297">
                  <c:v>659.34799999999996</c:v>
                </c:pt>
                <c:pt idx="298">
                  <c:v>665.51</c:v>
                </c:pt>
                <c:pt idx="299">
                  <c:v>671.67200000000003</c:v>
                </c:pt>
                <c:pt idx="300">
                  <c:v>677.83399999999995</c:v>
                </c:pt>
                <c:pt idx="301">
                  <c:v>683.99599999999998</c:v>
                </c:pt>
                <c:pt idx="302">
                  <c:v>690.15800000000002</c:v>
                </c:pt>
                <c:pt idx="303">
                  <c:v>693.01499999999999</c:v>
                </c:pt>
                <c:pt idx="304">
                  <c:v>696.32</c:v>
                </c:pt>
                <c:pt idx="305">
                  <c:v>702.48299999999995</c:v>
                </c:pt>
                <c:pt idx="306">
                  <c:v>708.64499999999998</c:v>
                </c:pt>
                <c:pt idx="307">
                  <c:v>714.80700000000002</c:v>
                </c:pt>
                <c:pt idx="308">
                  <c:v>720.96900000000005</c:v>
                </c:pt>
                <c:pt idx="309">
                  <c:v>727.13099999999997</c:v>
                </c:pt>
                <c:pt idx="310">
                  <c:v>730.67499999999995</c:v>
                </c:pt>
                <c:pt idx="311">
                  <c:v>733.29300000000001</c:v>
                </c:pt>
                <c:pt idx="312">
                  <c:v>739.45500000000004</c:v>
                </c:pt>
                <c:pt idx="313">
                  <c:v>745.61800000000005</c:v>
                </c:pt>
                <c:pt idx="314">
                  <c:v>751.78</c:v>
                </c:pt>
                <c:pt idx="315">
                  <c:v>757.94200000000001</c:v>
                </c:pt>
                <c:pt idx="316">
                  <c:v>764.10400000000004</c:v>
                </c:pt>
                <c:pt idx="317">
                  <c:v>764.71400000000006</c:v>
                </c:pt>
                <c:pt idx="318">
                  <c:v>770.26599999999996</c:v>
                </c:pt>
                <c:pt idx="319">
                  <c:v>776.428</c:v>
                </c:pt>
                <c:pt idx="320">
                  <c:v>782.59</c:v>
                </c:pt>
                <c:pt idx="321">
                  <c:v>788.75199999999995</c:v>
                </c:pt>
                <c:pt idx="322">
                  <c:v>794.91499999999996</c:v>
                </c:pt>
                <c:pt idx="323">
                  <c:v>801.077</c:v>
                </c:pt>
                <c:pt idx="324">
                  <c:v>803.798</c:v>
                </c:pt>
                <c:pt idx="325">
                  <c:v>807.23900000000003</c:v>
                </c:pt>
                <c:pt idx="326">
                  <c:v>813.40099999999995</c:v>
                </c:pt>
                <c:pt idx="327">
                  <c:v>819.56299999999999</c:v>
                </c:pt>
                <c:pt idx="328">
                  <c:v>825.72500000000002</c:v>
                </c:pt>
                <c:pt idx="329">
                  <c:v>831.88699999999994</c:v>
                </c:pt>
                <c:pt idx="330">
                  <c:v>838.04899999999998</c:v>
                </c:pt>
                <c:pt idx="331">
                  <c:v>844.21199999999999</c:v>
                </c:pt>
                <c:pt idx="332">
                  <c:v>849.00699999999995</c:v>
                </c:pt>
                <c:pt idx="333">
                  <c:v>850.37400000000002</c:v>
                </c:pt>
                <c:pt idx="334">
                  <c:v>856.53599999999994</c:v>
                </c:pt>
                <c:pt idx="335">
                  <c:v>862.69799999999998</c:v>
                </c:pt>
                <c:pt idx="336">
                  <c:v>868.86</c:v>
                </c:pt>
                <c:pt idx="337">
                  <c:v>875.02200000000005</c:v>
                </c:pt>
                <c:pt idx="338">
                  <c:v>881.18399999999997</c:v>
                </c:pt>
                <c:pt idx="339">
                  <c:v>887.346</c:v>
                </c:pt>
                <c:pt idx="340">
                  <c:v>893.50900000000001</c:v>
                </c:pt>
                <c:pt idx="341">
                  <c:v>897.24099999999999</c:v>
                </c:pt>
                <c:pt idx="342">
                  <c:v>899.67100000000005</c:v>
                </c:pt>
                <c:pt idx="343">
                  <c:v>905.83299999999997</c:v>
                </c:pt>
                <c:pt idx="344">
                  <c:v>911.995</c:v>
                </c:pt>
                <c:pt idx="345">
                  <c:v>918.15700000000004</c:v>
                </c:pt>
                <c:pt idx="346">
                  <c:v>924.31899999999996</c:v>
                </c:pt>
                <c:pt idx="347">
                  <c:v>930.48099999999999</c:v>
                </c:pt>
                <c:pt idx="348">
                  <c:v>936.64400000000001</c:v>
                </c:pt>
                <c:pt idx="349">
                  <c:v>942.80600000000004</c:v>
                </c:pt>
                <c:pt idx="350">
                  <c:v>945.15099999999995</c:v>
                </c:pt>
                <c:pt idx="351">
                  <c:v>948.96799999999996</c:v>
                </c:pt>
                <c:pt idx="352">
                  <c:v>955.13</c:v>
                </c:pt>
                <c:pt idx="353">
                  <c:v>961.29200000000003</c:v>
                </c:pt>
                <c:pt idx="354">
                  <c:v>967.45399999999995</c:v>
                </c:pt>
                <c:pt idx="355">
                  <c:v>973.61599999999999</c:v>
                </c:pt>
                <c:pt idx="356">
                  <c:v>979.77800000000002</c:v>
                </c:pt>
                <c:pt idx="357">
                  <c:v>985.94100000000003</c:v>
                </c:pt>
                <c:pt idx="358">
                  <c:v>992.10299999999995</c:v>
                </c:pt>
                <c:pt idx="359">
                  <c:v>996.75699999999995</c:v>
                </c:pt>
                <c:pt idx="360">
                  <c:v>998.26499999999999</c:v>
                </c:pt>
                <c:pt idx="361">
                  <c:v>1004.427</c:v>
                </c:pt>
                <c:pt idx="362">
                  <c:v>1010.5890000000001</c:v>
                </c:pt>
                <c:pt idx="363">
                  <c:v>1016.751</c:v>
                </c:pt>
                <c:pt idx="364">
                  <c:v>1022.913</c:v>
                </c:pt>
                <c:pt idx="365">
                  <c:v>1029.075</c:v>
                </c:pt>
                <c:pt idx="366">
                  <c:v>1035.2380000000001</c:v>
                </c:pt>
                <c:pt idx="367">
                  <c:v>1041.4000000000001</c:v>
                </c:pt>
                <c:pt idx="368">
                  <c:v>1046.865</c:v>
                </c:pt>
                <c:pt idx="369">
                  <c:v>1047.5619999999999</c:v>
                </c:pt>
                <c:pt idx="370">
                  <c:v>1053.7239999999999</c:v>
                </c:pt>
                <c:pt idx="371">
                  <c:v>1059.886</c:v>
                </c:pt>
                <c:pt idx="372">
                  <c:v>1066.048</c:v>
                </c:pt>
                <c:pt idx="373">
                  <c:v>1072.21</c:v>
                </c:pt>
                <c:pt idx="374">
                  <c:v>1078.3720000000001</c:v>
                </c:pt>
                <c:pt idx="375">
                  <c:v>1084.5350000000001</c:v>
                </c:pt>
                <c:pt idx="376">
                  <c:v>1090.6969999999999</c:v>
                </c:pt>
                <c:pt idx="377">
                  <c:v>1096.8589999999999</c:v>
                </c:pt>
                <c:pt idx="378">
                  <c:v>1103.021</c:v>
                </c:pt>
                <c:pt idx="379">
                  <c:v>1105.3030000000001</c:v>
                </c:pt>
                <c:pt idx="380">
                  <c:v>1109.183</c:v>
                </c:pt>
                <c:pt idx="381">
                  <c:v>1115.345</c:v>
                </c:pt>
                <c:pt idx="382">
                  <c:v>1121.5070000000001</c:v>
                </c:pt>
                <c:pt idx="383">
                  <c:v>1127.6690000000001</c:v>
                </c:pt>
                <c:pt idx="384">
                  <c:v>1133.8320000000001</c:v>
                </c:pt>
                <c:pt idx="385">
                  <c:v>1139.9939999999999</c:v>
                </c:pt>
                <c:pt idx="386">
                  <c:v>1146.1559999999999</c:v>
                </c:pt>
                <c:pt idx="387">
                  <c:v>1152.318</c:v>
                </c:pt>
                <c:pt idx="388">
                  <c:v>1158.48</c:v>
                </c:pt>
                <c:pt idx="389">
                  <c:v>1164.6420000000001</c:v>
                </c:pt>
                <c:pt idx="390">
                  <c:v>1170.8040000000001</c:v>
                </c:pt>
                <c:pt idx="391">
                  <c:v>1176.9670000000001</c:v>
                </c:pt>
                <c:pt idx="392">
                  <c:v>1183.1289999999999</c:v>
                </c:pt>
                <c:pt idx="393">
                  <c:v>1189.2909999999999</c:v>
                </c:pt>
                <c:pt idx="394">
                  <c:v>1195.453</c:v>
                </c:pt>
                <c:pt idx="395">
                  <c:v>1201.615</c:v>
                </c:pt>
                <c:pt idx="396">
                  <c:v>1207.777</c:v>
                </c:pt>
                <c:pt idx="397">
                  <c:v>1213.9390000000001</c:v>
                </c:pt>
                <c:pt idx="398">
                  <c:v>1220.1010000000001</c:v>
                </c:pt>
                <c:pt idx="399">
                  <c:v>1226.2639999999999</c:v>
                </c:pt>
                <c:pt idx="400">
                  <c:v>1232.4259999999999</c:v>
                </c:pt>
                <c:pt idx="401">
                  <c:v>1232.4259999999999</c:v>
                </c:pt>
              </c:numCache>
            </c:numRef>
          </c:xVal>
          <c:yVal>
            <c:numRef>
              <c:f>Foglio6!$H$411:$H$812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.411000000000001</c:v>
                </c:pt>
                <c:pt idx="120">
                  <c:v>41</c:v>
                </c:pt>
                <c:pt idx="121">
                  <c:v>40.5</c:v>
                </c:pt>
                <c:pt idx="122">
                  <c:v>40</c:v>
                </c:pt>
                <c:pt idx="123">
                  <c:v>39.5</c:v>
                </c:pt>
                <c:pt idx="124">
                  <c:v>39</c:v>
                </c:pt>
                <c:pt idx="125">
                  <c:v>38.5</c:v>
                </c:pt>
                <c:pt idx="126">
                  <c:v>38</c:v>
                </c:pt>
                <c:pt idx="127">
                  <c:v>37.5</c:v>
                </c:pt>
                <c:pt idx="128">
                  <c:v>37</c:v>
                </c:pt>
                <c:pt idx="129">
                  <c:v>36.5</c:v>
                </c:pt>
                <c:pt idx="130">
                  <c:v>36</c:v>
                </c:pt>
                <c:pt idx="131">
                  <c:v>35.5</c:v>
                </c:pt>
                <c:pt idx="132">
                  <c:v>35</c:v>
                </c:pt>
                <c:pt idx="133">
                  <c:v>34.5</c:v>
                </c:pt>
                <c:pt idx="134">
                  <c:v>34</c:v>
                </c:pt>
                <c:pt idx="135">
                  <c:v>33.5</c:v>
                </c:pt>
                <c:pt idx="136">
                  <c:v>33</c:v>
                </c:pt>
                <c:pt idx="137">
                  <c:v>32.5</c:v>
                </c:pt>
                <c:pt idx="138">
                  <c:v>32</c:v>
                </c:pt>
                <c:pt idx="139">
                  <c:v>31.5</c:v>
                </c:pt>
                <c:pt idx="140">
                  <c:v>31</c:v>
                </c:pt>
                <c:pt idx="141">
                  <c:v>30.5</c:v>
                </c:pt>
                <c:pt idx="142">
                  <c:v>30</c:v>
                </c:pt>
                <c:pt idx="143">
                  <c:v>29.5</c:v>
                </c:pt>
                <c:pt idx="144">
                  <c:v>29.148</c:v>
                </c:pt>
                <c:pt idx="145">
                  <c:v>29</c:v>
                </c:pt>
                <c:pt idx="146">
                  <c:v>28.5</c:v>
                </c:pt>
                <c:pt idx="147">
                  <c:v>28</c:v>
                </c:pt>
                <c:pt idx="148">
                  <c:v>27.5</c:v>
                </c:pt>
                <c:pt idx="149">
                  <c:v>27</c:v>
                </c:pt>
                <c:pt idx="150">
                  <c:v>26.5</c:v>
                </c:pt>
                <c:pt idx="151">
                  <c:v>26</c:v>
                </c:pt>
                <c:pt idx="152">
                  <c:v>25.5</c:v>
                </c:pt>
                <c:pt idx="153">
                  <c:v>25.236999999999998</c:v>
                </c:pt>
                <c:pt idx="154">
                  <c:v>25</c:v>
                </c:pt>
                <c:pt idx="155">
                  <c:v>24.5</c:v>
                </c:pt>
                <c:pt idx="156">
                  <c:v>24</c:v>
                </c:pt>
                <c:pt idx="157">
                  <c:v>23.5</c:v>
                </c:pt>
                <c:pt idx="158">
                  <c:v>23.234999999999999</c:v>
                </c:pt>
                <c:pt idx="159">
                  <c:v>23</c:v>
                </c:pt>
                <c:pt idx="160">
                  <c:v>22.5</c:v>
                </c:pt>
                <c:pt idx="161">
                  <c:v>22</c:v>
                </c:pt>
                <c:pt idx="162">
                  <c:v>21.956</c:v>
                </c:pt>
                <c:pt idx="163">
                  <c:v>21.5</c:v>
                </c:pt>
                <c:pt idx="164">
                  <c:v>21</c:v>
                </c:pt>
                <c:pt idx="165">
                  <c:v>20.974</c:v>
                </c:pt>
                <c:pt idx="166">
                  <c:v>20.5</c:v>
                </c:pt>
                <c:pt idx="167">
                  <c:v>20.213000000000001</c:v>
                </c:pt>
                <c:pt idx="168">
                  <c:v>20</c:v>
                </c:pt>
                <c:pt idx="169">
                  <c:v>19.565000000000001</c:v>
                </c:pt>
                <c:pt idx="170">
                  <c:v>19.5</c:v>
                </c:pt>
                <c:pt idx="171">
                  <c:v>19</c:v>
                </c:pt>
                <c:pt idx="172">
                  <c:v>18.968</c:v>
                </c:pt>
                <c:pt idx="173">
                  <c:v>18.507999999999999</c:v>
                </c:pt>
                <c:pt idx="174">
                  <c:v>18.5</c:v>
                </c:pt>
                <c:pt idx="175">
                  <c:v>18.065999999999999</c:v>
                </c:pt>
                <c:pt idx="176">
                  <c:v>18</c:v>
                </c:pt>
                <c:pt idx="177">
                  <c:v>17.670999999999999</c:v>
                </c:pt>
                <c:pt idx="178">
                  <c:v>17.5</c:v>
                </c:pt>
                <c:pt idx="179">
                  <c:v>17.329999999999998</c:v>
                </c:pt>
                <c:pt idx="180">
                  <c:v>17</c:v>
                </c:pt>
                <c:pt idx="181">
                  <c:v>16.998000000000001</c:v>
                </c:pt>
                <c:pt idx="182">
                  <c:v>16.722000000000001</c:v>
                </c:pt>
                <c:pt idx="183">
                  <c:v>16.5</c:v>
                </c:pt>
                <c:pt idx="184">
                  <c:v>16.428999999999998</c:v>
                </c:pt>
                <c:pt idx="185">
                  <c:v>16.148</c:v>
                </c:pt>
                <c:pt idx="186">
                  <c:v>16</c:v>
                </c:pt>
                <c:pt idx="187">
                  <c:v>15.887</c:v>
                </c:pt>
                <c:pt idx="188">
                  <c:v>15.673</c:v>
                </c:pt>
                <c:pt idx="189">
                  <c:v>15.5</c:v>
                </c:pt>
                <c:pt idx="190">
                  <c:v>15.465</c:v>
                </c:pt>
                <c:pt idx="191">
                  <c:v>15.24</c:v>
                </c:pt>
                <c:pt idx="192">
                  <c:v>15.01</c:v>
                </c:pt>
                <c:pt idx="193">
                  <c:v>15</c:v>
                </c:pt>
                <c:pt idx="194">
                  <c:v>14.82</c:v>
                </c:pt>
                <c:pt idx="195">
                  <c:v>14.635999999999999</c:v>
                </c:pt>
                <c:pt idx="196">
                  <c:v>14.5</c:v>
                </c:pt>
                <c:pt idx="197">
                  <c:v>14.464</c:v>
                </c:pt>
                <c:pt idx="198">
                  <c:v>14.282</c:v>
                </c:pt>
                <c:pt idx="199">
                  <c:v>14.103999999999999</c:v>
                </c:pt>
                <c:pt idx="200">
                  <c:v>14</c:v>
                </c:pt>
                <c:pt idx="201">
                  <c:v>13.941000000000001</c:v>
                </c:pt>
                <c:pt idx="202">
                  <c:v>13.778</c:v>
                </c:pt>
                <c:pt idx="203">
                  <c:v>13.62</c:v>
                </c:pt>
                <c:pt idx="204">
                  <c:v>13.5</c:v>
                </c:pt>
                <c:pt idx="205">
                  <c:v>13.461</c:v>
                </c:pt>
                <c:pt idx="206">
                  <c:v>13.308</c:v>
                </c:pt>
                <c:pt idx="207">
                  <c:v>13.169</c:v>
                </c:pt>
                <c:pt idx="208">
                  <c:v>13.053000000000001</c:v>
                </c:pt>
                <c:pt idx="209">
                  <c:v>13</c:v>
                </c:pt>
                <c:pt idx="210">
                  <c:v>12.945</c:v>
                </c:pt>
                <c:pt idx="211">
                  <c:v>12.79</c:v>
                </c:pt>
                <c:pt idx="212">
                  <c:v>12.664</c:v>
                </c:pt>
                <c:pt idx="213">
                  <c:v>12.51</c:v>
                </c:pt>
                <c:pt idx="214">
                  <c:v>12.5</c:v>
                </c:pt>
                <c:pt idx="215">
                  <c:v>12.393000000000001</c:v>
                </c:pt>
                <c:pt idx="216">
                  <c:v>12.25</c:v>
                </c:pt>
                <c:pt idx="217">
                  <c:v>12.156000000000001</c:v>
                </c:pt>
                <c:pt idx="218">
                  <c:v>12.032999999999999</c:v>
                </c:pt>
                <c:pt idx="219">
                  <c:v>12</c:v>
                </c:pt>
                <c:pt idx="220">
                  <c:v>11.891999999999999</c:v>
                </c:pt>
                <c:pt idx="221">
                  <c:v>11.762</c:v>
                </c:pt>
                <c:pt idx="222">
                  <c:v>11.635999999999999</c:v>
                </c:pt>
                <c:pt idx="223">
                  <c:v>11.510999999999999</c:v>
                </c:pt>
                <c:pt idx="224">
                  <c:v>11.5</c:v>
                </c:pt>
                <c:pt idx="225">
                  <c:v>11.403</c:v>
                </c:pt>
                <c:pt idx="226">
                  <c:v>11.304</c:v>
                </c:pt>
                <c:pt idx="227">
                  <c:v>11.215999999999999</c:v>
                </c:pt>
                <c:pt idx="228">
                  <c:v>11.118</c:v>
                </c:pt>
                <c:pt idx="229">
                  <c:v>11.022</c:v>
                </c:pt>
                <c:pt idx="230">
                  <c:v>11</c:v>
                </c:pt>
                <c:pt idx="231">
                  <c:v>10.874000000000001</c:v>
                </c:pt>
                <c:pt idx="232">
                  <c:v>10.742000000000001</c:v>
                </c:pt>
                <c:pt idx="233">
                  <c:v>10.638999999999999</c:v>
                </c:pt>
                <c:pt idx="234">
                  <c:v>10.537000000000001</c:v>
                </c:pt>
                <c:pt idx="235">
                  <c:v>10.5</c:v>
                </c:pt>
                <c:pt idx="236">
                  <c:v>10.43</c:v>
                </c:pt>
                <c:pt idx="237">
                  <c:v>10.333</c:v>
                </c:pt>
                <c:pt idx="238">
                  <c:v>10.218999999999999</c:v>
                </c:pt>
                <c:pt idx="239">
                  <c:v>10.097</c:v>
                </c:pt>
                <c:pt idx="240">
                  <c:v>10</c:v>
                </c:pt>
                <c:pt idx="241">
                  <c:v>9.9559999999999995</c:v>
                </c:pt>
                <c:pt idx="242">
                  <c:v>9.8170000000000002</c:v>
                </c:pt>
                <c:pt idx="243">
                  <c:v>9.7309999999999999</c:v>
                </c:pt>
                <c:pt idx="244">
                  <c:v>9.625</c:v>
                </c:pt>
                <c:pt idx="245">
                  <c:v>9.5220000000000002</c:v>
                </c:pt>
                <c:pt idx="246">
                  <c:v>9.5</c:v>
                </c:pt>
                <c:pt idx="247">
                  <c:v>9.4209999999999994</c:v>
                </c:pt>
                <c:pt idx="248">
                  <c:v>9.3170000000000002</c:v>
                </c:pt>
                <c:pt idx="249">
                  <c:v>9.2140000000000004</c:v>
                </c:pt>
                <c:pt idx="250">
                  <c:v>9.077</c:v>
                </c:pt>
                <c:pt idx="251">
                  <c:v>9</c:v>
                </c:pt>
                <c:pt idx="252">
                  <c:v>8.9559999999999995</c:v>
                </c:pt>
                <c:pt idx="253">
                  <c:v>8.8350000000000009</c:v>
                </c:pt>
                <c:pt idx="254">
                  <c:v>8.7059999999999995</c:v>
                </c:pt>
                <c:pt idx="255">
                  <c:v>8.593</c:v>
                </c:pt>
                <c:pt idx="256">
                  <c:v>8.5</c:v>
                </c:pt>
                <c:pt idx="257">
                  <c:v>8.4909999999999997</c:v>
                </c:pt>
                <c:pt idx="258">
                  <c:v>8.391</c:v>
                </c:pt>
                <c:pt idx="259">
                  <c:v>8.3030000000000008</c:v>
                </c:pt>
                <c:pt idx="260">
                  <c:v>8.2050000000000001</c:v>
                </c:pt>
                <c:pt idx="261">
                  <c:v>8.1219999999999999</c:v>
                </c:pt>
                <c:pt idx="262">
                  <c:v>8.0350000000000001</c:v>
                </c:pt>
                <c:pt idx="263">
                  <c:v>8</c:v>
                </c:pt>
                <c:pt idx="264">
                  <c:v>7.944</c:v>
                </c:pt>
                <c:pt idx="265">
                  <c:v>7.85</c:v>
                </c:pt>
                <c:pt idx="266">
                  <c:v>7.7359999999999998</c:v>
                </c:pt>
                <c:pt idx="267">
                  <c:v>7.6360000000000001</c:v>
                </c:pt>
                <c:pt idx="268">
                  <c:v>7.5350000000000001</c:v>
                </c:pt>
                <c:pt idx="269">
                  <c:v>7.5</c:v>
                </c:pt>
                <c:pt idx="270">
                  <c:v>7.4020000000000001</c:v>
                </c:pt>
                <c:pt idx="271">
                  <c:v>7.3090000000000002</c:v>
                </c:pt>
                <c:pt idx="272">
                  <c:v>7.218</c:v>
                </c:pt>
                <c:pt idx="273">
                  <c:v>7.1210000000000004</c:v>
                </c:pt>
                <c:pt idx="274">
                  <c:v>7.0410000000000004</c:v>
                </c:pt>
                <c:pt idx="275">
                  <c:v>7</c:v>
                </c:pt>
                <c:pt idx="276">
                  <c:v>6.9539999999999997</c:v>
                </c:pt>
                <c:pt idx="277">
                  <c:v>6.875</c:v>
                </c:pt>
                <c:pt idx="278">
                  <c:v>6.7889999999999997</c:v>
                </c:pt>
                <c:pt idx="279">
                  <c:v>6.7130000000000001</c:v>
                </c:pt>
                <c:pt idx="280">
                  <c:v>6.6390000000000002</c:v>
                </c:pt>
                <c:pt idx="281">
                  <c:v>6.52</c:v>
                </c:pt>
                <c:pt idx="282">
                  <c:v>6.5</c:v>
                </c:pt>
                <c:pt idx="283">
                  <c:v>6.4539999999999997</c:v>
                </c:pt>
                <c:pt idx="284">
                  <c:v>6.3630000000000004</c:v>
                </c:pt>
                <c:pt idx="285">
                  <c:v>6.3010000000000002</c:v>
                </c:pt>
                <c:pt idx="286">
                  <c:v>6.2270000000000003</c:v>
                </c:pt>
                <c:pt idx="287">
                  <c:v>6.1619999999999999</c:v>
                </c:pt>
                <c:pt idx="288">
                  <c:v>6.0970000000000004</c:v>
                </c:pt>
                <c:pt idx="289">
                  <c:v>6</c:v>
                </c:pt>
                <c:pt idx="290">
                  <c:v>5.9880000000000004</c:v>
                </c:pt>
                <c:pt idx="291">
                  <c:v>5.9160000000000004</c:v>
                </c:pt>
                <c:pt idx="292">
                  <c:v>5.8230000000000004</c:v>
                </c:pt>
                <c:pt idx="293">
                  <c:v>5.75</c:v>
                </c:pt>
                <c:pt idx="294">
                  <c:v>5.649</c:v>
                </c:pt>
                <c:pt idx="295">
                  <c:v>5.5549999999999997</c:v>
                </c:pt>
                <c:pt idx="296">
                  <c:v>5.5</c:v>
                </c:pt>
                <c:pt idx="297">
                  <c:v>5.4969999999999999</c:v>
                </c:pt>
                <c:pt idx="298">
                  <c:v>5.3920000000000003</c:v>
                </c:pt>
                <c:pt idx="299">
                  <c:v>5.2969999999999997</c:v>
                </c:pt>
                <c:pt idx="300">
                  <c:v>5.2220000000000004</c:v>
                </c:pt>
                <c:pt idx="301">
                  <c:v>5.1100000000000003</c:v>
                </c:pt>
                <c:pt idx="302">
                  <c:v>5.048</c:v>
                </c:pt>
                <c:pt idx="303">
                  <c:v>5</c:v>
                </c:pt>
                <c:pt idx="304">
                  <c:v>4.96</c:v>
                </c:pt>
                <c:pt idx="305">
                  <c:v>4.8710000000000004</c:v>
                </c:pt>
                <c:pt idx="306">
                  <c:v>4.7869999999999999</c:v>
                </c:pt>
                <c:pt idx="307">
                  <c:v>4.7009999999999996</c:v>
                </c:pt>
                <c:pt idx="308">
                  <c:v>4.6269999999999998</c:v>
                </c:pt>
                <c:pt idx="309">
                  <c:v>4.5519999999999996</c:v>
                </c:pt>
                <c:pt idx="310">
                  <c:v>4.5</c:v>
                </c:pt>
                <c:pt idx="311">
                  <c:v>4.4690000000000003</c:v>
                </c:pt>
                <c:pt idx="312">
                  <c:v>4.3769999999999998</c:v>
                </c:pt>
                <c:pt idx="313">
                  <c:v>4.3170000000000002</c:v>
                </c:pt>
                <c:pt idx="314">
                  <c:v>4.202</c:v>
                </c:pt>
                <c:pt idx="315">
                  <c:v>4.0830000000000002</c:v>
                </c:pt>
                <c:pt idx="316">
                  <c:v>4.0049999999999999</c:v>
                </c:pt>
                <c:pt idx="317">
                  <c:v>4</c:v>
                </c:pt>
                <c:pt idx="318">
                  <c:v>3.952</c:v>
                </c:pt>
                <c:pt idx="319">
                  <c:v>3.8809999999999998</c:v>
                </c:pt>
                <c:pt idx="320">
                  <c:v>3.7890000000000001</c:v>
                </c:pt>
                <c:pt idx="321">
                  <c:v>3.7010000000000001</c:v>
                </c:pt>
                <c:pt idx="322">
                  <c:v>3.6080000000000001</c:v>
                </c:pt>
                <c:pt idx="323">
                  <c:v>3.548</c:v>
                </c:pt>
                <c:pt idx="324">
                  <c:v>3.5</c:v>
                </c:pt>
                <c:pt idx="325">
                  <c:v>3.452</c:v>
                </c:pt>
                <c:pt idx="326">
                  <c:v>3.3839999999999999</c:v>
                </c:pt>
                <c:pt idx="327">
                  <c:v>3.3279999999999998</c:v>
                </c:pt>
                <c:pt idx="328">
                  <c:v>3.254</c:v>
                </c:pt>
                <c:pt idx="329">
                  <c:v>3.1880000000000002</c:v>
                </c:pt>
                <c:pt idx="330">
                  <c:v>3.1440000000000001</c:v>
                </c:pt>
                <c:pt idx="331">
                  <c:v>3.0670000000000002</c:v>
                </c:pt>
                <c:pt idx="332">
                  <c:v>3</c:v>
                </c:pt>
                <c:pt idx="333">
                  <c:v>2.9860000000000002</c:v>
                </c:pt>
                <c:pt idx="334">
                  <c:v>2.9079999999999999</c:v>
                </c:pt>
                <c:pt idx="335">
                  <c:v>2.8340000000000001</c:v>
                </c:pt>
                <c:pt idx="336">
                  <c:v>2.7759999999999998</c:v>
                </c:pt>
                <c:pt idx="337">
                  <c:v>2.7069999999999999</c:v>
                </c:pt>
                <c:pt idx="338">
                  <c:v>2.6560000000000001</c:v>
                </c:pt>
                <c:pt idx="339">
                  <c:v>2.5939999999999999</c:v>
                </c:pt>
                <c:pt idx="340">
                  <c:v>2.5449999999999999</c:v>
                </c:pt>
                <c:pt idx="341">
                  <c:v>2.5</c:v>
                </c:pt>
                <c:pt idx="342">
                  <c:v>2.4740000000000002</c:v>
                </c:pt>
                <c:pt idx="343">
                  <c:v>2.419</c:v>
                </c:pt>
                <c:pt idx="344">
                  <c:v>2.343</c:v>
                </c:pt>
                <c:pt idx="345">
                  <c:v>2.27</c:v>
                </c:pt>
                <c:pt idx="346">
                  <c:v>2.2090000000000001</c:v>
                </c:pt>
                <c:pt idx="347">
                  <c:v>2.13</c:v>
                </c:pt>
                <c:pt idx="348">
                  <c:v>2.0720000000000001</c:v>
                </c:pt>
                <c:pt idx="349">
                  <c:v>2.0299999999999998</c:v>
                </c:pt>
                <c:pt idx="350">
                  <c:v>2</c:v>
                </c:pt>
                <c:pt idx="351">
                  <c:v>1.952</c:v>
                </c:pt>
                <c:pt idx="352">
                  <c:v>1.9119999999999999</c:v>
                </c:pt>
                <c:pt idx="353">
                  <c:v>1.8160000000000001</c:v>
                </c:pt>
                <c:pt idx="354">
                  <c:v>1.7509999999999999</c:v>
                </c:pt>
                <c:pt idx="355">
                  <c:v>1.7110000000000001</c:v>
                </c:pt>
                <c:pt idx="356">
                  <c:v>1.6639999999999999</c:v>
                </c:pt>
                <c:pt idx="357">
                  <c:v>1.615</c:v>
                </c:pt>
                <c:pt idx="358">
                  <c:v>1.5669999999999999</c:v>
                </c:pt>
                <c:pt idx="359">
                  <c:v>1.5</c:v>
                </c:pt>
                <c:pt idx="360">
                  <c:v>1.484</c:v>
                </c:pt>
                <c:pt idx="361">
                  <c:v>1.423</c:v>
                </c:pt>
                <c:pt idx="362">
                  <c:v>1.369</c:v>
                </c:pt>
                <c:pt idx="363">
                  <c:v>1.3140000000000001</c:v>
                </c:pt>
                <c:pt idx="364">
                  <c:v>1.2569999999999999</c:v>
                </c:pt>
                <c:pt idx="365">
                  <c:v>1.1910000000000001</c:v>
                </c:pt>
                <c:pt idx="366">
                  <c:v>1.1220000000000001</c:v>
                </c:pt>
                <c:pt idx="367">
                  <c:v>1.056</c:v>
                </c:pt>
                <c:pt idx="368">
                  <c:v>1</c:v>
                </c:pt>
                <c:pt idx="369">
                  <c:v>0.99199999999999999</c:v>
                </c:pt>
                <c:pt idx="370">
                  <c:v>0.95499999999999996</c:v>
                </c:pt>
                <c:pt idx="371">
                  <c:v>0.91300000000000003</c:v>
                </c:pt>
                <c:pt idx="372">
                  <c:v>0.85699999999999998</c:v>
                </c:pt>
                <c:pt idx="373">
                  <c:v>0.79300000000000004</c:v>
                </c:pt>
                <c:pt idx="374">
                  <c:v>0.73799999999999999</c:v>
                </c:pt>
                <c:pt idx="375">
                  <c:v>0.67</c:v>
                </c:pt>
                <c:pt idx="376">
                  <c:v>0.61699999999999999</c:v>
                </c:pt>
                <c:pt idx="377">
                  <c:v>0.56899999999999995</c:v>
                </c:pt>
                <c:pt idx="378">
                  <c:v>0.52400000000000002</c:v>
                </c:pt>
                <c:pt idx="379">
                  <c:v>0.5</c:v>
                </c:pt>
                <c:pt idx="380">
                  <c:v>0.46700000000000003</c:v>
                </c:pt>
                <c:pt idx="381">
                  <c:v>0.40899999999999997</c:v>
                </c:pt>
                <c:pt idx="382">
                  <c:v>0.36799999999999999</c:v>
                </c:pt>
                <c:pt idx="383">
                  <c:v>0.317</c:v>
                </c:pt>
                <c:pt idx="384">
                  <c:v>0.27200000000000002</c:v>
                </c:pt>
                <c:pt idx="385">
                  <c:v>0.23400000000000001</c:v>
                </c:pt>
                <c:pt idx="386">
                  <c:v>0.20200000000000001</c:v>
                </c:pt>
                <c:pt idx="387">
                  <c:v>0.161</c:v>
                </c:pt>
                <c:pt idx="388">
                  <c:v>0.13600000000000001</c:v>
                </c:pt>
                <c:pt idx="389">
                  <c:v>0.106</c:v>
                </c:pt>
                <c:pt idx="390">
                  <c:v>7.0999999999999994E-2</c:v>
                </c:pt>
                <c:pt idx="391">
                  <c:v>5.7000000000000002E-2</c:v>
                </c:pt>
                <c:pt idx="392">
                  <c:v>3.9E-2</c:v>
                </c:pt>
                <c:pt idx="393">
                  <c:v>2.8000000000000001E-2</c:v>
                </c:pt>
                <c:pt idx="394">
                  <c:v>1.9E-2</c:v>
                </c:pt>
                <c:pt idx="395">
                  <c:v>1.2E-2</c:v>
                </c:pt>
                <c:pt idx="396">
                  <c:v>0.01</c:v>
                </c:pt>
                <c:pt idx="397">
                  <c:v>5.0000000000000001E-3</c:v>
                </c:pt>
                <c:pt idx="398">
                  <c:v>3.0000000000000001E-3</c:v>
                </c:pt>
                <c:pt idx="399">
                  <c:v>2E-3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7EB-4971-BBB7-EC35B5F78EDB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I$411:$I$812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9000000000000001E-2</c:v>
                </c:pt>
                <c:pt idx="9">
                  <c:v>8.2000000000000003E-2</c:v>
                </c:pt>
                <c:pt idx="10">
                  <c:v>0.13400000000000001</c:v>
                </c:pt>
                <c:pt idx="11">
                  <c:v>0.187</c:v>
                </c:pt>
                <c:pt idx="12">
                  <c:v>0.24</c:v>
                </c:pt>
                <c:pt idx="13">
                  <c:v>0.29299999999999998</c:v>
                </c:pt>
                <c:pt idx="14">
                  <c:v>0.34599999999999997</c:v>
                </c:pt>
                <c:pt idx="15">
                  <c:v>0.39900000000000002</c:v>
                </c:pt>
                <c:pt idx="16">
                  <c:v>0.45100000000000001</c:v>
                </c:pt>
                <c:pt idx="17">
                  <c:v>0.504</c:v>
                </c:pt>
                <c:pt idx="18">
                  <c:v>0.55700000000000005</c:v>
                </c:pt>
                <c:pt idx="19">
                  <c:v>0.61</c:v>
                </c:pt>
                <c:pt idx="20">
                  <c:v>0.66300000000000003</c:v>
                </c:pt>
                <c:pt idx="21">
                  <c:v>0.71599999999999997</c:v>
                </c:pt>
                <c:pt idx="22">
                  <c:v>0.76900000000000002</c:v>
                </c:pt>
                <c:pt idx="23">
                  <c:v>0.82099999999999995</c:v>
                </c:pt>
                <c:pt idx="24">
                  <c:v>0.874</c:v>
                </c:pt>
                <c:pt idx="25">
                  <c:v>0.92700000000000005</c:v>
                </c:pt>
                <c:pt idx="26">
                  <c:v>0.98</c:v>
                </c:pt>
                <c:pt idx="27">
                  <c:v>1.0329999999999999</c:v>
                </c:pt>
                <c:pt idx="28">
                  <c:v>1.0860000000000001</c:v>
                </c:pt>
                <c:pt idx="29">
                  <c:v>1.1379999999999999</c:v>
                </c:pt>
                <c:pt idx="30">
                  <c:v>1.1910000000000001</c:v>
                </c:pt>
                <c:pt idx="31">
                  <c:v>1.24</c:v>
                </c:pt>
                <c:pt idx="32">
                  <c:v>1.2829999999999999</c:v>
                </c:pt>
                <c:pt idx="33">
                  <c:v>1.325</c:v>
                </c:pt>
                <c:pt idx="34">
                  <c:v>1.367</c:v>
                </c:pt>
                <c:pt idx="35">
                  <c:v>1.41</c:v>
                </c:pt>
                <c:pt idx="36">
                  <c:v>1.452</c:v>
                </c:pt>
                <c:pt idx="37">
                  <c:v>1.4950000000000001</c:v>
                </c:pt>
                <c:pt idx="38">
                  <c:v>1.5369999999999999</c:v>
                </c:pt>
                <c:pt idx="39">
                  <c:v>1.579</c:v>
                </c:pt>
                <c:pt idx="40">
                  <c:v>1.6220000000000001</c:v>
                </c:pt>
                <c:pt idx="41">
                  <c:v>1.6639999999999999</c:v>
                </c:pt>
                <c:pt idx="42">
                  <c:v>1.7070000000000001</c:v>
                </c:pt>
                <c:pt idx="43">
                  <c:v>1.7490000000000001</c:v>
                </c:pt>
                <c:pt idx="44">
                  <c:v>1.792</c:v>
                </c:pt>
                <c:pt idx="45">
                  <c:v>1.8340000000000001</c:v>
                </c:pt>
                <c:pt idx="46">
                  <c:v>1.8759999999999999</c:v>
                </c:pt>
                <c:pt idx="47">
                  <c:v>1.919</c:v>
                </c:pt>
                <c:pt idx="48">
                  <c:v>1.9610000000000001</c:v>
                </c:pt>
                <c:pt idx="49">
                  <c:v>2.004</c:v>
                </c:pt>
                <c:pt idx="50">
                  <c:v>2.0459999999999998</c:v>
                </c:pt>
                <c:pt idx="51">
                  <c:v>2.0880000000000001</c:v>
                </c:pt>
                <c:pt idx="52">
                  <c:v>2.1309999999999998</c:v>
                </c:pt>
                <c:pt idx="53">
                  <c:v>2.173</c:v>
                </c:pt>
                <c:pt idx="54">
                  <c:v>2.2160000000000002</c:v>
                </c:pt>
                <c:pt idx="55">
                  <c:v>2.258</c:v>
                </c:pt>
                <c:pt idx="56">
                  <c:v>2.3010000000000002</c:v>
                </c:pt>
                <c:pt idx="57">
                  <c:v>2.343</c:v>
                </c:pt>
                <c:pt idx="58">
                  <c:v>2.3849999999999998</c:v>
                </c:pt>
                <c:pt idx="59">
                  <c:v>2.4279999999999999</c:v>
                </c:pt>
                <c:pt idx="60">
                  <c:v>2.48</c:v>
                </c:pt>
                <c:pt idx="61">
                  <c:v>2.54</c:v>
                </c:pt>
                <c:pt idx="62">
                  <c:v>2.6</c:v>
                </c:pt>
                <c:pt idx="63">
                  <c:v>2.66</c:v>
                </c:pt>
                <c:pt idx="64">
                  <c:v>2.72</c:v>
                </c:pt>
                <c:pt idx="65">
                  <c:v>2.78</c:v>
                </c:pt>
                <c:pt idx="66">
                  <c:v>2.8410000000000002</c:v>
                </c:pt>
                <c:pt idx="67">
                  <c:v>2.9009999999999998</c:v>
                </c:pt>
                <c:pt idx="68">
                  <c:v>2.9609999999999999</c:v>
                </c:pt>
                <c:pt idx="69">
                  <c:v>3.0209999999999999</c:v>
                </c:pt>
                <c:pt idx="70">
                  <c:v>3.081</c:v>
                </c:pt>
                <c:pt idx="71">
                  <c:v>3.1419999999999999</c:v>
                </c:pt>
                <c:pt idx="72">
                  <c:v>3.202</c:v>
                </c:pt>
                <c:pt idx="73">
                  <c:v>3.262</c:v>
                </c:pt>
                <c:pt idx="74">
                  <c:v>3.3220000000000001</c:v>
                </c:pt>
                <c:pt idx="75">
                  <c:v>3.3820000000000001</c:v>
                </c:pt>
                <c:pt idx="76">
                  <c:v>3.4430000000000001</c:v>
                </c:pt>
                <c:pt idx="77">
                  <c:v>3.5030000000000001</c:v>
                </c:pt>
                <c:pt idx="78">
                  <c:v>3.5630000000000002</c:v>
                </c:pt>
                <c:pt idx="79">
                  <c:v>3.6230000000000002</c:v>
                </c:pt>
                <c:pt idx="80">
                  <c:v>3.6880000000000002</c:v>
                </c:pt>
                <c:pt idx="81">
                  <c:v>3.7730000000000001</c:v>
                </c:pt>
                <c:pt idx="82">
                  <c:v>3.8570000000000002</c:v>
                </c:pt>
                <c:pt idx="83">
                  <c:v>3.9420000000000002</c:v>
                </c:pt>
                <c:pt idx="84">
                  <c:v>4.0270000000000001</c:v>
                </c:pt>
                <c:pt idx="85">
                  <c:v>4.1109999999999998</c:v>
                </c:pt>
                <c:pt idx="86">
                  <c:v>4.1959999999999997</c:v>
                </c:pt>
                <c:pt idx="87">
                  <c:v>4.2809999999999997</c:v>
                </c:pt>
                <c:pt idx="88">
                  <c:v>4.3659999999999997</c:v>
                </c:pt>
                <c:pt idx="89">
                  <c:v>4.45</c:v>
                </c:pt>
                <c:pt idx="90">
                  <c:v>4.5350000000000001</c:v>
                </c:pt>
                <c:pt idx="91">
                  <c:v>4.62</c:v>
                </c:pt>
                <c:pt idx="92">
                  <c:v>4.7039999999999997</c:v>
                </c:pt>
                <c:pt idx="93">
                  <c:v>4.7889999999999997</c:v>
                </c:pt>
                <c:pt idx="94">
                  <c:v>4.8739999999999997</c:v>
                </c:pt>
                <c:pt idx="95">
                  <c:v>4.9779999999999998</c:v>
                </c:pt>
                <c:pt idx="96">
                  <c:v>5.0890000000000004</c:v>
                </c:pt>
                <c:pt idx="97">
                  <c:v>5.2</c:v>
                </c:pt>
                <c:pt idx="98">
                  <c:v>5.3109999999999999</c:v>
                </c:pt>
                <c:pt idx="99">
                  <c:v>5.4219999999999997</c:v>
                </c:pt>
                <c:pt idx="100">
                  <c:v>5.5330000000000004</c:v>
                </c:pt>
                <c:pt idx="101">
                  <c:v>5.6440000000000001</c:v>
                </c:pt>
                <c:pt idx="102">
                  <c:v>5.7549999999999999</c:v>
                </c:pt>
                <c:pt idx="103">
                  <c:v>5.8659999999999997</c:v>
                </c:pt>
                <c:pt idx="104">
                  <c:v>5.9770000000000003</c:v>
                </c:pt>
                <c:pt idx="105">
                  <c:v>6.0880000000000001</c:v>
                </c:pt>
                <c:pt idx="106">
                  <c:v>6.12</c:v>
                </c:pt>
                <c:pt idx="107">
                  <c:v>6.2270000000000003</c:v>
                </c:pt>
                <c:pt idx="108">
                  <c:v>6.3780000000000001</c:v>
                </c:pt>
                <c:pt idx="109">
                  <c:v>6.5289999999999999</c:v>
                </c:pt>
                <c:pt idx="110">
                  <c:v>6.68</c:v>
                </c:pt>
                <c:pt idx="111">
                  <c:v>6.8310000000000004</c:v>
                </c:pt>
                <c:pt idx="112">
                  <c:v>6.9820000000000002</c:v>
                </c:pt>
                <c:pt idx="113">
                  <c:v>7.1340000000000003</c:v>
                </c:pt>
                <c:pt idx="114">
                  <c:v>7.2850000000000001</c:v>
                </c:pt>
                <c:pt idx="115">
                  <c:v>7.4720000000000004</c:v>
                </c:pt>
                <c:pt idx="116">
                  <c:v>7.6820000000000004</c:v>
                </c:pt>
                <c:pt idx="117">
                  <c:v>7.8920000000000003</c:v>
                </c:pt>
                <c:pt idx="118">
                  <c:v>8.1029999999999998</c:v>
                </c:pt>
                <c:pt idx="119">
                  <c:v>8.3130000000000006</c:v>
                </c:pt>
                <c:pt idx="120">
                  <c:v>8.5239999999999991</c:v>
                </c:pt>
                <c:pt idx="121">
                  <c:v>8.7880000000000003</c:v>
                </c:pt>
                <c:pt idx="122">
                  <c:v>9.0660000000000007</c:v>
                </c:pt>
                <c:pt idx="123">
                  <c:v>9.3450000000000006</c:v>
                </c:pt>
                <c:pt idx="124">
                  <c:v>9.6240000000000006</c:v>
                </c:pt>
                <c:pt idx="125">
                  <c:v>9.9269999999999996</c:v>
                </c:pt>
                <c:pt idx="126">
                  <c:v>10.266999999999999</c:v>
                </c:pt>
                <c:pt idx="127">
                  <c:v>10.606999999999999</c:v>
                </c:pt>
                <c:pt idx="128">
                  <c:v>10.946999999999999</c:v>
                </c:pt>
                <c:pt idx="129">
                  <c:v>11.337999999999999</c:v>
                </c:pt>
                <c:pt idx="130">
                  <c:v>11.743</c:v>
                </c:pt>
                <c:pt idx="131">
                  <c:v>12.148</c:v>
                </c:pt>
                <c:pt idx="132">
                  <c:v>12.24</c:v>
                </c:pt>
                <c:pt idx="133">
                  <c:v>12.63</c:v>
                </c:pt>
                <c:pt idx="134">
                  <c:v>13.135</c:v>
                </c:pt>
                <c:pt idx="135">
                  <c:v>13.680999999999999</c:v>
                </c:pt>
                <c:pt idx="136">
                  <c:v>14.304</c:v>
                </c:pt>
                <c:pt idx="137">
                  <c:v>14.965</c:v>
                </c:pt>
                <c:pt idx="138">
                  <c:v>15.691000000000001</c:v>
                </c:pt>
                <c:pt idx="139">
                  <c:v>16.495999999999999</c:v>
                </c:pt>
                <c:pt idx="140">
                  <c:v>17.373000000000001</c:v>
                </c:pt>
                <c:pt idx="141">
                  <c:v>18.361000000000001</c:v>
                </c:pt>
                <c:pt idx="142">
                  <c:v>18.370999999999999</c:v>
                </c:pt>
                <c:pt idx="143">
                  <c:v>19.436</c:v>
                </c:pt>
                <c:pt idx="144">
                  <c:v>20.574000000000002</c:v>
                </c:pt>
                <c:pt idx="145">
                  <c:v>21.835999999999999</c:v>
                </c:pt>
                <c:pt idx="146">
                  <c:v>23.318999999999999</c:v>
                </c:pt>
                <c:pt idx="147">
                  <c:v>24.481000000000002</c:v>
                </c:pt>
                <c:pt idx="148">
                  <c:v>25.053999999999998</c:v>
                </c:pt>
                <c:pt idx="149">
                  <c:v>26.672999999999998</c:v>
                </c:pt>
                <c:pt idx="150">
                  <c:v>28.654</c:v>
                </c:pt>
                <c:pt idx="151">
                  <c:v>30.600999999999999</c:v>
                </c:pt>
                <c:pt idx="152">
                  <c:v>30.789000000000001</c:v>
                </c:pt>
                <c:pt idx="153">
                  <c:v>33.158000000000001</c:v>
                </c:pt>
                <c:pt idx="154">
                  <c:v>35.93</c:v>
                </c:pt>
                <c:pt idx="155">
                  <c:v>36.720999999999997</c:v>
                </c:pt>
                <c:pt idx="156">
                  <c:v>39.015000000000001</c:v>
                </c:pt>
                <c:pt idx="157">
                  <c:v>42.521999999999998</c:v>
                </c:pt>
                <c:pt idx="158">
                  <c:v>42.841999999999999</c:v>
                </c:pt>
                <c:pt idx="159">
                  <c:v>46.595999999999997</c:v>
                </c:pt>
                <c:pt idx="160">
                  <c:v>48.962000000000003</c:v>
                </c:pt>
                <c:pt idx="161">
                  <c:v>50.268999999999998</c:v>
                </c:pt>
                <c:pt idx="162">
                  <c:v>55.082000000000001</c:v>
                </c:pt>
                <c:pt idx="163">
                  <c:v>55.15</c:v>
                </c:pt>
                <c:pt idx="164">
                  <c:v>60.847000000000001</c:v>
                </c:pt>
                <c:pt idx="165">
                  <c:v>61.201999999999998</c:v>
                </c:pt>
                <c:pt idx="166">
                  <c:v>66.061999999999998</c:v>
                </c:pt>
                <c:pt idx="167">
                  <c:v>67.322999999999993</c:v>
                </c:pt>
                <c:pt idx="168">
                  <c:v>72.150999999999996</c:v>
                </c:pt>
                <c:pt idx="169">
                  <c:v>73.442999999999998</c:v>
                </c:pt>
                <c:pt idx="170">
                  <c:v>79.563000000000002</c:v>
                </c:pt>
                <c:pt idx="171">
                  <c:v>79.89</c:v>
                </c:pt>
                <c:pt idx="172">
                  <c:v>85.683000000000007</c:v>
                </c:pt>
                <c:pt idx="173">
                  <c:v>87.608000000000004</c:v>
                </c:pt>
                <c:pt idx="174">
                  <c:v>91.804000000000002</c:v>
                </c:pt>
                <c:pt idx="175">
                  <c:v>95.503</c:v>
                </c:pt>
                <c:pt idx="176">
                  <c:v>97.924000000000007</c:v>
                </c:pt>
                <c:pt idx="177">
                  <c:v>104.044</c:v>
                </c:pt>
                <c:pt idx="178">
                  <c:v>105.246</c:v>
                </c:pt>
                <c:pt idx="179">
                  <c:v>110.164</c:v>
                </c:pt>
                <c:pt idx="180">
                  <c:v>115.907</c:v>
                </c:pt>
                <c:pt idx="181">
                  <c:v>116.285</c:v>
                </c:pt>
                <c:pt idx="182">
                  <c:v>122.405</c:v>
                </c:pt>
                <c:pt idx="183">
                  <c:v>125.74299999999999</c:v>
                </c:pt>
                <c:pt idx="184">
                  <c:v>128.52500000000001</c:v>
                </c:pt>
                <c:pt idx="185">
                  <c:v>134.64500000000001</c:v>
                </c:pt>
                <c:pt idx="186">
                  <c:v>136.667</c:v>
                </c:pt>
                <c:pt idx="187">
                  <c:v>140.76599999999999</c:v>
                </c:pt>
                <c:pt idx="188">
                  <c:v>146.886</c:v>
                </c:pt>
                <c:pt idx="189">
                  <c:v>152.36500000000001</c:v>
                </c:pt>
                <c:pt idx="190">
                  <c:v>153.006</c:v>
                </c:pt>
                <c:pt idx="191">
                  <c:v>159.126</c:v>
                </c:pt>
                <c:pt idx="192">
                  <c:v>164.69900000000001</c:v>
                </c:pt>
                <c:pt idx="193">
                  <c:v>165.24600000000001</c:v>
                </c:pt>
                <c:pt idx="194">
                  <c:v>171.36699999999999</c:v>
                </c:pt>
                <c:pt idx="195">
                  <c:v>177.48699999999999</c:v>
                </c:pt>
                <c:pt idx="196">
                  <c:v>178.048</c:v>
                </c:pt>
                <c:pt idx="197">
                  <c:v>183.607</c:v>
                </c:pt>
                <c:pt idx="198">
                  <c:v>189.727</c:v>
                </c:pt>
                <c:pt idx="199">
                  <c:v>195.18100000000001</c:v>
                </c:pt>
                <c:pt idx="200">
                  <c:v>195.84800000000001</c:v>
                </c:pt>
                <c:pt idx="201">
                  <c:v>201.96799999999999</c:v>
                </c:pt>
                <c:pt idx="202">
                  <c:v>208.08799999999999</c:v>
                </c:pt>
                <c:pt idx="203">
                  <c:v>211.75399999999999</c:v>
                </c:pt>
                <c:pt idx="204">
                  <c:v>214.208</c:v>
                </c:pt>
                <c:pt idx="205">
                  <c:v>220.32900000000001</c:v>
                </c:pt>
                <c:pt idx="206">
                  <c:v>226.44900000000001</c:v>
                </c:pt>
                <c:pt idx="207">
                  <c:v>226.75299999999999</c:v>
                </c:pt>
                <c:pt idx="208">
                  <c:v>232.56899999999999</c:v>
                </c:pt>
                <c:pt idx="209">
                  <c:v>238.68899999999999</c:v>
                </c:pt>
                <c:pt idx="210">
                  <c:v>244.81</c:v>
                </c:pt>
                <c:pt idx="211">
                  <c:v>247.33099999999999</c:v>
                </c:pt>
                <c:pt idx="212">
                  <c:v>250.93</c:v>
                </c:pt>
                <c:pt idx="213">
                  <c:v>257.05</c:v>
                </c:pt>
                <c:pt idx="214">
                  <c:v>263.17</c:v>
                </c:pt>
                <c:pt idx="215">
                  <c:v>264.45299999999997</c:v>
                </c:pt>
                <c:pt idx="216">
                  <c:v>269.291</c:v>
                </c:pt>
                <c:pt idx="217">
                  <c:v>275.411</c:v>
                </c:pt>
                <c:pt idx="218">
                  <c:v>281.53100000000001</c:v>
                </c:pt>
                <c:pt idx="219">
                  <c:v>283.01799999999997</c:v>
                </c:pt>
                <c:pt idx="220">
                  <c:v>287.65100000000001</c:v>
                </c:pt>
                <c:pt idx="221">
                  <c:v>293.77199999999999</c:v>
                </c:pt>
                <c:pt idx="222">
                  <c:v>299.05900000000003</c:v>
                </c:pt>
                <c:pt idx="223">
                  <c:v>299.892</c:v>
                </c:pt>
                <c:pt idx="224">
                  <c:v>306.012</c:v>
                </c:pt>
                <c:pt idx="225">
                  <c:v>312.13200000000001</c:v>
                </c:pt>
                <c:pt idx="226">
                  <c:v>318.25299999999999</c:v>
                </c:pt>
                <c:pt idx="227">
                  <c:v>319.94799999999998</c:v>
                </c:pt>
                <c:pt idx="228">
                  <c:v>324.37299999999999</c:v>
                </c:pt>
                <c:pt idx="229">
                  <c:v>330.49299999999999</c:v>
                </c:pt>
                <c:pt idx="230">
                  <c:v>336.613</c:v>
                </c:pt>
                <c:pt idx="231">
                  <c:v>336.89</c:v>
                </c:pt>
                <c:pt idx="232">
                  <c:v>342.733</c:v>
                </c:pt>
                <c:pt idx="233">
                  <c:v>348.85399999999998</c:v>
                </c:pt>
                <c:pt idx="234">
                  <c:v>354.97399999999999</c:v>
                </c:pt>
                <c:pt idx="235">
                  <c:v>355.58199999999999</c:v>
                </c:pt>
                <c:pt idx="236">
                  <c:v>361.09399999999999</c:v>
                </c:pt>
                <c:pt idx="237">
                  <c:v>367.214</c:v>
                </c:pt>
                <c:pt idx="238">
                  <c:v>373.33499999999998</c:v>
                </c:pt>
                <c:pt idx="239">
                  <c:v>375.80200000000002</c:v>
                </c:pt>
                <c:pt idx="240">
                  <c:v>379.45499999999998</c:v>
                </c:pt>
                <c:pt idx="241">
                  <c:v>385.57499999999999</c:v>
                </c:pt>
                <c:pt idx="242">
                  <c:v>391.69499999999999</c:v>
                </c:pt>
                <c:pt idx="243">
                  <c:v>397.81599999999997</c:v>
                </c:pt>
                <c:pt idx="244">
                  <c:v>400.59300000000002</c:v>
                </c:pt>
                <c:pt idx="245">
                  <c:v>403.93599999999998</c:v>
                </c:pt>
                <c:pt idx="246">
                  <c:v>410.05599999999998</c:v>
                </c:pt>
                <c:pt idx="247">
                  <c:v>416.17599999999999</c:v>
                </c:pt>
                <c:pt idx="248">
                  <c:v>422.29700000000003</c:v>
                </c:pt>
                <c:pt idx="249">
                  <c:v>424.50799999999998</c:v>
                </c:pt>
                <c:pt idx="250">
                  <c:v>428.41699999999997</c:v>
                </c:pt>
                <c:pt idx="251">
                  <c:v>434.53699999999998</c:v>
                </c:pt>
                <c:pt idx="252">
                  <c:v>440.65699999999998</c:v>
                </c:pt>
                <c:pt idx="253">
                  <c:v>446.77800000000002</c:v>
                </c:pt>
                <c:pt idx="254">
                  <c:v>452.89800000000002</c:v>
                </c:pt>
                <c:pt idx="255">
                  <c:v>456.17899999999997</c:v>
                </c:pt>
                <c:pt idx="256">
                  <c:v>459.01799999999997</c:v>
                </c:pt>
                <c:pt idx="257">
                  <c:v>465.13799999999998</c:v>
                </c:pt>
                <c:pt idx="258">
                  <c:v>471.25900000000001</c:v>
                </c:pt>
                <c:pt idx="259">
                  <c:v>477.37900000000002</c:v>
                </c:pt>
                <c:pt idx="260">
                  <c:v>483.49900000000002</c:v>
                </c:pt>
                <c:pt idx="261">
                  <c:v>484.01100000000002</c:v>
                </c:pt>
                <c:pt idx="262">
                  <c:v>489.61900000000003</c:v>
                </c:pt>
                <c:pt idx="263">
                  <c:v>495.73899999999998</c:v>
                </c:pt>
                <c:pt idx="264">
                  <c:v>501.86</c:v>
                </c:pt>
                <c:pt idx="265">
                  <c:v>507.98</c:v>
                </c:pt>
                <c:pt idx="266">
                  <c:v>513.80200000000002</c:v>
                </c:pt>
                <c:pt idx="267">
                  <c:v>514.1</c:v>
                </c:pt>
                <c:pt idx="268">
                  <c:v>520.22</c:v>
                </c:pt>
                <c:pt idx="269">
                  <c:v>526.34100000000001</c:v>
                </c:pt>
                <c:pt idx="270">
                  <c:v>532.46100000000001</c:v>
                </c:pt>
                <c:pt idx="271">
                  <c:v>538.58100000000002</c:v>
                </c:pt>
                <c:pt idx="272">
                  <c:v>544.70100000000002</c:v>
                </c:pt>
                <c:pt idx="273">
                  <c:v>545.62400000000002</c:v>
                </c:pt>
                <c:pt idx="274">
                  <c:v>550.822</c:v>
                </c:pt>
                <c:pt idx="275">
                  <c:v>556.94200000000001</c:v>
                </c:pt>
                <c:pt idx="276">
                  <c:v>563.06200000000001</c:v>
                </c:pt>
                <c:pt idx="277">
                  <c:v>569.18200000000002</c:v>
                </c:pt>
                <c:pt idx="278">
                  <c:v>575.303</c:v>
                </c:pt>
                <c:pt idx="279">
                  <c:v>576.38300000000004</c:v>
                </c:pt>
                <c:pt idx="280">
                  <c:v>581.423</c:v>
                </c:pt>
                <c:pt idx="281">
                  <c:v>587.54300000000001</c:v>
                </c:pt>
                <c:pt idx="282">
                  <c:v>593.66300000000001</c:v>
                </c:pt>
                <c:pt idx="283">
                  <c:v>599.78399999999999</c:v>
                </c:pt>
                <c:pt idx="284">
                  <c:v>604.95699999999999</c:v>
                </c:pt>
                <c:pt idx="285">
                  <c:v>605.904</c:v>
                </c:pt>
                <c:pt idx="286">
                  <c:v>612.024</c:v>
                </c:pt>
                <c:pt idx="287">
                  <c:v>618.14400000000001</c:v>
                </c:pt>
                <c:pt idx="288">
                  <c:v>624.26499999999999</c:v>
                </c:pt>
                <c:pt idx="289">
                  <c:v>630.38499999999999</c:v>
                </c:pt>
                <c:pt idx="290">
                  <c:v>632.33199999999999</c:v>
                </c:pt>
                <c:pt idx="291">
                  <c:v>636.505</c:v>
                </c:pt>
                <c:pt idx="292">
                  <c:v>642.625</c:v>
                </c:pt>
                <c:pt idx="293">
                  <c:v>648.745</c:v>
                </c:pt>
                <c:pt idx="294">
                  <c:v>654.86599999999999</c:v>
                </c:pt>
                <c:pt idx="295">
                  <c:v>657.81399999999996</c:v>
                </c:pt>
                <c:pt idx="296">
                  <c:v>660.98599999999999</c:v>
                </c:pt>
                <c:pt idx="297">
                  <c:v>667.10599999999999</c:v>
                </c:pt>
                <c:pt idx="298">
                  <c:v>673.226</c:v>
                </c:pt>
                <c:pt idx="299">
                  <c:v>679.34699999999998</c:v>
                </c:pt>
                <c:pt idx="300">
                  <c:v>685.46699999999998</c:v>
                </c:pt>
                <c:pt idx="301">
                  <c:v>685.74</c:v>
                </c:pt>
                <c:pt idx="302">
                  <c:v>691.58699999999999</c:v>
                </c:pt>
                <c:pt idx="303">
                  <c:v>697.70699999999999</c:v>
                </c:pt>
                <c:pt idx="304">
                  <c:v>703.82799999999997</c:v>
                </c:pt>
                <c:pt idx="305">
                  <c:v>709.94799999999998</c:v>
                </c:pt>
                <c:pt idx="306">
                  <c:v>715.27599999999995</c:v>
                </c:pt>
                <c:pt idx="307">
                  <c:v>716.06799999999998</c:v>
                </c:pt>
                <c:pt idx="308">
                  <c:v>722.18799999999999</c:v>
                </c:pt>
                <c:pt idx="309">
                  <c:v>728.30899999999997</c:v>
                </c:pt>
                <c:pt idx="310">
                  <c:v>734.42899999999997</c:v>
                </c:pt>
                <c:pt idx="311">
                  <c:v>740.54899999999998</c:v>
                </c:pt>
                <c:pt idx="312">
                  <c:v>744.39800000000002</c:v>
                </c:pt>
                <c:pt idx="313">
                  <c:v>746.66899999999998</c:v>
                </c:pt>
                <c:pt idx="314">
                  <c:v>752.79</c:v>
                </c:pt>
                <c:pt idx="315">
                  <c:v>758.91</c:v>
                </c:pt>
                <c:pt idx="316">
                  <c:v>765.03</c:v>
                </c:pt>
                <c:pt idx="317">
                  <c:v>771.15</c:v>
                </c:pt>
                <c:pt idx="318">
                  <c:v>772.32</c:v>
                </c:pt>
                <c:pt idx="319">
                  <c:v>777.27099999999996</c:v>
                </c:pt>
                <c:pt idx="320">
                  <c:v>783.39099999999996</c:v>
                </c:pt>
                <c:pt idx="321">
                  <c:v>789.51099999999997</c:v>
                </c:pt>
                <c:pt idx="322">
                  <c:v>795.63099999999997</c:v>
                </c:pt>
                <c:pt idx="323">
                  <c:v>801.75199999999995</c:v>
                </c:pt>
                <c:pt idx="324">
                  <c:v>807.87199999999996</c:v>
                </c:pt>
                <c:pt idx="325">
                  <c:v>810.423</c:v>
                </c:pt>
                <c:pt idx="326">
                  <c:v>813.99199999999996</c:v>
                </c:pt>
                <c:pt idx="327">
                  <c:v>820.11199999999997</c:v>
                </c:pt>
                <c:pt idx="328">
                  <c:v>826.23199999999997</c:v>
                </c:pt>
                <c:pt idx="329">
                  <c:v>832.35299999999995</c:v>
                </c:pt>
                <c:pt idx="330">
                  <c:v>838.47299999999996</c:v>
                </c:pt>
                <c:pt idx="331">
                  <c:v>844.59299999999996</c:v>
                </c:pt>
                <c:pt idx="332">
                  <c:v>848.66499999999996</c:v>
                </c:pt>
                <c:pt idx="333">
                  <c:v>850.71299999999997</c:v>
                </c:pt>
                <c:pt idx="334">
                  <c:v>856.83399999999995</c:v>
                </c:pt>
                <c:pt idx="335">
                  <c:v>862.95399999999995</c:v>
                </c:pt>
                <c:pt idx="336">
                  <c:v>869.07399999999996</c:v>
                </c:pt>
                <c:pt idx="337">
                  <c:v>875.19399999999996</c:v>
                </c:pt>
                <c:pt idx="338">
                  <c:v>881.31500000000005</c:v>
                </c:pt>
                <c:pt idx="339">
                  <c:v>884.62300000000005</c:v>
                </c:pt>
                <c:pt idx="340">
                  <c:v>887.43499999999995</c:v>
                </c:pt>
                <c:pt idx="341">
                  <c:v>893.55499999999995</c:v>
                </c:pt>
                <c:pt idx="342">
                  <c:v>899.67499999999995</c:v>
                </c:pt>
                <c:pt idx="343">
                  <c:v>905.79600000000005</c:v>
                </c:pt>
                <c:pt idx="344">
                  <c:v>911.91600000000005</c:v>
                </c:pt>
                <c:pt idx="345">
                  <c:v>918.03599999999994</c:v>
                </c:pt>
                <c:pt idx="346">
                  <c:v>924.15599999999995</c:v>
                </c:pt>
                <c:pt idx="347">
                  <c:v>927.82100000000003</c:v>
                </c:pt>
                <c:pt idx="348">
                  <c:v>930.27700000000004</c:v>
                </c:pt>
                <c:pt idx="349">
                  <c:v>936.39700000000005</c:v>
                </c:pt>
                <c:pt idx="350">
                  <c:v>942.51700000000005</c:v>
                </c:pt>
                <c:pt idx="351">
                  <c:v>948.63699999999994</c:v>
                </c:pt>
                <c:pt idx="352">
                  <c:v>954.75800000000004</c:v>
                </c:pt>
                <c:pt idx="353">
                  <c:v>960.87800000000004</c:v>
                </c:pt>
                <c:pt idx="354">
                  <c:v>966.99800000000005</c:v>
                </c:pt>
                <c:pt idx="355">
                  <c:v>973.11800000000005</c:v>
                </c:pt>
                <c:pt idx="356">
                  <c:v>973.96199999999999</c:v>
                </c:pt>
                <c:pt idx="357">
                  <c:v>979.23800000000006</c:v>
                </c:pt>
                <c:pt idx="358">
                  <c:v>985.35900000000004</c:v>
                </c:pt>
                <c:pt idx="359">
                  <c:v>991.47900000000004</c:v>
                </c:pt>
                <c:pt idx="360">
                  <c:v>997.59900000000005</c:v>
                </c:pt>
                <c:pt idx="361">
                  <c:v>1003.7190000000001</c:v>
                </c:pt>
                <c:pt idx="362">
                  <c:v>1009.84</c:v>
                </c:pt>
                <c:pt idx="363">
                  <c:v>1015.725</c:v>
                </c:pt>
                <c:pt idx="364">
                  <c:v>1015.96</c:v>
                </c:pt>
                <c:pt idx="365">
                  <c:v>1022.08</c:v>
                </c:pt>
                <c:pt idx="366">
                  <c:v>1028.2</c:v>
                </c:pt>
                <c:pt idx="367">
                  <c:v>1034.3209999999999</c:v>
                </c:pt>
                <c:pt idx="368">
                  <c:v>1040.441</c:v>
                </c:pt>
                <c:pt idx="369">
                  <c:v>1046.5609999999999</c:v>
                </c:pt>
                <c:pt idx="370">
                  <c:v>1052.681</c:v>
                </c:pt>
                <c:pt idx="371">
                  <c:v>1058.8019999999999</c:v>
                </c:pt>
                <c:pt idx="372">
                  <c:v>1063.3689999999999</c:v>
                </c:pt>
                <c:pt idx="373">
                  <c:v>1064.922</c:v>
                </c:pt>
                <c:pt idx="374">
                  <c:v>1071.0419999999999</c:v>
                </c:pt>
                <c:pt idx="375">
                  <c:v>1077.162</c:v>
                </c:pt>
                <c:pt idx="376">
                  <c:v>1083.2829999999999</c:v>
                </c:pt>
                <c:pt idx="377">
                  <c:v>1089.403</c:v>
                </c:pt>
                <c:pt idx="378">
                  <c:v>1095.5229999999999</c:v>
                </c:pt>
                <c:pt idx="379">
                  <c:v>1101.643</c:v>
                </c:pt>
                <c:pt idx="380">
                  <c:v>1107.7639999999999</c:v>
                </c:pt>
                <c:pt idx="381">
                  <c:v>1113.884</c:v>
                </c:pt>
                <c:pt idx="382">
                  <c:v>1115.241</c:v>
                </c:pt>
                <c:pt idx="383">
                  <c:v>1120.0039999999999</c:v>
                </c:pt>
                <c:pt idx="384">
                  <c:v>1126.124</c:v>
                </c:pt>
                <c:pt idx="385">
                  <c:v>1132.2439999999999</c:v>
                </c:pt>
                <c:pt idx="386">
                  <c:v>1138.365</c:v>
                </c:pt>
                <c:pt idx="387">
                  <c:v>1144.4849999999999</c:v>
                </c:pt>
                <c:pt idx="388">
                  <c:v>1150.605</c:v>
                </c:pt>
                <c:pt idx="389">
                  <c:v>1156.7249999999999</c:v>
                </c:pt>
                <c:pt idx="390">
                  <c:v>1162.846</c:v>
                </c:pt>
                <c:pt idx="391">
                  <c:v>1168.9659999999999</c:v>
                </c:pt>
                <c:pt idx="392">
                  <c:v>1175.086</c:v>
                </c:pt>
                <c:pt idx="393">
                  <c:v>1181.2059999999999</c:v>
                </c:pt>
                <c:pt idx="394">
                  <c:v>1187.327</c:v>
                </c:pt>
                <c:pt idx="395">
                  <c:v>1193.4469999999999</c:v>
                </c:pt>
                <c:pt idx="396">
                  <c:v>1199.567</c:v>
                </c:pt>
                <c:pt idx="397">
                  <c:v>1205.6869999999999</c:v>
                </c:pt>
                <c:pt idx="398">
                  <c:v>1211.808</c:v>
                </c:pt>
                <c:pt idx="399">
                  <c:v>1217.9280000000001</c:v>
                </c:pt>
                <c:pt idx="400">
                  <c:v>1224.048</c:v>
                </c:pt>
                <c:pt idx="401">
                  <c:v>1224.048</c:v>
                </c:pt>
              </c:numCache>
            </c:numRef>
          </c:xVal>
          <c:yVal>
            <c:numRef>
              <c:f>Foglio6!$J$411:$J$812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853000000000002</c:v>
                </c:pt>
                <c:pt idx="107">
                  <c:v>47.5</c:v>
                </c:pt>
                <c:pt idx="108">
                  <c:v>47</c:v>
                </c:pt>
                <c:pt idx="109">
                  <c:v>46.5</c:v>
                </c:pt>
                <c:pt idx="110">
                  <c:v>46</c:v>
                </c:pt>
                <c:pt idx="111">
                  <c:v>45.5</c:v>
                </c:pt>
                <c:pt idx="112">
                  <c:v>45</c:v>
                </c:pt>
                <c:pt idx="113">
                  <c:v>44.5</c:v>
                </c:pt>
                <c:pt idx="114">
                  <c:v>44</c:v>
                </c:pt>
                <c:pt idx="115">
                  <c:v>43.5</c:v>
                </c:pt>
                <c:pt idx="116">
                  <c:v>43</c:v>
                </c:pt>
                <c:pt idx="117">
                  <c:v>42.5</c:v>
                </c:pt>
                <c:pt idx="118">
                  <c:v>42</c:v>
                </c:pt>
                <c:pt idx="119">
                  <c:v>41.5</c:v>
                </c:pt>
                <c:pt idx="120">
                  <c:v>41</c:v>
                </c:pt>
                <c:pt idx="121">
                  <c:v>40.5</c:v>
                </c:pt>
                <c:pt idx="122">
                  <c:v>40</c:v>
                </c:pt>
                <c:pt idx="123">
                  <c:v>39.5</c:v>
                </c:pt>
                <c:pt idx="124">
                  <c:v>39</c:v>
                </c:pt>
                <c:pt idx="125">
                  <c:v>38.5</c:v>
                </c:pt>
                <c:pt idx="126">
                  <c:v>38</c:v>
                </c:pt>
                <c:pt idx="127">
                  <c:v>37.5</c:v>
                </c:pt>
                <c:pt idx="128">
                  <c:v>37</c:v>
                </c:pt>
                <c:pt idx="129">
                  <c:v>36.5</c:v>
                </c:pt>
                <c:pt idx="130">
                  <c:v>36</c:v>
                </c:pt>
                <c:pt idx="131">
                  <c:v>35.5</c:v>
                </c:pt>
                <c:pt idx="132">
                  <c:v>35.386000000000003</c:v>
                </c:pt>
                <c:pt idx="133">
                  <c:v>35</c:v>
                </c:pt>
                <c:pt idx="134">
                  <c:v>34.5</c:v>
                </c:pt>
                <c:pt idx="135">
                  <c:v>34</c:v>
                </c:pt>
                <c:pt idx="136">
                  <c:v>33.5</c:v>
                </c:pt>
                <c:pt idx="137">
                  <c:v>33</c:v>
                </c:pt>
                <c:pt idx="138">
                  <c:v>32.5</c:v>
                </c:pt>
                <c:pt idx="139">
                  <c:v>32</c:v>
                </c:pt>
                <c:pt idx="140">
                  <c:v>31.5</c:v>
                </c:pt>
                <c:pt idx="141">
                  <c:v>31.004999999999999</c:v>
                </c:pt>
                <c:pt idx="142">
                  <c:v>31</c:v>
                </c:pt>
                <c:pt idx="143">
                  <c:v>30.5</c:v>
                </c:pt>
                <c:pt idx="144">
                  <c:v>30</c:v>
                </c:pt>
                <c:pt idx="145">
                  <c:v>29.5</c:v>
                </c:pt>
                <c:pt idx="146">
                  <c:v>29</c:v>
                </c:pt>
                <c:pt idx="147">
                  <c:v>28.673999999999999</c:v>
                </c:pt>
                <c:pt idx="148">
                  <c:v>28.5</c:v>
                </c:pt>
                <c:pt idx="149">
                  <c:v>28</c:v>
                </c:pt>
                <c:pt idx="150">
                  <c:v>27.5</c:v>
                </c:pt>
                <c:pt idx="151">
                  <c:v>27.041</c:v>
                </c:pt>
                <c:pt idx="152">
                  <c:v>27</c:v>
                </c:pt>
                <c:pt idx="153">
                  <c:v>26.5</c:v>
                </c:pt>
                <c:pt idx="154">
                  <c:v>26</c:v>
                </c:pt>
                <c:pt idx="155">
                  <c:v>25.861999999999998</c:v>
                </c:pt>
                <c:pt idx="156">
                  <c:v>25.5</c:v>
                </c:pt>
                <c:pt idx="157">
                  <c:v>25</c:v>
                </c:pt>
                <c:pt idx="158">
                  <c:v>24.952000000000002</c:v>
                </c:pt>
                <c:pt idx="159">
                  <c:v>24.5</c:v>
                </c:pt>
                <c:pt idx="160">
                  <c:v>24.152999999999999</c:v>
                </c:pt>
                <c:pt idx="161">
                  <c:v>24</c:v>
                </c:pt>
                <c:pt idx="162">
                  <c:v>23.506</c:v>
                </c:pt>
                <c:pt idx="163">
                  <c:v>23.5</c:v>
                </c:pt>
                <c:pt idx="164">
                  <c:v>23</c:v>
                </c:pt>
                <c:pt idx="165">
                  <c:v>22.963999999999999</c:v>
                </c:pt>
                <c:pt idx="166">
                  <c:v>22.5</c:v>
                </c:pt>
                <c:pt idx="167">
                  <c:v>22.384</c:v>
                </c:pt>
                <c:pt idx="168">
                  <c:v>22</c:v>
                </c:pt>
                <c:pt idx="169">
                  <c:v>21.911999999999999</c:v>
                </c:pt>
                <c:pt idx="170">
                  <c:v>21.518999999999998</c:v>
                </c:pt>
                <c:pt idx="171">
                  <c:v>21.5</c:v>
                </c:pt>
                <c:pt idx="172">
                  <c:v>21.146999999999998</c:v>
                </c:pt>
                <c:pt idx="173">
                  <c:v>21</c:v>
                </c:pt>
                <c:pt idx="174">
                  <c:v>20.686</c:v>
                </c:pt>
                <c:pt idx="175">
                  <c:v>20.5</c:v>
                </c:pt>
                <c:pt idx="176">
                  <c:v>20.34</c:v>
                </c:pt>
                <c:pt idx="177">
                  <c:v>20.065000000000001</c:v>
                </c:pt>
                <c:pt idx="178">
                  <c:v>20</c:v>
                </c:pt>
                <c:pt idx="179">
                  <c:v>19.763999999999999</c:v>
                </c:pt>
                <c:pt idx="180">
                  <c:v>19.5</c:v>
                </c:pt>
                <c:pt idx="181">
                  <c:v>19.481999999999999</c:v>
                </c:pt>
                <c:pt idx="182">
                  <c:v>19.190000000000001</c:v>
                </c:pt>
                <c:pt idx="183">
                  <c:v>19</c:v>
                </c:pt>
                <c:pt idx="184">
                  <c:v>18.827000000000002</c:v>
                </c:pt>
                <c:pt idx="185">
                  <c:v>18.576000000000001</c:v>
                </c:pt>
                <c:pt idx="186">
                  <c:v>18.5</c:v>
                </c:pt>
                <c:pt idx="187">
                  <c:v>18.364000000000001</c:v>
                </c:pt>
                <c:pt idx="188">
                  <c:v>18.172999999999998</c:v>
                </c:pt>
                <c:pt idx="189">
                  <c:v>18</c:v>
                </c:pt>
                <c:pt idx="190">
                  <c:v>17.972999999999999</c:v>
                </c:pt>
                <c:pt idx="191">
                  <c:v>17.709</c:v>
                </c:pt>
                <c:pt idx="192">
                  <c:v>17.5</c:v>
                </c:pt>
                <c:pt idx="193">
                  <c:v>17.478999999999999</c:v>
                </c:pt>
                <c:pt idx="194">
                  <c:v>17.234999999999999</c:v>
                </c:pt>
                <c:pt idx="195">
                  <c:v>17.015999999999998</c:v>
                </c:pt>
                <c:pt idx="196">
                  <c:v>17</c:v>
                </c:pt>
                <c:pt idx="197">
                  <c:v>16.829000000000001</c:v>
                </c:pt>
                <c:pt idx="198">
                  <c:v>16.664000000000001</c:v>
                </c:pt>
                <c:pt idx="199">
                  <c:v>16.5</c:v>
                </c:pt>
                <c:pt idx="200">
                  <c:v>16.475000000000001</c:v>
                </c:pt>
                <c:pt idx="201">
                  <c:v>16.28</c:v>
                </c:pt>
                <c:pt idx="202">
                  <c:v>16.117000000000001</c:v>
                </c:pt>
                <c:pt idx="203">
                  <c:v>16</c:v>
                </c:pt>
                <c:pt idx="204">
                  <c:v>15.906000000000001</c:v>
                </c:pt>
                <c:pt idx="205">
                  <c:v>15.696999999999999</c:v>
                </c:pt>
                <c:pt idx="206">
                  <c:v>15.509</c:v>
                </c:pt>
                <c:pt idx="207">
                  <c:v>15.5</c:v>
                </c:pt>
                <c:pt idx="208">
                  <c:v>15.352</c:v>
                </c:pt>
                <c:pt idx="209">
                  <c:v>15.195</c:v>
                </c:pt>
                <c:pt idx="210">
                  <c:v>15.061999999999999</c:v>
                </c:pt>
                <c:pt idx="211">
                  <c:v>15</c:v>
                </c:pt>
                <c:pt idx="212">
                  <c:v>14.913</c:v>
                </c:pt>
                <c:pt idx="213">
                  <c:v>14.724</c:v>
                </c:pt>
                <c:pt idx="214">
                  <c:v>14.551</c:v>
                </c:pt>
                <c:pt idx="215">
                  <c:v>14.5</c:v>
                </c:pt>
                <c:pt idx="216">
                  <c:v>14.377000000000001</c:v>
                </c:pt>
                <c:pt idx="217">
                  <c:v>14.198</c:v>
                </c:pt>
                <c:pt idx="218">
                  <c:v>14.042999999999999</c:v>
                </c:pt>
                <c:pt idx="219">
                  <c:v>14</c:v>
                </c:pt>
                <c:pt idx="220">
                  <c:v>13.869</c:v>
                </c:pt>
                <c:pt idx="221">
                  <c:v>13.654999999999999</c:v>
                </c:pt>
                <c:pt idx="222">
                  <c:v>13.5</c:v>
                </c:pt>
                <c:pt idx="223">
                  <c:v>13.477</c:v>
                </c:pt>
                <c:pt idx="224">
                  <c:v>13.35</c:v>
                </c:pt>
                <c:pt idx="225">
                  <c:v>13.209</c:v>
                </c:pt>
                <c:pt idx="226">
                  <c:v>13.038</c:v>
                </c:pt>
                <c:pt idx="227">
                  <c:v>13</c:v>
                </c:pt>
                <c:pt idx="228">
                  <c:v>12.87</c:v>
                </c:pt>
                <c:pt idx="229">
                  <c:v>12.673999999999999</c:v>
                </c:pt>
                <c:pt idx="230">
                  <c:v>12.506</c:v>
                </c:pt>
                <c:pt idx="231">
                  <c:v>12.5</c:v>
                </c:pt>
                <c:pt idx="232">
                  <c:v>12.342000000000001</c:v>
                </c:pt>
                <c:pt idx="233">
                  <c:v>12.189</c:v>
                </c:pt>
                <c:pt idx="234">
                  <c:v>12.018000000000001</c:v>
                </c:pt>
                <c:pt idx="235">
                  <c:v>12</c:v>
                </c:pt>
                <c:pt idx="236">
                  <c:v>11.856999999999999</c:v>
                </c:pt>
                <c:pt idx="237">
                  <c:v>11.707000000000001</c:v>
                </c:pt>
                <c:pt idx="238">
                  <c:v>11.551</c:v>
                </c:pt>
                <c:pt idx="239">
                  <c:v>11.5</c:v>
                </c:pt>
                <c:pt idx="240">
                  <c:v>11.436</c:v>
                </c:pt>
                <c:pt idx="241">
                  <c:v>11.32</c:v>
                </c:pt>
                <c:pt idx="242">
                  <c:v>11.192</c:v>
                </c:pt>
                <c:pt idx="243">
                  <c:v>11.071</c:v>
                </c:pt>
                <c:pt idx="244">
                  <c:v>11</c:v>
                </c:pt>
                <c:pt idx="245">
                  <c:v>10.949</c:v>
                </c:pt>
                <c:pt idx="246">
                  <c:v>10.827</c:v>
                </c:pt>
                <c:pt idx="247">
                  <c:v>10.692</c:v>
                </c:pt>
                <c:pt idx="248">
                  <c:v>10.552</c:v>
                </c:pt>
                <c:pt idx="249">
                  <c:v>10.5</c:v>
                </c:pt>
                <c:pt idx="250">
                  <c:v>10.444000000000001</c:v>
                </c:pt>
                <c:pt idx="251">
                  <c:v>10.353999999999999</c:v>
                </c:pt>
                <c:pt idx="252">
                  <c:v>10.262</c:v>
                </c:pt>
                <c:pt idx="253">
                  <c:v>10.167</c:v>
                </c:pt>
                <c:pt idx="254">
                  <c:v>10.053000000000001</c:v>
                </c:pt>
                <c:pt idx="255">
                  <c:v>10</c:v>
                </c:pt>
                <c:pt idx="256">
                  <c:v>9.9629999999999992</c:v>
                </c:pt>
                <c:pt idx="257">
                  <c:v>9.8650000000000002</c:v>
                </c:pt>
                <c:pt idx="258">
                  <c:v>9.7390000000000008</c:v>
                </c:pt>
                <c:pt idx="259">
                  <c:v>9.6289999999999996</c:v>
                </c:pt>
                <c:pt idx="260">
                  <c:v>9.5090000000000003</c:v>
                </c:pt>
                <c:pt idx="261">
                  <c:v>9.5</c:v>
                </c:pt>
                <c:pt idx="262">
                  <c:v>9.3879999999999999</c:v>
                </c:pt>
                <c:pt idx="263">
                  <c:v>9.2929999999999993</c:v>
                </c:pt>
                <c:pt idx="264">
                  <c:v>9.1809999999999992</c:v>
                </c:pt>
                <c:pt idx="265">
                  <c:v>9.0749999999999993</c:v>
                </c:pt>
                <c:pt idx="266">
                  <c:v>9</c:v>
                </c:pt>
                <c:pt idx="267">
                  <c:v>8.9949999999999992</c:v>
                </c:pt>
                <c:pt idx="268">
                  <c:v>8.8940000000000001</c:v>
                </c:pt>
                <c:pt idx="269">
                  <c:v>8.8030000000000008</c:v>
                </c:pt>
                <c:pt idx="270">
                  <c:v>8.6940000000000008</c:v>
                </c:pt>
                <c:pt idx="271">
                  <c:v>8.5909999999999993</c:v>
                </c:pt>
                <c:pt idx="272">
                  <c:v>8.5129999999999999</c:v>
                </c:pt>
                <c:pt idx="273">
                  <c:v>8.5</c:v>
                </c:pt>
                <c:pt idx="274">
                  <c:v>8.4030000000000005</c:v>
                </c:pt>
                <c:pt idx="275">
                  <c:v>8.2880000000000003</c:v>
                </c:pt>
                <c:pt idx="276">
                  <c:v>8.1999999999999993</c:v>
                </c:pt>
                <c:pt idx="277">
                  <c:v>8.1159999999999997</c:v>
                </c:pt>
                <c:pt idx="278">
                  <c:v>8.0220000000000002</c:v>
                </c:pt>
                <c:pt idx="279">
                  <c:v>8</c:v>
                </c:pt>
                <c:pt idx="280">
                  <c:v>7.9219999999999997</c:v>
                </c:pt>
                <c:pt idx="281">
                  <c:v>7.7990000000000004</c:v>
                </c:pt>
                <c:pt idx="282">
                  <c:v>7.6980000000000004</c:v>
                </c:pt>
                <c:pt idx="283">
                  <c:v>7.6079999999999997</c:v>
                </c:pt>
                <c:pt idx="284">
                  <c:v>7.5</c:v>
                </c:pt>
                <c:pt idx="285">
                  <c:v>7.4829999999999997</c:v>
                </c:pt>
                <c:pt idx="286">
                  <c:v>7.3920000000000003</c:v>
                </c:pt>
                <c:pt idx="287">
                  <c:v>7.2670000000000003</c:v>
                </c:pt>
                <c:pt idx="288">
                  <c:v>7.1529999999999996</c:v>
                </c:pt>
                <c:pt idx="289">
                  <c:v>7.0389999999999997</c:v>
                </c:pt>
                <c:pt idx="290">
                  <c:v>7</c:v>
                </c:pt>
                <c:pt idx="291">
                  <c:v>6.9240000000000004</c:v>
                </c:pt>
                <c:pt idx="292">
                  <c:v>6.7720000000000002</c:v>
                </c:pt>
                <c:pt idx="293">
                  <c:v>6.6479999999999997</c:v>
                </c:pt>
                <c:pt idx="294">
                  <c:v>6.5490000000000004</c:v>
                </c:pt>
                <c:pt idx="295">
                  <c:v>6.5</c:v>
                </c:pt>
                <c:pt idx="296">
                  <c:v>6.4489999999999998</c:v>
                </c:pt>
                <c:pt idx="297">
                  <c:v>6.3360000000000003</c:v>
                </c:pt>
                <c:pt idx="298">
                  <c:v>6.242</c:v>
                </c:pt>
                <c:pt idx="299">
                  <c:v>6.1120000000000001</c:v>
                </c:pt>
                <c:pt idx="300">
                  <c:v>6.0039999999999996</c:v>
                </c:pt>
                <c:pt idx="301">
                  <c:v>6</c:v>
                </c:pt>
                <c:pt idx="302">
                  <c:v>5.8979999999999997</c:v>
                </c:pt>
                <c:pt idx="303">
                  <c:v>5.7729999999999997</c:v>
                </c:pt>
                <c:pt idx="304">
                  <c:v>5.7030000000000003</c:v>
                </c:pt>
                <c:pt idx="305">
                  <c:v>5.6150000000000002</c:v>
                </c:pt>
                <c:pt idx="306">
                  <c:v>5.5</c:v>
                </c:pt>
                <c:pt idx="307">
                  <c:v>5.4829999999999997</c:v>
                </c:pt>
                <c:pt idx="308">
                  <c:v>5.3810000000000002</c:v>
                </c:pt>
                <c:pt idx="309">
                  <c:v>5.2779999999999996</c:v>
                </c:pt>
                <c:pt idx="310">
                  <c:v>5.1630000000000003</c:v>
                </c:pt>
                <c:pt idx="311">
                  <c:v>5.0590000000000002</c:v>
                </c:pt>
                <c:pt idx="312">
                  <c:v>5</c:v>
                </c:pt>
                <c:pt idx="313">
                  <c:v>4.9429999999999996</c:v>
                </c:pt>
                <c:pt idx="314">
                  <c:v>4.8650000000000002</c:v>
                </c:pt>
                <c:pt idx="315">
                  <c:v>4.7530000000000001</c:v>
                </c:pt>
                <c:pt idx="316">
                  <c:v>4.6349999999999998</c:v>
                </c:pt>
                <c:pt idx="317">
                  <c:v>4.5259999999999998</c:v>
                </c:pt>
                <c:pt idx="318">
                  <c:v>4.5</c:v>
                </c:pt>
                <c:pt idx="319">
                  <c:v>4.4130000000000003</c:v>
                </c:pt>
                <c:pt idx="320">
                  <c:v>4.3479999999999999</c:v>
                </c:pt>
                <c:pt idx="321">
                  <c:v>4.2939999999999996</c:v>
                </c:pt>
                <c:pt idx="322">
                  <c:v>4.2210000000000001</c:v>
                </c:pt>
                <c:pt idx="323">
                  <c:v>4.1319999999999997</c:v>
                </c:pt>
                <c:pt idx="324">
                  <c:v>4.0460000000000003</c:v>
                </c:pt>
                <c:pt idx="325">
                  <c:v>4</c:v>
                </c:pt>
                <c:pt idx="326">
                  <c:v>3.9390000000000001</c:v>
                </c:pt>
                <c:pt idx="327">
                  <c:v>3.8690000000000002</c:v>
                </c:pt>
                <c:pt idx="328">
                  <c:v>3.8</c:v>
                </c:pt>
                <c:pt idx="329">
                  <c:v>3.734</c:v>
                </c:pt>
                <c:pt idx="330">
                  <c:v>3.6339999999999999</c:v>
                </c:pt>
                <c:pt idx="331">
                  <c:v>3.552</c:v>
                </c:pt>
                <c:pt idx="332">
                  <c:v>3.5</c:v>
                </c:pt>
                <c:pt idx="333">
                  <c:v>3.468</c:v>
                </c:pt>
                <c:pt idx="334">
                  <c:v>3.3919999999999999</c:v>
                </c:pt>
                <c:pt idx="335">
                  <c:v>3.3</c:v>
                </c:pt>
                <c:pt idx="336">
                  <c:v>3.2280000000000002</c:v>
                </c:pt>
                <c:pt idx="337">
                  <c:v>3.1309999999999998</c:v>
                </c:pt>
                <c:pt idx="338">
                  <c:v>3.0550000000000002</c:v>
                </c:pt>
                <c:pt idx="339">
                  <c:v>3</c:v>
                </c:pt>
                <c:pt idx="340">
                  <c:v>2.968</c:v>
                </c:pt>
                <c:pt idx="341">
                  <c:v>2.9020000000000001</c:v>
                </c:pt>
                <c:pt idx="342">
                  <c:v>2.83</c:v>
                </c:pt>
                <c:pt idx="343">
                  <c:v>2.75</c:v>
                </c:pt>
                <c:pt idx="344">
                  <c:v>2.6850000000000001</c:v>
                </c:pt>
                <c:pt idx="345">
                  <c:v>2.6179999999999999</c:v>
                </c:pt>
                <c:pt idx="346">
                  <c:v>2.5470000000000002</c:v>
                </c:pt>
                <c:pt idx="347">
                  <c:v>2.5</c:v>
                </c:pt>
                <c:pt idx="348">
                  <c:v>2.4750000000000001</c:v>
                </c:pt>
                <c:pt idx="349">
                  <c:v>2.3839999999999999</c:v>
                </c:pt>
                <c:pt idx="350">
                  <c:v>2.339</c:v>
                </c:pt>
                <c:pt idx="351">
                  <c:v>2.2690000000000001</c:v>
                </c:pt>
                <c:pt idx="352">
                  <c:v>2.1970000000000001</c:v>
                </c:pt>
                <c:pt idx="353">
                  <c:v>2.1280000000000001</c:v>
                </c:pt>
                <c:pt idx="354">
                  <c:v>2.077</c:v>
                </c:pt>
                <c:pt idx="355">
                  <c:v>2.0139999999999998</c:v>
                </c:pt>
                <c:pt idx="356">
                  <c:v>2</c:v>
                </c:pt>
                <c:pt idx="357">
                  <c:v>1.907</c:v>
                </c:pt>
                <c:pt idx="358">
                  <c:v>1.827</c:v>
                </c:pt>
                <c:pt idx="359">
                  <c:v>1.77</c:v>
                </c:pt>
                <c:pt idx="360">
                  <c:v>1.69</c:v>
                </c:pt>
                <c:pt idx="361">
                  <c:v>1.623</c:v>
                </c:pt>
                <c:pt idx="362">
                  <c:v>1.556</c:v>
                </c:pt>
                <c:pt idx="363">
                  <c:v>1.5</c:v>
                </c:pt>
                <c:pt idx="364">
                  <c:v>1.4970000000000001</c:v>
                </c:pt>
                <c:pt idx="365">
                  <c:v>1.4330000000000001</c:v>
                </c:pt>
                <c:pt idx="366">
                  <c:v>1.3540000000000001</c:v>
                </c:pt>
                <c:pt idx="367">
                  <c:v>1.3109999999999999</c:v>
                </c:pt>
                <c:pt idx="368">
                  <c:v>1.2350000000000001</c:v>
                </c:pt>
                <c:pt idx="369">
                  <c:v>1.169</c:v>
                </c:pt>
                <c:pt idx="370">
                  <c:v>1.1020000000000001</c:v>
                </c:pt>
                <c:pt idx="371">
                  <c:v>1.0209999999999999</c:v>
                </c:pt>
                <c:pt idx="372">
                  <c:v>1</c:v>
                </c:pt>
                <c:pt idx="373">
                  <c:v>0.98899999999999999</c:v>
                </c:pt>
                <c:pt idx="374">
                  <c:v>0.95</c:v>
                </c:pt>
                <c:pt idx="375">
                  <c:v>0.85599999999999998</c:v>
                </c:pt>
                <c:pt idx="376">
                  <c:v>0.80400000000000005</c:v>
                </c:pt>
                <c:pt idx="377">
                  <c:v>0.73499999999999999</c:v>
                </c:pt>
                <c:pt idx="378">
                  <c:v>0.68700000000000006</c:v>
                </c:pt>
                <c:pt idx="379">
                  <c:v>0.61499999999999999</c:v>
                </c:pt>
                <c:pt idx="380">
                  <c:v>0.56899999999999995</c:v>
                </c:pt>
                <c:pt idx="381">
                  <c:v>0.51500000000000001</c:v>
                </c:pt>
                <c:pt idx="382">
                  <c:v>0.5</c:v>
                </c:pt>
                <c:pt idx="383">
                  <c:v>0.45800000000000002</c:v>
                </c:pt>
                <c:pt idx="384">
                  <c:v>0.41499999999999998</c:v>
                </c:pt>
                <c:pt idx="385">
                  <c:v>0.34200000000000003</c:v>
                </c:pt>
                <c:pt idx="386">
                  <c:v>0.308</c:v>
                </c:pt>
                <c:pt idx="387">
                  <c:v>0.26300000000000001</c:v>
                </c:pt>
                <c:pt idx="388">
                  <c:v>0.22</c:v>
                </c:pt>
                <c:pt idx="389">
                  <c:v>0.16600000000000001</c:v>
                </c:pt>
                <c:pt idx="390">
                  <c:v>0.13300000000000001</c:v>
                </c:pt>
                <c:pt idx="391">
                  <c:v>0.10199999999999999</c:v>
                </c:pt>
                <c:pt idx="392">
                  <c:v>6.2E-2</c:v>
                </c:pt>
                <c:pt idx="393">
                  <c:v>3.7999999999999999E-2</c:v>
                </c:pt>
                <c:pt idx="394">
                  <c:v>2.7E-2</c:v>
                </c:pt>
                <c:pt idx="395">
                  <c:v>1.4999999999999999E-2</c:v>
                </c:pt>
                <c:pt idx="396">
                  <c:v>1.0999999999999999E-2</c:v>
                </c:pt>
                <c:pt idx="397">
                  <c:v>5.0000000000000001E-3</c:v>
                </c:pt>
                <c:pt idx="398">
                  <c:v>3.0000000000000001E-3</c:v>
                </c:pt>
                <c:pt idx="399">
                  <c:v>1E-3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7EB-4971-BBB7-EC35B5F78EDB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K$411:$K$812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.0000000000000002E-3</c:v>
                </c:pt>
                <c:pt idx="9">
                  <c:v>6.0999999999999999E-2</c:v>
                </c:pt>
                <c:pt idx="10">
                  <c:v>0.113</c:v>
                </c:pt>
                <c:pt idx="11">
                  <c:v>0.16600000000000001</c:v>
                </c:pt>
                <c:pt idx="12">
                  <c:v>0.219</c:v>
                </c:pt>
                <c:pt idx="13">
                  <c:v>0.27200000000000002</c:v>
                </c:pt>
                <c:pt idx="14">
                  <c:v>0.32500000000000001</c:v>
                </c:pt>
                <c:pt idx="15">
                  <c:v>0.378</c:v>
                </c:pt>
                <c:pt idx="16">
                  <c:v>0.43099999999999999</c:v>
                </c:pt>
                <c:pt idx="17">
                  <c:v>0.48299999999999998</c:v>
                </c:pt>
                <c:pt idx="18">
                  <c:v>0.53600000000000003</c:v>
                </c:pt>
                <c:pt idx="19">
                  <c:v>0.58899999999999997</c:v>
                </c:pt>
                <c:pt idx="20">
                  <c:v>0.64200000000000002</c:v>
                </c:pt>
                <c:pt idx="21">
                  <c:v>0.69499999999999995</c:v>
                </c:pt>
                <c:pt idx="22">
                  <c:v>0.748</c:v>
                </c:pt>
                <c:pt idx="23">
                  <c:v>0.80100000000000005</c:v>
                </c:pt>
                <c:pt idx="24">
                  <c:v>0.85399999999999998</c:v>
                </c:pt>
                <c:pt idx="25">
                  <c:v>0.90600000000000003</c:v>
                </c:pt>
                <c:pt idx="26">
                  <c:v>0.95899999999999996</c:v>
                </c:pt>
                <c:pt idx="27">
                  <c:v>1.012</c:v>
                </c:pt>
                <c:pt idx="28">
                  <c:v>1.0649999999999999</c:v>
                </c:pt>
                <c:pt idx="29">
                  <c:v>1.1180000000000001</c:v>
                </c:pt>
                <c:pt idx="30">
                  <c:v>1.171</c:v>
                </c:pt>
                <c:pt idx="31">
                  <c:v>1.224</c:v>
                </c:pt>
                <c:pt idx="32">
                  <c:v>1.2689999999999999</c:v>
                </c:pt>
                <c:pt idx="33">
                  <c:v>1.3120000000000001</c:v>
                </c:pt>
                <c:pt idx="34">
                  <c:v>1.3560000000000001</c:v>
                </c:pt>
                <c:pt idx="35">
                  <c:v>1.4</c:v>
                </c:pt>
                <c:pt idx="36">
                  <c:v>1.444</c:v>
                </c:pt>
                <c:pt idx="37">
                  <c:v>1.4870000000000001</c:v>
                </c:pt>
                <c:pt idx="38">
                  <c:v>1.5309999999999999</c:v>
                </c:pt>
                <c:pt idx="39">
                  <c:v>1.575</c:v>
                </c:pt>
                <c:pt idx="40">
                  <c:v>1.6180000000000001</c:v>
                </c:pt>
                <c:pt idx="41">
                  <c:v>1.6619999999999999</c:v>
                </c:pt>
                <c:pt idx="42">
                  <c:v>1.706</c:v>
                </c:pt>
                <c:pt idx="43">
                  <c:v>1.75</c:v>
                </c:pt>
                <c:pt idx="44">
                  <c:v>1.7929999999999999</c:v>
                </c:pt>
                <c:pt idx="45">
                  <c:v>1.837</c:v>
                </c:pt>
                <c:pt idx="46">
                  <c:v>1.881</c:v>
                </c:pt>
                <c:pt idx="47">
                  <c:v>1.925</c:v>
                </c:pt>
                <c:pt idx="48">
                  <c:v>1.968</c:v>
                </c:pt>
                <c:pt idx="49">
                  <c:v>2.012</c:v>
                </c:pt>
                <c:pt idx="50">
                  <c:v>2.056</c:v>
                </c:pt>
                <c:pt idx="51">
                  <c:v>2.0990000000000002</c:v>
                </c:pt>
                <c:pt idx="52">
                  <c:v>2.1429999999999998</c:v>
                </c:pt>
                <c:pt idx="53">
                  <c:v>2.1869999999999998</c:v>
                </c:pt>
                <c:pt idx="54">
                  <c:v>2.2309999999999999</c:v>
                </c:pt>
                <c:pt idx="55">
                  <c:v>2.274</c:v>
                </c:pt>
                <c:pt idx="56">
                  <c:v>2.3180000000000001</c:v>
                </c:pt>
                <c:pt idx="57">
                  <c:v>2.3620000000000001</c:v>
                </c:pt>
                <c:pt idx="58">
                  <c:v>2.4060000000000001</c:v>
                </c:pt>
                <c:pt idx="59">
                  <c:v>2.4489999999999998</c:v>
                </c:pt>
                <c:pt idx="60">
                  <c:v>2.5049999999999999</c:v>
                </c:pt>
                <c:pt idx="61">
                  <c:v>2.5649999999999999</c:v>
                </c:pt>
                <c:pt idx="62">
                  <c:v>2.6259999999999999</c:v>
                </c:pt>
                <c:pt idx="63">
                  <c:v>2.6859999999999999</c:v>
                </c:pt>
                <c:pt idx="64">
                  <c:v>2.746</c:v>
                </c:pt>
                <c:pt idx="65">
                  <c:v>2.8069999999999999</c:v>
                </c:pt>
                <c:pt idx="66">
                  <c:v>2.867</c:v>
                </c:pt>
                <c:pt idx="67">
                  <c:v>2.9279999999999999</c:v>
                </c:pt>
                <c:pt idx="68">
                  <c:v>2.988</c:v>
                </c:pt>
                <c:pt idx="69">
                  <c:v>3.048</c:v>
                </c:pt>
                <c:pt idx="70">
                  <c:v>3.109</c:v>
                </c:pt>
                <c:pt idx="71">
                  <c:v>3.169</c:v>
                </c:pt>
                <c:pt idx="72">
                  <c:v>3.23</c:v>
                </c:pt>
                <c:pt idx="73">
                  <c:v>3.29</c:v>
                </c:pt>
                <c:pt idx="74">
                  <c:v>3.351</c:v>
                </c:pt>
                <c:pt idx="75">
                  <c:v>3.411</c:v>
                </c:pt>
                <c:pt idx="76">
                  <c:v>3.4710000000000001</c:v>
                </c:pt>
                <c:pt idx="77">
                  <c:v>3.532</c:v>
                </c:pt>
                <c:pt idx="78">
                  <c:v>3.5920000000000001</c:v>
                </c:pt>
                <c:pt idx="79">
                  <c:v>3.653</c:v>
                </c:pt>
                <c:pt idx="80">
                  <c:v>3.72</c:v>
                </c:pt>
                <c:pt idx="81">
                  <c:v>3.8010000000000002</c:v>
                </c:pt>
                <c:pt idx="82">
                  <c:v>3.883</c:v>
                </c:pt>
                <c:pt idx="83">
                  <c:v>3.964</c:v>
                </c:pt>
                <c:pt idx="84">
                  <c:v>4.0460000000000003</c:v>
                </c:pt>
                <c:pt idx="85">
                  <c:v>4.1269999999999998</c:v>
                </c:pt>
                <c:pt idx="86">
                  <c:v>4.2089999999999996</c:v>
                </c:pt>
                <c:pt idx="87">
                  <c:v>4.29</c:v>
                </c:pt>
                <c:pt idx="88">
                  <c:v>4.3710000000000004</c:v>
                </c:pt>
                <c:pt idx="89">
                  <c:v>4.4530000000000003</c:v>
                </c:pt>
                <c:pt idx="90">
                  <c:v>4.5339999999999998</c:v>
                </c:pt>
                <c:pt idx="91">
                  <c:v>4.6159999999999997</c:v>
                </c:pt>
                <c:pt idx="92">
                  <c:v>4.6970000000000001</c:v>
                </c:pt>
                <c:pt idx="93">
                  <c:v>4.7789999999999999</c:v>
                </c:pt>
                <c:pt idx="94">
                  <c:v>4.8600000000000003</c:v>
                </c:pt>
                <c:pt idx="95">
                  <c:v>4.9470000000000001</c:v>
                </c:pt>
                <c:pt idx="96">
                  <c:v>5.0549999999999997</c:v>
                </c:pt>
                <c:pt idx="97">
                  <c:v>5.1639999999999997</c:v>
                </c:pt>
                <c:pt idx="98">
                  <c:v>5.2720000000000002</c:v>
                </c:pt>
                <c:pt idx="99">
                  <c:v>5.38</c:v>
                </c:pt>
                <c:pt idx="100">
                  <c:v>5.4880000000000004</c:v>
                </c:pt>
                <c:pt idx="101">
                  <c:v>5.5960000000000001</c:v>
                </c:pt>
                <c:pt idx="102">
                  <c:v>5.7039999999999997</c:v>
                </c:pt>
                <c:pt idx="103">
                  <c:v>5.8120000000000003</c:v>
                </c:pt>
                <c:pt idx="104">
                  <c:v>5.9210000000000003</c:v>
                </c:pt>
                <c:pt idx="105">
                  <c:v>6.0289999999999999</c:v>
                </c:pt>
                <c:pt idx="106">
                  <c:v>6.1369999999999996</c:v>
                </c:pt>
                <c:pt idx="107">
                  <c:v>6.157</c:v>
                </c:pt>
                <c:pt idx="108">
                  <c:v>6.2789999999999999</c:v>
                </c:pt>
                <c:pt idx="109">
                  <c:v>6.4290000000000003</c:v>
                </c:pt>
                <c:pt idx="110">
                  <c:v>6.5789999999999997</c:v>
                </c:pt>
                <c:pt idx="111">
                  <c:v>6.7290000000000001</c:v>
                </c:pt>
                <c:pt idx="112">
                  <c:v>6.8789999999999996</c:v>
                </c:pt>
                <c:pt idx="113">
                  <c:v>7.0289999999999999</c:v>
                </c:pt>
                <c:pt idx="114">
                  <c:v>7.1790000000000003</c:v>
                </c:pt>
                <c:pt idx="115">
                  <c:v>7.3289999999999997</c:v>
                </c:pt>
                <c:pt idx="116">
                  <c:v>7.516</c:v>
                </c:pt>
                <c:pt idx="117">
                  <c:v>7.7279999999999998</c:v>
                </c:pt>
                <c:pt idx="118">
                  <c:v>7.94</c:v>
                </c:pt>
                <c:pt idx="119">
                  <c:v>8.1519999999999992</c:v>
                </c:pt>
                <c:pt idx="120">
                  <c:v>8.3640000000000008</c:v>
                </c:pt>
                <c:pt idx="121">
                  <c:v>8.5760000000000005</c:v>
                </c:pt>
                <c:pt idx="122">
                  <c:v>8.8390000000000004</c:v>
                </c:pt>
                <c:pt idx="123">
                  <c:v>9.1159999999999997</c:v>
                </c:pt>
                <c:pt idx="124">
                  <c:v>9.3919999999999995</c:v>
                </c:pt>
                <c:pt idx="125">
                  <c:v>9.6690000000000005</c:v>
                </c:pt>
                <c:pt idx="126">
                  <c:v>9.9710000000000001</c:v>
                </c:pt>
                <c:pt idx="127">
                  <c:v>10.323</c:v>
                </c:pt>
                <c:pt idx="128">
                  <c:v>10.675000000000001</c:v>
                </c:pt>
                <c:pt idx="129">
                  <c:v>11.028</c:v>
                </c:pt>
                <c:pt idx="130">
                  <c:v>11.452</c:v>
                </c:pt>
                <c:pt idx="131">
                  <c:v>11.89</c:v>
                </c:pt>
                <c:pt idx="132">
                  <c:v>12.313000000000001</c:v>
                </c:pt>
                <c:pt idx="133">
                  <c:v>12.331</c:v>
                </c:pt>
                <c:pt idx="134">
                  <c:v>12.867000000000001</c:v>
                </c:pt>
                <c:pt idx="135">
                  <c:v>13.404</c:v>
                </c:pt>
                <c:pt idx="136">
                  <c:v>14.007999999999999</c:v>
                </c:pt>
                <c:pt idx="137">
                  <c:v>14.635999999999999</c:v>
                </c:pt>
                <c:pt idx="138">
                  <c:v>15.346</c:v>
                </c:pt>
                <c:pt idx="139">
                  <c:v>16.088999999999999</c:v>
                </c:pt>
                <c:pt idx="140">
                  <c:v>16.917999999999999</c:v>
                </c:pt>
                <c:pt idx="141">
                  <c:v>17.806000000000001</c:v>
                </c:pt>
                <c:pt idx="142">
                  <c:v>18.47</c:v>
                </c:pt>
                <c:pt idx="143">
                  <c:v>18.788</c:v>
                </c:pt>
                <c:pt idx="144">
                  <c:v>19.934000000000001</c:v>
                </c:pt>
                <c:pt idx="145">
                  <c:v>21.222000000000001</c:v>
                </c:pt>
                <c:pt idx="146">
                  <c:v>22.652000000000001</c:v>
                </c:pt>
                <c:pt idx="147">
                  <c:v>24.166</c:v>
                </c:pt>
                <c:pt idx="148">
                  <c:v>24.626000000000001</c:v>
                </c:pt>
                <c:pt idx="149">
                  <c:v>25.734000000000002</c:v>
                </c:pt>
                <c:pt idx="150">
                  <c:v>27.626000000000001</c:v>
                </c:pt>
                <c:pt idx="151">
                  <c:v>29.806999999999999</c:v>
                </c:pt>
                <c:pt idx="152">
                  <c:v>30.783000000000001</c:v>
                </c:pt>
                <c:pt idx="153">
                  <c:v>32.409999999999997</c:v>
                </c:pt>
                <c:pt idx="154">
                  <c:v>34.994999999999997</c:v>
                </c:pt>
                <c:pt idx="155">
                  <c:v>36.94</c:v>
                </c:pt>
                <c:pt idx="156">
                  <c:v>37.774000000000001</c:v>
                </c:pt>
                <c:pt idx="157">
                  <c:v>40.869</c:v>
                </c:pt>
                <c:pt idx="158">
                  <c:v>43.095999999999997</c:v>
                </c:pt>
                <c:pt idx="159">
                  <c:v>44.633000000000003</c:v>
                </c:pt>
                <c:pt idx="160">
                  <c:v>48.643000000000001</c:v>
                </c:pt>
                <c:pt idx="161">
                  <c:v>49.253</c:v>
                </c:pt>
                <c:pt idx="162">
                  <c:v>52.91</c:v>
                </c:pt>
                <c:pt idx="163">
                  <c:v>55.408999999999999</c:v>
                </c:pt>
                <c:pt idx="164">
                  <c:v>57.447000000000003</c:v>
                </c:pt>
                <c:pt idx="165">
                  <c:v>61.566000000000003</c:v>
                </c:pt>
                <c:pt idx="166">
                  <c:v>63.53</c:v>
                </c:pt>
                <c:pt idx="167">
                  <c:v>67.722999999999999</c:v>
                </c:pt>
                <c:pt idx="168">
                  <c:v>69.64</c:v>
                </c:pt>
                <c:pt idx="169">
                  <c:v>73.879000000000005</c:v>
                </c:pt>
                <c:pt idx="170">
                  <c:v>75.912000000000006</c:v>
                </c:pt>
                <c:pt idx="171">
                  <c:v>80.036000000000001</c:v>
                </c:pt>
                <c:pt idx="172">
                  <c:v>83.45</c:v>
                </c:pt>
                <c:pt idx="173">
                  <c:v>86.191999999999993</c:v>
                </c:pt>
                <c:pt idx="174">
                  <c:v>92.007000000000005</c:v>
                </c:pt>
                <c:pt idx="175">
                  <c:v>92.349000000000004</c:v>
                </c:pt>
                <c:pt idx="176">
                  <c:v>98.506</c:v>
                </c:pt>
                <c:pt idx="177">
                  <c:v>99.988</c:v>
                </c:pt>
                <c:pt idx="178">
                  <c:v>104.66200000000001</c:v>
                </c:pt>
                <c:pt idx="179">
                  <c:v>109.768</c:v>
                </c:pt>
                <c:pt idx="180">
                  <c:v>110.819</c:v>
                </c:pt>
                <c:pt idx="181">
                  <c:v>116.97499999999999</c:v>
                </c:pt>
                <c:pt idx="182">
                  <c:v>121.4</c:v>
                </c:pt>
                <c:pt idx="183">
                  <c:v>123.13200000000001</c:v>
                </c:pt>
                <c:pt idx="184">
                  <c:v>129.28899999999999</c:v>
                </c:pt>
                <c:pt idx="185">
                  <c:v>132.22499999999999</c:v>
                </c:pt>
                <c:pt idx="186">
                  <c:v>135.44499999999999</c:v>
                </c:pt>
                <c:pt idx="187">
                  <c:v>141.602</c:v>
                </c:pt>
                <c:pt idx="188">
                  <c:v>144.60599999999999</c:v>
                </c:pt>
                <c:pt idx="189">
                  <c:v>147.75800000000001</c:v>
                </c:pt>
                <c:pt idx="190">
                  <c:v>153.91499999999999</c:v>
                </c:pt>
                <c:pt idx="191">
                  <c:v>159.208</c:v>
                </c:pt>
                <c:pt idx="192">
                  <c:v>160.072</c:v>
                </c:pt>
                <c:pt idx="193">
                  <c:v>166.22800000000001</c:v>
                </c:pt>
                <c:pt idx="194">
                  <c:v>172.38499999999999</c:v>
                </c:pt>
                <c:pt idx="195">
                  <c:v>172.97</c:v>
                </c:pt>
                <c:pt idx="196">
                  <c:v>178.541</c:v>
                </c:pt>
                <c:pt idx="197">
                  <c:v>184.69800000000001</c:v>
                </c:pt>
                <c:pt idx="198">
                  <c:v>187.88800000000001</c:v>
                </c:pt>
                <c:pt idx="199">
                  <c:v>190.85499999999999</c:v>
                </c:pt>
                <c:pt idx="200">
                  <c:v>197.011</c:v>
                </c:pt>
                <c:pt idx="201">
                  <c:v>203.16800000000001</c:v>
                </c:pt>
                <c:pt idx="202">
                  <c:v>204.821</c:v>
                </c:pt>
                <c:pt idx="203">
                  <c:v>209.32400000000001</c:v>
                </c:pt>
                <c:pt idx="204">
                  <c:v>215.48099999999999</c:v>
                </c:pt>
                <c:pt idx="205">
                  <c:v>221.63800000000001</c:v>
                </c:pt>
                <c:pt idx="206">
                  <c:v>222.79300000000001</c:v>
                </c:pt>
                <c:pt idx="207">
                  <c:v>227.79400000000001</c:v>
                </c:pt>
                <c:pt idx="208">
                  <c:v>233.95099999999999</c:v>
                </c:pt>
                <c:pt idx="209">
                  <c:v>238.88900000000001</c:v>
                </c:pt>
                <c:pt idx="210">
                  <c:v>240.107</c:v>
                </c:pt>
                <c:pt idx="211">
                  <c:v>246.26400000000001</c:v>
                </c:pt>
                <c:pt idx="212">
                  <c:v>252.42</c:v>
                </c:pt>
                <c:pt idx="213">
                  <c:v>258.577</c:v>
                </c:pt>
                <c:pt idx="214">
                  <c:v>260.483</c:v>
                </c:pt>
                <c:pt idx="215">
                  <c:v>264.73399999999998</c:v>
                </c:pt>
                <c:pt idx="216">
                  <c:v>270.89</c:v>
                </c:pt>
                <c:pt idx="217">
                  <c:v>277.04700000000003</c:v>
                </c:pt>
                <c:pt idx="218">
                  <c:v>279.41500000000002</c:v>
                </c:pt>
                <c:pt idx="219">
                  <c:v>283.20299999999997</c:v>
                </c:pt>
                <c:pt idx="220">
                  <c:v>289.36</c:v>
                </c:pt>
                <c:pt idx="221">
                  <c:v>295.517</c:v>
                </c:pt>
                <c:pt idx="222">
                  <c:v>298.85399999999998</c:v>
                </c:pt>
                <c:pt idx="223">
                  <c:v>301.673</c:v>
                </c:pt>
                <c:pt idx="224">
                  <c:v>307.83</c:v>
                </c:pt>
                <c:pt idx="225">
                  <c:v>313.98599999999999</c:v>
                </c:pt>
                <c:pt idx="226">
                  <c:v>318.06</c:v>
                </c:pt>
                <c:pt idx="227">
                  <c:v>320.14299999999997</c:v>
                </c:pt>
                <c:pt idx="228">
                  <c:v>326.3</c:v>
                </c:pt>
                <c:pt idx="229">
                  <c:v>332.45600000000002</c:v>
                </c:pt>
                <c:pt idx="230">
                  <c:v>336.83600000000001</c:v>
                </c:pt>
                <c:pt idx="231">
                  <c:v>338.613</c:v>
                </c:pt>
                <c:pt idx="232">
                  <c:v>344.76900000000001</c:v>
                </c:pt>
                <c:pt idx="233">
                  <c:v>350.92599999999999</c:v>
                </c:pt>
                <c:pt idx="234">
                  <c:v>357.08300000000003</c:v>
                </c:pt>
                <c:pt idx="235">
                  <c:v>360.43900000000002</c:v>
                </c:pt>
                <c:pt idx="236">
                  <c:v>363.23899999999998</c:v>
                </c:pt>
                <c:pt idx="237">
                  <c:v>369.39600000000002</c:v>
                </c:pt>
                <c:pt idx="238">
                  <c:v>375.55200000000002</c:v>
                </c:pt>
                <c:pt idx="239">
                  <c:v>380.40699999999998</c:v>
                </c:pt>
                <c:pt idx="240">
                  <c:v>381.709</c:v>
                </c:pt>
                <c:pt idx="241">
                  <c:v>387.86599999999999</c:v>
                </c:pt>
                <c:pt idx="242">
                  <c:v>394.02199999999999</c:v>
                </c:pt>
                <c:pt idx="243">
                  <c:v>400.17899999999997</c:v>
                </c:pt>
                <c:pt idx="244">
                  <c:v>400.73899999999998</c:v>
                </c:pt>
                <c:pt idx="245">
                  <c:v>406.33499999999998</c:v>
                </c:pt>
                <c:pt idx="246">
                  <c:v>412.49200000000002</c:v>
                </c:pt>
                <c:pt idx="247">
                  <c:v>418.649</c:v>
                </c:pt>
                <c:pt idx="248">
                  <c:v>423.98700000000002</c:v>
                </c:pt>
                <c:pt idx="249">
                  <c:v>424.80500000000001</c:v>
                </c:pt>
                <c:pt idx="250">
                  <c:v>430.96199999999999</c:v>
                </c:pt>
                <c:pt idx="251">
                  <c:v>437.11799999999999</c:v>
                </c:pt>
                <c:pt idx="252">
                  <c:v>443.27499999999998</c:v>
                </c:pt>
                <c:pt idx="253">
                  <c:v>449.43200000000002</c:v>
                </c:pt>
                <c:pt idx="254">
                  <c:v>452.572</c:v>
                </c:pt>
                <c:pt idx="255">
                  <c:v>455.58800000000002</c:v>
                </c:pt>
                <c:pt idx="256">
                  <c:v>461.745</c:v>
                </c:pt>
                <c:pt idx="257">
                  <c:v>467.90100000000001</c:v>
                </c:pt>
                <c:pt idx="258">
                  <c:v>474.05799999999999</c:v>
                </c:pt>
                <c:pt idx="259">
                  <c:v>480.21499999999997</c:v>
                </c:pt>
                <c:pt idx="260">
                  <c:v>481.36099999999999</c:v>
                </c:pt>
                <c:pt idx="261">
                  <c:v>486.37099999999998</c:v>
                </c:pt>
                <c:pt idx="262">
                  <c:v>492.52800000000002</c:v>
                </c:pt>
                <c:pt idx="263">
                  <c:v>498.68400000000003</c:v>
                </c:pt>
                <c:pt idx="264">
                  <c:v>504.84100000000001</c:v>
                </c:pt>
                <c:pt idx="265">
                  <c:v>510.99799999999999</c:v>
                </c:pt>
                <c:pt idx="266">
                  <c:v>512.16</c:v>
                </c:pt>
                <c:pt idx="267">
                  <c:v>517.154</c:v>
                </c:pt>
                <c:pt idx="268">
                  <c:v>523.31100000000004</c:v>
                </c:pt>
                <c:pt idx="269">
                  <c:v>529.46699999999998</c:v>
                </c:pt>
                <c:pt idx="270">
                  <c:v>535.62400000000002</c:v>
                </c:pt>
                <c:pt idx="271">
                  <c:v>540.69000000000005</c:v>
                </c:pt>
                <c:pt idx="272">
                  <c:v>541.78099999999995</c:v>
                </c:pt>
                <c:pt idx="273">
                  <c:v>547.93700000000001</c:v>
                </c:pt>
                <c:pt idx="274">
                  <c:v>554.09400000000005</c:v>
                </c:pt>
                <c:pt idx="275">
                  <c:v>560.25</c:v>
                </c:pt>
                <c:pt idx="276">
                  <c:v>566.40700000000004</c:v>
                </c:pt>
                <c:pt idx="277">
                  <c:v>572.56399999999996</c:v>
                </c:pt>
                <c:pt idx="278">
                  <c:v>573.46600000000001</c:v>
                </c:pt>
                <c:pt idx="279">
                  <c:v>578.72</c:v>
                </c:pt>
                <c:pt idx="280">
                  <c:v>584.87699999999995</c:v>
                </c:pt>
                <c:pt idx="281">
                  <c:v>591.03300000000002</c:v>
                </c:pt>
                <c:pt idx="282">
                  <c:v>597.19000000000005</c:v>
                </c:pt>
                <c:pt idx="283">
                  <c:v>603.34699999999998</c:v>
                </c:pt>
                <c:pt idx="284">
                  <c:v>604.36099999999999</c:v>
                </c:pt>
                <c:pt idx="285">
                  <c:v>609.50300000000004</c:v>
                </c:pt>
                <c:pt idx="286">
                  <c:v>615.66</c:v>
                </c:pt>
                <c:pt idx="287">
                  <c:v>621.81600000000003</c:v>
                </c:pt>
                <c:pt idx="288">
                  <c:v>627.97299999999996</c:v>
                </c:pt>
                <c:pt idx="289">
                  <c:v>634.13</c:v>
                </c:pt>
                <c:pt idx="290">
                  <c:v>635.76800000000003</c:v>
                </c:pt>
                <c:pt idx="291">
                  <c:v>640.28599999999994</c:v>
                </c:pt>
                <c:pt idx="292">
                  <c:v>646.44299999999998</c:v>
                </c:pt>
                <c:pt idx="293">
                  <c:v>652.59900000000005</c:v>
                </c:pt>
                <c:pt idx="294">
                  <c:v>658.75599999999997</c:v>
                </c:pt>
                <c:pt idx="295">
                  <c:v>664.31399999999996</c:v>
                </c:pt>
                <c:pt idx="296">
                  <c:v>664.91300000000001</c:v>
                </c:pt>
                <c:pt idx="297">
                  <c:v>671.06899999999996</c:v>
                </c:pt>
                <c:pt idx="298">
                  <c:v>677.226</c:v>
                </c:pt>
                <c:pt idx="299">
                  <c:v>683.38199999999995</c:v>
                </c:pt>
                <c:pt idx="300">
                  <c:v>689.53899999999999</c:v>
                </c:pt>
                <c:pt idx="301">
                  <c:v>694.17899999999997</c:v>
                </c:pt>
                <c:pt idx="302">
                  <c:v>695.69500000000005</c:v>
                </c:pt>
                <c:pt idx="303">
                  <c:v>701.85199999999998</c:v>
                </c:pt>
                <c:pt idx="304">
                  <c:v>708.00900000000001</c:v>
                </c:pt>
                <c:pt idx="305">
                  <c:v>714.16499999999996</c:v>
                </c:pt>
                <c:pt idx="306">
                  <c:v>720.322</c:v>
                </c:pt>
                <c:pt idx="307">
                  <c:v>726.47799999999995</c:v>
                </c:pt>
                <c:pt idx="308">
                  <c:v>726.91099999999994</c:v>
                </c:pt>
                <c:pt idx="309">
                  <c:v>732.63499999999999</c:v>
                </c:pt>
                <c:pt idx="310">
                  <c:v>738.79200000000003</c:v>
                </c:pt>
                <c:pt idx="311">
                  <c:v>744.94799999999998</c:v>
                </c:pt>
                <c:pt idx="312">
                  <c:v>751.10500000000002</c:v>
                </c:pt>
                <c:pt idx="313">
                  <c:v>757.26099999999997</c:v>
                </c:pt>
                <c:pt idx="314">
                  <c:v>757.85900000000004</c:v>
                </c:pt>
                <c:pt idx="315">
                  <c:v>763.41800000000001</c:v>
                </c:pt>
                <c:pt idx="316">
                  <c:v>769.57500000000005</c:v>
                </c:pt>
                <c:pt idx="317">
                  <c:v>775.73099999999999</c:v>
                </c:pt>
                <c:pt idx="318">
                  <c:v>781.88800000000003</c:v>
                </c:pt>
                <c:pt idx="319">
                  <c:v>788.04399999999998</c:v>
                </c:pt>
                <c:pt idx="320">
                  <c:v>791.44200000000001</c:v>
                </c:pt>
                <c:pt idx="321">
                  <c:v>794.20100000000002</c:v>
                </c:pt>
                <c:pt idx="322">
                  <c:v>800.35799999999995</c:v>
                </c:pt>
                <c:pt idx="323">
                  <c:v>806.51400000000001</c:v>
                </c:pt>
                <c:pt idx="324">
                  <c:v>812.67100000000005</c:v>
                </c:pt>
                <c:pt idx="325">
                  <c:v>818.827</c:v>
                </c:pt>
                <c:pt idx="326">
                  <c:v>824.98400000000004</c:v>
                </c:pt>
                <c:pt idx="327">
                  <c:v>827.16099999999994</c:v>
                </c:pt>
                <c:pt idx="328">
                  <c:v>831.14099999999996</c:v>
                </c:pt>
                <c:pt idx="329">
                  <c:v>837.29700000000003</c:v>
                </c:pt>
                <c:pt idx="330">
                  <c:v>843.45399999999995</c:v>
                </c:pt>
                <c:pt idx="331">
                  <c:v>849.61</c:v>
                </c:pt>
                <c:pt idx="332">
                  <c:v>855.76700000000005</c:v>
                </c:pt>
                <c:pt idx="333">
                  <c:v>861.92399999999998</c:v>
                </c:pt>
                <c:pt idx="334">
                  <c:v>864.87099999999998</c:v>
                </c:pt>
                <c:pt idx="335">
                  <c:v>868.08</c:v>
                </c:pt>
                <c:pt idx="336">
                  <c:v>874.23699999999997</c:v>
                </c:pt>
                <c:pt idx="337">
                  <c:v>880.39300000000003</c:v>
                </c:pt>
                <c:pt idx="338">
                  <c:v>886.55</c:v>
                </c:pt>
                <c:pt idx="339">
                  <c:v>892.70699999999999</c:v>
                </c:pt>
                <c:pt idx="340">
                  <c:v>898.86300000000006</c:v>
                </c:pt>
                <c:pt idx="341">
                  <c:v>905.02</c:v>
                </c:pt>
                <c:pt idx="342">
                  <c:v>906.15300000000002</c:v>
                </c:pt>
                <c:pt idx="343">
                  <c:v>911.17600000000004</c:v>
                </c:pt>
                <c:pt idx="344">
                  <c:v>917.33299999999997</c:v>
                </c:pt>
                <c:pt idx="345">
                  <c:v>923.49</c:v>
                </c:pt>
                <c:pt idx="346">
                  <c:v>929.64599999999996</c:v>
                </c:pt>
                <c:pt idx="347">
                  <c:v>935.803</c:v>
                </c:pt>
                <c:pt idx="348">
                  <c:v>941.95899999999995</c:v>
                </c:pt>
                <c:pt idx="349">
                  <c:v>945.33199999999999</c:v>
                </c:pt>
                <c:pt idx="350">
                  <c:v>948.11599999999999</c:v>
                </c:pt>
                <c:pt idx="351">
                  <c:v>954.27300000000002</c:v>
                </c:pt>
                <c:pt idx="352">
                  <c:v>960.42899999999997</c:v>
                </c:pt>
                <c:pt idx="353">
                  <c:v>966.58600000000001</c:v>
                </c:pt>
                <c:pt idx="354">
                  <c:v>972.74199999999996</c:v>
                </c:pt>
                <c:pt idx="355">
                  <c:v>978.899</c:v>
                </c:pt>
                <c:pt idx="356">
                  <c:v>985.05600000000004</c:v>
                </c:pt>
                <c:pt idx="357">
                  <c:v>986.42499999999995</c:v>
                </c:pt>
                <c:pt idx="358">
                  <c:v>991.21199999999999</c:v>
                </c:pt>
                <c:pt idx="359">
                  <c:v>997.36900000000003</c:v>
                </c:pt>
                <c:pt idx="360">
                  <c:v>1003.525</c:v>
                </c:pt>
                <c:pt idx="361">
                  <c:v>1009.682</c:v>
                </c:pt>
                <c:pt idx="362">
                  <c:v>1015.8390000000001</c:v>
                </c:pt>
                <c:pt idx="363">
                  <c:v>1021.995</c:v>
                </c:pt>
                <c:pt idx="364">
                  <c:v>1024.3620000000001</c:v>
                </c:pt>
                <c:pt idx="365">
                  <c:v>1028.152</c:v>
                </c:pt>
                <c:pt idx="366">
                  <c:v>1034.308</c:v>
                </c:pt>
                <c:pt idx="367">
                  <c:v>1040.4649999999999</c:v>
                </c:pt>
                <c:pt idx="368">
                  <c:v>1046.6220000000001</c:v>
                </c:pt>
                <c:pt idx="369">
                  <c:v>1052.778</c:v>
                </c:pt>
                <c:pt idx="370">
                  <c:v>1058.9349999999999</c:v>
                </c:pt>
                <c:pt idx="371">
                  <c:v>1065.0909999999999</c:v>
                </c:pt>
                <c:pt idx="372">
                  <c:v>1066.4880000000001</c:v>
                </c:pt>
                <c:pt idx="373">
                  <c:v>1071.248</c:v>
                </c:pt>
                <c:pt idx="374">
                  <c:v>1077.405</c:v>
                </c:pt>
                <c:pt idx="375">
                  <c:v>1083.5609999999999</c:v>
                </c:pt>
                <c:pt idx="376">
                  <c:v>1089.7180000000001</c:v>
                </c:pt>
                <c:pt idx="377">
                  <c:v>1095.874</c:v>
                </c:pt>
                <c:pt idx="378">
                  <c:v>1102.0309999999999</c:v>
                </c:pt>
                <c:pt idx="379">
                  <c:v>1108.1880000000001</c:v>
                </c:pt>
                <c:pt idx="380">
                  <c:v>1110.682</c:v>
                </c:pt>
                <c:pt idx="381">
                  <c:v>1114.3440000000001</c:v>
                </c:pt>
                <c:pt idx="382">
                  <c:v>1120.501</c:v>
                </c:pt>
                <c:pt idx="383">
                  <c:v>1126.6569999999999</c:v>
                </c:pt>
                <c:pt idx="384">
                  <c:v>1132.8140000000001</c:v>
                </c:pt>
                <c:pt idx="385">
                  <c:v>1138.97</c:v>
                </c:pt>
                <c:pt idx="386">
                  <c:v>1145.127</c:v>
                </c:pt>
                <c:pt idx="387">
                  <c:v>1151.2840000000001</c:v>
                </c:pt>
                <c:pt idx="388">
                  <c:v>1157.44</c:v>
                </c:pt>
                <c:pt idx="389">
                  <c:v>1163.597</c:v>
                </c:pt>
                <c:pt idx="390">
                  <c:v>1169.7529999999999</c:v>
                </c:pt>
                <c:pt idx="391">
                  <c:v>1175.9100000000001</c:v>
                </c:pt>
                <c:pt idx="392">
                  <c:v>1182.067</c:v>
                </c:pt>
                <c:pt idx="393">
                  <c:v>1188.223</c:v>
                </c:pt>
                <c:pt idx="394">
                  <c:v>1194.3800000000001</c:v>
                </c:pt>
                <c:pt idx="395">
                  <c:v>1200.5360000000001</c:v>
                </c:pt>
                <c:pt idx="396">
                  <c:v>1206.693</c:v>
                </c:pt>
                <c:pt idx="397">
                  <c:v>1212.8499999999999</c:v>
                </c:pt>
                <c:pt idx="398">
                  <c:v>1219.0060000000001</c:v>
                </c:pt>
                <c:pt idx="399">
                  <c:v>1225.163</c:v>
                </c:pt>
                <c:pt idx="400">
                  <c:v>1231.319</c:v>
                </c:pt>
                <c:pt idx="401">
                  <c:v>1231.319</c:v>
                </c:pt>
              </c:numCache>
            </c:numRef>
          </c:xVal>
          <c:yVal>
            <c:numRef>
              <c:f>Foglio6!$L$411:$L$812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.408999999999999</c:v>
                </c:pt>
                <c:pt idx="108">
                  <c:v>47</c:v>
                </c:pt>
                <c:pt idx="109">
                  <c:v>46.5</c:v>
                </c:pt>
                <c:pt idx="110">
                  <c:v>46</c:v>
                </c:pt>
                <c:pt idx="111">
                  <c:v>45.5</c:v>
                </c:pt>
                <c:pt idx="112">
                  <c:v>45</c:v>
                </c:pt>
                <c:pt idx="113">
                  <c:v>44.5</c:v>
                </c:pt>
                <c:pt idx="114">
                  <c:v>44</c:v>
                </c:pt>
                <c:pt idx="115">
                  <c:v>43.5</c:v>
                </c:pt>
                <c:pt idx="116">
                  <c:v>43</c:v>
                </c:pt>
                <c:pt idx="117">
                  <c:v>42.5</c:v>
                </c:pt>
                <c:pt idx="118">
                  <c:v>42</c:v>
                </c:pt>
                <c:pt idx="119">
                  <c:v>41.5</c:v>
                </c:pt>
                <c:pt idx="120">
                  <c:v>41</c:v>
                </c:pt>
                <c:pt idx="121">
                  <c:v>40.5</c:v>
                </c:pt>
                <c:pt idx="122">
                  <c:v>40</c:v>
                </c:pt>
                <c:pt idx="123">
                  <c:v>39.5</c:v>
                </c:pt>
                <c:pt idx="124">
                  <c:v>39</c:v>
                </c:pt>
                <c:pt idx="125">
                  <c:v>38.5</c:v>
                </c:pt>
                <c:pt idx="126">
                  <c:v>38</c:v>
                </c:pt>
                <c:pt idx="127">
                  <c:v>37.5</c:v>
                </c:pt>
                <c:pt idx="128">
                  <c:v>37</c:v>
                </c:pt>
                <c:pt idx="129">
                  <c:v>36.5</c:v>
                </c:pt>
                <c:pt idx="130">
                  <c:v>36</c:v>
                </c:pt>
                <c:pt idx="131">
                  <c:v>35.5</c:v>
                </c:pt>
                <c:pt idx="132">
                  <c:v>35.017000000000003</c:v>
                </c:pt>
                <c:pt idx="133">
                  <c:v>35</c:v>
                </c:pt>
                <c:pt idx="134">
                  <c:v>34.5</c:v>
                </c:pt>
                <c:pt idx="135">
                  <c:v>34</c:v>
                </c:pt>
                <c:pt idx="136">
                  <c:v>33.5</c:v>
                </c:pt>
                <c:pt idx="137">
                  <c:v>33</c:v>
                </c:pt>
                <c:pt idx="138">
                  <c:v>32.5</c:v>
                </c:pt>
                <c:pt idx="139">
                  <c:v>32</c:v>
                </c:pt>
                <c:pt idx="140">
                  <c:v>31.5</c:v>
                </c:pt>
                <c:pt idx="141">
                  <c:v>31</c:v>
                </c:pt>
                <c:pt idx="142">
                  <c:v>30.641999999999999</c:v>
                </c:pt>
                <c:pt idx="143">
                  <c:v>30.5</c:v>
                </c:pt>
                <c:pt idx="144">
                  <c:v>30</c:v>
                </c:pt>
                <c:pt idx="145">
                  <c:v>29.5</c:v>
                </c:pt>
                <c:pt idx="146">
                  <c:v>29</c:v>
                </c:pt>
                <c:pt idx="147">
                  <c:v>28.5</c:v>
                </c:pt>
                <c:pt idx="148">
                  <c:v>28.347999999999999</c:v>
                </c:pt>
                <c:pt idx="149">
                  <c:v>28</c:v>
                </c:pt>
                <c:pt idx="150">
                  <c:v>27.5</c:v>
                </c:pt>
                <c:pt idx="151">
                  <c:v>27</c:v>
                </c:pt>
                <c:pt idx="152">
                  <c:v>26.81</c:v>
                </c:pt>
                <c:pt idx="153">
                  <c:v>26.5</c:v>
                </c:pt>
                <c:pt idx="154">
                  <c:v>26</c:v>
                </c:pt>
                <c:pt idx="155">
                  <c:v>25.632000000000001</c:v>
                </c:pt>
                <c:pt idx="156">
                  <c:v>25.5</c:v>
                </c:pt>
                <c:pt idx="157">
                  <c:v>25</c:v>
                </c:pt>
                <c:pt idx="158">
                  <c:v>24.713999999999999</c:v>
                </c:pt>
                <c:pt idx="159">
                  <c:v>24.5</c:v>
                </c:pt>
                <c:pt idx="160">
                  <c:v>24</c:v>
                </c:pt>
                <c:pt idx="161">
                  <c:v>23.931000000000001</c:v>
                </c:pt>
                <c:pt idx="162">
                  <c:v>23.5</c:v>
                </c:pt>
                <c:pt idx="163">
                  <c:v>23.228000000000002</c:v>
                </c:pt>
                <c:pt idx="164">
                  <c:v>23</c:v>
                </c:pt>
                <c:pt idx="165">
                  <c:v>22.664999999999999</c:v>
                </c:pt>
                <c:pt idx="166">
                  <c:v>22.5</c:v>
                </c:pt>
                <c:pt idx="167">
                  <c:v>22.15</c:v>
                </c:pt>
                <c:pt idx="168">
                  <c:v>22</c:v>
                </c:pt>
                <c:pt idx="169">
                  <c:v>21.666</c:v>
                </c:pt>
                <c:pt idx="170">
                  <c:v>21.5</c:v>
                </c:pt>
                <c:pt idx="171">
                  <c:v>21.228000000000002</c:v>
                </c:pt>
                <c:pt idx="172">
                  <c:v>21</c:v>
                </c:pt>
                <c:pt idx="173">
                  <c:v>20.846</c:v>
                </c:pt>
                <c:pt idx="174">
                  <c:v>20.5</c:v>
                </c:pt>
                <c:pt idx="175">
                  <c:v>20.477</c:v>
                </c:pt>
                <c:pt idx="176">
                  <c:v>20.077000000000002</c:v>
                </c:pt>
                <c:pt idx="177">
                  <c:v>20</c:v>
                </c:pt>
                <c:pt idx="178">
                  <c:v>19.725000000000001</c:v>
                </c:pt>
                <c:pt idx="179">
                  <c:v>19.5</c:v>
                </c:pt>
                <c:pt idx="180">
                  <c:v>19.449000000000002</c:v>
                </c:pt>
                <c:pt idx="181">
                  <c:v>19.199000000000002</c:v>
                </c:pt>
                <c:pt idx="182">
                  <c:v>19</c:v>
                </c:pt>
                <c:pt idx="183">
                  <c:v>18.914000000000001</c:v>
                </c:pt>
                <c:pt idx="184">
                  <c:v>18.635000000000002</c:v>
                </c:pt>
                <c:pt idx="185">
                  <c:v>18.5</c:v>
                </c:pt>
                <c:pt idx="186">
                  <c:v>18.37</c:v>
                </c:pt>
                <c:pt idx="187">
                  <c:v>18.091999999999999</c:v>
                </c:pt>
                <c:pt idx="188">
                  <c:v>18</c:v>
                </c:pt>
                <c:pt idx="189">
                  <c:v>17.888999999999999</c:v>
                </c:pt>
                <c:pt idx="190">
                  <c:v>17.684999999999999</c:v>
                </c:pt>
                <c:pt idx="191">
                  <c:v>17.5</c:v>
                </c:pt>
                <c:pt idx="192">
                  <c:v>17.472999999999999</c:v>
                </c:pt>
                <c:pt idx="193">
                  <c:v>17.260000000000002</c:v>
                </c:pt>
                <c:pt idx="194">
                  <c:v>17.024000000000001</c:v>
                </c:pt>
                <c:pt idx="195">
                  <c:v>17</c:v>
                </c:pt>
                <c:pt idx="196">
                  <c:v>16.812999999999999</c:v>
                </c:pt>
                <c:pt idx="197">
                  <c:v>16.606000000000002</c:v>
                </c:pt>
                <c:pt idx="198">
                  <c:v>16.5</c:v>
                </c:pt>
                <c:pt idx="199">
                  <c:v>16.41</c:v>
                </c:pt>
                <c:pt idx="200">
                  <c:v>16.204000000000001</c:v>
                </c:pt>
                <c:pt idx="201">
                  <c:v>16.042999999999999</c:v>
                </c:pt>
                <c:pt idx="202">
                  <c:v>16</c:v>
                </c:pt>
                <c:pt idx="203">
                  <c:v>15.885999999999999</c:v>
                </c:pt>
                <c:pt idx="204">
                  <c:v>15.699</c:v>
                </c:pt>
                <c:pt idx="205">
                  <c:v>15.54</c:v>
                </c:pt>
                <c:pt idx="206">
                  <c:v>15.5</c:v>
                </c:pt>
                <c:pt idx="207">
                  <c:v>15.32</c:v>
                </c:pt>
                <c:pt idx="208">
                  <c:v>15.148</c:v>
                </c:pt>
                <c:pt idx="209">
                  <c:v>15</c:v>
                </c:pt>
                <c:pt idx="210">
                  <c:v>14.97</c:v>
                </c:pt>
                <c:pt idx="211">
                  <c:v>14.858000000000001</c:v>
                </c:pt>
                <c:pt idx="212">
                  <c:v>14.698</c:v>
                </c:pt>
                <c:pt idx="213">
                  <c:v>14.561</c:v>
                </c:pt>
                <c:pt idx="214">
                  <c:v>14.5</c:v>
                </c:pt>
                <c:pt idx="215">
                  <c:v>14.394</c:v>
                </c:pt>
                <c:pt idx="216">
                  <c:v>14.201000000000001</c:v>
                </c:pt>
                <c:pt idx="217">
                  <c:v>14.057</c:v>
                </c:pt>
                <c:pt idx="218">
                  <c:v>14</c:v>
                </c:pt>
                <c:pt idx="219">
                  <c:v>13.907999999999999</c:v>
                </c:pt>
                <c:pt idx="220">
                  <c:v>13.747</c:v>
                </c:pt>
                <c:pt idx="221">
                  <c:v>13.581</c:v>
                </c:pt>
                <c:pt idx="222">
                  <c:v>13.5</c:v>
                </c:pt>
                <c:pt idx="223">
                  <c:v>13.425000000000001</c:v>
                </c:pt>
                <c:pt idx="224">
                  <c:v>13.273999999999999</c:v>
                </c:pt>
                <c:pt idx="225">
                  <c:v>13.127000000000001</c:v>
                </c:pt>
                <c:pt idx="226">
                  <c:v>13</c:v>
                </c:pt>
                <c:pt idx="227">
                  <c:v>12.945</c:v>
                </c:pt>
                <c:pt idx="228">
                  <c:v>12.782</c:v>
                </c:pt>
                <c:pt idx="229">
                  <c:v>12.614000000000001</c:v>
                </c:pt>
                <c:pt idx="230">
                  <c:v>12.5</c:v>
                </c:pt>
                <c:pt idx="231">
                  <c:v>12.456</c:v>
                </c:pt>
                <c:pt idx="232">
                  <c:v>12.321</c:v>
                </c:pt>
                <c:pt idx="233">
                  <c:v>12.199</c:v>
                </c:pt>
                <c:pt idx="234">
                  <c:v>12.093999999999999</c:v>
                </c:pt>
                <c:pt idx="235">
                  <c:v>12</c:v>
                </c:pt>
                <c:pt idx="236">
                  <c:v>11.941000000000001</c:v>
                </c:pt>
                <c:pt idx="237">
                  <c:v>11.794</c:v>
                </c:pt>
                <c:pt idx="238">
                  <c:v>11.621</c:v>
                </c:pt>
                <c:pt idx="239">
                  <c:v>11.5</c:v>
                </c:pt>
                <c:pt idx="240">
                  <c:v>11.467000000000001</c:v>
                </c:pt>
                <c:pt idx="241">
                  <c:v>11.295999999999999</c:v>
                </c:pt>
                <c:pt idx="242">
                  <c:v>11.153</c:v>
                </c:pt>
                <c:pt idx="243">
                  <c:v>11.013999999999999</c:v>
                </c:pt>
                <c:pt idx="244">
                  <c:v>11</c:v>
                </c:pt>
                <c:pt idx="245">
                  <c:v>10.88</c:v>
                </c:pt>
                <c:pt idx="246">
                  <c:v>10.75</c:v>
                </c:pt>
                <c:pt idx="247">
                  <c:v>10.61</c:v>
                </c:pt>
                <c:pt idx="248">
                  <c:v>10.5</c:v>
                </c:pt>
                <c:pt idx="249">
                  <c:v>10.48</c:v>
                </c:pt>
                <c:pt idx="250">
                  <c:v>10.38</c:v>
                </c:pt>
                <c:pt idx="251">
                  <c:v>10.241</c:v>
                </c:pt>
                <c:pt idx="252">
                  <c:v>10.170999999999999</c:v>
                </c:pt>
                <c:pt idx="253">
                  <c:v>10.055999999999999</c:v>
                </c:pt>
                <c:pt idx="254">
                  <c:v>10</c:v>
                </c:pt>
                <c:pt idx="255">
                  <c:v>9.9220000000000006</c:v>
                </c:pt>
                <c:pt idx="256">
                  <c:v>9.8279999999999994</c:v>
                </c:pt>
                <c:pt idx="257">
                  <c:v>9.73</c:v>
                </c:pt>
                <c:pt idx="258">
                  <c:v>9.6419999999999995</c:v>
                </c:pt>
                <c:pt idx="259">
                  <c:v>9.5250000000000004</c:v>
                </c:pt>
                <c:pt idx="260">
                  <c:v>9.5</c:v>
                </c:pt>
                <c:pt idx="261">
                  <c:v>9.4139999999999997</c:v>
                </c:pt>
                <c:pt idx="262">
                  <c:v>9.3089999999999993</c:v>
                </c:pt>
                <c:pt idx="263">
                  <c:v>9.1980000000000004</c:v>
                </c:pt>
                <c:pt idx="264">
                  <c:v>9.109</c:v>
                </c:pt>
                <c:pt idx="265">
                  <c:v>9.0220000000000002</c:v>
                </c:pt>
                <c:pt idx="266">
                  <c:v>9</c:v>
                </c:pt>
                <c:pt idx="267">
                  <c:v>8.9120000000000008</c:v>
                </c:pt>
                <c:pt idx="268">
                  <c:v>8.7729999999999997</c:v>
                </c:pt>
                <c:pt idx="269">
                  <c:v>8.6969999999999992</c:v>
                </c:pt>
                <c:pt idx="270">
                  <c:v>8.6059999999999999</c:v>
                </c:pt>
                <c:pt idx="271">
                  <c:v>8.5</c:v>
                </c:pt>
                <c:pt idx="272">
                  <c:v>8.4719999999999995</c:v>
                </c:pt>
                <c:pt idx="273">
                  <c:v>8.3740000000000006</c:v>
                </c:pt>
                <c:pt idx="274">
                  <c:v>8.2880000000000003</c:v>
                </c:pt>
                <c:pt idx="275">
                  <c:v>8.1850000000000005</c:v>
                </c:pt>
                <c:pt idx="276">
                  <c:v>8.0939999999999994</c:v>
                </c:pt>
                <c:pt idx="277">
                  <c:v>8.0180000000000007</c:v>
                </c:pt>
                <c:pt idx="278">
                  <c:v>8</c:v>
                </c:pt>
                <c:pt idx="279">
                  <c:v>7.9130000000000003</c:v>
                </c:pt>
                <c:pt idx="280">
                  <c:v>7.8159999999999998</c:v>
                </c:pt>
                <c:pt idx="281">
                  <c:v>7.7169999999999996</c:v>
                </c:pt>
                <c:pt idx="282">
                  <c:v>7.6139999999999999</c:v>
                </c:pt>
                <c:pt idx="283">
                  <c:v>7.5179999999999998</c:v>
                </c:pt>
                <c:pt idx="284">
                  <c:v>7.5</c:v>
                </c:pt>
                <c:pt idx="285">
                  <c:v>7.4569999999999999</c:v>
                </c:pt>
                <c:pt idx="286">
                  <c:v>7.3470000000000004</c:v>
                </c:pt>
                <c:pt idx="287">
                  <c:v>7.2359999999999998</c:v>
                </c:pt>
                <c:pt idx="288">
                  <c:v>7.1310000000000002</c:v>
                </c:pt>
                <c:pt idx="289">
                  <c:v>7.032</c:v>
                </c:pt>
                <c:pt idx="290">
                  <c:v>7</c:v>
                </c:pt>
                <c:pt idx="291">
                  <c:v>6.8970000000000002</c:v>
                </c:pt>
                <c:pt idx="292">
                  <c:v>6.8049999999999997</c:v>
                </c:pt>
                <c:pt idx="293">
                  <c:v>6.6929999999999996</c:v>
                </c:pt>
                <c:pt idx="294">
                  <c:v>6.5960000000000001</c:v>
                </c:pt>
                <c:pt idx="295">
                  <c:v>6.5</c:v>
                </c:pt>
                <c:pt idx="296">
                  <c:v>6.4850000000000003</c:v>
                </c:pt>
                <c:pt idx="297">
                  <c:v>6.399</c:v>
                </c:pt>
                <c:pt idx="298">
                  <c:v>6.2859999999999996</c:v>
                </c:pt>
                <c:pt idx="299">
                  <c:v>6.17</c:v>
                </c:pt>
                <c:pt idx="300">
                  <c:v>6.0810000000000004</c:v>
                </c:pt>
                <c:pt idx="301">
                  <c:v>6</c:v>
                </c:pt>
                <c:pt idx="302">
                  <c:v>5.9729999999999999</c:v>
                </c:pt>
                <c:pt idx="303">
                  <c:v>5.8680000000000003</c:v>
                </c:pt>
                <c:pt idx="304">
                  <c:v>5.7560000000000002</c:v>
                </c:pt>
                <c:pt idx="305">
                  <c:v>5.6719999999999997</c:v>
                </c:pt>
                <c:pt idx="306">
                  <c:v>5.5919999999999996</c:v>
                </c:pt>
                <c:pt idx="307">
                  <c:v>5.5049999999999999</c:v>
                </c:pt>
                <c:pt idx="308">
                  <c:v>5.5</c:v>
                </c:pt>
                <c:pt idx="309">
                  <c:v>5.383</c:v>
                </c:pt>
                <c:pt idx="310">
                  <c:v>5.298</c:v>
                </c:pt>
                <c:pt idx="311">
                  <c:v>5.1929999999999996</c:v>
                </c:pt>
                <c:pt idx="312">
                  <c:v>5.093</c:v>
                </c:pt>
                <c:pt idx="313">
                  <c:v>5.0060000000000002</c:v>
                </c:pt>
                <c:pt idx="314">
                  <c:v>5</c:v>
                </c:pt>
                <c:pt idx="315">
                  <c:v>4.9050000000000002</c:v>
                </c:pt>
                <c:pt idx="316">
                  <c:v>4.82</c:v>
                </c:pt>
                <c:pt idx="317">
                  <c:v>4.726</c:v>
                </c:pt>
                <c:pt idx="318">
                  <c:v>4.6390000000000002</c:v>
                </c:pt>
                <c:pt idx="319">
                  <c:v>4.55</c:v>
                </c:pt>
                <c:pt idx="320">
                  <c:v>4.5</c:v>
                </c:pt>
                <c:pt idx="321">
                  <c:v>4.46</c:v>
                </c:pt>
                <c:pt idx="322">
                  <c:v>4.41</c:v>
                </c:pt>
                <c:pt idx="323">
                  <c:v>4.3070000000000004</c:v>
                </c:pt>
                <c:pt idx="324">
                  <c:v>4.1929999999999996</c:v>
                </c:pt>
                <c:pt idx="325">
                  <c:v>4.0970000000000004</c:v>
                </c:pt>
                <c:pt idx="326">
                  <c:v>4.0229999999999997</c:v>
                </c:pt>
                <c:pt idx="327">
                  <c:v>4</c:v>
                </c:pt>
                <c:pt idx="328">
                  <c:v>3.9430000000000001</c:v>
                </c:pt>
                <c:pt idx="329">
                  <c:v>3.8580000000000001</c:v>
                </c:pt>
                <c:pt idx="330">
                  <c:v>3.7639999999999998</c:v>
                </c:pt>
                <c:pt idx="331">
                  <c:v>3.6850000000000001</c:v>
                </c:pt>
                <c:pt idx="332">
                  <c:v>3.609</c:v>
                </c:pt>
                <c:pt idx="333">
                  <c:v>3.5409999999999999</c:v>
                </c:pt>
                <c:pt idx="334">
                  <c:v>3.5</c:v>
                </c:pt>
                <c:pt idx="335">
                  <c:v>3.452</c:v>
                </c:pt>
                <c:pt idx="336">
                  <c:v>3.3679999999999999</c:v>
                </c:pt>
                <c:pt idx="337">
                  <c:v>3.2869999999999999</c:v>
                </c:pt>
                <c:pt idx="338">
                  <c:v>3.24</c:v>
                </c:pt>
                <c:pt idx="339">
                  <c:v>3.1640000000000001</c:v>
                </c:pt>
                <c:pt idx="340">
                  <c:v>3.0819999999999999</c:v>
                </c:pt>
                <c:pt idx="341">
                  <c:v>3.0209999999999999</c:v>
                </c:pt>
                <c:pt idx="342">
                  <c:v>3</c:v>
                </c:pt>
                <c:pt idx="343">
                  <c:v>2.9279999999999999</c:v>
                </c:pt>
                <c:pt idx="344">
                  <c:v>2.847</c:v>
                </c:pt>
                <c:pt idx="345">
                  <c:v>2.7679999999999998</c:v>
                </c:pt>
                <c:pt idx="346">
                  <c:v>2.702</c:v>
                </c:pt>
                <c:pt idx="347">
                  <c:v>2.61</c:v>
                </c:pt>
                <c:pt idx="348">
                  <c:v>2.5449999999999999</c:v>
                </c:pt>
                <c:pt idx="349">
                  <c:v>2.5</c:v>
                </c:pt>
                <c:pt idx="350">
                  <c:v>2.4630000000000001</c:v>
                </c:pt>
                <c:pt idx="351">
                  <c:v>2.403</c:v>
                </c:pt>
                <c:pt idx="352">
                  <c:v>2.327</c:v>
                </c:pt>
                <c:pt idx="353">
                  <c:v>2.2370000000000001</c:v>
                </c:pt>
                <c:pt idx="354">
                  <c:v>2.169</c:v>
                </c:pt>
                <c:pt idx="355">
                  <c:v>2.125</c:v>
                </c:pt>
                <c:pt idx="356">
                  <c:v>2.024</c:v>
                </c:pt>
                <c:pt idx="357">
                  <c:v>2</c:v>
                </c:pt>
                <c:pt idx="358">
                  <c:v>1.9359999999999999</c:v>
                </c:pt>
                <c:pt idx="359">
                  <c:v>1.8660000000000001</c:v>
                </c:pt>
                <c:pt idx="360">
                  <c:v>1.8029999999999999</c:v>
                </c:pt>
                <c:pt idx="361">
                  <c:v>1.7250000000000001</c:v>
                </c:pt>
                <c:pt idx="362">
                  <c:v>1.6319999999999999</c:v>
                </c:pt>
                <c:pt idx="363">
                  <c:v>1.534</c:v>
                </c:pt>
                <c:pt idx="364">
                  <c:v>1.5</c:v>
                </c:pt>
                <c:pt idx="365">
                  <c:v>1.452</c:v>
                </c:pt>
                <c:pt idx="366">
                  <c:v>1.3819999999999999</c:v>
                </c:pt>
                <c:pt idx="367">
                  <c:v>1.3180000000000001</c:v>
                </c:pt>
                <c:pt idx="368">
                  <c:v>1.2370000000000001</c:v>
                </c:pt>
                <c:pt idx="369">
                  <c:v>1.165</c:v>
                </c:pt>
                <c:pt idx="370">
                  <c:v>1.089</c:v>
                </c:pt>
                <c:pt idx="371">
                  <c:v>1.0169999999999999</c:v>
                </c:pt>
                <c:pt idx="372">
                  <c:v>1</c:v>
                </c:pt>
                <c:pt idx="373">
                  <c:v>0.95299999999999996</c:v>
                </c:pt>
                <c:pt idx="374">
                  <c:v>0.88900000000000001</c:v>
                </c:pt>
                <c:pt idx="375">
                  <c:v>0.81599999999999995</c:v>
                </c:pt>
                <c:pt idx="376">
                  <c:v>0.754</c:v>
                </c:pt>
                <c:pt idx="377">
                  <c:v>0.66600000000000004</c:v>
                </c:pt>
                <c:pt idx="378">
                  <c:v>0.58399999999999996</c:v>
                </c:pt>
                <c:pt idx="379">
                  <c:v>0.51900000000000002</c:v>
                </c:pt>
                <c:pt idx="380">
                  <c:v>0.5</c:v>
                </c:pt>
                <c:pt idx="381">
                  <c:v>0.46200000000000002</c:v>
                </c:pt>
                <c:pt idx="382">
                  <c:v>0.40100000000000002</c:v>
                </c:pt>
                <c:pt idx="383">
                  <c:v>0.33400000000000002</c:v>
                </c:pt>
                <c:pt idx="384">
                  <c:v>0.28299999999999997</c:v>
                </c:pt>
                <c:pt idx="385">
                  <c:v>0.248</c:v>
                </c:pt>
                <c:pt idx="386">
                  <c:v>0.20100000000000001</c:v>
                </c:pt>
                <c:pt idx="387">
                  <c:v>0.16600000000000001</c:v>
                </c:pt>
                <c:pt idx="388">
                  <c:v>0.124</c:v>
                </c:pt>
                <c:pt idx="389">
                  <c:v>0.10299999999999999</c:v>
                </c:pt>
                <c:pt idx="390">
                  <c:v>7.4999999999999997E-2</c:v>
                </c:pt>
                <c:pt idx="391">
                  <c:v>5.5E-2</c:v>
                </c:pt>
                <c:pt idx="392">
                  <c:v>3.9E-2</c:v>
                </c:pt>
                <c:pt idx="393">
                  <c:v>2.3E-2</c:v>
                </c:pt>
                <c:pt idx="394">
                  <c:v>1.4999999999999999E-2</c:v>
                </c:pt>
                <c:pt idx="395">
                  <c:v>0.01</c:v>
                </c:pt>
                <c:pt idx="396">
                  <c:v>5.0000000000000001E-3</c:v>
                </c:pt>
                <c:pt idx="397">
                  <c:v>1E-3</c:v>
                </c:pt>
                <c:pt idx="398">
                  <c:v>1E-3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7EB-4971-BBB7-EC35B5F78E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12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dirty="0"/>
                  <a:t>Dose [</a:t>
                </a:r>
                <a:r>
                  <a:rPr lang="it-IT" sz="800" dirty="0" err="1"/>
                  <a:t>cGy</a:t>
                </a:r>
                <a:r>
                  <a:rPr lang="it-IT" sz="800" dirty="0"/>
                  <a:t>(RBE)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  <c:max val="6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dirty="0"/>
                  <a:t>Volume</a:t>
                </a:r>
                <a:r>
                  <a:rPr lang="it-IT" sz="800" baseline="0" dirty="0"/>
                  <a:t> [%]</a:t>
                </a:r>
                <a:endParaRPr lang="it-IT" sz="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34761904761906"/>
          <c:y val="7.7611111111111117E-2"/>
          <c:w val="0.6602539682539682"/>
          <c:h val="0.6898144444444444"/>
        </c:manualLayout>
      </c:layout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rgbClr val="9DC3E6"/>
              </a:solidFill>
              <a:round/>
            </a:ln>
            <a:effectLst/>
          </c:spPr>
          <c:marker>
            <c:symbol val="none"/>
          </c:marker>
          <c:xVal>
            <c:numRef>
              <c:f>Foglio6!$A$1227:$A$1628</c:f>
              <c:numCache>
                <c:formatCode>General</c:formatCode>
                <c:ptCount val="402"/>
                <c:pt idx="0">
                  <c:v>0</c:v>
                </c:pt>
                <c:pt idx="1">
                  <c:v>5.9119999999999999</c:v>
                </c:pt>
                <c:pt idx="2">
                  <c:v>11.824</c:v>
                </c:pt>
                <c:pt idx="3">
                  <c:v>17.736000000000001</c:v>
                </c:pt>
                <c:pt idx="4">
                  <c:v>23.648</c:v>
                </c:pt>
                <c:pt idx="5">
                  <c:v>29.559000000000001</c:v>
                </c:pt>
                <c:pt idx="6">
                  <c:v>35.470999999999997</c:v>
                </c:pt>
                <c:pt idx="7">
                  <c:v>41.383000000000003</c:v>
                </c:pt>
                <c:pt idx="8">
                  <c:v>47.295000000000002</c:v>
                </c:pt>
                <c:pt idx="9">
                  <c:v>53.207000000000001</c:v>
                </c:pt>
                <c:pt idx="10">
                  <c:v>59.119</c:v>
                </c:pt>
                <c:pt idx="11">
                  <c:v>65.031000000000006</c:v>
                </c:pt>
                <c:pt idx="12">
                  <c:v>70.942999999999998</c:v>
                </c:pt>
                <c:pt idx="13">
                  <c:v>76.855000000000004</c:v>
                </c:pt>
                <c:pt idx="14">
                  <c:v>82.766999999999996</c:v>
                </c:pt>
                <c:pt idx="15">
                  <c:v>88.677999999999997</c:v>
                </c:pt>
                <c:pt idx="16">
                  <c:v>94.59</c:v>
                </c:pt>
                <c:pt idx="17">
                  <c:v>100.502</c:v>
                </c:pt>
                <c:pt idx="18">
                  <c:v>106.414</c:v>
                </c:pt>
                <c:pt idx="19">
                  <c:v>112.32599999999999</c:v>
                </c:pt>
                <c:pt idx="20">
                  <c:v>118.238</c:v>
                </c:pt>
                <c:pt idx="21">
                  <c:v>124.15</c:v>
                </c:pt>
                <c:pt idx="22">
                  <c:v>130.06200000000001</c:v>
                </c:pt>
                <c:pt idx="23">
                  <c:v>135.97399999999999</c:v>
                </c:pt>
                <c:pt idx="24">
                  <c:v>141.886</c:v>
                </c:pt>
                <c:pt idx="25">
                  <c:v>147.797</c:v>
                </c:pt>
                <c:pt idx="26">
                  <c:v>153.709</c:v>
                </c:pt>
                <c:pt idx="27">
                  <c:v>159.62100000000001</c:v>
                </c:pt>
                <c:pt idx="28">
                  <c:v>165.53299999999999</c:v>
                </c:pt>
                <c:pt idx="29">
                  <c:v>171.44499999999999</c:v>
                </c:pt>
                <c:pt idx="30">
                  <c:v>177.357</c:v>
                </c:pt>
                <c:pt idx="31">
                  <c:v>183.26900000000001</c:v>
                </c:pt>
                <c:pt idx="32">
                  <c:v>189.18100000000001</c:v>
                </c:pt>
                <c:pt idx="33">
                  <c:v>195.09299999999999</c:v>
                </c:pt>
                <c:pt idx="34">
                  <c:v>201.005</c:v>
                </c:pt>
                <c:pt idx="35">
                  <c:v>206.916</c:v>
                </c:pt>
                <c:pt idx="36">
                  <c:v>212.828</c:v>
                </c:pt>
                <c:pt idx="37">
                  <c:v>216.053</c:v>
                </c:pt>
                <c:pt idx="38">
                  <c:v>218.74</c:v>
                </c:pt>
                <c:pt idx="39">
                  <c:v>224.65199999999999</c:v>
                </c:pt>
                <c:pt idx="40">
                  <c:v>230.56399999999999</c:v>
                </c:pt>
                <c:pt idx="41">
                  <c:v>236.476</c:v>
                </c:pt>
                <c:pt idx="42">
                  <c:v>242.38800000000001</c:v>
                </c:pt>
                <c:pt idx="43">
                  <c:v>245.83600000000001</c:v>
                </c:pt>
                <c:pt idx="44">
                  <c:v>248.3</c:v>
                </c:pt>
                <c:pt idx="45">
                  <c:v>254.21199999999999</c:v>
                </c:pt>
                <c:pt idx="46">
                  <c:v>260.12400000000002</c:v>
                </c:pt>
                <c:pt idx="47">
                  <c:v>263.95400000000001</c:v>
                </c:pt>
                <c:pt idx="48">
                  <c:v>266.03500000000003</c:v>
                </c:pt>
                <c:pt idx="49">
                  <c:v>271.947</c:v>
                </c:pt>
                <c:pt idx="50">
                  <c:v>277.85899999999998</c:v>
                </c:pt>
                <c:pt idx="51">
                  <c:v>283.77100000000002</c:v>
                </c:pt>
                <c:pt idx="52">
                  <c:v>285.95299999999997</c:v>
                </c:pt>
                <c:pt idx="53">
                  <c:v>289.68299999999999</c:v>
                </c:pt>
                <c:pt idx="54">
                  <c:v>295.59500000000003</c:v>
                </c:pt>
                <c:pt idx="55">
                  <c:v>298.32499999999999</c:v>
                </c:pt>
                <c:pt idx="56">
                  <c:v>301.50700000000001</c:v>
                </c:pt>
                <c:pt idx="57">
                  <c:v>307.41899999999998</c:v>
                </c:pt>
                <c:pt idx="58">
                  <c:v>312.35500000000002</c:v>
                </c:pt>
                <c:pt idx="59">
                  <c:v>313.33100000000002</c:v>
                </c:pt>
                <c:pt idx="60">
                  <c:v>317.12700000000001</c:v>
                </c:pt>
                <c:pt idx="61">
                  <c:v>319.24299999999999</c:v>
                </c:pt>
                <c:pt idx="62">
                  <c:v>325.154</c:v>
                </c:pt>
                <c:pt idx="63">
                  <c:v>331.06599999999997</c:v>
                </c:pt>
                <c:pt idx="64">
                  <c:v>336.54</c:v>
                </c:pt>
                <c:pt idx="65">
                  <c:v>336.97800000000001</c:v>
                </c:pt>
                <c:pt idx="66">
                  <c:v>342.89</c:v>
                </c:pt>
                <c:pt idx="67">
                  <c:v>346.39400000000001</c:v>
                </c:pt>
                <c:pt idx="68">
                  <c:v>348.80200000000002</c:v>
                </c:pt>
                <c:pt idx="69">
                  <c:v>354.714</c:v>
                </c:pt>
                <c:pt idx="70">
                  <c:v>359.45800000000003</c:v>
                </c:pt>
                <c:pt idx="71">
                  <c:v>360.62599999999998</c:v>
                </c:pt>
                <c:pt idx="72">
                  <c:v>366.53800000000001</c:v>
                </c:pt>
                <c:pt idx="73">
                  <c:v>372.45</c:v>
                </c:pt>
                <c:pt idx="74">
                  <c:v>378.36200000000002</c:v>
                </c:pt>
                <c:pt idx="75">
                  <c:v>378.988</c:v>
                </c:pt>
                <c:pt idx="76">
                  <c:v>384.27300000000002</c:v>
                </c:pt>
                <c:pt idx="77">
                  <c:v>384.65100000000001</c:v>
                </c:pt>
                <c:pt idx="78">
                  <c:v>390.185</c:v>
                </c:pt>
                <c:pt idx="79">
                  <c:v>390.61700000000002</c:v>
                </c:pt>
                <c:pt idx="80">
                  <c:v>396.09699999999998</c:v>
                </c:pt>
                <c:pt idx="81">
                  <c:v>401.47</c:v>
                </c:pt>
                <c:pt idx="82">
                  <c:v>402.00900000000001</c:v>
                </c:pt>
                <c:pt idx="83">
                  <c:v>403.22</c:v>
                </c:pt>
                <c:pt idx="84">
                  <c:v>407.92099999999999</c:v>
                </c:pt>
                <c:pt idx="85">
                  <c:v>413.83300000000003</c:v>
                </c:pt>
                <c:pt idx="86">
                  <c:v>416.87599999999998</c:v>
                </c:pt>
                <c:pt idx="87">
                  <c:v>419.745</c:v>
                </c:pt>
                <c:pt idx="88">
                  <c:v>425.61</c:v>
                </c:pt>
                <c:pt idx="89">
                  <c:v>425.65699999999998</c:v>
                </c:pt>
                <c:pt idx="90">
                  <c:v>431.56900000000002</c:v>
                </c:pt>
                <c:pt idx="91">
                  <c:v>437.48099999999999</c:v>
                </c:pt>
                <c:pt idx="92">
                  <c:v>440.94299999999998</c:v>
                </c:pt>
                <c:pt idx="93">
                  <c:v>443.392</c:v>
                </c:pt>
                <c:pt idx="94">
                  <c:v>449.30399999999997</c:v>
                </c:pt>
                <c:pt idx="95">
                  <c:v>455.21600000000001</c:v>
                </c:pt>
                <c:pt idx="96">
                  <c:v>456.66699999999997</c:v>
                </c:pt>
                <c:pt idx="97">
                  <c:v>461.12799999999999</c:v>
                </c:pt>
                <c:pt idx="98">
                  <c:v>467.04</c:v>
                </c:pt>
                <c:pt idx="99">
                  <c:v>472.42200000000003</c:v>
                </c:pt>
                <c:pt idx="100">
                  <c:v>472.952</c:v>
                </c:pt>
                <c:pt idx="101">
                  <c:v>478.86399999999998</c:v>
                </c:pt>
                <c:pt idx="102">
                  <c:v>479.17599999999999</c:v>
                </c:pt>
                <c:pt idx="103">
                  <c:v>484.77600000000001</c:v>
                </c:pt>
                <c:pt idx="104">
                  <c:v>490.68799999999999</c:v>
                </c:pt>
                <c:pt idx="105">
                  <c:v>496.6</c:v>
                </c:pt>
                <c:pt idx="106">
                  <c:v>500.971</c:v>
                </c:pt>
                <c:pt idx="107">
                  <c:v>502.51100000000002</c:v>
                </c:pt>
                <c:pt idx="108">
                  <c:v>508.423</c:v>
                </c:pt>
                <c:pt idx="109">
                  <c:v>511.69600000000003</c:v>
                </c:pt>
                <c:pt idx="110">
                  <c:v>514.33500000000004</c:v>
                </c:pt>
                <c:pt idx="111">
                  <c:v>519.33199999999999</c:v>
                </c:pt>
                <c:pt idx="112">
                  <c:v>520.24699999999996</c:v>
                </c:pt>
                <c:pt idx="113">
                  <c:v>524.95899999999995</c:v>
                </c:pt>
                <c:pt idx="114">
                  <c:v>526.15899999999999</c:v>
                </c:pt>
                <c:pt idx="115">
                  <c:v>530.73900000000003</c:v>
                </c:pt>
                <c:pt idx="116">
                  <c:v>532.07100000000003</c:v>
                </c:pt>
                <c:pt idx="117">
                  <c:v>534.24099999999999</c:v>
                </c:pt>
                <c:pt idx="118">
                  <c:v>537.98299999999995</c:v>
                </c:pt>
                <c:pt idx="119">
                  <c:v>543.89499999999998</c:v>
                </c:pt>
                <c:pt idx="120">
                  <c:v>549.80700000000002</c:v>
                </c:pt>
                <c:pt idx="121">
                  <c:v>554.93100000000004</c:v>
                </c:pt>
                <c:pt idx="122">
                  <c:v>555.71900000000005</c:v>
                </c:pt>
                <c:pt idx="123">
                  <c:v>561.63</c:v>
                </c:pt>
                <c:pt idx="124">
                  <c:v>561.98299999999995</c:v>
                </c:pt>
                <c:pt idx="125">
                  <c:v>567.54200000000003</c:v>
                </c:pt>
                <c:pt idx="126">
                  <c:v>573.45399999999995</c:v>
                </c:pt>
                <c:pt idx="127">
                  <c:v>576.93799999999999</c:v>
                </c:pt>
                <c:pt idx="128">
                  <c:v>579.36599999999999</c:v>
                </c:pt>
                <c:pt idx="129">
                  <c:v>585.27800000000002</c:v>
                </c:pt>
                <c:pt idx="130">
                  <c:v>591.19000000000005</c:v>
                </c:pt>
                <c:pt idx="131">
                  <c:v>597.10199999999998</c:v>
                </c:pt>
                <c:pt idx="132">
                  <c:v>603.01400000000001</c:v>
                </c:pt>
                <c:pt idx="133">
                  <c:v>605.36800000000005</c:v>
                </c:pt>
                <c:pt idx="134">
                  <c:v>608.92600000000004</c:v>
                </c:pt>
                <c:pt idx="135">
                  <c:v>613.09699999999998</c:v>
                </c:pt>
                <c:pt idx="136">
                  <c:v>614.83799999999997</c:v>
                </c:pt>
                <c:pt idx="137">
                  <c:v>620.74900000000002</c:v>
                </c:pt>
                <c:pt idx="138">
                  <c:v>625.24900000000002</c:v>
                </c:pt>
                <c:pt idx="139">
                  <c:v>626.66099999999994</c:v>
                </c:pt>
                <c:pt idx="140">
                  <c:v>632.57299999999998</c:v>
                </c:pt>
                <c:pt idx="141">
                  <c:v>636.08600000000001</c:v>
                </c:pt>
                <c:pt idx="142">
                  <c:v>638.48500000000001</c:v>
                </c:pt>
                <c:pt idx="143">
                  <c:v>644.39700000000005</c:v>
                </c:pt>
                <c:pt idx="144">
                  <c:v>646.36599999999999</c:v>
                </c:pt>
                <c:pt idx="145">
                  <c:v>648.51199999999994</c:v>
                </c:pt>
                <c:pt idx="146">
                  <c:v>648.99599999999998</c:v>
                </c:pt>
                <c:pt idx="147">
                  <c:v>649.51599999999996</c:v>
                </c:pt>
                <c:pt idx="148">
                  <c:v>650.30899999999997</c:v>
                </c:pt>
                <c:pt idx="149">
                  <c:v>650.76199999999994</c:v>
                </c:pt>
                <c:pt idx="150">
                  <c:v>653.85500000000002</c:v>
                </c:pt>
                <c:pt idx="151">
                  <c:v>656.221</c:v>
                </c:pt>
                <c:pt idx="152">
                  <c:v>656.30799999999999</c:v>
                </c:pt>
                <c:pt idx="153">
                  <c:v>662.13300000000004</c:v>
                </c:pt>
                <c:pt idx="154">
                  <c:v>665.79399999999998</c:v>
                </c:pt>
                <c:pt idx="155">
                  <c:v>668.04499999999996</c:v>
                </c:pt>
                <c:pt idx="156">
                  <c:v>673.72500000000002</c:v>
                </c:pt>
                <c:pt idx="157">
                  <c:v>673.95699999999999</c:v>
                </c:pt>
                <c:pt idx="158">
                  <c:v>679.86800000000005</c:v>
                </c:pt>
                <c:pt idx="159">
                  <c:v>685.78</c:v>
                </c:pt>
                <c:pt idx="160">
                  <c:v>691.69200000000001</c:v>
                </c:pt>
                <c:pt idx="161">
                  <c:v>694.15</c:v>
                </c:pt>
                <c:pt idx="162">
                  <c:v>697.60400000000004</c:v>
                </c:pt>
                <c:pt idx="163">
                  <c:v>701.471</c:v>
                </c:pt>
                <c:pt idx="164">
                  <c:v>703.51599999999996</c:v>
                </c:pt>
                <c:pt idx="165">
                  <c:v>704.10400000000004</c:v>
                </c:pt>
                <c:pt idx="166">
                  <c:v>707.43399999999997</c:v>
                </c:pt>
                <c:pt idx="167">
                  <c:v>709.428</c:v>
                </c:pt>
                <c:pt idx="168">
                  <c:v>715.34</c:v>
                </c:pt>
                <c:pt idx="169">
                  <c:v>721.25199999999995</c:v>
                </c:pt>
                <c:pt idx="170">
                  <c:v>727.16399999999999</c:v>
                </c:pt>
                <c:pt idx="171">
                  <c:v>730.50199999999995</c:v>
                </c:pt>
                <c:pt idx="172">
                  <c:v>733.07600000000002</c:v>
                </c:pt>
                <c:pt idx="173">
                  <c:v>736.73699999999997</c:v>
                </c:pt>
                <c:pt idx="174">
                  <c:v>736.84500000000003</c:v>
                </c:pt>
                <c:pt idx="175">
                  <c:v>736.96799999999996</c:v>
                </c:pt>
                <c:pt idx="176">
                  <c:v>738.98699999999997</c:v>
                </c:pt>
                <c:pt idx="177">
                  <c:v>739.03700000000003</c:v>
                </c:pt>
                <c:pt idx="178">
                  <c:v>744.899</c:v>
                </c:pt>
                <c:pt idx="179">
                  <c:v>744.92100000000005</c:v>
                </c:pt>
                <c:pt idx="180">
                  <c:v>750.81100000000004</c:v>
                </c:pt>
                <c:pt idx="181">
                  <c:v>751.26700000000005</c:v>
                </c:pt>
                <c:pt idx="182">
                  <c:v>756.72299999999996</c:v>
                </c:pt>
                <c:pt idx="183">
                  <c:v>757.34199999999998</c:v>
                </c:pt>
                <c:pt idx="184">
                  <c:v>757.72799999999995</c:v>
                </c:pt>
                <c:pt idx="185">
                  <c:v>761.01400000000001</c:v>
                </c:pt>
                <c:pt idx="186">
                  <c:v>762.63499999999999</c:v>
                </c:pt>
                <c:pt idx="187">
                  <c:v>765.46900000000005</c:v>
                </c:pt>
                <c:pt idx="188">
                  <c:v>768.54700000000003</c:v>
                </c:pt>
                <c:pt idx="189">
                  <c:v>770.51199999999994</c:v>
                </c:pt>
                <c:pt idx="190">
                  <c:v>774.45899999999995</c:v>
                </c:pt>
                <c:pt idx="191">
                  <c:v>775.55399999999997</c:v>
                </c:pt>
                <c:pt idx="192">
                  <c:v>777.30100000000004</c:v>
                </c:pt>
                <c:pt idx="193">
                  <c:v>777.94399999999996</c:v>
                </c:pt>
                <c:pt idx="194">
                  <c:v>778.16099999999994</c:v>
                </c:pt>
                <c:pt idx="195">
                  <c:v>778.60400000000004</c:v>
                </c:pt>
                <c:pt idx="196">
                  <c:v>779.21</c:v>
                </c:pt>
                <c:pt idx="197">
                  <c:v>780.37099999999998</c:v>
                </c:pt>
                <c:pt idx="198">
                  <c:v>783.298</c:v>
                </c:pt>
                <c:pt idx="199">
                  <c:v>786.28300000000002</c:v>
                </c:pt>
                <c:pt idx="200">
                  <c:v>792.19500000000005</c:v>
                </c:pt>
                <c:pt idx="201">
                  <c:v>795.774</c:v>
                </c:pt>
                <c:pt idx="202">
                  <c:v>798.10599999999999</c:v>
                </c:pt>
                <c:pt idx="203">
                  <c:v>804.01800000000003</c:v>
                </c:pt>
                <c:pt idx="204">
                  <c:v>804.85199999999998</c:v>
                </c:pt>
                <c:pt idx="205">
                  <c:v>808.67200000000003</c:v>
                </c:pt>
                <c:pt idx="206">
                  <c:v>809.93</c:v>
                </c:pt>
                <c:pt idx="207">
                  <c:v>811.45699999999999</c:v>
                </c:pt>
                <c:pt idx="208">
                  <c:v>813.64499999999998</c:v>
                </c:pt>
                <c:pt idx="209">
                  <c:v>815.84199999999998</c:v>
                </c:pt>
                <c:pt idx="210">
                  <c:v>821.22500000000002</c:v>
                </c:pt>
                <c:pt idx="211">
                  <c:v>821.75400000000002</c:v>
                </c:pt>
                <c:pt idx="212">
                  <c:v>822.83199999999999</c:v>
                </c:pt>
                <c:pt idx="213">
                  <c:v>824.25400000000002</c:v>
                </c:pt>
                <c:pt idx="214">
                  <c:v>825.29600000000005</c:v>
                </c:pt>
                <c:pt idx="215">
                  <c:v>825.81299999999999</c:v>
                </c:pt>
                <c:pt idx="216">
                  <c:v>827.66600000000005</c:v>
                </c:pt>
                <c:pt idx="217">
                  <c:v>830.71699999999998</c:v>
                </c:pt>
                <c:pt idx="218">
                  <c:v>833.57799999999997</c:v>
                </c:pt>
                <c:pt idx="219">
                  <c:v>838.553</c:v>
                </c:pt>
                <c:pt idx="220">
                  <c:v>839.49</c:v>
                </c:pt>
                <c:pt idx="221">
                  <c:v>841.07299999999998</c:v>
                </c:pt>
                <c:pt idx="222">
                  <c:v>842.94399999999996</c:v>
                </c:pt>
                <c:pt idx="223">
                  <c:v>845.40200000000004</c:v>
                </c:pt>
                <c:pt idx="224">
                  <c:v>846.23699999999997</c:v>
                </c:pt>
                <c:pt idx="225">
                  <c:v>851.31399999999996</c:v>
                </c:pt>
                <c:pt idx="226">
                  <c:v>857.22500000000002</c:v>
                </c:pt>
                <c:pt idx="227">
                  <c:v>861.90599999999995</c:v>
                </c:pt>
                <c:pt idx="228">
                  <c:v>863.13699999999994</c:v>
                </c:pt>
                <c:pt idx="229">
                  <c:v>867.68299999999999</c:v>
                </c:pt>
                <c:pt idx="230">
                  <c:v>869.04899999999998</c:v>
                </c:pt>
                <c:pt idx="231">
                  <c:v>869.79300000000001</c:v>
                </c:pt>
                <c:pt idx="232">
                  <c:v>870.83900000000006</c:v>
                </c:pt>
                <c:pt idx="233">
                  <c:v>871.01599999999996</c:v>
                </c:pt>
                <c:pt idx="234">
                  <c:v>871.23400000000004</c:v>
                </c:pt>
                <c:pt idx="235">
                  <c:v>872.16300000000001</c:v>
                </c:pt>
                <c:pt idx="236">
                  <c:v>872.654</c:v>
                </c:pt>
                <c:pt idx="237">
                  <c:v>872.67700000000002</c:v>
                </c:pt>
                <c:pt idx="238">
                  <c:v>873.28</c:v>
                </c:pt>
                <c:pt idx="239">
                  <c:v>873.94100000000003</c:v>
                </c:pt>
                <c:pt idx="240">
                  <c:v>874.96100000000001</c:v>
                </c:pt>
                <c:pt idx="241">
                  <c:v>877.78800000000001</c:v>
                </c:pt>
                <c:pt idx="242">
                  <c:v>880.87300000000005</c:v>
                </c:pt>
                <c:pt idx="243">
                  <c:v>886.596</c:v>
                </c:pt>
                <c:pt idx="244">
                  <c:v>886.78499999999997</c:v>
                </c:pt>
                <c:pt idx="245">
                  <c:v>892.697</c:v>
                </c:pt>
                <c:pt idx="246">
                  <c:v>898.60900000000004</c:v>
                </c:pt>
                <c:pt idx="247">
                  <c:v>902.02700000000004</c:v>
                </c:pt>
                <c:pt idx="248">
                  <c:v>903.77499999999998</c:v>
                </c:pt>
                <c:pt idx="249">
                  <c:v>904.38400000000001</c:v>
                </c:pt>
                <c:pt idx="250">
                  <c:v>904.52099999999996</c:v>
                </c:pt>
                <c:pt idx="251">
                  <c:v>905.24300000000005</c:v>
                </c:pt>
                <c:pt idx="252">
                  <c:v>905.47500000000002</c:v>
                </c:pt>
                <c:pt idx="253">
                  <c:v>905.59400000000005</c:v>
                </c:pt>
                <c:pt idx="254">
                  <c:v>906.85699999999997</c:v>
                </c:pt>
                <c:pt idx="255">
                  <c:v>908.077</c:v>
                </c:pt>
                <c:pt idx="256">
                  <c:v>908.28099999999995</c:v>
                </c:pt>
                <c:pt idx="257">
                  <c:v>908.39</c:v>
                </c:pt>
                <c:pt idx="258">
                  <c:v>908.46100000000001</c:v>
                </c:pt>
                <c:pt idx="259">
                  <c:v>910.01499999999999</c:v>
                </c:pt>
                <c:pt idx="260">
                  <c:v>910.43299999999999</c:v>
                </c:pt>
                <c:pt idx="261">
                  <c:v>912.81</c:v>
                </c:pt>
                <c:pt idx="262">
                  <c:v>914.63300000000004</c:v>
                </c:pt>
                <c:pt idx="263">
                  <c:v>914.83500000000004</c:v>
                </c:pt>
                <c:pt idx="264">
                  <c:v>916.34400000000005</c:v>
                </c:pt>
                <c:pt idx="265">
                  <c:v>919.31899999999996</c:v>
                </c:pt>
                <c:pt idx="266">
                  <c:v>922.25599999999997</c:v>
                </c:pt>
                <c:pt idx="267">
                  <c:v>924.06799999999998</c:v>
                </c:pt>
                <c:pt idx="268">
                  <c:v>927.91800000000001</c:v>
                </c:pt>
                <c:pt idx="269">
                  <c:v>928.16800000000001</c:v>
                </c:pt>
                <c:pt idx="270">
                  <c:v>929.16899999999998</c:v>
                </c:pt>
                <c:pt idx="271">
                  <c:v>929.38599999999997</c:v>
                </c:pt>
                <c:pt idx="272">
                  <c:v>931.65800000000002</c:v>
                </c:pt>
                <c:pt idx="273">
                  <c:v>934.08</c:v>
                </c:pt>
                <c:pt idx="274">
                  <c:v>935.66200000000003</c:v>
                </c:pt>
                <c:pt idx="275">
                  <c:v>939.99199999999996</c:v>
                </c:pt>
                <c:pt idx="276">
                  <c:v>940.76</c:v>
                </c:pt>
                <c:pt idx="277">
                  <c:v>942.54399999999998</c:v>
                </c:pt>
                <c:pt idx="278">
                  <c:v>942.65899999999999</c:v>
                </c:pt>
                <c:pt idx="279">
                  <c:v>942.92700000000002</c:v>
                </c:pt>
                <c:pt idx="280">
                  <c:v>943.25</c:v>
                </c:pt>
                <c:pt idx="281">
                  <c:v>943.97199999999998</c:v>
                </c:pt>
                <c:pt idx="282">
                  <c:v>944.92600000000004</c:v>
                </c:pt>
                <c:pt idx="283">
                  <c:v>945.904</c:v>
                </c:pt>
                <c:pt idx="284">
                  <c:v>946.58600000000001</c:v>
                </c:pt>
                <c:pt idx="285">
                  <c:v>950.89099999999996</c:v>
                </c:pt>
                <c:pt idx="286">
                  <c:v>951.34100000000001</c:v>
                </c:pt>
                <c:pt idx="287">
                  <c:v>951.81600000000003</c:v>
                </c:pt>
                <c:pt idx="288">
                  <c:v>952.02200000000005</c:v>
                </c:pt>
                <c:pt idx="289">
                  <c:v>954.51199999999994</c:v>
                </c:pt>
                <c:pt idx="290">
                  <c:v>957.72799999999995</c:v>
                </c:pt>
                <c:pt idx="291">
                  <c:v>963.61</c:v>
                </c:pt>
                <c:pt idx="292">
                  <c:v>963.64</c:v>
                </c:pt>
                <c:pt idx="293">
                  <c:v>964.79700000000003</c:v>
                </c:pt>
                <c:pt idx="294">
                  <c:v>965.86599999999999</c:v>
                </c:pt>
                <c:pt idx="295">
                  <c:v>966.89700000000005</c:v>
                </c:pt>
                <c:pt idx="296">
                  <c:v>967.923</c:v>
                </c:pt>
                <c:pt idx="297">
                  <c:v>969.55200000000002</c:v>
                </c:pt>
                <c:pt idx="298">
                  <c:v>975.36</c:v>
                </c:pt>
                <c:pt idx="299">
                  <c:v>975.46299999999997</c:v>
                </c:pt>
                <c:pt idx="300">
                  <c:v>978.64400000000001</c:v>
                </c:pt>
                <c:pt idx="301">
                  <c:v>979.18399999999997</c:v>
                </c:pt>
                <c:pt idx="302">
                  <c:v>981.375</c:v>
                </c:pt>
                <c:pt idx="303">
                  <c:v>982.45500000000004</c:v>
                </c:pt>
                <c:pt idx="304">
                  <c:v>984.32899999999995</c:v>
                </c:pt>
                <c:pt idx="305">
                  <c:v>986.05799999999999</c:v>
                </c:pt>
                <c:pt idx="306">
                  <c:v>986.505</c:v>
                </c:pt>
                <c:pt idx="307">
                  <c:v>986.95100000000002</c:v>
                </c:pt>
                <c:pt idx="308">
                  <c:v>987.28700000000003</c:v>
                </c:pt>
                <c:pt idx="309">
                  <c:v>989.64300000000003</c:v>
                </c:pt>
                <c:pt idx="310">
                  <c:v>993.19899999999996</c:v>
                </c:pt>
                <c:pt idx="311">
                  <c:v>993.39300000000003</c:v>
                </c:pt>
                <c:pt idx="312">
                  <c:v>996.30200000000002</c:v>
                </c:pt>
                <c:pt idx="313">
                  <c:v>998.99599999999998</c:v>
                </c:pt>
                <c:pt idx="314">
                  <c:v>999.11099999999999</c:v>
                </c:pt>
                <c:pt idx="315">
                  <c:v>1000.812</c:v>
                </c:pt>
                <c:pt idx="316">
                  <c:v>1002.628</c:v>
                </c:pt>
                <c:pt idx="317">
                  <c:v>1003.74</c:v>
                </c:pt>
                <c:pt idx="318">
                  <c:v>1004.55</c:v>
                </c:pt>
                <c:pt idx="319">
                  <c:v>1004.9059999999999</c:v>
                </c:pt>
                <c:pt idx="320">
                  <c:v>1004.9160000000001</c:v>
                </c:pt>
                <c:pt idx="321">
                  <c:v>1005.023</c:v>
                </c:pt>
                <c:pt idx="322">
                  <c:v>1010.1849999999999</c:v>
                </c:pt>
                <c:pt idx="323">
                  <c:v>1010.9349999999999</c:v>
                </c:pt>
                <c:pt idx="324">
                  <c:v>1011.436</c:v>
                </c:pt>
                <c:pt idx="325">
                  <c:v>1011.558</c:v>
                </c:pt>
                <c:pt idx="326">
                  <c:v>1012.432</c:v>
                </c:pt>
                <c:pt idx="327">
                  <c:v>1015.377</c:v>
                </c:pt>
                <c:pt idx="328">
                  <c:v>1016.283</c:v>
                </c:pt>
                <c:pt idx="329">
                  <c:v>1016.847</c:v>
                </c:pt>
                <c:pt idx="330">
                  <c:v>1019.622</c:v>
                </c:pt>
                <c:pt idx="331">
                  <c:v>1022.759</c:v>
                </c:pt>
                <c:pt idx="332">
                  <c:v>1023.24</c:v>
                </c:pt>
                <c:pt idx="333">
                  <c:v>1028.075</c:v>
                </c:pt>
                <c:pt idx="334">
                  <c:v>1028.451</c:v>
                </c:pt>
                <c:pt idx="335">
                  <c:v>1028.67</c:v>
                </c:pt>
                <c:pt idx="336">
                  <c:v>1032.5709999999999</c:v>
                </c:pt>
                <c:pt idx="337">
                  <c:v>1034.5820000000001</c:v>
                </c:pt>
                <c:pt idx="338">
                  <c:v>1039.2190000000001</c:v>
                </c:pt>
                <c:pt idx="339">
                  <c:v>1040.4939999999999</c:v>
                </c:pt>
                <c:pt idx="340">
                  <c:v>1045.0530000000001</c:v>
                </c:pt>
                <c:pt idx="341">
                  <c:v>1046.4059999999999</c:v>
                </c:pt>
                <c:pt idx="342">
                  <c:v>1047.4459999999999</c:v>
                </c:pt>
                <c:pt idx="343">
                  <c:v>1049.8389999999999</c:v>
                </c:pt>
                <c:pt idx="344">
                  <c:v>1050.6959999999999</c:v>
                </c:pt>
                <c:pt idx="345">
                  <c:v>1052.318</c:v>
                </c:pt>
                <c:pt idx="346">
                  <c:v>1053.819</c:v>
                </c:pt>
                <c:pt idx="347">
                  <c:v>1053.902</c:v>
                </c:pt>
                <c:pt idx="348">
                  <c:v>1053.981</c:v>
                </c:pt>
                <c:pt idx="349">
                  <c:v>1054.1959999999999</c:v>
                </c:pt>
                <c:pt idx="350">
                  <c:v>1054.93</c:v>
                </c:pt>
                <c:pt idx="351">
                  <c:v>1058.23</c:v>
                </c:pt>
                <c:pt idx="352">
                  <c:v>1059.125</c:v>
                </c:pt>
                <c:pt idx="353">
                  <c:v>1061.308</c:v>
                </c:pt>
                <c:pt idx="354">
                  <c:v>1062.9929999999999</c:v>
                </c:pt>
                <c:pt idx="355">
                  <c:v>1064.1420000000001</c:v>
                </c:pt>
                <c:pt idx="356">
                  <c:v>1065.2370000000001</c:v>
                </c:pt>
                <c:pt idx="357">
                  <c:v>1068.807</c:v>
                </c:pt>
                <c:pt idx="358">
                  <c:v>1070.0540000000001</c:v>
                </c:pt>
                <c:pt idx="359">
                  <c:v>1072.1990000000001</c:v>
                </c:pt>
                <c:pt idx="360">
                  <c:v>1074.3130000000001</c:v>
                </c:pt>
                <c:pt idx="361">
                  <c:v>1075.9659999999999</c:v>
                </c:pt>
                <c:pt idx="362">
                  <c:v>1077.1890000000001</c:v>
                </c:pt>
                <c:pt idx="363">
                  <c:v>1081.3979999999999</c:v>
                </c:pt>
                <c:pt idx="364">
                  <c:v>1081.52</c:v>
                </c:pt>
                <c:pt idx="365">
                  <c:v>1081.8779999999999</c:v>
                </c:pt>
                <c:pt idx="366">
                  <c:v>1084.2</c:v>
                </c:pt>
                <c:pt idx="367">
                  <c:v>1087.7270000000001</c:v>
                </c:pt>
                <c:pt idx="368">
                  <c:v>1087.789</c:v>
                </c:pt>
                <c:pt idx="369">
                  <c:v>1093.2070000000001</c:v>
                </c:pt>
                <c:pt idx="370">
                  <c:v>1093.701</c:v>
                </c:pt>
                <c:pt idx="371">
                  <c:v>1097.7149999999999</c:v>
                </c:pt>
                <c:pt idx="372">
                  <c:v>1098.421</c:v>
                </c:pt>
                <c:pt idx="373">
                  <c:v>1099.6130000000001</c:v>
                </c:pt>
                <c:pt idx="374">
                  <c:v>1100.635</c:v>
                </c:pt>
                <c:pt idx="375">
                  <c:v>1105.5250000000001</c:v>
                </c:pt>
                <c:pt idx="376">
                  <c:v>1106.067</c:v>
                </c:pt>
                <c:pt idx="377">
                  <c:v>1110.114</c:v>
                </c:pt>
                <c:pt idx="378">
                  <c:v>1111.4369999999999</c:v>
                </c:pt>
                <c:pt idx="379">
                  <c:v>1113.3820000000001</c:v>
                </c:pt>
                <c:pt idx="380">
                  <c:v>1114.7809999999999</c:v>
                </c:pt>
                <c:pt idx="381">
                  <c:v>1116.4290000000001</c:v>
                </c:pt>
                <c:pt idx="382">
                  <c:v>1117.3489999999999</c:v>
                </c:pt>
                <c:pt idx="383">
                  <c:v>1119.7080000000001</c:v>
                </c:pt>
                <c:pt idx="384">
                  <c:v>1122.866</c:v>
                </c:pt>
                <c:pt idx="385">
                  <c:v>1123.261</c:v>
                </c:pt>
                <c:pt idx="386">
                  <c:v>1128.019</c:v>
                </c:pt>
                <c:pt idx="387">
                  <c:v>1129.173</c:v>
                </c:pt>
                <c:pt idx="388">
                  <c:v>1135.085</c:v>
                </c:pt>
                <c:pt idx="389">
                  <c:v>1139.106</c:v>
                </c:pt>
                <c:pt idx="390">
                  <c:v>1140.9970000000001</c:v>
                </c:pt>
                <c:pt idx="391">
                  <c:v>1146.9079999999999</c:v>
                </c:pt>
                <c:pt idx="392">
                  <c:v>1148.0070000000001</c:v>
                </c:pt>
                <c:pt idx="393">
                  <c:v>1152.82</c:v>
                </c:pt>
                <c:pt idx="394">
                  <c:v>1153.473</c:v>
                </c:pt>
                <c:pt idx="395">
                  <c:v>1158.732</c:v>
                </c:pt>
                <c:pt idx="396">
                  <c:v>1164.163</c:v>
                </c:pt>
                <c:pt idx="397">
                  <c:v>1164.644</c:v>
                </c:pt>
                <c:pt idx="398">
                  <c:v>1170.556</c:v>
                </c:pt>
                <c:pt idx="399">
                  <c:v>1176.4680000000001</c:v>
                </c:pt>
                <c:pt idx="400">
                  <c:v>1182.3800000000001</c:v>
                </c:pt>
                <c:pt idx="401">
                  <c:v>1182.3800000000001</c:v>
                </c:pt>
              </c:numCache>
            </c:numRef>
          </c:xVal>
          <c:yVal>
            <c:numRef>
              <c:f>Foglio6!$B$1227:$B$1628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99.906000000000006</c:v>
                </c:pt>
                <c:pt idx="39">
                  <c:v>99.828999999999994</c:v>
                </c:pt>
                <c:pt idx="40">
                  <c:v>99.751999999999995</c:v>
                </c:pt>
                <c:pt idx="41">
                  <c:v>99.674999999999997</c:v>
                </c:pt>
                <c:pt idx="42">
                  <c:v>99.572999999999993</c:v>
                </c:pt>
                <c:pt idx="43">
                  <c:v>99.5</c:v>
                </c:pt>
                <c:pt idx="44">
                  <c:v>99.447999999999993</c:v>
                </c:pt>
                <c:pt idx="45">
                  <c:v>99.322000000000003</c:v>
                </c:pt>
                <c:pt idx="46">
                  <c:v>99.174000000000007</c:v>
                </c:pt>
                <c:pt idx="47">
                  <c:v>99</c:v>
                </c:pt>
                <c:pt idx="48">
                  <c:v>98.932000000000002</c:v>
                </c:pt>
                <c:pt idx="49">
                  <c:v>98.813000000000002</c:v>
                </c:pt>
                <c:pt idx="50">
                  <c:v>98.694999999999993</c:v>
                </c:pt>
                <c:pt idx="51">
                  <c:v>98.575999999999993</c:v>
                </c:pt>
                <c:pt idx="52">
                  <c:v>98.5</c:v>
                </c:pt>
                <c:pt idx="53">
                  <c:v>98.337000000000003</c:v>
                </c:pt>
                <c:pt idx="54">
                  <c:v>98.08</c:v>
                </c:pt>
                <c:pt idx="55">
                  <c:v>98</c:v>
                </c:pt>
                <c:pt idx="56">
                  <c:v>97.906000000000006</c:v>
                </c:pt>
                <c:pt idx="57">
                  <c:v>97.733000000000004</c:v>
                </c:pt>
                <c:pt idx="58">
                  <c:v>97.5</c:v>
                </c:pt>
                <c:pt idx="59">
                  <c:v>97.36</c:v>
                </c:pt>
                <c:pt idx="60">
                  <c:v>97</c:v>
                </c:pt>
                <c:pt idx="61">
                  <c:v>96.884</c:v>
                </c:pt>
                <c:pt idx="62">
                  <c:v>96.713999999999999</c:v>
                </c:pt>
                <c:pt idx="63">
                  <c:v>96.602999999999994</c:v>
                </c:pt>
                <c:pt idx="64">
                  <c:v>96.5</c:v>
                </c:pt>
                <c:pt idx="65">
                  <c:v>96.492000000000004</c:v>
                </c:pt>
                <c:pt idx="66">
                  <c:v>96.38</c:v>
                </c:pt>
                <c:pt idx="67">
                  <c:v>96</c:v>
                </c:pt>
                <c:pt idx="68">
                  <c:v>95.962000000000003</c:v>
                </c:pt>
                <c:pt idx="69">
                  <c:v>95.781000000000006</c:v>
                </c:pt>
                <c:pt idx="70">
                  <c:v>95.5</c:v>
                </c:pt>
                <c:pt idx="71">
                  <c:v>95.472999999999999</c:v>
                </c:pt>
                <c:pt idx="72">
                  <c:v>95.334000000000003</c:v>
                </c:pt>
                <c:pt idx="73">
                  <c:v>95.195999999999998</c:v>
                </c:pt>
                <c:pt idx="74">
                  <c:v>95.055000000000007</c:v>
                </c:pt>
                <c:pt idx="75">
                  <c:v>95</c:v>
                </c:pt>
                <c:pt idx="76">
                  <c:v>94.533000000000001</c:v>
                </c:pt>
                <c:pt idx="77">
                  <c:v>94.5</c:v>
                </c:pt>
                <c:pt idx="78">
                  <c:v>94.016000000000005</c:v>
                </c:pt>
                <c:pt idx="79">
                  <c:v>94</c:v>
                </c:pt>
                <c:pt idx="80">
                  <c:v>93.793000000000006</c:v>
                </c:pt>
                <c:pt idx="81">
                  <c:v>93.5</c:v>
                </c:pt>
                <c:pt idx="82">
                  <c:v>93.304000000000002</c:v>
                </c:pt>
                <c:pt idx="83">
                  <c:v>93</c:v>
                </c:pt>
                <c:pt idx="84">
                  <c:v>92.831000000000003</c:v>
                </c:pt>
                <c:pt idx="85">
                  <c:v>92.617000000000004</c:v>
                </c:pt>
                <c:pt idx="86">
                  <c:v>92.5</c:v>
                </c:pt>
                <c:pt idx="87">
                  <c:v>92.369</c:v>
                </c:pt>
                <c:pt idx="88">
                  <c:v>92</c:v>
                </c:pt>
                <c:pt idx="89">
                  <c:v>91.995000000000005</c:v>
                </c:pt>
                <c:pt idx="90">
                  <c:v>91.673000000000002</c:v>
                </c:pt>
                <c:pt idx="91">
                  <c:v>91.563999999999993</c:v>
                </c:pt>
                <c:pt idx="92">
                  <c:v>91.5</c:v>
                </c:pt>
                <c:pt idx="93">
                  <c:v>91.454999999999998</c:v>
                </c:pt>
                <c:pt idx="94">
                  <c:v>91.385000000000005</c:v>
                </c:pt>
                <c:pt idx="95">
                  <c:v>91.274000000000001</c:v>
                </c:pt>
                <c:pt idx="96">
                  <c:v>91</c:v>
                </c:pt>
                <c:pt idx="97">
                  <c:v>90.748000000000005</c:v>
                </c:pt>
                <c:pt idx="98">
                  <c:v>90.656000000000006</c:v>
                </c:pt>
                <c:pt idx="99">
                  <c:v>90.5</c:v>
                </c:pt>
                <c:pt idx="100">
                  <c:v>90.48</c:v>
                </c:pt>
                <c:pt idx="101">
                  <c:v>90.253</c:v>
                </c:pt>
                <c:pt idx="102">
                  <c:v>90</c:v>
                </c:pt>
                <c:pt idx="103">
                  <c:v>89.734999999999999</c:v>
                </c:pt>
                <c:pt idx="104">
                  <c:v>89.658000000000001</c:v>
                </c:pt>
                <c:pt idx="105">
                  <c:v>89.581000000000003</c:v>
                </c:pt>
                <c:pt idx="106">
                  <c:v>89.5</c:v>
                </c:pt>
                <c:pt idx="107">
                  <c:v>89.429000000000002</c:v>
                </c:pt>
                <c:pt idx="108">
                  <c:v>89.155000000000001</c:v>
                </c:pt>
                <c:pt idx="109">
                  <c:v>89</c:v>
                </c:pt>
                <c:pt idx="110">
                  <c:v>88.826999999999998</c:v>
                </c:pt>
                <c:pt idx="111">
                  <c:v>88.5</c:v>
                </c:pt>
                <c:pt idx="112">
                  <c:v>88.44</c:v>
                </c:pt>
                <c:pt idx="113">
                  <c:v>88</c:v>
                </c:pt>
                <c:pt idx="114">
                  <c:v>87.831999999999994</c:v>
                </c:pt>
                <c:pt idx="115">
                  <c:v>87.5</c:v>
                </c:pt>
                <c:pt idx="116">
                  <c:v>87.052000000000007</c:v>
                </c:pt>
                <c:pt idx="117">
                  <c:v>87</c:v>
                </c:pt>
                <c:pt idx="118">
                  <c:v>86.91</c:v>
                </c:pt>
                <c:pt idx="119">
                  <c:v>86.766999999999996</c:v>
                </c:pt>
                <c:pt idx="120">
                  <c:v>86.623999999999995</c:v>
                </c:pt>
                <c:pt idx="121">
                  <c:v>86.5</c:v>
                </c:pt>
                <c:pt idx="122">
                  <c:v>86.480999999999995</c:v>
                </c:pt>
                <c:pt idx="123">
                  <c:v>86.040999999999997</c:v>
                </c:pt>
                <c:pt idx="124">
                  <c:v>86</c:v>
                </c:pt>
                <c:pt idx="125">
                  <c:v>85.626999999999995</c:v>
                </c:pt>
                <c:pt idx="126">
                  <c:v>85.563000000000002</c:v>
                </c:pt>
                <c:pt idx="127">
                  <c:v>85.5</c:v>
                </c:pt>
                <c:pt idx="128">
                  <c:v>85.385999999999996</c:v>
                </c:pt>
                <c:pt idx="129">
                  <c:v>85.337999999999994</c:v>
                </c:pt>
                <c:pt idx="130">
                  <c:v>85.287000000000006</c:v>
                </c:pt>
                <c:pt idx="131">
                  <c:v>85.197000000000003</c:v>
                </c:pt>
                <c:pt idx="132">
                  <c:v>85.108000000000004</c:v>
                </c:pt>
                <c:pt idx="133">
                  <c:v>85</c:v>
                </c:pt>
                <c:pt idx="134">
                  <c:v>84.822999999999993</c:v>
                </c:pt>
                <c:pt idx="135">
                  <c:v>84.5</c:v>
                </c:pt>
                <c:pt idx="136">
                  <c:v>84.388000000000005</c:v>
                </c:pt>
                <c:pt idx="137">
                  <c:v>84.188000000000002</c:v>
                </c:pt>
                <c:pt idx="138">
                  <c:v>84</c:v>
                </c:pt>
                <c:pt idx="139">
                  <c:v>83.94</c:v>
                </c:pt>
                <c:pt idx="140">
                  <c:v>83.671000000000006</c:v>
                </c:pt>
                <c:pt idx="141">
                  <c:v>83.5</c:v>
                </c:pt>
                <c:pt idx="142">
                  <c:v>83.382999999999996</c:v>
                </c:pt>
                <c:pt idx="143">
                  <c:v>83.096000000000004</c:v>
                </c:pt>
                <c:pt idx="144">
                  <c:v>83</c:v>
                </c:pt>
                <c:pt idx="145">
                  <c:v>82.5</c:v>
                </c:pt>
                <c:pt idx="146">
                  <c:v>82</c:v>
                </c:pt>
                <c:pt idx="147">
                  <c:v>81.5</c:v>
                </c:pt>
                <c:pt idx="148">
                  <c:v>81.070999999999998</c:v>
                </c:pt>
                <c:pt idx="149">
                  <c:v>81</c:v>
                </c:pt>
                <c:pt idx="150">
                  <c:v>80.5</c:v>
                </c:pt>
                <c:pt idx="151">
                  <c:v>80.018000000000001</c:v>
                </c:pt>
                <c:pt idx="152">
                  <c:v>80</c:v>
                </c:pt>
                <c:pt idx="153">
                  <c:v>79.650000000000006</c:v>
                </c:pt>
                <c:pt idx="154">
                  <c:v>79.5</c:v>
                </c:pt>
                <c:pt idx="155">
                  <c:v>79.161000000000001</c:v>
                </c:pt>
                <c:pt idx="156">
                  <c:v>79</c:v>
                </c:pt>
                <c:pt idx="157">
                  <c:v>78.992999999999995</c:v>
                </c:pt>
                <c:pt idx="158">
                  <c:v>78.861000000000004</c:v>
                </c:pt>
                <c:pt idx="159">
                  <c:v>78.849000000000004</c:v>
                </c:pt>
                <c:pt idx="160">
                  <c:v>78.736999999999995</c:v>
                </c:pt>
                <c:pt idx="161">
                  <c:v>78.5</c:v>
                </c:pt>
                <c:pt idx="162">
                  <c:v>78.296000000000006</c:v>
                </c:pt>
                <c:pt idx="163">
                  <c:v>78</c:v>
                </c:pt>
                <c:pt idx="164">
                  <c:v>77.611999999999995</c:v>
                </c:pt>
                <c:pt idx="165">
                  <c:v>77.5</c:v>
                </c:pt>
                <c:pt idx="166">
                  <c:v>77</c:v>
                </c:pt>
                <c:pt idx="167">
                  <c:v>76.908000000000001</c:v>
                </c:pt>
                <c:pt idx="168">
                  <c:v>76.801000000000002</c:v>
                </c:pt>
                <c:pt idx="169">
                  <c:v>76.694000000000003</c:v>
                </c:pt>
                <c:pt idx="170">
                  <c:v>76.585999999999999</c:v>
                </c:pt>
                <c:pt idx="171">
                  <c:v>76.5</c:v>
                </c:pt>
                <c:pt idx="172">
                  <c:v>76.305000000000007</c:v>
                </c:pt>
                <c:pt idx="173">
                  <c:v>76</c:v>
                </c:pt>
                <c:pt idx="174">
                  <c:v>75.5</c:v>
                </c:pt>
                <c:pt idx="175">
                  <c:v>75</c:v>
                </c:pt>
                <c:pt idx="176">
                  <c:v>74.504000000000005</c:v>
                </c:pt>
                <c:pt idx="177">
                  <c:v>74.5</c:v>
                </c:pt>
                <c:pt idx="178">
                  <c:v>74.001999999999995</c:v>
                </c:pt>
                <c:pt idx="179">
                  <c:v>74</c:v>
                </c:pt>
                <c:pt idx="180">
                  <c:v>73.536000000000001</c:v>
                </c:pt>
                <c:pt idx="181">
                  <c:v>73.5</c:v>
                </c:pt>
                <c:pt idx="182">
                  <c:v>73.069999999999993</c:v>
                </c:pt>
                <c:pt idx="183">
                  <c:v>73</c:v>
                </c:pt>
                <c:pt idx="184">
                  <c:v>72.5</c:v>
                </c:pt>
                <c:pt idx="185">
                  <c:v>72</c:v>
                </c:pt>
                <c:pt idx="186">
                  <c:v>71.813999999999993</c:v>
                </c:pt>
                <c:pt idx="187">
                  <c:v>71.5</c:v>
                </c:pt>
                <c:pt idx="188">
                  <c:v>71.194999999999993</c:v>
                </c:pt>
                <c:pt idx="189">
                  <c:v>71</c:v>
                </c:pt>
                <c:pt idx="190">
                  <c:v>70.608999999999995</c:v>
                </c:pt>
                <c:pt idx="191">
                  <c:v>70.5</c:v>
                </c:pt>
                <c:pt idx="192">
                  <c:v>70</c:v>
                </c:pt>
                <c:pt idx="193">
                  <c:v>69.5</c:v>
                </c:pt>
                <c:pt idx="194">
                  <c:v>69</c:v>
                </c:pt>
                <c:pt idx="195">
                  <c:v>68.5</c:v>
                </c:pt>
                <c:pt idx="196">
                  <c:v>68</c:v>
                </c:pt>
                <c:pt idx="197">
                  <c:v>67.617000000000004</c:v>
                </c:pt>
                <c:pt idx="198">
                  <c:v>67.5</c:v>
                </c:pt>
                <c:pt idx="199">
                  <c:v>67.38</c:v>
                </c:pt>
                <c:pt idx="200">
                  <c:v>67.143000000000001</c:v>
                </c:pt>
                <c:pt idx="201">
                  <c:v>67</c:v>
                </c:pt>
                <c:pt idx="202">
                  <c:v>66.906999999999996</c:v>
                </c:pt>
                <c:pt idx="203">
                  <c:v>66.591999999999999</c:v>
                </c:pt>
                <c:pt idx="204">
                  <c:v>66.5</c:v>
                </c:pt>
                <c:pt idx="205">
                  <c:v>66</c:v>
                </c:pt>
                <c:pt idx="206">
                  <c:v>65.790000000000006</c:v>
                </c:pt>
                <c:pt idx="207">
                  <c:v>65.5</c:v>
                </c:pt>
                <c:pt idx="208">
                  <c:v>65</c:v>
                </c:pt>
                <c:pt idx="209">
                  <c:v>64.856999999999999</c:v>
                </c:pt>
                <c:pt idx="210">
                  <c:v>64.5</c:v>
                </c:pt>
                <c:pt idx="211">
                  <c:v>64.337999999999994</c:v>
                </c:pt>
                <c:pt idx="212">
                  <c:v>64</c:v>
                </c:pt>
                <c:pt idx="213">
                  <c:v>63.5</c:v>
                </c:pt>
                <c:pt idx="214">
                  <c:v>63</c:v>
                </c:pt>
                <c:pt idx="215">
                  <c:v>62.5</c:v>
                </c:pt>
                <c:pt idx="216">
                  <c:v>62.253</c:v>
                </c:pt>
                <c:pt idx="217">
                  <c:v>62</c:v>
                </c:pt>
                <c:pt idx="218">
                  <c:v>61.881999999999998</c:v>
                </c:pt>
                <c:pt idx="219">
                  <c:v>61.5</c:v>
                </c:pt>
                <c:pt idx="220">
                  <c:v>61.421999999999997</c:v>
                </c:pt>
                <c:pt idx="221">
                  <c:v>61</c:v>
                </c:pt>
                <c:pt idx="222">
                  <c:v>60.5</c:v>
                </c:pt>
                <c:pt idx="223">
                  <c:v>60.045999999999999</c:v>
                </c:pt>
                <c:pt idx="224">
                  <c:v>60</c:v>
                </c:pt>
                <c:pt idx="225">
                  <c:v>59.838999999999999</c:v>
                </c:pt>
                <c:pt idx="226">
                  <c:v>59.65</c:v>
                </c:pt>
                <c:pt idx="227">
                  <c:v>59.5</c:v>
                </c:pt>
                <c:pt idx="228">
                  <c:v>59.460999999999999</c:v>
                </c:pt>
                <c:pt idx="229">
                  <c:v>59</c:v>
                </c:pt>
                <c:pt idx="230">
                  <c:v>58.701999999999998</c:v>
                </c:pt>
                <c:pt idx="231">
                  <c:v>58.5</c:v>
                </c:pt>
                <c:pt idx="232">
                  <c:v>58</c:v>
                </c:pt>
                <c:pt idx="233">
                  <c:v>57.5</c:v>
                </c:pt>
                <c:pt idx="234">
                  <c:v>57</c:v>
                </c:pt>
                <c:pt idx="235">
                  <c:v>56.5</c:v>
                </c:pt>
                <c:pt idx="236">
                  <c:v>56</c:v>
                </c:pt>
                <c:pt idx="237">
                  <c:v>55.5</c:v>
                </c:pt>
                <c:pt idx="238">
                  <c:v>55</c:v>
                </c:pt>
                <c:pt idx="239">
                  <c:v>54.5</c:v>
                </c:pt>
                <c:pt idx="240">
                  <c:v>54.241999999999997</c:v>
                </c:pt>
                <c:pt idx="241">
                  <c:v>54</c:v>
                </c:pt>
                <c:pt idx="242">
                  <c:v>53.735999999999997</c:v>
                </c:pt>
                <c:pt idx="243">
                  <c:v>53.5</c:v>
                </c:pt>
                <c:pt idx="244">
                  <c:v>53.497</c:v>
                </c:pt>
                <c:pt idx="245">
                  <c:v>53.404000000000003</c:v>
                </c:pt>
                <c:pt idx="246">
                  <c:v>53.311</c:v>
                </c:pt>
                <c:pt idx="247">
                  <c:v>53</c:v>
                </c:pt>
                <c:pt idx="248">
                  <c:v>52.5</c:v>
                </c:pt>
                <c:pt idx="249">
                  <c:v>52</c:v>
                </c:pt>
                <c:pt idx="250">
                  <c:v>51.920999999999999</c:v>
                </c:pt>
                <c:pt idx="251">
                  <c:v>51.5</c:v>
                </c:pt>
                <c:pt idx="252">
                  <c:v>51</c:v>
                </c:pt>
                <c:pt idx="253">
                  <c:v>50.5</c:v>
                </c:pt>
                <c:pt idx="254">
                  <c:v>50</c:v>
                </c:pt>
                <c:pt idx="255">
                  <c:v>49.5</c:v>
                </c:pt>
                <c:pt idx="256">
                  <c:v>49</c:v>
                </c:pt>
                <c:pt idx="257">
                  <c:v>48.5</c:v>
                </c:pt>
                <c:pt idx="258">
                  <c:v>48</c:v>
                </c:pt>
                <c:pt idx="259">
                  <c:v>47.5</c:v>
                </c:pt>
                <c:pt idx="260">
                  <c:v>47.424999999999997</c:v>
                </c:pt>
                <c:pt idx="261">
                  <c:v>47</c:v>
                </c:pt>
                <c:pt idx="262">
                  <c:v>46.5</c:v>
                </c:pt>
                <c:pt idx="263">
                  <c:v>46</c:v>
                </c:pt>
                <c:pt idx="264">
                  <c:v>45.823</c:v>
                </c:pt>
                <c:pt idx="265">
                  <c:v>45.5</c:v>
                </c:pt>
                <c:pt idx="266">
                  <c:v>45.177</c:v>
                </c:pt>
                <c:pt idx="267">
                  <c:v>45</c:v>
                </c:pt>
                <c:pt idx="268">
                  <c:v>44.5</c:v>
                </c:pt>
                <c:pt idx="269">
                  <c:v>44.44</c:v>
                </c:pt>
                <c:pt idx="270">
                  <c:v>44</c:v>
                </c:pt>
                <c:pt idx="271">
                  <c:v>43.5</c:v>
                </c:pt>
                <c:pt idx="272">
                  <c:v>43</c:v>
                </c:pt>
                <c:pt idx="273">
                  <c:v>42.683</c:v>
                </c:pt>
                <c:pt idx="274">
                  <c:v>42.5</c:v>
                </c:pt>
                <c:pt idx="275">
                  <c:v>42.073</c:v>
                </c:pt>
                <c:pt idx="276">
                  <c:v>42</c:v>
                </c:pt>
                <c:pt idx="277">
                  <c:v>41.5</c:v>
                </c:pt>
                <c:pt idx="278">
                  <c:v>41</c:v>
                </c:pt>
                <c:pt idx="279">
                  <c:v>40.5</c:v>
                </c:pt>
                <c:pt idx="280">
                  <c:v>40</c:v>
                </c:pt>
                <c:pt idx="281">
                  <c:v>39.5</c:v>
                </c:pt>
                <c:pt idx="282">
                  <c:v>39</c:v>
                </c:pt>
                <c:pt idx="283">
                  <c:v>38.579000000000001</c:v>
                </c:pt>
                <c:pt idx="284">
                  <c:v>38.5</c:v>
                </c:pt>
                <c:pt idx="285">
                  <c:v>38</c:v>
                </c:pt>
                <c:pt idx="286">
                  <c:v>37.5</c:v>
                </c:pt>
                <c:pt idx="287">
                  <c:v>37.110999999999997</c:v>
                </c:pt>
                <c:pt idx="288">
                  <c:v>37</c:v>
                </c:pt>
                <c:pt idx="289">
                  <c:v>36.5</c:v>
                </c:pt>
                <c:pt idx="290">
                  <c:v>36.406999999999996</c:v>
                </c:pt>
                <c:pt idx="291">
                  <c:v>36</c:v>
                </c:pt>
                <c:pt idx="292">
                  <c:v>35.988</c:v>
                </c:pt>
                <c:pt idx="293">
                  <c:v>35.5</c:v>
                </c:pt>
                <c:pt idx="294">
                  <c:v>35</c:v>
                </c:pt>
                <c:pt idx="295">
                  <c:v>34.5</c:v>
                </c:pt>
                <c:pt idx="296">
                  <c:v>34</c:v>
                </c:pt>
                <c:pt idx="297">
                  <c:v>33.564</c:v>
                </c:pt>
                <c:pt idx="298">
                  <c:v>33.5</c:v>
                </c:pt>
                <c:pt idx="299">
                  <c:v>33.484000000000002</c:v>
                </c:pt>
                <c:pt idx="300">
                  <c:v>33</c:v>
                </c:pt>
                <c:pt idx="301">
                  <c:v>32.5</c:v>
                </c:pt>
                <c:pt idx="302">
                  <c:v>32.298000000000002</c:v>
                </c:pt>
                <c:pt idx="303">
                  <c:v>32</c:v>
                </c:pt>
                <c:pt idx="304">
                  <c:v>31.5</c:v>
                </c:pt>
                <c:pt idx="305">
                  <c:v>31</c:v>
                </c:pt>
                <c:pt idx="306">
                  <c:v>30.5</c:v>
                </c:pt>
                <c:pt idx="307">
                  <c:v>30</c:v>
                </c:pt>
                <c:pt idx="308">
                  <c:v>29.814</c:v>
                </c:pt>
                <c:pt idx="309">
                  <c:v>29.5</c:v>
                </c:pt>
                <c:pt idx="310">
                  <c:v>29.026</c:v>
                </c:pt>
                <c:pt idx="311">
                  <c:v>29</c:v>
                </c:pt>
                <c:pt idx="312">
                  <c:v>28.5</c:v>
                </c:pt>
                <c:pt idx="313">
                  <c:v>28</c:v>
                </c:pt>
                <c:pt idx="314">
                  <c:v>27.968</c:v>
                </c:pt>
                <c:pt idx="315">
                  <c:v>27.5</c:v>
                </c:pt>
                <c:pt idx="316">
                  <c:v>27</c:v>
                </c:pt>
                <c:pt idx="317">
                  <c:v>26.5</c:v>
                </c:pt>
                <c:pt idx="318">
                  <c:v>26</c:v>
                </c:pt>
                <c:pt idx="319">
                  <c:v>25.5</c:v>
                </c:pt>
                <c:pt idx="320">
                  <c:v>25</c:v>
                </c:pt>
                <c:pt idx="321">
                  <c:v>24.92</c:v>
                </c:pt>
                <c:pt idx="322">
                  <c:v>24.5</c:v>
                </c:pt>
                <c:pt idx="323">
                  <c:v>24.439</c:v>
                </c:pt>
                <c:pt idx="324">
                  <c:v>24</c:v>
                </c:pt>
                <c:pt idx="325">
                  <c:v>23.5</c:v>
                </c:pt>
                <c:pt idx="326">
                  <c:v>23</c:v>
                </c:pt>
                <c:pt idx="327">
                  <c:v>22.5</c:v>
                </c:pt>
                <c:pt idx="328">
                  <c:v>22</c:v>
                </c:pt>
                <c:pt idx="329">
                  <c:v>21.916</c:v>
                </c:pt>
                <c:pt idx="330">
                  <c:v>21.5</c:v>
                </c:pt>
                <c:pt idx="331">
                  <c:v>21.06</c:v>
                </c:pt>
                <c:pt idx="332">
                  <c:v>21</c:v>
                </c:pt>
                <c:pt idx="333">
                  <c:v>20.5</c:v>
                </c:pt>
                <c:pt idx="334">
                  <c:v>20</c:v>
                </c:pt>
                <c:pt idx="335">
                  <c:v>19.792999999999999</c:v>
                </c:pt>
                <c:pt idx="336">
                  <c:v>19.5</c:v>
                </c:pt>
                <c:pt idx="337">
                  <c:v>19.349</c:v>
                </c:pt>
                <c:pt idx="338">
                  <c:v>19</c:v>
                </c:pt>
                <c:pt idx="339">
                  <c:v>18.904</c:v>
                </c:pt>
                <c:pt idx="340">
                  <c:v>18.5</c:v>
                </c:pt>
                <c:pt idx="341">
                  <c:v>18.216999999999999</c:v>
                </c:pt>
                <c:pt idx="342">
                  <c:v>18</c:v>
                </c:pt>
                <c:pt idx="343">
                  <c:v>17.5</c:v>
                </c:pt>
                <c:pt idx="344">
                  <c:v>17</c:v>
                </c:pt>
                <c:pt idx="345">
                  <c:v>16.724</c:v>
                </c:pt>
                <c:pt idx="346">
                  <c:v>16.5</c:v>
                </c:pt>
                <c:pt idx="347">
                  <c:v>16</c:v>
                </c:pt>
                <c:pt idx="348">
                  <c:v>15.5</c:v>
                </c:pt>
                <c:pt idx="349">
                  <c:v>15</c:v>
                </c:pt>
                <c:pt idx="350">
                  <c:v>14.5</c:v>
                </c:pt>
                <c:pt idx="351">
                  <c:v>14.093999999999999</c:v>
                </c:pt>
                <c:pt idx="352">
                  <c:v>14</c:v>
                </c:pt>
                <c:pt idx="353">
                  <c:v>13.5</c:v>
                </c:pt>
                <c:pt idx="354">
                  <c:v>13</c:v>
                </c:pt>
                <c:pt idx="355">
                  <c:v>12.691000000000001</c:v>
                </c:pt>
                <c:pt idx="356">
                  <c:v>12.5</c:v>
                </c:pt>
                <c:pt idx="357">
                  <c:v>12</c:v>
                </c:pt>
                <c:pt idx="358">
                  <c:v>11.826000000000001</c:v>
                </c:pt>
                <c:pt idx="359">
                  <c:v>11.5</c:v>
                </c:pt>
                <c:pt idx="360">
                  <c:v>11</c:v>
                </c:pt>
                <c:pt idx="361">
                  <c:v>10.752000000000001</c:v>
                </c:pt>
                <c:pt idx="362">
                  <c:v>10.5</c:v>
                </c:pt>
                <c:pt idx="363">
                  <c:v>10</c:v>
                </c:pt>
                <c:pt idx="364">
                  <c:v>9.5</c:v>
                </c:pt>
                <c:pt idx="365">
                  <c:v>9.3409999999999993</c:v>
                </c:pt>
                <c:pt idx="366">
                  <c:v>9</c:v>
                </c:pt>
                <c:pt idx="367">
                  <c:v>8.5</c:v>
                </c:pt>
                <c:pt idx="368">
                  <c:v>8.4949999999999992</c:v>
                </c:pt>
                <c:pt idx="369">
                  <c:v>8</c:v>
                </c:pt>
                <c:pt idx="370">
                  <c:v>7.9489999999999998</c:v>
                </c:pt>
                <c:pt idx="371">
                  <c:v>7.5</c:v>
                </c:pt>
                <c:pt idx="372">
                  <c:v>7</c:v>
                </c:pt>
                <c:pt idx="373">
                  <c:v>6.5940000000000003</c:v>
                </c:pt>
                <c:pt idx="374">
                  <c:v>6.5</c:v>
                </c:pt>
                <c:pt idx="375">
                  <c:v>6.05</c:v>
                </c:pt>
                <c:pt idx="376">
                  <c:v>6</c:v>
                </c:pt>
                <c:pt idx="377">
                  <c:v>5.5</c:v>
                </c:pt>
                <c:pt idx="378">
                  <c:v>5.3049999999999997</c:v>
                </c:pt>
                <c:pt idx="379">
                  <c:v>5</c:v>
                </c:pt>
                <c:pt idx="380">
                  <c:v>4.5</c:v>
                </c:pt>
                <c:pt idx="381">
                  <c:v>4</c:v>
                </c:pt>
                <c:pt idx="382">
                  <c:v>3.8570000000000002</c:v>
                </c:pt>
                <c:pt idx="383">
                  <c:v>3.5</c:v>
                </c:pt>
                <c:pt idx="384">
                  <c:v>3</c:v>
                </c:pt>
                <c:pt idx="385">
                  <c:v>2.9590000000000001</c:v>
                </c:pt>
                <c:pt idx="386">
                  <c:v>2.5</c:v>
                </c:pt>
                <c:pt idx="387">
                  <c:v>2.403</c:v>
                </c:pt>
                <c:pt idx="388">
                  <c:v>2.1629999999999998</c:v>
                </c:pt>
                <c:pt idx="389">
                  <c:v>2</c:v>
                </c:pt>
                <c:pt idx="390">
                  <c:v>1.923</c:v>
                </c:pt>
                <c:pt idx="391">
                  <c:v>1.5820000000000001</c:v>
                </c:pt>
                <c:pt idx="392">
                  <c:v>1.5</c:v>
                </c:pt>
                <c:pt idx="393">
                  <c:v>1.0740000000000001</c:v>
                </c:pt>
                <c:pt idx="394">
                  <c:v>1</c:v>
                </c:pt>
                <c:pt idx="395">
                  <c:v>0.70499999999999996</c:v>
                </c:pt>
                <c:pt idx="396">
                  <c:v>0.5</c:v>
                </c:pt>
                <c:pt idx="397">
                  <c:v>0.48499999999999999</c:v>
                </c:pt>
                <c:pt idx="398">
                  <c:v>0.40500000000000003</c:v>
                </c:pt>
                <c:pt idx="399">
                  <c:v>0.32400000000000001</c:v>
                </c:pt>
                <c:pt idx="400">
                  <c:v>0.14899999999999999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55F-45DA-A1D6-04490D79AFD9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xVal>
            <c:numRef>
              <c:f>Foglio6!$C$1227:$C$1628</c:f>
              <c:numCache>
                <c:formatCode>General</c:formatCode>
                <c:ptCount val="402"/>
                <c:pt idx="0">
                  <c:v>0</c:v>
                </c:pt>
                <c:pt idx="1">
                  <c:v>6.1420000000000003</c:v>
                </c:pt>
                <c:pt idx="2">
                  <c:v>12.284000000000001</c:v>
                </c:pt>
                <c:pt idx="3">
                  <c:v>18.427</c:v>
                </c:pt>
                <c:pt idx="4">
                  <c:v>24.568999999999999</c:v>
                </c:pt>
                <c:pt idx="5">
                  <c:v>30.710999999999999</c:v>
                </c:pt>
                <c:pt idx="6">
                  <c:v>36.853000000000002</c:v>
                </c:pt>
                <c:pt idx="7">
                  <c:v>42.994999999999997</c:v>
                </c:pt>
                <c:pt idx="8">
                  <c:v>49.137999999999998</c:v>
                </c:pt>
                <c:pt idx="9">
                  <c:v>55.28</c:v>
                </c:pt>
                <c:pt idx="10">
                  <c:v>61.421999999999997</c:v>
                </c:pt>
                <c:pt idx="11">
                  <c:v>67.563999999999993</c:v>
                </c:pt>
                <c:pt idx="12">
                  <c:v>73.706000000000003</c:v>
                </c:pt>
                <c:pt idx="13">
                  <c:v>79.847999999999999</c:v>
                </c:pt>
                <c:pt idx="14">
                  <c:v>85.991</c:v>
                </c:pt>
                <c:pt idx="15">
                  <c:v>92.132999999999996</c:v>
                </c:pt>
                <c:pt idx="16">
                  <c:v>98.275000000000006</c:v>
                </c:pt>
                <c:pt idx="17">
                  <c:v>104.417</c:v>
                </c:pt>
                <c:pt idx="18">
                  <c:v>110.559</c:v>
                </c:pt>
                <c:pt idx="19">
                  <c:v>116.702</c:v>
                </c:pt>
                <c:pt idx="20">
                  <c:v>122.84399999999999</c:v>
                </c:pt>
                <c:pt idx="21">
                  <c:v>128.98599999999999</c:v>
                </c:pt>
                <c:pt idx="22">
                  <c:v>135.12799999999999</c:v>
                </c:pt>
                <c:pt idx="23">
                  <c:v>141.27000000000001</c:v>
                </c:pt>
                <c:pt idx="24">
                  <c:v>147.41300000000001</c:v>
                </c:pt>
                <c:pt idx="25">
                  <c:v>153.55500000000001</c:v>
                </c:pt>
                <c:pt idx="26">
                  <c:v>159.697</c:v>
                </c:pt>
                <c:pt idx="27">
                  <c:v>165.839</c:v>
                </c:pt>
                <c:pt idx="28">
                  <c:v>171.98099999999999</c:v>
                </c:pt>
                <c:pt idx="29">
                  <c:v>178.12299999999999</c:v>
                </c:pt>
                <c:pt idx="30">
                  <c:v>180.80099999999999</c:v>
                </c:pt>
                <c:pt idx="31">
                  <c:v>184.26599999999999</c:v>
                </c:pt>
                <c:pt idx="32">
                  <c:v>190.40799999999999</c:v>
                </c:pt>
                <c:pt idx="33">
                  <c:v>196.55</c:v>
                </c:pt>
                <c:pt idx="34">
                  <c:v>202.69200000000001</c:v>
                </c:pt>
                <c:pt idx="35">
                  <c:v>208.834</c:v>
                </c:pt>
                <c:pt idx="36">
                  <c:v>214.977</c:v>
                </c:pt>
                <c:pt idx="37">
                  <c:v>221.119</c:v>
                </c:pt>
                <c:pt idx="38">
                  <c:v>227.261</c:v>
                </c:pt>
                <c:pt idx="39">
                  <c:v>230.08600000000001</c:v>
                </c:pt>
                <c:pt idx="40">
                  <c:v>233.40299999999999</c:v>
                </c:pt>
                <c:pt idx="41">
                  <c:v>239.54499999999999</c:v>
                </c:pt>
                <c:pt idx="42">
                  <c:v>245.68799999999999</c:v>
                </c:pt>
                <c:pt idx="43">
                  <c:v>251.83</c:v>
                </c:pt>
                <c:pt idx="44">
                  <c:v>252.74299999999999</c:v>
                </c:pt>
                <c:pt idx="45">
                  <c:v>257.97199999999998</c:v>
                </c:pt>
                <c:pt idx="46">
                  <c:v>264.11399999999998</c:v>
                </c:pt>
                <c:pt idx="47">
                  <c:v>270.25599999999997</c:v>
                </c:pt>
                <c:pt idx="48">
                  <c:v>276.39800000000002</c:v>
                </c:pt>
                <c:pt idx="49">
                  <c:v>277.44400000000002</c:v>
                </c:pt>
                <c:pt idx="50">
                  <c:v>282.541</c:v>
                </c:pt>
                <c:pt idx="51">
                  <c:v>288.68299999999999</c:v>
                </c:pt>
                <c:pt idx="52">
                  <c:v>294.82499999999999</c:v>
                </c:pt>
                <c:pt idx="53">
                  <c:v>298.09899999999999</c:v>
                </c:pt>
                <c:pt idx="54">
                  <c:v>300.96699999999998</c:v>
                </c:pt>
                <c:pt idx="55">
                  <c:v>307.10899999999998</c:v>
                </c:pt>
                <c:pt idx="56">
                  <c:v>313.25200000000001</c:v>
                </c:pt>
                <c:pt idx="57">
                  <c:v>314.404</c:v>
                </c:pt>
                <c:pt idx="58">
                  <c:v>319.39400000000001</c:v>
                </c:pt>
                <c:pt idx="59">
                  <c:v>325.536</c:v>
                </c:pt>
                <c:pt idx="60">
                  <c:v>331.08300000000003</c:v>
                </c:pt>
                <c:pt idx="61">
                  <c:v>331.678</c:v>
                </c:pt>
                <c:pt idx="62">
                  <c:v>337.82</c:v>
                </c:pt>
                <c:pt idx="63">
                  <c:v>343.96300000000002</c:v>
                </c:pt>
                <c:pt idx="64">
                  <c:v>345.161</c:v>
                </c:pt>
                <c:pt idx="65">
                  <c:v>350.10500000000002</c:v>
                </c:pt>
                <c:pt idx="66">
                  <c:v>356.24700000000001</c:v>
                </c:pt>
                <c:pt idx="67">
                  <c:v>362.38900000000001</c:v>
                </c:pt>
                <c:pt idx="68">
                  <c:v>364.65300000000002</c:v>
                </c:pt>
                <c:pt idx="69">
                  <c:v>368.53100000000001</c:v>
                </c:pt>
                <c:pt idx="70">
                  <c:v>374.673</c:v>
                </c:pt>
                <c:pt idx="71">
                  <c:v>380.81599999999997</c:v>
                </c:pt>
                <c:pt idx="72">
                  <c:v>386.166</c:v>
                </c:pt>
                <c:pt idx="73">
                  <c:v>386.95800000000003</c:v>
                </c:pt>
                <c:pt idx="74">
                  <c:v>393.1</c:v>
                </c:pt>
                <c:pt idx="75">
                  <c:v>394.33199999999999</c:v>
                </c:pt>
                <c:pt idx="76">
                  <c:v>399.24200000000002</c:v>
                </c:pt>
                <c:pt idx="77">
                  <c:v>404.85599999999999</c:v>
                </c:pt>
                <c:pt idx="78">
                  <c:v>405.38400000000001</c:v>
                </c:pt>
                <c:pt idx="79">
                  <c:v>411.52699999999999</c:v>
                </c:pt>
                <c:pt idx="80">
                  <c:v>415.83699999999999</c:v>
                </c:pt>
                <c:pt idx="81">
                  <c:v>417.66899999999998</c:v>
                </c:pt>
                <c:pt idx="82">
                  <c:v>423.24900000000002</c:v>
                </c:pt>
                <c:pt idx="83">
                  <c:v>423.81099999999998</c:v>
                </c:pt>
                <c:pt idx="84">
                  <c:v>429.95299999999997</c:v>
                </c:pt>
                <c:pt idx="85">
                  <c:v>433.91500000000002</c:v>
                </c:pt>
                <c:pt idx="86">
                  <c:v>434.98500000000001</c:v>
                </c:pt>
                <c:pt idx="87">
                  <c:v>436.09500000000003</c:v>
                </c:pt>
                <c:pt idx="88">
                  <c:v>442.238</c:v>
                </c:pt>
                <c:pt idx="89">
                  <c:v>446.04700000000003</c:v>
                </c:pt>
                <c:pt idx="90">
                  <c:v>448.38</c:v>
                </c:pt>
                <c:pt idx="91">
                  <c:v>454.52199999999999</c:v>
                </c:pt>
                <c:pt idx="92">
                  <c:v>455.762</c:v>
                </c:pt>
                <c:pt idx="93">
                  <c:v>460.66399999999999</c:v>
                </c:pt>
                <c:pt idx="94">
                  <c:v>466.80599999999998</c:v>
                </c:pt>
                <c:pt idx="95">
                  <c:v>469.71100000000001</c:v>
                </c:pt>
                <c:pt idx="96">
                  <c:v>472.94799999999998</c:v>
                </c:pt>
                <c:pt idx="97">
                  <c:v>479.09100000000001</c:v>
                </c:pt>
                <c:pt idx="98">
                  <c:v>485.233</c:v>
                </c:pt>
                <c:pt idx="99">
                  <c:v>491.22800000000001</c:v>
                </c:pt>
                <c:pt idx="100">
                  <c:v>491.375</c:v>
                </c:pt>
                <c:pt idx="101">
                  <c:v>497.517</c:v>
                </c:pt>
                <c:pt idx="102">
                  <c:v>503.65899999999999</c:v>
                </c:pt>
                <c:pt idx="103">
                  <c:v>506.33199999999999</c:v>
                </c:pt>
                <c:pt idx="104">
                  <c:v>509.80200000000002</c:v>
                </c:pt>
                <c:pt idx="105">
                  <c:v>515.94399999999996</c:v>
                </c:pt>
                <c:pt idx="106">
                  <c:v>518.30200000000002</c:v>
                </c:pt>
                <c:pt idx="107">
                  <c:v>521.24400000000003</c:v>
                </c:pt>
                <c:pt idx="108">
                  <c:v>522.08600000000001</c:v>
                </c:pt>
                <c:pt idx="109">
                  <c:v>525.79499999999996</c:v>
                </c:pt>
                <c:pt idx="110">
                  <c:v>528.22799999999995</c:v>
                </c:pt>
                <c:pt idx="111">
                  <c:v>534.37</c:v>
                </c:pt>
                <c:pt idx="112">
                  <c:v>540.51300000000003</c:v>
                </c:pt>
                <c:pt idx="113">
                  <c:v>540.76</c:v>
                </c:pt>
                <c:pt idx="114">
                  <c:v>546.65499999999997</c:v>
                </c:pt>
                <c:pt idx="115">
                  <c:v>549.29899999999998</c:v>
                </c:pt>
                <c:pt idx="116">
                  <c:v>552.79700000000003</c:v>
                </c:pt>
                <c:pt idx="117">
                  <c:v>558.11900000000003</c:v>
                </c:pt>
                <c:pt idx="118">
                  <c:v>558.93899999999996</c:v>
                </c:pt>
                <c:pt idx="119">
                  <c:v>565.08100000000002</c:v>
                </c:pt>
                <c:pt idx="120">
                  <c:v>571.22299999999996</c:v>
                </c:pt>
                <c:pt idx="121">
                  <c:v>575.51700000000005</c:v>
                </c:pt>
                <c:pt idx="122">
                  <c:v>577.36599999999999</c:v>
                </c:pt>
                <c:pt idx="123">
                  <c:v>581.51599999999996</c:v>
                </c:pt>
                <c:pt idx="124">
                  <c:v>583.50800000000004</c:v>
                </c:pt>
                <c:pt idx="125">
                  <c:v>589.65</c:v>
                </c:pt>
                <c:pt idx="126">
                  <c:v>593.95899999999995</c:v>
                </c:pt>
                <c:pt idx="127">
                  <c:v>595.79200000000003</c:v>
                </c:pt>
                <c:pt idx="128">
                  <c:v>601.93399999999997</c:v>
                </c:pt>
                <c:pt idx="129">
                  <c:v>608.077</c:v>
                </c:pt>
                <c:pt idx="130">
                  <c:v>614.21900000000005</c:v>
                </c:pt>
                <c:pt idx="131">
                  <c:v>618.91600000000005</c:v>
                </c:pt>
                <c:pt idx="132">
                  <c:v>620.36099999999999</c:v>
                </c:pt>
                <c:pt idx="133">
                  <c:v>621.952</c:v>
                </c:pt>
                <c:pt idx="134">
                  <c:v>626.50300000000004</c:v>
                </c:pt>
                <c:pt idx="135">
                  <c:v>632.64499999999998</c:v>
                </c:pt>
                <c:pt idx="136">
                  <c:v>638.78800000000001</c:v>
                </c:pt>
                <c:pt idx="137">
                  <c:v>643.31100000000004</c:v>
                </c:pt>
                <c:pt idx="138">
                  <c:v>644.92999999999995</c:v>
                </c:pt>
                <c:pt idx="139">
                  <c:v>651.072</c:v>
                </c:pt>
                <c:pt idx="140">
                  <c:v>657.21400000000006</c:v>
                </c:pt>
                <c:pt idx="141">
                  <c:v>659.71199999999999</c:v>
                </c:pt>
                <c:pt idx="142">
                  <c:v>663.35599999999999</c:v>
                </c:pt>
                <c:pt idx="143">
                  <c:v>669.49800000000005</c:v>
                </c:pt>
                <c:pt idx="144">
                  <c:v>675.64099999999996</c:v>
                </c:pt>
                <c:pt idx="145">
                  <c:v>677.82799999999997</c:v>
                </c:pt>
                <c:pt idx="146">
                  <c:v>679.09</c:v>
                </c:pt>
                <c:pt idx="147">
                  <c:v>679.78</c:v>
                </c:pt>
                <c:pt idx="148">
                  <c:v>680.11900000000003</c:v>
                </c:pt>
                <c:pt idx="149">
                  <c:v>681.13199999999995</c:v>
                </c:pt>
                <c:pt idx="150">
                  <c:v>681.78300000000002</c:v>
                </c:pt>
                <c:pt idx="151">
                  <c:v>683.89</c:v>
                </c:pt>
                <c:pt idx="152">
                  <c:v>686.91800000000001</c:v>
                </c:pt>
                <c:pt idx="153">
                  <c:v>687.92499999999995</c:v>
                </c:pt>
                <c:pt idx="154">
                  <c:v>694.06700000000001</c:v>
                </c:pt>
                <c:pt idx="155">
                  <c:v>696.61800000000005</c:v>
                </c:pt>
                <c:pt idx="156">
                  <c:v>700.20899999999995</c:v>
                </c:pt>
                <c:pt idx="157">
                  <c:v>705.06500000000005</c:v>
                </c:pt>
                <c:pt idx="158">
                  <c:v>706.35199999999998</c:v>
                </c:pt>
                <c:pt idx="159">
                  <c:v>709.45899999999995</c:v>
                </c:pt>
                <c:pt idx="160">
                  <c:v>710.63</c:v>
                </c:pt>
                <c:pt idx="161">
                  <c:v>712.49400000000003</c:v>
                </c:pt>
                <c:pt idx="162">
                  <c:v>717.71500000000003</c:v>
                </c:pt>
                <c:pt idx="163">
                  <c:v>718.63599999999997</c:v>
                </c:pt>
                <c:pt idx="164">
                  <c:v>724.77800000000002</c:v>
                </c:pt>
                <c:pt idx="165">
                  <c:v>730.92</c:v>
                </c:pt>
                <c:pt idx="166">
                  <c:v>737.06299999999999</c:v>
                </c:pt>
                <c:pt idx="167">
                  <c:v>740.15899999999999</c:v>
                </c:pt>
                <c:pt idx="168">
                  <c:v>743.20500000000004</c:v>
                </c:pt>
                <c:pt idx="169">
                  <c:v>749.34699999999998</c:v>
                </c:pt>
                <c:pt idx="170">
                  <c:v>755.48900000000003</c:v>
                </c:pt>
                <c:pt idx="171">
                  <c:v>760.13800000000003</c:v>
                </c:pt>
                <c:pt idx="172">
                  <c:v>761.34100000000001</c:v>
                </c:pt>
                <c:pt idx="173">
                  <c:v>761.63099999999997</c:v>
                </c:pt>
                <c:pt idx="174">
                  <c:v>766.23099999999999</c:v>
                </c:pt>
                <c:pt idx="175">
                  <c:v>767.77300000000002</c:v>
                </c:pt>
                <c:pt idx="176">
                  <c:v>769.23299999999995</c:v>
                </c:pt>
                <c:pt idx="177">
                  <c:v>769.745</c:v>
                </c:pt>
                <c:pt idx="178">
                  <c:v>772.11500000000001</c:v>
                </c:pt>
                <c:pt idx="179">
                  <c:v>773.91600000000005</c:v>
                </c:pt>
                <c:pt idx="180">
                  <c:v>775.91399999999999</c:v>
                </c:pt>
                <c:pt idx="181">
                  <c:v>780.05799999999999</c:v>
                </c:pt>
                <c:pt idx="182">
                  <c:v>781.18600000000004</c:v>
                </c:pt>
                <c:pt idx="183">
                  <c:v>786.2</c:v>
                </c:pt>
                <c:pt idx="184">
                  <c:v>790.13400000000001</c:v>
                </c:pt>
                <c:pt idx="185">
                  <c:v>792.34199999999998</c:v>
                </c:pt>
                <c:pt idx="186">
                  <c:v>794.99300000000005</c:v>
                </c:pt>
                <c:pt idx="187">
                  <c:v>798.48400000000004</c:v>
                </c:pt>
                <c:pt idx="188">
                  <c:v>799.30200000000002</c:v>
                </c:pt>
                <c:pt idx="189">
                  <c:v>803.67100000000005</c:v>
                </c:pt>
                <c:pt idx="190">
                  <c:v>804.62699999999995</c:v>
                </c:pt>
                <c:pt idx="191">
                  <c:v>806.31399999999996</c:v>
                </c:pt>
                <c:pt idx="192">
                  <c:v>808.55499999999995</c:v>
                </c:pt>
                <c:pt idx="193">
                  <c:v>809.99800000000005</c:v>
                </c:pt>
                <c:pt idx="194">
                  <c:v>810.76900000000001</c:v>
                </c:pt>
                <c:pt idx="195">
                  <c:v>810.79300000000001</c:v>
                </c:pt>
                <c:pt idx="196">
                  <c:v>811.53</c:v>
                </c:pt>
                <c:pt idx="197">
                  <c:v>811.95799999999997</c:v>
                </c:pt>
                <c:pt idx="198">
                  <c:v>812.38499999999999</c:v>
                </c:pt>
                <c:pt idx="199">
                  <c:v>815.07500000000005</c:v>
                </c:pt>
                <c:pt idx="200">
                  <c:v>816.91099999999994</c:v>
                </c:pt>
                <c:pt idx="201">
                  <c:v>818.57600000000002</c:v>
                </c:pt>
                <c:pt idx="202">
                  <c:v>823.053</c:v>
                </c:pt>
                <c:pt idx="203">
                  <c:v>829.19500000000005</c:v>
                </c:pt>
                <c:pt idx="204">
                  <c:v>831.63199999999995</c:v>
                </c:pt>
                <c:pt idx="205">
                  <c:v>835.33799999999997</c:v>
                </c:pt>
                <c:pt idx="206">
                  <c:v>837.30499999999995</c:v>
                </c:pt>
                <c:pt idx="207">
                  <c:v>838.65499999999997</c:v>
                </c:pt>
                <c:pt idx="208">
                  <c:v>839.77200000000005</c:v>
                </c:pt>
                <c:pt idx="209">
                  <c:v>841.48</c:v>
                </c:pt>
                <c:pt idx="210">
                  <c:v>845.327</c:v>
                </c:pt>
                <c:pt idx="211">
                  <c:v>847.62199999999996</c:v>
                </c:pt>
                <c:pt idx="212">
                  <c:v>847.94399999999996</c:v>
                </c:pt>
                <c:pt idx="213">
                  <c:v>849.80499999999995</c:v>
                </c:pt>
                <c:pt idx="214">
                  <c:v>851.66399999999999</c:v>
                </c:pt>
                <c:pt idx="215">
                  <c:v>853.76400000000001</c:v>
                </c:pt>
                <c:pt idx="216">
                  <c:v>854.07500000000005</c:v>
                </c:pt>
                <c:pt idx="217">
                  <c:v>858.02499999999998</c:v>
                </c:pt>
                <c:pt idx="218">
                  <c:v>859.90599999999995</c:v>
                </c:pt>
                <c:pt idx="219">
                  <c:v>861.96199999999999</c:v>
                </c:pt>
                <c:pt idx="220">
                  <c:v>863.59</c:v>
                </c:pt>
                <c:pt idx="221">
                  <c:v>866.048</c:v>
                </c:pt>
                <c:pt idx="222">
                  <c:v>868.38599999999997</c:v>
                </c:pt>
                <c:pt idx="223">
                  <c:v>872.19100000000003</c:v>
                </c:pt>
                <c:pt idx="224">
                  <c:v>874.10500000000002</c:v>
                </c:pt>
                <c:pt idx="225">
                  <c:v>877.274</c:v>
                </c:pt>
                <c:pt idx="226">
                  <c:v>878.33299999999997</c:v>
                </c:pt>
                <c:pt idx="227">
                  <c:v>879.38499999999999</c:v>
                </c:pt>
                <c:pt idx="228">
                  <c:v>881.86900000000003</c:v>
                </c:pt>
                <c:pt idx="229">
                  <c:v>883.54499999999996</c:v>
                </c:pt>
                <c:pt idx="230">
                  <c:v>884.47500000000002</c:v>
                </c:pt>
                <c:pt idx="231">
                  <c:v>885.22</c:v>
                </c:pt>
                <c:pt idx="232">
                  <c:v>887.48099999999999</c:v>
                </c:pt>
                <c:pt idx="233">
                  <c:v>889.30899999999997</c:v>
                </c:pt>
                <c:pt idx="234">
                  <c:v>890.28399999999999</c:v>
                </c:pt>
                <c:pt idx="235">
                  <c:v>890.61699999999996</c:v>
                </c:pt>
                <c:pt idx="236">
                  <c:v>891.56700000000001</c:v>
                </c:pt>
                <c:pt idx="237">
                  <c:v>892.84900000000005</c:v>
                </c:pt>
                <c:pt idx="238">
                  <c:v>893.50099999999998</c:v>
                </c:pt>
                <c:pt idx="239">
                  <c:v>895.05</c:v>
                </c:pt>
                <c:pt idx="240">
                  <c:v>896.75900000000001</c:v>
                </c:pt>
                <c:pt idx="241">
                  <c:v>899.99900000000002</c:v>
                </c:pt>
                <c:pt idx="242">
                  <c:v>902.90200000000004</c:v>
                </c:pt>
                <c:pt idx="243">
                  <c:v>909.04399999999998</c:v>
                </c:pt>
                <c:pt idx="244">
                  <c:v>911.654</c:v>
                </c:pt>
                <c:pt idx="245">
                  <c:v>915.18600000000004</c:v>
                </c:pt>
                <c:pt idx="246">
                  <c:v>921.32799999999997</c:v>
                </c:pt>
                <c:pt idx="247">
                  <c:v>924.66200000000003</c:v>
                </c:pt>
                <c:pt idx="248">
                  <c:v>927.47</c:v>
                </c:pt>
                <c:pt idx="249">
                  <c:v>930.452</c:v>
                </c:pt>
                <c:pt idx="250">
                  <c:v>933.61300000000006</c:v>
                </c:pt>
                <c:pt idx="251">
                  <c:v>934.02800000000002</c:v>
                </c:pt>
                <c:pt idx="252">
                  <c:v>937.07799999999997</c:v>
                </c:pt>
                <c:pt idx="253">
                  <c:v>938.06399999999996</c:v>
                </c:pt>
                <c:pt idx="254">
                  <c:v>939.43399999999997</c:v>
                </c:pt>
                <c:pt idx="255">
                  <c:v>939.755</c:v>
                </c:pt>
                <c:pt idx="256">
                  <c:v>941.65</c:v>
                </c:pt>
                <c:pt idx="257">
                  <c:v>943.80399999999997</c:v>
                </c:pt>
                <c:pt idx="258">
                  <c:v>944.33100000000002</c:v>
                </c:pt>
                <c:pt idx="259">
                  <c:v>944.85799999999995</c:v>
                </c:pt>
                <c:pt idx="260">
                  <c:v>945.20399999999995</c:v>
                </c:pt>
                <c:pt idx="261">
                  <c:v>945.52200000000005</c:v>
                </c:pt>
                <c:pt idx="262">
                  <c:v>945.89700000000005</c:v>
                </c:pt>
                <c:pt idx="263">
                  <c:v>945.94799999999998</c:v>
                </c:pt>
                <c:pt idx="264">
                  <c:v>946.37699999999995</c:v>
                </c:pt>
                <c:pt idx="265">
                  <c:v>951.27200000000005</c:v>
                </c:pt>
                <c:pt idx="266">
                  <c:v>952.03899999999999</c:v>
                </c:pt>
                <c:pt idx="267">
                  <c:v>954.46600000000001</c:v>
                </c:pt>
                <c:pt idx="268">
                  <c:v>956.351</c:v>
                </c:pt>
                <c:pt idx="269">
                  <c:v>958.18100000000004</c:v>
                </c:pt>
                <c:pt idx="270">
                  <c:v>960.40700000000004</c:v>
                </c:pt>
                <c:pt idx="271">
                  <c:v>964.32299999999998</c:v>
                </c:pt>
                <c:pt idx="272">
                  <c:v>964.46400000000006</c:v>
                </c:pt>
                <c:pt idx="273">
                  <c:v>967.03499999999997</c:v>
                </c:pt>
                <c:pt idx="274">
                  <c:v>970.46600000000001</c:v>
                </c:pt>
                <c:pt idx="275">
                  <c:v>971.65800000000002</c:v>
                </c:pt>
                <c:pt idx="276">
                  <c:v>975.58699999999999</c:v>
                </c:pt>
                <c:pt idx="277">
                  <c:v>976.59900000000005</c:v>
                </c:pt>
                <c:pt idx="278">
                  <c:v>976.60799999999995</c:v>
                </c:pt>
                <c:pt idx="279">
                  <c:v>978.63599999999997</c:v>
                </c:pt>
                <c:pt idx="280">
                  <c:v>980.94</c:v>
                </c:pt>
                <c:pt idx="281">
                  <c:v>982.12099999999998</c:v>
                </c:pt>
                <c:pt idx="282">
                  <c:v>982.75</c:v>
                </c:pt>
                <c:pt idx="283">
                  <c:v>983.18399999999997</c:v>
                </c:pt>
                <c:pt idx="284">
                  <c:v>984.24699999999996</c:v>
                </c:pt>
                <c:pt idx="285">
                  <c:v>985.65599999999995</c:v>
                </c:pt>
                <c:pt idx="286">
                  <c:v>988.21299999999997</c:v>
                </c:pt>
                <c:pt idx="287">
                  <c:v>988.89200000000005</c:v>
                </c:pt>
                <c:pt idx="288">
                  <c:v>990.34699999999998</c:v>
                </c:pt>
                <c:pt idx="289">
                  <c:v>992.23099999999999</c:v>
                </c:pt>
                <c:pt idx="290">
                  <c:v>993.54300000000001</c:v>
                </c:pt>
                <c:pt idx="291">
                  <c:v>995.03399999999999</c:v>
                </c:pt>
                <c:pt idx="292">
                  <c:v>997.72699999999998</c:v>
                </c:pt>
                <c:pt idx="293">
                  <c:v>1001.177</c:v>
                </c:pt>
                <c:pt idx="294">
                  <c:v>1003.074</c:v>
                </c:pt>
                <c:pt idx="295">
                  <c:v>1003.163</c:v>
                </c:pt>
                <c:pt idx="296">
                  <c:v>1007.319</c:v>
                </c:pt>
                <c:pt idx="297">
                  <c:v>1013.447</c:v>
                </c:pt>
                <c:pt idx="298">
                  <c:v>1013.461</c:v>
                </c:pt>
                <c:pt idx="299">
                  <c:v>1013.837</c:v>
                </c:pt>
                <c:pt idx="300">
                  <c:v>1014.74</c:v>
                </c:pt>
                <c:pt idx="301">
                  <c:v>1015.766</c:v>
                </c:pt>
                <c:pt idx="302">
                  <c:v>1017.159</c:v>
                </c:pt>
                <c:pt idx="303">
                  <c:v>1019.067</c:v>
                </c:pt>
                <c:pt idx="304">
                  <c:v>1019.603</c:v>
                </c:pt>
                <c:pt idx="305">
                  <c:v>1020.921</c:v>
                </c:pt>
                <c:pt idx="306">
                  <c:v>1020.941</c:v>
                </c:pt>
                <c:pt idx="307">
                  <c:v>1020.96</c:v>
                </c:pt>
                <c:pt idx="308">
                  <c:v>1021.256</c:v>
                </c:pt>
                <c:pt idx="309">
                  <c:v>1021.73</c:v>
                </c:pt>
                <c:pt idx="310">
                  <c:v>1022.295</c:v>
                </c:pt>
                <c:pt idx="311">
                  <c:v>1023.255</c:v>
                </c:pt>
                <c:pt idx="312">
                  <c:v>1024.2190000000001</c:v>
                </c:pt>
                <c:pt idx="313">
                  <c:v>1025.68</c:v>
                </c:pt>
                <c:pt idx="314">
                  <c:v>1025.7449999999999</c:v>
                </c:pt>
                <c:pt idx="315">
                  <c:v>1031.8879999999999</c:v>
                </c:pt>
                <c:pt idx="316">
                  <c:v>1032.5170000000001</c:v>
                </c:pt>
                <c:pt idx="317">
                  <c:v>1038.03</c:v>
                </c:pt>
                <c:pt idx="318">
                  <c:v>1041.578</c:v>
                </c:pt>
                <c:pt idx="319">
                  <c:v>1043.1389999999999</c:v>
                </c:pt>
                <c:pt idx="320">
                  <c:v>1044.1659999999999</c:v>
                </c:pt>
                <c:pt idx="321">
                  <c:v>1044.172</c:v>
                </c:pt>
                <c:pt idx="322">
                  <c:v>1046.577</c:v>
                </c:pt>
                <c:pt idx="323">
                  <c:v>1050.3140000000001</c:v>
                </c:pt>
                <c:pt idx="324">
                  <c:v>1050.326</c:v>
                </c:pt>
                <c:pt idx="325">
                  <c:v>1052.7550000000001</c:v>
                </c:pt>
                <c:pt idx="326">
                  <c:v>1053.1420000000001</c:v>
                </c:pt>
                <c:pt idx="327">
                  <c:v>1053.4449999999999</c:v>
                </c:pt>
                <c:pt idx="328">
                  <c:v>1054.327</c:v>
                </c:pt>
                <c:pt idx="329">
                  <c:v>1056.4559999999999</c:v>
                </c:pt>
                <c:pt idx="330">
                  <c:v>1057.3399999999999</c:v>
                </c:pt>
                <c:pt idx="331">
                  <c:v>1059.3109999999999</c:v>
                </c:pt>
                <c:pt idx="332">
                  <c:v>1061.548</c:v>
                </c:pt>
                <c:pt idx="333">
                  <c:v>1062.598</c:v>
                </c:pt>
                <c:pt idx="334">
                  <c:v>1062.7650000000001</c:v>
                </c:pt>
                <c:pt idx="335">
                  <c:v>1063.923</c:v>
                </c:pt>
                <c:pt idx="336">
                  <c:v>1066.444</c:v>
                </c:pt>
                <c:pt idx="337">
                  <c:v>1067.9190000000001</c:v>
                </c:pt>
                <c:pt idx="338">
                  <c:v>1068.741</c:v>
                </c:pt>
                <c:pt idx="339">
                  <c:v>1073.2360000000001</c:v>
                </c:pt>
                <c:pt idx="340">
                  <c:v>1074.883</c:v>
                </c:pt>
                <c:pt idx="341">
                  <c:v>1081.0250000000001</c:v>
                </c:pt>
                <c:pt idx="342">
                  <c:v>1084.8920000000001</c:v>
                </c:pt>
                <c:pt idx="343">
                  <c:v>1087.1669999999999</c:v>
                </c:pt>
                <c:pt idx="344">
                  <c:v>1088.0540000000001</c:v>
                </c:pt>
                <c:pt idx="345">
                  <c:v>1088.0889999999999</c:v>
                </c:pt>
                <c:pt idx="346">
                  <c:v>1088.143</c:v>
                </c:pt>
                <c:pt idx="347">
                  <c:v>1088.222</c:v>
                </c:pt>
                <c:pt idx="348">
                  <c:v>1088.73</c:v>
                </c:pt>
                <c:pt idx="349">
                  <c:v>1091.915</c:v>
                </c:pt>
                <c:pt idx="350">
                  <c:v>1093.309</c:v>
                </c:pt>
                <c:pt idx="351">
                  <c:v>1096.4359999999999</c:v>
                </c:pt>
                <c:pt idx="352">
                  <c:v>1098.248</c:v>
                </c:pt>
                <c:pt idx="353">
                  <c:v>1099.452</c:v>
                </c:pt>
                <c:pt idx="354">
                  <c:v>1101.4110000000001</c:v>
                </c:pt>
                <c:pt idx="355">
                  <c:v>1105.5940000000001</c:v>
                </c:pt>
                <c:pt idx="356">
                  <c:v>1107.5920000000001</c:v>
                </c:pt>
                <c:pt idx="357">
                  <c:v>1110.402</c:v>
                </c:pt>
                <c:pt idx="358">
                  <c:v>1111.056</c:v>
                </c:pt>
                <c:pt idx="359">
                  <c:v>1111.7360000000001</c:v>
                </c:pt>
                <c:pt idx="360">
                  <c:v>1112.9280000000001</c:v>
                </c:pt>
                <c:pt idx="361">
                  <c:v>1115.769</c:v>
                </c:pt>
                <c:pt idx="362">
                  <c:v>1116.5889999999999</c:v>
                </c:pt>
                <c:pt idx="363">
                  <c:v>1117.8779999999999</c:v>
                </c:pt>
                <c:pt idx="364">
                  <c:v>1120.472</c:v>
                </c:pt>
                <c:pt idx="365">
                  <c:v>1124.02</c:v>
                </c:pt>
                <c:pt idx="366">
                  <c:v>1130.163</c:v>
                </c:pt>
                <c:pt idx="367">
                  <c:v>1133.4929999999999</c:v>
                </c:pt>
                <c:pt idx="368">
                  <c:v>1136.3050000000001</c:v>
                </c:pt>
                <c:pt idx="369">
                  <c:v>1137.79</c:v>
                </c:pt>
                <c:pt idx="370">
                  <c:v>1141.5060000000001</c:v>
                </c:pt>
                <c:pt idx="371">
                  <c:v>1142.4469999999999</c:v>
                </c:pt>
                <c:pt idx="372">
                  <c:v>1144.1949999999999</c:v>
                </c:pt>
                <c:pt idx="373">
                  <c:v>1144.51</c:v>
                </c:pt>
                <c:pt idx="374">
                  <c:v>1144.8679999999999</c:v>
                </c:pt>
                <c:pt idx="375">
                  <c:v>1145.4780000000001</c:v>
                </c:pt>
                <c:pt idx="376">
                  <c:v>1148.4090000000001</c:v>
                </c:pt>
                <c:pt idx="377">
                  <c:v>1148.5889999999999</c:v>
                </c:pt>
                <c:pt idx="378">
                  <c:v>1154.731</c:v>
                </c:pt>
                <c:pt idx="379">
                  <c:v>1155.059</c:v>
                </c:pt>
                <c:pt idx="380">
                  <c:v>1157.8699999999999</c:v>
                </c:pt>
                <c:pt idx="381">
                  <c:v>1159.9690000000001</c:v>
                </c:pt>
                <c:pt idx="382">
                  <c:v>1160.873</c:v>
                </c:pt>
                <c:pt idx="383">
                  <c:v>1163.133</c:v>
                </c:pt>
                <c:pt idx="384">
                  <c:v>1167.0160000000001</c:v>
                </c:pt>
                <c:pt idx="385">
                  <c:v>1168.3989999999999</c:v>
                </c:pt>
                <c:pt idx="386">
                  <c:v>1173.1579999999999</c:v>
                </c:pt>
                <c:pt idx="387">
                  <c:v>1175.441</c:v>
                </c:pt>
                <c:pt idx="388">
                  <c:v>1179.3</c:v>
                </c:pt>
                <c:pt idx="389">
                  <c:v>1180.7260000000001</c:v>
                </c:pt>
                <c:pt idx="390">
                  <c:v>1184.588</c:v>
                </c:pt>
                <c:pt idx="391">
                  <c:v>1185.442</c:v>
                </c:pt>
                <c:pt idx="392">
                  <c:v>1188.7560000000001</c:v>
                </c:pt>
                <c:pt idx="393">
                  <c:v>1191.5840000000001</c:v>
                </c:pt>
                <c:pt idx="394">
                  <c:v>1197.7270000000001</c:v>
                </c:pt>
                <c:pt idx="395">
                  <c:v>1200.3610000000001</c:v>
                </c:pt>
                <c:pt idx="396">
                  <c:v>1203.8689999999999</c:v>
                </c:pt>
                <c:pt idx="397">
                  <c:v>1210.011</c:v>
                </c:pt>
                <c:pt idx="398">
                  <c:v>1216.153</c:v>
                </c:pt>
                <c:pt idx="399">
                  <c:v>1222.2950000000001</c:v>
                </c:pt>
                <c:pt idx="400">
                  <c:v>1228.4380000000001</c:v>
                </c:pt>
                <c:pt idx="401">
                  <c:v>1228.4380000000001</c:v>
                </c:pt>
              </c:numCache>
            </c:numRef>
          </c:xVal>
          <c:yVal>
            <c:numRef>
              <c:f>Foglio6!$D$1227:$D$1628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99.918000000000006</c:v>
                </c:pt>
                <c:pt idx="32">
                  <c:v>99.875</c:v>
                </c:pt>
                <c:pt idx="33">
                  <c:v>99.832999999999998</c:v>
                </c:pt>
                <c:pt idx="34">
                  <c:v>99.79</c:v>
                </c:pt>
                <c:pt idx="35">
                  <c:v>99.748000000000005</c:v>
                </c:pt>
                <c:pt idx="36">
                  <c:v>99.704999999999998</c:v>
                </c:pt>
                <c:pt idx="37">
                  <c:v>99.662999999999997</c:v>
                </c:pt>
                <c:pt idx="38">
                  <c:v>99.575000000000003</c:v>
                </c:pt>
                <c:pt idx="39">
                  <c:v>99.5</c:v>
                </c:pt>
                <c:pt idx="40">
                  <c:v>99.412000000000006</c:v>
                </c:pt>
                <c:pt idx="41">
                  <c:v>99.248999999999995</c:v>
                </c:pt>
                <c:pt idx="42">
                  <c:v>99.128</c:v>
                </c:pt>
                <c:pt idx="43">
                  <c:v>99.016999999999996</c:v>
                </c:pt>
                <c:pt idx="44">
                  <c:v>99</c:v>
                </c:pt>
                <c:pt idx="45">
                  <c:v>98.9</c:v>
                </c:pt>
                <c:pt idx="46">
                  <c:v>98.775999999999996</c:v>
                </c:pt>
                <c:pt idx="47">
                  <c:v>98.652000000000001</c:v>
                </c:pt>
                <c:pt idx="48">
                  <c:v>98.524000000000001</c:v>
                </c:pt>
                <c:pt idx="49">
                  <c:v>98.5</c:v>
                </c:pt>
                <c:pt idx="50">
                  <c:v>98.385000000000005</c:v>
                </c:pt>
                <c:pt idx="51">
                  <c:v>98.245999999999995</c:v>
                </c:pt>
                <c:pt idx="52">
                  <c:v>98.106999999999999</c:v>
                </c:pt>
                <c:pt idx="53">
                  <c:v>98</c:v>
                </c:pt>
                <c:pt idx="54">
                  <c:v>97.867000000000004</c:v>
                </c:pt>
                <c:pt idx="55">
                  <c:v>97.647999999999996</c:v>
                </c:pt>
                <c:pt idx="56">
                  <c:v>97.522999999999996</c:v>
                </c:pt>
                <c:pt idx="57">
                  <c:v>97.5</c:v>
                </c:pt>
                <c:pt idx="58">
                  <c:v>97.399000000000001</c:v>
                </c:pt>
                <c:pt idx="59">
                  <c:v>97.274000000000001</c:v>
                </c:pt>
                <c:pt idx="60">
                  <c:v>97</c:v>
                </c:pt>
                <c:pt idx="61">
                  <c:v>96.956000000000003</c:v>
                </c:pt>
                <c:pt idx="62">
                  <c:v>96.676000000000002</c:v>
                </c:pt>
                <c:pt idx="63">
                  <c:v>96.522999999999996</c:v>
                </c:pt>
                <c:pt idx="64">
                  <c:v>96.5</c:v>
                </c:pt>
                <c:pt idx="65">
                  <c:v>96.405000000000001</c:v>
                </c:pt>
                <c:pt idx="66">
                  <c:v>96.287000000000006</c:v>
                </c:pt>
                <c:pt idx="67">
                  <c:v>96.087999999999994</c:v>
                </c:pt>
                <c:pt idx="68">
                  <c:v>96</c:v>
                </c:pt>
                <c:pt idx="69">
                  <c:v>95.911000000000001</c:v>
                </c:pt>
                <c:pt idx="70">
                  <c:v>95.796999999999997</c:v>
                </c:pt>
                <c:pt idx="71">
                  <c:v>95.683999999999997</c:v>
                </c:pt>
                <c:pt idx="72">
                  <c:v>95.5</c:v>
                </c:pt>
                <c:pt idx="73">
                  <c:v>95.450999999999993</c:v>
                </c:pt>
                <c:pt idx="74">
                  <c:v>95.07</c:v>
                </c:pt>
                <c:pt idx="75">
                  <c:v>95</c:v>
                </c:pt>
                <c:pt idx="76">
                  <c:v>94.727000000000004</c:v>
                </c:pt>
                <c:pt idx="77">
                  <c:v>94.5</c:v>
                </c:pt>
                <c:pt idx="78">
                  <c:v>94.480999999999995</c:v>
                </c:pt>
                <c:pt idx="79">
                  <c:v>94.263999999999996</c:v>
                </c:pt>
                <c:pt idx="80">
                  <c:v>94</c:v>
                </c:pt>
                <c:pt idx="81">
                  <c:v>93.855999999999995</c:v>
                </c:pt>
                <c:pt idx="82">
                  <c:v>93.5</c:v>
                </c:pt>
                <c:pt idx="83">
                  <c:v>93.474000000000004</c:v>
                </c:pt>
                <c:pt idx="84">
                  <c:v>93.188999999999993</c:v>
                </c:pt>
                <c:pt idx="85">
                  <c:v>93</c:v>
                </c:pt>
                <c:pt idx="86">
                  <c:v>92.5</c:v>
                </c:pt>
                <c:pt idx="87">
                  <c:v>92.436999999999998</c:v>
                </c:pt>
                <c:pt idx="88">
                  <c:v>92.213999999999999</c:v>
                </c:pt>
                <c:pt idx="89">
                  <c:v>92</c:v>
                </c:pt>
                <c:pt idx="90">
                  <c:v>91.789000000000001</c:v>
                </c:pt>
                <c:pt idx="91">
                  <c:v>91.534999999999997</c:v>
                </c:pt>
                <c:pt idx="92">
                  <c:v>91.5</c:v>
                </c:pt>
                <c:pt idx="93">
                  <c:v>91.361000000000004</c:v>
                </c:pt>
                <c:pt idx="94">
                  <c:v>91.171999999999997</c:v>
                </c:pt>
                <c:pt idx="95">
                  <c:v>91</c:v>
                </c:pt>
                <c:pt idx="96">
                  <c:v>90.98</c:v>
                </c:pt>
                <c:pt idx="97">
                  <c:v>90.941000000000003</c:v>
                </c:pt>
                <c:pt idx="98">
                  <c:v>90.867000000000004</c:v>
                </c:pt>
                <c:pt idx="99">
                  <c:v>90.5</c:v>
                </c:pt>
                <c:pt idx="100">
                  <c:v>90.495999999999995</c:v>
                </c:pt>
                <c:pt idx="101">
                  <c:v>90.299000000000007</c:v>
                </c:pt>
                <c:pt idx="102">
                  <c:v>90.100999999999999</c:v>
                </c:pt>
                <c:pt idx="103">
                  <c:v>90</c:v>
                </c:pt>
                <c:pt idx="104">
                  <c:v>89.863</c:v>
                </c:pt>
                <c:pt idx="105">
                  <c:v>89.619</c:v>
                </c:pt>
                <c:pt idx="106">
                  <c:v>89.5</c:v>
                </c:pt>
                <c:pt idx="107">
                  <c:v>89</c:v>
                </c:pt>
                <c:pt idx="108">
                  <c:v>88.787999999999997</c:v>
                </c:pt>
                <c:pt idx="109">
                  <c:v>88.5</c:v>
                </c:pt>
                <c:pt idx="110">
                  <c:v>88.424000000000007</c:v>
                </c:pt>
                <c:pt idx="111">
                  <c:v>88.230999999999995</c:v>
                </c:pt>
                <c:pt idx="112">
                  <c:v>88.013999999999996</c:v>
                </c:pt>
                <c:pt idx="113">
                  <c:v>88</c:v>
                </c:pt>
                <c:pt idx="114">
                  <c:v>87.664000000000001</c:v>
                </c:pt>
                <c:pt idx="115">
                  <c:v>87.5</c:v>
                </c:pt>
                <c:pt idx="116">
                  <c:v>87.266999999999996</c:v>
                </c:pt>
                <c:pt idx="117">
                  <c:v>87</c:v>
                </c:pt>
                <c:pt idx="118">
                  <c:v>86.975999999999999</c:v>
                </c:pt>
                <c:pt idx="119">
                  <c:v>86.8</c:v>
                </c:pt>
                <c:pt idx="120">
                  <c:v>86.623000000000005</c:v>
                </c:pt>
                <c:pt idx="121">
                  <c:v>86.5</c:v>
                </c:pt>
                <c:pt idx="122">
                  <c:v>86.447000000000003</c:v>
                </c:pt>
                <c:pt idx="123">
                  <c:v>86</c:v>
                </c:pt>
                <c:pt idx="124">
                  <c:v>85.623000000000005</c:v>
                </c:pt>
                <c:pt idx="125">
                  <c:v>85.554000000000002</c:v>
                </c:pt>
                <c:pt idx="126">
                  <c:v>85.5</c:v>
                </c:pt>
                <c:pt idx="127">
                  <c:v>85.474999999999994</c:v>
                </c:pt>
                <c:pt idx="128">
                  <c:v>85.393000000000001</c:v>
                </c:pt>
                <c:pt idx="129">
                  <c:v>85.311000000000007</c:v>
                </c:pt>
                <c:pt idx="130">
                  <c:v>85.162000000000006</c:v>
                </c:pt>
                <c:pt idx="131">
                  <c:v>85</c:v>
                </c:pt>
                <c:pt idx="132">
                  <c:v>84.784000000000006</c:v>
                </c:pt>
                <c:pt idx="133">
                  <c:v>84.5</c:v>
                </c:pt>
                <c:pt idx="134">
                  <c:v>84.295000000000002</c:v>
                </c:pt>
                <c:pt idx="135">
                  <c:v>84.174999999999997</c:v>
                </c:pt>
                <c:pt idx="136">
                  <c:v>84.073999999999998</c:v>
                </c:pt>
                <c:pt idx="137">
                  <c:v>84</c:v>
                </c:pt>
                <c:pt idx="138">
                  <c:v>83.974000000000004</c:v>
                </c:pt>
                <c:pt idx="139">
                  <c:v>83.873000000000005</c:v>
                </c:pt>
                <c:pt idx="140">
                  <c:v>83.673000000000002</c:v>
                </c:pt>
                <c:pt idx="141">
                  <c:v>83.5</c:v>
                </c:pt>
                <c:pt idx="142">
                  <c:v>83.456000000000003</c:v>
                </c:pt>
                <c:pt idx="143">
                  <c:v>83.427000000000007</c:v>
                </c:pt>
                <c:pt idx="144">
                  <c:v>83.397999999999996</c:v>
                </c:pt>
                <c:pt idx="145">
                  <c:v>83</c:v>
                </c:pt>
                <c:pt idx="146">
                  <c:v>82.5</c:v>
                </c:pt>
                <c:pt idx="147">
                  <c:v>82</c:v>
                </c:pt>
                <c:pt idx="148">
                  <c:v>81.5</c:v>
                </c:pt>
                <c:pt idx="149">
                  <c:v>81</c:v>
                </c:pt>
                <c:pt idx="150">
                  <c:v>80.882000000000005</c:v>
                </c:pt>
                <c:pt idx="151">
                  <c:v>80.5</c:v>
                </c:pt>
                <c:pt idx="152">
                  <c:v>80</c:v>
                </c:pt>
                <c:pt idx="153">
                  <c:v>79.947999999999993</c:v>
                </c:pt>
                <c:pt idx="154">
                  <c:v>79.631</c:v>
                </c:pt>
                <c:pt idx="155">
                  <c:v>79.5</c:v>
                </c:pt>
                <c:pt idx="156">
                  <c:v>79.314999999999998</c:v>
                </c:pt>
                <c:pt idx="157">
                  <c:v>79</c:v>
                </c:pt>
                <c:pt idx="158">
                  <c:v>78.891999999999996</c:v>
                </c:pt>
                <c:pt idx="159">
                  <c:v>78.5</c:v>
                </c:pt>
                <c:pt idx="160">
                  <c:v>78</c:v>
                </c:pt>
                <c:pt idx="161">
                  <c:v>77.736999999999995</c:v>
                </c:pt>
                <c:pt idx="162">
                  <c:v>77.5</c:v>
                </c:pt>
                <c:pt idx="163">
                  <c:v>77.361999999999995</c:v>
                </c:pt>
                <c:pt idx="164">
                  <c:v>77.191000000000003</c:v>
                </c:pt>
                <c:pt idx="165">
                  <c:v>77.114999999999995</c:v>
                </c:pt>
                <c:pt idx="166">
                  <c:v>77.037999999999997</c:v>
                </c:pt>
                <c:pt idx="167">
                  <c:v>77</c:v>
                </c:pt>
                <c:pt idx="168">
                  <c:v>76.962000000000003</c:v>
                </c:pt>
                <c:pt idx="169">
                  <c:v>76.885999999999996</c:v>
                </c:pt>
                <c:pt idx="170">
                  <c:v>76.769000000000005</c:v>
                </c:pt>
                <c:pt idx="171">
                  <c:v>76.5</c:v>
                </c:pt>
                <c:pt idx="172">
                  <c:v>76</c:v>
                </c:pt>
                <c:pt idx="173">
                  <c:v>75.97</c:v>
                </c:pt>
                <c:pt idx="174">
                  <c:v>75.5</c:v>
                </c:pt>
                <c:pt idx="175">
                  <c:v>75.341999999999999</c:v>
                </c:pt>
                <c:pt idx="176">
                  <c:v>75</c:v>
                </c:pt>
                <c:pt idx="177">
                  <c:v>74.5</c:v>
                </c:pt>
                <c:pt idx="178">
                  <c:v>74</c:v>
                </c:pt>
                <c:pt idx="179">
                  <c:v>73.763000000000005</c:v>
                </c:pt>
                <c:pt idx="180">
                  <c:v>73.5</c:v>
                </c:pt>
                <c:pt idx="181">
                  <c:v>73.063000000000002</c:v>
                </c:pt>
                <c:pt idx="182">
                  <c:v>73</c:v>
                </c:pt>
                <c:pt idx="183">
                  <c:v>72.72</c:v>
                </c:pt>
                <c:pt idx="184">
                  <c:v>72.5</c:v>
                </c:pt>
                <c:pt idx="185">
                  <c:v>72.376999999999995</c:v>
                </c:pt>
                <c:pt idx="186">
                  <c:v>72</c:v>
                </c:pt>
                <c:pt idx="187">
                  <c:v>71.593000000000004</c:v>
                </c:pt>
                <c:pt idx="188">
                  <c:v>71.5</c:v>
                </c:pt>
                <c:pt idx="189">
                  <c:v>71</c:v>
                </c:pt>
                <c:pt idx="190">
                  <c:v>70.876000000000005</c:v>
                </c:pt>
                <c:pt idx="191">
                  <c:v>70.5</c:v>
                </c:pt>
                <c:pt idx="192">
                  <c:v>70</c:v>
                </c:pt>
                <c:pt idx="193">
                  <c:v>69.5</c:v>
                </c:pt>
                <c:pt idx="194">
                  <c:v>69.015000000000001</c:v>
                </c:pt>
                <c:pt idx="195">
                  <c:v>69</c:v>
                </c:pt>
                <c:pt idx="196">
                  <c:v>68.5</c:v>
                </c:pt>
                <c:pt idx="197">
                  <c:v>68</c:v>
                </c:pt>
                <c:pt idx="198">
                  <c:v>67.5</c:v>
                </c:pt>
                <c:pt idx="199">
                  <c:v>67</c:v>
                </c:pt>
                <c:pt idx="200">
                  <c:v>66.738</c:v>
                </c:pt>
                <c:pt idx="201">
                  <c:v>66.5</c:v>
                </c:pt>
                <c:pt idx="202">
                  <c:v>66.286000000000001</c:v>
                </c:pt>
                <c:pt idx="203">
                  <c:v>66.081000000000003</c:v>
                </c:pt>
                <c:pt idx="204">
                  <c:v>66</c:v>
                </c:pt>
                <c:pt idx="205">
                  <c:v>65.876000000000005</c:v>
                </c:pt>
                <c:pt idx="206">
                  <c:v>65.5</c:v>
                </c:pt>
                <c:pt idx="207">
                  <c:v>65</c:v>
                </c:pt>
                <c:pt idx="208">
                  <c:v>64.5</c:v>
                </c:pt>
                <c:pt idx="209">
                  <c:v>64.290999999999997</c:v>
                </c:pt>
                <c:pt idx="210">
                  <c:v>64</c:v>
                </c:pt>
                <c:pt idx="211">
                  <c:v>63.585999999999999</c:v>
                </c:pt>
                <c:pt idx="212">
                  <c:v>63.5</c:v>
                </c:pt>
                <c:pt idx="213">
                  <c:v>63</c:v>
                </c:pt>
                <c:pt idx="214">
                  <c:v>62.5</c:v>
                </c:pt>
                <c:pt idx="215">
                  <c:v>62.055999999999997</c:v>
                </c:pt>
                <c:pt idx="216">
                  <c:v>62</c:v>
                </c:pt>
                <c:pt idx="217">
                  <c:v>61.5</c:v>
                </c:pt>
                <c:pt idx="218">
                  <c:v>61.293999999999997</c:v>
                </c:pt>
                <c:pt idx="219">
                  <c:v>61</c:v>
                </c:pt>
                <c:pt idx="220">
                  <c:v>60.5</c:v>
                </c:pt>
                <c:pt idx="221">
                  <c:v>60.145000000000003</c:v>
                </c:pt>
                <c:pt idx="222">
                  <c:v>60</c:v>
                </c:pt>
                <c:pt idx="223">
                  <c:v>59.679000000000002</c:v>
                </c:pt>
                <c:pt idx="224">
                  <c:v>59.5</c:v>
                </c:pt>
                <c:pt idx="225">
                  <c:v>59</c:v>
                </c:pt>
                <c:pt idx="226">
                  <c:v>58.701999999999998</c:v>
                </c:pt>
                <c:pt idx="227">
                  <c:v>58.5</c:v>
                </c:pt>
                <c:pt idx="228">
                  <c:v>58</c:v>
                </c:pt>
                <c:pt idx="229">
                  <c:v>57.5</c:v>
                </c:pt>
                <c:pt idx="230">
                  <c:v>57.222000000000001</c:v>
                </c:pt>
                <c:pt idx="231">
                  <c:v>57</c:v>
                </c:pt>
                <c:pt idx="232">
                  <c:v>56.5</c:v>
                </c:pt>
                <c:pt idx="233">
                  <c:v>56</c:v>
                </c:pt>
                <c:pt idx="234">
                  <c:v>55.5</c:v>
                </c:pt>
                <c:pt idx="235">
                  <c:v>55.37</c:v>
                </c:pt>
                <c:pt idx="236">
                  <c:v>55</c:v>
                </c:pt>
                <c:pt idx="237">
                  <c:v>54.5</c:v>
                </c:pt>
                <c:pt idx="238">
                  <c:v>54</c:v>
                </c:pt>
                <c:pt idx="239">
                  <c:v>53.5</c:v>
                </c:pt>
                <c:pt idx="240">
                  <c:v>53.241999999999997</c:v>
                </c:pt>
                <c:pt idx="241">
                  <c:v>53</c:v>
                </c:pt>
                <c:pt idx="242">
                  <c:v>52.808999999999997</c:v>
                </c:pt>
                <c:pt idx="243">
                  <c:v>52.591999999999999</c:v>
                </c:pt>
                <c:pt idx="244">
                  <c:v>52.5</c:v>
                </c:pt>
                <c:pt idx="245">
                  <c:v>52.146999999999998</c:v>
                </c:pt>
                <c:pt idx="246">
                  <c:v>52.045999999999999</c:v>
                </c:pt>
                <c:pt idx="247">
                  <c:v>52</c:v>
                </c:pt>
                <c:pt idx="248">
                  <c:v>51.960999999999999</c:v>
                </c:pt>
                <c:pt idx="249">
                  <c:v>51.5</c:v>
                </c:pt>
                <c:pt idx="250">
                  <c:v>51.058</c:v>
                </c:pt>
                <c:pt idx="251">
                  <c:v>51</c:v>
                </c:pt>
                <c:pt idx="252">
                  <c:v>50.5</c:v>
                </c:pt>
                <c:pt idx="253">
                  <c:v>50</c:v>
                </c:pt>
                <c:pt idx="254">
                  <c:v>49.5</c:v>
                </c:pt>
                <c:pt idx="255">
                  <c:v>49.427999999999997</c:v>
                </c:pt>
                <c:pt idx="256">
                  <c:v>49</c:v>
                </c:pt>
                <c:pt idx="257">
                  <c:v>48.5</c:v>
                </c:pt>
                <c:pt idx="258">
                  <c:v>48</c:v>
                </c:pt>
                <c:pt idx="259">
                  <c:v>47.5</c:v>
                </c:pt>
                <c:pt idx="260">
                  <c:v>47</c:v>
                </c:pt>
                <c:pt idx="261">
                  <c:v>46.5</c:v>
                </c:pt>
                <c:pt idx="262">
                  <c:v>46.058999999999997</c:v>
                </c:pt>
                <c:pt idx="263">
                  <c:v>46</c:v>
                </c:pt>
                <c:pt idx="264">
                  <c:v>45.5</c:v>
                </c:pt>
                <c:pt idx="265">
                  <c:v>45</c:v>
                </c:pt>
                <c:pt idx="266">
                  <c:v>44.933999999999997</c:v>
                </c:pt>
                <c:pt idx="267">
                  <c:v>44.5</c:v>
                </c:pt>
                <c:pt idx="268">
                  <c:v>44</c:v>
                </c:pt>
                <c:pt idx="269">
                  <c:v>43.774000000000001</c:v>
                </c:pt>
                <c:pt idx="270">
                  <c:v>43.5</c:v>
                </c:pt>
                <c:pt idx="271">
                  <c:v>43.017000000000003</c:v>
                </c:pt>
                <c:pt idx="272">
                  <c:v>43</c:v>
                </c:pt>
                <c:pt idx="273">
                  <c:v>42.5</c:v>
                </c:pt>
                <c:pt idx="274">
                  <c:v>42.140999999999998</c:v>
                </c:pt>
                <c:pt idx="275">
                  <c:v>42</c:v>
                </c:pt>
                <c:pt idx="276">
                  <c:v>41.5</c:v>
                </c:pt>
                <c:pt idx="277">
                  <c:v>41</c:v>
                </c:pt>
                <c:pt idx="278">
                  <c:v>40.994999999999997</c:v>
                </c:pt>
                <c:pt idx="279">
                  <c:v>40.5</c:v>
                </c:pt>
                <c:pt idx="280">
                  <c:v>40</c:v>
                </c:pt>
                <c:pt idx="281">
                  <c:v>39.5</c:v>
                </c:pt>
                <c:pt idx="282">
                  <c:v>39.216999999999999</c:v>
                </c:pt>
                <c:pt idx="283">
                  <c:v>39</c:v>
                </c:pt>
                <c:pt idx="284">
                  <c:v>38.5</c:v>
                </c:pt>
                <c:pt idx="285">
                  <c:v>38</c:v>
                </c:pt>
                <c:pt idx="286">
                  <c:v>37.5</c:v>
                </c:pt>
                <c:pt idx="287">
                  <c:v>37.347999999999999</c:v>
                </c:pt>
                <c:pt idx="288">
                  <c:v>37</c:v>
                </c:pt>
                <c:pt idx="289">
                  <c:v>36.5</c:v>
                </c:pt>
                <c:pt idx="290">
                  <c:v>36</c:v>
                </c:pt>
                <c:pt idx="291">
                  <c:v>35.658999999999999</c:v>
                </c:pt>
                <c:pt idx="292">
                  <c:v>35.5</c:v>
                </c:pt>
                <c:pt idx="293">
                  <c:v>35.207999999999998</c:v>
                </c:pt>
                <c:pt idx="294">
                  <c:v>35</c:v>
                </c:pt>
                <c:pt idx="295">
                  <c:v>34.5</c:v>
                </c:pt>
                <c:pt idx="296">
                  <c:v>34.375999999999998</c:v>
                </c:pt>
                <c:pt idx="297">
                  <c:v>34</c:v>
                </c:pt>
                <c:pt idx="298">
                  <c:v>33.981999999999999</c:v>
                </c:pt>
                <c:pt idx="299">
                  <c:v>33.5</c:v>
                </c:pt>
                <c:pt idx="300">
                  <c:v>33</c:v>
                </c:pt>
                <c:pt idx="301">
                  <c:v>32.5</c:v>
                </c:pt>
                <c:pt idx="302">
                  <c:v>32</c:v>
                </c:pt>
                <c:pt idx="303">
                  <c:v>31.5</c:v>
                </c:pt>
                <c:pt idx="304">
                  <c:v>31.36</c:v>
                </c:pt>
                <c:pt idx="305">
                  <c:v>31</c:v>
                </c:pt>
                <c:pt idx="306">
                  <c:v>30.5</c:v>
                </c:pt>
                <c:pt idx="307">
                  <c:v>30</c:v>
                </c:pt>
                <c:pt idx="308">
                  <c:v>29.5</c:v>
                </c:pt>
                <c:pt idx="309">
                  <c:v>29</c:v>
                </c:pt>
                <c:pt idx="310">
                  <c:v>28.5</c:v>
                </c:pt>
                <c:pt idx="311">
                  <c:v>28</c:v>
                </c:pt>
                <c:pt idx="312">
                  <c:v>27.5</c:v>
                </c:pt>
                <c:pt idx="313">
                  <c:v>27</c:v>
                </c:pt>
                <c:pt idx="314">
                  <c:v>26.978000000000002</c:v>
                </c:pt>
                <c:pt idx="315">
                  <c:v>26.507000000000001</c:v>
                </c:pt>
                <c:pt idx="316">
                  <c:v>26.5</c:v>
                </c:pt>
                <c:pt idx="317">
                  <c:v>26.437000000000001</c:v>
                </c:pt>
                <c:pt idx="318">
                  <c:v>26</c:v>
                </c:pt>
                <c:pt idx="319">
                  <c:v>25.5</c:v>
                </c:pt>
                <c:pt idx="320">
                  <c:v>25</c:v>
                </c:pt>
                <c:pt idx="321">
                  <c:v>24.997</c:v>
                </c:pt>
                <c:pt idx="322">
                  <c:v>24.5</c:v>
                </c:pt>
                <c:pt idx="323">
                  <c:v>24.001999999999999</c:v>
                </c:pt>
                <c:pt idx="324">
                  <c:v>24</c:v>
                </c:pt>
                <c:pt idx="325">
                  <c:v>23.5</c:v>
                </c:pt>
                <c:pt idx="326">
                  <c:v>23</c:v>
                </c:pt>
                <c:pt idx="327">
                  <c:v>22.5</c:v>
                </c:pt>
                <c:pt idx="328">
                  <c:v>22</c:v>
                </c:pt>
                <c:pt idx="329">
                  <c:v>21.690999999999999</c:v>
                </c:pt>
                <c:pt idx="330">
                  <c:v>21.5</c:v>
                </c:pt>
                <c:pt idx="331">
                  <c:v>21</c:v>
                </c:pt>
                <c:pt idx="332">
                  <c:v>20.5</c:v>
                </c:pt>
                <c:pt idx="333">
                  <c:v>20.071999999999999</c:v>
                </c:pt>
                <c:pt idx="334">
                  <c:v>20</c:v>
                </c:pt>
                <c:pt idx="335">
                  <c:v>19.5</c:v>
                </c:pt>
                <c:pt idx="336">
                  <c:v>19</c:v>
                </c:pt>
                <c:pt idx="337">
                  <c:v>18.5</c:v>
                </c:pt>
                <c:pt idx="338">
                  <c:v>18.242000000000001</c:v>
                </c:pt>
                <c:pt idx="339">
                  <c:v>18</c:v>
                </c:pt>
                <c:pt idx="340">
                  <c:v>17.981000000000002</c:v>
                </c:pt>
                <c:pt idx="341">
                  <c:v>17.86</c:v>
                </c:pt>
                <c:pt idx="342">
                  <c:v>17.5</c:v>
                </c:pt>
                <c:pt idx="343">
                  <c:v>17.224</c:v>
                </c:pt>
                <c:pt idx="344">
                  <c:v>17</c:v>
                </c:pt>
                <c:pt idx="345">
                  <c:v>16.5</c:v>
                </c:pt>
                <c:pt idx="346">
                  <c:v>16</c:v>
                </c:pt>
                <c:pt idx="347">
                  <c:v>15.5</c:v>
                </c:pt>
                <c:pt idx="348">
                  <c:v>15</c:v>
                </c:pt>
                <c:pt idx="349">
                  <c:v>14.5</c:v>
                </c:pt>
                <c:pt idx="350">
                  <c:v>14.475</c:v>
                </c:pt>
                <c:pt idx="351">
                  <c:v>14</c:v>
                </c:pt>
                <c:pt idx="352">
                  <c:v>13.5</c:v>
                </c:pt>
                <c:pt idx="353">
                  <c:v>13.167999999999999</c:v>
                </c:pt>
                <c:pt idx="354">
                  <c:v>13</c:v>
                </c:pt>
                <c:pt idx="355">
                  <c:v>12.662000000000001</c:v>
                </c:pt>
                <c:pt idx="356">
                  <c:v>12.5</c:v>
                </c:pt>
                <c:pt idx="357">
                  <c:v>12</c:v>
                </c:pt>
                <c:pt idx="358">
                  <c:v>11.5</c:v>
                </c:pt>
                <c:pt idx="359">
                  <c:v>11.21</c:v>
                </c:pt>
                <c:pt idx="360">
                  <c:v>11</c:v>
                </c:pt>
                <c:pt idx="361">
                  <c:v>10.5</c:v>
                </c:pt>
                <c:pt idx="362">
                  <c:v>10</c:v>
                </c:pt>
                <c:pt idx="363">
                  <c:v>9.6890000000000001</c:v>
                </c:pt>
                <c:pt idx="364">
                  <c:v>9.5</c:v>
                </c:pt>
                <c:pt idx="365">
                  <c:v>9.4130000000000003</c:v>
                </c:pt>
                <c:pt idx="366">
                  <c:v>9.3170000000000002</c:v>
                </c:pt>
                <c:pt idx="367">
                  <c:v>9</c:v>
                </c:pt>
                <c:pt idx="368">
                  <c:v>8.6549999999999994</c:v>
                </c:pt>
                <c:pt idx="369">
                  <c:v>8.5</c:v>
                </c:pt>
                <c:pt idx="370">
                  <c:v>8</c:v>
                </c:pt>
                <c:pt idx="371">
                  <c:v>7.84</c:v>
                </c:pt>
                <c:pt idx="372">
                  <c:v>7.5</c:v>
                </c:pt>
                <c:pt idx="373">
                  <c:v>7</c:v>
                </c:pt>
                <c:pt idx="374">
                  <c:v>6.5</c:v>
                </c:pt>
                <c:pt idx="375">
                  <c:v>6</c:v>
                </c:pt>
                <c:pt idx="376">
                  <c:v>5.5</c:v>
                </c:pt>
                <c:pt idx="377">
                  <c:v>5.4880000000000004</c:v>
                </c:pt>
                <c:pt idx="378">
                  <c:v>5.056</c:v>
                </c:pt>
                <c:pt idx="379">
                  <c:v>5</c:v>
                </c:pt>
                <c:pt idx="380">
                  <c:v>4.5</c:v>
                </c:pt>
                <c:pt idx="381">
                  <c:v>4</c:v>
                </c:pt>
                <c:pt idx="382">
                  <c:v>3.8570000000000002</c:v>
                </c:pt>
                <c:pt idx="383">
                  <c:v>3.5</c:v>
                </c:pt>
                <c:pt idx="384">
                  <c:v>3.0979999999999999</c:v>
                </c:pt>
                <c:pt idx="385">
                  <c:v>3</c:v>
                </c:pt>
                <c:pt idx="386">
                  <c:v>2.6619999999999999</c:v>
                </c:pt>
                <c:pt idx="387">
                  <c:v>2.5</c:v>
                </c:pt>
                <c:pt idx="388">
                  <c:v>2.1429999999999998</c:v>
                </c:pt>
                <c:pt idx="389">
                  <c:v>2</c:v>
                </c:pt>
                <c:pt idx="390">
                  <c:v>1.5</c:v>
                </c:pt>
                <c:pt idx="391">
                  <c:v>1.4079999999999999</c:v>
                </c:pt>
                <c:pt idx="392">
                  <c:v>1</c:v>
                </c:pt>
                <c:pt idx="393">
                  <c:v>0.73099999999999998</c:v>
                </c:pt>
                <c:pt idx="394">
                  <c:v>0.56899999999999995</c:v>
                </c:pt>
                <c:pt idx="395">
                  <c:v>0.5</c:v>
                </c:pt>
                <c:pt idx="396">
                  <c:v>0.40100000000000002</c:v>
                </c:pt>
                <c:pt idx="397">
                  <c:v>0.20899999999999999</c:v>
                </c:pt>
                <c:pt idx="398">
                  <c:v>0.112</c:v>
                </c:pt>
                <c:pt idx="399">
                  <c:v>5.6000000000000001E-2</c:v>
                </c:pt>
                <c:pt idx="400">
                  <c:v>1E-3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55F-45DA-A1D6-04490D79AFD9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xVal>
            <c:numRef>
              <c:f>Foglio6!$E$1227:$E$1628</c:f>
              <c:numCache>
                <c:formatCode>General</c:formatCode>
                <c:ptCount val="402"/>
                <c:pt idx="0">
                  <c:v>0</c:v>
                </c:pt>
                <c:pt idx="1">
                  <c:v>5.8620000000000001</c:v>
                </c:pt>
                <c:pt idx="2">
                  <c:v>11.724</c:v>
                </c:pt>
                <c:pt idx="3">
                  <c:v>17.587</c:v>
                </c:pt>
                <c:pt idx="4">
                  <c:v>23.449000000000002</c:v>
                </c:pt>
                <c:pt idx="5">
                  <c:v>26.677</c:v>
                </c:pt>
                <c:pt idx="6">
                  <c:v>29.311</c:v>
                </c:pt>
                <c:pt idx="7">
                  <c:v>33.484999999999999</c:v>
                </c:pt>
                <c:pt idx="8">
                  <c:v>35.173000000000002</c:v>
                </c:pt>
                <c:pt idx="9">
                  <c:v>39.798999999999999</c:v>
                </c:pt>
                <c:pt idx="10">
                  <c:v>41.036000000000001</c:v>
                </c:pt>
                <c:pt idx="11">
                  <c:v>42.947000000000003</c:v>
                </c:pt>
                <c:pt idx="12">
                  <c:v>46.898000000000003</c:v>
                </c:pt>
                <c:pt idx="13">
                  <c:v>47.816000000000003</c:v>
                </c:pt>
                <c:pt idx="14">
                  <c:v>52.76</c:v>
                </c:pt>
                <c:pt idx="15">
                  <c:v>54.636000000000003</c:v>
                </c:pt>
                <c:pt idx="16">
                  <c:v>58.622</c:v>
                </c:pt>
                <c:pt idx="17">
                  <c:v>59.076999999999998</c:v>
                </c:pt>
                <c:pt idx="18">
                  <c:v>61.494999999999997</c:v>
                </c:pt>
                <c:pt idx="19">
                  <c:v>64.484999999999999</c:v>
                </c:pt>
                <c:pt idx="20">
                  <c:v>66.278000000000006</c:v>
                </c:pt>
                <c:pt idx="21">
                  <c:v>70.346999999999994</c:v>
                </c:pt>
                <c:pt idx="22">
                  <c:v>70.590999999999994</c:v>
                </c:pt>
                <c:pt idx="23">
                  <c:v>76.209000000000003</c:v>
                </c:pt>
                <c:pt idx="24">
                  <c:v>80.501000000000005</c:v>
                </c:pt>
                <c:pt idx="25">
                  <c:v>82.070999999999998</c:v>
                </c:pt>
                <c:pt idx="26">
                  <c:v>84.284999999999997</c:v>
                </c:pt>
                <c:pt idx="27">
                  <c:v>87.933999999999997</c:v>
                </c:pt>
                <c:pt idx="28">
                  <c:v>91.671999999999997</c:v>
                </c:pt>
                <c:pt idx="29">
                  <c:v>93.796000000000006</c:v>
                </c:pt>
                <c:pt idx="30">
                  <c:v>97.745999999999995</c:v>
                </c:pt>
                <c:pt idx="31">
                  <c:v>99.658000000000001</c:v>
                </c:pt>
                <c:pt idx="32">
                  <c:v>102.625</c:v>
                </c:pt>
                <c:pt idx="33">
                  <c:v>105.52</c:v>
                </c:pt>
                <c:pt idx="34">
                  <c:v>107.003</c:v>
                </c:pt>
                <c:pt idx="35">
                  <c:v>111.383</c:v>
                </c:pt>
                <c:pt idx="36">
                  <c:v>112.157</c:v>
                </c:pt>
                <c:pt idx="37">
                  <c:v>117.245</c:v>
                </c:pt>
                <c:pt idx="38">
                  <c:v>119.357</c:v>
                </c:pt>
                <c:pt idx="39">
                  <c:v>123.107</c:v>
                </c:pt>
                <c:pt idx="40">
                  <c:v>124.711</c:v>
                </c:pt>
                <c:pt idx="41">
                  <c:v>128.96899999999999</c:v>
                </c:pt>
                <c:pt idx="42">
                  <c:v>134.83199999999999</c:v>
                </c:pt>
                <c:pt idx="43">
                  <c:v>138.47900000000001</c:v>
                </c:pt>
                <c:pt idx="44">
                  <c:v>139.20400000000001</c:v>
                </c:pt>
                <c:pt idx="45">
                  <c:v>140.69399999999999</c:v>
                </c:pt>
                <c:pt idx="46">
                  <c:v>146.399</c:v>
                </c:pt>
                <c:pt idx="47">
                  <c:v>146.55600000000001</c:v>
                </c:pt>
                <c:pt idx="48">
                  <c:v>151.97399999999999</c:v>
                </c:pt>
                <c:pt idx="49">
                  <c:v>152.41800000000001</c:v>
                </c:pt>
                <c:pt idx="50">
                  <c:v>158.28</c:v>
                </c:pt>
                <c:pt idx="51">
                  <c:v>164.143</c:v>
                </c:pt>
                <c:pt idx="52">
                  <c:v>170.005</c:v>
                </c:pt>
                <c:pt idx="53">
                  <c:v>170.18299999999999</c:v>
                </c:pt>
                <c:pt idx="54">
                  <c:v>175.86699999999999</c:v>
                </c:pt>
                <c:pt idx="55">
                  <c:v>177.96299999999999</c:v>
                </c:pt>
                <c:pt idx="56">
                  <c:v>181.72900000000001</c:v>
                </c:pt>
                <c:pt idx="57">
                  <c:v>187.59200000000001</c:v>
                </c:pt>
                <c:pt idx="58">
                  <c:v>190.98</c:v>
                </c:pt>
                <c:pt idx="59">
                  <c:v>193.45400000000001</c:v>
                </c:pt>
                <c:pt idx="60">
                  <c:v>199.316</c:v>
                </c:pt>
                <c:pt idx="61">
                  <c:v>203.71</c:v>
                </c:pt>
                <c:pt idx="62">
                  <c:v>205.178</c:v>
                </c:pt>
                <c:pt idx="63">
                  <c:v>211.041</c:v>
                </c:pt>
                <c:pt idx="64">
                  <c:v>211.709</c:v>
                </c:pt>
                <c:pt idx="65">
                  <c:v>215.28100000000001</c:v>
                </c:pt>
                <c:pt idx="66">
                  <c:v>216.90299999999999</c:v>
                </c:pt>
                <c:pt idx="67">
                  <c:v>222.76499999999999</c:v>
                </c:pt>
                <c:pt idx="68">
                  <c:v>225.34</c:v>
                </c:pt>
                <c:pt idx="69">
                  <c:v>228.62700000000001</c:v>
                </c:pt>
                <c:pt idx="70">
                  <c:v>230.774</c:v>
                </c:pt>
                <c:pt idx="71">
                  <c:v>234.49</c:v>
                </c:pt>
                <c:pt idx="72">
                  <c:v>239.26300000000001</c:v>
                </c:pt>
                <c:pt idx="73">
                  <c:v>240.352</c:v>
                </c:pt>
                <c:pt idx="74">
                  <c:v>246.214</c:v>
                </c:pt>
                <c:pt idx="75">
                  <c:v>252.07599999999999</c:v>
                </c:pt>
                <c:pt idx="76">
                  <c:v>257.93900000000002</c:v>
                </c:pt>
                <c:pt idx="77">
                  <c:v>260.03199999999998</c:v>
                </c:pt>
                <c:pt idx="78">
                  <c:v>263.80099999999999</c:v>
                </c:pt>
                <c:pt idx="79">
                  <c:v>266.99599999999998</c:v>
                </c:pt>
                <c:pt idx="80">
                  <c:v>269.66300000000001</c:v>
                </c:pt>
                <c:pt idx="81">
                  <c:v>275.52499999999998</c:v>
                </c:pt>
                <c:pt idx="82">
                  <c:v>276.94900000000001</c:v>
                </c:pt>
                <c:pt idx="83">
                  <c:v>281.38799999999998</c:v>
                </c:pt>
                <c:pt idx="84">
                  <c:v>282.83199999999999</c:v>
                </c:pt>
                <c:pt idx="85">
                  <c:v>287.25</c:v>
                </c:pt>
                <c:pt idx="86">
                  <c:v>287.709</c:v>
                </c:pt>
                <c:pt idx="87">
                  <c:v>292.25799999999998</c:v>
                </c:pt>
                <c:pt idx="88">
                  <c:v>293.11200000000002</c:v>
                </c:pt>
                <c:pt idx="89">
                  <c:v>296.33300000000003</c:v>
                </c:pt>
                <c:pt idx="90">
                  <c:v>298.97399999999999</c:v>
                </c:pt>
                <c:pt idx="91">
                  <c:v>300.37200000000001</c:v>
                </c:pt>
                <c:pt idx="92">
                  <c:v>304.83600000000001</c:v>
                </c:pt>
                <c:pt idx="93">
                  <c:v>306.96100000000001</c:v>
                </c:pt>
                <c:pt idx="94">
                  <c:v>310.69900000000001</c:v>
                </c:pt>
                <c:pt idx="95">
                  <c:v>316.56099999999998</c:v>
                </c:pt>
                <c:pt idx="96">
                  <c:v>317.68599999999998</c:v>
                </c:pt>
                <c:pt idx="97">
                  <c:v>322.423</c:v>
                </c:pt>
                <c:pt idx="98">
                  <c:v>328.28500000000003</c:v>
                </c:pt>
                <c:pt idx="99">
                  <c:v>334.14800000000002</c:v>
                </c:pt>
                <c:pt idx="100">
                  <c:v>340.01</c:v>
                </c:pt>
                <c:pt idx="101">
                  <c:v>345.87200000000001</c:v>
                </c:pt>
                <c:pt idx="102">
                  <c:v>348.60399999999998</c:v>
                </c:pt>
                <c:pt idx="103">
                  <c:v>351.73399999999998</c:v>
                </c:pt>
                <c:pt idx="104">
                  <c:v>357.59699999999998</c:v>
                </c:pt>
                <c:pt idx="105">
                  <c:v>361.37</c:v>
                </c:pt>
                <c:pt idx="106">
                  <c:v>363.459</c:v>
                </c:pt>
                <c:pt idx="107">
                  <c:v>367.63799999999998</c:v>
                </c:pt>
                <c:pt idx="108">
                  <c:v>369.089</c:v>
                </c:pt>
                <c:pt idx="109">
                  <c:v>369.32100000000003</c:v>
                </c:pt>
                <c:pt idx="110">
                  <c:v>373.61799999999999</c:v>
                </c:pt>
                <c:pt idx="111">
                  <c:v>375.18299999999999</c:v>
                </c:pt>
                <c:pt idx="112">
                  <c:v>381.04599999999999</c:v>
                </c:pt>
                <c:pt idx="113">
                  <c:v>385.96600000000001</c:v>
                </c:pt>
                <c:pt idx="114">
                  <c:v>386.90800000000002</c:v>
                </c:pt>
                <c:pt idx="115">
                  <c:v>390.35199999999998</c:v>
                </c:pt>
                <c:pt idx="116">
                  <c:v>392.274</c:v>
                </c:pt>
                <c:pt idx="117">
                  <c:v>392.77</c:v>
                </c:pt>
                <c:pt idx="118">
                  <c:v>394.76600000000002</c:v>
                </c:pt>
                <c:pt idx="119">
                  <c:v>398.09500000000003</c:v>
                </c:pt>
                <c:pt idx="120">
                  <c:v>398.63200000000001</c:v>
                </c:pt>
                <c:pt idx="121">
                  <c:v>400.45100000000002</c:v>
                </c:pt>
                <c:pt idx="122">
                  <c:v>401.97</c:v>
                </c:pt>
                <c:pt idx="123">
                  <c:v>404.495</c:v>
                </c:pt>
                <c:pt idx="124">
                  <c:v>410.27300000000002</c:v>
                </c:pt>
                <c:pt idx="125">
                  <c:v>410.35700000000003</c:v>
                </c:pt>
                <c:pt idx="126">
                  <c:v>416.21899999999999</c:v>
                </c:pt>
                <c:pt idx="127">
                  <c:v>422.08100000000002</c:v>
                </c:pt>
                <c:pt idx="128">
                  <c:v>427.94400000000002</c:v>
                </c:pt>
                <c:pt idx="129">
                  <c:v>433.80599999999998</c:v>
                </c:pt>
                <c:pt idx="130">
                  <c:v>437.94</c:v>
                </c:pt>
                <c:pt idx="131">
                  <c:v>439.66800000000001</c:v>
                </c:pt>
                <c:pt idx="132">
                  <c:v>445.53</c:v>
                </c:pt>
                <c:pt idx="133">
                  <c:v>451.392</c:v>
                </c:pt>
                <c:pt idx="134">
                  <c:v>454.96499999999997</c:v>
                </c:pt>
                <c:pt idx="135">
                  <c:v>457.255</c:v>
                </c:pt>
                <c:pt idx="136">
                  <c:v>463.11700000000002</c:v>
                </c:pt>
                <c:pt idx="137">
                  <c:v>464.30099999999999</c:v>
                </c:pt>
                <c:pt idx="138">
                  <c:v>468.97899999999998</c:v>
                </c:pt>
                <c:pt idx="139">
                  <c:v>470.435</c:v>
                </c:pt>
                <c:pt idx="140">
                  <c:v>471.40600000000001</c:v>
                </c:pt>
                <c:pt idx="141">
                  <c:v>472.423</c:v>
                </c:pt>
                <c:pt idx="142">
                  <c:v>474.20600000000002</c:v>
                </c:pt>
                <c:pt idx="143">
                  <c:v>474.84100000000001</c:v>
                </c:pt>
                <c:pt idx="144">
                  <c:v>475.98899999999998</c:v>
                </c:pt>
                <c:pt idx="145">
                  <c:v>477.57</c:v>
                </c:pt>
                <c:pt idx="146">
                  <c:v>479.036</c:v>
                </c:pt>
                <c:pt idx="147">
                  <c:v>480.70400000000001</c:v>
                </c:pt>
                <c:pt idx="148">
                  <c:v>482.16</c:v>
                </c:pt>
                <c:pt idx="149">
                  <c:v>486.56599999999997</c:v>
                </c:pt>
                <c:pt idx="150">
                  <c:v>490.50799999999998</c:v>
                </c:pt>
                <c:pt idx="151">
                  <c:v>492.428</c:v>
                </c:pt>
                <c:pt idx="152">
                  <c:v>496.12400000000002</c:v>
                </c:pt>
                <c:pt idx="153">
                  <c:v>496.7</c:v>
                </c:pt>
                <c:pt idx="154">
                  <c:v>498.29</c:v>
                </c:pt>
                <c:pt idx="155">
                  <c:v>498.95800000000003</c:v>
                </c:pt>
                <c:pt idx="156">
                  <c:v>504.15300000000002</c:v>
                </c:pt>
                <c:pt idx="157">
                  <c:v>510.01499999999999</c:v>
                </c:pt>
                <c:pt idx="158">
                  <c:v>510.38499999999999</c:v>
                </c:pt>
                <c:pt idx="159">
                  <c:v>515.87699999999995</c:v>
                </c:pt>
                <c:pt idx="160">
                  <c:v>516.68399999999997</c:v>
                </c:pt>
                <c:pt idx="161">
                  <c:v>518.84199999999998</c:v>
                </c:pt>
                <c:pt idx="162">
                  <c:v>521.73900000000003</c:v>
                </c:pt>
                <c:pt idx="163">
                  <c:v>527.60199999999998</c:v>
                </c:pt>
                <c:pt idx="164">
                  <c:v>533.46400000000006</c:v>
                </c:pt>
                <c:pt idx="165">
                  <c:v>533.76800000000003</c:v>
                </c:pt>
                <c:pt idx="166">
                  <c:v>539.32600000000002</c:v>
                </c:pt>
                <c:pt idx="167">
                  <c:v>545.18799999999999</c:v>
                </c:pt>
                <c:pt idx="168">
                  <c:v>546.54499999999996</c:v>
                </c:pt>
                <c:pt idx="169">
                  <c:v>551.05100000000004</c:v>
                </c:pt>
                <c:pt idx="170">
                  <c:v>553.25099999999998</c:v>
                </c:pt>
                <c:pt idx="171">
                  <c:v>553.94899999999996</c:v>
                </c:pt>
                <c:pt idx="172">
                  <c:v>554.84199999999998</c:v>
                </c:pt>
                <c:pt idx="173">
                  <c:v>556.23699999999997</c:v>
                </c:pt>
                <c:pt idx="174">
                  <c:v>556.91300000000001</c:v>
                </c:pt>
                <c:pt idx="175">
                  <c:v>562.77499999999998</c:v>
                </c:pt>
                <c:pt idx="176">
                  <c:v>565.26599999999996</c:v>
                </c:pt>
                <c:pt idx="177">
                  <c:v>568.63699999999994</c:v>
                </c:pt>
                <c:pt idx="178">
                  <c:v>574.5</c:v>
                </c:pt>
                <c:pt idx="179">
                  <c:v>578.03399999999999</c:v>
                </c:pt>
                <c:pt idx="180">
                  <c:v>580.36199999999997</c:v>
                </c:pt>
                <c:pt idx="181">
                  <c:v>585.28599999999994</c:v>
                </c:pt>
                <c:pt idx="182">
                  <c:v>586.22400000000005</c:v>
                </c:pt>
                <c:pt idx="183">
                  <c:v>586.52599999999995</c:v>
                </c:pt>
                <c:pt idx="184">
                  <c:v>592.08600000000001</c:v>
                </c:pt>
                <c:pt idx="185">
                  <c:v>593.03899999999999</c:v>
                </c:pt>
                <c:pt idx="186">
                  <c:v>596.44799999999998</c:v>
                </c:pt>
                <c:pt idx="187">
                  <c:v>597.63699999999994</c:v>
                </c:pt>
                <c:pt idx="188">
                  <c:v>597.94799999999998</c:v>
                </c:pt>
                <c:pt idx="189">
                  <c:v>598.84299999999996</c:v>
                </c:pt>
                <c:pt idx="190">
                  <c:v>600.13599999999997</c:v>
                </c:pt>
                <c:pt idx="191">
                  <c:v>601.42999999999995</c:v>
                </c:pt>
                <c:pt idx="192">
                  <c:v>603.81100000000004</c:v>
                </c:pt>
                <c:pt idx="193">
                  <c:v>606.33799999999997</c:v>
                </c:pt>
                <c:pt idx="194">
                  <c:v>609.673</c:v>
                </c:pt>
                <c:pt idx="195">
                  <c:v>610.92899999999997</c:v>
                </c:pt>
                <c:pt idx="196">
                  <c:v>614.03399999999999</c:v>
                </c:pt>
                <c:pt idx="197">
                  <c:v>615.53499999999997</c:v>
                </c:pt>
                <c:pt idx="198">
                  <c:v>617.04399999999998</c:v>
                </c:pt>
                <c:pt idx="199">
                  <c:v>620.72699999999998</c:v>
                </c:pt>
                <c:pt idx="200">
                  <c:v>621.39700000000005</c:v>
                </c:pt>
                <c:pt idx="201">
                  <c:v>623.29499999999996</c:v>
                </c:pt>
                <c:pt idx="202">
                  <c:v>627.26</c:v>
                </c:pt>
                <c:pt idx="203">
                  <c:v>633.12199999999996</c:v>
                </c:pt>
                <c:pt idx="204">
                  <c:v>635.33199999999999</c:v>
                </c:pt>
                <c:pt idx="205">
                  <c:v>638.98400000000004</c:v>
                </c:pt>
                <c:pt idx="206">
                  <c:v>639.64800000000002</c:v>
                </c:pt>
                <c:pt idx="207">
                  <c:v>644.846</c:v>
                </c:pt>
                <c:pt idx="208">
                  <c:v>650.70899999999995</c:v>
                </c:pt>
                <c:pt idx="209">
                  <c:v>651.73199999999997</c:v>
                </c:pt>
                <c:pt idx="210">
                  <c:v>656.57100000000003</c:v>
                </c:pt>
                <c:pt idx="211">
                  <c:v>661.80200000000002</c:v>
                </c:pt>
                <c:pt idx="212">
                  <c:v>662.43299999999999</c:v>
                </c:pt>
                <c:pt idx="213">
                  <c:v>664.14300000000003</c:v>
                </c:pt>
                <c:pt idx="214">
                  <c:v>664.79700000000003</c:v>
                </c:pt>
                <c:pt idx="215">
                  <c:v>668.29499999999996</c:v>
                </c:pt>
                <c:pt idx="216">
                  <c:v>668.99400000000003</c:v>
                </c:pt>
                <c:pt idx="217">
                  <c:v>674.06500000000005</c:v>
                </c:pt>
                <c:pt idx="218">
                  <c:v>674.15800000000002</c:v>
                </c:pt>
                <c:pt idx="219">
                  <c:v>679.00800000000004</c:v>
                </c:pt>
                <c:pt idx="220">
                  <c:v>679.71400000000006</c:v>
                </c:pt>
                <c:pt idx="221">
                  <c:v>680.02</c:v>
                </c:pt>
                <c:pt idx="222">
                  <c:v>680.36099999999999</c:v>
                </c:pt>
                <c:pt idx="223">
                  <c:v>681.35</c:v>
                </c:pt>
                <c:pt idx="224">
                  <c:v>682.39599999999996</c:v>
                </c:pt>
                <c:pt idx="225">
                  <c:v>682.94399999999996</c:v>
                </c:pt>
                <c:pt idx="226">
                  <c:v>683.47900000000004</c:v>
                </c:pt>
                <c:pt idx="227">
                  <c:v>685.88199999999995</c:v>
                </c:pt>
                <c:pt idx="228">
                  <c:v>688.88400000000001</c:v>
                </c:pt>
                <c:pt idx="229">
                  <c:v>691.74400000000003</c:v>
                </c:pt>
                <c:pt idx="230">
                  <c:v>695.46900000000005</c:v>
                </c:pt>
                <c:pt idx="231">
                  <c:v>697.60699999999997</c:v>
                </c:pt>
                <c:pt idx="232">
                  <c:v>701.14200000000005</c:v>
                </c:pt>
                <c:pt idx="233">
                  <c:v>703.46900000000005</c:v>
                </c:pt>
                <c:pt idx="234">
                  <c:v>705.34799999999996</c:v>
                </c:pt>
                <c:pt idx="235">
                  <c:v>709.33100000000002</c:v>
                </c:pt>
                <c:pt idx="236">
                  <c:v>709.553</c:v>
                </c:pt>
                <c:pt idx="237">
                  <c:v>710.46799999999996</c:v>
                </c:pt>
                <c:pt idx="238">
                  <c:v>715.19299999999998</c:v>
                </c:pt>
                <c:pt idx="239">
                  <c:v>721.05600000000004</c:v>
                </c:pt>
                <c:pt idx="240">
                  <c:v>723.53300000000002</c:v>
                </c:pt>
                <c:pt idx="241">
                  <c:v>726.19500000000005</c:v>
                </c:pt>
                <c:pt idx="242">
                  <c:v>726.44799999999998</c:v>
                </c:pt>
                <c:pt idx="243">
                  <c:v>726.91800000000001</c:v>
                </c:pt>
                <c:pt idx="244">
                  <c:v>726.92499999999995</c:v>
                </c:pt>
                <c:pt idx="245">
                  <c:v>727.87199999999996</c:v>
                </c:pt>
                <c:pt idx="246">
                  <c:v>729.04399999999998</c:v>
                </c:pt>
                <c:pt idx="247">
                  <c:v>730.11</c:v>
                </c:pt>
                <c:pt idx="248">
                  <c:v>732.78</c:v>
                </c:pt>
                <c:pt idx="249">
                  <c:v>733.12699999999995</c:v>
                </c:pt>
                <c:pt idx="250">
                  <c:v>738.41200000000003</c:v>
                </c:pt>
                <c:pt idx="251">
                  <c:v>738.64200000000005</c:v>
                </c:pt>
                <c:pt idx="252">
                  <c:v>741.88499999999999</c:v>
                </c:pt>
                <c:pt idx="253">
                  <c:v>744.50400000000002</c:v>
                </c:pt>
                <c:pt idx="254">
                  <c:v>745.83900000000006</c:v>
                </c:pt>
                <c:pt idx="255">
                  <c:v>747.71900000000005</c:v>
                </c:pt>
                <c:pt idx="256">
                  <c:v>750.36699999999996</c:v>
                </c:pt>
                <c:pt idx="257">
                  <c:v>756.22900000000004</c:v>
                </c:pt>
                <c:pt idx="258">
                  <c:v>760.75300000000004</c:v>
                </c:pt>
                <c:pt idx="259">
                  <c:v>762.09100000000001</c:v>
                </c:pt>
                <c:pt idx="260">
                  <c:v>767.95299999999997</c:v>
                </c:pt>
                <c:pt idx="261">
                  <c:v>773.69500000000005</c:v>
                </c:pt>
                <c:pt idx="262">
                  <c:v>773.81600000000003</c:v>
                </c:pt>
                <c:pt idx="263">
                  <c:v>778.95899999999995</c:v>
                </c:pt>
                <c:pt idx="264">
                  <c:v>779.678</c:v>
                </c:pt>
                <c:pt idx="265">
                  <c:v>781.74199999999996</c:v>
                </c:pt>
                <c:pt idx="266">
                  <c:v>785.54</c:v>
                </c:pt>
                <c:pt idx="267">
                  <c:v>786.11800000000005</c:v>
                </c:pt>
                <c:pt idx="268">
                  <c:v>791.40200000000004</c:v>
                </c:pt>
                <c:pt idx="269">
                  <c:v>794.85500000000002</c:v>
                </c:pt>
                <c:pt idx="270">
                  <c:v>797.26499999999999</c:v>
                </c:pt>
                <c:pt idx="271">
                  <c:v>803.12699999999995</c:v>
                </c:pt>
                <c:pt idx="272">
                  <c:v>803.59100000000001</c:v>
                </c:pt>
                <c:pt idx="273">
                  <c:v>805.35799999999995</c:v>
                </c:pt>
                <c:pt idx="274">
                  <c:v>805.86099999999999</c:v>
                </c:pt>
                <c:pt idx="275">
                  <c:v>806.90800000000002</c:v>
                </c:pt>
                <c:pt idx="276">
                  <c:v>808.02</c:v>
                </c:pt>
                <c:pt idx="277">
                  <c:v>808.98900000000003</c:v>
                </c:pt>
                <c:pt idx="278">
                  <c:v>814.851</c:v>
                </c:pt>
                <c:pt idx="279">
                  <c:v>815.28200000000004</c:v>
                </c:pt>
                <c:pt idx="280">
                  <c:v>819.04899999999998</c:v>
                </c:pt>
                <c:pt idx="281">
                  <c:v>820.71400000000006</c:v>
                </c:pt>
                <c:pt idx="282">
                  <c:v>820.75900000000001</c:v>
                </c:pt>
                <c:pt idx="283">
                  <c:v>822.93399999999997</c:v>
                </c:pt>
                <c:pt idx="284">
                  <c:v>825.10799999999995</c:v>
                </c:pt>
                <c:pt idx="285">
                  <c:v>825.83600000000001</c:v>
                </c:pt>
                <c:pt idx="286">
                  <c:v>826.495</c:v>
                </c:pt>
                <c:pt idx="287">
                  <c:v>826.57600000000002</c:v>
                </c:pt>
                <c:pt idx="288">
                  <c:v>832.43799999999999</c:v>
                </c:pt>
                <c:pt idx="289">
                  <c:v>832.86099999999999</c:v>
                </c:pt>
                <c:pt idx="290">
                  <c:v>838.3</c:v>
                </c:pt>
                <c:pt idx="291">
                  <c:v>843.10599999999999</c:v>
                </c:pt>
                <c:pt idx="292">
                  <c:v>844.16300000000001</c:v>
                </c:pt>
                <c:pt idx="293">
                  <c:v>846.48</c:v>
                </c:pt>
                <c:pt idx="294">
                  <c:v>848.28</c:v>
                </c:pt>
                <c:pt idx="295">
                  <c:v>850.02499999999998</c:v>
                </c:pt>
                <c:pt idx="296">
                  <c:v>850.35799999999995</c:v>
                </c:pt>
                <c:pt idx="297">
                  <c:v>853.10699999999997</c:v>
                </c:pt>
                <c:pt idx="298">
                  <c:v>855.88699999999994</c:v>
                </c:pt>
                <c:pt idx="299">
                  <c:v>856.77800000000002</c:v>
                </c:pt>
                <c:pt idx="300">
                  <c:v>860.43499999999995</c:v>
                </c:pt>
                <c:pt idx="301">
                  <c:v>861.74900000000002</c:v>
                </c:pt>
                <c:pt idx="302">
                  <c:v>864.60299999999995</c:v>
                </c:pt>
                <c:pt idx="303">
                  <c:v>867.61199999999997</c:v>
                </c:pt>
                <c:pt idx="304">
                  <c:v>867.81600000000003</c:v>
                </c:pt>
                <c:pt idx="305">
                  <c:v>873.47400000000005</c:v>
                </c:pt>
                <c:pt idx="306">
                  <c:v>876.74400000000003</c:v>
                </c:pt>
                <c:pt idx="307">
                  <c:v>879.33600000000001</c:v>
                </c:pt>
                <c:pt idx="308">
                  <c:v>885.19799999999998</c:v>
                </c:pt>
                <c:pt idx="309">
                  <c:v>885.67100000000005</c:v>
                </c:pt>
                <c:pt idx="310">
                  <c:v>887.04100000000005</c:v>
                </c:pt>
                <c:pt idx="311">
                  <c:v>887.81</c:v>
                </c:pt>
                <c:pt idx="312">
                  <c:v>891.06</c:v>
                </c:pt>
                <c:pt idx="313">
                  <c:v>896.28599999999994</c:v>
                </c:pt>
                <c:pt idx="314">
                  <c:v>896.923</c:v>
                </c:pt>
                <c:pt idx="315">
                  <c:v>899.16200000000003</c:v>
                </c:pt>
                <c:pt idx="316">
                  <c:v>900.61400000000003</c:v>
                </c:pt>
                <c:pt idx="317">
                  <c:v>902.07</c:v>
                </c:pt>
                <c:pt idx="318">
                  <c:v>902.78499999999997</c:v>
                </c:pt>
                <c:pt idx="319">
                  <c:v>903.69500000000005</c:v>
                </c:pt>
                <c:pt idx="320">
                  <c:v>905.48599999999999</c:v>
                </c:pt>
                <c:pt idx="321">
                  <c:v>908.64700000000005</c:v>
                </c:pt>
                <c:pt idx="322">
                  <c:v>909.63300000000004</c:v>
                </c:pt>
                <c:pt idx="323">
                  <c:v>914.50900000000001</c:v>
                </c:pt>
                <c:pt idx="324">
                  <c:v>914.55</c:v>
                </c:pt>
                <c:pt idx="325">
                  <c:v>920.37199999999996</c:v>
                </c:pt>
                <c:pt idx="326">
                  <c:v>924.04100000000005</c:v>
                </c:pt>
                <c:pt idx="327">
                  <c:v>926.23400000000004</c:v>
                </c:pt>
                <c:pt idx="328">
                  <c:v>926.404</c:v>
                </c:pt>
                <c:pt idx="329">
                  <c:v>927.05899999999997</c:v>
                </c:pt>
                <c:pt idx="330">
                  <c:v>927.35</c:v>
                </c:pt>
                <c:pt idx="331">
                  <c:v>931.70399999999995</c:v>
                </c:pt>
                <c:pt idx="332">
                  <c:v>932.096</c:v>
                </c:pt>
                <c:pt idx="333">
                  <c:v>937.95799999999997</c:v>
                </c:pt>
                <c:pt idx="334">
                  <c:v>943.82100000000003</c:v>
                </c:pt>
                <c:pt idx="335">
                  <c:v>944.94600000000003</c:v>
                </c:pt>
                <c:pt idx="336">
                  <c:v>946.56399999999996</c:v>
                </c:pt>
                <c:pt idx="337">
                  <c:v>949.68299999999999</c:v>
                </c:pt>
                <c:pt idx="338">
                  <c:v>952.37400000000002</c:v>
                </c:pt>
                <c:pt idx="339">
                  <c:v>955.54499999999996</c:v>
                </c:pt>
                <c:pt idx="340">
                  <c:v>960.84299999999996</c:v>
                </c:pt>
                <c:pt idx="341">
                  <c:v>961.40700000000004</c:v>
                </c:pt>
                <c:pt idx="342">
                  <c:v>967.27</c:v>
                </c:pt>
                <c:pt idx="343">
                  <c:v>972.346</c:v>
                </c:pt>
                <c:pt idx="344">
                  <c:v>973.13199999999995</c:v>
                </c:pt>
                <c:pt idx="345">
                  <c:v>976.17899999999997</c:v>
                </c:pt>
                <c:pt idx="346">
                  <c:v>978.47500000000002</c:v>
                </c:pt>
                <c:pt idx="347">
                  <c:v>978.99400000000003</c:v>
                </c:pt>
                <c:pt idx="348">
                  <c:v>984.16800000000001</c:v>
                </c:pt>
                <c:pt idx="349">
                  <c:v>984.85599999999999</c:v>
                </c:pt>
                <c:pt idx="350">
                  <c:v>988.51499999999999</c:v>
                </c:pt>
                <c:pt idx="351">
                  <c:v>990.71900000000005</c:v>
                </c:pt>
                <c:pt idx="352">
                  <c:v>991.404</c:v>
                </c:pt>
                <c:pt idx="353">
                  <c:v>996.58100000000002</c:v>
                </c:pt>
                <c:pt idx="354">
                  <c:v>1001.731</c:v>
                </c:pt>
                <c:pt idx="355">
                  <c:v>1002.443</c:v>
                </c:pt>
                <c:pt idx="356">
                  <c:v>1003.505</c:v>
                </c:pt>
                <c:pt idx="357">
                  <c:v>1004.686</c:v>
                </c:pt>
                <c:pt idx="358">
                  <c:v>1006.813</c:v>
                </c:pt>
                <c:pt idx="359">
                  <c:v>1008.3049999999999</c:v>
                </c:pt>
                <c:pt idx="360">
                  <c:v>1014.168</c:v>
                </c:pt>
                <c:pt idx="361">
                  <c:v>1020.03</c:v>
                </c:pt>
                <c:pt idx="362">
                  <c:v>1021.857</c:v>
                </c:pt>
                <c:pt idx="363">
                  <c:v>1025.8920000000001</c:v>
                </c:pt>
                <c:pt idx="364">
                  <c:v>1031.7539999999999</c:v>
                </c:pt>
                <c:pt idx="365">
                  <c:v>1036.5630000000001</c:v>
                </c:pt>
                <c:pt idx="366">
                  <c:v>1037.616</c:v>
                </c:pt>
                <c:pt idx="367">
                  <c:v>1042.336</c:v>
                </c:pt>
                <c:pt idx="368">
                  <c:v>1043.3610000000001</c:v>
                </c:pt>
                <c:pt idx="369">
                  <c:v>1043.479</c:v>
                </c:pt>
                <c:pt idx="370">
                  <c:v>1048.231</c:v>
                </c:pt>
                <c:pt idx="371">
                  <c:v>1049.3409999999999</c:v>
                </c:pt>
                <c:pt idx="372">
                  <c:v>1055.203</c:v>
                </c:pt>
                <c:pt idx="373">
                  <c:v>1061.0650000000001</c:v>
                </c:pt>
                <c:pt idx="374">
                  <c:v>1064.7059999999999</c:v>
                </c:pt>
                <c:pt idx="375">
                  <c:v>1066.9280000000001</c:v>
                </c:pt>
                <c:pt idx="376">
                  <c:v>1072.79</c:v>
                </c:pt>
                <c:pt idx="377">
                  <c:v>1078.0989999999999</c:v>
                </c:pt>
                <c:pt idx="378">
                  <c:v>1078.652</c:v>
                </c:pt>
                <c:pt idx="379">
                  <c:v>1080.1300000000001</c:v>
                </c:pt>
                <c:pt idx="380">
                  <c:v>1082.896</c:v>
                </c:pt>
                <c:pt idx="381">
                  <c:v>1084.5139999999999</c:v>
                </c:pt>
                <c:pt idx="382">
                  <c:v>1090.377</c:v>
                </c:pt>
                <c:pt idx="383">
                  <c:v>1096.239</c:v>
                </c:pt>
                <c:pt idx="384">
                  <c:v>1102.1010000000001</c:v>
                </c:pt>
                <c:pt idx="385">
                  <c:v>1104.4349999999999</c:v>
                </c:pt>
                <c:pt idx="386">
                  <c:v>1107.963</c:v>
                </c:pt>
                <c:pt idx="387">
                  <c:v>1111.7159999999999</c:v>
                </c:pt>
                <c:pt idx="388">
                  <c:v>1113.826</c:v>
                </c:pt>
                <c:pt idx="389">
                  <c:v>1119.6880000000001</c:v>
                </c:pt>
                <c:pt idx="390">
                  <c:v>1125.55</c:v>
                </c:pt>
                <c:pt idx="391">
                  <c:v>1131.412</c:v>
                </c:pt>
                <c:pt idx="392">
                  <c:v>1131.4960000000001</c:v>
                </c:pt>
                <c:pt idx="393">
                  <c:v>1137.2750000000001</c:v>
                </c:pt>
                <c:pt idx="394">
                  <c:v>1143.1369999999999</c:v>
                </c:pt>
                <c:pt idx="395">
                  <c:v>1148.999</c:v>
                </c:pt>
                <c:pt idx="396">
                  <c:v>1154.8610000000001</c:v>
                </c:pt>
                <c:pt idx="397">
                  <c:v>1160.7239999999999</c:v>
                </c:pt>
                <c:pt idx="398">
                  <c:v>1162.3320000000001</c:v>
                </c:pt>
                <c:pt idx="399">
                  <c:v>1166.586</c:v>
                </c:pt>
                <c:pt idx="400">
                  <c:v>1172.4480000000001</c:v>
                </c:pt>
                <c:pt idx="401">
                  <c:v>1172.4480000000001</c:v>
                </c:pt>
              </c:numCache>
            </c:numRef>
          </c:xVal>
          <c:yVal>
            <c:numRef>
              <c:f>Foglio6!$F$1227:$F$1628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99.769000000000005</c:v>
                </c:pt>
                <c:pt idx="7">
                  <c:v>99.5</c:v>
                </c:pt>
                <c:pt idx="8">
                  <c:v>99.391999999999996</c:v>
                </c:pt>
                <c:pt idx="9">
                  <c:v>99</c:v>
                </c:pt>
                <c:pt idx="10">
                  <c:v>98.850999999999999</c:v>
                </c:pt>
                <c:pt idx="11">
                  <c:v>98.5</c:v>
                </c:pt>
                <c:pt idx="12">
                  <c:v>98.049000000000007</c:v>
                </c:pt>
                <c:pt idx="13">
                  <c:v>98</c:v>
                </c:pt>
                <c:pt idx="14">
                  <c:v>97.691999999999993</c:v>
                </c:pt>
                <c:pt idx="15">
                  <c:v>97.5</c:v>
                </c:pt>
                <c:pt idx="16">
                  <c:v>97.052000000000007</c:v>
                </c:pt>
                <c:pt idx="17">
                  <c:v>97</c:v>
                </c:pt>
                <c:pt idx="18">
                  <c:v>96.5</c:v>
                </c:pt>
                <c:pt idx="19">
                  <c:v>96.256</c:v>
                </c:pt>
                <c:pt idx="20">
                  <c:v>96</c:v>
                </c:pt>
                <c:pt idx="21">
                  <c:v>95.507999999999996</c:v>
                </c:pt>
                <c:pt idx="22">
                  <c:v>95.5</c:v>
                </c:pt>
                <c:pt idx="23">
                  <c:v>95.305000000000007</c:v>
                </c:pt>
                <c:pt idx="24">
                  <c:v>95</c:v>
                </c:pt>
                <c:pt idx="25">
                  <c:v>94.64</c:v>
                </c:pt>
                <c:pt idx="26">
                  <c:v>94.5</c:v>
                </c:pt>
                <c:pt idx="27">
                  <c:v>94.27</c:v>
                </c:pt>
                <c:pt idx="28">
                  <c:v>94</c:v>
                </c:pt>
                <c:pt idx="29">
                  <c:v>93.828000000000003</c:v>
                </c:pt>
                <c:pt idx="30">
                  <c:v>93.5</c:v>
                </c:pt>
                <c:pt idx="31">
                  <c:v>93.331999999999994</c:v>
                </c:pt>
                <c:pt idx="32">
                  <c:v>93</c:v>
                </c:pt>
                <c:pt idx="33">
                  <c:v>92.825999999999993</c:v>
                </c:pt>
                <c:pt idx="34">
                  <c:v>92.5</c:v>
                </c:pt>
                <c:pt idx="35">
                  <c:v>92.040999999999997</c:v>
                </c:pt>
                <c:pt idx="36">
                  <c:v>92</c:v>
                </c:pt>
                <c:pt idx="37">
                  <c:v>91.692999999999998</c:v>
                </c:pt>
                <c:pt idx="38">
                  <c:v>91.5</c:v>
                </c:pt>
                <c:pt idx="39">
                  <c:v>91.152000000000001</c:v>
                </c:pt>
                <c:pt idx="40">
                  <c:v>91</c:v>
                </c:pt>
                <c:pt idx="41">
                  <c:v>90.867999999999995</c:v>
                </c:pt>
                <c:pt idx="42">
                  <c:v>90.751000000000005</c:v>
                </c:pt>
                <c:pt idx="43">
                  <c:v>90.5</c:v>
                </c:pt>
                <c:pt idx="44">
                  <c:v>90</c:v>
                </c:pt>
                <c:pt idx="45">
                  <c:v>89.734999999999999</c:v>
                </c:pt>
                <c:pt idx="46">
                  <c:v>89.5</c:v>
                </c:pt>
                <c:pt idx="47">
                  <c:v>89.494</c:v>
                </c:pt>
                <c:pt idx="48">
                  <c:v>89</c:v>
                </c:pt>
                <c:pt idx="49">
                  <c:v>88.950999999999993</c:v>
                </c:pt>
                <c:pt idx="50">
                  <c:v>88.811999999999998</c:v>
                </c:pt>
                <c:pt idx="51">
                  <c:v>88.707999999999998</c:v>
                </c:pt>
                <c:pt idx="52">
                  <c:v>88.51</c:v>
                </c:pt>
                <c:pt idx="53">
                  <c:v>88.5</c:v>
                </c:pt>
                <c:pt idx="54">
                  <c:v>88.137</c:v>
                </c:pt>
                <c:pt idx="55">
                  <c:v>88</c:v>
                </c:pt>
                <c:pt idx="56">
                  <c:v>87.847999999999999</c:v>
                </c:pt>
                <c:pt idx="57">
                  <c:v>87.628</c:v>
                </c:pt>
                <c:pt idx="58">
                  <c:v>87.5</c:v>
                </c:pt>
                <c:pt idx="59">
                  <c:v>87.406999999999996</c:v>
                </c:pt>
                <c:pt idx="60">
                  <c:v>87.186000000000007</c:v>
                </c:pt>
                <c:pt idx="61">
                  <c:v>87</c:v>
                </c:pt>
                <c:pt idx="62">
                  <c:v>86.908000000000001</c:v>
                </c:pt>
                <c:pt idx="63">
                  <c:v>86.542000000000002</c:v>
                </c:pt>
                <c:pt idx="64">
                  <c:v>86.5</c:v>
                </c:pt>
                <c:pt idx="65">
                  <c:v>86</c:v>
                </c:pt>
                <c:pt idx="66">
                  <c:v>85.915999999999997</c:v>
                </c:pt>
                <c:pt idx="67">
                  <c:v>85.66</c:v>
                </c:pt>
                <c:pt idx="68">
                  <c:v>85.5</c:v>
                </c:pt>
                <c:pt idx="69">
                  <c:v>85.245999999999995</c:v>
                </c:pt>
                <c:pt idx="70">
                  <c:v>85</c:v>
                </c:pt>
                <c:pt idx="71">
                  <c:v>84.664000000000001</c:v>
                </c:pt>
                <c:pt idx="72">
                  <c:v>84.5</c:v>
                </c:pt>
                <c:pt idx="73">
                  <c:v>84.453999999999994</c:v>
                </c:pt>
                <c:pt idx="74">
                  <c:v>84.203000000000003</c:v>
                </c:pt>
                <c:pt idx="75">
                  <c:v>84.168999999999997</c:v>
                </c:pt>
                <c:pt idx="76">
                  <c:v>84.135000000000005</c:v>
                </c:pt>
                <c:pt idx="77">
                  <c:v>84</c:v>
                </c:pt>
                <c:pt idx="78">
                  <c:v>83.66</c:v>
                </c:pt>
                <c:pt idx="79">
                  <c:v>83.5</c:v>
                </c:pt>
                <c:pt idx="80">
                  <c:v>83.366</c:v>
                </c:pt>
                <c:pt idx="81">
                  <c:v>83.072000000000003</c:v>
                </c:pt>
                <c:pt idx="82">
                  <c:v>83</c:v>
                </c:pt>
                <c:pt idx="83">
                  <c:v>82.647999999999996</c:v>
                </c:pt>
                <c:pt idx="84">
                  <c:v>82.5</c:v>
                </c:pt>
                <c:pt idx="85">
                  <c:v>82.046999999999997</c:v>
                </c:pt>
                <c:pt idx="86">
                  <c:v>82</c:v>
                </c:pt>
                <c:pt idx="87">
                  <c:v>81.5</c:v>
                </c:pt>
                <c:pt idx="88">
                  <c:v>81.397000000000006</c:v>
                </c:pt>
                <c:pt idx="89">
                  <c:v>81</c:v>
                </c:pt>
                <c:pt idx="90">
                  <c:v>80.671000000000006</c:v>
                </c:pt>
                <c:pt idx="91">
                  <c:v>80.5</c:v>
                </c:pt>
                <c:pt idx="92">
                  <c:v>80.085999999999999</c:v>
                </c:pt>
                <c:pt idx="93">
                  <c:v>80</c:v>
                </c:pt>
                <c:pt idx="94">
                  <c:v>79.847999999999999</c:v>
                </c:pt>
                <c:pt idx="95">
                  <c:v>79.611000000000004</c:v>
                </c:pt>
                <c:pt idx="96">
                  <c:v>79.5</c:v>
                </c:pt>
                <c:pt idx="97">
                  <c:v>79.382000000000005</c:v>
                </c:pt>
                <c:pt idx="98">
                  <c:v>79.325999999999993</c:v>
                </c:pt>
                <c:pt idx="99">
                  <c:v>79.234999999999999</c:v>
                </c:pt>
                <c:pt idx="100">
                  <c:v>79.143000000000001</c:v>
                </c:pt>
                <c:pt idx="101">
                  <c:v>79.052000000000007</c:v>
                </c:pt>
                <c:pt idx="102">
                  <c:v>79</c:v>
                </c:pt>
                <c:pt idx="103">
                  <c:v>78.876999999999995</c:v>
                </c:pt>
                <c:pt idx="104">
                  <c:v>78.647999999999996</c:v>
                </c:pt>
                <c:pt idx="105">
                  <c:v>78.5</c:v>
                </c:pt>
                <c:pt idx="106">
                  <c:v>78.418000000000006</c:v>
                </c:pt>
                <c:pt idx="107">
                  <c:v>78</c:v>
                </c:pt>
                <c:pt idx="108">
                  <c:v>77.5</c:v>
                </c:pt>
                <c:pt idx="109">
                  <c:v>77.436000000000007</c:v>
                </c:pt>
                <c:pt idx="110">
                  <c:v>77</c:v>
                </c:pt>
                <c:pt idx="111">
                  <c:v>76.882999999999996</c:v>
                </c:pt>
                <c:pt idx="112">
                  <c:v>76.668000000000006</c:v>
                </c:pt>
                <c:pt idx="113">
                  <c:v>76.5</c:v>
                </c:pt>
                <c:pt idx="114">
                  <c:v>76.397000000000006</c:v>
                </c:pt>
                <c:pt idx="115">
                  <c:v>76</c:v>
                </c:pt>
                <c:pt idx="116">
                  <c:v>75.5</c:v>
                </c:pt>
                <c:pt idx="117">
                  <c:v>75.370999999999995</c:v>
                </c:pt>
                <c:pt idx="118">
                  <c:v>75</c:v>
                </c:pt>
                <c:pt idx="119">
                  <c:v>74.5</c:v>
                </c:pt>
                <c:pt idx="120">
                  <c:v>74.418999999999997</c:v>
                </c:pt>
                <c:pt idx="121">
                  <c:v>74</c:v>
                </c:pt>
                <c:pt idx="122">
                  <c:v>73.5</c:v>
                </c:pt>
                <c:pt idx="123">
                  <c:v>73.103999999999999</c:v>
                </c:pt>
                <c:pt idx="124">
                  <c:v>73</c:v>
                </c:pt>
                <c:pt idx="125">
                  <c:v>72.998000000000005</c:v>
                </c:pt>
                <c:pt idx="126">
                  <c:v>72.893000000000001</c:v>
                </c:pt>
                <c:pt idx="127">
                  <c:v>72.787000000000006</c:v>
                </c:pt>
                <c:pt idx="128">
                  <c:v>72.680999999999997</c:v>
                </c:pt>
                <c:pt idx="129">
                  <c:v>72.575000000000003</c:v>
                </c:pt>
                <c:pt idx="130">
                  <c:v>72.5</c:v>
                </c:pt>
                <c:pt idx="131">
                  <c:v>72.468999999999994</c:v>
                </c:pt>
                <c:pt idx="132">
                  <c:v>72.363</c:v>
                </c:pt>
                <c:pt idx="133">
                  <c:v>72.141999999999996</c:v>
                </c:pt>
                <c:pt idx="134">
                  <c:v>72</c:v>
                </c:pt>
                <c:pt idx="135">
                  <c:v>71.899000000000001</c:v>
                </c:pt>
                <c:pt idx="136">
                  <c:v>71.566999999999993</c:v>
                </c:pt>
                <c:pt idx="137">
                  <c:v>71.5</c:v>
                </c:pt>
                <c:pt idx="138">
                  <c:v>71.234999999999999</c:v>
                </c:pt>
                <c:pt idx="139">
                  <c:v>71</c:v>
                </c:pt>
                <c:pt idx="140">
                  <c:v>70.5</c:v>
                </c:pt>
                <c:pt idx="141">
                  <c:v>70</c:v>
                </c:pt>
                <c:pt idx="142">
                  <c:v>69.5</c:v>
                </c:pt>
                <c:pt idx="143">
                  <c:v>69.322000000000003</c:v>
                </c:pt>
                <c:pt idx="144">
                  <c:v>69</c:v>
                </c:pt>
                <c:pt idx="145">
                  <c:v>68.5</c:v>
                </c:pt>
                <c:pt idx="146">
                  <c:v>68</c:v>
                </c:pt>
                <c:pt idx="147">
                  <c:v>67.587000000000003</c:v>
                </c:pt>
                <c:pt idx="148">
                  <c:v>67.5</c:v>
                </c:pt>
                <c:pt idx="149">
                  <c:v>67.236000000000004</c:v>
                </c:pt>
                <c:pt idx="150">
                  <c:v>67</c:v>
                </c:pt>
                <c:pt idx="151">
                  <c:v>66.885000000000005</c:v>
                </c:pt>
                <c:pt idx="152">
                  <c:v>66.5</c:v>
                </c:pt>
                <c:pt idx="153">
                  <c:v>66</c:v>
                </c:pt>
                <c:pt idx="154">
                  <c:v>65.528000000000006</c:v>
                </c:pt>
                <c:pt idx="155">
                  <c:v>65.5</c:v>
                </c:pt>
                <c:pt idx="156">
                  <c:v>65.278000000000006</c:v>
                </c:pt>
                <c:pt idx="157">
                  <c:v>65.019000000000005</c:v>
                </c:pt>
                <c:pt idx="158">
                  <c:v>65</c:v>
                </c:pt>
                <c:pt idx="159">
                  <c:v>64.686999999999998</c:v>
                </c:pt>
                <c:pt idx="160">
                  <c:v>64.5</c:v>
                </c:pt>
                <c:pt idx="161">
                  <c:v>64</c:v>
                </c:pt>
                <c:pt idx="162">
                  <c:v>63.856000000000002</c:v>
                </c:pt>
                <c:pt idx="163">
                  <c:v>63.683</c:v>
                </c:pt>
                <c:pt idx="164">
                  <c:v>63.509</c:v>
                </c:pt>
                <c:pt idx="165">
                  <c:v>63.5</c:v>
                </c:pt>
                <c:pt idx="166">
                  <c:v>63.335000000000001</c:v>
                </c:pt>
                <c:pt idx="167">
                  <c:v>63.093000000000004</c:v>
                </c:pt>
                <c:pt idx="168">
                  <c:v>63</c:v>
                </c:pt>
                <c:pt idx="169">
                  <c:v>62.692</c:v>
                </c:pt>
                <c:pt idx="170">
                  <c:v>62.5</c:v>
                </c:pt>
                <c:pt idx="171">
                  <c:v>62</c:v>
                </c:pt>
                <c:pt idx="172">
                  <c:v>61.5</c:v>
                </c:pt>
                <c:pt idx="173">
                  <c:v>61</c:v>
                </c:pt>
                <c:pt idx="174">
                  <c:v>60.96</c:v>
                </c:pt>
                <c:pt idx="175">
                  <c:v>60.610999999999997</c:v>
                </c:pt>
                <c:pt idx="176">
                  <c:v>60.5</c:v>
                </c:pt>
                <c:pt idx="177">
                  <c:v>60.374000000000002</c:v>
                </c:pt>
                <c:pt idx="178">
                  <c:v>60.151000000000003</c:v>
                </c:pt>
                <c:pt idx="179">
                  <c:v>60</c:v>
                </c:pt>
                <c:pt idx="180">
                  <c:v>59.901000000000003</c:v>
                </c:pt>
                <c:pt idx="181">
                  <c:v>59.5</c:v>
                </c:pt>
                <c:pt idx="182">
                  <c:v>59.023000000000003</c:v>
                </c:pt>
                <c:pt idx="183">
                  <c:v>59</c:v>
                </c:pt>
                <c:pt idx="184">
                  <c:v>58.573</c:v>
                </c:pt>
                <c:pt idx="185">
                  <c:v>58.5</c:v>
                </c:pt>
                <c:pt idx="186">
                  <c:v>58</c:v>
                </c:pt>
                <c:pt idx="187">
                  <c:v>57.5</c:v>
                </c:pt>
                <c:pt idx="188">
                  <c:v>57.369</c:v>
                </c:pt>
                <c:pt idx="189">
                  <c:v>57</c:v>
                </c:pt>
                <c:pt idx="190">
                  <c:v>56.5</c:v>
                </c:pt>
                <c:pt idx="191">
                  <c:v>56</c:v>
                </c:pt>
                <c:pt idx="192">
                  <c:v>55.731999999999999</c:v>
                </c:pt>
                <c:pt idx="193">
                  <c:v>55.5</c:v>
                </c:pt>
                <c:pt idx="194">
                  <c:v>55.194000000000003</c:v>
                </c:pt>
                <c:pt idx="195">
                  <c:v>55</c:v>
                </c:pt>
                <c:pt idx="196">
                  <c:v>54.5</c:v>
                </c:pt>
                <c:pt idx="197">
                  <c:v>54.253</c:v>
                </c:pt>
                <c:pt idx="198">
                  <c:v>54</c:v>
                </c:pt>
                <c:pt idx="199">
                  <c:v>53.5</c:v>
                </c:pt>
                <c:pt idx="200">
                  <c:v>53.427</c:v>
                </c:pt>
                <c:pt idx="201">
                  <c:v>53</c:v>
                </c:pt>
                <c:pt idx="202">
                  <c:v>52.875999999999998</c:v>
                </c:pt>
                <c:pt idx="203">
                  <c:v>52.639000000000003</c:v>
                </c:pt>
                <c:pt idx="204">
                  <c:v>52.5</c:v>
                </c:pt>
                <c:pt idx="205">
                  <c:v>52.027999999999999</c:v>
                </c:pt>
                <c:pt idx="206">
                  <c:v>52</c:v>
                </c:pt>
                <c:pt idx="207">
                  <c:v>51.777999999999999</c:v>
                </c:pt>
                <c:pt idx="208">
                  <c:v>51.54</c:v>
                </c:pt>
                <c:pt idx="209">
                  <c:v>51.5</c:v>
                </c:pt>
                <c:pt idx="210">
                  <c:v>51.308999999999997</c:v>
                </c:pt>
                <c:pt idx="211">
                  <c:v>51</c:v>
                </c:pt>
                <c:pt idx="212">
                  <c:v>50.881999999999998</c:v>
                </c:pt>
                <c:pt idx="213">
                  <c:v>50.5</c:v>
                </c:pt>
                <c:pt idx="214">
                  <c:v>50</c:v>
                </c:pt>
                <c:pt idx="215">
                  <c:v>49.567999999999998</c:v>
                </c:pt>
                <c:pt idx="216">
                  <c:v>49.5</c:v>
                </c:pt>
                <c:pt idx="217">
                  <c:v>49</c:v>
                </c:pt>
                <c:pt idx="218">
                  <c:v>48.991</c:v>
                </c:pt>
                <c:pt idx="219">
                  <c:v>48.5</c:v>
                </c:pt>
                <c:pt idx="220">
                  <c:v>48</c:v>
                </c:pt>
                <c:pt idx="221">
                  <c:v>47.764000000000003</c:v>
                </c:pt>
                <c:pt idx="222">
                  <c:v>47.5</c:v>
                </c:pt>
                <c:pt idx="223">
                  <c:v>47</c:v>
                </c:pt>
                <c:pt idx="224">
                  <c:v>46.5</c:v>
                </c:pt>
                <c:pt idx="225">
                  <c:v>46</c:v>
                </c:pt>
                <c:pt idx="226">
                  <c:v>45.5</c:v>
                </c:pt>
                <c:pt idx="227">
                  <c:v>45.228000000000002</c:v>
                </c:pt>
                <c:pt idx="228">
                  <c:v>45</c:v>
                </c:pt>
                <c:pt idx="229">
                  <c:v>44.783000000000001</c:v>
                </c:pt>
                <c:pt idx="230">
                  <c:v>44.5</c:v>
                </c:pt>
                <c:pt idx="231">
                  <c:v>44.338000000000001</c:v>
                </c:pt>
                <c:pt idx="232">
                  <c:v>44</c:v>
                </c:pt>
                <c:pt idx="233">
                  <c:v>43.722999999999999</c:v>
                </c:pt>
                <c:pt idx="234">
                  <c:v>43.5</c:v>
                </c:pt>
                <c:pt idx="235">
                  <c:v>43.026000000000003</c:v>
                </c:pt>
                <c:pt idx="236">
                  <c:v>43</c:v>
                </c:pt>
                <c:pt idx="237">
                  <c:v>42.5</c:v>
                </c:pt>
                <c:pt idx="238">
                  <c:v>42.350999999999999</c:v>
                </c:pt>
                <c:pt idx="239">
                  <c:v>42.213000000000001</c:v>
                </c:pt>
                <c:pt idx="240">
                  <c:v>42</c:v>
                </c:pt>
                <c:pt idx="241">
                  <c:v>41.5</c:v>
                </c:pt>
                <c:pt idx="242">
                  <c:v>41</c:v>
                </c:pt>
                <c:pt idx="243">
                  <c:v>40.503999999999998</c:v>
                </c:pt>
                <c:pt idx="244">
                  <c:v>40.5</c:v>
                </c:pt>
                <c:pt idx="245">
                  <c:v>40</c:v>
                </c:pt>
                <c:pt idx="246">
                  <c:v>39.5</c:v>
                </c:pt>
                <c:pt idx="247">
                  <c:v>39</c:v>
                </c:pt>
                <c:pt idx="248">
                  <c:v>38.531999999999996</c:v>
                </c:pt>
                <c:pt idx="249">
                  <c:v>38.5</c:v>
                </c:pt>
                <c:pt idx="250">
                  <c:v>38</c:v>
                </c:pt>
                <c:pt idx="251">
                  <c:v>37.966000000000001</c:v>
                </c:pt>
                <c:pt idx="252">
                  <c:v>37.5</c:v>
                </c:pt>
                <c:pt idx="253">
                  <c:v>37.173000000000002</c:v>
                </c:pt>
                <c:pt idx="254">
                  <c:v>37</c:v>
                </c:pt>
                <c:pt idx="255">
                  <c:v>36.5</c:v>
                </c:pt>
                <c:pt idx="256">
                  <c:v>36.287999999999997</c:v>
                </c:pt>
                <c:pt idx="257">
                  <c:v>36.106000000000002</c:v>
                </c:pt>
                <c:pt idx="258">
                  <c:v>36</c:v>
                </c:pt>
                <c:pt idx="259">
                  <c:v>35.981999999999999</c:v>
                </c:pt>
                <c:pt idx="260">
                  <c:v>35.808999999999997</c:v>
                </c:pt>
                <c:pt idx="261">
                  <c:v>35.5</c:v>
                </c:pt>
                <c:pt idx="262">
                  <c:v>35.494</c:v>
                </c:pt>
                <c:pt idx="263">
                  <c:v>35</c:v>
                </c:pt>
                <c:pt idx="264">
                  <c:v>34.871000000000002</c:v>
                </c:pt>
                <c:pt idx="265">
                  <c:v>34.5</c:v>
                </c:pt>
                <c:pt idx="266">
                  <c:v>34.033000000000001</c:v>
                </c:pt>
                <c:pt idx="267">
                  <c:v>34</c:v>
                </c:pt>
                <c:pt idx="268">
                  <c:v>33.698</c:v>
                </c:pt>
                <c:pt idx="269">
                  <c:v>33.5</c:v>
                </c:pt>
                <c:pt idx="270">
                  <c:v>33.362000000000002</c:v>
                </c:pt>
                <c:pt idx="271">
                  <c:v>33.027000000000001</c:v>
                </c:pt>
                <c:pt idx="272">
                  <c:v>33</c:v>
                </c:pt>
                <c:pt idx="273">
                  <c:v>32.5</c:v>
                </c:pt>
                <c:pt idx="274">
                  <c:v>32</c:v>
                </c:pt>
                <c:pt idx="275">
                  <c:v>31.5</c:v>
                </c:pt>
                <c:pt idx="276">
                  <c:v>31</c:v>
                </c:pt>
                <c:pt idx="277">
                  <c:v>30.911999999999999</c:v>
                </c:pt>
                <c:pt idx="278">
                  <c:v>30.527999999999999</c:v>
                </c:pt>
                <c:pt idx="279">
                  <c:v>30.5</c:v>
                </c:pt>
                <c:pt idx="280">
                  <c:v>30</c:v>
                </c:pt>
                <c:pt idx="281">
                  <c:v>29.51</c:v>
                </c:pt>
                <c:pt idx="282">
                  <c:v>29.5</c:v>
                </c:pt>
                <c:pt idx="283">
                  <c:v>29</c:v>
                </c:pt>
                <c:pt idx="284">
                  <c:v>28.5</c:v>
                </c:pt>
                <c:pt idx="285">
                  <c:v>28</c:v>
                </c:pt>
                <c:pt idx="286">
                  <c:v>27.5</c:v>
                </c:pt>
                <c:pt idx="287">
                  <c:v>27.439</c:v>
                </c:pt>
                <c:pt idx="288">
                  <c:v>27.027000000000001</c:v>
                </c:pt>
                <c:pt idx="289">
                  <c:v>27</c:v>
                </c:pt>
                <c:pt idx="290">
                  <c:v>26.667999999999999</c:v>
                </c:pt>
                <c:pt idx="291">
                  <c:v>26.5</c:v>
                </c:pt>
                <c:pt idx="292">
                  <c:v>26.463000000000001</c:v>
                </c:pt>
                <c:pt idx="293">
                  <c:v>26</c:v>
                </c:pt>
                <c:pt idx="294">
                  <c:v>25.5</c:v>
                </c:pt>
                <c:pt idx="295">
                  <c:v>25.067</c:v>
                </c:pt>
                <c:pt idx="296">
                  <c:v>25</c:v>
                </c:pt>
                <c:pt idx="297">
                  <c:v>24.5</c:v>
                </c:pt>
                <c:pt idx="298">
                  <c:v>24.102</c:v>
                </c:pt>
                <c:pt idx="299">
                  <c:v>24</c:v>
                </c:pt>
                <c:pt idx="300">
                  <c:v>23.5</c:v>
                </c:pt>
                <c:pt idx="301">
                  <c:v>23.253</c:v>
                </c:pt>
                <c:pt idx="302">
                  <c:v>23</c:v>
                </c:pt>
                <c:pt idx="303">
                  <c:v>22.510999999999999</c:v>
                </c:pt>
                <c:pt idx="304">
                  <c:v>22.5</c:v>
                </c:pt>
                <c:pt idx="305">
                  <c:v>22.183</c:v>
                </c:pt>
                <c:pt idx="306">
                  <c:v>22</c:v>
                </c:pt>
                <c:pt idx="307">
                  <c:v>21.855</c:v>
                </c:pt>
                <c:pt idx="308">
                  <c:v>21.526</c:v>
                </c:pt>
                <c:pt idx="309">
                  <c:v>21.5</c:v>
                </c:pt>
                <c:pt idx="310">
                  <c:v>21</c:v>
                </c:pt>
                <c:pt idx="311">
                  <c:v>20.5</c:v>
                </c:pt>
                <c:pt idx="312">
                  <c:v>20.292000000000002</c:v>
                </c:pt>
                <c:pt idx="313">
                  <c:v>20</c:v>
                </c:pt>
                <c:pt idx="314">
                  <c:v>19.963999999999999</c:v>
                </c:pt>
                <c:pt idx="315">
                  <c:v>19.5</c:v>
                </c:pt>
                <c:pt idx="316">
                  <c:v>19</c:v>
                </c:pt>
                <c:pt idx="317">
                  <c:v>18.5</c:v>
                </c:pt>
                <c:pt idx="318">
                  <c:v>18.254000000000001</c:v>
                </c:pt>
                <c:pt idx="319">
                  <c:v>18</c:v>
                </c:pt>
                <c:pt idx="320">
                  <c:v>17.5</c:v>
                </c:pt>
                <c:pt idx="321">
                  <c:v>17.100000000000001</c:v>
                </c:pt>
                <c:pt idx="322">
                  <c:v>17</c:v>
                </c:pt>
                <c:pt idx="323">
                  <c:v>16.504000000000001</c:v>
                </c:pt>
                <c:pt idx="324">
                  <c:v>16.5</c:v>
                </c:pt>
                <c:pt idx="325">
                  <c:v>16.167999999999999</c:v>
                </c:pt>
                <c:pt idx="326">
                  <c:v>16</c:v>
                </c:pt>
                <c:pt idx="327">
                  <c:v>15.563000000000001</c:v>
                </c:pt>
                <c:pt idx="328">
                  <c:v>15.5</c:v>
                </c:pt>
                <c:pt idx="329">
                  <c:v>15</c:v>
                </c:pt>
                <c:pt idx="330">
                  <c:v>14.5</c:v>
                </c:pt>
                <c:pt idx="331">
                  <c:v>14</c:v>
                </c:pt>
                <c:pt idx="332">
                  <c:v>13.986000000000001</c:v>
                </c:pt>
                <c:pt idx="333">
                  <c:v>13.776</c:v>
                </c:pt>
                <c:pt idx="334">
                  <c:v>13.566000000000001</c:v>
                </c:pt>
                <c:pt idx="335">
                  <c:v>13.5</c:v>
                </c:pt>
                <c:pt idx="336">
                  <c:v>13</c:v>
                </c:pt>
                <c:pt idx="337">
                  <c:v>12.629</c:v>
                </c:pt>
                <c:pt idx="338">
                  <c:v>12.5</c:v>
                </c:pt>
                <c:pt idx="339">
                  <c:v>12.340999999999999</c:v>
                </c:pt>
                <c:pt idx="340">
                  <c:v>12</c:v>
                </c:pt>
                <c:pt idx="341">
                  <c:v>11.923999999999999</c:v>
                </c:pt>
                <c:pt idx="342">
                  <c:v>11.653</c:v>
                </c:pt>
                <c:pt idx="343">
                  <c:v>11.5</c:v>
                </c:pt>
                <c:pt idx="344">
                  <c:v>11.476000000000001</c:v>
                </c:pt>
                <c:pt idx="345">
                  <c:v>11</c:v>
                </c:pt>
                <c:pt idx="346">
                  <c:v>10.5</c:v>
                </c:pt>
                <c:pt idx="347">
                  <c:v>10.454000000000001</c:v>
                </c:pt>
                <c:pt idx="348">
                  <c:v>10</c:v>
                </c:pt>
                <c:pt idx="349">
                  <c:v>9.94</c:v>
                </c:pt>
                <c:pt idx="350">
                  <c:v>9.5</c:v>
                </c:pt>
                <c:pt idx="351">
                  <c:v>9.0289999999999999</c:v>
                </c:pt>
                <c:pt idx="352">
                  <c:v>9</c:v>
                </c:pt>
                <c:pt idx="353">
                  <c:v>8.7769999999999992</c:v>
                </c:pt>
                <c:pt idx="354">
                  <c:v>8.5</c:v>
                </c:pt>
                <c:pt idx="355">
                  <c:v>8.4610000000000003</c:v>
                </c:pt>
                <c:pt idx="356">
                  <c:v>8</c:v>
                </c:pt>
                <c:pt idx="357">
                  <c:v>7.5</c:v>
                </c:pt>
                <c:pt idx="358">
                  <c:v>7</c:v>
                </c:pt>
                <c:pt idx="359">
                  <c:v>6.8070000000000004</c:v>
                </c:pt>
                <c:pt idx="360">
                  <c:v>6.6740000000000004</c:v>
                </c:pt>
                <c:pt idx="361">
                  <c:v>6.5410000000000004</c:v>
                </c:pt>
                <c:pt idx="362">
                  <c:v>6.5</c:v>
                </c:pt>
                <c:pt idx="363">
                  <c:v>6.4080000000000004</c:v>
                </c:pt>
                <c:pt idx="364">
                  <c:v>6.2750000000000004</c:v>
                </c:pt>
                <c:pt idx="365">
                  <c:v>6</c:v>
                </c:pt>
                <c:pt idx="366">
                  <c:v>5.9169999999999998</c:v>
                </c:pt>
                <c:pt idx="367">
                  <c:v>5.5</c:v>
                </c:pt>
                <c:pt idx="368">
                  <c:v>5</c:v>
                </c:pt>
                <c:pt idx="369">
                  <c:v>4.9630000000000001</c:v>
                </c:pt>
                <c:pt idx="370">
                  <c:v>4.5</c:v>
                </c:pt>
                <c:pt idx="371">
                  <c:v>4.4669999999999996</c:v>
                </c:pt>
                <c:pt idx="372">
                  <c:v>4.2930000000000001</c:v>
                </c:pt>
                <c:pt idx="373">
                  <c:v>4.1189999999999998</c:v>
                </c:pt>
                <c:pt idx="374">
                  <c:v>4</c:v>
                </c:pt>
                <c:pt idx="375">
                  <c:v>3.9169999999999998</c:v>
                </c:pt>
                <c:pt idx="376">
                  <c:v>3.698</c:v>
                </c:pt>
                <c:pt idx="377">
                  <c:v>3.5</c:v>
                </c:pt>
                <c:pt idx="378">
                  <c:v>3.4790000000000001</c:v>
                </c:pt>
                <c:pt idx="379">
                  <c:v>3</c:v>
                </c:pt>
                <c:pt idx="380">
                  <c:v>2.5</c:v>
                </c:pt>
                <c:pt idx="381">
                  <c:v>2.4670000000000001</c:v>
                </c:pt>
                <c:pt idx="382">
                  <c:v>2.3490000000000002</c:v>
                </c:pt>
                <c:pt idx="383">
                  <c:v>2.2290000000000001</c:v>
                </c:pt>
                <c:pt idx="384">
                  <c:v>2.0649999999999999</c:v>
                </c:pt>
                <c:pt idx="385">
                  <c:v>2</c:v>
                </c:pt>
                <c:pt idx="386">
                  <c:v>1.901</c:v>
                </c:pt>
                <c:pt idx="387">
                  <c:v>1.5</c:v>
                </c:pt>
                <c:pt idx="388">
                  <c:v>1.2889999999999999</c:v>
                </c:pt>
                <c:pt idx="389">
                  <c:v>1.1930000000000001</c:v>
                </c:pt>
                <c:pt idx="390">
                  <c:v>1.097</c:v>
                </c:pt>
                <c:pt idx="391">
                  <c:v>1.0009999999999999</c:v>
                </c:pt>
                <c:pt idx="392">
                  <c:v>1</c:v>
                </c:pt>
                <c:pt idx="393">
                  <c:v>0.90600000000000003</c:v>
                </c:pt>
                <c:pt idx="394">
                  <c:v>0.81100000000000005</c:v>
                </c:pt>
                <c:pt idx="395">
                  <c:v>0.71599999999999997</c:v>
                </c:pt>
                <c:pt idx="396">
                  <c:v>0.621</c:v>
                </c:pt>
                <c:pt idx="397">
                  <c:v>0.52600000000000002</c:v>
                </c:pt>
                <c:pt idx="398">
                  <c:v>0.5</c:v>
                </c:pt>
                <c:pt idx="399">
                  <c:v>0.38700000000000001</c:v>
                </c:pt>
                <c:pt idx="400">
                  <c:v>0.14899999999999999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55F-45DA-A1D6-04490D79AFD9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xVal>
            <c:numRef>
              <c:f>Foglio6!$G$1227:$G$1628</c:f>
              <c:numCache>
                <c:formatCode>General</c:formatCode>
                <c:ptCount val="402"/>
                <c:pt idx="0">
                  <c:v>0</c:v>
                </c:pt>
                <c:pt idx="1">
                  <c:v>5.976</c:v>
                </c:pt>
                <c:pt idx="2">
                  <c:v>11.951000000000001</c:v>
                </c:pt>
                <c:pt idx="3">
                  <c:v>17.927</c:v>
                </c:pt>
                <c:pt idx="4">
                  <c:v>20.59</c:v>
                </c:pt>
                <c:pt idx="5">
                  <c:v>23.902999999999999</c:v>
                </c:pt>
                <c:pt idx="6">
                  <c:v>29.878</c:v>
                </c:pt>
                <c:pt idx="7">
                  <c:v>30.337</c:v>
                </c:pt>
                <c:pt idx="8">
                  <c:v>35.853999999999999</c:v>
                </c:pt>
                <c:pt idx="9">
                  <c:v>39.052</c:v>
                </c:pt>
                <c:pt idx="10">
                  <c:v>41.83</c:v>
                </c:pt>
                <c:pt idx="11">
                  <c:v>44.66</c:v>
                </c:pt>
                <c:pt idx="12">
                  <c:v>47.286999999999999</c:v>
                </c:pt>
                <c:pt idx="13">
                  <c:v>47.805</c:v>
                </c:pt>
                <c:pt idx="14">
                  <c:v>53.780999999999999</c:v>
                </c:pt>
                <c:pt idx="15">
                  <c:v>55.097000000000001</c:v>
                </c:pt>
                <c:pt idx="16">
                  <c:v>57.362000000000002</c:v>
                </c:pt>
                <c:pt idx="17">
                  <c:v>59.756</c:v>
                </c:pt>
                <c:pt idx="18">
                  <c:v>62.426000000000002</c:v>
                </c:pt>
                <c:pt idx="19">
                  <c:v>65.731999999999999</c:v>
                </c:pt>
                <c:pt idx="20">
                  <c:v>71.087000000000003</c:v>
                </c:pt>
                <c:pt idx="21">
                  <c:v>71.707999999999998</c:v>
                </c:pt>
                <c:pt idx="22">
                  <c:v>75.019000000000005</c:v>
                </c:pt>
                <c:pt idx="23">
                  <c:v>77.683000000000007</c:v>
                </c:pt>
                <c:pt idx="24">
                  <c:v>83.659000000000006</c:v>
                </c:pt>
                <c:pt idx="25">
                  <c:v>85.48</c:v>
                </c:pt>
                <c:pt idx="26">
                  <c:v>86.781000000000006</c:v>
                </c:pt>
                <c:pt idx="27">
                  <c:v>89.635000000000005</c:v>
                </c:pt>
                <c:pt idx="28">
                  <c:v>92.415999999999997</c:v>
                </c:pt>
                <c:pt idx="29">
                  <c:v>95.61</c:v>
                </c:pt>
                <c:pt idx="30">
                  <c:v>101.586</c:v>
                </c:pt>
                <c:pt idx="31">
                  <c:v>102.46899999999999</c:v>
                </c:pt>
                <c:pt idx="32">
                  <c:v>103.955</c:v>
                </c:pt>
                <c:pt idx="33">
                  <c:v>107.562</c:v>
                </c:pt>
                <c:pt idx="34">
                  <c:v>107.815</c:v>
                </c:pt>
                <c:pt idx="35">
                  <c:v>113.53700000000001</c:v>
                </c:pt>
                <c:pt idx="36">
                  <c:v>119.51300000000001</c:v>
                </c:pt>
                <c:pt idx="37">
                  <c:v>119.89700000000001</c:v>
                </c:pt>
                <c:pt idx="38">
                  <c:v>124.57899999999999</c:v>
                </c:pt>
                <c:pt idx="39">
                  <c:v>125.489</c:v>
                </c:pt>
                <c:pt idx="40">
                  <c:v>128.63399999999999</c:v>
                </c:pt>
                <c:pt idx="41">
                  <c:v>131.464</c:v>
                </c:pt>
                <c:pt idx="42">
                  <c:v>137.44</c:v>
                </c:pt>
                <c:pt idx="43">
                  <c:v>142.83199999999999</c:v>
                </c:pt>
                <c:pt idx="44">
                  <c:v>143.416</c:v>
                </c:pt>
                <c:pt idx="45">
                  <c:v>148.792</c:v>
                </c:pt>
                <c:pt idx="46">
                  <c:v>149.39099999999999</c:v>
                </c:pt>
                <c:pt idx="47">
                  <c:v>155.36699999999999</c:v>
                </c:pt>
                <c:pt idx="48">
                  <c:v>159.214</c:v>
                </c:pt>
                <c:pt idx="49">
                  <c:v>161.34299999999999</c:v>
                </c:pt>
                <c:pt idx="50">
                  <c:v>166.16</c:v>
                </c:pt>
                <c:pt idx="51">
                  <c:v>167.31800000000001</c:v>
                </c:pt>
                <c:pt idx="52">
                  <c:v>173.29400000000001</c:v>
                </c:pt>
                <c:pt idx="53">
                  <c:v>179.26900000000001</c:v>
                </c:pt>
                <c:pt idx="54">
                  <c:v>183.33</c:v>
                </c:pt>
                <c:pt idx="55">
                  <c:v>184.107</c:v>
                </c:pt>
                <c:pt idx="56">
                  <c:v>185.245</c:v>
                </c:pt>
                <c:pt idx="57">
                  <c:v>191.221</c:v>
                </c:pt>
                <c:pt idx="58">
                  <c:v>194.17500000000001</c:v>
                </c:pt>
                <c:pt idx="59">
                  <c:v>197.196</c:v>
                </c:pt>
                <c:pt idx="60">
                  <c:v>203.172</c:v>
                </c:pt>
                <c:pt idx="61">
                  <c:v>205.387</c:v>
                </c:pt>
                <c:pt idx="62">
                  <c:v>209.148</c:v>
                </c:pt>
                <c:pt idx="63">
                  <c:v>215.12299999999999</c:v>
                </c:pt>
                <c:pt idx="64">
                  <c:v>221.09899999999999</c:v>
                </c:pt>
                <c:pt idx="65">
                  <c:v>223.06399999999999</c:v>
                </c:pt>
                <c:pt idx="66">
                  <c:v>227.07499999999999</c:v>
                </c:pt>
                <c:pt idx="67">
                  <c:v>233.05</c:v>
                </c:pt>
                <c:pt idx="68">
                  <c:v>234.80799999999999</c:v>
                </c:pt>
                <c:pt idx="69">
                  <c:v>239.02600000000001</c:v>
                </c:pt>
                <c:pt idx="70">
                  <c:v>245.00200000000001</c:v>
                </c:pt>
                <c:pt idx="71">
                  <c:v>248.399</c:v>
                </c:pt>
                <c:pt idx="72">
                  <c:v>250.977</c:v>
                </c:pt>
                <c:pt idx="73">
                  <c:v>254.666</c:v>
                </c:pt>
                <c:pt idx="74">
                  <c:v>256.95299999999997</c:v>
                </c:pt>
                <c:pt idx="75">
                  <c:v>259.40600000000001</c:v>
                </c:pt>
                <c:pt idx="76">
                  <c:v>262.92899999999997</c:v>
                </c:pt>
                <c:pt idx="77">
                  <c:v>268.904</c:v>
                </c:pt>
                <c:pt idx="78">
                  <c:v>274.88</c:v>
                </c:pt>
                <c:pt idx="79">
                  <c:v>280.85500000000002</c:v>
                </c:pt>
                <c:pt idx="80">
                  <c:v>282.065</c:v>
                </c:pt>
                <c:pt idx="81">
                  <c:v>286.83100000000002</c:v>
                </c:pt>
                <c:pt idx="82">
                  <c:v>292.80700000000002</c:v>
                </c:pt>
                <c:pt idx="83">
                  <c:v>294.52499999999998</c:v>
                </c:pt>
                <c:pt idx="84">
                  <c:v>298.78199999999998</c:v>
                </c:pt>
                <c:pt idx="85">
                  <c:v>300.03699999999998</c:v>
                </c:pt>
                <c:pt idx="86">
                  <c:v>304.75799999999998</c:v>
                </c:pt>
                <c:pt idx="87">
                  <c:v>306.875</c:v>
                </c:pt>
                <c:pt idx="88">
                  <c:v>310.73399999999998</c:v>
                </c:pt>
                <c:pt idx="89">
                  <c:v>313.983</c:v>
                </c:pt>
                <c:pt idx="90">
                  <c:v>316.709</c:v>
                </c:pt>
                <c:pt idx="91">
                  <c:v>319.28300000000002</c:v>
                </c:pt>
                <c:pt idx="92">
                  <c:v>322.685</c:v>
                </c:pt>
                <c:pt idx="93">
                  <c:v>322.69600000000003</c:v>
                </c:pt>
                <c:pt idx="94">
                  <c:v>327.47500000000002</c:v>
                </c:pt>
                <c:pt idx="95">
                  <c:v>328.661</c:v>
                </c:pt>
                <c:pt idx="96">
                  <c:v>331.47500000000002</c:v>
                </c:pt>
                <c:pt idx="97">
                  <c:v>334.63600000000002</c:v>
                </c:pt>
                <c:pt idx="98">
                  <c:v>340.61200000000002</c:v>
                </c:pt>
                <c:pt idx="99">
                  <c:v>346.58800000000002</c:v>
                </c:pt>
                <c:pt idx="100">
                  <c:v>347.91699999999997</c:v>
                </c:pt>
                <c:pt idx="101">
                  <c:v>352.56299999999999</c:v>
                </c:pt>
                <c:pt idx="102">
                  <c:v>358.53899999999999</c:v>
                </c:pt>
                <c:pt idx="103">
                  <c:v>360.26799999999997</c:v>
                </c:pt>
                <c:pt idx="104">
                  <c:v>364.51499999999999</c:v>
                </c:pt>
                <c:pt idx="105">
                  <c:v>370.49</c:v>
                </c:pt>
                <c:pt idx="106">
                  <c:v>376.46600000000001</c:v>
                </c:pt>
                <c:pt idx="107">
                  <c:v>376.74400000000003</c:v>
                </c:pt>
                <c:pt idx="108">
                  <c:v>382.44099999999997</c:v>
                </c:pt>
                <c:pt idx="109">
                  <c:v>388.41699999999997</c:v>
                </c:pt>
                <c:pt idx="110">
                  <c:v>389.04399999999998</c:v>
                </c:pt>
                <c:pt idx="111">
                  <c:v>394.39299999999997</c:v>
                </c:pt>
                <c:pt idx="112">
                  <c:v>395.39400000000001</c:v>
                </c:pt>
                <c:pt idx="113">
                  <c:v>397.476</c:v>
                </c:pt>
                <c:pt idx="114">
                  <c:v>400.36799999999999</c:v>
                </c:pt>
                <c:pt idx="115">
                  <c:v>402.78800000000001</c:v>
                </c:pt>
                <c:pt idx="116">
                  <c:v>406.34399999999999</c:v>
                </c:pt>
                <c:pt idx="117">
                  <c:v>411.214</c:v>
                </c:pt>
                <c:pt idx="118">
                  <c:v>412.32</c:v>
                </c:pt>
                <c:pt idx="119">
                  <c:v>418.29500000000002</c:v>
                </c:pt>
                <c:pt idx="120">
                  <c:v>422.25</c:v>
                </c:pt>
                <c:pt idx="121">
                  <c:v>424.21199999999999</c:v>
                </c:pt>
                <c:pt idx="122">
                  <c:v>424.27100000000002</c:v>
                </c:pt>
                <c:pt idx="123">
                  <c:v>425.90300000000002</c:v>
                </c:pt>
                <c:pt idx="124">
                  <c:v>426.952</c:v>
                </c:pt>
                <c:pt idx="125">
                  <c:v>427.50599999999997</c:v>
                </c:pt>
                <c:pt idx="126">
                  <c:v>430.24700000000001</c:v>
                </c:pt>
                <c:pt idx="127">
                  <c:v>435.74700000000001</c:v>
                </c:pt>
                <c:pt idx="128">
                  <c:v>436.22199999999998</c:v>
                </c:pt>
                <c:pt idx="129">
                  <c:v>442.19799999999998</c:v>
                </c:pt>
                <c:pt idx="130">
                  <c:v>448.17399999999998</c:v>
                </c:pt>
                <c:pt idx="131">
                  <c:v>454.149</c:v>
                </c:pt>
                <c:pt idx="132">
                  <c:v>460.125</c:v>
                </c:pt>
                <c:pt idx="133">
                  <c:v>463.18200000000002</c:v>
                </c:pt>
                <c:pt idx="134">
                  <c:v>466.101</c:v>
                </c:pt>
                <c:pt idx="135">
                  <c:v>472.07600000000002</c:v>
                </c:pt>
                <c:pt idx="136">
                  <c:v>478.05200000000002</c:v>
                </c:pt>
                <c:pt idx="137">
                  <c:v>481.24799999999999</c:v>
                </c:pt>
                <c:pt idx="138">
                  <c:v>484.02800000000002</c:v>
                </c:pt>
                <c:pt idx="139">
                  <c:v>490.00299999999999</c:v>
                </c:pt>
                <c:pt idx="140">
                  <c:v>494.56099999999998</c:v>
                </c:pt>
                <c:pt idx="141">
                  <c:v>495.97899999999998</c:v>
                </c:pt>
                <c:pt idx="142">
                  <c:v>500.53199999999998</c:v>
                </c:pt>
                <c:pt idx="143">
                  <c:v>501.95400000000001</c:v>
                </c:pt>
                <c:pt idx="144">
                  <c:v>506.07499999999999</c:v>
                </c:pt>
                <c:pt idx="145">
                  <c:v>507.93</c:v>
                </c:pt>
                <c:pt idx="146">
                  <c:v>510.95800000000003</c:v>
                </c:pt>
                <c:pt idx="147">
                  <c:v>513.90599999999995</c:v>
                </c:pt>
                <c:pt idx="148">
                  <c:v>513.96900000000005</c:v>
                </c:pt>
                <c:pt idx="149">
                  <c:v>515.57600000000002</c:v>
                </c:pt>
                <c:pt idx="150">
                  <c:v>516.01800000000003</c:v>
                </c:pt>
                <c:pt idx="151">
                  <c:v>517.16099999999994</c:v>
                </c:pt>
                <c:pt idx="152">
                  <c:v>518.30399999999997</c:v>
                </c:pt>
                <c:pt idx="153">
                  <c:v>519.88099999999997</c:v>
                </c:pt>
                <c:pt idx="154">
                  <c:v>522.947</c:v>
                </c:pt>
                <c:pt idx="155">
                  <c:v>525.85699999999997</c:v>
                </c:pt>
                <c:pt idx="156">
                  <c:v>531.83299999999997</c:v>
                </c:pt>
                <c:pt idx="157">
                  <c:v>532.81399999999996</c:v>
                </c:pt>
                <c:pt idx="158">
                  <c:v>537.80799999999999</c:v>
                </c:pt>
                <c:pt idx="159">
                  <c:v>538.41800000000001</c:v>
                </c:pt>
                <c:pt idx="160">
                  <c:v>540.32600000000002</c:v>
                </c:pt>
                <c:pt idx="161">
                  <c:v>541.24</c:v>
                </c:pt>
                <c:pt idx="162">
                  <c:v>543.63599999999997</c:v>
                </c:pt>
                <c:pt idx="163">
                  <c:v>543.78399999999999</c:v>
                </c:pt>
                <c:pt idx="164">
                  <c:v>547.76800000000003</c:v>
                </c:pt>
                <c:pt idx="165">
                  <c:v>549.76</c:v>
                </c:pt>
                <c:pt idx="166">
                  <c:v>555.73500000000001</c:v>
                </c:pt>
                <c:pt idx="167">
                  <c:v>558.33199999999999</c:v>
                </c:pt>
                <c:pt idx="168">
                  <c:v>561.71100000000001</c:v>
                </c:pt>
                <c:pt idx="169">
                  <c:v>567.68700000000001</c:v>
                </c:pt>
                <c:pt idx="170">
                  <c:v>571.01900000000001</c:v>
                </c:pt>
                <c:pt idx="171">
                  <c:v>573.66200000000003</c:v>
                </c:pt>
                <c:pt idx="172">
                  <c:v>579.63800000000003</c:v>
                </c:pt>
                <c:pt idx="173">
                  <c:v>581.39200000000005</c:v>
                </c:pt>
                <c:pt idx="174">
                  <c:v>585.61400000000003</c:v>
                </c:pt>
                <c:pt idx="175">
                  <c:v>591.58900000000006</c:v>
                </c:pt>
                <c:pt idx="176">
                  <c:v>592.39200000000005</c:v>
                </c:pt>
                <c:pt idx="177">
                  <c:v>597.56500000000005</c:v>
                </c:pt>
                <c:pt idx="178">
                  <c:v>599.654</c:v>
                </c:pt>
                <c:pt idx="179">
                  <c:v>603.54</c:v>
                </c:pt>
                <c:pt idx="180">
                  <c:v>607.19500000000005</c:v>
                </c:pt>
                <c:pt idx="181">
                  <c:v>609.51599999999996</c:v>
                </c:pt>
                <c:pt idx="182">
                  <c:v>612.17399999999998</c:v>
                </c:pt>
                <c:pt idx="183">
                  <c:v>613.00199999999995</c:v>
                </c:pt>
                <c:pt idx="184">
                  <c:v>615.49199999999996</c:v>
                </c:pt>
                <c:pt idx="185">
                  <c:v>615.93899999999996</c:v>
                </c:pt>
                <c:pt idx="186">
                  <c:v>621.46699999999998</c:v>
                </c:pt>
                <c:pt idx="187">
                  <c:v>624.10400000000004</c:v>
                </c:pt>
                <c:pt idx="188">
                  <c:v>627.44299999999998</c:v>
                </c:pt>
                <c:pt idx="189">
                  <c:v>632.245</c:v>
                </c:pt>
                <c:pt idx="190">
                  <c:v>633.41899999999998</c:v>
                </c:pt>
                <c:pt idx="191">
                  <c:v>635.98599999999999</c:v>
                </c:pt>
                <c:pt idx="192">
                  <c:v>639.39400000000001</c:v>
                </c:pt>
                <c:pt idx="193">
                  <c:v>639.92499999999995</c:v>
                </c:pt>
                <c:pt idx="194">
                  <c:v>643.31899999999996</c:v>
                </c:pt>
                <c:pt idx="195">
                  <c:v>644.04</c:v>
                </c:pt>
                <c:pt idx="196">
                  <c:v>644.76099999999997</c:v>
                </c:pt>
                <c:pt idx="197">
                  <c:v>645.37</c:v>
                </c:pt>
                <c:pt idx="198">
                  <c:v>645.55999999999995</c:v>
                </c:pt>
                <c:pt idx="199">
                  <c:v>646.38300000000004</c:v>
                </c:pt>
                <c:pt idx="200">
                  <c:v>646.87900000000002</c:v>
                </c:pt>
                <c:pt idx="201">
                  <c:v>647.00599999999997</c:v>
                </c:pt>
                <c:pt idx="202">
                  <c:v>651.346</c:v>
                </c:pt>
                <c:pt idx="203">
                  <c:v>653.803</c:v>
                </c:pt>
                <c:pt idx="204">
                  <c:v>657.32100000000003</c:v>
                </c:pt>
                <c:pt idx="205">
                  <c:v>663.29700000000003</c:v>
                </c:pt>
                <c:pt idx="206">
                  <c:v>664.19200000000001</c:v>
                </c:pt>
                <c:pt idx="207">
                  <c:v>669.27300000000002</c:v>
                </c:pt>
                <c:pt idx="208">
                  <c:v>673.42100000000005</c:v>
                </c:pt>
                <c:pt idx="209">
                  <c:v>675.24800000000005</c:v>
                </c:pt>
                <c:pt idx="210">
                  <c:v>681.22400000000005</c:v>
                </c:pt>
                <c:pt idx="211">
                  <c:v>687.2</c:v>
                </c:pt>
                <c:pt idx="212">
                  <c:v>693.17499999999995</c:v>
                </c:pt>
                <c:pt idx="213">
                  <c:v>696.21900000000005</c:v>
                </c:pt>
                <c:pt idx="214">
                  <c:v>699.15099999999995</c:v>
                </c:pt>
                <c:pt idx="215">
                  <c:v>701.73299999999995</c:v>
                </c:pt>
                <c:pt idx="216">
                  <c:v>702.75800000000004</c:v>
                </c:pt>
                <c:pt idx="217">
                  <c:v>705.06600000000003</c:v>
                </c:pt>
                <c:pt idx="218">
                  <c:v>705.12599999999998</c:v>
                </c:pt>
                <c:pt idx="219">
                  <c:v>711.10199999999998</c:v>
                </c:pt>
                <c:pt idx="220">
                  <c:v>712.68899999999996</c:v>
                </c:pt>
                <c:pt idx="221">
                  <c:v>716.98699999999997</c:v>
                </c:pt>
                <c:pt idx="222">
                  <c:v>717.07799999999997</c:v>
                </c:pt>
                <c:pt idx="223">
                  <c:v>719.66099999999994</c:v>
                </c:pt>
                <c:pt idx="224">
                  <c:v>721.73099999999999</c:v>
                </c:pt>
                <c:pt idx="225">
                  <c:v>723.053</c:v>
                </c:pt>
                <c:pt idx="226">
                  <c:v>723.37599999999998</c:v>
                </c:pt>
                <c:pt idx="227">
                  <c:v>724.44600000000003</c:v>
                </c:pt>
                <c:pt idx="228">
                  <c:v>724.71299999999997</c:v>
                </c:pt>
                <c:pt idx="229">
                  <c:v>725.91200000000003</c:v>
                </c:pt>
                <c:pt idx="230">
                  <c:v>729.029</c:v>
                </c:pt>
                <c:pt idx="231">
                  <c:v>729.94</c:v>
                </c:pt>
                <c:pt idx="232">
                  <c:v>735.005</c:v>
                </c:pt>
                <c:pt idx="233">
                  <c:v>739.65</c:v>
                </c:pt>
                <c:pt idx="234">
                  <c:v>740.98</c:v>
                </c:pt>
                <c:pt idx="235">
                  <c:v>743.84400000000005</c:v>
                </c:pt>
                <c:pt idx="236">
                  <c:v>745.601</c:v>
                </c:pt>
                <c:pt idx="237">
                  <c:v>746.95600000000002</c:v>
                </c:pt>
                <c:pt idx="238">
                  <c:v>747.90200000000004</c:v>
                </c:pt>
                <c:pt idx="239">
                  <c:v>752.40099999999995</c:v>
                </c:pt>
                <c:pt idx="240">
                  <c:v>752.93200000000002</c:v>
                </c:pt>
                <c:pt idx="241">
                  <c:v>758.90700000000004</c:v>
                </c:pt>
                <c:pt idx="242">
                  <c:v>759.55799999999999</c:v>
                </c:pt>
                <c:pt idx="243">
                  <c:v>761.67600000000004</c:v>
                </c:pt>
                <c:pt idx="244">
                  <c:v>764.88300000000004</c:v>
                </c:pt>
                <c:pt idx="245">
                  <c:v>767.20600000000002</c:v>
                </c:pt>
                <c:pt idx="246">
                  <c:v>770.85900000000004</c:v>
                </c:pt>
                <c:pt idx="247">
                  <c:v>772.60699999999997</c:v>
                </c:pt>
                <c:pt idx="248">
                  <c:v>774.55799999999999</c:v>
                </c:pt>
                <c:pt idx="249">
                  <c:v>776.76700000000005</c:v>
                </c:pt>
                <c:pt idx="250">
                  <c:v>776.83399999999995</c:v>
                </c:pt>
                <c:pt idx="251">
                  <c:v>778.654</c:v>
                </c:pt>
                <c:pt idx="252">
                  <c:v>780.86800000000005</c:v>
                </c:pt>
                <c:pt idx="253">
                  <c:v>782.81</c:v>
                </c:pt>
                <c:pt idx="254">
                  <c:v>782.85900000000004</c:v>
                </c:pt>
                <c:pt idx="255">
                  <c:v>783.125</c:v>
                </c:pt>
                <c:pt idx="256">
                  <c:v>783.27300000000002</c:v>
                </c:pt>
                <c:pt idx="257">
                  <c:v>783.41600000000005</c:v>
                </c:pt>
                <c:pt idx="258">
                  <c:v>788.78599999999994</c:v>
                </c:pt>
                <c:pt idx="259">
                  <c:v>793.91</c:v>
                </c:pt>
                <c:pt idx="260">
                  <c:v>794.76099999999997</c:v>
                </c:pt>
                <c:pt idx="261">
                  <c:v>799.74199999999996</c:v>
                </c:pt>
                <c:pt idx="262">
                  <c:v>800.73699999999997</c:v>
                </c:pt>
                <c:pt idx="263">
                  <c:v>802.97</c:v>
                </c:pt>
                <c:pt idx="264">
                  <c:v>806.71299999999997</c:v>
                </c:pt>
                <c:pt idx="265">
                  <c:v>806.94600000000003</c:v>
                </c:pt>
                <c:pt idx="266">
                  <c:v>809.42399999999998</c:v>
                </c:pt>
                <c:pt idx="267">
                  <c:v>811.26300000000003</c:v>
                </c:pt>
                <c:pt idx="268">
                  <c:v>812.68799999999999</c:v>
                </c:pt>
                <c:pt idx="269">
                  <c:v>818.66399999999999</c:v>
                </c:pt>
                <c:pt idx="270">
                  <c:v>820.27099999999996</c:v>
                </c:pt>
                <c:pt idx="271">
                  <c:v>824.63900000000001</c:v>
                </c:pt>
                <c:pt idx="272">
                  <c:v>830.61500000000001</c:v>
                </c:pt>
                <c:pt idx="273">
                  <c:v>836.59100000000001</c:v>
                </c:pt>
                <c:pt idx="274">
                  <c:v>842.56600000000003</c:v>
                </c:pt>
                <c:pt idx="275">
                  <c:v>846.05600000000004</c:v>
                </c:pt>
                <c:pt idx="276">
                  <c:v>848.35799999999995</c:v>
                </c:pt>
                <c:pt idx="277">
                  <c:v>848.54200000000003</c:v>
                </c:pt>
                <c:pt idx="278">
                  <c:v>849.65800000000002</c:v>
                </c:pt>
                <c:pt idx="279">
                  <c:v>850.23099999999999</c:v>
                </c:pt>
                <c:pt idx="280">
                  <c:v>850.81</c:v>
                </c:pt>
                <c:pt idx="281">
                  <c:v>851.41700000000003</c:v>
                </c:pt>
                <c:pt idx="282">
                  <c:v>852.024</c:v>
                </c:pt>
                <c:pt idx="283">
                  <c:v>854.51800000000003</c:v>
                </c:pt>
                <c:pt idx="284">
                  <c:v>855.33199999999999</c:v>
                </c:pt>
                <c:pt idx="285">
                  <c:v>859.45299999999997</c:v>
                </c:pt>
                <c:pt idx="286">
                  <c:v>860.49300000000005</c:v>
                </c:pt>
                <c:pt idx="287">
                  <c:v>861.19899999999996</c:v>
                </c:pt>
                <c:pt idx="288">
                  <c:v>861.31</c:v>
                </c:pt>
                <c:pt idx="289">
                  <c:v>862.97</c:v>
                </c:pt>
                <c:pt idx="290">
                  <c:v>866.46900000000005</c:v>
                </c:pt>
                <c:pt idx="291">
                  <c:v>866.80600000000004</c:v>
                </c:pt>
                <c:pt idx="292">
                  <c:v>872.44500000000005</c:v>
                </c:pt>
                <c:pt idx="293">
                  <c:v>878.42</c:v>
                </c:pt>
                <c:pt idx="294">
                  <c:v>881.22799999999995</c:v>
                </c:pt>
                <c:pt idx="295">
                  <c:v>881.92600000000004</c:v>
                </c:pt>
                <c:pt idx="296">
                  <c:v>884.245</c:v>
                </c:pt>
                <c:pt idx="297">
                  <c:v>884.39599999999996</c:v>
                </c:pt>
                <c:pt idx="298">
                  <c:v>890.37199999999996</c:v>
                </c:pt>
                <c:pt idx="299">
                  <c:v>890.57100000000003</c:v>
                </c:pt>
                <c:pt idx="300">
                  <c:v>896.34699999999998</c:v>
                </c:pt>
                <c:pt idx="301">
                  <c:v>896.75400000000002</c:v>
                </c:pt>
                <c:pt idx="302">
                  <c:v>899.23400000000004</c:v>
                </c:pt>
                <c:pt idx="303">
                  <c:v>901.71500000000003</c:v>
                </c:pt>
                <c:pt idx="304">
                  <c:v>902.32299999999998</c:v>
                </c:pt>
                <c:pt idx="305">
                  <c:v>904.25300000000004</c:v>
                </c:pt>
                <c:pt idx="306">
                  <c:v>906.97500000000002</c:v>
                </c:pt>
                <c:pt idx="307">
                  <c:v>908.29899999999998</c:v>
                </c:pt>
                <c:pt idx="308">
                  <c:v>911.68299999999999</c:v>
                </c:pt>
                <c:pt idx="309">
                  <c:v>914.274</c:v>
                </c:pt>
                <c:pt idx="310">
                  <c:v>916.55799999999999</c:v>
                </c:pt>
                <c:pt idx="311">
                  <c:v>920.25</c:v>
                </c:pt>
                <c:pt idx="312">
                  <c:v>920.72199999999998</c:v>
                </c:pt>
                <c:pt idx="313">
                  <c:v>924.46299999999997</c:v>
                </c:pt>
                <c:pt idx="314">
                  <c:v>926.22500000000002</c:v>
                </c:pt>
                <c:pt idx="315">
                  <c:v>929.53700000000003</c:v>
                </c:pt>
                <c:pt idx="316">
                  <c:v>932.20100000000002</c:v>
                </c:pt>
                <c:pt idx="317">
                  <c:v>932.61699999999996</c:v>
                </c:pt>
                <c:pt idx="318">
                  <c:v>935.14200000000005</c:v>
                </c:pt>
                <c:pt idx="319">
                  <c:v>938.17700000000002</c:v>
                </c:pt>
                <c:pt idx="320">
                  <c:v>938.4</c:v>
                </c:pt>
                <c:pt idx="321">
                  <c:v>944.15200000000004</c:v>
                </c:pt>
                <c:pt idx="322">
                  <c:v>949.08399999999995</c:v>
                </c:pt>
                <c:pt idx="323">
                  <c:v>949.899</c:v>
                </c:pt>
                <c:pt idx="324">
                  <c:v>950.12800000000004</c:v>
                </c:pt>
                <c:pt idx="325">
                  <c:v>950.71500000000003</c:v>
                </c:pt>
                <c:pt idx="326">
                  <c:v>951.6</c:v>
                </c:pt>
                <c:pt idx="327">
                  <c:v>952.49400000000003</c:v>
                </c:pt>
                <c:pt idx="328">
                  <c:v>956.10400000000004</c:v>
                </c:pt>
                <c:pt idx="329">
                  <c:v>962.07899999999995</c:v>
                </c:pt>
                <c:pt idx="330">
                  <c:v>968.05499999999995</c:v>
                </c:pt>
                <c:pt idx="331">
                  <c:v>968.06600000000003</c:v>
                </c:pt>
                <c:pt idx="332">
                  <c:v>970.85900000000004</c:v>
                </c:pt>
                <c:pt idx="333">
                  <c:v>974.03099999999995</c:v>
                </c:pt>
                <c:pt idx="334">
                  <c:v>976.36599999999999</c:v>
                </c:pt>
                <c:pt idx="335">
                  <c:v>978.173</c:v>
                </c:pt>
                <c:pt idx="336">
                  <c:v>979.07</c:v>
                </c:pt>
                <c:pt idx="337">
                  <c:v>980.00599999999997</c:v>
                </c:pt>
                <c:pt idx="338">
                  <c:v>982.57299999999998</c:v>
                </c:pt>
                <c:pt idx="339">
                  <c:v>985.98199999999997</c:v>
                </c:pt>
                <c:pt idx="340">
                  <c:v>988.01700000000005</c:v>
                </c:pt>
                <c:pt idx="341">
                  <c:v>989.15599999999995</c:v>
                </c:pt>
                <c:pt idx="342">
                  <c:v>991.95799999999997</c:v>
                </c:pt>
                <c:pt idx="343">
                  <c:v>993.29899999999998</c:v>
                </c:pt>
                <c:pt idx="344">
                  <c:v>996.66099999999994</c:v>
                </c:pt>
                <c:pt idx="345">
                  <c:v>997.93299999999999</c:v>
                </c:pt>
                <c:pt idx="346">
                  <c:v>1003.909</c:v>
                </c:pt>
                <c:pt idx="347">
                  <c:v>1004.563</c:v>
                </c:pt>
                <c:pt idx="348">
                  <c:v>1007.347</c:v>
                </c:pt>
                <c:pt idx="349">
                  <c:v>1008.893</c:v>
                </c:pt>
                <c:pt idx="350">
                  <c:v>1009.885</c:v>
                </c:pt>
                <c:pt idx="351">
                  <c:v>1014.121</c:v>
                </c:pt>
                <c:pt idx="352">
                  <c:v>1015.86</c:v>
                </c:pt>
                <c:pt idx="353">
                  <c:v>1019.717</c:v>
                </c:pt>
                <c:pt idx="354">
                  <c:v>1021.836</c:v>
                </c:pt>
                <c:pt idx="355">
                  <c:v>1025.309</c:v>
                </c:pt>
                <c:pt idx="356">
                  <c:v>1027.8109999999999</c:v>
                </c:pt>
                <c:pt idx="357">
                  <c:v>1028.9580000000001</c:v>
                </c:pt>
                <c:pt idx="358">
                  <c:v>1030.769</c:v>
                </c:pt>
                <c:pt idx="359">
                  <c:v>1032.1559999999999</c:v>
                </c:pt>
                <c:pt idx="360">
                  <c:v>1033.787</c:v>
                </c:pt>
                <c:pt idx="361">
                  <c:v>1034.8340000000001</c:v>
                </c:pt>
                <c:pt idx="362">
                  <c:v>1039.5029999999999</c:v>
                </c:pt>
                <c:pt idx="363">
                  <c:v>1039.7629999999999</c:v>
                </c:pt>
                <c:pt idx="364">
                  <c:v>1045.7380000000001</c:v>
                </c:pt>
                <c:pt idx="365">
                  <c:v>1050.059</c:v>
                </c:pt>
                <c:pt idx="366">
                  <c:v>1051.7139999999999</c:v>
                </c:pt>
                <c:pt idx="367">
                  <c:v>1057.69</c:v>
                </c:pt>
                <c:pt idx="368">
                  <c:v>1063.665</c:v>
                </c:pt>
                <c:pt idx="369">
                  <c:v>1069.6410000000001</c:v>
                </c:pt>
                <c:pt idx="370">
                  <c:v>1071.47</c:v>
                </c:pt>
                <c:pt idx="371">
                  <c:v>1072.338</c:v>
                </c:pt>
                <c:pt idx="372">
                  <c:v>1075.136</c:v>
                </c:pt>
                <c:pt idx="373">
                  <c:v>1075.617</c:v>
                </c:pt>
                <c:pt idx="374">
                  <c:v>1081.5920000000001</c:v>
                </c:pt>
                <c:pt idx="375">
                  <c:v>1083.6410000000001</c:v>
                </c:pt>
                <c:pt idx="376">
                  <c:v>1087.568</c:v>
                </c:pt>
                <c:pt idx="377">
                  <c:v>1093.5440000000001</c:v>
                </c:pt>
                <c:pt idx="378">
                  <c:v>1094.502</c:v>
                </c:pt>
                <c:pt idx="379">
                  <c:v>1096.57</c:v>
                </c:pt>
                <c:pt idx="380">
                  <c:v>1099.519</c:v>
                </c:pt>
                <c:pt idx="381">
                  <c:v>1101.9880000000001</c:v>
                </c:pt>
                <c:pt idx="382">
                  <c:v>1105.4949999999999</c:v>
                </c:pt>
                <c:pt idx="383">
                  <c:v>1111.471</c:v>
                </c:pt>
                <c:pt idx="384">
                  <c:v>1117.4459999999999</c:v>
                </c:pt>
                <c:pt idx="385">
                  <c:v>1123.422</c:v>
                </c:pt>
                <c:pt idx="386">
                  <c:v>1129.3979999999999</c:v>
                </c:pt>
                <c:pt idx="387">
                  <c:v>1135.373</c:v>
                </c:pt>
                <c:pt idx="388">
                  <c:v>1135.9290000000001</c:v>
                </c:pt>
                <c:pt idx="389">
                  <c:v>1141.3489999999999</c:v>
                </c:pt>
                <c:pt idx="390">
                  <c:v>1147.3240000000001</c:v>
                </c:pt>
                <c:pt idx="391">
                  <c:v>1150.8699999999999</c:v>
                </c:pt>
                <c:pt idx="392">
                  <c:v>1153.3</c:v>
                </c:pt>
                <c:pt idx="393">
                  <c:v>1156.75</c:v>
                </c:pt>
                <c:pt idx="394">
                  <c:v>1159.2760000000001</c:v>
                </c:pt>
                <c:pt idx="395">
                  <c:v>1165.251</c:v>
                </c:pt>
                <c:pt idx="396">
                  <c:v>1171.2270000000001</c:v>
                </c:pt>
                <c:pt idx="397">
                  <c:v>1177.203</c:v>
                </c:pt>
                <c:pt idx="398">
                  <c:v>1183.1780000000001</c:v>
                </c:pt>
                <c:pt idx="399">
                  <c:v>1189.154</c:v>
                </c:pt>
                <c:pt idx="400">
                  <c:v>1195.1300000000001</c:v>
                </c:pt>
                <c:pt idx="401">
                  <c:v>1195.1300000000001</c:v>
                </c:pt>
              </c:numCache>
            </c:numRef>
          </c:xVal>
          <c:yVal>
            <c:numRef>
              <c:f>Foglio6!$H$1227:$H$1628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99.82</c:v>
                </c:pt>
                <c:pt idx="6">
                  <c:v>99.543999999999997</c:v>
                </c:pt>
                <c:pt idx="7">
                  <c:v>99.5</c:v>
                </c:pt>
                <c:pt idx="8">
                  <c:v>99.120999999999995</c:v>
                </c:pt>
                <c:pt idx="9">
                  <c:v>99</c:v>
                </c:pt>
                <c:pt idx="10">
                  <c:v>98.813999999999993</c:v>
                </c:pt>
                <c:pt idx="11">
                  <c:v>98.5</c:v>
                </c:pt>
                <c:pt idx="12">
                  <c:v>98</c:v>
                </c:pt>
                <c:pt idx="13">
                  <c:v>97.98</c:v>
                </c:pt>
                <c:pt idx="14">
                  <c:v>97.754999999999995</c:v>
                </c:pt>
                <c:pt idx="15">
                  <c:v>97.5</c:v>
                </c:pt>
                <c:pt idx="16">
                  <c:v>97</c:v>
                </c:pt>
                <c:pt idx="17">
                  <c:v>96.554000000000002</c:v>
                </c:pt>
                <c:pt idx="18">
                  <c:v>96.5</c:v>
                </c:pt>
                <c:pt idx="19">
                  <c:v>96.408000000000001</c:v>
                </c:pt>
                <c:pt idx="20">
                  <c:v>96</c:v>
                </c:pt>
                <c:pt idx="21">
                  <c:v>95.897999999999996</c:v>
                </c:pt>
                <c:pt idx="22">
                  <c:v>95.5</c:v>
                </c:pt>
                <c:pt idx="23">
                  <c:v>95.376999999999995</c:v>
                </c:pt>
                <c:pt idx="24">
                  <c:v>95.1</c:v>
                </c:pt>
                <c:pt idx="25">
                  <c:v>95</c:v>
                </c:pt>
                <c:pt idx="26">
                  <c:v>94.5</c:v>
                </c:pt>
                <c:pt idx="27">
                  <c:v>94.111000000000004</c:v>
                </c:pt>
                <c:pt idx="28">
                  <c:v>94</c:v>
                </c:pt>
                <c:pt idx="29">
                  <c:v>93.872</c:v>
                </c:pt>
                <c:pt idx="30">
                  <c:v>93.634</c:v>
                </c:pt>
                <c:pt idx="31">
                  <c:v>93.5</c:v>
                </c:pt>
                <c:pt idx="32">
                  <c:v>93</c:v>
                </c:pt>
                <c:pt idx="33">
                  <c:v>92.537000000000006</c:v>
                </c:pt>
                <c:pt idx="34">
                  <c:v>92.5</c:v>
                </c:pt>
                <c:pt idx="35">
                  <c:v>92.266000000000005</c:v>
                </c:pt>
                <c:pt idx="36">
                  <c:v>92.03</c:v>
                </c:pt>
                <c:pt idx="37">
                  <c:v>92</c:v>
                </c:pt>
                <c:pt idx="38">
                  <c:v>91.5</c:v>
                </c:pt>
                <c:pt idx="39">
                  <c:v>91.37</c:v>
                </c:pt>
                <c:pt idx="40">
                  <c:v>91</c:v>
                </c:pt>
                <c:pt idx="41">
                  <c:v>90.878</c:v>
                </c:pt>
                <c:pt idx="42">
                  <c:v>90.688000000000002</c:v>
                </c:pt>
                <c:pt idx="43">
                  <c:v>90.5</c:v>
                </c:pt>
                <c:pt idx="44">
                  <c:v>90.388999999999996</c:v>
                </c:pt>
                <c:pt idx="45">
                  <c:v>90</c:v>
                </c:pt>
                <c:pt idx="46">
                  <c:v>89.978999999999999</c:v>
                </c:pt>
                <c:pt idx="47">
                  <c:v>89.71</c:v>
                </c:pt>
                <c:pt idx="48">
                  <c:v>89.5</c:v>
                </c:pt>
                <c:pt idx="49">
                  <c:v>89.340999999999994</c:v>
                </c:pt>
                <c:pt idx="50">
                  <c:v>89</c:v>
                </c:pt>
                <c:pt idx="51">
                  <c:v>88.935000000000002</c:v>
                </c:pt>
                <c:pt idx="52">
                  <c:v>88.685000000000002</c:v>
                </c:pt>
                <c:pt idx="53">
                  <c:v>88.619</c:v>
                </c:pt>
                <c:pt idx="54">
                  <c:v>88.5</c:v>
                </c:pt>
                <c:pt idx="55">
                  <c:v>88</c:v>
                </c:pt>
                <c:pt idx="56">
                  <c:v>87.936999999999998</c:v>
                </c:pt>
                <c:pt idx="57">
                  <c:v>87.644000000000005</c:v>
                </c:pt>
                <c:pt idx="58">
                  <c:v>87.5</c:v>
                </c:pt>
                <c:pt idx="59">
                  <c:v>87.352000000000004</c:v>
                </c:pt>
                <c:pt idx="60">
                  <c:v>87.063000000000002</c:v>
                </c:pt>
                <c:pt idx="61">
                  <c:v>87</c:v>
                </c:pt>
                <c:pt idx="62">
                  <c:v>86.894000000000005</c:v>
                </c:pt>
                <c:pt idx="63">
                  <c:v>86.724999999999994</c:v>
                </c:pt>
                <c:pt idx="64">
                  <c:v>86.555999999999997</c:v>
                </c:pt>
                <c:pt idx="65">
                  <c:v>86.5</c:v>
                </c:pt>
                <c:pt idx="66">
                  <c:v>86.44</c:v>
                </c:pt>
                <c:pt idx="67">
                  <c:v>86.075000000000003</c:v>
                </c:pt>
                <c:pt idx="68">
                  <c:v>86</c:v>
                </c:pt>
                <c:pt idx="69">
                  <c:v>85.82</c:v>
                </c:pt>
                <c:pt idx="70">
                  <c:v>85.6</c:v>
                </c:pt>
                <c:pt idx="71">
                  <c:v>85.5</c:v>
                </c:pt>
                <c:pt idx="72">
                  <c:v>85.424000000000007</c:v>
                </c:pt>
                <c:pt idx="73">
                  <c:v>85</c:v>
                </c:pt>
                <c:pt idx="74">
                  <c:v>84.741</c:v>
                </c:pt>
                <c:pt idx="75">
                  <c:v>84.5</c:v>
                </c:pt>
                <c:pt idx="76">
                  <c:v>84.347999999999999</c:v>
                </c:pt>
                <c:pt idx="77">
                  <c:v>84.203000000000003</c:v>
                </c:pt>
                <c:pt idx="78">
                  <c:v>84.147000000000006</c:v>
                </c:pt>
                <c:pt idx="79">
                  <c:v>84.025999999999996</c:v>
                </c:pt>
                <c:pt idx="80">
                  <c:v>84</c:v>
                </c:pt>
                <c:pt idx="81">
                  <c:v>83.897000000000006</c:v>
                </c:pt>
                <c:pt idx="82">
                  <c:v>83.656000000000006</c:v>
                </c:pt>
                <c:pt idx="83">
                  <c:v>83.5</c:v>
                </c:pt>
                <c:pt idx="84">
                  <c:v>83.114000000000004</c:v>
                </c:pt>
                <c:pt idx="85">
                  <c:v>83</c:v>
                </c:pt>
                <c:pt idx="86">
                  <c:v>82.649000000000001</c:v>
                </c:pt>
                <c:pt idx="87">
                  <c:v>82.5</c:v>
                </c:pt>
                <c:pt idx="88">
                  <c:v>82.228999999999999</c:v>
                </c:pt>
                <c:pt idx="89">
                  <c:v>82</c:v>
                </c:pt>
                <c:pt idx="90">
                  <c:v>81.808000000000007</c:v>
                </c:pt>
                <c:pt idx="91">
                  <c:v>81.5</c:v>
                </c:pt>
                <c:pt idx="92">
                  <c:v>81.001999999999995</c:v>
                </c:pt>
                <c:pt idx="93">
                  <c:v>81</c:v>
                </c:pt>
                <c:pt idx="94">
                  <c:v>80.5</c:v>
                </c:pt>
                <c:pt idx="95">
                  <c:v>80.156000000000006</c:v>
                </c:pt>
                <c:pt idx="96">
                  <c:v>80</c:v>
                </c:pt>
                <c:pt idx="97">
                  <c:v>79.825000000000003</c:v>
                </c:pt>
                <c:pt idx="98">
                  <c:v>79.569999999999993</c:v>
                </c:pt>
                <c:pt idx="99">
                  <c:v>79.525999999999996</c:v>
                </c:pt>
                <c:pt idx="100">
                  <c:v>79.5</c:v>
                </c:pt>
                <c:pt idx="101">
                  <c:v>79.253</c:v>
                </c:pt>
                <c:pt idx="102">
                  <c:v>79.055000000000007</c:v>
                </c:pt>
                <c:pt idx="103">
                  <c:v>79</c:v>
                </c:pt>
                <c:pt idx="104">
                  <c:v>78.870999999999995</c:v>
                </c:pt>
                <c:pt idx="105">
                  <c:v>78.69</c:v>
                </c:pt>
                <c:pt idx="106">
                  <c:v>78.507999999999996</c:v>
                </c:pt>
                <c:pt idx="107">
                  <c:v>78.5</c:v>
                </c:pt>
                <c:pt idx="108">
                  <c:v>78.319000000000003</c:v>
                </c:pt>
                <c:pt idx="109">
                  <c:v>78.03</c:v>
                </c:pt>
                <c:pt idx="110">
                  <c:v>78</c:v>
                </c:pt>
                <c:pt idx="111">
                  <c:v>77.625</c:v>
                </c:pt>
                <c:pt idx="112">
                  <c:v>77.5</c:v>
                </c:pt>
                <c:pt idx="113">
                  <c:v>77</c:v>
                </c:pt>
                <c:pt idx="114">
                  <c:v>76.760999999999996</c:v>
                </c:pt>
                <c:pt idx="115">
                  <c:v>76.5</c:v>
                </c:pt>
                <c:pt idx="116">
                  <c:v>76.162000000000006</c:v>
                </c:pt>
                <c:pt idx="117">
                  <c:v>76</c:v>
                </c:pt>
                <c:pt idx="118">
                  <c:v>75.962999999999994</c:v>
                </c:pt>
                <c:pt idx="119">
                  <c:v>75.765000000000001</c:v>
                </c:pt>
                <c:pt idx="120">
                  <c:v>75.5</c:v>
                </c:pt>
                <c:pt idx="121">
                  <c:v>75</c:v>
                </c:pt>
                <c:pt idx="122">
                  <c:v>74.981999999999999</c:v>
                </c:pt>
                <c:pt idx="123">
                  <c:v>74.5</c:v>
                </c:pt>
                <c:pt idx="124">
                  <c:v>74</c:v>
                </c:pt>
                <c:pt idx="125">
                  <c:v>73.5</c:v>
                </c:pt>
                <c:pt idx="126">
                  <c:v>73.099999999999994</c:v>
                </c:pt>
                <c:pt idx="127">
                  <c:v>73</c:v>
                </c:pt>
                <c:pt idx="128">
                  <c:v>72.991</c:v>
                </c:pt>
                <c:pt idx="129">
                  <c:v>72.882000000000005</c:v>
                </c:pt>
                <c:pt idx="130">
                  <c:v>72.774000000000001</c:v>
                </c:pt>
                <c:pt idx="131">
                  <c:v>72.665000000000006</c:v>
                </c:pt>
                <c:pt idx="132">
                  <c:v>72.555999999999997</c:v>
                </c:pt>
                <c:pt idx="133">
                  <c:v>72.5</c:v>
                </c:pt>
                <c:pt idx="134">
                  <c:v>72.447000000000003</c:v>
                </c:pt>
                <c:pt idx="135">
                  <c:v>72.313000000000002</c:v>
                </c:pt>
                <c:pt idx="136">
                  <c:v>72.108999999999995</c:v>
                </c:pt>
                <c:pt idx="137">
                  <c:v>72</c:v>
                </c:pt>
                <c:pt idx="138">
                  <c:v>71.905000000000001</c:v>
                </c:pt>
                <c:pt idx="139">
                  <c:v>71.700999999999993</c:v>
                </c:pt>
                <c:pt idx="140">
                  <c:v>71.5</c:v>
                </c:pt>
                <c:pt idx="141">
                  <c:v>71.381</c:v>
                </c:pt>
                <c:pt idx="142">
                  <c:v>71</c:v>
                </c:pt>
                <c:pt idx="143">
                  <c:v>70.881</c:v>
                </c:pt>
                <c:pt idx="144">
                  <c:v>70.5</c:v>
                </c:pt>
                <c:pt idx="145">
                  <c:v>70.326999999999998</c:v>
                </c:pt>
                <c:pt idx="146">
                  <c:v>70</c:v>
                </c:pt>
                <c:pt idx="147">
                  <c:v>69.510000000000005</c:v>
                </c:pt>
                <c:pt idx="148">
                  <c:v>69.5</c:v>
                </c:pt>
                <c:pt idx="149">
                  <c:v>69</c:v>
                </c:pt>
                <c:pt idx="150">
                  <c:v>68.5</c:v>
                </c:pt>
                <c:pt idx="151">
                  <c:v>68</c:v>
                </c:pt>
                <c:pt idx="152">
                  <c:v>67.5</c:v>
                </c:pt>
                <c:pt idx="153">
                  <c:v>67.260000000000005</c:v>
                </c:pt>
                <c:pt idx="154">
                  <c:v>67</c:v>
                </c:pt>
                <c:pt idx="155">
                  <c:v>66.753</c:v>
                </c:pt>
                <c:pt idx="156">
                  <c:v>66.531999999999996</c:v>
                </c:pt>
                <c:pt idx="157">
                  <c:v>66.5</c:v>
                </c:pt>
                <c:pt idx="158">
                  <c:v>66.147000000000006</c:v>
                </c:pt>
                <c:pt idx="159">
                  <c:v>66</c:v>
                </c:pt>
                <c:pt idx="160">
                  <c:v>65.5</c:v>
                </c:pt>
                <c:pt idx="161">
                  <c:v>65</c:v>
                </c:pt>
                <c:pt idx="162">
                  <c:v>64.5</c:v>
                </c:pt>
                <c:pt idx="163">
                  <c:v>64.481999999999999</c:v>
                </c:pt>
                <c:pt idx="164">
                  <c:v>64</c:v>
                </c:pt>
                <c:pt idx="165">
                  <c:v>63.862000000000002</c:v>
                </c:pt>
                <c:pt idx="166">
                  <c:v>63.61</c:v>
                </c:pt>
                <c:pt idx="167">
                  <c:v>63.5</c:v>
                </c:pt>
                <c:pt idx="168">
                  <c:v>63.356999999999999</c:v>
                </c:pt>
                <c:pt idx="169">
                  <c:v>63.121000000000002</c:v>
                </c:pt>
                <c:pt idx="170">
                  <c:v>63</c:v>
                </c:pt>
                <c:pt idx="171">
                  <c:v>62.904000000000003</c:v>
                </c:pt>
                <c:pt idx="172">
                  <c:v>62.567</c:v>
                </c:pt>
                <c:pt idx="173">
                  <c:v>62.5</c:v>
                </c:pt>
                <c:pt idx="174">
                  <c:v>62.338999999999999</c:v>
                </c:pt>
                <c:pt idx="175">
                  <c:v>62.055</c:v>
                </c:pt>
                <c:pt idx="176">
                  <c:v>62</c:v>
                </c:pt>
                <c:pt idx="177">
                  <c:v>61.643999999999998</c:v>
                </c:pt>
                <c:pt idx="178">
                  <c:v>61.5</c:v>
                </c:pt>
                <c:pt idx="179">
                  <c:v>61.241999999999997</c:v>
                </c:pt>
                <c:pt idx="180">
                  <c:v>61</c:v>
                </c:pt>
                <c:pt idx="181">
                  <c:v>60.847000000000001</c:v>
                </c:pt>
                <c:pt idx="182">
                  <c:v>60.5</c:v>
                </c:pt>
                <c:pt idx="183">
                  <c:v>60</c:v>
                </c:pt>
                <c:pt idx="184">
                  <c:v>59.552999999999997</c:v>
                </c:pt>
                <c:pt idx="185">
                  <c:v>59.5</c:v>
                </c:pt>
                <c:pt idx="186">
                  <c:v>59.128</c:v>
                </c:pt>
                <c:pt idx="187">
                  <c:v>59</c:v>
                </c:pt>
                <c:pt idx="188">
                  <c:v>58.838000000000001</c:v>
                </c:pt>
                <c:pt idx="189">
                  <c:v>58.5</c:v>
                </c:pt>
                <c:pt idx="190">
                  <c:v>58.343000000000004</c:v>
                </c:pt>
                <c:pt idx="191">
                  <c:v>58</c:v>
                </c:pt>
                <c:pt idx="192">
                  <c:v>57.566000000000003</c:v>
                </c:pt>
                <c:pt idx="193">
                  <c:v>57.5</c:v>
                </c:pt>
                <c:pt idx="194">
                  <c:v>57</c:v>
                </c:pt>
                <c:pt idx="195">
                  <c:v>56.5</c:v>
                </c:pt>
                <c:pt idx="196">
                  <c:v>56</c:v>
                </c:pt>
                <c:pt idx="197">
                  <c:v>55.616</c:v>
                </c:pt>
                <c:pt idx="198">
                  <c:v>55.5</c:v>
                </c:pt>
                <c:pt idx="199">
                  <c:v>55</c:v>
                </c:pt>
                <c:pt idx="200">
                  <c:v>54.5</c:v>
                </c:pt>
                <c:pt idx="201">
                  <c:v>54</c:v>
                </c:pt>
                <c:pt idx="202">
                  <c:v>53.607999999999997</c:v>
                </c:pt>
                <c:pt idx="203">
                  <c:v>53.5</c:v>
                </c:pt>
                <c:pt idx="204">
                  <c:v>53.411999999999999</c:v>
                </c:pt>
                <c:pt idx="205">
                  <c:v>53.125</c:v>
                </c:pt>
                <c:pt idx="206">
                  <c:v>53</c:v>
                </c:pt>
                <c:pt idx="207">
                  <c:v>52.566000000000003</c:v>
                </c:pt>
                <c:pt idx="208">
                  <c:v>52.5</c:v>
                </c:pt>
                <c:pt idx="209">
                  <c:v>52.470999999999997</c:v>
                </c:pt>
                <c:pt idx="210">
                  <c:v>52.377000000000002</c:v>
                </c:pt>
                <c:pt idx="211">
                  <c:v>52.253</c:v>
                </c:pt>
                <c:pt idx="212">
                  <c:v>52.106000000000002</c:v>
                </c:pt>
                <c:pt idx="213">
                  <c:v>52</c:v>
                </c:pt>
                <c:pt idx="214">
                  <c:v>51.734000000000002</c:v>
                </c:pt>
                <c:pt idx="215">
                  <c:v>51.5</c:v>
                </c:pt>
                <c:pt idx="216">
                  <c:v>51</c:v>
                </c:pt>
                <c:pt idx="217">
                  <c:v>50.5</c:v>
                </c:pt>
                <c:pt idx="218">
                  <c:v>50.491</c:v>
                </c:pt>
                <c:pt idx="219">
                  <c:v>50.094000000000001</c:v>
                </c:pt>
                <c:pt idx="220">
                  <c:v>50</c:v>
                </c:pt>
                <c:pt idx="221">
                  <c:v>49.5</c:v>
                </c:pt>
                <c:pt idx="222">
                  <c:v>49.482999999999997</c:v>
                </c:pt>
                <c:pt idx="223">
                  <c:v>49</c:v>
                </c:pt>
                <c:pt idx="224">
                  <c:v>48.5</c:v>
                </c:pt>
                <c:pt idx="225">
                  <c:v>48.097999999999999</c:v>
                </c:pt>
                <c:pt idx="226">
                  <c:v>48</c:v>
                </c:pt>
                <c:pt idx="227">
                  <c:v>47.5</c:v>
                </c:pt>
                <c:pt idx="228">
                  <c:v>47</c:v>
                </c:pt>
                <c:pt idx="229">
                  <c:v>46.5</c:v>
                </c:pt>
                <c:pt idx="230">
                  <c:v>46.113</c:v>
                </c:pt>
                <c:pt idx="231">
                  <c:v>46</c:v>
                </c:pt>
                <c:pt idx="232">
                  <c:v>45.734999999999999</c:v>
                </c:pt>
                <c:pt idx="233">
                  <c:v>45.5</c:v>
                </c:pt>
                <c:pt idx="234">
                  <c:v>45.433</c:v>
                </c:pt>
                <c:pt idx="235">
                  <c:v>45</c:v>
                </c:pt>
                <c:pt idx="236">
                  <c:v>44.5</c:v>
                </c:pt>
                <c:pt idx="237">
                  <c:v>44.127000000000002</c:v>
                </c:pt>
                <c:pt idx="238">
                  <c:v>44</c:v>
                </c:pt>
                <c:pt idx="239">
                  <c:v>43.5</c:v>
                </c:pt>
                <c:pt idx="240">
                  <c:v>43.484999999999999</c:v>
                </c:pt>
                <c:pt idx="241">
                  <c:v>43.37</c:v>
                </c:pt>
                <c:pt idx="242">
                  <c:v>43</c:v>
                </c:pt>
                <c:pt idx="243">
                  <c:v>42.5</c:v>
                </c:pt>
                <c:pt idx="244">
                  <c:v>42.155999999999999</c:v>
                </c:pt>
                <c:pt idx="245">
                  <c:v>42</c:v>
                </c:pt>
                <c:pt idx="246">
                  <c:v>41.837000000000003</c:v>
                </c:pt>
                <c:pt idx="247">
                  <c:v>41.5</c:v>
                </c:pt>
                <c:pt idx="248">
                  <c:v>41</c:v>
                </c:pt>
                <c:pt idx="249">
                  <c:v>40.5</c:v>
                </c:pt>
                <c:pt idx="250">
                  <c:v>40.481999999999999</c:v>
                </c:pt>
                <c:pt idx="251">
                  <c:v>40</c:v>
                </c:pt>
                <c:pt idx="252">
                  <c:v>39.5</c:v>
                </c:pt>
                <c:pt idx="253">
                  <c:v>39.091000000000001</c:v>
                </c:pt>
                <c:pt idx="254">
                  <c:v>39</c:v>
                </c:pt>
                <c:pt idx="255">
                  <c:v>38.5</c:v>
                </c:pt>
                <c:pt idx="256">
                  <c:v>38</c:v>
                </c:pt>
                <c:pt idx="257">
                  <c:v>37.5</c:v>
                </c:pt>
                <c:pt idx="258">
                  <c:v>37.194000000000003</c:v>
                </c:pt>
                <c:pt idx="259">
                  <c:v>37</c:v>
                </c:pt>
                <c:pt idx="260">
                  <c:v>36.968000000000004</c:v>
                </c:pt>
                <c:pt idx="261">
                  <c:v>36.5</c:v>
                </c:pt>
                <c:pt idx="262">
                  <c:v>36.21</c:v>
                </c:pt>
                <c:pt idx="263">
                  <c:v>36</c:v>
                </c:pt>
                <c:pt idx="264">
                  <c:v>35.531999999999996</c:v>
                </c:pt>
                <c:pt idx="265">
                  <c:v>35.5</c:v>
                </c:pt>
                <c:pt idx="266">
                  <c:v>35</c:v>
                </c:pt>
                <c:pt idx="267">
                  <c:v>34.5</c:v>
                </c:pt>
                <c:pt idx="268">
                  <c:v>34.335000000000001</c:v>
                </c:pt>
                <c:pt idx="269">
                  <c:v>34.070999999999998</c:v>
                </c:pt>
                <c:pt idx="270">
                  <c:v>34</c:v>
                </c:pt>
                <c:pt idx="271">
                  <c:v>33.959000000000003</c:v>
                </c:pt>
                <c:pt idx="272">
                  <c:v>33.936</c:v>
                </c:pt>
                <c:pt idx="273">
                  <c:v>33.912999999999997</c:v>
                </c:pt>
                <c:pt idx="274">
                  <c:v>33.89</c:v>
                </c:pt>
                <c:pt idx="275">
                  <c:v>33.5</c:v>
                </c:pt>
                <c:pt idx="276">
                  <c:v>33</c:v>
                </c:pt>
                <c:pt idx="277">
                  <c:v>32.96</c:v>
                </c:pt>
                <c:pt idx="278">
                  <c:v>32.5</c:v>
                </c:pt>
                <c:pt idx="279">
                  <c:v>32</c:v>
                </c:pt>
                <c:pt idx="280">
                  <c:v>31.5</c:v>
                </c:pt>
                <c:pt idx="281">
                  <c:v>31</c:v>
                </c:pt>
                <c:pt idx="282">
                  <c:v>30.5</c:v>
                </c:pt>
                <c:pt idx="283">
                  <c:v>30.099</c:v>
                </c:pt>
                <c:pt idx="284">
                  <c:v>30</c:v>
                </c:pt>
                <c:pt idx="285">
                  <c:v>29.5</c:v>
                </c:pt>
                <c:pt idx="286">
                  <c:v>29.373999999999999</c:v>
                </c:pt>
                <c:pt idx="287">
                  <c:v>29</c:v>
                </c:pt>
                <c:pt idx="288">
                  <c:v>28.5</c:v>
                </c:pt>
                <c:pt idx="289">
                  <c:v>28</c:v>
                </c:pt>
                <c:pt idx="290">
                  <c:v>27.544</c:v>
                </c:pt>
                <c:pt idx="291">
                  <c:v>27.5</c:v>
                </c:pt>
                <c:pt idx="292">
                  <c:v>27.312000000000001</c:v>
                </c:pt>
                <c:pt idx="293">
                  <c:v>27.132999999999999</c:v>
                </c:pt>
                <c:pt idx="294">
                  <c:v>27</c:v>
                </c:pt>
                <c:pt idx="295">
                  <c:v>26.5</c:v>
                </c:pt>
                <c:pt idx="296">
                  <c:v>26</c:v>
                </c:pt>
                <c:pt idx="297">
                  <c:v>25.988</c:v>
                </c:pt>
                <c:pt idx="298">
                  <c:v>25.515999999999998</c:v>
                </c:pt>
                <c:pt idx="299">
                  <c:v>25.5</c:v>
                </c:pt>
                <c:pt idx="300">
                  <c:v>25.042999999999999</c:v>
                </c:pt>
                <c:pt idx="301">
                  <c:v>25</c:v>
                </c:pt>
                <c:pt idx="302">
                  <c:v>24.5</c:v>
                </c:pt>
                <c:pt idx="303">
                  <c:v>24</c:v>
                </c:pt>
                <c:pt idx="304">
                  <c:v>23.878</c:v>
                </c:pt>
                <c:pt idx="305">
                  <c:v>23.5</c:v>
                </c:pt>
                <c:pt idx="306">
                  <c:v>23</c:v>
                </c:pt>
                <c:pt idx="307">
                  <c:v>22.870999999999999</c:v>
                </c:pt>
                <c:pt idx="308">
                  <c:v>22.5</c:v>
                </c:pt>
                <c:pt idx="309">
                  <c:v>22.19</c:v>
                </c:pt>
                <c:pt idx="310">
                  <c:v>22</c:v>
                </c:pt>
                <c:pt idx="311">
                  <c:v>21.573</c:v>
                </c:pt>
                <c:pt idx="312">
                  <c:v>21.5</c:v>
                </c:pt>
                <c:pt idx="313">
                  <c:v>21</c:v>
                </c:pt>
                <c:pt idx="314">
                  <c:v>20.826000000000001</c:v>
                </c:pt>
                <c:pt idx="315">
                  <c:v>20.5</c:v>
                </c:pt>
                <c:pt idx="316">
                  <c:v>20.076000000000001</c:v>
                </c:pt>
                <c:pt idx="317">
                  <c:v>20</c:v>
                </c:pt>
                <c:pt idx="318">
                  <c:v>19.5</c:v>
                </c:pt>
                <c:pt idx="319">
                  <c:v>19.009</c:v>
                </c:pt>
                <c:pt idx="320">
                  <c:v>19</c:v>
                </c:pt>
                <c:pt idx="321">
                  <c:v>18.762</c:v>
                </c:pt>
                <c:pt idx="322">
                  <c:v>18.5</c:v>
                </c:pt>
                <c:pt idx="323">
                  <c:v>18</c:v>
                </c:pt>
                <c:pt idx="324">
                  <c:v>17.86</c:v>
                </c:pt>
                <c:pt idx="325">
                  <c:v>17.5</c:v>
                </c:pt>
                <c:pt idx="326">
                  <c:v>17</c:v>
                </c:pt>
                <c:pt idx="327">
                  <c:v>16.5</c:v>
                </c:pt>
                <c:pt idx="328">
                  <c:v>16.353999999999999</c:v>
                </c:pt>
                <c:pt idx="329">
                  <c:v>16.190999999999999</c:v>
                </c:pt>
                <c:pt idx="330">
                  <c:v>16.027000000000001</c:v>
                </c:pt>
                <c:pt idx="331">
                  <c:v>16</c:v>
                </c:pt>
                <c:pt idx="332">
                  <c:v>15.5</c:v>
                </c:pt>
                <c:pt idx="333">
                  <c:v>15.212</c:v>
                </c:pt>
                <c:pt idx="334">
                  <c:v>15</c:v>
                </c:pt>
                <c:pt idx="335">
                  <c:v>14.5</c:v>
                </c:pt>
                <c:pt idx="336">
                  <c:v>14</c:v>
                </c:pt>
                <c:pt idx="337">
                  <c:v>13.686999999999999</c:v>
                </c:pt>
                <c:pt idx="338">
                  <c:v>13.5</c:v>
                </c:pt>
                <c:pt idx="339">
                  <c:v>13.252000000000001</c:v>
                </c:pt>
                <c:pt idx="340">
                  <c:v>13</c:v>
                </c:pt>
                <c:pt idx="341">
                  <c:v>12.5</c:v>
                </c:pt>
                <c:pt idx="342">
                  <c:v>12.153</c:v>
                </c:pt>
                <c:pt idx="343">
                  <c:v>12</c:v>
                </c:pt>
                <c:pt idx="344">
                  <c:v>11.5</c:v>
                </c:pt>
                <c:pt idx="345">
                  <c:v>11.43</c:v>
                </c:pt>
                <c:pt idx="346">
                  <c:v>11.05</c:v>
                </c:pt>
                <c:pt idx="347">
                  <c:v>11</c:v>
                </c:pt>
                <c:pt idx="348">
                  <c:v>10.5</c:v>
                </c:pt>
                <c:pt idx="349">
                  <c:v>10</c:v>
                </c:pt>
                <c:pt idx="350">
                  <c:v>9.9049999999999994</c:v>
                </c:pt>
                <c:pt idx="351">
                  <c:v>9.5</c:v>
                </c:pt>
                <c:pt idx="352">
                  <c:v>9.3339999999999996</c:v>
                </c:pt>
                <c:pt idx="353">
                  <c:v>9</c:v>
                </c:pt>
                <c:pt idx="354">
                  <c:v>8.8230000000000004</c:v>
                </c:pt>
                <c:pt idx="355">
                  <c:v>8.5</c:v>
                </c:pt>
                <c:pt idx="356">
                  <c:v>8.1980000000000004</c:v>
                </c:pt>
                <c:pt idx="357">
                  <c:v>8</c:v>
                </c:pt>
                <c:pt idx="358">
                  <c:v>7.5</c:v>
                </c:pt>
                <c:pt idx="359">
                  <c:v>7</c:v>
                </c:pt>
                <c:pt idx="360">
                  <c:v>6.6109999999999998</c:v>
                </c:pt>
                <c:pt idx="361">
                  <c:v>6.5</c:v>
                </c:pt>
                <c:pt idx="362">
                  <c:v>6</c:v>
                </c:pt>
                <c:pt idx="363">
                  <c:v>5.9720000000000004</c:v>
                </c:pt>
                <c:pt idx="364">
                  <c:v>5.6449999999999996</c:v>
                </c:pt>
                <c:pt idx="365">
                  <c:v>5.5</c:v>
                </c:pt>
                <c:pt idx="366">
                  <c:v>5.4740000000000002</c:v>
                </c:pt>
                <c:pt idx="367">
                  <c:v>5.3810000000000002</c:v>
                </c:pt>
                <c:pt idx="368">
                  <c:v>5.2869999999999999</c:v>
                </c:pt>
                <c:pt idx="369">
                  <c:v>5.1929999999999996</c:v>
                </c:pt>
                <c:pt idx="370">
                  <c:v>5</c:v>
                </c:pt>
                <c:pt idx="371">
                  <c:v>4.5</c:v>
                </c:pt>
                <c:pt idx="372">
                  <c:v>4</c:v>
                </c:pt>
                <c:pt idx="373">
                  <c:v>3.9340000000000002</c:v>
                </c:pt>
                <c:pt idx="374">
                  <c:v>3.5550000000000002</c:v>
                </c:pt>
                <c:pt idx="375">
                  <c:v>3.5</c:v>
                </c:pt>
                <c:pt idx="376">
                  <c:v>3.395</c:v>
                </c:pt>
                <c:pt idx="377">
                  <c:v>3.234</c:v>
                </c:pt>
                <c:pt idx="378">
                  <c:v>3</c:v>
                </c:pt>
                <c:pt idx="379">
                  <c:v>2.5</c:v>
                </c:pt>
                <c:pt idx="380">
                  <c:v>2.198</c:v>
                </c:pt>
                <c:pt idx="381">
                  <c:v>2</c:v>
                </c:pt>
                <c:pt idx="382">
                  <c:v>1.87</c:v>
                </c:pt>
                <c:pt idx="383">
                  <c:v>1.7969999999999999</c:v>
                </c:pt>
                <c:pt idx="384">
                  <c:v>1.7250000000000001</c:v>
                </c:pt>
                <c:pt idx="385">
                  <c:v>1.6519999999999999</c:v>
                </c:pt>
                <c:pt idx="386">
                  <c:v>1.579</c:v>
                </c:pt>
                <c:pt idx="387">
                  <c:v>1.5069999999999999</c:v>
                </c:pt>
                <c:pt idx="388">
                  <c:v>1.5</c:v>
                </c:pt>
                <c:pt idx="389">
                  <c:v>1.4339999999999999</c:v>
                </c:pt>
                <c:pt idx="390">
                  <c:v>1.361</c:v>
                </c:pt>
                <c:pt idx="391">
                  <c:v>1</c:v>
                </c:pt>
                <c:pt idx="392">
                  <c:v>0.73</c:v>
                </c:pt>
                <c:pt idx="393">
                  <c:v>0.5</c:v>
                </c:pt>
                <c:pt idx="394">
                  <c:v>0.436</c:v>
                </c:pt>
                <c:pt idx="395">
                  <c:v>0.32300000000000001</c:v>
                </c:pt>
                <c:pt idx="396">
                  <c:v>0.21</c:v>
                </c:pt>
                <c:pt idx="397">
                  <c:v>0.13</c:v>
                </c:pt>
                <c:pt idx="398">
                  <c:v>8.6999999999999994E-2</c:v>
                </c:pt>
                <c:pt idx="399">
                  <c:v>4.3999999999999997E-2</c:v>
                </c:pt>
                <c:pt idx="400">
                  <c:v>1E-3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55F-45DA-A1D6-04490D79AFD9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I$1227:$I$1628</c:f>
              <c:numCache>
                <c:formatCode>General</c:formatCode>
                <c:ptCount val="402"/>
                <c:pt idx="0">
                  <c:v>0</c:v>
                </c:pt>
                <c:pt idx="1">
                  <c:v>6.0940000000000003</c:v>
                </c:pt>
                <c:pt idx="2">
                  <c:v>12.188000000000001</c:v>
                </c:pt>
                <c:pt idx="3">
                  <c:v>18.283000000000001</c:v>
                </c:pt>
                <c:pt idx="4">
                  <c:v>24.376999999999999</c:v>
                </c:pt>
                <c:pt idx="5">
                  <c:v>30.471</c:v>
                </c:pt>
                <c:pt idx="6">
                  <c:v>36.564999999999998</c:v>
                </c:pt>
                <c:pt idx="7">
                  <c:v>42.66</c:v>
                </c:pt>
                <c:pt idx="8">
                  <c:v>48.753999999999998</c:v>
                </c:pt>
                <c:pt idx="9">
                  <c:v>53.704000000000001</c:v>
                </c:pt>
                <c:pt idx="10">
                  <c:v>54.847999999999999</c:v>
                </c:pt>
                <c:pt idx="11">
                  <c:v>60.942</c:v>
                </c:pt>
                <c:pt idx="12">
                  <c:v>67.037000000000006</c:v>
                </c:pt>
                <c:pt idx="13">
                  <c:v>72.503</c:v>
                </c:pt>
                <c:pt idx="14">
                  <c:v>73.131</c:v>
                </c:pt>
                <c:pt idx="15">
                  <c:v>79.224999999999994</c:v>
                </c:pt>
                <c:pt idx="16">
                  <c:v>85.319000000000003</c:v>
                </c:pt>
                <c:pt idx="17">
                  <c:v>85.676000000000002</c:v>
                </c:pt>
                <c:pt idx="18">
                  <c:v>91.414000000000001</c:v>
                </c:pt>
                <c:pt idx="19">
                  <c:v>97.507999999999996</c:v>
                </c:pt>
                <c:pt idx="20">
                  <c:v>98.248000000000005</c:v>
                </c:pt>
                <c:pt idx="21">
                  <c:v>103.602</c:v>
                </c:pt>
                <c:pt idx="22">
                  <c:v>109.696</c:v>
                </c:pt>
                <c:pt idx="23">
                  <c:v>110.88200000000001</c:v>
                </c:pt>
                <c:pt idx="24">
                  <c:v>115.791</c:v>
                </c:pt>
                <c:pt idx="25">
                  <c:v>121.88500000000001</c:v>
                </c:pt>
                <c:pt idx="26">
                  <c:v>123.502</c:v>
                </c:pt>
                <c:pt idx="27">
                  <c:v>126.96299999999999</c:v>
                </c:pt>
                <c:pt idx="28">
                  <c:v>127.979</c:v>
                </c:pt>
                <c:pt idx="29">
                  <c:v>134.07300000000001</c:v>
                </c:pt>
                <c:pt idx="30">
                  <c:v>140.167</c:v>
                </c:pt>
                <c:pt idx="31">
                  <c:v>143.48500000000001</c:v>
                </c:pt>
                <c:pt idx="32">
                  <c:v>146.262</c:v>
                </c:pt>
                <c:pt idx="33">
                  <c:v>152.35599999999999</c:v>
                </c:pt>
                <c:pt idx="34">
                  <c:v>155.11799999999999</c:v>
                </c:pt>
                <c:pt idx="35">
                  <c:v>158.44999999999999</c:v>
                </c:pt>
                <c:pt idx="36">
                  <c:v>161.35900000000001</c:v>
                </c:pt>
                <c:pt idx="37">
                  <c:v>164.54400000000001</c:v>
                </c:pt>
                <c:pt idx="38">
                  <c:v>170.63900000000001</c:v>
                </c:pt>
                <c:pt idx="39">
                  <c:v>176.733</c:v>
                </c:pt>
                <c:pt idx="40">
                  <c:v>179.06700000000001</c:v>
                </c:pt>
                <c:pt idx="41">
                  <c:v>182.827</c:v>
                </c:pt>
                <c:pt idx="42">
                  <c:v>185.727</c:v>
                </c:pt>
                <c:pt idx="43">
                  <c:v>188.92099999999999</c:v>
                </c:pt>
                <c:pt idx="44">
                  <c:v>193.50200000000001</c:v>
                </c:pt>
                <c:pt idx="45">
                  <c:v>195.01599999999999</c:v>
                </c:pt>
                <c:pt idx="46">
                  <c:v>201.11</c:v>
                </c:pt>
                <c:pt idx="47">
                  <c:v>207.19499999999999</c:v>
                </c:pt>
                <c:pt idx="48">
                  <c:v>207.20400000000001</c:v>
                </c:pt>
                <c:pt idx="49">
                  <c:v>213.298</c:v>
                </c:pt>
                <c:pt idx="50">
                  <c:v>219.393</c:v>
                </c:pt>
                <c:pt idx="51">
                  <c:v>220.76900000000001</c:v>
                </c:pt>
                <c:pt idx="52">
                  <c:v>225.48699999999999</c:v>
                </c:pt>
                <c:pt idx="53">
                  <c:v>227.81399999999999</c:v>
                </c:pt>
                <c:pt idx="54">
                  <c:v>231.58099999999999</c:v>
                </c:pt>
                <c:pt idx="55">
                  <c:v>235.905</c:v>
                </c:pt>
                <c:pt idx="56">
                  <c:v>237.67500000000001</c:v>
                </c:pt>
                <c:pt idx="57">
                  <c:v>243.77</c:v>
                </c:pt>
                <c:pt idx="58">
                  <c:v>247.07300000000001</c:v>
                </c:pt>
                <c:pt idx="59">
                  <c:v>249.864</c:v>
                </c:pt>
                <c:pt idx="60">
                  <c:v>254.26499999999999</c:v>
                </c:pt>
                <c:pt idx="61">
                  <c:v>255.958</c:v>
                </c:pt>
                <c:pt idx="62">
                  <c:v>262.05200000000002</c:v>
                </c:pt>
                <c:pt idx="63">
                  <c:v>268.14699999999999</c:v>
                </c:pt>
                <c:pt idx="64">
                  <c:v>274.24099999999999</c:v>
                </c:pt>
                <c:pt idx="65">
                  <c:v>276.03199999999998</c:v>
                </c:pt>
                <c:pt idx="66">
                  <c:v>280.33499999999998</c:v>
                </c:pt>
                <c:pt idx="67">
                  <c:v>285.01100000000002</c:v>
                </c:pt>
                <c:pt idx="68">
                  <c:v>286.42899999999997</c:v>
                </c:pt>
                <c:pt idx="69">
                  <c:v>292.52300000000002</c:v>
                </c:pt>
                <c:pt idx="70">
                  <c:v>298.61799999999999</c:v>
                </c:pt>
                <c:pt idx="71">
                  <c:v>298.858</c:v>
                </c:pt>
                <c:pt idx="72">
                  <c:v>304.25</c:v>
                </c:pt>
                <c:pt idx="73">
                  <c:v>304.71199999999999</c:v>
                </c:pt>
                <c:pt idx="74">
                  <c:v>310.80599999999998</c:v>
                </c:pt>
                <c:pt idx="75">
                  <c:v>316.89999999999998</c:v>
                </c:pt>
                <c:pt idx="76">
                  <c:v>322.995</c:v>
                </c:pt>
                <c:pt idx="77">
                  <c:v>326.22000000000003</c:v>
                </c:pt>
                <c:pt idx="78">
                  <c:v>329.089</c:v>
                </c:pt>
                <c:pt idx="79">
                  <c:v>334.22</c:v>
                </c:pt>
                <c:pt idx="80">
                  <c:v>335.18299999999999</c:v>
                </c:pt>
                <c:pt idx="81">
                  <c:v>341.27699999999999</c:v>
                </c:pt>
                <c:pt idx="82">
                  <c:v>346.20100000000002</c:v>
                </c:pt>
                <c:pt idx="83">
                  <c:v>347.37200000000001</c:v>
                </c:pt>
                <c:pt idx="84">
                  <c:v>353.46600000000001</c:v>
                </c:pt>
                <c:pt idx="85">
                  <c:v>359.56</c:v>
                </c:pt>
                <c:pt idx="86">
                  <c:v>365.654</c:v>
                </c:pt>
                <c:pt idx="87">
                  <c:v>370.10700000000003</c:v>
                </c:pt>
                <c:pt idx="88">
                  <c:v>371.74900000000002</c:v>
                </c:pt>
                <c:pt idx="89">
                  <c:v>377.84300000000002</c:v>
                </c:pt>
                <c:pt idx="90">
                  <c:v>380.78100000000001</c:v>
                </c:pt>
                <c:pt idx="91">
                  <c:v>383.93700000000001</c:v>
                </c:pt>
                <c:pt idx="92">
                  <c:v>388.33300000000003</c:v>
                </c:pt>
                <c:pt idx="93">
                  <c:v>390.03100000000001</c:v>
                </c:pt>
                <c:pt idx="94">
                  <c:v>396.12599999999998</c:v>
                </c:pt>
                <c:pt idx="95">
                  <c:v>402.22</c:v>
                </c:pt>
                <c:pt idx="96">
                  <c:v>408.31400000000002</c:v>
                </c:pt>
                <c:pt idx="97">
                  <c:v>409.863</c:v>
                </c:pt>
                <c:pt idx="98">
                  <c:v>414.40800000000002</c:v>
                </c:pt>
                <c:pt idx="99">
                  <c:v>420.50200000000001</c:v>
                </c:pt>
                <c:pt idx="100">
                  <c:v>420.53199999999998</c:v>
                </c:pt>
                <c:pt idx="101">
                  <c:v>426.59699999999998</c:v>
                </c:pt>
                <c:pt idx="102">
                  <c:v>428.04199999999997</c:v>
                </c:pt>
                <c:pt idx="103">
                  <c:v>432.69099999999997</c:v>
                </c:pt>
                <c:pt idx="104">
                  <c:v>438.78500000000003</c:v>
                </c:pt>
                <c:pt idx="105">
                  <c:v>444.87900000000002</c:v>
                </c:pt>
                <c:pt idx="106">
                  <c:v>450.97399999999999</c:v>
                </c:pt>
                <c:pt idx="107">
                  <c:v>454.44200000000001</c:v>
                </c:pt>
                <c:pt idx="108">
                  <c:v>457.06799999999998</c:v>
                </c:pt>
                <c:pt idx="109">
                  <c:v>463.16199999999998</c:v>
                </c:pt>
                <c:pt idx="110">
                  <c:v>468.81099999999998</c:v>
                </c:pt>
                <c:pt idx="111">
                  <c:v>469.25599999999997</c:v>
                </c:pt>
                <c:pt idx="112">
                  <c:v>472.697</c:v>
                </c:pt>
                <c:pt idx="113">
                  <c:v>475.351</c:v>
                </c:pt>
                <c:pt idx="114">
                  <c:v>478.78100000000001</c:v>
                </c:pt>
                <c:pt idx="115">
                  <c:v>481.44499999999999</c:v>
                </c:pt>
                <c:pt idx="116">
                  <c:v>485.40800000000002</c:v>
                </c:pt>
                <c:pt idx="117">
                  <c:v>487.53899999999999</c:v>
                </c:pt>
                <c:pt idx="118">
                  <c:v>490.66500000000002</c:v>
                </c:pt>
                <c:pt idx="119">
                  <c:v>493.63299999999998</c:v>
                </c:pt>
                <c:pt idx="120">
                  <c:v>494.74</c:v>
                </c:pt>
                <c:pt idx="121">
                  <c:v>496.64600000000002</c:v>
                </c:pt>
                <c:pt idx="122">
                  <c:v>499.03699999999998</c:v>
                </c:pt>
                <c:pt idx="123">
                  <c:v>499.72800000000001</c:v>
                </c:pt>
                <c:pt idx="124">
                  <c:v>503.608</c:v>
                </c:pt>
                <c:pt idx="125">
                  <c:v>505.822</c:v>
                </c:pt>
                <c:pt idx="126">
                  <c:v>511.916</c:v>
                </c:pt>
                <c:pt idx="127">
                  <c:v>518.01</c:v>
                </c:pt>
                <c:pt idx="128">
                  <c:v>524.10500000000002</c:v>
                </c:pt>
                <c:pt idx="129">
                  <c:v>529.48099999999999</c:v>
                </c:pt>
                <c:pt idx="130">
                  <c:v>530.19899999999996</c:v>
                </c:pt>
                <c:pt idx="131">
                  <c:v>536.29300000000001</c:v>
                </c:pt>
                <c:pt idx="132">
                  <c:v>542.38699999999994</c:v>
                </c:pt>
                <c:pt idx="133">
                  <c:v>546.79</c:v>
                </c:pt>
                <c:pt idx="134">
                  <c:v>548.48199999999997</c:v>
                </c:pt>
                <c:pt idx="135">
                  <c:v>554.57600000000002</c:v>
                </c:pt>
                <c:pt idx="136">
                  <c:v>560.07100000000003</c:v>
                </c:pt>
                <c:pt idx="137">
                  <c:v>560.66999999999996</c:v>
                </c:pt>
                <c:pt idx="138">
                  <c:v>564.57299999999998</c:v>
                </c:pt>
                <c:pt idx="139">
                  <c:v>566.76400000000001</c:v>
                </c:pt>
                <c:pt idx="140">
                  <c:v>572.66600000000005</c:v>
                </c:pt>
                <c:pt idx="141">
                  <c:v>572.85799999999995</c:v>
                </c:pt>
                <c:pt idx="142">
                  <c:v>578.95299999999997</c:v>
                </c:pt>
                <c:pt idx="143">
                  <c:v>585.04700000000003</c:v>
                </c:pt>
                <c:pt idx="144">
                  <c:v>591.14099999999996</c:v>
                </c:pt>
                <c:pt idx="145">
                  <c:v>593.827</c:v>
                </c:pt>
                <c:pt idx="146">
                  <c:v>597.23500000000001</c:v>
                </c:pt>
                <c:pt idx="147">
                  <c:v>600.02300000000002</c:v>
                </c:pt>
                <c:pt idx="148">
                  <c:v>603.33000000000004</c:v>
                </c:pt>
                <c:pt idx="149">
                  <c:v>604.25800000000004</c:v>
                </c:pt>
                <c:pt idx="150">
                  <c:v>608.18700000000001</c:v>
                </c:pt>
                <c:pt idx="151">
                  <c:v>608.31899999999996</c:v>
                </c:pt>
                <c:pt idx="152">
                  <c:v>608.57000000000005</c:v>
                </c:pt>
                <c:pt idx="153">
                  <c:v>609.42399999999998</c:v>
                </c:pt>
                <c:pt idx="154">
                  <c:v>609.97900000000004</c:v>
                </c:pt>
                <c:pt idx="155">
                  <c:v>611.74099999999999</c:v>
                </c:pt>
                <c:pt idx="156">
                  <c:v>615.51800000000003</c:v>
                </c:pt>
                <c:pt idx="157">
                  <c:v>621.61199999999997</c:v>
                </c:pt>
                <c:pt idx="158">
                  <c:v>627.70699999999999</c:v>
                </c:pt>
                <c:pt idx="159">
                  <c:v>631.92399999999998</c:v>
                </c:pt>
                <c:pt idx="160">
                  <c:v>633.80100000000004</c:v>
                </c:pt>
                <c:pt idx="161">
                  <c:v>639.89499999999998</c:v>
                </c:pt>
                <c:pt idx="162">
                  <c:v>644.72699999999998</c:v>
                </c:pt>
                <c:pt idx="163">
                  <c:v>645.98900000000003</c:v>
                </c:pt>
                <c:pt idx="164">
                  <c:v>652.08399999999995</c:v>
                </c:pt>
                <c:pt idx="165">
                  <c:v>654.005</c:v>
                </c:pt>
                <c:pt idx="166">
                  <c:v>658.178</c:v>
                </c:pt>
                <c:pt idx="167">
                  <c:v>660.226</c:v>
                </c:pt>
                <c:pt idx="168">
                  <c:v>663.66</c:v>
                </c:pt>
                <c:pt idx="169">
                  <c:v>664.25800000000004</c:v>
                </c:pt>
                <c:pt idx="170">
                  <c:v>664.27200000000005</c:v>
                </c:pt>
                <c:pt idx="171">
                  <c:v>665.16800000000001</c:v>
                </c:pt>
                <c:pt idx="172">
                  <c:v>666.08600000000001</c:v>
                </c:pt>
                <c:pt idx="173">
                  <c:v>670.36599999999999</c:v>
                </c:pt>
                <c:pt idx="174">
                  <c:v>670.44299999999998</c:v>
                </c:pt>
                <c:pt idx="175">
                  <c:v>676.34900000000005</c:v>
                </c:pt>
                <c:pt idx="176">
                  <c:v>676.46100000000001</c:v>
                </c:pt>
                <c:pt idx="177">
                  <c:v>682.55499999999995</c:v>
                </c:pt>
                <c:pt idx="178">
                  <c:v>684.70699999999999</c:v>
                </c:pt>
                <c:pt idx="179">
                  <c:v>688.649</c:v>
                </c:pt>
                <c:pt idx="180">
                  <c:v>694.74300000000005</c:v>
                </c:pt>
                <c:pt idx="181">
                  <c:v>699.76800000000003</c:v>
                </c:pt>
                <c:pt idx="182">
                  <c:v>700.83699999999999</c:v>
                </c:pt>
                <c:pt idx="183">
                  <c:v>706.93200000000002</c:v>
                </c:pt>
                <c:pt idx="184">
                  <c:v>707.34</c:v>
                </c:pt>
                <c:pt idx="185">
                  <c:v>709.90599999999995</c:v>
                </c:pt>
                <c:pt idx="186">
                  <c:v>710.28099999999995</c:v>
                </c:pt>
                <c:pt idx="187">
                  <c:v>712.53300000000002</c:v>
                </c:pt>
                <c:pt idx="188">
                  <c:v>713.02599999999995</c:v>
                </c:pt>
                <c:pt idx="189">
                  <c:v>714.64400000000001</c:v>
                </c:pt>
                <c:pt idx="190">
                  <c:v>719.12</c:v>
                </c:pt>
                <c:pt idx="191">
                  <c:v>719.94799999999998</c:v>
                </c:pt>
                <c:pt idx="192">
                  <c:v>725.21400000000006</c:v>
                </c:pt>
                <c:pt idx="193">
                  <c:v>725.41499999999996</c:v>
                </c:pt>
                <c:pt idx="194">
                  <c:v>729.24199999999996</c:v>
                </c:pt>
                <c:pt idx="195">
                  <c:v>730.11500000000001</c:v>
                </c:pt>
                <c:pt idx="196">
                  <c:v>731.23099999999999</c:v>
                </c:pt>
                <c:pt idx="197">
                  <c:v>731.30899999999997</c:v>
                </c:pt>
                <c:pt idx="198">
                  <c:v>732.62300000000005</c:v>
                </c:pt>
                <c:pt idx="199">
                  <c:v>732.93100000000004</c:v>
                </c:pt>
                <c:pt idx="200">
                  <c:v>737.40300000000002</c:v>
                </c:pt>
                <c:pt idx="201">
                  <c:v>741.52300000000002</c:v>
                </c:pt>
                <c:pt idx="202">
                  <c:v>743.49699999999996</c:v>
                </c:pt>
                <c:pt idx="203">
                  <c:v>749.59100000000001</c:v>
                </c:pt>
                <c:pt idx="204">
                  <c:v>755.68600000000004</c:v>
                </c:pt>
                <c:pt idx="205">
                  <c:v>757.30399999999997</c:v>
                </c:pt>
                <c:pt idx="206">
                  <c:v>761.78</c:v>
                </c:pt>
                <c:pt idx="207">
                  <c:v>767.87400000000002</c:v>
                </c:pt>
                <c:pt idx="208">
                  <c:v>770.98699999999997</c:v>
                </c:pt>
                <c:pt idx="209">
                  <c:v>772.221</c:v>
                </c:pt>
                <c:pt idx="210">
                  <c:v>773.92899999999997</c:v>
                </c:pt>
                <c:pt idx="211">
                  <c:v>773.96799999999996</c:v>
                </c:pt>
                <c:pt idx="212">
                  <c:v>775.67</c:v>
                </c:pt>
                <c:pt idx="213">
                  <c:v>778.19600000000003</c:v>
                </c:pt>
                <c:pt idx="214">
                  <c:v>780.06299999999999</c:v>
                </c:pt>
                <c:pt idx="215">
                  <c:v>781.01599999999996</c:v>
                </c:pt>
                <c:pt idx="216">
                  <c:v>783.476</c:v>
                </c:pt>
                <c:pt idx="217">
                  <c:v>785.12400000000002</c:v>
                </c:pt>
                <c:pt idx="218">
                  <c:v>786.15700000000004</c:v>
                </c:pt>
                <c:pt idx="219">
                  <c:v>786.779</c:v>
                </c:pt>
                <c:pt idx="220">
                  <c:v>789.02300000000002</c:v>
                </c:pt>
                <c:pt idx="221">
                  <c:v>791.26700000000005</c:v>
                </c:pt>
                <c:pt idx="222">
                  <c:v>791.91899999999998</c:v>
                </c:pt>
                <c:pt idx="223">
                  <c:v>792.25099999999998</c:v>
                </c:pt>
                <c:pt idx="224">
                  <c:v>798.34500000000003</c:v>
                </c:pt>
                <c:pt idx="225">
                  <c:v>800.80200000000002</c:v>
                </c:pt>
                <c:pt idx="226">
                  <c:v>804.44</c:v>
                </c:pt>
                <c:pt idx="227">
                  <c:v>809.91</c:v>
                </c:pt>
                <c:pt idx="228">
                  <c:v>810.53399999999999</c:v>
                </c:pt>
                <c:pt idx="229">
                  <c:v>812.91899999999998</c:v>
                </c:pt>
                <c:pt idx="230">
                  <c:v>814.81</c:v>
                </c:pt>
                <c:pt idx="231">
                  <c:v>816.62800000000004</c:v>
                </c:pt>
                <c:pt idx="232">
                  <c:v>817.98800000000006</c:v>
                </c:pt>
                <c:pt idx="233">
                  <c:v>822.72199999999998</c:v>
                </c:pt>
                <c:pt idx="234">
                  <c:v>823.63099999999997</c:v>
                </c:pt>
                <c:pt idx="235">
                  <c:v>828.81600000000003</c:v>
                </c:pt>
                <c:pt idx="236">
                  <c:v>829.27300000000002</c:v>
                </c:pt>
                <c:pt idx="237">
                  <c:v>831.89599999999996</c:v>
                </c:pt>
                <c:pt idx="238">
                  <c:v>834.91099999999994</c:v>
                </c:pt>
                <c:pt idx="239">
                  <c:v>835.35400000000004</c:v>
                </c:pt>
                <c:pt idx="240">
                  <c:v>839.52200000000005</c:v>
                </c:pt>
                <c:pt idx="241">
                  <c:v>841.005</c:v>
                </c:pt>
                <c:pt idx="242">
                  <c:v>843.66</c:v>
                </c:pt>
                <c:pt idx="243">
                  <c:v>846.47900000000004</c:v>
                </c:pt>
                <c:pt idx="244">
                  <c:v>847.09900000000005</c:v>
                </c:pt>
                <c:pt idx="245">
                  <c:v>848.01700000000005</c:v>
                </c:pt>
                <c:pt idx="246">
                  <c:v>848.56</c:v>
                </c:pt>
                <c:pt idx="247">
                  <c:v>849.08199999999999</c:v>
                </c:pt>
                <c:pt idx="248">
                  <c:v>849.42100000000005</c:v>
                </c:pt>
                <c:pt idx="249">
                  <c:v>849.76</c:v>
                </c:pt>
                <c:pt idx="250">
                  <c:v>850.35199999999998</c:v>
                </c:pt>
                <c:pt idx="251">
                  <c:v>853.19299999999998</c:v>
                </c:pt>
                <c:pt idx="252">
                  <c:v>859.28800000000001</c:v>
                </c:pt>
                <c:pt idx="253">
                  <c:v>865.38199999999995</c:v>
                </c:pt>
                <c:pt idx="254">
                  <c:v>871.476</c:v>
                </c:pt>
                <c:pt idx="255">
                  <c:v>874.50099999999998</c:v>
                </c:pt>
                <c:pt idx="256">
                  <c:v>876.77800000000002</c:v>
                </c:pt>
                <c:pt idx="257">
                  <c:v>876.81200000000001</c:v>
                </c:pt>
                <c:pt idx="258">
                  <c:v>877.00099999999998</c:v>
                </c:pt>
                <c:pt idx="259">
                  <c:v>877.57</c:v>
                </c:pt>
                <c:pt idx="260">
                  <c:v>879.47299999999996</c:v>
                </c:pt>
                <c:pt idx="261">
                  <c:v>883.66499999999996</c:v>
                </c:pt>
                <c:pt idx="262">
                  <c:v>885.39099999999996</c:v>
                </c:pt>
                <c:pt idx="263">
                  <c:v>889.75900000000001</c:v>
                </c:pt>
                <c:pt idx="264">
                  <c:v>891.31</c:v>
                </c:pt>
                <c:pt idx="265">
                  <c:v>892.55399999999997</c:v>
                </c:pt>
                <c:pt idx="266">
                  <c:v>894.12800000000004</c:v>
                </c:pt>
                <c:pt idx="267">
                  <c:v>894.31399999999996</c:v>
                </c:pt>
                <c:pt idx="268">
                  <c:v>894.46400000000006</c:v>
                </c:pt>
                <c:pt idx="269">
                  <c:v>895.85299999999995</c:v>
                </c:pt>
                <c:pt idx="270">
                  <c:v>896.57399999999996</c:v>
                </c:pt>
                <c:pt idx="271">
                  <c:v>901.947</c:v>
                </c:pt>
                <c:pt idx="272">
                  <c:v>902.23</c:v>
                </c:pt>
                <c:pt idx="273">
                  <c:v>904.90599999999995</c:v>
                </c:pt>
                <c:pt idx="274">
                  <c:v>907.49800000000005</c:v>
                </c:pt>
                <c:pt idx="275">
                  <c:v>908.04200000000003</c:v>
                </c:pt>
                <c:pt idx="276">
                  <c:v>910.65099999999995</c:v>
                </c:pt>
                <c:pt idx="277">
                  <c:v>911.73400000000004</c:v>
                </c:pt>
                <c:pt idx="278">
                  <c:v>914.13599999999997</c:v>
                </c:pt>
                <c:pt idx="279">
                  <c:v>920.23</c:v>
                </c:pt>
                <c:pt idx="280">
                  <c:v>922.779</c:v>
                </c:pt>
                <c:pt idx="281">
                  <c:v>926.32399999999996</c:v>
                </c:pt>
                <c:pt idx="282">
                  <c:v>928.16300000000001</c:v>
                </c:pt>
                <c:pt idx="283">
                  <c:v>929.80899999999997</c:v>
                </c:pt>
                <c:pt idx="284">
                  <c:v>931.54</c:v>
                </c:pt>
                <c:pt idx="285">
                  <c:v>932.41899999999998</c:v>
                </c:pt>
                <c:pt idx="286">
                  <c:v>933.81399999999996</c:v>
                </c:pt>
                <c:pt idx="287">
                  <c:v>936.08799999999997</c:v>
                </c:pt>
                <c:pt idx="288">
                  <c:v>938.51300000000003</c:v>
                </c:pt>
                <c:pt idx="289">
                  <c:v>940.16</c:v>
                </c:pt>
                <c:pt idx="290">
                  <c:v>944.60699999999997</c:v>
                </c:pt>
                <c:pt idx="291">
                  <c:v>946.16700000000003</c:v>
                </c:pt>
                <c:pt idx="292">
                  <c:v>950.70100000000002</c:v>
                </c:pt>
                <c:pt idx="293">
                  <c:v>952.61800000000005</c:v>
                </c:pt>
                <c:pt idx="294">
                  <c:v>955.74300000000005</c:v>
                </c:pt>
                <c:pt idx="295">
                  <c:v>956.79600000000005</c:v>
                </c:pt>
                <c:pt idx="296">
                  <c:v>958.86800000000005</c:v>
                </c:pt>
                <c:pt idx="297">
                  <c:v>959.77200000000005</c:v>
                </c:pt>
                <c:pt idx="298">
                  <c:v>960.13400000000001</c:v>
                </c:pt>
                <c:pt idx="299">
                  <c:v>962.29200000000003</c:v>
                </c:pt>
                <c:pt idx="300">
                  <c:v>962.89</c:v>
                </c:pt>
                <c:pt idx="301">
                  <c:v>966.971</c:v>
                </c:pt>
                <c:pt idx="302">
                  <c:v>968.98400000000004</c:v>
                </c:pt>
                <c:pt idx="303">
                  <c:v>971.73</c:v>
                </c:pt>
                <c:pt idx="304">
                  <c:v>974.87699999999995</c:v>
                </c:pt>
                <c:pt idx="305">
                  <c:v>975.07799999999997</c:v>
                </c:pt>
                <c:pt idx="306">
                  <c:v>975.45899999999995</c:v>
                </c:pt>
                <c:pt idx="307">
                  <c:v>978.06299999999999</c:v>
                </c:pt>
                <c:pt idx="308">
                  <c:v>981.17200000000003</c:v>
                </c:pt>
                <c:pt idx="309">
                  <c:v>981.62599999999998</c:v>
                </c:pt>
                <c:pt idx="310">
                  <c:v>983.452</c:v>
                </c:pt>
                <c:pt idx="311">
                  <c:v>983.529</c:v>
                </c:pt>
                <c:pt idx="312">
                  <c:v>983.64700000000005</c:v>
                </c:pt>
                <c:pt idx="313">
                  <c:v>984.16600000000005</c:v>
                </c:pt>
                <c:pt idx="314">
                  <c:v>984.68499999999995</c:v>
                </c:pt>
                <c:pt idx="315">
                  <c:v>985.53200000000004</c:v>
                </c:pt>
                <c:pt idx="316">
                  <c:v>986.16099999999994</c:v>
                </c:pt>
                <c:pt idx="317">
                  <c:v>987.26700000000005</c:v>
                </c:pt>
                <c:pt idx="318">
                  <c:v>990.33500000000004</c:v>
                </c:pt>
                <c:pt idx="319">
                  <c:v>992.48099999999999</c:v>
                </c:pt>
                <c:pt idx="320">
                  <c:v>993.36099999999999</c:v>
                </c:pt>
                <c:pt idx="321">
                  <c:v>993.875</c:v>
                </c:pt>
                <c:pt idx="322">
                  <c:v>994.18100000000004</c:v>
                </c:pt>
                <c:pt idx="323">
                  <c:v>994.38199999999995</c:v>
                </c:pt>
                <c:pt idx="324">
                  <c:v>995.15300000000002</c:v>
                </c:pt>
                <c:pt idx="325">
                  <c:v>998.46699999999998</c:v>
                </c:pt>
                <c:pt idx="326">
                  <c:v>999.45500000000004</c:v>
                </c:pt>
                <c:pt idx="327">
                  <c:v>1005.549</c:v>
                </c:pt>
                <c:pt idx="328">
                  <c:v>1010.6</c:v>
                </c:pt>
                <c:pt idx="329">
                  <c:v>1011.644</c:v>
                </c:pt>
                <c:pt idx="330">
                  <c:v>1014.489</c:v>
                </c:pt>
                <c:pt idx="331">
                  <c:v>1017.7380000000001</c:v>
                </c:pt>
                <c:pt idx="332">
                  <c:v>1019.428</c:v>
                </c:pt>
                <c:pt idx="333">
                  <c:v>1023.832</c:v>
                </c:pt>
                <c:pt idx="334">
                  <c:v>1024.461</c:v>
                </c:pt>
                <c:pt idx="335">
                  <c:v>1028.4739999999999</c:v>
                </c:pt>
                <c:pt idx="336">
                  <c:v>1029.9259999999999</c:v>
                </c:pt>
                <c:pt idx="337">
                  <c:v>1031.4580000000001</c:v>
                </c:pt>
                <c:pt idx="338">
                  <c:v>1033.826</c:v>
                </c:pt>
                <c:pt idx="339">
                  <c:v>1034.5070000000001</c:v>
                </c:pt>
                <c:pt idx="340">
                  <c:v>1036.021</c:v>
                </c:pt>
                <c:pt idx="341">
                  <c:v>1037.6880000000001</c:v>
                </c:pt>
                <c:pt idx="342">
                  <c:v>1041.3330000000001</c:v>
                </c:pt>
                <c:pt idx="343">
                  <c:v>1042.115</c:v>
                </c:pt>
                <c:pt idx="344">
                  <c:v>1042.566</c:v>
                </c:pt>
                <c:pt idx="345">
                  <c:v>1043.9100000000001</c:v>
                </c:pt>
                <c:pt idx="346">
                  <c:v>1045.769</c:v>
                </c:pt>
                <c:pt idx="347">
                  <c:v>1047.626</c:v>
                </c:pt>
                <c:pt idx="348">
                  <c:v>1048.2090000000001</c:v>
                </c:pt>
                <c:pt idx="349">
                  <c:v>1051.981</c:v>
                </c:pt>
                <c:pt idx="350">
                  <c:v>1054.3030000000001</c:v>
                </c:pt>
                <c:pt idx="351">
                  <c:v>1056.297</c:v>
                </c:pt>
                <c:pt idx="352">
                  <c:v>1058.105</c:v>
                </c:pt>
                <c:pt idx="353">
                  <c:v>1060.3979999999999</c:v>
                </c:pt>
                <c:pt idx="354">
                  <c:v>1061.5440000000001</c:v>
                </c:pt>
                <c:pt idx="355">
                  <c:v>1066.492</c:v>
                </c:pt>
                <c:pt idx="356">
                  <c:v>1069.0350000000001</c:v>
                </c:pt>
                <c:pt idx="357">
                  <c:v>1072.586</c:v>
                </c:pt>
                <c:pt idx="358">
                  <c:v>1074.9690000000001</c:v>
                </c:pt>
                <c:pt idx="359">
                  <c:v>1077.5530000000001</c:v>
                </c:pt>
                <c:pt idx="360">
                  <c:v>1078.68</c:v>
                </c:pt>
                <c:pt idx="361">
                  <c:v>1079.396</c:v>
                </c:pt>
                <c:pt idx="362">
                  <c:v>1084.7750000000001</c:v>
                </c:pt>
                <c:pt idx="363">
                  <c:v>1090.8689999999999</c:v>
                </c:pt>
                <c:pt idx="364">
                  <c:v>1093.5540000000001</c:v>
                </c:pt>
                <c:pt idx="365">
                  <c:v>1096.963</c:v>
                </c:pt>
                <c:pt idx="366">
                  <c:v>1097.0909999999999</c:v>
                </c:pt>
                <c:pt idx="367">
                  <c:v>1100.306</c:v>
                </c:pt>
                <c:pt idx="368">
                  <c:v>1103.057</c:v>
                </c:pt>
                <c:pt idx="369">
                  <c:v>1103.52</c:v>
                </c:pt>
                <c:pt idx="370">
                  <c:v>1104.548</c:v>
                </c:pt>
                <c:pt idx="371">
                  <c:v>1105.7139999999999</c:v>
                </c:pt>
                <c:pt idx="372">
                  <c:v>1108.6369999999999</c:v>
                </c:pt>
                <c:pt idx="373">
                  <c:v>1109.1510000000001</c:v>
                </c:pt>
                <c:pt idx="374">
                  <c:v>1115.2460000000001</c:v>
                </c:pt>
                <c:pt idx="375">
                  <c:v>1117.145</c:v>
                </c:pt>
                <c:pt idx="376">
                  <c:v>1121.046</c:v>
                </c:pt>
                <c:pt idx="377">
                  <c:v>1121.3399999999999</c:v>
                </c:pt>
                <c:pt idx="378">
                  <c:v>1121.635</c:v>
                </c:pt>
                <c:pt idx="379">
                  <c:v>1127.28</c:v>
                </c:pt>
                <c:pt idx="380">
                  <c:v>1127.434</c:v>
                </c:pt>
                <c:pt idx="381">
                  <c:v>1133.528</c:v>
                </c:pt>
                <c:pt idx="382">
                  <c:v>1139.623</c:v>
                </c:pt>
                <c:pt idx="383">
                  <c:v>1141.2349999999999</c:v>
                </c:pt>
                <c:pt idx="384">
                  <c:v>1145.7170000000001</c:v>
                </c:pt>
                <c:pt idx="385">
                  <c:v>1146.1949999999999</c:v>
                </c:pt>
                <c:pt idx="386">
                  <c:v>1151.8109999999999</c:v>
                </c:pt>
                <c:pt idx="387">
                  <c:v>1157.905</c:v>
                </c:pt>
                <c:pt idx="388">
                  <c:v>1159.22</c:v>
                </c:pt>
                <c:pt idx="389">
                  <c:v>1164</c:v>
                </c:pt>
                <c:pt idx="390">
                  <c:v>1166.643</c:v>
                </c:pt>
                <c:pt idx="391">
                  <c:v>1170.0940000000001</c:v>
                </c:pt>
                <c:pt idx="392">
                  <c:v>1176.1880000000001</c:v>
                </c:pt>
                <c:pt idx="393">
                  <c:v>1180.921</c:v>
                </c:pt>
                <c:pt idx="394">
                  <c:v>1182.2819999999999</c:v>
                </c:pt>
                <c:pt idx="395">
                  <c:v>1188.377</c:v>
                </c:pt>
                <c:pt idx="396">
                  <c:v>1194.471</c:v>
                </c:pt>
                <c:pt idx="397">
                  <c:v>1200.5650000000001</c:v>
                </c:pt>
                <c:pt idx="398">
                  <c:v>1206.6590000000001</c:v>
                </c:pt>
                <c:pt idx="399">
                  <c:v>1212.7539999999999</c:v>
                </c:pt>
                <c:pt idx="400">
                  <c:v>1218.848</c:v>
                </c:pt>
                <c:pt idx="401">
                  <c:v>1218.848</c:v>
                </c:pt>
              </c:numCache>
            </c:numRef>
          </c:xVal>
          <c:yVal>
            <c:numRef>
              <c:f>Foglio6!$J$1227:$J$1628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99.92</c:v>
                </c:pt>
                <c:pt idx="11">
                  <c:v>99.808000000000007</c:v>
                </c:pt>
                <c:pt idx="12">
                  <c:v>99.695999999999998</c:v>
                </c:pt>
                <c:pt idx="13">
                  <c:v>99.5</c:v>
                </c:pt>
                <c:pt idx="14">
                  <c:v>99.460999999999999</c:v>
                </c:pt>
                <c:pt idx="15">
                  <c:v>99.162000000000006</c:v>
                </c:pt>
                <c:pt idx="16">
                  <c:v>99.009</c:v>
                </c:pt>
                <c:pt idx="17">
                  <c:v>99</c:v>
                </c:pt>
                <c:pt idx="18">
                  <c:v>98.847999999999999</c:v>
                </c:pt>
                <c:pt idx="19">
                  <c:v>98.653000000000006</c:v>
                </c:pt>
                <c:pt idx="20">
                  <c:v>98.5</c:v>
                </c:pt>
                <c:pt idx="21">
                  <c:v>98.138000000000005</c:v>
                </c:pt>
                <c:pt idx="22">
                  <c:v>98.022000000000006</c:v>
                </c:pt>
                <c:pt idx="23">
                  <c:v>98</c:v>
                </c:pt>
                <c:pt idx="24">
                  <c:v>97.906999999999996</c:v>
                </c:pt>
                <c:pt idx="25">
                  <c:v>97.792000000000002</c:v>
                </c:pt>
                <c:pt idx="26">
                  <c:v>97.5</c:v>
                </c:pt>
                <c:pt idx="27">
                  <c:v>97</c:v>
                </c:pt>
                <c:pt idx="28">
                  <c:v>96.947000000000003</c:v>
                </c:pt>
                <c:pt idx="29">
                  <c:v>96.787999999999997</c:v>
                </c:pt>
                <c:pt idx="30">
                  <c:v>96.629000000000005</c:v>
                </c:pt>
                <c:pt idx="31">
                  <c:v>96.5</c:v>
                </c:pt>
                <c:pt idx="32">
                  <c:v>96.376999999999995</c:v>
                </c:pt>
                <c:pt idx="33">
                  <c:v>96.162000000000006</c:v>
                </c:pt>
                <c:pt idx="34">
                  <c:v>96</c:v>
                </c:pt>
                <c:pt idx="35">
                  <c:v>95.623999999999995</c:v>
                </c:pt>
                <c:pt idx="36">
                  <c:v>95.5</c:v>
                </c:pt>
                <c:pt idx="37">
                  <c:v>95.429000000000002</c:v>
                </c:pt>
                <c:pt idx="38">
                  <c:v>95.293000000000006</c:v>
                </c:pt>
                <c:pt idx="39">
                  <c:v>95.144999999999996</c:v>
                </c:pt>
                <c:pt idx="40">
                  <c:v>95</c:v>
                </c:pt>
                <c:pt idx="41">
                  <c:v>94.766000000000005</c:v>
                </c:pt>
                <c:pt idx="42">
                  <c:v>94.5</c:v>
                </c:pt>
                <c:pt idx="43">
                  <c:v>94.168000000000006</c:v>
                </c:pt>
                <c:pt idx="44">
                  <c:v>94</c:v>
                </c:pt>
                <c:pt idx="45">
                  <c:v>93.947999999999993</c:v>
                </c:pt>
                <c:pt idx="46">
                  <c:v>93.738</c:v>
                </c:pt>
                <c:pt idx="47">
                  <c:v>93.5</c:v>
                </c:pt>
                <c:pt idx="48">
                  <c:v>93.5</c:v>
                </c:pt>
                <c:pt idx="49">
                  <c:v>93.207999999999998</c:v>
                </c:pt>
                <c:pt idx="50">
                  <c:v>93.034000000000006</c:v>
                </c:pt>
                <c:pt idx="51">
                  <c:v>93</c:v>
                </c:pt>
                <c:pt idx="52">
                  <c:v>92.820999999999998</c:v>
                </c:pt>
                <c:pt idx="53">
                  <c:v>92.5</c:v>
                </c:pt>
                <c:pt idx="54">
                  <c:v>92.149000000000001</c:v>
                </c:pt>
                <c:pt idx="55">
                  <c:v>92</c:v>
                </c:pt>
                <c:pt idx="56">
                  <c:v>91.938999999999993</c:v>
                </c:pt>
                <c:pt idx="57">
                  <c:v>91.727999999999994</c:v>
                </c:pt>
                <c:pt idx="58">
                  <c:v>91.5</c:v>
                </c:pt>
                <c:pt idx="59">
                  <c:v>91.177000000000007</c:v>
                </c:pt>
                <c:pt idx="60">
                  <c:v>91</c:v>
                </c:pt>
                <c:pt idx="61">
                  <c:v>90.935000000000002</c:v>
                </c:pt>
                <c:pt idx="62">
                  <c:v>90.814999999999998</c:v>
                </c:pt>
                <c:pt idx="63">
                  <c:v>90.733000000000004</c:v>
                </c:pt>
                <c:pt idx="64">
                  <c:v>90.652000000000001</c:v>
                </c:pt>
                <c:pt idx="65">
                  <c:v>90.5</c:v>
                </c:pt>
                <c:pt idx="66">
                  <c:v>90.097999999999999</c:v>
                </c:pt>
                <c:pt idx="67">
                  <c:v>90</c:v>
                </c:pt>
                <c:pt idx="68">
                  <c:v>89.97</c:v>
                </c:pt>
                <c:pt idx="69">
                  <c:v>89.843000000000004</c:v>
                </c:pt>
                <c:pt idx="70">
                  <c:v>89.527000000000001</c:v>
                </c:pt>
                <c:pt idx="71">
                  <c:v>89.5</c:v>
                </c:pt>
                <c:pt idx="72">
                  <c:v>89</c:v>
                </c:pt>
                <c:pt idx="73">
                  <c:v>88.988</c:v>
                </c:pt>
                <c:pt idx="74">
                  <c:v>88.864999999999995</c:v>
                </c:pt>
                <c:pt idx="75">
                  <c:v>88.741</c:v>
                </c:pt>
                <c:pt idx="76">
                  <c:v>88.617999999999995</c:v>
                </c:pt>
                <c:pt idx="77">
                  <c:v>88.5</c:v>
                </c:pt>
                <c:pt idx="78">
                  <c:v>88.316999999999993</c:v>
                </c:pt>
                <c:pt idx="79">
                  <c:v>88</c:v>
                </c:pt>
                <c:pt idx="80">
                  <c:v>87.948999999999998</c:v>
                </c:pt>
                <c:pt idx="81">
                  <c:v>87.623999999999995</c:v>
                </c:pt>
                <c:pt idx="82">
                  <c:v>87.5</c:v>
                </c:pt>
                <c:pt idx="83">
                  <c:v>87.477000000000004</c:v>
                </c:pt>
                <c:pt idx="84">
                  <c:v>87.356999999999999</c:v>
                </c:pt>
                <c:pt idx="85">
                  <c:v>87.236999999999995</c:v>
                </c:pt>
                <c:pt idx="86">
                  <c:v>87.117000000000004</c:v>
                </c:pt>
                <c:pt idx="87">
                  <c:v>87</c:v>
                </c:pt>
                <c:pt idx="88">
                  <c:v>86.923000000000002</c:v>
                </c:pt>
                <c:pt idx="89">
                  <c:v>86.638000000000005</c:v>
                </c:pt>
                <c:pt idx="90">
                  <c:v>86.5</c:v>
                </c:pt>
                <c:pt idx="91">
                  <c:v>86.352000000000004</c:v>
                </c:pt>
                <c:pt idx="92">
                  <c:v>86</c:v>
                </c:pt>
                <c:pt idx="93">
                  <c:v>85.930999999999997</c:v>
                </c:pt>
                <c:pt idx="94">
                  <c:v>85.826999999999998</c:v>
                </c:pt>
                <c:pt idx="95">
                  <c:v>85.751000000000005</c:v>
                </c:pt>
                <c:pt idx="96">
                  <c:v>85.676000000000002</c:v>
                </c:pt>
                <c:pt idx="97">
                  <c:v>85.5</c:v>
                </c:pt>
                <c:pt idx="98">
                  <c:v>85.405000000000001</c:v>
                </c:pt>
                <c:pt idx="99">
                  <c:v>85.001000000000005</c:v>
                </c:pt>
                <c:pt idx="100">
                  <c:v>85</c:v>
                </c:pt>
                <c:pt idx="101">
                  <c:v>84.698999999999998</c:v>
                </c:pt>
                <c:pt idx="102">
                  <c:v>84.5</c:v>
                </c:pt>
                <c:pt idx="103">
                  <c:v>84.418999999999997</c:v>
                </c:pt>
                <c:pt idx="104">
                  <c:v>84.272000000000006</c:v>
                </c:pt>
                <c:pt idx="105">
                  <c:v>84.165999999999997</c:v>
                </c:pt>
                <c:pt idx="106">
                  <c:v>84.06</c:v>
                </c:pt>
                <c:pt idx="107">
                  <c:v>84</c:v>
                </c:pt>
                <c:pt idx="108">
                  <c:v>83.953999999999994</c:v>
                </c:pt>
                <c:pt idx="109">
                  <c:v>83.849000000000004</c:v>
                </c:pt>
                <c:pt idx="110">
                  <c:v>83.5</c:v>
                </c:pt>
                <c:pt idx="111">
                  <c:v>83.442999999999998</c:v>
                </c:pt>
                <c:pt idx="112">
                  <c:v>83</c:v>
                </c:pt>
                <c:pt idx="113">
                  <c:v>82.759</c:v>
                </c:pt>
                <c:pt idx="114">
                  <c:v>82.5</c:v>
                </c:pt>
                <c:pt idx="115">
                  <c:v>82.299000000000007</c:v>
                </c:pt>
                <c:pt idx="116">
                  <c:v>82</c:v>
                </c:pt>
                <c:pt idx="117">
                  <c:v>81.838999999999999</c:v>
                </c:pt>
                <c:pt idx="118">
                  <c:v>81.5</c:v>
                </c:pt>
                <c:pt idx="119">
                  <c:v>81.146000000000001</c:v>
                </c:pt>
                <c:pt idx="120">
                  <c:v>81</c:v>
                </c:pt>
                <c:pt idx="121">
                  <c:v>80.5</c:v>
                </c:pt>
                <c:pt idx="122">
                  <c:v>80</c:v>
                </c:pt>
                <c:pt idx="123">
                  <c:v>79.885000000000005</c:v>
                </c:pt>
                <c:pt idx="124">
                  <c:v>79.5</c:v>
                </c:pt>
                <c:pt idx="125">
                  <c:v>79.459000000000003</c:v>
                </c:pt>
                <c:pt idx="126">
                  <c:v>79.447000000000003</c:v>
                </c:pt>
                <c:pt idx="127">
                  <c:v>79.435000000000002</c:v>
                </c:pt>
                <c:pt idx="128">
                  <c:v>79.424000000000007</c:v>
                </c:pt>
                <c:pt idx="129">
                  <c:v>79</c:v>
                </c:pt>
                <c:pt idx="130">
                  <c:v>78.947000000000003</c:v>
                </c:pt>
                <c:pt idx="131">
                  <c:v>78.703999999999994</c:v>
                </c:pt>
                <c:pt idx="132">
                  <c:v>78.585999999999999</c:v>
                </c:pt>
                <c:pt idx="133">
                  <c:v>78.5</c:v>
                </c:pt>
                <c:pt idx="134">
                  <c:v>78.466999999999999</c:v>
                </c:pt>
                <c:pt idx="135">
                  <c:v>78.349000000000004</c:v>
                </c:pt>
                <c:pt idx="136">
                  <c:v>78</c:v>
                </c:pt>
                <c:pt idx="137">
                  <c:v>77.954999999999998</c:v>
                </c:pt>
                <c:pt idx="138">
                  <c:v>77.5</c:v>
                </c:pt>
                <c:pt idx="139">
                  <c:v>77.245000000000005</c:v>
                </c:pt>
                <c:pt idx="140">
                  <c:v>77</c:v>
                </c:pt>
                <c:pt idx="141">
                  <c:v>76.992000000000004</c:v>
                </c:pt>
                <c:pt idx="142">
                  <c:v>76.753</c:v>
                </c:pt>
                <c:pt idx="143">
                  <c:v>76.67</c:v>
                </c:pt>
                <c:pt idx="144">
                  <c:v>76.587000000000003</c:v>
                </c:pt>
                <c:pt idx="145">
                  <c:v>76.5</c:v>
                </c:pt>
                <c:pt idx="146">
                  <c:v>76.224999999999994</c:v>
                </c:pt>
                <c:pt idx="147">
                  <c:v>76</c:v>
                </c:pt>
                <c:pt idx="148">
                  <c:v>75.617999999999995</c:v>
                </c:pt>
                <c:pt idx="149">
                  <c:v>75.5</c:v>
                </c:pt>
                <c:pt idx="150">
                  <c:v>75</c:v>
                </c:pt>
                <c:pt idx="151">
                  <c:v>74.5</c:v>
                </c:pt>
                <c:pt idx="152">
                  <c:v>74</c:v>
                </c:pt>
                <c:pt idx="153">
                  <c:v>73.697000000000003</c:v>
                </c:pt>
                <c:pt idx="154">
                  <c:v>73.5</c:v>
                </c:pt>
                <c:pt idx="155">
                  <c:v>73</c:v>
                </c:pt>
                <c:pt idx="156">
                  <c:v>72.906000000000006</c:v>
                </c:pt>
                <c:pt idx="157">
                  <c:v>72.754999999999995</c:v>
                </c:pt>
                <c:pt idx="158">
                  <c:v>72.603999999999999</c:v>
                </c:pt>
                <c:pt idx="159">
                  <c:v>72.5</c:v>
                </c:pt>
                <c:pt idx="160">
                  <c:v>72.453999999999994</c:v>
                </c:pt>
                <c:pt idx="161">
                  <c:v>72.248999999999995</c:v>
                </c:pt>
                <c:pt idx="162">
                  <c:v>72</c:v>
                </c:pt>
                <c:pt idx="163">
                  <c:v>71.935000000000002</c:v>
                </c:pt>
                <c:pt idx="164">
                  <c:v>71.620999999999995</c:v>
                </c:pt>
                <c:pt idx="165">
                  <c:v>71.5</c:v>
                </c:pt>
                <c:pt idx="166">
                  <c:v>71.165000000000006</c:v>
                </c:pt>
                <c:pt idx="167">
                  <c:v>71</c:v>
                </c:pt>
                <c:pt idx="168">
                  <c:v>70.5</c:v>
                </c:pt>
                <c:pt idx="169">
                  <c:v>70</c:v>
                </c:pt>
                <c:pt idx="170">
                  <c:v>69.988</c:v>
                </c:pt>
                <c:pt idx="171">
                  <c:v>69.5</c:v>
                </c:pt>
                <c:pt idx="172">
                  <c:v>69</c:v>
                </c:pt>
                <c:pt idx="173">
                  <c:v>68.506</c:v>
                </c:pt>
                <c:pt idx="174">
                  <c:v>68.5</c:v>
                </c:pt>
                <c:pt idx="175">
                  <c:v>68</c:v>
                </c:pt>
                <c:pt idx="176">
                  <c:v>67.991</c:v>
                </c:pt>
                <c:pt idx="177">
                  <c:v>67.570999999999998</c:v>
                </c:pt>
                <c:pt idx="178">
                  <c:v>67.5</c:v>
                </c:pt>
                <c:pt idx="179">
                  <c:v>67.369</c:v>
                </c:pt>
                <c:pt idx="180">
                  <c:v>67.167000000000002</c:v>
                </c:pt>
                <c:pt idx="181">
                  <c:v>67</c:v>
                </c:pt>
                <c:pt idx="182">
                  <c:v>66.965000000000003</c:v>
                </c:pt>
                <c:pt idx="183">
                  <c:v>66.537999999999997</c:v>
                </c:pt>
                <c:pt idx="184">
                  <c:v>66.5</c:v>
                </c:pt>
                <c:pt idx="185">
                  <c:v>66</c:v>
                </c:pt>
                <c:pt idx="186">
                  <c:v>65.5</c:v>
                </c:pt>
                <c:pt idx="187">
                  <c:v>65</c:v>
                </c:pt>
                <c:pt idx="188">
                  <c:v>64.887</c:v>
                </c:pt>
                <c:pt idx="189">
                  <c:v>64.5</c:v>
                </c:pt>
                <c:pt idx="190">
                  <c:v>64.073999999999998</c:v>
                </c:pt>
                <c:pt idx="191">
                  <c:v>64</c:v>
                </c:pt>
                <c:pt idx="192">
                  <c:v>63.518999999999998</c:v>
                </c:pt>
                <c:pt idx="193">
                  <c:v>63.5</c:v>
                </c:pt>
                <c:pt idx="194">
                  <c:v>63</c:v>
                </c:pt>
                <c:pt idx="195">
                  <c:v>62.5</c:v>
                </c:pt>
                <c:pt idx="196">
                  <c:v>62</c:v>
                </c:pt>
                <c:pt idx="197">
                  <c:v>61.972000000000001</c:v>
                </c:pt>
                <c:pt idx="198">
                  <c:v>61.5</c:v>
                </c:pt>
                <c:pt idx="199">
                  <c:v>61</c:v>
                </c:pt>
                <c:pt idx="200">
                  <c:v>60.587000000000003</c:v>
                </c:pt>
                <c:pt idx="201">
                  <c:v>60.5</c:v>
                </c:pt>
                <c:pt idx="202">
                  <c:v>60.457999999999998</c:v>
                </c:pt>
                <c:pt idx="203">
                  <c:v>60.33</c:v>
                </c:pt>
                <c:pt idx="204">
                  <c:v>60.103999999999999</c:v>
                </c:pt>
                <c:pt idx="205">
                  <c:v>60</c:v>
                </c:pt>
                <c:pt idx="206">
                  <c:v>59.92</c:v>
                </c:pt>
                <c:pt idx="207">
                  <c:v>59.731999999999999</c:v>
                </c:pt>
                <c:pt idx="208">
                  <c:v>59.5</c:v>
                </c:pt>
                <c:pt idx="209">
                  <c:v>59</c:v>
                </c:pt>
                <c:pt idx="210">
                  <c:v>58.5</c:v>
                </c:pt>
                <c:pt idx="211">
                  <c:v>58.488999999999997</c:v>
                </c:pt>
                <c:pt idx="212">
                  <c:v>58</c:v>
                </c:pt>
                <c:pt idx="213">
                  <c:v>57.5</c:v>
                </c:pt>
                <c:pt idx="214">
                  <c:v>57.168999999999997</c:v>
                </c:pt>
                <c:pt idx="215">
                  <c:v>57</c:v>
                </c:pt>
                <c:pt idx="216">
                  <c:v>56.5</c:v>
                </c:pt>
                <c:pt idx="217">
                  <c:v>56</c:v>
                </c:pt>
                <c:pt idx="218">
                  <c:v>55.686</c:v>
                </c:pt>
                <c:pt idx="219">
                  <c:v>55.5</c:v>
                </c:pt>
                <c:pt idx="220">
                  <c:v>55</c:v>
                </c:pt>
                <c:pt idx="221">
                  <c:v>54.5</c:v>
                </c:pt>
                <c:pt idx="222">
                  <c:v>54</c:v>
                </c:pt>
                <c:pt idx="223">
                  <c:v>53.697000000000003</c:v>
                </c:pt>
                <c:pt idx="224">
                  <c:v>53.579000000000001</c:v>
                </c:pt>
                <c:pt idx="225">
                  <c:v>53.5</c:v>
                </c:pt>
                <c:pt idx="226">
                  <c:v>53.347000000000001</c:v>
                </c:pt>
                <c:pt idx="227">
                  <c:v>53</c:v>
                </c:pt>
                <c:pt idx="228">
                  <c:v>52.941000000000003</c:v>
                </c:pt>
                <c:pt idx="229">
                  <c:v>52.5</c:v>
                </c:pt>
                <c:pt idx="230">
                  <c:v>52</c:v>
                </c:pt>
                <c:pt idx="231">
                  <c:v>51.686999999999998</c:v>
                </c:pt>
                <c:pt idx="232">
                  <c:v>51.5</c:v>
                </c:pt>
                <c:pt idx="233">
                  <c:v>51.081000000000003</c:v>
                </c:pt>
                <c:pt idx="234">
                  <c:v>51</c:v>
                </c:pt>
                <c:pt idx="235">
                  <c:v>50.54</c:v>
                </c:pt>
                <c:pt idx="236">
                  <c:v>50.5</c:v>
                </c:pt>
                <c:pt idx="237">
                  <c:v>50</c:v>
                </c:pt>
                <c:pt idx="238">
                  <c:v>49.552999999999997</c:v>
                </c:pt>
                <c:pt idx="239">
                  <c:v>49.5</c:v>
                </c:pt>
                <c:pt idx="240">
                  <c:v>49</c:v>
                </c:pt>
                <c:pt idx="241">
                  <c:v>48.820999999999998</c:v>
                </c:pt>
                <c:pt idx="242">
                  <c:v>48.5</c:v>
                </c:pt>
                <c:pt idx="243">
                  <c:v>48</c:v>
                </c:pt>
                <c:pt idx="244">
                  <c:v>47.832000000000001</c:v>
                </c:pt>
                <c:pt idx="245">
                  <c:v>47.5</c:v>
                </c:pt>
                <c:pt idx="246">
                  <c:v>47</c:v>
                </c:pt>
                <c:pt idx="247">
                  <c:v>46.5</c:v>
                </c:pt>
                <c:pt idx="248">
                  <c:v>46</c:v>
                </c:pt>
                <c:pt idx="249">
                  <c:v>45.5</c:v>
                </c:pt>
                <c:pt idx="250">
                  <c:v>45</c:v>
                </c:pt>
                <c:pt idx="251">
                  <c:v>44.869</c:v>
                </c:pt>
                <c:pt idx="252">
                  <c:v>44.817999999999998</c:v>
                </c:pt>
                <c:pt idx="253">
                  <c:v>44.78</c:v>
                </c:pt>
                <c:pt idx="254">
                  <c:v>44.756999999999998</c:v>
                </c:pt>
                <c:pt idx="255">
                  <c:v>44.5</c:v>
                </c:pt>
                <c:pt idx="256">
                  <c:v>44</c:v>
                </c:pt>
                <c:pt idx="257">
                  <c:v>43.5</c:v>
                </c:pt>
                <c:pt idx="258">
                  <c:v>43</c:v>
                </c:pt>
                <c:pt idx="259">
                  <c:v>42.661000000000001</c:v>
                </c:pt>
                <c:pt idx="260">
                  <c:v>42.5</c:v>
                </c:pt>
                <c:pt idx="261">
                  <c:v>42.146000000000001</c:v>
                </c:pt>
                <c:pt idx="262">
                  <c:v>42</c:v>
                </c:pt>
                <c:pt idx="263">
                  <c:v>41.631</c:v>
                </c:pt>
                <c:pt idx="264">
                  <c:v>41.5</c:v>
                </c:pt>
                <c:pt idx="265">
                  <c:v>41</c:v>
                </c:pt>
                <c:pt idx="266">
                  <c:v>40.5</c:v>
                </c:pt>
                <c:pt idx="267">
                  <c:v>40</c:v>
                </c:pt>
                <c:pt idx="268">
                  <c:v>39.5</c:v>
                </c:pt>
                <c:pt idx="269">
                  <c:v>39.097000000000001</c:v>
                </c:pt>
                <c:pt idx="270">
                  <c:v>39</c:v>
                </c:pt>
                <c:pt idx="271">
                  <c:v>38.527999999999999</c:v>
                </c:pt>
                <c:pt idx="272">
                  <c:v>38.5</c:v>
                </c:pt>
                <c:pt idx="273">
                  <c:v>38</c:v>
                </c:pt>
                <c:pt idx="274">
                  <c:v>37.5</c:v>
                </c:pt>
                <c:pt idx="275">
                  <c:v>37.429000000000002</c:v>
                </c:pt>
                <c:pt idx="276">
                  <c:v>37</c:v>
                </c:pt>
                <c:pt idx="277">
                  <c:v>36.5</c:v>
                </c:pt>
                <c:pt idx="278">
                  <c:v>36.383000000000003</c:v>
                </c:pt>
                <c:pt idx="279">
                  <c:v>36.113</c:v>
                </c:pt>
                <c:pt idx="280">
                  <c:v>36</c:v>
                </c:pt>
                <c:pt idx="281">
                  <c:v>35.761000000000003</c:v>
                </c:pt>
                <c:pt idx="282">
                  <c:v>35.5</c:v>
                </c:pt>
                <c:pt idx="283">
                  <c:v>35</c:v>
                </c:pt>
                <c:pt idx="284">
                  <c:v>34.5</c:v>
                </c:pt>
                <c:pt idx="285">
                  <c:v>34.307000000000002</c:v>
                </c:pt>
                <c:pt idx="286">
                  <c:v>34</c:v>
                </c:pt>
                <c:pt idx="287">
                  <c:v>33.5</c:v>
                </c:pt>
                <c:pt idx="288">
                  <c:v>33.180999999999997</c:v>
                </c:pt>
                <c:pt idx="289">
                  <c:v>33</c:v>
                </c:pt>
                <c:pt idx="290">
                  <c:v>32.604999999999997</c:v>
                </c:pt>
                <c:pt idx="291">
                  <c:v>32.5</c:v>
                </c:pt>
                <c:pt idx="292">
                  <c:v>32.194000000000003</c:v>
                </c:pt>
                <c:pt idx="293">
                  <c:v>32</c:v>
                </c:pt>
                <c:pt idx="294">
                  <c:v>31.5</c:v>
                </c:pt>
                <c:pt idx="295">
                  <c:v>31.332000000000001</c:v>
                </c:pt>
                <c:pt idx="296">
                  <c:v>31</c:v>
                </c:pt>
                <c:pt idx="297">
                  <c:v>30.5</c:v>
                </c:pt>
                <c:pt idx="298">
                  <c:v>30</c:v>
                </c:pt>
                <c:pt idx="299">
                  <c:v>29.5</c:v>
                </c:pt>
                <c:pt idx="300">
                  <c:v>29.436</c:v>
                </c:pt>
                <c:pt idx="301">
                  <c:v>29</c:v>
                </c:pt>
                <c:pt idx="302">
                  <c:v>28.786999999999999</c:v>
                </c:pt>
                <c:pt idx="303">
                  <c:v>28.5</c:v>
                </c:pt>
                <c:pt idx="304">
                  <c:v>28</c:v>
                </c:pt>
                <c:pt idx="305">
                  <c:v>27.664999999999999</c:v>
                </c:pt>
                <c:pt idx="306">
                  <c:v>27.5</c:v>
                </c:pt>
                <c:pt idx="307">
                  <c:v>27</c:v>
                </c:pt>
                <c:pt idx="308">
                  <c:v>26.564</c:v>
                </c:pt>
                <c:pt idx="309">
                  <c:v>26.5</c:v>
                </c:pt>
                <c:pt idx="310">
                  <c:v>26</c:v>
                </c:pt>
                <c:pt idx="311">
                  <c:v>25.5</c:v>
                </c:pt>
                <c:pt idx="312">
                  <c:v>25</c:v>
                </c:pt>
                <c:pt idx="313">
                  <c:v>24.5</c:v>
                </c:pt>
                <c:pt idx="314">
                  <c:v>24</c:v>
                </c:pt>
                <c:pt idx="315">
                  <c:v>23.5</c:v>
                </c:pt>
                <c:pt idx="316">
                  <c:v>23</c:v>
                </c:pt>
                <c:pt idx="317">
                  <c:v>22.867999999999999</c:v>
                </c:pt>
                <c:pt idx="318">
                  <c:v>22.5</c:v>
                </c:pt>
                <c:pt idx="319">
                  <c:v>22</c:v>
                </c:pt>
                <c:pt idx="320">
                  <c:v>21.757999999999999</c:v>
                </c:pt>
                <c:pt idx="321">
                  <c:v>21.5</c:v>
                </c:pt>
                <c:pt idx="322">
                  <c:v>21</c:v>
                </c:pt>
                <c:pt idx="323">
                  <c:v>20.5</c:v>
                </c:pt>
                <c:pt idx="324">
                  <c:v>20</c:v>
                </c:pt>
                <c:pt idx="325">
                  <c:v>19.5</c:v>
                </c:pt>
                <c:pt idx="326">
                  <c:v>19.468</c:v>
                </c:pt>
                <c:pt idx="327">
                  <c:v>19.268000000000001</c:v>
                </c:pt>
                <c:pt idx="328">
                  <c:v>19</c:v>
                </c:pt>
                <c:pt idx="329">
                  <c:v>18.866</c:v>
                </c:pt>
                <c:pt idx="330">
                  <c:v>18.5</c:v>
                </c:pt>
                <c:pt idx="331">
                  <c:v>18.167999999999999</c:v>
                </c:pt>
                <c:pt idx="332">
                  <c:v>18</c:v>
                </c:pt>
                <c:pt idx="333">
                  <c:v>17.562000000000001</c:v>
                </c:pt>
                <c:pt idx="334">
                  <c:v>17.5</c:v>
                </c:pt>
                <c:pt idx="335">
                  <c:v>17</c:v>
                </c:pt>
                <c:pt idx="336">
                  <c:v>16.757000000000001</c:v>
                </c:pt>
                <c:pt idx="337">
                  <c:v>16.5</c:v>
                </c:pt>
                <c:pt idx="338">
                  <c:v>16</c:v>
                </c:pt>
                <c:pt idx="339">
                  <c:v>15.5</c:v>
                </c:pt>
                <c:pt idx="340">
                  <c:v>15.21</c:v>
                </c:pt>
                <c:pt idx="341">
                  <c:v>15</c:v>
                </c:pt>
                <c:pt idx="342">
                  <c:v>14.5</c:v>
                </c:pt>
                <c:pt idx="343">
                  <c:v>14.183</c:v>
                </c:pt>
                <c:pt idx="344">
                  <c:v>14</c:v>
                </c:pt>
                <c:pt idx="345">
                  <c:v>13.5</c:v>
                </c:pt>
                <c:pt idx="346">
                  <c:v>13</c:v>
                </c:pt>
                <c:pt idx="347">
                  <c:v>12.5</c:v>
                </c:pt>
                <c:pt idx="348">
                  <c:v>12.343</c:v>
                </c:pt>
                <c:pt idx="349">
                  <c:v>12</c:v>
                </c:pt>
                <c:pt idx="350">
                  <c:v>11.872999999999999</c:v>
                </c:pt>
                <c:pt idx="351">
                  <c:v>11.5</c:v>
                </c:pt>
                <c:pt idx="352">
                  <c:v>11</c:v>
                </c:pt>
                <c:pt idx="353">
                  <c:v>10.821</c:v>
                </c:pt>
                <c:pt idx="354">
                  <c:v>10.5</c:v>
                </c:pt>
                <c:pt idx="355">
                  <c:v>10.179</c:v>
                </c:pt>
                <c:pt idx="356">
                  <c:v>10</c:v>
                </c:pt>
                <c:pt idx="357">
                  <c:v>9.7010000000000005</c:v>
                </c:pt>
                <c:pt idx="358">
                  <c:v>9.5</c:v>
                </c:pt>
                <c:pt idx="359">
                  <c:v>9</c:v>
                </c:pt>
                <c:pt idx="360">
                  <c:v>8.7430000000000003</c:v>
                </c:pt>
                <c:pt idx="361">
                  <c:v>8.5</c:v>
                </c:pt>
                <c:pt idx="362">
                  <c:v>8.2520000000000007</c:v>
                </c:pt>
                <c:pt idx="363">
                  <c:v>8.2070000000000007</c:v>
                </c:pt>
                <c:pt idx="364">
                  <c:v>8</c:v>
                </c:pt>
                <c:pt idx="365">
                  <c:v>7.52</c:v>
                </c:pt>
                <c:pt idx="366">
                  <c:v>7.5</c:v>
                </c:pt>
                <c:pt idx="367">
                  <c:v>7</c:v>
                </c:pt>
                <c:pt idx="368">
                  <c:v>6.5720000000000001</c:v>
                </c:pt>
                <c:pt idx="369">
                  <c:v>6.5</c:v>
                </c:pt>
                <c:pt idx="370">
                  <c:v>6</c:v>
                </c:pt>
                <c:pt idx="371">
                  <c:v>5.5</c:v>
                </c:pt>
                <c:pt idx="372">
                  <c:v>5</c:v>
                </c:pt>
                <c:pt idx="373">
                  <c:v>4.9180000000000001</c:v>
                </c:pt>
                <c:pt idx="374">
                  <c:v>4.593</c:v>
                </c:pt>
                <c:pt idx="375">
                  <c:v>4.5</c:v>
                </c:pt>
                <c:pt idx="376">
                  <c:v>4</c:v>
                </c:pt>
                <c:pt idx="377">
                  <c:v>3.7959999999999998</c:v>
                </c:pt>
                <c:pt idx="378">
                  <c:v>3.5</c:v>
                </c:pt>
                <c:pt idx="379">
                  <c:v>3</c:v>
                </c:pt>
                <c:pt idx="380">
                  <c:v>2.996</c:v>
                </c:pt>
                <c:pt idx="381">
                  <c:v>2.839</c:v>
                </c:pt>
                <c:pt idx="382">
                  <c:v>2.6819999999999999</c:v>
                </c:pt>
                <c:pt idx="383">
                  <c:v>2.5</c:v>
                </c:pt>
                <c:pt idx="384">
                  <c:v>2.0129999999999999</c:v>
                </c:pt>
                <c:pt idx="385">
                  <c:v>2</c:v>
                </c:pt>
                <c:pt idx="386">
                  <c:v>1.847</c:v>
                </c:pt>
                <c:pt idx="387">
                  <c:v>1.6819999999999999</c:v>
                </c:pt>
                <c:pt idx="388">
                  <c:v>1.5</c:v>
                </c:pt>
                <c:pt idx="389">
                  <c:v>1.095</c:v>
                </c:pt>
                <c:pt idx="390">
                  <c:v>1</c:v>
                </c:pt>
                <c:pt idx="391">
                  <c:v>0.875</c:v>
                </c:pt>
                <c:pt idx="392">
                  <c:v>0.66400000000000003</c:v>
                </c:pt>
                <c:pt idx="393">
                  <c:v>0.5</c:v>
                </c:pt>
                <c:pt idx="394">
                  <c:v>0.435</c:v>
                </c:pt>
                <c:pt idx="395">
                  <c:v>0.14699999999999999</c:v>
                </c:pt>
                <c:pt idx="396">
                  <c:v>0.11799999999999999</c:v>
                </c:pt>
                <c:pt idx="397">
                  <c:v>8.8999999999999996E-2</c:v>
                </c:pt>
                <c:pt idx="398">
                  <c:v>5.8999999999999997E-2</c:v>
                </c:pt>
                <c:pt idx="399">
                  <c:v>0.03</c:v>
                </c:pt>
                <c:pt idx="400">
                  <c:v>1E-3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55F-45DA-A1D6-04490D79AFD9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Foglio6!$K$1227:$K$1628</c:f>
              <c:numCache>
                <c:formatCode>General</c:formatCode>
                <c:ptCount val="402"/>
                <c:pt idx="0">
                  <c:v>0</c:v>
                </c:pt>
                <c:pt idx="1">
                  <c:v>6.1520000000000001</c:v>
                </c:pt>
                <c:pt idx="2">
                  <c:v>12.305</c:v>
                </c:pt>
                <c:pt idx="3">
                  <c:v>18.457000000000001</c:v>
                </c:pt>
                <c:pt idx="4">
                  <c:v>24.61</c:v>
                </c:pt>
                <c:pt idx="5">
                  <c:v>30.762</c:v>
                </c:pt>
                <c:pt idx="6">
                  <c:v>36.914999999999999</c:v>
                </c:pt>
                <c:pt idx="7">
                  <c:v>43.067</c:v>
                </c:pt>
                <c:pt idx="8">
                  <c:v>49.219000000000001</c:v>
                </c:pt>
                <c:pt idx="9">
                  <c:v>53.83</c:v>
                </c:pt>
                <c:pt idx="10">
                  <c:v>55.372</c:v>
                </c:pt>
                <c:pt idx="11">
                  <c:v>61.524000000000001</c:v>
                </c:pt>
                <c:pt idx="12">
                  <c:v>67.677000000000007</c:v>
                </c:pt>
                <c:pt idx="13">
                  <c:v>73.828999999999994</c:v>
                </c:pt>
                <c:pt idx="14">
                  <c:v>73.870999999999995</c:v>
                </c:pt>
                <c:pt idx="15">
                  <c:v>79.980999999999995</c:v>
                </c:pt>
                <c:pt idx="16">
                  <c:v>84.183999999999997</c:v>
                </c:pt>
                <c:pt idx="17">
                  <c:v>86.134</c:v>
                </c:pt>
                <c:pt idx="18">
                  <c:v>92.286000000000001</c:v>
                </c:pt>
                <c:pt idx="19">
                  <c:v>98.075999999999993</c:v>
                </c:pt>
                <c:pt idx="20">
                  <c:v>98.438999999999993</c:v>
                </c:pt>
                <c:pt idx="21">
                  <c:v>104.59099999999999</c:v>
                </c:pt>
                <c:pt idx="22">
                  <c:v>110.744</c:v>
                </c:pt>
                <c:pt idx="23">
                  <c:v>111.273</c:v>
                </c:pt>
                <c:pt idx="24">
                  <c:v>116.896</c:v>
                </c:pt>
                <c:pt idx="25">
                  <c:v>123.048</c:v>
                </c:pt>
                <c:pt idx="26">
                  <c:v>126.128</c:v>
                </c:pt>
                <c:pt idx="27">
                  <c:v>129.16</c:v>
                </c:pt>
                <c:pt idx="28">
                  <c:v>129.20099999999999</c:v>
                </c:pt>
                <c:pt idx="29">
                  <c:v>135.35300000000001</c:v>
                </c:pt>
                <c:pt idx="30">
                  <c:v>141.506</c:v>
                </c:pt>
                <c:pt idx="31">
                  <c:v>144.46199999999999</c:v>
                </c:pt>
                <c:pt idx="32">
                  <c:v>147.65799999999999</c:v>
                </c:pt>
                <c:pt idx="33">
                  <c:v>153.81100000000001</c:v>
                </c:pt>
                <c:pt idx="34">
                  <c:v>159.96299999999999</c:v>
                </c:pt>
                <c:pt idx="35">
                  <c:v>161.22200000000001</c:v>
                </c:pt>
                <c:pt idx="36">
                  <c:v>166.11500000000001</c:v>
                </c:pt>
                <c:pt idx="37">
                  <c:v>169.886</c:v>
                </c:pt>
                <c:pt idx="38">
                  <c:v>172.268</c:v>
                </c:pt>
                <c:pt idx="39">
                  <c:v>178.42</c:v>
                </c:pt>
                <c:pt idx="40">
                  <c:v>179.80600000000001</c:v>
                </c:pt>
                <c:pt idx="41">
                  <c:v>184.57300000000001</c:v>
                </c:pt>
                <c:pt idx="42">
                  <c:v>189.429</c:v>
                </c:pt>
                <c:pt idx="43">
                  <c:v>190.72499999999999</c:v>
                </c:pt>
                <c:pt idx="44">
                  <c:v>196.87700000000001</c:v>
                </c:pt>
                <c:pt idx="45">
                  <c:v>203.03</c:v>
                </c:pt>
                <c:pt idx="46">
                  <c:v>203.297</c:v>
                </c:pt>
                <c:pt idx="47">
                  <c:v>209.18199999999999</c:v>
                </c:pt>
                <c:pt idx="48">
                  <c:v>213.667</c:v>
                </c:pt>
                <c:pt idx="49">
                  <c:v>215.33500000000001</c:v>
                </c:pt>
                <c:pt idx="50">
                  <c:v>221.48699999999999</c:v>
                </c:pt>
                <c:pt idx="51">
                  <c:v>221.78100000000001</c:v>
                </c:pt>
                <c:pt idx="52">
                  <c:v>227.64</c:v>
                </c:pt>
                <c:pt idx="53">
                  <c:v>233.792</c:v>
                </c:pt>
                <c:pt idx="54">
                  <c:v>236.815</c:v>
                </c:pt>
                <c:pt idx="55">
                  <c:v>239.94399999999999</c:v>
                </c:pt>
                <c:pt idx="56">
                  <c:v>246.09700000000001</c:v>
                </c:pt>
                <c:pt idx="57">
                  <c:v>252.249</c:v>
                </c:pt>
                <c:pt idx="58">
                  <c:v>252.708</c:v>
                </c:pt>
                <c:pt idx="59">
                  <c:v>258.40199999999999</c:v>
                </c:pt>
                <c:pt idx="60">
                  <c:v>259.72800000000001</c:v>
                </c:pt>
                <c:pt idx="61">
                  <c:v>264.55399999999997</c:v>
                </c:pt>
                <c:pt idx="62">
                  <c:v>270.70699999999999</c:v>
                </c:pt>
                <c:pt idx="63">
                  <c:v>271.14600000000002</c:v>
                </c:pt>
                <c:pt idx="64">
                  <c:v>276.85899999999998</c:v>
                </c:pt>
                <c:pt idx="65">
                  <c:v>283.01100000000002</c:v>
                </c:pt>
                <c:pt idx="66">
                  <c:v>289.16399999999999</c:v>
                </c:pt>
                <c:pt idx="67">
                  <c:v>293.56599999999997</c:v>
                </c:pt>
                <c:pt idx="68">
                  <c:v>295.31599999999997</c:v>
                </c:pt>
                <c:pt idx="69">
                  <c:v>298.75</c:v>
                </c:pt>
                <c:pt idx="70">
                  <c:v>301.46899999999999</c:v>
                </c:pt>
                <c:pt idx="71">
                  <c:v>307.62099999999998</c:v>
                </c:pt>
                <c:pt idx="72">
                  <c:v>313.77300000000002</c:v>
                </c:pt>
                <c:pt idx="73">
                  <c:v>315.43900000000002</c:v>
                </c:pt>
                <c:pt idx="74">
                  <c:v>319.92599999999999</c:v>
                </c:pt>
                <c:pt idx="75">
                  <c:v>326.07799999999997</c:v>
                </c:pt>
                <c:pt idx="76">
                  <c:v>332.23099999999999</c:v>
                </c:pt>
                <c:pt idx="77">
                  <c:v>336.20499999999998</c:v>
                </c:pt>
                <c:pt idx="78">
                  <c:v>338.38299999999998</c:v>
                </c:pt>
                <c:pt idx="79">
                  <c:v>344.536</c:v>
                </c:pt>
                <c:pt idx="80">
                  <c:v>350.68799999999999</c:v>
                </c:pt>
                <c:pt idx="81">
                  <c:v>351.08699999999999</c:v>
                </c:pt>
                <c:pt idx="82">
                  <c:v>356.84</c:v>
                </c:pt>
                <c:pt idx="83">
                  <c:v>362.22899999999998</c:v>
                </c:pt>
                <c:pt idx="84">
                  <c:v>362.99299999999999</c:v>
                </c:pt>
                <c:pt idx="85">
                  <c:v>369.14499999999998</c:v>
                </c:pt>
                <c:pt idx="86">
                  <c:v>372.488</c:v>
                </c:pt>
                <c:pt idx="87">
                  <c:v>375.298</c:v>
                </c:pt>
                <c:pt idx="88">
                  <c:v>381.45</c:v>
                </c:pt>
                <c:pt idx="89">
                  <c:v>387.46499999999997</c:v>
                </c:pt>
                <c:pt idx="90">
                  <c:v>387.60300000000001</c:v>
                </c:pt>
                <c:pt idx="91">
                  <c:v>393.755</c:v>
                </c:pt>
                <c:pt idx="92">
                  <c:v>399.90699999999998</c:v>
                </c:pt>
                <c:pt idx="93">
                  <c:v>406.06</c:v>
                </c:pt>
                <c:pt idx="94">
                  <c:v>407.49</c:v>
                </c:pt>
                <c:pt idx="95">
                  <c:v>412.21199999999999</c:v>
                </c:pt>
                <c:pt idx="96">
                  <c:v>417.15800000000002</c:v>
                </c:pt>
                <c:pt idx="97">
                  <c:v>418.36500000000001</c:v>
                </c:pt>
                <c:pt idx="98">
                  <c:v>424.517</c:v>
                </c:pt>
                <c:pt idx="99">
                  <c:v>430.66899999999998</c:v>
                </c:pt>
                <c:pt idx="100">
                  <c:v>436.822</c:v>
                </c:pt>
                <c:pt idx="101">
                  <c:v>442.47300000000001</c:v>
                </c:pt>
                <c:pt idx="102">
                  <c:v>442.97399999999999</c:v>
                </c:pt>
                <c:pt idx="103">
                  <c:v>449.12700000000001</c:v>
                </c:pt>
                <c:pt idx="104">
                  <c:v>455.279</c:v>
                </c:pt>
                <c:pt idx="105">
                  <c:v>460.18299999999999</c:v>
                </c:pt>
                <c:pt idx="106">
                  <c:v>461.43200000000002</c:v>
                </c:pt>
                <c:pt idx="107">
                  <c:v>467.584</c:v>
                </c:pt>
                <c:pt idx="108">
                  <c:v>471.20299999999997</c:v>
                </c:pt>
                <c:pt idx="109">
                  <c:v>473.73599999999999</c:v>
                </c:pt>
                <c:pt idx="110">
                  <c:v>479.88900000000001</c:v>
                </c:pt>
                <c:pt idx="111">
                  <c:v>482.16699999999997</c:v>
                </c:pt>
                <c:pt idx="112">
                  <c:v>486.041</c:v>
                </c:pt>
                <c:pt idx="113">
                  <c:v>490.57900000000001</c:v>
                </c:pt>
                <c:pt idx="114">
                  <c:v>492.19400000000002</c:v>
                </c:pt>
                <c:pt idx="115">
                  <c:v>498.346</c:v>
                </c:pt>
                <c:pt idx="116">
                  <c:v>504.12099999999998</c:v>
                </c:pt>
                <c:pt idx="117">
                  <c:v>504.49900000000002</c:v>
                </c:pt>
                <c:pt idx="118">
                  <c:v>510.65100000000001</c:v>
                </c:pt>
                <c:pt idx="119">
                  <c:v>514.87199999999996</c:v>
                </c:pt>
                <c:pt idx="120">
                  <c:v>516.803</c:v>
                </c:pt>
                <c:pt idx="121">
                  <c:v>522.95600000000002</c:v>
                </c:pt>
                <c:pt idx="122">
                  <c:v>524.93399999999997</c:v>
                </c:pt>
                <c:pt idx="123">
                  <c:v>529.10799999999995</c:v>
                </c:pt>
                <c:pt idx="124">
                  <c:v>530.59</c:v>
                </c:pt>
                <c:pt idx="125">
                  <c:v>531.1</c:v>
                </c:pt>
                <c:pt idx="126">
                  <c:v>532.58199999999999</c:v>
                </c:pt>
                <c:pt idx="127">
                  <c:v>535.26099999999997</c:v>
                </c:pt>
                <c:pt idx="128">
                  <c:v>539.976</c:v>
                </c:pt>
                <c:pt idx="129">
                  <c:v>541.41300000000001</c:v>
                </c:pt>
                <c:pt idx="130">
                  <c:v>547.56500000000005</c:v>
                </c:pt>
                <c:pt idx="131">
                  <c:v>553.71799999999996</c:v>
                </c:pt>
                <c:pt idx="132">
                  <c:v>554.35799999999995</c:v>
                </c:pt>
                <c:pt idx="133">
                  <c:v>559.87</c:v>
                </c:pt>
                <c:pt idx="134">
                  <c:v>566.02300000000002</c:v>
                </c:pt>
                <c:pt idx="135">
                  <c:v>572.17499999999995</c:v>
                </c:pt>
                <c:pt idx="136">
                  <c:v>578.32799999999997</c:v>
                </c:pt>
                <c:pt idx="137">
                  <c:v>582.83699999999999</c:v>
                </c:pt>
                <c:pt idx="138">
                  <c:v>584.48</c:v>
                </c:pt>
                <c:pt idx="139">
                  <c:v>590.63199999999995</c:v>
                </c:pt>
                <c:pt idx="140">
                  <c:v>591.87800000000004</c:v>
                </c:pt>
                <c:pt idx="141">
                  <c:v>595.79700000000003</c:v>
                </c:pt>
                <c:pt idx="142">
                  <c:v>596.78499999999997</c:v>
                </c:pt>
                <c:pt idx="143">
                  <c:v>597.92399999999998</c:v>
                </c:pt>
                <c:pt idx="144">
                  <c:v>602.93700000000001</c:v>
                </c:pt>
                <c:pt idx="145">
                  <c:v>609.09</c:v>
                </c:pt>
                <c:pt idx="146">
                  <c:v>611.93600000000004</c:v>
                </c:pt>
                <c:pt idx="147">
                  <c:v>615.24199999999996</c:v>
                </c:pt>
                <c:pt idx="148">
                  <c:v>621.39499999999998</c:v>
                </c:pt>
                <c:pt idx="149">
                  <c:v>625.22299999999996</c:v>
                </c:pt>
                <c:pt idx="150">
                  <c:v>627.54700000000003</c:v>
                </c:pt>
                <c:pt idx="151">
                  <c:v>633.69899999999996</c:v>
                </c:pt>
                <c:pt idx="152">
                  <c:v>634.90599999999995</c:v>
                </c:pt>
                <c:pt idx="153">
                  <c:v>636.96900000000005</c:v>
                </c:pt>
                <c:pt idx="154">
                  <c:v>639.04</c:v>
                </c:pt>
                <c:pt idx="155">
                  <c:v>639.85199999999998</c:v>
                </c:pt>
                <c:pt idx="156">
                  <c:v>641.13199999999995</c:v>
                </c:pt>
                <c:pt idx="157">
                  <c:v>645.40800000000002</c:v>
                </c:pt>
                <c:pt idx="158">
                  <c:v>646.00400000000002</c:v>
                </c:pt>
                <c:pt idx="159">
                  <c:v>651.68200000000002</c:v>
                </c:pt>
                <c:pt idx="160">
                  <c:v>652.15700000000004</c:v>
                </c:pt>
                <c:pt idx="161">
                  <c:v>658.30899999999997</c:v>
                </c:pt>
                <c:pt idx="162">
                  <c:v>658.73299999999995</c:v>
                </c:pt>
                <c:pt idx="163">
                  <c:v>664.46100000000001</c:v>
                </c:pt>
                <c:pt idx="164">
                  <c:v>670.61400000000003</c:v>
                </c:pt>
                <c:pt idx="165">
                  <c:v>676.76599999999996</c:v>
                </c:pt>
                <c:pt idx="166">
                  <c:v>682.91899999999998</c:v>
                </c:pt>
                <c:pt idx="167">
                  <c:v>686.399</c:v>
                </c:pt>
                <c:pt idx="168">
                  <c:v>689.07100000000003</c:v>
                </c:pt>
                <c:pt idx="169">
                  <c:v>695.22400000000005</c:v>
                </c:pt>
                <c:pt idx="170">
                  <c:v>699.60599999999999</c:v>
                </c:pt>
                <c:pt idx="171">
                  <c:v>701.37599999999998</c:v>
                </c:pt>
                <c:pt idx="172">
                  <c:v>704.77</c:v>
                </c:pt>
                <c:pt idx="173">
                  <c:v>706.89700000000005</c:v>
                </c:pt>
                <c:pt idx="174">
                  <c:v>707.52800000000002</c:v>
                </c:pt>
                <c:pt idx="175">
                  <c:v>709.024</c:v>
                </c:pt>
                <c:pt idx="176">
                  <c:v>713.68100000000004</c:v>
                </c:pt>
                <c:pt idx="177">
                  <c:v>713.85599999999999</c:v>
                </c:pt>
                <c:pt idx="178">
                  <c:v>719.26</c:v>
                </c:pt>
                <c:pt idx="179">
                  <c:v>719.399</c:v>
                </c:pt>
                <c:pt idx="180">
                  <c:v>719.83299999999997</c:v>
                </c:pt>
                <c:pt idx="181">
                  <c:v>721.82899999999995</c:v>
                </c:pt>
                <c:pt idx="182">
                  <c:v>725.98599999999999</c:v>
                </c:pt>
                <c:pt idx="183">
                  <c:v>727.46299999999997</c:v>
                </c:pt>
                <c:pt idx="184">
                  <c:v>728.67</c:v>
                </c:pt>
                <c:pt idx="185">
                  <c:v>732.13800000000003</c:v>
                </c:pt>
                <c:pt idx="186">
                  <c:v>733.79100000000005</c:v>
                </c:pt>
                <c:pt idx="187">
                  <c:v>738.29100000000005</c:v>
                </c:pt>
                <c:pt idx="188">
                  <c:v>742.06399999999996</c:v>
                </c:pt>
                <c:pt idx="189">
                  <c:v>744.44299999999998</c:v>
                </c:pt>
                <c:pt idx="190">
                  <c:v>748.97299999999996</c:v>
                </c:pt>
                <c:pt idx="191">
                  <c:v>750.59500000000003</c:v>
                </c:pt>
                <c:pt idx="192">
                  <c:v>754.00699999999995</c:v>
                </c:pt>
                <c:pt idx="193">
                  <c:v>756.74800000000005</c:v>
                </c:pt>
                <c:pt idx="194">
                  <c:v>757.81600000000003</c:v>
                </c:pt>
                <c:pt idx="195">
                  <c:v>759.78899999999999</c:v>
                </c:pt>
                <c:pt idx="196">
                  <c:v>762.05600000000004</c:v>
                </c:pt>
                <c:pt idx="197">
                  <c:v>762.9</c:v>
                </c:pt>
                <c:pt idx="198">
                  <c:v>766.702</c:v>
                </c:pt>
                <c:pt idx="199">
                  <c:v>767.25800000000004</c:v>
                </c:pt>
                <c:pt idx="200">
                  <c:v>767.66200000000003</c:v>
                </c:pt>
                <c:pt idx="201">
                  <c:v>769.053</c:v>
                </c:pt>
                <c:pt idx="202">
                  <c:v>769.10699999999997</c:v>
                </c:pt>
                <c:pt idx="203">
                  <c:v>771.19</c:v>
                </c:pt>
                <c:pt idx="204">
                  <c:v>774.81200000000001</c:v>
                </c:pt>
                <c:pt idx="205">
                  <c:v>775.20500000000004</c:v>
                </c:pt>
                <c:pt idx="206">
                  <c:v>781.35799999999995</c:v>
                </c:pt>
                <c:pt idx="207">
                  <c:v>786.774</c:v>
                </c:pt>
                <c:pt idx="208">
                  <c:v>787.51</c:v>
                </c:pt>
                <c:pt idx="209">
                  <c:v>793.66200000000003</c:v>
                </c:pt>
                <c:pt idx="210">
                  <c:v>796.73099999999999</c:v>
                </c:pt>
                <c:pt idx="211">
                  <c:v>799.81500000000005</c:v>
                </c:pt>
                <c:pt idx="212">
                  <c:v>805.10599999999999</c:v>
                </c:pt>
                <c:pt idx="213">
                  <c:v>805.74699999999996</c:v>
                </c:pt>
                <c:pt idx="214">
                  <c:v>805.96699999999998</c:v>
                </c:pt>
                <c:pt idx="215">
                  <c:v>812.12</c:v>
                </c:pt>
                <c:pt idx="216">
                  <c:v>818.12099999999998</c:v>
                </c:pt>
                <c:pt idx="217">
                  <c:v>818.25</c:v>
                </c:pt>
                <c:pt idx="218">
                  <c:v>818.27200000000005</c:v>
                </c:pt>
                <c:pt idx="219">
                  <c:v>819.20899999999995</c:v>
                </c:pt>
                <c:pt idx="220">
                  <c:v>820.46600000000001</c:v>
                </c:pt>
                <c:pt idx="221">
                  <c:v>821.19100000000003</c:v>
                </c:pt>
                <c:pt idx="222">
                  <c:v>821.76800000000003</c:v>
                </c:pt>
                <c:pt idx="223">
                  <c:v>822.75199999999995</c:v>
                </c:pt>
                <c:pt idx="224">
                  <c:v>824.42399999999998</c:v>
                </c:pt>
                <c:pt idx="225">
                  <c:v>825.40800000000002</c:v>
                </c:pt>
                <c:pt idx="226">
                  <c:v>827.41899999999998</c:v>
                </c:pt>
                <c:pt idx="227">
                  <c:v>828.62400000000002</c:v>
                </c:pt>
                <c:pt idx="228">
                  <c:v>830.577</c:v>
                </c:pt>
                <c:pt idx="229">
                  <c:v>832.98699999999997</c:v>
                </c:pt>
                <c:pt idx="230">
                  <c:v>836.72900000000004</c:v>
                </c:pt>
                <c:pt idx="231">
                  <c:v>838.86699999999996</c:v>
                </c:pt>
                <c:pt idx="232">
                  <c:v>842.88199999999995</c:v>
                </c:pt>
                <c:pt idx="233">
                  <c:v>849.03399999999999</c:v>
                </c:pt>
                <c:pt idx="234">
                  <c:v>851.38599999999997</c:v>
                </c:pt>
                <c:pt idx="235">
                  <c:v>855.18700000000001</c:v>
                </c:pt>
                <c:pt idx="236">
                  <c:v>859.71799999999996</c:v>
                </c:pt>
                <c:pt idx="237">
                  <c:v>861.33900000000006</c:v>
                </c:pt>
                <c:pt idx="238">
                  <c:v>862.43</c:v>
                </c:pt>
                <c:pt idx="239">
                  <c:v>865.56600000000003</c:v>
                </c:pt>
                <c:pt idx="240">
                  <c:v>866.83299999999997</c:v>
                </c:pt>
                <c:pt idx="241">
                  <c:v>867.49099999999999</c:v>
                </c:pt>
                <c:pt idx="242">
                  <c:v>868.93700000000001</c:v>
                </c:pt>
                <c:pt idx="243">
                  <c:v>870.52700000000004</c:v>
                </c:pt>
                <c:pt idx="244">
                  <c:v>871.96400000000006</c:v>
                </c:pt>
                <c:pt idx="245">
                  <c:v>873.36199999999997</c:v>
                </c:pt>
                <c:pt idx="246">
                  <c:v>873.64400000000001</c:v>
                </c:pt>
                <c:pt idx="247">
                  <c:v>876.34299999999996</c:v>
                </c:pt>
                <c:pt idx="248">
                  <c:v>879.79600000000005</c:v>
                </c:pt>
                <c:pt idx="249">
                  <c:v>881.13300000000004</c:v>
                </c:pt>
                <c:pt idx="250">
                  <c:v>884.96699999999998</c:v>
                </c:pt>
                <c:pt idx="251">
                  <c:v>885.94899999999996</c:v>
                </c:pt>
                <c:pt idx="252">
                  <c:v>888.80100000000004</c:v>
                </c:pt>
                <c:pt idx="253">
                  <c:v>891.14800000000002</c:v>
                </c:pt>
                <c:pt idx="254">
                  <c:v>892.101</c:v>
                </c:pt>
                <c:pt idx="255">
                  <c:v>892.601</c:v>
                </c:pt>
                <c:pt idx="256">
                  <c:v>894.154</c:v>
                </c:pt>
                <c:pt idx="257">
                  <c:v>898.25400000000002</c:v>
                </c:pt>
                <c:pt idx="258">
                  <c:v>904.40599999999995</c:v>
                </c:pt>
                <c:pt idx="259">
                  <c:v>905.33600000000001</c:v>
                </c:pt>
                <c:pt idx="260">
                  <c:v>909.58299999999997</c:v>
                </c:pt>
                <c:pt idx="261">
                  <c:v>910.55799999999999</c:v>
                </c:pt>
                <c:pt idx="262">
                  <c:v>912.27800000000002</c:v>
                </c:pt>
                <c:pt idx="263">
                  <c:v>916.20299999999997</c:v>
                </c:pt>
                <c:pt idx="264">
                  <c:v>916.65</c:v>
                </c:pt>
                <c:pt idx="265">
                  <c:v>916.71100000000001</c:v>
                </c:pt>
                <c:pt idx="266">
                  <c:v>917.14700000000005</c:v>
                </c:pt>
                <c:pt idx="267">
                  <c:v>919.07600000000002</c:v>
                </c:pt>
                <c:pt idx="268">
                  <c:v>922.46</c:v>
                </c:pt>
                <c:pt idx="269">
                  <c:v>922.86300000000006</c:v>
                </c:pt>
                <c:pt idx="270">
                  <c:v>924.35400000000004</c:v>
                </c:pt>
                <c:pt idx="271">
                  <c:v>925.77700000000004</c:v>
                </c:pt>
                <c:pt idx="272">
                  <c:v>926.34799999999996</c:v>
                </c:pt>
                <c:pt idx="273">
                  <c:v>926.91899999999998</c:v>
                </c:pt>
                <c:pt idx="274">
                  <c:v>927.75699999999995</c:v>
                </c:pt>
                <c:pt idx="275">
                  <c:v>928.69100000000003</c:v>
                </c:pt>
                <c:pt idx="276">
                  <c:v>929.01599999999996</c:v>
                </c:pt>
                <c:pt idx="277">
                  <c:v>932.25099999999998</c:v>
                </c:pt>
                <c:pt idx="278">
                  <c:v>935.16800000000001</c:v>
                </c:pt>
                <c:pt idx="279">
                  <c:v>939.96400000000006</c:v>
                </c:pt>
                <c:pt idx="280">
                  <c:v>941.32</c:v>
                </c:pt>
                <c:pt idx="281">
                  <c:v>945.88099999999997</c:v>
                </c:pt>
                <c:pt idx="282">
                  <c:v>947.12599999999998</c:v>
                </c:pt>
                <c:pt idx="283">
                  <c:v>947.47299999999996</c:v>
                </c:pt>
                <c:pt idx="284">
                  <c:v>949.91300000000001</c:v>
                </c:pt>
                <c:pt idx="285">
                  <c:v>952.55799999999999</c:v>
                </c:pt>
                <c:pt idx="286">
                  <c:v>953.625</c:v>
                </c:pt>
                <c:pt idx="287">
                  <c:v>958.21</c:v>
                </c:pt>
                <c:pt idx="288">
                  <c:v>959.77800000000002</c:v>
                </c:pt>
                <c:pt idx="289">
                  <c:v>961.66499999999996</c:v>
                </c:pt>
                <c:pt idx="290">
                  <c:v>963.16399999999999</c:v>
                </c:pt>
                <c:pt idx="291">
                  <c:v>965.93</c:v>
                </c:pt>
                <c:pt idx="292">
                  <c:v>966.22500000000002</c:v>
                </c:pt>
                <c:pt idx="293">
                  <c:v>969.71100000000001</c:v>
                </c:pt>
                <c:pt idx="294">
                  <c:v>972.053</c:v>
                </c:pt>
                <c:pt idx="295">
                  <c:v>972.08299999999997</c:v>
                </c:pt>
                <c:pt idx="296">
                  <c:v>973.66499999999996</c:v>
                </c:pt>
                <c:pt idx="297">
                  <c:v>975.58199999999999</c:v>
                </c:pt>
                <c:pt idx="298">
                  <c:v>977.89599999999996</c:v>
                </c:pt>
                <c:pt idx="299">
                  <c:v>978.23500000000001</c:v>
                </c:pt>
                <c:pt idx="300">
                  <c:v>980.20299999999997</c:v>
                </c:pt>
                <c:pt idx="301">
                  <c:v>981.89300000000003</c:v>
                </c:pt>
                <c:pt idx="302">
                  <c:v>984.38699999999994</c:v>
                </c:pt>
                <c:pt idx="303">
                  <c:v>990.54</c:v>
                </c:pt>
                <c:pt idx="304">
                  <c:v>993.32799999999997</c:v>
                </c:pt>
                <c:pt idx="305">
                  <c:v>994.98599999999999</c:v>
                </c:pt>
                <c:pt idx="306">
                  <c:v>995.77099999999996</c:v>
                </c:pt>
                <c:pt idx="307">
                  <c:v>996.29499999999996</c:v>
                </c:pt>
                <c:pt idx="308">
                  <c:v>996.68299999999999</c:v>
                </c:pt>
                <c:pt idx="309">
                  <c:v>996.69200000000001</c:v>
                </c:pt>
                <c:pt idx="310">
                  <c:v>996.85199999999998</c:v>
                </c:pt>
                <c:pt idx="311">
                  <c:v>998.91700000000003</c:v>
                </c:pt>
                <c:pt idx="312">
                  <c:v>1002.845</c:v>
                </c:pt>
                <c:pt idx="313">
                  <c:v>1003.78</c:v>
                </c:pt>
                <c:pt idx="314">
                  <c:v>1008.3049999999999</c:v>
                </c:pt>
                <c:pt idx="315">
                  <c:v>1008.997</c:v>
                </c:pt>
                <c:pt idx="316">
                  <c:v>1009.192</c:v>
                </c:pt>
                <c:pt idx="317">
                  <c:v>1010.282</c:v>
                </c:pt>
                <c:pt idx="318">
                  <c:v>1012.857</c:v>
                </c:pt>
                <c:pt idx="319">
                  <c:v>1014.486</c:v>
                </c:pt>
                <c:pt idx="320">
                  <c:v>1014.651</c:v>
                </c:pt>
                <c:pt idx="321">
                  <c:v>1015.15</c:v>
                </c:pt>
                <c:pt idx="322">
                  <c:v>1015.984</c:v>
                </c:pt>
                <c:pt idx="323">
                  <c:v>1017.157</c:v>
                </c:pt>
                <c:pt idx="324">
                  <c:v>1018.4640000000001</c:v>
                </c:pt>
                <c:pt idx="325">
                  <c:v>1020.43</c:v>
                </c:pt>
                <c:pt idx="326">
                  <c:v>1021.302</c:v>
                </c:pt>
                <c:pt idx="327">
                  <c:v>1023.609</c:v>
                </c:pt>
                <c:pt idx="328">
                  <c:v>1026.664</c:v>
                </c:pt>
                <c:pt idx="329">
                  <c:v>1027.454</c:v>
                </c:pt>
                <c:pt idx="330">
                  <c:v>1028.2819999999999</c:v>
                </c:pt>
                <c:pt idx="331">
                  <c:v>1029.644</c:v>
                </c:pt>
                <c:pt idx="332">
                  <c:v>1030.4839999999999</c:v>
                </c:pt>
                <c:pt idx="333">
                  <c:v>1032.9949999999999</c:v>
                </c:pt>
                <c:pt idx="334">
                  <c:v>1033.607</c:v>
                </c:pt>
                <c:pt idx="335">
                  <c:v>1037.4780000000001</c:v>
                </c:pt>
                <c:pt idx="336">
                  <c:v>1039.759</c:v>
                </c:pt>
                <c:pt idx="337">
                  <c:v>1043.587</c:v>
                </c:pt>
                <c:pt idx="338">
                  <c:v>1043.875</c:v>
                </c:pt>
                <c:pt idx="339">
                  <c:v>1044.163</c:v>
                </c:pt>
                <c:pt idx="340">
                  <c:v>1044.5139999999999</c:v>
                </c:pt>
                <c:pt idx="341">
                  <c:v>1045.912</c:v>
                </c:pt>
                <c:pt idx="342">
                  <c:v>1046.048</c:v>
                </c:pt>
                <c:pt idx="343">
                  <c:v>1052.0640000000001</c:v>
                </c:pt>
                <c:pt idx="344">
                  <c:v>1057.0440000000001</c:v>
                </c:pt>
                <c:pt idx="345">
                  <c:v>1058.2159999999999</c:v>
                </c:pt>
                <c:pt idx="346">
                  <c:v>1058.8599999999999</c:v>
                </c:pt>
                <c:pt idx="347">
                  <c:v>1060.6559999999999</c:v>
                </c:pt>
                <c:pt idx="348">
                  <c:v>1064.3689999999999</c:v>
                </c:pt>
                <c:pt idx="349">
                  <c:v>1068.3789999999999</c:v>
                </c:pt>
                <c:pt idx="350">
                  <c:v>1070.521</c:v>
                </c:pt>
                <c:pt idx="351">
                  <c:v>1072.325</c:v>
                </c:pt>
                <c:pt idx="352">
                  <c:v>1075.7280000000001</c:v>
                </c:pt>
                <c:pt idx="353">
                  <c:v>1075.7380000000001</c:v>
                </c:pt>
                <c:pt idx="354">
                  <c:v>1076.674</c:v>
                </c:pt>
                <c:pt idx="355">
                  <c:v>1078.692</c:v>
                </c:pt>
                <c:pt idx="356">
                  <c:v>1082.826</c:v>
                </c:pt>
                <c:pt idx="357">
                  <c:v>1088.979</c:v>
                </c:pt>
                <c:pt idx="358">
                  <c:v>1095.1310000000001</c:v>
                </c:pt>
                <c:pt idx="359">
                  <c:v>1095.433</c:v>
                </c:pt>
                <c:pt idx="360">
                  <c:v>1098.0440000000001</c:v>
                </c:pt>
                <c:pt idx="361">
                  <c:v>1099.796</c:v>
                </c:pt>
                <c:pt idx="362">
                  <c:v>1100.587</c:v>
                </c:pt>
                <c:pt idx="363">
                  <c:v>1100.9290000000001</c:v>
                </c:pt>
                <c:pt idx="364">
                  <c:v>1101.2829999999999</c:v>
                </c:pt>
                <c:pt idx="365">
                  <c:v>1101.663</c:v>
                </c:pt>
                <c:pt idx="366">
                  <c:v>1104.8150000000001</c:v>
                </c:pt>
                <c:pt idx="367">
                  <c:v>1107.4359999999999</c:v>
                </c:pt>
                <c:pt idx="368">
                  <c:v>1112.856</c:v>
                </c:pt>
                <c:pt idx="369">
                  <c:v>1113.588</c:v>
                </c:pt>
                <c:pt idx="370">
                  <c:v>1119.741</c:v>
                </c:pt>
                <c:pt idx="371">
                  <c:v>1122.876</c:v>
                </c:pt>
                <c:pt idx="372">
                  <c:v>1125.893</c:v>
                </c:pt>
                <c:pt idx="373">
                  <c:v>1127.9949999999999</c:v>
                </c:pt>
                <c:pt idx="374">
                  <c:v>1132.046</c:v>
                </c:pt>
                <c:pt idx="375">
                  <c:v>1132.5999999999999</c:v>
                </c:pt>
                <c:pt idx="376">
                  <c:v>1136.9390000000001</c:v>
                </c:pt>
                <c:pt idx="377">
                  <c:v>1138.1980000000001</c:v>
                </c:pt>
                <c:pt idx="378">
                  <c:v>1140.5650000000001</c:v>
                </c:pt>
                <c:pt idx="379">
                  <c:v>1142.4659999999999</c:v>
                </c:pt>
                <c:pt idx="380">
                  <c:v>1144.3499999999999</c:v>
                </c:pt>
                <c:pt idx="381">
                  <c:v>1146.1099999999999</c:v>
                </c:pt>
                <c:pt idx="382">
                  <c:v>1150.5029999999999</c:v>
                </c:pt>
                <c:pt idx="383">
                  <c:v>1155.634</c:v>
                </c:pt>
                <c:pt idx="384">
                  <c:v>1156.655</c:v>
                </c:pt>
                <c:pt idx="385">
                  <c:v>1162.808</c:v>
                </c:pt>
                <c:pt idx="386">
                  <c:v>1165.009</c:v>
                </c:pt>
                <c:pt idx="387">
                  <c:v>1167.326</c:v>
                </c:pt>
                <c:pt idx="388">
                  <c:v>1168.96</c:v>
                </c:pt>
                <c:pt idx="389">
                  <c:v>1169.252</c:v>
                </c:pt>
                <c:pt idx="390">
                  <c:v>1175.1120000000001</c:v>
                </c:pt>
                <c:pt idx="391">
                  <c:v>1181.2650000000001</c:v>
                </c:pt>
                <c:pt idx="392">
                  <c:v>1186.9690000000001</c:v>
                </c:pt>
                <c:pt idx="393">
                  <c:v>1187.4169999999999</c:v>
                </c:pt>
                <c:pt idx="394">
                  <c:v>1193.57</c:v>
                </c:pt>
                <c:pt idx="395">
                  <c:v>1199.722</c:v>
                </c:pt>
                <c:pt idx="396">
                  <c:v>1205.875</c:v>
                </c:pt>
                <c:pt idx="397">
                  <c:v>1212.027</c:v>
                </c:pt>
                <c:pt idx="398">
                  <c:v>1218.1790000000001</c:v>
                </c:pt>
                <c:pt idx="399">
                  <c:v>1224.3320000000001</c:v>
                </c:pt>
                <c:pt idx="400">
                  <c:v>1230.4839999999999</c:v>
                </c:pt>
                <c:pt idx="401">
                  <c:v>1230.4839999999999</c:v>
                </c:pt>
              </c:numCache>
            </c:numRef>
          </c:xVal>
          <c:yVal>
            <c:numRef>
              <c:f>Foglio6!$L$1227:$L$1628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99.914000000000001</c:v>
                </c:pt>
                <c:pt idx="11">
                  <c:v>99.807000000000002</c:v>
                </c:pt>
                <c:pt idx="12">
                  <c:v>99.698999999999998</c:v>
                </c:pt>
                <c:pt idx="13">
                  <c:v>99.501999999999995</c:v>
                </c:pt>
                <c:pt idx="14">
                  <c:v>99.5</c:v>
                </c:pt>
                <c:pt idx="15">
                  <c:v>99.185000000000002</c:v>
                </c:pt>
                <c:pt idx="16">
                  <c:v>99</c:v>
                </c:pt>
                <c:pt idx="17">
                  <c:v>98.921999999999997</c:v>
                </c:pt>
                <c:pt idx="18">
                  <c:v>98.709000000000003</c:v>
                </c:pt>
                <c:pt idx="19">
                  <c:v>98.5</c:v>
                </c:pt>
                <c:pt idx="20">
                  <c:v>98.484999999999999</c:v>
                </c:pt>
                <c:pt idx="21">
                  <c:v>98.23</c:v>
                </c:pt>
                <c:pt idx="22">
                  <c:v>98.013999999999996</c:v>
                </c:pt>
                <c:pt idx="23">
                  <c:v>98</c:v>
                </c:pt>
                <c:pt idx="24">
                  <c:v>97.852000000000004</c:v>
                </c:pt>
                <c:pt idx="25">
                  <c:v>97.632000000000005</c:v>
                </c:pt>
                <c:pt idx="26">
                  <c:v>97.5</c:v>
                </c:pt>
                <c:pt idx="27">
                  <c:v>97</c:v>
                </c:pt>
                <c:pt idx="28">
                  <c:v>96.991</c:v>
                </c:pt>
                <c:pt idx="29">
                  <c:v>96.551000000000002</c:v>
                </c:pt>
                <c:pt idx="30">
                  <c:v>96.516999999999996</c:v>
                </c:pt>
                <c:pt idx="31">
                  <c:v>96.5</c:v>
                </c:pt>
                <c:pt idx="32">
                  <c:v>96.481999999999999</c:v>
                </c:pt>
                <c:pt idx="33">
                  <c:v>96.447000000000003</c:v>
                </c:pt>
                <c:pt idx="34">
                  <c:v>96.076999999999998</c:v>
                </c:pt>
                <c:pt idx="35">
                  <c:v>96</c:v>
                </c:pt>
                <c:pt idx="36">
                  <c:v>95.7</c:v>
                </c:pt>
                <c:pt idx="37">
                  <c:v>95.5</c:v>
                </c:pt>
                <c:pt idx="38">
                  <c:v>95.41</c:v>
                </c:pt>
                <c:pt idx="39">
                  <c:v>95.177000000000007</c:v>
                </c:pt>
                <c:pt idx="40">
                  <c:v>95</c:v>
                </c:pt>
                <c:pt idx="41">
                  <c:v>94.632999999999996</c:v>
                </c:pt>
                <c:pt idx="42">
                  <c:v>94.5</c:v>
                </c:pt>
                <c:pt idx="43">
                  <c:v>94.463999999999999</c:v>
                </c:pt>
                <c:pt idx="44">
                  <c:v>94.296000000000006</c:v>
                </c:pt>
                <c:pt idx="45">
                  <c:v>94.034999999999997</c:v>
                </c:pt>
                <c:pt idx="46">
                  <c:v>94</c:v>
                </c:pt>
                <c:pt idx="47">
                  <c:v>93.748000000000005</c:v>
                </c:pt>
                <c:pt idx="48">
                  <c:v>93.5</c:v>
                </c:pt>
                <c:pt idx="49">
                  <c:v>93.284999999999997</c:v>
                </c:pt>
                <c:pt idx="50">
                  <c:v>93.010999999999996</c:v>
                </c:pt>
                <c:pt idx="51">
                  <c:v>93</c:v>
                </c:pt>
                <c:pt idx="52">
                  <c:v>92.775999999999996</c:v>
                </c:pt>
                <c:pt idx="53">
                  <c:v>92.575999999999993</c:v>
                </c:pt>
                <c:pt idx="54">
                  <c:v>92.5</c:v>
                </c:pt>
                <c:pt idx="55">
                  <c:v>92.421999999999997</c:v>
                </c:pt>
                <c:pt idx="56">
                  <c:v>92.268000000000001</c:v>
                </c:pt>
                <c:pt idx="57">
                  <c:v>92.028000000000006</c:v>
                </c:pt>
                <c:pt idx="58">
                  <c:v>92</c:v>
                </c:pt>
                <c:pt idx="59">
                  <c:v>91.575000000000003</c:v>
                </c:pt>
                <c:pt idx="60">
                  <c:v>91.5</c:v>
                </c:pt>
                <c:pt idx="61">
                  <c:v>91.299000000000007</c:v>
                </c:pt>
                <c:pt idx="62">
                  <c:v>91.022000000000006</c:v>
                </c:pt>
                <c:pt idx="63">
                  <c:v>91</c:v>
                </c:pt>
                <c:pt idx="64">
                  <c:v>90.796000000000006</c:v>
                </c:pt>
                <c:pt idx="65">
                  <c:v>90.686999999999998</c:v>
                </c:pt>
                <c:pt idx="66">
                  <c:v>90.578000000000003</c:v>
                </c:pt>
                <c:pt idx="67">
                  <c:v>90.5</c:v>
                </c:pt>
                <c:pt idx="68">
                  <c:v>90.468999999999994</c:v>
                </c:pt>
                <c:pt idx="69">
                  <c:v>90</c:v>
                </c:pt>
                <c:pt idx="70">
                  <c:v>89.85</c:v>
                </c:pt>
                <c:pt idx="71">
                  <c:v>89.614000000000004</c:v>
                </c:pt>
                <c:pt idx="72">
                  <c:v>89.516999999999996</c:v>
                </c:pt>
                <c:pt idx="73">
                  <c:v>89.5</c:v>
                </c:pt>
                <c:pt idx="74">
                  <c:v>89.453000000000003</c:v>
                </c:pt>
                <c:pt idx="75">
                  <c:v>89.388999999999996</c:v>
                </c:pt>
                <c:pt idx="76">
                  <c:v>89.212000000000003</c:v>
                </c:pt>
                <c:pt idx="77">
                  <c:v>89</c:v>
                </c:pt>
                <c:pt idx="78">
                  <c:v>88.926000000000002</c:v>
                </c:pt>
                <c:pt idx="79">
                  <c:v>88.72</c:v>
                </c:pt>
                <c:pt idx="80">
                  <c:v>88.513000000000005</c:v>
                </c:pt>
                <c:pt idx="81">
                  <c:v>88.5</c:v>
                </c:pt>
                <c:pt idx="82">
                  <c:v>88.307000000000002</c:v>
                </c:pt>
                <c:pt idx="83">
                  <c:v>88</c:v>
                </c:pt>
                <c:pt idx="84">
                  <c:v>87.944000000000003</c:v>
                </c:pt>
                <c:pt idx="85">
                  <c:v>87.614000000000004</c:v>
                </c:pt>
                <c:pt idx="86">
                  <c:v>87.5</c:v>
                </c:pt>
                <c:pt idx="87">
                  <c:v>87.402000000000001</c:v>
                </c:pt>
                <c:pt idx="88">
                  <c:v>87.186999999999998</c:v>
                </c:pt>
                <c:pt idx="89">
                  <c:v>87</c:v>
                </c:pt>
                <c:pt idx="90">
                  <c:v>86.997</c:v>
                </c:pt>
                <c:pt idx="91">
                  <c:v>86.847999999999999</c:v>
                </c:pt>
                <c:pt idx="92">
                  <c:v>86.7</c:v>
                </c:pt>
                <c:pt idx="93">
                  <c:v>86.552000000000007</c:v>
                </c:pt>
                <c:pt idx="94">
                  <c:v>86.5</c:v>
                </c:pt>
                <c:pt idx="95">
                  <c:v>86.293999999999997</c:v>
                </c:pt>
                <c:pt idx="96">
                  <c:v>86</c:v>
                </c:pt>
                <c:pt idx="97">
                  <c:v>85.921999999999997</c:v>
                </c:pt>
                <c:pt idx="98">
                  <c:v>85.796999999999997</c:v>
                </c:pt>
                <c:pt idx="99">
                  <c:v>85.7</c:v>
                </c:pt>
                <c:pt idx="100">
                  <c:v>85.596999999999994</c:v>
                </c:pt>
                <c:pt idx="101">
                  <c:v>85.5</c:v>
                </c:pt>
                <c:pt idx="102">
                  <c:v>85.491</c:v>
                </c:pt>
                <c:pt idx="103">
                  <c:v>85.418999999999997</c:v>
                </c:pt>
                <c:pt idx="104">
                  <c:v>85.37</c:v>
                </c:pt>
                <c:pt idx="105">
                  <c:v>85</c:v>
                </c:pt>
                <c:pt idx="106">
                  <c:v>84.866</c:v>
                </c:pt>
                <c:pt idx="107">
                  <c:v>84.616</c:v>
                </c:pt>
                <c:pt idx="108">
                  <c:v>84.5</c:v>
                </c:pt>
                <c:pt idx="109">
                  <c:v>84.411000000000001</c:v>
                </c:pt>
                <c:pt idx="110">
                  <c:v>84.141999999999996</c:v>
                </c:pt>
                <c:pt idx="111">
                  <c:v>84</c:v>
                </c:pt>
                <c:pt idx="112">
                  <c:v>83.712999999999994</c:v>
                </c:pt>
                <c:pt idx="113">
                  <c:v>83.5</c:v>
                </c:pt>
                <c:pt idx="114">
                  <c:v>83.44</c:v>
                </c:pt>
                <c:pt idx="115">
                  <c:v>83.212999999999994</c:v>
                </c:pt>
                <c:pt idx="116">
                  <c:v>83</c:v>
                </c:pt>
                <c:pt idx="117">
                  <c:v>82.986000000000004</c:v>
                </c:pt>
                <c:pt idx="118">
                  <c:v>82.71</c:v>
                </c:pt>
                <c:pt idx="119">
                  <c:v>82.5</c:v>
                </c:pt>
                <c:pt idx="120">
                  <c:v>82.403999999999996</c:v>
                </c:pt>
                <c:pt idx="121">
                  <c:v>82.097999999999999</c:v>
                </c:pt>
                <c:pt idx="122">
                  <c:v>82</c:v>
                </c:pt>
                <c:pt idx="123">
                  <c:v>81.793000000000006</c:v>
                </c:pt>
                <c:pt idx="124">
                  <c:v>81.5</c:v>
                </c:pt>
                <c:pt idx="125">
                  <c:v>81</c:v>
                </c:pt>
                <c:pt idx="126">
                  <c:v>80.5</c:v>
                </c:pt>
                <c:pt idx="127">
                  <c:v>80.319000000000003</c:v>
                </c:pt>
                <c:pt idx="128">
                  <c:v>80</c:v>
                </c:pt>
                <c:pt idx="129">
                  <c:v>79.903000000000006</c:v>
                </c:pt>
                <c:pt idx="130">
                  <c:v>79.575000000000003</c:v>
                </c:pt>
                <c:pt idx="131">
                  <c:v>79.504999999999995</c:v>
                </c:pt>
                <c:pt idx="132">
                  <c:v>79.5</c:v>
                </c:pt>
                <c:pt idx="133">
                  <c:v>79.453999999999994</c:v>
                </c:pt>
                <c:pt idx="134">
                  <c:v>79.433999999999997</c:v>
                </c:pt>
                <c:pt idx="135">
                  <c:v>79.42</c:v>
                </c:pt>
                <c:pt idx="136">
                  <c:v>79.257000000000005</c:v>
                </c:pt>
                <c:pt idx="137">
                  <c:v>79</c:v>
                </c:pt>
                <c:pt idx="138">
                  <c:v>78.893000000000001</c:v>
                </c:pt>
                <c:pt idx="139">
                  <c:v>78.56</c:v>
                </c:pt>
                <c:pt idx="140">
                  <c:v>78.5</c:v>
                </c:pt>
                <c:pt idx="141">
                  <c:v>78</c:v>
                </c:pt>
                <c:pt idx="142">
                  <c:v>77.742999999999995</c:v>
                </c:pt>
                <c:pt idx="143">
                  <c:v>77.5</c:v>
                </c:pt>
                <c:pt idx="144">
                  <c:v>77.22</c:v>
                </c:pt>
                <c:pt idx="145">
                  <c:v>77.069999999999993</c:v>
                </c:pt>
                <c:pt idx="146">
                  <c:v>77</c:v>
                </c:pt>
                <c:pt idx="147">
                  <c:v>76.918999999999997</c:v>
                </c:pt>
                <c:pt idx="148">
                  <c:v>76.641000000000005</c:v>
                </c:pt>
                <c:pt idx="149">
                  <c:v>76.5</c:v>
                </c:pt>
                <c:pt idx="150">
                  <c:v>76.414000000000001</c:v>
                </c:pt>
                <c:pt idx="151">
                  <c:v>76.186999999999998</c:v>
                </c:pt>
                <c:pt idx="152">
                  <c:v>76</c:v>
                </c:pt>
                <c:pt idx="153">
                  <c:v>75.5</c:v>
                </c:pt>
                <c:pt idx="154">
                  <c:v>75</c:v>
                </c:pt>
                <c:pt idx="155">
                  <c:v>74.805999999999997</c:v>
                </c:pt>
                <c:pt idx="156">
                  <c:v>74.5</c:v>
                </c:pt>
                <c:pt idx="157">
                  <c:v>74</c:v>
                </c:pt>
                <c:pt idx="158">
                  <c:v>73.930999999999997</c:v>
                </c:pt>
                <c:pt idx="159">
                  <c:v>73.5</c:v>
                </c:pt>
                <c:pt idx="160">
                  <c:v>73.465999999999994</c:v>
                </c:pt>
                <c:pt idx="161">
                  <c:v>73.03</c:v>
                </c:pt>
                <c:pt idx="162">
                  <c:v>73</c:v>
                </c:pt>
                <c:pt idx="163">
                  <c:v>72.849000000000004</c:v>
                </c:pt>
                <c:pt idx="164">
                  <c:v>72.751000000000005</c:v>
                </c:pt>
                <c:pt idx="165">
                  <c:v>72.653000000000006</c:v>
                </c:pt>
                <c:pt idx="166">
                  <c:v>72.555000000000007</c:v>
                </c:pt>
                <c:pt idx="167">
                  <c:v>72.5</c:v>
                </c:pt>
                <c:pt idx="168">
                  <c:v>72.456999999999994</c:v>
                </c:pt>
                <c:pt idx="169">
                  <c:v>72.36</c:v>
                </c:pt>
                <c:pt idx="170">
                  <c:v>72</c:v>
                </c:pt>
                <c:pt idx="171">
                  <c:v>71.841999999999999</c:v>
                </c:pt>
                <c:pt idx="172">
                  <c:v>71.5</c:v>
                </c:pt>
                <c:pt idx="173">
                  <c:v>71</c:v>
                </c:pt>
                <c:pt idx="174">
                  <c:v>70.852000000000004</c:v>
                </c:pt>
                <c:pt idx="175">
                  <c:v>70.5</c:v>
                </c:pt>
                <c:pt idx="176">
                  <c:v>70.015000000000001</c:v>
                </c:pt>
                <c:pt idx="177">
                  <c:v>70</c:v>
                </c:pt>
                <c:pt idx="178">
                  <c:v>69.5</c:v>
                </c:pt>
                <c:pt idx="179">
                  <c:v>69</c:v>
                </c:pt>
                <c:pt idx="180">
                  <c:v>68.677000000000007</c:v>
                </c:pt>
                <c:pt idx="181">
                  <c:v>68.5</c:v>
                </c:pt>
                <c:pt idx="182">
                  <c:v>68.131</c:v>
                </c:pt>
                <c:pt idx="183">
                  <c:v>68</c:v>
                </c:pt>
                <c:pt idx="184">
                  <c:v>67.5</c:v>
                </c:pt>
                <c:pt idx="185">
                  <c:v>67.099999999999994</c:v>
                </c:pt>
                <c:pt idx="186">
                  <c:v>67</c:v>
                </c:pt>
                <c:pt idx="187">
                  <c:v>66.727999999999994</c:v>
                </c:pt>
                <c:pt idx="188">
                  <c:v>66.5</c:v>
                </c:pt>
                <c:pt idx="189">
                  <c:v>66.343999999999994</c:v>
                </c:pt>
                <c:pt idx="190">
                  <c:v>66</c:v>
                </c:pt>
                <c:pt idx="191">
                  <c:v>65.876999999999995</c:v>
                </c:pt>
                <c:pt idx="192">
                  <c:v>65.5</c:v>
                </c:pt>
                <c:pt idx="193">
                  <c:v>65.138000000000005</c:v>
                </c:pt>
                <c:pt idx="194">
                  <c:v>65</c:v>
                </c:pt>
                <c:pt idx="195">
                  <c:v>64.5</c:v>
                </c:pt>
                <c:pt idx="196">
                  <c:v>64</c:v>
                </c:pt>
                <c:pt idx="197">
                  <c:v>63.908999999999999</c:v>
                </c:pt>
                <c:pt idx="198">
                  <c:v>63.5</c:v>
                </c:pt>
                <c:pt idx="199">
                  <c:v>63</c:v>
                </c:pt>
                <c:pt idx="200">
                  <c:v>62.5</c:v>
                </c:pt>
                <c:pt idx="201">
                  <c:v>62.015000000000001</c:v>
                </c:pt>
                <c:pt idx="202">
                  <c:v>62</c:v>
                </c:pt>
                <c:pt idx="203">
                  <c:v>61.5</c:v>
                </c:pt>
                <c:pt idx="204">
                  <c:v>61</c:v>
                </c:pt>
                <c:pt idx="205">
                  <c:v>60.945999999999998</c:v>
                </c:pt>
                <c:pt idx="206">
                  <c:v>60.652999999999999</c:v>
                </c:pt>
                <c:pt idx="207">
                  <c:v>60.5</c:v>
                </c:pt>
                <c:pt idx="208">
                  <c:v>60.478999999999999</c:v>
                </c:pt>
                <c:pt idx="209">
                  <c:v>60.183</c:v>
                </c:pt>
                <c:pt idx="210">
                  <c:v>60</c:v>
                </c:pt>
                <c:pt idx="211">
                  <c:v>59.816000000000003</c:v>
                </c:pt>
                <c:pt idx="212">
                  <c:v>59.5</c:v>
                </c:pt>
                <c:pt idx="213">
                  <c:v>59</c:v>
                </c:pt>
                <c:pt idx="214">
                  <c:v>58.83</c:v>
                </c:pt>
                <c:pt idx="215">
                  <c:v>58.707999999999998</c:v>
                </c:pt>
                <c:pt idx="216">
                  <c:v>58.5</c:v>
                </c:pt>
                <c:pt idx="217">
                  <c:v>58</c:v>
                </c:pt>
                <c:pt idx="218">
                  <c:v>57.914999999999999</c:v>
                </c:pt>
                <c:pt idx="219">
                  <c:v>57.5</c:v>
                </c:pt>
                <c:pt idx="220">
                  <c:v>57</c:v>
                </c:pt>
                <c:pt idx="221">
                  <c:v>56.5</c:v>
                </c:pt>
                <c:pt idx="222">
                  <c:v>56</c:v>
                </c:pt>
                <c:pt idx="223">
                  <c:v>55.5</c:v>
                </c:pt>
                <c:pt idx="224">
                  <c:v>55.087000000000003</c:v>
                </c:pt>
                <c:pt idx="225">
                  <c:v>55</c:v>
                </c:pt>
                <c:pt idx="226">
                  <c:v>54.5</c:v>
                </c:pt>
                <c:pt idx="227">
                  <c:v>54</c:v>
                </c:pt>
                <c:pt idx="228">
                  <c:v>53.704999999999998</c:v>
                </c:pt>
                <c:pt idx="229">
                  <c:v>53.5</c:v>
                </c:pt>
                <c:pt idx="230">
                  <c:v>53.182000000000002</c:v>
                </c:pt>
                <c:pt idx="231">
                  <c:v>53</c:v>
                </c:pt>
                <c:pt idx="232">
                  <c:v>52.83</c:v>
                </c:pt>
                <c:pt idx="233">
                  <c:v>52.591000000000001</c:v>
                </c:pt>
                <c:pt idx="234">
                  <c:v>52.5</c:v>
                </c:pt>
                <c:pt idx="235">
                  <c:v>52.314</c:v>
                </c:pt>
                <c:pt idx="236">
                  <c:v>52</c:v>
                </c:pt>
                <c:pt idx="237">
                  <c:v>51.697000000000003</c:v>
                </c:pt>
                <c:pt idx="238">
                  <c:v>51.5</c:v>
                </c:pt>
                <c:pt idx="239">
                  <c:v>51</c:v>
                </c:pt>
                <c:pt idx="240">
                  <c:v>50.5</c:v>
                </c:pt>
                <c:pt idx="241">
                  <c:v>50.344000000000001</c:v>
                </c:pt>
                <c:pt idx="242">
                  <c:v>50</c:v>
                </c:pt>
                <c:pt idx="243">
                  <c:v>49.5</c:v>
                </c:pt>
                <c:pt idx="244">
                  <c:v>49</c:v>
                </c:pt>
                <c:pt idx="245">
                  <c:v>48.5</c:v>
                </c:pt>
                <c:pt idx="246">
                  <c:v>48.396999999999998</c:v>
                </c:pt>
                <c:pt idx="247">
                  <c:v>48</c:v>
                </c:pt>
                <c:pt idx="248">
                  <c:v>47.645000000000003</c:v>
                </c:pt>
                <c:pt idx="249">
                  <c:v>47.5</c:v>
                </c:pt>
                <c:pt idx="250">
                  <c:v>47</c:v>
                </c:pt>
                <c:pt idx="251">
                  <c:v>46.872</c:v>
                </c:pt>
                <c:pt idx="252">
                  <c:v>46.5</c:v>
                </c:pt>
                <c:pt idx="253">
                  <c:v>46</c:v>
                </c:pt>
                <c:pt idx="254">
                  <c:v>45.689</c:v>
                </c:pt>
                <c:pt idx="255">
                  <c:v>45.5</c:v>
                </c:pt>
                <c:pt idx="256">
                  <c:v>45</c:v>
                </c:pt>
                <c:pt idx="257">
                  <c:v>44.680999999999997</c:v>
                </c:pt>
                <c:pt idx="258">
                  <c:v>44.652000000000001</c:v>
                </c:pt>
                <c:pt idx="259">
                  <c:v>44.5</c:v>
                </c:pt>
                <c:pt idx="260">
                  <c:v>44</c:v>
                </c:pt>
                <c:pt idx="261">
                  <c:v>43.819000000000003</c:v>
                </c:pt>
                <c:pt idx="262">
                  <c:v>43.5</c:v>
                </c:pt>
                <c:pt idx="263">
                  <c:v>43</c:v>
                </c:pt>
                <c:pt idx="264">
                  <c:v>42.5</c:v>
                </c:pt>
                <c:pt idx="265">
                  <c:v>42.438000000000002</c:v>
                </c:pt>
                <c:pt idx="266">
                  <c:v>42</c:v>
                </c:pt>
                <c:pt idx="267">
                  <c:v>41.5</c:v>
                </c:pt>
                <c:pt idx="268">
                  <c:v>41</c:v>
                </c:pt>
                <c:pt idx="269">
                  <c:v>40.94</c:v>
                </c:pt>
                <c:pt idx="270">
                  <c:v>40.5</c:v>
                </c:pt>
                <c:pt idx="271">
                  <c:v>40</c:v>
                </c:pt>
                <c:pt idx="272">
                  <c:v>39.5</c:v>
                </c:pt>
                <c:pt idx="273">
                  <c:v>39</c:v>
                </c:pt>
                <c:pt idx="274">
                  <c:v>38.5</c:v>
                </c:pt>
                <c:pt idx="275">
                  <c:v>38</c:v>
                </c:pt>
                <c:pt idx="276">
                  <c:v>37.826000000000001</c:v>
                </c:pt>
                <c:pt idx="277">
                  <c:v>37.5</c:v>
                </c:pt>
                <c:pt idx="278">
                  <c:v>37.268000000000001</c:v>
                </c:pt>
                <c:pt idx="279">
                  <c:v>37</c:v>
                </c:pt>
                <c:pt idx="280">
                  <c:v>36.930999999999997</c:v>
                </c:pt>
                <c:pt idx="281">
                  <c:v>36.5</c:v>
                </c:pt>
                <c:pt idx="282">
                  <c:v>36</c:v>
                </c:pt>
                <c:pt idx="283">
                  <c:v>35.938000000000002</c:v>
                </c:pt>
                <c:pt idx="284">
                  <c:v>35.5</c:v>
                </c:pt>
                <c:pt idx="285">
                  <c:v>35</c:v>
                </c:pt>
                <c:pt idx="286">
                  <c:v>34.790999999999997</c:v>
                </c:pt>
                <c:pt idx="287">
                  <c:v>34.5</c:v>
                </c:pt>
                <c:pt idx="288">
                  <c:v>34.412999999999997</c:v>
                </c:pt>
                <c:pt idx="289">
                  <c:v>34</c:v>
                </c:pt>
                <c:pt idx="290">
                  <c:v>33.5</c:v>
                </c:pt>
                <c:pt idx="291">
                  <c:v>33.042000000000002</c:v>
                </c:pt>
                <c:pt idx="292">
                  <c:v>33</c:v>
                </c:pt>
                <c:pt idx="293">
                  <c:v>32.5</c:v>
                </c:pt>
                <c:pt idx="294">
                  <c:v>32</c:v>
                </c:pt>
                <c:pt idx="295">
                  <c:v>31.991</c:v>
                </c:pt>
                <c:pt idx="296">
                  <c:v>31.5</c:v>
                </c:pt>
                <c:pt idx="297">
                  <c:v>31</c:v>
                </c:pt>
                <c:pt idx="298">
                  <c:v>30.5</c:v>
                </c:pt>
                <c:pt idx="299">
                  <c:v>30.427</c:v>
                </c:pt>
                <c:pt idx="300">
                  <c:v>30</c:v>
                </c:pt>
                <c:pt idx="301">
                  <c:v>29.5</c:v>
                </c:pt>
                <c:pt idx="302">
                  <c:v>29.324000000000002</c:v>
                </c:pt>
                <c:pt idx="303">
                  <c:v>29.213999999999999</c:v>
                </c:pt>
                <c:pt idx="304">
                  <c:v>29</c:v>
                </c:pt>
                <c:pt idx="305">
                  <c:v>28.5</c:v>
                </c:pt>
                <c:pt idx="306">
                  <c:v>28</c:v>
                </c:pt>
                <c:pt idx="307">
                  <c:v>27.5</c:v>
                </c:pt>
                <c:pt idx="308">
                  <c:v>27</c:v>
                </c:pt>
                <c:pt idx="309">
                  <c:v>26.974</c:v>
                </c:pt>
                <c:pt idx="310">
                  <c:v>26.5</c:v>
                </c:pt>
                <c:pt idx="311">
                  <c:v>26</c:v>
                </c:pt>
                <c:pt idx="312">
                  <c:v>25.579000000000001</c:v>
                </c:pt>
                <c:pt idx="313">
                  <c:v>25.5</c:v>
                </c:pt>
                <c:pt idx="314">
                  <c:v>25</c:v>
                </c:pt>
                <c:pt idx="315">
                  <c:v>24.61</c:v>
                </c:pt>
                <c:pt idx="316">
                  <c:v>24.5</c:v>
                </c:pt>
                <c:pt idx="317">
                  <c:v>24</c:v>
                </c:pt>
                <c:pt idx="318">
                  <c:v>23.5</c:v>
                </c:pt>
                <c:pt idx="319">
                  <c:v>23</c:v>
                </c:pt>
                <c:pt idx="320">
                  <c:v>22.5</c:v>
                </c:pt>
                <c:pt idx="321">
                  <c:v>22.286000000000001</c:v>
                </c:pt>
                <c:pt idx="322">
                  <c:v>22</c:v>
                </c:pt>
                <c:pt idx="323">
                  <c:v>21.5</c:v>
                </c:pt>
                <c:pt idx="324">
                  <c:v>21</c:v>
                </c:pt>
                <c:pt idx="325">
                  <c:v>20.5</c:v>
                </c:pt>
                <c:pt idx="326">
                  <c:v>20.363</c:v>
                </c:pt>
                <c:pt idx="327">
                  <c:v>20</c:v>
                </c:pt>
                <c:pt idx="328">
                  <c:v>19.5</c:v>
                </c:pt>
                <c:pt idx="329">
                  <c:v>19.256</c:v>
                </c:pt>
                <c:pt idx="330">
                  <c:v>19</c:v>
                </c:pt>
                <c:pt idx="331">
                  <c:v>18.5</c:v>
                </c:pt>
                <c:pt idx="332">
                  <c:v>18</c:v>
                </c:pt>
                <c:pt idx="333">
                  <c:v>17.5</c:v>
                </c:pt>
                <c:pt idx="334">
                  <c:v>17.416</c:v>
                </c:pt>
                <c:pt idx="335">
                  <c:v>17</c:v>
                </c:pt>
                <c:pt idx="336">
                  <c:v>16.818000000000001</c:v>
                </c:pt>
                <c:pt idx="337">
                  <c:v>16.5</c:v>
                </c:pt>
                <c:pt idx="338">
                  <c:v>16</c:v>
                </c:pt>
                <c:pt idx="339">
                  <c:v>15.5</c:v>
                </c:pt>
                <c:pt idx="340">
                  <c:v>15</c:v>
                </c:pt>
                <c:pt idx="341">
                  <c:v>14.506</c:v>
                </c:pt>
                <c:pt idx="342">
                  <c:v>14.5</c:v>
                </c:pt>
                <c:pt idx="343">
                  <c:v>14.226000000000001</c:v>
                </c:pt>
                <c:pt idx="344">
                  <c:v>14</c:v>
                </c:pt>
                <c:pt idx="345">
                  <c:v>13.946999999999999</c:v>
                </c:pt>
                <c:pt idx="346">
                  <c:v>13.5</c:v>
                </c:pt>
                <c:pt idx="347">
                  <c:v>13</c:v>
                </c:pt>
                <c:pt idx="348">
                  <c:v>12.76</c:v>
                </c:pt>
                <c:pt idx="349">
                  <c:v>12.5</c:v>
                </c:pt>
                <c:pt idx="350">
                  <c:v>12.183999999999999</c:v>
                </c:pt>
                <c:pt idx="351">
                  <c:v>12</c:v>
                </c:pt>
                <c:pt idx="352">
                  <c:v>11.5</c:v>
                </c:pt>
                <c:pt idx="353">
                  <c:v>11</c:v>
                </c:pt>
                <c:pt idx="354">
                  <c:v>10.707000000000001</c:v>
                </c:pt>
                <c:pt idx="355">
                  <c:v>10.5</c:v>
                </c:pt>
                <c:pt idx="356">
                  <c:v>10.403</c:v>
                </c:pt>
                <c:pt idx="357">
                  <c:v>10.3</c:v>
                </c:pt>
                <c:pt idx="358">
                  <c:v>10.044</c:v>
                </c:pt>
                <c:pt idx="359">
                  <c:v>10</c:v>
                </c:pt>
                <c:pt idx="360">
                  <c:v>9.5</c:v>
                </c:pt>
                <c:pt idx="361">
                  <c:v>9</c:v>
                </c:pt>
                <c:pt idx="362">
                  <c:v>8.5</c:v>
                </c:pt>
                <c:pt idx="363">
                  <c:v>8</c:v>
                </c:pt>
                <c:pt idx="364">
                  <c:v>7.6760000000000002</c:v>
                </c:pt>
                <c:pt idx="365">
                  <c:v>7.5</c:v>
                </c:pt>
                <c:pt idx="366">
                  <c:v>7</c:v>
                </c:pt>
                <c:pt idx="367">
                  <c:v>6.77</c:v>
                </c:pt>
                <c:pt idx="368">
                  <c:v>6.5</c:v>
                </c:pt>
                <c:pt idx="369">
                  <c:v>6.4630000000000001</c:v>
                </c:pt>
                <c:pt idx="370">
                  <c:v>6.1559999999999997</c:v>
                </c:pt>
                <c:pt idx="371">
                  <c:v>6</c:v>
                </c:pt>
                <c:pt idx="372">
                  <c:v>5.7309999999999999</c:v>
                </c:pt>
                <c:pt idx="373">
                  <c:v>5.5</c:v>
                </c:pt>
                <c:pt idx="374">
                  <c:v>5.0599999999999996</c:v>
                </c:pt>
                <c:pt idx="375">
                  <c:v>5</c:v>
                </c:pt>
                <c:pt idx="376">
                  <c:v>4.5</c:v>
                </c:pt>
                <c:pt idx="377">
                  <c:v>4.3499999999999996</c:v>
                </c:pt>
                <c:pt idx="378">
                  <c:v>4</c:v>
                </c:pt>
                <c:pt idx="379">
                  <c:v>3.5</c:v>
                </c:pt>
                <c:pt idx="380">
                  <c:v>3.0950000000000002</c:v>
                </c:pt>
                <c:pt idx="381">
                  <c:v>3</c:v>
                </c:pt>
                <c:pt idx="382">
                  <c:v>2.7639999999999998</c:v>
                </c:pt>
                <c:pt idx="383">
                  <c:v>2.5</c:v>
                </c:pt>
                <c:pt idx="384">
                  <c:v>2.452</c:v>
                </c:pt>
                <c:pt idx="385">
                  <c:v>2.16</c:v>
                </c:pt>
                <c:pt idx="386">
                  <c:v>2</c:v>
                </c:pt>
                <c:pt idx="387">
                  <c:v>1.5</c:v>
                </c:pt>
                <c:pt idx="388">
                  <c:v>1.028</c:v>
                </c:pt>
                <c:pt idx="389">
                  <c:v>1</c:v>
                </c:pt>
                <c:pt idx="390">
                  <c:v>0.74</c:v>
                </c:pt>
                <c:pt idx="391">
                  <c:v>0.61599999999999999</c:v>
                </c:pt>
                <c:pt idx="392">
                  <c:v>0.5</c:v>
                </c:pt>
                <c:pt idx="393">
                  <c:v>0.49099999999999999</c:v>
                </c:pt>
                <c:pt idx="394">
                  <c:v>0.42</c:v>
                </c:pt>
                <c:pt idx="395">
                  <c:v>0.35099999999999998</c:v>
                </c:pt>
                <c:pt idx="396">
                  <c:v>0.28199999999999997</c:v>
                </c:pt>
                <c:pt idx="397">
                  <c:v>0.21299999999999999</c:v>
                </c:pt>
                <c:pt idx="398">
                  <c:v>0.14399999999999999</c:v>
                </c:pt>
                <c:pt idx="399">
                  <c:v>7.1999999999999995E-2</c:v>
                </c:pt>
                <c:pt idx="400">
                  <c:v>1E-3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55F-45DA-A1D6-04490D79AF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12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b="0" i="0" baseline="0" dirty="0">
                    <a:effectLst/>
                  </a:rPr>
                  <a:t>Dose [</a:t>
                </a:r>
                <a:r>
                  <a:rPr lang="it-IT" sz="800" b="0" i="0" baseline="0" dirty="0" err="1">
                    <a:effectLst/>
                  </a:rPr>
                  <a:t>cGy</a:t>
                </a:r>
                <a:r>
                  <a:rPr lang="it-IT" sz="800" b="0" i="0" baseline="0" dirty="0">
                    <a:effectLst/>
                  </a:rPr>
                  <a:t>(RBE)]</a:t>
                </a:r>
                <a:endParaRPr lang="it-IT" sz="8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2113928571428572"/>
              <c:y val="0.895824444444444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dirty="0"/>
                  <a:t>Volume</a:t>
                </a:r>
                <a:r>
                  <a:rPr lang="it-IT" sz="800" baseline="0" dirty="0"/>
                  <a:t> [%]</a:t>
                </a:r>
                <a:endParaRPr lang="it-IT" sz="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55873015873016"/>
          <c:y val="7.7611111111111117E-2"/>
          <c:w val="0.73813293650793643"/>
          <c:h val="0.71702444444444446"/>
        </c:manualLayout>
      </c:layout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rgbClr val="9DC3E6"/>
              </a:solidFill>
              <a:round/>
            </a:ln>
            <a:effectLst/>
          </c:spPr>
          <c:marker>
            <c:symbol val="none"/>
          </c:marker>
          <c:xVal>
            <c:numRef>
              <c:f>Foglio6!$A$819:$A$1220</c:f>
              <c:numCache>
                <c:formatCode>General</c:formatCode>
                <c:ptCount val="402"/>
                <c:pt idx="0">
                  <c:v>0</c:v>
                </c:pt>
                <c:pt idx="1">
                  <c:v>5.7350000000000003</c:v>
                </c:pt>
                <c:pt idx="2">
                  <c:v>11.471</c:v>
                </c:pt>
                <c:pt idx="3">
                  <c:v>17.206</c:v>
                </c:pt>
                <c:pt idx="4">
                  <c:v>22.942</c:v>
                </c:pt>
                <c:pt idx="5">
                  <c:v>28.677</c:v>
                </c:pt>
                <c:pt idx="6">
                  <c:v>34.411999999999999</c:v>
                </c:pt>
                <c:pt idx="7">
                  <c:v>40.148000000000003</c:v>
                </c:pt>
                <c:pt idx="8">
                  <c:v>45.883000000000003</c:v>
                </c:pt>
                <c:pt idx="9">
                  <c:v>51.619</c:v>
                </c:pt>
                <c:pt idx="10">
                  <c:v>57.353999999999999</c:v>
                </c:pt>
                <c:pt idx="11">
                  <c:v>63.09</c:v>
                </c:pt>
                <c:pt idx="12">
                  <c:v>68.825000000000003</c:v>
                </c:pt>
                <c:pt idx="13">
                  <c:v>74.56</c:v>
                </c:pt>
                <c:pt idx="14">
                  <c:v>80.296000000000006</c:v>
                </c:pt>
                <c:pt idx="15">
                  <c:v>86.031000000000006</c:v>
                </c:pt>
                <c:pt idx="16">
                  <c:v>91.766999999999996</c:v>
                </c:pt>
                <c:pt idx="17">
                  <c:v>97.501999999999995</c:v>
                </c:pt>
                <c:pt idx="18">
                  <c:v>103.23699999999999</c:v>
                </c:pt>
                <c:pt idx="19">
                  <c:v>108.973</c:v>
                </c:pt>
                <c:pt idx="20">
                  <c:v>114.708</c:v>
                </c:pt>
                <c:pt idx="21">
                  <c:v>120.444</c:v>
                </c:pt>
                <c:pt idx="22">
                  <c:v>126.179</c:v>
                </c:pt>
                <c:pt idx="23">
                  <c:v>131.91499999999999</c:v>
                </c:pt>
                <c:pt idx="24">
                  <c:v>137.65</c:v>
                </c:pt>
                <c:pt idx="25">
                  <c:v>143.38499999999999</c:v>
                </c:pt>
                <c:pt idx="26">
                  <c:v>149.12100000000001</c:v>
                </c:pt>
                <c:pt idx="27">
                  <c:v>154.85599999999999</c:v>
                </c:pt>
                <c:pt idx="28">
                  <c:v>160.59200000000001</c:v>
                </c:pt>
                <c:pt idx="29">
                  <c:v>166.327</c:v>
                </c:pt>
                <c:pt idx="30">
                  <c:v>172.06200000000001</c:v>
                </c:pt>
                <c:pt idx="31">
                  <c:v>177.798</c:v>
                </c:pt>
                <c:pt idx="32">
                  <c:v>183.53299999999999</c:v>
                </c:pt>
                <c:pt idx="33">
                  <c:v>189.26900000000001</c:v>
                </c:pt>
                <c:pt idx="34">
                  <c:v>195.00399999999999</c:v>
                </c:pt>
                <c:pt idx="35">
                  <c:v>200.739</c:v>
                </c:pt>
                <c:pt idx="36">
                  <c:v>206.47499999999999</c:v>
                </c:pt>
                <c:pt idx="37">
                  <c:v>212.21</c:v>
                </c:pt>
                <c:pt idx="38">
                  <c:v>217.946</c:v>
                </c:pt>
                <c:pt idx="39">
                  <c:v>223.68100000000001</c:v>
                </c:pt>
                <c:pt idx="40">
                  <c:v>229.417</c:v>
                </c:pt>
                <c:pt idx="41">
                  <c:v>235.15199999999999</c:v>
                </c:pt>
                <c:pt idx="42">
                  <c:v>240.887</c:v>
                </c:pt>
                <c:pt idx="43">
                  <c:v>246.62299999999999</c:v>
                </c:pt>
                <c:pt idx="44">
                  <c:v>252.358</c:v>
                </c:pt>
                <c:pt idx="45">
                  <c:v>258.09399999999999</c:v>
                </c:pt>
                <c:pt idx="46">
                  <c:v>263.82900000000001</c:v>
                </c:pt>
                <c:pt idx="47">
                  <c:v>269.56400000000002</c:v>
                </c:pt>
                <c:pt idx="48">
                  <c:v>275.3</c:v>
                </c:pt>
                <c:pt idx="49">
                  <c:v>281.03500000000003</c:v>
                </c:pt>
                <c:pt idx="50">
                  <c:v>286.77100000000002</c:v>
                </c:pt>
                <c:pt idx="51">
                  <c:v>292.50599999999997</c:v>
                </c:pt>
                <c:pt idx="52">
                  <c:v>298.24200000000002</c:v>
                </c:pt>
                <c:pt idx="53">
                  <c:v>303.97699999999998</c:v>
                </c:pt>
                <c:pt idx="54">
                  <c:v>309.71199999999999</c:v>
                </c:pt>
                <c:pt idx="55">
                  <c:v>315.44799999999998</c:v>
                </c:pt>
                <c:pt idx="56">
                  <c:v>321.18299999999999</c:v>
                </c:pt>
                <c:pt idx="57">
                  <c:v>326.91899999999998</c:v>
                </c:pt>
                <c:pt idx="58">
                  <c:v>332.654</c:v>
                </c:pt>
                <c:pt idx="59">
                  <c:v>338.38900000000001</c:v>
                </c:pt>
                <c:pt idx="60">
                  <c:v>344.125</c:v>
                </c:pt>
                <c:pt idx="61">
                  <c:v>349.86</c:v>
                </c:pt>
                <c:pt idx="62">
                  <c:v>355.596</c:v>
                </c:pt>
                <c:pt idx="63">
                  <c:v>361.33100000000002</c:v>
                </c:pt>
                <c:pt idx="64">
                  <c:v>367.06599999999997</c:v>
                </c:pt>
                <c:pt idx="65">
                  <c:v>372.80200000000002</c:v>
                </c:pt>
                <c:pt idx="66">
                  <c:v>378.53699999999998</c:v>
                </c:pt>
                <c:pt idx="67">
                  <c:v>384.27300000000002</c:v>
                </c:pt>
                <c:pt idx="68">
                  <c:v>390.00799999999998</c:v>
                </c:pt>
                <c:pt idx="69">
                  <c:v>395.74400000000003</c:v>
                </c:pt>
                <c:pt idx="70">
                  <c:v>401.47899999999998</c:v>
                </c:pt>
                <c:pt idx="71">
                  <c:v>407.214</c:v>
                </c:pt>
                <c:pt idx="72">
                  <c:v>412.95</c:v>
                </c:pt>
                <c:pt idx="73">
                  <c:v>418.685</c:v>
                </c:pt>
                <c:pt idx="74">
                  <c:v>419.96100000000001</c:v>
                </c:pt>
                <c:pt idx="75">
                  <c:v>424.42099999999999</c:v>
                </c:pt>
                <c:pt idx="76">
                  <c:v>430.15600000000001</c:v>
                </c:pt>
                <c:pt idx="77">
                  <c:v>435.89100000000002</c:v>
                </c:pt>
                <c:pt idx="78">
                  <c:v>441.62700000000001</c:v>
                </c:pt>
                <c:pt idx="79">
                  <c:v>447.36200000000002</c:v>
                </c:pt>
                <c:pt idx="80">
                  <c:v>453.09800000000001</c:v>
                </c:pt>
                <c:pt idx="81">
                  <c:v>458.83300000000003</c:v>
                </c:pt>
                <c:pt idx="82">
                  <c:v>464.56900000000002</c:v>
                </c:pt>
                <c:pt idx="83">
                  <c:v>470.30399999999997</c:v>
                </c:pt>
                <c:pt idx="84">
                  <c:v>476.03899999999999</c:v>
                </c:pt>
                <c:pt idx="85">
                  <c:v>481.77499999999998</c:v>
                </c:pt>
                <c:pt idx="86">
                  <c:v>487.51</c:v>
                </c:pt>
                <c:pt idx="87">
                  <c:v>488.161</c:v>
                </c:pt>
                <c:pt idx="88">
                  <c:v>493.24599999999998</c:v>
                </c:pt>
                <c:pt idx="89">
                  <c:v>498.98099999999999</c:v>
                </c:pt>
                <c:pt idx="90">
                  <c:v>504.71600000000001</c:v>
                </c:pt>
                <c:pt idx="91">
                  <c:v>507.03399999999999</c:v>
                </c:pt>
                <c:pt idx="92">
                  <c:v>510.452</c:v>
                </c:pt>
                <c:pt idx="93">
                  <c:v>516.18700000000001</c:v>
                </c:pt>
                <c:pt idx="94">
                  <c:v>521.923</c:v>
                </c:pt>
                <c:pt idx="95">
                  <c:v>522.30799999999999</c:v>
                </c:pt>
                <c:pt idx="96">
                  <c:v>527.65800000000002</c:v>
                </c:pt>
                <c:pt idx="97">
                  <c:v>533.39300000000003</c:v>
                </c:pt>
                <c:pt idx="98">
                  <c:v>539.08799999999997</c:v>
                </c:pt>
                <c:pt idx="99">
                  <c:v>539.12900000000002</c:v>
                </c:pt>
                <c:pt idx="100">
                  <c:v>541.41099999999994</c:v>
                </c:pt>
                <c:pt idx="101">
                  <c:v>544.86400000000003</c:v>
                </c:pt>
                <c:pt idx="102">
                  <c:v>550.6</c:v>
                </c:pt>
                <c:pt idx="103">
                  <c:v>552.024</c:v>
                </c:pt>
                <c:pt idx="104">
                  <c:v>556.33500000000004</c:v>
                </c:pt>
                <c:pt idx="105">
                  <c:v>558.07299999999998</c:v>
                </c:pt>
                <c:pt idx="106">
                  <c:v>560.38699999999994</c:v>
                </c:pt>
                <c:pt idx="107">
                  <c:v>561.53300000000002</c:v>
                </c:pt>
                <c:pt idx="108">
                  <c:v>562.07100000000003</c:v>
                </c:pt>
                <c:pt idx="109">
                  <c:v>563.65800000000002</c:v>
                </c:pt>
                <c:pt idx="110">
                  <c:v>566.904</c:v>
                </c:pt>
                <c:pt idx="111">
                  <c:v>567.80600000000004</c:v>
                </c:pt>
                <c:pt idx="112">
                  <c:v>570.68799999999999</c:v>
                </c:pt>
                <c:pt idx="113">
                  <c:v>571.96100000000001</c:v>
                </c:pt>
                <c:pt idx="114">
                  <c:v>573.54100000000005</c:v>
                </c:pt>
                <c:pt idx="115">
                  <c:v>574.173</c:v>
                </c:pt>
                <c:pt idx="116">
                  <c:v>579.27700000000004</c:v>
                </c:pt>
                <c:pt idx="117">
                  <c:v>585.01199999999994</c:v>
                </c:pt>
                <c:pt idx="118">
                  <c:v>585.41800000000001</c:v>
                </c:pt>
                <c:pt idx="119">
                  <c:v>590.74800000000005</c:v>
                </c:pt>
                <c:pt idx="120">
                  <c:v>596.48299999999995</c:v>
                </c:pt>
                <c:pt idx="121">
                  <c:v>597.70699999999999</c:v>
                </c:pt>
                <c:pt idx="122">
                  <c:v>602.21799999999996</c:v>
                </c:pt>
                <c:pt idx="123">
                  <c:v>604.05799999999999</c:v>
                </c:pt>
                <c:pt idx="124">
                  <c:v>607.80899999999997</c:v>
                </c:pt>
                <c:pt idx="125">
                  <c:v>607.95399999999995</c:v>
                </c:pt>
                <c:pt idx="126">
                  <c:v>610.91600000000005</c:v>
                </c:pt>
                <c:pt idx="127">
                  <c:v>613.68899999999996</c:v>
                </c:pt>
                <c:pt idx="128">
                  <c:v>615.90300000000002</c:v>
                </c:pt>
                <c:pt idx="129">
                  <c:v>619.42499999999995</c:v>
                </c:pt>
                <c:pt idx="130">
                  <c:v>623.22699999999998</c:v>
                </c:pt>
                <c:pt idx="131">
                  <c:v>625.16</c:v>
                </c:pt>
                <c:pt idx="132">
                  <c:v>625.32899999999995</c:v>
                </c:pt>
                <c:pt idx="133">
                  <c:v>626.14099999999996</c:v>
                </c:pt>
                <c:pt idx="134">
                  <c:v>629.6</c:v>
                </c:pt>
                <c:pt idx="135">
                  <c:v>630.89599999999996</c:v>
                </c:pt>
                <c:pt idx="136">
                  <c:v>632.84199999999998</c:v>
                </c:pt>
                <c:pt idx="137">
                  <c:v>634.99199999999996</c:v>
                </c:pt>
                <c:pt idx="138">
                  <c:v>636.00400000000002</c:v>
                </c:pt>
                <c:pt idx="139">
                  <c:v>636.59900000000005</c:v>
                </c:pt>
                <c:pt idx="140">
                  <c:v>636.63099999999997</c:v>
                </c:pt>
                <c:pt idx="141">
                  <c:v>636.95000000000005</c:v>
                </c:pt>
                <c:pt idx="142">
                  <c:v>637.78</c:v>
                </c:pt>
                <c:pt idx="143">
                  <c:v>638.56600000000003</c:v>
                </c:pt>
                <c:pt idx="144">
                  <c:v>642.36599999999999</c:v>
                </c:pt>
                <c:pt idx="145">
                  <c:v>642.92100000000005</c:v>
                </c:pt>
                <c:pt idx="146">
                  <c:v>646.81600000000003</c:v>
                </c:pt>
                <c:pt idx="147">
                  <c:v>648.10199999999998</c:v>
                </c:pt>
                <c:pt idx="148">
                  <c:v>650.48800000000006</c:v>
                </c:pt>
                <c:pt idx="149">
                  <c:v>651.54300000000001</c:v>
                </c:pt>
                <c:pt idx="150">
                  <c:v>653.01199999999994</c:v>
                </c:pt>
                <c:pt idx="151">
                  <c:v>653.83699999999999</c:v>
                </c:pt>
                <c:pt idx="152">
                  <c:v>656.45600000000002</c:v>
                </c:pt>
                <c:pt idx="153">
                  <c:v>658.69200000000001</c:v>
                </c:pt>
                <c:pt idx="154">
                  <c:v>659.57299999999998</c:v>
                </c:pt>
                <c:pt idx="155">
                  <c:v>665.30799999999999</c:v>
                </c:pt>
                <c:pt idx="156">
                  <c:v>668.49</c:v>
                </c:pt>
                <c:pt idx="157">
                  <c:v>670.47500000000002</c:v>
                </c:pt>
                <c:pt idx="158">
                  <c:v>671.04300000000001</c:v>
                </c:pt>
                <c:pt idx="159">
                  <c:v>672.41700000000003</c:v>
                </c:pt>
                <c:pt idx="160">
                  <c:v>674.38800000000003</c:v>
                </c:pt>
                <c:pt idx="161">
                  <c:v>676.779</c:v>
                </c:pt>
                <c:pt idx="162">
                  <c:v>680.83</c:v>
                </c:pt>
                <c:pt idx="163">
                  <c:v>682.51400000000001</c:v>
                </c:pt>
                <c:pt idx="164">
                  <c:v>683.62400000000002</c:v>
                </c:pt>
                <c:pt idx="165">
                  <c:v>684.52599999999995</c:v>
                </c:pt>
                <c:pt idx="166">
                  <c:v>685.21799999999996</c:v>
                </c:pt>
                <c:pt idx="167">
                  <c:v>685.90800000000002</c:v>
                </c:pt>
                <c:pt idx="168">
                  <c:v>688.25</c:v>
                </c:pt>
                <c:pt idx="169">
                  <c:v>688.49099999999999</c:v>
                </c:pt>
                <c:pt idx="170">
                  <c:v>690.73500000000001</c:v>
                </c:pt>
                <c:pt idx="171">
                  <c:v>691.69100000000003</c:v>
                </c:pt>
                <c:pt idx="172">
                  <c:v>691.82</c:v>
                </c:pt>
                <c:pt idx="173">
                  <c:v>693.346</c:v>
                </c:pt>
                <c:pt idx="174">
                  <c:v>693.98500000000001</c:v>
                </c:pt>
                <c:pt idx="175">
                  <c:v>694.15200000000004</c:v>
                </c:pt>
                <c:pt idx="176">
                  <c:v>694.57799999999997</c:v>
                </c:pt>
                <c:pt idx="177">
                  <c:v>698.72900000000004</c:v>
                </c:pt>
                <c:pt idx="178">
                  <c:v>699.72</c:v>
                </c:pt>
                <c:pt idx="179">
                  <c:v>702.85500000000002</c:v>
                </c:pt>
                <c:pt idx="180">
                  <c:v>705.45600000000002</c:v>
                </c:pt>
                <c:pt idx="181">
                  <c:v>706.20600000000002</c:v>
                </c:pt>
                <c:pt idx="182">
                  <c:v>711.19100000000003</c:v>
                </c:pt>
                <c:pt idx="183">
                  <c:v>715.77300000000002</c:v>
                </c:pt>
                <c:pt idx="184">
                  <c:v>716.92700000000002</c:v>
                </c:pt>
                <c:pt idx="185">
                  <c:v>722.66200000000003</c:v>
                </c:pt>
                <c:pt idx="186">
                  <c:v>724.798</c:v>
                </c:pt>
                <c:pt idx="187">
                  <c:v>727.27599999999995</c:v>
                </c:pt>
                <c:pt idx="188">
                  <c:v>728.39800000000002</c:v>
                </c:pt>
                <c:pt idx="189">
                  <c:v>730.76</c:v>
                </c:pt>
                <c:pt idx="190">
                  <c:v>734.13300000000004</c:v>
                </c:pt>
                <c:pt idx="191">
                  <c:v>734.64</c:v>
                </c:pt>
                <c:pt idx="192">
                  <c:v>737.80700000000002</c:v>
                </c:pt>
                <c:pt idx="193">
                  <c:v>739.86800000000005</c:v>
                </c:pt>
                <c:pt idx="194">
                  <c:v>740.69299999999998</c:v>
                </c:pt>
                <c:pt idx="195">
                  <c:v>741.87300000000005</c:v>
                </c:pt>
                <c:pt idx="196">
                  <c:v>742.03899999999999</c:v>
                </c:pt>
                <c:pt idx="197">
                  <c:v>742.60900000000004</c:v>
                </c:pt>
                <c:pt idx="198">
                  <c:v>743.74400000000003</c:v>
                </c:pt>
                <c:pt idx="199">
                  <c:v>744.81200000000001</c:v>
                </c:pt>
                <c:pt idx="200">
                  <c:v>745.07299999999998</c:v>
                </c:pt>
                <c:pt idx="201">
                  <c:v>745.36400000000003</c:v>
                </c:pt>
                <c:pt idx="202">
                  <c:v>745.60400000000004</c:v>
                </c:pt>
                <c:pt idx="203">
                  <c:v>745.71799999999996</c:v>
                </c:pt>
                <c:pt idx="204">
                  <c:v>747.20100000000002</c:v>
                </c:pt>
                <c:pt idx="205">
                  <c:v>749.14300000000003</c:v>
                </c:pt>
                <c:pt idx="206">
                  <c:v>751.33900000000006</c:v>
                </c:pt>
                <c:pt idx="207">
                  <c:v>751.38</c:v>
                </c:pt>
                <c:pt idx="208">
                  <c:v>752.09400000000005</c:v>
                </c:pt>
                <c:pt idx="209">
                  <c:v>752.68200000000002</c:v>
                </c:pt>
                <c:pt idx="210">
                  <c:v>753.40700000000004</c:v>
                </c:pt>
                <c:pt idx="211">
                  <c:v>755.87900000000002</c:v>
                </c:pt>
                <c:pt idx="212">
                  <c:v>757.07500000000005</c:v>
                </c:pt>
                <c:pt idx="213">
                  <c:v>757.09500000000003</c:v>
                </c:pt>
                <c:pt idx="214">
                  <c:v>757.649</c:v>
                </c:pt>
                <c:pt idx="215">
                  <c:v>758.81</c:v>
                </c:pt>
                <c:pt idx="216">
                  <c:v>760.38499999999999</c:v>
                </c:pt>
                <c:pt idx="217">
                  <c:v>762.81</c:v>
                </c:pt>
                <c:pt idx="218">
                  <c:v>762.95299999999997</c:v>
                </c:pt>
                <c:pt idx="219">
                  <c:v>764.86099999999999</c:v>
                </c:pt>
                <c:pt idx="220">
                  <c:v>765.47199999999998</c:v>
                </c:pt>
                <c:pt idx="221">
                  <c:v>765.61800000000005</c:v>
                </c:pt>
                <c:pt idx="222">
                  <c:v>766.19500000000005</c:v>
                </c:pt>
                <c:pt idx="223">
                  <c:v>767.20899999999995</c:v>
                </c:pt>
                <c:pt idx="224">
                  <c:v>768.54499999999996</c:v>
                </c:pt>
                <c:pt idx="225">
                  <c:v>770.11699999999996</c:v>
                </c:pt>
                <c:pt idx="226">
                  <c:v>774.28099999999995</c:v>
                </c:pt>
                <c:pt idx="227">
                  <c:v>779.45299999999997</c:v>
                </c:pt>
                <c:pt idx="228">
                  <c:v>780.01599999999996</c:v>
                </c:pt>
                <c:pt idx="229">
                  <c:v>783.20100000000002</c:v>
                </c:pt>
                <c:pt idx="230">
                  <c:v>785.75199999999995</c:v>
                </c:pt>
                <c:pt idx="231">
                  <c:v>787.41399999999999</c:v>
                </c:pt>
                <c:pt idx="232">
                  <c:v>791.48699999999997</c:v>
                </c:pt>
                <c:pt idx="233">
                  <c:v>791.62699999999995</c:v>
                </c:pt>
                <c:pt idx="234">
                  <c:v>795.63599999999997</c:v>
                </c:pt>
                <c:pt idx="235">
                  <c:v>797.22299999999996</c:v>
                </c:pt>
                <c:pt idx="236">
                  <c:v>799.23299999999995</c:v>
                </c:pt>
                <c:pt idx="237">
                  <c:v>801.01099999999997</c:v>
                </c:pt>
                <c:pt idx="238">
                  <c:v>802.04200000000003</c:v>
                </c:pt>
                <c:pt idx="239">
                  <c:v>802.95799999999997</c:v>
                </c:pt>
                <c:pt idx="240">
                  <c:v>803.20500000000004</c:v>
                </c:pt>
                <c:pt idx="241">
                  <c:v>804.36800000000005</c:v>
                </c:pt>
                <c:pt idx="242">
                  <c:v>807.36099999999999</c:v>
                </c:pt>
                <c:pt idx="243">
                  <c:v>808.69299999999998</c:v>
                </c:pt>
                <c:pt idx="244">
                  <c:v>811.25699999999995</c:v>
                </c:pt>
                <c:pt idx="245">
                  <c:v>814.04700000000003</c:v>
                </c:pt>
                <c:pt idx="246">
                  <c:v>814.42899999999997</c:v>
                </c:pt>
                <c:pt idx="247">
                  <c:v>814.59400000000005</c:v>
                </c:pt>
                <c:pt idx="248">
                  <c:v>815.596</c:v>
                </c:pt>
                <c:pt idx="249">
                  <c:v>820.16399999999999</c:v>
                </c:pt>
                <c:pt idx="250">
                  <c:v>820.59199999999998</c:v>
                </c:pt>
                <c:pt idx="251">
                  <c:v>825.88599999999997</c:v>
                </c:pt>
                <c:pt idx="252">
                  <c:v>825.9</c:v>
                </c:pt>
                <c:pt idx="253">
                  <c:v>831.32299999999998</c:v>
                </c:pt>
                <c:pt idx="254">
                  <c:v>831.63499999999999</c:v>
                </c:pt>
                <c:pt idx="255">
                  <c:v>834.32899999999995</c:v>
                </c:pt>
                <c:pt idx="256">
                  <c:v>835.79899999999998</c:v>
                </c:pt>
                <c:pt idx="257">
                  <c:v>836.95699999999999</c:v>
                </c:pt>
                <c:pt idx="258">
                  <c:v>837.37</c:v>
                </c:pt>
                <c:pt idx="259">
                  <c:v>837.976</c:v>
                </c:pt>
                <c:pt idx="260">
                  <c:v>839.58699999999999</c:v>
                </c:pt>
                <c:pt idx="261">
                  <c:v>840.447</c:v>
                </c:pt>
                <c:pt idx="262">
                  <c:v>840.47299999999996</c:v>
                </c:pt>
                <c:pt idx="263">
                  <c:v>840.51199999999994</c:v>
                </c:pt>
                <c:pt idx="264">
                  <c:v>840.63800000000003</c:v>
                </c:pt>
                <c:pt idx="265">
                  <c:v>842.553</c:v>
                </c:pt>
                <c:pt idx="266">
                  <c:v>843.10599999999999</c:v>
                </c:pt>
                <c:pt idx="267">
                  <c:v>845.93100000000004</c:v>
                </c:pt>
                <c:pt idx="268">
                  <c:v>846.88900000000001</c:v>
                </c:pt>
                <c:pt idx="269">
                  <c:v>847.17600000000004</c:v>
                </c:pt>
                <c:pt idx="270">
                  <c:v>847.60599999999999</c:v>
                </c:pt>
                <c:pt idx="271">
                  <c:v>848.35</c:v>
                </c:pt>
                <c:pt idx="272">
                  <c:v>848.84100000000001</c:v>
                </c:pt>
                <c:pt idx="273">
                  <c:v>849.37699999999995</c:v>
                </c:pt>
                <c:pt idx="274">
                  <c:v>850.89200000000005</c:v>
                </c:pt>
                <c:pt idx="275">
                  <c:v>852.38800000000003</c:v>
                </c:pt>
                <c:pt idx="276">
                  <c:v>852.66200000000003</c:v>
                </c:pt>
                <c:pt idx="277">
                  <c:v>852.93499999999995</c:v>
                </c:pt>
                <c:pt idx="278">
                  <c:v>854.577</c:v>
                </c:pt>
                <c:pt idx="279">
                  <c:v>855.65200000000004</c:v>
                </c:pt>
                <c:pt idx="280">
                  <c:v>858.95399999999995</c:v>
                </c:pt>
                <c:pt idx="281">
                  <c:v>860.31200000000001</c:v>
                </c:pt>
                <c:pt idx="282">
                  <c:v>861.13400000000001</c:v>
                </c:pt>
                <c:pt idx="283">
                  <c:v>862.726</c:v>
                </c:pt>
                <c:pt idx="284">
                  <c:v>863.09500000000003</c:v>
                </c:pt>
                <c:pt idx="285">
                  <c:v>863.72699999999998</c:v>
                </c:pt>
                <c:pt idx="286">
                  <c:v>866.04700000000003</c:v>
                </c:pt>
                <c:pt idx="287">
                  <c:v>867.14</c:v>
                </c:pt>
                <c:pt idx="288">
                  <c:v>871.78300000000002</c:v>
                </c:pt>
                <c:pt idx="289">
                  <c:v>877.06500000000005</c:v>
                </c:pt>
                <c:pt idx="290">
                  <c:v>877.51800000000003</c:v>
                </c:pt>
                <c:pt idx="291">
                  <c:v>883.25400000000002</c:v>
                </c:pt>
                <c:pt idx="292">
                  <c:v>886.16</c:v>
                </c:pt>
                <c:pt idx="293">
                  <c:v>888.98900000000003</c:v>
                </c:pt>
                <c:pt idx="294">
                  <c:v>889.327</c:v>
                </c:pt>
                <c:pt idx="295">
                  <c:v>890.69600000000003</c:v>
                </c:pt>
                <c:pt idx="296">
                  <c:v>890.95699999999999</c:v>
                </c:pt>
                <c:pt idx="297">
                  <c:v>892.00900000000001</c:v>
                </c:pt>
                <c:pt idx="298">
                  <c:v>893.23599999999999</c:v>
                </c:pt>
                <c:pt idx="299">
                  <c:v>893.53599999999994</c:v>
                </c:pt>
                <c:pt idx="300">
                  <c:v>894.72500000000002</c:v>
                </c:pt>
                <c:pt idx="301">
                  <c:v>895.03700000000003</c:v>
                </c:pt>
                <c:pt idx="302">
                  <c:v>896.73199999999997</c:v>
                </c:pt>
                <c:pt idx="303">
                  <c:v>898.779</c:v>
                </c:pt>
                <c:pt idx="304">
                  <c:v>900.46</c:v>
                </c:pt>
                <c:pt idx="305">
                  <c:v>901.14700000000005</c:v>
                </c:pt>
                <c:pt idx="306">
                  <c:v>904.15200000000004</c:v>
                </c:pt>
                <c:pt idx="307">
                  <c:v>906.19500000000005</c:v>
                </c:pt>
                <c:pt idx="308">
                  <c:v>910</c:v>
                </c:pt>
                <c:pt idx="309">
                  <c:v>910.53200000000004</c:v>
                </c:pt>
                <c:pt idx="310">
                  <c:v>911.93100000000004</c:v>
                </c:pt>
                <c:pt idx="311">
                  <c:v>912.31399999999996</c:v>
                </c:pt>
                <c:pt idx="312">
                  <c:v>914.30700000000002</c:v>
                </c:pt>
                <c:pt idx="313">
                  <c:v>916.279</c:v>
                </c:pt>
                <c:pt idx="314">
                  <c:v>917.66600000000005</c:v>
                </c:pt>
                <c:pt idx="315">
                  <c:v>919.46</c:v>
                </c:pt>
                <c:pt idx="316">
                  <c:v>923.40200000000004</c:v>
                </c:pt>
                <c:pt idx="317">
                  <c:v>923.53099999999995</c:v>
                </c:pt>
                <c:pt idx="318">
                  <c:v>928.31799999999998</c:v>
                </c:pt>
                <c:pt idx="319">
                  <c:v>929.13699999999994</c:v>
                </c:pt>
                <c:pt idx="320">
                  <c:v>934.87199999999996</c:v>
                </c:pt>
                <c:pt idx="321">
                  <c:v>938.77099999999996</c:v>
                </c:pt>
                <c:pt idx="322">
                  <c:v>940.60799999999995</c:v>
                </c:pt>
                <c:pt idx="323">
                  <c:v>940.75</c:v>
                </c:pt>
                <c:pt idx="324">
                  <c:v>941.34400000000005</c:v>
                </c:pt>
                <c:pt idx="325">
                  <c:v>941.83199999999999</c:v>
                </c:pt>
                <c:pt idx="326">
                  <c:v>942.15</c:v>
                </c:pt>
                <c:pt idx="327">
                  <c:v>945.452</c:v>
                </c:pt>
                <c:pt idx="328">
                  <c:v>946.34299999999996</c:v>
                </c:pt>
                <c:pt idx="329">
                  <c:v>947.28599999999994</c:v>
                </c:pt>
                <c:pt idx="330">
                  <c:v>947.52</c:v>
                </c:pt>
                <c:pt idx="331">
                  <c:v>950.06100000000004</c:v>
                </c:pt>
                <c:pt idx="332">
                  <c:v>951.16200000000003</c:v>
                </c:pt>
                <c:pt idx="333">
                  <c:v>951.47900000000004</c:v>
                </c:pt>
                <c:pt idx="334">
                  <c:v>952.07899999999995</c:v>
                </c:pt>
                <c:pt idx="335">
                  <c:v>953.88400000000001</c:v>
                </c:pt>
                <c:pt idx="336">
                  <c:v>957.81399999999996</c:v>
                </c:pt>
                <c:pt idx="337">
                  <c:v>960.98</c:v>
                </c:pt>
                <c:pt idx="338">
                  <c:v>963.55</c:v>
                </c:pt>
                <c:pt idx="339">
                  <c:v>967.70699999999999</c:v>
                </c:pt>
                <c:pt idx="340">
                  <c:v>969.28499999999997</c:v>
                </c:pt>
                <c:pt idx="341">
                  <c:v>969.68299999999999</c:v>
                </c:pt>
                <c:pt idx="342">
                  <c:v>975.02</c:v>
                </c:pt>
                <c:pt idx="343">
                  <c:v>976.61199999999997</c:v>
                </c:pt>
                <c:pt idx="344">
                  <c:v>979.26099999999997</c:v>
                </c:pt>
                <c:pt idx="345">
                  <c:v>980.75599999999997</c:v>
                </c:pt>
                <c:pt idx="346">
                  <c:v>986.49099999999999</c:v>
                </c:pt>
                <c:pt idx="347">
                  <c:v>989.65200000000004</c:v>
                </c:pt>
                <c:pt idx="348">
                  <c:v>992.22699999999998</c:v>
                </c:pt>
                <c:pt idx="349">
                  <c:v>996.30700000000002</c:v>
                </c:pt>
                <c:pt idx="350">
                  <c:v>996.35199999999998</c:v>
                </c:pt>
                <c:pt idx="351">
                  <c:v>996.59400000000005</c:v>
                </c:pt>
                <c:pt idx="352">
                  <c:v>997.81700000000001</c:v>
                </c:pt>
                <c:pt idx="353">
                  <c:v>997.96199999999999</c:v>
                </c:pt>
                <c:pt idx="354">
                  <c:v>1000.05</c:v>
                </c:pt>
                <c:pt idx="355">
                  <c:v>1002.448</c:v>
                </c:pt>
                <c:pt idx="356">
                  <c:v>1003.697</c:v>
                </c:pt>
                <c:pt idx="357">
                  <c:v>1004.224</c:v>
                </c:pt>
                <c:pt idx="358">
                  <c:v>1006.008</c:v>
                </c:pt>
                <c:pt idx="359">
                  <c:v>1009.433</c:v>
                </c:pt>
                <c:pt idx="360">
                  <c:v>1012.771</c:v>
                </c:pt>
                <c:pt idx="361">
                  <c:v>1014.8440000000001</c:v>
                </c:pt>
                <c:pt idx="362">
                  <c:v>1015.042</c:v>
                </c:pt>
                <c:pt idx="363">
                  <c:v>1015.168</c:v>
                </c:pt>
                <c:pt idx="364">
                  <c:v>1017.669</c:v>
                </c:pt>
                <c:pt idx="365">
                  <c:v>1020.728</c:v>
                </c:pt>
                <c:pt idx="366">
                  <c:v>1020.904</c:v>
                </c:pt>
                <c:pt idx="367">
                  <c:v>1024.2619999999999</c:v>
                </c:pt>
                <c:pt idx="368">
                  <c:v>1026.6389999999999</c:v>
                </c:pt>
                <c:pt idx="369">
                  <c:v>1028.3109999999999</c:v>
                </c:pt>
                <c:pt idx="370">
                  <c:v>1032.374</c:v>
                </c:pt>
                <c:pt idx="371">
                  <c:v>1034.827</c:v>
                </c:pt>
                <c:pt idx="372">
                  <c:v>1038.1099999999999</c:v>
                </c:pt>
                <c:pt idx="373">
                  <c:v>1042.2529999999999</c:v>
                </c:pt>
                <c:pt idx="374">
                  <c:v>1043.845</c:v>
                </c:pt>
                <c:pt idx="375">
                  <c:v>1046.46</c:v>
                </c:pt>
                <c:pt idx="376">
                  <c:v>1049.5809999999999</c:v>
                </c:pt>
                <c:pt idx="377">
                  <c:v>1053.27</c:v>
                </c:pt>
                <c:pt idx="378">
                  <c:v>1055.316</c:v>
                </c:pt>
                <c:pt idx="379">
                  <c:v>1058.0229999999999</c:v>
                </c:pt>
                <c:pt idx="380">
                  <c:v>1060.1559999999999</c:v>
                </c:pt>
                <c:pt idx="381">
                  <c:v>1061.0519999999999</c:v>
                </c:pt>
                <c:pt idx="382">
                  <c:v>1063.5229999999999</c:v>
                </c:pt>
                <c:pt idx="383">
                  <c:v>1066.787</c:v>
                </c:pt>
                <c:pt idx="384">
                  <c:v>1072.5219999999999</c:v>
                </c:pt>
                <c:pt idx="385">
                  <c:v>1074.0309999999999</c:v>
                </c:pt>
                <c:pt idx="386">
                  <c:v>1078.258</c:v>
                </c:pt>
                <c:pt idx="387">
                  <c:v>1082.163</c:v>
                </c:pt>
                <c:pt idx="388">
                  <c:v>1083.9929999999999</c:v>
                </c:pt>
                <c:pt idx="389">
                  <c:v>1089.729</c:v>
                </c:pt>
                <c:pt idx="390">
                  <c:v>1095.4639999999999</c:v>
                </c:pt>
                <c:pt idx="391">
                  <c:v>1096.9739999999999</c:v>
                </c:pt>
                <c:pt idx="392">
                  <c:v>1101.1990000000001</c:v>
                </c:pt>
                <c:pt idx="393">
                  <c:v>1106.9349999999999</c:v>
                </c:pt>
                <c:pt idx="394">
                  <c:v>1112.67</c:v>
                </c:pt>
                <c:pt idx="395">
                  <c:v>1118.4059999999999</c:v>
                </c:pt>
                <c:pt idx="396">
                  <c:v>1124.1410000000001</c:v>
                </c:pt>
                <c:pt idx="397">
                  <c:v>1129.877</c:v>
                </c:pt>
                <c:pt idx="398">
                  <c:v>1135.6120000000001</c:v>
                </c:pt>
                <c:pt idx="399">
                  <c:v>1141.347</c:v>
                </c:pt>
                <c:pt idx="400">
                  <c:v>1147.0830000000001</c:v>
                </c:pt>
                <c:pt idx="401">
                  <c:v>1147.0830000000001</c:v>
                </c:pt>
              </c:numCache>
            </c:numRef>
          </c:xVal>
          <c:yVal>
            <c:numRef>
              <c:f>Foglio6!$B$819:$B$1220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100</c:v>
                </c:pt>
                <c:pt idx="68">
                  <c:v>100</c:v>
                </c:pt>
                <c:pt idx="69">
                  <c:v>100</c:v>
                </c:pt>
                <c:pt idx="70">
                  <c:v>100</c:v>
                </c:pt>
                <c:pt idx="71">
                  <c:v>100</c:v>
                </c:pt>
                <c:pt idx="72">
                  <c:v>100</c:v>
                </c:pt>
                <c:pt idx="73">
                  <c:v>100</c:v>
                </c:pt>
                <c:pt idx="74">
                  <c:v>100</c:v>
                </c:pt>
                <c:pt idx="75">
                  <c:v>99.965000000000003</c:v>
                </c:pt>
                <c:pt idx="76">
                  <c:v>99.956000000000003</c:v>
                </c:pt>
                <c:pt idx="77">
                  <c:v>99.945999999999998</c:v>
                </c:pt>
                <c:pt idx="78">
                  <c:v>99.936999999999998</c:v>
                </c:pt>
                <c:pt idx="79">
                  <c:v>99.933000000000007</c:v>
                </c:pt>
                <c:pt idx="80">
                  <c:v>99.929000000000002</c:v>
                </c:pt>
                <c:pt idx="81">
                  <c:v>99.915000000000006</c:v>
                </c:pt>
                <c:pt idx="82">
                  <c:v>99.822000000000003</c:v>
                </c:pt>
                <c:pt idx="83">
                  <c:v>99.796000000000006</c:v>
                </c:pt>
                <c:pt idx="84">
                  <c:v>99.77</c:v>
                </c:pt>
                <c:pt idx="85">
                  <c:v>99.745000000000005</c:v>
                </c:pt>
                <c:pt idx="86">
                  <c:v>99.629000000000005</c:v>
                </c:pt>
                <c:pt idx="87">
                  <c:v>99.5</c:v>
                </c:pt>
                <c:pt idx="88">
                  <c:v>99.265000000000001</c:v>
                </c:pt>
                <c:pt idx="89">
                  <c:v>99.159000000000006</c:v>
                </c:pt>
                <c:pt idx="90">
                  <c:v>99.105000000000004</c:v>
                </c:pt>
                <c:pt idx="91">
                  <c:v>99</c:v>
                </c:pt>
                <c:pt idx="92">
                  <c:v>98.891000000000005</c:v>
                </c:pt>
                <c:pt idx="93">
                  <c:v>98.724999999999994</c:v>
                </c:pt>
                <c:pt idx="94">
                  <c:v>98.558000000000007</c:v>
                </c:pt>
                <c:pt idx="95">
                  <c:v>98.5</c:v>
                </c:pt>
                <c:pt idx="96">
                  <c:v>98.203000000000003</c:v>
                </c:pt>
                <c:pt idx="97">
                  <c:v>98.100999999999999</c:v>
                </c:pt>
                <c:pt idx="98">
                  <c:v>98</c:v>
                </c:pt>
                <c:pt idx="99">
                  <c:v>97.998999999999995</c:v>
                </c:pt>
                <c:pt idx="100">
                  <c:v>97.5</c:v>
                </c:pt>
                <c:pt idx="101">
                  <c:v>97.245999999999995</c:v>
                </c:pt>
                <c:pt idx="102">
                  <c:v>97.096000000000004</c:v>
                </c:pt>
                <c:pt idx="103">
                  <c:v>97</c:v>
                </c:pt>
                <c:pt idx="104">
                  <c:v>96.707999999999998</c:v>
                </c:pt>
                <c:pt idx="105">
                  <c:v>96.5</c:v>
                </c:pt>
                <c:pt idx="106">
                  <c:v>96</c:v>
                </c:pt>
                <c:pt idx="107">
                  <c:v>95.5</c:v>
                </c:pt>
                <c:pt idx="108">
                  <c:v>95.296999999999997</c:v>
                </c:pt>
                <c:pt idx="109">
                  <c:v>95</c:v>
                </c:pt>
                <c:pt idx="110">
                  <c:v>94.5</c:v>
                </c:pt>
                <c:pt idx="111">
                  <c:v>94.376000000000005</c:v>
                </c:pt>
                <c:pt idx="112">
                  <c:v>94</c:v>
                </c:pt>
                <c:pt idx="113">
                  <c:v>93.5</c:v>
                </c:pt>
                <c:pt idx="114">
                  <c:v>93.215999999999994</c:v>
                </c:pt>
                <c:pt idx="115">
                  <c:v>93</c:v>
                </c:pt>
                <c:pt idx="116">
                  <c:v>92.718000000000004</c:v>
                </c:pt>
                <c:pt idx="117">
                  <c:v>92.513999999999996</c:v>
                </c:pt>
                <c:pt idx="118">
                  <c:v>92.5</c:v>
                </c:pt>
                <c:pt idx="119">
                  <c:v>92.305999999999997</c:v>
                </c:pt>
                <c:pt idx="120">
                  <c:v>92.067999999999998</c:v>
                </c:pt>
                <c:pt idx="121">
                  <c:v>92</c:v>
                </c:pt>
                <c:pt idx="122">
                  <c:v>91.745000000000005</c:v>
                </c:pt>
                <c:pt idx="123">
                  <c:v>91.5</c:v>
                </c:pt>
                <c:pt idx="124">
                  <c:v>91</c:v>
                </c:pt>
                <c:pt idx="125">
                  <c:v>90.98</c:v>
                </c:pt>
                <c:pt idx="126">
                  <c:v>90.5</c:v>
                </c:pt>
                <c:pt idx="127">
                  <c:v>90.162999999999997</c:v>
                </c:pt>
                <c:pt idx="128">
                  <c:v>90</c:v>
                </c:pt>
                <c:pt idx="129">
                  <c:v>89.74</c:v>
                </c:pt>
                <c:pt idx="130">
                  <c:v>89.5</c:v>
                </c:pt>
                <c:pt idx="131">
                  <c:v>89.177000000000007</c:v>
                </c:pt>
                <c:pt idx="132">
                  <c:v>89</c:v>
                </c:pt>
                <c:pt idx="133">
                  <c:v>88.5</c:v>
                </c:pt>
                <c:pt idx="134">
                  <c:v>88</c:v>
                </c:pt>
                <c:pt idx="135">
                  <c:v>87.790999999999997</c:v>
                </c:pt>
                <c:pt idx="136">
                  <c:v>87.5</c:v>
                </c:pt>
                <c:pt idx="137">
                  <c:v>87</c:v>
                </c:pt>
                <c:pt idx="138">
                  <c:v>86.5</c:v>
                </c:pt>
                <c:pt idx="139">
                  <c:v>86</c:v>
                </c:pt>
                <c:pt idx="140">
                  <c:v>85.953999999999994</c:v>
                </c:pt>
                <c:pt idx="141">
                  <c:v>85.5</c:v>
                </c:pt>
                <c:pt idx="142">
                  <c:v>85</c:v>
                </c:pt>
                <c:pt idx="143">
                  <c:v>84.5</c:v>
                </c:pt>
                <c:pt idx="144">
                  <c:v>84.055999999999997</c:v>
                </c:pt>
                <c:pt idx="145">
                  <c:v>84</c:v>
                </c:pt>
                <c:pt idx="146">
                  <c:v>83.5</c:v>
                </c:pt>
                <c:pt idx="147">
                  <c:v>83.325000000000003</c:v>
                </c:pt>
                <c:pt idx="148">
                  <c:v>83</c:v>
                </c:pt>
                <c:pt idx="149">
                  <c:v>82.5</c:v>
                </c:pt>
                <c:pt idx="150">
                  <c:v>82</c:v>
                </c:pt>
                <c:pt idx="151">
                  <c:v>81.88</c:v>
                </c:pt>
                <c:pt idx="152">
                  <c:v>81.5</c:v>
                </c:pt>
                <c:pt idx="153">
                  <c:v>81</c:v>
                </c:pt>
                <c:pt idx="154">
                  <c:v>80.676000000000002</c:v>
                </c:pt>
                <c:pt idx="155">
                  <c:v>80.631</c:v>
                </c:pt>
                <c:pt idx="156">
                  <c:v>80.5</c:v>
                </c:pt>
                <c:pt idx="157">
                  <c:v>80</c:v>
                </c:pt>
                <c:pt idx="158">
                  <c:v>79.853999999999999</c:v>
                </c:pt>
                <c:pt idx="159">
                  <c:v>79.5</c:v>
                </c:pt>
                <c:pt idx="160">
                  <c:v>79</c:v>
                </c:pt>
                <c:pt idx="161">
                  <c:v>78.813999999999993</c:v>
                </c:pt>
                <c:pt idx="162">
                  <c:v>78.5</c:v>
                </c:pt>
                <c:pt idx="163">
                  <c:v>78.369</c:v>
                </c:pt>
                <c:pt idx="164">
                  <c:v>78</c:v>
                </c:pt>
                <c:pt idx="165">
                  <c:v>77.5</c:v>
                </c:pt>
                <c:pt idx="166">
                  <c:v>77</c:v>
                </c:pt>
                <c:pt idx="167">
                  <c:v>76.5</c:v>
                </c:pt>
                <c:pt idx="168">
                  <c:v>76.037000000000006</c:v>
                </c:pt>
                <c:pt idx="169">
                  <c:v>76</c:v>
                </c:pt>
                <c:pt idx="170">
                  <c:v>75.5</c:v>
                </c:pt>
                <c:pt idx="171">
                  <c:v>75</c:v>
                </c:pt>
                <c:pt idx="172">
                  <c:v>74.5</c:v>
                </c:pt>
                <c:pt idx="173">
                  <c:v>74</c:v>
                </c:pt>
                <c:pt idx="174">
                  <c:v>73.695999999999998</c:v>
                </c:pt>
                <c:pt idx="175">
                  <c:v>73.5</c:v>
                </c:pt>
                <c:pt idx="176">
                  <c:v>73</c:v>
                </c:pt>
                <c:pt idx="177">
                  <c:v>72.5</c:v>
                </c:pt>
                <c:pt idx="178">
                  <c:v>72.393000000000001</c:v>
                </c:pt>
                <c:pt idx="179">
                  <c:v>72</c:v>
                </c:pt>
                <c:pt idx="180">
                  <c:v>71.611999999999995</c:v>
                </c:pt>
                <c:pt idx="181">
                  <c:v>71.5</c:v>
                </c:pt>
                <c:pt idx="182">
                  <c:v>71.218000000000004</c:v>
                </c:pt>
                <c:pt idx="183">
                  <c:v>71</c:v>
                </c:pt>
                <c:pt idx="184">
                  <c:v>70.944999999999993</c:v>
                </c:pt>
                <c:pt idx="185">
                  <c:v>70.671999999999997</c:v>
                </c:pt>
                <c:pt idx="186">
                  <c:v>70.5</c:v>
                </c:pt>
                <c:pt idx="187">
                  <c:v>70</c:v>
                </c:pt>
                <c:pt idx="188">
                  <c:v>69.805000000000007</c:v>
                </c:pt>
                <c:pt idx="189">
                  <c:v>69.5</c:v>
                </c:pt>
                <c:pt idx="190">
                  <c:v>69.064999999999998</c:v>
                </c:pt>
                <c:pt idx="191">
                  <c:v>69</c:v>
                </c:pt>
                <c:pt idx="192">
                  <c:v>68.5</c:v>
                </c:pt>
                <c:pt idx="193">
                  <c:v>68.143000000000001</c:v>
                </c:pt>
                <c:pt idx="194">
                  <c:v>68</c:v>
                </c:pt>
                <c:pt idx="195">
                  <c:v>67.5</c:v>
                </c:pt>
                <c:pt idx="196">
                  <c:v>67</c:v>
                </c:pt>
                <c:pt idx="197">
                  <c:v>66.5</c:v>
                </c:pt>
                <c:pt idx="198">
                  <c:v>66</c:v>
                </c:pt>
                <c:pt idx="199">
                  <c:v>65.5</c:v>
                </c:pt>
                <c:pt idx="200">
                  <c:v>65</c:v>
                </c:pt>
                <c:pt idx="201">
                  <c:v>64.5</c:v>
                </c:pt>
                <c:pt idx="202">
                  <c:v>64.161000000000001</c:v>
                </c:pt>
                <c:pt idx="203">
                  <c:v>64</c:v>
                </c:pt>
                <c:pt idx="204">
                  <c:v>63.5</c:v>
                </c:pt>
                <c:pt idx="205">
                  <c:v>63</c:v>
                </c:pt>
                <c:pt idx="206">
                  <c:v>62.509</c:v>
                </c:pt>
                <c:pt idx="207">
                  <c:v>62.5</c:v>
                </c:pt>
                <c:pt idx="208">
                  <c:v>62</c:v>
                </c:pt>
                <c:pt idx="209">
                  <c:v>61.5</c:v>
                </c:pt>
                <c:pt idx="210">
                  <c:v>61</c:v>
                </c:pt>
                <c:pt idx="211">
                  <c:v>60.5</c:v>
                </c:pt>
                <c:pt idx="212">
                  <c:v>60.125</c:v>
                </c:pt>
                <c:pt idx="213">
                  <c:v>60</c:v>
                </c:pt>
                <c:pt idx="214">
                  <c:v>59.5</c:v>
                </c:pt>
                <c:pt idx="215">
                  <c:v>59</c:v>
                </c:pt>
                <c:pt idx="216">
                  <c:v>58.5</c:v>
                </c:pt>
                <c:pt idx="217">
                  <c:v>58.027999999999999</c:v>
                </c:pt>
                <c:pt idx="218">
                  <c:v>58</c:v>
                </c:pt>
                <c:pt idx="219">
                  <c:v>57.5</c:v>
                </c:pt>
                <c:pt idx="220">
                  <c:v>57</c:v>
                </c:pt>
                <c:pt idx="221">
                  <c:v>56.5</c:v>
                </c:pt>
                <c:pt idx="222">
                  <c:v>56</c:v>
                </c:pt>
                <c:pt idx="223">
                  <c:v>55.5</c:v>
                </c:pt>
                <c:pt idx="224">
                  <c:v>55.167000000000002</c:v>
                </c:pt>
                <c:pt idx="225">
                  <c:v>55</c:v>
                </c:pt>
                <c:pt idx="226">
                  <c:v>54.738</c:v>
                </c:pt>
                <c:pt idx="227">
                  <c:v>54.5</c:v>
                </c:pt>
                <c:pt idx="228">
                  <c:v>54.423999999999999</c:v>
                </c:pt>
                <c:pt idx="229">
                  <c:v>54</c:v>
                </c:pt>
                <c:pt idx="230">
                  <c:v>53.697000000000003</c:v>
                </c:pt>
                <c:pt idx="231">
                  <c:v>53.5</c:v>
                </c:pt>
                <c:pt idx="232">
                  <c:v>53.017000000000003</c:v>
                </c:pt>
                <c:pt idx="233">
                  <c:v>53</c:v>
                </c:pt>
                <c:pt idx="234">
                  <c:v>52.5</c:v>
                </c:pt>
                <c:pt idx="235">
                  <c:v>52.3</c:v>
                </c:pt>
                <c:pt idx="236">
                  <c:v>52</c:v>
                </c:pt>
                <c:pt idx="237">
                  <c:v>51.5</c:v>
                </c:pt>
                <c:pt idx="238">
                  <c:v>51</c:v>
                </c:pt>
                <c:pt idx="239">
                  <c:v>50.606000000000002</c:v>
                </c:pt>
                <c:pt idx="240">
                  <c:v>50.5</c:v>
                </c:pt>
                <c:pt idx="241">
                  <c:v>50</c:v>
                </c:pt>
                <c:pt idx="242">
                  <c:v>49.5</c:v>
                </c:pt>
                <c:pt idx="243">
                  <c:v>49.329000000000001</c:v>
                </c:pt>
                <c:pt idx="244">
                  <c:v>49</c:v>
                </c:pt>
                <c:pt idx="245">
                  <c:v>48.5</c:v>
                </c:pt>
                <c:pt idx="246">
                  <c:v>48.151000000000003</c:v>
                </c:pt>
                <c:pt idx="247">
                  <c:v>48</c:v>
                </c:pt>
                <c:pt idx="248">
                  <c:v>47.5</c:v>
                </c:pt>
                <c:pt idx="249">
                  <c:v>47.042000000000002</c:v>
                </c:pt>
                <c:pt idx="250">
                  <c:v>47</c:v>
                </c:pt>
                <c:pt idx="251">
                  <c:v>46.5</c:v>
                </c:pt>
                <c:pt idx="252">
                  <c:v>46.499000000000002</c:v>
                </c:pt>
                <c:pt idx="253">
                  <c:v>46</c:v>
                </c:pt>
                <c:pt idx="254">
                  <c:v>45.970999999999997</c:v>
                </c:pt>
                <c:pt idx="255">
                  <c:v>45.5</c:v>
                </c:pt>
                <c:pt idx="256">
                  <c:v>45</c:v>
                </c:pt>
                <c:pt idx="257">
                  <c:v>44.5</c:v>
                </c:pt>
                <c:pt idx="258">
                  <c:v>44.29</c:v>
                </c:pt>
                <c:pt idx="259">
                  <c:v>44</c:v>
                </c:pt>
                <c:pt idx="260">
                  <c:v>43.5</c:v>
                </c:pt>
                <c:pt idx="261">
                  <c:v>43</c:v>
                </c:pt>
                <c:pt idx="262">
                  <c:v>42.5</c:v>
                </c:pt>
                <c:pt idx="263">
                  <c:v>42</c:v>
                </c:pt>
                <c:pt idx="264">
                  <c:v>41.5</c:v>
                </c:pt>
                <c:pt idx="265">
                  <c:v>41</c:v>
                </c:pt>
                <c:pt idx="266">
                  <c:v>40.942999999999998</c:v>
                </c:pt>
                <c:pt idx="267">
                  <c:v>40.5</c:v>
                </c:pt>
                <c:pt idx="268">
                  <c:v>40</c:v>
                </c:pt>
                <c:pt idx="269">
                  <c:v>39.5</c:v>
                </c:pt>
                <c:pt idx="270">
                  <c:v>39</c:v>
                </c:pt>
                <c:pt idx="271">
                  <c:v>38.5</c:v>
                </c:pt>
                <c:pt idx="272">
                  <c:v>38.222999999999999</c:v>
                </c:pt>
                <c:pt idx="273">
                  <c:v>38</c:v>
                </c:pt>
                <c:pt idx="274">
                  <c:v>37.5</c:v>
                </c:pt>
                <c:pt idx="275">
                  <c:v>37</c:v>
                </c:pt>
                <c:pt idx="276">
                  <c:v>36.5</c:v>
                </c:pt>
                <c:pt idx="277">
                  <c:v>36</c:v>
                </c:pt>
                <c:pt idx="278">
                  <c:v>35.662999999999997</c:v>
                </c:pt>
                <c:pt idx="279">
                  <c:v>35.5</c:v>
                </c:pt>
                <c:pt idx="280">
                  <c:v>35</c:v>
                </c:pt>
                <c:pt idx="281">
                  <c:v>34.744</c:v>
                </c:pt>
                <c:pt idx="282">
                  <c:v>34.5</c:v>
                </c:pt>
                <c:pt idx="283">
                  <c:v>34</c:v>
                </c:pt>
                <c:pt idx="284">
                  <c:v>33.5</c:v>
                </c:pt>
                <c:pt idx="285">
                  <c:v>33</c:v>
                </c:pt>
                <c:pt idx="286">
                  <c:v>32.622999999999998</c:v>
                </c:pt>
                <c:pt idx="287">
                  <c:v>32.5</c:v>
                </c:pt>
                <c:pt idx="288">
                  <c:v>32.173999999999999</c:v>
                </c:pt>
                <c:pt idx="289">
                  <c:v>32</c:v>
                </c:pt>
                <c:pt idx="290">
                  <c:v>31.984999999999999</c:v>
                </c:pt>
                <c:pt idx="291">
                  <c:v>31.756</c:v>
                </c:pt>
                <c:pt idx="292">
                  <c:v>31.5</c:v>
                </c:pt>
                <c:pt idx="293">
                  <c:v>31.068999999999999</c:v>
                </c:pt>
                <c:pt idx="294">
                  <c:v>31</c:v>
                </c:pt>
                <c:pt idx="295">
                  <c:v>30.5</c:v>
                </c:pt>
                <c:pt idx="296">
                  <c:v>30</c:v>
                </c:pt>
                <c:pt idx="297">
                  <c:v>29.5</c:v>
                </c:pt>
                <c:pt idx="298">
                  <c:v>29</c:v>
                </c:pt>
                <c:pt idx="299">
                  <c:v>28.5</c:v>
                </c:pt>
                <c:pt idx="300">
                  <c:v>28.091999999999999</c:v>
                </c:pt>
                <c:pt idx="301">
                  <c:v>28</c:v>
                </c:pt>
                <c:pt idx="302">
                  <c:v>27.5</c:v>
                </c:pt>
                <c:pt idx="303">
                  <c:v>27</c:v>
                </c:pt>
                <c:pt idx="304">
                  <c:v>26.645</c:v>
                </c:pt>
                <c:pt idx="305">
                  <c:v>26.5</c:v>
                </c:pt>
                <c:pt idx="306">
                  <c:v>26</c:v>
                </c:pt>
                <c:pt idx="307">
                  <c:v>25.824999999999999</c:v>
                </c:pt>
                <c:pt idx="308">
                  <c:v>25.5</c:v>
                </c:pt>
                <c:pt idx="309">
                  <c:v>25</c:v>
                </c:pt>
                <c:pt idx="310">
                  <c:v>24.596</c:v>
                </c:pt>
                <c:pt idx="311">
                  <c:v>24.5</c:v>
                </c:pt>
                <c:pt idx="312">
                  <c:v>24</c:v>
                </c:pt>
                <c:pt idx="313">
                  <c:v>23.5</c:v>
                </c:pt>
                <c:pt idx="314">
                  <c:v>23.146999999999998</c:v>
                </c:pt>
                <c:pt idx="315">
                  <c:v>23</c:v>
                </c:pt>
                <c:pt idx="316">
                  <c:v>22.748000000000001</c:v>
                </c:pt>
                <c:pt idx="317">
                  <c:v>22.5</c:v>
                </c:pt>
                <c:pt idx="318">
                  <c:v>22</c:v>
                </c:pt>
                <c:pt idx="319">
                  <c:v>21.960999999999999</c:v>
                </c:pt>
                <c:pt idx="320">
                  <c:v>21.686</c:v>
                </c:pt>
                <c:pt idx="321">
                  <c:v>21.5</c:v>
                </c:pt>
                <c:pt idx="322">
                  <c:v>21.058</c:v>
                </c:pt>
                <c:pt idx="323">
                  <c:v>21</c:v>
                </c:pt>
                <c:pt idx="324">
                  <c:v>20.5</c:v>
                </c:pt>
                <c:pt idx="325">
                  <c:v>20</c:v>
                </c:pt>
                <c:pt idx="326">
                  <c:v>19.5</c:v>
                </c:pt>
                <c:pt idx="327">
                  <c:v>19</c:v>
                </c:pt>
                <c:pt idx="328">
                  <c:v>18.879000000000001</c:v>
                </c:pt>
                <c:pt idx="329">
                  <c:v>18.5</c:v>
                </c:pt>
                <c:pt idx="330">
                  <c:v>18</c:v>
                </c:pt>
                <c:pt idx="331">
                  <c:v>17.5</c:v>
                </c:pt>
                <c:pt idx="332">
                  <c:v>17</c:v>
                </c:pt>
                <c:pt idx="333">
                  <c:v>16.5</c:v>
                </c:pt>
                <c:pt idx="334">
                  <c:v>16.126999999999999</c:v>
                </c:pt>
                <c:pt idx="335">
                  <c:v>16</c:v>
                </c:pt>
                <c:pt idx="336">
                  <c:v>15.723000000000001</c:v>
                </c:pt>
                <c:pt idx="337">
                  <c:v>15.5</c:v>
                </c:pt>
                <c:pt idx="338">
                  <c:v>15.319000000000001</c:v>
                </c:pt>
                <c:pt idx="339">
                  <c:v>15</c:v>
                </c:pt>
                <c:pt idx="340">
                  <c:v>14.601000000000001</c:v>
                </c:pt>
                <c:pt idx="341">
                  <c:v>14.5</c:v>
                </c:pt>
                <c:pt idx="342">
                  <c:v>14.106</c:v>
                </c:pt>
                <c:pt idx="343">
                  <c:v>14</c:v>
                </c:pt>
                <c:pt idx="344">
                  <c:v>13.5</c:v>
                </c:pt>
                <c:pt idx="345">
                  <c:v>13.352</c:v>
                </c:pt>
                <c:pt idx="346">
                  <c:v>13.125</c:v>
                </c:pt>
                <c:pt idx="347">
                  <c:v>13</c:v>
                </c:pt>
                <c:pt idx="348">
                  <c:v>12.898</c:v>
                </c:pt>
                <c:pt idx="349">
                  <c:v>12.5</c:v>
                </c:pt>
                <c:pt idx="350">
                  <c:v>12</c:v>
                </c:pt>
                <c:pt idx="351">
                  <c:v>11.5</c:v>
                </c:pt>
                <c:pt idx="352">
                  <c:v>11</c:v>
                </c:pt>
                <c:pt idx="353">
                  <c:v>10.941000000000001</c:v>
                </c:pt>
                <c:pt idx="354">
                  <c:v>10.5</c:v>
                </c:pt>
                <c:pt idx="355">
                  <c:v>10</c:v>
                </c:pt>
                <c:pt idx="356">
                  <c:v>9.6590000000000007</c:v>
                </c:pt>
                <c:pt idx="357">
                  <c:v>9.5</c:v>
                </c:pt>
                <c:pt idx="358">
                  <c:v>9</c:v>
                </c:pt>
                <c:pt idx="359">
                  <c:v>8.7469999999999999</c:v>
                </c:pt>
                <c:pt idx="360">
                  <c:v>8.5</c:v>
                </c:pt>
                <c:pt idx="361">
                  <c:v>8</c:v>
                </c:pt>
                <c:pt idx="362">
                  <c:v>7.5</c:v>
                </c:pt>
                <c:pt idx="363">
                  <c:v>7.4089999999999998</c:v>
                </c:pt>
                <c:pt idx="364">
                  <c:v>7</c:v>
                </c:pt>
                <c:pt idx="365">
                  <c:v>6.5</c:v>
                </c:pt>
                <c:pt idx="366">
                  <c:v>6.4710000000000001</c:v>
                </c:pt>
                <c:pt idx="367">
                  <c:v>6</c:v>
                </c:pt>
                <c:pt idx="368">
                  <c:v>5.6840000000000002</c:v>
                </c:pt>
                <c:pt idx="369">
                  <c:v>5.5</c:v>
                </c:pt>
                <c:pt idx="370">
                  <c:v>5.165</c:v>
                </c:pt>
                <c:pt idx="371">
                  <c:v>5</c:v>
                </c:pt>
                <c:pt idx="372">
                  <c:v>4.7789999999999999</c:v>
                </c:pt>
                <c:pt idx="373">
                  <c:v>4.5</c:v>
                </c:pt>
                <c:pt idx="374">
                  <c:v>4.3330000000000002</c:v>
                </c:pt>
                <c:pt idx="375">
                  <c:v>4</c:v>
                </c:pt>
                <c:pt idx="376">
                  <c:v>3.6909999999999998</c:v>
                </c:pt>
                <c:pt idx="377">
                  <c:v>3.5</c:v>
                </c:pt>
                <c:pt idx="378">
                  <c:v>3.3940000000000001</c:v>
                </c:pt>
                <c:pt idx="379">
                  <c:v>3</c:v>
                </c:pt>
                <c:pt idx="380">
                  <c:v>2.5</c:v>
                </c:pt>
                <c:pt idx="381">
                  <c:v>2.367</c:v>
                </c:pt>
                <c:pt idx="382">
                  <c:v>2</c:v>
                </c:pt>
                <c:pt idx="383">
                  <c:v>1.8109999999999999</c:v>
                </c:pt>
                <c:pt idx="384">
                  <c:v>1.5649999999999999</c:v>
                </c:pt>
                <c:pt idx="385">
                  <c:v>1.5</c:v>
                </c:pt>
                <c:pt idx="386">
                  <c:v>1.266</c:v>
                </c:pt>
                <c:pt idx="387">
                  <c:v>1</c:v>
                </c:pt>
                <c:pt idx="388">
                  <c:v>0.89400000000000002</c:v>
                </c:pt>
                <c:pt idx="389">
                  <c:v>0.72</c:v>
                </c:pt>
                <c:pt idx="390">
                  <c:v>0.54600000000000004</c:v>
                </c:pt>
                <c:pt idx="391">
                  <c:v>0.5</c:v>
                </c:pt>
                <c:pt idx="392">
                  <c:v>0.39</c:v>
                </c:pt>
                <c:pt idx="393">
                  <c:v>0.32700000000000001</c:v>
                </c:pt>
                <c:pt idx="394">
                  <c:v>0.30399999999999999</c:v>
                </c:pt>
                <c:pt idx="395">
                  <c:v>0.28000000000000003</c:v>
                </c:pt>
                <c:pt idx="396">
                  <c:v>0.25700000000000001</c:v>
                </c:pt>
                <c:pt idx="397">
                  <c:v>0.23300000000000001</c:v>
                </c:pt>
                <c:pt idx="398">
                  <c:v>0.21</c:v>
                </c:pt>
                <c:pt idx="399">
                  <c:v>0.153</c:v>
                </c:pt>
                <c:pt idx="400">
                  <c:v>5.7000000000000002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496-4CC3-8534-400DC70DE595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C$819:$C$1220</c:f>
              <c:numCache>
                <c:formatCode>General</c:formatCode>
                <c:ptCount val="402"/>
                <c:pt idx="0">
                  <c:v>0</c:v>
                </c:pt>
                <c:pt idx="1">
                  <c:v>5.7779999999999996</c:v>
                </c:pt>
                <c:pt idx="2">
                  <c:v>11.555</c:v>
                </c:pt>
                <c:pt idx="3">
                  <c:v>17.332999999999998</c:v>
                </c:pt>
                <c:pt idx="4">
                  <c:v>23.11</c:v>
                </c:pt>
                <c:pt idx="5">
                  <c:v>28.888000000000002</c:v>
                </c:pt>
                <c:pt idx="6">
                  <c:v>34.664999999999999</c:v>
                </c:pt>
                <c:pt idx="7">
                  <c:v>40.442999999999998</c:v>
                </c:pt>
                <c:pt idx="8">
                  <c:v>46.22</c:v>
                </c:pt>
                <c:pt idx="9">
                  <c:v>51.997999999999998</c:v>
                </c:pt>
                <c:pt idx="10">
                  <c:v>57.774999999999999</c:v>
                </c:pt>
                <c:pt idx="11">
                  <c:v>63.552999999999997</c:v>
                </c:pt>
                <c:pt idx="12">
                  <c:v>69.33</c:v>
                </c:pt>
                <c:pt idx="13">
                  <c:v>75.108000000000004</c:v>
                </c:pt>
                <c:pt idx="14">
                  <c:v>80.885000000000005</c:v>
                </c:pt>
                <c:pt idx="15">
                  <c:v>86.662999999999997</c:v>
                </c:pt>
                <c:pt idx="16">
                  <c:v>92.44</c:v>
                </c:pt>
                <c:pt idx="17">
                  <c:v>98.218000000000004</c:v>
                </c:pt>
                <c:pt idx="18">
                  <c:v>103.995</c:v>
                </c:pt>
                <c:pt idx="19">
                  <c:v>109.773</c:v>
                </c:pt>
                <c:pt idx="20">
                  <c:v>115.55</c:v>
                </c:pt>
                <c:pt idx="21">
                  <c:v>121.328</c:v>
                </c:pt>
                <c:pt idx="22">
                  <c:v>127.105</c:v>
                </c:pt>
                <c:pt idx="23">
                  <c:v>132.88300000000001</c:v>
                </c:pt>
                <c:pt idx="24">
                  <c:v>138.66</c:v>
                </c:pt>
                <c:pt idx="25">
                  <c:v>144.43799999999999</c:v>
                </c:pt>
                <c:pt idx="26">
                  <c:v>150.215</c:v>
                </c:pt>
                <c:pt idx="27">
                  <c:v>155.99299999999999</c:v>
                </c:pt>
                <c:pt idx="28">
                  <c:v>161.77000000000001</c:v>
                </c:pt>
                <c:pt idx="29">
                  <c:v>167.548</c:v>
                </c:pt>
                <c:pt idx="30">
                  <c:v>173.32499999999999</c:v>
                </c:pt>
                <c:pt idx="31">
                  <c:v>179.10300000000001</c:v>
                </c:pt>
                <c:pt idx="32">
                  <c:v>184.88</c:v>
                </c:pt>
                <c:pt idx="33">
                  <c:v>190.65799999999999</c:v>
                </c:pt>
                <c:pt idx="34">
                  <c:v>196.435</c:v>
                </c:pt>
                <c:pt idx="35">
                  <c:v>202.21299999999999</c:v>
                </c:pt>
                <c:pt idx="36">
                  <c:v>207.99</c:v>
                </c:pt>
                <c:pt idx="37">
                  <c:v>213.768</c:v>
                </c:pt>
                <c:pt idx="38">
                  <c:v>219.54499999999999</c:v>
                </c:pt>
                <c:pt idx="39">
                  <c:v>225.32300000000001</c:v>
                </c:pt>
                <c:pt idx="40">
                  <c:v>231.1</c:v>
                </c:pt>
                <c:pt idx="41">
                  <c:v>236.87799999999999</c:v>
                </c:pt>
                <c:pt idx="42">
                  <c:v>242.655</c:v>
                </c:pt>
                <c:pt idx="43">
                  <c:v>248.43299999999999</c:v>
                </c:pt>
                <c:pt idx="44">
                  <c:v>254.21</c:v>
                </c:pt>
                <c:pt idx="45">
                  <c:v>259.988</c:v>
                </c:pt>
                <c:pt idx="46">
                  <c:v>265.76499999999999</c:v>
                </c:pt>
                <c:pt idx="47">
                  <c:v>271.54300000000001</c:v>
                </c:pt>
                <c:pt idx="48">
                  <c:v>277.32</c:v>
                </c:pt>
                <c:pt idx="49">
                  <c:v>283.09800000000001</c:v>
                </c:pt>
                <c:pt idx="50">
                  <c:v>288.875</c:v>
                </c:pt>
                <c:pt idx="51">
                  <c:v>294.65300000000002</c:v>
                </c:pt>
                <c:pt idx="52">
                  <c:v>300.43</c:v>
                </c:pt>
                <c:pt idx="53">
                  <c:v>306.20800000000003</c:v>
                </c:pt>
                <c:pt idx="54">
                  <c:v>311.98500000000001</c:v>
                </c:pt>
                <c:pt idx="55">
                  <c:v>317.76299999999998</c:v>
                </c:pt>
                <c:pt idx="56">
                  <c:v>323.54000000000002</c:v>
                </c:pt>
                <c:pt idx="57">
                  <c:v>329.31799999999998</c:v>
                </c:pt>
                <c:pt idx="58">
                  <c:v>335.09500000000003</c:v>
                </c:pt>
                <c:pt idx="59">
                  <c:v>340.87299999999999</c:v>
                </c:pt>
                <c:pt idx="60">
                  <c:v>346.65100000000001</c:v>
                </c:pt>
                <c:pt idx="61">
                  <c:v>352.428</c:v>
                </c:pt>
                <c:pt idx="62">
                  <c:v>358.20600000000002</c:v>
                </c:pt>
                <c:pt idx="63">
                  <c:v>363.983</c:v>
                </c:pt>
                <c:pt idx="64">
                  <c:v>369.76100000000002</c:v>
                </c:pt>
                <c:pt idx="65">
                  <c:v>375.53800000000001</c:v>
                </c:pt>
                <c:pt idx="66">
                  <c:v>379.017</c:v>
                </c:pt>
                <c:pt idx="67">
                  <c:v>381.31599999999997</c:v>
                </c:pt>
                <c:pt idx="68">
                  <c:v>387.09300000000002</c:v>
                </c:pt>
                <c:pt idx="69">
                  <c:v>392.87099999999998</c:v>
                </c:pt>
                <c:pt idx="70">
                  <c:v>398.64800000000002</c:v>
                </c:pt>
                <c:pt idx="71">
                  <c:v>404.42599999999999</c:v>
                </c:pt>
                <c:pt idx="72">
                  <c:v>410.20299999999997</c:v>
                </c:pt>
                <c:pt idx="73">
                  <c:v>415.98099999999999</c:v>
                </c:pt>
                <c:pt idx="74">
                  <c:v>421.75799999999998</c:v>
                </c:pt>
                <c:pt idx="75">
                  <c:v>427.536</c:v>
                </c:pt>
                <c:pt idx="76">
                  <c:v>433.31299999999999</c:v>
                </c:pt>
                <c:pt idx="77">
                  <c:v>439.09100000000001</c:v>
                </c:pt>
                <c:pt idx="78">
                  <c:v>444.86799999999999</c:v>
                </c:pt>
                <c:pt idx="79">
                  <c:v>450.64600000000002</c:v>
                </c:pt>
                <c:pt idx="80">
                  <c:v>451.48399999999998</c:v>
                </c:pt>
                <c:pt idx="81">
                  <c:v>456.41699999999997</c:v>
                </c:pt>
                <c:pt idx="82">
                  <c:v>456.423</c:v>
                </c:pt>
                <c:pt idx="83">
                  <c:v>459.74200000000002</c:v>
                </c:pt>
                <c:pt idx="84">
                  <c:v>462.20100000000002</c:v>
                </c:pt>
                <c:pt idx="85">
                  <c:v>467.01299999999998</c:v>
                </c:pt>
                <c:pt idx="86">
                  <c:v>467.97800000000001</c:v>
                </c:pt>
                <c:pt idx="87">
                  <c:v>473.75599999999997</c:v>
                </c:pt>
                <c:pt idx="88">
                  <c:v>476.601</c:v>
                </c:pt>
                <c:pt idx="89">
                  <c:v>479.53300000000002</c:v>
                </c:pt>
                <c:pt idx="90">
                  <c:v>485.31099999999998</c:v>
                </c:pt>
                <c:pt idx="91">
                  <c:v>486.32400000000001</c:v>
                </c:pt>
                <c:pt idx="92">
                  <c:v>490.012</c:v>
                </c:pt>
                <c:pt idx="93">
                  <c:v>491.08800000000002</c:v>
                </c:pt>
                <c:pt idx="94">
                  <c:v>493.37700000000001</c:v>
                </c:pt>
                <c:pt idx="95">
                  <c:v>496.62200000000001</c:v>
                </c:pt>
                <c:pt idx="96">
                  <c:v>496.86599999999999</c:v>
                </c:pt>
                <c:pt idx="97">
                  <c:v>499.298</c:v>
                </c:pt>
                <c:pt idx="98">
                  <c:v>502.64299999999997</c:v>
                </c:pt>
                <c:pt idx="99">
                  <c:v>506.35599999999999</c:v>
                </c:pt>
                <c:pt idx="100">
                  <c:v>508.42099999999999</c:v>
                </c:pt>
                <c:pt idx="101">
                  <c:v>514.03300000000002</c:v>
                </c:pt>
                <c:pt idx="102">
                  <c:v>514.19799999999998</c:v>
                </c:pt>
                <c:pt idx="103">
                  <c:v>518.89300000000003</c:v>
                </c:pt>
                <c:pt idx="104">
                  <c:v>519.976</c:v>
                </c:pt>
                <c:pt idx="105">
                  <c:v>525.75300000000004</c:v>
                </c:pt>
                <c:pt idx="106">
                  <c:v>527.63499999999999</c:v>
                </c:pt>
                <c:pt idx="107">
                  <c:v>531.53099999999995</c:v>
                </c:pt>
                <c:pt idx="108">
                  <c:v>535.03</c:v>
                </c:pt>
                <c:pt idx="109">
                  <c:v>537.30799999999999</c:v>
                </c:pt>
                <c:pt idx="110">
                  <c:v>537.61800000000005</c:v>
                </c:pt>
                <c:pt idx="111">
                  <c:v>541.67600000000004</c:v>
                </c:pt>
                <c:pt idx="112">
                  <c:v>543.08600000000001</c:v>
                </c:pt>
                <c:pt idx="113">
                  <c:v>548.62599999999998</c:v>
                </c:pt>
                <c:pt idx="114">
                  <c:v>548.86300000000006</c:v>
                </c:pt>
                <c:pt idx="115">
                  <c:v>550.81299999999999</c:v>
                </c:pt>
                <c:pt idx="116">
                  <c:v>552.46600000000001</c:v>
                </c:pt>
                <c:pt idx="117">
                  <c:v>552.99099999999999</c:v>
                </c:pt>
                <c:pt idx="118">
                  <c:v>553.90499999999997</c:v>
                </c:pt>
                <c:pt idx="119">
                  <c:v>554.64099999999996</c:v>
                </c:pt>
                <c:pt idx="120">
                  <c:v>557.39300000000003</c:v>
                </c:pt>
                <c:pt idx="121">
                  <c:v>560.41800000000001</c:v>
                </c:pt>
                <c:pt idx="122">
                  <c:v>564.399</c:v>
                </c:pt>
                <c:pt idx="123">
                  <c:v>566.19600000000003</c:v>
                </c:pt>
                <c:pt idx="124">
                  <c:v>569.95100000000002</c:v>
                </c:pt>
                <c:pt idx="125">
                  <c:v>571.97299999999996</c:v>
                </c:pt>
                <c:pt idx="126">
                  <c:v>572.38599999999997</c:v>
                </c:pt>
                <c:pt idx="127">
                  <c:v>573.97799999999995</c:v>
                </c:pt>
                <c:pt idx="128">
                  <c:v>575.52499999999998</c:v>
                </c:pt>
                <c:pt idx="129">
                  <c:v>577.06799999999998</c:v>
                </c:pt>
                <c:pt idx="130">
                  <c:v>577.75099999999998</c:v>
                </c:pt>
                <c:pt idx="131">
                  <c:v>582.01099999999997</c:v>
                </c:pt>
                <c:pt idx="132">
                  <c:v>583.52800000000002</c:v>
                </c:pt>
                <c:pt idx="133">
                  <c:v>587.11099999999999</c:v>
                </c:pt>
                <c:pt idx="134">
                  <c:v>587.51400000000001</c:v>
                </c:pt>
                <c:pt idx="135">
                  <c:v>589.30600000000004</c:v>
                </c:pt>
                <c:pt idx="136">
                  <c:v>590.23699999999997</c:v>
                </c:pt>
                <c:pt idx="137">
                  <c:v>594.947</c:v>
                </c:pt>
                <c:pt idx="138">
                  <c:v>595.08299999999997</c:v>
                </c:pt>
                <c:pt idx="139">
                  <c:v>595.66600000000005</c:v>
                </c:pt>
                <c:pt idx="140">
                  <c:v>596.21600000000001</c:v>
                </c:pt>
                <c:pt idx="141">
                  <c:v>597.19600000000003</c:v>
                </c:pt>
                <c:pt idx="142">
                  <c:v>600.86099999999999</c:v>
                </c:pt>
                <c:pt idx="143">
                  <c:v>602.29</c:v>
                </c:pt>
                <c:pt idx="144">
                  <c:v>604.649</c:v>
                </c:pt>
                <c:pt idx="145">
                  <c:v>606.63800000000003</c:v>
                </c:pt>
                <c:pt idx="146">
                  <c:v>612.41600000000005</c:v>
                </c:pt>
                <c:pt idx="147">
                  <c:v>615.04600000000005</c:v>
                </c:pt>
                <c:pt idx="148">
                  <c:v>617.38699999999994</c:v>
                </c:pt>
                <c:pt idx="149">
                  <c:v>618.19299999999998</c:v>
                </c:pt>
                <c:pt idx="150">
                  <c:v>618.87900000000002</c:v>
                </c:pt>
                <c:pt idx="151">
                  <c:v>619.07000000000005</c:v>
                </c:pt>
                <c:pt idx="152">
                  <c:v>619.846</c:v>
                </c:pt>
                <c:pt idx="153">
                  <c:v>623.971</c:v>
                </c:pt>
                <c:pt idx="154">
                  <c:v>629.47500000000002</c:v>
                </c:pt>
                <c:pt idx="155">
                  <c:v>629.74800000000005</c:v>
                </c:pt>
                <c:pt idx="156">
                  <c:v>635.11400000000003</c:v>
                </c:pt>
                <c:pt idx="157">
                  <c:v>635.52599999999995</c:v>
                </c:pt>
                <c:pt idx="158">
                  <c:v>636.90800000000002</c:v>
                </c:pt>
                <c:pt idx="159">
                  <c:v>637.67200000000003</c:v>
                </c:pt>
                <c:pt idx="160">
                  <c:v>638.43600000000004</c:v>
                </c:pt>
                <c:pt idx="161">
                  <c:v>641.303</c:v>
                </c:pt>
                <c:pt idx="162">
                  <c:v>645.05200000000002</c:v>
                </c:pt>
                <c:pt idx="163">
                  <c:v>647.08100000000002</c:v>
                </c:pt>
                <c:pt idx="164">
                  <c:v>651.76300000000003</c:v>
                </c:pt>
                <c:pt idx="165">
                  <c:v>652.81200000000001</c:v>
                </c:pt>
                <c:pt idx="166">
                  <c:v>652.85799999999995</c:v>
                </c:pt>
                <c:pt idx="167">
                  <c:v>652.96299999999997</c:v>
                </c:pt>
                <c:pt idx="168">
                  <c:v>653.58199999999999</c:v>
                </c:pt>
                <c:pt idx="169">
                  <c:v>654.62599999999998</c:v>
                </c:pt>
                <c:pt idx="170">
                  <c:v>655.63499999999999</c:v>
                </c:pt>
                <c:pt idx="171">
                  <c:v>656.62400000000002</c:v>
                </c:pt>
                <c:pt idx="172">
                  <c:v>656.91700000000003</c:v>
                </c:pt>
                <c:pt idx="173">
                  <c:v>657.21</c:v>
                </c:pt>
                <c:pt idx="174">
                  <c:v>658.63599999999997</c:v>
                </c:pt>
                <c:pt idx="175">
                  <c:v>659.36199999999997</c:v>
                </c:pt>
                <c:pt idx="176">
                  <c:v>661.58699999999999</c:v>
                </c:pt>
                <c:pt idx="177">
                  <c:v>664.41300000000001</c:v>
                </c:pt>
                <c:pt idx="178">
                  <c:v>665.95</c:v>
                </c:pt>
                <c:pt idx="179">
                  <c:v>670.19100000000003</c:v>
                </c:pt>
                <c:pt idx="180">
                  <c:v>670.75699999999995</c:v>
                </c:pt>
                <c:pt idx="181">
                  <c:v>675.76400000000001</c:v>
                </c:pt>
                <c:pt idx="182">
                  <c:v>675.96799999999996</c:v>
                </c:pt>
                <c:pt idx="183">
                  <c:v>676.30499999999995</c:v>
                </c:pt>
                <c:pt idx="184">
                  <c:v>676.73800000000006</c:v>
                </c:pt>
                <c:pt idx="185">
                  <c:v>676.91200000000003</c:v>
                </c:pt>
                <c:pt idx="186">
                  <c:v>677.09500000000003</c:v>
                </c:pt>
                <c:pt idx="187">
                  <c:v>677.29200000000003</c:v>
                </c:pt>
                <c:pt idx="188">
                  <c:v>677.88199999999995</c:v>
                </c:pt>
                <c:pt idx="189">
                  <c:v>679.46100000000001</c:v>
                </c:pt>
                <c:pt idx="190">
                  <c:v>681.74300000000005</c:v>
                </c:pt>
                <c:pt idx="191">
                  <c:v>681.74599999999998</c:v>
                </c:pt>
                <c:pt idx="192">
                  <c:v>684.77099999999996</c:v>
                </c:pt>
                <c:pt idx="193">
                  <c:v>687.07</c:v>
                </c:pt>
                <c:pt idx="194">
                  <c:v>687.524</c:v>
                </c:pt>
                <c:pt idx="195">
                  <c:v>689.375</c:v>
                </c:pt>
                <c:pt idx="196">
                  <c:v>693.30100000000004</c:v>
                </c:pt>
                <c:pt idx="197">
                  <c:v>699.07899999999995</c:v>
                </c:pt>
                <c:pt idx="198">
                  <c:v>700.22799999999995</c:v>
                </c:pt>
                <c:pt idx="199">
                  <c:v>703.21699999999998</c:v>
                </c:pt>
                <c:pt idx="200">
                  <c:v>704.85599999999999</c:v>
                </c:pt>
                <c:pt idx="201">
                  <c:v>705.55899999999997</c:v>
                </c:pt>
                <c:pt idx="202">
                  <c:v>707.9</c:v>
                </c:pt>
                <c:pt idx="203">
                  <c:v>709.17899999999997</c:v>
                </c:pt>
                <c:pt idx="204">
                  <c:v>710.34299999999996</c:v>
                </c:pt>
                <c:pt idx="205">
                  <c:v>710.63400000000001</c:v>
                </c:pt>
                <c:pt idx="206">
                  <c:v>711.29700000000003</c:v>
                </c:pt>
                <c:pt idx="207">
                  <c:v>712.39400000000001</c:v>
                </c:pt>
                <c:pt idx="208">
                  <c:v>713.54300000000001</c:v>
                </c:pt>
                <c:pt idx="209">
                  <c:v>715.47900000000004</c:v>
                </c:pt>
                <c:pt idx="210">
                  <c:v>716.41099999999994</c:v>
                </c:pt>
                <c:pt idx="211">
                  <c:v>718.14</c:v>
                </c:pt>
                <c:pt idx="212">
                  <c:v>722.18899999999996</c:v>
                </c:pt>
                <c:pt idx="213">
                  <c:v>722.904</c:v>
                </c:pt>
                <c:pt idx="214">
                  <c:v>726.346</c:v>
                </c:pt>
                <c:pt idx="215">
                  <c:v>727.96600000000001</c:v>
                </c:pt>
                <c:pt idx="216">
                  <c:v>728.755</c:v>
                </c:pt>
                <c:pt idx="217">
                  <c:v>730.53399999999999</c:v>
                </c:pt>
                <c:pt idx="218">
                  <c:v>731.73099999999999</c:v>
                </c:pt>
                <c:pt idx="219">
                  <c:v>732.63400000000001</c:v>
                </c:pt>
                <c:pt idx="220">
                  <c:v>733.74400000000003</c:v>
                </c:pt>
                <c:pt idx="221">
                  <c:v>733.93100000000004</c:v>
                </c:pt>
                <c:pt idx="222">
                  <c:v>735.452</c:v>
                </c:pt>
                <c:pt idx="223">
                  <c:v>736.77</c:v>
                </c:pt>
                <c:pt idx="224">
                  <c:v>737.33399999999995</c:v>
                </c:pt>
                <c:pt idx="225">
                  <c:v>738.37599999999998</c:v>
                </c:pt>
                <c:pt idx="226">
                  <c:v>739.52099999999996</c:v>
                </c:pt>
                <c:pt idx="227">
                  <c:v>739.90200000000004</c:v>
                </c:pt>
                <c:pt idx="228">
                  <c:v>741.70899999999995</c:v>
                </c:pt>
                <c:pt idx="229">
                  <c:v>744.20899999999995</c:v>
                </c:pt>
                <c:pt idx="230">
                  <c:v>745.29899999999998</c:v>
                </c:pt>
                <c:pt idx="231">
                  <c:v>746.98099999999999</c:v>
                </c:pt>
                <c:pt idx="232">
                  <c:v>749.33500000000004</c:v>
                </c:pt>
                <c:pt idx="233">
                  <c:v>751.00199999999995</c:v>
                </c:pt>
                <c:pt idx="234">
                  <c:v>751.07600000000002</c:v>
                </c:pt>
                <c:pt idx="235">
                  <c:v>752.38199999999995</c:v>
                </c:pt>
                <c:pt idx="236">
                  <c:v>753.322</c:v>
                </c:pt>
                <c:pt idx="237">
                  <c:v>756.16800000000001</c:v>
                </c:pt>
                <c:pt idx="238">
                  <c:v>756.85400000000004</c:v>
                </c:pt>
                <c:pt idx="239">
                  <c:v>761.69899999999996</c:v>
                </c:pt>
                <c:pt idx="240">
                  <c:v>762.63099999999997</c:v>
                </c:pt>
                <c:pt idx="241">
                  <c:v>767.10500000000002</c:v>
                </c:pt>
                <c:pt idx="242">
                  <c:v>767.63599999999997</c:v>
                </c:pt>
                <c:pt idx="243">
                  <c:v>768.40899999999999</c:v>
                </c:pt>
                <c:pt idx="244">
                  <c:v>768.45399999999995</c:v>
                </c:pt>
                <c:pt idx="245">
                  <c:v>769.73199999999997</c:v>
                </c:pt>
                <c:pt idx="246">
                  <c:v>770.72799999999995</c:v>
                </c:pt>
                <c:pt idx="247">
                  <c:v>771.57</c:v>
                </c:pt>
                <c:pt idx="248">
                  <c:v>772.50800000000004</c:v>
                </c:pt>
                <c:pt idx="249">
                  <c:v>773.57899999999995</c:v>
                </c:pt>
                <c:pt idx="250">
                  <c:v>774.18600000000004</c:v>
                </c:pt>
                <c:pt idx="251">
                  <c:v>774.49699999999996</c:v>
                </c:pt>
                <c:pt idx="252">
                  <c:v>775.524</c:v>
                </c:pt>
                <c:pt idx="253">
                  <c:v>776.89499999999998</c:v>
                </c:pt>
                <c:pt idx="254">
                  <c:v>778.553</c:v>
                </c:pt>
                <c:pt idx="255">
                  <c:v>779.96400000000006</c:v>
                </c:pt>
                <c:pt idx="256">
                  <c:v>780.66099999999994</c:v>
                </c:pt>
                <c:pt idx="257">
                  <c:v>782.43799999999999</c:v>
                </c:pt>
                <c:pt idx="258">
                  <c:v>783.87099999999998</c:v>
                </c:pt>
                <c:pt idx="259">
                  <c:v>785.74099999999999</c:v>
                </c:pt>
                <c:pt idx="260">
                  <c:v>785.84199999999998</c:v>
                </c:pt>
                <c:pt idx="261">
                  <c:v>790.80600000000004</c:v>
                </c:pt>
                <c:pt idx="262">
                  <c:v>791.51900000000001</c:v>
                </c:pt>
                <c:pt idx="263">
                  <c:v>797.29600000000005</c:v>
                </c:pt>
                <c:pt idx="264">
                  <c:v>798.41899999999998</c:v>
                </c:pt>
                <c:pt idx="265">
                  <c:v>803.07399999999996</c:v>
                </c:pt>
                <c:pt idx="266">
                  <c:v>805.22500000000002</c:v>
                </c:pt>
                <c:pt idx="267">
                  <c:v>807.21799999999996</c:v>
                </c:pt>
                <c:pt idx="268">
                  <c:v>808.45799999999997</c:v>
                </c:pt>
                <c:pt idx="269">
                  <c:v>808.851</c:v>
                </c:pt>
                <c:pt idx="270">
                  <c:v>809.10699999999997</c:v>
                </c:pt>
                <c:pt idx="271">
                  <c:v>810.33600000000001</c:v>
                </c:pt>
                <c:pt idx="272">
                  <c:v>813.19</c:v>
                </c:pt>
                <c:pt idx="273">
                  <c:v>814.62900000000002</c:v>
                </c:pt>
                <c:pt idx="274">
                  <c:v>816.02599999999995</c:v>
                </c:pt>
                <c:pt idx="275">
                  <c:v>818.84799999999996</c:v>
                </c:pt>
                <c:pt idx="276">
                  <c:v>820.40599999999995</c:v>
                </c:pt>
                <c:pt idx="277">
                  <c:v>821.12400000000002</c:v>
                </c:pt>
                <c:pt idx="278">
                  <c:v>823.399</c:v>
                </c:pt>
                <c:pt idx="279">
                  <c:v>824.69500000000005</c:v>
                </c:pt>
                <c:pt idx="280">
                  <c:v>826.18399999999997</c:v>
                </c:pt>
                <c:pt idx="281">
                  <c:v>831.96100000000001</c:v>
                </c:pt>
                <c:pt idx="282">
                  <c:v>833.96900000000005</c:v>
                </c:pt>
                <c:pt idx="283">
                  <c:v>836.40300000000002</c:v>
                </c:pt>
                <c:pt idx="284">
                  <c:v>837.73900000000003</c:v>
                </c:pt>
                <c:pt idx="285">
                  <c:v>841.029</c:v>
                </c:pt>
                <c:pt idx="286">
                  <c:v>843.51599999999996</c:v>
                </c:pt>
                <c:pt idx="287">
                  <c:v>845.59400000000005</c:v>
                </c:pt>
                <c:pt idx="288">
                  <c:v>848.00800000000004</c:v>
                </c:pt>
                <c:pt idx="289">
                  <c:v>849.29399999999998</c:v>
                </c:pt>
                <c:pt idx="290">
                  <c:v>849.35400000000004</c:v>
                </c:pt>
                <c:pt idx="291">
                  <c:v>850.98099999999999</c:v>
                </c:pt>
                <c:pt idx="292">
                  <c:v>855.07100000000003</c:v>
                </c:pt>
                <c:pt idx="293">
                  <c:v>856.30899999999997</c:v>
                </c:pt>
                <c:pt idx="294">
                  <c:v>859.447</c:v>
                </c:pt>
                <c:pt idx="295">
                  <c:v>860.84900000000005</c:v>
                </c:pt>
                <c:pt idx="296">
                  <c:v>860.96600000000001</c:v>
                </c:pt>
                <c:pt idx="297">
                  <c:v>864.18399999999997</c:v>
                </c:pt>
                <c:pt idx="298">
                  <c:v>866.62599999999998</c:v>
                </c:pt>
                <c:pt idx="299">
                  <c:v>867.76499999999999</c:v>
                </c:pt>
                <c:pt idx="300">
                  <c:v>871.63499999999999</c:v>
                </c:pt>
                <c:pt idx="301">
                  <c:v>872.404</c:v>
                </c:pt>
                <c:pt idx="302">
                  <c:v>874.67899999999997</c:v>
                </c:pt>
                <c:pt idx="303">
                  <c:v>874.726</c:v>
                </c:pt>
                <c:pt idx="304">
                  <c:v>874.774</c:v>
                </c:pt>
                <c:pt idx="305">
                  <c:v>874.87099999999998</c:v>
                </c:pt>
                <c:pt idx="306">
                  <c:v>874.97400000000005</c:v>
                </c:pt>
                <c:pt idx="307">
                  <c:v>875.06299999999999</c:v>
                </c:pt>
                <c:pt idx="308">
                  <c:v>875.14200000000005</c:v>
                </c:pt>
                <c:pt idx="309">
                  <c:v>876.20600000000002</c:v>
                </c:pt>
                <c:pt idx="310">
                  <c:v>878.18100000000004</c:v>
                </c:pt>
                <c:pt idx="311">
                  <c:v>880.04499999999996</c:v>
                </c:pt>
                <c:pt idx="312">
                  <c:v>883.88400000000001</c:v>
                </c:pt>
                <c:pt idx="313">
                  <c:v>883.95899999999995</c:v>
                </c:pt>
                <c:pt idx="314">
                  <c:v>886.08699999999999</c:v>
                </c:pt>
                <c:pt idx="315">
                  <c:v>888.15300000000002</c:v>
                </c:pt>
                <c:pt idx="316">
                  <c:v>889.73599999999999</c:v>
                </c:pt>
                <c:pt idx="317">
                  <c:v>891.50800000000004</c:v>
                </c:pt>
                <c:pt idx="318">
                  <c:v>895.44899999999996</c:v>
                </c:pt>
                <c:pt idx="319">
                  <c:v>895.51400000000001</c:v>
                </c:pt>
                <c:pt idx="320">
                  <c:v>897.495</c:v>
                </c:pt>
                <c:pt idx="321">
                  <c:v>900.22299999999996</c:v>
                </c:pt>
                <c:pt idx="322">
                  <c:v>901.29100000000005</c:v>
                </c:pt>
                <c:pt idx="323">
                  <c:v>907.06899999999996</c:v>
                </c:pt>
                <c:pt idx="324">
                  <c:v>909.13300000000004</c:v>
                </c:pt>
                <c:pt idx="325">
                  <c:v>912.846</c:v>
                </c:pt>
                <c:pt idx="326">
                  <c:v>914.85799999999995</c:v>
                </c:pt>
                <c:pt idx="327">
                  <c:v>918.31799999999998</c:v>
                </c:pt>
                <c:pt idx="328">
                  <c:v>918.62400000000002</c:v>
                </c:pt>
                <c:pt idx="329">
                  <c:v>921.202</c:v>
                </c:pt>
                <c:pt idx="330">
                  <c:v>922.45899999999995</c:v>
                </c:pt>
                <c:pt idx="331">
                  <c:v>923.37099999999998</c:v>
                </c:pt>
                <c:pt idx="332">
                  <c:v>924.40099999999995</c:v>
                </c:pt>
                <c:pt idx="333">
                  <c:v>925.93</c:v>
                </c:pt>
                <c:pt idx="334">
                  <c:v>928.4</c:v>
                </c:pt>
                <c:pt idx="335">
                  <c:v>930.17899999999997</c:v>
                </c:pt>
                <c:pt idx="336">
                  <c:v>930.87</c:v>
                </c:pt>
                <c:pt idx="337">
                  <c:v>934.25900000000001</c:v>
                </c:pt>
                <c:pt idx="338">
                  <c:v>935.95600000000002</c:v>
                </c:pt>
                <c:pt idx="339">
                  <c:v>937.7</c:v>
                </c:pt>
                <c:pt idx="340">
                  <c:v>941.06899999999996</c:v>
                </c:pt>
                <c:pt idx="341">
                  <c:v>941.73400000000004</c:v>
                </c:pt>
                <c:pt idx="342">
                  <c:v>944.86599999999999</c:v>
                </c:pt>
                <c:pt idx="343">
                  <c:v>947.51099999999997</c:v>
                </c:pt>
                <c:pt idx="344">
                  <c:v>951.08500000000004</c:v>
                </c:pt>
                <c:pt idx="345">
                  <c:v>953.28899999999999</c:v>
                </c:pt>
                <c:pt idx="346">
                  <c:v>955.53599999999994</c:v>
                </c:pt>
                <c:pt idx="347">
                  <c:v>959.06600000000003</c:v>
                </c:pt>
                <c:pt idx="348">
                  <c:v>960.26599999999996</c:v>
                </c:pt>
                <c:pt idx="349">
                  <c:v>964.84400000000005</c:v>
                </c:pt>
                <c:pt idx="350">
                  <c:v>966.58600000000001</c:v>
                </c:pt>
                <c:pt idx="351">
                  <c:v>970.62099999999998</c:v>
                </c:pt>
                <c:pt idx="352">
                  <c:v>975.17100000000005</c:v>
                </c:pt>
                <c:pt idx="353">
                  <c:v>976.399</c:v>
                </c:pt>
                <c:pt idx="354">
                  <c:v>982.17600000000004</c:v>
                </c:pt>
                <c:pt idx="355">
                  <c:v>986.85400000000004</c:v>
                </c:pt>
                <c:pt idx="356">
                  <c:v>987.95399999999995</c:v>
                </c:pt>
                <c:pt idx="357">
                  <c:v>992.51300000000003</c:v>
                </c:pt>
                <c:pt idx="358">
                  <c:v>993.73099999999999</c:v>
                </c:pt>
                <c:pt idx="359">
                  <c:v>995.87199999999996</c:v>
                </c:pt>
                <c:pt idx="360">
                  <c:v>998.726</c:v>
                </c:pt>
                <c:pt idx="361">
                  <c:v>999.50900000000001</c:v>
                </c:pt>
                <c:pt idx="362">
                  <c:v>1001.58</c:v>
                </c:pt>
                <c:pt idx="363">
                  <c:v>1004.433</c:v>
                </c:pt>
                <c:pt idx="364">
                  <c:v>1005.172</c:v>
                </c:pt>
                <c:pt idx="365">
                  <c:v>1005.2859999999999</c:v>
                </c:pt>
                <c:pt idx="366">
                  <c:v>1005.3579999999999</c:v>
                </c:pt>
                <c:pt idx="367">
                  <c:v>1011.064</c:v>
                </c:pt>
                <c:pt idx="368">
                  <c:v>1016.842</c:v>
                </c:pt>
                <c:pt idx="369">
                  <c:v>1022.619</c:v>
                </c:pt>
                <c:pt idx="370">
                  <c:v>1026.8800000000001</c:v>
                </c:pt>
                <c:pt idx="371">
                  <c:v>1028.3969999999999</c:v>
                </c:pt>
                <c:pt idx="372">
                  <c:v>1031.9639999999999</c:v>
                </c:pt>
                <c:pt idx="373">
                  <c:v>1034.174</c:v>
                </c:pt>
                <c:pt idx="374">
                  <c:v>1039.952</c:v>
                </c:pt>
                <c:pt idx="375">
                  <c:v>1045.729</c:v>
                </c:pt>
                <c:pt idx="376">
                  <c:v>1051.5070000000001</c:v>
                </c:pt>
                <c:pt idx="377">
                  <c:v>1052.6220000000001</c:v>
                </c:pt>
                <c:pt idx="378">
                  <c:v>1057.2840000000001</c:v>
                </c:pt>
                <c:pt idx="379">
                  <c:v>1063.0619999999999</c:v>
                </c:pt>
                <c:pt idx="380">
                  <c:v>1068.8389999999999</c:v>
                </c:pt>
                <c:pt idx="381">
                  <c:v>1068.902</c:v>
                </c:pt>
                <c:pt idx="382">
                  <c:v>1073.3889999999999</c:v>
                </c:pt>
                <c:pt idx="383">
                  <c:v>1074.578</c:v>
                </c:pt>
                <c:pt idx="384">
                  <c:v>1074.617</c:v>
                </c:pt>
                <c:pt idx="385">
                  <c:v>1079.1559999999999</c:v>
                </c:pt>
                <c:pt idx="386">
                  <c:v>1080.394</c:v>
                </c:pt>
                <c:pt idx="387">
                  <c:v>1086.172</c:v>
                </c:pt>
                <c:pt idx="388">
                  <c:v>1091.9490000000001</c:v>
                </c:pt>
                <c:pt idx="389">
                  <c:v>1092.2550000000001</c:v>
                </c:pt>
                <c:pt idx="390">
                  <c:v>1097.7270000000001</c:v>
                </c:pt>
                <c:pt idx="391">
                  <c:v>1103.5039999999999</c:v>
                </c:pt>
                <c:pt idx="392">
                  <c:v>1109.2819999999999</c:v>
                </c:pt>
                <c:pt idx="393">
                  <c:v>1115.059</c:v>
                </c:pt>
                <c:pt idx="394">
                  <c:v>1120.837</c:v>
                </c:pt>
                <c:pt idx="395">
                  <c:v>1126.614</c:v>
                </c:pt>
                <c:pt idx="396">
                  <c:v>1132.3920000000001</c:v>
                </c:pt>
                <c:pt idx="397">
                  <c:v>1138.1690000000001</c:v>
                </c:pt>
                <c:pt idx="398">
                  <c:v>1143.9469999999999</c:v>
                </c:pt>
                <c:pt idx="399">
                  <c:v>1149.7239999999999</c:v>
                </c:pt>
                <c:pt idx="400">
                  <c:v>1155.502</c:v>
                </c:pt>
                <c:pt idx="401">
                  <c:v>1155.502</c:v>
                </c:pt>
              </c:numCache>
            </c:numRef>
          </c:xVal>
          <c:yVal>
            <c:numRef>
              <c:f>Foglio6!$D$819:$D$1220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100</c:v>
                </c:pt>
                <c:pt idx="54">
                  <c:v>100</c:v>
                </c:pt>
                <c:pt idx="55">
                  <c:v>100</c:v>
                </c:pt>
                <c:pt idx="56">
                  <c:v>100</c:v>
                </c:pt>
                <c:pt idx="57">
                  <c:v>100</c:v>
                </c:pt>
                <c:pt idx="58">
                  <c:v>100</c:v>
                </c:pt>
                <c:pt idx="59">
                  <c:v>100</c:v>
                </c:pt>
                <c:pt idx="60">
                  <c:v>100</c:v>
                </c:pt>
                <c:pt idx="61">
                  <c:v>100</c:v>
                </c:pt>
                <c:pt idx="62">
                  <c:v>100</c:v>
                </c:pt>
                <c:pt idx="63">
                  <c:v>100</c:v>
                </c:pt>
                <c:pt idx="64">
                  <c:v>100</c:v>
                </c:pt>
                <c:pt idx="65">
                  <c:v>100</c:v>
                </c:pt>
                <c:pt idx="66">
                  <c:v>100</c:v>
                </c:pt>
                <c:pt idx="67">
                  <c:v>99.951999999999998</c:v>
                </c:pt>
                <c:pt idx="68">
                  <c:v>99.846000000000004</c:v>
                </c:pt>
                <c:pt idx="69">
                  <c:v>99.834000000000003</c:v>
                </c:pt>
                <c:pt idx="70">
                  <c:v>99.820999999999998</c:v>
                </c:pt>
                <c:pt idx="71">
                  <c:v>99.816999999999993</c:v>
                </c:pt>
                <c:pt idx="72">
                  <c:v>99.816000000000003</c:v>
                </c:pt>
                <c:pt idx="73">
                  <c:v>99.814999999999998</c:v>
                </c:pt>
                <c:pt idx="74">
                  <c:v>99.813999999999993</c:v>
                </c:pt>
                <c:pt idx="75">
                  <c:v>99.795000000000002</c:v>
                </c:pt>
                <c:pt idx="76">
                  <c:v>99.712999999999994</c:v>
                </c:pt>
                <c:pt idx="77">
                  <c:v>99.692999999999998</c:v>
                </c:pt>
                <c:pt idx="78">
                  <c:v>99.67</c:v>
                </c:pt>
                <c:pt idx="79">
                  <c:v>99.55</c:v>
                </c:pt>
                <c:pt idx="80">
                  <c:v>99.5</c:v>
                </c:pt>
                <c:pt idx="81">
                  <c:v>99</c:v>
                </c:pt>
                <c:pt idx="82">
                  <c:v>98.998999999999995</c:v>
                </c:pt>
                <c:pt idx="83">
                  <c:v>98.5</c:v>
                </c:pt>
                <c:pt idx="84">
                  <c:v>98.418999999999997</c:v>
                </c:pt>
                <c:pt idx="85">
                  <c:v>98</c:v>
                </c:pt>
                <c:pt idx="86">
                  <c:v>97.68</c:v>
                </c:pt>
                <c:pt idx="87">
                  <c:v>97.558999999999997</c:v>
                </c:pt>
                <c:pt idx="88">
                  <c:v>97.5</c:v>
                </c:pt>
                <c:pt idx="89">
                  <c:v>97.438999999999993</c:v>
                </c:pt>
                <c:pt idx="90">
                  <c:v>97.096999999999994</c:v>
                </c:pt>
                <c:pt idx="91">
                  <c:v>97</c:v>
                </c:pt>
                <c:pt idx="92">
                  <c:v>96.5</c:v>
                </c:pt>
                <c:pt idx="93">
                  <c:v>96.4</c:v>
                </c:pt>
                <c:pt idx="94">
                  <c:v>96</c:v>
                </c:pt>
                <c:pt idx="95">
                  <c:v>95.5</c:v>
                </c:pt>
                <c:pt idx="96">
                  <c:v>95.471000000000004</c:v>
                </c:pt>
                <c:pt idx="97">
                  <c:v>95</c:v>
                </c:pt>
                <c:pt idx="98">
                  <c:v>94.626000000000005</c:v>
                </c:pt>
                <c:pt idx="99">
                  <c:v>94.5</c:v>
                </c:pt>
                <c:pt idx="100">
                  <c:v>94.43</c:v>
                </c:pt>
                <c:pt idx="101">
                  <c:v>94</c:v>
                </c:pt>
                <c:pt idx="102">
                  <c:v>93.981999999999999</c:v>
                </c:pt>
                <c:pt idx="103">
                  <c:v>93.5</c:v>
                </c:pt>
                <c:pt idx="104">
                  <c:v>93.27</c:v>
                </c:pt>
                <c:pt idx="105">
                  <c:v>93.06</c:v>
                </c:pt>
                <c:pt idx="106">
                  <c:v>93</c:v>
                </c:pt>
                <c:pt idx="107">
                  <c:v>92.85</c:v>
                </c:pt>
                <c:pt idx="108">
                  <c:v>92.5</c:v>
                </c:pt>
                <c:pt idx="109">
                  <c:v>92.137</c:v>
                </c:pt>
                <c:pt idx="110">
                  <c:v>92</c:v>
                </c:pt>
                <c:pt idx="111">
                  <c:v>91.5</c:v>
                </c:pt>
                <c:pt idx="112">
                  <c:v>91.45</c:v>
                </c:pt>
                <c:pt idx="113">
                  <c:v>91</c:v>
                </c:pt>
                <c:pt idx="114">
                  <c:v>90.953000000000003</c:v>
                </c:pt>
                <c:pt idx="115">
                  <c:v>90.5</c:v>
                </c:pt>
                <c:pt idx="116">
                  <c:v>90</c:v>
                </c:pt>
                <c:pt idx="117">
                  <c:v>89.5</c:v>
                </c:pt>
                <c:pt idx="118">
                  <c:v>89</c:v>
                </c:pt>
                <c:pt idx="119">
                  <c:v>88.82</c:v>
                </c:pt>
                <c:pt idx="120">
                  <c:v>88.5</c:v>
                </c:pt>
                <c:pt idx="121">
                  <c:v>88.308000000000007</c:v>
                </c:pt>
                <c:pt idx="122">
                  <c:v>88</c:v>
                </c:pt>
                <c:pt idx="123">
                  <c:v>87.837999999999994</c:v>
                </c:pt>
                <c:pt idx="124">
                  <c:v>87.5</c:v>
                </c:pt>
                <c:pt idx="125">
                  <c:v>87.13</c:v>
                </c:pt>
                <c:pt idx="126">
                  <c:v>87</c:v>
                </c:pt>
                <c:pt idx="127">
                  <c:v>86.5</c:v>
                </c:pt>
                <c:pt idx="128">
                  <c:v>86</c:v>
                </c:pt>
                <c:pt idx="129">
                  <c:v>85.5</c:v>
                </c:pt>
                <c:pt idx="130">
                  <c:v>85.281999999999996</c:v>
                </c:pt>
                <c:pt idx="131">
                  <c:v>85</c:v>
                </c:pt>
                <c:pt idx="132">
                  <c:v>84.899000000000001</c:v>
                </c:pt>
                <c:pt idx="133">
                  <c:v>84.5</c:v>
                </c:pt>
                <c:pt idx="134">
                  <c:v>84</c:v>
                </c:pt>
                <c:pt idx="135">
                  <c:v>83.543999999999997</c:v>
                </c:pt>
                <c:pt idx="136">
                  <c:v>83.5</c:v>
                </c:pt>
                <c:pt idx="137">
                  <c:v>83</c:v>
                </c:pt>
                <c:pt idx="138">
                  <c:v>82.918000000000006</c:v>
                </c:pt>
                <c:pt idx="139">
                  <c:v>82.5</c:v>
                </c:pt>
                <c:pt idx="140">
                  <c:v>82</c:v>
                </c:pt>
                <c:pt idx="141">
                  <c:v>81.5</c:v>
                </c:pt>
                <c:pt idx="142">
                  <c:v>81.084000000000003</c:v>
                </c:pt>
                <c:pt idx="143">
                  <c:v>81</c:v>
                </c:pt>
                <c:pt idx="144">
                  <c:v>80.5</c:v>
                </c:pt>
                <c:pt idx="145">
                  <c:v>80.376000000000005</c:v>
                </c:pt>
                <c:pt idx="146">
                  <c:v>80.138999999999996</c:v>
                </c:pt>
                <c:pt idx="147">
                  <c:v>80</c:v>
                </c:pt>
                <c:pt idx="148">
                  <c:v>79.5</c:v>
                </c:pt>
                <c:pt idx="149">
                  <c:v>79.328000000000003</c:v>
                </c:pt>
                <c:pt idx="150">
                  <c:v>79</c:v>
                </c:pt>
                <c:pt idx="151">
                  <c:v>78.5</c:v>
                </c:pt>
                <c:pt idx="152">
                  <c:v>78</c:v>
                </c:pt>
                <c:pt idx="153">
                  <c:v>77.786000000000001</c:v>
                </c:pt>
                <c:pt idx="154">
                  <c:v>77.5</c:v>
                </c:pt>
                <c:pt idx="155">
                  <c:v>77.486000000000004</c:v>
                </c:pt>
                <c:pt idx="156">
                  <c:v>77</c:v>
                </c:pt>
                <c:pt idx="157">
                  <c:v>76.885999999999996</c:v>
                </c:pt>
                <c:pt idx="158">
                  <c:v>76.5</c:v>
                </c:pt>
                <c:pt idx="159">
                  <c:v>76</c:v>
                </c:pt>
                <c:pt idx="160">
                  <c:v>75.5</c:v>
                </c:pt>
                <c:pt idx="161">
                  <c:v>75.278999999999996</c:v>
                </c:pt>
                <c:pt idx="162">
                  <c:v>75</c:v>
                </c:pt>
                <c:pt idx="163">
                  <c:v>74.849000000000004</c:v>
                </c:pt>
                <c:pt idx="164">
                  <c:v>74.5</c:v>
                </c:pt>
                <c:pt idx="165">
                  <c:v>74</c:v>
                </c:pt>
                <c:pt idx="166">
                  <c:v>73.846999999999994</c:v>
                </c:pt>
                <c:pt idx="167">
                  <c:v>73.5</c:v>
                </c:pt>
                <c:pt idx="168">
                  <c:v>73</c:v>
                </c:pt>
                <c:pt idx="169">
                  <c:v>72.5</c:v>
                </c:pt>
                <c:pt idx="170">
                  <c:v>72</c:v>
                </c:pt>
                <c:pt idx="171">
                  <c:v>71.5</c:v>
                </c:pt>
                <c:pt idx="172">
                  <c:v>71</c:v>
                </c:pt>
                <c:pt idx="173">
                  <c:v>70.5</c:v>
                </c:pt>
                <c:pt idx="174">
                  <c:v>70.162999999999997</c:v>
                </c:pt>
                <c:pt idx="175">
                  <c:v>70</c:v>
                </c:pt>
                <c:pt idx="176">
                  <c:v>69.5</c:v>
                </c:pt>
                <c:pt idx="177">
                  <c:v>69.17</c:v>
                </c:pt>
                <c:pt idx="178">
                  <c:v>69</c:v>
                </c:pt>
                <c:pt idx="179">
                  <c:v>68.555000000000007</c:v>
                </c:pt>
                <c:pt idx="180">
                  <c:v>68.5</c:v>
                </c:pt>
                <c:pt idx="181">
                  <c:v>68</c:v>
                </c:pt>
                <c:pt idx="182">
                  <c:v>67.811000000000007</c:v>
                </c:pt>
                <c:pt idx="183">
                  <c:v>67.5</c:v>
                </c:pt>
                <c:pt idx="184">
                  <c:v>67</c:v>
                </c:pt>
                <c:pt idx="185">
                  <c:v>66.5</c:v>
                </c:pt>
                <c:pt idx="186">
                  <c:v>66</c:v>
                </c:pt>
                <c:pt idx="187">
                  <c:v>65.5</c:v>
                </c:pt>
                <c:pt idx="188">
                  <c:v>65</c:v>
                </c:pt>
                <c:pt idx="189">
                  <c:v>64.5</c:v>
                </c:pt>
                <c:pt idx="190">
                  <c:v>64</c:v>
                </c:pt>
                <c:pt idx="191">
                  <c:v>64</c:v>
                </c:pt>
                <c:pt idx="192">
                  <c:v>63.5</c:v>
                </c:pt>
                <c:pt idx="193">
                  <c:v>63</c:v>
                </c:pt>
                <c:pt idx="194">
                  <c:v>62.853000000000002</c:v>
                </c:pt>
                <c:pt idx="195">
                  <c:v>62.5</c:v>
                </c:pt>
                <c:pt idx="196">
                  <c:v>62.26</c:v>
                </c:pt>
                <c:pt idx="197">
                  <c:v>62.087000000000003</c:v>
                </c:pt>
                <c:pt idx="198">
                  <c:v>62</c:v>
                </c:pt>
                <c:pt idx="199">
                  <c:v>61.5</c:v>
                </c:pt>
                <c:pt idx="200">
                  <c:v>61.15</c:v>
                </c:pt>
                <c:pt idx="201">
                  <c:v>61</c:v>
                </c:pt>
                <c:pt idx="202">
                  <c:v>60.5</c:v>
                </c:pt>
                <c:pt idx="203">
                  <c:v>60</c:v>
                </c:pt>
                <c:pt idx="204">
                  <c:v>59.5</c:v>
                </c:pt>
                <c:pt idx="205">
                  <c:v>59.347999999999999</c:v>
                </c:pt>
                <c:pt idx="206">
                  <c:v>59</c:v>
                </c:pt>
                <c:pt idx="207">
                  <c:v>58.5</c:v>
                </c:pt>
                <c:pt idx="208">
                  <c:v>58</c:v>
                </c:pt>
                <c:pt idx="209">
                  <c:v>57.5</c:v>
                </c:pt>
                <c:pt idx="210">
                  <c:v>57.325000000000003</c:v>
                </c:pt>
                <c:pt idx="211">
                  <c:v>57</c:v>
                </c:pt>
                <c:pt idx="212">
                  <c:v>56.569000000000003</c:v>
                </c:pt>
                <c:pt idx="213">
                  <c:v>56.5</c:v>
                </c:pt>
                <c:pt idx="214">
                  <c:v>56</c:v>
                </c:pt>
                <c:pt idx="215">
                  <c:v>55.722000000000001</c:v>
                </c:pt>
                <c:pt idx="216">
                  <c:v>55.5</c:v>
                </c:pt>
                <c:pt idx="217">
                  <c:v>55</c:v>
                </c:pt>
                <c:pt idx="218">
                  <c:v>54.5</c:v>
                </c:pt>
                <c:pt idx="219">
                  <c:v>54</c:v>
                </c:pt>
                <c:pt idx="220">
                  <c:v>53.567999999999998</c:v>
                </c:pt>
                <c:pt idx="221">
                  <c:v>53.5</c:v>
                </c:pt>
                <c:pt idx="222">
                  <c:v>53</c:v>
                </c:pt>
                <c:pt idx="223">
                  <c:v>52.5</c:v>
                </c:pt>
                <c:pt idx="224">
                  <c:v>52</c:v>
                </c:pt>
                <c:pt idx="225">
                  <c:v>51.5</c:v>
                </c:pt>
                <c:pt idx="226">
                  <c:v>51.104999999999997</c:v>
                </c:pt>
                <c:pt idx="227">
                  <c:v>51</c:v>
                </c:pt>
                <c:pt idx="228">
                  <c:v>50.5</c:v>
                </c:pt>
                <c:pt idx="229">
                  <c:v>50</c:v>
                </c:pt>
                <c:pt idx="230">
                  <c:v>49.804000000000002</c:v>
                </c:pt>
                <c:pt idx="231">
                  <c:v>49.5</c:v>
                </c:pt>
                <c:pt idx="232">
                  <c:v>49</c:v>
                </c:pt>
                <c:pt idx="233">
                  <c:v>48.5</c:v>
                </c:pt>
                <c:pt idx="234">
                  <c:v>48.478000000000002</c:v>
                </c:pt>
                <c:pt idx="235">
                  <c:v>48</c:v>
                </c:pt>
                <c:pt idx="236">
                  <c:v>47.5</c:v>
                </c:pt>
                <c:pt idx="237">
                  <c:v>47</c:v>
                </c:pt>
                <c:pt idx="238">
                  <c:v>46.921999999999997</c:v>
                </c:pt>
                <c:pt idx="239">
                  <c:v>46.5</c:v>
                </c:pt>
                <c:pt idx="240">
                  <c:v>46.432000000000002</c:v>
                </c:pt>
                <c:pt idx="241">
                  <c:v>46</c:v>
                </c:pt>
                <c:pt idx="242">
                  <c:v>45.5</c:v>
                </c:pt>
                <c:pt idx="243">
                  <c:v>45.018000000000001</c:v>
                </c:pt>
                <c:pt idx="244">
                  <c:v>45</c:v>
                </c:pt>
                <c:pt idx="245">
                  <c:v>44.5</c:v>
                </c:pt>
                <c:pt idx="246">
                  <c:v>44</c:v>
                </c:pt>
                <c:pt idx="247">
                  <c:v>43.5</c:v>
                </c:pt>
                <c:pt idx="248">
                  <c:v>43</c:v>
                </c:pt>
                <c:pt idx="249">
                  <c:v>42.5</c:v>
                </c:pt>
                <c:pt idx="250">
                  <c:v>42.173999999999999</c:v>
                </c:pt>
                <c:pt idx="251">
                  <c:v>42</c:v>
                </c:pt>
                <c:pt idx="252">
                  <c:v>41.5</c:v>
                </c:pt>
                <c:pt idx="253">
                  <c:v>41</c:v>
                </c:pt>
                <c:pt idx="254">
                  <c:v>40.5</c:v>
                </c:pt>
                <c:pt idx="255">
                  <c:v>40.164999999999999</c:v>
                </c:pt>
                <c:pt idx="256">
                  <c:v>40</c:v>
                </c:pt>
                <c:pt idx="257">
                  <c:v>39.5</c:v>
                </c:pt>
                <c:pt idx="258">
                  <c:v>39</c:v>
                </c:pt>
                <c:pt idx="259">
                  <c:v>38.51</c:v>
                </c:pt>
                <c:pt idx="260">
                  <c:v>38.5</c:v>
                </c:pt>
                <c:pt idx="261">
                  <c:v>38</c:v>
                </c:pt>
                <c:pt idx="262">
                  <c:v>37.927999999999997</c:v>
                </c:pt>
                <c:pt idx="263">
                  <c:v>37.549999999999997</c:v>
                </c:pt>
                <c:pt idx="264">
                  <c:v>37.5</c:v>
                </c:pt>
                <c:pt idx="265">
                  <c:v>37.186</c:v>
                </c:pt>
                <c:pt idx="266">
                  <c:v>37</c:v>
                </c:pt>
                <c:pt idx="267">
                  <c:v>36.5</c:v>
                </c:pt>
                <c:pt idx="268">
                  <c:v>36</c:v>
                </c:pt>
                <c:pt idx="269">
                  <c:v>35.697000000000003</c:v>
                </c:pt>
                <c:pt idx="270">
                  <c:v>35.5</c:v>
                </c:pt>
                <c:pt idx="271">
                  <c:v>35</c:v>
                </c:pt>
                <c:pt idx="272">
                  <c:v>34.5</c:v>
                </c:pt>
                <c:pt idx="273">
                  <c:v>34.247</c:v>
                </c:pt>
                <c:pt idx="274">
                  <c:v>34</c:v>
                </c:pt>
                <c:pt idx="275">
                  <c:v>33.5</c:v>
                </c:pt>
                <c:pt idx="276">
                  <c:v>33.158000000000001</c:v>
                </c:pt>
                <c:pt idx="277">
                  <c:v>33</c:v>
                </c:pt>
                <c:pt idx="278">
                  <c:v>32.5</c:v>
                </c:pt>
                <c:pt idx="279">
                  <c:v>32</c:v>
                </c:pt>
                <c:pt idx="280">
                  <c:v>31.681000000000001</c:v>
                </c:pt>
                <c:pt idx="281">
                  <c:v>31.611000000000001</c:v>
                </c:pt>
                <c:pt idx="282">
                  <c:v>31.5</c:v>
                </c:pt>
                <c:pt idx="283">
                  <c:v>31</c:v>
                </c:pt>
                <c:pt idx="284">
                  <c:v>30.856000000000002</c:v>
                </c:pt>
                <c:pt idx="285">
                  <c:v>30.5</c:v>
                </c:pt>
                <c:pt idx="286">
                  <c:v>30.231000000000002</c:v>
                </c:pt>
                <c:pt idx="287">
                  <c:v>30</c:v>
                </c:pt>
                <c:pt idx="288">
                  <c:v>29.5</c:v>
                </c:pt>
                <c:pt idx="289">
                  <c:v>29.234000000000002</c:v>
                </c:pt>
                <c:pt idx="290">
                  <c:v>29</c:v>
                </c:pt>
                <c:pt idx="291">
                  <c:v>28.5</c:v>
                </c:pt>
                <c:pt idx="292">
                  <c:v>28.116</c:v>
                </c:pt>
                <c:pt idx="293">
                  <c:v>28</c:v>
                </c:pt>
                <c:pt idx="294">
                  <c:v>27.5</c:v>
                </c:pt>
                <c:pt idx="295">
                  <c:v>27.018000000000001</c:v>
                </c:pt>
                <c:pt idx="296">
                  <c:v>27</c:v>
                </c:pt>
                <c:pt idx="297">
                  <c:v>26.5</c:v>
                </c:pt>
                <c:pt idx="298">
                  <c:v>26.146999999999998</c:v>
                </c:pt>
                <c:pt idx="299">
                  <c:v>26</c:v>
                </c:pt>
                <c:pt idx="300">
                  <c:v>25.5</c:v>
                </c:pt>
                <c:pt idx="301">
                  <c:v>25.401</c:v>
                </c:pt>
                <c:pt idx="302">
                  <c:v>25</c:v>
                </c:pt>
                <c:pt idx="303">
                  <c:v>24.5</c:v>
                </c:pt>
                <c:pt idx="304">
                  <c:v>24</c:v>
                </c:pt>
                <c:pt idx="305">
                  <c:v>23.5</c:v>
                </c:pt>
                <c:pt idx="306">
                  <c:v>23</c:v>
                </c:pt>
                <c:pt idx="307">
                  <c:v>22.5</c:v>
                </c:pt>
                <c:pt idx="308">
                  <c:v>22</c:v>
                </c:pt>
                <c:pt idx="309">
                  <c:v>21.5</c:v>
                </c:pt>
                <c:pt idx="310">
                  <c:v>21.242999999999999</c:v>
                </c:pt>
                <c:pt idx="311">
                  <c:v>21</c:v>
                </c:pt>
                <c:pt idx="312">
                  <c:v>20.5</c:v>
                </c:pt>
                <c:pt idx="313">
                  <c:v>20.49</c:v>
                </c:pt>
                <c:pt idx="314">
                  <c:v>20</c:v>
                </c:pt>
                <c:pt idx="315">
                  <c:v>19.5</c:v>
                </c:pt>
                <c:pt idx="316">
                  <c:v>19.225000000000001</c:v>
                </c:pt>
                <c:pt idx="317">
                  <c:v>19</c:v>
                </c:pt>
                <c:pt idx="318">
                  <c:v>18.5</c:v>
                </c:pt>
                <c:pt idx="319">
                  <c:v>18.492000000000001</c:v>
                </c:pt>
                <c:pt idx="320">
                  <c:v>18</c:v>
                </c:pt>
                <c:pt idx="321">
                  <c:v>17.5</c:v>
                </c:pt>
                <c:pt idx="322">
                  <c:v>17.381</c:v>
                </c:pt>
                <c:pt idx="323">
                  <c:v>17.149999999999999</c:v>
                </c:pt>
                <c:pt idx="324">
                  <c:v>17</c:v>
                </c:pt>
                <c:pt idx="325">
                  <c:v>16.765999999999998</c:v>
                </c:pt>
                <c:pt idx="326">
                  <c:v>16.5</c:v>
                </c:pt>
                <c:pt idx="327">
                  <c:v>16</c:v>
                </c:pt>
                <c:pt idx="328">
                  <c:v>15.946999999999999</c:v>
                </c:pt>
                <c:pt idx="329">
                  <c:v>15.5</c:v>
                </c:pt>
                <c:pt idx="330">
                  <c:v>15</c:v>
                </c:pt>
                <c:pt idx="331">
                  <c:v>14.5</c:v>
                </c:pt>
                <c:pt idx="332">
                  <c:v>14.298999999999999</c:v>
                </c:pt>
                <c:pt idx="333">
                  <c:v>14</c:v>
                </c:pt>
                <c:pt idx="334">
                  <c:v>13.5</c:v>
                </c:pt>
                <c:pt idx="335">
                  <c:v>13.14</c:v>
                </c:pt>
                <c:pt idx="336">
                  <c:v>13</c:v>
                </c:pt>
                <c:pt idx="337">
                  <c:v>12.5</c:v>
                </c:pt>
                <c:pt idx="338">
                  <c:v>12.253</c:v>
                </c:pt>
                <c:pt idx="339">
                  <c:v>12</c:v>
                </c:pt>
                <c:pt idx="340">
                  <c:v>11.5</c:v>
                </c:pt>
                <c:pt idx="341">
                  <c:v>11.4</c:v>
                </c:pt>
                <c:pt idx="342">
                  <c:v>11</c:v>
                </c:pt>
                <c:pt idx="343">
                  <c:v>10.787000000000001</c:v>
                </c:pt>
                <c:pt idx="344">
                  <c:v>10.5</c:v>
                </c:pt>
                <c:pt idx="345">
                  <c:v>10.271000000000001</c:v>
                </c:pt>
                <c:pt idx="346">
                  <c:v>10</c:v>
                </c:pt>
                <c:pt idx="347">
                  <c:v>9.6059999999999999</c:v>
                </c:pt>
                <c:pt idx="348">
                  <c:v>9.5</c:v>
                </c:pt>
                <c:pt idx="349">
                  <c:v>9.1059999999999999</c:v>
                </c:pt>
                <c:pt idx="350">
                  <c:v>9</c:v>
                </c:pt>
                <c:pt idx="351">
                  <c:v>8.7539999999999996</c:v>
                </c:pt>
                <c:pt idx="352">
                  <c:v>8.5</c:v>
                </c:pt>
                <c:pt idx="353">
                  <c:v>8.4510000000000005</c:v>
                </c:pt>
                <c:pt idx="354">
                  <c:v>8.218</c:v>
                </c:pt>
                <c:pt idx="355">
                  <c:v>8</c:v>
                </c:pt>
                <c:pt idx="356">
                  <c:v>7.9029999999999996</c:v>
                </c:pt>
                <c:pt idx="357">
                  <c:v>7.5</c:v>
                </c:pt>
                <c:pt idx="358">
                  <c:v>7.375</c:v>
                </c:pt>
                <c:pt idx="359">
                  <c:v>7</c:v>
                </c:pt>
                <c:pt idx="360">
                  <c:v>6.5</c:v>
                </c:pt>
                <c:pt idx="361">
                  <c:v>6.3630000000000004</c:v>
                </c:pt>
                <c:pt idx="362">
                  <c:v>6</c:v>
                </c:pt>
                <c:pt idx="363">
                  <c:v>5.5</c:v>
                </c:pt>
                <c:pt idx="364">
                  <c:v>5</c:v>
                </c:pt>
                <c:pt idx="365">
                  <c:v>4.5279999999999996</c:v>
                </c:pt>
                <c:pt idx="366">
                  <c:v>4.5</c:v>
                </c:pt>
                <c:pt idx="367">
                  <c:v>4.1970000000000001</c:v>
                </c:pt>
                <c:pt idx="368">
                  <c:v>4.1760000000000002</c:v>
                </c:pt>
                <c:pt idx="369">
                  <c:v>4.1559999999999997</c:v>
                </c:pt>
                <c:pt idx="370">
                  <c:v>4</c:v>
                </c:pt>
                <c:pt idx="371">
                  <c:v>3.6970000000000001</c:v>
                </c:pt>
                <c:pt idx="372">
                  <c:v>3.5</c:v>
                </c:pt>
                <c:pt idx="373">
                  <c:v>3.4470000000000001</c:v>
                </c:pt>
                <c:pt idx="374">
                  <c:v>3.3069999999999999</c:v>
                </c:pt>
                <c:pt idx="375">
                  <c:v>3.1669999999999998</c:v>
                </c:pt>
                <c:pt idx="376">
                  <c:v>3.0270000000000001</c:v>
                </c:pt>
                <c:pt idx="377">
                  <c:v>3</c:v>
                </c:pt>
                <c:pt idx="378">
                  <c:v>2.887</c:v>
                </c:pt>
                <c:pt idx="379">
                  <c:v>2.7469999999999999</c:v>
                </c:pt>
                <c:pt idx="380">
                  <c:v>2.5070000000000001</c:v>
                </c:pt>
                <c:pt idx="381">
                  <c:v>2.5</c:v>
                </c:pt>
                <c:pt idx="382">
                  <c:v>2</c:v>
                </c:pt>
                <c:pt idx="383">
                  <c:v>1.5</c:v>
                </c:pt>
                <c:pt idx="384">
                  <c:v>1.377</c:v>
                </c:pt>
                <c:pt idx="385">
                  <c:v>1</c:v>
                </c:pt>
                <c:pt idx="386">
                  <c:v>0.95899999999999996</c:v>
                </c:pt>
                <c:pt idx="387">
                  <c:v>0.76600000000000001</c:v>
                </c:pt>
                <c:pt idx="388">
                  <c:v>0.51600000000000001</c:v>
                </c:pt>
                <c:pt idx="389">
                  <c:v>0.5</c:v>
                </c:pt>
                <c:pt idx="390">
                  <c:v>0.372</c:v>
                </c:pt>
                <c:pt idx="391">
                  <c:v>0.33900000000000002</c:v>
                </c:pt>
                <c:pt idx="392">
                  <c:v>0.30599999999999999</c:v>
                </c:pt>
                <c:pt idx="393">
                  <c:v>0.27300000000000002</c:v>
                </c:pt>
                <c:pt idx="394">
                  <c:v>0.22700000000000001</c:v>
                </c:pt>
                <c:pt idx="395">
                  <c:v>0.18</c:v>
                </c:pt>
                <c:pt idx="396">
                  <c:v>0.13400000000000001</c:v>
                </c:pt>
                <c:pt idx="397">
                  <c:v>0.107</c:v>
                </c:pt>
                <c:pt idx="398">
                  <c:v>7.9000000000000001E-2</c:v>
                </c:pt>
                <c:pt idx="399">
                  <c:v>5.1999999999999998E-2</c:v>
                </c:pt>
                <c:pt idx="400">
                  <c:v>2.5000000000000001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496-4CC3-8534-400DC70DE595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xVal>
            <c:numRef>
              <c:f>Foglio6!$E$819:$E$1220</c:f>
              <c:numCache>
                <c:formatCode>General</c:formatCode>
                <c:ptCount val="402"/>
                <c:pt idx="0">
                  <c:v>0</c:v>
                </c:pt>
                <c:pt idx="1">
                  <c:v>5.2930000000000001</c:v>
                </c:pt>
                <c:pt idx="2">
                  <c:v>10.587</c:v>
                </c:pt>
                <c:pt idx="3">
                  <c:v>15.88</c:v>
                </c:pt>
                <c:pt idx="4">
                  <c:v>21.172999999999998</c:v>
                </c:pt>
                <c:pt idx="5">
                  <c:v>26.466999999999999</c:v>
                </c:pt>
                <c:pt idx="6">
                  <c:v>31.76</c:v>
                </c:pt>
                <c:pt idx="7">
                  <c:v>37.052999999999997</c:v>
                </c:pt>
                <c:pt idx="8">
                  <c:v>42.347000000000001</c:v>
                </c:pt>
                <c:pt idx="9">
                  <c:v>47.64</c:v>
                </c:pt>
                <c:pt idx="10">
                  <c:v>52.933</c:v>
                </c:pt>
                <c:pt idx="11">
                  <c:v>58.226999999999997</c:v>
                </c:pt>
                <c:pt idx="12">
                  <c:v>63.52</c:v>
                </c:pt>
                <c:pt idx="13">
                  <c:v>68.813000000000002</c:v>
                </c:pt>
                <c:pt idx="14">
                  <c:v>74.106999999999999</c:v>
                </c:pt>
                <c:pt idx="15">
                  <c:v>79.400000000000006</c:v>
                </c:pt>
                <c:pt idx="16">
                  <c:v>84.692999999999998</c:v>
                </c:pt>
                <c:pt idx="17">
                  <c:v>89.986999999999995</c:v>
                </c:pt>
                <c:pt idx="18">
                  <c:v>95.28</c:v>
                </c:pt>
                <c:pt idx="19">
                  <c:v>100.57299999999999</c:v>
                </c:pt>
                <c:pt idx="20">
                  <c:v>105.867</c:v>
                </c:pt>
                <c:pt idx="21">
                  <c:v>111.16</c:v>
                </c:pt>
                <c:pt idx="22">
                  <c:v>116.453</c:v>
                </c:pt>
                <c:pt idx="23">
                  <c:v>121.747</c:v>
                </c:pt>
                <c:pt idx="24">
                  <c:v>127.04</c:v>
                </c:pt>
                <c:pt idx="25">
                  <c:v>132.333</c:v>
                </c:pt>
                <c:pt idx="26">
                  <c:v>137.62700000000001</c:v>
                </c:pt>
                <c:pt idx="27">
                  <c:v>138.71100000000001</c:v>
                </c:pt>
                <c:pt idx="28">
                  <c:v>142.91999999999999</c:v>
                </c:pt>
                <c:pt idx="29">
                  <c:v>148.21299999999999</c:v>
                </c:pt>
                <c:pt idx="30">
                  <c:v>153.50700000000001</c:v>
                </c:pt>
                <c:pt idx="31">
                  <c:v>158.80000000000001</c:v>
                </c:pt>
                <c:pt idx="32">
                  <c:v>164.09299999999999</c:v>
                </c:pt>
                <c:pt idx="33">
                  <c:v>169.387</c:v>
                </c:pt>
                <c:pt idx="34">
                  <c:v>174.68</c:v>
                </c:pt>
                <c:pt idx="35">
                  <c:v>179.97300000000001</c:v>
                </c:pt>
                <c:pt idx="36">
                  <c:v>185.267</c:v>
                </c:pt>
                <c:pt idx="37">
                  <c:v>187.83799999999999</c:v>
                </c:pt>
                <c:pt idx="38">
                  <c:v>190.56</c:v>
                </c:pt>
                <c:pt idx="39">
                  <c:v>195.85300000000001</c:v>
                </c:pt>
                <c:pt idx="40">
                  <c:v>201.14699999999999</c:v>
                </c:pt>
                <c:pt idx="41">
                  <c:v>206.44</c:v>
                </c:pt>
                <c:pt idx="42">
                  <c:v>208.583</c:v>
                </c:pt>
                <c:pt idx="43">
                  <c:v>211.733</c:v>
                </c:pt>
                <c:pt idx="44">
                  <c:v>217.02699999999999</c:v>
                </c:pt>
                <c:pt idx="45">
                  <c:v>222.32</c:v>
                </c:pt>
                <c:pt idx="46">
                  <c:v>222.506</c:v>
                </c:pt>
                <c:pt idx="47">
                  <c:v>227.613</c:v>
                </c:pt>
                <c:pt idx="48">
                  <c:v>232.90700000000001</c:v>
                </c:pt>
                <c:pt idx="49">
                  <c:v>237.929</c:v>
                </c:pt>
                <c:pt idx="50">
                  <c:v>238.2</c:v>
                </c:pt>
                <c:pt idx="51">
                  <c:v>243.49299999999999</c:v>
                </c:pt>
                <c:pt idx="52">
                  <c:v>247.875</c:v>
                </c:pt>
                <c:pt idx="53">
                  <c:v>248.74199999999999</c:v>
                </c:pt>
                <c:pt idx="54">
                  <c:v>248.78700000000001</c:v>
                </c:pt>
                <c:pt idx="55">
                  <c:v>249.75399999999999</c:v>
                </c:pt>
                <c:pt idx="56">
                  <c:v>252.59200000000001</c:v>
                </c:pt>
                <c:pt idx="57">
                  <c:v>254.08</c:v>
                </c:pt>
                <c:pt idx="58">
                  <c:v>257.52600000000001</c:v>
                </c:pt>
                <c:pt idx="59">
                  <c:v>259.37299999999999</c:v>
                </c:pt>
                <c:pt idx="60">
                  <c:v>263.863</c:v>
                </c:pt>
                <c:pt idx="61">
                  <c:v>264.66699999999997</c:v>
                </c:pt>
                <c:pt idx="62">
                  <c:v>267.63200000000001</c:v>
                </c:pt>
                <c:pt idx="63">
                  <c:v>269.95999999999998</c:v>
                </c:pt>
                <c:pt idx="64">
                  <c:v>275.25299999999999</c:v>
                </c:pt>
                <c:pt idx="65">
                  <c:v>280.54700000000003</c:v>
                </c:pt>
                <c:pt idx="66">
                  <c:v>282.54700000000003</c:v>
                </c:pt>
                <c:pt idx="67">
                  <c:v>285.83999999999997</c:v>
                </c:pt>
                <c:pt idx="68">
                  <c:v>291.13299999999998</c:v>
                </c:pt>
                <c:pt idx="69">
                  <c:v>296.42700000000002</c:v>
                </c:pt>
                <c:pt idx="70">
                  <c:v>296.55399999999997</c:v>
                </c:pt>
                <c:pt idx="71">
                  <c:v>301.72000000000003</c:v>
                </c:pt>
                <c:pt idx="72">
                  <c:v>303.33100000000002</c:v>
                </c:pt>
                <c:pt idx="73">
                  <c:v>304.91199999999998</c:v>
                </c:pt>
                <c:pt idx="74">
                  <c:v>305.37900000000002</c:v>
                </c:pt>
                <c:pt idx="75">
                  <c:v>306.86700000000002</c:v>
                </c:pt>
                <c:pt idx="76">
                  <c:v>307.01299999999998</c:v>
                </c:pt>
                <c:pt idx="77">
                  <c:v>309.04899999999998</c:v>
                </c:pt>
                <c:pt idx="78">
                  <c:v>311.52999999999997</c:v>
                </c:pt>
                <c:pt idx="79">
                  <c:v>312.30700000000002</c:v>
                </c:pt>
                <c:pt idx="80">
                  <c:v>314.43099999999998</c:v>
                </c:pt>
                <c:pt idx="81">
                  <c:v>315.435</c:v>
                </c:pt>
                <c:pt idx="82">
                  <c:v>317.60000000000002</c:v>
                </c:pt>
                <c:pt idx="83">
                  <c:v>317.923</c:v>
                </c:pt>
                <c:pt idx="84">
                  <c:v>321.35500000000002</c:v>
                </c:pt>
                <c:pt idx="85">
                  <c:v>322.89299999999997</c:v>
                </c:pt>
                <c:pt idx="86">
                  <c:v>326.21499999999997</c:v>
                </c:pt>
                <c:pt idx="87">
                  <c:v>328.18700000000001</c:v>
                </c:pt>
                <c:pt idx="88">
                  <c:v>332.49799999999999</c:v>
                </c:pt>
                <c:pt idx="89">
                  <c:v>333.48</c:v>
                </c:pt>
                <c:pt idx="90">
                  <c:v>333.96100000000001</c:v>
                </c:pt>
                <c:pt idx="91">
                  <c:v>338.77300000000002</c:v>
                </c:pt>
                <c:pt idx="92">
                  <c:v>341.46</c:v>
                </c:pt>
                <c:pt idx="93">
                  <c:v>344.06700000000001</c:v>
                </c:pt>
                <c:pt idx="94">
                  <c:v>349.36</c:v>
                </c:pt>
                <c:pt idx="95">
                  <c:v>350.57400000000001</c:v>
                </c:pt>
                <c:pt idx="96">
                  <c:v>352.89600000000002</c:v>
                </c:pt>
                <c:pt idx="97">
                  <c:v>354.56799999999998</c:v>
                </c:pt>
                <c:pt idx="98">
                  <c:v>354.65300000000002</c:v>
                </c:pt>
                <c:pt idx="99">
                  <c:v>359.947</c:v>
                </c:pt>
                <c:pt idx="100">
                  <c:v>360.16199999999998</c:v>
                </c:pt>
                <c:pt idx="101">
                  <c:v>365.24</c:v>
                </c:pt>
                <c:pt idx="102">
                  <c:v>370.53300000000002</c:v>
                </c:pt>
                <c:pt idx="103">
                  <c:v>375.827</c:v>
                </c:pt>
                <c:pt idx="104">
                  <c:v>377.84100000000001</c:v>
                </c:pt>
                <c:pt idx="105">
                  <c:v>381.12</c:v>
                </c:pt>
                <c:pt idx="106">
                  <c:v>385.96499999999997</c:v>
                </c:pt>
                <c:pt idx="107">
                  <c:v>386.07100000000003</c:v>
                </c:pt>
                <c:pt idx="108">
                  <c:v>386.27100000000002</c:v>
                </c:pt>
                <c:pt idx="109">
                  <c:v>386.41300000000001</c:v>
                </c:pt>
                <c:pt idx="110">
                  <c:v>386.846</c:v>
                </c:pt>
                <c:pt idx="111">
                  <c:v>387.42099999999999</c:v>
                </c:pt>
                <c:pt idx="112">
                  <c:v>387.911</c:v>
                </c:pt>
                <c:pt idx="113">
                  <c:v>388.96100000000001</c:v>
                </c:pt>
                <c:pt idx="114">
                  <c:v>391.65600000000001</c:v>
                </c:pt>
                <c:pt idx="115">
                  <c:v>391.70699999999999</c:v>
                </c:pt>
                <c:pt idx="116">
                  <c:v>394.17099999999999</c:v>
                </c:pt>
                <c:pt idx="117">
                  <c:v>396.238</c:v>
                </c:pt>
                <c:pt idx="118">
                  <c:v>396.92599999999999</c:v>
                </c:pt>
                <c:pt idx="119">
                  <c:v>397</c:v>
                </c:pt>
                <c:pt idx="120">
                  <c:v>397.613</c:v>
                </c:pt>
                <c:pt idx="121">
                  <c:v>398.245</c:v>
                </c:pt>
                <c:pt idx="122">
                  <c:v>398.553</c:v>
                </c:pt>
                <c:pt idx="123">
                  <c:v>400.12299999999999</c:v>
                </c:pt>
                <c:pt idx="124">
                  <c:v>402.29300000000001</c:v>
                </c:pt>
                <c:pt idx="125">
                  <c:v>403.36</c:v>
                </c:pt>
                <c:pt idx="126">
                  <c:v>406.92700000000002</c:v>
                </c:pt>
                <c:pt idx="127">
                  <c:v>407.58699999999999</c:v>
                </c:pt>
                <c:pt idx="128">
                  <c:v>410.798</c:v>
                </c:pt>
                <c:pt idx="129">
                  <c:v>412.88</c:v>
                </c:pt>
                <c:pt idx="130">
                  <c:v>413.18</c:v>
                </c:pt>
                <c:pt idx="131">
                  <c:v>414.517</c:v>
                </c:pt>
                <c:pt idx="132">
                  <c:v>418.06599999999997</c:v>
                </c:pt>
                <c:pt idx="133">
                  <c:v>418.173</c:v>
                </c:pt>
                <c:pt idx="134">
                  <c:v>422.529</c:v>
                </c:pt>
                <c:pt idx="135">
                  <c:v>423.46699999999998</c:v>
                </c:pt>
                <c:pt idx="136">
                  <c:v>428.76</c:v>
                </c:pt>
                <c:pt idx="137">
                  <c:v>429.52199999999999</c:v>
                </c:pt>
                <c:pt idx="138">
                  <c:v>434.053</c:v>
                </c:pt>
                <c:pt idx="139">
                  <c:v>436.19200000000001</c:v>
                </c:pt>
                <c:pt idx="140">
                  <c:v>437.61700000000002</c:v>
                </c:pt>
                <c:pt idx="141">
                  <c:v>437.78199999999998</c:v>
                </c:pt>
                <c:pt idx="142">
                  <c:v>439.34699999999998</c:v>
                </c:pt>
                <c:pt idx="143">
                  <c:v>442.077</c:v>
                </c:pt>
                <c:pt idx="144">
                  <c:v>444.64</c:v>
                </c:pt>
                <c:pt idx="145">
                  <c:v>448.524</c:v>
                </c:pt>
                <c:pt idx="146">
                  <c:v>448.88099999999997</c:v>
                </c:pt>
                <c:pt idx="147">
                  <c:v>449.29700000000003</c:v>
                </c:pt>
                <c:pt idx="148">
                  <c:v>449.73700000000002</c:v>
                </c:pt>
                <c:pt idx="149">
                  <c:v>449.93299999999999</c:v>
                </c:pt>
                <c:pt idx="150">
                  <c:v>450.26600000000002</c:v>
                </c:pt>
                <c:pt idx="151">
                  <c:v>450.79599999999999</c:v>
                </c:pt>
                <c:pt idx="152">
                  <c:v>455.14499999999998</c:v>
                </c:pt>
                <c:pt idx="153">
                  <c:v>455.22699999999998</c:v>
                </c:pt>
                <c:pt idx="154">
                  <c:v>458.512</c:v>
                </c:pt>
                <c:pt idx="155">
                  <c:v>460.52</c:v>
                </c:pt>
                <c:pt idx="156">
                  <c:v>463.00599999999997</c:v>
                </c:pt>
                <c:pt idx="157">
                  <c:v>465.81299999999999</c:v>
                </c:pt>
                <c:pt idx="158">
                  <c:v>468.24700000000001</c:v>
                </c:pt>
                <c:pt idx="159">
                  <c:v>470.822</c:v>
                </c:pt>
                <c:pt idx="160">
                  <c:v>470.92399999999998</c:v>
                </c:pt>
                <c:pt idx="161">
                  <c:v>471.10700000000003</c:v>
                </c:pt>
                <c:pt idx="162">
                  <c:v>472.82</c:v>
                </c:pt>
                <c:pt idx="163">
                  <c:v>476.4</c:v>
                </c:pt>
                <c:pt idx="164">
                  <c:v>477.464</c:v>
                </c:pt>
                <c:pt idx="165">
                  <c:v>481.48500000000001</c:v>
                </c:pt>
                <c:pt idx="166">
                  <c:v>481.69299999999998</c:v>
                </c:pt>
                <c:pt idx="167">
                  <c:v>483.86599999999999</c:v>
                </c:pt>
                <c:pt idx="168">
                  <c:v>486.98700000000002</c:v>
                </c:pt>
                <c:pt idx="169">
                  <c:v>488.69499999999999</c:v>
                </c:pt>
                <c:pt idx="170">
                  <c:v>491.048</c:v>
                </c:pt>
                <c:pt idx="171">
                  <c:v>492.28</c:v>
                </c:pt>
                <c:pt idx="172">
                  <c:v>497.57299999999998</c:v>
                </c:pt>
                <c:pt idx="173">
                  <c:v>498.53100000000001</c:v>
                </c:pt>
                <c:pt idx="174">
                  <c:v>502.64400000000001</c:v>
                </c:pt>
                <c:pt idx="175">
                  <c:v>502.86700000000002</c:v>
                </c:pt>
                <c:pt idx="176">
                  <c:v>504.52600000000001</c:v>
                </c:pt>
                <c:pt idx="177">
                  <c:v>508.16</c:v>
                </c:pt>
                <c:pt idx="178">
                  <c:v>509.113</c:v>
                </c:pt>
                <c:pt idx="179">
                  <c:v>513.16399999999999</c:v>
                </c:pt>
                <c:pt idx="180">
                  <c:v>513.45299999999997</c:v>
                </c:pt>
                <c:pt idx="181">
                  <c:v>514.63400000000001</c:v>
                </c:pt>
                <c:pt idx="182">
                  <c:v>516.10299999999995</c:v>
                </c:pt>
                <c:pt idx="183">
                  <c:v>516.25800000000004</c:v>
                </c:pt>
                <c:pt idx="184">
                  <c:v>516.37599999999998</c:v>
                </c:pt>
                <c:pt idx="185">
                  <c:v>516.41</c:v>
                </c:pt>
                <c:pt idx="186">
                  <c:v>516.93700000000001</c:v>
                </c:pt>
                <c:pt idx="187">
                  <c:v>518.74699999999996</c:v>
                </c:pt>
                <c:pt idx="188">
                  <c:v>519.80999999999995</c:v>
                </c:pt>
                <c:pt idx="189">
                  <c:v>524.04</c:v>
                </c:pt>
                <c:pt idx="190">
                  <c:v>527.65700000000004</c:v>
                </c:pt>
                <c:pt idx="191">
                  <c:v>529.33299999999997</c:v>
                </c:pt>
                <c:pt idx="192">
                  <c:v>532.09900000000005</c:v>
                </c:pt>
                <c:pt idx="193">
                  <c:v>534.62699999999995</c:v>
                </c:pt>
                <c:pt idx="194">
                  <c:v>536.02300000000002</c:v>
                </c:pt>
                <c:pt idx="195">
                  <c:v>539.02599999999995</c:v>
                </c:pt>
                <c:pt idx="196">
                  <c:v>539.91999999999996</c:v>
                </c:pt>
                <c:pt idx="197">
                  <c:v>540.09699999999998</c:v>
                </c:pt>
                <c:pt idx="198">
                  <c:v>541.17600000000004</c:v>
                </c:pt>
                <c:pt idx="199">
                  <c:v>542.42399999999998</c:v>
                </c:pt>
                <c:pt idx="200">
                  <c:v>543.67100000000005</c:v>
                </c:pt>
                <c:pt idx="201">
                  <c:v>545.11099999999999</c:v>
                </c:pt>
                <c:pt idx="202">
                  <c:v>545.21299999999997</c:v>
                </c:pt>
                <c:pt idx="203">
                  <c:v>546.63</c:v>
                </c:pt>
                <c:pt idx="204">
                  <c:v>550.24099999999999</c:v>
                </c:pt>
                <c:pt idx="205">
                  <c:v>550.50699999999995</c:v>
                </c:pt>
                <c:pt idx="206">
                  <c:v>553.34299999999996</c:v>
                </c:pt>
                <c:pt idx="207">
                  <c:v>554.80799999999999</c:v>
                </c:pt>
                <c:pt idx="208">
                  <c:v>555.79999999999995</c:v>
                </c:pt>
                <c:pt idx="209">
                  <c:v>558.98599999999999</c:v>
                </c:pt>
                <c:pt idx="210">
                  <c:v>561.09299999999996</c:v>
                </c:pt>
                <c:pt idx="211">
                  <c:v>561.721</c:v>
                </c:pt>
                <c:pt idx="212">
                  <c:v>561.86900000000003</c:v>
                </c:pt>
                <c:pt idx="213">
                  <c:v>566.38699999999994</c:v>
                </c:pt>
                <c:pt idx="214">
                  <c:v>571.67999999999995</c:v>
                </c:pt>
                <c:pt idx="215">
                  <c:v>576.97299999999996</c:v>
                </c:pt>
                <c:pt idx="216">
                  <c:v>581.37599999999998</c:v>
                </c:pt>
                <c:pt idx="217">
                  <c:v>582.26700000000005</c:v>
                </c:pt>
                <c:pt idx="218">
                  <c:v>582.52700000000004</c:v>
                </c:pt>
                <c:pt idx="219">
                  <c:v>584.88499999999999</c:v>
                </c:pt>
                <c:pt idx="220">
                  <c:v>587.55999999999995</c:v>
                </c:pt>
                <c:pt idx="221">
                  <c:v>588.95899999999995</c:v>
                </c:pt>
                <c:pt idx="222">
                  <c:v>592.85299999999995</c:v>
                </c:pt>
                <c:pt idx="223">
                  <c:v>598.06100000000004</c:v>
                </c:pt>
                <c:pt idx="224">
                  <c:v>598.14700000000005</c:v>
                </c:pt>
                <c:pt idx="225">
                  <c:v>603.44000000000005</c:v>
                </c:pt>
                <c:pt idx="226">
                  <c:v>604.00900000000001</c:v>
                </c:pt>
                <c:pt idx="227">
                  <c:v>608.19899999999996</c:v>
                </c:pt>
                <c:pt idx="228">
                  <c:v>608.73299999999995</c:v>
                </c:pt>
                <c:pt idx="229">
                  <c:v>611.70799999999997</c:v>
                </c:pt>
                <c:pt idx="230">
                  <c:v>612.58500000000004</c:v>
                </c:pt>
                <c:pt idx="231">
                  <c:v>613.20799999999997</c:v>
                </c:pt>
                <c:pt idx="232">
                  <c:v>613.76599999999996</c:v>
                </c:pt>
                <c:pt idx="233">
                  <c:v>614.02700000000004</c:v>
                </c:pt>
                <c:pt idx="234">
                  <c:v>614.20500000000004</c:v>
                </c:pt>
                <c:pt idx="235">
                  <c:v>614.37</c:v>
                </c:pt>
                <c:pt idx="236">
                  <c:v>614.53499999999997</c:v>
                </c:pt>
                <c:pt idx="237">
                  <c:v>614.69899999999996</c:v>
                </c:pt>
                <c:pt idx="238">
                  <c:v>614.93399999999997</c:v>
                </c:pt>
                <c:pt idx="239">
                  <c:v>616.46199999999999</c:v>
                </c:pt>
                <c:pt idx="240">
                  <c:v>618.73199999999997</c:v>
                </c:pt>
                <c:pt idx="241">
                  <c:v>619.32000000000005</c:v>
                </c:pt>
                <c:pt idx="242">
                  <c:v>624.61300000000006</c:v>
                </c:pt>
                <c:pt idx="243">
                  <c:v>629.47199999999998</c:v>
                </c:pt>
                <c:pt idx="244">
                  <c:v>629.90700000000004</c:v>
                </c:pt>
                <c:pt idx="245">
                  <c:v>632.87400000000002</c:v>
                </c:pt>
                <c:pt idx="246">
                  <c:v>634.13800000000003</c:v>
                </c:pt>
                <c:pt idx="247">
                  <c:v>634.24199999999996</c:v>
                </c:pt>
                <c:pt idx="248">
                  <c:v>634.38800000000003</c:v>
                </c:pt>
                <c:pt idx="249">
                  <c:v>635.20000000000005</c:v>
                </c:pt>
                <c:pt idx="250">
                  <c:v>637.572</c:v>
                </c:pt>
                <c:pt idx="251">
                  <c:v>640.02700000000004</c:v>
                </c:pt>
                <c:pt idx="252">
                  <c:v>640.35</c:v>
                </c:pt>
                <c:pt idx="253">
                  <c:v>640.49300000000005</c:v>
                </c:pt>
                <c:pt idx="254">
                  <c:v>644.39499999999998</c:v>
                </c:pt>
                <c:pt idx="255">
                  <c:v>645.78700000000003</c:v>
                </c:pt>
                <c:pt idx="256">
                  <c:v>651.08000000000004</c:v>
                </c:pt>
                <c:pt idx="257">
                  <c:v>655.29999999999995</c:v>
                </c:pt>
                <c:pt idx="258">
                  <c:v>656.37300000000005</c:v>
                </c:pt>
                <c:pt idx="259">
                  <c:v>658.57100000000003</c:v>
                </c:pt>
                <c:pt idx="260">
                  <c:v>660.12</c:v>
                </c:pt>
                <c:pt idx="261">
                  <c:v>661.56399999999996</c:v>
                </c:pt>
                <c:pt idx="262">
                  <c:v>661.66700000000003</c:v>
                </c:pt>
                <c:pt idx="263">
                  <c:v>662.89300000000003</c:v>
                </c:pt>
                <c:pt idx="264">
                  <c:v>663.41</c:v>
                </c:pt>
                <c:pt idx="265">
                  <c:v>666.96</c:v>
                </c:pt>
                <c:pt idx="266">
                  <c:v>671.84299999999996</c:v>
                </c:pt>
                <c:pt idx="267">
                  <c:v>672.25300000000004</c:v>
                </c:pt>
                <c:pt idx="268">
                  <c:v>677.54700000000003</c:v>
                </c:pt>
                <c:pt idx="269">
                  <c:v>680.01400000000001</c:v>
                </c:pt>
                <c:pt idx="270">
                  <c:v>682.84</c:v>
                </c:pt>
                <c:pt idx="271">
                  <c:v>684.41499999999996</c:v>
                </c:pt>
                <c:pt idx="272">
                  <c:v>685.60199999999998</c:v>
                </c:pt>
                <c:pt idx="273">
                  <c:v>688.13300000000004</c:v>
                </c:pt>
                <c:pt idx="274">
                  <c:v>688.88199999999995</c:v>
                </c:pt>
                <c:pt idx="275">
                  <c:v>692.41099999999994</c:v>
                </c:pt>
                <c:pt idx="276">
                  <c:v>693.42700000000002</c:v>
                </c:pt>
                <c:pt idx="277">
                  <c:v>695.70399999999995</c:v>
                </c:pt>
                <c:pt idx="278">
                  <c:v>698.72</c:v>
                </c:pt>
                <c:pt idx="279">
                  <c:v>698.79300000000001</c:v>
                </c:pt>
                <c:pt idx="280">
                  <c:v>699.68600000000004</c:v>
                </c:pt>
                <c:pt idx="281">
                  <c:v>700.62800000000004</c:v>
                </c:pt>
                <c:pt idx="282">
                  <c:v>701.67200000000003</c:v>
                </c:pt>
                <c:pt idx="283">
                  <c:v>702.46500000000003</c:v>
                </c:pt>
                <c:pt idx="284">
                  <c:v>704.01300000000003</c:v>
                </c:pt>
                <c:pt idx="285">
                  <c:v>709.26199999999994</c:v>
                </c:pt>
                <c:pt idx="286">
                  <c:v>709.30700000000002</c:v>
                </c:pt>
                <c:pt idx="287">
                  <c:v>714.6</c:v>
                </c:pt>
                <c:pt idx="288">
                  <c:v>719.89300000000003</c:v>
                </c:pt>
                <c:pt idx="289">
                  <c:v>721.38400000000001</c:v>
                </c:pt>
                <c:pt idx="290">
                  <c:v>722.52</c:v>
                </c:pt>
                <c:pt idx="291">
                  <c:v>723.65599999999995</c:v>
                </c:pt>
                <c:pt idx="292">
                  <c:v>725.18700000000001</c:v>
                </c:pt>
                <c:pt idx="293">
                  <c:v>730.48</c:v>
                </c:pt>
                <c:pt idx="294">
                  <c:v>731.69899999999996</c:v>
                </c:pt>
                <c:pt idx="295">
                  <c:v>735.77300000000002</c:v>
                </c:pt>
                <c:pt idx="296">
                  <c:v>737.19100000000003</c:v>
                </c:pt>
                <c:pt idx="297">
                  <c:v>738.16700000000003</c:v>
                </c:pt>
                <c:pt idx="298">
                  <c:v>738.25</c:v>
                </c:pt>
                <c:pt idx="299">
                  <c:v>739.11</c:v>
                </c:pt>
                <c:pt idx="300">
                  <c:v>741.06700000000001</c:v>
                </c:pt>
                <c:pt idx="301">
                  <c:v>746.36</c:v>
                </c:pt>
                <c:pt idx="302">
                  <c:v>747.6</c:v>
                </c:pt>
                <c:pt idx="303">
                  <c:v>751.65300000000002</c:v>
                </c:pt>
                <c:pt idx="304">
                  <c:v>755.26700000000005</c:v>
                </c:pt>
                <c:pt idx="305">
                  <c:v>756.947</c:v>
                </c:pt>
                <c:pt idx="306">
                  <c:v>762.24</c:v>
                </c:pt>
                <c:pt idx="307">
                  <c:v>762.37800000000004</c:v>
                </c:pt>
                <c:pt idx="308">
                  <c:v>763.50599999999997</c:v>
                </c:pt>
                <c:pt idx="309">
                  <c:v>765.46</c:v>
                </c:pt>
                <c:pt idx="310">
                  <c:v>766.13699999999994</c:v>
                </c:pt>
                <c:pt idx="311">
                  <c:v>766.78800000000001</c:v>
                </c:pt>
                <c:pt idx="312">
                  <c:v>767.53300000000002</c:v>
                </c:pt>
                <c:pt idx="313">
                  <c:v>768.44200000000001</c:v>
                </c:pt>
                <c:pt idx="314">
                  <c:v>772.827</c:v>
                </c:pt>
                <c:pt idx="315">
                  <c:v>773.87400000000002</c:v>
                </c:pt>
                <c:pt idx="316">
                  <c:v>778.10599999999999</c:v>
                </c:pt>
                <c:pt idx="317">
                  <c:v>778.12</c:v>
                </c:pt>
                <c:pt idx="318">
                  <c:v>780.87</c:v>
                </c:pt>
                <c:pt idx="319">
                  <c:v>783.41300000000001</c:v>
                </c:pt>
                <c:pt idx="320">
                  <c:v>788.70699999999999</c:v>
                </c:pt>
                <c:pt idx="321">
                  <c:v>794</c:v>
                </c:pt>
                <c:pt idx="322">
                  <c:v>799.29300000000001</c:v>
                </c:pt>
                <c:pt idx="323">
                  <c:v>804.58699999999999</c:v>
                </c:pt>
                <c:pt idx="324">
                  <c:v>809.88</c:v>
                </c:pt>
                <c:pt idx="325">
                  <c:v>815.173</c:v>
                </c:pt>
                <c:pt idx="326">
                  <c:v>820.46699999999998</c:v>
                </c:pt>
                <c:pt idx="327">
                  <c:v>821.07500000000005</c:v>
                </c:pt>
                <c:pt idx="328">
                  <c:v>821.45699999999999</c:v>
                </c:pt>
                <c:pt idx="329">
                  <c:v>821.63</c:v>
                </c:pt>
                <c:pt idx="330">
                  <c:v>821.74099999999999</c:v>
                </c:pt>
                <c:pt idx="331">
                  <c:v>823.01800000000003</c:v>
                </c:pt>
                <c:pt idx="332">
                  <c:v>825.76</c:v>
                </c:pt>
                <c:pt idx="333">
                  <c:v>827.27099999999996</c:v>
                </c:pt>
                <c:pt idx="334">
                  <c:v>831.053</c:v>
                </c:pt>
                <c:pt idx="335">
                  <c:v>832.80700000000002</c:v>
                </c:pt>
                <c:pt idx="336">
                  <c:v>833.50900000000001</c:v>
                </c:pt>
                <c:pt idx="337">
                  <c:v>834.57299999999998</c:v>
                </c:pt>
                <c:pt idx="338">
                  <c:v>836.34699999999998</c:v>
                </c:pt>
                <c:pt idx="339">
                  <c:v>841.01599999999996</c:v>
                </c:pt>
                <c:pt idx="340">
                  <c:v>841.64</c:v>
                </c:pt>
                <c:pt idx="341">
                  <c:v>846.93299999999999</c:v>
                </c:pt>
                <c:pt idx="342">
                  <c:v>847.36699999999996</c:v>
                </c:pt>
                <c:pt idx="343">
                  <c:v>852.22699999999998</c:v>
                </c:pt>
                <c:pt idx="344">
                  <c:v>853.37800000000004</c:v>
                </c:pt>
                <c:pt idx="345">
                  <c:v>857.52</c:v>
                </c:pt>
                <c:pt idx="346">
                  <c:v>858.11199999999997</c:v>
                </c:pt>
                <c:pt idx="347">
                  <c:v>859.24300000000005</c:v>
                </c:pt>
                <c:pt idx="348">
                  <c:v>860.37400000000002</c:v>
                </c:pt>
                <c:pt idx="349">
                  <c:v>862.81299999999999</c:v>
                </c:pt>
                <c:pt idx="350">
                  <c:v>868.10699999999997</c:v>
                </c:pt>
                <c:pt idx="351">
                  <c:v>872.15</c:v>
                </c:pt>
                <c:pt idx="352">
                  <c:v>873.4</c:v>
                </c:pt>
                <c:pt idx="353">
                  <c:v>878.69299999999998</c:v>
                </c:pt>
                <c:pt idx="354">
                  <c:v>883.98699999999997</c:v>
                </c:pt>
                <c:pt idx="355">
                  <c:v>884.46799999999996</c:v>
                </c:pt>
                <c:pt idx="356">
                  <c:v>889.28</c:v>
                </c:pt>
                <c:pt idx="357">
                  <c:v>890.88699999999994</c:v>
                </c:pt>
                <c:pt idx="358">
                  <c:v>892.82100000000003</c:v>
                </c:pt>
                <c:pt idx="359">
                  <c:v>894.57299999999998</c:v>
                </c:pt>
                <c:pt idx="360">
                  <c:v>899.86699999999996</c:v>
                </c:pt>
                <c:pt idx="361">
                  <c:v>905.16</c:v>
                </c:pt>
                <c:pt idx="362">
                  <c:v>905.87900000000002</c:v>
                </c:pt>
                <c:pt idx="363">
                  <c:v>910.45299999999997</c:v>
                </c:pt>
                <c:pt idx="364">
                  <c:v>915.74699999999996</c:v>
                </c:pt>
                <c:pt idx="365">
                  <c:v>921.04</c:v>
                </c:pt>
                <c:pt idx="366">
                  <c:v>923.67399999999998</c:v>
                </c:pt>
                <c:pt idx="367">
                  <c:v>926.33299999999997</c:v>
                </c:pt>
                <c:pt idx="368">
                  <c:v>931.62699999999995</c:v>
                </c:pt>
                <c:pt idx="369">
                  <c:v>936.92</c:v>
                </c:pt>
                <c:pt idx="370">
                  <c:v>940.28399999999999</c:v>
                </c:pt>
                <c:pt idx="371">
                  <c:v>942.21299999999997</c:v>
                </c:pt>
                <c:pt idx="372">
                  <c:v>947.50699999999995</c:v>
                </c:pt>
                <c:pt idx="373">
                  <c:v>950.75300000000004</c:v>
                </c:pt>
                <c:pt idx="374">
                  <c:v>952.8</c:v>
                </c:pt>
                <c:pt idx="375">
                  <c:v>954.577</c:v>
                </c:pt>
                <c:pt idx="376">
                  <c:v>955.55799999999999</c:v>
                </c:pt>
                <c:pt idx="377">
                  <c:v>958.09299999999996</c:v>
                </c:pt>
                <c:pt idx="378">
                  <c:v>958.44299999999998</c:v>
                </c:pt>
                <c:pt idx="379">
                  <c:v>961.09</c:v>
                </c:pt>
                <c:pt idx="380">
                  <c:v>961.38900000000001</c:v>
                </c:pt>
                <c:pt idx="381">
                  <c:v>963.38699999999994</c:v>
                </c:pt>
                <c:pt idx="382">
                  <c:v>968.68</c:v>
                </c:pt>
                <c:pt idx="383">
                  <c:v>973.97299999999996</c:v>
                </c:pt>
                <c:pt idx="384">
                  <c:v>979.26700000000005</c:v>
                </c:pt>
                <c:pt idx="385">
                  <c:v>984.56</c:v>
                </c:pt>
                <c:pt idx="386">
                  <c:v>989.85299999999995</c:v>
                </c:pt>
                <c:pt idx="387">
                  <c:v>995.14700000000005</c:v>
                </c:pt>
                <c:pt idx="388">
                  <c:v>1000.44</c:v>
                </c:pt>
                <c:pt idx="389">
                  <c:v>1005.7329999999999</c:v>
                </c:pt>
                <c:pt idx="390">
                  <c:v>1007.4880000000001</c:v>
                </c:pt>
                <c:pt idx="391">
                  <c:v>1011.027</c:v>
                </c:pt>
                <c:pt idx="392">
                  <c:v>1016.32</c:v>
                </c:pt>
                <c:pt idx="393">
                  <c:v>1021.6130000000001</c:v>
                </c:pt>
                <c:pt idx="394">
                  <c:v>1026.9069999999999</c:v>
                </c:pt>
                <c:pt idx="395">
                  <c:v>1032.2</c:v>
                </c:pt>
                <c:pt idx="396">
                  <c:v>1037.4929999999999</c:v>
                </c:pt>
                <c:pt idx="397">
                  <c:v>1042.787</c:v>
                </c:pt>
                <c:pt idx="398">
                  <c:v>1048.08</c:v>
                </c:pt>
                <c:pt idx="399">
                  <c:v>1053.373</c:v>
                </c:pt>
                <c:pt idx="400">
                  <c:v>1058.6669999999999</c:v>
                </c:pt>
                <c:pt idx="401">
                  <c:v>1058.6669999999999</c:v>
                </c:pt>
              </c:numCache>
            </c:numRef>
          </c:xVal>
          <c:yVal>
            <c:numRef>
              <c:f>Foglio6!$F$819:$F$1220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99.944999999999993</c:v>
                </c:pt>
                <c:pt idx="29">
                  <c:v>99.933999999999997</c:v>
                </c:pt>
                <c:pt idx="30">
                  <c:v>99.930999999999997</c:v>
                </c:pt>
                <c:pt idx="31">
                  <c:v>99.927000000000007</c:v>
                </c:pt>
                <c:pt idx="32">
                  <c:v>99.885000000000005</c:v>
                </c:pt>
                <c:pt idx="33">
                  <c:v>99.876000000000005</c:v>
                </c:pt>
                <c:pt idx="34">
                  <c:v>99.867000000000004</c:v>
                </c:pt>
                <c:pt idx="35">
                  <c:v>99.858000000000004</c:v>
                </c:pt>
                <c:pt idx="36">
                  <c:v>99.728999999999999</c:v>
                </c:pt>
                <c:pt idx="37">
                  <c:v>99.5</c:v>
                </c:pt>
                <c:pt idx="38">
                  <c:v>99.284000000000006</c:v>
                </c:pt>
                <c:pt idx="39">
                  <c:v>99.233999999999995</c:v>
                </c:pt>
                <c:pt idx="40">
                  <c:v>99.206000000000003</c:v>
                </c:pt>
                <c:pt idx="41">
                  <c:v>99.093999999999994</c:v>
                </c:pt>
                <c:pt idx="42">
                  <c:v>99</c:v>
                </c:pt>
                <c:pt idx="43">
                  <c:v>98.620999999999995</c:v>
                </c:pt>
                <c:pt idx="44">
                  <c:v>98.561999999999998</c:v>
                </c:pt>
                <c:pt idx="45">
                  <c:v>98.501999999999995</c:v>
                </c:pt>
                <c:pt idx="46">
                  <c:v>98.5</c:v>
                </c:pt>
                <c:pt idx="47">
                  <c:v>98.441999999999993</c:v>
                </c:pt>
                <c:pt idx="48">
                  <c:v>98.382999999999996</c:v>
                </c:pt>
                <c:pt idx="49">
                  <c:v>98</c:v>
                </c:pt>
                <c:pt idx="50">
                  <c:v>97.986000000000004</c:v>
                </c:pt>
                <c:pt idx="51">
                  <c:v>97.72</c:v>
                </c:pt>
                <c:pt idx="52">
                  <c:v>97.5</c:v>
                </c:pt>
                <c:pt idx="53">
                  <c:v>97</c:v>
                </c:pt>
                <c:pt idx="54">
                  <c:v>96.968000000000004</c:v>
                </c:pt>
                <c:pt idx="55">
                  <c:v>96.5</c:v>
                </c:pt>
                <c:pt idx="56">
                  <c:v>96</c:v>
                </c:pt>
                <c:pt idx="57">
                  <c:v>95.799000000000007</c:v>
                </c:pt>
                <c:pt idx="58">
                  <c:v>95.5</c:v>
                </c:pt>
                <c:pt idx="59">
                  <c:v>95.353999999999999</c:v>
                </c:pt>
                <c:pt idx="60">
                  <c:v>95</c:v>
                </c:pt>
                <c:pt idx="61">
                  <c:v>94.900999999999996</c:v>
                </c:pt>
                <c:pt idx="62">
                  <c:v>94.5</c:v>
                </c:pt>
                <c:pt idx="63">
                  <c:v>94.322999999999993</c:v>
                </c:pt>
                <c:pt idx="64">
                  <c:v>94.191000000000003</c:v>
                </c:pt>
                <c:pt idx="65">
                  <c:v>94.055999999999997</c:v>
                </c:pt>
                <c:pt idx="66">
                  <c:v>94</c:v>
                </c:pt>
                <c:pt idx="67">
                  <c:v>93.908000000000001</c:v>
                </c:pt>
                <c:pt idx="68">
                  <c:v>93.713999999999999</c:v>
                </c:pt>
                <c:pt idx="69">
                  <c:v>93.504999999999995</c:v>
                </c:pt>
                <c:pt idx="70">
                  <c:v>93.5</c:v>
                </c:pt>
                <c:pt idx="71">
                  <c:v>93.296000000000006</c:v>
                </c:pt>
                <c:pt idx="72">
                  <c:v>93</c:v>
                </c:pt>
                <c:pt idx="73">
                  <c:v>92.5</c:v>
                </c:pt>
                <c:pt idx="74">
                  <c:v>92</c:v>
                </c:pt>
                <c:pt idx="75">
                  <c:v>91.5</c:v>
                </c:pt>
                <c:pt idx="76">
                  <c:v>91.471999999999994</c:v>
                </c:pt>
                <c:pt idx="77">
                  <c:v>91</c:v>
                </c:pt>
                <c:pt idx="78">
                  <c:v>90.5</c:v>
                </c:pt>
                <c:pt idx="79">
                  <c:v>90.239000000000004</c:v>
                </c:pt>
                <c:pt idx="80">
                  <c:v>90</c:v>
                </c:pt>
                <c:pt idx="81">
                  <c:v>89.5</c:v>
                </c:pt>
                <c:pt idx="82">
                  <c:v>89.046999999999997</c:v>
                </c:pt>
                <c:pt idx="83">
                  <c:v>89</c:v>
                </c:pt>
                <c:pt idx="84">
                  <c:v>88.5</c:v>
                </c:pt>
                <c:pt idx="85">
                  <c:v>88.275999999999996</c:v>
                </c:pt>
                <c:pt idx="86">
                  <c:v>88</c:v>
                </c:pt>
                <c:pt idx="87">
                  <c:v>87.843000000000004</c:v>
                </c:pt>
                <c:pt idx="88">
                  <c:v>87.5</c:v>
                </c:pt>
                <c:pt idx="89">
                  <c:v>87.24</c:v>
                </c:pt>
                <c:pt idx="90">
                  <c:v>87</c:v>
                </c:pt>
                <c:pt idx="91">
                  <c:v>86.647999999999996</c:v>
                </c:pt>
                <c:pt idx="92">
                  <c:v>86.5</c:v>
                </c:pt>
                <c:pt idx="93">
                  <c:v>86.356999999999999</c:v>
                </c:pt>
                <c:pt idx="94">
                  <c:v>86.066999999999993</c:v>
                </c:pt>
                <c:pt idx="95">
                  <c:v>86</c:v>
                </c:pt>
                <c:pt idx="96">
                  <c:v>85.5</c:v>
                </c:pt>
                <c:pt idx="97">
                  <c:v>85</c:v>
                </c:pt>
                <c:pt idx="98">
                  <c:v>84.974000000000004</c:v>
                </c:pt>
                <c:pt idx="99">
                  <c:v>84.515000000000001</c:v>
                </c:pt>
                <c:pt idx="100">
                  <c:v>84.5</c:v>
                </c:pt>
                <c:pt idx="101">
                  <c:v>84.21</c:v>
                </c:pt>
                <c:pt idx="102">
                  <c:v>84.122</c:v>
                </c:pt>
                <c:pt idx="103">
                  <c:v>84.034000000000006</c:v>
                </c:pt>
                <c:pt idx="104">
                  <c:v>84</c:v>
                </c:pt>
                <c:pt idx="105">
                  <c:v>83.84</c:v>
                </c:pt>
                <c:pt idx="106">
                  <c:v>83.5</c:v>
                </c:pt>
                <c:pt idx="107">
                  <c:v>83</c:v>
                </c:pt>
                <c:pt idx="108">
                  <c:v>82.5</c:v>
                </c:pt>
                <c:pt idx="109">
                  <c:v>82.376999999999995</c:v>
                </c:pt>
                <c:pt idx="110">
                  <c:v>82</c:v>
                </c:pt>
                <c:pt idx="111">
                  <c:v>81.5</c:v>
                </c:pt>
                <c:pt idx="112">
                  <c:v>81</c:v>
                </c:pt>
                <c:pt idx="113">
                  <c:v>80.5</c:v>
                </c:pt>
                <c:pt idx="114">
                  <c:v>80</c:v>
                </c:pt>
                <c:pt idx="115">
                  <c:v>79.989999999999995</c:v>
                </c:pt>
                <c:pt idx="116">
                  <c:v>79.5</c:v>
                </c:pt>
                <c:pt idx="117">
                  <c:v>79</c:v>
                </c:pt>
                <c:pt idx="118">
                  <c:v>78.5</c:v>
                </c:pt>
                <c:pt idx="119">
                  <c:v>78.445999999999998</c:v>
                </c:pt>
                <c:pt idx="120">
                  <c:v>78</c:v>
                </c:pt>
                <c:pt idx="121">
                  <c:v>77.5</c:v>
                </c:pt>
                <c:pt idx="122">
                  <c:v>77</c:v>
                </c:pt>
                <c:pt idx="123">
                  <c:v>76.5</c:v>
                </c:pt>
                <c:pt idx="124">
                  <c:v>76.165000000000006</c:v>
                </c:pt>
                <c:pt idx="125">
                  <c:v>76</c:v>
                </c:pt>
                <c:pt idx="126">
                  <c:v>75.5</c:v>
                </c:pt>
                <c:pt idx="127">
                  <c:v>75.415000000000006</c:v>
                </c:pt>
                <c:pt idx="128">
                  <c:v>75</c:v>
                </c:pt>
                <c:pt idx="129">
                  <c:v>74.611999999999995</c:v>
                </c:pt>
                <c:pt idx="130">
                  <c:v>74.5</c:v>
                </c:pt>
                <c:pt idx="131">
                  <c:v>74</c:v>
                </c:pt>
                <c:pt idx="132">
                  <c:v>73.5</c:v>
                </c:pt>
                <c:pt idx="133">
                  <c:v>73.488</c:v>
                </c:pt>
                <c:pt idx="134">
                  <c:v>73</c:v>
                </c:pt>
                <c:pt idx="135">
                  <c:v>72.902000000000001</c:v>
                </c:pt>
                <c:pt idx="136">
                  <c:v>72.551000000000002</c:v>
                </c:pt>
                <c:pt idx="137">
                  <c:v>72.5</c:v>
                </c:pt>
                <c:pt idx="138">
                  <c:v>72.198999999999998</c:v>
                </c:pt>
                <c:pt idx="139">
                  <c:v>72</c:v>
                </c:pt>
                <c:pt idx="140">
                  <c:v>71.5</c:v>
                </c:pt>
                <c:pt idx="141">
                  <c:v>71</c:v>
                </c:pt>
                <c:pt idx="142">
                  <c:v>70.584000000000003</c:v>
                </c:pt>
                <c:pt idx="143">
                  <c:v>70.5</c:v>
                </c:pt>
                <c:pt idx="144">
                  <c:v>70.433000000000007</c:v>
                </c:pt>
                <c:pt idx="145">
                  <c:v>70</c:v>
                </c:pt>
                <c:pt idx="146">
                  <c:v>69.5</c:v>
                </c:pt>
                <c:pt idx="147">
                  <c:v>69</c:v>
                </c:pt>
                <c:pt idx="148">
                  <c:v>68.5</c:v>
                </c:pt>
                <c:pt idx="149">
                  <c:v>68.314999999999998</c:v>
                </c:pt>
                <c:pt idx="150">
                  <c:v>68</c:v>
                </c:pt>
                <c:pt idx="151">
                  <c:v>67.5</c:v>
                </c:pt>
                <c:pt idx="152">
                  <c:v>67</c:v>
                </c:pt>
                <c:pt idx="153">
                  <c:v>66.991</c:v>
                </c:pt>
                <c:pt idx="154">
                  <c:v>66.5</c:v>
                </c:pt>
                <c:pt idx="155">
                  <c:v>66.236999999999995</c:v>
                </c:pt>
                <c:pt idx="156">
                  <c:v>66</c:v>
                </c:pt>
                <c:pt idx="157">
                  <c:v>65.731999999999999</c:v>
                </c:pt>
                <c:pt idx="158">
                  <c:v>65.5</c:v>
                </c:pt>
                <c:pt idx="159">
                  <c:v>65</c:v>
                </c:pt>
                <c:pt idx="160">
                  <c:v>64.5</c:v>
                </c:pt>
                <c:pt idx="161">
                  <c:v>64.183999999999997</c:v>
                </c:pt>
                <c:pt idx="162">
                  <c:v>64</c:v>
                </c:pt>
                <c:pt idx="163">
                  <c:v>63.615000000000002</c:v>
                </c:pt>
                <c:pt idx="164">
                  <c:v>63.5</c:v>
                </c:pt>
                <c:pt idx="165">
                  <c:v>63</c:v>
                </c:pt>
                <c:pt idx="166">
                  <c:v>62.956000000000003</c:v>
                </c:pt>
                <c:pt idx="167">
                  <c:v>62.5</c:v>
                </c:pt>
                <c:pt idx="168">
                  <c:v>62.265999999999998</c:v>
                </c:pt>
                <c:pt idx="169">
                  <c:v>62</c:v>
                </c:pt>
                <c:pt idx="170">
                  <c:v>61.5</c:v>
                </c:pt>
                <c:pt idx="171">
                  <c:v>61.415999999999997</c:v>
                </c:pt>
                <c:pt idx="172">
                  <c:v>61.064</c:v>
                </c:pt>
                <c:pt idx="173">
                  <c:v>61</c:v>
                </c:pt>
                <c:pt idx="174">
                  <c:v>60.5</c:v>
                </c:pt>
                <c:pt idx="175">
                  <c:v>60.414999999999999</c:v>
                </c:pt>
                <c:pt idx="176">
                  <c:v>60</c:v>
                </c:pt>
                <c:pt idx="177">
                  <c:v>59.603999999999999</c:v>
                </c:pt>
                <c:pt idx="178">
                  <c:v>59.5</c:v>
                </c:pt>
                <c:pt idx="179">
                  <c:v>59</c:v>
                </c:pt>
                <c:pt idx="180">
                  <c:v>58.902000000000001</c:v>
                </c:pt>
                <c:pt idx="181">
                  <c:v>58.5</c:v>
                </c:pt>
                <c:pt idx="182">
                  <c:v>58</c:v>
                </c:pt>
                <c:pt idx="183">
                  <c:v>57.5</c:v>
                </c:pt>
                <c:pt idx="184">
                  <c:v>57</c:v>
                </c:pt>
                <c:pt idx="185">
                  <c:v>56.5</c:v>
                </c:pt>
                <c:pt idx="186">
                  <c:v>56</c:v>
                </c:pt>
                <c:pt idx="187">
                  <c:v>55.567999999999998</c:v>
                </c:pt>
                <c:pt idx="188">
                  <c:v>55.5</c:v>
                </c:pt>
                <c:pt idx="189">
                  <c:v>55.23</c:v>
                </c:pt>
                <c:pt idx="190">
                  <c:v>55</c:v>
                </c:pt>
                <c:pt idx="191">
                  <c:v>54.893000000000001</c:v>
                </c:pt>
                <c:pt idx="192">
                  <c:v>54.5</c:v>
                </c:pt>
                <c:pt idx="193">
                  <c:v>54.164999999999999</c:v>
                </c:pt>
                <c:pt idx="194">
                  <c:v>54</c:v>
                </c:pt>
                <c:pt idx="195">
                  <c:v>53.5</c:v>
                </c:pt>
                <c:pt idx="196">
                  <c:v>53.082000000000001</c:v>
                </c:pt>
                <c:pt idx="197">
                  <c:v>53</c:v>
                </c:pt>
                <c:pt idx="198">
                  <c:v>52.5</c:v>
                </c:pt>
                <c:pt idx="199">
                  <c:v>52</c:v>
                </c:pt>
                <c:pt idx="200">
                  <c:v>51.5</c:v>
                </c:pt>
                <c:pt idx="201">
                  <c:v>51</c:v>
                </c:pt>
                <c:pt idx="202">
                  <c:v>50.966000000000001</c:v>
                </c:pt>
                <c:pt idx="203">
                  <c:v>50.5</c:v>
                </c:pt>
                <c:pt idx="204">
                  <c:v>50</c:v>
                </c:pt>
                <c:pt idx="205">
                  <c:v>49.963999999999999</c:v>
                </c:pt>
                <c:pt idx="206">
                  <c:v>49.5</c:v>
                </c:pt>
                <c:pt idx="207">
                  <c:v>49</c:v>
                </c:pt>
                <c:pt idx="208">
                  <c:v>48.908999999999999</c:v>
                </c:pt>
                <c:pt idx="209">
                  <c:v>48.5</c:v>
                </c:pt>
                <c:pt idx="210">
                  <c:v>48.173999999999999</c:v>
                </c:pt>
                <c:pt idx="211">
                  <c:v>48</c:v>
                </c:pt>
                <c:pt idx="212">
                  <c:v>47.5</c:v>
                </c:pt>
                <c:pt idx="213">
                  <c:v>47.401000000000003</c:v>
                </c:pt>
                <c:pt idx="214">
                  <c:v>47.320999999999998</c:v>
                </c:pt>
                <c:pt idx="215">
                  <c:v>47.241</c:v>
                </c:pt>
                <c:pt idx="216">
                  <c:v>47</c:v>
                </c:pt>
                <c:pt idx="217">
                  <c:v>46.613</c:v>
                </c:pt>
                <c:pt idx="218">
                  <c:v>46.5</c:v>
                </c:pt>
                <c:pt idx="219">
                  <c:v>46</c:v>
                </c:pt>
                <c:pt idx="220">
                  <c:v>45.576999999999998</c:v>
                </c:pt>
                <c:pt idx="221">
                  <c:v>45.5</c:v>
                </c:pt>
                <c:pt idx="222">
                  <c:v>45.286000000000001</c:v>
                </c:pt>
                <c:pt idx="223">
                  <c:v>45</c:v>
                </c:pt>
                <c:pt idx="224">
                  <c:v>44.994999999999997</c:v>
                </c:pt>
                <c:pt idx="225">
                  <c:v>44.567</c:v>
                </c:pt>
                <c:pt idx="226">
                  <c:v>44.5</c:v>
                </c:pt>
                <c:pt idx="227">
                  <c:v>44</c:v>
                </c:pt>
                <c:pt idx="228">
                  <c:v>43.923999999999999</c:v>
                </c:pt>
                <c:pt idx="229">
                  <c:v>43.5</c:v>
                </c:pt>
                <c:pt idx="230">
                  <c:v>43</c:v>
                </c:pt>
                <c:pt idx="231">
                  <c:v>42.5</c:v>
                </c:pt>
                <c:pt idx="232">
                  <c:v>42</c:v>
                </c:pt>
                <c:pt idx="233">
                  <c:v>41.767000000000003</c:v>
                </c:pt>
                <c:pt idx="234">
                  <c:v>41.5</c:v>
                </c:pt>
                <c:pt idx="235">
                  <c:v>41</c:v>
                </c:pt>
                <c:pt idx="236">
                  <c:v>40.5</c:v>
                </c:pt>
                <c:pt idx="237">
                  <c:v>40</c:v>
                </c:pt>
                <c:pt idx="238">
                  <c:v>39.5</c:v>
                </c:pt>
                <c:pt idx="239">
                  <c:v>39</c:v>
                </c:pt>
                <c:pt idx="240">
                  <c:v>38.5</c:v>
                </c:pt>
                <c:pt idx="241">
                  <c:v>38.472999999999999</c:v>
                </c:pt>
                <c:pt idx="242">
                  <c:v>38.225999999999999</c:v>
                </c:pt>
                <c:pt idx="243">
                  <c:v>38</c:v>
                </c:pt>
                <c:pt idx="244">
                  <c:v>37.979999999999997</c:v>
                </c:pt>
                <c:pt idx="245">
                  <c:v>37.5</c:v>
                </c:pt>
                <c:pt idx="246">
                  <c:v>37</c:v>
                </c:pt>
                <c:pt idx="247">
                  <c:v>36.5</c:v>
                </c:pt>
                <c:pt idx="248">
                  <c:v>36</c:v>
                </c:pt>
                <c:pt idx="249">
                  <c:v>35.872999999999998</c:v>
                </c:pt>
                <c:pt idx="250">
                  <c:v>35.5</c:v>
                </c:pt>
                <c:pt idx="251">
                  <c:v>35</c:v>
                </c:pt>
                <c:pt idx="252">
                  <c:v>34.5</c:v>
                </c:pt>
                <c:pt idx="253">
                  <c:v>34.414000000000001</c:v>
                </c:pt>
                <c:pt idx="254">
                  <c:v>34</c:v>
                </c:pt>
                <c:pt idx="255">
                  <c:v>33.936</c:v>
                </c:pt>
                <c:pt idx="256">
                  <c:v>33.692999999999998</c:v>
                </c:pt>
                <c:pt idx="257">
                  <c:v>33.5</c:v>
                </c:pt>
                <c:pt idx="258">
                  <c:v>33.451000000000001</c:v>
                </c:pt>
                <c:pt idx="259">
                  <c:v>33</c:v>
                </c:pt>
                <c:pt idx="260">
                  <c:v>32.5</c:v>
                </c:pt>
                <c:pt idx="261">
                  <c:v>32</c:v>
                </c:pt>
                <c:pt idx="262">
                  <c:v>31.960999999999999</c:v>
                </c:pt>
                <c:pt idx="263">
                  <c:v>31.5</c:v>
                </c:pt>
                <c:pt idx="264">
                  <c:v>31</c:v>
                </c:pt>
                <c:pt idx="265">
                  <c:v>30.702000000000002</c:v>
                </c:pt>
                <c:pt idx="266">
                  <c:v>30.5</c:v>
                </c:pt>
                <c:pt idx="267">
                  <c:v>30.483000000000001</c:v>
                </c:pt>
                <c:pt idx="268">
                  <c:v>30.184999999999999</c:v>
                </c:pt>
                <c:pt idx="269">
                  <c:v>30</c:v>
                </c:pt>
                <c:pt idx="270">
                  <c:v>29.788</c:v>
                </c:pt>
                <c:pt idx="271">
                  <c:v>29.5</c:v>
                </c:pt>
                <c:pt idx="272">
                  <c:v>29</c:v>
                </c:pt>
                <c:pt idx="273">
                  <c:v>28.606000000000002</c:v>
                </c:pt>
                <c:pt idx="274">
                  <c:v>28.5</c:v>
                </c:pt>
                <c:pt idx="275">
                  <c:v>28</c:v>
                </c:pt>
                <c:pt idx="276">
                  <c:v>27.852</c:v>
                </c:pt>
                <c:pt idx="277">
                  <c:v>27.5</c:v>
                </c:pt>
                <c:pt idx="278">
                  <c:v>27.033000000000001</c:v>
                </c:pt>
                <c:pt idx="279">
                  <c:v>27</c:v>
                </c:pt>
                <c:pt idx="280">
                  <c:v>26.5</c:v>
                </c:pt>
                <c:pt idx="281">
                  <c:v>26</c:v>
                </c:pt>
                <c:pt idx="282">
                  <c:v>25.5</c:v>
                </c:pt>
                <c:pt idx="283">
                  <c:v>25</c:v>
                </c:pt>
                <c:pt idx="284">
                  <c:v>24.696000000000002</c:v>
                </c:pt>
                <c:pt idx="285">
                  <c:v>24.5</c:v>
                </c:pt>
                <c:pt idx="286">
                  <c:v>24.498000000000001</c:v>
                </c:pt>
                <c:pt idx="287">
                  <c:v>24.300999999999998</c:v>
                </c:pt>
                <c:pt idx="288">
                  <c:v>24.103000000000002</c:v>
                </c:pt>
                <c:pt idx="289">
                  <c:v>24</c:v>
                </c:pt>
                <c:pt idx="290">
                  <c:v>23.5</c:v>
                </c:pt>
                <c:pt idx="291">
                  <c:v>23</c:v>
                </c:pt>
                <c:pt idx="292">
                  <c:v>22.82</c:v>
                </c:pt>
                <c:pt idx="293">
                  <c:v>22.56</c:v>
                </c:pt>
                <c:pt idx="294">
                  <c:v>22.5</c:v>
                </c:pt>
                <c:pt idx="295">
                  <c:v>22.3</c:v>
                </c:pt>
                <c:pt idx="296">
                  <c:v>22</c:v>
                </c:pt>
                <c:pt idx="297">
                  <c:v>21.5</c:v>
                </c:pt>
                <c:pt idx="298">
                  <c:v>21</c:v>
                </c:pt>
                <c:pt idx="299">
                  <c:v>20.5</c:v>
                </c:pt>
                <c:pt idx="300">
                  <c:v>20.385000000000002</c:v>
                </c:pt>
                <c:pt idx="301">
                  <c:v>20.073</c:v>
                </c:pt>
                <c:pt idx="302">
                  <c:v>20</c:v>
                </c:pt>
                <c:pt idx="303">
                  <c:v>19.754000000000001</c:v>
                </c:pt>
                <c:pt idx="304">
                  <c:v>19.5</c:v>
                </c:pt>
                <c:pt idx="305">
                  <c:v>19.382000000000001</c:v>
                </c:pt>
                <c:pt idx="306">
                  <c:v>19.010000000000002</c:v>
                </c:pt>
                <c:pt idx="307">
                  <c:v>19</c:v>
                </c:pt>
                <c:pt idx="308">
                  <c:v>18.5</c:v>
                </c:pt>
                <c:pt idx="309">
                  <c:v>18</c:v>
                </c:pt>
                <c:pt idx="310">
                  <c:v>17.5</c:v>
                </c:pt>
                <c:pt idx="311">
                  <c:v>17</c:v>
                </c:pt>
                <c:pt idx="312">
                  <c:v>16.774999999999999</c:v>
                </c:pt>
                <c:pt idx="313">
                  <c:v>16.5</c:v>
                </c:pt>
                <c:pt idx="314">
                  <c:v>16.094999999999999</c:v>
                </c:pt>
                <c:pt idx="315">
                  <c:v>16</c:v>
                </c:pt>
                <c:pt idx="316">
                  <c:v>15.5</c:v>
                </c:pt>
                <c:pt idx="317">
                  <c:v>15.496</c:v>
                </c:pt>
                <c:pt idx="318">
                  <c:v>15</c:v>
                </c:pt>
                <c:pt idx="319">
                  <c:v>14.946999999999999</c:v>
                </c:pt>
                <c:pt idx="320">
                  <c:v>14.917</c:v>
                </c:pt>
                <c:pt idx="321">
                  <c:v>14.888</c:v>
                </c:pt>
                <c:pt idx="322">
                  <c:v>14.859</c:v>
                </c:pt>
                <c:pt idx="323">
                  <c:v>14.755000000000001</c:v>
                </c:pt>
                <c:pt idx="324">
                  <c:v>14.657999999999999</c:v>
                </c:pt>
                <c:pt idx="325">
                  <c:v>14.587999999999999</c:v>
                </c:pt>
                <c:pt idx="326">
                  <c:v>14.516999999999999</c:v>
                </c:pt>
                <c:pt idx="327">
                  <c:v>14.5</c:v>
                </c:pt>
                <c:pt idx="328">
                  <c:v>14</c:v>
                </c:pt>
                <c:pt idx="329">
                  <c:v>13.5</c:v>
                </c:pt>
                <c:pt idx="330">
                  <c:v>13</c:v>
                </c:pt>
                <c:pt idx="331">
                  <c:v>12.5</c:v>
                </c:pt>
                <c:pt idx="332">
                  <c:v>12.103</c:v>
                </c:pt>
                <c:pt idx="333">
                  <c:v>12</c:v>
                </c:pt>
                <c:pt idx="334">
                  <c:v>11.741</c:v>
                </c:pt>
                <c:pt idx="335">
                  <c:v>11.5</c:v>
                </c:pt>
                <c:pt idx="336">
                  <c:v>11</c:v>
                </c:pt>
                <c:pt idx="337">
                  <c:v>10.5</c:v>
                </c:pt>
                <c:pt idx="338">
                  <c:v>10.362</c:v>
                </c:pt>
                <c:pt idx="339">
                  <c:v>10</c:v>
                </c:pt>
                <c:pt idx="340">
                  <c:v>9.952</c:v>
                </c:pt>
                <c:pt idx="341">
                  <c:v>9.5359999999999996</c:v>
                </c:pt>
                <c:pt idx="342">
                  <c:v>9.5</c:v>
                </c:pt>
                <c:pt idx="343">
                  <c:v>9.0960000000000001</c:v>
                </c:pt>
                <c:pt idx="344">
                  <c:v>9</c:v>
                </c:pt>
                <c:pt idx="345">
                  <c:v>8.6560000000000006</c:v>
                </c:pt>
                <c:pt idx="346">
                  <c:v>8.5</c:v>
                </c:pt>
                <c:pt idx="347">
                  <c:v>8</c:v>
                </c:pt>
                <c:pt idx="348">
                  <c:v>7.5</c:v>
                </c:pt>
                <c:pt idx="349">
                  <c:v>7.3680000000000003</c:v>
                </c:pt>
                <c:pt idx="350">
                  <c:v>7.16</c:v>
                </c:pt>
                <c:pt idx="351">
                  <c:v>7</c:v>
                </c:pt>
                <c:pt idx="352">
                  <c:v>6.9509999999999996</c:v>
                </c:pt>
                <c:pt idx="353">
                  <c:v>6.742</c:v>
                </c:pt>
                <c:pt idx="354">
                  <c:v>6.5330000000000004</c:v>
                </c:pt>
                <c:pt idx="355">
                  <c:v>6.5</c:v>
                </c:pt>
                <c:pt idx="356">
                  <c:v>6.125</c:v>
                </c:pt>
                <c:pt idx="357">
                  <c:v>6</c:v>
                </c:pt>
                <c:pt idx="358">
                  <c:v>5.5</c:v>
                </c:pt>
                <c:pt idx="359">
                  <c:v>5.4379999999999997</c:v>
                </c:pt>
                <c:pt idx="360">
                  <c:v>5.2530000000000001</c:v>
                </c:pt>
                <c:pt idx="361">
                  <c:v>5.0510000000000002</c:v>
                </c:pt>
                <c:pt idx="362">
                  <c:v>5</c:v>
                </c:pt>
                <c:pt idx="363">
                  <c:v>4.71</c:v>
                </c:pt>
                <c:pt idx="364">
                  <c:v>4.6390000000000002</c:v>
                </c:pt>
                <c:pt idx="365">
                  <c:v>4.5679999999999996</c:v>
                </c:pt>
                <c:pt idx="366">
                  <c:v>4.5</c:v>
                </c:pt>
                <c:pt idx="367">
                  <c:v>4.3879999999999999</c:v>
                </c:pt>
                <c:pt idx="368">
                  <c:v>4.2279999999999998</c:v>
                </c:pt>
                <c:pt idx="369">
                  <c:v>4.0890000000000004</c:v>
                </c:pt>
                <c:pt idx="370">
                  <c:v>4</c:v>
                </c:pt>
                <c:pt idx="371">
                  <c:v>3.9489999999999998</c:v>
                </c:pt>
                <c:pt idx="372">
                  <c:v>3.81</c:v>
                </c:pt>
                <c:pt idx="373">
                  <c:v>3.5</c:v>
                </c:pt>
                <c:pt idx="374">
                  <c:v>3.2869999999999999</c:v>
                </c:pt>
                <c:pt idx="375">
                  <c:v>3</c:v>
                </c:pt>
                <c:pt idx="376">
                  <c:v>2.5</c:v>
                </c:pt>
                <c:pt idx="377">
                  <c:v>2.0569999999999999</c:v>
                </c:pt>
                <c:pt idx="378">
                  <c:v>2</c:v>
                </c:pt>
                <c:pt idx="379">
                  <c:v>1.5</c:v>
                </c:pt>
                <c:pt idx="380">
                  <c:v>1</c:v>
                </c:pt>
                <c:pt idx="381">
                  <c:v>0.91300000000000003</c:v>
                </c:pt>
                <c:pt idx="382">
                  <c:v>0.86399999999999999</c:v>
                </c:pt>
                <c:pt idx="383">
                  <c:v>0.81399999999999995</c:v>
                </c:pt>
                <c:pt idx="384">
                  <c:v>0.76500000000000001</c:v>
                </c:pt>
                <c:pt idx="385">
                  <c:v>0.71499999999999997</c:v>
                </c:pt>
                <c:pt idx="386">
                  <c:v>0.66500000000000004</c:v>
                </c:pt>
                <c:pt idx="387">
                  <c:v>0.61599999999999999</c:v>
                </c:pt>
                <c:pt idx="388">
                  <c:v>0.56599999999999995</c:v>
                </c:pt>
                <c:pt idx="389">
                  <c:v>0.51600000000000001</c:v>
                </c:pt>
                <c:pt idx="390">
                  <c:v>0.5</c:v>
                </c:pt>
                <c:pt idx="391">
                  <c:v>0.46700000000000003</c:v>
                </c:pt>
                <c:pt idx="392">
                  <c:v>0.42499999999999999</c:v>
                </c:pt>
                <c:pt idx="393">
                  <c:v>0.41299999999999998</c:v>
                </c:pt>
                <c:pt idx="394">
                  <c:v>0.40100000000000002</c:v>
                </c:pt>
                <c:pt idx="395">
                  <c:v>0.38900000000000001</c:v>
                </c:pt>
                <c:pt idx="396">
                  <c:v>0.377</c:v>
                </c:pt>
                <c:pt idx="397">
                  <c:v>0.36499999999999999</c:v>
                </c:pt>
                <c:pt idx="398">
                  <c:v>0.35299999999999998</c:v>
                </c:pt>
                <c:pt idx="399">
                  <c:v>0.28000000000000003</c:v>
                </c:pt>
                <c:pt idx="400">
                  <c:v>6.0999999999999999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496-4CC3-8534-400DC70DE595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xVal>
            <c:numRef>
              <c:f>Foglio6!$G$819:$G$1220</c:f>
              <c:numCache>
                <c:formatCode>General</c:formatCode>
                <c:ptCount val="402"/>
                <c:pt idx="0">
                  <c:v>0</c:v>
                </c:pt>
                <c:pt idx="1">
                  <c:v>5.3339999999999996</c:v>
                </c:pt>
                <c:pt idx="2">
                  <c:v>10.667</c:v>
                </c:pt>
                <c:pt idx="3">
                  <c:v>16.001000000000001</c:v>
                </c:pt>
                <c:pt idx="4">
                  <c:v>21.334</c:v>
                </c:pt>
                <c:pt idx="5">
                  <c:v>26.667999999999999</c:v>
                </c:pt>
                <c:pt idx="6">
                  <c:v>32.000999999999998</c:v>
                </c:pt>
                <c:pt idx="7">
                  <c:v>37.335000000000001</c:v>
                </c:pt>
                <c:pt idx="8">
                  <c:v>42.668999999999997</c:v>
                </c:pt>
                <c:pt idx="9">
                  <c:v>48.002000000000002</c:v>
                </c:pt>
                <c:pt idx="10">
                  <c:v>53.335999999999999</c:v>
                </c:pt>
                <c:pt idx="11">
                  <c:v>58.668999999999997</c:v>
                </c:pt>
                <c:pt idx="12">
                  <c:v>64.003</c:v>
                </c:pt>
                <c:pt idx="13">
                  <c:v>69.335999999999999</c:v>
                </c:pt>
                <c:pt idx="14">
                  <c:v>74.67</c:v>
                </c:pt>
                <c:pt idx="15">
                  <c:v>80.004000000000005</c:v>
                </c:pt>
                <c:pt idx="16">
                  <c:v>85.337000000000003</c:v>
                </c:pt>
                <c:pt idx="17">
                  <c:v>90.671000000000006</c:v>
                </c:pt>
                <c:pt idx="18">
                  <c:v>96.004000000000005</c:v>
                </c:pt>
                <c:pt idx="19">
                  <c:v>101.33799999999999</c:v>
                </c:pt>
                <c:pt idx="20">
                  <c:v>106.67100000000001</c:v>
                </c:pt>
                <c:pt idx="21">
                  <c:v>112.005</c:v>
                </c:pt>
                <c:pt idx="22">
                  <c:v>117.339</c:v>
                </c:pt>
                <c:pt idx="23">
                  <c:v>119.24299999999999</c:v>
                </c:pt>
                <c:pt idx="24">
                  <c:v>122.672</c:v>
                </c:pt>
                <c:pt idx="25">
                  <c:v>128.006</c:v>
                </c:pt>
                <c:pt idx="26">
                  <c:v>133.339</c:v>
                </c:pt>
                <c:pt idx="27">
                  <c:v>138.673</c:v>
                </c:pt>
                <c:pt idx="28">
                  <c:v>144.006</c:v>
                </c:pt>
                <c:pt idx="29">
                  <c:v>149.34</c:v>
                </c:pt>
                <c:pt idx="30">
                  <c:v>154.67400000000001</c:v>
                </c:pt>
                <c:pt idx="31">
                  <c:v>160.00700000000001</c:v>
                </c:pt>
                <c:pt idx="32">
                  <c:v>162.017</c:v>
                </c:pt>
                <c:pt idx="33">
                  <c:v>165.34100000000001</c:v>
                </c:pt>
                <c:pt idx="34">
                  <c:v>170.67400000000001</c:v>
                </c:pt>
                <c:pt idx="35">
                  <c:v>173.14599999999999</c:v>
                </c:pt>
                <c:pt idx="36">
                  <c:v>176.00800000000001</c:v>
                </c:pt>
                <c:pt idx="37">
                  <c:v>181.34100000000001</c:v>
                </c:pt>
                <c:pt idx="38">
                  <c:v>183.096</c:v>
                </c:pt>
                <c:pt idx="39">
                  <c:v>186.67500000000001</c:v>
                </c:pt>
                <c:pt idx="40">
                  <c:v>192.00899999999999</c:v>
                </c:pt>
                <c:pt idx="41">
                  <c:v>197.34200000000001</c:v>
                </c:pt>
                <c:pt idx="42">
                  <c:v>201.32400000000001</c:v>
                </c:pt>
                <c:pt idx="43">
                  <c:v>202.67599999999999</c:v>
                </c:pt>
                <c:pt idx="44">
                  <c:v>203.01599999999999</c:v>
                </c:pt>
                <c:pt idx="45">
                  <c:v>205.31200000000001</c:v>
                </c:pt>
                <c:pt idx="46">
                  <c:v>208.00899999999999</c:v>
                </c:pt>
                <c:pt idx="47">
                  <c:v>208.75299999999999</c:v>
                </c:pt>
                <c:pt idx="48">
                  <c:v>212.1</c:v>
                </c:pt>
                <c:pt idx="49">
                  <c:v>213.173</c:v>
                </c:pt>
                <c:pt idx="50">
                  <c:v>213.30199999999999</c:v>
                </c:pt>
                <c:pt idx="51">
                  <c:v>213.34299999999999</c:v>
                </c:pt>
                <c:pt idx="52">
                  <c:v>216.02799999999999</c:v>
                </c:pt>
                <c:pt idx="53">
                  <c:v>218.67599999999999</c:v>
                </c:pt>
                <c:pt idx="54">
                  <c:v>222.233</c:v>
                </c:pt>
                <c:pt idx="55">
                  <c:v>224.01</c:v>
                </c:pt>
                <c:pt idx="56">
                  <c:v>225.38900000000001</c:v>
                </c:pt>
                <c:pt idx="57">
                  <c:v>229.34399999999999</c:v>
                </c:pt>
                <c:pt idx="58">
                  <c:v>234.67699999999999</c:v>
                </c:pt>
                <c:pt idx="59">
                  <c:v>235.3</c:v>
                </c:pt>
                <c:pt idx="60">
                  <c:v>240.011</c:v>
                </c:pt>
                <c:pt idx="61">
                  <c:v>240.715</c:v>
                </c:pt>
                <c:pt idx="62">
                  <c:v>241.63900000000001</c:v>
                </c:pt>
                <c:pt idx="63">
                  <c:v>245.34399999999999</c:v>
                </c:pt>
                <c:pt idx="64">
                  <c:v>250.678</c:v>
                </c:pt>
                <c:pt idx="65">
                  <c:v>251.58199999999999</c:v>
                </c:pt>
                <c:pt idx="66">
                  <c:v>255.58099999999999</c:v>
                </c:pt>
                <c:pt idx="67">
                  <c:v>256.01100000000002</c:v>
                </c:pt>
                <c:pt idx="68">
                  <c:v>256.05799999999999</c:v>
                </c:pt>
                <c:pt idx="69">
                  <c:v>256.904</c:v>
                </c:pt>
                <c:pt idx="70">
                  <c:v>259.29300000000001</c:v>
                </c:pt>
                <c:pt idx="71">
                  <c:v>261.34500000000003</c:v>
                </c:pt>
                <c:pt idx="72">
                  <c:v>262.47500000000002</c:v>
                </c:pt>
                <c:pt idx="73">
                  <c:v>266.67899999999997</c:v>
                </c:pt>
                <c:pt idx="74">
                  <c:v>271.22300000000001</c:v>
                </c:pt>
                <c:pt idx="75">
                  <c:v>272.012</c:v>
                </c:pt>
                <c:pt idx="76">
                  <c:v>274.80700000000002</c:v>
                </c:pt>
                <c:pt idx="77">
                  <c:v>275.37</c:v>
                </c:pt>
                <c:pt idx="78">
                  <c:v>275.71100000000001</c:v>
                </c:pt>
                <c:pt idx="79">
                  <c:v>276.62400000000002</c:v>
                </c:pt>
                <c:pt idx="80">
                  <c:v>277.346</c:v>
                </c:pt>
                <c:pt idx="81">
                  <c:v>278.654</c:v>
                </c:pt>
                <c:pt idx="82">
                  <c:v>281.68700000000001</c:v>
                </c:pt>
                <c:pt idx="83">
                  <c:v>282.67899999999997</c:v>
                </c:pt>
                <c:pt idx="84">
                  <c:v>286.36399999999998</c:v>
                </c:pt>
                <c:pt idx="85">
                  <c:v>287.04599999999999</c:v>
                </c:pt>
                <c:pt idx="86">
                  <c:v>288.01299999999998</c:v>
                </c:pt>
                <c:pt idx="87">
                  <c:v>289.38600000000002</c:v>
                </c:pt>
                <c:pt idx="88">
                  <c:v>293.12400000000002</c:v>
                </c:pt>
                <c:pt idx="89">
                  <c:v>293.346</c:v>
                </c:pt>
                <c:pt idx="90">
                  <c:v>296.19499999999999</c:v>
                </c:pt>
                <c:pt idx="91">
                  <c:v>296.64100000000002</c:v>
                </c:pt>
                <c:pt idx="92">
                  <c:v>297.08699999999999</c:v>
                </c:pt>
                <c:pt idx="93">
                  <c:v>298.68</c:v>
                </c:pt>
                <c:pt idx="94">
                  <c:v>299.71699999999998</c:v>
                </c:pt>
                <c:pt idx="95">
                  <c:v>302.69200000000001</c:v>
                </c:pt>
                <c:pt idx="96">
                  <c:v>304.01400000000001</c:v>
                </c:pt>
                <c:pt idx="97">
                  <c:v>309.34699999999998</c:v>
                </c:pt>
                <c:pt idx="98">
                  <c:v>311.05799999999999</c:v>
                </c:pt>
                <c:pt idx="99">
                  <c:v>314.68099999999998</c:v>
                </c:pt>
                <c:pt idx="100">
                  <c:v>316.036</c:v>
                </c:pt>
                <c:pt idx="101">
                  <c:v>318.04300000000001</c:v>
                </c:pt>
                <c:pt idx="102">
                  <c:v>320.01400000000001</c:v>
                </c:pt>
                <c:pt idx="103">
                  <c:v>321.05700000000002</c:v>
                </c:pt>
                <c:pt idx="104">
                  <c:v>324.63900000000001</c:v>
                </c:pt>
                <c:pt idx="105">
                  <c:v>325.34800000000001</c:v>
                </c:pt>
                <c:pt idx="106">
                  <c:v>326.98899999999998</c:v>
                </c:pt>
                <c:pt idx="107">
                  <c:v>328.51</c:v>
                </c:pt>
                <c:pt idx="108">
                  <c:v>329.84899999999999</c:v>
                </c:pt>
                <c:pt idx="109">
                  <c:v>330.68099999999998</c:v>
                </c:pt>
                <c:pt idx="110">
                  <c:v>331.37900000000002</c:v>
                </c:pt>
                <c:pt idx="111">
                  <c:v>332.90800000000002</c:v>
                </c:pt>
                <c:pt idx="112">
                  <c:v>335.90699999999998</c:v>
                </c:pt>
                <c:pt idx="113">
                  <c:v>336.01499999999999</c:v>
                </c:pt>
                <c:pt idx="114">
                  <c:v>339.09899999999999</c:v>
                </c:pt>
                <c:pt idx="115">
                  <c:v>341.34899999999999</c:v>
                </c:pt>
                <c:pt idx="116">
                  <c:v>341.90499999999997</c:v>
                </c:pt>
                <c:pt idx="117">
                  <c:v>346.49</c:v>
                </c:pt>
                <c:pt idx="118">
                  <c:v>346.68200000000002</c:v>
                </c:pt>
                <c:pt idx="119">
                  <c:v>348.83100000000002</c:v>
                </c:pt>
                <c:pt idx="120">
                  <c:v>349.298</c:v>
                </c:pt>
                <c:pt idx="121">
                  <c:v>351.05399999999997</c:v>
                </c:pt>
                <c:pt idx="122">
                  <c:v>352.01600000000002</c:v>
                </c:pt>
                <c:pt idx="123">
                  <c:v>353.52499999999998</c:v>
                </c:pt>
                <c:pt idx="124">
                  <c:v>357.34899999999999</c:v>
                </c:pt>
                <c:pt idx="125">
                  <c:v>362.68299999999999</c:v>
                </c:pt>
                <c:pt idx="126">
                  <c:v>363.02699999999999</c:v>
                </c:pt>
                <c:pt idx="127">
                  <c:v>364.46</c:v>
                </c:pt>
                <c:pt idx="128">
                  <c:v>368.01600000000002</c:v>
                </c:pt>
                <c:pt idx="129">
                  <c:v>368.97199999999998</c:v>
                </c:pt>
                <c:pt idx="130">
                  <c:v>373.07900000000001</c:v>
                </c:pt>
                <c:pt idx="131">
                  <c:v>373.35</c:v>
                </c:pt>
                <c:pt idx="132">
                  <c:v>376.73099999999999</c:v>
                </c:pt>
                <c:pt idx="133">
                  <c:v>377.87700000000001</c:v>
                </c:pt>
                <c:pt idx="134">
                  <c:v>378.68400000000003</c:v>
                </c:pt>
                <c:pt idx="135">
                  <c:v>380.03300000000002</c:v>
                </c:pt>
                <c:pt idx="136">
                  <c:v>383.709</c:v>
                </c:pt>
                <c:pt idx="137">
                  <c:v>384.017</c:v>
                </c:pt>
                <c:pt idx="138">
                  <c:v>385.68200000000002</c:v>
                </c:pt>
                <c:pt idx="139">
                  <c:v>386.85</c:v>
                </c:pt>
                <c:pt idx="140">
                  <c:v>387.642</c:v>
                </c:pt>
                <c:pt idx="141">
                  <c:v>388.40600000000001</c:v>
                </c:pt>
                <c:pt idx="142">
                  <c:v>389.351</c:v>
                </c:pt>
                <c:pt idx="143">
                  <c:v>391.02300000000002</c:v>
                </c:pt>
                <c:pt idx="144">
                  <c:v>394.36399999999998</c:v>
                </c:pt>
                <c:pt idx="145">
                  <c:v>394.68400000000003</c:v>
                </c:pt>
                <c:pt idx="146">
                  <c:v>395.66699999999997</c:v>
                </c:pt>
                <c:pt idx="147">
                  <c:v>396.20299999999997</c:v>
                </c:pt>
                <c:pt idx="148">
                  <c:v>396.553</c:v>
                </c:pt>
                <c:pt idx="149">
                  <c:v>396.85599999999999</c:v>
                </c:pt>
                <c:pt idx="150">
                  <c:v>397.27800000000002</c:v>
                </c:pt>
                <c:pt idx="151">
                  <c:v>400.01799999999997</c:v>
                </c:pt>
                <c:pt idx="152">
                  <c:v>400.80799999999999</c:v>
                </c:pt>
                <c:pt idx="153">
                  <c:v>404.72</c:v>
                </c:pt>
                <c:pt idx="154">
                  <c:v>405.351</c:v>
                </c:pt>
                <c:pt idx="155">
                  <c:v>408.80500000000001</c:v>
                </c:pt>
                <c:pt idx="156">
                  <c:v>409.89699999999999</c:v>
                </c:pt>
                <c:pt idx="157">
                  <c:v>409.99799999999999</c:v>
                </c:pt>
                <c:pt idx="158">
                  <c:v>410.685</c:v>
                </c:pt>
                <c:pt idx="159">
                  <c:v>415.74599999999998</c:v>
                </c:pt>
                <c:pt idx="160">
                  <c:v>416.01900000000001</c:v>
                </c:pt>
                <c:pt idx="161">
                  <c:v>421.35199999999998</c:v>
                </c:pt>
                <c:pt idx="162">
                  <c:v>423.31900000000002</c:v>
                </c:pt>
                <c:pt idx="163">
                  <c:v>426.68599999999998</c:v>
                </c:pt>
                <c:pt idx="164">
                  <c:v>428.464</c:v>
                </c:pt>
                <c:pt idx="165">
                  <c:v>430.202</c:v>
                </c:pt>
                <c:pt idx="166">
                  <c:v>432.01900000000001</c:v>
                </c:pt>
                <c:pt idx="167">
                  <c:v>432.52100000000002</c:v>
                </c:pt>
                <c:pt idx="168">
                  <c:v>437.35300000000001</c:v>
                </c:pt>
                <c:pt idx="169">
                  <c:v>439.38400000000001</c:v>
                </c:pt>
                <c:pt idx="170">
                  <c:v>442.68599999999998</c:v>
                </c:pt>
                <c:pt idx="171">
                  <c:v>444.63099999999997</c:v>
                </c:pt>
                <c:pt idx="172">
                  <c:v>446.399</c:v>
                </c:pt>
                <c:pt idx="173">
                  <c:v>447.93299999999999</c:v>
                </c:pt>
                <c:pt idx="174">
                  <c:v>448.02</c:v>
                </c:pt>
                <c:pt idx="175">
                  <c:v>449.25900000000001</c:v>
                </c:pt>
                <c:pt idx="176">
                  <c:v>450.45400000000001</c:v>
                </c:pt>
                <c:pt idx="177">
                  <c:v>452.08199999999999</c:v>
                </c:pt>
                <c:pt idx="178">
                  <c:v>453.35300000000001</c:v>
                </c:pt>
                <c:pt idx="179">
                  <c:v>454.04399999999998</c:v>
                </c:pt>
                <c:pt idx="180">
                  <c:v>457.28899999999999</c:v>
                </c:pt>
                <c:pt idx="181">
                  <c:v>458.68700000000001</c:v>
                </c:pt>
                <c:pt idx="182">
                  <c:v>459.11700000000002</c:v>
                </c:pt>
                <c:pt idx="183">
                  <c:v>459.75599999999997</c:v>
                </c:pt>
                <c:pt idx="184">
                  <c:v>460.63200000000001</c:v>
                </c:pt>
                <c:pt idx="185">
                  <c:v>464.02100000000002</c:v>
                </c:pt>
                <c:pt idx="186">
                  <c:v>469.35399999999998</c:v>
                </c:pt>
                <c:pt idx="187">
                  <c:v>470.16</c:v>
                </c:pt>
                <c:pt idx="188">
                  <c:v>474.68799999999999</c:v>
                </c:pt>
                <c:pt idx="189">
                  <c:v>479.09699999999998</c:v>
                </c:pt>
                <c:pt idx="190">
                  <c:v>480.02100000000002</c:v>
                </c:pt>
                <c:pt idx="191">
                  <c:v>481.00099999999998</c:v>
                </c:pt>
                <c:pt idx="192">
                  <c:v>481.45800000000003</c:v>
                </c:pt>
                <c:pt idx="193">
                  <c:v>481.63400000000001</c:v>
                </c:pt>
                <c:pt idx="194">
                  <c:v>483.048</c:v>
                </c:pt>
                <c:pt idx="195">
                  <c:v>485.35500000000002</c:v>
                </c:pt>
                <c:pt idx="196">
                  <c:v>485.529</c:v>
                </c:pt>
                <c:pt idx="197">
                  <c:v>485.92700000000002</c:v>
                </c:pt>
                <c:pt idx="198">
                  <c:v>486.67700000000002</c:v>
                </c:pt>
                <c:pt idx="199">
                  <c:v>490.05900000000003</c:v>
                </c:pt>
                <c:pt idx="200">
                  <c:v>490.68799999999999</c:v>
                </c:pt>
                <c:pt idx="201">
                  <c:v>496.02199999999999</c:v>
                </c:pt>
                <c:pt idx="202">
                  <c:v>497.99900000000002</c:v>
                </c:pt>
                <c:pt idx="203">
                  <c:v>501.35599999999999</c:v>
                </c:pt>
                <c:pt idx="204">
                  <c:v>504.697</c:v>
                </c:pt>
                <c:pt idx="205">
                  <c:v>506.68900000000002</c:v>
                </c:pt>
                <c:pt idx="206">
                  <c:v>509.97</c:v>
                </c:pt>
                <c:pt idx="207">
                  <c:v>511.49400000000003</c:v>
                </c:pt>
                <c:pt idx="208">
                  <c:v>512.02300000000002</c:v>
                </c:pt>
                <c:pt idx="209">
                  <c:v>513.10299999999995</c:v>
                </c:pt>
                <c:pt idx="210">
                  <c:v>516.71699999999998</c:v>
                </c:pt>
                <c:pt idx="211">
                  <c:v>517.35599999999999</c:v>
                </c:pt>
                <c:pt idx="212">
                  <c:v>520.33100000000002</c:v>
                </c:pt>
                <c:pt idx="213">
                  <c:v>522.69000000000005</c:v>
                </c:pt>
                <c:pt idx="214">
                  <c:v>523.88099999999997</c:v>
                </c:pt>
                <c:pt idx="215">
                  <c:v>527.41600000000005</c:v>
                </c:pt>
                <c:pt idx="216">
                  <c:v>528.02300000000002</c:v>
                </c:pt>
                <c:pt idx="217">
                  <c:v>529.11599999999999</c:v>
                </c:pt>
                <c:pt idx="218">
                  <c:v>530.72</c:v>
                </c:pt>
                <c:pt idx="219">
                  <c:v>532.10799999999995</c:v>
                </c:pt>
                <c:pt idx="220">
                  <c:v>533.02800000000002</c:v>
                </c:pt>
                <c:pt idx="221">
                  <c:v>533.35699999999997</c:v>
                </c:pt>
                <c:pt idx="222">
                  <c:v>534.62900000000002</c:v>
                </c:pt>
                <c:pt idx="223">
                  <c:v>538.69100000000003</c:v>
                </c:pt>
                <c:pt idx="224">
                  <c:v>541.48199999999997</c:v>
                </c:pt>
                <c:pt idx="225">
                  <c:v>544.024</c:v>
                </c:pt>
                <c:pt idx="226">
                  <c:v>548.04600000000005</c:v>
                </c:pt>
                <c:pt idx="227">
                  <c:v>549.35799999999995</c:v>
                </c:pt>
                <c:pt idx="228">
                  <c:v>549.89099999999996</c:v>
                </c:pt>
                <c:pt idx="229">
                  <c:v>551.73599999999999</c:v>
                </c:pt>
                <c:pt idx="230">
                  <c:v>552.72299999999996</c:v>
                </c:pt>
                <c:pt idx="231">
                  <c:v>553.375</c:v>
                </c:pt>
                <c:pt idx="232">
                  <c:v>554.69100000000003</c:v>
                </c:pt>
                <c:pt idx="233">
                  <c:v>556.05600000000004</c:v>
                </c:pt>
                <c:pt idx="234">
                  <c:v>560.02499999999998</c:v>
                </c:pt>
                <c:pt idx="235">
                  <c:v>561.82600000000002</c:v>
                </c:pt>
                <c:pt idx="236">
                  <c:v>563.61599999999999</c:v>
                </c:pt>
                <c:pt idx="237">
                  <c:v>565.03399999999999</c:v>
                </c:pt>
                <c:pt idx="238">
                  <c:v>565.35799999999995</c:v>
                </c:pt>
                <c:pt idx="239">
                  <c:v>567.61</c:v>
                </c:pt>
                <c:pt idx="240">
                  <c:v>570.69200000000001</c:v>
                </c:pt>
                <c:pt idx="241">
                  <c:v>571.04399999999998</c:v>
                </c:pt>
                <c:pt idx="242">
                  <c:v>576.02599999999995</c:v>
                </c:pt>
                <c:pt idx="243">
                  <c:v>577.47400000000005</c:v>
                </c:pt>
                <c:pt idx="244">
                  <c:v>581.35900000000004</c:v>
                </c:pt>
                <c:pt idx="245">
                  <c:v>583.83299999999997</c:v>
                </c:pt>
                <c:pt idx="246">
                  <c:v>585.38800000000003</c:v>
                </c:pt>
                <c:pt idx="247">
                  <c:v>586.69299999999998</c:v>
                </c:pt>
                <c:pt idx="248">
                  <c:v>587.80999999999995</c:v>
                </c:pt>
                <c:pt idx="249">
                  <c:v>592.02599999999995</c:v>
                </c:pt>
                <c:pt idx="250">
                  <c:v>593.55799999999999</c:v>
                </c:pt>
                <c:pt idx="251">
                  <c:v>597.36</c:v>
                </c:pt>
                <c:pt idx="252">
                  <c:v>602.69299999999998</c:v>
                </c:pt>
                <c:pt idx="253">
                  <c:v>605.17700000000002</c:v>
                </c:pt>
                <c:pt idx="254">
                  <c:v>608.02700000000004</c:v>
                </c:pt>
                <c:pt idx="255">
                  <c:v>613.36099999999999</c:v>
                </c:pt>
                <c:pt idx="256">
                  <c:v>615.923</c:v>
                </c:pt>
                <c:pt idx="257">
                  <c:v>617.05899999999997</c:v>
                </c:pt>
                <c:pt idx="258">
                  <c:v>618.69399999999996</c:v>
                </c:pt>
                <c:pt idx="259">
                  <c:v>621.20299999999997</c:v>
                </c:pt>
                <c:pt idx="260">
                  <c:v>624.02800000000002</c:v>
                </c:pt>
                <c:pt idx="261">
                  <c:v>627.68799999999999</c:v>
                </c:pt>
                <c:pt idx="262">
                  <c:v>629.36099999999999</c:v>
                </c:pt>
                <c:pt idx="263">
                  <c:v>631.91600000000005</c:v>
                </c:pt>
                <c:pt idx="264">
                  <c:v>633.48900000000003</c:v>
                </c:pt>
                <c:pt idx="265">
                  <c:v>634.69500000000005</c:v>
                </c:pt>
                <c:pt idx="266">
                  <c:v>634.74099999999999</c:v>
                </c:pt>
                <c:pt idx="267">
                  <c:v>637.15899999999999</c:v>
                </c:pt>
                <c:pt idx="268">
                  <c:v>640.02800000000002</c:v>
                </c:pt>
                <c:pt idx="269">
                  <c:v>640.22500000000002</c:v>
                </c:pt>
                <c:pt idx="270">
                  <c:v>641.21299999999997</c:v>
                </c:pt>
                <c:pt idx="271">
                  <c:v>642.94299999999998</c:v>
                </c:pt>
                <c:pt idx="272">
                  <c:v>644.80399999999997</c:v>
                </c:pt>
                <c:pt idx="273">
                  <c:v>645.36199999999997</c:v>
                </c:pt>
                <c:pt idx="274">
                  <c:v>645.971</c:v>
                </c:pt>
                <c:pt idx="275">
                  <c:v>646.81100000000004</c:v>
                </c:pt>
                <c:pt idx="276">
                  <c:v>647.65200000000004</c:v>
                </c:pt>
                <c:pt idx="277">
                  <c:v>648.75300000000004</c:v>
                </c:pt>
                <c:pt idx="278">
                  <c:v>650.00599999999997</c:v>
                </c:pt>
                <c:pt idx="279">
                  <c:v>650.69600000000003</c:v>
                </c:pt>
                <c:pt idx="280">
                  <c:v>651.73199999999997</c:v>
                </c:pt>
                <c:pt idx="281">
                  <c:v>654.81700000000001</c:v>
                </c:pt>
                <c:pt idx="282">
                  <c:v>656.029</c:v>
                </c:pt>
                <c:pt idx="283">
                  <c:v>659.43299999999999</c:v>
                </c:pt>
                <c:pt idx="284">
                  <c:v>661.36300000000006</c:v>
                </c:pt>
                <c:pt idx="285">
                  <c:v>665.82799999999997</c:v>
                </c:pt>
                <c:pt idx="286">
                  <c:v>666.69600000000003</c:v>
                </c:pt>
                <c:pt idx="287">
                  <c:v>672.03</c:v>
                </c:pt>
                <c:pt idx="288">
                  <c:v>677.36300000000006</c:v>
                </c:pt>
                <c:pt idx="289">
                  <c:v>682.697</c:v>
                </c:pt>
                <c:pt idx="290">
                  <c:v>684.05899999999997</c:v>
                </c:pt>
                <c:pt idx="291">
                  <c:v>688.03099999999995</c:v>
                </c:pt>
                <c:pt idx="292">
                  <c:v>689.197</c:v>
                </c:pt>
                <c:pt idx="293">
                  <c:v>690.60799999999995</c:v>
                </c:pt>
                <c:pt idx="294">
                  <c:v>693.36400000000003</c:v>
                </c:pt>
                <c:pt idx="295">
                  <c:v>693.43499999999995</c:v>
                </c:pt>
                <c:pt idx="296">
                  <c:v>696.048</c:v>
                </c:pt>
                <c:pt idx="297">
                  <c:v>698.69799999999998</c:v>
                </c:pt>
                <c:pt idx="298">
                  <c:v>701.49900000000002</c:v>
                </c:pt>
                <c:pt idx="299">
                  <c:v>704.03099999999995</c:v>
                </c:pt>
                <c:pt idx="300">
                  <c:v>709.36500000000001</c:v>
                </c:pt>
                <c:pt idx="301">
                  <c:v>714.69799999999998</c:v>
                </c:pt>
                <c:pt idx="302">
                  <c:v>720.03200000000004</c:v>
                </c:pt>
                <c:pt idx="303">
                  <c:v>720.38</c:v>
                </c:pt>
                <c:pt idx="304">
                  <c:v>722.51199999999994</c:v>
                </c:pt>
                <c:pt idx="305">
                  <c:v>724.64300000000003</c:v>
                </c:pt>
                <c:pt idx="306">
                  <c:v>725.36599999999999</c:v>
                </c:pt>
                <c:pt idx="307">
                  <c:v>730.69899999999996</c:v>
                </c:pt>
                <c:pt idx="308">
                  <c:v>731.23699999999997</c:v>
                </c:pt>
                <c:pt idx="309">
                  <c:v>736.03300000000002</c:v>
                </c:pt>
                <c:pt idx="310">
                  <c:v>738.21699999999998</c:v>
                </c:pt>
                <c:pt idx="311">
                  <c:v>741</c:v>
                </c:pt>
                <c:pt idx="312">
                  <c:v>741.36599999999999</c:v>
                </c:pt>
                <c:pt idx="313">
                  <c:v>742.99300000000005</c:v>
                </c:pt>
                <c:pt idx="314">
                  <c:v>744.34299999999996</c:v>
                </c:pt>
                <c:pt idx="315">
                  <c:v>746.7</c:v>
                </c:pt>
                <c:pt idx="316">
                  <c:v>750.00199999999995</c:v>
                </c:pt>
                <c:pt idx="317">
                  <c:v>752.03300000000002</c:v>
                </c:pt>
                <c:pt idx="318">
                  <c:v>755.49800000000005</c:v>
                </c:pt>
                <c:pt idx="319">
                  <c:v>757.36699999999996</c:v>
                </c:pt>
                <c:pt idx="320">
                  <c:v>759.29300000000001</c:v>
                </c:pt>
                <c:pt idx="321">
                  <c:v>762.70100000000002</c:v>
                </c:pt>
                <c:pt idx="322">
                  <c:v>766.88300000000004</c:v>
                </c:pt>
                <c:pt idx="323">
                  <c:v>768.03399999999999</c:v>
                </c:pt>
                <c:pt idx="324">
                  <c:v>773.36800000000005</c:v>
                </c:pt>
                <c:pt idx="325">
                  <c:v>778.70100000000002</c:v>
                </c:pt>
                <c:pt idx="326">
                  <c:v>781.51199999999994</c:v>
                </c:pt>
                <c:pt idx="327">
                  <c:v>784.03499999999997</c:v>
                </c:pt>
                <c:pt idx="328">
                  <c:v>789.36800000000005</c:v>
                </c:pt>
                <c:pt idx="329">
                  <c:v>793.18</c:v>
                </c:pt>
                <c:pt idx="330">
                  <c:v>794.702</c:v>
                </c:pt>
                <c:pt idx="331">
                  <c:v>800.03599999999994</c:v>
                </c:pt>
                <c:pt idx="332">
                  <c:v>802.70299999999997</c:v>
                </c:pt>
                <c:pt idx="333">
                  <c:v>805.36900000000003</c:v>
                </c:pt>
                <c:pt idx="334">
                  <c:v>809.827</c:v>
                </c:pt>
                <c:pt idx="335">
                  <c:v>810.495</c:v>
                </c:pt>
                <c:pt idx="336">
                  <c:v>810.70299999999997</c:v>
                </c:pt>
                <c:pt idx="337">
                  <c:v>813.10199999999998</c:v>
                </c:pt>
                <c:pt idx="338">
                  <c:v>813.81</c:v>
                </c:pt>
                <c:pt idx="339">
                  <c:v>815.78399999999999</c:v>
                </c:pt>
                <c:pt idx="340">
                  <c:v>816.03599999999994</c:v>
                </c:pt>
                <c:pt idx="341">
                  <c:v>821.37</c:v>
                </c:pt>
                <c:pt idx="342">
                  <c:v>823.78</c:v>
                </c:pt>
                <c:pt idx="343">
                  <c:v>826.21100000000001</c:v>
                </c:pt>
                <c:pt idx="344">
                  <c:v>826.70299999999997</c:v>
                </c:pt>
                <c:pt idx="345">
                  <c:v>826.75400000000002</c:v>
                </c:pt>
                <c:pt idx="346">
                  <c:v>829.54100000000005</c:v>
                </c:pt>
                <c:pt idx="347">
                  <c:v>832.03700000000003</c:v>
                </c:pt>
                <c:pt idx="348">
                  <c:v>833.53099999999995</c:v>
                </c:pt>
                <c:pt idx="349">
                  <c:v>837.37099999999998</c:v>
                </c:pt>
                <c:pt idx="350">
                  <c:v>842.70399999999995</c:v>
                </c:pt>
                <c:pt idx="351">
                  <c:v>848.03800000000001</c:v>
                </c:pt>
                <c:pt idx="352">
                  <c:v>853.37099999999998</c:v>
                </c:pt>
                <c:pt idx="353">
                  <c:v>858.70500000000004</c:v>
                </c:pt>
                <c:pt idx="354">
                  <c:v>864.03800000000001</c:v>
                </c:pt>
                <c:pt idx="355">
                  <c:v>869.37199999999996</c:v>
                </c:pt>
                <c:pt idx="356">
                  <c:v>874.70600000000002</c:v>
                </c:pt>
                <c:pt idx="357">
                  <c:v>880.03899999999999</c:v>
                </c:pt>
                <c:pt idx="358">
                  <c:v>880.96299999999997</c:v>
                </c:pt>
                <c:pt idx="359">
                  <c:v>885.37300000000005</c:v>
                </c:pt>
                <c:pt idx="360">
                  <c:v>890.70600000000002</c:v>
                </c:pt>
                <c:pt idx="361">
                  <c:v>896.04</c:v>
                </c:pt>
                <c:pt idx="362">
                  <c:v>901.37300000000005</c:v>
                </c:pt>
                <c:pt idx="363">
                  <c:v>906.70699999999999</c:v>
                </c:pt>
                <c:pt idx="364">
                  <c:v>912.04100000000005</c:v>
                </c:pt>
                <c:pt idx="365">
                  <c:v>913.66099999999994</c:v>
                </c:pt>
                <c:pt idx="366">
                  <c:v>917.37400000000002</c:v>
                </c:pt>
                <c:pt idx="367">
                  <c:v>921.56700000000001</c:v>
                </c:pt>
                <c:pt idx="368">
                  <c:v>922.70799999999997</c:v>
                </c:pt>
                <c:pt idx="369">
                  <c:v>927.39099999999996</c:v>
                </c:pt>
                <c:pt idx="370">
                  <c:v>928.04100000000005</c:v>
                </c:pt>
                <c:pt idx="371">
                  <c:v>932.596</c:v>
                </c:pt>
                <c:pt idx="372">
                  <c:v>933.375</c:v>
                </c:pt>
                <c:pt idx="373">
                  <c:v>938.70799999999997</c:v>
                </c:pt>
                <c:pt idx="374">
                  <c:v>939.58900000000006</c:v>
                </c:pt>
                <c:pt idx="375">
                  <c:v>944.04200000000003</c:v>
                </c:pt>
                <c:pt idx="376">
                  <c:v>945.09500000000003</c:v>
                </c:pt>
                <c:pt idx="377">
                  <c:v>949.37599999999998</c:v>
                </c:pt>
                <c:pt idx="378">
                  <c:v>954.70899999999995</c:v>
                </c:pt>
                <c:pt idx="379">
                  <c:v>960.04300000000001</c:v>
                </c:pt>
                <c:pt idx="380">
                  <c:v>965.37599999999998</c:v>
                </c:pt>
                <c:pt idx="381">
                  <c:v>970.71</c:v>
                </c:pt>
                <c:pt idx="382">
                  <c:v>976.04300000000001</c:v>
                </c:pt>
                <c:pt idx="383">
                  <c:v>980.91</c:v>
                </c:pt>
                <c:pt idx="384">
                  <c:v>981.37699999999995</c:v>
                </c:pt>
                <c:pt idx="385">
                  <c:v>986.71100000000001</c:v>
                </c:pt>
                <c:pt idx="386">
                  <c:v>992.04399999999998</c:v>
                </c:pt>
                <c:pt idx="387">
                  <c:v>997.37800000000004</c:v>
                </c:pt>
                <c:pt idx="388">
                  <c:v>1002.711</c:v>
                </c:pt>
                <c:pt idx="389">
                  <c:v>1008.045</c:v>
                </c:pt>
                <c:pt idx="390">
                  <c:v>1013.378</c:v>
                </c:pt>
                <c:pt idx="391">
                  <c:v>1018.712</c:v>
                </c:pt>
                <c:pt idx="392">
                  <c:v>1024.046</c:v>
                </c:pt>
                <c:pt idx="393">
                  <c:v>1029.3789999999999</c:v>
                </c:pt>
                <c:pt idx="394">
                  <c:v>1034.713</c:v>
                </c:pt>
                <c:pt idx="395">
                  <c:v>1040.046</c:v>
                </c:pt>
                <c:pt idx="396">
                  <c:v>1045.3800000000001</c:v>
                </c:pt>
                <c:pt idx="397">
                  <c:v>1050.713</c:v>
                </c:pt>
                <c:pt idx="398">
                  <c:v>1056.047</c:v>
                </c:pt>
                <c:pt idx="399">
                  <c:v>1061.3810000000001</c:v>
                </c:pt>
                <c:pt idx="400">
                  <c:v>1066.7139999999999</c:v>
                </c:pt>
                <c:pt idx="401">
                  <c:v>1066.7139999999999</c:v>
                </c:pt>
              </c:numCache>
            </c:numRef>
          </c:xVal>
          <c:yVal>
            <c:numRef>
              <c:f>Foglio6!$H$819:$H$1220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99.927999999999997</c:v>
                </c:pt>
                <c:pt idx="25">
                  <c:v>99.888000000000005</c:v>
                </c:pt>
                <c:pt idx="26">
                  <c:v>99.861000000000004</c:v>
                </c:pt>
                <c:pt idx="27">
                  <c:v>99.832999999999998</c:v>
                </c:pt>
                <c:pt idx="28">
                  <c:v>99.801000000000002</c:v>
                </c:pt>
                <c:pt idx="29">
                  <c:v>99.771000000000001</c:v>
                </c:pt>
                <c:pt idx="30">
                  <c:v>99.742999999999995</c:v>
                </c:pt>
                <c:pt idx="31">
                  <c:v>99.634</c:v>
                </c:pt>
                <c:pt idx="32">
                  <c:v>99.5</c:v>
                </c:pt>
                <c:pt idx="33">
                  <c:v>99.334999999999994</c:v>
                </c:pt>
                <c:pt idx="34">
                  <c:v>99.106999999999999</c:v>
                </c:pt>
                <c:pt idx="35">
                  <c:v>99</c:v>
                </c:pt>
                <c:pt idx="36">
                  <c:v>98.807000000000002</c:v>
                </c:pt>
                <c:pt idx="37">
                  <c:v>98.573999999999998</c:v>
                </c:pt>
                <c:pt idx="38">
                  <c:v>98.5</c:v>
                </c:pt>
                <c:pt idx="39">
                  <c:v>98.387</c:v>
                </c:pt>
                <c:pt idx="40">
                  <c:v>98.247</c:v>
                </c:pt>
                <c:pt idx="41">
                  <c:v>98.105999999999995</c:v>
                </c:pt>
                <c:pt idx="42">
                  <c:v>98</c:v>
                </c:pt>
                <c:pt idx="43">
                  <c:v>97.617000000000004</c:v>
                </c:pt>
                <c:pt idx="44">
                  <c:v>97.5</c:v>
                </c:pt>
                <c:pt idx="45">
                  <c:v>97</c:v>
                </c:pt>
                <c:pt idx="46">
                  <c:v>96.584999999999994</c:v>
                </c:pt>
                <c:pt idx="47">
                  <c:v>96.5</c:v>
                </c:pt>
                <c:pt idx="48">
                  <c:v>96</c:v>
                </c:pt>
                <c:pt idx="49">
                  <c:v>95.5</c:v>
                </c:pt>
                <c:pt idx="50">
                  <c:v>95</c:v>
                </c:pt>
                <c:pt idx="51">
                  <c:v>94.911000000000001</c:v>
                </c:pt>
                <c:pt idx="52">
                  <c:v>94.5</c:v>
                </c:pt>
                <c:pt idx="53">
                  <c:v>94.295000000000002</c:v>
                </c:pt>
                <c:pt idx="54">
                  <c:v>94</c:v>
                </c:pt>
                <c:pt idx="55">
                  <c:v>93.784000000000006</c:v>
                </c:pt>
                <c:pt idx="56">
                  <c:v>93.5</c:v>
                </c:pt>
                <c:pt idx="57">
                  <c:v>93.052000000000007</c:v>
                </c:pt>
                <c:pt idx="58">
                  <c:v>93.004999999999995</c:v>
                </c:pt>
                <c:pt idx="59">
                  <c:v>93</c:v>
                </c:pt>
                <c:pt idx="60">
                  <c:v>92.655000000000001</c:v>
                </c:pt>
                <c:pt idx="61">
                  <c:v>92.5</c:v>
                </c:pt>
                <c:pt idx="62">
                  <c:v>92</c:v>
                </c:pt>
                <c:pt idx="63">
                  <c:v>91.804000000000002</c:v>
                </c:pt>
                <c:pt idx="64">
                  <c:v>91.590999999999994</c:v>
                </c:pt>
                <c:pt idx="65">
                  <c:v>91.5</c:v>
                </c:pt>
                <c:pt idx="66">
                  <c:v>91</c:v>
                </c:pt>
                <c:pt idx="67">
                  <c:v>90.527000000000001</c:v>
                </c:pt>
                <c:pt idx="68">
                  <c:v>90.5</c:v>
                </c:pt>
                <c:pt idx="69">
                  <c:v>90</c:v>
                </c:pt>
                <c:pt idx="70">
                  <c:v>89.5</c:v>
                </c:pt>
                <c:pt idx="71">
                  <c:v>89.072000000000003</c:v>
                </c:pt>
                <c:pt idx="72">
                  <c:v>89</c:v>
                </c:pt>
                <c:pt idx="73">
                  <c:v>88.733000000000004</c:v>
                </c:pt>
                <c:pt idx="74">
                  <c:v>88.5</c:v>
                </c:pt>
                <c:pt idx="75">
                  <c:v>88.459000000000003</c:v>
                </c:pt>
                <c:pt idx="76">
                  <c:v>88</c:v>
                </c:pt>
                <c:pt idx="77">
                  <c:v>87.5</c:v>
                </c:pt>
                <c:pt idx="78">
                  <c:v>87</c:v>
                </c:pt>
                <c:pt idx="79">
                  <c:v>86.5</c:v>
                </c:pt>
                <c:pt idx="80">
                  <c:v>86.299000000000007</c:v>
                </c:pt>
                <c:pt idx="81">
                  <c:v>86</c:v>
                </c:pt>
                <c:pt idx="82">
                  <c:v>85.5</c:v>
                </c:pt>
                <c:pt idx="83">
                  <c:v>85.41</c:v>
                </c:pt>
                <c:pt idx="84">
                  <c:v>85</c:v>
                </c:pt>
                <c:pt idx="85">
                  <c:v>84.5</c:v>
                </c:pt>
                <c:pt idx="86">
                  <c:v>84.183999999999997</c:v>
                </c:pt>
                <c:pt idx="87">
                  <c:v>84</c:v>
                </c:pt>
                <c:pt idx="88">
                  <c:v>83.5</c:v>
                </c:pt>
                <c:pt idx="89">
                  <c:v>83.47</c:v>
                </c:pt>
                <c:pt idx="90">
                  <c:v>83</c:v>
                </c:pt>
                <c:pt idx="91">
                  <c:v>82.5</c:v>
                </c:pt>
                <c:pt idx="92">
                  <c:v>82</c:v>
                </c:pt>
                <c:pt idx="93">
                  <c:v>81.674000000000007</c:v>
                </c:pt>
                <c:pt idx="94">
                  <c:v>81.5</c:v>
                </c:pt>
                <c:pt idx="95">
                  <c:v>81</c:v>
                </c:pt>
                <c:pt idx="96">
                  <c:v>80.915999999999997</c:v>
                </c:pt>
                <c:pt idx="97">
                  <c:v>80.600999999999999</c:v>
                </c:pt>
                <c:pt idx="98">
                  <c:v>80.5</c:v>
                </c:pt>
                <c:pt idx="99">
                  <c:v>80.286000000000001</c:v>
                </c:pt>
                <c:pt idx="100">
                  <c:v>80</c:v>
                </c:pt>
                <c:pt idx="101">
                  <c:v>79.5</c:v>
                </c:pt>
                <c:pt idx="102">
                  <c:v>79.146000000000001</c:v>
                </c:pt>
                <c:pt idx="103">
                  <c:v>79</c:v>
                </c:pt>
                <c:pt idx="104">
                  <c:v>78.5</c:v>
                </c:pt>
                <c:pt idx="105">
                  <c:v>78.400999999999996</c:v>
                </c:pt>
                <c:pt idx="106">
                  <c:v>78</c:v>
                </c:pt>
                <c:pt idx="107">
                  <c:v>77.5</c:v>
                </c:pt>
                <c:pt idx="108">
                  <c:v>77</c:v>
                </c:pt>
                <c:pt idx="109">
                  <c:v>76.727999999999994</c:v>
                </c:pt>
                <c:pt idx="110">
                  <c:v>76.5</c:v>
                </c:pt>
                <c:pt idx="111">
                  <c:v>76</c:v>
                </c:pt>
                <c:pt idx="112">
                  <c:v>75.5</c:v>
                </c:pt>
                <c:pt idx="113">
                  <c:v>75.483000000000004</c:v>
                </c:pt>
                <c:pt idx="114">
                  <c:v>75</c:v>
                </c:pt>
                <c:pt idx="115">
                  <c:v>74.608000000000004</c:v>
                </c:pt>
                <c:pt idx="116">
                  <c:v>74.5</c:v>
                </c:pt>
                <c:pt idx="117">
                  <c:v>74</c:v>
                </c:pt>
                <c:pt idx="118">
                  <c:v>73.986000000000004</c:v>
                </c:pt>
                <c:pt idx="119">
                  <c:v>73.5</c:v>
                </c:pt>
                <c:pt idx="120">
                  <c:v>73</c:v>
                </c:pt>
                <c:pt idx="121">
                  <c:v>72.5</c:v>
                </c:pt>
                <c:pt idx="122">
                  <c:v>72.266000000000005</c:v>
                </c:pt>
                <c:pt idx="123">
                  <c:v>72</c:v>
                </c:pt>
                <c:pt idx="124">
                  <c:v>71.799000000000007</c:v>
                </c:pt>
                <c:pt idx="125">
                  <c:v>71.518000000000001</c:v>
                </c:pt>
                <c:pt idx="126">
                  <c:v>71.5</c:v>
                </c:pt>
                <c:pt idx="127">
                  <c:v>71</c:v>
                </c:pt>
                <c:pt idx="128">
                  <c:v>70.605999999999995</c:v>
                </c:pt>
                <c:pt idx="129">
                  <c:v>70.5</c:v>
                </c:pt>
                <c:pt idx="130">
                  <c:v>70</c:v>
                </c:pt>
                <c:pt idx="131">
                  <c:v>69.962999999999994</c:v>
                </c:pt>
                <c:pt idx="132">
                  <c:v>69.5</c:v>
                </c:pt>
                <c:pt idx="133">
                  <c:v>69</c:v>
                </c:pt>
                <c:pt idx="134">
                  <c:v>68.683000000000007</c:v>
                </c:pt>
                <c:pt idx="135">
                  <c:v>68.5</c:v>
                </c:pt>
                <c:pt idx="136">
                  <c:v>68</c:v>
                </c:pt>
                <c:pt idx="137">
                  <c:v>67.957999999999998</c:v>
                </c:pt>
                <c:pt idx="138">
                  <c:v>67.5</c:v>
                </c:pt>
                <c:pt idx="139">
                  <c:v>67</c:v>
                </c:pt>
                <c:pt idx="140">
                  <c:v>66.5</c:v>
                </c:pt>
                <c:pt idx="141">
                  <c:v>66</c:v>
                </c:pt>
                <c:pt idx="142">
                  <c:v>65.75</c:v>
                </c:pt>
                <c:pt idx="143">
                  <c:v>65.5</c:v>
                </c:pt>
                <c:pt idx="144">
                  <c:v>65</c:v>
                </c:pt>
                <c:pt idx="145">
                  <c:v>64.951999999999998</c:v>
                </c:pt>
                <c:pt idx="146">
                  <c:v>64.5</c:v>
                </c:pt>
                <c:pt idx="147">
                  <c:v>64</c:v>
                </c:pt>
                <c:pt idx="148">
                  <c:v>63.5</c:v>
                </c:pt>
                <c:pt idx="149">
                  <c:v>63</c:v>
                </c:pt>
                <c:pt idx="150">
                  <c:v>62.5</c:v>
                </c:pt>
                <c:pt idx="151">
                  <c:v>62.109000000000002</c:v>
                </c:pt>
                <c:pt idx="152">
                  <c:v>62</c:v>
                </c:pt>
                <c:pt idx="153">
                  <c:v>61.5</c:v>
                </c:pt>
                <c:pt idx="154">
                  <c:v>61.423000000000002</c:v>
                </c:pt>
                <c:pt idx="155">
                  <c:v>61</c:v>
                </c:pt>
                <c:pt idx="156">
                  <c:v>60.5</c:v>
                </c:pt>
                <c:pt idx="157">
                  <c:v>60</c:v>
                </c:pt>
                <c:pt idx="158">
                  <c:v>59.834000000000003</c:v>
                </c:pt>
                <c:pt idx="159">
                  <c:v>59.5</c:v>
                </c:pt>
                <c:pt idx="160">
                  <c:v>59.481999999999999</c:v>
                </c:pt>
                <c:pt idx="161">
                  <c:v>59.13</c:v>
                </c:pt>
                <c:pt idx="162">
                  <c:v>59</c:v>
                </c:pt>
                <c:pt idx="163">
                  <c:v>58.777999999999999</c:v>
                </c:pt>
                <c:pt idx="164">
                  <c:v>58.5</c:v>
                </c:pt>
                <c:pt idx="165">
                  <c:v>58</c:v>
                </c:pt>
                <c:pt idx="166">
                  <c:v>57.554000000000002</c:v>
                </c:pt>
                <c:pt idx="167">
                  <c:v>57.5</c:v>
                </c:pt>
                <c:pt idx="168">
                  <c:v>57.027999999999999</c:v>
                </c:pt>
                <c:pt idx="169">
                  <c:v>57</c:v>
                </c:pt>
                <c:pt idx="170">
                  <c:v>56.935000000000002</c:v>
                </c:pt>
                <c:pt idx="171">
                  <c:v>56.5</c:v>
                </c:pt>
                <c:pt idx="172">
                  <c:v>56</c:v>
                </c:pt>
                <c:pt idx="173">
                  <c:v>55.5</c:v>
                </c:pt>
                <c:pt idx="174">
                  <c:v>55.472000000000001</c:v>
                </c:pt>
                <c:pt idx="175">
                  <c:v>55</c:v>
                </c:pt>
                <c:pt idx="176">
                  <c:v>54.5</c:v>
                </c:pt>
                <c:pt idx="177">
                  <c:v>54</c:v>
                </c:pt>
                <c:pt idx="178">
                  <c:v>53.676000000000002</c:v>
                </c:pt>
                <c:pt idx="179">
                  <c:v>53.5</c:v>
                </c:pt>
                <c:pt idx="180">
                  <c:v>53</c:v>
                </c:pt>
                <c:pt idx="181">
                  <c:v>52.78</c:v>
                </c:pt>
                <c:pt idx="182">
                  <c:v>52.5</c:v>
                </c:pt>
                <c:pt idx="183">
                  <c:v>52</c:v>
                </c:pt>
                <c:pt idx="184">
                  <c:v>51.5</c:v>
                </c:pt>
                <c:pt idx="185">
                  <c:v>51.322000000000003</c:v>
                </c:pt>
                <c:pt idx="186">
                  <c:v>51.042000000000002</c:v>
                </c:pt>
                <c:pt idx="187">
                  <c:v>51</c:v>
                </c:pt>
                <c:pt idx="188">
                  <c:v>50.683</c:v>
                </c:pt>
                <c:pt idx="189">
                  <c:v>50.5</c:v>
                </c:pt>
                <c:pt idx="190">
                  <c:v>50.462000000000003</c:v>
                </c:pt>
                <c:pt idx="191">
                  <c:v>50</c:v>
                </c:pt>
                <c:pt idx="192">
                  <c:v>49.5</c:v>
                </c:pt>
                <c:pt idx="193">
                  <c:v>49</c:v>
                </c:pt>
                <c:pt idx="194">
                  <c:v>48.5</c:v>
                </c:pt>
                <c:pt idx="195">
                  <c:v>48.034999999999997</c:v>
                </c:pt>
                <c:pt idx="196">
                  <c:v>48</c:v>
                </c:pt>
                <c:pt idx="197">
                  <c:v>47.5</c:v>
                </c:pt>
                <c:pt idx="198">
                  <c:v>47</c:v>
                </c:pt>
                <c:pt idx="199">
                  <c:v>46.5</c:v>
                </c:pt>
                <c:pt idx="200">
                  <c:v>46.463000000000001</c:v>
                </c:pt>
                <c:pt idx="201">
                  <c:v>46.146000000000001</c:v>
                </c:pt>
                <c:pt idx="202">
                  <c:v>46</c:v>
                </c:pt>
                <c:pt idx="203">
                  <c:v>45.750999999999998</c:v>
                </c:pt>
                <c:pt idx="204">
                  <c:v>45.5</c:v>
                </c:pt>
                <c:pt idx="205">
                  <c:v>45.35</c:v>
                </c:pt>
                <c:pt idx="206">
                  <c:v>45</c:v>
                </c:pt>
                <c:pt idx="207">
                  <c:v>44.5</c:v>
                </c:pt>
                <c:pt idx="208">
                  <c:v>44.326000000000001</c:v>
                </c:pt>
                <c:pt idx="209">
                  <c:v>44</c:v>
                </c:pt>
                <c:pt idx="210">
                  <c:v>43.5</c:v>
                </c:pt>
                <c:pt idx="211">
                  <c:v>43.411999999999999</c:v>
                </c:pt>
                <c:pt idx="212">
                  <c:v>43</c:v>
                </c:pt>
                <c:pt idx="213">
                  <c:v>42.667999999999999</c:v>
                </c:pt>
                <c:pt idx="214">
                  <c:v>42.5</c:v>
                </c:pt>
                <c:pt idx="215">
                  <c:v>42</c:v>
                </c:pt>
                <c:pt idx="216">
                  <c:v>41.835000000000001</c:v>
                </c:pt>
                <c:pt idx="217">
                  <c:v>41.5</c:v>
                </c:pt>
                <c:pt idx="218">
                  <c:v>41</c:v>
                </c:pt>
                <c:pt idx="219">
                  <c:v>40.5</c:v>
                </c:pt>
                <c:pt idx="220">
                  <c:v>40</c:v>
                </c:pt>
                <c:pt idx="221">
                  <c:v>39.674999999999997</c:v>
                </c:pt>
                <c:pt idx="222">
                  <c:v>39.5</c:v>
                </c:pt>
                <c:pt idx="223">
                  <c:v>39.204000000000001</c:v>
                </c:pt>
                <c:pt idx="224">
                  <c:v>39</c:v>
                </c:pt>
                <c:pt idx="225">
                  <c:v>38.814999999999998</c:v>
                </c:pt>
                <c:pt idx="226">
                  <c:v>38.5</c:v>
                </c:pt>
                <c:pt idx="227">
                  <c:v>38.143999999999998</c:v>
                </c:pt>
                <c:pt idx="228">
                  <c:v>38</c:v>
                </c:pt>
                <c:pt idx="229">
                  <c:v>37.5</c:v>
                </c:pt>
                <c:pt idx="230">
                  <c:v>37</c:v>
                </c:pt>
                <c:pt idx="231">
                  <c:v>36.5</c:v>
                </c:pt>
                <c:pt idx="232">
                  <c:v>36.195999999999998</c:v>
                </c:pt>
                <c:pt idx="233">
                  <c:v>36</c:v>
                </c:pt>
                <c:pt idx="234">
                  <c:v>35.741999999999997</c:v>
                </c:pt>
                <c:pt idx="235">
                  <c:v>35.5</c:v>
                </c:pt>
                <c:pt idx="236">
                  <c:v>35</c:v>
                </c:pt>
                <c:pt idx="237">
                  <c:v>34.5</c:v>
                </c:pt>
                <c:pt idx="238">
                  <c:v>34.436999999999998</c:v>
                </c:pt>
                <c:pt idx="239">
                  <c:v>34</c:v>
                </c:pt>
                <c:pt idx="240">
                  <c:v>33.527000000000001</c:v>
                </c:pt>
                <c:pt idx="241">
                  <c:v>33.5</c:v>
                </c:pt>
                <c:pt idx="242">
                  <c:v>33.113</c:v>
                </c:pt>
                <c:pt idx="243">
                  <c:v>33</c:v>
                </c:pt>
                <c:pt idx="244">
                  <c:v>32.698</c:v>
                </c:pt>
                <c:pt idx="245">
                  <c:v>32.5</c:v>
                </c:pt>
                <c:pt idx="246">
                  <c:v>32</c:v>
                </c:pt>
                <c:pt idx="247">
                  <c:v>31.652999999999999</c:v>
                </c:pt>
                <c:pt idx="248">
                  <c:v>31.5</c:v>
                </c:pt>
                <c:pt idx="249">
                  <c:v>31.094000000000001</c:v>
                </c:pt>
                <c:pt idx="250">
                  <c:v>31</c:v>
                </c:pt>
                <c:pt idx="251">
                  <c:v>30.768000000000001</c:v>
                </c:pt>
                <c:pt idx="252">
                  <c:v>30.582000000000001</c:v>
                </c:pt>
                <c:pt idx="253">
                  <c:v>30.5</c:v>
                </c:pt>
                <c:pt idx="254">
                  <c:v>30.405999999999999</c:v>
                </c:pt>
                <c:pt idx="255">
                  <c:v>30.231000000000002</c:v>
                </c:pt>
                <c:pt idx="256">
                  <c:v>30</c:v>
                </c:pt>
                <c:pt idx="257">
                  <c:v>29.5</c:v>
                </c:pt>
                <c:pt idx="258">
                  <c:v>29.193000000000001</c:v>
                </c:pt>
                <c:pt idx="259">
                  <c:v>29</c:v>
                </c:pt>
                <c:pt idx="260">
                  <c:v>28.782</c:v>
                </c:pt>
                <c:pt idx="261">
                  <c:v>28.5</c:v>
                </c:pt>
                <c:pt idx="262">
                  <c:v>28.370999999999999</c:v>
                </c:pt>
                <c:pt idx="263">
                  <c:v>28</c:v>
                </c:pt>
                <c:pt idx="264">
                  <c:v>27.5</c:v>
                </c:pt>
                <c:pt idx="265">
                  <c:v>27.033999999999999</c:v>
                </c:pt>
                <c:pt idx="266">
                  <c:v>27</c:v>
                </c:pt>
                <c:pt idx="267">
                  <c:v>26.5</c:v>
                </c:pt>
                <c:pt idx="268">
                  <c:v>26.099</c:v>
                </c:pt>
                <c:pt idx="269">
                  <c:v>26</c:v>
                </c:pt>
                <c:pt idx="270">
                  <c:v>25.5</c:v>
                </c:pt>
                <c:pt idx="271">
                  <c:v>25</c:v>
                </c:pt>
                <c:pt idx="272">
                  <c:v>24.5</c:v>
                </c:pt>
                <c:pt idx="273">
                  <c:v>24.263000000000002</c:v>
                </c:pt>
                <c:pt idx="274">
                  <c:v>24</c:v>
                </c:pt>
                <c:pt idx="275">
                  <c:v>23.5</c:v>
                </c:pt>
                <c:pt idx="276">
                  <c:v>23</c:v>
                </c:pt>
                <c:pt idx="277">
                  <c:v>22.5</c:v>
                </c:pt>
                <c:pt idx="278">
                  <c:v>22</c:v>
                </c:pt>
                <c:pt idx="279">
                  <c:v>21.8</c:v>
                </c:pt>
                <c:pt idx="280">
                  <c:v>21.5</c:v>
                </c:pt>
                <c:pt idx="281">
                  <c:v>21</c:v>
                </c:pt>
                <c:pt idx="282">
                  <c:v>20.869</c:v>
                </c:pt>
                <c:pt idx="283">
                  <c:v>20.5</c:v>
                </c:pt>
                <c:pt idx="284">
                  <c:v>20.291</c:v>
                </c:pt>
                <c:pt idx="285">
                  <c:v>20</c:v>
                </c:pt>
                <c:pt idx="286">
                  <c:v>19.975999999999999</c:v>
                </c:pt>
                <c:pt idx="287">
                  <c:v>19.829999999999998</c:v>
                </c:pt>
                <c:pt idx="288">
                  <c:v>19.684000000000001</c:v>
                </c:pt>
                <c:pt idx="289">
                  <c:v>19.536999999999999</c:v>
                </c:pt>
                <c:pt idx="290">
                  <c:v>19.5</c:v>
                </c:pt>
                <c:pt idx="291">
                  <c:v>19.390999999999998</c:v>
                </c:pt>
                <c:pt idx="292">
                  <c:v>19</c:v>
                </c:pt>
                <c:pt idx="293">
                  <c:v>18.5</c:v>
                </c:pt>
                <c:pt idx="294">
                  <c:v>18.013000000000002</c:v>
                </c:pt>
                <c:pt idx="295">
                  <c:v>18</c:v>
                </c:pt>
                <c:pt idx="296">
                  <c:v>17.5</c:v>
                </c:pt>
                <c:pt idx="297">
                  <c:v>17.074000000000002</c:v>
                </c:pt>
                <c:pt idx="298">
                  <c:v>17</c:v>
                </c:pt>
                <c:pt idx="299">
                  <c:v>16.934000000000001</c:v>
                </c:pt>
                <c:pt idx="300">
                  <c:v>16.792999999999999</c:v>
                </c:pt>
                <c:pt idx="301">
                  <c:v>16.652999999999999</c:v>
                </c:pt>
                <c:pt idx="302">
                  <c:v>16.513000000000002</c:v>
                </c:pt>
                <c:pt idx="303">
                  <c:v>16.5</c:v>
                </c:pt>
                <c:pt idx="304">
                  <c:v>16</c:v>
                </c:pt>
                <c:pt idx="305">
                  <c:v>15.5</c:v>
                </c:pt>
                <c:pt idx="306">
                  <c:v>15.382</c:v>
                </c:pt>
                <c:pt idx="307">
                  <c:v>15.035</c:v>
                </c:pt>
                <c:pt idx="308">
                  <c:v>15</c:v>
                </c:pt>
                <c:pt idx="309">
                  <c:v>14.688000000000001</c:v>
                </c:pt>
                <c:pt idx="310">
                  <c:v>14.5</c:v>
                </c:pt>
                <c:pt idx="311">
                  <c:v>14</c:v>
                </c:pt>
                <c:pt idx="312">
                  <c:v>13.933999999999999</c:v>
                </c:pt>
                <c:pt idx="313">
                  <c:v>13.5</c:v>
                </c:pt>
                <c:pt idx="314">
                  <c:v>13</c:v>
                </c:pt>
                <c:pt idx="315">
                  <c:v>12.744999999999999</c:v>
                </c:pt>
                <c:pt idx="316">
                  <c:v>12.5</c:v>
                </c:pt>
                <c:pt idx="317">
                  <c:v>12.349</c:v>
                </c:pt>
                <c:pt idx="318">
                  <c:v>12</c:v>
                </c:pt>
                <c:pt idx="319">
                  <c:v>11.754</c:v>
                </c:pt>
                <c:pt idx="320">
                  <c:v>11.5</c:v>
                </c:pt>
                <c:pt idx="321">
                  <c:v>11.237</c:v>
                </c:pt>
                <c:pt idx="322">
                  <c:v>11</c:v>
                </c:pt>
                <c:pt idx="323">
                  <c:v>10.961</c:v>
                </c:pt>
                <c:pt idx="324">
                  <c:v>10.778</c:v>
                </c:pt>
                <c:pt idx="325">
                  <c:v>10.596</c:v>
                </c:pt>
                <c:pt idx="326">
                  <c:v>10.5</c:v>
                </c:pt>
                <c:pt idx="327">
                  <c:v>10.414</c:v>
                </c:pt>
                <c:pt idx="328">
                  <c:v>10.199999999999999</c:v>
                </c:pt>
                <c:pt idx="329">
                  <c:v>10</c:v>
                </c:pt>
                <c:pt idx="330">
                  <c:v>9.92</c:v>
                </c:pt>
                <c:pt idx="331">
                  <c:v>9.64</c:v>
                </c:pt>
                <c:pt idx="332">
                  <c:v>9.5</c:v>
                </c:pt>
                <c:pt idx="333">
                  <c:v>9.36</c:v>
                </c:pt>
                <c:pt idx="334">
                  <c:v>9</c:v>
                </c:pt>
                <c:pt idx="335">
                  <c:v>8.5</c:v>
                </c:pt>
                <c:pt idx="336">
                  <c:v>8.41</c:v>
                </c:pt>
                <c:pt idx="337">
                  <c:v>8</c:v>
                </c:pt>
                <c:pt idx="338">
                  <c:v>7.5</c:v>
                </c:pt>
                <c:pt idx="339">
                  <c:v>7</c:v>
                </c:pt>
                <c:pt idx="340">
                  <c:v>6.9850000000000003</c:v>
                </c:pt>
                <c:pt idx="341">
                  <c:v>6.6689999999999996</c:v>
                </c:pt>
                <c:pt idx="342">
                  <c:v>6.5</c:v>
                </c:pt>
                <c:pt idx="343">
                  <c:v>6</c:v>
                </c:pt>
                <c:pt idx="344">
                  <c:v>5.5460000000000003</c:v>
                </c:pt>
                <c:pt idx="345">
                  <c:v>5.5</c:v>
                </c:pt>
                <c:pt idx="346">
                  <c:v>5</c:v>
                </c:pt>
                <c:pt idx="347">
                  <c:v>4.6740000000000004</c:v>
                </c:pt>
                <c:pt idx="348">
                  <c:v>4.5</c:v>
                </c:pt>
                <c:pt idx="349">
                  <c:v>4.2569999999999997</c:v>
                </c:pt>
                <c:pt idx="350">
                  <c:v>4.1079999999999997</c:v>
                </c:pt>
                <c:pt idx="351">
                  <c:v>4.0949999999999998</c:v>
                </c:pt>
                <c:pt idx="352">
                  <c:v>4.0890000000000004</c:v>
                </c:pt>
                <c:pt idx="353">
                  <c:v>4.0819999999999999</c:v>
                </c:pt>
                <c:pt idx="354">
                  <c:v>4.0759999999999996</c:v>
                </c:pt>
                <c:pt idx="355">
                  <c:v>4.07</c:v>
                </c:pt>
                <c:pt idx="356">
                  <c:v>4.0629999999999997</c:v>
                </c:pt>
                <c:pt idx="357">
                  <c:v>4.0129999999999999</c:v>
                </c:pt>
                <c:pt idx="358">
                  <c:v>4</c:v>
                </c:pt>
                <c:pt idx="359">
                  <c:v>3.94</c:v>
                </c:pt>
                <c:pt idx="360">
                  <c:v>3.8679999999999999</c:v>
                </c:pt>
                <c:pt idx="361">
                  <c:v>3.7949999999999999</c:v>
                </c:pt>
                <c:pt idx="362">
                  <c:v>3.7229999999999999</c:v>
                </c:pt>
                <c:pt idx="363">
                  <c:v>3.65</c:v>
                </c:pt>
                <c:pt idx="364">
                  <c:v>3.5779999999999998</c:v>
                </c:pt>
                <c:pt idx="365">
                  <c:v>3.5</c:v>
                </c:pt>
                <c:pt idx="366">
                  <c:v>3.2650000000000001</c:v>
                </c:pt>
                <c:pt idx="367">
                  <c:v>3</c:v>
                </c:pt>
                <c:pt idx="368">
                  <c:v>2.9279999999999999</c:v>
                </c:pt>
                <c:pt idx="369">
                  <c:v>2.5</c:v>
                </c:pt>
                <c:pt idx="370">
                  <c:v>2.4329999999999998</c:v>
                </c:pt>
                <c:pt idx="371">
                  <c:v>2</c:v>
                </c:pt>
                <c:pt idx="372">
                  <c:v>1.944</c:v>
                </c:pt>
                <c:pt idx="373">
                  <c:v>1.5629999999999999</c:v>
                </c:pt>
                <c:pt idx="374">
                  <c:v>1.5</c:v>
                </c:pt>
                <c:pt idx="375">
                  <c:v>1.1819999999999999</c:v>
                </c:pt>
                <c:pt idx="376">
                  <c:v>1</c:v>
                </c:pt>
                <c:pt idx="377">
                  <c:v>0.60599999999999998</c:v>
                </c:pt>
                <c:pt idx="378">
                  <c:v>0.58799999999999997</c:v>
                </c:pt>
                <c:pt idx="379">
                  <c:v>0.56999999999999995</c:v>
                </c:pt>
                <c:pt idx="380">
                  <c:v>0.55200000000000005</c:v>
                </c:pt>
                <c:pt idx="381">
                  <c:v>0.53400000000000003</c:v>
                </c:pt>
                <c:pt idx="382">
                  <c:v>0.51600000000000001</c:v>
                </c:pt>
                <c:pt idx="383">
                  <c:v>0.5</c:v>
                </c:pt>
                <c:pt idx="384">
                  <c:v>0.498</c:v>
                </c:pt>
                <c:pt idx="385">
                  <c:v>0.46899999999999997</c:v>
                </c:pt>
                <c:pt idx="386">
                  <c:v>0.438</c:v>
                </c:pt>
                <c:pt idx="387">
                  <c:v>0.40699999999999997</c:v>
                </c:pt>
                <c:pt idx="388">
                  <c:v>0.35199999999999998</c:v>
                </c:pt>
                <c:pt idx="389">
                  <c:v>0.27600000000000002</c:v>
                </c:pt>
                <c:pt idx="390">
                  <c:v>0.25</c:v>
                </c:pt>
                <c:pt idx="391">
                  <c:v>0.22700000000000001</c:v>
                </c:pt>
                <c:pt idx="392">
                  <c:v>0.20399999999999999</c:v>
                </c:pt>
                <c:pt idx="393">
                  <c:v>0.18</c:v>
                </c:pt>
                <c:pt idx="394">
                  <c:v>0.157</c:v>
                </c:pt>
                <c:pt idx="395">
                  <c:v>0.13300000000000001</c:v>
                </c:pt>
                <c:pt idx="396">
                  <c:v>0.112</c:v>
                </c:pt>
                <c:pt idx="397">
                  <c:v>0.09</c:v>
                </c:pt>
                <c:pt idx="398">
                  <c:v>6.8000000000000005E-2</c:v>
                </c:pt>
                <c:pt idx="399">
                  <c:v>4.7E-2</c:v>
                </c:pt>
                <c:pt idx="400">
                  <c:v>2.5000000000000001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496-4CC3-8534-400DC70DE595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I$819:$I$1220</c:f>
              <c:numCache>
                <c:formatCode>General</c:formatCode>
                <c:ptCount val="402"/>
                <c:pt idx="0">
                  <c:v>0</c:v>
                </c:pt>
                <c:pt idx="1">
                  <c:v>5.7389999999999999</c:v>
                </c:pt>
                <c:pt idx="2">
                  <c:v>11.477</c:v>
                </c:pt>
                <c:pt idx="3">
                  <c:v>17.216000000000001</c:v>
                </c:pt>
                <c:pt idx="4">
                  <c:v>22.954000000000001</c:v>
                </c:pt>
                <c:pt idx="5">
                  <c:v>28.693000000000001</c:v>
                </c:pt>
                <c:pt idx="6">
                  <c:v>34.430999999999997</c:v>
                </c:pt>
                <c:pt idx="7">
                  <c:v>40.17</c:v>
                </c:pt>
                <c:pt idx="8">
                  <c:v>45.908000000000001</c:v>
                </c:pt>
                <c:pt idx="9">
                  <c:v>51.646999999999998</c:v>
                </c:pt>
                <c:pt idx="10">
                  <c:v>57.386000000000003</c:v>
                </c:pt>
                <c:pt idx="11">
                  <c:v>63.124000000000002</c:v>
                </c:pt>
                <c:pt idx="12">
                  <c:v>68.863</c:v>
                </c:pt>
                <c:pt idx="13">
                  <c:v>74.600999999999999</c:v>
                </c:pt>
                <c:pt idx="14">
                  <c:v>80.34</c:v>
                </c:pt>
                <c:pt idx="15">
                  <c:v>86.078000000000003</c:v>
                </c:pt>
                <c:pt idx="16">
                  <c:v>91.816999999999993</c:v>
                </c:pt>
                <c:pt idx="17">
                  <c:v>97.555000000000007</c:v>
                </c:pt>
                <c:pt idx="18">
                  <c:v>103.294</c:v>
                </c:pt>
                <c:pt idx="19">
                  <c:v>109.033</c:v>
                </c:pt>
                <c:pt idx="20">
                  <c:v>114.771</c:v>
                </c:pt>
                <c:pt idx="21">
                  <c:v>120.51</c:v>
                </c:pt>
                <c:pt idx="22">
                  <c:v>126.248</c:v>
                </c:pt>
                <c:pt idx="23">
                  <c:v>131.98699999999999</c:v>
                </c:pt>
                <c:pt idx="24">
                  <c:v>137.72499999999999</c:v>
                </c:pt>
                <c:pt idx="25">
                  <c:v>143.464</c:v>
                </c:pt>
                <c:pt idx="26">
                  <c:v>149.202</c:v>
                </c:pt>
                <c:pt idx="27">
                  <c:v>154.941</c:v>
                </c:pt>
                <c:pt idx="28">
                  <c:v>160.68</c:v>
                </c:pt>
                <c:pt idx="29">
                  <c:v>166.41800000000001</c:v>
                </c:pt>
                <c:pt idx="30">
                  <c:v>172.15700000000001</c:v>
                </c:pt>
                <c:pt idx="31">
                  <c:v>177.89500000000001</c:v>
                </c:pt>
                <c:pt idx="32">
                  <c:v>183.63399999999999</c:v>
                </c:pt>
                <c:pt idx="33">
                  <c:v>189.37200000000001</c:v>
                </c:pt>
                <c:pt idx="34">
                  <c:v>195.11099999999999</c:v>
                </c:pt>
                <c:pt idx="35">
                  <c:v>200.84899999999999</c:v>
                </c:pt>
                <c:pt idx="36">
                  <c:v>206.58799999999999</c:v>
                </c:pt>
                <c:pt idx="37">
                  <c:v>212.327</c:v>
                </c:pt>
                <c:pt idx="38">
                  <c:v>218.065</c:v>
                </c:pt>
                <c:pt idx="39">
                  <c:v>223.804</c:v>
                </c:pt>
                <c:pt idx="40">
                  <c:v>229.542</c:v>
                </c:pt>
                <c:pt idx="41">
                  <c:v>235.28100000000001</c:v>
                </c:pt>
                <c:pt idx="42">
                  <c:v>241.01900000000001</c:v>
                </c:pt>
                <c:pt idx="43">
                  <c:v>246.75800000000001</c:v>
                </c:pt>
                <c:pt idx="44">
                  <c:v>252.49700000000001</c:v>
                </c:pt>
                <c:pt idx="45">
                  <c:v>258.23500000000001</c:v>
                </c:pt>
                <c:pt idx="46">
                  <c:v>263.97399999999999</c:v>
                </c:pt>
                <c:pt idx="47">
                  <c:v>269.71199999999999</c:v>
                </c:pt>
                <c:pt idx="48">
                  <c:v>275.45100000000002</c:v>
                </c:pt>
                <c:pt idx="49">
                  <c:v>281.18900000000002</c:v>
                </c:pt>
                <c:pt idx="50">
                  <c:v>286.928</c:v>
                </c:pt>
                <c:pt idx="51">
                  <c:v>292.666</c:v>
                </c:pt>
                <c:pt idx="52">
                  <c:v>295.53199999999998</c:v>
                </c:pt>
                <c:pt idx="53">
                  <c:v>298.40499999999997</c:v>
                </c:pt>
                <c:pt idx="54">
                  <c:v>304.14400000000001</c:v>
                </c:pt>
                <c:pt idx="55">
                  <c:v>309.88200000000001</c:v>
                </c:pt>
                <c:pt idx="56">
                  <c:v>315.62099999999998</c:v>
                </c:pt>
                <c:pt idx="57">
                  <c:v>321.35899999999998</c:v>
                </c:pt>
                <c:pt idx="58">
                  <c:v>327.09800000000001</c:v>
                </c:pt>
                <c:pt idx="59">
                  <c:v>332.83600000000001</c:v>
                </c:pt>
                <c:pt idx="60">
                  <c:v>338.57499999999999</c:v>
                </c:pt>
                <c:pt idx="61">
                  <c:v>344.31299999999999</c:v>
                </c:pt>
                <c:pt idx="62">
                  <c:v>350.05200000000002</c:v>
                </c:pt>
                <c:pt idx="63">
                  <c:v>355.791</c:v>
                </c:pt>
                <c:pt idx="64">
                  <c:v>361.529</c:v>
                </c:pt>
                <c:pt idx="65">
                  <c:v>367.26799999999997</c:v>
                </c:pt>
                <c:pt idx="66">
                  <c:v>373.00599999999997</c:v>
                </c:pt>
                <c:pt idx="67">
                  <c:v>378.62</c:v>
                </c:pt>
                <c:pt idx="68">
                  <c:v>378.745</c:v>
                </c:pt>
                <c:pt idx="69">
                  <c:v>384.483</c:v>
                </c:pt>
                <c:pt idx="70">
                  <c:v>390.22199999999998</c:v>
                </c:pt>
                <c:pt idx="71">
                  <c:v>395.96</c:v>
                </c:pt>
                <c:pt idx="72">
                  <c:v>401.69900000000001</c:v>
                </c:pt>
                <c:pt idx="73">
                  <c:v>402.67899999999997</c:v>
                </c:pt>
                <c:pt idx="74">
                  <c:v>407.43799999999999</c:v>
                </c:pt>
                <c:pt idx="75">
                  <c:v>410.16500000000002</c:v>
                </c:pt>
                <c:pt idx="76">
                  <c:v>413.17599999999999</c:v>
                </c:pt>
                <c:pt idx="77">
                  <c:v>418.91500000000002</c:v>
                </c:pt>
                <c:pt idx="78">
                  <c:v>424.65300000000002</c:v>
                </c:pt>
                <c:pt idx="79">
                  <c:v>430.392</c:v>
                </c:pt>
                <c:pt idx="80">
                  <c:v>432.71</c:v>
                </c:pt>
                <c:pt idx="81">
                  <c:v>433.16699999999997</c:v>
                </c:pt>
                <c:pt idx="82">
                  <c:v>433.33100000000002</c:v>
                </c:pt>
                <c:pt idx="83">
                  <c:v>436.13</c:v>
                </c:pt>
                <c:pt idx="84">
                  <c:v>441.86900000000003</c:v>
                </c:pt>
                <c:pt idx="85">
                  <c:v>443.64100000000002</c:v>
                </c:pt>
                <c:pt idx="86">
                  <c:v>447.60700000000003</c:v>
                </c:pt>
                <c:pt idx="87">
                  <c:v>453.346</c:v>
                </c:pt>
                <c:pt idx="88">
                  <c:v>457.29599999999999</c:v>
                </c:pt>
                <c:pt idx="89">
                  <c:v>459.08499999999998</c:v>
                </c:pt>
                <c:pt idx="90">
                  <c:v>460.73700000000002</c:v>
                </c:pt>
                <c:pt idx="91">
                  <c:v>464.82299999999998</c:v>
                </c:pt>
                <c:pt idx="92">
                  <c:v>467.37</c:v>
                </c:pt>
                <c:pt idx="93">
                  <c:v>468.678</c:v>
                </c:pt>
                <c:pt idx="94">
                  <c:v>470.56200000000001</c:v>
                </c:pt>
                <c:pt idx="95">
                  <c:v>470.74</c:v>
                </c:pt>
                <c:pt idx="96">
                  <c:v>476.3</c:v>
                </c:pt>
                <c:pt idx="97">
                  <c:v>482.03899999999999</c:v>
                </c:pt>
                <c:pt idx="98">
                  <c:v>482.21</c:v>
                </c:pt>
                <c:pt idx="99">
                  <c:v>487.77699999999999</c:v>
                </c:pt>
                <c:pt idx="100">
                  <c:v>487.81799999999998</c:v>
                </c:pt>
                <c:pt idx="101">
                  <c:v>493.51600000000002</c:v>
                </c:pt>
                <c:pt idx="102">
                  <c:v>499.25400000000002</c:v>
                </c:pt>
                <c:pt idx="103">
                  <c:v>502.19900000000001</c:v>
                </c:pt>
                <c:pt idx="104">
                  <c:v>504.99299999999999</c:v>
                </c:pt>
                <c:pt idx="105">
                  <c:v>507.71199999999999</c:v>
                </c:pt>
                <c:pt idx="106">
                  <c:v>510.73200000000003</c:v>
                </c:pt>
                <c:pt idx="107">
                  <c:v>512.10299999999995</c:v>
                </c:pt>
                <c:pt idx="108">
                  <c:v>516.30700000000002</c:v>
                </c:pt>
                <c:pt idx="109">
                  <c:v>516.47</c:v>
                </c:pt>
                <c:pt idx="110">
                  <c:v>519.87699999999995</c:v>
                </c:pt>
                <c:pt idx="111">
                  <c:v>522.20899999999995</c:v>
                </c:pt>
                <c:pt idx="112">
                  <c:v>523.68600000000004</c:v>
                </c:pt>
                <c:pt idx="113">
                  <c:v>527.947</c:v>
                </c:pt>
                <c:pt idx="114">
                  <c:v>529.02099999999996</c:v>
                </c:pt>
                <c:pt idx="115">
                  <c:v>531.14700000000005</c:v>
                </c:pt>
                <c:pt idx="116">
                  <c:v>531.78899999999999</c:v>
                </c:pt>
                <c:pt idx="117">
                  <c:v>532.59799999999996</c:v>
                </c:pt>
                <c:pt idx="118">
                  <c:v>533.68600000000004</c:v>
                </c:pt>
                <c:pt idx="119">
                  <c:v>533.83799999999997</c:v>
                </c:pt>
                <c:pt idx="120">
                  <c:v>538.48299999999995</c:v>
                </c:pt>
                <c:pt idx="121">
                  <c:v>539.42399999999998</c:v>
                </c:pt>
                <c:pt idx="122">
                  <c:v>539.61</c:v>
                </c:pt>
                <c:pt idx="123">
                  <c:v>541.91700000000003</c:v>
                </c:pt>
                <c:pt idx="124">
                  <c:v>545.16300000000001</c:v>
                </c:pt>
                <c:pt idx="125">
                  <c:v>545.298</c:v>
                </c:pt>
                <c:pt idx="126">
                  <c:v>548.65499999999997</c:v>
                </c:pt>
                <c:pt idx="127">
                  <c:v>550.38400000000001</c:v>
                </c:pt>
                <c:pt idx="128">
                  <c:v>550.90099999999995</c:v>
                </c:pt>
                <c:pt idx="129">
                  <c:v>556.64</c:v>
                </c:pt>
                <c:pt idx="130">
                  <c:v>562.15899999999999</c:v>
                </c:pt>
                <c:pt idx="131">
                  <c:v>562.37900000000002</c:v>
                </c:pt>
                <c:pt idx="132">
                  <c:v>568.11699999999996</c:v>
                </c:pt>
                <c:pt idx="133">
                  <c:v>573.5</c:v>
                </c:pt>
                <c:pt idx="134">
                  <c:v>573.80700000000002</c:v>
                </c:pt>
                <c:pt idx="135">
                  <c:v>573.85599999999999</c:v>
                </c:pt>
                <c:pt idx="136">
                  <c:v>575.14599999999996</c:v>
                </c:pt>
                <c:pt idx="137">
                  <c:v>577.88199999999995</c:v>
                </c:pt>
                <c:pt idx="138">
                  <c:v>579.59400000000005</c:v>
                </c:pt>
                <c:pt idx="139">
                  <c:v>585.33299999999997</c:v>
                </c:pt>
                <c:pt idx="140">
                  <c:v>586.92399999999998</c:v>
                </c:pt>
                <c:pt idx="141">
                  <c:v>591.07100000000003</c:v>
                </c:pt>
                <c:pt idx="142">
                  <c:v>596.80999999999995</c:v>
                </c:pt>
                <c:pt idx="143">
                  <c:v>599.72199999999998</c:v>
                </c:pt>
                <c:pt idx="144">
                  <c:v>601.053</c:v>
                </c:pt>
                <c:pt idx="145">
                  <c:v>602.43799999999999</c:v>
                </c:pt>
                <c:pt idx="146">
                  <c:v>602.548</c:v>
                </c:pt>
                <c:pt idx="147">
                  <c:v>604.02300000000002</c:v>
                </c:pt>
                <c:pt idx="148">
                  <c:v>605.06100000000004</c:v>
                </c:pt>
                <c:pt idx="149">
                  <c:v>605.10599999999999</c:v>
                </c:pt>
                <c:pt idx="150">
                  <c:v>606.46299999999997</c:v>
                </c:pt>
                <c:pt idx="151">
                  <c:v>608.28700000000003</c:v>
                </c:pt>
                <c:pt idx="152">
                  <c:v>609.38</c:v>
                </c:pt>
                <c:pt idx="153">
                  <c:v>611.24</c:v>
                </c:pt>
                <c:pt idx="154">
                  <c:v>611.43399999999997</c:v>
                </c:pt>
                <c:pt idx="155">
                  <c:v>611.63699999999994</c:v>
                </c:pt>
                <c:pt idx="156">
                  <c:v>612.08199999999999</c:v>
                </c:pt>
                <c:pt idx="157">
                  <c:v>612.77800000000002</c:v>
                </c:pt>
                <c:pt idx="158">
                  <c:v>614.02599999999995</c:v>
                </c:pt>
                <c:pt idx="159">
                  <c:v>614.88599999999997</c:v>
                </c:pt>
                <c:pt idx="160">
                  <c:v>616.99400000000003</c:v>
                </c:pt>
                <c:pt idx="161">
                  <c:v>619.76400000000001</c:v>
                </c:pt>
                <c:pt idx="162">
                  <c:v>622.90800000000002</c:v>
                </c:pt>
                <c:pt idx="163">
                  <c:v>625.50300000000004</c:v>
                </c:pt>
                <c:pt idx="164">
                  <c:v>630.72699999999998</c:v>
                </c:pt>
                <c:pt idx="165">
                  <c:v>631.24099999999999</c:v>
                </c:pt>
                <c:pt idx="166">
                  <c:v>636.98</c:v>
                </c:pt>
                <c:pt idx="167">
                  <c:v>637.43700000000001</c:v>
                </c:pt>
                <c:pt idx="168">
                  <c:v>639.91399999999999</c:v>
                </c:pt>
                <c:pt idx="169">
                  <c:v>642.71799999999996</c:v>
                </c:pt>
                <c:pt idx="170">
                  <c:v>646.29499999999996</c:v>
                </c:pt>
                <c:pt idx="171">
                  <c:v>648.45699999999999</c:v>
                </c:pt>
                <c:pt idx="172">
                  <c:v>649.17600000000004</c:v>
                </c:pt>
                <c:pt idx="173">
                  <c:v>650.05899999999997</c:v>
                </c:pt>
                <c:pt idx="174">
                  <c:v>651.58900000000006</c:v>
                </c:pt>
                <c:pt idx="175">
                  <c:v>654.19600000000003</c:v>
                </c:pt>
                <c:pt idx="176">
                  <c:v>654.64700000000005</c:v>
                </c:pt>
                <c:pt idx="177">
                  <c:v>657.70100000000002</c:v>
                </c:pt>
                <c:pt idx="178">
                  <c:v>659.93399999999997</c:v>
                </c:pt>
                <c:pt idx="179">
                  <c:v>660.71699999999998</c:v>
                </c:pt>
                <c:pt idx="180">
                  <c:v>662.89499999999998</c:v>
                </c:pt>
                <c:pt idx="181">
                  <c:v>665.03399999999999</c:v>
                </c:pt>
                <c:pt idx="182">
                  <c:v>665.673</c:v>
                </c:pt>
                <c:pt idx="183">
                  <c:v>667.54600000000005</c:v>
                </c:pt>
                <c:pt idx="184">
                  <c:v>671.08900000000006</c:v>
                </c:pt>
                <c:pt idx="185">
                  <c:v>671.41099999999994</c:v>
                </c:pt>
                <c:pt idx="186">
                  <c:v>674.05600000000004</c:v>
                </c:pt>
                <c:pt idx="187">
                  <c:v>674.87699999999995</c:v>
                </c:pt>
                <c:pt idx="188">
                  <c:v>675.77700000000004</c:v>
                </c:pt>
                <c:pt idx="189">
                  <c:v>677.15</c:v>
                </c:pt>
                <c:pt idx="190">
                  <c:v>677.76700000000005</c:v>
                </c:pt>
                <c:pt idx="191">
                  <c:v>679.75699999999995</c:v>
                </c:pt>
                <c:pt idx="192">
                  <c:v>681.72299999999996</c:v>
                </c:pt>
                <c:pt idx="193">
                  <c:v>682.88800000000003</c:v>
                </c:pt>
                <c:pt idx="194">
                  <c:v>683.68499999999995</c:v>
                </c:pt>
                <c:pt idx="195">
                  <c:v>684.70500000000004</c:v>
                </c:pt>
                <c:pt idx="196">
                  <c:v>685.22799999999995</c:v>
                </c:pt>
                <c:pt idx="197">
                  <c:v>687.76599999999996</c:v>
                </c:pt>
                <c:pt idx="198">
                  <c:v>688.62699999999995</c:v>
                </c:pt>
                <c:pt idx="199">
                  <c:v>692.90899999999999</c:v>
                </c:pt>
                <c:pt idx="200">
                  <c:v>694.36500000000001</c:v>
                </c:pt>
                <c:pt idx="201">
                  <c:v>697.07</c:v>
                </c:pt>
                <c:pt idx="202">
                  <c:v>700.10400000000004</c:v>
                </c:pt>
                <c:pt idx="203">
                  <c:v>700.29</c:v>
                </c:pt>
                <c:pt idx="204">
                  <c:v>703.97900000000004</c:v>
                </c:pt>
                <c:pt idx="205">
                  <c:v>705.84299999999996</c:v>
                </c:pt>
                <c:pt idx="206">
                  <c:v>706.39</c:v>
                </c:pt>
                <c:pt idx="207">
                  <c:v>708.94</c:v>
                </c:pt>
                <c:pt idx="208">
                  <c:v>710.88199999999995</c:v>
                </c:pt>
                <c:pt idx="209">
                  <c:v>711.58100000000002</c:v>
                </c:pt>
                <c:pt idx="210">
                  <c:v>716.81299999999999</c:v>
                </c:pt>
                <c:pt idx="211">
                  <c:v>717.32</c:v>
                </c:pt>
                <c:pt idx="212">
                  <c:v>718.101</c:v>
                </c:pt>
                <c:pt idx="213">
                  <c:v>720.48599999999999</c:v>
                </c:pt>
                <c:pt idx="214">
                  <c:v>723.05799999999999</c:v>
                </c:pt>
                <c:pt idx="215">
                  <c:v>726.88099999999997</c:v>
                </c:pt>
                <c:pt idx="216">
                  <c:v>728.79700000000003</c:v>
                </c:pt>
                <c:pt idx="217">
                  <c:v>731.50900000000001</c:v>
                </c:pt>
                <c:pt idx="218">
                  <c:v>733.76300000000003</c:v>
                </c:pt>
                <c:pt idx="219">
                  <c:v>734.53499999999997</c:v>
                </c:pt>
                <c:pt idx="220">
                  <c:v>734.79499999999996</c:v>
                </c:pt>
                <c:pt idx="221">
                  <c:v>735.17700000000002</c:v>
                </c:pt>
                <c:pt idx="222">
                  <c:v>735.72799999999995</c:v>
                </c:pt>
                <c:pt idx="223">
                  <c:v>736.298</c:v>
                </c:pt>
                <c:pt idx="224">
                  <c:v>740.274</c:v>
                </c:pt>
                <c:pt idx="225">
                  <c:v>742.15800000000002</c:v>
                </c:pt>
                <c:pt idx="226">
                  <c:v>746.01199999999994</c:v>
                </c:pt>
                <c:pt idx="227">
                  <c:v>751.75099999999998</c:v>
                </c:pt>
                <c:pt idx="228">
                  <c:v>752.23299999999995</c:v>
                </c:pt>
                <c:pt idx="229">
                  <c:v>757.49</c:v>
                </c:pt>
                <c:pt idx="230">
                  <c:v>763.22799999999995</c:v>
                </c:pt>
                <c:pt idx="231">
                  <c:v>767.18399999999997</c:v>
                </c:pt>
                <c:pt idx="232">
                  <c:v>767.73</c:v>
                </c:pt>
                <c:pt idx="233">
                  <c:v>767.846</c:v>
                </c:pt>
                <c:pt idx="234">
                  <c:v>768.20799999999997</c:v>
                </c:pt>
                <c:pt idx="235">
                  <c:v>768.89499999999998</c:v>
                </c:pt>
                <c:pt idx="236">
                  <c:v>768.96699999999998</c:v>
                </c:pt>
                <c:pt idx="237">
                  <c:v>769.58699999999999</c:v>
                </c:pt>
                <c:pt idx="238">
                  <c:v>770.298</c:v>
                </c:pt>
                <c:pt idx="239">
                  <c:v>771.01</c:v>
                </c:pt>
                <c:pt idx="240">
                  <c:v>771.37199999999996</c:v>
                </c:pt>
                <c:pt idx="241">
                  <c:v>771.67899999999997</c:v>
                </c:pt>
                <c:pt idx="242">
                  <c:v>771.90200000000004</c:v>
                </c:pt>
                <c:pt idx="243">
                  <c:v>772.05600000000004</c:v>
                </c:pt>
                <c:pt idx="244">
                  <c:v>773.78399999999999</c:v>
                </c:pt>
                <c:pt idx="245">
                  <c:v>774.70500000000004</c:v>
                </c:pt>
                <c:pt idx="246">
                  <c:v>777.44100000000003</c:v>
                </c:pt>
                <c:pt idx="247">
                  <c:v>780.44399999999996</c:v>
                </c:pt>
                <c:pt idx="248">
                  <c:v>782.66200000000003</c:v>
                </c:pt>
                <c:pt idx="249">
                  <c:v>786.18200000000002</c:v>
                </c:pt>
                <c:pt idx="250">
                  <c:v>791.36300000000006</c:v>
                </c:pt>
                <c:pt idx="251">
                  <c:v>791.92100000000005</c:v>
                </c:pt>
                <c:pt idx="252">
                  <c:v>794.86800000000005</c:v>
                </c:pt>
                <c:pt idx="253">
                  <c:v>796.42899999999997</c:v>
                </c:pt>
                <c:pt idx="254">
                  <c:v>797.38599999999997</c:v>
                </c:pt>
                <c:pt idx="255">
                  <c:v>797.65899999999999</c:v>
                </c:pt>
                <c:pt idx="256">
                  <c:v>798.20600000000002</c:v>
                </c:pt>
                <c:pt idx="257">
                  <c:v>798.83699999999999</c:v>
                </c:pt>
                <c:pt idx="258">
                  <c:v>799.43</c:v>
                </c:pt>
                <c:pt idx="259">
                  <c:v>802.07399999999996</c:v>
                </c:pt>
                <c:pt idx="260">
                  <c:v>803.39800000000002</c:v>
                </c:pt>
                <c:pt idx="261">
                  <c:v>805.08900000000006</c:v>
                </c:pt>
                <c:pt idx="262">
                  <c:v>807.30899999999997</c:v>
                </c:pt>
                <c:pt idx="263">
                  <c:v>808.75699999999995</c:v>
                </c:pt>
                <c:pt idx="264">
                  <c:v>809.13699999999994</c:v>
                </c:pt>
                <c:pt idx="265">
                  <c:v>809.78899999999999</c:v>
                </c:pt>
                <c:pt idx="266">
                  <c:v>809.84900000000005</c:v>
                </c:pt>
                <c:pt idx="267">
                  <c:v>814.875</c:v>
                </c:pt>
                <c:pt idx="268">
                  <c:v>817.39400000000001</c:v>
                </c:pt>
                <c:pt idx="269">
                  <c:v>818.76199999999994</c:v>
                </c:pt>
                <c:pt idx="270">
                  <c:v>819.24900000000002</c:v>
                </c:pt>
                <c:pt idx="271">
                  <c:v>820.61400000000003</c:v>
                </c:pt>
                <c:pt idx="272">
                  <c:v>821.66200000000003</c:v>
                </c:pt>
                <c:pt idx="273">
                  <c:v>822.53800000000001</c:v>
                </c:pt>
                <c:pt idx="274">
                  <c:v>825.10900000000004</c:v>
                </c:pt>
                <c:pt idx="275">
                  <c:v>826.35199999999998</c:v>
                </c:pt>
                <c:pt idx="276">
                  <c:v>829.76</c:v>
                </c:pt>
                <c:pt idx="277">
                  <c:v>832.09100000000001</c:v>
                </c:pt>
                <c:pt idx="278">
                  <c:v>835.49199999999996</c:v>
                </c:pt>
                <c:pt idx="279">
                  <c:v>836.33100000000002</c:v>
                </c:pt>
                <c:pt idx="280">
                  <c:v>837.28099999999995</c:v>
                </c:pt>
                <c:pt idx="281">
                  <c:v>837.82899999999995</c:v>
                </c:pt>
                <c:pt idx="282">
                  <c:v>838.25599999999997</c:v>
                </c:pt>
                <c:pt idx="283">
                  <c:v>838.58299999999997</c:v>
                </c:pt>
                <c:pt idx="284">
                  <c:v>839.03800000000001</c:v>
                </c:pt>
                <c:pt idx="285">
                  <c:v>842.18600000000004</c:v>
                </c:pt>
                <c:pt idx="286">
                  <c:v>843.56799999999998</c:v>
                </c:pt>
                <c:pt idx="287">
                  <c:v>849.30600000000004</c:v>
                </c:pt>
                <c:pt idx="288">
                  <c:v>851.11099999999999</c:v>
                </c:pt>
                <c:pt idx="289">
                  <c:v>852.72</c:v>
                </c:pt>
                <c:pt idx="290">
                  <c:v>853.92600000000004</c:v>
                </c:pt>
                <c:pt idx="291">
                  <c:v>855.04499999999996</c:v>
                </c:pt>
                <c:pt idx="292">
                  <c:v>860.78399999999999</c:v>
                </c:pt>
                <c:pt idx="293">
                  <c:v>862.67899999999997</c:v>
                </c:pt>
                <c:pt idx="294">
                  <c:v>866.52200000000005</c:v>
                </c:pt>
                <c:pt idx="295">
                  <c:v>867.05100000000004</c:v>
                </c:pt>
                <c:pt idx="296">
                  <c:v>868.84900000000005</c:v>
                </c:pt>
                <c:pt idx="297">
                  <c:v>869.42200000000003</c:v>
                </c:pt>
                <c:pt idx="298">
                  <c:v>872.26099999999997</c:v>
                </c:pt>
                <c:pt idx="299">
                  <c:v>874.42899999999997</c:v>
                </c:pt>
                <c:pt idx="300">
                  <c:v>877.99900000000002</c:v>
                </c:pt>
                <c:pt idx="301">
                  <c:v>878.83500000000004</c:v>
                </c:pt>
                <c:pt idx="302">
                  <c:v>880.08900000000006</c:v>
                </c:pt>
                <c:pt idx="303">
                  <c:v>882.06399999999996</c:v>
                </c:pt>
                <c:pt idx="304">
                  <c:v>883.73800000000006</c:v>
                </c:pt>
                <c:pt idx="305">
                  <c:v>883.91700000000003</c:v>
                </c:pt>
                <c:pt idx="306">
                  <c:v>885.50800000000004</c:v>
                </c:pt>
                <c:pt idx="307">
                  <c:v>887.65499999999997</c:v>
                </c:pt>
                <c:pt idx="308">
                  <c:v>889.476</c:v>
                </c:pt>
                <c:pt idx="309">
                  <c:v>889.95100000000002</c:v>
                </c:pt>
                <c:pt idx="310">
                  <c:v>890.649</c:v>
                </c:pt>
                <c:pt idx="311">
                  <c:v>891.34699999999998</c:v>
                </c:pt>
                <c:pt idx="312">
                  <c:v>894.06600000000003</c:v>
                </c:pt>
                <c:pt idx="313">
                  <c:v>895.21500000000003</c:v>
                </c:pt>
                <c:pt idx="314">
                  <c:v>897.41899999999998</c:v>
                </c:pt>
                <c:pt idx="315">
                  <c:v>898.52300000000002</c:v>
                </c:pt>
                <c:pt idx="316">
                  <c:v>900.78499999999997</c:v>
                </c:pt>
                <c:pt idx="317">
                  <c:v>900.95299999999997</c:v>
                </c:pt>
                <c:pt idx="318">
                  <c:v>904.35400000000004</c:v>
                </c:pt>
                <c:pt idx="319">
                  <c:v>905.38199999999995</c:v>
                </c:pt>
                <c:pt idx="320">
                  <c:v>906.24199999999996</c:v>
                </c:pt>
                <c:pt idx="321">
                  <c:v>906.69200000000001</c:v>
                </c:pt>
                <c:pt idx="322">
                  <c:v>907.101</c:v>
                </c:pt>
                <c:pt idx="323">
                  <c:v>909.08699999999999</c:v>
                </c:pt>
                <c:pt idx="324">
                  <c:v>911.3</c:v>
                </c:pt>
                <c:pt idx="325">
                  <c:v>912.43100000000004</c:v>
                </c:pt>
                <c:pt idx="326">
                  <c:v>913.78800000000001</c:v>
                </c:pt>
                <c:pt idx="327">
                  <c:v>918.16899999999998</c:v>
                </c:pt>
                <c:pt idx="328">
                  <c:v>918.70699999999999</c:v>
                </c:pt>
                <c:pt idx="329">
                  <c:v>923.90800000000002</c:v>
                </c:pt>
                <c:pt idx="330">
                  <c:v>929.64599999999996</c:v>
                </c:pt>
                <c:pt idx="331">
                  <c:v>935.38499999999999</c:v>
                </c:pt>
                <c:pt idx="332">
                  <c:v>937.24300000000005</c:v>
                </c:pt>
                <c:pt idx="333">
                  <c:v>941.12300000000005</c:v>
                </c:pt>
                <c:pt idx="334">
                  <c:v>946.86199999999997</c:v>
                </c:pt>
                <c:pt idx="335">
                  <c:v>948.64099999999996</c:v>
                </c:pt>
                <c:pt idx="336">
                  <c:v>952.6</c:v>
                </c:pt>
                <c:pt idx="337">
                  <c:v>958.33900000000006</c:v>
                </c:pt>
                <c:pt idx="338">
                  <c:v>959.50099999999998</c:v>
                </c:pt>
                <c:pt idx="339">
                  <c:v>963.53200000000004</c:v>
                </c:pt>
                <c:pt idx="340">
                  <c:v>964.07799999999997</c:v>
                </c:pt>
                <c:pt idx="341">
                  <c:v>965.64200000000005</c:v>
                </c:pt>
                <c:pt idx="342">
                  <c:v>968.27800000000002</c:v>
                </c:pt>
                <c:pt idx="343">
                  <c:v>969.81600000000003</c:v>
                </c:pt>
                <c:pt idx="344">
                  <c:v>971.43499999999995</c:v>
                </c:pt>
                <c:pt idx="345">
                  <c:v>973.36099999999999</c:v>
                </c:pt>
                <c:pt idx="346">
                  <c:v>973.75599999999997</c:v>
                </c:pt>
                <c:pt idx="347">
                  <c:v>974.18799999999999</c:v>
                </c:pt>
                <c:pt idx="348">
                  <c:v>974.93799999999999</c:v>
                </c:pt>
                <c:pt idx="349">
                  <c:v>975.55499999999995</c:v>
                </c:pt>
                <c:pt idx="350">
                  <c:v>975.68799999999999</c:v>
                </c:pt>
                <c:pt idx="351">
                  <c:v>976.78099999999995</c:v>
                </c:pt>
                <c:pt idx="352">
                  <c:v>977.79499999999996</c:v>
                </c:pt>
                <c:pt idx="353">
                  <c:v>978.75900000000001</c:v>
                </c:pt>
                <c:pt idx="354">
                  <c:v>980.16700000000003</c:v>
                </c:pt>
                <c:pt idx="355">
                  <c:v>981.29300000000001</c:v>
                </c:pt>
                <c:pt idx="356">
                  <c:v>984.29300000000001</c:v>
                </c:pt>
                <c:pt idx="357">
                  <c:v>987.03200000000004</c:v>
                </c:pt>
                <c:pt idx="358">
                  <c:v>990.154</c:v>
                </c:pt>
                <c:pt idx="359">
                  <c:v>992.77</c:v>
                </c:pt>
                <c:pt idx="360">
                  <c:v>995.21699999999998</c:v>
                </c:pt>
                <c:pt idx="361">
                  <c:v>998.50900000000001</c:v>
                </c:pt>
                <c:pt idx="362">
                  <c:v>999.62199999999996</c:v>
                </c:pt>
                <c:pt idx="363">
                  <c:v>1004.247</c:v>
                </c:pt>
                <c:pt idx="364">
                  <c:v>1004.663</c:v>
                </c:pt>
                <c:pt idx="365">
                  <c:v>1009.986</c:v>
                </c:pt>
                <c:pt idx="366">
                  <c:v>1013.505</c:v>
                </c:pt>
                <c:pt idx="367">
                  <c:v>1015.725</c:v>
                </c:pt>
                <c:pt idx="368">
                  <c:v>1021.463</c:v>
                </c:pt>
                <c:pt idx="369">
                  <c:v>1027.202</c:v>
                </c:pt>
                <c:pt idx="370">
                  <c:v>1032.6659999999999</c:v>
                </c:pt>
                <c:pt idx="371">
                  <c:v>1032.94</c:v>
                </c:pt>
                <c:pt idx="372">
                  <c:v>1038.6790000000001</c:v>
                </c:pt>
                <c:pt idx="373">
                  <c:v>1041.54</c:v>
                </c:pt>
                <c:pt idx="374">
                  <c:v>1044.4169999999999</c:v>
                </c:pt>
                <c:pt idx="375">
                  <c:v>1046.383</c:v>
                </c:pt>
                <c:pt idx="376">
                  <c:v>1050.1559999999999</c:v>
                </c:pt>
                <c:pt idx="377">
                  <c:v>1053.0260000000001</c:v>
                </c:pt>
                <c:pt idx="378">
                  <c:v>1055.895</c:v>
                </c:pt>
                <c:pt idx="379">
                  <c:v>1058.8779999999999</c:v>
                </c:pt>
                <c:pt idx="380">
                  <c:v>1061.49</c:v>
                </c:pt>
                <c:pt idx="381">
                  <c:v>1061.633</c:v>
                </c:pt>
                <c:pt idx="382">
                  <c:v>1064.749</c:v>
                </c:pt>
                <c:pt idx="383">
                  <c:v>1067.3720000000001</c:v>
                </c:pt>
                <c:pt idx="384">
                  <c:v>1071.8820000000001</c:v>
                </c:pt>
                <c:pt idx="385">
                  <c:v>1073.1099999999999</c:v>
                </c:pt>
                <c:pt idx="386">
                  <c:v>1078.8489999999999</c:v>
                </c:pt>
                <c:pt idx="387">
                  <c:v>1081.1600000000001</c:v>
                </c:pt>
                <c:pt idx="388">
                  <c:v>1084.587</c:v>
                </c:pt>
                <c:pt idx="389">
                  <c:v>1090.326</c:v>
                </c:pt>
                <c:pt idx="390">
                  <c:v>1096.0640000000001</c:v>
                </c:pt>
                <c:pt idx="391">
                  <c:v>1096.4680000000001</c:v>
                </c:pt>
                <c:pt idx="392">
                  <c:v>1101.8030000000001</c:v>
                </c:pt>
                <c:pt idx="393">
                  <c:v>1107.5419999999999</c:v>
                </c:pt>
                <c:pt idx="394">
                  <c:v>1113.28</c:v>
                </c:pt>
                <c:pt idx="395">
                  <c:v>1119.019</c:v>
                </c:pt>
                <c:pt idx="396">
                  <c:v>1124.7570000000001</c:v>
                </c:pt>
                <c:pt idx="397">
                  <c:v>1130.4960000000001</c:v>
                </c:pt>
                <c:pt idx="398">
                  <c:v>1136.2339999999999</c:v>
                </c:pt>
                <c:pt idx="399">
                  <c:v>1141.973</c:v>
                </c:pt>
                <c:pt idx="400">
                  <c:v>1147.711</c:v>
                </c:pt>
                <c:pt idx="401">
                  <c:v>1147.711</c:v>
                </c:pt>
              </c:numCache>
            </c:numRef>
          </c:xVal>
          <c:yVal>
            <c:numRef>
              <c:f>Foglio6!$J$819:$J$1220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100</c:v>
                </c:pt>
                <c:pt idx="46">
                  <c:v>100</c:v>
                </c:pt>
                <c:pt idx="47">
                  <c:v>100</c:v>
                </c:pt>
                <c:pt idx="48">
                  <c:v>100</c:v>
                </c:pt>
                <c:pt idx="49">
                  <c:v>100</c:v>
                </c:pt>
                <c:pt idx="50">
                  <c:v>100</c:v>
                </c:pt>
                <c:pt idx="51">
                  <c:v>100</c:v>
                </c:pt>
                <c:pt idx="52">
                  <c:v>100</c:v>
                </c:pt>
                <c:pt idx="53">
                  <c:v>99.965000000000003</c:v>
                </c:pt>
                <c:pt idx="54">
                  <c:v>99.950999999999993</c:v>
                </c:pt>
                <c:pt idx="55">
                  <c:v>99.936999999999998</c:v>
                </c:pt>
                <c:pt idx="56">
                  <c:v>99.921999999999997</c:v>
                </c:pt>
                <c:pt idx="57">
                  <c:v>99.906999999999996</c:v>
                </c:pt>
                <c:pt idx="58">
                  <c:v>99.884</c:v>
                </c:pt>
                <c:pt idx="59">
                  <c:v>99.866</c:v>
                </c:pt>
                <c:pt idx="60">
                  <c:v>99.858000000000004</c:v>
                </c:pt>
                <c:pt idx="61">
                  <c:v>99.855000000000004</c:v>
                </c:pt>
                <c:pt idx="62">
                  <c:v>99.849000000000004</c:v>
                </c:pt>
                <c:pt idx="63">
                  <c:v>99.84</c:v>
                </c:pt>
                <c:pt idx="64">
                  <c:v>99.831000000000003</c:v>
                </c:pt>
                <c:pt idx="65">
                  <c:v>99.808000000000007</c:v>
                </c:pt>
                <c:pt idx="66">
                  <c:v>99.742000000000004</c:v>
                </c:pt>
                <c:pt idx="67">
                  <c:v>99.5</c:v>
                </c:pt>
                <c:pt idx="68">
                  <c:v>99.492999999999995</c:v>
                </c:pt>
                <c:pt idx="69">
                  <c:v>99.322999999999993</c:v>
                </c:pt>
                <c:pt idx="70">
                  <c:v>99.192999999999998</c:v>
                </c:pt>
                <c:pt idx="71">
                  <c:v>99.168999999999997</c:v>
                </c:pt>
                <c:pt idx="72">
                  <c:v>99.037999999999997</c:v>
                </c:pt>
                <c:pt idx="73">
                  <c:v>99</c:v>
                </c:pt>
                <c:pt idx="74">
                  <c:v>98.744</c:v>
                </c:pt>
                <c:pt idx="75">
                  <c:v>98.5</c:v>
                </c:pt>
                <c:pt idx="76">
                  <c:v>98.406000000000006</c:v>
                </c:pt>
                <c:pt idx="77">
                  <c:v>98.31</c:v>
                </c:pt>
                <c:pt idx="78">
                  <c:v>98.213999999999999</c:v>
                </c:pt>
                <c:pt idx="79">
                  <c:v>98.117999999999995</c:v>
                </c:pt>
                <c:pt idx="80">
                  <c:v>98</c:v>
                </c:pt>
                <c:pt idx="81">
                  <c:v>97.5</c:v>
                </c:pt>
                <c:pt idx="82">
                  <c:v>97</c:v>
                </c:pt>
                <c:pt idx="83">
                  <c:v>96.707999999999998</c:v>
                </c:pt>
                <c:pt idx="84">
                  <c:v>96.527000000000001</c:v>
                </c:pt>
                <c:pt idx="85">
                  <c:v>96.5</c:v>
                </c:pt>
                <c:pt idx="86">
                  <c:v>96.44</c:v>
                </c:pt>
                <c:pt idx="87">
                  <c:v>96.352999999999994</c:v>
                </c:pt>
                <c:pt idx="88">
                  <c:v>96</c:v>
                </c:pt>
                <c:pt idx="89">
                  <c:v>95.581999999999994</c:v>
                </c:pt>
                <c:pt idx="90">
                  <c:v>95.5</c:v>
                </c:pt>
                <c:pt idx="91">
                  <c:v>95.296999999999997</c:v>
                </c:pt>
                <c:pt idx="92">
                  <c:v>95</c:v>
                </c:pt>
                <c:pt idx="93">
                  <c:v>94.5</c:v>
                </c:pt>
                <c:pt idx="94">
                  <c:v>94.024000000000001</c:v>
                </c:pt>
                <c:pt idx="95">
                  <c:v>94</c:v>
                </c:pt>
                <c:pt idx="96">
                  <c:v>93.63</c:v>
                </c:pt>
                <c:pt idx="97">
                  <c:v>93.504000000000005</c:v>
                </c:pt>
                <c:pt idx="98">
                  <c:v>93.5</c:v>
                </c:pt>
                <c:pt idx="99">
                  <c:v>93.001000000000005</c:v>
                </c:pt>
                <c:pt idx="100">
                  <c:v>93</c:v>
                </c:pt>
                <c:pt idx="101">
                  <c:v>92.802000000000007</c:v>
                </c:pt>
                <c:pt idx="102">
                  <c:v>92.602000000000004</c:v>
                </c:pt>
                <c:pt idx="103">
                  <c:v>92.5</c:v>
                </c:pt>
                <c:pt idx="104">
                  <c:v>92.302999999999997</c:v>
                </c:pt>
                <c:pt idx="105">
                  <c:v>92</c:v>
                </c:pt>
                <c:pt idx="106">
                  <c:v>91.658000000000001</c:v>
                </c:pt>
                <c:pt idx="107">
                  <c:v>91.5</c:v>
                </c:pt>
                <c:pt idx="108">
                  <c:v>91</c:v>
                </c:pt>
                <c:pt idx="109">
                  <c:v>90.977000000000004</c:v>
                </c:pt>
                <c:pt idx="110">
                  <c:v>90.5</c:v>
                </c:pt>
                <c:pt idx="111">
                  <c:v>90.173000000000002</c:v>
                </c:pt>
                <c:pt idx="112">
                  <c:v>90</c:v>
                </c:pt>
                <c:pt idx="113">
                  <c:v>89.600999999999999</c:v>
                </c:pt>
                <c:pt idx="114">
                  <c:v>89.5</c:v>
                </c:pt>
                <c:pt idx="115">
                  <c:v>89</c:v>
                </c:pt>
                <c:pt idx="116">
                  <c:v>88.5</c:v>
                </c:pt>
                <c:pt idx="117">
                  <c:v>88</c:v>
                </c:pt>
                <c:pt idx="118">
                  <c:v>87.509</c:v>
                </c:pt>
                <c:pt idx="119">
                  <c:v>87.5</c:v>
                </c:pt>
                <c:pt idx="120">
                  <c:v>87</c:v>
                </c:pt>
                <c:pt idx="121">
                  <c:v>86.581999999999994</c:v>
                </c:pt>
                <c:pt idx="122">
                  <c:v>86.5</c:v>
                </c:pt>
                <c:pt idx="123">
                  <c:v>86</c:v>
                </c:pt>
                <c:pt idx="124">
                  <c:v>85.516000000000005</c:v>
                </c:pt>
                <c:pt idx="125">
                  <c:v>85.5</c:v>
                </c:pt>
                <c:pt idx="126">
                  <c:v>85</c:v>
                </c:pt>
                <c:pt idx="127">
                  <c:v>84.5</c:v>
                </c:pt>
                <c:pt idx="128">
                  <c:v>84.400999999999996</c:v>
                </c:pt>
                <c:pt idx="129">
                  <c:v>84.195999999999998</c:v>
                </c:pt>
                <c:pt idx="130">
                  <c:v>84</c:v>
                </c:pt>
                <c:pt idx="131">
                  <c:v>83.992999999999995</c:v>
                </c:pt>
                <c:pt idx="132">
                  <c:v>83.808999999999997</c:v>
                </c:pt>
                <c:pt idx="133">
                  <c:v>83.5</c:v>
                </c:pt>
                <c:pt idx="134">
                  <c:v>83</c:v>
                </c:pt>
                <c:pt idx="135">
                  <c:v>82.981999999999999</c:v>
                </c:pt>
                <c:pt idx="136">
                  <c:v>82.5</c:v>
                </c:pt>
                <c:pt idx="137">
                  <c:v>82</c:v>
                </c:pt>
                <c:pt idx="138">
                  <c:v>81.905000000000001</c:v>
                </c:pt>
                <c:pt idx="139">
                  <c:v>81.587999999999994</c:v>
                </c:pt>
                <c:pt idx="140">
                  <c:v>81.5</c:v>
                </c:pt>
                <c:pt idx="141">
                  <c:v>81.338999999999999</c:v>
                </c:pt>
                <c:pt idx="142">
                  <c:v>81.141000000000005</c:v>
                </c:pt>
                <c:pt idx="143">
                  <c:v>81</c:v>
                </c:pt>
                <c:pt idx="144">
                  <c:v>80.5</c:v>
                </c:pt>
                <c:pt idx="145">
                  <c:v>80</c:v>
                </c:pt>
                <c:pt idx="146">
                  <c:v>79.965000000000003</c:v>
                </c:pt>
                <c:pt idx="147">
                  <c:v>79.5</c:v>
                </c:pt>
                <c:pt idx="148">
                  <c:v>79</c:v>
                </c:pt>
                <c:pt idx="149">
                  <c:v>78.5</c:v>
                </c:pt>
                <c:pt idx="150">
                  <c:v>78</c:v>
                </c:pt>
                <c:pt idx="151">
                  <c:v>77.655000000000001</c:v>
                </c:pt>
                <c:pt idx="152">
                  <c:v>77.5</c:v>
                </c:pt>
                <c:pt idx="153">
                  <c:v>77</c:v>
                </c:pt>
                <c:pt idx="154">
                  <c:v>76.5</c:v>
                </c:pt>
                <c:pt idx="155">
                  <c:v>76</c:v>
                </c:pt>
                <c:pt idx="156">
                  <c:v>75.5</c:v>
                </c:pt>
                <c:pt idx="157">
                  <c:v>75</c:v>
                </c:pt>
                <c:pt idx="158">
                  <c:v>74.703999999999994</c:v>
                </c:pt>
                <c:pt idx="159">
                  <c:v>74.5</c:v>
                </c:pt>
                <c:pt idx="160">
                  <c:v>74</c:v>
                </c:pt>
                <c:pt idx="161">
                  <c:v>73.747</c:v>
                </c:pt>
                <c:pt idx="162">
                  <c:v>73.5</c:v>
                </c:pt>
                <c:pt idx="163">
                  <c:v>73.311999999999998</c:v>
                </c:pt>
                <c:pt idx="164">
                  <c:v>73</c:v>
                </c:pt>
                <c:pt idx="165">
                  <c:v>72.968000000000004</c:v>
                </c:pt>
                <c:pt idx="166">
                  <c:v>72.614999999999995</c:v>
                </c:pt>
                <c:pt idx="167">
                  <c:v>72.5</c:v>
                </c:pt>
                <c:pt idx="168">
                  <c:v>72</c:v>
                </c:pt>
                <c:pt idx="169">
                  <c:v>71.78</c:v>
                </c:pt>
                <c:pt idx="170">
                  <c:v>71.5</c:v>
                </c:pt>
                <c:pt idx="171">
                  <c:v>71.331000000000003</c:v>
                </c:pt>
                <c:pt idx="172">
                  <c:v>71</c:v>
                </c:pt>
                <c:pt idx="173">
                  <c:v>70.5</c:v>
                </c:pt>
                <c:pt idx="174">
                  <c:v>70</c:v>
                </c:pt>
                <c:pt idx="175">
                  <c:v>69.573999999999998</c:v>
                </c:pt>
                <c:pt idx="176">
                  <c:v>69.5</c:v>
                </c:pt>
                <c:pt idx="177">
                  <c:v>69</c:v>
                </c:pt>
                <c:pt idx="178">
                  <c:v>68.63</c:v>
                </c:pt>
                <c:pt idx="179">
                  <c:v>68.5</c:v>
                </c:pt>
                <c:pt idx="180">
                  <c:v>68</c:v>
                </c:pt>
                <c:pt idx="181">
                  <c:v>67.5</c:v>
                </c:pt>
                <c:pt idx="182">
                  <c:v>67.364000000000004</c:v>
                </c:pt>
                <c:pt idx="183">
                  <c:v>67</c:v>
                </c:pt>
                <c:pt idx="184">
                  <c:v>66.5</c:v>
                </c:pt>
                <c:pt idx="185">
                  <c:v>66.454999999999998</c:v>
                </c:pt>
                <c:pt idx="186">
                  <c:v>66</c:v>
                </c:pt>
                <c:pt idx="187">
                  <c:v>65.5</c:v>
                </c:pt>
                <c:pt idx="188">
                  <c:v>65</c:v>
                </c:pt>
                <c:pt idx="189">
                  <c:v>64.655000000000001</c:v>
                </c:pt>
                <c:pt idx="190">
                  <c:v>64.5</c:v>
                </c:pt>
                <c:pt idx="191">
                  <c:v>64</c:v>
                </c:pt>
                <c:pt idx="192">
                  <c:v>63.5</c:v>
                </c:pt>
                <c:pt idx="193">
                  <c:v>63.203000000000003</c:v>
                </c:pt>
                <c:pt idx="194">
                  <c:v>63</c:v>
                </c:pt>
                <c:pt idx="195">
                  <c:v>62.5</c:v>
                </c:pt>
                <c:pt idx="196">
                  <c:v>62</c:v>
                </c:pt>
                <c:pt idx="197">
                  <c:v>61.5</c:v>
                </c:pt>
                <c:pt idx="198">
                  <c:v>61.415999999999997</c:v>
                </c:pt>
                <c:pt idx="199">
                  <c:v>61</c:v>
                </c:pt>
                <c:pt idx="200">
                  <c:v>60.857999999999997</c:v>
                </c:pt>
                <c:pt idx="201">
                  <c:v>60.5</c:v>
                </c:pt>
                <c:pt idx="202">
                  <c:v>60.021999999999998</c:v>
                </c:pt>
                <c:pt idx="203">
                  <c:v>60</c:v>
                </c:pt>
                <c:pt idx="204">
                  <c:v>59.5</c:v>
                </c:pt>
                <c:pt idx="205">
                  <c:v>59.072000000000003</c:v>
                </c:pt>
                <c:pt idx="206">
                  <c:v>59</c:v>
                </c:pt>
                <c:pt idx="207">
                  <c:v>58.5</c:v>
                </c:pt>
                <c:pt idx="208">
                  <c:v>58</c:v>
                </c:pt>
                <c:pt idx="209">
                  <c:v>57.941000000000003</c:v>
                </c:pt>
                <c:pt idx="210">
                  <c:v>57.5</c:v>
                </c:pt>
                <c:pt idx="211">
                  <c:v>57.341999999999999</c:v>
                </c:pt>
                <c:pt idx="212">
                  <c:v>57</c:v>
                </c:pt>
                <c:pt idx="213">
                  <c:v>56.5</c:v>
                </c:pt>
                <c:pt idx="214">
                  <c:v>56.21</c:v>
                </c:pt>
                <c:pt idx="215">
                  <c:v>56</c:v>
                </c:pt>
                <c:pt idx="216">
                  <c:v>55.881</c:v>
                </c:pt>
                <c:pt idx="217">
                  <c:v>55.5</c:v>
                </c:pt>
                <c:pt idx="218">
                  <c:v>55</c:v>
                </c:pt>
                <c:pt idx="219">
                  <c:v>54.685000000000002</c:v>
                </c:pt>
                <c:pt idx="220">
                  <c:v>54.5</c:v>
                </c:pt>
                <c:pt idx="221">
                  <c:v>54</c:v>
                </c:pt>
                <c:pt idx="222">
                  <c:v>53.5</c:v>
                </c:pt>
                <c:pt idx="223">
                  <c:v>53</c:v>
                </c:pt>
                <c:pt idx="224">
                  <c:v>52.594000000000001</c:v>
                </c:pt>
                <c:pt idx="225">
                  <c:v>52.5</c:v>
                </c:pt>
                <c:pt idx="226">
                  <c:v>52.308999999999997</c:v>
                </c:pt>
                <c:pt idx="227">
                  <c:v>52.024000000000001</c:v>
                </c:pt>
                <c:pt idx="228">
                  <c:v>52</c:v>
                </c:pt>
                <c:pt idx="229">
                  <c:v>51.920999999999999</c:v>
                </c:pt>
                <c:pt idx="230">
                  <c:v>51.835999999999999</c:v>
                </c:pt>
                <c:pt idx="231">
                  <c:v>51.5</c:v>
                </c:pt>
                <c:pt idx="232">
                  <c:v>51</c:v>
                </c:pt>
                <c:pt idx="233">
                  <c:v>50.5</c:v>
                </c:pt>
                <c:pt idx="234">
                  <c:v>50</c:v>
                </c:pt>
                <c:pt idx="235">
                  <c:v>49.5</c:v>
                </c:pt>
                <c:pt idx="236">
                  <c:v>49.448</c:v>
                </c:pt>
                <c:pt idx="237">
                  <c:v>49</c:v>
                </c:pt>
                <c:pt idx="238">
                  <c:v>48.5</c:v>
                </c:pt>
                <c:pt idx="239">
                  <c:v>48</c:v>
                </c:pt>
                <c:pt idx="240">
                  <c:v>47.5</c:v>
                </c:pt>
                <c:pt idx="241">
                  <c:v>47</c:v>
                </c:pt>
                <c:pt idx="242">
                  <c:v>46.5</c:v>
                </c:pt>
                <c:pt idx="243">
                  <c:v>46</c:v>
                </c:pt>
                <c:pt idx="244">
                  <c:v>45.5</c:v>
                </c:pt>
                <c:pt idx="245">
                  <c:v>45.341999999999999</c:v>
                </c:pt>
                <c:pt idx="246">
                  <c:v>45</c:v>
                </c:pt>
                <c:pt idx="247">
                  <c:v>44.627000000000002</c:v>
                </c:pt>
                <c:pt idx="248">
                  <c:v>44.5</c:v>
                </c:pt>
                <c:pt idx="249">
                  <c:v>44.298000000000002</c:v>
                </c:pt>
                <c:pt idx="250">
                  <c:v>44</c:v>
                </c:pt>
                <c:pt idx="251">
                  <c:v>43.968000000000004</c:v>
                </c:pt>
                <c:pt idx="252">
                  <c:v>43.5</c:v>
                </c:pt>
                <c:pt idx="253">
                  <c:v>43</c:v>
                </c:pt>
                <c:pt idx="254">
                  <c:v>42.5</c:v>
                </c:pt>
                <c:pt idx="255">
                  <c:v>42.332999999999998</c:v>
                </c:pt>
                <c:pt idx="256">
                  <c:v>42</c:v>
                </c:pt>
                <c:pt idx="257">
                  <c:v>41.5</c:v>
                </c:pt>
                <c:pt idx="258">
                  <c:v>41</c:v>
                </c:pt>
                <c:pt idx="259">
                  <c:v>40.5</c:v>
                </c:pt>
                <c:pt idx="260">
                  <c:v>40.28</c:v>
                </c:pt>
                <c:pt idx="261">
                  <c:v>40</c:v>
                </c:pt>
                <c:pt idx="262">
                  <c:v>39.5</c:v>
                </c:pt>
                <c:pt idx="263">
                  <c:v>39</c:v>
                </c:pt>
                <c:pt idx="264">
                  <c:v>38.869</c:v>
                </c:pt>
                <c:pt idx="265">
                  <c:v>38.5</c:v>
                </c:pt>
                <c:pt idx="266">
                  <c:v>38</c:v>
                </c:pt>
                <c:pt idx="267">
                  <c:v>37.692</c:v>
                </c:pt>
                <c:pt idx="268">
                  <c:v>37.5</c:v>
                </c:pt>
                <c:pt idx="269">
                  <c:v>37</c:v>
                </c:pt>
                <c:pt idx="270">
                  <c:v>36.5</c:v>
                </c:pt>
                <c:pt idx="271">
                  <c:v>36.216000000000001</c:v>
                </c:pt>
                <c:pt idx="272">
                  <c:v>36</c:v>
                </c:pt>
                <c:pt idx="273">
                  <c:v>35.5</c:v>
                </c:pt>
                <c:pt idx="274">
                  <c:v>35</c:v>
                </c:pt>
                <c:pt idx="275">
                  <c:v>34.866</c:v>
                </c:pt>
                <c:pt idx="276">
                  <c:v>34.5</c:v>
                </c:pt>
                <c:pt idx="277">
                  <c:v>34.277999999999999</c:v>
                </c:pt>
                <c:pt idx="278">
                  <c:v>34</c:v>
                </c:pt>
                <c:pt idx="279">
                  <c:v>33.5</c:v>
                </c:pt>
                <c:pt idx="280">
                  <c:v>33</c:v>
                </c:pt>
                <c:pt idx="281">
                  <c:v>32.719000000000001</c:v>
                </c:pt>
                <c:pt idx="282">
                  <c:v>32.5</c:v>
                </c:pt>
                <c:pt idx="283">
                  <c:v>32</c:v>
                </c:pt>
                <c:pt idx="284">
                  <c:v>31.5</c:v>
                </c:pt>
                <c:pt idx="285">
                  <c:v>31</c:v>
                </c:pt>
                <c:pt idx="286">
                  <c:v>30.922999999999998</c:v>
                </c:pt>
                <c:pt idx="287">
                  <c:v>30.600999999999999</c:v>
                </c:pt>
                <c:pt idx="288">
                  <c:v>30.5</c:v>
                </c:pt>
                <c:pt idx="289">
                  <c:v>30</c:v>
                </c:pt>
                <c:pt idx="290">
                  <c:v>29.5</c:v>
                </c:pt>
                <c:pt idx="291">
                  <c:v>29.436</c:v>
                </c:pt>
                <c:pt idx="292">
                  <c:v>29.108000000000001</c:v>
                </c:pt>
                <c:pt idx="293">
                  <c:v>29</c:v>
                </c:pt>
                <c:pt idx="294">
                  <c:v>28.600999999999999</c:v>
                </c:pt>
                <c:pt idx="295">
                  <c:v>28.5</c:v>
                </c:pt>
                <c:pt idx="296">
                  <c:v>28</c:v>
                </c:pt>
                <c:pt idx="297">
                  <c:v>27.5</c:v>
                </c:pt>
                <c:pt idx="298">
                  <c:v>27.117000000000001</c:v>
                </c:pt>
                <c:pt idx="299">
                  <c:v>27</c:v>
                </c:pt>
                <c:pt idx="300">
                  <c:v>26.806999999999999</c:v>
                </c:pt>
                <c:pt idx="301">
                  <c:v>26.5</c:v>
                </c:pt>
                <c:pt idx="302">
                  <c:v>26</c:v>
                </c:pt>
                <c:pt idx="303">
                  <c:v>25.5</c:v>
                </c:pt>
                <c:pt idx="304">
                  <c:v>25.056000000000001</c:v>
                </c:pt>
                <c:pt idx="305">
                  <c:v>25</c:v>
                </c:pt>
                <c:pt idx="306">
                  <c:v>24.5</c:v>
                </c:pt>
                <c:pt idx="307">
                  <c:v>24</c:v>
                </c:pt>
                <c:pt idx="308">
                  <c:v>23.62</c:v>
                </c:pt>
                <c:pt idx="309">
                  <c:v>23.5</c:v>
                </c:pt>
                <c:pt idx="310">
                  <c:v>23</c:v>
                </c:pt>
                <c:pt idx="311">
                  <c:v>22.5</c:v>
                </c:pt>
                <c:pt idx="312">
                  <c:v>22</c:v>
                </c:pt>
                <c:pt idx="313">
                  <c:v>21.835999999999999</c:v>
                </c:pt>
                <c:pt idx="314">
                  <c:v>21.5</c:v>
                </c:pt>
                <c:pt idx="315">
                  <c:v>21</c:v>
                </c:pt>
                <c:pt idx="316">
                  <c:v>20.5</c:v>
                </c:pt>
                <c:pt idx="317">
                  <c:v>20.478999999999999</c:v>
                </c:pt>
                <c:pt idx="318">
                  <c:v>20</c:v>
                </c:pt>
                <c:pt idx="319">
                  <c:v>19.5</c:v>
                </c:pt>
                <c:pt idx="320">
                  <c:v>19</c:v>
                </c:pt>
                <c:pt idx="321">
                  <c:v>18.738</c:v>
                </c:pt>
                <c:pt idx="322">
                  <c:v>18.5</c:v>
                </c:pt>
                <c:pt idx="323">
                  <c:v>18</c:v>
                </c:pt>
                <c:pt idx="324">
                  <c:v>17.5</c:v>
                </c:pt>
                <c:pt idx="325">
                  <c:v>17.248000000000001</c:v>
                </c:pt>
                <c:pt idx="326">
                  <c:v>17</c:v>
                </c:pt>
                <c:pt idx="327">
                  <c:v>16.523</c:v>
                </c:pt>
                <c:pt idx="328">
                  <c:v>16.5</c:v>
                </c:pt>
                <c:pt idx="329">
                  <c:v>16.324000000000002</c:v>
                </c:pt>
                <c:pt idx="330">
                  <c:v>16.158999999999999</c:v>
                </c:pt>
                <c:pt idx="331">
                  <c:v>16.039000000000001</c:v>
                </c:pt>
                <c:pt idx="332">
                  <c:v>16</c:v>
                </c:pt>
                <c:pt idx="333">
                  <c:v>15.919</c:v>
                </c:pt>
                <c:pt idx="334">
                  <c:v>15.75</c:v>
                </c:pt>
                <c:pt idx="335">
                  <c:v>15.5</c:v>
                </c:pt>
                <c:pt idx="336">
                  <c:v>15.425000000000001</c:v>
                </c:pt>
                <c:pt idx="337">
                  <c:v>15.137</c:v>
                </c:pt>
                <c:pt idx="338">
                  <c:v>15</c:v>
                </c:pt>
                <c:pt idx="339">
                  <c:v>14.5</c:v>
                </c:pt>
                <c:pt idx="340">
                  <c:v>14.430999999999999</c:v>
                </c:pt>
                <c:pt idx="341">
                  <c:v>14</c:v>
                </c:pt>
                <c:pt idx="342">
                  <c:v>13.5</c:v>
                </c:pt>
                <c:pt idx="343">
                  <c:v>13.256</c:v>
                </c:pt>
                <c:pt idx="344">
                  <c:v>13</c:v>
                </c:pt>
                <c:pt idx="345">
                  <c:v>12.5</c:v>
                </c:pt>
                <c:pt idx="346">
                  <c:v>12</c:v>
                </c:pt>
                <c:pt idx="347">
                  <c:v>11.5</c:v>
                </c:pt>
                <c:pt idx="348">
                  <c:v>11</c:v>
                </c:pt>
                <c:pt idx="349">
                  <c:v>10.589</c:v>
                </c:pt>
                <c:pt idx="350">
                  <c:v>10.5</c:v>
                </c:pt>
                <c:pt idx="351">
                  <c:v>10</c:v>
                </c:pt>
                <c:pt idx="352">
                  <c:v>9.5</c:v>
                </c:pt>
                <c:pt idx="353">
                  <c:v>9</c:v>
                </c:pt>
                <c:pt idx="354">
                  <c:v>8.5</c:v>
                </c:pt>
                <c:pt idx="355">
                  <c:v>8.234</c:v>
                </c:pt>
                <c:pt idx="356">
                  <c:v>8</c:v>
                </c:pt>
                <c:pt idx="357">
                  <c:v>7.7859999999999996</c:v>
                </c:pt>
                <c:pt idx="358">
                  <c:v>7.5</c:v>
                </c:pt>
                <c:pt idx="359">
                  <c:v>7.2519999999999998</c:v>
                </c:pt>
                <c:pt idx="360">
                  <c:v>7</c:v>
                </c:pt>
                <c:pt idx="361">
                  <c:v>6.6260000000000003</c:v>
                </c:pt>
                <c:pt idx="362">
                  <c:v>6.5</c:v>
                </c:pt>
                <c:pt idx="363">
                  <c:v>6.0339999999999998</c:v>
                </c:pt>
                <c:pt idx="364">
                  <c:v>6</c:v>
                </c:pt>
                <c:pt idx="365">
                  <c:v>5.6459999999999999</c:v>
                </c:pt>
                <c:pt idx="366">
                  <c:v>5.5</c:v>
                </c:pt>
                <c:pt idx="367">
                  <c:v>5.4080000000000004</c:v>
                </c:pt>
                <c:pt idx="368">
                  <c:v>5.2309999999999999</c:v>
                </c:pt>
                <c:pt idx="369">
                  <c:v>5.1130000000000004</c:v>
                </c:pt>
                <c:pt idx="370">
                  <c:v>5</c:v>
                </c:pt>
                <c:pt idx="371">
                  <c:v>4.9939999999999998</c:v>
                </c:pt>
                <c:pt idx="372">
                  <c:v>4.835</c:v>
                </c:pt>
                <c:pt idx="373">
                  <c:v>4.5</c:v>
                </c:pt>
                <c:pt idx="374">
                  <c:v>4.1710000000000003</c:v>
                </c:pt>
                <c:pt idx="375">
                  <c:v>4</c:v>
                </c:pt>
                <c:pt idx="376">
                  <c:v>3.7160000000000002</c:v>
                </c:pt>
                <c:pt idx="377">
                  <c:v>3.5</c:v>
                </c:pt>
                <c:pt idx="378">
                  <c:v>3.2709999999999999</c:v>
                </c:pt>
                <c:pt idx="379">
                  <c:v>3</c:v>
                </c:pt>
                <c:pt idx="380">
                  <c:v>2.5</c:v>
                </c:pt>
                <c:pt idx="381">
                  <c:v>2.4780000000000002</c:v>
                </c:pt>
                <c:pt idx="382">
                  <c:v>2</c:v>
                </c:pt>
                <c:pt idx="383">
                  <c:v>1.7430000000000001</c:v>
                </c:pt>
                <c:pt idx="384">
                  <c:v>1.5</c:v>
                </c:pt>
                <c:pt idx="385">
                  <c:v>1.4339999999999999</c:v>
                </c:pt>
                <c:pt idx="386">
                  <c:v>1.125</c:v>
                </c:pt>
                <c:pt idx="387">
                  <c:v>1</c:v>
                </c:pt>
                <c:pt idx="388">
                  <c:v>0.85699999999999998</c:v>
                </c:pt>
                <c:pt idx="389">
                  <c:v>0.68400000000000005</c:v>
                </c:pt>
                <c:pt idx="390">
                  <c:v>0.51200000000000001</c:v>
                </c:pt>
                <c:pt idx="391">
                  <c:v>0.5</c:v>
                </c:pt>
                <c:pt idx="392">
                  <c:v>0.38</c:v>
                </c:pt>
                <c:pt idx="393">
                  <c:v>0.34200000000000003</c:v>
                </c:pt>
                <c:pt idx="394">
                  <c:v>0.30299999999999999</c:v>
                </c:pt>
                <c:pt idx="395">
                  <c:v>0.22800000000000001</c:v>
                </c:pt>
                <c:pt idx="396">
                  <c:v>0.19600000000000001</c:v>
                </c:pt>
                <c:pt idx="397">
                  <c:v>0.16800000000000001</c:v>
                </c:pt>
                <c:pt idx="398">
                  <c:v>0.13900000000000001</c:v>
                </c:pt>
                <c:pt idx="399">
                  <c:v>0.111</c:v>
                </c:pt>
                <c:pt idx="400">
                  <c:v>8.3000000000000004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496-4CC3-8534-400DC70DE595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K$819:$K$1220</c:f>
              <c:numCache>
                <c:formatCode>General</c:formatCode>
                <c:ptCount val="402"/>
                <c:pt idx="0">
                  <c:v>0</c:v>
                </c:pt>
                <c:pt idx="1">
                  <c:v>5.6180000000000003</c:v>
                </c:pt>
                <c:pt idx="2">
                  <c:v>11.236000000000001</c:v>
                </c:pt>
                <c:pt idx="3">
                  <c:v>16.853000000000002</c:v>
                </c:pt>
                <c:pt idx="4">
                  <c:v>22.471</c:v>
                </c:pt>
                <c:pt idx="5">
                  <c:v>28.088999999999999</c:v>
                </c:pt>
                <c:pt idx="6">
                  <c:v>33.707000000000001</c:v>
                </c:pt>
                <c:pt idx="7">
                  <c:v>39.325000000000003</c:v>
                </c:pt>
                <c:pt idx="8">
                  <c:v>44.942</c:v>
                </c:pt>
                <c:pt idx="9">
                  <c:v>50.56</c:v>
                </c:pt>
                <c:pt idx="10">
                  <c:v>56.177999999999997</c:v>
                </c:pt>
                <c:pt idx="11">
                  <c:v>61.795999999999999</c:v>
                </c:pt>
                <c:pt idx="12">
                  <c:v>67.414000000000001</c:v>
                </c:pt>
                <c:pt idx="13">
                  <c:v>73.031000000000006</c:v>
                </c:pt>
                <c:pt idx="14">
                  <c:v>78.649000000000001</c:v>
                </c:pt>
                <c:pt idx="15">
                  <c:v>84.266999999999996</c:v>
                </c:pt>
                <c:pt idx="16">
                  <c:v>89.885000000000005</c:v>
                </c:pt>
                <c:pt idx="17">
                  <c:v>95.503</c:v>
                </c:pt>
                <c:pt idx="18">
                  <c:v>101.12</c:v>
                </c:pt>
                <c:pt idx="19">
                  <c:v>106.738</c:v>
                </c:pt>
                <c:pt idx="20">
                  <c:v>112.35599999999999</c:v>
                </c:pt>
                <c:pt idx="21">
                  <c:v>117.974</c:v>
                </c:pt>
                <c:pt idx="22">
                  <c:v>123.592</c:v>
                </c:pt>
                <c:pt idx="23">
                  <c:v>129.209</c:v>
                </c:pt>
                <c:pt idx="24">
                  <c:v>134.827</c:v>
                </c:pt>
                <c:pt idx="25">
                  <c:v>140.44499999999999</c:v>
                </c:pt>
                <c:pt idx="26">
                  <c:v>146.06299999999999</c:v>
                </c:pt>
                <c:pt idx="27">
                  <c:v>151.68100000000001</c:v>
                </c:pt>
                <c:pt idx="28">
                  <c:v>157.298</c:v>
                </c:pt>
                <c:pt idx="29">
                  <c:v>162.916</c:v>
                </c:pt>
                <c:pt idx="30">
                  <c:v>168.53399999999999</c:v>
                </c:pt>
                <c:pt idx="31">
                  <c:v>174.15199999999999</c:v>
                </c:pt>
                <c:pt idx="32">
                  <c:v>179.77</c:v>
                </c:pt>
                <c:pt idx="33">
                  <c:v>185.387</c:v>
                </c:pt>
                <c:pt idx="34">
                  <c:v>191.005</c:v>
                </c:pt>
                <c:pt idx="35">
                  <c:v>196.62299999999999</c:v>
                </c:pt>
                <c:pt idx="36">
                  <c:v>202.24100000000001</c:v>
                </c:pt>
                <c:pt idx="37">
                  <c:v>207.85900000000001</c:v>
                </c:pt>
                <c:pt idx="38">
                  <c:v>213.477</c:v>
                </c:pt>
                <c:pt idx="39">
                  <c:v>213.959</c:v>
                </c:pt>
                <c:pt idx="40">
                  <c:v>219.09399999999999</c:v>
                </c:pt>
                <c:pt idx="41">
                  <c:v>224.71199999999999</c:v>
                </c:pt>
                <c:pt idx="42">
                  <c:v>230.33</c:v>
                </c:pt>
                <c:pt idx="43">
                  <c:v>235.94800000000001</c:v>
                </c:pt>
                <c:pt idx="44">
                  <c:v>241.566</c:v>
                </c:pt>
                <c:pt idx="45">
                  <c:v>247.18299999999999</c:v>
                </c:pt>
                <c:pt idx="46">
                  <c:v>252.80099999999999</c:v>
                </c:pt>
                <c:pt idx="47">
                  <c:v>258.41899999999998</c:v>
                </c:pt>
                <c:pt idx="48">
                  <c:v>264.03699999999998</c:v>
                </c:pt>
                <c:pt idx="49">
                  <c:v>269.65499999999997</c:v>
                </c:pt>
                <c:pt idx="50">
                  <c:v>275.27199999999999</c:v>
                </c:pt>
                <c:pt idx="51">
                  <c:v>277.77800000000002</c:v>
                </c:pt>
                <c:pt idx="52">
                  <c:v>280.89</c:v>
                </c:pt>
                <c:pt idx="53">
                  <c:v>286.50799999999998</c:v>
                </c:pt>
                <c:pt idx="54">
                  <c:v>288.46100000000001</c:v>
                </c:pt>
                <c:pt idx="55">
                  <c:v>292.12599999999998</c:v>
                </c:pt>
                <c:pt idx="56">
                  <c:v>297.74400000000003</c:v>
                </c:pt>
                <c:pt idx="57">
                  <c:v>301.51100000000002</c:v>
                </c:pt>
                <c:pt idx="58">
                  <c:v>303.36099999999999</c:v>
                </c:pt>
                <c:pt idx="59">
                  <c:v>308.97899999999998</c:v>
                </c:pt>
                <c:pt idx="60">
                  <c:v>309.18299999999999</c:v>
                </c:pt>
                <c:pt idx="61">
                  <c:v>313.23200000000003</c:v>
                </c:pt>
                <c:pt idx="62">
                  <c:v>314.59699999999998</c:v>
                </c:pt>
                <c:pt idx="63">
                  <c:v>314.89400000000001</c:v>
                </c:pt>
                <c:pt idx="64">
                  <c:v>315.23200000000003</c:v>
                </c:pt>
                <c:pt idx="65">
                  <c:v>316.24299999999999</c:v>
                </c:pt>
                <c:pt idx="66">
                  <c:v>320.21499999999997</c:v>
                </c:pt>
                <c:pt idx="67">
                  <c:v>323.16300000000001</c:v>
                </c:pt>
                <c:pt idx="68">
                  <c:v>325.05799999999999</c:v>
                </c:pt>
                <c:pt idx="69">
                  <c:v>325.83300000000003</c:v>
                </c:pt>
                <c:pt idx="70">
                  <c:v>331.45</c:v>
                </c:pt>
                <c:pt idx="71">
                  <c:v>335.74700000000001</c:v>
                </c:pt>
                <c:pt idx="72">
                  <c:v>337.06799999999998</c:v>
                </c:pt>
                <c:pt idx="73">
                  <c:v>341.50299999999999</c:v>
                </c:pt>
                <c:pt idx="74">
                  <c:v>342.68599999999998</c:v>
                </c:pt>
                <c:pt idx="75">
                  <c:v>343.899</c:v>
                </c:pt>
                <c:pt idx="76">
                  <c:v>348.30399999999997</c:v>
                </c:pt>
                <c:pt idx="77">
                  <c:v>348.36399999999998</c:v>
                </c:pt>
                <c:pt idx="78">
                  <c:v>353.92200000000003</c:v>
                </c:pt>
                <c:pt idx="79">
                  <c:v>356.637</c:v>
                </c:pt>
                <c:pt idx="80">
                  <c:v>357.726</c:v>
                </c:pt>
                <c:pt idx="81">
                  <c:v>359.53899999999999</c:v>
                </c:pt>
                <c:pt idx="82">
                  <c:v>363.85500000000002</c:v>
                </c:pt>
                <c:pt idx="83">
                  <c:v>365.15699999999998</c:v>
                </c:pt>
                <c:pt idx="84">
                  <c:v>370.77499999999998</c:v>
                </c:pt>
                <c:pt idx="85">
                  <c:v>372.23500000000001</c:v>
                </c:pt>
                <c:pt idx="86">
                  <c:v>376.39299999999997</c:v>
                </c:pt>
                <c:pt idx="87">
                  <c:v>379.34</c:v>
                </c:pt>
                <c:pt idx="88">
                  <c:v>382.01100000000002</c:v>
                </c:pt>
                <c:pt idx="89">
                  <c:v>382.29899999999998</c:v>
                </c:pt>
                <c:pt idx="90">
                  <c:v>382.34699999999998</c:v>
                </c:pt>
                <c:pt idx="91">
                  <c:v>383.87099999999998</c:v>
                </c:pt>
                <c:pt idx="92">
                  <c:v>386.03399999999999</c:v>
                </c:pt>
                <c:pt idx="93">
                  <c:v>386.202</c:v>
                </c:pt>
                <c:pt idx="94">
                  <c:v>387.32600000000002</c:v>
                </c:pt>
                <c:pt idx="95">
                  <c:v>387.62799999999999</c:v>
                </c:pt>
                <c:pt idx="96">
                  <c:v>389.21499999999997</c:v>
                </c:pt>
                <c:pt idx="97">
                  <c:v>393.24599999999998</c:v>
                </c:pt>
                <c:pt idx="98">
                  <c:v>397.80900000000003</c:v>
                </c:pt>
                <c:pt idx="99">
                  <c:v>398.44</c:v>
                </c:pt>
                <c:pt idx="100">
                  <c:v>398.86399999999998</c:v>
                </c:pt>
                <c:pt idx="101">
                  <c:v>399.726</c:v>
                </c:pt>
                <c:pt idx="102">
                  <c:v>401.23</c:v>
                </c:pt>
                <c:pt idx="103">
                  <c:v>403.54399999999998</c:v>
                </c:pt>
                <c:pt idx="104">
                  <c:v>404.48200000000003</c:v>
                </c:pt>
                <c:pt idx="105">
                  <c:v>407.02</c:v>
                </c:pt>
                <c:pt idx="106">
                  <c:v>410.1</c:v>
                </c:pt>
                <c:pt idx="107">
                  <c:v>410.25799999999998</c:v>
                </c:pt>
                <c:pt idx="108">
                  <c:v>410.41</c:v>
                </c:pt>
                <c:pt idx="109">
                  <c:v>410.56200000000001</c:v>
                </c:pt>
                <c:pt idx="110">
                  <c:v>412.71300000000002</c:v>
                </c:pt>
                <c:pt idx="111">
                  <c:v>415.71699999999998</c:v>
                </c:pt>
                <c:pt idx="112">
                  <c:v>421.334</c:v>
                </c:pt>
                <c:pt idx="113">
                  <c:v>421.33499999999998</c:v>
                </c:pt>
                <c:pt idx="114">
                  <c:v>423.59800000000001</c:v>
                </c:pt>
                <c:pt idx="115">
                  <c:v>426.327</c:v>
                </c:pt>
                <c:pt idx="116">
                  <c:v>426.95299999999997</c:v>
                </c:pt>
                <c:pt idx="117">
                  <c:v>429.88799999999998</c:v>
                </c:pt>
                <c:pt idx="118">
                  <c:v>430.21499999999997</c:v>
                </c:pt>
                <c:pt idx="119">
                  <c:v>432.57100000000003</c:v>
                </c:pt>
                <c:pt idx="120">
                  <c:v>438.18900000000002</c:v>
                </c:pt>
                <c:pt idx="121">
                  <c:v>440.73200000000003</c:v>
                </c:pt>
                <c:pt idx="122">
                  <c:v>441.41199999999998</c:v>
                </c:pt>
                <c:pt idx="123">
                  <c:v>442.01799999999997</c:v>
                </c:pt>
                <c:pt idx="124">
                  <c:v>442.04500000000002</c:v>
                </c:pt>
                <c:pt idx="125">
                  <c:v>443.80599999999998</c:v>
                </c:pt>
                <c:pt idx="126">
                  <c:v>449.33800000000002</c:v>
                </c:pt>
                <c:pt idx="127">
                  <c:v>449.42399999999998</c:v>
                </c:pt>
                <c:pt idx="128">
                  <c:v>455.04199999999997</c:v>
                </c:pt>
                <c:pt idx="129">
                  <c:v>455.55</c:v>
                </c:pt>
                <c:pt idx="130">
                  <c:v>459.43400000000003</c:v>
                </c:pt>
                <c:pt idx="131">
                  <c:v>460.24</c:v>
                </c:pt>
                <c:pt idx="132">
                  <c:v>460.66</c:v>
                </c:pt>
                <c:pt idx="133">
                  <c:v>461.29700000000003</c:v>
                </c:pt>
                <c:pt idx="134">
                  <c:v>464.04700000000003</c:v>
                </c:pt>
                <c:pt idx="135">
                  <c:v>466.27800000000002</c:v>
                </c:pt>
                <c:pt idx="136">
                  <c:v>466.79700000000003</c:v>
                </c:pt>
                <c:pt idx="137">
                  <c:v>468.25299999999999</c:v>
                </c:pt>
                <c:pt idx="138">
                  <c:v>469.363</c:v>
                </c:pt>
                <c:pt idx="139">
                  <c:v>471.89499999999998</c:v>
                </c:pt>
                <c:pt idx="140">
                  <c:v>472.27699999999999</c:v>
                </c:pt>
                <c:pt idx="141">
                  <c:v>475.077</c:v>
                </c:pt>
                <c:pt idx="142">
                  <c:v>476.30599999999998</c:v>
                </c:pt>
                <c:pt idx="143">
                  <c:v>476.71499999999997</c:v>
                </c:pt>
                <c:pt idx="144">
                  <c:v>477.51299999999998</c:v>
                </c:pt>
                <c:pt idx="145">
                  <c:v>479.73099999999999</c:v>
                </c:pt>
                <c:pt idx="146">
                  <c:v>483.13099999999997</c:v>
                </c:pt>
                <c:pt idx="147">
                  <c:v>483.15100000000001</c:v>
                </c:pt>
                <c:pt idx="148">
                  <c:v>487.7</c:v>
                </c:pt>
                <c:pt idx="149">
                  <c:v>488.74900000000002</c:v>
                </c:pt>
                <c:pt idx="150">
                  <c:v>490.96899999999999</c:v>
                </c:pt>
                <c:pt idx="151">
                  <c:v>492.86900000000003</c:v>
                </c:pt>
                <c:pt idx="152">
                  <c:v>494.36700000000002</c:v>
                </c:pt>
                <c:pt idx="153">
                  <c:v>495.142</c:v>
                </c:pt>
                <c:pt idx="154">
                  <c:v>498.32299999999998</c:v>
                </c:pt>
                <c:pt idx="155">
                  <c:v>499.98399999999998</c:v>
                </c:pt>
                <c:pt idx="156">
                  <c:v>501.67200000000003</c:v>
                </c:pt>
                <c:pt idx="157">
                  <c:v>503.79899999999998</c:v>
                </c:pt>
                <c:pt idx="158">
                  <c:v>504.64100000000002</c:v>
                </c:pt>
                <c:pt idx="159">
                  <c:v>505.60199999999998</c:v>
                </c:pt>
                <c:pt idx="160">
                  <c:v>506.55700000000002</c:v>
                </c:pt>
                <c:pt idx="161">
                  <c:v>508.47300000000001</c:v>
                </c:pt>
                <c:pt idx="162">
                  <c:v>510.875</c:v>
                </c:pt>
                <c:pt idx="163">
                  <c:v>511.22</c:v>
                </c:pt>
                <c:pt idx="164">
                  <c:v>513.35299999999995</c:v>
                </c:pt>
                <c:pt idx="165">
                  <c:v>515.59799999999996</c:v>
                </c:pt>
                <c:pt idx="166">
                  <c:v>516.83799999999997</c:v>
                </c:pt>
                <c:pt idx="167">
                  <c:v>517.63499999999999</c:v>
                </c:pt>
                <c:pt idx="168">
                  <c:v>519.86400000000003</c:v>
                </c:pt>
                <c:pt idx="169">
                  <c:v>522.30600000000004</c:v>
                </c:pt>
                <c:pt idx="170">
                  <c:v>522.45600000000002</c:v>
                </c:pt>
                <c:pt idx="171">
                  <c:v>523.49599999999998</c:v>
                </c:pt>
                <c:pt idx="172">
                  <c:v>524.38900000000001</c:v>
                </c:pt>
                <c:pt idx="173">
                  <c:v>524.66200000000003</c:v>
                </c:pt>
                <c:pt idx="174">
                  <c:v>528.07299999999998</c:v>
                </c:pt>
                <c:pt idx="175">
                  <c:v>528.66800000000001</c:v>
                </c:pt>
                <c:pt idx="176">
                  <c:v>531.74300000000005</c:v>
                </c:pt>
                <c:pt idx="177">
                  <c:v>533.54499999999996</c:v>
                </c:pt>
                <c:pt idx="178">
                  <c:v>533.69100000000003</c:v>
                </c:pt>
                <c:pt idx="179">
                  <c:v>534.00099999999998</c:v>
                </c:pt>
                <c:pt idx="180">
                  <c:v>534.45699999999999</c:v>
                </c:pt>
                <c:pt idx="181">
                  <c:v>538.59199999999998</c:v>
                </c:pt>
                <c:pt idx="182">
                  <c:v>539.30899999999997</c:v>
                </c:pt>
                <c:pt idx="183">
                  <c:v>542.55399999999997</c:v>
                </c:pt>
                <c:pt idx="184">
                  <c:v>544.92700000000002</c:v>
                </c:pt>
                <c:pt idx="185">
                  <c:v>545.85299999999995</c:v>
                </c:pt>
                <c:pt idx="186">
                  <c:v>550.54499999999996</c:v>
                </c:pt>
                <c:pt idx="187">
                  <c:v>550.90499999999997</c:v>
                </c:pt>
                <c:pt idx="188">
                  <c:v>556.16200000000003</c:v>
                </c:pt>
                <c:pt idx="189">
                  <c:v>561.00800000000004</c:v>
                </c:pt>
                <c:pt idx="190">
                  <c:v>561.36800000000005</c:v>
                </c:pt>
                <c:pt idx="191">
                  <c:v>561.78</c:v>
                </c:pt>
                <c:pt idx="192">
                  <c:v>563.55999999999995</c:v>
                </c:pt>
                <c:pt idx="193">
                  <c:v>566.1</c:v>
                </c:pt>
                <c:pt idx="194">
                  <c:v>567.09199999999998</c:v>
                </c:pt>
                <c:pt idx="195">
                  <c:v>567.39800000000002</c:v>
                </c:pt>
                <c:pt idx="196">
                  <c:v>568.52</c:v>
                </c:pt>
                <c:pt idx="197">
                  <c:v>570.04899999999998</c:v>
                </c:pt>
                <c:pt idx="198">
                  <c:v>570.79399999999998</c:v>
                </c:pt>
                <c:pt idx="199">
                  <c:v>571.53800000000001</c:v>
                </c:pt>
                <c:pt idx="200">
                  <c:v>573.01599999999996</c:v>
                </c:pt>
                <c:pt idx="201">
                  <c:v>574.39400000000001</c:v>
                </c:pt>
                <c:pt idx="202">
                  <c:v>578.63400000000001</c:v>
                </c:pt>
                <c:pt idx="203">
                  <c:v>579.69600000000003</c:v>
                </c:pt>
                <c:pt idx="204">
                  <c:v>584.18399999999997</c:v>
                </c:pt>
                <c:pt idx="205">
                  <c:v>584.25099999999998</c:v>
                </c:pt>
                <c:pt idx="206">
                  <c:v>585.12599999999998</c:v>
                </c:pt>
                <c:pt idx="207">
                  <c:v>586.74599999999998</c:v>
                </c:pt>
                <c:pt idx="208">
                  <c:v>589.86900000000003</c:v>
                </c:pt>
                <c:pt idx="209">
                  <c:v>590.35699999999997</c:v>
                </c:pt>
                <c:pt idx="210">
                  <c:v>593.34199999999998</c:v>
                </c:pt>
                <c:pt idx="211">
                  <c:v>594.09500000000003</c:v>
                </c:pt>
                <c:pt idx="212">
                  <c:v>595.29100000000005</c:v>
                </c:pt>
                <c:pt idx="213">
                  <c:v>595.48699999999997</c:v>
                </c:pt>
                <c:pt idx="214">
                  <c:v>598.85799999999995</c:v>
                </c:pt>
                <c:pt idx="215">
                  <c:v>601.10500000000002</c:v>
                </c:pt>
                <c:pt idx="216">
                  <c:v>602.30799999999999</c:v>
                </c:pt>
                <c:pt idx="217">
                  <c:v>605.57500000000005</c:v>
                </c:pt>
                <c:pt idx="218">
                  <c:v>606.649</c:v>
                </c:pt>
                <c:pt idx="219">
                  <c:v>606.72299999999996</c:v>
                </c:pt>
                <c:pt idx="220">
                  <c:v>607.34900000000005</c:v>
                </c:pt>
                <c:pt idx="221">
                  <c:v>608.49300000000005</c:v>
                </c:pt>
                <c:pt idx="222">
                  <c:v>609.702</c:v>
                </c:pt>
                <c:pt idx="223">
                  <c:v>610.53</c:v>
                </c:pt>
                <c:pt idx="224">
                  <c:v>611.02200000000005</c:v>
                </c:pt>
                <c:pt idx="225">
                  <c:v>611.56100000000004</c:v>
                </c:pt>
                <c:pt idx="226">
                  <c:v>612.29399999999998</c:v>
                </c:pt>
                <c:pt idx="227">
                  <c:v>612.34</c:v>
                </c:pt>
                <c:pt idx="228">
                  <c:v>614.06100000000004</c:v>
                </c:pt>
                <c:pt idx="229">
                  <c:v>617.95799999999997</c:v>
                </c:pt>
                <c:pt idx="230">
                  <c:v>620.84</c:v>
                </c:pt>
                <c:pt idx="231">
                  <c:v>623.57600000000002</c:v>
                </c:pt>
                <c:pt idx="232">
                  <c:v>624.46100000000001</c:v>
                </c:pt>
                <c:pt idx="233">
                  <c:v>625.13900000000001</c:v>
                </c:pt>
                <c:pt idx="234">
                  <c:v>625.87099999999998</c:v>
                </c:pt>
                <c:pt idx="235">
                  <c:v>626.78</c:v>
                </c:pt>
                <c:pt idx="236">
                  <c:v>627.68899999999996</c:v>
                </c:pt>
                <c:pt idx="237">
                  <c:v>629.19399999999996</c:v>
                </c:pt>
                <c:pt idx="238">
                  <c:v>629.95399999999995</c:v>
                </c:pt>
                <c:pt idx="239">
                  <c:v>632.87300000000005</c:v>
                </c:pt>
                <c:pt idx="240">
                  <c:v>634.81200000000001</c:v>
                </c:pt>
                <c:pt idx="241">
                  <c:v>635.20399999999995</c:v>
                </c:pt>
                <c:pt idx="242">
                  <c:v>638.76900000000001</c:v>
                </c:pt>
                <c:pt idx="243">
                  <c:v>640.42999999999995</c:v>
                </c:pt>
                <c:pt idx="244">
                  <c:v>646.04700000000003</c:v>
                </c:pt>
                <c:pt idx="245">
                  <c:v>646.84100000000001</c:v>
                </c:pt>
                <c:pt idx="246">
                  <c:v>651.66499999999996</c:v>
                </c:pt>
                <c:pt idx="247">
                  <c:v>657.28300000000002</c:v>
                </c:pt>
                <c:pt idx="248">
                  <c:v>657.36300000000006</c:v>
                </c:pt>
                <c:pt idx="249">
                  <c:v>662.90099999999995</c:v>
                </c:pt>
                <c:pt idx="250">
                  <c:v>664.26499999999999</c:v>
                </c:pt>
                <c:pt idx="251">
                  <c:v>668.51900000000001</c:v>
                </c:pt>
                <c:pt idx="252">
                  <c:v>672.21799999999996</c:v>
                </c:pt>
                <c:pt idx="253">
                  <c:v>674.13599999999997</c:v>
                </c:pt>
                <c:pt idx="254">
                  <c:v>675.79499999999996</c:v>
                </c:pt>
                <c:pt idx="255">
                  <c:v>676.80899999999997</c:v>
                </c:pt>
                <c:pt idx="256">
                  <c:v>676.80899999999997</c:v>
                </c:pt>
                <c:pt idx="257">
                  <c:v>676.88900000000001</c:v>
                </c:pt>
                <c:pt idx="258">
                  <c:v>677.16899999999998</c:v>
                </c:pt>
                <c:pt idx="259">
                  <c:v>677.85299999999995</c:v>
                </c:pt>
                <c:pt idx="260">
                  <c:v>679.75400000000002</c:v>
                </c:pt>
                <c:pt idx="261">
                  <c:v>685.37199999999996</c:v>
                </c:pt>
                <c:pt idx="262">
                  <c:v>686.40499999999997</c:v>
                </c:pt>
                <c:pt idx="263">
                  <c:v>690.99</c:v>
                </c:pt>
                <c:pt idx="264">
                  <c:v>696.60799999999995</c:v>
                </c:pt>
                <c:pt idx="265">
                  <c:v>700.86099999999999</c:v>
                </c:pt>
                <c:pt idx="266">
                  <c:v>702.22500000000002</c:v>
                </c:pt>
                <c:pt idx="267">
                  <c:v>704.63900000000001</c:v>
                </c:pt>
                <c:pt idx="268">
                  <c:v>706.00800000000004</c:v>
                </c:pt>
                <c:pt idx="269">
                  <c:v>707.78899999999999</c:v>
                </c:pt>
                <c:pt idx="270">
                  <c:v>707.84299999999996</c:v>
                </c:pt>
                <c:pt idx="271">
                  <c:v>710.02499999999998</c:v>
                </c:pt>
                <c:pt idx="272">
                  <c:v>713.46100000000001</c:v>
                </c:pt>
                <c:pt idx="273">
                  <c:v>714.37099999999998</c:v>
                </c:pt>
                <c:pt idx="274">
                  <c:v>715.41499999999996</c:v>
                </c:pt>
                <c:pt idx="275">
                  <c:v>715.76900000000001</c:v>
                </c:pt>
                <c:pt idx="276">
                  <c:v>716.12300000000005</c:v>
                </c:pt>
                <c:pt idx="277">
                  <c:v>719.07899999999995</c:v>
                </c:pt>
                <c:pt idx="278">
                  <c:v>720.54300000000001</c:v>
                </c:pt>
                <c:pt idx="279">
                  <c:v>722.60400000000004</c:v>
                </c:pt>
                <c:pt idx="280">
                  <c:v>723.221</c:v>
                </c:pt>
                <c:pt idx="281">
                  <c:v>724.697</c:v>
                </c:pt>
                <c:pt idx="282">
                  <c:v>726.97699999999998</c:v>
                </c:pt>
                <c:pt idx="283">
                  <c:v>730.31399999999996</c:v>
                </c:pt>
                <c:pt idx="284">
                  <c:v>735.19500000000005</c:v>
                </c:pt>
                <c:pt idx="285">
                  <c:v>735.93200000000002</c:v>
                </c:pt>
                <c:pt idx="286">
                  <c:v>741.55</c:v>
                </c:pt>
                <c:pt idx="287">
                  <c:v>742.72299999999996</c:v>
                </c:pt>
                <c:pt idx="288">
                  <c:v>746.755</c:v>
                </c:pt>
                <c:pt idx="289">
                  <c:v>747.16800000000001</c:v>
                </c:pt>
                <c:pt idx="290">
                  <c:v>749.55399999999997</c:v>
                </c:pt>
                <c:pt idx="291">
                  <c:v>750.32600000000002</c:v>
                </c:pt>
                <c:pt idx="292">
                  <c:v>750.38800000000003</c:v>
                </c:pt>
                <c:pt idx="293">
                  <c:v>751.33900000000006</c:v>
                </c:pt>
                <c:pt idx="294">
                  <c:v>752.78599999999994</c:v>
                </c:pt>
                <c:pt idx="295">
                  <c:v>752.79499999999996</c:v>
                </c:pt>
                <c:pt idx="296">
                  <c:v>754.03200000000004</c:v>
                </c:pt>
                <c:pt idx="297">
                  <c:v>754.755</c:v>
                </c:pt>
                <c:pt idx="298">
                  <c:v>758.40300000000002</c:v>
                </c:pt>
                <c:pt idx="299">
                  <c:v>758.86199999999997</c:v>
                </c:pt>
                <c:pt idx="300">
                  <c:v>764.02099999999996</c:v>
                </c:pt>
                <c:pt idx="301">
                  <c:v>764.14700000000005</c:v>
                </c:pt>
                <c:pt idx="302">
                  <c:v>769.41300000000001</c:v>
                </c:pt>
                <c:pt idx="303">
                  <c:v>769.63900000000001</c:v>
                </c:pt>
                <c:pt idx="304">
                  <c:v>773.73199999999997</c:v>
                </c:pt>
                <c:pt idx="305">
                  <c:v>775.25699999999995</c:v>
                </c:pt>
                <c:pt idx="306">
                  <c:v>776.27300000000002</c:v>
                </c:pt>
                <c:pt idx="307">
                  <c:v>778.82</c:v>
                </c:pt>
                <c:pt idx="308">
                  <c:v>780.875</c:v>
                </c:pt>
                <c:pt idx="309">
                  <c:v>782.09500000000003</c:v>
                </c:pt>
                <c:pt idx="310">
                  <c:v>785.69299999999998</c:v>
                </c:pt>
                <c:pt idx="311">
                  <c:v>786.49199999999996</c:v>
                </c:pt>
                <c:pt idx="312">
                  <c:v>787.06899999999996</c:v>
                </c:pt>
                <c:pt idx="313">
                  <c:v>792.11</c:v>
                </c:pt>
                <c:pt idx="314">
                  <c:v>795.553</c:v>
                </c:pt>
                <c:pt idx="315">
                  <c:v>797.72799999999995</c:v>
                </c:pt>
                <c:pt idx="316">
                  <c:v>803.346</c:v>
                </c:pt>
                <c:pt idx="317">
                  <c:v>808.49599999999998</c:v>
                </c:pt>
                <c:pt idx="318">
                  <c:v>808.96400000000006</c:v>
                </c:pt>
                <c:pt idx="319">
                  <c:v>814.58100000000002</c:v>
                </c:pt>
                <c:pt idx="320">
                  <c:v>820.19899999999996</c:v>
                </c:pt>
                <c:pt idx="321">
                  <c:v>825.81700000000001</c:v>
                </c:pt>
                <c:pt idx="322">
                  <c:v>827.11599999999999</c:v>
                </c:pt>
                <c:pt idx="323">
                  <c:v>828.81299999999999</c:v>
                </c:pt>
                <c:pt idx="324">
                  <c:v>829.52099999999996</c:v>
                </c:pt>
                <c:pt idx="325">
                  <c:v>831.43499999999995</c:v>
                </c:pt>
                <c:pt idx="326">
                  <c:v>831.45399999999995</c:v>
                </c:pt>
                <c:pt idx="327">
                  <c:v>832.63300000000004</c:v>
                </c:pt>
                <c:pt idx="328">
                  <c:v>837.053</c:v>
                </c:pt>
                <c:pt idx="329">
                  <c:v>838.99</c:v>
                </c:pt>
                <c:pt idx="330">
                  <c:v>842.67</c:v>
                </c:pt>
                <c:pt idx="331">
                  <c:v>843.53700000000003</c:v>
                </c:pt>
                <c:pt idx="332">
                  <c:v>844.23500000000001</c:v>
                </c:pt>
                <c:pt idx="333">
                  <c:v>846.95</c:v>
                </c:pt>
                <c:pt idx="334">
                  <c:v>848.28800000000001</c:v>
                </c:pt>
                <c:pt idx="335">
                  <c:v>853.90599999999995</c:v>
                </c:pt>
                <c:pt idx="336">
                  <c:v>857.05899999999997</c:v>
                </c:pt>
                <c:pt idx="337">
                  <c:v>859.524</c:v>
                </c:pt>
                <c:pt idx="338">
                  <c:v>864.55899999999997</c:v>
                </c:pt>
                <c:pt idx="339">
                  <c:v>865.14200000000005</c:v>
                </c:pt>
                <c:pt idx="340">
                  <c:v>869.25300000000004</c:v>
                </c:pt>
                <c:pt idx="341">
                  <c:v>870.75900000000001</c:v>
                </c:pt>
                <c:pt idx="342">
                  <c:v>876.37699999999995</c:v>
                </c:pt>
                <c:pt idx="343">
                  <c:v>880.93200000000002</c:v>
                </c:pt>
                <c:pt idx="344">
                  <c:v>881.995</c:v>
                </c:pt>
                <c:pt idx="345">
                  <c:v>887.61300000000006</c:v>
                </c:pt>
                <c:pt idx="346">
                  <c:v>891.49699999999996</c:v>
                </c:pt>
                <c:pt idx="347">
                  <c:v>893.23099999999999</c:v>
                </c:pt>
                <c:pt idx="348">
                  <c:v>895.32299999999998</c:v>
                </c:pt>
                <c:pt idx="349">
                  <c:v>898.84799999999996</c:v>
                </c:pt>
                <c:pt idx="350">
                  <c:v>902.50599999999997</c:v>
                </c:pt>
                <c:pt idx="351">
                  <c:v>904.46600000000001</c:v>
                </c:pt>
                <c:pt idx="352">
                  <c:v>908.79899999999998</c:v>
                </c:pt>
                <c:pt idx="353">
                  <c:v>910.08399999999995</c:v>
                </c:pt>
                <c:pt idx="354">
                  <c:v>914.48</c:v>
                </c:pt>
                <c:pt idx="355">
                  <c:v>915.702</c:v>
                </c:pt>
                <c:pt idx="356">
                  <c:v>921.32</c:v>
                </c:pt>
                <c:pt idx="357">
                  <c:v>926.93700000000001</c:v>
                </c:pt>
                <c:pt idx="358">
                  <c:v>932.55499999999995</c:v>
                </c:pt>
                <c:pt idx="359">
                  <c:v>938.173</c:v>
                </c:pt>
                <c:pt idx="360">
                  <c:v>939.303</c:v>
                </c:pt>
                <c:pt idx="361">
                  <c:v>943.79100000000005</c:v>
                </c:pt>
                <c:pt idx="362">
                  <c:v>949.40899999999999</c:v>
                </c:pt>
                <c:pt idx="363">
                  <c:v>954.44600000000003</c:v>
                </c:pt>
                <c:pt idx="364">
                  <c:v>955.02599999999995</c:v>
                </c:pt>
                <c:pt idx="365">
                  <c:v>960.64400000000001</c:v>
                </c:pt>
                <c:pt idx="366">
                  <c:v>966.26199999999994</c:v>
                </c:pt>
                <c:pt idx="367">
                  <c:v>966.64800000000002</c:v>
                </c:pt>
                <c:pt idx="368">
                  <c:v>971.88</c:v>
                </c:pt>
                <c:pt idx="369">
                  <c:v>975.048</c:v>
                </c:pt>
                <c:pt idx="370">
                  <c:v>977.49800000000005</c:v>
                </c:pt>
                <c:pt idx="371">
                  <c:v>983.11500000000001</c:v>
                </c:pt>
                <c:pt idx="372">
                  <c:v>986.14</c:v>
                </c:pt>
                <c:pt idx="373">
                  <c:v>988.73299999999995</c:v>
                </c:pt>
                <c:pt idx="374">
                  <c:v>994.351</c:v>
                </c:pt>
                <c:pt idx="375">
                  <c:v>994.53200000000004</c:v>
                </c:pt>
                <c:pt idx="376">
                  <c:v>999.96900000000005</c:v>
                </c:pt>
                <c:pt idx="377">
                  <c:v>1005.587</c:v>
                </c:pt>
                <c:pt idx="378">
                  <c:v>1011.204</c:v>
                </c:pt>
                <c:pt idx="379">
                  <c:v>1015.165</c:v>
                </c:pt>
                <c:pt idx="380">
                  <c:v>1016.822</c:v>
                </c:pt>
                <c:pt idx="381">
                  <c:v>1018.268</c:v>
                </c:pt>
                <c:pt idx="382">
                  <c:v>1022.44</c:v>
                </c:pt>
                <c:pt idx="383">
                  <c:v>1028.058</c:v>
                </c:pt>
                <c:pt idx="384">
                  <c:v>1033.6759999999999</c:v>
                </c:pt>
                <c:pt idx="385">
                  <c:v>1039.2940000000001</c:v>
                </c:pt>
                <c:pt idx="386">
                  <c:v>1044.9110000000001</c:v>
                </c:pt>
                <c:pt idx="387">
                  <c:v>1050.529</c:v>
                </c:pt>
                <c:pt idx="388">
                  <c:v>1056.1469999999999</c:v>
                </c:pt>
                <c:pt idx="389">
                  <c:v>1061.7650000000001</c:v>
                </c:pt>
                <c:pt idx="390">
                  <c:v>1067.383</c:v>
                </c:pt>
                <c:pt idx="391">
                  <c:v>1073</c:v>
                </c:pt>
                <c:pt idx="392">
                  <c:v>1078.6179999999999</c:v>
                </c:pt>
                <c:pt idx="393">
                  <c:v>1084.2360000000001</c:v>
                </c:pt>
                <c:pt idx="394">
                  <c:v>1089.854</c:v>
                </c:pt>
                <c:pt idx="395">
                  <c:v>1095.472</c:v>
                </c:pt>
                <c:pt idx="396">
                  <c:v>1101.0889999999999</c:v>
                </c:pt>
                <c:pt idx="397">
                  <c:v>1106.7070000000001</c:v>
                </c:pt>
                <c:pt idx="398">
                  <c:v>1112.325</c:v>
                </c:pt>
                <c:pt idx="399">
                  <c:v>1117.943</c:v>
                </c:pt>
                <c:pt idx="400">
                  <c:v>1123.5609999999999</c:v>
                </c:pt>
                <c:pt idx="401">
                  <c:v>1123.5609999999999</c:v>
                </c:pt>
              </c:numCache>
            </c:numRef>
          </c:xVal>
          <c:yVal>
            <c:numRef>
              <c:f>Foglio6!$L$819:$L$1220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  <c:pt idx="20">
                  <c:v>100</c:v>
                </c:pt>
                <c:pt idx="21">
                  <c:v>100</c:v>
                </c:pt>
                <c:pt idx="22">
                  <c:v>100</c:v>
                </c:pt>
                <c:pt idx="23">
                  <c:v>100</c:v>
                </c:pt>
                <c:pt idx="24">
                  <c:v>100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100</c:v>
                </c:pt>
                <c:pt idx="32">
                  <c:v>100</c:v>
                </c:pt>
                <c:pt idx="33">
                  <c:v>100</c:v>
                </c:pt>
                <c:pt idx="34">
                  <c:v>100</c:v>
                </c:pt>
                <c:pt idx="35">
                  <c:v>100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99.956000000000003</c:v>
                </c:pt>
                <c:pt idx="41">
                  <c:v>99.938999999999993</c:v>
                </c:pt>
                <c:pt idx="42">
                  <c:v>99.921000000000006</c:v>
                </c:pt>
                <c:pt idx="43">
                  <c:v>99.858000000000004</c:v>
                </c:pt>
                <c:pt idx="44">
                  <c:v>99.813999999999993</c:v>
                </c:pt>
                <c:pt idx="45">
                  <c:v>99.811999999999998</c:v>
                </c:pt>
                <c:pt idx="46">
                  <c:v>99.808999999999997</c:v>
                </c:pt>
                <c:pt idx="47">
                  <c:v>99.807000000000002</c:v>
                </c:pt>
                <c:pt idx="48">
                  <c:v>99.804000000000002</c:v>
                </c:pt>
                <c:pt idx="49">
                  <c:v>99.777000000000001</c:v>
                </c:pt>
                <c:pt idx="50">
                  <c:v>99.599000000000004</c:v>
                </c:pt>
                <c:pt idx="51">
                  <c:v>99.5</c:v>
                </c:pt>
                <c:pt idx="52">
                  <c:v>99.358999999999995</c:v>
                </c:pt>
                <c:pt idx="53">
                  <c:v>99.078999999999994</c:v>
                </c:pt>
                <c:pt idx="54">
                  <c:v>99</c:v>
                </c:pt>
                <c:pt idx="55">
                  <c:v>98.852000000000004</c:v>
                </c:pt>
                <c:pt idx="56">
                  <c:v>98.647000000000006</c:v>
                </c:pt>
                <c:pt idx="57">
                  <c:v>98.5</c:v>
                </c:pt>
                <c:pt idx="58">
                  <c:v>98.325999999999993</c:v>
                </c:pt>
                <c:pt idx="59">
                  <c:v>98.01</c:v>
                </c:pt>
                <c:pt idx="60">
                  <c:v>98</c:v>
                </c:pt>
                <c:pt idx="61">
                  <c:v>97.5</c:v>
                </c:pt>
                <c:pt idx="62">
                  <c:v>97.186999999999998</c:v>
                </c:pt>
                <c:pt idx="63">
                  <c:v>97</c:v>
                </c:pt>
                <c:pt idx="64">
                  <c:v>96.5</c:v>
                </c:pt>
                <c:pt idx="65">
                  <c:v>96</c:v>
                </c:pt>
                <c:pt idx="66">
                  <c:v>95.866</c:v>
                </c:pt>
                <c:pt idx="67">
                  <c:v>95.5</c:v>
                </c:pt>
                <c:pt idx="68">
                  <c:v>95</c:v>
                </c:pt>
                <c:pt idx="69">
                  <c:v>94.81</c:v>
                </c:pt>
                <c:pt idx="70">
                  <c:v>94.649000000000001</c:v>
                </c:pt>
                <c:pt idx="71">
                  <c:v>94.5</c:v>
                </c:pt>
                <c:pt idx="72">
                  <c:v>94.409000000000006</c:v>
                </c:pt>
                <c:pt idx="73">
                  <c:v>94</c:v>
                </c:pt>
                <c:pt idx="74">
                  <c:v>93.763000000000005</c:v>
                </c:pt>
                <c:pt idx="75">
                  <c:v>93.5</c:v>
                </c:pt>
                <c:pt idx="76">
                  <c:v>93.003</c:v>
                </c:pt>
                <c:pt idx="77">
                  <c:v>93</c:v>
                </c:pt>
                <c:pt idx="78">
                  <c:v>92.691999999999993</c:v>
                </c:pt>
                <c:pt idx="79">
                  <c:v>92.5</c:v>
                </c:pt>
                <c:pt idx="80">
                  <c:v>92</c:v>
                </c:pt>
                <c:pt idx="81">
                  <c:v>91.808000000000007</c:v>
                </c:pt>
                <c:pt idx="82">
                  <c:v>91.5</c:v>
                </c:pt>
                <c:pt idx="83">
                  <c:v>91.406999999999996</c:v>
                </c:pt>
                <c:pt idx="84">
                  <c:v>91.04</c:v>
                </c:pt>
                <c:pt idx="85">
                  <c:v>91</c:v>
                </c:pt>
                <c:pt idx="86">
                  <c:v>90.763999999999996</c:v>
                </c:pt>
                <c:pt idx="87">
                  <c:v>90.5</c:v>
                </c:pt>
                <c:pt idx="88">
                  <c:v>90.260999999999996</c:v>
                </c:pt>
                <c:pt idx="89">
                  <c:v>90</c:v>
                </c:pt>
                <c:pt idx="90">
                  <c:v>89.5</c:v>
                </c:pt>
                <c:pt idx="91">
                  <c:v>89</c:v>
                </c:pt>
                <c:pt idx="92">
                  <c:v>88.5</c:v>
                </c:pt>
                <c:pt idx="93">
                  <c:v>88</c:v>
                </c:pt>
                <c:pt idx="94">
                  <c:v>87.5</c:v>
                </c:pt>
                <c:pt idx="95">
                  <c:v>87.42</c:v>
                </c:pt>
                <c:pt idx="96">
                  <c:v>87</c:v>
                </c:pt>
                <c:pt idx="97">
                  <c:v>86.736999999999995</c:v>
                </c:pt>
                <c:pt idx="98">
                  <c:v>86.5</c:v>
                </c:pt>
                <c:pt idx="99">
                  <c:v>86</c:v>
                </c:pt>
                <c:pt idx="100">
                  <c:v>85.787000000000006</c:v>
                </c:pt>
                <c:pt idx="101">
                  <c:v>85.5</c:v>
                </c:pt>
                <c:pt idx="102">
                  <c:v>85</c:v>
                </c:pt>
                <c:pt idx="103">
                  <c:v>84.5</c:v>
                </c:pt>
                <c:pt idx="104">
                  <c:v>84.364999999999995</c:v>
                </c:pt>
                <c:pt idx="105">
                  <c:v>84</c:v>
                </c:pt>
                <c:pt idx="106">
                  <c:v>83.557000000000002</c:v>
                </c:pt>
                <c:pt idx="107">
                  <c:v>83.5</c:v>
                </c:pt>
                <c:pt idx="108">
                  <c:v>83</c:v>
                </c:pt>
                <c:pt idx="109">
                  <c:v>82.5</c:v>
                </c:pt>
                <c:pt idx="110">
                  <c:v>82</c:v>
                </c:pt>
                <c:pt idx="111">
                  <c:v>81.739000000000004</c:v>
                </c:pt>
                <c:pt idx="112">
                  <c:v>81.5</c:v>
                </c:pt>
                <c:pt idx="113">
                  <c:v>81.5</c:v>
                </c:pt>
                <c:pt idx="114">
                  <c:v>81</c:v>
                </c:pt>
                <c:pt idx="115">
                  <c:v>80.5</c:v>
                </c:pt>
                <c:pt idx="116">
                  <c:v>80.427999999999997</c:v>
                </c:pt>
                <c:pt idx="117">
                  <c:v>80</c:v>
                </c:pt>
                <c:pt idx="118">
                  <c:v>79.5</c:v>
                </c:pt>
                <c:pt idx="119">
                  <c:v>79.316999999999993</c:v>
                </c:pt>
                <c:pt idx="120">
                  <c:v>79.102000000000004</c:v>
                </c:pt>
                <c:pt idx="121">
                  <c:v>79</c:v>
                </c:pt>
                <c:pt idx="122">
                  <c:v>78.5</c:v>
                </c:pt>
                <c:pt idx="123">
                  <c:v>78</c:v>
                </c:pt>
                <c:pt idx="124">
                  <c:v>77.5</c:v>
                </c:pt>
                <c:pt idx="125">
                  <c:v>77.251000000000005</c:v>
                </c:pt>
                <c:pt idx="126">
                  <c:v>77</c:v>
                </c:pt>
                <c:pt idx="127">
                  <c:v>76.995999999999995</c:v>
                </c:pt>
                <c:pt idx="128">
                  <c:v>76.552000000000007</c:v>
                </c:pt>
                <c:pt idx="129">
                  <c:v>76.5</c:v>
                </c:pt>
                <c:pt idx="130">
                  <c:v>76</c:v>
                </c:pt>
                <c:pt idx="131">
                  <c:v>75.5</c:v>
                </c:pt>
                <c:pt idx="132">
                  <c:v>75.239000000000004</c:v>
                </c:pt>
                <c:pt idx="133">
                  <c:v>75</c:v>
                </c:pt>
                <c:pt idx="134">
                  <c:v>74.5</c:v>
                </c:pt>
                <c:pt idx="135">
                  <c:v>74.093999999999994</c:v>
                </c:pt>
                <c:pt idx="136">
                  <c:v>74</c:v>
                </c:pt>
                <c:pt idx="137">
                  <c:v>73.5</c:v>
                </c:pt>
                <c:pt idx="138">
                  <c:v>73</c:v>
                </c:pt>
                <c:pt idx="139">
                  <c:v>72.561999999999998</c:v>
                </c:pt>
                <c:pt idx="140">
                  <c:v>72.5</c:v>
                </c:pt>
                <c:pt idx="141">
                  <c:v>72</c:v>
                </c:pt>
                <c:pt idx="142">
                  <c:v>71.5</c:v>
                </c:pt>
                <c:pt idx="143">
                  <c:v>71</c:v>
                </c:pt>
                <c:pt idx="144">
                  <c:v>70.823999999999998</c:v>
                </c:pt>
                <c:pt idx="145">
                  <c:v>70.5</c:v>
                </c:pt>
                <c:pt idx="146">
                  <c:v>70.003</c:v>
                </c:pt>
                <c:pt idx="147">
                  <c:v>70</c:v>
                </c:pt>
                <c:pt idx="148">
                  <c:v>69.5</c:v>
                </c:pt>
                <c:pt idx="149">
                  <c:v>69.394000000000005</c:v>
                </c:pt>
                <c:pt idx="150">
                  <c:v>69</c:v>
                </c:pt>
                <c:pt idx="151">
                  <c:v>68.5</c:v>
                </c:pt>
                <c:pt idx="152">
                  <c:v>68.122</c:v>
                </c:pt>
                <c:pt idx="153">
                  <c:v>68</c:v>
                </c:pt>
                <c:pt idx="154">
                  <c:v>67.5</c:v>
                </c:pt>
                <c:pt idx="155">
                  <c:v>67.247</c:v>
                </c:pt>
                <c:pt idx="156">
                  <c:v>67</c:v>
                </c:pt>
                <c:pt idx="157">
                  <c:v>66.5</c:v>
                </c:pt>
                <c:pt idx="158">
                  <c:v>66</c:v>
                </c:pt>
                <c:pt idx="159">
                  <c:v>65.748999999999995</c:v>
                </c:pt>
                <c:pt idx="160">
                  <c:v>65.5</c:v>
                </c:pt>
                <c:pt idx="161">
                  <c:v>65</c:v>
                </c:pt>
                <c:pt idx="162">
                  <c:v>64.5</c:v>
                </c:pt>
                <c:pt idx="163">
                  <c:v>64.430000000000007</c:v>
                </c:pt>
                <c:pt idx="164">
                  <c:v>64</c:v>
                </c:pt>
                <c:pt idx="165">
                  <c:v>63.5</c:v>
                </c:pt>
                <c:pt idx="166">
                  <c:v>63.195999999999998</c:v>
                </c:pt>
                <c:pt idx="167">
                  <c:v>63</c:v>
                </c:pt>
                <c:pt idx="168">
                  <c:v>62.5</c:v>
                </c:pt>
                <c:pt idx="169">
                  <c:v>62</c:v>
                </c:pt>
                <c:pt idx="170">
                  <c:v>61.969000000000001</c:v>
                </c:pt>
                <c:pt idx="171">
                  <c:v>61.5</c:v>
                </c:pt>
                <c:pt idx="172">
                  <c:v>61</c:v>
                </c:pt>
                <c:pt idx="173">
                  <c:v>60.5</c:v>
                </c:pt>
                <c:pt idx="174">
                  <c:v>60.043999999999997</c:v>
                </c:pt>
                <c:pt idx="175">
                  <c:v>60</c:v>
                </c:pt>
                <c:pt idx="176">
                  <c:v>59.5</c:v>
                </c:pt>
                <c:pt idx="177">
                  <c:v>59</c:v>
                </c:pt>
                <c:pt idx="178">
                  <c:v>58.84</c:v>
                </c:pt>
                <c:pt idx="179">
                  <c:v>58.5</c:v>
                </c:pt>
                <c:pt idx="180">
                  <c:v>58</c:v>
                </c:pt>
                <c:pt idx="181">
                  <c:v>57.5</c:v>
                </c:pt>
                <c:pt idx="182">
                  <c:v>57.418999999999997</c:v>
                </c:pt>
                <c:pt idx="183">
                  <c:v>57</c:v>
                </c:pt>
                <c:pt idx="184">
                  <c:v>56.634999999999998</c:v>
                </c:pt>
                <c:pt idx="185">
                  <c:v>56.5</c:v>
                </c:pt>
                <c:pt idx="186">
                  <c:v>56.009</c:v>
                </c:pt>
                <c:pt idx="187">
                  <c:v>56</c:v>
                </c:pt>
                <c:pt idx="188">
                  <c:v>55.808999999999997</c:v>
                </c:pt>
                <c:pt idx="189">
                  <c:v>55.5</c:v>
                </c:pt>
                <c:pt idx="190">
                  <c:v>55</c:v>
                </c:pt>
                <c:pt idx="191">
                  <c:v>54.808999999999997</c:v>
                </c:pt>
                <c:pt idx="192">
                  <c:v>54.5</c:v>
                </c:pt>
                <c:pt idx="193">
                  <c:v>54</c:v>
                </c:pt>
                <c:pt idx="194">
                  <c:v>53.5</c:v>
                </c:pt>
                <c:pt idx="195">
                  <c:v>53.357999999999997</c:v>
                </c:pt>
                <c:pt idx="196">
                  <c:v>53</c:v>
                </c:pt>
                <c:pt idx="197">
                  <c:v>52.5</c:v>
                </c:pt>
                <c:pt idx="198">
                  <c:v>52</c:v>
                </c:pt>
                <c:pt idx="199">
                  <c:v>51.5</c:v>
                </c:pt>
                <c:pt idx="200">
                  <c:v>51.237000000000002</c:v>
                </c:pt>
                <c:pt idx="201">
                  <c:v>51</c:v>
                </c:pt>
                <c:pt idx="202">
                  <c:v>50.557000000000002</c:v>
                </c:pt>
                <c:pt idx="203">
                  <c:v>50.5</c:v>
                </c:pt>
                <c:pt idx="204">
                  <c:v>50</c:v>
                </c:pt>
                <c:pt idx="205">
                  <c:v>49.96</c:v>
                </c:pt>
                <c:pt idx="206">
                  <c:v>49.5</c:v>
                </c:pt>
                <c:pt idx="207">
                  <c:v>49</c:v>
                </c:pt>
                <c:pt idx="208">
                  <c:v>48.557000000000002</c:v>
                </c:pt>
                <c:pt idx="209">
                  <c:v>48.5</c:v>
                </c:pt>
                <c:pt idx="210">
                  <c:v>48</c:v>
                </c:pt>
                <c:pt idx="211">
                  <c:v>47.5</c:v>
                </c:pt>
                <c:pt idx="212">
                  <c:v>47</c:v>
                </c:pt>
                <c:pt idx="213">
                  <c:v>46.972999999999999</c:v>
                </c:pt>
                <c:pt idx="214">
                  <c:v>46.5</c:v>
                </c:pt>
                <c:pt idx="215">
                  <c:v>46.183999999999997</c:v>
                </c:pt>
                <c:pt idx="216">
                  <c:v>46</c:v>
                </c:pt>
                <c:pt idx="217">
                  <c:v>45.5</c:v>
                </c:pt>
                <c:pt idx="218">
                  <c:v>45</c:v>
                </c:pt>
                <c:pt idx="219">
                  <c:v>44.947000000000003</c:v>
                </c:pt>
                <c:pt idx="220">
                  <c:v>44.5</c:v>
                </c:pt>
                <c:pt idx="221">
                  <c:v>44</c:v>
                </c:pt>
                <c:pt idx="222">
                  <c:v>43.5</c:v>
                </c:pt>
                <c:pt idx="223">
                  <c:v>43</c:v>
                </c:pt>
                <c:pt idx="224">
                  <c:v>42.5</c:v>
                </c:pt>
                <c:pt idx="225">
                  <c:v>42</c:v>
                </c:pt>
                <c:pt idx="226">
                  <c:v>41.5</c:v>
                </c:pt>
                <c:pt idx="227">
                  <c:v>41.469000000000001</c:v>
                </c:pt>
                <c:pt idx="228">
                  <c:v>41</c:v>
                </c:pt>
                <c:pt idx="229">
                  <c:v>40.69</c:v>
                </c:pt>
                <c:pt idx="230">
                  <c:v>40.5</c:v>
                </c:pt>
                <c:pt idx="231">
                  <c:v>40.32</c:v>
                </c:pt>
                <c:pt idx="232">
                  <c:v>40</c:v>
                </c:pt>
                <c:pt idx="233">
                  <c:v>39.5</c:v>
                </c:pt>
                <c:pt idx="234">
                  <c:v>39</c:v>
                </c:pt>
                <c:pt idx="235">
                  <c:v>38.5</c:v>
                </c:pt>
                <c:pt idx="236">
                  <c:v>38</c:v>
                </c:pt>
                <c:pt idx="237">
                  <c:v>37.656999999999996</c:v>
                </c:pt>
                <c:pt idx="238">
                  <c:v>37.5</c:v>
                </c:pt>
                <c:pt idx="239">
                  <c:v>37</c:v>
                </c:pt>
                <c:pt idx="240">
                  <c:v>36.555</c:v>
                </c:pt>
                <c:pt idx="241">
                  <c:v>36.5</c:v>
                </c:pt>
                <c:pt idx="242">
                  <c:v>36</c:v>
                </c:pt>
                <c:pt idx="243">
                  <c:v>35.792999999999999</c:v>
                </c:pt>
                <c:pt idx="244">
                  <c:v>35.536000000000001</c:v>
                </c:pt>
                <c:pt idx="245">
                  <c:v>35.5</c:v>
                </c:pt>
                <c:pt idx="246">
                  <c:v>35.274000000000001</c:v>
                </c:pt>
                <c:pt idx="247">
                  <c:v>35.003999999999998</c:v>
                </c:pt>
                <c:pt idx="248">
                  <c:v>35</c:v>
                </c:pt>
                <c:pt idx="249">
                  <c:v>34.619</c:v>
                </c:pt>
                <c:pt idx="250">
                  <c:v>34.5</c:v>
                </c:pt>
                <c:pt idx="251">
                  <c:v>34.167000000000002</c:v>
                </c:pt>
                <c:pt idx="252">
                  <c:v>34</c:v>
                </c:pt>
                <c:pt idx="253">
                  <c:v>33.866999999999997</c:v>
                </c:pt>
                <c:pt idx="254">
                  <c:v>33.5</c:v>
                </c:pt>
                <c:pt idx="255">
                  <c:v>33</c:v>
                </c:pt>
                <c:pt idx="256">
                  <c:v>32.5</c:v>
                </c:pt>
                <c:pt idx="257">
                  <c:v>32</c:v>
                </c:pt>
                <c:pt idx="258">
                  <c:v>31.5</c:v>
                </c:pt>
                <c:pt idx="259">
                  <c:v>31</c:v>
                </c:pt>
                <c:pt idx="260">
                  <c:v>30.73</c:v>
                </c:pt>
                <c:pt idx="261">
                  <c:v>30.536000000000001</c:v>
                </c:pt>
                <c:pt idx="262">
                  <c:v>30.5</c:v>
                </c:pt>
                <c:pt idx="263">
                  <c:v>30.341000000000001</c:v>
                </c:pt>
                <c:pt idx="264">
                  <c:v>30.146999999999998</c:v>
                </c:pt>
                <c:pt idx="265">
                  <c:v>30</c:v>
                </c:pt>
                <c:pt idx="266">
                  <c:v>29.952999999999999</c:v>
                </c:pt>
                <c:pt idx="267">
                  <c:v>29.5</c:v>
                </c:pt>
                <c:pt idx="268">
                  <c:v>29</c:v>
                </c:pt>
                <c:pt idx="269">
                  <c:v>28.5</c:v>
                </c:pt>
                <c:pt idx="270">
                  <c:v>28.488</c:v>
                </c:pt>
                <c:pt idx="271">
                  <c:v>28</c:v>
                </c:pt>
                <c:pt idx="272">
                  <c:v>27.588000000000001</c:v>
                </c:pt>
                <c:pt idx="273">
                  <c:v>27.5</c:v>
                </c:pt>
                <c:pt idx="274">
                  <c:v>27</c:v>
                </c:pt>
                <c:pt idx="275">
                  <c:v>26.5</c:v>
                </c:pt>
                <c:pt idx="276">
                  <c:v>26</c:v>
                </c:pt>
                <c:pt idx="277">
                  <c:v>25.666</c:v>
                </c:pt>
                <c:pt idx="278">
                  <c:v>25.5</c:v>
                </c:pt>
                <c:pt idx="279">
                  <c:v>25</c:v>
                </c:pt>
                <c:pt idx="280">
                  <c:v>24.5</c:v>
                </c:pt>
                <c:pt idx="281">
                  <c:v>24.138000000000002</c:v>
                </c:pt>
                <c:pt idx="282">
                  <c:v>24</c:v>
                </c:pt>
                <c:pt idx="283">
                  <c:v>23.797000000000001</c:v>
                </c:pt>
                <c:pt idx="284">
                  <c:v>23.5</c:v>
                </c:pt>
                <c:pt idx="285">
                  <c:v>23.451000000000001</c:v>
                </c:pt>
                <c:pt idx="286">
                  <c:v>23.077999999999999</c:v>
                </c:pt>
                <c:pt idx="287">
                  <c:v>23</c:v>
                </c:pt>
                <c:pt idx="288">
                  <c:v>22.5</c:v>
                </c:pt>
                <c:pt idx="289">
                  <c:v>22.425999999999998</c:v>
                </c:pt>
                <c:pt idx="290">
                  <c:v>22</c:v>
                </c:pt>
                <c:pt idx="291">
                  <c:v>21.5</c:v>
                </c:pt>
                <c:pt idx="292">
                  <c:v>21</c:v>
                </c:pt>
                <c:pt idx="293">
                  <c:v>20.5</c:v>
                </c:pt>
                <c:pt idx="294">
                  <c:v>20.003</c:v>
                </c:pt>
                <c:pt idx="295">
                  <c:v>20</c:v>
                </c:pt>
                <c:pt idx="296">
                  <c:v>19.5</c:v>
                </c:pt>
                <c:pt idx="297">
                  <c:v>19</c:v>
                </c:pt>
                <c:pt idx="298">
                  <c:v>18.542999999999999</c:v>
                </c:pt>
                <c:pt idx="299">
                  <c:v>18.5</c:v>
                </c:pt>
                <c:pt idx="300">
                  <c:v>18.012</c:v>
                </c:pt>
                <c:pt idx="301">
                  <c:v>18</c:v>
                </c:pt>
                <c:pt idx="302">
                  <c:v>17.5</c:v>
                </c:pt>
                <c:pt idx="303">
                  <c:v>17.478999999999999</c:v>
                </c:pt>
                <c:pt idx="304">
                  <c:v>17</c:v>
                </c:pt>
                <c:pt idx="305">
                  <c:v>16.7</c:v>
                </c:pt>
                <c:pt idx="306">
                  <c:v>16.5</c:v>
                </c:pt>
                <c:pt idx="307">
                  <c:v>16</c:v>
                </c:pt>
                <c:pt idx="308">
                  <c:v>15.686</c:v>
                </c:pt>
                <c:pt idx="309">
                  <c:v>15.5</c:v>
                </c:pt>
                <c:pt idx="310">
                  <c:v>15</c:v>
                </c:pt>
                <c:pt idx="311">
                  <c:v>14.71</c:v>
                </c:pt>
                <c:pt idx="312">
                  <c:v>14.5</c:v>
                </c:pt>
                <c:pt idx="313">
                  <c:v>14.135</c:v>
                </c:pt>
                <c:pt idx="314">
                  <c:v>14</c:v>
                </c:pt>
                <c:pt idx="315">
                  <c:v>13.914999999999999</c:v>
                </c:pt>
                <c:pt idx="316">
                  <c:v>13.694000000000001</c:v>
                </c:pt>
                <c:pt idx="317">
                  <c:v>13.5</c:v>
                </c:pt>
                <c:pt idx="318">
                  <c:v>13.489000000000001</c:v>
                </c:pt>
                <c:pt idx="319">
                  <c:v>13.353</c:v>
                </c:pt>
                <c:pt idx="320">
                  <c:v>13.215999999999999</c:v>
                </c:pt>
                <c:pt idx="321">
                  <c:v>13.08</c:v>
                </c:pt>
                <c:pt idx="322">
                  <c:v>13</c:v>
                </c:pt>
                <c:pt idx="323">
                  <c:v>12.5</c:v>
                </c:pt>
                <c:pt idx="324">
                  <c:v>12</c:v>
                </c:pt>
                <c:pt idx="325">
                  <c:v>11.505000000000001</c:v>
                </c:pt>
                <c:pt idx="326">
                  <c:v>11.5</c:v>
                </c:pt>
                <c:pt idx="327">
                  <c:v>11</c:v>
                </c:pt>
                <c:pt idx="328">
                  <c:v>10.632</c:v>
                </c:pt>
                <c:pt idx="329">
                  <c:v>10.5</c:v>
                </c:pt>
                <c:pt idx="330">
                  <c:v>10.249000000000001</c:v>
                </c:pt>
                <c:pt idx="331">
                  <c:v>10</c:v>
                </c:pt>
                <c:pt idx="332">
                  <c:v>9.5</c:v>
                </c:pt>
                <c:pt idx="333">
                  <c:v>9</c:v>
                </c:pt>
                <c:pt idx="334">
                  <c:v>8.9339999999999993</c:v>
                </c:pt>
                <c:pt idx="335">
                  <c:v>8.6560000000000006</c:v>
                </c:pt>
                <c:pt idx="336">
                  <c:v>8.5</c:v>
                </c:pt>
                <c:pt idx="337">
                  <c:v>8.3780000000000001</c:v>
                </c:pt>
                <c:pt idx="338">
                  <c:v>8</c:v>
                </c:pt>
                <c:pt idx="339">
                  <c:v>7.9379999999999997</c:v>
                </c:pt>
                <c:pt idx="340">
                  <c:v>7.5</c:v>
                </c:pt>
                <c:pt idx="341">
                  <c:v>7.375</c:v>
                </c:pt>
                <c:pt idx="342">
                  <c:v>7.1680000000000001</c:v>
                </c:pt>
                <c:pt idx="343">
                  <c:v>7</c:v>
                </c:pt>
                <c:pt idx="344">
                  <c:v>6.9610000000000003</c:v>
                </c:pt>
                <c:pt idx="345">
                  <c:v>6.7539999999999996</c:v>
                </c:pt>
                <c:pt idx="346">
                  <c:v>6.5</c:v>
                </c:pt>
                <c:pt idx="347">
                  <c:v>6.2729999999999997</c:v>
                </c:pt>
                <c:pt idx="348">
                  <c:v>6</c:v>
                </c:pt>
                <c:pt idx="349">
                  <c:v>5.7110000000000003</c:v>
                </c:pt>
                <c:pt idx="350">
                  <c:v>5.5</c:v>
                </c:pt>
                <c:pt idx="351">
                  <c:v>5.3869999999999996</c:v>
                </c:pt>
                <c:pt idx="352">
                  <c:v>5</c:v>
                </c:pt>
                <c:pt idx="353">
                  <c:v>4.5890000000000004</c:v>
                </c:pt>
                <c:pt idx="354">
                  <c:v>4.5</c:v>
                </c:pt>
                <c:pt idx="355">
                  <c:v>4.4749999999999996</c:v>
                </c:pt>
                <c:pt idx="356">
                  <c:v>4.3620000000000001</c:v>
                </c:pt>
                <c:pt idx="357">
                  <c:v>4.2489999999999997</c:v>
                </c:pt>
                <c:pt idx="358">
                  <c:v>4.1360000000000001</c:v>
                </c:pt>
                <c:pt idx="359">
                  <c:v>4.0229999999999997</c:v>
                </c:pt>
                <c:pt idx="360">
                  <c:v>4</c:v>
                </c:pt>
                <c:pt idx="361">
                  <c:v>3.91</c:v>
                </c:pt>
                <c:pt idx="362">
                  <c:v>3.7959999999999998</c:v>
                </c:pt>
                <c:pt idx="363">
                  <c:v>3.5</c:v>
                </c:pt>
                <c:pt idx="364">
                  <c:v>3.4550000000000001</c:v>
                </c:pt>
                <c:pt idx="365">
                  <c:v>3.2069999999999999</c:v>
                </c:pt>
                <c:pt idx="366">
                  <c:v>3.0259999999999998</c:v>
                </c:pt>
                <c:pt idx="367">
                  <c:v>3</c:v>
                </c:pt>
                <c:pt idx="368">
                  <c:v>2.6469999999999998</c:v>
                </c:pt>
                <c:pt idx="369">
                  <c:v>2.5</c:v>
                </c:pt>
                <c:pt idx="370">
                  <c:v>2.39</c:v>
                </c:pt>
                <c:pt idx="371">
                  <c:v>2.1360000000000001</c:v>
                </c:pt>
                <c:pt idx="372">
                  <c:v>2</c:v>
                </c:pt>
                <c:pt idx="373">
                  <c:v>1.883</c:v>
                </c:pt>
                <c:pt idx="374">
                  <c:v>1.5209999999999999</c:v>
                </c:pt>
                <c:pt idx="375">
                  <c:v>1.5</c:v>
                </c:pt>
                <c:pt idx="376">
                  <c:v>1.1639999999999999</c:v>
                </c:pt>
                <c:pt idx="377">
                  <c:v>1.1259999999999999</c:v>
                </c:pt>
                <c:pt idx="378">
                  <c:v>1.089</c:v>
                </c:pt>
                <c:pt idx="379">
                  <c:v>1</c:v>
                </c:pt>
                <c:pt idx="380">
                  <c:v>0.64300000000000002</c:v>
                </c:pt>
                <c:pt idx="381">
                  <c:v>0.5</c:v>
                </c:pt>
                <c:pt idx="382">
                  <c:v>0.35799999999999998</c:v>
                </c:pt>
                <c:pt idx="383">
                  <c:v>0.28100000000000003</c:v>
                </c:pt>
                <c:pt idx="384">
                  <c:v>0.254</c:v>
                </c:pt>
                <c:pt idx="385">
                  <c:v>0.22800000000000001</c:v>
                </c:pt>
                <c:pt idx="386">
                  <c:v>0.20200000000000001</c:v>
                </c:pt>
                <c:pt idx="387">
                  <c:v>0.17499999999999999</c:v>
                </c:pt>
                <c:pt idx="388">
                  <c:v>0.14899999999999999</c:v>
                </c:pt>
                <c:pt idx="389">
                  <c:v>0.126</c:v>
                </c:pt>
                <c:pt idx="390">
                  <c:v>0.11700000000000001</c:v>
                </c:pt>
                <c:pt idx="391">
                  <c:v>0.108</c:v>
                </c:pt>
                <c:pt idx="392">
                  <c:v>9.8000000000000004E-2</c:v>
                </c:pt>
                <c:pt idx="393">
                  <c:v>8.8999999999999996E-2</c:v>
                </c:pt>
                <c:pt idx="394">
                  <c:v>0.08</c:v>
                </c:pt>
                <c:pt idx="395">
                  <c:v>7.0999999999999994E-2</c:v>
                </c:pt>
                <c:pt idx="396">
                  <c:v>6.2E-2</c:v>
                </c:pt>
                <c:pt idx="397">
                  <c:v>5.2999999999999999E-2</c:v>
                </c:pt>
                <c:pt idx="398">
                  <c:v>4.3999999999999997E-2</c:v>
                </c:pt>
                <c:pt idx="399">
                  <c:v>3.4000000000000002E-2</c:v>
                </c:pt>
                <c:pt idx="400">
                  <c:v>2.5000000000000001E-2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496-4CC3-8534-400DC70DE5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12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n-US" sz="8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dirty="0"/>
                  <a:t>Dose [</a:t>
                </a:r>
                <a:r>
                  <a:rPr lang="it-IT" dirty="0" err="1"/>
                  <a:t>cGy</a:t>
                </a:r>
                <a:r>
                  <a:rPr lang="it-IT" dirty="0"/>
                  <a:t>(RBE)]</a:t>
                </a:r>
              </a:p>
            </c:rich>
          </c:tx>
          <c:layout>
            <c:manualLayout>
              <c:xMode val="edge"/>
              <c:yMode val="edge"/>
              <c:x val="0.40240912698412701"/>
              <c:y val="0.902880000000000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en-US" sz="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8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8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dirty="0"/>
                  <a:t>Volume [%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8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 algn="ctr" rtl="0">
        <a:defRPr lang="en-US" sz="800" b="0" i="0" u="none" strike="noStrike" kern="1200" baseline="0">
          <a:solidFill>
            <a:prstClr val="black">
              <a:lumMod val="65000"/>
              <a:lumOff val="35000"/>
            </a:prstClr>
          </a:solidFill>
          <a:latin typeface="+mn-lt"/>
          <a:ea typeface="+mn-ea"/>
          <a:cs typeface="+mn-cs"/>
        </a:defRPr>
      </a:pPr>
      <a:endParaRPr lang="it-IT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oglio6!$A$1</c:f>
              <c:strCache>
                <c:ptCount val="1"/>
                <c:pt idx="0">
                  <c:v>S0,5NA</c:v>
                </c:pt>
              </c:strCache>
            </c:strRef>
          </c:tx>
          <c:spPr>
            <a:ln w="19050" cap="rnd">
              <a:solidFill>
                <a:srgbClr val="9DC3E6"/>
              </a:solidFill>
              <a:round/>
            </a:ln>
            <a:effectLst/>
          </c:spPr>
          <c:marker>
            <c:symbol val="none"/>
          </c:marker>
          <c:xVal>
            <c:numRef>
              <c:f>Foglio6!$A$1634:$A$203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5.0000000000000001E-3</c:v>
                </c:pt>
                <c:pt idx="71">
                  <c:v>2.1000000000000001E-2</c:v>
                </c:pt>
                <c:pt idx="72">
                  <c:v>3.6999999999999998E-2</c:v>
                </c:pt>
                <c:pt idx="73">
                  <c:v>5.1999999999999998E-2</c:v>
                </c:pt>
                <c:pt idx="74">
                  <c:v>6.8000000000000005E-2</c:v>
                </c:pt>
                <c:pt idx="75">
                  <c:v>8.3000000000000004E-2</c:v>
                </c:pt>
                <c:pt idx="76">
                  <c:v>9.9000000000000005E-2</c:v>
                </c:pt>
                <c:pt idx="77">
                  <c:v>0.115</c:v>
                </c:pt>
                <c:pt idx="78">
                  <c:v>0.13</c:v>
                </c:pt>
                <c:pt idx="79">
                  <c:v>0.14599999999999999</c:v>
                </c:pt>
                <c:pt idx="80">
                  <c:v>0.16200000000000001</c:v>
                </c:pt>
                <c:pt idx="81">
                  <c:v>0.17699999999999999</c:v>
                </c:pt>
                <c:pt idx="82">
                  <c:v>0.193</c:v>
                </c:pt>
                <c:pt idx="83">
                  <c:v>0.20799999999999999</c:v>
                </c:pt>
                <c:pt idx="84">
                  <c:v>0.224</c:v>
                </c:pt>
                <c:pt idx="85">
                  <c:v>0.24</c:v>
                </c:pt>
                <c:pt idx="86">
                  <c:v>0.255</c:v>
                </c:pt>
                <c:pt idx="87">
                  <c:v>0.27100000000000002</c:v>
                </c:pt>
                <c:pt idx="88">
                  <c:v>0.28699999999999998</c:v>
                </c:pt>
                <c:pt idx="89">
                  <c:v>0.30199999999999999</c:v>
                </c:pt>
                <c:pt idx="90">
                  <c:v>0.318</c:v>
                </c:pt>
                <c:pt idx="91">
                  <c:v>0.33400000000000002</c:v>
                </c:pt>
                <c:pt idx="92">
                  <c:v>0.34899999999999998</c:v>
                </c:pt>
                <c:pt idx="93">
                  <c:v>0.36499999999999999</c:v>
                </c:pt>
                <c:pt idx="94">
                  <c:v>0.38</c:v>
                </c:pt>
                <c:pt idx="95">
                  <c:v>0.39600000000000002</c:v>
                </c:pt>
                <c:pt idx="96">
                  <c:v>0.41199999999999998</c:v>
                </c:pt>
                <c:pt idx="97">
                  <c:v>0.42699999999999999</c:v>
                </c:pt>
                <c:pt idx="98">
                  <c:v>0.443</c:v>
                </c:pt>
                <c:pt idx="99">
                  <c:v>0.45900000000000002</c:v>
                </c:pt>
                <c:pt idx="100">
                  <c:v>0.47399999999999998</c:v>
                </c:pt>
                <c:pt idx="101">
                  <c:v>0.49</c:v>
                </c:pt>
                <c:pt idx="102">
                  <c:v>0.505</c:v>
                </c:pt>
                <c:pt idx="103">
                  <c:v>0.52100000000000002</c:v>
                </c:pt>
                <c:pt idx="104">
                  <c:v>0.53700000000000003</c:v>
                </c:pt>
                <c:pt idx="105">
                  <c:v>0.55200000000000005</c:v>
                </c:pt>
                <c:pt idx="106">
                  <c:v>0.56799999999999995</c:v>
                </c:pt>
                <c:pt idx="107">
                  <c:v>0.58399999999999996</c:v>
                </c:pt>
                <c:pt idx="108">
                  <c:v>0.59899999999999998</c:v>
                </c:pt>
                <c:pt idx="109">
                  <c:v>0.61499999999999999</c:v>
                </c:pt>
                <c:pt idx="110">
                  <c:v>0.63</c:v>
                </c:pt>
                <c:pt idx="111">
                  <c:v>0.64600000000000002</c:v>
                </c:pt>
                <c:pt idx="112">
                  <c:v>0.66200000000000003</c:v>
                </c:pt>
                <c:pt idx="113">
                  <c:v>0.67700000000000005</c:v>
                </c:pt>
                <c:pt idx="114">
                  <c:v>0.69299999999999995</c:v>
                </c:pt>
                <c:pt idx="115">
                  <c:v>0.70899999999999996</c:v>
                </c:pt>
                <c:pt idx="116">
                  <c:v>0.72399999999999998</c:v>
                </c:pt>
                <c:pt idx="117">
                  <c:v>0.74</c:v>
                </c:pt>
                <c:pt idx="118">
                  <c:v>0.75600000000000001</c:v>
                </c:pt>
                <c:pt idx="119">
                  <c:v>0.77100000000000002</c:v>
                </c:pt>
                <c:pt idx="120">
                  <c:v>0.78700000000000003</c:v>
                </c:pt>
                <c:pt idx="121">
                  <c:v>0.80200000000000005</c:v>
                </c:pt>
                <c:pt idx="122">
                  <c:v>0.81799999999999995</c:v>
                </c:pt>
                <c:pt idx="123">
                  <c:v>0.83399999999999996</c:v>
                </c:pt>
                <c:pt idx="124">
                  <c:v>0.84899999999999998</c:v>
                </c:pt>
                <c:pt idx="125">
                  <c:v>0.86499999999999999</c:v>
                </c:pt>
                <c:pt idx="126">
                  <c:v>0.88100000000000001</c:v>
                </c:pt>
                <c:pt idx="127">
                  <c:v>0.89600000000000002</c:v>
                </c:pt>
                <c:pt idx="128">
                  <c:v>0.91200000000000003</c:v>
                </c:pt>
                <c:pt idx="129">
                  <c:v>0.92700000000000005</c:v>
                </c:pt>
                <c:pt idx="130">
                  <c:v>0.94299999999999995</c:v>
                </c:pt>
                <c:pt idx="131">
                  <c:v>0.95899999999999996</c:v>
                </c:pt>
                <c:pt idx="132">
                  <c:v>0.97399999999999998</c:v>
                </c:pt>
                <c:pt idx="133">
                  <c:v>0.99</c:v>
                </c:pt>
                <c:pt idx="134">
                  <c:v>1.006</c:v>
                </c:pt>
                <c:pt idx="135">
                  <c:v>1.0209999999999999</c:v>
                </c:pt>
                <c:pt idx="136">
                  <c:v>1.0369999999999999</c:v>
                </c:pt>
                <c:pt idx="137">
                  <c:v>1.052</c:v>
                </c:pt>
                <c:pt idx="138">
                  <c:v>1.0680000000000001</c:v>
                </c:pt>
                <c:pt idx="139">
                  <c:v>1.0840000000000001</c:v>
                </c:pt>
                <c:pt idx="140">
                  <c:v>1.099</c:v>
                </c:pt>
                <c:pt idx="141">
                  <c:v>1.115</c:v>
                </c:pt>
                <c:pt idx="142">
                  <c:v>1.131</c:v>
                </c:pt>
                <c:pt idx="143">
                  <c:v>1.1459999999999999</c:v>
                </c:pt>
                <c:pt idx="144">
                  <c:v>1.1619999999999999</c:v>
                </c:pt>
                <c:pt idx="145">
                  <c:v>1.1779999999999999</c:v>
                </c:pt>
                <c:pt idx="146">
                  <c:v>1.1930000000000001</c:v>
                </c:pt>
                <c:pt idx="147">
                  <c:v>1.2869999999999999</c:v>
                </c:pt>
                <c:pt idx="148">
                  <c:v>1.401</c:v>
                </c:pt>
                <c:pt idx="149">
                  <c:v>1.514</c:v>
                </c:pt>
                <c:pt idx="150">
                  <c:v>1.6279999999999999</c:v>
                </c:pt>
                <c:pt idx="151">
                  <c:v>1.7410000000000001</c:v>
                </c:pt>
                <c:pt idx="152">
                  <c:v>1.855</c:v>
                </c:pt>
                <c:pt idx="153">
                  <c:v>1.968</c:v>
                </c:pt>
                <c:pt idx="154">
                  <c:v>2.081</c:v>
                </c:pt>
                <c:pt idx="155">
                  <c:v>2.1949999999999998</c:v>
                </c:pt>
                <c:pt idx="156">
                  <c:v>2.3079999999999998</c:v>
                </c:pt>
                <c:pt idx="157">
                  <c:v>2.468</c:v>
                </c:pt>
                <c:pt idx="158">
                  <c:v>2.7589999999999999</c:v>
                </c:pt>
                <c:pt idx="159">
                  <c:v>3.05</c:v>
                </c:pt>
                <c:pt idx="160">
                  <c:v>3.34</c:v>
                </c:pt>
                <c:pt idx="161">
                  <c:v>3.661</c:v>
                </c:pt>
                <c:pt idx="162">
                  <c:v>4.157</c:v>
                </c:pt>
                <c:pt idx="163">
                  <c:v>4.6520000000000001</c:v>
                </c:pt>
                <c:pt idx="164">
                  <c:v>5.3</c:v>
                </c:pt>
                <c:pt idx="165">
                  <c:v>5.9809999999999999</c:v>
                </c:pt>
                <c:pt idx="166">
                  <c:v>6.01</c:v>
                </c:pt>
                <c:pt idx="167">
                  <c:v>6.9180000000000001</c:v>
                </c:pt>
                <c:pt idx="168">
                  <c:v>7.98</c:v>
                </c:pt>
                <c:pt idx="169">
                  <c:v>9.2360000000000007</c:v>
                </c:pt>
                <c:pt idx="170">
                  <c:v>10.707000000000001</c:v>
                </c:pt>
                <c:pt idx="171">
                  <c:v>11.962</c:v>
                </c:pt>
                <c:pt idx="172">
                  <c:v>12.467000000000001</c:v>
                </c:pt>
                <c:pt idx="173">
                  <c:v>14.5</c:v>
                </c:pt>
                <c:pt idx="174">
                  <c:v>16.882000000000001</c:v>
                </c:pt>
                <c:pt idx="175">
                  <c:v>17.943999999999999</c:v>
                </c:pt>
                <c:pt idx="176">
                  <c:v>19.657</c:v>
                </c:pt>
                <c:pt idx="177">
                  <c:v>22.867999999999999</c:v>
                </c:pt>
                <c:pt idx="178">
                  <c:v>23.925000000000001</c:v>
                </c:pt>
                <c:pt idx="179">
                  <c:v>26.555</c:v>
                </c:pt>
                <c:pt idx="180">
                  <c:v>29.905999999999999</c:v>
                </c:pt>
                <c:pt idx="181">
                  <c:v>30.873999999999999</c:v>
                </c:pt>
                <c:pt idx="182">
                  <c:v>35.671999999999997</c:v>
                </c:pt>
                <c:pt idx="183">
                  <c:v>35.887</c:v>
                </c:pt>
                <c:pt idx="184">
                  <c:v>41.119</c:v>
                </c:pt>
                <c:pt idx="185">
                  <c:v>41.868000000000002</c:v>
                </c:pt>
                <c:pt idx="186">
                  <c:v>47.165999999999997</c:v>
                </c:pt>
                <c:pt idx="187">
                  <c:v>47.85</c:v>
                </c:pt>
                <c:pt idx="188">
                  <c:v>53.831000000000003</c:v>
                </c:pt>
                <c:pt idx="189">
                  <c:v>54.006999999999998</c:v>
                </c:pt>
                <c:pt idx="190">
                  <c:v>59.811999999999998</c:v>
                </c:pt>
                <c:pt idx="191">
                  <c:v>61.680999999999997</c:v>
                </c:pt>
                <c:pt idx="192">
                  <c:v>65.793000000000006</c:v>
                </c:pt>
                <c:pt idx="193">
                  <c:v>70.034000000000006</c:v>
                </c:pt>
                <c:pt idx="194">
                  <c:v>71.775000000000006</c:v>
                </c:pt>
                <c:pt idx="195">
                  <c:v>77.756</c:v>
                </c:pt>
                <c:pt idx="196">
                  <c:v>79.241</c:v>
                </c:pt>
                <c:pt idx="197">
                  <c:v>83.736999999999995</c:v>
                </c:pt>
                <c:pt idx="198">
                  <c:v>89.216999999999999</c:v>
                </c:pt>
                <c:pt idx="199">
                  <c:v>89.718000000000004</c:v>
                </c:pt>
                <c:pt idx="200">
                  <c:v>95.698999999999998</c:v>
                </c:pt>
                <c:pt idx="201">
                  <c:v>99.956000000000003</c:v>
                </c:pt>
                <c:pt idx="202">
                  <c:v>101.681</c:v>
                </c:pt>
                <c:pt idx="203">
                  <c:v>107.66200000000001</c:v>
                </c:pt>
                <c:pt idx="204">
                  <c:v>111.515</c:v>
                </c:pt>
                <c:pt idx="205">
                  <c:v>113.643</c:v>
                </c:pt>
                <c:pt idx="206">
                  <c:v>119.624</c:v>
                </c:pt>
                <c:pt idx="207">
                  <c:v>123.718</c:v>
                </c:pt>
                <c:pt idx="208">
                  <c:v>125.605</c:v>
                </c:pt>
                <c:pt idx="209">
                  <c:v>131.58699999999999</c:v>
                </c:pt>
                <c:pt idx="210">
                  <c:v>136.44</c:v>
                </c:pt>
                <c:pt idx="211">
                  <c:v>137.56800000000001</c:v>
                </c:pt>
                <c:pt idx="212">
                  <c:v>143.54900000000001</c:v>
                </c:pt>
                <c:pt idx="213">
                  <c:v>149.53</c:v>
                </c:pt>
                <c:pt idx="214">
                  <c:v>149.75399999999999</c:v>
                </c:pt>
                <c:pt idx="215">
                  <c:v>155.512</c:v>
                </c:pt>
                <c:pt idx="216">
                  <c:v>161.49299999999999</c:v>
                </c:pt>
                <c:pt idx="217">
                  <c:v>163.46899999999999</c:v>
                </c:pt>
                <c:pt idx="218">
                  <c:v>167.47399999999999</c:v>
                </c:pt>
                <c:pt idx="219">
                  <c:v>173.45500000000001</c:v>
                </c:pt>
                <c:pt idx="220">
                  <c:v>177.16900000000001</c:v>
                </c:pt>
                <c:pt idx="221">
                  <c:v>179.43600000000001</c:v>
                </c:pt>
                <c:pt idx="222">
                  <c:v>185.41800000000001</c:v>
                </c:pt>
                <c:pt idx="223">
                  <c:v>190.66300000000001</c:v>
                </c:pt>
                <c:pt idx="224">
                  <c:v>191.399</c:v>
                </c:pt>
                <c:pt idx="225">
                  <c:v>197.38</c:v>
                </c:pt>
                <c:pt idx="226">
                  <c:v>202.91</c:v>
                </c:pt>
                <c:pt idx="227">
                  <c:v>203.36099999999999</c:v>
                </c:pt>
                <c:pt idx="228">
                  <c:v>209.34200000000001</c:v>
                </c:pt>
                <c:pt idx="229">
                  <c:v>213.131</c:v>
                </c:pt>
                <c:pt idx="230">
                  <c:v>215.32400000000001</c:v>
                </c:pt>
                <c:pt idx="231">
                  <c:v>221.30500000000001</c:v>
                </c:pt>
                <c:pt idx="232">
                  <c:v>222.71899999999999</c:v>
                </c:pt>
                <c:pt idx="233">
                  <c:v>227.286</c:v>
                </c:pt>
                <c:pt idx="234">
                  <c:v>232.71</c:v>
                </c:pt>
                <c:pt idx="235">
                  <c:v>233.267</c:v>
                </c:pt>
                <c:pt idx="236">
                  <c:v>239.249</c:v>
                </c:pt>
                <c:pt idx="237">
                  <c:v>244.91499999999999</c:v>
                </c:pt>
                <c:pt idx="238">
                  <c:v>245.23</c:v>
                </c:pt>
                <c:pt idx="239">
                  <c:v>251.21100000000001</c:v>
                </c:pt>
                <c:pt idx="240">
                  <c:v>257.19200000000001</c:v>
                </c:pt>
                <c:pt idx="241">
                  <c:v>263.173</c:v>
                </c:pt>
                <c:pt idx="242">
                  <c:v>263.35599999999999</c:v>
                </c:pt>
                <c:pt idx="243">
                  <c:v>269.15499999999997</c:v>
                </c:pt>
                <c:pt idx="244">
                  <c:v>275.13600000000002</c:v>
                </c:pt>
                <c:pt idx="245">
                  <c:v>281.11700000000002</c:v>
                </c:pt>
                <c:pt idx="246">
                  <c:v>287.09800000000001</c:v>
                </c:pt>
                <c:pt idx="247">
                  <c:v>293.07900000000001</c:v>
                </c:pt>
                <c:pt idx="248">
                  <c:v>299.06099999999998</c:v>
                </c:pt>
                <c:pt idx="249">
                  <c:v>301.55399999999997</c:v>
                </c:pt>
                <c:pt idx="250">
                  <c:v>305.04199999999997</c:v>
                </c:pt>
                <c:pt idx="251">
                  <c:v>311.02300000000002</c:v>
                </c:pt>
                <c:pt idx="252">
                  <c:v>317.00400000000002</c:v>
                </c:pt>
                <c:pt idx="253">
                  <c:v>322.98599999999999</c:v>
                </c:pt>
                <c:pt idx="254">
                  <c:v>328.96699999999998</c:v>
                </c:pt>
                <c:pt idx="255">
                  <c:v>334.94799999999998</c:v>
                </c:pt>
                <c:pt idx="256">
                  <c:v>340.92899999999997</c:v>
                </c:pt>
                <c:pt idx="257">
                  <c:v>346.91</c:v>
                </c:pt>
                <c:pt idx="258">
                  <c:v>352.892</c:v>
                </c:pt>
                <c:pt idx="259">
                  <c:v>358.87299999999999</c:v>
                </c:pt>
                <c:pt idx="260">
                  <c:v>364.85399999999998</c:v>
                </c:pt>
                <c:pt idx="261">
                  <c:v>370.83499999999998</c:v>
                </c:pt>
                <c:pt idx="262">
                  <c:v>376.81599999999997</c:v>
                </c:pt>
                <c:pt idx="263">
                  <c:v>382.798</c:v>
                </c:pt>
                <c:pt idx="264">
                  <c:v>388.779</c:v>
                </c:pt>
                <c:pt idx="265">
                  <c:v>394.76</c:v>
                </c:pt>
                <c:pt idx="266">
                  <c:v>400.74099999999999</c:v>
                </c:pt>
                <c:pt idx="267">
                  <c:v>406.42500000000001</c:v>
                </c:pt>
                <c:pt idx="268">
                  <c:v>406.72300000000001</c:v>
                </c:pt>
                <c:pt idx="269">
                  <c:v>412.70400000000001</c:v>
                </c:pt>
                <c:pt idx="270">
                  <c:v>418.685</c:v>
                </c:pt>
                <c:pt idx="271">
                  <c:v>424.666</c:v>
                </c:pt>
                <c:pt idx="272">
                  <c:v>430.64699999999999</c:v>
                </c:pt>
                <c:pt idx="273">
                  <c:v>436.62900000000002</c:v>
                </c:pt>
                <c:pt idx="274">
                  <c:v>442.61</c:v>
                </c:pt>
                <c:pt idx="275">
                  <c:v>448.59100000000001</c:v>
                </c:pt>
                <c:pt idx="276">
                  <c:v>454.572</c:v>
                </c:pt>
                <c:pt idx="277">
                  <c:v>460.553</c:v>
                </c:pt>
                <c:pt idx="278">
                  <c:v>466.53500000000003</c:v>
                </c:pt>
                <c:pt idx="279">
                  <c:v>472.51600000000002</c:v>
                </c:pt>
                <c:pt idx="280">
                  <c:v>478.49700000000001</c:v>
                </c:pt>
                <c:pt idx="281">
                  <c:v>484.47800000000001</c:v>
                </c:pt>
                <c:pt idx="282">
                  <c:v>490.459</c:v>
                </c:pt>
                <c:pt idx="283">
                  <c:v>496.44099999999997</c:v>
                </c:pt>
                <c:pt idx="284">
                  <c:v>502.42200000000003</c:v>
                </c:pt>
                <c:pt idx="285">
                  <c:v>508.40300000000002</c:v>
                </c:pt>
                <c:pt idx="286">
                  <c:v>514.38400000000001</c:v>
                </c:pt>
                <c:pt idx="287">
                  <c:v>520.36599999999999</c:v>
                </c:pt>
                <c:pt idx="288">
                  <c:v>526.34699999999998</c:v>
                </c:pt>
                <c:pt idx="289">
                  <c:v>532.32799999999997</c:v>
                </c:pt>
                <c:pt idx="290">
                  <c:v>538.30899999999997</c:v>
                </c:pt>
                <c:pt idx="291">
                  <c:v>544.29</c:v>
                </c:pt>
                <c:pt idx="292">
                  <c:v>550.27200000000005</c:v>
                </c:pt>
                <c:pt idx="293">
                  <c:v>556.25300000000004</c:v>
                </c:pt>
                <c:pt idx="294">
                  <c:v>562.23400000000004</c:v>
                </c:pt>
                <c:pt idx="295">
                  <c:v>568.21500000000003</c:v>
                </c:pt>
                <c:pt idx="296">
                  <c:v>574.19600000000003</c:v>
                </c:pt>
                <c:pt idx="297">
                  <c:v>580.178</c:v>
                </c:pt>
                <c:pt idx="298">
                  <c:v>586.15899999999999</c:v>
                </c:pt>
                <c:pt idx="299">
                  <c:v>592.14</c:v>
                </c:pt>
                <c:pt idx="300">
                  <c:v>598.12099999999998</c:v>
                </c:pt>
                <c:pt idx="301">
                  <c:v>604.10299999999995</c:v>
                </c:pt>
                <c:pt idx="302">
                  <c:v>610.08399999999995</c:v>
                </c:pt>
                <c:pt idx="303">
                  <c:v>616.06500000000005</c:v>
                </c:pt>
                <c:pt idx="304">
                  <c:v>622.04600000000005</c:v>
                </c:pt>
                <c:pt idx="305">
                  <c:v>628.02700000000004</c:v>
                </c:pt>
                <c:pt idx="306">
                  <c:v>634.00900000000001</c:v>
                </c:pt>
                <c:pt idx="307">
                  <c:v>639.99</c:v>
                </c:pt>
                <c:pt idx="308">
                  <c:v>645.971</c:v>
                </c:pt>
                <c:pt idx="309">
                  <c:v>651.952</c:v>
                </c:pt>
                <c:pt idx="310">
                  <c:v>657.93299999999999</c:v>
                </c:pt>
                <c:pt idx="311">
                  <c:v>663.91499999999996</c:v>
                </c:pt>
                <c:pt idx="312">
                  <c:v>669.89599999999996</c:v>
                </c:pt>
                <c:pt idx="313">
                  <c:v>675.87699999999995</c:v>
                </c:pt>
                <c:pt idx="314">
                  <c:v>681.85799999999995</c:v>
                </c:pt>
                <c:pt idx="315">
                  <c:v>687.84</c:v>
                </c:pt>
                <c:pt idx="316">
                  <c:v>693.82100000000003</c:v>
                </c:pt>
                <c:pt idx="317">
                  <c:v>699.80200000000002</c:v>
                </c:pt>
                <c:pt idx="318">
                  <c:v>705.78300000000002</c:v>
                </c:pt>
                <c:pt idx="319">
                  <c:v>711.76400000000001</c:v>
                </c:pt>
                <c:pt idx="320">
                  <c:v>717.74599999999998</c:v>
                </c:pt>
                <c:pt idx="321">
                  <c:v>723.72699999999998</c:v>
                </c:pt>
                <c:pt idx="322">
                  <c:v>729.70799999999997</c:v>
                </c:pt>
                <c:pt idx="323">
                  <c:v>735.68899999999996</c:v>
                </c:pt>
                <c:pt idx="324">
                  <c:v>741.67</c:v>
                </c:pt>
                <c:pt idx="325">
                  <c:v>747.65200000000004</c:v>
                </c:pt>
                <c:pt idx="326">
                  <c:v>753.63300000000004</c:v>
                </c:pt>
                <c:pt idx="327">
                  <c:v>759.61400000000003</c:v>
                </c:pt>
                <c:pt idx="328">
                  <c:v>765.59500000000003</c:v>
                </c:pt>
                <c:pt idx="329">
                  <c:v>771.577</c:v>
                </c:pt>
                <c:pt idx="330">
                  <c:v>777.55799999999999</c:v>
                </c:pt>
                <c:pt idx="331">
                  <c:v>783.53899999999999</c:v>
                </c:pt>
                <c:pt idx="332">
                  <c:v>789.52</c:v>
                </c:pt>
                <c:pt idx="333">
                  <c:v>795.50099999999998</c:v>
                </c:pt>
                <c:pt idx="334">
                  <c:v>801.48299999999995</c:v>
                </c:pt>
                <c:pt idx="335">
                  <c:v>807.46400000000006</c:v>
                </c:pt>
                <c:pt idx="336">
                  <c:v>813.44500000000005</c:v>
                </c:pt>
                <c:pt idx="337">
                  <c:v>819.42600000000004</c:v>
                </c:pt>
                <c:pt idx="338">
                  <c:v>825.40700000000004</c:v>
                </c:pt>
                <c:pt idx="339">
                  <c:v>831.38900000000001</c:v>
                </c:pt>
                <c:pt idx="340">
                  <c:v>837.37</c:v>
                </c:pt>
                <c:pt idx="341">
                  <c:v>843.351</c:v>
                </c:pt>
                <c:pt idx="342">
                  <c:v>849.33199999999999</c:v>
                </c:pt>
                <c:pt idx="343">
                  <c:v>855.31399999999996</c:v>
                </c:pt>
                <c:pt idx="344">
                  <c:v>861.29499999999996</c:v>
                </c:pt>
                <c:pt idx="345">
                  <c:v>867.27599999999995</c:v>
                </c:pt>
                <c:pt idx="346">
                  <c:v>873.25699999999995</c:v>
                </c:pt>
                <c:pt idx="347">
                  <c:v>879.23800000000006</c:v>
                </c:pt>
                <c:pt idx="348">
                  <c:v>885.22</c:v>
                </c:pt>
                <c:pt idx="349">
                  <c:v>891.20100000000002</c:v>
                </c:pt>
                <c:pt idx="350">
                  <c:v>897.18200000000002</c:v>
                </c:pt>
                <c:pt idx="351">
                  <c:v>903.16300000000001</c:v>
                </c:pt>
                <c:pt idx="352">
                  <c:v>909.14400000000001</c:v>
                </c:pt>
                <c:pt idx="353">
                  <c:v>915.12599999999998</c:v>
                </c:pt>
                <c:pt idx="354">
                  <c:v>921.10699999999997</c:v>
                </c:pt>
                <c:pt idx="355">
                  <c:v>927.08799999999997</c:v>
                </c:pt>
                <c:pt idx="356">
                  <c:v>933.06899999999996</c:v>
                </c:pt>
                <c:pt idx="357">
                  <c:v>939.05100000000004</c:v>
                </c:pt>
                <c:pt idx="358">
                  <c:v>945.03200000000004</c:v>
                </c:pt>
                <c:pt idx="359">
                  <c:v>951.01300000000003</c:v>
                </c:pt>
                <c:pt idx="360">
                  <c:v>956.99400000000003</c:v>
                </c:pt>
                <c:pt idx="361">
                  <c:v>962.97500000000002</c:v>
                </c:pt>
                <c:pt idx="362">
                  <c:v>968.95699999999999</c:v>
                </c:pt>
                <c:pt idx="363">
                  <c:v>974.93799999999999</c:v>
                </c:pt>
                <c:pt idx="364">
                  <c:v>980.91899999999998</c:v>
                </c:pt>
                <c:pt idx="365">
                  <c:v>986.9</c:v>
                </c:pt>
                <c:pt idx="366">
                  <c:v>992.88099999999997</c:v>
                </c:pt>
                <c:pt idx="367">
                  <c:v>998.86300000000006</c:v>
                </c:pt>
                <c:pt idx="368">
                  <c:v>1004.8440000000001</c:v>
                </c:pt>
                <c:pt idx="369">
                  <c:v>1010.825</c:v>
                </c:pt>
                <c:pt idx="370">
                  <c:v>1016.806</c:v>
                </c:pt>
                <c:pt idx="371">
                  <c:v>1022.787</c:v>
                </c:pt>
                <c:pt idx="372">
                  <c:v>1028.769</c:v>
                </c:pt>
                <c:pt idx="373">
                  <c:v>1034.75</c:v>
                </c:pt>
                <c:pt idx="374">
                  <c:v>1040.731</c:v>
                </c:pt>
                <c:pt idx="375">
                  <c:v>1046.712</c:v>
                </c:pt>
                <c:pt idx="376">
                  <c:v>1052.694</c:v>
                </c:pt>
                <c:pt idx="377">
                  <c:v>1058.675</c:v>
                </c:pt>
                <c:pt idx="378">
                  <c:v>1064.6559999999999</c:v>
                </c:pt>
                <c:pt idx="379">
                  <c:v>1070.6369999999999</c:v>
                </c:pt>
                <c:pt idx="380">
                  <c:v>1076.6179999999999</c:v>
                </c:pt>
                <c:pt idx="381">
                  <c:v>1082.5999999999999</c:v>
                </c:pt>
                <c:pt idx="382">
                  <c:v>1088.5809999999999</c:v>
                </c:pt>
                <c:pt idx="383">
                  <c:v>1094.5619999999999</c:v>
                </c:pt>
                <c:pt idx="384">
                  <c:v>1100.5429999999999</c:v>
                </c:pt>
                <c:pt idx="385">
                  <c:v>1106.5239999999999</c:v>
                </c:pt>
                <c:pt idx="386">
                  <c:v>1112.5060000000001</c:v>
                </c:pt>
                <c:pt idx="387">
                  <c:v>1118.4870000000001</c:v>
                </c:pt>
                <c:pt idx="388">
                  <c:v>1124.4680000000001</c:v>
                </c:pt>
                <c:pt idx="389">
                  <c:v>1130.4490000000001</c:v>
                </c:pt>
                <c:pt idx="390">
                  <c:v>1136.431</c:v>
                </c:pt>
                <c:pt idx="391">
                  <c:v>1142.412</c:v>
                </c:pt>
                <c:pt idx="392">
                  <c:v>1148.393</c:v>
                </c:pt>
                <c:pt idx="393">
                  <c:v>1154.374</c:v>
                </c:pt>
                <c:pt idx="394">
                  <c:v>1160.355</c:v>
                </c:pt>
                <c:pt idx="395">
                  <c:v>1166.337</c:v>
                </c:pt>
                <c:pt idx="396">
                  <c:v>1172.318</c:v>
                </c:pt>
                <c:pt idx="397">
                  <c:v>1178.299</c:v>
                </c:pt>
                <c:pt idx="398">
                  <c:v>1184.28</c:v>
                </c:pt>
                <c:pt idx="399">
                  <c:v>1190.261</c:v>
                </c:pt>
                <c:pt idx="400">
                  <c:v>1196.2429999999999</c:v>
                </c:pt>
                <c:pt idx="401">
                  <c:v>1196.2429999999999</c:v>
                </c:pt>
              </c:numCache>
            </c:numRef>
          </c:xVal>
          <c:yVal>
            <c:numRef>
              <c:f>Foglio6!$B$1634:$B$203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.015999999999998</c:v>
                </c:pt>
                <c:pt idx="166">
                  <c:v>18</c:v>
                </c:pt>
                <c:pt idx="167">
                  <c:v>17.5</c:v>
                </c:pt>
                <c:pt idx="168">
                  <c:v>17</c:v>
                </c:pt>
                <c:pt idx="169">
                  <c:v>16.5</c:v>
                </c:pt>
                <c:pt idx="170">
                  <c:v>16</c:v>
                </c:pt>
                <c:pt idx="171">
                  <c:v>15.632999999999999</c:v>
                </c:pt>
                <c:pt idx="172">
                  <c:v>15.5</c:v>
                </c:pt>
                <c:pt idx="173">
                  <c:v>15</c:v>
                </c:pt>
                <c:pt idx="174">
                  <c:v>14.5</c:v>
                </c:pt>
                <c:pt idx="175">
                  <c:v>14.298</c:v>
                </c:pt>
                <c:pt idx="176">
                  <c:v>14</c:v>
                </c:pt>
                <c:pt idx="177">
                  <c:v>13.5</c:v>
                </c:pt>
                <c:pt idx="178">
                  <c:v>13.352</c:v>
                </c:pt>
                <c:pt idx="179">
                  <c:v>13</c:v>
                </c:pt>
                <c:pt idx="180">
                  <c:v>12.608000000000001</c:v>
                </c:pt>
                <c:pt idx="181">
                  <c:v>12.5</c:v>
                </c:pt>
                <c:pt idx="182">
                  <c:v>12</c:v>
                </c:pt>
                <c:pt idx="183">
                  <c:v>11.978999999999999</c:v>
                </c:pt>
                <c:pt idx="184">
                  <c:v>11.5</c:v>
                </c:pt>
                <c:pt idx="185">
                  <c:v>11.436</c:v>
                </c:pt>
                <c:pt idx="186">
                  <c:v>11</c:v>
                </c:pt>
                <c:pt idx="187">
                  <c:v>10.946</c:v>
                </c:pt>
                <c:pt idx="188">
                  <c:v>10.512</c:v>
                </c:pt>
                <c:pt idx="189">
                  <c:v>10.5</c:v>
                </c:pt>
                <c:pt idx="190">
                  <c:v>10.116</c:v>
                </c:pt>
                <c:pt idx="191">
                  <c:v>10</c:v>
                </c:pt>
                <c:pt idx="192">
                  <c:v>9.7490000000000006</c:v>
                </c:pt>
                <c:pt idx="193">
                  <c:v>9.5</c:v>
                </c:pt>
                <c:pt idx="194">
                  <c:v>9.4</c:v>
                </c:pt>
                <c:pt idx="195">
                  <c:v>9.077</c:v>
                </c:pt>
                <c:pt idx="196">
                  <c:v>9</c:v>
                </c:pt>
                <c:pt idx="197">
                  <c:v>8.7690000000000001</c:v>
                </c:pt>
                <c:pt idx="198">
                  <c:v>8.5</c:v>
                </c:pt>
                <c:pt idx="199">
                  <c:v>8.4760000000000009</c:v>
                </c:pt>
                <c:pt idx="200">
                  <c:v>8.1940000000000008</c:v>
                </c:pt>
                <c:pt idx="201">
                  <c:v>8</c:v>
                </c:pt>
                <c:pt idx="202">
                  <c:v>7.923</c:v>
                </c:pt>
                <c:pt idx="203">
                  <c:v>7.6639999999999997</c:v>
                </c:pt>
                <c:pt idx="204">
                  <c:v>7.5</c:v>
                </c:pt>
                <c:pt idx="205">
                  <c:v>7.4119999999999999</c:v>
                </c:pt>
                <c:pt idx="206">
                  <c:v>7.165</c:v>
                </c:pt>
                <c:pt idx="207">
                  <c:v>7</c:v>
                </c:pt>
                <c:pt idx="208">
                  <c:v>6.9249999999999998</c:v>
                </c:pt>
                <c:pt idx="209">
                  <c:v>6.6920000000000002</c:v>
                </c:pt>
                <c:pt idx="210">
                  <c:v>6.5</c:v>
                </c:pt>
                <c:pt idx="211">
                  <c:v>6.4580000000000002</c:v>
                </c:pt>
                <c:pt idx="212">
                  <c:v>6.2329999999999997</c:v>
                </c:pt>
                <c:pt idx="213">
                  <c:v>6.008</c:v>
                </c:pt>
                <c:pt idx="214">
                  <c:v>6</c:v>
                </c:pt>
                <c:pt idx="215">
                  <c:v>5.7889999999999997</c:v>
                </c:pt>
                <c:pt idx="216">
                  <c:v>5.5739999999999998</c:v>
                </c:pt>
                <c:pt idx="217">
                  <c:v>5.5</c:v>
                </c:pt>
                <c:pt idx="218">
                  <c:v>5.3529999999999998</c:v>
                </c:pt>
                <c:pt idx="219">
                  <c:v>5.1369999999999996</c:v>
                </c:pt>
                <c:pt idx="220">
                  <c:v>5</c:v>
                </c:pt>
                <c:pt idx="221">
                  <c:v>4.915</c:v>
                </c:pt>
                <c:pt idx="222">
                  <c:v>4.6980000000000004</c:v>
                </c:pt>
                <c:pt idx="223">
                  <c:v>4.5</c:v>
                </c:pt>
                <c:pt idx="224">
                  <c:v>4.4729999999999999</c:v>
                </c:pt>
                <c:pt idx="225">
                  <c:v>4.24</c:v>
                </c:pt>
                <c:pt idx="226">
                  <c:v>4</c:v>
                </c:pt>
                <c:pt idx="227">
                  <c:v>3.98</c:v>
                </c:pt>
                <c:pt idx="228">
                  <c:v>3.694</c:v>
                </c:pt>
                <c:pt idx="229">
                  <c:v>3.5</c:v>
                </c:pt>
                <c:pt idx="230">
                  <c:v>3.3820000000000001</c:v>
                </c:pt>
                <c:pt idx="231">
                  <c:v>3.0739999999999998</c:v>
                </c:pt>
                <c:pt idx="232">
                  <c:v>3</c:v>
                </c:pt>
                <c:pt idx="233">
                  <c:v>2.7629999999999999</c:v>
                </c:pt>
                <c:pt idx="234">
                  <c:v>2.5</c:v>
                </c:pt>
                <c:pt idx="235">
                  <c:v>2.4740000000000002</c:v>
                </c:pt>
                <c:pt idx="236">
                  <c:v>2.2120000000000002</c:v>
                </c:pt>
                <c:pt idx="237">
                  <c:v>2</c:v>
                </c:pt>
                <c:pt idx="238">
                  <c:v>1.9890000000000001</c:v>
                </c:pt>
                <c:pt idx="239">
                  <c:v>1.798</c:v>
                </c:pt>
                <c:pt idx="240">
                  <c:v>1.6359999999999999</c:v>
                </c:pt>
                <c:pt idx="241">
                  <c:v>1.504</c:v>
                </c:pt>
                <c:pt idx="242">
                  <c:v>1.5</c:v>
                </c:pt>
                <c:pt idx="243">
                  <c:v>1.389</c:v>
                </c:pt>
                <c:pt idx="244">
                  <c:v>1.2949999999999999</c:v>
                </c:pt>
                <c:pt idx="245">
                  <c:v>1.2110000000000001</c:v>
                </c:pt>
                <c:pt idx="246">
                  <c:v>1.141</c:v>
                </c:pt>
                <c:pt idx="247">
                  <c:v>1.079</c:v>
                </c:pt>
                <c:pt idx="248">
                  <c:v>1.022</c:v>
                </c:pt>
                <c:pt idx="249">
                  <c:v>1</c:v>
                </c:pt>
                <c:pt idx="250">
                  <c:v>0.97099999999999997</c:v>
                </c:pt>
                <c:pt idx="251">
                  <c:v>0.92700000000000005</c:v>
                </c:pt>
                <c:pt idx="252">
                  <c:v>0.88500000000000001</c:v>
                </c:pt>
                <c:pt idx="253">
                  <c:v>0.84699999999999998</c:v>
                </c:pt>
                <c:pt idx="254">
                  <c:v>0.81200000000000006</c:v>
                </c:pt>
                <c:pt idx="255">
                  <c:v>0.77900000000000003</c:v>
                </c:pt>
                <c:pt idx="256">
                  <c:v>0.75</c:v>
                </c:pt>
                <c:pt idx="257">
                  <c:v>0.72</c:v>
                </c:pt>
                <c:pt idx="258">
                  <c:v>0.69199999999999995</c:v>
                </c:pt>
                <c:pt idx="259">
                  <c:v>0.66600000000000004</c:v>
                </c:pt>
                <c:pt idx="260">
                  <c:v>0.64300000000000002</c:v>
                </c:pt>
                <c:pt idx="261">
                  <c:v>0.621</c:v>
                </c:pt>
                <c:pt idx="262">
                  <c:v>0.59799999999999998</c:v>
                </c:pt>
                <c:pt idx="263">
                  <c:v>0.57599999999999996</c:v>
                </c:pt>
                <c:pt idx="264">
                  <c:v>0.55700000000000005</c:v>
                </c:pt>
                <c:pt idx="265">
                  <c:v>0.53500000000000003</c:v>
                </c:pt>
                <c:pt idx="266">
                  <c:v>0.51800000000000002</c:v>
                </c:pt>
                <c:pt idx="267">
                  <c:v>0.5</c:v>
                </c:pt>
                <c:pt idx="268">
                  <c:v>0.499</c:v>
                </c:pt>
                <c:pt idx="269">
                  <c:v>0.48199999999999998</c:v>
                </c:pt>
                <c:pt idx="270">
                  <c:v>0.46600000000000003</c:v>
                </c:pt>
                <c:pt idx="271">
                  <c:v>0.45</c:v>
                </c:pt>
                <c:pt idx="272">
                  <c:v>0.433</c:v>
                </c:pt>
                <c:pt idx="273">
                  <c:v>0.41599999999999998</c:v>
                </c:pt>
                <c:pt idx="274">
                  <c:v>0.40200000000000002</c:v>
                </c:pt>
                <c:pt idx="275">
                  <c:v>0.38800000000000001</c:v>
                </c:pt>
                <c:pt idx="276">
                  <c:v>0.374</c:v>
                </c:pt>
                <c:pt idx="277">
                  <c:v>0.36099999999999999</c:v>
                </c:pt>
                <c:pt idx="278">
                  <c:v>0.34899999999999998</c:v>
                </c:pt>
                <c:pt idx="279">
                  <c:v>0.33600000000000002</c:v>
                </c:pt>
                <c:pt idx="280">
                  <c:v>0.32300000000000001</c:v>
                </c:pt>
                <c:pt idx="281">
                  <c:v>0.311</c:v>
                </c:pt>
                <c:pt idx="282">
                  <c:v>0.29899999999999999</c:v>
                </c:pt>
                <c:pt idx="283">
                  <c:v>0.28699999999999998</c:v>
                </c:pt>
                <c:pt idx="284">
                  <c:v>0.27600000000000002</c:v>
                </c:pt>
                <c:pt idx="285">
                  <c:v>0.26700000000000002</c:v>
                </c:pt>
                <c:pt idx="286">
                  <c:v>0.25700000000000001</c:v>
                </c:pt>
                <c:pt idx="287">
                  <c:v>0.247</c:v>
                </c:pt>
                <c:pt idx="288">
                  <c:v>0.23699999999999999</c:v>
                </c:pt>
                <c:pt idx="289">
                  <c:v>0.22700000000000001</c:v>
                </c:pt>
                <c:pt idx="290">
                  <c:v>0.219</c:v>
                </c:pt>
                <c:pt idx="291">
                  <c:v>0.21</c:v>
                </c:pt>
                <c:pt idx="292">
                  <c:v>0.20200000000000001</c:v>
                </c:pt>
                <c:pt idx="293">
                  <c:v>0.19400000000000001</c:v>
                </c:pt>
                <c:pt idx="294">
                  <c:v>0.186</c:v>
                </c:pt>
                <c:pt idx="295">
                  <c:v>0.17799999999999999</c:v>
                </c:pt>
                <c:pt idx="296">
                  <c:v>0.17100000000000001</c:v>
                </c:pt>
                <c:pt idx="297">
                  <c:v>0.16500000000000001</c:v>
                </c:pt>
                <c:pt idx="298">
                  <c:v>0.158</c:v>
                </c:pt>
                <c:pt idx="299">
                  <c:v>0.152</c:v>
                </c:pt>
                <c:pt idx="300">
                  <c:v>0.14599999999999999</c:v>
                </c:pt>
                <c:pt idx="301">
                  <c:v>0.13900000000000001</c:v>
                </c:pt>
                <c:pt idx="302">
                  <c:v>0.13300000000000001</c:v>
                </c:pt>
                <c:pt idx="303">
                  <c:v>0.128</c:v>
                </c:pt>
                <c:pt idx="304">
                  <c:v>0.122</c:v>
                </c:pt>
                <c:pt idx="305">
                  <c:v>0.11700000000000001</c:v>
                </c:pt>
                <c:pt idx="306">
                  <c:v>0.112</c:v>
                </c:pt>
                <c:pt idx="307">
                  <c:v>0.106</c:v>
                </c:pt>
                <c:pt idx="308">
                  <c:v>0.10299999999999999</c:v>
                </c:pt>
                <c:pt idx="309">
                  <c:v>9.8000000000000004E-2</c:v>
                </c:pt>
                <c:pt idx="310">
                  <c:v>9.5000000000000001E-2</c:v>
                </c:pt>
                <c:pt idx="311">
                  <c:v>0.09</c:v>
                </c:pt>
                <c:pt idx="312">
                  <c:v>8.6999999999999994E-2</c:v>
                </c:pt>
                <c:pt idx="313">
                  <c:v>8.3000000000000004E-2</c:v>
                </c:pt>
                <c:pt idx="314">
                  <c:v>0.08</c:v>
                </c:pt>
                <c:pt idx="315">
                  <c:v>7.5999999999999998E-2</c:v>
                </c:pt>
                <c:pt idx="316">
                  <c:v>7.1999999999999995E-2</c:v>
                </c:pt>
                <c:pt idx="317">
                  <c:v>6.9000000000000006E-2</c:v>
                </c:pt>
                <c:pt idx="318">
                  <c:v>6.5000000000000002E-2</c:v>
                </c:pt>
                <c:pt idx="319">
                  <c:v>6.3E-2</c:v>
                </c:pt>
                <c:pt idx="320">
                  <c:v>5.8999999999999997E-2</c:v>
                </c:pt>
                <c:pt idx="321">
                  <c:v>5.7000000000000002E-2</c:v>
                </c:pt>
                <c:pt idx="322">
                  <c:v>5.3999999999999999E-2</c:v>
                </c:pt>
                <c:pt idx="323">
                  <c:v>5.0999999999999997E-2</c:v>
                </c:pt>
                <c:pt idx="324">
                  <c:v>4.9000000000000002E-2</c:v>
                </c:pt>
                <c:pt idx="325">
                  <c:v>4.7E-2</c:v>
                </c:pt>
                <c:pt idx="326">
                  <c:v>4.4999999999999998E-2</c:v>
                </c:pt>
                <c:pt idx="327">
                  <c:v>4.2000000000000003E-2</c:v>
                </c:pt>
                <c:pt idx="328">
                  <c:v>0.04</c:v>
                </c:pt>
                <c:pt idx="329">
                  <c:v>3.7999999999999999E-2</c:v>
                </c:pt>
                <c:pt idx="330">
                  <c:v>3.5999999999999997E-2</c:v>
                </c:pt>
                <c:pt idx="331">
                  <c:v>3.4000000000000002E-2</c:v>
                </c:pt>
                <c:pt idx="332">
                  <c:v>3.1E-2</c:v>
                </c:pt>
                <c:pt idx="333">
                  <c:v>2.9000000000000001E-2</c:v>
                </c:pt>
                <c:pt idx="334">
                  <c:v>2.8000000000000001E-2</c:v>
                </c:pt>
                <c:pt idx="335">
                  <c:v>2.5999999999999999E-2</c:v>
                </c:pt>
                <c:pt idx="336">
                  <c:v>2.4E-2</c:v>
                </c:pt>
                <c:pt idx="337">
                  <c:v>2.3E-2</c:v>
                </c:pt>
                <c:pt idx="338">
                  <c:v>2.1999999999999999E-2</c:v>
                </c:pt>
                <c:pt idx="339">
                  <c:v>2.1000000000000001E-2</c:v>
                </c:pt>
                <c:pt idx="340">
                  <c:v>1.9E-2</c:v>
                </c:pt>
                <c:pt idx="341">
                  <c:v>1.7999999999999999E-2</c:v>
                </c:pt>
                <c:pt idx="342">
                  <c:v>1.7000000000000001E-2</c:v>
                </c:pt>
                <c:pt idx="343">
                  <c:v>1.4999999999999999E-2</c:v>
                </c:pt>
                <c:pt idx="344">
                  <c:v>1.4E-2</c:v>
                </c:pt>
                <c:pt idx="345">
                  <c:v>1.2999999999999999E-2</c:v>
                </c:pt>
                <c:pt idx="346">
                  <c:v>1.2E-2</c:v>
                </c:pt>
                <c:pt idx="347">
                  <c:v>1.0999999999999999E-2</c:v>
                </c:pt>
                <c:pt idx="348">
                  <c:v>0.01</c:v>
                </c:pt>
                <c:pt idx="349">
                  <c:v>8.9999999999999993E-3</c:v>
                </c:pt>
                <c:pt idx="350">
                  <c:v>8.0000000000000002E-3</c:v>
                </c:pt>
                <c:pt idx="351">
                  <c:v>8.0000000000000002E-3</c:v>
                </c:pt>
                <c:pt idx="352">
                  <c:v>7.0000000000000001E-3</c:v>
                </c:pt>
                <c:pt idx="353">
                  <c:v>7.0000000000000001E-3</c:v>
                </c:pt>
                <c:pt idx="354">
                  <c:v>6.0000000000000001E-3</c:v>
                </c:pt>
                <c:pt idx="355">
                  <c:v>5.0000000000000001E-3</c:v>
                </c:pt>
                <c:pt idx="356">
                  <c:v>5.0000000000000001E-3</c:v>
                </c:pt>
                <c:pt idx="357">
                  <c:v>4.0000000000000001E-3</c:v>
                </c:pt>
                <c:pt idx="358">
                  <c:v>4.0000000000000001E-3</c:v>
                </c:pt>
                <c:pt idx="359">
                  <c:v>3.0000000000000001E-3</c:v>
                </c:pt>
                <c:pt idx="360">
                  <c:v>3.0000000000000001E-3</c:v>
                </c:pt>
                <c:pt idx="361">
                  <c:v>3.0000000000000001E-3</c:v>
                </c:pt>
                <c:pt idx="362">
                  <c:v>2E-3</c:v>
                </c:pt>
                <c:pt idx="363">
                  <c:v>2E-3</c:v>
                </c:pt>
                <c:pt idx="364">
                  <c:v>2E-3</c:v>
                </c:pt>
                <c:pt idx="365">
                  <c:v>2E-3</c:v>
                </c:pt>
                <c:pt idx="366">
                  <c:v>1E-3</c:v>
                </c:pt>
                <c:pt idx="367">
                  <c:v>1E-3</c:v>
                </c:pt>
                <c:pt idx="368">
                  <c:v>1E-3</c:v>
                </c:pt>
                <c:pt idx="369">
                  <c:v>1E-3</c:v>
                </c:pt>
                <c:pt idx="370">
                  <c:v>1E-3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E28-411E-AF58-EA6FBC711BBE}"/>
            </c:ext>
          </c:extLst>
        </c:ser>
        <c:ser>
          <c:idx val="3"/>
          <c:order val="1"/>
          <c:tx>
            <c:strRef>
              <c:f>Foglio6!$C$1</c:f>
              <c:strCache>
                <c:ptCount val="1"/>
                <c:pt idx="0">
                  <c:v>S1,0NA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xVal>
            <c:numRef>
              <c:f>Foglio6!$C$1634:$C$203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1E-3</c:v>
                </c:pt>
                <c:pt idx="71">
                  <c:v>1.7999999999999999E-2</c:v>
                </c:pt>
                <c:pt idx="72">
                  <c:v>3.5000000000000003E-2</c:v>
                </c:pt>
                <c:pt idx="73">
                  <c:v>5.1999999999999998E-2</c:v>
                </c:pt>
                <c:pt idx="74">
                  <c:v>6.9000000000000006E-2</c:v>
                </c:pt>
                <c:pt idx="75">
                  <c:v>8.5000000000000006E-2</c:v>
                </c:pt>
                <c:pt idx="76">
                  <c:v>0.10199999999999999</c:v>
                </c:pt>
                <c:pt idx="77">
                  <c:v>0.11899999999999999</c:v>
                </c:pt>
                <c:pt idx="78">
                  <c:v>0.13600000000000001</c:v>
                </c:pt>
                <c:pt idx="79">
                  <c:v>0.153</c:v>
                </c:pt>
                <c:pt idx="80">
                  <c:v>0.16900000000000001</c:v>
                </c:pt>
                <c:pt idx="81">
                  <c:v>0.186</c:v>
                </c:pt>
                <c:pt idx="82">
                  <c:v>0.20300000000000001</c:v>
                </c:pt>
                <c:pt idx="83">
                  <c:v>0.22</c:v>
                </c:pt>
                <c:pt idx="84">
                  <c:v>0.23699999999999999</c:v>
                </c:pt>
                <c:pt idx="85">
                  <c:v>0.253</c:v>
                </c:pt>
                <c:pt idx="86">
                  <c:v>0.27</c:v>
                </c:pt>
                <c:pt idx="87">
                  <c:v>0.28699999999999998</c:v>
                </c:pt>
                <c:pt idx="88">
                  <c:v>0.30399999999999999</c:v>
                </c:pt>
                <c:pt idx="89">
                  <c:v>0.32100000000000001</c:v>
                </c:pt>
                <c:pt idx="90">
                  <c:v>0.33700000000000002</c:v>
                </c:pt>
                <c:pt idx="91">
                  <c:v>0.35399999999999998</c:v>
                </c:pt>
                <c:pt idx="92">
                  <c:v>0.371</c:v>
                </c:pt>
                <c:pt idx="93">
                  <c:v>0.38800000000000001</c:v>
                </c:pt>
                <c:pt idx="94">
                  <c:v>0.40500000000000003</c:v>
                </c:pt>
                <c:pt idx="95">
                  <c:v>0.42199999999999999</c:v>
                </c:pt>
                <c:pt idx="96">
                  <c:v>0.438</c:v>
                </c:pt>
                <c:pt idx="97">
                  <c:v>0.45500000000000002</c:v>
                </c:pt>
                <c:pt idx="98">
                  <c:v>0.47199999999999998</c:v>
                </c:pt>
                <c:pt idx="99">
                  <c:v>0.48899999999999999</c:v>
                </c:pt>
                <c:pt idx="100">
                  <c:v>0.50600000000000001</c:v>
                </c:pt>
                <c:pt idx="101">
                  <c:v>0.52200000000000002</c:v>
                </c:pt>
                <c:pt idx="102">
                  <c:v>0.53900000000000003</c:v>
                </c:pt>
                <c:pt idx="103">
                  <c:v>0.55600000000000005</c:v>
                </c:pt>
                <c:pt idx="104">
                  <c:v>0.57299999999999995</c:v>
                </c:pt>
                <c:pt idx="105">
                  <c:v>0.59</c:v>
                </c:pt>
                <c:pt idx="106">
                  <c:v>0.60599999999999998</c:v>
                </c:pt>
                <c:pt idx="107">
                  <c:v>0.623</c:v>
                </c:pt>
                <c:pt idx="108">
                  <c:v>0.64</c:v>
                </c:pt>
                <c:pt idx="109">
                  <c:v>0.65700000000000003</c:v>
                </c:pt>
                <c:pt idx="110">
                  <c:v>0.67400000000000004</c:v>
                </c:pt>
                <c:pt idx="111">
                  <c:v>0.69</c:v>
                </c:pt>
                <c:pt idx="112">
                  <c:v>0.70699999999999996</c:v>
                </c:pt>
                <c:pt idx="113">
                  <c:v>0.72399999999999998</c:v>
                </c:pt>
                <c:pt idx="114">
                  <c:v>0.74099999999999999</c:v>
                </c:pt>
                <c:pt idx="115">
                  <c:v>0.75800000000000001</c:v>
                </c:pt>
                <c:pt idx="116">
                  <c:v>0.77400000000000002</c:v>
                </c:pt>
                <c:pt idx="117">
                  <c:v>0.79100000000000004</c:v>
                </c:pt>
                <c:pt idx="118">
                  <c:v>0.80800000000000005</c:v>
                </c:pt>
                <c:pt idx="119">
                  <c:v>0.82499999999999996</c:v>
                </c:pt>
                <c:pt idx="120">
                  <c:v>0.84199999999999997</c:v>
                </c:pt>
                <c:pt idx="121">
                  <c:v>0.85899999999999999</c:v>
                </c:pt>
                <c:pt idx="122">
                  <c:v>0.875</c:v>
                </c:pt>
                <c:pt idx="123">
                  <c:v>0.89200000000000002</c:v>
                </c:pt>
                <c:pt idx="124">
                  <c:v>0.90900000000000003</c:v>
                </c:pt>
                <c:pt idx="125">
                  <c:v>0.92600000000000005</c:v>
                </c:pt>
                <c:pt idx="126">
                  <c:v>0.94299999999999995</c:v>
                </c:pt>
                <c:pt idx="127">
                  <c:v>0.95899999999999996</c:v>
                </c:pt>
                <c:pt idx="128">
                  <c:v>0.97599999999999998</c:v>
                </c:pt>
                <c:pt idx="129">
                  <c:v>0.99299999999999999</c:v>
                </c:pt>
                <c:pt idx="130">
                  <c:v>1.01</c:v>
                </c:pt>
                <c:pt idx="131">
                  <c:v>1.0269999999999999</c:v>
                </c:pt>
                <c:pt idx="132">
                  <c:v>1.0429999999999999</c:v>
                </c:pt>
                <c:pt idx="133">
                  <c:v>1.06</c:v>
                </c:pt>
                <c:pt idx="134">
                  <c:v>1.077</c:v>
                </c:pt>
                <c:pt idx="135">
                  <c:v>1.0940000000000001</c:v>
                </c:pt>
                <c:pt idx="136">
                  <c:v>1.111</c:v>
                </c:pt>
                <c:pt idx="137">
                  <c:v>1.127</c:v>
                </c:pt>
                <c:pt idx="138">
                  <c:v>1.1439999999999999</c:v>
                </c:pt>
                <c:pt idx="139">
                  <c:v>1.161</c:v>
                </c:pt>
                <c:pt idx="140">
                  <c:v>1.1779999999999999</c:v>
                </c:pt>
                <c:pt idx="141">
                  <c:v>1.1950000000000001</c:v>
                </c:pt>
                <c:pt idx="142">
                  <c:v>1.2110000000000001</c:v>
                </c:pt>
                <c:pt idx="143">
                  <c:v>1.228</c:v>
                </c:pt>
                <c:pt idx="144">
                  <c:v>1.2450000000000001</c:v>
                </c:pt>
                <c:pt idx="145">
                  <c:v>1.262</c:v>
                </c:pt>
                <c:pt idx="146">
                  <c:v>1.2789999999999999</c:v>
                </c:pt>
                <c:pt idx="147">
                  <c:v>1.3380000000000001</c:v>
                </c:pt>
                <c:pt idx="148">
                  <c:v>1.462</c:v>
                </c:pt>
                <c:pt idx="149">
                  <c:v>1.5860000000000001</c:v>
                </c:pt>
                <c:pt idx="150">
                  <c:v>1.71</c:v>
                </c:pt>
                <c:pt idx="151">
                  <c:v>1.8340000000000001</c:v>
                </c:pt>
                <c:pt idx="152">
                  <c:v>1.958</c:v>
                </c:pt>
                <c:pt idx="153">
                  <c:v>2.0819999999999999</c:v>
                </c:pt>
                <c:pt idx="154">
                  <c:v>2.206</c:v>
                </c:pt>
                <c:pt idx="155">
                  <c:v>2.3290000000000002</c:v>
                </c:pt>
                <c:pt idx="156">
                  <c:v>2.4529999999999998</c:v>
                </c:pt>
                <c:pt idx="157">
                  <c:v>2.577</c:v>
                </c:pt>
                <c:pt idx="158">
                  <c:v>2.8929999999999998</c:v>
                </c:pt>
                <c:pt idx="159">
                  <c:v>3.2090000000000001</c:v>
                </c:pt>
                <c:pt idx="160">
                  <c:v>3.5249999999999999</c:v>
                </c:pt>
                <c:pt idx="161">
                  <c:v>3.8410000000000002</c:v>
                </c:pt>
                <c:pt idx="162">
                  <c:v>4.3600000000000003</c:v>
                </c:pt>
                <c:pt idx="163">
                  <c:v>4.8970000000000002</c:v>
                </c:pt>
                <c:pt idx="164">
                  <c:v>5.5519999999999996</c:v>
                </c:pt>
                <c:pt idx="165">
                  <c:v>6.3159999999999998</c:v>
                </c:pt>
                <c:pt idx="166">
                  <c:v>6.444</c:v>
                </c:pt>
                <c:pt idx="167">
                  <c:v>7.274</c:v>
                </c:pt>
                <c:pt idx="168">
                  <c:v>8.3960000000000008</c:v>
                </c:pt>
                <c:pt idx="169">
                  <c:v>9.7309999999999999</c:v>
                </c:pt>
                <c:pt idx="170">
                  <c:v>11.301</c:v>
                </c:pt>
                <c:pt idx="171">
                  <c:v>12.888</c:v>
                </c:pt>
                <c:pt idx="172">
                  <c:v>13.166</c:v>
                </c:pt>
                <c:pt idx="173">
                  <c:v>15.363</c:v>
                </c:pt>
                <c:pt idx="174">
                  <c:v>17.934999999999999</c:v>
                </c:pt>
                <c:pt idx="175">
                  <c:v>19.332000000000001</c:v>
                </c:pt>
                <c:pt idx="176">
                  <c:v>20.887</c:v>
                </c:pt>
                <c:pt idx="177">
                  <c:v>24.341999999999999</c:v>
                </c:pt>
                <c:pt idx="178">
                  <c:v>25.776</c:v>
                </c:pt>
                <c:pt idx="179">
                  <c:v>28.315000000000001</c:v>
                </c:pt>
                <c:pt idx="180">
                  <c:v>32.220999999999997</c:v>
                </c:pt>
                <c:pt idx="181">
                  <c:v>32.866999999999997</c:v>
                </c:pt>
                <c:pt idx="182">
                  <c:v>38.045999999999999</c:v>
                </c:pt>
                <c:pt idx="183">
                  <c:v>38.664999999999999</c:v>
                </c:pt>
                <c:pt idx="184">
                  <c:v>43.917999999999999</c:v>
                </c:pt>
                <c:pt idx="185">
                  <c:v>45.109000000000002</c:v>
                </c:pt>
                <c:pt idx="186">
                  <c:v>50.442999999999998</c:v>
                </c:pt>
                <c:pt idx="187">
                  <c:v>51.552999999999997</c:v>
                </c:pt>
                <c:pt idx="188">
                  <c:v>57.814999999999998</c:v>
                </c:pt>
                <c:pt idx="189">
                  <c:v>57.997</c:v>
                </c:pt>
                <c:pt idx="190">
                  <c:v>64.441000000000003</c:v>
                </c:pt>
                <c:pt idx="191">
                  <c:v>65.921000000000006</c:v>
                </c:pt>
                <c:pt idx="192">
                  <c:v>70.885000000000005</c:v>
                </c:pt>
                <c:pt idx="193">
                  <c:v>74.866</c:v>
                </c:pt>
                <c:pt idx="194">
                  <c:v>77.328999999999994</c:v>
                </c:pt>
                <c:pt idx="195">
                  <c:v>83.772999999999996</c:v>
                </c:pt>
                <c:pt idx="196">
                  <c:v>84.643000000000001</c:v>
                </c:pt>
                <c:pt idx="197">
                  <c:v>90.216999999999999</c:v>
                </c:pt>
                <c:pt idx="198">
                  <c:v>95.132000000000005</c:v>
                </c:pt>
                <c:pt idx="199">
                  <c:v>96.662000000000006</c:v>
                </c:pt>
                <c:pt idx="200">
                  <c:v>103.10599999999999</c:v>
                </c:pt>
                <c:pt idx="201">
                  <c:v>106.40900000000001</c:v>
                </c:pt>
                <c:pt idx="202">
                  <c:v>109.55</c:v>
                </c:pt>
                <c:pt idx="203">
                  <c:v>115.994</c:v>
                </c:pt>
                <c:pt idx="204">
                  <c:v>118.54</c:v>
                </c:pt>
                <c:pt idx="205">
                  <c:v>122.438</c:v>
                </c:pt>
                <c:pt idx="206">
                  <c:v>128.88200000000001</c:v>
                </c:pt>
                <c:pt idx="207">
                  <c:v>130.959</c:v>
                </c:pt>
                <c:pt idx="208">
                  <c:v>135.32599999999999</c:v>
                </c:pt>
                <c:pt idx="209">
                  <c:v>141.77000000000001</c:v>
                </c:pt>
                <c:pt idx="210">
                  <c:v>144.51400000000001</c:v>
                </c:pt>
                <c:pt idx="211">
                  <c:v>148.214</c:v>
                </c:pt>
                <c:pt idx="212">
                  <c:v>154.65799999999999</c:v>
                </c:pt>
                <c:pt idx="213">
                  <c:v>158.167</c:v>
                </c:pt>
                <c:pt idx="214">
                  <c:v>161.10300000000001</c:v>
                </c:pt>
                <c:pt idx="215">
                  <c:v>167.547</c:v>
                </c:pt>
                <c:pt idx="216">
                  <c:v>171.95599999999999</c:v>
                </c:pt>
                <c:pt idx="217">
                  <c:v>173.99100000000001</c:v>
                </c:pt>
                <c:pt idx="218">
                  <c:v>180.435</c:v>
                </c:pt>
                <c:pt idx="219">
                  <c:v>185.81</c:v>
                </c:pt>
                <c:pt idx="220">
                  <c:v>186.87899999999999</c:v>
                </c:pt>
                <c:pt idx="221">
                  <c:v>193.32300000000001</c:v>
                </c:pt>
                <c:pt idx="222">
                  <c:v>199.53100000000001</c:v>
                </c:pt>
                <c:pt idx="223">
                  <c:v>199.767</c:v>
                </c:pt>
                <c:pt idx="224">
                  <c:v>206.21100000000001</c:v>
                </c:pt>
                <c:pt idx="225">
                  <c:v>212.655</c:v>
                </c:pt>
                <c:pt idx="226">
                  <c:v>213.255</c:v>
                </c:pt>
                <c:pt idx="227">
                  <c:v>219.09899999999999</c:v>
                </c:pt>
                <c:pt idx="228">
                  <c:v>225.54400000000001</c:v>
                </c:pt>
                <c:pt idx="229">
                  <c:v>226.25</c:v>
                </c:pt>
                <c:pt idx="230">
                  <c:v>231.988</c:v>
                </c:pt>
                <c:pt idx="231">
                  <c:v>237.67099999999999</c:v>
                </c:pt>
                <c:pt idx="232">
                  <c:v>238.43199999999999</c:v>
                </c:pt>
                <c:pt idx="233">
                  <c:v>244.876</c:v>
                </c:pt>
                <c:pt idx="234">
                  <c:v>248.92099999999999</c:v>
                </c:pt>
                <c:pt idx="235">
                  <c:v>251.32</c:v>
                </c:pt>
                <c:pt idx="236">
                  <c:v>257.76400000000001</c:v>
                </c:pt>
                <c:pt idx="237">
                  <c:v>262.58699999999999</c:v>
                </c:pt>
                <c:pt idx="238">
                  <c:v>264.20800000000003</c:v>
                </c:pt>
                <c:pt idx="239">
                  <c:v>270.65199999999999</c:v>
                </c:pt>
                <c:pt idx="240">
                  <c:v>277.096</c:v>
                </c:pt>
                <c:pt idx="241">
                  <c:v>283.54000000000002</c:v>
                </c:pt>
                <c:pt idx="242">
                  <c:v>284.24599999999998</c:v>
                </c:pt>
                <c:pt idx="243">
                  <c:v>289.98500000000001</c:v>
                </c:pt>
                <c:pt idx="244">
                  <c:v>296.42899999999997</c:v>
                </c:pt>
                <c:pt idx="245">
                  <c:v>302.87299999999999</c:v>
                </c:pt>
                <c:pt idx="246">
                  <c:v>309.31700000000001</c:v>
                </c:pt>
                <c:pt idx="247">
                  <c:v>315.76100000000002</c:v>
                </c:pt>
                <c:pt idx="248">
                  <c:v>322.20499999999998</c:v>
                </c:pt>
                <c:pt idx="249">
                  <c:v>328.649</c:v>
                </c:pt>
                <c:pt idx="250">
                  <c:v>331.30700000000002</c:v>
                </c:pt>
                <c:pt idx="251">
                  <c:v>335.09300000000002</c:v>
                </c:pt>
                <c:pt idx="252">
                  <c:v>341.53699999999998</c:v>
                </c:pt>
                <c:pt idx="253">
                  <c:v>347.98099999999999</c:v>
                </c:pt>
                <c:pt idx="254">
                  <c:v>354.42599999999999</c:v>
                </c:pt>
                <c:pt idx="255">
                  <c:v>360.87</c:v>
                </c:pt>
                <c:pt idx="256">
                  <c:v>367.31400000000002</c:v>
                </c:pt>
                <c:pt idx="257">
                  <c:v>373.75799999999998</c:v>
                </c:pt>
                <c:pt idx="258">
                  <c:v>380.202</c:v>
                </c:pt>
                <c:pt idx="259">
                  <c:v>386.64600000000002</c:v>
                </c:pt>
                <c:pt idx="260">
                  <c:v>393.09</c:v>
                </c:pt>
                <c:pt idx="261">
                  <c:v>399.53399999999999</c:v>
                </c:pt>
                <c:pt idx="262">
                  <c:v>405.97800000000001</c:v>
                </c:pt>
                <c:pt idx="263">
                  <c:v>412.42200000000003</c:v>
                </c:pt>
                <c:pt idx="264">
                  <c:v>418.86700000000002</c:v>
                </c:pt>
                <c:pt idx="265">
                  <c:v>425.31099999999998</c:v>
                </c:pt>
                <c:pt idx="266">
                  <c:v>431.755</c:v>
                </c:pt>
                <c:pt idx="267">
                  <c:v>438.19900000000001</c:v>
                </c:pt>
                <c:pt idx="268">
                  <c:v>444.64299999999997</c:v>
                </c:pt>
                <c:pt idx="269">
                  <c:v>449.65600000000001</c:v>
                </c:pt>
                <c:pt idx="270">
                  <c:v>451.08699999999999</c:v>
                </c:pt>
                <c:pt idx="271">
                  <c:v>457.53100000000001</c:v>
                </c:pt>
                <c:pt idx="272">
                  <c:v>463.97500000000002</c:v>
                </c:pt>
                <c:pt idx="273">
                  <c:v>470.41899999999998</c:v>
                </c:pt>
                <c:pt idx="274">
                  <c:v>476.863</c:v>
                </c:pt>
                <c:pt idx="275">
                  <c:v>483.30799999999999</c:v>
                </c:pt>
                <c:pt idx="276">
                  <c:v>489.75200000000001</c:v>
                </c:pt>
                <c:pt idx="277">
                  <c:v>496.19600000000003</c:v>
                </c:pt>
                <c:pt idx="278">
                  <c:v>502.64</c:v>
                </c:pt>
                <c:pt idx="279">
                  <c:v>509.084</c:v>
                </c:pt>
                <c:pt idx="280">
                  <c:v>515.52800000000002</c:v>
                </c:pt>
                <c:pt idx="281">
                  <c:v>521.97199999999998</c:v>
                </c:pt>
                <c:pt idx="282">
                  <c:v>528.41600000000005</c:v>
                </c:pt>
                <c:pt idx="283">
                  <c:v>534.86</c:v>
                </c:pt>
                <c:pt idx="284">
                  <c:v>541.30399999999997</c:v>
                </c:pt>
                <c:pt idx="285">
                  <c:v>547.74900000000002</c:v>
                </c:pt>
                <c:pt idx="286">
                  <c:v>554.19299999999998</c:v>
                </c:pt>
                <c:pt idx="287">
                  <c:v>560.63699999999994</c:v>
                </c:pt>
                <c:pt idx="288">
                  <c:v>567.08100000000002</c:v>
                </c:pt>
                <c:pt idx="289">
                  <c:v>573.52499999999998</c:v>
                </c:pt>
                <c:pt idx="290">
                  <c:v>579.96900000000005</c:v>
                </c:pt>
                <c:pt idx="291">
                  <c:v>586.41300000000001</c:v>
                </c:pt>
                <c:pt idx="292">
                  <c:v>592.85699999999997</c:v>
                </c:pt>
                <c:pt idx="293">
                  <c:v>599.30100000000004</c:v>
                </c:pt>
                <c:pt idx="294">
                  <c:v>605.745</c:v>
                </c:pt>
                <c:pt idx="295">
                  <c:v>612.19000000000005</c:v>
                </c:pt>
                <c:pt idx="296">
                  <c:v>618.63400000000001</c:v>
                </c:pt>
                <c:pt idx="297">
                  <c:v>625.07799999999997</c:v>
                </c:pt>
                <c:pt idx="298">
                  <c:v>631.52200000000005</c:v>
                </c:pt>
                <c:pt idx="299">
                  <c:v>637.96600000000001</c:v>
                </c:pt>
                <c:pt idx="300">
                  <c:v>644.41</c:v>
                </c:pt>
                <c:pt idx="301">
                  <c:v>650.85400000000004</c:v>
                </c:pt>
                <c:pt idx="302">
                  <c:v>657.298</c:v>
                </c:pt>
                <c:pt idx="303">
                  <c:v>663.74199999999996</c:v>
                </c:pt>
                <c:pt idx="304">
                  <c:v>670.18600000000004</c:v>
                </c:pt>
                <c:pt idx="305">
                  <c:v>676.63099999999997</c:v>
                </c:pt>
                <c:pt idx="306">
                  <c:v>683.07500000000005</c:v>
                </c:pt>
                <c:pt idx="307">
                  <c:v>689.51900000000001</c:v>
                </c:pt>
                <c:pt idx="308">
                  <c:v>695.96299999999997</c:v>
                </c:pt>
                <c:pt idx="309">
                  <c:v>702.40700000000004</c:v>
                </c:pt>
                <c:pt idx="310">
                  <c:v>708.851</c:v>
                </c:pt>
                <c:pt idx="311">
                  <c:v>715.29499999999996</c:v>
                </c:pt>
                <c:pt idx="312">
                  <c:v>721.73900000000003</c:v>
                </c:pt>
                <c:pt idx="313">
                  <c:v>728.18299999999999</c:v>
                </c:pt>
                <c:pt idx="314">
                  <c:v>734.62699999999995</c:v>
                </c:pt>
                <c:pt idx="315">
                  <c:v>741.072</c:v>
                </c:pt>
                <c:pt idx="316">
                  <c:v>747.51599999999996</c:v>
                </c:pt>
                <c:pt idx="317">
                  <c:v>753.96</c:v>
                </c:pt>
                <c:pt idx="318">
                  <c:v>760.404</c:v>
                </c:pt>
                <c:pt idx="319">
                  <c:v>766.84799999999996</c:v>
                </c:pt>
                <c:pt idx="320">
                  <c:v>773.29200000000003</c:v>
                </c:pt>
                <c:pt idx="321">
                  <c:v>779.73599999999999</c:v>
                </c:pt>
                <c:pt idx="322">
                  <c:v>786.18</c:v>
                </c:pt>
                <c:pt idx="323">
                  <c:v>792.62400000000002</c:v>
                </c:pt>
                <c:pt idx="324">
                  <c:v>799.06799999999998</c:v>
                </c:pt>
                <c:pt idx="325">
                  <c:v>805.51300000000003</c:v>
                </c:pt>
                <c:pt idx="326">
                  <c:v>811.95699999999999</c:v>
                </c:pt>
                <c:pt idx="327">
                  <c:v>818.40099999999995</c:v>
                </c:pt>
                <c:pt idx="328">
                  <c:v>824.84500000000003</c:v>
                </c:pt>
                <c:pt idx="329">
                  <c:v>831.28899999999999</c:v>
                </c:pt>
                <c:pt idx="330">
                  <c:v>837.73299999999995</c:v>
                </c:pt>
                <c:pt idx="331">
                  <c:v>844.17700000000002</c:v>
                </c:pt>
                <c:pt idx="332">
                  <c:v>850.62099999999998</c:v>
                </c:pt>
                <c:pt idx="333">
                  <c:v>857.06500000000005</c:v>
                </c:pt>
                <c:pt idx="334">
                  <c:v>863.50900000000001</c:v>
                </c:pt>
                <c:pt idx="335">
                  <c:v>869.95399999999995</c:v>
                </c:pt>
                <c:pt idx="336">
                  <c:v>876.39800000000002</c:v>
                </c:pt>
                <c:pt idx="337">
                  <c:v>882.84199999999998</c:v>
                </c:pt>
                <c:pt idx="338">
                  <c:v>889.28599999999994</c:v>
                </c:pt>
                <c:pt idx="339">
                  <c:v>895.73</c:v>
                </c:pt>
                <c:pt idx="340">
                  <c:v>902.17399999999998</c:v>
                </c:pt>
                <c:pt idx="341">
                  <c:v>908.61800000000005</c:v>
                </c:pt>
                <c:pt idx="342">
                  <c:v>915.06200000000001</c:v>
                </c:pt>
                <c:pt idx="343">
                  <c:v>921.50599999999997</c:v>
                </c:pt>
                <c:pt idx="344">
                  <c:v>927.95</c:v>
                </c:pt>
                <c:pt idx="345">
                  <c:v>934.39499999999998</c:v>
                </c:pt>
                <c:pt idx="346">
                  <c:v>940.83900000000006</c:v>
                </c:pt>
                <c:pt idx="347">
                  <c:v>947.28300000000002</c:v>
                </c:pt>
                <c:pt idx="348">
                  <c:v>953.72699999999998</c:v>
                </c:pt>
                <c:pt idx="349">
                  <c:v>960.17100000000005</c:v>
                </c:pt>
                <c:pt idx="350">
                  <c:v>966.61500000000001</c:v>
                </c:pt>
                <c:pt idx="351">
                  <c:v>973.05899999999997</c:v>
                </c:pt>
                <c:pt idx="352">
                  <c:v>979.50300000000004</c:v>
                </c:pt>
                <c:pt idx="353">
                  <c:v>985.947</c:v>
                </c:pt>
                <c:pt idx="354">
                  <c:v>992.39099999999996</c:v>
                </c:pt>
                <c:pt idx="355">
                  <c:v>998.83600000000001</c:v>
                </c:pt>
                <c:pt idx="356">
                  <c:v>1005.28</c:v>
                </c:pt>
                <c:pt idx="357">
                  <c:v>1011.724</c:v>
                </c:pt>
                <c:pt idx="358">
                  <c:v>1018.168</c:v>
                </c:pt>
                <c:pt idx="359">
                  <c:v>1024.6120000000001</c:v>
                </c:pt>
                <c:pt idx="360">
                  <c:v>1031.056</c:v>
                </c:pt>
                <c:pt idx="361">
                  <c:v>1037.5</c:v>
                </c:pt>
                <c:pt idx="362">
                  <c:v>1043.944</c:v>
                </c:pt>
                <c:pt idx="363">
                  <c:v>1050.3879999999999</c:v>
                </c:pt>
                <c:pt idx="364">
                  <c:v>1056.8320000000001</c:v>
                </c:pt>
                <c:pt idx="365">
                  <c:v>1063.277</c:v>
                </c:pt>
                <c:pt idx="366">
                  <c:v>1069.721</c:v>
                </c:pt>
                <c:pt idx="367">
                  <c:v>1076.165</c:v>
                </c:pt>
                <c:pt idx="368">
                  <c:v>1082.6089999999999</c:v>
                </c:pt>
                <c:pt idx="369">
                  <c:v>1089.0530000000001</c:v>
                </c:pt>
                <c:pt idx="370">
                  <c:v>1095.4970000000001</c:v>
                </c:pt>
                <c:pt idx="371">
                  <c:v>1101.941</c:v>
                </c:pt>
                <c:pt idx="372">
                  <c:v>1108.385</c:v>
                </c:pt>
                <c:pt idx="373">
                  <c:v>1114.829</c:v>
                </c:pt>
                <c:pt idx="374">
                  <c:v>1121.2729999999999</c:v>
                </c:pt>
                <c:pt idx="375">
                  <c:v>1127.7180000000001</c:v>
                </c:pt>
                <c:pt idx="376">
                  <c:v>1134.162</c:v>
                </c:pt>
                <c:pt idx="377">
                  <c:v>1140.606</c:v>
                </c:pt>
                <c:pt idx="378">
                  <c:v>1147.05</c:v>
                </c:pt>
                <c:pt idx="379">
                  <c:v>1153.4939999999999</c:v>
                </c:pt>
                <c:pt idx="380">
                  <c:v>1159.9380000000001</c:v>
                </c:pt>
                <c:pt idx="381">
                  <c:v>1166.3820000000001</c:v>
                </c:pt>
                <c:pt idx="382">
                  <c:v>1172.826</c:v>
                </c:pt>
                <c:pt idx="383">
                  <c:v>1179.27</c:v>
                </c:pt>
                <c:pt idx="384">
                  <c:v>1185.7139999999999</c:v>
                </c:pt>
                <c:pt idx="385">
                  <c:v>1192.1590000000001</c:v>
                </c:pt>
                <c:pt idx="386">
                  <c:v>1198.6030000000001</c:v>
                </c:pt>
                <c:pt idx="387">
                  <c:v>1205.047</c:v>
                </c:pt>
                <c:pt idx="388">
                  <c:v>1211.491</c:v>
                </c:pt>
                <c:pt idx="389">
                  <c:v>1217.9349999999999</c:v>
                </c:pt>
                <c:pt idx="390">
                  <c:v>1224.3789999999999</c:v>
                </c:pt>
                <c:pt idx="391">
                  <c:v>1230.8230000000001</c:v>
                </c:pt>
                <c:pt idx="392">
                  <c:v>1237.2670000000001</c:v>
                </c:pt>
                <c:pt idx="393">
                  <c:v>1243.711</c:v>
                </c:pt>
                <c:pt idx="394">
                  <c:v>1250.155</c:v>
                </c:pt>
                <c:pt idx="395">
                  <c:v>1256.5999999999999</c:v>
                </c:pt>
                <c:pt idx="396">
                  <c:v>1263.0440000000001</c:v>
                </c:pt>
                <c:pt idx="397">
                  <c:v>1269.4880000000001</c:v>
                </c:pt>
                <c:pt idx="398">
                  <c:v>1275.932</c:v>
                </c:pt>
                <c:pt idx="399">
                  <c:v>1282.376</c:v>
                </c:pt>
                <c:pt idx="400">
                  <c:v>1288.82</c:v>
                </c:pt>
                <c:pt idx="401">
                  <c:v>1288.82</c:v>
                </c:pt>
              </c:numCache>
            </c:numRef>
          </c:xVal>
          <c:yVal>
            <c:numRef>
              <c:f>Foglio6!$D$1634:$D$203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916</c:v>
                </c:pt>
                <c:pt idx="167">
                  <c:v>17.5</c:v>
                </c:pt>
                <c:pt idx="168">
                  <c:v>17</c:v>
                </c:pt>
                <c:pt idx="169">
                  <c:v>16.5</c:v>
                </c:pt>
                <c:pt idx="170">
                  <c:v>16</c:v>
                </c:pt>
                <c:pt idx="171">
                  <c:v>15.567</c:v>
                </c:pt>
                <c:pt idx="172">
                  <c:v>15.5</c:v>
                </c:pt>
                <c:pt idx="173">
                  <c:v>15</c:v>
                </c:pt>
                <c:pt idx="174">
                  <c:v>14.5</c:v>
                </c:pt>
                <c:pt idx="175">
                  <c:v>14.252000000000001</c:v>
                </c:pt>
                <c:pt idx="176">
                  <c:v>14</c:v>
                </c:pt>
                <c:pt idx="177">
                  <c:v>13.5</c:v>
                </c:pt>
                <c:pt idx="178">
                  <c:v>13.311</c:v>
                </c:pt>
                <c:pt idx="179">
                  <c:v>13</c:v>
                </c:pt>
                <c:pt idx="180">
                  <c:v>12.567</c:v>
                </c:pt>
                <c:pt idx="181">
                  <c:v>12.5</c:v>
                </c:pt>
                <c:pt idx="182">
                  <c:v>12</c:v>
                </c:pt>
                <c:pt idx="183">
                  <c:v>11.945</c:v>
                </c:pt>
                <c:pt idx="184">
                  <c:v>11.5</c:v>
                </c:pt>
                <c:pt idx="185">
                  <c:v>11.407999999999999</c:v>
                </c:pt>
                <c:pt idx="186">
                  <c:v>11</c:v>
                </c:pt>
                <c:pt idx="187">
                  <c:v>10.92</c:v>
                </c:pt>
                <c:pt idx="188">
                  <c:v>10.5</c:v>
                </c:pt>
                <c:pt idx="189">
                  <c:v>10.488</c:v>
                </c:pt>
                <c:pt idx="190">
                  <c:v>10.090999999999999</c:v>
                </c:pt>
                <c:pt idx="191">
                  <c:v>10</c:v>
                </c:pt>
                <c:pt idx="192">
                  <c:v>9.718</c:v>
                </c:pt>
                <c:pt idx="193">
                  <c:v>9.5</c:v>
                </c:pt>
                <c:pt idx="194">
                  <c:v>9.3680000000000003</c:v>
                </c:pt>
                <c:pt idx="195">
                  <c:v>9.0419999999999998</c:v>
                </c:pt>
                <c:pt idx="196">
                  <c:v>9</c:v>
                </c:pt>
                <c:pt idx="197">
                  <c:v>8.7279999999999998</c:v>
                </c:pt>
                <c:pt idx="198">
                  <c:v>8.5</c:v>
                </c:pt>
                <c:pt idx="199">
                  <c:v>8.4290000000000003</c:v>
                </c:pt>
                <c:pt idx="200">
                  <c:v>8.1440000000000001</c:v>
                </c:pt>
                <c:pt idx="201">
                  <c:v>8</c:v>
                </c:pt>
                <c:pt idx="202">
                  <c:v>7.8710000000000004</c:v>
                </c:pt>
                <c:pt idx="203">
                  <c:v>7.6020000000000003</c:v>
                </c:pt>
                <c:pt idx="204">
                  <c:v>7.5</c:v>
                </c:pt>
                <c:pt idx="205">
                  <c:v>7.3390000000000004</c:v>
                </c:pt>
                <c:pt idx="206">
                  <c:v>7.0789999999999997</c:v>
                </c:pt>
                <c:pt idx="207">
                  <c:v>7</c:v>
                </c:pt>
                <c:pt idx="208">
                  <c:v>6.84</c:v>
                </c:pt>
                <c:pt idx="209">
                  <c:v>6.6029999999999998</c:v>
                </c:pt>
                <c:pt idx="210">
                  <c:v>6.5</c:v>
                </c:pt>
                <c:pt idx="211">
                  <c:v>6.3620000000000001</c:v>
                </c:pt>
                <c:pt idx="212">
                  <c:v>6.1260000000000003</c:v>
                </c:pt>
                <c:pt idx="213">
                  <c:v>6</c:v>
                </c:pt>
                <c:pt idx="214">
                  <c:v>5.8940000000000001</c:v>
                </c:pt>
                <c:pt idx="215">
                  <c:v>5.6609999999999996</c:v>
                </c:pt>
                <c:pt idx="216">
                  <c:v>5.5</c:v>
                </c:pt>
                <c:pt idx="217">
                  <c:v>5.4260000000000002</c:v>
                </c:pt>
                <c:pt idx="218">
                  <c:v>5.1950000000000003</c:v>
                </c:pt>
                <c:pt idx="219">
                  <c:v>5</c:v>
                </c:pt>
                <c:pt idx="220">
                  <c:v>4.9619999999999997</c:v>
                </c:pt>
                <c:pt idx="221">
                  <c:v>4.7290000000000001</c:v>
                </c:pt>
                <c:pt idx="222">
                  <c:v>4.5</c:v>
                </c:pt>
                <c:pt idx="223">
                  <c:v>4.4909999999999997</c:v>
                </c:pt>
                <c:pt idx="224">
                  <c:v>4.2560000000000002</c:v>
                </c:pt>
                <c:pt idx="225">
                  <c:v>4.0220000000000002</c:v>
                </c:pt>
                <c:pt idx="226">
                  <c:v>4</c:v>
                </c:pt>
                <c:pt idx="227">
                  <c:v>3.7839999999999998</c:v>
                </c:pt>
                <c:pt idx="228">
                  <c:v>3.528</c:v>
                </c:pt>
                <c:pt idx="229">
                  <c:v>3.5</c:v>
                </c:pt>
                <c:pt idx="230">
                  <c:v>3.2570000000000001</c:v>
                </c:pt>
                <c:pt idx="231">
                  <c:v>3</c:v>
                </c:pt>
                <c:pt idx="232">
                  <c:v>2.9649999999999999</c:v>
                </c:pt>
                <c:pt idx="233">
                  <c:v>2.673</c:v>
                </c:pt>
                <c:pt idx="234">
                  <c:v>2.5</c:v>
                </c:pt>
                <c:pt idx="235">
                  <c:v>2.4020000000000001</c:v>
                </c:pt>
                <c:pt idx="236">
                  <c:v>2.157</c:v>
                </c:pt>
                <c:pt idx="237">
                  <c:v>2</c:v>
                </c:pt>
                <c:pt idx="238">
                  <c:v>1.95</c:v>
                </c:pt>
                <c:pt idx="239">
                  <c:v>1.778</c:v>
                </c:pt>
                <c:pt idx="240">
                  <c:v>1.633</c:v>
                </c:pt>
                <c:pt idx="241">
                  <c:v>1.512</c:v>
                </c:pt>
                <c:pt idx="242">
                  <c:v>1.5</c:v>
                </c:pt>
                <c:pt idx="243">
                  <c:v>1.409</c:v>
                </c:pt>
                <c:pt idx="244">
                  <c:v>1.3220000000000001</c:v>
                </c:pt>
                <c:pt idx="245">
                  <c:v>1.246</c:v>
                </c:pt>
                <c:pt idx="246">
                  <c:v>1.1779999999999999</c:v>
                </c:pt>
                <c:pt idx="247">
                  <c:v>1.119</c:v>
                </c:pt>
                <c:pt idx="248">
                  <c:v>1.0660000000000001</c:v>
                </c:pt>
                <c:pt idx="249">
                  <c:v>1.018</c:v>
                </c:pt>
                <c:pt idx="250">
                  <c:v>1</c:v>
                </c:pt>
                <c:pt idx="251">
                  <c:v>0.97399999999999998</c:v>
                </c:pt>
                <c:pt idx="252">
                  <c:v>0.93600000000000005</c:v>
                </c:pt>
                <c:pt idx="253">
                  <c:v>0.89800000000000002</c:v>
                </c:pt>
                <c:pt idx="254">
                  <c:v>0.86299999999999999</c:v>
                </c:pt>
                <c:pt idx="255">
                  <c:v>0.83099999999999996</c:v>
                </c:pt>
                <c:pt idx="256">
                  <c:v>0.80100000000000005</c:v>
                </c:pt>
                <c:pt idx="257">
                  <c:v>0.77</c:v>
                </c:pt>
                <c:pt idx="258">
                  <c:v>0.74299999999999999</c:v>
                </c:pt>
                <c:pt idx="259">
                  <c:v>0.71599999999999997</c:v>
                </c:pt>
                <c:pt idx="260">
                  <c:v>0.69</c:v>
                </c:pt>
                <c:pt idx="261">
                  <c:v>0.66500000000000004</c:v>
                </c:pt>
                <c:pt idx="262">
                  <c:v>0.64100000000000001</c:v>
                </c:pt>
                <c:pt idx="263">
                  <c:v>0.61799999999999999</c:v>
                </c:pt>
                <c:pt idx="264">
                  <c:v>0.59499999999999997</c:v>
                </c:pt>
                <c:pt idx="265">
                  <c:v>0.57599999999999996</c:v>
                </c:pt>
                <c:pt idx="266">
                  <c:v>0.55500000000000005</c:v>
                </c:pt>
                <c:pt idx="267">
                  <c:v>0.53500000000000003</c:v>
                </c:pt>
                <c:pt idx="268">
                  <c:v>0.51500000000000001</c:v>
                </c:pt>
                <c:pt idx="269">
                  <c:v>0.5</c:v>
                </c:pt>
                <c:pt idx="270">
                  <c:v>0.496</c:v>
                </c:pt>
                <c:pt idx="271">
                  <c:v>0.47899999999999998</c:v>
                </c:pt>
                <c:pt idx="272">
                  <c:v>0.46100000000000002</c:v>
                </c:pt>
                <c:pt idx="273">
                  <c:v>0.44400000000000001</c:v>
                </c:pt>
                <c:pt idx="274">
                  <c:v>0.42699999999999999</c:v>
                </c:pt>
                <c:pt idx="275">
                  <c:v>0.41199999999999998</c:v>
                </c:pt>
                <c:pt idx="276">
                  <c:v>0.39600000000000002</c:v>
                </c:pt>
                <c:pt idx="277">
                  <c:v>0.38200000000000001</c:v>
                </c:pt>
                <c:pt idx="278">
                  <c:v>0.36799999999999999</c:v>
                </c:pt>
                <c:pt idx="279">
                  <c:v>0.35399999999999998</c:v>
                </c:pt>
                <c:pt idx="280">
                  <c:v>0.33900000000000002</c:v>
                </c:pt>
                <c:pt idx="281">
                  <c:v>0.32600000000000001</c:v>
                </c:pt>
                <c:pt idx="282">
                  <c:v>0.313</c:v>
                </c:pt>
                <c:pt idx="283">
                  <c:v>0.30099999999999999</c:v>
                </c:pt>
                <c:pt idx="284">
                  <c:v>0.28999999999999998</c:v>
                </c:pt>
                <c:pt idx="285">
                  <c:v>0.27800000000000002</c:v>
                </c:pt>
                <c:pt idx="286">
                  <c:v>0.26700000000000002</c:v>
                </c:pt>
                <c:pt idx="287">
                  <c:v>0.25600000000000001</c:v>
                </c:pt>
                <c:pt idx="288">
                  <c:v>0.245</c:v>
                </c:pt>
                <c:pt idx="289">
                  <c:v>0.23499999999999999</c:v>
                </c:pt>
                <c:pt idx="290">
                  <c:v>0.22600000000000001</c:v>
                </c:pt>
                <c:pt idx="291">
                  <c:v>0.216</c:v>
                </c:pt>
                <c:pt idx="292">
                  <c:v>0.20599999999999999</c:v>
                </c:pt>
                <c:pt idx="293">
                  <c:v>0.19700000000000001</c:v>
                </c:pt>
                <c:pt idx="294">
                  <c:v>0.19</c:v>
                </c:pt>
                <c:pt idx="295">
                  <c:v>0.18</c:v>
                </c:pt>
                <c:pt idx="296">
                  <c:v>0.17199999999999999</c:v>
                </c:pt>
                <c:pt idx="297">
                  <c:v>0.16500000000000001</c:v>
                </c:pt>
                <c:pt idx="298">
                  <c:v>0.159</c:v>
                </c:pt>
                <c:pt idx="299">
                  <c:v>0.152</c:v>
                </c:pt>
                <c:pt idx="300">
                  <c:v>0.14599999999999999</c:v>
                </c:pt>
                <c:pt idx="301">
                  <c:v>0.14000000000000001</c:v>
                </c:pt>
                <c:pt idx="302">
                  <c:v>0.13300000000000001</c:v>
                </c:pt>
                <c:pt idx="303">
                  <c:v>0.126</c:v>
                </c:pt>
                <c:pt idx="304">
                  <c:v>0.121</c:v>
                </c:pt>
                <c:pt idx="305">
                  <c:v>0.115</c:v>
                </c:pt>
                <c:pt idx="306">
                  <c:v>0.11</c:v>
                </c:pt>
                <c:pt idx="307">
                  <c:v>0.105</c:v>
                </c:pt>
                <c:pt idx="308">
                  <c:v>0.1</c:v>
                </c:pt>
                <c:pt idx="309">
                  <c:v>9.5000000000000001E-2</c:v>
                </c:pt>
                <c:pt idx="310">
                  <c:v>0.09</c:v>
                </c:pt>
                <c:pt idx="311">
                  <c:v>8.6999999999999994E-2</c:v>
                </c:pt>
                <c:pt idx="312">
                  <c:v>8.2000000000000003E-2</c:v>
                </c:pt>
                <c:pt idx="313">
                  <c:v>7.9000000000000001E-2</c:v>
                </c:pt>
                <c:pt idx="314">
                  <c:v>7.4999999999999997E-2</c:v>
                </c:pt>
                <c:pt idx="315">
                  <c:v>7.0999999999999994E-2</c:v>
                </c:pt>
                <c:pt idx="316">
                  <c:v>6.8000000000000005E-2</c:v>
                </c:pt>
                <c:pt idx="317">
                  <c:v>6.5000000000000002E-2</c:v>
                </c:pt>
                <c:pt idx="318">
                  <c:v>6.2E-2</c:v>
                </c:pt>
                <c:pt idx="319">
                  <c:v>5.8000000000000003E-2</c:v>
                </c:pt>
                <c:pt idx="320">
                  <c:v>5.5E-2</c:v>
                </c:pt>
                <c:pt idx="321">
                  <c:v>5.1999999999999998E-2</c:v>
                </c:pt>
                <c:pt idx="322">
                  <c:v>4.9000000000000002E-2</c:v>
                </c:pt>
                <c:pt idx="323">
                  <c:v>4.7E-2</c:v>
                </c:pt>
                <c:pt idx="324">
                  <c:v>4.4999999999999998E-2</c:v>
                </c:pt>
                <c:pt idx="325">
                  <c:v>4.2000000000000003E-2</c:v>
                </c:pt>
                <c:pt idx="326">
                  <c:v>0.04</c:v>
                </c:pt>
                <c:pt idx="327">
                  <c:v>3.6999999999999998E-2</c:v>
                </c:pt>
                <c:pt idx="328">
                  <c:v>3.5000000000000003E-2</c:v>
                </c:pt>
                <c:pt idx="329">
                  <c:v>3.3000000000000002E-2</c:v>
                </c:pt>
                <c:pt idx="330">
                  <c:v>3.1E-2</c:v>
                </c:pt>
                <c:pt idx="331">
                  <c:v>2.9000000000000001E-2</c:v>
                </c:pt>
                <c:pt idx="332">
                  <c:v>2.7E-2</c:v>
                </c:pt>
                <c:pt idx="333">
                  <c:v>2.5000000000000001E-2</c:v>
                </c:pt>
                <c:pt idx="334">
                  <c:v>2.4E-2</c:v>
                </c:pt>
                <c:pt idx="335">
                  <c:v>2.1999999999999999E-2</c:v>
                </c:pt>
                <c:pt idx="336">
                  <c:v>2.1000000000000001E-2</c:v>
                </c:pt>
                <c:pt idx="337">
                  <c:v>1.9E-2</c:v>
                </c:pt>
                <c:pt idx="338">
                  <c:v>1.7000000000000001E-2</c:v>
                </c:pt>
                <c:pt idx="339">
                  <c:v>1.6E-2</c:v>
                </c:pt>
                <c:pt idx="340">
                  <c:v>1.4999999999999999E-2</c:v>
                </c:pt>
                <c:pt idx="341">
                  <c:v>1.4E-2</c:v>
                </c:pt>
                <c:pt idx="342">
                  <c:v>1.2999999999999999E-2</c:v>
                </c:pt>
                <c:pt idx="343">
                  <c:v>1.2E-2</c:v>
                </c:pt>
                <c:pt idx="344">
                  <c:v>1.0999999999999999E-2</c:v>
                </c:pt>
                <c:pt idx="345">
                  <c:v>0.01</c:v>
                </c:pt>
                <c:pt idx="346">
                  <c:v>8.9999999999999993E-3</c:v>
                </c:pt>
                <c:pt idx="347">
                  <c:v>8.0000000000000002E-3</c:v>
                </c:pt>
                <c:pt idx="348">
                  <c:v>7.0000000000000001E-3</c:v>
                </c:pt>
                <c:pt idx="349">
                  <c:v>6.0000000000000001E-3</c:v>
                </c:pt>
                <c:pt idx="350">
                  <c:v>5.0000000000000001E-3</c:v>
                </c:pt>
                <c:pt idx="351">
                  <c:v>5.0000000000000001E-3</c:v>
                </c:pt>
                <c:pt idx="352">
                  <c:v>4.0000000000000001E-3</c:v>
                </c:pt>
                <c:pt idx="353">
                  <c:v>3.0000000000000001E-3</c:v>
                </c:pt>
                <c:pt idx="354">
                  <c:v>3.0000000000000001E-3</c:v>
                </c:pt>
                <c:pt idx="355">
                  <c:v>3.0000000000000001E-3</c:v>
                </c:pt>
                <c:pt idx="356">
                  <c:v>3.0000000000000001E-3</c:v>
                </c:pt>
                <c:pt idx="357">
                  <c:v>2E-3</c:v>
                </c:pt>
                <c:pt idx="358">
                  <c:v>2E-3</c:v>
                </c:pt>
                <c:pt idx="359">
                  <c:v>2E-3</c:v>
                </c:pt>
                <c:pt idx="360">
                  <c:v>1E-3</c:v>
                </c:pt>
                <c:pt idx="361">
                  <c:v>1E-3</c:v>
                </c:pt>
                <c:pt idx="362">
                  <c:v>1E-3</c:v>
                </c:pt>
                <c:pt idx="363">
                  <c:v>1E-3</c:v>
                </c:pt>
                <c:pt idx="364">
                  <c:v>1E-3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E28-411E-AF58-EA6FBC711BBE}"/>
            </c:ext>
          </c:extLst>
        </c:ser>
        <c:ser>
          <c:idx val="1"/>
          <c:order val="2"/>
          <c:tx>
            <c:strRef>
              <c:f>Foglio6!$E$1</c:f>
              <c:strCache>
                <c:ptCount val="1"/>
                <c:pt idx="0">
                  <c:v>S0,5M5</c:v>
                </c:pt>
              </c:strCache>
            </c:strRef>
          </c:tx>
          <c:spPr>
            <a:ln w="19050" cap="rnd">
              <a:solidFill>
                <a:srgbClr val="FFCCCC"/>
              </a:solidFill>
              <a:round/>
            </a:ln>
            <a:effectLst/>
          </c:spPr>
          <c:marker>
            <c:symbol val="none"/>
          </c:marker>
          <c:xVal>
            <c:numRef>
              <c:f>Foglio6!$E$1634:$E$203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5.0000000000000001E-3</c:v>
                </c:pt>
                <c:pt idx="65">
                  <c:v>0.02</c:v>
                </c:pt>
                <c:pt idx="66">
                  <c:v>3.5999999999999997E-2</c:v>
                </c:pt>
                <c:pt idx="67">
                  <c:v>5.0999999999999997E-2</c:v>
                </c:pt>
                <c:pt idx="68">
                  <c:v>6.7000000000000004E-2</c:v>
                </c:pt>
                <c:pt idx="69">
                  <c:v>8.2000000000000003E-2</c:v>
                </c:pt>
                <c:pt idx="70">
                  <c:v>9.8000000000000004E-2</c:v>
                </c:pt>
                <c:pt idx="71">
                  <c:v>0.113</c:v>
                </c:pt>
                <c:pt idx="72">
                  <c:v>0.128</c:v>
                </c:pt>
                <c:pt idx="73">
                  <c:v>0.14399999999999999</c:v>
                </c:pt>
                <c:pt idx="74">
                  <c:v>0.159</c:v>
                </c:pt>
                <c:pt idx="75">
                  <c:v>0.17499999999999999</c:v>
                </c:pt>
                <c:pt idx="76">
                  <c:v>0.19</c:v>
                </c:pt>
                <c:pt idx="77">
                  <c:v>0.20499999999999999</c:v>
                </c:pt>
                <c:pt idx="78">
                  <c:v>0.221</c:v>
                </c:pt>
                <c:pt idx="79">
                  <c:v>0.23599999999999999</c:v>
                </c:pt>
                <c:pt idx="80">
                  <c:v>0.252</c:v>
                </c:pt>
                <c:pt idx="81">
                  <c:v>0.26700000000000002</c:v>
                </c:pt>
                <c:pt idx="82">
                  <c:v>0.28299999999999997</c:v>
                </c:pt>
                <c:pt idx="83">
                  <c:v>0.29799999999999999</c:v>
                </c:pt>
                <c:pt idx="84">
                  <c:v>0.313</c:v>
                </c:pt>
                <c:pt idx="85">
                  <c:v>0.32900000000000001</c:v>
                </c:pt>
                <c:pt idx="86">
                  <c:v>0.34399999999999997</c:v>
                </c:pt>
                <c:pt idx="87">
                  <c:v>0.36</c:v>
                </c:pt>
                <c:pt idx="88">
                  <c:v>0.375</c:v>
                </c:pt>
                <c:pt idx="89">
                  <c:v>0.39</c:v>
                </c:pt>
                <c:pt idx="90">
                  <c:v>0.40600000000000003</c:v>
                </c:pt>
                <c:pt idx="91">
                  <c:v>0.42099999999999999</c:v>
                </c:pt>
                <c:pt idx="92">
                  <c:v>0.437</c:v>
                </c:pt>
                <c:pt idx="93">
                  <c:v>0.45200000000000001</c:v>
                </c:pt>
                <c:pt idx="94">
                  <c:v>0.46800000000000003</c:v>
                </c:pt>
                <c:pt idx="95">
                  <c:v>0.48299999999999998</c:v>
                </c:pt>
                <c:pt idx="96">
                  <c:v>0.498</c:v>
                </c:pt>
                <c:pt idx="97">
                  <c:v>0.51400000000000001</c:v>
                </c:pt>
                <c:pt idx="98">
                  <c:v>0.52900000000000003</c:v>
                </c:pt>
                <c:pt idx="99">
                  <c:v>0.54500000000000004</c:v>
                </c:pt>
                <c:pt idx="100">
                  <c:v>0.56000000000000005</c:v>
                </c:pt>
                <c:pt idx="101">
                  <c:v>0.57499999999999996</c:v>
                </c:pt>
                <c:pt idx="102">
                  <c:v>0.59099999999999997</c:v>
                </c:pt>
                <c:pt idx="103">
                  <c:v>0.60599999999999998</c:v>
                </c:pt>
                <c:pt idx="104">
                  <c:v>0.622</c:v>
                </c:pt>
                <c:pt idx="105">
                  <c:v>0.63700000000000001</c:v>
                </c:pt>
                <c:pt idx="106">
                  <c:v>0.65200000000000002</c:v>
                </c:pt>
                <c:pt idx="107">
                  <c:v>0.66800000000000004</c:v>
                </c:pt>
                <c:pt idx="108">
                  <c:v>0.68300000000000005</c:v>
                </c:pt>
                <c:pt idx="109">
                  <c:v>0.69899999999999995</c:v>
                </c:pt>
                <c:pt idx="110">
                  <c:v>0.71399999999999997</c:v>
                </c:pt>
                <c:pt idx="111">
                  <c:v>0.73</c:v>
                </c:pt>
                <c:pt idx="112">
                  <c:v>0.745</c:v>
                </c:pt>
                <c:pt idx="113">
                  <c:v>0.76</c:v>
                </c:pt>
                <c:pt idx="114">
                  <c:v>0.77600000000000002</c:v>
                </c:pt>
                <c:pt idx="115">
                  <c:v>0.79100000000000004</c:v>
                </c:pt>
                <c:pt idx="116">
                  <c:v>0.80700000000000005</c:v>
                </c:pt>
                <c:pt idx="117">
                  <c:v>0.82199999999999995</c:v>
                </c:pt>
                <c:pt idx="118">
                  <c:v>0.83699999999999997</c:v>
                </c:pt>
                <c:pt idx="119">
                  <c:v>0.85299999999999998</c:v>
                </c:pt>
                <c:pt idx="120">
                  <c:v>0.86799999999999999</c:v>
                </c:pt>
                <c:pt idx="121">
                  <c:v>0.88400000000000001</c:v>
                </c:pt>
                <c:pt idx="122">
                  <c:v>0.89900000000000002</c:v>
                </c:pt>
                <c:pt idx="123">
                  <c:v>0.91500000000000004</c:v>
                </c:pt>
                <c:pt idx="124">
                  <c:v>0.93</c:v>
                </c:pt>
                <c:pt idx="125">
                  <c:v>0.94499999999999995</c:v>
                </c:pt>
                <c:pt idx="126">
                  <c:v>0.96099999999999997</c:v>
                </c:pt>
                <c:pt idx="127">
                  <c:v>0.97599999999999998</c:v>
                </c:pt>
                <c:pt idx="128">
                  <c:v>0.99199999999999999</c:v>
                </c:pt>
                <c:pt idx="129">
                  <c:v>1.0069999999999999</c:v>
                </c:pt>
                <c:pt idx="130">
                  <c:v>1.022</c:v>
                </c:pt>
                <c:pt idx="131">
                  <c:v>1.038</c:v>
                </c:pt>
                <c:pt idx="132">
                  <c:v>1.0529999999999999</c:v>
                </c:pt>
                <c:pt idx="133">
                  <c:v>1.069</c:v>
                </c:pt>
                <c:pt idx="134">
                  <c:v>1.0840000000000001</c:v>
                </c:pt>
                <c:pt idx="135">
                  <c:v>1.1000000000000001</c:v>
                </c:pt>
                <c:pt idx="136">
                  <c:v>1.115</c:v>
                </c:pt>
                <c:pt idx="137">
                  <c:v>1.1299999999999999</c:v>
                </c:pt>
                <c:pt idx="138">
                  <c:v>1.1459999999999999</c:v>
                </c:pt>
                <c:pt idx="139">
                  <c:v>1.161</c:v>
                </c:pt>
                <c:pt idx="140">
                  <c:v>1.177</c:v>
                </c:pt>
                <c:pt idx="141">
                  <c:v>1.212</c:v>
                </c:pt>
                <c:pt idx="142">
                  <c:v>1.2709999999999999</c:v>
                </c:pt>
                <c:pt idx="143">
                  <c:v>1.329</c:v>
                </c:pt>
                <c:pt idx="144">
                  <c:v>1.3879999999999999</c:v>
                </c:pt>
                <c:pt idx="145">
                  <c:v>1.446</c:v>
                </c:pt>
                <c:pt idx="146">
                  <c:v>1.5049999999999999</c:v>
                </c:pt>
                <c:pt idx="147">
                  <c:v>1.5629999999999999</c:v>
                </c:pt>
                <c:pt idx="148">
                  <c:v>1.6220000000000001</c:v>
                </c:pt>
                <c:pt idx="149">
                  <c:v>1.68</c:v>
                </c:pt>
                <c:pt idx="150">
                  <c:v>1.738</c:v>
                </c:pt>
                <c:pt idx="151">
                  <c:v>1.7969999999999999</c:v>
                </c:pt>
                <c:pt idx="152">
                  <c:v>1.855</c:v>
                </c:pt>
                <c:pt idx="153">
                  <c:v>1.9139999999999999</c:v>
                </c:pt>
                <c:pt idx="154">
                  <c:v>1.972</c:v>
                </c:pt>
                <c:pt idx="155">
                  <c:v>2.0310000000000001</c:v>
                </c:pt>
                <c:pt idx="156">
                  <c:v>2.089</c:v>
                </c:pt>
                <c:pt idx="157">
                  <c:v>2.1480000000000001</c:v>
                </c:pt>
                <c:pt idx="158">
                  <c:v>2.206</c:v>
                </c:pt>
                <c:pt idx="159">
                  <c:v>2.2639999999999998</c:v>
                </c:pt>
                <c:pt idx="160">
                  <c:v>2.323</c:v>
                </c:pt>
                <c:pt idx="161">
                  <c:v>2.395</c:v>
                </c:pt>
                <c:pt idx="162">
                  <c:v>2.5209999999999999</c:v>
                </c:pt>
                <c:pt idx="163">
                  <c:v>2.6480000000000001</c:v>
                </c:pt>
                <c:pt idx="164">
                  <c:v>2.774</c:v>
                </c:pt>
                <c:pt idx="165">
                  <c:v>2.9</c:v>
                </c:pt>
                <c:pt idx="166">
                  <c:v>3.0270000000000001</c:v>
                </c:pt>
                <c:pt idx="167">
                  <c:v>3.153</c:v>
                </c:pt>
                <c:pt idx="168">
                  <c:v>3.2789999999999999</c:v>
                </c:pt>
                <c:pt idx="169">
                  <c:v>3.4060000000000001</c:v>
                </c:pt>
                <c:pt idx="170">
                  <c:v>3.532</c:v>
                </c:pt>
                <c:pt idx="171">
                  <c:v>3.7450000000000001</c:v>
                </c:pt>
                <c:pt idx="172">
                  <c:v>3.976</c:v>
                </c:pt>
                <c:pt idx="173">
                  <c:v>4.2069999999999999</c:v>
                </c:pt>
                <c:pt idx="174">
                  <c:v>4.4379999999999997</c:v>
                </c:pt>
                <c:pt idx="175">
                  <c:v>4.6689999999999996</c:v>
                </c:pt>
                <c:pt idx="176">
                  <c:v>5.016</c:v>
                </c:pt>
                <c:pt idx="177">
                  <c:v>5.415</c:v>
                </c:pt>
                <c:pt idx="178">
                  <c:v>5.8140000000000001</c:v>
                </c:pt>
                <c:pt idx="179">
                  <c:v>5.923</c:v>
                </c:pt>
                <c:pt idx="180">
                  <c:v>6.3869999999999996</c:v>
                </c:pt>
                <c:pt idx="181">
                  <c:v>7.0250000000000004</c:v>
                </c:pt>
                <c:pt idx="182">
                  <c:v>7.96</c:v>
                </c:pt>
                <c:pt idx="183">
                  <c:v>9.2149999999999999</c:v>
                </c:pt>
                <c:pt idx="184">
                  <c:v>11.015000000000001</c:v>
                </c:pt>
                <c:pt idx="185">
                  <c:v>11.847</c:v>
                </c:pt>
                <c:pt idx="186">
                  <c:v>13.7</c:v>
                </c:pt>
                <c:pt idx="187">
                  <c:v>17.61</c:v>
                </c:pt>
                <c:pt idx="188">
                  <c:v>17.77</c:v>
                </c:pt>
                <c:pt idx="189">
                  <c:v>23.457999999999998</c:v>
                </c:pt>
                <c:pt idx="190">
                  <c:v>23.693999999999999</c:v>
                </c:pt>
                <c:pt idx="191">
                  <c:v>29.617000000000001</c:v>
                </c:pt>
                <c:pt idx="192">
                  <c:v>31.855</c:v>
                </c:pt>
                <c:pt idx="193">
                  <c:v>35.540999999999997</c:v>
                </c:pt>
                <c:pt idx="194">
                  <c:v>41.463999999999999</c:v>
                </c:pt>
                <c:pt idx="195">
                  <c:v>43.780999999999999</c:v>
                </c:pt>
                <c:pt idx="196">
                  <c:v>47.387999999999998</c:v>
                </c:pt>
                <c:pt idx="197">
                  <c:v>53.311</c:v>
                </c:pt>
                <c:pt idx="198">
                  <c:v>59.234999999999999</c:v>
                </c:pt>
                <c:pt idx="199">
                  <c:v>59.573999999999998</c:v>
                </c:pt>
                <c:pt idx="200">
                  <c:v>65.158000000000001</c:v>
                </c:pt>
                <c:pt idx="201">
                  <c:v>71.081999999999994</c:v>
                </c:pt>
                <c:pt idx="202">
                  <c:v>77.004999999999995</c:v>
                </c:pt>
                <c:pt idx="203">
                  <c:v>80.322000000000003</c:v>
                </c:pt>
                <c:pt idx="204">
                  <c:v>82.929000000000002</c:v>
                </c:pt>
                <c:pt idx="205">
                  <c:v>88.852000000000004</c:v>
                </c:pt>
                <c:pt idx="206">
                  <c:v>94.775999999999996</c:v>
                </c:pt>
                <c:pt idx="207">
                  <c:v>100.699</c:v>
                </c:pt>
                <c:pt idx="208">
                  <c:v>105.346</c:v>
                </c:pt>
                <c:pt idx="209">
                  <c:v>106.623</c:v>
                </c:pt>
                <c:pt idx="210">
                  <c:v>112.54600000000001</c:v>
                </c:pt>
                <c:pt idx="211">
                  <c:v>118.46899999999999</c:v>
                </c:pt>
                <c:pt idx="212">
                  <c:v>124.393</c:v>
                </c:pt>
                <c:pt idx="213">
                  <c:v>130.316</c:v>
                </c:pt>
                <c:pt idx="214">
                  <c:v>134.51499999999999</c:v>
                </c:pt>
                <c:pt idx="215">
                  <c:v>136.24</c:v>
                </c:pt>
                <c:pt idx="216">
                  <c:v>142.16300000000001</c:v>
                </c:pt>
                <c:pt idx="217">
                  <c:v>148.08699999999999</c:v>
                </c:pt>
                <c:pt idx="218">
                  <c:v>154.01</c:v>
                </c:pt>
                <c:pt idx="219">
                  <c:v>159.934</c:v>
                </c:pt>
                <c:pt idx="220">
                  <c:v>165.434</c:v>
                </c:pt>
                <c:pt idx="221">
                  <c:v>165.857</c:v>
                </c:pt>
                <c:pt idx="222">
                  <c:v>171.78100000000001</c:v>
                </c:pt>
                <c:pt idx="223">
                  <c:v>177.70400000000001</c:v>
                </c:pt>
                <c:pt idx="224">
                  <c:v>183.62799999999999</c:v>
                </c:pt>
                <c:pt idx="225">
                  <c:v>189.55099999999999</c:v>
                </c:pt>
                <c:pt idx="226">
                  <c:v>195.47499999999999</c:v>
                </c:pt>
                <c:pt idx="227">
                  <c:v>196.572</c:v>
                </c:pt>
                <c:pt idx="228">
                  <c:v>201.398</c:v>
                </c:pt>
                <c:pt idx="229">
                  <c:v>207.322</c:v>
                </c:pt>
                <c:pt idx="230">
                  <c:v>213.245</c:v>
                </c:pt>
                <c:pt idx="231">
                  <c:v>219.16800000000001</c:v>
                </c:pt>
                <c:pt idx="232">
                  <c:v>221.94399999999999</c:v>
                </c:pt>
                <c:pt idx="233">
                  <c:v>225.09200000000001</c:v>
                </c:pt>
                <c:pt idx="234">
                  <c:v>231.01499999999999</c:v>
                </c:pt>
                <c:pt idx="235">
                  <c:v>236.93899999999999</c:v>
                </c:pt>
                <c:pt idx="236">
                  <c:v>238.62100000000001</c:v>
                </c:pt>
                <c:pt idx="237">
                  <c:v>242.86199999999999</c:v>
                </c:pt>
                <c:pt idx="238">
                  <c:v>248.786</c:v>
                </c:pt>
                <c:pt idx="239">
                  <c:v>249.46600000000001</c:v>
                </c:pt>
                <c:pt idx="240">
                  <c:v>254.709</c:v>
                </c:pt>
                <c:pt idx="241">
                  <c:v>260.63299999999998</c:v>
                </c:pt>
                <c:pt idx="242">
                  <c:v>261.233</c:v>
                </c:pt>
                <c:pt idx="243">
                  <c:v>266.55599999999998</c:v>
                </c:pt>
                <c:pt idx="244">
                  <c:v>272.48</c:v>
                </c:pt>
                <c:pt idx="245">
                  <c:v>277.84500000000003</c:v>
                </c:pt>
                <c:pt idx="246">
                  <c:v>278.40300000000002</c:v>
                </c:pt>
                <c:pt idx="247">
                  <c:v>284.327</c:v>
                </c:pt>
                <c:pt idx="248">
                  <c:v>290.25</c:v>
                </c:pt>
                <c:pt idx="249">
                  <c:v>296.17399999999998</c:v>
                </c:pt>
                <c:pt idx="250">
                  <c:v>302.09699999999998</c:v>
                </c:pt>
                <c:pt idx="251">
                  <c:v>308.02100000000002</c:v>
                </c:pt>
                <c:pt idx="252">
                  <c:v>313.94400000000002</c:v>
                </c:pt>
                <c:pt idx="253">
                  <c:v>319.16399999999999</c:v>
                </c:pt>
                <c:pt idx="254">
                  <c:v>319.86799999999999</c:v>
                </c:pt>
                <c:pt idx="255">
                  <c:v>325.791</c:v>
                </c:pt>
                <c:pt idx="256">
                  <c:v>331.714</c:v>
                </c:pt>
                <c:pt idx="257">
                  <c:v>337.63799999999998</c:v>
                </c:pt>
                <c:pt idx="258">
                  <c:v>343.56099999999998</c:v>
                </c:pt>
                <c:pt idx="259">
                  <c:v>349.48500000000001</c:v>
                </c:pt>
                <c:pt idx="260">
                  <c:v>355.40800000000002</c:v>
                </c:pt>
                <c:pt idx="261">
                  <c:v>361.33199999999999</c:v>
                </c:pt>
                <c:pt idx="262">
                  <c:v>367.255</c:v>
                </c:pt>
                <c:pt idx="263">
                  <c:v>373.17899999999997</c:v>
                </c:pt>
                <c:pt idx="264">
                  <c:v>379.10199999999998</c:v>
                </c:pt>
                <c:pt idx="265">
                  <c:v>385.02600000000001</c:v>
                </c:pt>
                <c:pt idx="266">
                  <c:v>390.94900000000001</c:v>
                </c:pt>
                <c:pt idx="267">
                  <c:v>396.87299999999999</c:v>
                </c:pt>
                <c:pt idx="268">
                  <c:v>402.79599999999999</c:v>
                </c:pt>
                <c:pt idx="269">
                  <c:v>408.72</c:v>
                </c:pt>
                <c:pt idx="270">
                  <c:v>414.64299999999997</c:v>
                </c:pt>
                <c:pt idx="271">
                  <c:v>420.56700000000001</c:v>
                </c:pt>
                <c:pt idx="272">
                  <c:v>426.49</c:v>
                </c:pt>
                <c:pt idx="273">
                  <c:v>432.41300000000001</c:v>
                </c:pt>
                <c:pt idx="274">
                  <c:v>438.33699999999999</c:v>
                </c:pt>
                <c:pt idx="275">
                  <c:v>444.26</c:v>
                </c:pt>
                <c:pt idx="276">
                  <c:v>450.18400000000003</c:v>
                </c:pt>
                <c:pt idx="277">
                  <c:v>456.10700000000003</c:v>
                </c:pt>
                <c:pt idx="278">
                  <c:v>462.03100000000001</c:v>
                </c:pt>
                <c:pt idx="279">
                  <c:v>467.95400000000001</c:v>
                </c:pt>
                <c:pt idx="280">
                  <c:v>473.87799999999999</c:v>
                </c:pt>
                <c:pt idx="281">
                  <c:v>479.80099999999999</c:v>
                </c:pt>
                <c:pt idx="282">
                  <c:v>485.72500000000002</c:v>
                </c:pt>
                <c:pt idx="283">
                  <c:v>491.64800000000002</c:v>
                </c:pt>
                <c:pt idx="284">
                  <c:v>497.572</c:v>
                </c:pt>
                <c:pt idx="285">
                  <c:v>503.495</c:v>
                </c:pt>
                <c:pt idx="286">
                  <c:v>509.41899999999998</c:v>
                </c:pt>
                <c:pt idx="287">
                  <c:v>515.34199999999998</c:v>
                </c:pt>
                <c:pt idx="288">
                  <c:v>521.26599999999996</c:v>
                </c:pt>
                <c:pt idx="289">
                  <c:v>527.18899999999996</c:v>
                </c:pt>
                <c:pt idx="290">
                  <c:v>533.11300000000006</c:v>
                </c:pt>
                <c:pt idx="291">
                  <c:v>539.03599999999994</c:v>
                </c:pt>
                <c:pt idx="292">
                  <c:v>544.95899999999995</c:v>
                </c:pt>
                <c:pt idx="293">
                  <c:v>550.88300000000004</c:v>
                </c:pt>
                <c:pt idx="294">
                  <c:v>556.80600000000004</c:v>
                </c:pt>
                <c:pt idx="295">
                  <c:v>562.73</c:v>
                </c:pt>
                <c:pt idx="296">
                  <c:v>568.65300000000002</c:v>
                </c:pt>
                <c:pt idx="297">
                  <c:v>574.577</c:v>
                </c:pt>
                <c:pt idx="298">
                  <c:v>580.5</c:v>
                </c:pt>
                <c:pt idx="299">
                  <c:v>586.42399999999998</c:v>
                </c:pt>
                <c:pt idx="300">
                  <c:v>592.34699999999998</c:v>
                </c:pt>
                <c:pt idx="301">
                  <c:v>598.27099999999996</c:v>
                </c:pt>
                <c:pt idx="302">
                  <c:v>604.19399999999996</c:v>
                </c:pt>
                <c:pt idx="303">
                  <c:v>610.11800000000005</c:v>
                </c:pt>
                <c:pt idx="304">
                  <c:v>616.04100000000005</c:v>
                </c:pt>
                <c:pt idx="305">
                  <c:v>621.96500000000003</c:v>
                </c:pt>
                <c:pt idx="306">
                  <c:v>627.88800000000003</c:v>
                </c:pt>
                <c:pt idx="307">
                  <c:v>633.81200000000001</c:v>
                </c:pt>
                <c:pt idx="308">
                  <c:v>639.73500000000001</c:v>
                </c:pt>
                <c:pt idx="309">
                  <c:v>645.65800000000002</c:v>
                </c:pt>
                <c:pt idx="310">
                  <c:v>651.58199999999999</c:v>
                </c:pt>
                <c:pt idx="311">
                  <c:v>657.505</c:v>
                </c:pt>
                <c:pt idx="312">
                  <c:v>663.42899999999997</c:v>
                </c:pt>
                <c:pt idx="313">
                  <c:v>669.35199999999998</c:v>
                </c:pt>
                <c:pt idx="314">
                  <c:v>675.27599999999995</c:v>
                </c:pt>
                <c:pt idx="315">
                  <c:v>681.19899999999996</c:v>
                </c:pt>
                <c:pt idx="316">
                  <c:v>687.12300000000005</c:v>
                </c:pt>
                <c:pt idx="317">
                  <c:v>693.04600000000005</c:v>
                </c:pt>
                <c:pt idx="318">
                  <c:v>698.97</c:v>
                </c:pt>
                <c:pt idx="319">
                  <c:v>704.89300000000003</c:v>
                </c:pt>
                <c:pt idx="320">
                  <c:v>710.81700000000001</c:v>
                </c:pt>
                <c:pt idx="321">
                  <c:v>716.74</c:v>
                </c:pt>
                <c:pt idx="322">
                  <c:v>722.66399999999999</c:v>
                </c:pt>
                <c:pt idx="323">
                  <c:v>728.58699999999999</c:v>
                </c:pt>
                <c:pt idx="324">
                  <c:v>734.51099999999997</c:v>
                </c:pt>
                <c:pt idx="325">
                  <c:v>740.43399999999997</c:v>
                </c:pt>
                <c:pt idx="326">
                  <c:v>746.35799999999995</c:v>
                </c:pt>
                <c:pt idx="327">
                  <c:v>752.28099999999995</c:v>
                </c:pt>
                <c:pt idx="328">
                  <c:v>758.20399999999995</c:v>
                </c:pt>
                <c:pt idx="329">
                  <c:v>764.12800000000004</c:v>
                </c:pt>
                <c:pt idx="330">
                  <c:v>770.05100000000004</c:v>
                </c:pt>
                <c:pt idx="331">
                  <c:v>775.97500000000002</c:v>
                </c:pt>
                <c:pt idx="332">
                  <c:v>781.89800000000002</c:v>
                </c:pt>
                <c:pt idx="333">
                  <c:v>787.822</c:v>
                </c:pt>
                <c:pt idx="334">
                  <c:v>793.745</c:v>
                </c:pt>
                <c:pt idx="335">
                  <c:v>799.66899999999998</c:v>
                </c:pt>
                <c:pt idx="336">
                  <c:v>805.59199999999998</c:v>
                </c:pt>
                <c:pt idx="337">
                  <c:v>811.51599999999996</c:v>
                </c:pt>
                <c:pt idx="338">
                  <c:v>817.43899999999996</c:v>
                </c:pt>
                <c:pt idx="339">
                  <c:v>823.36300000000006</c:v>
                </c:pt>
                <c:pt idx="340">
                  <c:v>829.28599999999994</c:v>
                </c:pt>
                <c:pt idx="341">
                  <c:v>835.21</c:v>
                </c:pt>
                <c:pt idx="342">
                  <c:v>841.13300000000004</c:v>
                </c:pt>
                <c:pt idx="343">
                  <c:v>847.05700000000002</c:v>
                </c:pt>
                <c:pt idx="344">
                  <c:v>852.98</c:v>
                </c:pt>
                <c:pt idx="345">
                  <c:v>858.90300000000002</c:v>
                </c:pt>
                <c:pt idx="346">
                  <c:v>864.827</c:v>
                </c:pt>
                <c:pt idx="347">
                  <c:v>870.75</c:v>
                </c:pt>
                <c:pt idx="348">
                  <c:v>876.67399999999998</c:v>
                </c:pt>
                <c:pt idx="349">
                  <c:v>882.59699999999998</c:v>
                </c:pt>
                <c:pt idx="350">
                  <c:v>888.52099999999996</c:v>
                </c:pt>
                <c:pt idx="351">
                  <c:v>894.44399999999996</c:v>
                </c:pt>
                <c:pt idx="352">
                  <c:v>900.36800000000005</c:v>
                </c:pt>
                <c:pt idx="353">
                  <c:v>906.29100000000005</c:v>
                </c:pt>
                <c:pt idx="354">
                  <c:v>912.21500000000003</c:v>
                </c:pt>
                <c:pt idx="355">
                  <c:v>918.13800000000003</c:v>
                </c:pt>
                <c:pt idx="356">
                  <c:v>924.06200000000001</c:v>
                </c:pt>
                <c:pt idx="357">
                  <c:v>929.98500000000001</c:v>
                </c:pt>
                <c:pt idx="358">
                  <c:v>935.90899999999999</c:v>
                </c:pt>
                <c:pt idx="359">
                  <c:v>941.83199999999999</c:v>
                </c:pt>
                <c:pt idx="360">
                  <c:v>947.75599999999997</c:v>
                </c:pt>
                <c:pt idx="361">
                  <c:v>953.67899999999997</c:v>
                </c:pt>
                <c:pt idx="362">
                  <c:v>959.60299999999995</c:v>
                </c:pt>
                <c:pt idx="363">
                  <c:v>965.52599999999995</c:v>
                </c:pt>
                <c:pt idx="364">
                  <c:v>971.44899999999996</c:v>
                </c:pt>
                <c:pt idx="365">
                  <c:v>977.37300000000005</c:v>
                </c:pt>
                <c:pt idx="366">
                  <c:v>983.29600000000005</c:v>
                </c:pt>
                <c:pt idx="367">
                  <c:v>989.22</c:v>
                </c:pt>
                <c:pt idx="368">
                  <c:v>995.14300000000003</c:v>
                </c:pt>
                <c:pt idx="369">
                  <c:v>1001.067</c:v>
                </c:pt>
                <c:pt idx="370">
                  <c:v>1006.99</c:v>
                </c:pt>
                <c:pt idx="371">
                  <c:v>1012.914</c:v>
                </c:pt>
                <c:pt idx="372">
                  <c:v>1018.837</c:v>
                </c:pt>
                <c:pt idx="373">
                  <c:v>1024.761</c:v>
                </c:pt>
                <c:pt idx="374">
                  <c:v>1030.684</c:v>
                </c:pt>
                <c:pt idx="375">
                  <c:v>1036.6079999999999</c:v>
                </c:pt>
                <c:pt idx="376">
                  <c:v>1042.5309999999999</c:v>
                </c:pt>
                <c:pt idx="377">
                  <c:v>1048.4549999999999</c:v>
                </c:pt>
                <c:pt idx="378">
                  <c:v>1054.3779999999999</c:v>
                </c:pt>
                <c:pt idx="379">
                  <c:v>1060.3019999999999</c:v>
                </c:pt>
                <c:pt idx="380">
                  <c:v>1066.2249999999999</c:v>
                </c:pt>
                <c:pt idx="381">
                  <c:v>1072.1479999999999</c:v>
                </c:pt>
                <c:pt idx="382">
                  <c:v>1078.0719999999999</c:v>
                </c:pt>
                <c:pt idx="383">
                  <c:v>1083.9949999999999</c:v>
                </c:pt>
                <c:pt idx="384">
                  <c:v>1089.9190000000001</c:v>
                </c:pt>
                <c:pt idx="385">
                  <c:v>1095.8420000000001</c:v>
                </c:pt>
                <c:pt idx="386">
                  <c:v>1101.7660000000001</c:v>
                </c:pt>
                <c:pt idx="387">
                  <c:v>1107.6890000000001</c:v>
                </c:pt>
                <c:pt idx="388">
                  <c:v>1113.6130000000001</c:v>
                </c:pt>
                <c:pt idx="389">
                  <c:v>1119.5360000000001</c:v>
                </c:pt>
                <c:pt idx="390">
                  <c:v>1125.46</c:v>
                </c:pt>
                <c:pt idx="391">
                  <c:v>1131.383</c:v>
                </c:pt>
                <c:pt idx="392">
                  <c:v>1137.307</c:v>
                </c:pt>
                <c:pt idx="393">
                  <c:v>1143.23</c:v>
                </c:pt>
                <c:pt idx="394">
                  <c:v>1149.154</c:v>
                </c:pt>
                <c:pt idx="395">
                  <c:v>1155.077</c:v>
                </c:pt>
                <c:pt idx="396">
                  <c:v>1161.001</c:v>
                </c:pt>
                <c:pt idx="397">
                  <c:v>1166.924</c:v>
                </c:pt>
                <c:pt idx="398">
                  <c:v>1172.848</c:v>
                </c:pt>
                <c:pt idx="399">
                  <c:v>1178.771</c:v>
                </c:pt>
                <c:pt idx="400">
                  <c:v>1184.694</c:v>
                </c:pt>
                <c:pt idx="401">
                  <c:v>1184.694</c:v>
                </c:pt>
              </c:numCache>
            </c:numRef>
          </c:xVal>
          <c:yVal>
            <c:numRef>
              <c:f>Foglio6!$F$1634:$F$203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</c:v>
                </c:pt>
                <c:pt idx="170">
                  <c:v>15.5</c:v>
                </c:pt>
                <c:pt idx="171">
                  <c:v>15</c:v>
                </c:pt>
                <c:pt idx="172">
                  <c:v>14.5</c:v>
                </c:pt>
                <c:pt idx="173">
                  <c:v>14</c:v>
                </c:pt>
                <c:pt idx="174">
                  <c:v>13.5</c:v>
                </c:pt>
                <c:pt idx="175">
                  <c:v>13</c:v>
                </c:pt>
                <c:pt idx="176">
                  <c:v>12.5</c:v>
                </c:pt>
                <c:pt idx="177">
                  <c:v>12</c:v>
                </c:pt>
                <c:pt idx="178">
                  <c:v>11.5</c:v>
                </c:pt>
                <c:pt idx="179">
                  <c:v>11.363</c:v>
                </c:pt>
                <c:pt idx="180">
                  <c:v>11</c:v>
                </c:pt>
                <c:pt idx="181">
                  <c:v>10.5</c:v>
                </c:pt>
                <c:pt idx="182">
                  <c:v>10</c:v>
                </c:pt>
                <c:pt idx="183">
                  <c:v>9.5</c:v>
                </c:pt>
                <c:pt idx="184">
                  <c:v>9</c:v>
                </c:pt>
                <c:pt idx="185">
                  <c:v>8.8160000000000007</c:v>
                </c:pt>
                <c:pt idx="186">
                  <c:v>8.5</c:v>
                </c:pt>
                <c:pt idx="187">
                  <c:v>8</c:v>
                </c:pt>
                <c:pt idx="188">
                  <c:v>7.9820000000000002</c:v>
                </c:pt>
                <c:pt idx="189">
                  <c:v>7.5</c:v>
                </c:pt>
                <c:pt idx="190">
                  <c:v>7.4829999999999997</c:v>
                </c:pt>
                <c:pt idx="191">
                  <c:v>7.117</c:v>
                </c:pt>
                <c:pt idx="192">
                  <c:v>7</c:v>
                </c:pt>
                <c:pt idx="193">
                  <c:v>6.8289999999999997</c:v>
                </c:pt>
                <c:pt idx="194">
                  <c:v>6.585</c:v>
                </c:pt>
                <c:pt idx="195">
                  <c:v>6.5</c:v>
                </c:pt>
                <c:pt idx="196">
                  <c:v>6.3739999999999997</c:v>
                </c:pt>
                <c:pt idx="197">
                  <c:v>6.1840000000000002</c:v>
                </c:pt>
                <c:pt idx="198">
                  <c:v>6.0090000000000003</c:v>
                </c:pt>
                <c:pt idx="199">
                  <c:v>6</c:v>
                </c:pt>
                <c:pt idx="200">
                  <c:v>5.8550000000000004</c:v>
                </c:pt>
                <c:pt idx="201">
                  <c:v>5.71</c:v>
                </c:pt>
                <c:pt idx="202">
                  <c:v>5.5730000000000004</c:v>
                </c:pt>
                <c:pt idx="203">
                  <c:v>5.5</c:v>
                </c:pt>
                <c:pt idx="204">
                  <c:v>5.444</c:v>
                </c:pt>
                <c:pt idx="205">
                  <c:v>5.3220000000000001</c:v>
                </c:pt>
                <c:pt idx="206">
                  <c:v>5.2009999999999996</c:v>
                </c:pt>
                <c:pt idx="207">
                  <c:v>5.0869999999999997</c:v>
                </c:pt>
                <c:pt idx="208">
                  <c:v>5</c:v>
                </c:pt>
                <c:pt idx="209">
                  <c:v>4.9749999999999996</c:v>
                </c:pt>
                <c:pt idx="210">
                  <c:v>4.8680000000000003</c:v>
                </c:pt>
                <c:pt idx="211">
                  <c:v>4.7649999999999997</c:v>
                </c:pt>
                <c:pt idx="212">
                  <c:v>4.6639999999999997</c:v>
                </c:pt>
                <c:pt idx="213">
                  <c:v>4.5679999999999996</c:v>
                </c:pt>
                <c:pt idx="214">
                  <c:v>4.5</c:v>
                </c:pt>
                <c:pt idx="215">
                  <c:v>4.4740000000000002</c:v>
                </c:pt>
                <c:pt idx="216">
                  <c:v>4.3780000000000001</c:v>
                </c:pt>
                <c:pt idx="217">
                  <c:v>4.28</c:v>
                </c:pt>
                <c:pt idx="218">
                  <c:v>4.1829999999999998</c:v>
                </c:pt>
                <c:pt idx="219">
                  <c:v>4.0869999999999997</c:v>
                </c:pt>
                <c:pt idx="220">
                  <c:v>4</c:v>
                </c:pt>
                <c:pt idx="221">
                  <c:v>3.9929999999999999</c:v>
                </c:pt>
                <c:pt idx="222">
                  <c:v>3.9</c:v>
                </c:pt>
                <c:pt idx="223">
                  <c:v>3.8029999999999999</c:v>
                </c:pt>
                <c:pt idx="224">
                  <c:v>3.71</c:v>
                </c:pt>
                <c:pt idx="225">
                  <c:v>3.6150000000000002</c:v>
                </c:pt>
                <c:pt idx="226">
                  <c:v>3.5179999999999998</c:v>
                </c:pt>
                <c:pt idx="227">
                  <c:v>3.5</c:v>
                </c:pt>
                <c:pt idx="228">
                  <c:v>3.4169999999999998</c:v>
                </c:pt>
                <c:pt idx="229">
                  <c:v>3.3119999999999998</c:v>
                </c:pt>
                <c:pt idx="230">
                  <c:v>3.1970000000000001</c:v>
                </c:pt>
                <c:pt idx="231">
                  <c:v>3.0670000000000002</c:v>
                </c:pt>
                <c:pt idx="232">
                  <c:v>3</c:v>
                </c:pt>
                <c:pt idx="233">
                  <c:v>2.9260000000000002</c:v>
                </c:pt>
                <c:pt idx="234">
                  <c:v>2.7650000000000001</c:v>
                </c:pt>
                <c:pt idx="235">
                  <c:v>2.5670000000000002</c:v>
                </c:pt>
                <c:pt idx="236">
                  <c:v>2.5</c:v>
                </c:pt>
                <c:pt idx="237">
                  <c:v>2.3140000000000001</c:v>
                </c:pt>
                <c:pt idx="238">
                  <c:v>2.0310000000000001</c:v>
                </c:pt>
                <c:pt idx="239">
                  <c:v>2</c:v>
                </c:pt>
                <c:pt idx="240">
                  <c:v>1.7649999999999999</c:v>
                </c:pt>
                <c:pt idx="241">
                  <c:v>1.5229999999999999</c:v>
                </c:pt>
                <c:pt idx="242">
                  <c:v>1.5</c:v>
                </c:pt>
                <c:pt idx="243">
                  <c:v>1.3109999999999999</c:v>
                </c:pt>
                <c:pt idx="244">
                  <c:v>1.131</c:v>
                </c:pt>
                <c:pt idx="245">
                  <c:v>1</c:v>
                </c:pt>
                <c:pt idx="246">
                  <c:v>0.98799999999999999</c:v>
                </c:pt>
                <c:pt idx="247">
                  <c:v>0.871</c:v>
                </c:pt>
                <c:pt idx="248">
                  <c:v>0.77600000000000002</c:v>
                </c:pt>
                <c:pt idx="249">
                  <c:v>0.69899999999999995</c:v>
                </c:pt>
                <c:pt idx="250">
                  <c:v>0.63500000000000001</c:v>
                </c:pt>
                <c:pt idx="251">
                  <c:v>0.57799999999999996</c:v>
                </c:pt>
                <c:pt idx="252">
                  <c:v>0.53400000000000003</c:v>
                </c:pt>
                <c:pt idx="253">
                  <c:v>0.5</c:v>
                </c:pt>
                <c:pt idx="254">
                  <c:v>0.496</c:v>
                </c:pt>
                <c:pt idx="255">
                  <c:v>0.46200000000000002</c:v>
                </c:pt>
                <c:pt idx="256">
                  <c:v>0.434</c:v>
                </c:pt>
                <c:pt idx="257">
                  <c:v>0.40799999999999997</c:v>
                </c:pt>
                <c:pt idx="258">
                  <c:v>0.38600000000000001</c:v>
                </c:pt>
                <c:pt idx="259">
                  <c:v>0.36499999999999999</c:v>
                </c:pt>
                <c:pt idx="260">
                  <c:v>0.34799999999999998</c:v>
                </c:pt>
                <c:pt idx="261">
                  <c:v>0.33200000000000002</c:v>
                </c:pt>
                <c:pt idx="262">
                  <c:v>0.317</c:v>
                </c:pt>
                <c:pt idx="263">
                  <c:v>0.30399999999999999</c:v>
                </c:pt>
                <c:pt idx="264">
                  <c:v>0.29099999999999998</c:v>
                </c:pt>
                <c:pt idx="265">
                  <c:v>0.27900000000000003</c:v>
                </c:pt>
                <c:pt idx="266">
                  <c:v>0.26800000000000002</c:v>
                </c:pt>
                <c:pt idx="267">
                  <c:v>0.25700000000000001</c:v>
                </c:pt>
                <c:pt idx="268">
                  <c:v>0.247</c:v>
                </c:pt>
                <c:pt idx="269">
                  <c:v>0.23699999999999999</c:v>
                </c:pt>
                <c:pt idx="270">
                  <c:v>0.22700000000000001</c:v>
                </c:pt>
                <c:pt idx="271">
                  <c:v>0.219</c:v>
                </c:pt>
                <c:pt idx="272">
                  <c:v>0.21</c:v>
                </c:pt>
                <c:pt idx="273">
                  <c:v>0.20100000000000001</c:v>
                </c:pt>
                <c:pt idx="274">
                  <c:v>0.19400000000000001</c:v>
                </c:pt>
                <c:pt idx="275">
                  <c:v>0.187</c:v>
                </c:pt>
                <c:pt idx="276">
                  <c:v>0.18</c:v>
                </c:pt>
                <c:pt idx="277">
                  <c:v>0.17199999999999999</c:v>
                </c:pt>
                <c:pt idx="278">
                  <c:v>0.16500000000000001</c:v>
                </c:pt>
                <c:pt idx="279">
                  <c:v>0.159</c:v>
                </c:pt>
                <c:pt idx="280">
                  <c:v>0.152</c:v>
                </c:pt>
                <c:pt idx="281">
                  <c:v>0.14599999999999999</c:v>
                </c:pt>
                <c:pt idx="282">
                  <c:v>0.14000000000000001</c:v>
                </c:pt>
                <c:pt idx="283">
                  <c:v>0.13500000000000001</c:v>
                </c:pt>
                <c:pt idx="284">
                  <c:v>0.129</c:v>
                </c:pt>
                <c:pt idx="285">
                  <c:v>0.124</c:v>
                </c:pt>
                <c:pt idx="286">
                  <c:v>0.11799999999999999</c:v>
                </c:pt>
                <c:pt idx="287">
                  <c:v>0.112</c:v>
                </c:pt>
                <c:pt idx="288">
                  <c:v>0.107</c:v>
                </c:pt>
                <c:pt idx="289">
                  <c:v>0.10199999999999999</c:v>
                </c:pt>
                <c:pt idx="290">
                  <c:v>9.7000000000000003E-2</c:v>
                </c:pt>
                <c:pt idx="291">
                  <c:v>9.1999999999999998E-2</c:v>
                </c:pt>
                <c:pt idx="292">
                  <c:v>8.7999999999999995E-2</c:v>
                </c:pt>
                <c:pt idx="293">
                  <c:v>8.4000000000000005E-2</c:v>
                </c:pt>
                <c:pt idx="294">
                  <c:v>7.9000000000000001E-2</c:v>
                </c:pt>
                <c:pt idx="295">
                  <c:v>7.4999999999999997E-2</c:v>
                </c:pt>
                <c:pt idx="296">
                  <c:v>7.0000000000000007E-2</c:v>
                </c:pt>
                <c:pt idx="297">
                  <c:v>6.7000000000000004E-2</c:v>
                </c:pt>
                <c:pt idx="298">
                  <c:v>6.4000000000000001E-2</c:v>
                </c:pt>
                <c:pt idx="299">
                  <c:v>0.06</c:v>
                </c:pt>
                <c:pt idx="300">
                  <c:v>5.7000000000000002E-2</c:v>
                </c:pt>
                <c:pt idx="301">
                  <c:v>5.2999999999999999E-2</c:v>
                </c:pt>
                <c:pt idx="302">
                  <c:v>0.05</c:v>
                </c:pt>
                <c:pt idx="303">
                  <c:v>4.5999999999999999E-2</c:v>
                </c:pt>
                <c:pt idx="304">
                  <c:v>4.2999999999999997E-2</c:v>
                </c:pt>
                <c:pt idx="305">
                  <c:v>0.04</c:v>
                </c:pt>
                <c:pt idx="306">
                  <c:v>3.6999999999999998E-2</c:v>
                </c:pt>
                <c:pt idx="307">
                  <c:v>3.3000000000000002E-2</c:v>
                </c:pt>
                <c:pt idx="308">
                  <c:v>3.2000000000000001E-2</c:v>
                </c:pt>
                <c:pt idx="309">
                  <c:v>2.9000000000000001E-2</c:v>
                </c:pt>
                <c:pt idx="310">
                  <c:v>2.7E-2</c:v>
                </c:pt>
                <c:pt idx="311">
                  <c:v>2.5000000000000001E-2</c:v>
                </c:pt>
                <c:pt idx="312">
                  <c:v>2.3E-2</c:v>
                </c:pt>
                <c:pt idx="313">
                  <c:v>2.1000000000000001E-2</c:v>
                </c:pt>
                <c:pt idx="314">
                  <c:v>0.02</c:v>
                </c:pt>
                <c:pt idx="315">
                  <c:v>1.7999999999999999E-2</c:v>
                </c:pt>
                <c:pt idx="316">
                  <c:v>1.7000000000000001E-2</c:v>
                </c:pt>
                <c:pt idx="317">
                  <c:v>1.4999999999999999E-2</c:v>
                </c:pt>
                <c:pt idx="318">
                  <c:v>1.4E-2</c:v>
                </c:pt>
                <c:pt idx="319">
                  <c:v>1.2999999999999999E-2</c:v>
                </c:pt>
                <c:pt idx="320">
                  <c:v>1.2E-2</c:v>
                </c:pt>
                <c:pt idx="321">
                  <c:v>1.0999999999999999E-2</c:v>
                </c:pt>
                <c:pt idx="322">
                  <c:v>8.9999999999999993E-3</c:v>
                </c:pt>
                <c:pt idx="323">
                  <c:v>8.0000000000000002E-3</c:v>
                </c:pt>
                <c:pt idx="324">
                  <c:v>8.0000000000000002E-3</c:v>
                </c:pt>
                <c:pt idx="325">
                  <c:v>7.0000000000000001E-3</c:v>
                </c:pt>
                <c:pt idx="326">
                  <c:v>7.0000000000000001E-3</c:v>
                </c:pt>
                <c:pt idx="327">
                  <c:v>6.0000000000000001E-3</c:v>
                </c:pt>
                <c:pt idx="328">
                  <c:v>5.0000000000000001E-3</c:v>
                </c:pt>
                <c:pt idx="329">
                  <c:v>5.0000000000000001E-3</c:v>
                </c:pt>
                <c:pt idx="330">
                  <c:v>5.0000000000000001E-3</c:v>
                </c:pt>
                <c:pt idx="331">
                  <c:v>4.0000000000000001E-3</c:v>
                </c:pt>
                <c:pt idx="332">
                  <c:v>4.0000000000000001E-3</c:v>
                </c:pt>
                <c:pt idx="333">
                  <c:v>4.0000000000000001E-3</c:v>
                </c:pt>
                <c:pt idx="334">
                  <c:v>3.0000000000000001E-3</c:v>
                </c:pt>
                <c:pt idx="335">
                  <c:v>3.0000000000000001E-3</c:v>
                </c:pt>
                <c:pt idx="336">
                  <c:v>3.0000000000000001E-3</c:v>
                </c:pt>
                <c:pt idx="337">
                  <c:v>2E-3</c:v>
                </c:pt>
                <c:pt idx="338">
                  <c:v>2E-3</c:v>
                </c:pt>
                <c:pt idx="339">
                  <c:v>2E-3</c:v>
                </c:pt>
                <c:pt idx="340">
                  <c:v>2E-3</c:v>
                </c:pt>
                <c:pt idx="341">
                  <c:v>2E-3</c:v>
                </c:pt>
                <c:pt idx="342">
                  <c:v>1E-3</c:v>
                </c:pt>
                <c:pt idx="343">
                  <c:v>1E-3</c:v>
                </c:pt>
                <c:pt idx="344">
                  <c:v>1E-3</c:v>
                </c:pt>
                <c:pt idx="345">
                  <c:v>1E-3</c:v>
                </c:pt>
                <c:pt idx="346">
                  <c:v>1E-3</c:v>
                </c:pt>
                <c:pt idx="347">
                  <c:v>1E-3</c:v>
                </c:pt>
                <c:pt idx="348">
                  <c:v>1E-3</c:v>
                </c:pt>
                <c:pt idx="349">
                  <c:v>1E-3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E28-411E-AF58-EA6FBC711BBE}"/>
            </c:ext>
          </c:extLst>
        </c:ser>
        <c:ser>
          <c:idx val="4"/>
          <c:order val="3"/>
          <c:tx>
            <c:strRef>
              <c:f>Foglio6!$G$1</c:f>
              <c:strCache>
                <c:ptCount val="1"/>
                <c:pt idx="0">
                  <c:v>S1,0M5</c:v>
                </c:pt>
              </c:strCache>
            </c:strRef>
          </c:tx>
          <c:spPr>
            <a:ln w="19050" cap="rnd">
              <a:solidFill>
                <a:srgbClr val="990000"/>
              </a:solidFill>
              <a:round/>
            </a:ln>
            <a:effectLst/>
          </c:spPr>
          <c:marker>
            <c:symbol val="none"/>
          </c:marker>
          <c:xVal>
            <c:numRef>
              <c:f>Foglio6!$G$1634:$G$203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1.2999999999999999E-2</c:v>
                </c:pt>
                <c:pt idx="67">
                  <c:v>2.8000000000000001E-2</c:v>
                </c:pt>
                <c:pt idx="68">
                  <c:v>4.3999999999999997E-2</c:v>
                </c:pt>
                <c:pt idx="69">
                  <c:v>5.8999999999999997E-2</c:v>
                </c:pt>
                <c:pt idx="70">
                  <c:v>7.4999999999999997E-2</c:v>
                </c:pt>
                <c:pt idx="71">
                  <c:v>9.0999999999999998E-2</c:v>
                </c:pt>
                <c:pt idx="72">
                  <c:v>0.106</c:v>
                </c:pt>
                <c:pt idx="73">
                  <c:v>0.122</c:v>
                </c:pt>
                <c:pt idx="74">
                  <c:v>0.13700000000000001</c:v>
                </c:pt>
                <c:pt idx="75">
                  <c:v>0.153</c:v>
                </c:pt>
                <c:pt idx="76">
                  <c:v>0.16800000000000001</c:v>
                </c:pt>
                <c:pt idx="77">
                  <c:v>0.184</c:v>
                </c:pt>
                <c:pt idx="78">
                  <c:v>0.2</c:v>
                </c:pt>
                <c:pt idx="79">
                  <c:v>0.215</c:v>
                </c:pt>
                <c:pt idx="80">
                  <c:v>0.23100000000000001</c:v>
                </c:pt>
                <c:pt idx="81">
                  <c:v>0.246</c:v>
                </c:pt>
                <c:pt idx="82">
                  <c:v>0.26200000000000001</c:v>
                </c:pt>
                <c:pt idx="83">
                  <c:v>0.27700000000000002</c:v>
                </c:pt>
                <c:pt idx="84">
                  <c:v>0.29299999999999998</c:v>
                </c:pt>
                <c:pt idx="85">
                  <c:v>0.308</c:v>
                </c:pt>
                <c:pt idx="86">
                  <c:v>0.32400000000000001</c:v>
                </c:pt>
                <c:pt idx="87">
                  <c:v>0.34</c:v>
                </c:pt>
                <c:pt idx="88">
                  <c:v>0.35499999999999998</c:v>
                </c:pt>
                <c:pt idx="89">
                  <c:v>0.371</c:v>
                </c:pt>
                <c:pt idx="90">
                  <c:v>0.38600000000000001</c:v>
                </c:pt>
                <c:pt idx="91">
                  <c:v>0.40200000000000002</c:v>
                </c:pt>
                <c:pt idx="92">
                  <c:v>0.41699999999999998</c:v>
                </c:pt>
                <c:pt idx="93">
                  <c:v>0.433</c:v>
                </c:pt>
                <c:pt idx="94">
                  <c:v>0.44900000000000001</c:v>
                </c:pt>
                <c:pt idx="95">
                  <c:v>0.46400000000000002</c:v>
                </c:pt>
                <c:pt idx="96">
                  <c:v>0.48</c:v>
                </c:pt>
                <c:pt idx="97">
                  <c:v>0.495</c:v>
                </c:pt>
                <c:pt idx="98">
                  <c:v>0.51100000000000001</c:v>
                </c:pt>
                <c:pt idx="99">
                  <c:v>0.52600000000000002</c:v>
                </c:pt>
                <c:pt idx="100">
                  <c:v>0.54200000000000004</c:v>
                </c:pt>
                <c:pt idx="101">
                  <c:v>0.55800000000000005</c:v>
                </c:pt>
                <c:pt idx="102">
                  <c:v>0.57299999999999995</c:v>
                </c:pt>
                <c:pt idx="103">
                  <c:v>0.58899999999999997</c:v>
                </c:pt>
                <c:pt idx="104">
                  <c:v>0.60399999999999998</c:v>
                </c:pt>
                <c:pt idx="105">
                  <c:v>0.62</c:v>
                </c:pt>
                <c:pt idx="106">
                  <c:v>0.63500000000000001</c:v>
                </c:pt>
                <c:pt idx="107">
                  <c:v>0.65100000000000002</c:v>
                </c:pt>
                <c:pt idx="108">
                  <c:v>0.66700000000000004</c:v>
                </c:pt>
                <c:pt idx="109">
                  <c:v>0.68200000000000005</c:v>
                </c:pt>
                <c:pt idx="110">
                  <c:v>0.69799999999999995</c:v>
                </c:pt>
                <c:pt idx="111">
                  <c:v>0.71299999999999997</c:v>
                </c:pt>
                <c:pt idx="112">
                  <c:v>0.72899999999999998</c:v>
                </c:pt>
                <c:pt idx="113">
                  <c:v>0.74399999999999999</c:v>
                </c:pt>
                <c:pt idx="114">
                  <c:v>0.76</c:v>
                </c:pt>
                <c:pt idx="115">
                  <c:v>0.77600000000000002</c:v>
                </c:pt>
                <c:pt idx="116">
                  <c:v>0.79100000000000004</c:v>
                </c:pt>
                <c:pt idx="117">
                  <c:v>0.80700000000000005</c:v>
                </c:pt>
                <c:pt idx="118">
                  <c:v>0.82199999999999995</c:v>
                </c:pt>
                <c:pt idx="119">
                  <c:v>0.83799999999999997</c:v>
                </c:pt>
                <c:pt idx="120">
                  <c:v>0.85299999999999998</c:v>
                </c:pt>
                <c:pt idx="121">
                  <c:v>0.86899999999999999</c:v>
                </c:pt>
                <c:pt idx="122">
                  <c:v>0.88500000000000001</c:v>
                </c:pt>
                <c:pt idx="123">
                  <c:v>0.9</c:v>
                </c:pt>
                <c:pt idx="124">
                  <c:v>0.91600000000000004</c:v>
                </c:pt>
                <c:pt idx="125">
                  <c:v>0.93100000000000005</c:v>
                </c:pt>
                <c:pt idx="126">
                  <c:v>0.94699999999999995</c:v>
                </c:pt>
                <c:pt idx="127">
                  <c:v>0.96199999999999997</c:v>
                </c:pt>
                <c:pt idx="128">
                  <c:v>0.97799999999999998</c:v>
                </c:pt>
                <c:pt idx="129">
                  <c:v>0.99399999999999999</c:v>
                </c:pt>
                <c:pt idx="130">
                  <c:v>1.0089999999999999</c:v>
                </c:pt>
                <c:pt idx="131">
                  <c:v>1.0249999999999999</c:v>
                </c:pt>
                <c:pt idx="132">
                  <c:v>1.04</c:v>
                </c:pt>
                <c:pt idx="133">
                  <c:v>1.056</c:v>
                </c:pt>
                <c:pt idx="134">
                  <c:v>1.071</c:v>
                </c:pt>
                <c:pt idx="135">
                  <c:v>1.087</c:v>
                </c:pt>
                <c:pt idx="136">
                  <c:v>1.1020000000000001</c:v>
                </c:pt>
                <c:pt idx="137">
                  <c:v>1.1180000000000001</c:v>
                </c:pt>
                <c:pt idx="138">
                  <c:v>1.1339999999999999</c:v>
                </c:pt>
                <c:pt idx="139">
                  <c:v>1.149</c:v>
                </c:pt>
                <c:pt idx="140">
                  <c:v>1.165</c:v>
                </c:pt>
                <c:pt idx="141">
                  <c:v>1.18</c:v>
                </c:pt>
                <c:pt idx="142">
                  <c:v>1.196</c:v>
                </c:pt>
                <c:pt idx="143">
                  <c:v>1.218</c:v>
                </c:pt>
                <c:pt idx="144">
                  <c:v>1.28</c:v>
                </c:pt>
                <c:pt idx="145">
                  <c:v>1.3420000000000001</c:v>
                </c:pt>
                <c:pt idx="146">
                  <c:v>1.405</c:v>
                </c:pt>
                <c:pt idx="147">
                  <c:v>1.4670000000000001</c:v>
                </c:pt>
                <c:pt idx="148">
                  <c:v>1.5289999999999999</c:v>
                </c:pt>
                <c:pt idx="149">
                  <c:v>1.5920000000000001</c:v>
                </c:pt>
                <c:pt idx="150">
                  <c:v>1.6539999999999999</c:v>
                </c:pt>
                <c:pt idx="151">
                  <c:v>1.7170000000000001</c:v>
                </c:pt>
                <c:pt idx="152">
                  <c:v>1.7789999999999999</c:v>
                </c:pt>
                <c:pt idx="153">
                  <c:v>1.841</c:v>
                </c:pt>
                <c:pt idx="154">
                  <c:v>1.9039999999999999</c:v>
                </c:pt>
                <c:pt idx="155">
                  <c:v>1.966</c:v>
                </c:pt>
                <c:pt idx="156">
                  <c:v>2.0289999999999999</c:v>
                </c:pt>
                <c:pt idx="157">
                  <c:v>2.0910000000000002</c:v>
                </c:pt>
                <c:pt idx="158">
                  <c:v>2.153</c:v>
                </c:pt>
                <c:pt idx="159">
                  <c:v>2.2160000000000002</c:v>
                </c:pt>
                <c:pt idx="160">
                  <c:v>2.278</c:v>
                </c:pt>
                <c:pt idx="161">
                  <c:v>2.34</c:v>
                </c:pt>
                <c:pt idx="162">
                  <c:v>2.403</c:v>
                </c:pt>
                <c:pt idx="163">
                  <c:v>2.5190000000000001</c:v>
                </c:pt>
                <c:pt idx="164">
                  <c:v>2.653</c:v>
                </c:pt>
                <c:pt idx="165">
                  <c:v>2.7879999999999998</c:v>
                </c:pt>
                <c:pt idx="166">
                  <c:v>2.9220000000000002</c:v>
                </c:pt>
                <c:pt idx="167">
                  <c:v>3.0569999999999999</c:v>
                </c:pt>
                <c:pt idx="168">
                  <c:v>3.1920000000000002</c:v>
                </c:pt>
                <c:pt idx="169">
                  <c:v>3.3260000000000001</c:v>
                </c:pt>
                <c:pt idx="170">
                  <c:v>3.4609999999999999</c:v>
                </c:pt>
                <c:pt idx="171">
                  <c:v>3.5950000000000002</c:v>
                </c:pt>
                <c:pt idx="172">
                  <c:v>3.8149999999999999</c:v>
                </c:pt>
                <c:pt idx="173">
                  <c:v>4.0629999999999997</c:v>
                </c:pt>
                <c:pt idx="174">
                  <c:v>4.3109999999999999</c:v>
                </c:pt>
                <c:pt idx="175">
                  <c:v>4.5590000000000002</c:v>
                </c:pt>
                <c:pt idx="176">
                  <c:v>4.8070000000000004</c:v>
                </c:pt>
                <c:pt idx="177">
                  <c:v>5.2080000000000002</c:v>
                </c:pt>
                <c:pt idx="178">
                  <c:v>5.6310000000000002</c:v>
                </c:pt>
                <c:pt idx="179">
                  <c:v>6.0469999999999997</c:v>
                </c:pt>
                <c:pt idx="180">
                  <c:v>6.0590000000000002</c:v>
                </c:pt>
                <c:pt idx="181">
                  <c:v>6.7409999999999997</c:v>
                </c:pt>
                <c:pt idx="182">
                  <c:v>7.5049999999999999</c:v>
                </c:pt>
                <c:pt idx="183">
                  <c:v>8.5540000000000003</c:v>
                </c:pt>
                <c:pt idx="184">
                  <c:v>10.087</c:v>
                </c:pt>
                <c:pt idx="185">
                  <c:v>12.093999999999999</c:v>
                </c:pt>
                <c:pt idx="186">
                  <c:v>12.29</c:v>
                </c:pt>
                <c:pt idx="187">
                  <c:v>15.608000000000001</c:v>
                </c:pt>
                <c:pt idx="188">
                  <c:v>18.141999999999999</c:v>
                </c:pt>
                <c:pt idx="189">
                  <c:v>20.637</c:v>
                </c:pt>
                <c:pt idx="190">
                  <c:v>24.189</c:v>
                </c:pt>
                <c:pt idx="191">
                  <c:v>28.041</c:v>
                </c:pt>
                <c:pt idx="192">
                  <c:v>30.236000000000001</c:v>
                </c:pt>
                <c:pt idx="193">
                  <c:v>36.283000000000001</c:v>
                </c:pt>
                <c:pt idx="194">
                  <c:v>38.723999999999997</c:v>
                </c:pt>
                <c:pt idx="195">
                  <c:v>42.33</c:v>
                </c:pt>
                <c:pt idx="196">
                  <c:v>48.378</c:v>
                </c:pt>
                <c:pt idx="197">
                  <c:v>53.344999999999999</c:v>
                </c:pt>
                <c:pt idx="198">
                  <c:v>54.424999999999997</c:v>
                </c:pt>
                <c:pt idx="199">
                  <c:v>60.472000000000001</c:v>
                </c:pt>
                <c:pt idx="200">
                  <c:v>66.519000000000005</c:v>
                </c:pt>
                <c:pt idx="201">
                  <c:v>72.566000000000003</c:v>
                </c:pt>
                <c:pt idx="202">
                  <c:v>72.832999999999998</c:v>
                </c:pt>
                <c:pt idx="203">
                  <c:v>78.614000000000004</c:v>
                </c:pt>
                <c:pt idx="204">
                  <c:v>84.661000000000001</c:v>
                </c:pt>
                <c:pt idx="205">
                  <c:v>90.707999999999998</c:v>
                </c:pt>
                <c:pt idx="206">
                  <c:v>96.754999999999995</c:v>
                </c:pt>
                <c:pt idx="207">
                  <c:v>97.174999999999997</c:v>
                </c:pt>
                <c:pt idx="208">
                  <c:v>102.80200000000001</c:v>
                </c:pt>
                <c:pt idx="209">
                  <c:v>108.85</c:v>
                </c:pt>
                <c:pt idx="210">
                  <c:v>114.89700000000001</c:v>
                </c:pt>
                <c:pt idx="211">
                  <c:v>120.944</c:v>
                </c:pt>
                <c:pt idx="212">
                  <c:v>126.462</c:v>
                </c:pt>
                <c:pt idx="213">
                  <c:v>126.991</c:v>
                </c:pt>
                <c:pt idx="214">
                  <c:v>133.03899999999999</c:v>
                </c:pt>
                <c:pt idx="215">
                  <c:v>139.08600000000001</c:v>
                </c:pt>
                <c:pt idx="216">
                  <c:v>145.13300000000001</c:v>
                </c:pt>
                <c:pt idx="217">
                  <c:v>151.18</c:v>
                </c:pt>
                <c:pt idx="218">
                  <c:v>157.227</c:v>
                </c:pt>
                <c:pt idx="219">
                  <c:v>158.46799999999999</c:v>
                </c:pt>
                <c:pt idx="220">
                  <c:v>163.27500000000001</c:v>
                </c:pt>
                <c:pt idx="221">
                  <c:v>169.322</c:v>
                </c:pt>
                <c:pt idx="222">
                  <c:v>175.369</c:v>
                </c:pt>
                <c:pt idx="223">
                  <c:v>181.416</c:v>
                </c:pt>
                <c:pt idx="224">
                  <c:v>187.46299999999999</c:v>
                </c:pt>
                <c:pt idx="225">
                  <c:v>191.89500000000001</c:v>
                </c:pt>
                <c:pt idx="226">
                  <c:v>193.511</c:v>
                </c:pt>
                <c:pt idx="227">
                  <c:v>199.55799999999999</c:v>
                </c:pt>
                <c:pt idx="228">
                  <c:v>205.60499999999999</c:v>
                </c:pt>
                <c:pt idx="229">
                  <c:v>211.65199999999999</c:v>
                </c:pt>
                <c:pt idx="230">
                  <c:v>217.69900000000001</c:v>
                </c:pt>
                <c:pt idx="231">
                  <c:v>222.411</c:v>
                </c:pt>
                <c:pt idx="232">
                  <c:v>223.74700000000001</c:v>
                </c:pt>
                <c:pt idx="233">
                  <c:v>229.79400000000001</c:v>
                </c:pt>
                <c:pt idx="234">
                  <c:v>235.84100000000001</c:v>
                </c:pt>
                <c:pt idx="235">
                  <c:v>241.88800000000001</c:v>
                </c:pt>
                <c:pt idx="236">
                  <c:v>245.06</c:v>
                </c:pt>
                <c:pt idx="237">
                  <c:v>247.935</c:v>
                </c:pt>
                <c:pt idx="238">
                  <c:v>253.983</c:v>
                </c:pt>
                <c:pt idx="239">
                  <c:v>259.64100000000002</c:v>
                </c:pt>
                <c:pt idx="240">
                  <c:v>260.02999999999997</c:v>
                </c:pt>
                <c:pt idx="241">
                  <c:v>266.077</c:v>
                </c:pt>
                <c:pt idx="242">
                  <c:v>272.12400000000002</c:v>
                </c:pt>
                <c:pt idx="243">
                  <c:v>274.73</c:v>
                </c:pt>
                <c:pt idx="244">
                  <c:v>278.17099999999999</c:v>
                </c:pt>
                <c:pt idx="245">
                  <c:v>284.21899999999999</c:v>
                </c:pt>
                <c:pt idx="246">
                  <c:v>290.26600000000002</c:v>
                </c:pt>
                <c:pt idx="247">
                  <c:v>296.31299999999999</c:v>
                </c:pt>
                <c:pt idx="248">
                  <c:v>296.35000000000002</c:v>
                </c:pt>
                <c:pt idx="249">
                  <c:v>302.36</c:v>
                </c:pt>
                <c:pt idx="250">
                  <c:v>308.40699999999998</c:v>
                </c:pt>
                <c:pt idx="251">
                  <c:v>314.45499999999998</c:v>
                </c:pt>
                <c:pt idx="252">
                  <c:v>320.50200000000001</c:v>
                </c:pt>
                <c:pt idx="253">
                  <c:v>326.54899999999998</c:v>
                </c:pt>
                <c:pt idx="254">
                  <c:v>332.596</c:v>
                </c:pt>
                <c:pt idx="255">
                  <c:v>337.66899999999998</c:v>
                </c:pt>
                <c:pt idx="256">
                  <c:v>338.64299999999997</c:v>
                </c:pt>
                <c:pt idx="257">
                  <c:v>344.69099999999997</c:v>
                </c:pt>
                <c:pt idx="258">
                  <c:v>350.738</c:v>
                </c:pt>
                <c:pt idx="259">
                  <c:v>356.78500000000003</c:v>
                </c:pt>
                <c:pt idx="260">
                  <c:v>362.83199999999999</c:v>
                </c:pt>
                <c:pt idx="261">
                  <c:v>368.88</c:v>
                </c:pt>
                <c:pt idx="262">
                  <c:v>374.92700000000002</c:v>
                </c:pt>
                <c:pt idx="263">
                  <c:v>380.97399999999999</c:v>
                </c:pt>
                <c:pt idx="264">
                  <c:v>387.02100000000002</c:v>
                </c:pt>
                <c:pt idx="265">
                  <c:v>393.06799999999998</c:v>
                </c:pt>
                <c:pt idx="266">
                  <c:v>399.11599999999999</c:v>
                </c:pt>
                <c:pt idx="267">
                  <c:v>405.16300000000001</c:v>
                </c:pt>
                <c:pt idx="268">
                  <c:v>411.21</c:v>
                </c:pt>
                <c:pt idx="269">
                  <c:v>417.25700000000001</c:v>
                </c:pt>
                <c:pt idx="270">
                  <c:v>423.30399999999997</c:v>
                </c:pt>
                <c:pt idx="271">
                  <c:v>429.35199999999998</c:v>
                </c:pt>
                <c:pt idx="272">
                  <c:v>435.399</c:v>
                </c:pt>
                <c:pt idx="273">
                  <c:v>441.44600000000003</c:v>
                </c:pt>
                <c:pt idx="274">
                  <c:v>447.49299999999999</c:v>
                </c:pt>
                <c:pt idx="275">
                  <c:v>453.54</c:v>
                </c:pt>
                <c:pt idx="276">
                  <c:v>459.58800000000002</c:v>
                </c:pt>
                <c:pt idx="277">
                  <c:v>465.63499999999999</c:v>
                </c:pt>
                <c:pt idx="278">
                  <c:v>471.68200000000002</c:v>
                </c:pt>
                <c:pt idx="279">
                  <c:v>477.72899999999998</c:v>
                </c:pt>
                <c:pt idx="280">
                  <c:v>483.77600000000001</c:v>
                </c:pt>
                <c:pt idx="281">
                  <c:v>489.82400000000001</c:v>
                </c:pt>
                <c:pt idx="282">
                  <c:v>495.87099999999998</c:v>
                </c:pt>
                <c:pt idx="283">
                  <c:v>501.91800000000001</c:v>
                </c:pt>
                <c:pt idx="284">
                  <c:v>507.96499999999997</c:v>
                </c:pt>
                <c:pt idx="285">
                  <c:v>514.01199999999994</c:v>
                </c:pt>
                <c:pt idx="286">
                  <c:v>520.05999999999995</c:v>
                </c:pt>
                <c:pt idx="287">
                  <c:v>526.10699999999997</c:v>
                </c:pt>
                <c:pt idx="288">
                  <c:v>532.154</c:v>
                </c:pt>
                <c:pt idx="289">
                  <c:v>538.20100000000002</c:v>
                </c:pt>
                <c:pt idx="290">
                  <c:v>544.24800000000005</c:v>
                </c:pt>
                <c:pt idx="291">
                  <c:v>550.29600000000005</c:v>
                </c:pt>
                <c:pt idx="292">
                  <c:v>556.34299999999996</c:v>
                </c:pt>
                <c:pt idx="293">
                  <c:v>562.39</c:v>
                </c:pt>
                <c:pt idx="294">
                  <c:v>568.43700000000001</c:v>
                </c:pt>
                <c:pt idx="295">
                  <c:v>574.48400000000004</c:v>
                </c:pt>
                <c:pt idx="296">
                  <c:v>580.53200000000004</c:v>
                </c:pt>
                <c:pt idx="297">
                  <c:v>586.57899999999995</c:v>
                </c:pt>
                <c:pt idx="298">
                  <c:v>592.62599999999998</c:v>
                </c:pt>
                <c:pt idx="299">
                  <c:v>598.673</c:v>
                </c:pt>
                <c:pt idx="300">
                  <c:v>604.721</c:v>
                </c:pt>
                <c:pt idx="301">
                  <c:v>610.76800000000003</c:v>
                </c:pt>
                <c:pt idx="302">
                  <c:v>616.81500000000005</c:v>
                </c:pt>
                <c:pt idx="303">
                  <c:v>622.86199999999997</c:v>
                </c:pt>
                <c:pt idx="304">
                  <c:v>628.90899999999999</c:v>
                </c:pt>
                <c:pt idx="305">
                  <c:v>634.95699999999999</c:v>
                </c:pt>
                <c:pt idx="306">
                  <c:v>641.00400000000002</c:v>
                </c:pt>
                <c:pt idx="307">
                  <c:v>647.05100000000004</c:v>
                </c:pt>
                <c:pt idx="308">
                  <c:v>653.09799999999996</c:v>
                </c:pt>
                <c:pt idx="309">
                  <c:v>659.14499999999998</c:v>
                </c:pt>
                <c:pt idx="310">
                  <c:v>665.19299999999998</c:v>
                </c:pt>
                <c:pt idx="311">
                  <c:v>671.24</c:v>
                </c:pt>
                <c:pt idx="312">
                  <c:v>677.28700000000003</c:v>
                </c:pt>
                <c:pt idx="313">
                  <c:v>683.33399999999995</c:v>
                </c:pt>
                <c:pt idx="314">
                  <c:v>689.38099999999997</c:v>
                </c:pt>
                <c:pt idx="315">
                  <c:v>695.42899999999997</c:v>
                </c:pt>
                <c:pt idx="316">
                  <c:v>701.476</c:v>
                </c:pt>
                <c:pt idx="317">
                  <c:v>707.52300000000002</c:v>
                </c:pt>
                <c:pt idx="318">
                  <c:v>713.57</c:v>
                </c:pt>
                <c:pt idx="319">
                  <c:v>719.61699999999996</c:v>
                </c:pt>
                <c:pt idx="320">
                  <c:v>725.66499999999996</c:v>
                </c:pt>
                <c:pt idx="321">
                  <c:v>731.71199999999999</c:v>
                </c:pt>
                <c:pt idx="322">
                  <c:v>737.75900000000001</c:v>
                </c:pt>
                <c:pt idx="323">
                  <c:v>743.80600000000004</c:v>
                </c:pt>
                <c:pt idx="324">
                  <c:v>749.85299999999995</c:v>
                </c:pt>
                <c:pt idx="325">
                  <c:v>755.90099999999995</c:v>
                </c:pt>
                <c:pt idx="326">
                  <c:v>761.94799999999998</c:v>
                </c:pt>
                <c:pt idx="327">
                  <c:v>767.995</c:v>
                </c:pt>
                <c:pt idx="328">
                  <c:v>774.04200000000003</c:v>
                </c:pt>
                <c:pt idx="329">
                  <c:v>780.08900000000006</c:v>
                </c:pt>
                <c:pt idx="330">
                  <c:v>786.13699999999994</c:v>
                </c:pt>
                <c:pt idx="331">
                  <c:v>792.18399999999997</c:v>
                </c:pt>
                <c:pt idx="332">
                  <c:v>798.23099999999999</c:v>
                </c:pt>
                <c:pt idx="333">
                  <c:v>804.27800000000002</c:v>
                </c:pt>
                <c:pt idx="334">
                  <c:v>810.32500000000005</c:v>
                </c:pt>
                <c:pt idx="335">
                  <c:v>816.37300000000005</c:v>
                </c:pt>
                <c:pt idx="336">
                  <c:v>822.42</c:v>
                </c:pt>
                <c:pt idx="337">
                  <c:v>828.46699999999998</c:v>
                </c:pt>
                <c:pt idx="338">
                  <c:v>834.51400000000001</c:v>
                </c:pt>
                <c:pt idx="339">
                  <c:v>840.56200000000001</c:v>
                </c:pt>
                <c:pt idx="340">
                  <c:v>846.60900000000004</c:v>
                </c:pt>
                <c:pt idx="341">
                  <c:v>852.65599999999995</c:v>
                </c:pt>
                <c:pt idx="342">
                  <c:v>858.70299999999997</c:v>
                </c:pt>
                <c:pt idx="343">
                  <c:v>864.75</c:v>
                </c:pt>
                <c:pt idx="344">
                  <c:v>870.798</c:v>
                </c:pt>
                <c:pt idx="345">
                  <c:v>876.84500000000003</c:v>
                </c:pt>
                <c:pt idx="346">
                  <c:v>882.89200000000005</c:v>
                </c:pt>
                <c:pt idx="347">
                  <c:v>888.93899999999996</c:v>
                </c:pt>
                <c:pt idx="348">
                  <c:v>894.98599999999999</c:v>
                </c:pt>
                <c:pt idx="349">
                  <c:v>901.03399999999999</c:v>
                </c:pt>
                <c:pt idx="350">
                  <c:v>907.08100000000002</c:v>
                </c:pt>
                <c:pt idx="351">
                  <c:v>913.12800000000004</c:v>
                </c:pt>
                <c:pt idx="352">
                  <c:v>919.17499999999995</c:v>
                </c:pt>
                <c:pt idx="353">
                  <c:v>925.22199999999998</c:v>
                </c:pt>
                <c:pt idx="354">
                  <c:v>931.27</c:v>
                </c:pt>
                <c:pt idx="355">
                  <c:v>937.31700000000001</c:v>
                </c:pt>
                <c:pt idx="356">
                  <c:v>943.36400000000003</c:v>
                </c:pt>
                <c:pt idx="357">
                  <c:v>949.41099999999994</c:v>
                </c:pt>
                <c:pt idx="358">
                  <c:v>955.45799999999997</c:v>
                </c:pt>
                <c:pt idx="359">
                  <c:v>961.50599999999997</c:v>
                </c:pt>
                <c:pt idx="360">
                  <c:v>967.553</c:v>
                </c:pt>
                <c:pt idx="361">
                  <c:v>973.6</c:v>
                </c:pt>
                <c:pt idx="362">
                  <c:v>979.64700000000005</c:v>
                </c:pt>
                <c:pt idx="363">
                  <c:v>985.69399999999996</c:v>
                </c:pt>
                <c:pt idx="364">
                  <c:v>991.74199999999996</c:v>
                </c:pt>
                <c:pt idx="365">
                  <c:v>997.78899999999999</c:v>
                </c:pt>
                <c:pt idx="366">
                  <c:v>1003.836</c:v>
                </c:pt>
                <c:pt idx="367">
                  <c:v>1009.883</c:v>
                </c:pt>
                <c:pt idx="368">
                  <c:v>1015.93</c:v>
                </c:pt>
                <c:pt idx="369">
                  <c:v>1021.978</c:v>
                </c:pt>
                <c:pt idx="370">
                  <c:v>1028.0250000000001</c:v>
                </c:pt>
                <c:pt idx="371">
                  <c:v>1034.0719999999999</c:v>
                </c:pt>
                <c:pt idx="372">
                  <c:v>1040.1189999999999</c:v>
                </c:pt>
                <c:pt idx="373">
                  <c:v>1046.1659999999999</c:v>
                </c:pt>
                <c:pt idx="374">
                  <c:v>1052.2139999999999</c:v>
                </c:pt>
                <c:pt idx="375">
                  <c:v>1058.261</c:v>
                </c:pt>
                <c:pt idx="376">
                  <c:v>1064.308</c:v>
                </c:pt>
                <c:pt idx="377">
                  <c:v>1070.355</c:v>
                </c:pt>
                <c:pt idx="378">
                  <c:v>1076.403</c:v>
                </c:pt>
                <c:pt idx="379">
                  <c:v>1082.45</c:v>
                </c:pt>
                <c:pt idx="380">
                  <c:v>1088.4970000000001</c:v>
                </c:pt>
                <c:pt idx="381">
                  <c:v>1094.5440000000001</c:v>
                </c:pt>
                <c:pt idx="382">
                  <c:v>1100.5909999999999</c:v>
                </c:pt>
                <c:pt idx="383">
                  <c:v>1106.6389999999999</c:v>
                </c:pt>
                <c:pt idx="384">
                  <c:v>1112.6859999999999</c:v>
                </c:pt>
                <c:pt idx="385">
                  <c:v>1118.7329999999999</c:v>
                </c:pt>
                <c:pt idx="386">
                  <c:v>1124.78</c:v>
                </c:pt>
                <c:pt idx="387">
                  <c:v>1130.827</c:v>
                </c:pt>
                <c:pt idx="388">
                  <c:v>1136.875</c:v>
                </c:pt>
                <c:pt idx="389">
                  <c:v>1142.922</c:v>
                </c:pt>
                <c:pt idx="390">
                  <c:v>1148.9690000000001</c:v>
                </c:pt>
                <c:pt idx="391">
                  <c:v>1155.0160000000001</c:v>
                </c:pt>
                <c:pt idx="392">
                  <c:v>1161.0630000000001</c:v>
                </c:pt>
                <c:pt idx="393">
                  <c:v>1167.1110000000001</c:v>
                </c:pt>
                <c:pt idx="394">
                  <c:v>1173.1579999999999</c:v>
                </c:pt>
                <c:pt idx="395">
                  <c:v>1179.2049999999999</c:v>
                </c:pt>
                <c:pt idx="396">
                  <c:v>1185.252</c:v>
                </c:pt>
                <c:pt idx="397">
                  <c:v>1191.299</c:v>
                </c:pt>
                <c:pt idx="398">
                  <c:v>1197.347</c:v>
                </c:pt>
                <c:pt idx="399">
                  <c:v>1203.394</c:v>
                </c:pt>
                <c:pt idx="400">
                  <c:v>1209.441</c:v>
                </c:pt>
                <c:pt idx="401">
                  <c:v>1209.441</c:v>
                </c:pt>
              </c:numCache>
            </c:numRef>
          </c:xVal>
          <c:yVal>
            <c:numRef>
              <c:f>Foglio6!$H$1634:$H$203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</c:v>
                </c:pt>
                <c:pt idx="170">
                  <c:v>15.5</c:v>
                </c:pt>
                <c:pt idx="171">
                  <c:v>15</c:v>
                </c:pt>
                <c:pt idx="172">
                  <c:v>14.5</c:v>
                </c:pt>
                <c:pt idx="173">
                  <c:v>14</c:v>
                </c:pt>
                <c:pt idx="174">
                  <c:v>13.5</c:v>
                </c:pt>
                <c:pt idx="175">
                  <c:v>13</c:v>
                </c:pt>
                <c:pt idx="176">
                  <c:v>12.5</c:v>
                </c:pt>
                <c:pt idx="177">
                  <c:v>12</c:v>
                </c:pt>
                <c:pt idx="178">
                  <c:v>11.5</c:v>
                </c:pt>
                <c:pt idx="179">
                  <c:v>11.009</c:v>
                </c:pt>
                <c:pt idx="180">
                  <c:v>11</c:v>
                </c:pt>
                <c:pt idx="181">
                  <c:v>10.5</c:v>
                </c:pt>
                <c:pt idx="182">
                  <c:v>10</c:v>
                </c:pt>
                <c:pt idx="183">
                  <c:v>9.5</c:v>
                </c:pt>
                <c:pt idx="184">
                  <c:v>9</c:v>
                </c:pt>
                <c:pt idx="185">
                  <c:v>8.5340000000000007</c:v>
                </c:pt>
                <c:pt idx="186">
                  <c:v>8.5</c:v>
                </c:pt>
                <c:pt idx="187">
                  <c:v>8</c:v>
                </c:pt>
                <c:pt idx="188">
                  <c:v>7.7220000000000004</c:v>
                </c:pt>
                <c:pt idx="189">
                  <c:v>7.5</c:v>
                </c:pt>
                <c:pt idx="190">
                  <c:v>7.2370000000000001</c:v>
                </c:pt>
                <c:pt idx="191">
                  <c:v>7</c:v>
                </c:pt>
                <c:pt idx="192">
                  <c:v>6.8819999999999997</c:v>
                </c:pt>
                <c:pt idx="193">
                  <c:v>6.6</c:v>
                </c:pt>
                <c:pt idx="194">
                  <c:v>6.5</c:v>
                </c:pt>
                <c:pt idx="195">
                  <c:v>6.3630000000000004</c:v>
                </c:pt>
                <c:pt idx="196">
                  <c:v>6.1539999999999999</c:v>
                </c:pt>
                <c:pt idx="197">
                  <c:v>6</c:v>
                </c:pt>
                <c:pt idx="198">
                  <c:v>5.9690000000000003</c:v>
                </c:pt>
                <c:pt idx="199">
                  <c:v>5.8010000000000002</c:v>
                </c:pt>
                <c:pt idx="200">
                  <c:v>5.649</c:v>
                </c:pt>
                <c:pt idx="201">
                  <c:v>5.5060000000000002</c:v>
                </c:pt>
                <c:pt idx="202">
                  <c:v>5.5</c:v>
                </c:pt>
                <c:pt idx="203">
                  <c:v>5.3719999999999999</c:v>
                </c:pt>
                <c:pt idx="204">
                  <c:v>5.2439999999999998</c:v>
                </c:pt>
                <c:pt idx="205">
                  <c:v>5.1239999999999997</c:v>
                </c:pt>
                <c:pt idx="206">
                  <c:v>5.008</c:v>
                </c:pt>
                <c:pt idx="207">
                  <c:v>5</c:v>
                </c:pt>
                <c:pt idx="208">
                  <c:v>4.8970000000000002</c:v>
                </c:pt>
                <c:pt idx="209">
                  <c:v>4.7910000000000004</c:v>
                </c:pt>
                <c:pt idx="210">
                  <c:v>4.6870000000000003</c:v>
                </c:pt>
                <c:pt idx="211">
                  <c:v>4.5890000000000004</c:v>
                </c:pt>
                <c:pt idx="212">
                  <c:v>4.5</c:v>
                </c:pt>
                <c:pt idx="213">
                  <c:v>4.4909999999999997</c:v>
                </c:pt>
                <c:pt idx="214">
                  <c:v>4.391</c:v>
                </c:pt>
                <c:pt idx="215">
                  <c:v>4.2960000000000003</c:v>
                </c:pt>
                <c:pt idx="216">
                  <c:v>4.2</c:v>
                </c:pt>
                <c:pt idx="217">
                  <c:v>4.1100000000000003</c:v>
                </c:pt>
                <c:pt idx="218">
                  <c:v>4.0190000000000001</c:v>
                </c:pt>
                <c:pt idx="219">
                  <c:v>4</c:v>
                </c:pt>
                <c:pt idx="220">
                  <c:v>3.927</c:v>
                </c:pt>
                <c:pt idx="221">
                  <c:v>3.8380000000000001</c:v>
                </c:pt>
                <c:pt idx="222">
                  <c:v>3.746</c:v>
                </c:pt>
                <c:pt idx="223">
                  <c:v>3.653</c:v>
                </c:pt>
                <c:pt idx="224">
                  <c:v>3.5640000000000001</c:v>
                </c:pt>
                <c:pt idx="225">
                  <c:v>3.5</c:v>
                </c:pt>
                <c:pt idx="226">
                  <c:v>3.4769999999999999</c:v>
                </c:pt>
                <c:pt idx="227">
                  <c:v>3.3839999999999999</c:v>
                </c:pt>
                <c:pt idx="228">
                  <c:v>3.286</c:v>
                </c:pt>
                <c:pt idx="229">
                  <c:v>3.1829999999999998</c:v>
                </c:pt>
                <c:pt idx="230">
                  <c:v>3.08</c:v>
                </c:pt>
                <c:pt idx="231">
                  <c:v>3</c:v>
                </c:pt>
                <c:pt idx="232">
                  <c:v>2.9769999999999999</c:v>
                </c:pt>
                <c:pt idx="233">
                  <c:v>2.8679999999999999</c:v>
                </c:pt>
                <c:pt idx="234">
                  <c:v>2.7450000000000001</c:v>
                </c:pt>
                <c:pt idx="235">
                  <c:v>2.5920000000000001</c:v>
                </c:pt>
                <c:pt idx="236">
                  <c:v>2.5</c:v>
                </c:pt>
                <c:pt idx="237">
                  <c:v>2.41</c:v>
                </c:pt>
                <c:pt idx="238">
                  <c:v>2.2029999999999998</c:v>
                </c:pt>
                <c:pt idx="239">
                  <c:v>2</c:v>
                </c:pt>
                <c:pt idx="240">
                  <c:v>1.9850000000000001</c:v>
                </c:pt>
                <c:pt idx="241">
                  <c:v>1.7669999999999999</c:v>
                </c:pt>
                <c:pt idx="242">
                  <c:v>1.5760000000000001</c:v>
                </c:pt>
                <c:pt idx="243">
                  <c:v>1.5</c:v>
                </c:pt>
                <c:pt idx="244">
                  <c:v>1.4079999999999999</c:v>
                </c:pt>
                <c:pt idx="245">
                  <c:v>1.2509999999999999</c:v>
                </c:pt>
                <c:pt idx="246">
                  <c:v>1.1180000000000001</c:v>
                </c:pt>
                <c:pt idx="247">
                  <c:v>1.0009999999999999</c:v>
                </c:pt>
                <c:pt idx="248">
                  <c:v>1</c:v>
                </c:pt>
                <c:pt idx="249">
                  <c:v>0.89300000000000002</c:v>
                </c:pt>
                <c:pt idx="250">
                  <c:v>0.80200000000000005</c:v>
                </c:pt>
                <c:pt idx="251">
                  <c:v>0.71799999999999997</c:v>
                </c:pt>
                <c:pt idx="252">
                  <c:v>0.64500000000000002</c:v>
                </c:pt>
                <c:pt idx="253">
                  <c:v>0.58499999999999996</c:v>
                </c:pt>
                <c:pt idx="254">
                  <c:v>0.53500000000000003</c:v>
                </c:pt>
                <c:pt idx="255">
                  <c:v>0.5</c:v>
                </c:pt>
                <c:pt idx="256">
                  <c:v>0.49299999999999999</c:v>
                </c:pt>
                <c:pt idx="257">
                  <c:v>0.45600000000000002</c:v>
                </c:pt>
                <c:pt idx="258">
                  <c:v>0.42399999999999999</c:v>
                </c:pt>
                <c:pt idx="259">
                  <c:v>0.39500000000000002</c:v>
                </c:pt>
                <c:pt idx="260">
                  <c:v>0.371</c:v>
                </c:pt>
                <c:pt idx="261">
                  <c:v>0.35</c:v>
                </c:pt>
                <c:pt idx="262">
                  <c:v>0.33100000000000002</c:v>
                </c:pt>
                <c:pt idx="263">
                  <c:v>0.314</c:v>
                </c:pt>
                <c:pt idx="264">
                  <c:v>0.29699999999999999</c:v>
                </c:pt>
                <c:pt idx="265">
                  <c:v>0.28299999999999997</c:v>
                </c:pt>
                <c:pt idx="266">
                  <c:v>0.26900000000000002</c:v>
                </c:pt>
                <c:pt idx="267">
                  <c:v>0.25800000000000001</c:v>
                </c:pt>
                <c:pt idx="268">
                  <c:v>0.246</c:v>
                </c:pt>
                <c:pt idx="269">
                  <c:v>0.23499999999999999</c:v>
                </c:pt>
                <c:pt idx="270">
                  <c:v>0.22600000000000001</c:v>
                </c:pt>
                <c:pt idx="271">
                  <c:v>0.216</c:v>
                </c:pt>
                <c:pt idx="272">
                  <c:v>0.20699999999999999</c:v>
                </c:pt>
                <c:pt idx="273">
                  <c:v>0.19900000000000001</c:v>
                </c:pt>
                <c:pt idx="274">
                  <c:v>0.191</c:v>
                </c:pt>
                <c:pt idx="275">
                  <c:v>0.184</c:v>
                </c:pt>
                <c:pt idx="276">
                  <c:v>0.17599999999999999</c:v>
                </c:pt>
                <c:pt idx="277">
                  <c:v>0.17</c:v>
                </c:pt>
                <c:pt idx="278">
                  <c:v>0.16200000000000001</c:v>
                </c:pt>
                <c:pt idx="279">
                  <c:v>0.156</c:v>
                </c:pt>
                <c:pt idx="280">
                  <c:v>0.14899999999999999</c:v>
                </c:pt>
                <c:pt idx="281">
                  <c:v>0.14299999999999999</c:v>
                </c:pt>
                <c:pt idx="282">
                  <c:v>0.13700000000000001</c:v>
                </c:pt>
                <c:pt idx="283">
                  <c:v>0.13200000000000001</c:v>
                </c:pt>
                <c:pt idx="284">
                  <c:v>0.126</c:v>
                </c:pt>
                <c:pt idx="285">
                  <c:v>0.12</c:v>
                </c:pt>
                <c:pt idx="286">
                  <c:v>0.11600000000000001</c:v>
                </c:pt>
                <c:pt idx="287">
                  <c:v>0.111</c:v>
                </c:pt>
                <c:pt idx="288">
                  <c:v>0.106</c:v>
                </c:pt>
                <c:pt idx="289">
                  <c:v>0.10100000000000001</c:v>
                </c:pt>
                <c:pt idx="290">
                  <c:v>9.6000000000000002E-2</c:v>
                </c:pt>
                <c:pt idx="291">
                  <c:v>9.0999999999999998E-2</c:v>
                </c:pt>
                <c:pt idx="292">
                  <c:v>8.6999999999999994E-2</c:v>
                </c:pt>
                <c:pt idx="293">
                  <c:v>8.3000000000000004E-2</c:v>
                </c:pt>
                <c:pt idx="294">
                  <c:v>7.9000000000000001E-2</c:v>
                </c:pt>
                <c:pt idx="295">
                  <c:v>7.4999999999999997E-2</c:v>
                </c:pt>
                <c:pt idx="296">
                  <c:v>7.1999999999999995E-2</c:v>
                </c:pt>
                <c:pt idx="297">
                  <c:v>6.9000000000000006E-2</c:v>
                </c:pt>
                <c:pt idx="298">
                  <c:v>6.5000000000000002E-2</c:v>
                </c:pt>
                <c:pt idx="299">
                  <c:v>6.0999999999999999E-2</c:v>
                </c:pt>
                <c:pt idx="300">
                  <c:v>5.8000000000000003E-2</c:v>
                </c:pt>
                <c:pt idx="301">
                  <c:v>5.3999999999999999E-2</c:v>
                </c:pt>
                <c:pt idx="302">
                  <c:v>0.05</c:v>
                </c:pt>
                <c:pt idx="303">
                  <c:v>4.7E-2</c:v>
                </c:pt>
                <c:pt idx="304">
                  <c:v>4.3999999999999997E-2</c:v>
                </c:pt>
                <c:pt idx="305">
                  <c:v>4.1000000000000002E-2</c:v>
                </c:pt>
                <c:pt idx="306">
                  <c:v>3.9E-2</c:v>
                </c:pt>
                <c:pt idx="307">
                  <c:v>3.5999999999999997E-2</c:v>
                </c:pt>
                <c:pt idx="308">
                  <c:v>3.3000000000000002E-2</c:v>
                </c:pt>
                <c:pt idx="309">
                  <c:v>3.1E-2</c:v>
                </c:pt>
                <c:pt idx="310">
                  <c:v>2.9000000000000001E-2</c:v>
                </c:pt>
                <c:pt idx="311">
                  <c:v>2.7E-2</c:v>
                </c:pt>
                <c:pt idx="312">
                  <c:v>2.4E-2</c:v>
                </c:pt>
                <c:pt idx="313">
                  <c:v>2.3E-2</c:v>
                </c:pt>
                <c:pt idx="314">
                  <c:v>2.1000000000000001E-2</c:v>
                </c:pt>
                <c:pt idx="315">
                  <c:v>1.9E-2</c:v>
                </c:pt>
                <c:pt idx="316">
                  <c:v>1.7000000000000001E-2</c:v>
                </c:pt>
                <c:pt idx="317">
                  <c:v>1.6E-2</c:v>
                </c:pt>
                <c:pt idx="318">
                  <c:v>1.4E-2</c:v>
                </c:pt>
                <c:pt idx="319">
                  <c:v>1.2E-2</c:v>
                </c:pt>
                <c:pt idx="320">
                  <c:v>1.0999999999999999E-2</c:v>
                </c:pt>
                <c:pt idx="321">
                  <c:v>0.01</c:v>
                </c:pt>
                <c:pt idx="322">
                  <c:v>8.9999999999999993E-3</c:v>
                </c:pt>
                <c:pt idx="323">
                  <c:v>8.0000000000000002E-3</c:v>
                </c:pt>
                <c:pt idx="324">
                  <c:v>7.0000000000000001E-3</c:v>
                </c:pt>
                <c:pt idx="325">
                  <c:v>6.0000000000000001E-3</c:v>
                </c:pt>
                <c:pt idx="326">
                  <c:v>6.0000000000000001E-3</c:v>
                </c:pt>
                <c:pt idx="327">
                  <c:v>5.0000000000000001E-3</c:v>
                </c:pt>
                <c:pt idx="328">
                  <c:v>5.0000000000000001E-3</c:v>
                </c:pt>
                <c:pt idx="329">
                  <c:v>4.0000000000000001E-3</c:v>
                </c:pt>
                <c:pt idx="330">
                  <c:v>4.0000000000000001E-3</c:v>
                </c:pt>
                <c:pt idx="331">
                  <c:v>4.0000000000000001E-3</c:v>
                </c:pt>
                <c:pt idx="332">
                  <c:v>3.0000000000000001E-3</c:v>
                </c:pt>
                <c:pt idx="333">
                  <c:v>3.0000000000000001E-3</c:v>
                </c:pt>
                <c:pt idx="334">
                  <c:v>3.0000000000000001E-3</c:v>
                </c:pt>
                <c:pt idx="335">
                  <c:v>2E-3</c:v>
                </c:pt>
                <c:pt idx="336">
                  <c:v>2E-3</c:v>
                </c:pt>
                <c:pt idx="337">
                  <c:v>2E-3</c:v>
                </c:pt>
                <c:pt idx="338">
                  <c:v>2E-3</c:v>
                </c:pt>
                <c:pt idx="339">
                  <c:v>1E-3</c:v>
                </c:pt>
                <c:pt idx="340">
                  <c:v>1E-3</c:v>
                </c:pt>
                <c:pt idx="341">
                  <c:v>1E-3</c:v>
                </c:pt>
                <c:pt idx="342">
                  <c:v>1E-3</c:v>
                </c:pt>
                <c:pt idx="343">
                  <c:v>1E-3</c:v>
                </c:pt>
                <c:pt idx="344">
                  <c:v>1E-3</c:v>
                </c:pt>
                <c:pt idx="345">
                  <c:v>1E-3</c:v>
                </c:pt>
                <c:pt idx="346">
                  <c:v>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E28-411E-AF58-EA6FBC711BBE}"/>
            </c:ext>
          </c:extLst>
        </c:ser>
        <c:ser>
          <c:idx val="2"/>
          <c:order val="4"/>
          <c:tx>
            <c:strRef>
              <c:f>Foglio6!$I$1</c:f>
              <c:strCache>
                <c:ptCount val="1"/>
                <c:pt idx="0">
                  <c:v>S0,5M8</c:v>
                </c:pt>
              </c:strCache>
            </c:strRef>
          </c:tx>
          <c:spPr>
            <a:ln w="1905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I$1634:$I$203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1.4E-2</c:v>
                </c:pt>
                <c:pt idx="68">
                  <c:v>2.9000000000000001E-2</c:v>
                </c:pt>
                <c:pt idx="69">
                  <c:v>4.4999999999999998E-2</c:v>
                </c:pt>
                <c:pt idx="70">
                  <c:v>0.06</c:v>
                </c:pt>
                <c:pt idx="71">
                  <c:v>7.5999999999999998E-2</c:v>
                </c:pt>
                <c:pt idx="72">
                  <c:v>9.1999999999999998E-2</c:v>
                </c:pt>
                <c:pt idx="73">
                  <c:v>0.107</c:v>
                </c:pt>
                <c:pt idx="74">
                  <c:v>0.123</c:v>
                </c:pt>
                <c:pt idx="75">
                  <c:v>0.13900000000000001</c:v>
                </c:pt>
                <c:pt idx="76">
                  <c:v>0.154</c:v>
                </c:pt>
                <c:pt idx="77">
                  <c:v>0.17</c:v>
                </c:pt>
                <c:pt idx="78">
                  <c:v>0.185</c:v>
                </c:pt>
                <c:pt idx="79">
                  <c:v>0.20100000000000001</c:v>
                </c:pt>
                <c:pt idx="80">
                  <c:v>0.217</c:v>
                </c:pt>
                <c:pt idx="81">
                  <c:v>0.23200000000000001</c:v>
                </c:pt>
                <c:pt idx="82">
                  <c:v>0.248</c:v>
                </c:pt>
                <c:pt idx="83">
                  <c:v>0.26300000000000001</c:v>
                </c:pt>
                <c:pt idx="84">
                  <c:v>0.27900000000000003</c:v>
                </c:pt>
                <c:pt idx="85">
                  <c:v>0.29499999999999998</c:v>
                </c:pt>
                <c:pt idx="86">
                  <c:v>0.31</c:v>
                </c:pt>
                <c:pt idx="87">
                  <c:v>0.32600000000000001</c:v>
                </c:pt>
                <c:pt idx="88">
                  <c:v>0.34200000000000003</c:v>
                </c:pt>
                <c:pt idx="89">
                  <c:v>0.35699999999999998</c:v>
                </c:pt>
                <c:pt idx="90">
                  <c:v>0.373</c:v>
                </c:pt>
                <c:pt idx="91">
                  <c:v>0.38800000000000001</c:v>
                </c:pt>
                <c:pt idx="92">
                  <c:v>0.40400000000000003</c:v>
                </c:pt>
                <c:pt idx="93">
                  <c:v>0.42</c:v>
                </c:pt>
                <c:pt idx="94">
                  <c:v>0.435</c:v>
                </c:pt>
                <c:pt idx="95">
                  <c:v>0.45100000000000001</c:v>
                </c:pt>
                <c:pt idx="96">
                  <c:v>0.46700000000000003</c:v>
                </c:pt>
                <c:pt idx="97">
                  <c:v>0.48199999999999998</c:v>
                </c:pt>
                <c:pt idx="98">
                  <c:v>0.498</c:v>
                </c:pt>
                <c:pt idx="99">
                  <c:v>0.51300000000000001</c:v>
                </c:pt>
                <c:pt idx="100">
                  <c:v>0.52900000000000003</c:v>
                </c:pt>
                <c:pt idx="101">
                  <c:v>0.54500000000000004</c:v>
                </c:pt>
                <c:pt idx="102">
                  <c:v>0.56000000000000005</c:v>
                </c:pt>
                <c:pt idx="103">
                  <c:v>0.57599999999999996</c:v>
                </c:pt>
                <c:pt idx="104">
                  <c:v>0.59099999999999997</c:v>
                </c:pt>
                <c:pt idx="105">
                  <c:v>0.60699999999999998</c:v>
                </c:pt>
                <c:pt idx="106">
                  <c:v>0.623</c:v>
                </c:pt>
                <c:pt idx="107">
                  <c:v>0.63800000000000001</c:v>
                </c:pt>
                <c:pt idx="108">
                  <c:v>0.65400000000000003</c:v>
                </c:pt>
                <c:pt idx="109">
                  <c:v>0.67</c:v>
                </c:pt>
                <c:pt idx="110">
                  <c:v>0.68500000000000005</c:v>
                </c:pt>
                <c:pt idx="111">
                  <c:v>0.70099999999999996</c:v>
                </c:pt>
                <c:pt idx="112">
                  <c:v>0.71599999999999997</c:v>
                </c:pt>
                <c:pt idx="113">
                  <c:v>0.73199999999999998</c:v>
                </c:pt>
                <c:pt idx="114">
                  <c:v>0.748</c:v>
                </c:pt>
                <c:pt idx="115">
                  <c:v>0.76300000000000001</c:v>
                </c:pt>
                <c:pt idx="116">
                  <c:v>0.77900000000000003</c:v>
                </c:pt>
                <c:pt idx="117">
                  <c:v>0.79500000000000004</c:v>
                </c:pt>
                <c:pt idx="118">
                  <c:v>0.81</c:v>
                </c:pt>
                <c:pt idx="119">
                  <c:v>0.82599999999999996</c:v>
                </c:pt>
                <c:pt idx="120">
                  <c:v>0.84099999999999997</c:v>
                </c:pt>
                <c:pt idx="121">
                  <c:v>0.85699999999999998</c:v>
                </c:pt>
                <c:pt idx="122">
                  <c:v>0.873</c:v>
                </c:pt>
                <c:pt idx="123">
                  <c:v>0.88800000000000001</c:v>
                </c:pt>
                <c:pt idx="124">
                  <c:v>0.90400000000000003</c:v>
                </c:pt>
                <c:pt idx="125">
                  <c:v>0.91900000000000004</c:v>
                </c:pt>
                <c:pt idx="126">
                  <c:v>0.93500000000000005</c:v>
                </c:pt>
                <c:pt idx="127">
                  <c:v>0.95099999999999996</c:v>
                </c:pt>
                <c:pt idx="128">
                  <c:v>0.96599999999999997</c:v>
                </c:pt>
                <c:pt idx="129">
                  <c:v>0.98199999999999998</c:v>
                </c:pt>
                <c:pt idx="130">
                  <c:v>0.998</c:v>
                </c:pt>
                <c:pt idx="131">
                  <c:v>1.0129999999999999</c:v>
                </c:pt>
                <c:pt idx="132">
                  <c:v>1.0289999999999999</c:v>
                </c:pt>
                <c:pt idx="133">
                  <c:v>1.044</c:v>
                </c:pt>
                <c:pt idx="134">
                  <c:v>1.06</c:v>
                </c:pt>
                <c:pt idx="135">
                  <c:v>1.0760000000000001</c:v>
                </c:pt>
                <c:pt idx="136">
                  <c:v>1.091</c:v>
                </c:pt>
                <c:pt idx="137">
                  <c:v>1.107</c:v>
                </c:pt>
                <c:pt idx="138">
                  <c:v>1.123</c:v>
                </c:pt>
                <c:pt idx="139">
                  <c:v>1.1379999999999999</c:v>
                </c:pt>
                <c:pt idx="140">
                  <c:v>1.1539999999999999</c:v>
                </c:pt>
                <c:pt idx="141">
                  <c:v>1.169</c:v>
                </c:pt>
                <c:pt idx="142">
                  <c:v>1.1850000000000001</c:v>
                </c:pt>
                <c:pt idx="143">
                  <c:v>1.2010000000000001</c:v>
                </c:pt>
                <c:pt idx="144">
                  <c:v>1.2290000000000001</c:v>
                </c:pt>
                <c:pt idx="145">
                  <c:v>1.298</c:v>
                </c:pt>
                <c:pt idx="146">
                  <c:v>1.367</c:v>
                </c:pt>
                <c:pt idx="147">
                  <c:v>1.4359999999999999</c:v>
                </c:pt>
                <c:pt idx="148">
                  <c:v>1.504</c:v>
                </c:pt>
                <c:pt idx="149">
                  <c:v>1.573</c:v>
                </c:pt>
                <c:pt idx="150">
                  <c:v>1.6419999999999999</c:v>
                </c:pt>
                <c:pt idx="151">
                  <c:v>1.71</c:v>
                </c:pt>
                <c:pt idx="152">
                  <c:v>1.7789999999999999</c:v>
                </c:pt>
                <c:pt idx="153">
                  <c:v>1.8480000000000001</c:v>
                </c:pt>
                <c:pt idx="154">
                  <c:v>1.917</c:v>
                </c:pt>
                <c:pt idx="155">
                  <c:v>1.9850000000000001</c:v>
                </c:pt>
                <c:pt idx="156">
                  <c:v>2.0539999999999998</c:v>
                </c:pt>
                <c:pt idx="157">
                  <c:v>2.1230000000000002</c:v>
                </c:pt>
                <c:pt idx="158">
                  <c:v>2.1920000000000002</c:v>
                </c:pt>
                <c:pt idx="159">
                  <c:v>2.2599999999999998</c:v>
                </c:pt>
                <c:pt idx="160">
                  <c:v>2.3290000000000002</c:v>
                </c:pt>
                <c:pt idx="161">
                  <c:v>2.3980000000000001</c:v>
                </c:pt>
                <c:pt idx="162">
                  <c:v>2.52</c:v>
                </c:pt>
                <c:pt idx="163">
                  <c:v>2.6779999999999999</c:v>
                </c:pt>
                <c:pt idx="164">
                  <c:v>2.835</c:v>
                </c:pt>
                <c:pt idx="165">
                  <c:v>2.9929999999999999</c:v>
                </c:pt>
                <c:pt idx="166">
                  <c:v>3.1509999999999998</c:v>
                </c:pt>
                <c:pt idx="167">
                  <c:v>3.3079999999999998</c:v>
                </c:pt>
                <c:pt idx="168">
                  <c:v>3.4660000000000002</c:v>
                </c:pt>
                <c:pt idx="169">
                  <c:v>3.6230000000000002</c:v>
                </c:pt>
                <c:pt idx="170">
                  <c:v>3.9169999999999998</c:v>
                </c:pt>
                <c:pt idx="171">
                  <c:v>4.2249999999999996</c:v>
                </c:pt>
                <c:pt idx="172">
                  <c:v>4.532</c:v>
                </c:pt>
                <c:pt idx="173">
                  <c:v>4.84</c:v>
                </c:pt>
                <c:pt idx="174">
                  <c:v>5.375</c:v>
                </c:pt>
                <c:pt idx="175">
                  <c:v>5.9180000000000001</c:v>
                </c:pt>
                <c:pt idx="176">
                  <c:v>6.0620000000000003</c:v>
                </c:pt>
                <c:pt idx="177">
                  <c:v>6.7030000000000003</c:v>
                </c:pt>
                <c:pt idx="178">
                  <c:v>7.71</c:v>
                </c:pt>
                <c:pt idx="179">
                  <c:v>9.1259999999999994</c:v>
                </c:pt>
                <c:pt idx="180">
                  <c:v>11.093</c:v>
                </c:pt>
                <c:pt idx="181">
                  <c:v>12.124000000000001</c:v>
                </c:pt>
                <c:pt idx="182">
                  <c:v>13.939</c:v>
                </c:pt>
                <c:pt idx="183">
                  <c:v>17.908000000000001</c:v>
                </c:pt>
                <c:pt idx="184">
                  <c:v>18.186</c:v>
                </c:pt>
                <c:pt idx="185">
                  <c:v>23.338000000000001</c:v>
                </c:pt>
                <c:pt idx="186">
                  <c:v>24.248000000000001</c:v>
                </c:pt>
                <c:pt idx="187">
                  <c:v>30.31</c:v>
                </c:pt>
                <c:pt idx="188">
                  <c:v>30.690999999999999</c:v>
                </c:pt>
                <c:pt idx="189">
                  <c:v>36.372</c:v>
                </c:pt>
                <c:pt idx="190">
                  <c:v>40.234999999999999</c:v>
                </c:pt>
                <c:pt idx="191">
                  <c:v>42.433999999999997</c:v>
                </c:pt>
                <c:pt idx="192">
                  <c:v>48.496000000000002</c:v>
                </c:pt>
                <c:pt idx="193">
                  <c:v>52.22</c:v>
                </c:pt>
                <c:pt idx="194">
                  <c:v>54.558</c:v>
                </c:pt>
                <c:pt idx="195">
                  <c:v>60.62</c:v>
                </c:pt>
                <c:pt idx="196">
                  <c:v>66.682000000000002</c:v>
                </c:pt>
                <c:pt idx="197">
                  <c:v>66.813999999999993</c:v>
                </c:pt>
                <c:pt idx="198">
                  <c:v>72.744</c:v>
                </c:pt>
                <c:pt idx="199">
                  <c:v>78.805999999999997</c:v>
                </c:pt>
                <c:pt idx="200">
                  <c:v>83.603999999999999</c:v>
                </c:pt>
                <c:pt idx="201">
                  <c:v>84.867999999999995</c:v>
                </c:pt>
                <c:pt idx="202">
                  <c:v>90.93</c:v>
                </c:pt>
                <c:pt idx="203">
                  <c:v>96.992000000000004</c:v>
                </c:pt>
                <c:pt idx="204">
                  <c:v>102.68600000000001</c:v>
                </c:pt>
                <c:pt idx="205">
                  <c:v>103.054</c:v>
                </c:pt>
                <c:pt idx="206">
                  <c:v>109.116</c:v>
                </c:pt>
                <c:pt idx="207">
                  <c:v>115.178</c:v>
                </c:pt>
                <c:pt idx="208">
                  <c:v>121.24</c:v>
                </c:pt>
                <c:pt idx="209">
                  <c:v>122.85299999999999</c:v>
                </c:pt>
                <c:pt idx="210">
                  <c:v>127.30200000000001</c:v>
                </c:pt>
                <c:pt idx="211">
                  <c:v>133.364</c:v>
                </c:pt>
                <c:pt idx="212">
                  <c:v>139.42599999999999</c:v>
                </c:pt>
                <c:pt idx="213">
                  <c:v>143.61199999999999</c:v>
                </c:pt>
                <c:pt idx="214">
                  <c:v>145.488</c:v>
                </c:pt>
                <c:pt idx="215">
                  <c:v>151.55000000000001</c:v>
                </c:pt>
                <c:pt idx="216">
                  <c:v>157.61199999999999</c:v>
                </c:pt>
                <c:pt idx="217">
                  <c:v>163.67400000000001</c:v>
                </c:pt>
                <c:pt idx="218">
                  <c:v>163.93</c:v>
                </c:pt>
                <c:pt idx="219">
                  <c:v>169.73599999999999</c:v>
                </c:pt>
                <c:pt idx="220">
                  <c:v>175.798</c:v>
                </c:pt>
                <c:pt idx="221">
                  <c:v>181.86</c:v>
                </c:pt>
                <c:pt idx="222">
                  <c:v>183.124</c:v>
                </c:pt>
                <c:pt idx="223">
                  <c:v>187.922</c:v>
                </c:pt>
                <c:pt idx="224">
                  <c:v>193.98400000000001</c:v>
                </c:pt>
                <c:pt idx="225">
                  <c:v>200.04599999999999</c:v>
                </c:pt>
                <c:pt idx="226">
                  <c:v>200.726</c:v>
                </c:pt>
                <c:pt idx="227">
                  <c:v>206.108</c:v>
                </c:pt>
                <c:pt idx="228">
                  <c:v>212.17</c:v>
                </c:pt>
                <c:pt idx="229">
                  <c:v>215.48400000000001</c:v>
                </c:pt>
                <c:pt idx="230">
                  <c:v>218.232</c:v>
                </c:pt>
                <c:pt idx="231">
                  <c:v>224.29400000000001</c:v>
                </c:pt>
                <c:pt idx="232">
                  <c:v>226.24100000000001</c:v>
                </c:pt>
                <c:pt idx="233">
                  <c:v>230.35599999999999</c:v>
                </c:pt>
                <c:pt idx="234">
                  <c:v>235.74</c:v>
                </c:pt>
                <c:pt idx="235">
                  <c:v>236.41800000000001</c:v>
                </c:pt>
                <c:pt idx="236">
                  <c:v>242.48</c:v>
                </c:pt>
                <c:pt idx="237">
                  <c:v>246.24299999999999</c:v>
                </c:pt>
                <c:pt idx="238">
                  <c:v>248.542</c:v>
                </c:pt>
                <c:pt idx="239">
                  <c:v>254.60400000000001</c:v>
                </c:pt>
                <c:pt idx="240">
                  <c:v>260.404</c:v>
                </c:pt>
                <c:pt idx="241">
                  <c:v>260.666</c:v>
                </c:pt>
                <c:pt idx="242">
                  <c:v>266.72800000000001</c:v>
                </c:pt>
                <c:pt idx="243">
                  <c:v>272.79000000000002</c:v>
                </c:pt>
                <c:pt idx="244">
                  <c:v>278.85199999999998</c:v>
                </c:pt>
                <c:pt idx="245">
                  <c:v>284.2</c:v>
                </c:pt>
                <c:pt idx="246">
                  <c:v>284.91399999999999</c:v>
                </c:pt>
                <c:pt idx="247">
                  <c:v>290.976</c:v>
                </c:pt>
                <c:pt idx="248">
                  <c:v>297.03800000000001</c:v>
                </c:pt>
                <c:pt idx="249">
                  <c:v>303.10000000000002</c:v>
                </c:pt>
                <c:pt idx="250">
                  <c:v>309.16199999999998</c:v>
                </c:pt>
                <c:pt idx="251">
                  <c:v>315.22399999999999</c:v>
                </c:pt>
                <c:pt idx="252">
                  <c:v>321.286</c:v>
                </c:pt>
                <c:pt idx="253">
                  <c:v>327.34800000000001</c:v>
                </c:pt>
                <c:pt idx="254">
                  <c:v>333.41</c:v>
                </c:pt>
                <c:pt idx="255">
                  <c:v>339.47199999999998</c:v>
                </c:pt>
                <c:pt idx="256">
                  <c:v>345.53399999999999</c:v>
                </c:pt>
                <c:pt idx="257">
                  <c:v>351.596</c:v>
                </c:pt>
                <c:pt idx="258">
                  <c:v>357.65800000000002</c:v>
                </c:pt>
                <c:pt idx="259">
                  <c:v>362.81400000000002</c:v>
                </c:pt>
                <c:pt idx="260">
                  <c:v>363.72</c:v>
                </c:pt>
                <c:pt idx="261">
                  <c:v>369.78199999999998</c:v>
                </c:pt>
                <c:pt idx="262">
                  <c:v>375.84399999999999</c:v>
                </c:pt>
                <c:pt idx="263">
                  <c:v>381.90600000000001</c:v>
                </c:pt>
                <c:pt idx="264">
                  <c:v>387.96800000000002</c:v>
                </c:pt>
                <c:pt idx="265">
                  <c:v>394.03</c:v>
                </c:pt>
                <c:pt idx="266">
                  <c:v>400.09199999999998</c:v>
                </c:pt>
                <c:pt idx="267">
                  <c:v>406.154</c:v>
                </c:pt>
                <c:pt idx="268">
                  <c:v>412.21600000000001</c:v>
                </c:pt>
                <c:pt idx="269">
                  <c:v>418.27800000000002</c:v>
                </c:pt>
                <c:pt idx="270">
                  <c:v>424.34</c:v>
                </c:pt>
                <c:pt idx="271">
                  <c:v>430.40199999999999</c:v>
                </c:pt>
                <c:pt idx="272">
                  <c:v>436.464</c:v>
                </c:pt>
                <c:pt idx="273">
                  <c:v>442.52600000000001</c:v>
                </c:pt>
                <c:pt idx="274">
                  <c:v>448.58800000000002</c:v>
                </c:pt>
                <c:pt idx="275">
                  <c:v>454.65</c:v>
                </c:pt>
                <c:pt idx="276">
                  <c:v>460.71199999999999</c:v>
                </c:pt>
                <c:pt idx="277">
                  <c:v>466.774</c:v>
                </c:pt>
                <c:pt idx="278">
                  <c:v>472.83600000000001</c:v>
                </c:pt>
                <c:pt idx="279">
                  <c:v>478.89800000000002</c:v>
                </c:pt>
                <c:pt idx="280">
                  <c:v>484.96</c:v>
                </c:pt>
                <c:pt idx="281">
                  <c:v>491.02199999999999</c:v>
                </c:pt>
                <c:pt idx="282">
                  <c:v>497.084</c:v>
                </c:pt>
                <c:pt idx="283">
                  <c:v>503.14600000000002</c:v>
                </c:pt>
                <c:pt idx="284">
                  <c:v>509.20800000000003</c:v>
                </c:pt>
                <c:pt idx="285">
                  <c:v>515.27</c:v>
                </c:pt>
                <c:pt idx="286">
                  <c:v>521.33199999999999</c:v>
                </c:pt>
                <c:pt idx="287">
                  <c:v>527.39400000000001</c:v>
                </c:pt>
                <c:pt idx="288">
                  <c:v>533.45600000000002</c:v>
                </c:pt>
                <c:pt idx="289">
                  <c:v>539.51800000000003</c:v>
                </c:pt>
                <c:pt idx="290">
                  <c:v>545.58000000000004</c:v>
                </c:pt>
                <c:pt idx="291">
                  <c:v>551.64200000000005</c:v>
                </c:pt>
                <c:pt idx="292">
                  <c:v>557.70399999999995</c:v>
                </c:pt>
                <c:pt idx="293">
                  <c:v>563.76599999999996</c:v>
                </c:pt>
                <c:pt idx="294">
                  <c:v>569.82799999999997</c:v>
                </c:pt>
                <c:pt idx="295">
                  <c:v>575.89</c:v>
                </c:pt>
                <c:pt idx="296">
                  <c:v>581.952</c:v>
                </c:pt>
                <c:pt idx="297">
                  <c:v>588.01400000000001</c:v>
                </c:pt>
                <c:pt idx="298">
                  <c:v>594.07600000000002</c:v>
                </c:pt>
                <c:pt idx="299">
                  <c:v>600.13800000000003</c:v>
                </c:pt>
                <c:pt idx="300">
                  <c:v>606.20000000000005</c:v>
                </c:pt>
                <c:pt idx="301">
                  <c:v>612.26199999999994</c:v>
                </c:pt>
                <c:pt idx="302">
                  <c:v>618.32399999999996</c:v>
                </c:pt>
                <c:pt idx="303">
                  <c:v>624.38599999999997</c:v>
                </c:pt>
                <c:pt idx="304">
                  <c:v>630.44799999999998</c:v>
                </c:pt>
                <c:pt idx="305">
                  <c:v>636.51</c:v>
                </c:pt>
                <c:pt idx="306">
                  <c:v>642.572</c:v>
                </c:pt>
                <c:pt idx="307">
                  <c:v>648.63400000000001</c:v>
                </c:pt>
                <c:pt idx="308">
                  <c:v>654.69600000000003</c:v>
                </c:pt>
                <c:pt idx="309">
                  <c:v>660.75800000000004</c:v>
                </c:pt>
                <c:pt idx="310">
                  <c:v>666.82</c:v>
                </c:pt>
                <c:pt idx="311">
                  <c:v>672.88199999999995</c:v>
                </c:pt>
                <c:pt idx="312">
                  <c:v>678.94399999999996</c:v>
                </c:pt>
                <c:pt idx="313">
                  <c:v>685.00599999999997</c:v>
                </c:pt>
                <c:pt idx="314">
                  <c:v>691.06799999999998</c:v>
                </c:pt>
                <c:pt idx="315">
                  <c:v>697.13</c:v>
                </c:pt>
                <c:pt idx="316">
                  <c:v>703.19200000000001</c:v>
                </c:pt>
                <c:pt idx="317">
                  <c:v>709.25400000000002</c:v>
                </c:pt>
                <c:pt idx="318">
                  <c:v>715.31600000000003</c:v>
                </c:pt>
                <c:pt idx="319">
                  <c:v>721.37800000000004</c:v>
                </c:pt>
                <c:pt idx="320">
                  <c:v>727.44</c:v>
                </c:pt>
                <c:pt idx="321">
                  <c:v>733.50199999999995</c:v>
                </c:pt>
                <c:pt idx="322">
                  <c:v>739.56399999999996</c:v>
                </c:pt>
                <c:pt idx="323">
                  <c:v>745.62599999999998</c:v>
                </c:pt>
                <c:pt idx="324">
                  <c:v>751.68799999999999</c:v>
                </c:pt>
                <c:pt idx="325">
                  <c:v>757.75</c:v>
                </c:pt>
                <c:pt idx="326">
                  <c:v>763.81200000000001</c:v>
                </c:pt>
                <c:pt idx="327">
                  <c:v>769.87400000000002</c:v>
                </c:pt>
                <c:pt idx="328">
                  <c:v>775.93600000000004</c:v>
                </c:pt>
                <c:pt idx="329">
                  <c:v>781.99800000000005</c:v>
                </c:pt>
                <c:pt idx="330">
                  <c:v>788.06</c:v>
                </c:pt>
                <c:pt idx="331">
                  <c:v>794.12199999999996</c:v>
                </c:pt>
                <c:pt idx="332">
                  <c:v>800.18399999999997</c:v>
                </c:pt>
                <c:pt idx="333">
                  <c:v>806.24599999999998</c:v>
                </c:pt>
                <c:pt idx="334">
                  <c:v>812.30799999999999</c:v>
                </c:pt>
                <c:pt idx="335">
                  <c:v>818.37</c:v>
                </c:pt>
                <c:pt idx="336">
                  <c:v>824.43200000000002</c:v>
                </c:pt>
                <c:pt idx="337">
                  <c:v>830.49400000000003</c:v>
                </c:pt>
                <c:pt idx="338">
                  <c:v>836.55600000000004</c:v>
                </c:pt>
                <c:pt idx="339">
                  <c:v>842.61800000000005</c:v>
                </c:pt>
                <c:pt idx="340">
                  <c:v>848.68</c:v>
                </c:pt>
                <c:pt idx="341">
                  <c:v>854.74199999999996</c:v>
                </c:pt>
                <c:pt idx="342">
                  <c:v>860.80399999999997</c:v>
                </c:pt>
                <c:pt idx="343">
                  <c:v>866.86599999999999</c:v>
                </c:pt>
                <c:pt idx="344">
                  <c:v>872.928</c:v>
                </c:pt>
                <c:pt idx="345">
                  <c:v>878.99</c:v>
                </c:pt>
                <c:pt idx="346">
                  <c:v>885.05200000000002</c:v>
                </c:pt>
                <c:pt idx="347">
                  <c:v>891.11400000000003</c:v>
                </c:pt>
                <c:pt idx="348">
                  <c:v>897.17600000000004</c:v>
                </c:pt>
                <c:pt idx="349">
                  <c:v>903.23800000000006</c:v>
                </c:pt>
                <c:pt idx="350">
                  <c:v>909.3</c:v>
                </c:pt>
                <c:pt idx="351">
                  <c:v>915.36199999999997</c:v>
                </c:pt>
                <c:pt idx="352">
                  <c:v>921.42399999999998</c:v>
                </c:pt>
                <c:pt idx="353">
                  <c:v>927.48599999999999</c:v>
                </c:pt>
                <c:pt idx="354">
                  <c:v>933.548</c:v>
                </c:pt>
                <c:pt idx="355">
                  <c:v>939.61</c:v>
                </c:pt>
                <c:pt idx="356">
                  <c:v>945.67200000000003</c:v>
                </c:pt>
                <c:pt idx="357">
                  <c:v>951.73400000000004</c:v>
                </c:pt>
                <c:pt idx="358">
                  <c:v>957.79600000000005</c:v>
                </c:pt>
                <c:pt idx="359">
                  <c:v>963.85799999999995</c:v>
                </c:pt>
                <c:pt idx="360">
                  <c:v>969.92</c:v>
                </c:pt>
                <c:pt idx="361">
                  <c:v>975.98199999999997</c:v>
                </c:pt>
                <c:pt idx="362">
                  <c:v>982.04399999999998</c:v>
                </c:pt>
                <c:pt idx="363">
                  <c:v>988.10599999999999</c:v>
                </c:pt>
                <c:pt idx="364">
                  <c:v>994.16800000000001</c:v>
                </c:pt>
                <c:pt idx="365">
                  <c:v>1000.23</c:v>
                </c:pt>
                <c:pt idx="366">
                  <c:v>1006.292</c:v>
                </c:pt>
                <c:pt idx="367">
                  <c:v>1012.354</c:v>
                </c:pt>
                <c:pt idx="368">
                  <c:v>1018.4160000000001</c:v>
                </c:pt>
                <c:pt idx="369">
                  <c:v>1024.4780000000001</c:v>
                </c:pt>
                <c:pt idx="370">
                  <c:v>1030.54</c:v>
                </c:pt>
                <c:pt idx="371">
                  <c:v>1036.6020000000001</c:v>
                </c:pt>
                <c:pt idx="372">
                  <c:v>1042.664</c:v>
                </c:pt>
                <c:pt idx="373">
                  <c:v>1048.7260000000001</c:v>
                </c:pt>
                <c:pt idx="374">
                  <c:v>1054.788</c:v>
                </c:pt>
                <c:pt idx="375">
                  <c:v>1060.8499999999999</c:v>
                </c:pt>
                <c:pt idx="376">
                  <c:v>1066.912</c:v>
                </c:pt>
                <c:pt idx="377">
                  <c:v>1072.9739999999999</c:v>
                </c:pt>
                <c:pt idx="378">
                  <c:v>1079.0360000000001</c:v>
                </c:pt>
                <c:pt idx="379">
                  <c:v>1085.098</c:v>
                </c:pt>
                <c:pt idx="380">
                  <c:v>1091.1600000000001</c:v>
                </c:pt>
                <c:pt idx="381">
                  <c:v>1097.222</c:v>
                </c:pt>
                <c:pt idx="382">
                  <c:v>1103.2840000000001</c:v>
                </c:pt>
                <c:pt idx="383">
                  <c:v>1109.346</c:v>
                </c:pt>
                <c:pt idx="384">
                  <c:v>1115.4079999999999</c:v>
                </c:pt>
                <c:pt idx="385">
                  <c:v>1121.47</c:v>
                </c:pt>
                <c:pt idx="386">
                  <c:v>1127.5319999999999</c:v>
                </c:pt>
                <c:pt idx="387">
                  <c:v>1133.5940000000001</c:v>
                </c:pt>
                <c:pt idx="388">
                  <c:v>1139.6559999999999</c:v>
                </c:pt>
                <c:pt idx="389">
                  <c:v>1145.7180000000001</c:v>
                </c:pt>
                <c:pt idx="390">
                  <c:v>1151.78</c:v>
                </c:pt>
                <c:pt idx="391">
                  <c:v>1157.8420000000001</c:v>
                </c:pt>
                <c:pt idx="392">
                  <c:v>1163.904</c:v>
                </c:pt>
                <c:pt idx="393">
                  <c:v>1169.9659999999999</c:v>
                </c:pt>
                <c:pt idx="394">
                  <c:v>1176.028</c:v>
                </c:pt>
                <c:pt idx="395">
                  <c:v>1182.0899999999999</c:v>
                </c:pt>
                <c:pt idx="396">
                  <c:v>1188.152</c:v>
                </c:pt>
                <c:pt idx="397">
                  <c:v>1194.2139999999999</c:v>
                </c:pt>
                <c:pt idx="398">
                  <c:v>1200.2760000000001</c:v>
                </c:pt>
                <c:pt idx="399">
                  <c:v>1206.338</c:v>
                </c:pt>
                <c:pt idx="400">
                  <c:v>1212.4000000000001</c:v>
                </c:pt>
                <c:pt idx="401">
                  <c:v>1212.4000000000001</c:v>
                </c:pt>
              </c:numCache>
            </c:numRef>
          </c:xVal>
          <c:yVal>
            <c:numRef>
              <c:f>Foglio6!$J$1634:$J$203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</c:v>
                </c:pt>
                <c:pt idx="170">
                  <c:v>15.5</c:v>
                </c:pt>
                <c:pt idx="171">
                  <c:v>15</c:v>
                </c:pt>
                <c:pt idx="172">
                  <c:v>14.5</c:v>
                </c:pt>
                <c:pt idx="173">
                  <c:v>14</c:v>
                </c:pt>
                <c:pt idx="174">
                  <c:v>13.5</c:v>
                </c:pt>
                <c:pt idx="175">
                  <c:v>13</c:v>
                </c:pt>
                <c:pt idx="176">
                  <c:v>12.867000000000001</c:v>
                </c:pt>
                <c:pt idx="177">
                  <c:v>12.5</c:v>
                </c:pt>
                <c:pt idx="178">
                  <c:v>12</c:v>
                </c:pt>
                <c:pt idx="179">
                  <c:v>11.5</c:v>
                </c:pt>
                <c:pt idx="180">
                  <c:v>11</c:v>
                </c:pt>
                <c:pt idx="181">
                  <c:v>10.795</c:v>
                </c:pt>
                <c:pt idx="182">
                  <c:v>10.5</c:v>
                </c:pt>
                <c:pt idx="183">
                  <c:v>10</c:v>
                </c:pt>
                <c:pt idx="184">
                  <c:v>9.9700000000000006</c:v>
                </c:pt>
                <c:pt idx="185">
                  <c:v>9.5</c:v>
                </c:pt>
                <c:pt idx="186">
                  <c:v>9.4280000000000008</c:v>
                </c:pt>
                <c:pt idx="187">
                  <c:v>9.0229999999999997</c:v>
                </c:pt>
                <c:pt idx="188">
                  <c:v>9</c:v>
                </c:pt>
                <c:pt idx="189">
                  <c:v>8.6890000000000001</c:v>
                </c:pt>
                <c:pt idx="190">
                  <c:v>8.5</c:v>
                </c:pt>
                <c:pt idx="191">
                  <c:v>8.4</c:v>
                </c:pt>
                <c:pt idx="192">
                  <c:v>8.1430000000000007</c:v>
                </c:pt>
                <c:pt idx="193">
                  <c:v>8</c:v>
                </c:pt>
                <c:pt idx="194">
                  <c:v>7.9119999999999999</c:v>
                </c:pt>
                <c:pt idx="195">
                  <c:v>7.7030000000000003</c:v>
                </c:pt>
                <c:pt idx="196">
                  <c:v>7.5039999999999996</c:v>
                </c:pt>
                <c:pt idx="197">
                  <c:v>7.5</c:v>
                </c:pt>
                <c:pt idx="198">
                  <c:v>7.3129999999999997</c:v>
                </c:pt>
                <c:pt idx="199">
                  <c:v>7.133</c:v>
                </c:pt>
                <c:pt idx="200">
                  <c:v>7</c:v>
                </c:pt>
                <c:pt idx="201">
                  <c:v>6.9660000000000002</c:v>
                </c:pt>
                <c:pt idx="202">
                  <c:v>6.8040000000000003</c:v>
                </c:pt>
                <c:pt idx="203">
                  <c:v>6.6479999999999997</c:v>
                </c:pt>
                <c:pt idx="204">
                  <c:v>6.5</c:v>
                </c:pt>
                <c:pt idx="205">
                  <c:v>6.4909999999999997</c:v>
                </c:pt>
                <c:pt idx="206">
                  <c:v>6.3360000000000003</c:v>
                </c:pt>
                <c:pt idx="207">
                  <c:v>6.1879999999999997</c:v>
                </c:pt>
                <c:pt idx="208">
                  <c:v>6.0389999999999997</c:v>
                </c:pt>
                <c:pt idx="209">
                  <c:v>6</c:v>
                </c:pt>
                <c:pt idx="210">
                  <c:v>5.8929999999999998</c:v>
                </c:pt>
                <c:pt idx="211">
                  <c:v>5.7469999999999999</c:v>
                </c:pt>
                <c:pt idx="212">
                  <c:v>5.6029999999999998</c:v>
                </c:pt>
                <c:pt idx="213">
                  <c:v>5.5</c:v>
                </c:pt>
                <c:pt idx="214">
                  <c:v>5.4539999999999997</c:v>
                </c:pt>
                <c:pt idx="215">
                  <c:v>5.3040000000000003</c:v>
                </c:pt>
                <c:pt idx="216">
                  <c:v>5.1539999999999999</c:v>
                </c:pt>
                <c:pt idx="217">
                  <c:v>5.0060000000000002</c:v>
                </c:pt>
                <c:pt idx="218">
                  <c:v>5</c:v>
                </c:pt>
                <c:pt idx="219">
                  <c:v>4.8550000000000004</c:v>
                </c:pt>
                <c:pt idx="220">
                  <c:v>4.6959999999999997</c:v>
                </c:pt>
                <c:pt idx="221">
                  <c:v>4.5339999999999998</c:v>
                </c:pt>
                <c:pt idx="222">
                  <c:v>4.5</c:v>
                </c:pt>
                <c:pt idx="223">
                  <c:v>4.37</c:v>
                </c:pt>
                <c:pt idx="224">
                  <c:v>4.1970000000000001</c:v>
                </c:pt>
                <c:pt idx="225">
                  <c:v>4.0199999999999996</c:v>
                </c:pt>
                <c:pt idx="226">
                  <c:v>4</c:v>
                </c:pt>
                <c:pt idx="227">
                  <c:v>3.8359999999999999</c:v>
                </c:pt>
                <c:pt idx="228">
                  <c:v>3.6269999999999998</c:v>
                </c:pt>
                <c:pt idx="229">
                  <c:v>3.5</c:v>
                </c:pt>
                <c:pt idx="230">
                  <c:v>3.3879999999999999</c:v>
                </c:pt>
                <c:pt idx="231">
                  <c:v>3.097</c:v>
                </c:pt>
                <c:pt idx="232">
                  <c:v>3</c:v>
                </c:pt>
                <c:pt idx="233">
                  <c:v>2.7869999999999999</c:v>
                </c:pt>
                <c:pt idx="234">
                  <c:v>2.5</c:v>
                </c:pt>
                <c:pt idx="235">
                  <c:v>2.4649999999999999</c:v>
                </c:pt>
                <c:pt idx="236">
                  <c:v>2.165</c:v>
                </c:pt>
                <c:pt idx="237">
                  <c:v>2</c:v>
                </c:pt>
                <c:pt idx="238">
                  <c:v>1.9059999999999999</c:v>
                </c:pt>
                <c:pt idx="239">
                  <c:v>1.6819999999999999</c:v>
                </c:pt>
                <c:pt idx="240">
                  <c:v>1.5</c:v>
                </c:pt>
                <c:pt idx="241">
                  <c:v>1.492</c:v>
                </c:pt>
                <c:pt idx="242">
                  <c:v>1.331</c:v>
                </c:pt>
                <c:pt idx="243">
                  <c:v>1.1930000000000001</c:v>
                </c:pt>
                <c:pt idx="244">
                  <c:v>1.0820000000000001</c:v>
                </c:pt>
                <c:pt idx="245">
                  <c:v>1</c:v>
                </c:pt>
                <c:pt idx="246">
                  <c:v>0.99</c:v>
                </c:pt>
                <c:pt idx="247">
                  <c:v>0.91200000000000003</c:v>
                </c:pt>
                <c:pt idx="248">
                  <c:v>0.84899999999999998</c:v>
                </c:pt>
                <c:pt idx="249">
                  <c:v>0.79400000000000004</c:v>
                </c:pt>
                <c:pt idx="250">
                  <c:v>0.747</c:v>
                </c:pt>
                <c:pt idx="251">
                  <c:v>0.70599999999999996</c:v>
                </c:pt>
                <c:pt idx="252">
                  <c:v>0.66800000000000004</c:v>
                </c:pt>
                <c:pt idx="253">
                  <c:v>0.63600000000000001</c:v>
                </c:pt>
                <c:pt idx="254">
                  <c:v>0.60799999999999998</c:v>
                </c:pt>
                <c:pt idx="255">
                  <c:v>0.58199999999999996</c:v>
                </c:pt>
                <c:pt idx="256">
                  <c:v>0.55900000000000005</c:v>
                </c:pt>
                <c:pt idx="257">
                  <c:v>0.53600000000000003</c:v>
                </c:pt>
                <c:pt idx="258">
                  <c:v>0.51700000000000002</c:v>
                </c:pt>
                <c:pt idx="259">
                  <c:v>0.5</c:v>
                </c:pt>
                <c:pt idx="260">
                  <c:v>0.498</c:v>
                </c:pt>
                <c:pt idx="261">
                  <c:v>0.48</c:v>
                </c:pt>
                <c:pt idx="262">
                  <c:v>0.46200000000000002</c:v>
                </c:pt>
                <c:pt idx="263">
                  <c:v>0.44500000000000001</c:v>
                </c:pt>
                <c:pt idx="264">
                  <c:v>0.42899999999999999</c:v>
                </c:pt>
                <c:pt idx="265">
                  <c:v>0.41399999999999998</c:v>
                </c:pt>
                <c:pt idx="266">
                  <c:v>0.4</c:v>
                </c:pt>
                <c:pt idx="267">
                  <c:v>0.38600000000000001</c:v>
                </c:pt>
                <c:pt idx="268">
                  <c:v>0.373</c:v>
                </c:pt>
                <c:pt idx="269">
                  <c:v>0.36</c:v>
                </c:pt>
                <c:pt idx="270">
                  <c:v>0.34699999999999998</c:v>
                </c:pt>
                <c:pt idx="271">
                  <c:v>0.33500000000000002</c:v>
                </c:pt>
                <c:pt idx="272">
                  <c:v>0.32200000000000001</c:v>
                </c:pt>
                <c:pt idx="273">
                  <c:v>0.311</c:v>
                </c:pt>
                <c:pt idx="274">
                  <c:v>0.30099999999999999</c:v>
                </c:pt>
                <c:pt idx="275">
                  <c:v>0.28799999999999998</c:v>
                </c:pt>
                <c:pt idx="276">
                  <c:v>0.27800000000000002</c:v>
                </c:pt>
                <c:pt idx="277">
                  <c:v>0.26800000000000002</c:v>
                </c:pt>
                <c:pt idx="278">
                  <c:v>0.25700000000000001</c:v>
                </c:pt>
                <c:pt idx="279">
                  <c:v>0.248</c:v>
                </c:pt>
                <c:pt idx="280">
                  <c:v>0.23799999999999999</c:v>
                </c:pt>
                <c:pt idx="281">
                  <c:v>0.22900000000000001</c:v>
                </c:pt>
                <c:pt idx="282">
                  <c:v>0.22</c:v>
                </c:pt>
                <c:pt idx="283">
                  <c:v>0.21099999999999999</c:v>
                </c:pt>
                <c:pt idx="284">
                  <c:v>0.20200000000000001</c:v>
                </c:pt>
                <c:pt idx="285">
                  <c:v>0.193</c:v>
                </c:pt>
                <c:pt idx="286">
                  <c:v>0.185</c:v>
                </c:pt>
                <c:pt idx="287">
                  <c:v>0.17599999999999999</c:v>
                </c:pt>
                <c:pt idx="288">
                  <c:v>0.16800000000000001</c:v>
                </c:pt>
                <c:pt idx="289">
                  <c:v>0.161</c:v>
                </c:pt>
                <c:pt idx="290">
                  <c:v>0.152</c:v>
                </c:pt>
                <c:pt idx="291">
                  <c:v>0.14599999999999999</c:v>
                </c:pt>
                <c:pt idx="292">
                  <c:v>0.14000000000000001</c:v>
                </c:pt>
                <c:pt idx="293">
                  <c:v>0.13200000000000001</c:v>
                </c:pt>
                <c:pt idx="294">
                  <c:v>0.125</c:v>
                </c:pt>
                <c:pt idx="295">
                  <c:v>0.11899999999999999</c:v>
                </c:pt>
                <c:pt idx="296">
                  <c:v>0.113</c:v>
                </c:pt>
                <c:pt idx="297">
                  <c:v>0.107</c:v>
                </c:pt>
                <c:pt idx="298">
                  <c:v>0.10199999999999999</c:v>
                </c:pt>
                <c:pt idx="299">
                  <c:v>9.7000000000000003E-2</c:v>
                </c:pt>
                <c:pt idx="300">
                  <c:v>9.0999999999999998E-2</c:v>
                </c:pt>
                <c:pt idx="301">
                  <c:v>8.5999999999999993E-2</c:v>
                </c:pt>
                <c:pt idx="302">
                  <c:v>8.1000000000000003E-2</c:v>
                </c:pt>
                <c:pt idx="303">
                  <c:v>7.6999999999999999E-2</c:v>
                </c:pt>
                <c:pt idx="304">
                  <c:v>7.1999999999999995E-2</c:v>
                </c:pt>
                <c:pt idx="305">
                  <c:v>6.8000000000000005E-2</c:v>
                </c:pt>
                <c:pt idx="306">
                  <c:v>6.4000000000000001E-2</c:v>
                </c:pt>
                <c:pt idx="307">
                  <c:v>6.0999999999999999E-2</c:v>
                </c:pt>
                <c:pt idx="308">
                  <c:v>5.8000000000000003E-2</c:v>
                </c:pt>
                <c:pt idx="309">
                  <c:v>5.5E-2</c:v>
                </c:pt>
                <c:pt idx="310">
                  <c:v>5.2999999999999999E-2</c:v>
                </c:pt>
                <c:pt idx="311">
                  <c:v>0.05</c:v>
                </c:pt>
                <c:pt idx="312">
                  <c:v>4.7E-2</c:v>
                </c:pt>
                <c:pt idx="313">
                  <c:v>4.4999999999999998E-2</c:v>
                </c:pt>
                <c:pt idx="314">
                  <c:v>4.2000000000000003E-2</c:v>
                </c:pt>
                <c:pt idx="315">
                  <c:v>0.04</c:v>
                </c:pt>
                <c:pt idx="316">
                  <c:v>3.6999999999999998E-2</c:v>
                </c:pt>
                <c:pt idx="317">
                  <c:v>3.5000000000000003E-2</c:v>
                </c:pt>
                <c:pt idx="318">
                  <c:v>3.4000000000000002E-2</c:v>
                </c:pt>
                <c:pt idx="319">
                  <c:v>3.2000000000000001E-2</c:v>
                </c:pt>
                <c:pt idx="320">
                  <c:v>0.03</c:v>
                </c:pt>
                <c:pt idx="321">
                  <c:v>2.8000000000000001E-2</c:v>
                </c:pt>
                <c:pt idx="322">
                  <c:v>2.5999999999999999E-2</c:v>
                </c:pt>
                <c:pt idx="323">
                  <c:v>2.5000000000000001E-2</c:v>
                </c:pt>
                <c:pt idx="324">
                  <c:v>2.4E-2</c:v>
                </c:pt>
                <c:pt idx="325">
                  <c:v>2.3E-2</c:v>
                </c:pt>
                <c:pt idx="326">
                  <c:v>2.1999999999999999E-2</c:v>
                </c:pt>
                <c:pt idx="327">
                  <c:v>0.02</c:v>
                </c:pt>
                <c:pt idx="328">
                  <c:v>1.9E-2</c:v>
                </c:pt>
                <c:pt idx="329">
                  <c:v>1.7999999999999999E-2</c:v>
                </c:pt>
                <c:pt idx="330">
                  <c:v>1.7000000000000001E-2</c:v>
                </c:pt>
                <c:pt idx="331">
                  <c:v>1.6E-2</c:v>
                </c:pt>
                <c:pt idx="332">
                  <c:v>1.4E-2</c:v>
                </c:pt>
                <c:pt idx="333">
                  <c:v>1.2999999999999999E-2</c:v>
                </c:pt>
                <c:pt idx="334">
                  <c:v>1.2E-2</c:v>
                </c:pt>
                <c:pt idx="335">
                  <c:v>1.0999999999999999E-2</c:v>
                </c:pt>
                <c:pt idx="336">
                  <c:v>0.01</c:v>
                </c:pt>
                <c:pt idx="337">
                  <c:v>0.01</c:v>
                </c:pt>
                <c:pt idx="338">
                  <c:v>8.9999999999999993E-3</c:v>
                </c:pt>
                <c:pt idx="339">
                  <c:v>8.0000000000000002E-3</c:v>
                </c:pt>
                <c:pt idx="340">
                  <c:v>7.0000000000000001E-3</c:v>
                </c:pt>
                <c:pt idx="341">
                  <c:v>7.0000000000000001E-3</c:v>
                </c:pt>
                <c:pt idx="342">
                  <c:v>6.0000000000000001E-3</c:v>
                </c:pt>
                <c:pt idx="343">
                  <c:v>6.0000000000000001E-3</c:v>
                </c:pt>
                <c:pt idx="344">
                  <c:v>5.0000000000000001E-3</c:v>
                </c:pt>
                <c:pt idx="345">
                  <c:v>5.0000000000000001E-3</c:v>
                </c:pt>
                <c:pt idx="346">
                  <c:v>5.0000000000000001E-3</c:v>
                </c:pt>
                <c:pt idx="347">
                  <c:v>4.0000000000000001E-3</c:v>
                </c:pt>
                <c:pt idx="348">
                  <c:v>4.0000000000000001E-3</c:v>
                </c:pt>
                <c:pt idx="349">
                  <c:v>4.0000000000000001E-3</c:v>
                </c:pt>
                <c:pt idx="350">
                  <c:v>3.0000000000000001E-3</c:v>
                </c:pt>
                <c:pt idx="351">
                  <c:v>3.0000000000000001E-3</c:v>
                </c:pt>
                <c:pt idx="352">
                  <c:v>3.0000000000000001E-3</c:v>
                </c:pt>
                <c:pt idx="353">
                  <c:v>2E-3</c:v>
                </c:pt>
                <c:pt idx="354">
                  <c:v>2E-3</c:v>
                </c:pt>
                <c:pt idx="355">
                  <c:v>1E-3</c:v>
                </c:pt>
                <c:pt idx="356">
                  <c:v>1E-3</c:v>
                </c:pt>
                <c:pt idx="357">
                  <c:v>1E-3</c:v>
                </c:pt>
                <c:pt idx="358">
                  <c:v>1E-3</c:v>
                </c:pt>
                <c:pt idx="359">
                  <c:v>1E-3</c:v>
                </c:pt>
                <c:pt idx="360">
                  <c:v>1E-3</c:v>
                </c:pt>
                <c:pt idx="361">
                  <c:v>1E-3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E28-411E-AF58-EA6FBC711BBE}"/>
            </c:ext>
          </c:extLst>
        </c:ser>
        <c:ser>
          <c:idx val="5"/>
          <c:order val="5"/>
          <c:tx>
            <c:strRef>
              <c:f>Foglio6!$K$1</c:f>
              <c:strCache>
                <c:ptCount val="1"/>
                <c:pt idx="0">
                  <c:v>S1,0M8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glio6!$K$1634:$K$2035</c:f>
              <c:numCache>
                <c:formatCode>General</c:formatCode>
                <c:ptCount val="40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.01</c:v>
                </c:pt>
                <c:pt idx="68">
                  <c:v>2.5999999999999999E-2</c:v>
                </c:pt>
                <c:pt idx="69">
                  <c:v>4.2000000000000003E-2</c:v>
                </c:pt>
                <c:pt idx="70">
                  <c:v>5.8000000000000003E-2</c:v>
                </c:pt>
                <c:pt idx="71">
                  <c:v>7.3999999999999996E-2</c:v>
                </c:pt>
                <c:pt idx="72">
                  <c:v>0.09</c:v>
                </c:pt>
                <c:pt idx="73">
                  <c:v>0.107</c:v>
                </c:pt>
                <c:pt idx="74">
                  <c:v>0.123</c:v>
                </c:pt>
                <c:pt idx="75">
                  <c:v>0.13900000000000001</c:v>
                </c:pt>
                <c:pt idx="76">
                  <c:v>0.155</c:v>
                </c:pt>
                <c:pt idx="77">
                  <c:v>0.17100000000000001</c:v>
                </c:pt>
                <c:pt idx="78">
                  <c:v>0.187</c:v>
                </c:pt>
                <c:pt idx="79">
                  <c:v>0.20300000000000001</c:v>
                </c:pt>
                <c:pt idx="80">
                  <c:v>0.219</c:v>
                </c:pt>
                <c:pt idx="81">
                  <c:v>0.23599999999999999</c:v>
                </c:pt>
                <c:pt idx="82">
                  <c:v>0.252</c:v>
                </c:pt>
                <c:pt idx="83">
                  <c:v>0.26800000000000002</c:v>
                </c:pt>
                <c:pt idx="84">
                  <c:v>0.28399999999999997</c:v>
                </c:pt>
                <c:pt idx="85">
                  <c:v>0.3</c:v>
                </c:pt>
                <c:pt idx="86">
                  <c:v>0.316</c:v>
                </c:pt>
                <c:pt idx="87">
                  <c:v>0.33200000000000002</c:v>
                </c:pt>
                <c:pt idx="88">
                  <c:v>0.34799999999999998</c:v>
                </c:pt>
                <c:pt idx="89">
                  <c:v>0.36499999999999999</c:v>
                </c:pt>
                <c:pt idx="90">
                  <c:v>0.38100000000000001</c:v>
                </c:pt>
                <c:pt idx="91">
                  <c:v>0.39700000000000002</c:v>
                </c:pt>
                <c:pt idx="92">
                  <c:v>0.41299999999999998</c:v>
                </c:pt>
                <c:pt idx="93">
                  <c:v>0.42899999999999999</c:v>
                </c:pt>
                <c:pt idx="94">
                  <c:v>0.44500000000000001</c:v>
                </c:pt>
                <c:pt idx="95">
                  <c:v>0.46100000000000002</c:v>
                </c:pt>
                <c:pt idx="96">
                  <c:v>0.47699999999999998</c:v>
                </c:pt>
                <c:pt idx="97">
                  <c:v>0.49399999999999999</c:v>
                </c:pt>
                <c:pt idx="98">
                  <c:v>0.51</c:v>
                </c:pt>
                <c:pt idx="99">
                  <c:v>0.52600000000000002</c:v>
                </c:pt>
                <c:pt idx="100">
                  <c:v>0.54200000000000004</c:v>
                </c:pt>
                <c:pt idx="101">
                  <c:v>0.55800000000000005</c:v>
                </c:pt>
                <c:pt idx="102">
                  <c:v>0.57399999999999995</c:v>
                </c:pt>
                <c:pt idx="103">
                  <c:v>0.59</c:v>
                </c:pt>
                <c:pt idx="104">
                  <c:v>0.60599999999999998</c:v>
                </c:pt>
                <c:pt idx="105">
                  <c:v>0.623</c:v>
                </c:pt>
                <c:pt idx="106">
                  <c:v>0.63900000000000001</c:v>
                </c:pt>
                <c:pt idx="107">
                  <c:v>0.65500000000000003</c:v>
                </c:pt>
                <c:pt idx="108">
                  <c:v>0.67100000000000004</c:v>
                </c:pt>
                <c:pt idx="109">
                  <c:v>0.68700000000000006</c:v>
                </c:pt>
                <c:pt idx="110">
                  <c:v>0.70299999999999996</c:v>
                </c:pt>
                <c:pt idx="111">
                  <c:v>0.71899999999999997</c:v>
                </c:pt>
                <c:pt idx="112">
                  <c:v>0.73499999999999999</c:v>
                </c:pt>
                <c:pt idx="113">
                  <c:v>0.752</c:v>
                </c:pt>
                <c:pt idx="114">
                  <c:v>0.76800000000000002</c:v>
                </c:pt>
                <c:pt idx="115">
                  <c:v>0.78400000000000003</c:v>
                </c:pt>
                <c:pt idx="116">
                  <c:v>0.8</c:v>
                </c:pt>
                <c:pt idx="117">
                  <c:v>0.81599999999999995</c:v>
                </c:pt>
                <c:pt idx="118">
                  <c:v>0.83199999999999996</c:v>
                </c:pt>
                <c:pt idx="119">
                  <c:v>0.84799999999999998</c:v>
                </c:pt>
                <c:pt idx="120">
                  <c:v>0.86399999999999999</c:v>
                </c:pt>
                <c:pt idx="121">
                  <c:v>0.88100000000000001</c:v>
                </c:pt>
                <c:pt idx="122">
                  <c:v>0.89700000000000002</c:v>
                </c:pt>
                <c:pt idx="123">
                  <c:v>0.91300000000000003</c:v>
                </c:pt>
                <c:pt idx="124">
                  <c:v>0.92900000000000005</c:v>
                </c:pt>
                <c:pt idx="125">
                  <c:v>0.94499999999999995</c:v>
                </c:pt>
                <c:pt idx="126">
                  <c:v>0.96099999999999997</c:v>
                </c:pt>
                <c:pt idx="127">
                  <c:v>0.97699999999999998</c:v>
                </c:pt>
                <c:pt idx="128">
                  <c:v>0.99299999999999999</c:v>
                </c:pt>
                <c:pt idx="129">
                  <c:v>1.01</c:v>
                </c:pt>
                <c:pt idx="130">
                  <c:v>1.026</c:v>
                </c:pt>
                <c:pt idx="131">
                  <c:v>1.042</c:v>
                </c:pt>
                <c:pt idx="132">
                  <c:v>1.0580000000000001</c:v>
                </c:pt>
                <c:pt idx="133">
                  <c:v>1.0740000000000001</c:v>
                </c:pt>
                <c:pt idx="134">
                  <c:v>1.0900000000000001</c:v>
                </c:pt>
                <c:pt idx="135">
                  <c:v>1.1060000000000001</c:v>
                </c:pt>
                <c:pt idx="136">
                  <c:v>1.1220000000000001</c:v>
                </c:pt>
                <c:pt idx="137">
                  <c:v>1.139</c:v>
                </c:pt>
                <c:pt idx="138">
                  <c:v>1.155</c:v>
                </c:pt>
                <c:pt idx="139">
                  <c:v>1.171</c:v>
                </c:pt>
                <c:pt idx="140">
                  <c:v>1.1870000000000001</c:v>
                </c:pt>
                <c:pt idx="141">
                  <c:v>1.2030000000000001</c:v>
                </c:pt>
                <c:pt idx="142">
                  <c:v>1.2190000000000001</c:v>
                </c:pt>
                <c:pt idx="143">
                  <c:v>1.2350000000000001</c:v>
                </c:pt>
                <c:pt idx="144">
                  <c:v>1.2509999999999999</c:v>
                </c:pt>
                <c:pt idx="145">
                  <c:v>1.3080000000000001</c:v>
                </c:pt>
                <c:pt idx="146">
                  <c:v>1.379</c:v>
                </c:pt>
                <c:pt idx="147">
                  <c:v>1.45</c:v>
                </c:pt>
                <c:pt idx="148">
                  <c:v>1.522</c:v>
                </c:pt>
                <c:pt idx="149">
                  <c:v>1.593</c:v>
                </c:pt>
                <c:pt idx="150">
                  <c:v>1.665</c:v>
                </c:pt>
                <c:pt idx="151">
                  <c:v>1.736</c:v>
                </c:pt>
                <c:pt idx="152">
                  <c:v>1.8080000000000001</c:v>
                </c:pt>
                <c:pt idx="153">
                  <c:v>1.879</c:v>
                </c:pt>
                <c:pt idx="154">
                  <c:v>1.95</c:v>
                </c:pt>
                <c:pt idx="155">
                  <c:v>2.0219999999999998</c:v>
                </c:pt>
                <c:pt idx="156">
                  <c:v>2.093</c:v>
                </c:pt>
                <c:pt idx="157">
                  <c:v>2.165</c:v>
                </c:pt>
                <c:pt idx="158">
                  <c:v>2.2360000000000002</c:v>
                </c:pt>
                <c:pt idx="159">
                  <c:v>2.3069999999999999</c:v>
                </c:pt>
                <c:pt idx="160">
                  <c:v>2.379</c:v>
                </c:pt>
                <c:pt idx="161">
                  <c:v>2.4500000000000002</c:v>
                </c:pt>
                <c:pt idx="162">
                  <c:v>2.5350000000000001</c:v>
                </c:pt>
                <c:pt idx="163">
                  <c:v>2.7010000000000001</c:v>
                </c:pt>
                <c:pt idx="164">
                  <c:v>2.867</c:v>
                </c:pt>
                <c:pt idx="165">
                  <c:v>3.0329999999999999</c:v>
                </c:pt>
                <c:pt idx="166">
                  <c:v>3.1989999999999998</c:v>
                </c:pt>
                <c:pt idx="167">
                  <c:v>3.3660000000000001</c:v>
                </c:pt>
                <c:pt idx="168">
                  <c:v>3.532</c:v>
                </c:pt>
                <c:pt idx="169">
                  <c:v>3.698</c:v>
                </c:pt>
                <c:pt idx="170">
                  <c:v>3.9580000000000002</c:v>
                </c:pt>
                <c:pt idx="171">
                  <c:v>4.2869999999999999</c:v>
                </c:pt>
                <c:pt idx="172">
                  <c:v>4.6159999999999997</c:v>
                </c:pt>
                <c:pt idx="173">
                  <c:v>4.9450000000000003</c:v>
                </c:pt>
                <c:pt idx="174">
                  <c:v>5.468</c:v>
                </c:pt>
                <c:pt idx="175">
                  <c:v>6.0510000000000002</c:v>
                </c:pt>
                <c:pt idx="176">
                  <c:v>6.2789999999999999</c:v>
                </c:pt>
                <c:pt idx="177">
                  <c:v>6.8479999999999999</c:v>
                </c:pt>
                <c:pt idx="178">
                  <c:v>7.89</c:v>
                </c:pt>
                <c:pt idx="179">
                  <c:v>9.3699999999999992</c:v>
                </c:pt>
                <c:pt idx="180">
                  <c:v>11.41</c:v>
                </c:pt>
                <c:pt idx="181">
                  <c:v>12.558</c:v>
                </c:pt>
                <c:pt idx="182">
                  <c:v>14.324999999999999</c:v>
                </c:pt>
                <c:pt idx="183">
                  <c:v>18.399999999999999</c:v>
                </c:pt>
                <c:pt idx="184">
                  <c:v>18.837</c:v>
                </c:pt>
                <c:pt idx="185">
                  <c:v>24.026</c:v>
                </c:pt>
                <c:pt idx="186">
                  <c:v>25.116</c:v>
                </c:pt>
                <c:pt idx="187">
                  <c:v>31.396000000000001</c:v>
                </c:pt>
                <c:pt idx="188">
                  <c:v>31.562999999999999</c:v>
                </c:pt>
                <c:pt idx="189">
                  <c:v>37.674999999999997</c:v>
                </c:pt>
                <c:pt idx="190">
                  <c:v>41.170999999999999</c:v>
                </c:pt>
                <c:pt idx="191">
                  <c:v>43.954000000000001</c:v>
                </c:pt>
                <c:pt idx="192">
                  <c:v>50.232999999999997</c:v>
                </c:pt>
                <c:pt idx="193">
                  <c:v>53.42</c:v>
                </c:pt>
                <c:pt idx="194">
                  <c:v>56.512</c:v>
                </c:pt>
                <c:pt idx="195">
                  <c:v>62.790999999999997</c:v>
                </c:pt>
                <c:pt idx="196">
                  <c:v>68.244</c:v>
                </c:pt>
                <c:pt idx="197">
                  <c:v>69.069999999999993</c:v>
                </c:pt>
                <c:pt idx="198">
                  <c:v>75.349000000000004</c:v>
                </c:pt>
                <c:pt idx="199">
                  <c:v>81.628</c:v>
                </c:pt>
                <c:pt idx="200">
                  <c:v>84.923000000000002</c:v>
                </c:pt>
                <c:pt idx="201">
                  <c:v>87.906999999999996</c:v>
                </c:pt>
                <c:pt idx="202">
                  <c:v>94.186999999999998</c:v>
                </c:pt>
                <c:pt idx="203">
                  <c:v>100.46599999999999</c:v>
                </c:pt>
                <c:pt idx="204">
                  <c:v>104.05500000000001</c:v>
                </c:pt>
                <c:pt idx="205">
                  <c:v>106.745</c:v>
                </c:pt>
                <c:pt idx="206">
                  <c:v>113.024</c:v>
                </c:pt>
                <c:pt idx="207">
                  <c:v>119.303</c:v>
                </c:pt>
                <c:pt idx="208">
                  <c:v>124.087</c:v>
                </c:pt>
                <c:pt idx="209">
                  <c:v>125.58199999999999</c:v>
                </c:pt>
                <c:pt idx="210">
                  <c:v>131.86099999999999</c:v>
                </c:pt>
                <c:pt idx="211">
                  <c:v>138.13999999999999</c:v>
                </c:pt>
                <c:pt idx="212">
                  <c:v>144.41900000000001</c:v>
                </c:pt>
                <c:pt idx="213">
                  <c:v>144.71299999999999</c:v>
                </c:pt>
                <c:pt idx="214">
                  <c:v>150.69900000000001</c:v>
                </c:pt>
                <c:pt idx="215">
                  <c:v>156.97800000000001</c:v>
                </c:pt>
                <c:pt idx="216">
                  <c:v>163.25700000000001</c:v>
                </c:pt>
                <c:pt idx="217">
                  <c:v>165.01</c:v>
                </c:pt>
                <c:pt idx="218">
                  <c:v>169.536</c:v>
                </c:pt>
                <c:pt idx="219">
                  <c:v>175.815</c:v>
                </c:pt>
                <c:pt idx="220">
                  <c:v>182.09399999999999</c:v>
                </c:pt>
                <c:pt idx="221">
                  <c:v>184.41300000000001</c:v>
                </c:pt>
                <c:pt idx="222">
                  <c:v>188.37299999999999</c:v>
                </c:pt>
                <c:pt idx="223">
                  <c:v>194.65199999999999</c:v>
                </c:pt>
                <c:pt idx="224">
                  <c:v>200.93100000000001</c:v>
                </c:pt>
                <c:pt idx="225">
                  <c:v>202.21299999999999</c:v>
                </c:pt>
                <c:pt idx="226">
                  <c:v>207.21</c:v>
                </c:pt>
                <c:pt idx="227">
                  <c:v>213.49</c:v>
                </c:pt>
                <c:pt idx="228">
                  <c:v>218.655</c:v>
                </c:pt>
                <c:pt idx="229">
                  <c:v>219.76900000000001</c:v>
                </c:pt>
                <c:pt idx="230">
                  <c:v>226.048</c:v>
                </c:pt>
                <c:pt idx="231">
                  <c:v>232.327</c:v>
                </c:pt>
                <c:pt idx="232">
                  <c:v>233.00399999999999</c:v>
                </c:pt>
                <c:pt idx="233">
                  <c:v>238.60599999999999</c:v>
                </c:pt>
                <c:pt idx="234">
                  <c:v>244.88499999999999</c:v>
                </c:pt>
                <c:pt idx="235">
                  <c:v>245.5</c:v>
                </c:pt>
                <c:pt idx="236">
                  <c:v>251.16399999999999</c:v>
                </c:pt>
                <c:pt idx="237">
                  <c:v>256.99599999999998</c:v>
                </c:pt>
                <c:pt idx="238">
                  <c:v>257.44299999999998</c:v>
                </c:pt>
                <c:pt idx="239">
                  <c:v>263.72199999999998</c:v>
                </c:pt>
                <c:pt idx="240">
                  <c:v>270.00200000000001</c:v>
                </c:pt>
                <c:pt idx="241">
                  <c:v>271.923</c:v>
                </c:pt>
                <c:pt idx="242">
                  <c:v>276.28100000000001</c:v>
                </c:pt>
                <c:pt idx="243">
                  <c:v>282.56</c:v>
                </c:pt>
                <c:pt idx="244">
                  <c:v>288.839</c:v>
                </c:pt>
                <c:pt idx="245">
                  <c:v>295.11799999999999</c:v>
                </c:pt>
                <c:pt idx="246">
                  <c:v>296.96300000000002</c:v>
                </c:pt>
                <c:pt idx="247">
                  <c:v>301.39699999999999</c:v>
                </c:pt>
                <c:pt idx="248">
                  <c:v>307.67599999999999</c:v>
                </c:pt>
                <c:pt idx="249">
                  <c:v>313.95499999999998</c:v>
                </c:pt>
                <c:pt idx="250">
                  <c:v>320.23399999999998</c:v>
                </c:pt>
                <c:pt idx="251">
                  <c:v>326.51299999999998</c:v>
                </c:pt>
                <c:pt idx="252">
                  <c:v>332.79300000000001</c:v>
                </c:pt>
                <c:pt idx="253">
                  <c:v>339.072</c:v>
                </c:pt>
                <c:pt idx="254">
                  <c:v>345.351</c:v>
                </c:pt>
                <c:pt idx="255">
                  <c:v>351.63</c:v>
                </c:pt>
                <c:pt idx="256">
                  <c:v>357.90899999999999</c:v>
                </c:pt>
                <c:pt idx="257">
                  <c:v>364.18799999999999</c:v>
                </c:pt>
                <c:pt idx="258">
                  <c:v>370.46699999999998</c:v>
                </c:pt>
                <c:pt idx="259">
                  <c:v>373.27699999999999</c:v>
                </c:pt>
                <c:pt idx="260">
                  <c:v>376.74599999999998</c:v>
                </c:pt>
                <c:pt idx="261">
                  <c:v>383.02499999999998</c:v>
                </c:pt>
                <c:pt idx="262">
                  <c:v>389.30500000000001</c:v>
                </c:pt>
                <c:pt idx="263">
                  <c:v>395.584</c:v>
                </c:pt>
                <c:pt idx="264">
                  <c:v>401.863</c:v>
                </c:pt>
                <c:pt idx="265">
                  <c:v>408.142</c:v>
                </c:pt>
                <c:pt idx="266">
                  <c:v>414.42099999999999</c:v>
                </c:pt>
                <c:pt idx="267">
                  <c:v>420.7</c:v>
                </c:pt>
                <c:pt idx="268">
                  <c:v>426.97899999999998</c:v>
                </c:pt>
                <c:pt idx="269">
                  <c:v>433.25799999999998</c:v>
                </c:pt>
                <c:pt idx="270">
                  <c:v>439.53699999999998</c:v>
                </c:pt>
                <c:pt idx="271">
                  <c:v>445.81599999999997</c:v>
                </c:pt>
                <c:pt idx="272">
                  <c:v>452.096</c:v>
                </c:pt>
                <c:pt idx="273">
                  <c:v>458.375</c:v>
                </c:pt>
                <c:pt idx="274">
                  <c:v>464.654</c:v>
                </c:pt>
                <c:pt idx="275">
                  <c:v>470.93299999999999</c:v>
                </c:pt>
                <c:pt idx="276">
                  <c:v>477.21199999999999</c:v>
                </c:pt>
                <c:pt idx="277">
                  <c:v>483.49099999999999</c:v>
                </c:pt>
                <c:pt idx="278">
                  <c:v>489.77</c:v>
                </c:pt>
                <c:pt idx="279">
                  <c:v>496.04899999999998</c:v>
                </c:pt>
                <c:pt idx="280">
                  <c:v>502.32799999999997</c:v>
                </c:pt>
                <c:pt idx="281">
                  <c:v>508.608</c:v>
                </c:pt>
                <c:pt idx="282">
                  <c:v>514.88699999999994</c:v>
                </c:pt>
                <c:pt idx="283">
                  <c:v>521.16600000000005</c:v>
                </c:pt>
                <c:pt idx="284">
                  <c:v>527.44500000000005</c:v>
                </c:pt>
                <c:pt idx="285">
                  <c:v>533.72400000000005</c:v>
                </c:pt>
                <c:pt idx="286">
                  <c:v>540.00300000000004</c:v>
                </c:pt>
                <c:pt idx="287">
                  <c:v>546.28200000000004</c:v>
                </c:pt>
                <c:pt idx="288">
                  <c:v>552.56100000000004</c:v>
                </c:pt>
                <c:pt idx="289">
                  <c:v>558.84</c:v>
                </c:pt>
                <c:pt idx="290">
                  <c:v>565.11900000000003</c:v>
                </c:pt>
                <c:pt idx="291">
                  <c:v>571.399</c:v>
                </c:pt>
                <c:pt idx="292">
                  <c:v>577.678</c:v>
                </c:pt>
                <c:pt idx="293">
                  <c:v>583.95699999999999</c:v>
                </c:pt>
                <c:pt idx="294">
                  <c:v>590.23599999999999</c:v>
                </c:pt>
                <c:pt idx="295">
                  <c:v>596.51499999999999</c:v>
                </c:pt>
                <c:pt idx="296">
                  <c:v>602.79399999999998</c:v>
                </c:pt>
                <c:pt idx="297">
                  <c:v>609.07299999999998</c:v>
                </c:pt>
                <c:pt idx="298">
                  <c:v>615.35199999999998</c:v>
                </c:pt>
                <c:pt idx="299">
                  <c:v>621.63099999999997</c:v>
                </c:pt>
                <c:pt idx="300">
                  <c:v>627.91099999999994</c:v>
                </c:pt>
                <c:pt idx="301">
                  <c:v>634.19000000000005</c:v>
                </c:pt>
                <c:pt idx="302">
                  <c:v>640.46900000000005</c:v>
                </c:pt>
                <c:pt idx="303">
                  <c:v>646.74800000000005</c:v>
                </c:pt>
                <c:pt idx="304">
                  <c:v>653.02700000000004</c:v>
                </c:pt>
                <c:pt idx="305">
                  <c:v>659.30600000000004</c:v>
                </c:pt>
                <c:pt idx="306">
                  <c:v>665.58500000000004</c:v>
                </c:pt>
                <c:pt idx="307">
                  <c:v>671.86400000000003</c:v>
                </c:pt>
                <c:pt idx="308">
                  <c:v>678.14300000000003</c:v>
                </c:pt>
                <c:pt idx="309">
                  <c:v>684.42200000000003</c:v>
                </c:pt>
                <c:pt idx="310">
                  <c:v>690.702</c:v>
                </c:pt>
                <c:pt idx="311">
                  <c:v>696.98099999999999</c:v>
                </c:pt>
                <c:pt idx="312">
                  <c:v>703.26</c:v>
                </c:pt>
                <c:pt idx="313">
                  <c:v>709.53899999999999</c:v>
                </c:pt>
                <c:pt idx="314">
                  <c:v>715.81799999999998</c:v>
                </c:pt>
                <c:pt idx="315">
                  <c:v>722.09699999999998</c:v>
                </c:pt>
                <c:pt idx="316">
                  <c:v>728.37599999999998</c:v>
                </c:pt>
                <c:pt idx="317">
                  <c:v>734.65499999999997</c:v>
                </c:pt>
                <c:pt idx="318">
                  <c:v>740.93399999999997</c:v>
                </c:pt>
                <c:pt idx="319">
                  <c:v>747.21400000000006</c:v>
                </c:pt>
                <c:pt idx="320">
                  <c:v>753.49300000000005</c:v>
                </c:pt>
                <c:pt idx="321">
                  <c:v>759.77200000000005</c:v>
                </c:pt>
                <c:pt idx="322">
                  <c:v>766.05100000000004</c:v>
                </c:pt>
                <c:pt idx="323">
                  <c:v>772.33</c:v>
                </c:pt>
                <c:pt idx="324">
                  <c:v>778.60900000000004</c:v>
                </c:pt>
                <c:pt idx="325">
                  <c:v>784.88800000000003</c:v>
                </c:pt>
                <c:pt idx="326">
                  <c:v>791.16700000000003</c:v>
                </c:pt>
                <c:pt idx="327">
                  <c:v>797.44600000000003</c:v>
                </c:pt>
                <c:pt idx="328">
                  <c:v>803.72500000000002</c:v>
                </c:pt>
                <c:pt idx="329">
                  <c:v>810.005</c:v>
                </c:pt>
                <c:pt idx="330">
                  <c:v>816.28399999999999</c:v>
                </c:pt>
                <c:pt idx="331">
                  <c:v>822.56299999999999</c:v>
                </c:pt>
                <c:pt idx="332">
                  <c:v>828.84199999999998</c:v>
                </c:pt>
                <c:pt idx="333">
                  <c:v>835.12099999999998</c:v>
                </c:pt>
                <c:pt idx="334">
                  <c:v>841.4</c:v>
                </c:pt>
                <c:pt idx="335">
                  <c:v>847.67899999999997</c:v>
                </c:pt>
                <c:pt idx="336">
                  <c:v>853.95799999999997</c:v>
                </c:pt>
                <c:pt idx="337">
                  <c:v>860.23699999999997</c:v>
                </c:pt>
                <c:pt idx="338">
                  <c:v>866.51700000000005</c:v>
                </c:pt>
                <c:pt idx="339">
                  <c:v>872.79600000000005</c:v>
                </c:pt>
                <c:pt idx="340">
                  <c:v>879.07500000000005</c:v>
                </c:pt>
                <c:pt idx="341">
                  <c:v>885.35400000000004</c:v>
                </c:pt>
                <c:pt idx="342">
                  <c:v>891.63300000000004</c:v>
                </c:pt>
                <c:pt idx="343">
                  <c:v>897.91200000000003</c:v>
                </c:pt>
                <c:pt idx="344">
                  <c:v>904.19100000000003</c:v>
                </c:pt>
                <c:pt idx="345">
                  <c:v>910.47</c:v>
                </c:pt>
                <c:pt idx="346">
                  <c:v>916.74900000000002</c:v>
                </c:pt>
                <c:pt idx="347">
                  <c:v>923.02800000000002</c:v>
                </c:pt>
                <c:pt idx="348">
                  <c:v>929.30799999999999</c:v>
                </c:pt>
                <c:pt idx="349">
                  <c:v>935.58699999999999</c:v>
                </c:pt>
                <c:pt idx="350">
                  <c:v>941.86599999999999</c:v>
                </c:pt>
                <c:pt idx="351">
                  <c:v>948.14499999999998</c:v>
                </c:pt>
                <c:pt idx="352">
                  <c:v>954.42399999999998</c:v>
                </c:pt>
                <c:pt idx="353">
                  <c:v>960.70299999999997</c:v>
                </c:pt>
                <c:pt idx="354">
                  <c:v>966.98199999999997</c:v>
                </c:pt>
                <c:pt idx="355">
                  <c:v>973.26099999999997</c:v>
                </c:pt>
                <c:pt idx="356">
                  <c:v>979.54</c:v>
                </c:pt>
                <c:pt idx="357">
                  <c:v>985.82</c:v>
                </c:pt>
                <c:pt idx="358">
                  <c:v>992.09900000000005</c:v>
                </c:pt>
                <c:pt idx="359">
                  <c:v>998.37800000000004</c:v>
                </c:pt>
                <c:pt idx="360">
                  <c:v>1004.657</c:v>
                </c:pt>
                <c:pt idx="361">
                  <c:v>1010.936</c:v>
                </c:pt>
                <c:pt idx="362">
                  <c:v>1017.215</c:v>
                </c:pt>
                <c:pt idx="363">
                  <c:v>1023.494</c:v>
                </c:pt>
                <c:pt idx="364">
                  <c:v>1029.7729999999999</c:v>
                </c:pt>
                <c:pt idx="365">
                  <c:v>1036.0519999999999</c:v>
                </c:pt>
                <c:pt idx="366">
                  <c:v>1042.3309999999999</c:v>
                </c:pt>
                <c:pt idx="367">
                  <c:v>1048.6110000000001</c:v>
                </c:pt>
                <c:pt idx="368">
                  <c:v>1054.8900000000001</c:v>
                </c:pt>
                <c:pt idx="369">
                  <c:v>1061.1690000000001</c:v>
                </c:pt>
                <c:pt idx="370">
                  <c:v>1067.4480000000001</c:v>
                </c:pt>
                <c:pt idx="371">
                  <c:v>1073.7270000000001</c:v>
                </c:pt>
                <c:pt idx="372">
                  <c:v>1080.0060000000001</c:v>
                </c:pt>
                <c:pt idx="373">
                  <c:v>1086.2850000000001</c:v>
                </c:pt>
                <c:pt idx="374">
                  <c:v>1092.5640000000001</c:v>
                </c:pt>
                <c:pt idx="375">
                  <c:v>1098.8430000000001</c:v>
                </c:pt>
                <c:pt idx="376">
                  <c:v>1105.123</c:v>
                </c:pt>
                <c:pt idx="377">
                  <c:v>1111.402</c:v>
                </c:pt>
                <c:pt idx="378">
                  <c:v>1117.681</c:v>
                </c:pt>
                <c:pt idx="379">
                  <c:v>1123.96</c:v>
                </c:pt>
                <c:pt idx="380">
                  <c:v>1130.239</c:v>
                </c:pt>
                <c:pt idx="381">
                  <c:v>1136.518</c:v>
                </c:pt>
                <c:pt idx="382">
                  <c:v>1142.797</c:v>
                </c:pt>
                <c:pt idx="383">
                  <c:v>1149.076</c:v>
                </c:pt>
                <c:pt idx="384">
                  <c:v>1155.355</c:v>
                </c:pt>
                <c:pt idx="385">
                  <c:v>1161.634</c:v>
                </c:pt>
                <c:pt idx="386">
                  <c:v>1167.914</c:v>
                </c:pt>
                <c:pt idx="387">
                  <c:v>1174.193</c:v>
                </c:pt>
                <c:pt idx="388">
                  <c:v>1180.472</c:v>
                </c:pt>
                <c:pt idx="389">
                  <c:v>1186.751</c:v>
                </c:pt>
                <c:pt idx="390">
                  <c:v>1193.03</c:v>
                </c:pt>
                <c:pt idx="391">
                  <c:v>1199.309</c:v>
                </c:pt>
                <c:pt idx="392">
                  <c:v>1205.588</c:v>
                </c:pt>
                <c:pt idx="393">
                  <c:v>1211.867</c:v>
                </c:pt>
                <c:pt idx="394">
                  <c:v>1218.146</c:v>
                </c:pt>
                <c:pt idx="395">
                  <c:v>1224.4259999999999</c:v>
                </c:pt>
                <c:pt idx="396">
                  <c:v>1230.7049999999999</c:v>
                </c:pt>
                <c:pt idx="397">
                  <c:v>1236.9839999999999</c:v>
                </c:pt>
                <c:pt idx="398">
                  <c:v>1243.2629999999999</c:v>
                </c:pt>
                <c:pt idx="399">
                  <c:v>1249.5419999999999</c:v>
                </c:pt>
                <c:pt idx="400">
                  <c:v>1255.8209999999999</c:v>
                </c:pt>
                <c:pt idx="401">
                  <c:v>1255.8209999999999</c:v>
                </c:pt>
              </c:numCache>
            </c:numRef>
          </c:xVal>
          <c:yVal>
            <c:numRef>
              <c:f>Foglio6!$L$1634:$L$2035</c:f>
              <c:numCache>
                <c:formatCode>General</c:formatCode>
                <c:ptCount val="402"/>
                <c:pt idx="0">
                  <c:v>100</c:v>
                </c:pt>
                <c:pt idx="1">
                  <c:v>100</c:v>
                </c:pt>
                <c:pt idx="2">
                  <c:v>99.5</c:v>
                </c:pt>
                <c:pt idx="3">
                  <c:v>99</c:v>
                </c:pt>
                <c:pt idx="4">
                  <c:v>98.5</c:v>
                </c:pt>
                <c:pt idx="5">
                  <c:v>98</c:v>
                </c:pt>
                <c:pt idx="6">
                  <c:v>97.5</c:v>
                </c:pt>
                <c:pt idx="7">
                  <c:v>97</c:v>
                </c:pt>
                <c:pt idx="8">
                  <c:v>96.5</c:v>
                </c:pt>
                <c:pt idx="9">
                  <c:v>96</c:v>
                </c:pt>
                <c:pt idx="10">
                  <c:v>95.5</c:v>
                </c:pt>
                <c:pt idx="11">
                  <c:v>95</c:v>
                </c:pt>
                <c:pt idx="12">
                  <c:v>94.5</c:v>
                </c:pt>
                <c:pt idx="13">
                  <c:v>94</c:v>
                </c:pt>
                <c:pt idx="14">
                  <c:v>93.5</c:v>
                </c:pt>
                <c:pt idx="15">
                  <c:v>93</c:v>
                </c:pt>
                <c:pt idx="16">
                  <c:v>92.5</c:v>
                </c:pt>
                <c:pt idx="17">
                  <c:v>92</c:v>
                </c:pt>
                <c:pt idx="18">
                  <c:v>91.5</c:v>
                </c:pt>
                <c:pt idx="19">
                  <c:v>91</c:v>
                </c:pt>
                <c:pt idx="20">
                  <c:v>90.5</c:v>
                </c:pt>
                <c:pt idx="21">
                  <c:v>90</c:v>
                </c:pt>
                <c:pt idx="22">
                  <c:v>89.5</c:v>
                </c:pt>
                <c:pt idx="23">
                  <c:v>89</c:v>
                </c:pt>
                <c:pt idx="24">
                  <c:v>88.5</c:v>
                </c:pt>
                <c:pt idx="25">
                  <c:v>88</c:v>
                </c:pt>
                <c:pt idx="26">
                  <c:v>87.5</c:v>
                </c:pt>
                <c:pt idx="27">
                  <c:v>87</c:v>
                </c:pt>
                <c:pt idx="28">
                  <c:v>86.5</c:v>
                </c:pt>
                <c:pt idx="29">
                  <c:v>86</c:v>
                </c:pt>
                <c:pt idx="30">
                  <c:v>85.5</c:v>
                </c:pt>
                <c:pt idx="31">
                  <c:v>85</c:v>
                </c:pt>
                <c:pt idx="32">
                  <c:v>84.5</c:v>
                </c:pt>
                <c:pt idx="33">
                  <c:v>84</c:v>
                </c:pt>
                <c:pt idx="34">
                  <c:v>83.5</c:v>
                </c:pt>
                <c:pt idx="35">
                  <c:v>83</c:v>
                </c:pt>
                <c:pt idx="36">
                  <c:v>82.5</c:v>
                </c:pt>
                <c:pt idx="37">
                  <c:v>82</c:v>
                </c:pt>
                <c:pt idx="38">
                  <c:v>81.5</c:v>
                </c:pt>
                <c:pt idx="39">
                  <c:v>81</c:v>
                </c:pt>
                <c:pt idx="40">
                  <c:v>80.5</c:v>
                </c:pt>
                <c:pt idx="41">
                  <c:v>80</c:v>
                </c:pt>
                <c:pt idx="42">
                  <c:v>79.5</c:v>
                </c:pt>
                <c:pt idx="43">
                  <c:v>79</c:v>
                </c:pt>
                <c:pt idx="44">
                  <c:v>78.5</c:v>
                </c:pt>
                <c:pt idx="45">
                  <c:v>78</c:v>
                </c:pt>
                <c:pt idx="46">
                  <c:v>77.5</c:v>
                </c:pt>
                <c:pt idx="47">
                  <c:v>77</c:v>
                </c:pt>
                <c:pt idx="48">
                  <c:v>76.5</c:v>
                </c:pt>
                <c:pt idx="49">
                  <c:v>76</c:v>
                </c:pt>
                <c:pt idx="50">
                  <c:v>75.5</c:v>
                </c:pt>
                <c:pt idx="51">
                  <c:v>75</c:v>
                </c:pt>
                <c:pt idx="52">
                  <c:v>74.5</c:v>
                </c:pt>
                <c:pt idx="53">
                  <c:v>74</c:v>
                </c:pt>
                <c:pt idx="54">
                  <c:v>73.5</c:v>
                </c:pt>
                <c:pt idx="55">
                  <c:v>73</c:v>
                </c:pt>
                <c:pt idx="56">
                  <c:v>72.5</c:v>
                </c:pt>
                <c:pt idx="57">
                  <c:v>72</c:v>
                </c:pt>
                <c:pt idx="58">
                  <c:v>71.5</c:v>
                </c:pt>
                <c:pt idx="59">
                  <c:v>71</c:v>
                </c:pt>
                <c:pt idx="60">
                  <c:v>70.5</c:v>
                </c:pt>
                <c:pt idx="61">
                  <c:v>70</c:v>
                </c:pt>
                <c:pt idx="62">
                  <c:v>69.5</c:v>
                </c:pt>
                <c:pt idx="63">
                  <c:v>69</c:v>
                </c:pt>
                <c:pt idx="64">
                  <c:v>68.5</c:v>
                </c:pt>
                <c:pt idx="65">
                  <c:v>68</c:v>
                </c:pt>
                <c:pt idx="66">
                  <c:v>67.5</c:v>
                </c:pt>
                <c:pt idx="67">
                  <c:v>67</c:v>
                </c:pt>
                <c:pt idx="68">
                  <c:v>66.5</c:v>
                </c:pt>
                <c:pt idx="69">
                  <c:v>66</c:v>
                </c:pt>
                <c:pt idx="70">
                  <c:v>65.5</c:v>
                </c:pt>
                <c:pt idx="71">
                  <c:v>65</c:v>
                </c:pt>
                <c:pt idx="72">
                  <c:v>64.5</c:v>
                </c:pt>
                <c:pt idx="73">
                  <c:v>64</c:v>
                </c:pt>
                <c:pt idx="74">
                  <c:v>63.5</c:v>
                </c:pt>
                <c:pt idx="75">
                  <c:v>63</c:v>
                </c:pt>
                <c:pt idx="76">
                  <c:v>62.5</c:v>
                </c:pt>
                <c:pt idx="77">
                  <c:v>62</c:v>
                </c:pt>
                <c:pt idx="78">
                  <c:v>61.5</c:v>
                </c:pt>
                <c:pt idx="79">
                  <c:v>61</c:v>
                </c:pt>
                <c:pt idx="80">
                  <c:v>60.5</c:v>
                </c:pt>
                <c:pt idx="81">
                  <c:v>60</c:v>
                </c:pt>
                <c:pt idx="82">
                  <c:v>59.5</c:v>
                </c:pt>
                <c:pt idx="83">
                  <c:v>59</c:v>
                </c:pt>
                <c:pt idx="84">
                  <c:v>58.5</c:v>
                </c:pt>
                <c:pt idx="85">
                  <c:v>58</c:v>
                </c:pt>
                <c:pt idx="86">
                  <c:v>57.5</c:v>
                </c:pt>
                <c:pt idx="87">
                  <c:v>57</c:v>
                </c:pt>
                <c:pt idx="88">
                  <c:v>56.5</c:v>
                </c:pt>
                <c:pt idx="89">
                  <c:v>56</c:v>
                </c:pt>
                <c:pt idx="90">
                  <c:v>55.5</c:v>
                </c:pt>
                <c:pt idx="91">
                  <c:v>55</c:v>
                </c:pt>
                <c:pt idx="92">
                  <c:v>54.5</c:v>
                </c:pt>
                <c:pt idx="93">
                  <c:v>54</c:v>
                </c:pt>
                <c:pt idx="94">
                  <c:v>53.5</c:v>
                </c:pt>
                <c:pt idx="95">
                  <c:v>53</c:v>
                </c:pt>
                <c:pt idx="96">
                  <c:v>52.5</c:v>
                </c:pt>
                <c:pt idx="97">
                  <c:v>52</c:v>
                </c:pt>
                <c:pt idx="98">
                  <c:v>51.5</c:v>
                </c:pt>
                <c:pt idx="99">
                  <c:v>51</c:v>
                </c:pt>
                <c:pt idx="100">
                  <c:v>50.5</c:v>
                </c:pt>
                <c:pt idx="101">
                  <c:v>50</c:v>
                </c:pt>
                <c:pt idx="102">
                  <c:v>49.5</c:v>
                </c:pt>
                <c:pt idx="103">
                  <c:v>49</c:v>
                </c:pt>
                <c:pt idx="104">
                  <c:v>48.5</c:v>
                </c:pt>
                <c:pt idx="105">
                  <c:v>48</c:v>
                </c:pt>
                <c:pt idx="106">
                  <c:v>47.5</c:v>
                </c:pt>
                <c:pt idx="107">
                  <c:v>47</c:v>
                </c:pt>
                <c:pt idx="108">
                  <c:v>46.5</c:v>
                </c:pt>
                <c:pt idx="109">
                  <c:v>46</c:v>
                </c:pt>
                <c:pt idx="110">
                  <c:v>45.5</c:v>
                </c:pt>
                <c:pt idx="111">
                  <c:v>45</c:v>
                </c:pt>
                <c:pt idx="112">
                  <c:v>44.5</c:v>
                </c:pt>
                <c:pt idx="113">
                  <c:v>44</c:v>
                </c:pt>
                <c:pt idx="114">
                  <c:v>43.5</c:v>
                </c:pt>
                <c:pt idx="115">
                  <c:v>43</c:v>
                </c:pt>
                <c:pt idx="116">
                  <c:v>42.5</c:v>
                </c:pt>
                <c:pt idx="117">
                  <c:v>42</c:v>
                </c:pt>
                <c:pt idx="118">
                  <c:v>41.5</c:v>
                </c:pt>
                <c:pt idx="119">
                  <c:v>41</c:v>
                </c:pt>
                <c:pt idx="120">
                  <c:v>40.5</c:v>
                </c:pt>
                <c:pt idx="121">
                  <c:v>40</c:v>
                </c:pt>
                <c:pt idx="122">
                  <c:v>39.5</c:v>
                </c:pt>
                <c:pt idx="123">
                  <c:v>39</c:v>
                </c:pt>
                <c:pt idx="124">
                  <c:v>38.5</c:v>
                </c:pt>
                <c:pt idx="125">
                  <c:v>38</c:v>
                </c:pt>
                <c:pt idx="126">
                  <c:v>37.5</c:v>
                </c:pt>
                <c:pt idx="127">
                  <c:v>37</c:v>
                </c:pt>
                <c:pt idx="128">
                  <c:v>36.5</c:v>
                </c:pt>
                <c:pt idx="129">
                  <c:v>36</c:v>
                </c:pt>
                <c:pt idx="130">
                  <c:v>35.5</c:v>
                </c:pt>
                <c:pt idx="131">
                  <c:v>35</c:v>
                </c:pt>
                <c:pt idx="132">
                  <c:v>34.5</c:v>
                </c:pt>
                <c:pt idx="133">
                  <c:v>34</c:v>
                </c:pt>
                <c:pt idx="134">
                  <c:v>33.5</c:v>
                </c:pt>
                <c:pt idx="135">
                  <c:v>33</c:v>
                </c:pt>
                <c:pt idx="136">
                  <c:v>32.5</c:v>
                </c:pt>
                <c:pt idx="137">
                  <c:v>32</c:v>
                </c:pt>
                <c:pt idx="138">
                  <c:v>31.5</c:v>
                </c:pt>
                <c:pt idx="139">
                  <c:v>31</c:v>
                </c:pt>
                <c:pt idx="140">
                  <c:v>30.5</c:v>
                </c:pt>
                <c:pt idx="141">
                  <c:v>30</c:v>
                </c:pt>
                <c:pt idx="142">
                  <c:v>29.5</c:v>
                </c:pt>
                <c:pt idx="143">
                  <c:v>29</c:v>
                </c:pt>
                <c:pt idx="144">
                  <c:v>28.5</c:v>
                </c:pt>
                <c:pt idx="145">
                  <c:v>28</c:v>
                </c:pt>
                <c:pt idx="146">
                  <c:v>27.5</c:v>
                </c:pt>
                <c:pt idx="147">
                  <c:v>27</c:v>
                </c:pt>
                <c:pt idx="148">
                  <c:v>26.5</c:v>
                </c:pt>
                <c:pt idx="149">
                  <c:v>26</c:v>
                </c:pt>
                <c:pt idx="150">
                  <c:v>25.5</c:v>
                </c:pt>
                <c:pt idx="151">
                  <c:v>25</c:v>
                </c:pt>
                <c:pt idx="152">
                  <c:v>24.5</c:v>
                </c:pt>
                <c:pt idx="153">
                  <c:v>24</c:v>
                </c:pt>
                <c:pt idx="154">
                  <c:v>23.5</c:v>
                </c:pt>
                <c:pt idx="155">
                  <c:v>23</c:v>
                </c:pt>
                <c:pt idx="156">
                  <c:v>22.5</c:v>
                </c:pt>
                <c:pt idx="157">
                  <c:v>22</c:v>
                </c:pt>
                <c:pt idx="158">
                  <c:v>21.5</c:v>
                </c:pt>
                <c:pt idx="159">
                  <c:v>21</c:v>
                </c:pt>
                <c:pt idx="160">
                  <c:v>20.5</c:v>
                </c:pt>
                <c:pt idx="161">
                  <c:v>20</c:v>
                </c:pt>
                <c:pt idx="162">
                  <c:v>19.5</c:v>
                </c:pt>
                <c:pt idx="163">
                  <c:v>19</c:v>
                </c:pt>
                <c:pt idx="164">
                  <c:v>18.5</c:v>
                </c:pt>
                <c:pt idx="165">
                  <c:v>18</c:v>
                </c:pt>
                <c:pt idx="166">
                  <c:v>17.5</c:v>
                </c:pt>
                <c:pt idx="167">
                  <c:v>17</c:v>
                </c:pt>
                <c:pt idx="168">
                  <c:v>16.5</c:v>
                </c:pt>
                <c:pt idx="169">
                  <c:v>16</c:v>
                </c:pt>
                <c:pt idx="170">
                  <c:v>15.5</c:v>
                </c:pt>
                <c:pt idx="171">
                  <c:v>15</c:v>
                </c:pt>
                <c:pt idx="172">
                  <c:v>14.5</c:v>
                </c:pt>
                <c:pt idx="173">
                  <c:v>14</c:v>
                </c:pt>
                <c:pt idx="174">
                  <c:v>13.5</c:v>
                </c:pt>
                <c:pt idx="175">
                  <c:v>13</c:v>
                </c:pt>
                <c:pt idx="176">
                  <c:v>12.804</c:v>
                </c:pt>
                <c:pt idx="177">
                  <c:v>12.5</c:v>
                </c:pt>
                <c:pt idx="178">
                  <c:v>12</c:v>
                </c:pt>
                <c:pt idx="179">
                  <c:v>11.5</c:v>
                </c:pt>
                <c:pt idx="180">
                  <c:v>11</c:v>
                </c:pt>
                <c:pt idx="181">
                  <c:v>10.78</c:v>
                </c:pt>
                <c:pt idx="182">
                  <c:v>10.5</c:v>
                </c:pt>
                <c:pt idx="183">
                  <c:v>10</c:v>
                </c:pt>
                <c:pt idx="184">
                  <c:v>9.9540000000000006</c:v>
                </c:pt>
                <c:pt idx="185">
                  <c:v>9.5</c:v>
                </c:pt>
                <c:pt idx="186">
                  <c:v>9.4179999999999993</c:v>
                </c:pt>
                <c:pt idx="187">
                  <c:v>9.01</c:v>
                </c:pt>
                <c:pt idx="188">
                  <c:v>9</c:v>
                </c:pt>
                <c:pt idx="189">
                  <c:v>8.6669999999999998</c:v>
                </c:pt>
                <c:pt idx="190">
                  <c:v>8.5</c:v>
                </c:pt>
                <c:pt idx="191">
                  <c:v>8.3729999999999993</c:v>
                </c:pt>
                <c:pt idx="192">
                  <c:v>8.1170000000000009</c:v>
                </c:pt>
                <c:pt idx="193">
                  <c:v>8</c:v>
                </c:pt>
                <c:pt idx="194">
                  <c:v>7.89</c:v>
                </c:pt>
                <c:pt idx="195">
                  <c:v>7.68</c:v>
                </c:pt>
                <c:pt idx="196">
                  <c:v>7.5</c:v>
                </c:pt>
                <c:pt idx="197">
                  <c:v>7.4740000000000002</c:v>
                </c:pt>
                <c:pt idx="198">
                  <c:v>7.2759999999999998</c:v>
                </c:pt>
                <c:pt idx="199">
                  <c:v>7.0919999999999996</c:v>
                </c:pt>
                <c:pt idx="200">
                  <c:v>7</c:v>
                </c:pt>
                <c:pt idx="201">
                  <c:v>6.9210000000000003</c:v>
                </c:pt>
                <c:pt idx="202">
                  <c:v>6.7560000000000002</c:v>
                </c:pt>
                <c:pt idx="203">
                  <c:v>6.5949999999999998</c:v>
                </c:pt>
                <c:pt idx="204">
                  <c:v>6.5</c:v>
                </c:pt>
                <c:pt idx="205">
                  <c:v>6.4320000000000004</c:v>
                </c:pt>
                <c:pt idx="206">
                  <c:v>6.2759999999999998</c:v>
                </c:pt>
                <c:pt idx="207">
                  <c:v>6.117</c:v>
                </c:pt>
                <c:pt idx="208">
                  <c:v>6</c:v>
                </c:pt>
                <c:pt idx="209">
                  <c:v>5.9640000000000004</c:v>
                </c:pt>
                <c:pt idx="210">
                  <c:v>5.8129999999999997</c:v>
                </c:pt>
                <c:pt idx="211">
                  <c:v>5.6580000000000004</c:v>
                </c:pt>
                <c:pt idx="212">
                  <c:v>5.5069999999999997</c:v>
                </c:pt>
                <c:pt idx="213">
                  <c:v>5.5</c:v>
                </c:pt>
                <c:pt idx="214">
                  <c:v>5.3579999999999997</c:v>
                </c:pt>
                <c:pt idx="215">
                  <c:v>5.2039999999999997</c:v>
                </c:pt>
                <c:pt idx="216">
                  <c:v>5.0449999999999999</c:v>
                </c:pt>
                <c:pt idx="217">
                  <c:v>5</c:v>
                </c:pt>
                <c:pt idx="218">
                  <c:v>4.8840000000000003</c:v>
                </c:pt>
                <c:pt idx="219">
                  <c:v>4.7229999999999999</c:v>
                </c:pt>
                <c:pt idx="220">
                  <c:v>4.5599999999999996</c:v>
                </c:pt>
                <c:pt idx="221">
                  <c:v>4.5</c:v>
                </c:pt>
                <c:pt idx="222">
                  <c:v>4.3940000000000001</c:v>
                </c:pt>
                <c:pt idx="223">
                  <c:v>4.2190000000000003</c:v>
                </c:pt>
                <c:pt idx="224">
                  <c:v>4.0369999999999999</c:v>
                </c:pt>
                <c:pt idx="225">
                  <c:v>4</c:v>
                </c:pt>
                <c:pt idx="226">
                  <c:v>3.8519999999999999</c:v>
                </c:pt>
                <c:pt idx="227">
                  <c:v>3.6629999999999998</c:v>
                </c:pt>
                <c:pt idx="228">
                  <c:v>3.5</c:v>
                </c:pt>
                <c:pt idx="229">
                  <c:v>3.4649999999999999</c:v>
                </c:pt>
                <c:pt idx="230">
                  <c:v>3.2549999999999999</c:v>
                </c:pt>
                <c:pt idx="231">
                  <c:v>3.0259999999999998</c:v>
                </c:pt>
                <c:pt idx="232">
                  <c:v>3</c:v>
                </c:pt>
                <c:pt idx="233">
                  <c:v>2.7839999999999998</c:v>
                </c:pt>
                <c:pt idx="234">
                  <c:v>2.5259999999999998</c:v>
                </c:pt>
                <c:pt idx="235">
                  <c:v>2.5</c:v>
                </c:pt>
                <c:pt idx="236">
                  <c:v>2.2490000000000001</c:v>
                </c:pt>
                <c:pt idx="237">
                  <c:v>2</c:v>
                </c:pt>
                <c:pt idx="238">
                  <c:v>1.982</c:v>
                </c:pt>
                <c:pt idx="239">
                  <c:v>1.75</c:v>
                </c:pt>
                <c:pt idx="240">
                  <c:v>1.5549999999999999</c:v>
                </c:pt>
                <c:pt idx="241">
                  <c:v>1.5</c:v>
                </c:pt>
                <c:pt idx="242">
                  <c:v>1.385</c:v>
                </c:pt>
                <c:pt idx="243">
                  <c:v>1.2450000000000001</c:v>
                </c:pt>
                <c:pt idx="244">
                  <c:v>1.1259999999999999</c:v>
                </c:pt>
                <c:pt idx="245">
                  <c:v>1.026</c:v>
                </c:pt>
                <c:pt idx="246">
                  <c:v>1</c:v>
                </c:pt>
                <c:pt idx="247">
                  <c:v>0.94299999999999995</c:v>
                </c:pt>
                <c:pt idx="248">
                  <c:v>0.87</c:v>
                </c:pt>
                <c:pt idx="249">
                  <c:v>0.81</c:v>
                </c:pt>
                <c:pt idx="250">
                  <c:v>0.75800000000000001</c:v>
                </c:pt>
                <c:pt idx="251">
                  <c:v>0.71199999999999997</c:v>
                </c:pt>
                <c:pt idx="252">
                  <c:v>0.67100000000000004</c:v>
                </c:pt>
                <c:pt idx="253">
                  <c:v>0.63600000000000001</c:v>
                </c:pt>
                <c:pt idx="254">
                  <c:v>0.60499999999999998</c:v>
                </c:pt>
                <c:pt idx="255">
                  <c:v>0.57699999999999996</c:v>
                </c:pt>
                <c:pt idx="256">
                  <c:v>0.55100000000000005</c:v>
                </c:pt>
                <c:pt idx="257">
                  <c:v>0.52900000000000003</c:v>
                </c:pt>
                <c:pt idx="258">
                  <c:v>0.50800000000000001</c:v>
                </c:pt>
                <c:pt idx="259">
                  <c:v>0.5</c:v>
                </c:pt>
                <c:pt idx="260">
                  <c:v>0.48799999999999999</c:v>
                </c:pt>
                <c:pt idx="261">
                  <c:v>0.47099999999999997</c:v>
                </c:pt>
                <c:pt idx="262">
                  <c:v>0.45300000000000001</c:v>
                </c:pt>
                <c:pt idx="263">
                  <c:v>0.436</c:v>
                </c:pt>
                <c:pt idx="264">
                  <c:v>0.42099999999999999</c:v>
                </c:pt>
                <c:pt idx="265">
                  <c:v>0.40699999999999997</c:v>
                </c:pt>
                <c:pt idx="266">
                  <c:v>0.39200000000000002</c:v>
                </c:pt>
                <c:pt idx="267">
                  <c:v>0.379</c:v>
                </c:pt>
                <c:pt idx="268">
                  <c:v>0.36399999999999999</c:v>
                </c:pt>
                <c:pt idx="269">
                  <c:v>0.35099999999999998</c:v>
                </c:pt>
                <c:pt idx="270">
                  <c:v>0.33800000000000002</c:v>
                </c:pt>
                <c:pt idx="271">
                  <c:v>0.32600000000000001</c:v>
                </c:pt>
                <c:pt idx="272">
                  <c:v>0.314</c:v>
                </c:pt>
                <c:pt idx="273">
                  <c:v>0.30399999999999999</c:v>
                </c:pt>
                <c:pt idx="274">
                  <c:v>0.29399999999999998</c:v>
                </c:pt>
                <c:pt idx="275">
                  <c:v>0.28199999999999997</c:v>
                </c:pt>
                <c:pt idx="276">
                  <c:v>0.27200000000000002</c:v>
                </c:pt>
                <c:pt idx="277">
                  <c:v>0.26200000000000001</c:v>
                </c:pt>
                <c:pt idx="278">
                  <c:v>0.252</c:v>
                </c:pt>
                <c:pt idx="279">
                  <c:v>0.24199999999999999</c:v>
                </c:pt>
                <c:pt idx="280">
                  <c:v>0.23200000000000001</c:v>
                </c:pt>
                <c:pt idx="281">
                  <c:v>0.224</c:v>
                </c:pt>
                <c:pt idx="282">
                  <c:v>0.215</c:v>
                </c:pt>
                <c:pt idx="283">
                  <c:v>0.20799999999999999</c:v>
                </c:pt>
                <c:pt idx="284">
                  <c:v>0.19900000000000001</c:v>
                </c:pt>
                <c:pt idx="285">
                  <c:v>0.191</c:v>
                </c:pt>
                <c:pt idx="286">
                  <c:v>0.183</c:v>
                </c:pt>
                <c:pt idx="287">
                  <c:v>0.17399999999999999</c:v>
                </c:pt>
                <c:pt idx="288">
                  <c:v>0.16700000000000001</c:v>
                </c:pt>
                <c:pt idx="289">
                  <c:v>0.16</c:v>
                </c:pt>
                <c:pt idx="290">
                  <c:v>0.151</c:v>
                </c:pt>
                <c:pt idx="291">
                  <c:v>0.14499999999999999</c:v>
                </c:pt>
                <c:pt idx="292">
                  <c:v>0.13800000000000001</c:v>
                </c:pt>
                <c:pt idx="293">
                  <c:v>0.13200000000000001</c:v>
                </c:pt>
                <c:pt idx="294">
                  <c:v>0.127</c:v>
                </c:pt>
                <c:pt idx="295">
                  <c:v>0.121</c:v>
                </c:pt>
                <c:pt idx="296">
                  <c:v>0.115</c:v>
                </c:pt>
                <c:pt idx="297">
                  <c:v>0.109</c:v>
                </c:pt>
                <c:pt idx="298">
                  <c:v>0.104</c:v>
                </c:pt>
                <c:pt idx="299">
                  <c:v>9.8000000000000004E-2</c:v>
                </c:pt>
                <c:pt idx="300">
                  <c:v>9.4E-2</c:v>
                </c:pt>
                <c:pt idx="301">
                  <c:v>0.09</c:v>
                </c:pt>
                <c:pt idx="302">
                  <c:v>8.5000000000000006E-2</c:v>
                </c:pt>
                <c:pt idx="303">
                  <c:v>0.08</c:v>
                </c:pt>
                <c:pt idx="304">
                  <c:v>7.5999999999999998E-2</c:v>
                </c:pt>
                <c:pt idx="305">
                  <c:v>7.1999999999999995E-2</c:v>
                </c:pt>
                <c:pt idx="306">
                  <c:v>6.8000000000000005E-2</c:v>
                </c:pt>
                <c:pt idx="307">
                  <c:v>6.5000000000000002E-2</c:v>
                </c:pt>
                <c:pt idx="308">
                  <c:v>6.0999999999999999E-2</c:v>
                </c:pt>
                <c:pt idx="309">
                  <c:v>5.8000000000000003E-2</c:v>
                </c:pt>
                <c:pt idx="310">
                  <c:v>5.5E-2</c:v>
                </c:pt>
                <c:pt idx="311">
                  <c:v>5.2999999999999999E-2</c:v>
                </c:pt>
                <c:pt idx="312">
                  <c:v>0.05</c:v>
                </c:pt>
                <c:pt idx="313">
                  <c:v>4.7E-2</c:v>
                </c:pt>
                <c:pt idx="314">
                  <c:v>4.3999999999999997E-2</c:v>
                </c:pt>
                <c:pt idx="315">
                  <c:v>4.2000000000000003E-2</c:v>
                </c:pt>
                <c:pt idx="316">
                  <c:v>0.04</c:v>
                </c:pt>
                <c:pt idx="317">
                  <c:v>3.7999999999999999E-2</c:v>
                </c:pt>
                <c:pt idx="318">
                  <c:v>3.5000000000000003E-2</c:v>
                </c:pt>
                <c:pt idx="319">
                  <c:v>3.4000000000000002E-2</c:v>
                </c:pt>
                <c:pt idx="320">
                  <c:v>3.1E-2</c:v>
                </c:pt>
                <c:pt idx="321">
                  <c:v>0.03</c:v>
                </c:pt>
                <c:pt idx="322">
                  <c:v>2.8000000000000001E-2</c:v>
                </c:pt>
                <c:pt idx="323">
                  <c:v>2.5999999999999999E-2</c:v>
                </c:pt>
                <c:pt idx="324">
                  <c:v>2.5000000000000001E-2</c:v>
                </c:pt>
                <c:pt idx="325">
                  <c:v>2.4E-2</c:v>
                </c:pt>
                <c:pt idx="326">
                  <c:v>2.3E-2</c:v>
                </c:pt>
                <c:pt idx="327">
                  <c:v>2.1999999999999999E-2</c:v>
                </c:pt>
                <c:pt idx="328">
                  <c:v>0.02</c:v>
                </c:pt>
                <c:pt idx="329">
                  <c:v>1.9E-2</c:v>
                </c:pt>
                <c:pt idx="330">
                  <c:v>1.7999999999999999E-2</c:v>
                </c:pt>
                <c:pt idx="331">
                  <c:v>1.7000000000000001E-2</c:v>
                </c:pt>
                <c:pt idx="332">
                  <c:v>1.4999999999999999E-2</c:v>
                </c:pt>
                <c:pt idx="333">
                  <c:v>1.4E-2</c:v>
                </c:pt>
                <c:pt idx="334">
                  <c:v>1.2999999999999999E-2</c:v>
                </c:pt>
                <c:pt idx="335">
                  <c:v>1.2E-2</c:v>
                </c:pt>
                <c:pt idx="336">
                  <c:v>1.0999999999999999E-2</c:v>
                </c:pt>
                <c:pt idx="337">
                  <c:v>0.01</c:v>
                </c:pt>
                <c:pt idx="338">
                  <c:v>8.9999999999999993E-3</c:v>
                </c:pt>
                <c:pt idx="339">
                  <c:v>8.0000000000000002E-3</c:v>
                </c:pt>
                <c:pt idx="340">
                  <c:v>8.0000000000000002E-3</c:v>
                </c:pt>
                <c:pt idx="341">
                  <c:v>7.0000000000000001E-3</c:v>
                </c:pt>
                <c:pt idx="342">
                  <c:v>6.0000000000000001E-3</c:v>
                </c:pt>
                <c:pt idx="343">
                  <c:v>6.0000000000000001E-3</c:v>
                </c:pt>
                <c:pt idx="344">
                  <c:v>5.0000000000000001E-3</c:v>
                </c:pt>
                <c:pt idx="345">
                  <c:v>5.0000000000000001E-3</c:v>
                </c:pt>
                <c:pt idx="346">
                  <c:v>4.0000000000000001E-3</c:v>
                </c:pt>
                <c:pt idx="347">
                  <c:v>4.0000000000000001E-3</c:v>
                </c:pt>
                <c:pt idx="348">
                  <c:v>3.0000000000000001E-3</c:v>
                </c:pt>
                <c:pt idx="349">
                  <c:v>3.0000000000000001E-3</c:v>
                </c:pt>
                <c:pt idx="350">
                  <c:v>3.0000000000000001E-3</c:v>
                </c:pt>
                <c:pt idx="351">
                  <c:v>2E-3</c:v>
                </c:pt>
                <c:pt idx="352">
                  <c:v>2E-3</c:v>
                </c:pt>
                <c:pt idx="353">
                  <c:v>2E-3</c:v>
                </c:pt>
                <c:pt idx="354">
                  <c:v>2E-3</c:v>
                </c:pt>
                <c:pt idx="355">
                  <c:v>2E-3</c:v>
                </c:pt>
                <c:pt idx="356">
                  <c:v>1E-3</c:v>
                </c:pt>
                <c:pt idx="357">
                  <c:v>1E-3</c:v>
                </c:pt>
                <c:pt idx="358">
                  <c:v>1E-3</c:v>
                </c:pt>
                <c:pt idx="359">
                  <c:v>1E-3</c:v>
                </c:pt>
                <c:pt idx="360">
                  <c:v>1E-3</c:v>
                </c:pt>
                <c:pt idx="361">
                  <c:v>1E-3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E28-411E-AF58-EA6FBC711B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3823016"/>
        <c:axId val="513821376"/>
      </c:scatterChart>
      <c:valAx>
        <c:axId val="513823016"/>
        <c:scaling>
          <c:orientation val="minMax"/>
          <c:max val="5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dirty="0"/>
                  <a:t>Dose [</a:t>
                </a:r>
                <a:r>
                  <a:rPr lang="it-IT" sz="800" dirty="0" err="1"/>
                  <a:t>cGy</a:t>
                </a:r>
                <a:r>
                  <a:rPr lang="it-IT" sz="800" dirty="0"/>
                  <a:t>(RBE)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1376"/>
        <c:crosses val="autoZero"/>
        <c:crossBetween val="midCat"/>
      </c:valAx>
      <c:valAx>
        <c:axId val="513821376"/>
        <c:scaling>
          <c:orientation val="minMax"/>
          <c:max val="3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800" dirty="0"/>
                  <a:t>Volume</a:t>
                </a:r>
                <a:r>
                  <a:rPr lang="it-IT" sz="800" baseline="0" dirty="0"/>
                  <a:t> [%]</a:t>
                </a:r>
                <a:endParaRPr lang="it-IT" sz="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51382301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9684</cdr:x>
      <cdr:y>0.07231</cdr:y>
    </cdr:from>
    <cdr:to>
      <cdr:x>0.98504</cdr:x>
      <cdr:y>0.17394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63114E80-AD6B-4CAB-BDD3-A57789AF158F}"/>
            </a:ext>
          </a:extLst>
        </cdr:cNvPr>
        <cdr:cNvSpPr txBox="1"/>
      </cdr:nvSpPr>
      <cdr:spPr>
        <a:xfrm xmlns:a="http://schemas.openxmlformats.org/drawingml/2006/main">
          <a:off x="2008025" y="130161"/>
          <a:ext cx="474272" cy="1829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it-IT" sz="1000" b="1"/>
            <a:t>CTV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7607</cdr:x>
      <cdr:y>0.05855</cdr:y>
    </cdr:from>
    <cdr:to>
      <cdr:x>0.99775</cdr:x>
      <cdr:y>0.15108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57577C3-D651-4C7B-83D0-0AA8C0E20130}"/>
            </a:ext>
          </a:extLst>
        </cdr:cNvPr>
        <cdr:cNvSpPr txBox="1"/>
      </cdr:nvSpPr>
      <cdr:spPr>
        <a:xfrm xmlns:a="http://schemas.openxmlformats.org/drawingml/2006/main">
          <a:off x="1206361" y="98138"/>
          <a:ext cx="883055" cy="1550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000" b="1" dirty="0" err="1"/>
            <a:t>Brainstem</a:t>
          </a:r>
          <a:endParaRPr lang="it-IT" sz="10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2652</cdr:x>
      <cdr:y>0.07024</cdr:y>
    </cdr:from>
    <cdr:to>
      <cdr:x>0.98048</cdr:x>
      <cdr:y>0.14623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57577C3-D651-4C7B-83D0-0AA8C0E20130}"/>
            </a:ext>
          </a:extLst>
        </cdr:cNvPr>
        <cdr:cNvSpPr txBox="1"/>
      </cdr:nvSpPr>
      <cdr:spPr>
        <a:xfrm xmlns:a="http://schemas.openxmlformats.org/drawingml/2006/main">
          <a:off x="893196" y="117732"/>
          <a:ext cx="1160056" cy="1273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000" b="1" dirty="0"/>
            <a:t>V</a:t>
          </a:r>
          <a:r>
            <a:rPr lang="it-IT" sz="1000" b="1" baseline="0" dirty="0"/>
            <a:t> </a:t>
          </a:r>
          <a:r>
            <a:rPr lang="it-IT" sz="1000" b="1" baseline="0" dirty="0" err="1"/>
            <a:t>Cranial</a:t>
          </a:r>
          <a:r>
            <a:rPr lang="it-IT" sz="1000" b="1" baseline="0" dirty="0"/>
            <a:t> </a:t>
          </a:r>
          <a:r>
            <a:rPr lang="it-IT" sz="1000" b="1" baseline="0" dirty="0" err="1"/>
            <a:t>Nerve</a:t>
          </a:r>
          <a:endParaRPr lang="it-IT" sz="10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5602</cdr:x>
      <cdr:y>0.04186</cdr:y>
    </cdr:from>
    <cdr:to>
      <cdr:x>0.97934</cdr:x>
      <cdr:y>0.11553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57577C3-D651-4C7B-83D0-0AA8C0E20130}"/>
            </a:ext>
          </a:extLst>
        </cdr:cNvPr>
        <cdr:cNvSpPr txBox="1"/>
      </cdr:nvSpPr>
      <cdr:spPr>
        <a:xfrm xmlns:a="http://schemas.openxmlformats.org/drawingml/2006/main">
          <a:off x="1173136" y="70163"/>
          <a:ext cx="877728" cy="1234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000" b="1" dirty="0" err="1"/>
            <a:t>Cochlea</a:t>
          </a:r>
          <a:r>
            <a:rPr lang="it-IT" sz="1000" b="1" baseline="0" dirty="0"/>
            <a:t> </a:t>
          </a:r>
          <a:r>
            <a:rPr lang="it-IT" sz="1000" b="1" baseline="0" dirty="0" err="1"/>
            <a:t>Sx</a:t>
          </a:r>
          <a:endParaRPr lang="it-IT" sz="1000" b="1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0283</cdr:x>
      <cdr:y>0.04796</cdr:y>
    </cdr:from>
    <cdr:to>
      <cdr:x>0.80221</cdr:x>
      <cdr:y>0.15795</cdr:y>
    </cdr:to>
    <cdr:sp macro="" textlink="">
      <cdr:nvSpPr>
        <cdr:cNvPr id="2" name="CasellaDiTesto 1">
          <a:extLst xmlns:a="http://schemas.openxmlformats.org/drawingml/2006/main">
            <a:ext uri="{FF2B5EF4-FFF2-40B4-BE49-F238E27FC236}">
              <a16:creationId xmlns:a16="http://schemas.microsoft.com/office/drawing/2014/main" id="{A57577C3-D651-4C7B-83D0-0AA8C0E20130}"/>
            </a:ext>
          </a:extLst>
        </cdr:cNvPr>
        <cdr:cNvSpPr txBox="1"/>
      </cdr:nvSpPr>
      <cdr:spPr>
        <a:xfrm xmlns:a="http://schemas.openxmlformats.org/drawingml/2006/main">
          <a:off x="1276687" y="93844"/>
          <a:ext cx="2105310" cy="2152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it-IT" sz="1000" b="1" dirty="0" err="1"/>
            <a:t>Healthy</a:t>
          </a:r>
          <a:r>
            <a:rPr lang="it-IT" sz="1000" b="1" dirty="0"/>
            <a:t> Brain </a:t>
          </a:r>
          <a:r>
            <a:rPr lang="it-IT" sz="1000" b="1" dirty="0" err="1"/>
            <a:t>Tissue</a:t>
          </a:r>
          <a:endParaRPr lang="it-IT" sz="10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82477D-4BF5-4FF2-9F40-B48A4E020F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BEE64AE-351F-4623-BEAE-56381F420E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B88369-DEF8-49B1-9BA8-859CD9315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78D58ED-E98B-4788-B421-0C2307AF4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B7F512F-2817-40E5-80F8-5C4BC3661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8804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F5B0E0-E189-47DE-800E-454910319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4E6260E-ED70-4AD2-B42F-E8142CE2E1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7E1DA28-924E-4777-BEB7-B5E9EBB7A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299774-1C1E-432A-B4B0-FA6921B36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28BF5B-034C-4C6F-BE78-24133F6FD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8017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CFBCEEE-00C7-4F20-A751-5BBB07991F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1EC5DF-9EC9-42E9-A4E5-9E720835E4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67518F-B620-4D94-BDAE-BA6009B9B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CA28BF8-37FD-4115-A086-6C0436AF1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349928-174F-4BF7-BFFB-D0D0354D8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5339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3BC709-F05D-4ABE-8C05-6DFCADDFB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ADF964F-6832-4E1E-B32E-AF817CCF5E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B3DD4D9-076B-44AB-A114-BD4E143A8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F7FB980-3283-4775-AB93-637401968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85B443-6ED4-4169-961A-B706649C8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8532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DD2C3B9-E7FC-49A1-8C4A-C496DE216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0A57BED-5022-40A9-8541-2A203AF36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3A61B7-7CBE-40E6-8CB3-3070494F9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9B15E62-4376-4EEA-9735-22159DB2F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06279CC-68FB-42AC-A26E-43DFAAFE5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8338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B9A67A-52CA-4013-B099-FBCAB7606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B375FBE-AAD2-4D2B-B014-E7875DBD9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FFD8378-ED1B-43DE-ABF4-F14AD209DD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F523E61-0FE1-4F9B-96B3-8ABCA1DE5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45E2FA6-F7F9-4182-B63A-00630573F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0858003-88D3-4C85-86C4-240F29461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217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00C191-478F-4BC1-A494-18C885491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B6F7333-04B4-49C0-A98E-64DF45A30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A244967-6F0D-4358-839C-2FEAACE0F0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8AC7592-C3E9-48E0-96D2-AAB928BDF7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9E83F8B-9430-4B23-BB4B-24F3D40F0B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2A42DFB-DE88-45F2-AA85-0DB45E439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948C423-2A4A-4009-9AC5-188F1B58C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65D335F-56E4-4AE4-A54C-D8E084DAD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1201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53C3654-C1C5-48C5-A2C4-430C1853B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DCCD7D4-9F30-482A-96B8-71BDB809F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E35B6C9-91EF-407B-BABB-4BABA8CDF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372D437-484E-4187-BBB0-BE088B764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0938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D937039-8215-4E6E-848B-C2791D8791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013FE68-CFB7-4A6F-8EA0-49BAC79C1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6F4B17E-CFA8-4097-A3C7-D907399D6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04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50791C-6FF6-4ADF-9336-7F98E6D09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9ABB562-B203-43F6-AB6C-B6980607F4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82EA944-7D45-40A3-ABA4-7414CA01F2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B5C036C-AB46-471E-A3E7-8352330E0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CABB0-D84A-4F93-B711-FEAA91421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817E6FA-F64A-4260-9991-C9D6A7CBC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1667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84F664F-8C8C-4E02-AF31-C207CEF3DB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7D365AD-7E36-4680-97AA-532D23AC00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99FF92D-E270-4EE3-A63A-907A60C3D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2D4D5F9-EE0B-4DE6-8080-7417D03B3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AAD8179-5C23-4CB9-B01E-72F78BFF8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0D3FC91-5AC3-4988-9BD7-5E16B3932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965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13A3FC2-0E22-45F6-B755-4A2466F42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4C851D2-67CD-4CDD-B902-A9C1AE62B4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A9DC02-3032-49C9-9644-5A758924F7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9E645-71FF-4DAF-B519-702C972D0983}" type="datetimeFigureOut">
              <a:rPr lang="it-IT" smtClean="0"/>
              <a:t>19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3050E11-4E0A-4D2B-8924-B30729918C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6FA689-C6EE-4ED5-B29A-4158F1739A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4817C-7BD3-4FA2-96C0-2C759328F0F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9165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8971B746-3BCF-48AC-94F6-233A59AD41F2}"/>
              </a:ext>
            </a:extLst>
          </p:cNvPr>
          <p:cNvGrpSpPr/>
          <p:nvPr/>
        </p:nvGrpSpPr>
        <p:grpSpPr>
          <a:xfrm>
            <a:off x="1068770" y="377566"/>
            <a:ext cx="4195688" cy="3635068"/>
            <a:chOff x="292903" y="432984"/>
            <a:chExt cx="5048943" cy="3903677"/>
          </a:xfrm>
        </p:grpSpPr>
        <p:graphicFrame>
          <p:nvGraphicFramePr>
            <p:cNvPr id="4" name="Grafico 3">
              <a:extLst>
                <a:ext uri="{FF2B5EF4-FFF2-40B4-BE49-F238E27FC236}">
                  <a16:creationId xmlns:a16="http://schemas.microsoft.com/office/drawing/2014/main" id="{1CE4614C-A4EB-42A7-B51C-3AF39D77AB5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98015379"/>
                </p:ext>
              </p:extLst>
            </p:nvPr>
          </p:nvGraphicFramePr>
          <p:xfrm>
            <a:off x="303671" y="723322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Grafico 4">
              <a:extLst>
                <a:ext uri="{FF2B5EF4-FFF2-40B4-BE49-F238E27FC236}">
                  <a16:creationId xmlns:a16="http://schemas.microsoft.com/office/drawing/2014/main" id="{082CFA52-AAC2-45DA-B965-F10AFF543C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3307461"/>
                </p:ext>
              </p:extLst>
            </p:nvPr>
          </p:nvGraphicFramePr>
          <p:xfrm>
            <a:off x="2821846" y="728017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Grafico 7">
              <a:extLst>
                <a:ext uri="{FF2B5EF4-FFF2-40B4-BE49-F238E27FC236}">
                  <a16:creationId xmlns:a16="http://schemas.microsoft.com/office/drawing/2014/main" id="{C2AB2931-CC8B-4DCE-87FE-4919E606FB1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98462619"/>
                </p:ext>
              </p:extLst>
            </p:nvPr>
          </p:nvGraphicFramePr>
          <p:xfrm>
            <a:off x="292903" y="2529071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9" name="Grafico 8">
              <a:extLst>
                <a:ext uri="{FF2B5EF4-FFF2-40B4-BE49-F238E27FC236}">
                  <a16:creationId xmlns:a16="http://schemas.microsoft.com/office/drawing/2014/main" id="{AB2F56E6-F5A1-4482-B640-80AB5C627C0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8135054"/>
                </p:ext>
              </p:extLst>
            </p:nvPr>
          </p:nvGraphicFramePr>
          <p:xfrm>
            <a:off x="2819098" y="2536661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BA21D8C9-64F2-49F2-ACCD-47DCE260EBAD}"/>
                </a:ext>
              </a:extLst>
            </p:cNvPr>
            <p:cNvSpPr txBox="1"/>
            <p:nvPr/>
          </p:nvSpPr>
          <p:spPr>
            <a:xfrm>
              <a:off x="391168" y="432984"/>
              <a:ext cx="25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Neuroma</a:t>
              </a: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6E923DE4-C839-4DE8-866C-19064E7D27A6}"/>
              </a:ext>
            </a:extLst>
          </p:cNvPr>
          <p:cNvSpPr txBox="1"/>
          <p:nvPr/>
        </p:nvSpPr>
        <p:spPr>
          <a:xfrm>
            <a:off x="1358052" y="5774815"/>
            <a:ext cx="37730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>
                <a:cs typeface="Times New Roman" panose="02020603050405020304" pitchFamily="18" charset="0"/>
              </a:rPr>
              <a:t>Fig. </a:t>
            </a:r>
            <a:r>
              <a:rPr lang="it-IT" sz="1100" b="1">
                <a:cs typeface="Times New Roman" panose="02020603050405020304" pitchFamily="18" charset="0"/>
              </a:rPr>
              <a:t>S1 </a:t>
            </a:r>
            <a:r>
              <a:rPr lang="it-IT" sz="1100" dirty="0">
                <a:cs typeface="Times New Roman" panose="02020603050405020304" pitchFamily="18" charset="0"/>
              </a:rPr>
              <a:t>Dose volume </a:t>
            </a:r>
            <a:r>
              <a:rPr lang="it-IT" sz="1100" dirty="0" err="1">
                <a:cs typeface="Times New Roman" panose="02020603050405020304" pitchFamily="18" charset="0"/>
              </a:rPr>
              <a:t>histograms</a:t>
            </a:r>
            <a:r>
              <a:rPr lang="it-IT" sz="1100" dirty="0">
                <a:cs typeface="Times New Roman" panose="02020603050405020304" pitchFamily="18" charset="0"/>
              </a:rPr>
              <a:t> for the neuroma </a:t>
            </a:r>
            <a:r>
              <a:rPr lang="it-IT" sz="1100" dirty="0" err="1">
                <a:cs typeface="Times New Roman" panose="02020603050405020304" pitchFamily="18" charset="0"/>
              </a:rPr>
              <a:t>patient</a:t>
            </a:r>
            <a:r>
              <a:rPr lang="it-IT" sz="1100" dirty="0">
                <a:cs typeface="Times New Roman" panose="02020603050405020304" pitchFamily="18" charset="0"/>
              </a:rPr>
              <a:t> # 1, for the </a:t>
            </a:r>
            <a:r>
              <a:rPr lang="it-IT" sz="1100" dirty="0" err="1">
                <a:cs typeface="Times New Roman" panose="02020603050405020304" pitchFamily="18" charset="0"/>
              </a:rPr>
              <a:t>nominal</a:t>
            </a:r>
            <a:r>
              <a:rPr lang="it-IT" sz="1100" dirty="0">
                <a:cs typeface="Times New Roman" panose="02020603050405020304" pitchFamily="18" charset="0"/>
              </a:rPr>
              <a:t> scenario. </a:t>
            </a:r>
          </a:p>
        </p:txBody>
      </p:sp>
      <p:graphicFrame>
        <p:nvGraphicFramePr>
          <p:cNvPr id="11" name="Grafico 10">
            <a:extLst>
              <a:ext uri="{FF2B5EF4-FFF2-40B4-BE49-F238E27FC236}">
                <a16:creationId xmlns:a16="http://schemas.microsoft.com/office/drawing/2014/main" id="{44A336A5-18F4-4475-A15F-EB5CC5D2FC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0226242"/>
              </p:ext>
            </p:extLst>
          </p:nvPr>
        </p:nvGraphicFramePr>
        <p:xfrm>
          <a:off x="977589" y="3861826"/>
          <a:ext cx="4215848" cy="19565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353605542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69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ghetto Roberto</dc:creator>
  <cp:lastModifiedBy>Righetto Roberto</cp:lastModifiedBy>
  <cp:revision>10</cp:revision>
  <dcterms:created xsi:type="dcterms:W3CDTF">2021-08-17T11:29:33Z</dcterms:created>
  <dcterms:modified xsi:type="dcterms:W3CDTF">2021-08-19T13:43:54Z</dcterms:modified>
</cp:coreProperties>
</file>